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1" r:id="rId3"/>
    <p:sldId id="257" r:id="rId4"/>
    <p:sldId id="258" r:id="rId5"/>
    <p:sldId id="262" r:id="rId6"/>
    <p:sldId id="259" r:id="rId7"/>
    <p:sldId id="260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25" d="100"/>
          <a:sy n="125" d="100"/>
        </p:scale>
        <p:origin x="-1800" y="-2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817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257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73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52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2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285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13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1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917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98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353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9C5E1B-CEDE-A84C-9F5A-BDCAD2180E79}" type="datetimeFigureOut">
              <a:rPr lang="en-US" smtClean="0"/>
              <a:t>5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A7F868-3EA3-CD41-A0FC-F120E7A73F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989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635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ure 2A</a:t>
            </a:r>
            <a:endParaRPr lang="en-US" dirty="0"/>
          </a:p>
        </p:txBody>
      </p:sp>
      <p:sp>
        <p:nvSpPr>
          <p:cNvPr id="4" name="Rectangle 44"/>
          <p:cNvSpPr>
            <a:spLocks noChangeArrowheads="1"/>
          </p:cNvSpPr>
          <p:nvPr/>
        </p:nvSpPr>
        <p:spPr bwMode="auto">
          <a:xfrm>
            <a:off x="1069032" y="5720402"/>
            <a:ext cx="25653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dirty="0">
                <a:solidFill>
                  <a:srgbClr val="000000"/>
                </a:solidFill>
                <a:latin typeface="Arial Black"/>
                <a:cs typeface="Arial Black"/>
              </a:rPr>
              <a:t>-50</a:t>
            </a:r>
            <a:endParaRPr lang="es-ES" sz="1200" dirty="0">
              <a:latin typeface="Arial Black"/>
              <a:cs typeface="Arial Black"/>
            </a:endParaRPr>
          </a:p>
        </p:txBody>
      </p:sp>
      <p:sp>
        <p:nvSpPr>
          <p:cNvPr id="5" name="Freeform 100"/>
          <p:cNvSpPr>
            <a:spLocks/>
          </p:cNvSpPr>
          <p:nvPr/>
        </p:nvSpPr>
        <p:spPr bwMode="auto">
          <a:xfrm>
            <a:off x="1672431" y="3458212"/>
            <a:ext cx="6626225" cy="2679700"/>
          </a:xfrm>
          <a:custGeom>
            <a:avLst/>
            <a:gdLst>
              <a:gd name="T0" fmla="*/ 60 w 4174"/>
              <a:gd name="T1" fmla="*/ 1162 h 1688"/>
              <a:gd name="T2" fmla="*/ 133 w 4174"/>
              <a:gd name="T3" fmla="*/ 1162 h 1688"/>
              <a:gd name="T4" fmla="*/ 205 w 4174"/>
              <a:gd name="T5" fmla="*/ 1155 h 1688"/>
              <a:gd name="T6" fmla="*/ 279 w 4174"/>
              <a:gd name="T7" fmla="*/ 1284 h 1688"/>
              <a:gd name="T8" fmla="*/ 350 w 4174"/>
              <a:gd name="T9" fmla="*/ 1135 h 1688"/>
              <a:gd name="T10" fmla="*/ 424 w 4174"/>
              <a:gd name="T11" fmla="*/ 1060 h 1688"/>
              <a:gd name="T12" fmla="*/ 496 w 4174"/>
              <a:gd name="T13" fmla="*/ 1008 h 1688"/>
              <a:gd name="T14" fmla="*/ 569 w 4174"/>
              <a:gd name="T15" fmla="*/ 959 h 1688"/>
              <a:gd name="T16" fmla="*/ 641 w 4174"/>
              <a:gd name="T17" fmla="*/ 918 h 1688"/>
              <a:gd name="T18" fmla="*/ 714 w 4174"/>
              <a:gd name="T19" fmla="*/ 887 h 1688"/>
              <a:gd name="T20" fmla="*/ 786 w 4174"/>
              <a:gd name="T21" fmla="*/ 863 h 1688"/>
              <a:gd name="T22" fmla="*/ 860 w 4174"/>
              <a:gd name="T23" fmla="*/ 842 h 1688"/>
              <a:gd name="T24" fmla="*/ 931 w 4174"/>
              <a:gd name="T25" fmla="*/ 817 h 1688"/>
              <a:gd name="T26" fmla="*/ 1005 w 4174"/>
              <a:gd name="T27" fmla="*/ 799 h 1688"/>
              <a:gd name="T28" fmla="*/ 1077 w 4174"/>
              <a:gd name="T29" fmla="*/ 773 h 1688"/>
              <a:gd name="T30" fmla="*/ 1150 w 4174"/>
              <a:gd name="T31" fmla="*/ 754 h 1688"/>
              <a:gd name="T32" fmla="*/ 1222 w 4174"/>
              <a:gd name="T33" fmla="*/ 734 h 1688"/>
              <a:gd name="T34" fmla="*/ 1295 w 4174"/>
              <a:gd name="T35" fmla="*/ 716 h 1688"/>
              <a:gd name="T36" fmla="*/ 1367 w 4174"/>
              <a:gd name="T37" fmla="*/ 698 h 1688"/>
              <a:gd name="T38" fmla="*/ 1440 w 4174"/>
              <a:gd name="T39" fmla="*/ 680 h 1688"/>
              <a:gd name="T40" fmla="*/ 1512 w 4174"/>
              <a:gd name="T41" fmla="*/ 666 h 1688"/>
              <a:gd name="T42" fmla="*/ 1586 w 4174"/>
              <a:gd name="T43" fmla="*/ 648 h 1688"/>
              <a:gd name="T44" fmla="*/ 1657 w 4174"/>
              <a:gd name="T45" fmla="*/ 636 h 1688"/>
              <a:gd name="T46" fmla="*/ 1731 w 4174"/>
              <a:gd name="T47" fmla="*/ 622 h 1688"/>
              <a:gd name="T48" fmla="*/ 1803 w 4174"/>
              <a:gd name="T49" fmla="*/ 607 h 1688"/>
              <a:gd name="T50" fmla="*/ 1876 w 4174"/>
              <a:gd name="T51" fmla="*/ 594 h 1688"/>
              <a:gd name="T52" fmla="*/ 1948 w 4174"/>
              <a:gd name="T53" fmla="*/ 581 h 1688"/>
              <a:gd name="T54" fmla="*/ 2021 w 4174"/>
              <a:gd name="T55" fmla="*/ 566 h 1688"/>
              <a:gd name="T56" fmla="*/ 2093 w 4174"/>
              <a:gd name="T57" fmla="*/ 555 h 1688"/>
              <a:gd name="T58" fmla="*/ 2165 w 4174"/>
              <a:gd name="T59" fmla="*/ 542 h 1688"/>
              <a:gd name="T60" fmla="*/ 2238 w 4174"/>
              <a:gd name="T61" fmla="*/ 529 h 1688"/>
              <a:gd name="T62" fmla="*/ 2310 w 4174"/>
              <a:gd name="T63" fmla="*/ 519 h 1688"/>
              <a:gd name="T64" fmla="*/ 2384 w 4174"/>
              <a:gd name="T65" fmla="*/ 524 h 1688"/>
              <a:gd name="T66" fmla="*/ 2455 w 4174"/>
              <a:gd name="T67" fmla="*/ 542 h 1688"/>
              <a:gd name="T68" fmla="*/ 2529 w 4174"/>
              <a:gd name="T69" fmla="*/ 556 h 1688"/>
              <a:gd name="T70" fmla="*/ 2601 w 4174"/>
              <a:gd name="T71" fmla="*/ 569 h 1688"/>
              <a:gd name="T72" fmla="*/ 2674 w 4174"/>
              <a:gd name="T73" fmla="*/ 579 h 1688"/>
              <a:gd name="T74" fmla="*/ 2746 w 4174"/>
              <a:gd name="T75" fmla="*/ 587 h 1688"/>
              <a:gd name="T76" fmla="*/ 2819 w 4174"/>
              <a:gd name="T77" fmla="*/ 595 h 1688"/>
              <a:gd name="T78" fmla="*/ 2891 w 4174"/>
              <a:gd name="T79" fmla="*/ 600 h 1688"/>
              <a:gd name="T80" fmla="*/ 2965 w 4174"/>
              <a:gd name="T81" fmla="*/ 604 h 1688"/>
              <a:gd name="T82" fmla="*/ 3036 w 4174"/>
              <a:gd name="T83" fmla="*/ 609 h 1688"/>
              <a:gd name="T84" fmla="*/ 3110 w 4174"/>
              <a:gd name="T85" fmla="*/ 605 h 1688"/>
              <a:gd name="T86" fmla="*/ 3182 w 4174"/>
              <a:gd name="T87" fmla="*/ 607 h 1688"/>
              <a:gd name="T88" fmla="*/ 3255 w 4174"/>
              <a:gd name="T89" fmla="*/ 607 h 1688"/>
              <a:gd name="T90" fmla="*/ 3327 w 4174"/>
              <a:gd name="T91" fmla="*/ 607 h 1688"/>
              <a:gd name="T92" fmla="*/ 3400 w 4174"/>
              <a:gd name="T93" fmla="*/ 609 h 1688"/>
              <a:gd name="T94" fmla="*/ 3472 w 4174"/>
              <a:gd name="T95" fmla="*/ 610 h 1688"/>
              <a:gd name="T96" fmla="*/ 3545 w 4174"/>
              <a:gd name="T97" fmla="*/ 607 h 1688"/>
              <a:gd name="T98" fmla="*/ 3617 w 4174"/>
              <a:gd name="T99" fmla="*/ 607 h 1688"/>
              <a:gd name="T100" fmla="*/ 3691 w 4174"/>
              <a:gd name="T101" fmla="*/ 610 h 1688"/>
              <a:gd name="T102" fmla="*/ 3762 w 4174"/>
              <a:gd name="T103" fmla="*/ 610 h 1688"/>
              <a:gd name="T104" fmla="*/ 3836 w 4174"/>
              <a:gd name="T105" fmla="*/ 610 h 1688"/>
              <a:gd name="T106" fmla="*/ 3908 w 4174"/>
              <a:gd name="T107" fmla="*/ 610 h 1688"/>
              <a:gd name="T108" fmla="*/ 3981 w 4174"/>
              <a:gd name="T109" fmla="*/ 609 h 1688"/>
              <a:gd name="T110" fmla="*/ 4053 w 4174"/>
              <a:gd name="T111" fmla="*/ 605 h 1688"/>
              <a:gd name="T112" fmla="*/ 4126 w 4174"/>
              <a:gd name="T113" fmla="*/ 609 h 16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688">
                <a:moveTo>
                  <a:pt x="0" y="1162"/>
                </a:moveTo>
                <a:lnTo>
                  <a:pt x="13" y="1162"/>
                </a:lnTo>
                <a:lnTo>
                  <a:pt x="24" y="1163"/>
                </a:lnTo>
                <a:lnTo>
                  <a:pt x="37" y="1163"/>
                </a:lnTo>
                <a:lnTo>
                  <a:pt x="49" y="1162"/>
                </a:lnTo>
                <a:lnTo>
                  <a:pt x="60" y="1162"/>
                </a:lnTo>
                <a:lnTo>
                  <a:pt x="73" y="1162"/>
                </a:lnTo>
                <a:lnTo>
                  <a:pt x="85" y="1162"/>
                </a:lnTo>
                <a:lnTo>
                  <a:pt x="98" y="1162"/>
                </a:lnTo>
                <a:lnTo>
                  <a:pt x="109" y="1162"/>
                </a:lnTo>
                <a:lnTo>
                  <a:pt x="120" y="1162"/>
                </a:lnTo>
                <a:lnTo>
                  <a:pt x="133" y="1162"/>
                </a:lnTo>
                <a:lnTo>
                  <a:pt x="145" y="1162"/>
                </a:lnTo>
                <a:lnTo>
                  <a:pt x="158" y="1165"/>
                </a:lnTo>
                <a:lnTo>
                  <a:pt x="169" y="1162"/>
                </a:lnTo>
                <a:lnTo>
                  <a:pt x="182" y="1153"/>
                </a:lnTo>
                <a:lnTo>
                  <a:pt x="194" y="1152"/>
                </a:lnTo>
                <a:lnTo>
                  <a:pt x="205" y="1155"/>
                </a:lnTo>
                <a:lnTo>
                  <a:pt x="218" y="1165"/>
                </a:lnTo>
                <a:lnTo>
                  <a:pt x="230" y="1171"/>
                </a:lnTo>
                <a:lnTo>
                  <a:pt x="243" y="941"/>
                </a:lnTo>
                <a:lnTo>
                  <a:pt x="254" y="77"/>
                </a:lnTo>
                <a:lnTo>
                  <a:pt x="266" y="0"/>
                </a:lnTo>
                <a:lnTo>
                  <a:pt x="279" y="1284"/>
                </a:lnTo>
                <a:lnTo>
                  <a:pt x="290" y="1688"/>
                </a:lnTo>
                <a:lnTo>
                  <a:pt x="303" y="1491"/>
                </a:lnTo>
                <a:lnTo>
                  <a:pt x="315" y="1302"/>
                </a:lnTo>
                <a:lnTo>
                  <a:pt x="328" y="1207"/>
                </a:lnTo>
                <a:lnTo>
                  <a:pt x="339" y="1162"/>
                </a:lnTo>
                <a:lnTo>
                  <a:pt x="350" y="1135"/>
                </a:lnTo>
                <a:lnTo>
                  <a:pt x="364" y="1119"/>
                </a:lnTo>
                <a:lnTo>
                  <a:pt x="375" y="1104"/>
                </a:lnTo>
                <a:lnTo>
                  <a:pt x="388" y="1091"/>
                </a:lnTo>
                <a:lnTo>
                  <a:pt x="399" y="1082"/>
                </a:lnTo>
                <a:lnTo>
                  <a:pt x="411" y="1070"/>
                </a:lnTo>
                <a:lnTo>
                  <a:pt x="424" y="1060"/>
                </a:lnTo>
                <a:lnTo>
                  <a:pt x="435" y="1051"/>
                </a:lnTo>
                <a:lnTo>
                  <a:pt x="448" y="1042"/>
                </a:lnTo>
                <a:lnTo>
                  <a:pt x="460" y="1034"/>
                </a:lnTo>
                <a:lnTo>
                  <a:pt x="471" y="1024"/>
                </a:lnTo>
                <a:lnTo>
                  <a:pt x="484" y="1016"/>
                </a:lnTo>
                <a:lnTo>
                  <a:pt x="496" y="1008"/>
                </a:lnTo>
                <a:lnTo>
                  <a:pt x="509" y="1000"/>
                </a:lnTo>
                <a:lnTo>
                  <a:pt x="520" y="990"/>
                </a:lnTo>
                <a:lnTo>
                  <a:pt x="533" y="984"/>
                </a:lnTo>
                <a:lnTo>
                  <a:pt x="545" y="976"/>
                </a:lnTo>
                <a:lnTo>
                  <a:pt x="556" y="966"/>
                </a:lnTo>
                <a:lnTo>
                  <a:pt x="569" y="959"/>
                </a:lnTo>
                <a:lnTo>
                  <a:pt x="581" y="951"/>
                </a:lnTo>
                <a:lnTo>
                  <a:pt x="594" y="945"/>
                </a:lnTo>
                <a:lnTo>
                  <a:pt x="605" y="936"/>
                </a:lnTo>
                <a:lnTo>
                  <a:pt x="616" y="932"/>
                </a:lnTo>
                <a:lnTo>
                  <a:pt x="629" y="925"/>
                </a:lnTo>
                <a:lnTo>
                  <a:pt x="641" y="918"/>
                </a:lnTo>
                <a:lnTo>
                  <a:pt x="654" y="912"/>
                </a:lnTo>
                <a:lnTo>
                  <a:pt x="665" y="909"/>
                </a:lnTo>
                <a:lnTo>
                  <a:pt x="678" y="904"/>
                </a:lnTo>
                <a:lnTo>
                  <a:pt x="690" y="901"/>
                </a:lnTo>
                <a:lnTo>
                  <a:pt x="701" y="894"/>
                </a:lnTo>
                <a:lnTo>
                  <a:pt x="714" y="887"/>
                </a:lnTo>
                <a:lnTo>
                  <a:pt x="726" y="884"/>
                </a:lnTo>
                <a:lnTo>
                  <a:pt x="739" y="879"/>
                </a:lnTo>
                <a:lnTo>
                  <a:pt x="750" y="874"/>
                </a:lnTo>
                <a:lnTo>
                  <a:pt x="762" y="870"/>
                </a:lnTo>
                <a:lnTo>
                  <a:pt x="775" y="866"/>
                </a:lnTo>
                <a:lnTo>
                  <a:pt x="786" y="863"/>
                </a:lnTo>
                <a:lnTo>
                  <a:pt x="799" y="860"/>
                </a:lnTo>
                <a:lnTo>
                  <a:pt x="811" y="856"/>
                </a:lnTo>
                <a:lnTo>
                  <a:pt x="824" y="852"/>
                </a:lnTo>
                <a:lnTo>
                  <a:pt x="835" y="848"/>
                </a:lnTo>
                <a:lnTo>
                  <a:pt x="847" y="845"/>
                </a:lnTo>
                <a:lnTo>
                  <a:pt x="860" y="842"/>
                </a:lnTo>
                <a:lnTo>
                  <a:pt x="871" y="837"/>
                </a:lnTo>
                <a:lnTo>
                  <a:pt x="884" y="834"/>
                </a:lnTo>
                <a:lnTo>
                  <a:pt x="895" y="829"/>
                </a:lnTo>
                <a:lnTo>
                  <a:pt x="907" y="825"/>
                </a:lnTo>
                <a:lnTo>
                  <a:pt x="920" y="822"/>
                </a:lnTo>
                <a:lnTo>
                  <a:pt x="931" y="817"/>
                </a:lnTo>
                <a:lnTo>
                  <a:pt x="944" y="814"/>
                </a:lnTo>
                <a:lnTo>
                  <a:pt x="956" y="812"/>
                </a:lnTo>
                <a:lnTo>
                  <a:pt x="967" y="809"/>
                </a:lnTo>
                <a:lnTo>
                  <a:pt x="980" y="806"/>
                </a:lnTo>
                <a:lnTo>
                  <a:pt x="992" y="803"/>
                </a:lnTo>
                <a:lnTo>
                  <a:pt x="1005" y="799"/>
                </a:lnTo>
                <a:lnTo>
                  <a:pt x="1016" y="796"/>
                </a:lnTo>
                <a:lnTo>
                  <a:pt x="1029" y="793"/>
                </a:lnTo>
                <a:lnTo>
                  <a:pt x="1041" y="788"/>
                </a:lnTo>
                <a:lnTo>
                  <a:pt x="1052" y="783"/>
                </a:lnTo>
                <a:lnTo>
                  <a:pt x="1065" y="778"/>
                </a:lnTo>
                <a:lnTo>
                  <a:pt x="1077" y="773"/>
                </a:lnTo>
                <a:lnTo>
                  <a:pt x="1090" y="770"/>
                </a:lnTo>
                <a:lnTo>
                  <a:pt x="1101" y="767"/>
                </a:lnTo>
                <a:lnTo>
                  <a:pt x="1112" y="763"/>
                </a:lnTo>
                <a:lnTo>
                  <a:pt x="1126" y="760"/>
                </a:lnTo>
                <a:lnTo>
                  <a:pt x="1137" y="757"/>
                </a:lnTo>
                <a:lnTo>
                  <a:pt x="1150" y="754"/>
                </a:lnTo>
                <a:lnTo>
                  <a:pt x="1161" y="749"/>
                </a:lnTo>
                <a:lnTo>
                  <a:pt x="1174" y="747"/>
                </a:lnTo>
                <a:lnTo>
                  <a:pt x="1186" y="744"/>
                </a:lnTo>
                <a:lnTo>
                  <a:pt x="1197" y="741"/>
                </a:lnTo>
                <a:lnTo>
                  <a:pt x="1210" y="737"/>
                </a:lnTo>
                <a:lnTo>
                  <a:pt x="1222" y="734"/>
                </a:lnTo>
                <a:lnTo>
                  <a:pt x="1235" y="731"/>
                </a:lnTo>
                <a:lnTo>
                  <a:pt x="1246" y="729"/>
                </a:lnTo>
                <a:lnTo>
                  <a:pt x="1258" y="726"/>
                </a:lnTo>
                <a:lnTo>
                  <a:pt x="1271" y="723"/>
                </a:lnTo>
                <a:lnTo>
                  <a:pt x="1282" y="719"/>
                </a:lnTo>
                <a:lnTo>
                  <a:pt x="1295" y="716"/>
                </a:lnTo>
                <a:lnTo>
                  <a:pt x="1307" y="715"/>
                </a:lnTo>
                <a:lnTo>
                  <a:pt x="1318" y="711"/>
                </a:lnTo>
                <a:lnTo>
                  <a:pt x="1331" y="708"/>
                </a:lnTo>
                <a:lnTo>
                  <a:pt x="1343" y="705"/>
                </a:lnTo>
                <a:lnTo>
                  <a:pt x="1356" y="703"/>
                </a:lnTo>
                <a:lnTo>
                  <a:pt x="1367" y="698"/>
                </a:lnTo>
                <a:lnTo>
                  <a:pt x="1380" y="697"/>
                </a:lnTo>
                <a:lnTo>
                  <a:pt x="1392" y="693"/>
                </a:lnTo>
                <a:lnTo>
                  <a:pt x="1403" y="690"/>
                </a:lnTo>
                <a:lnTo>
                  <a:pt x="1416" y="687"/>
                </a:lnTo>
                <a:lnTo>
                  <a:pt x="1427" y="684"/>
                </a:lnTo>
                <a:lnTo>
                  <a:pt x="1440" y="680"/>
                </a:lnTo>
                <a:lnTo>
                  <a:pt x="1452" y="679"/>
                </a:lnTo>
                <a:lnTo>
                  <a:pt x="1463" y="675"/>
                </a:lnTo>
                <a:lnTo>
                  <a:pt x="1476" y="674"/>
                </a:lnTo>
                <a:lnTo>
                  <a:pt x="1488" y="671"/>
                </a:lnTo>
                <a:lnTo>
                  <a:pt x="1501" y="667"/>
                </a:lnTo>
                <a:lnTo>
                  <a:pt x="1512" y="666"/>
                </a:lnTo>
                <a:lnTo>
                  <a:pt x="1525" y="664"/>
                </a:lnTo>
                <a:lnTo>
                  <a:pt x="1537" y="661"/>
                </a:lnTo>
                <a:lnTo>
                  <a:pt x="1548" y="657"/>
                </a:lnTo>
                <a:lnTo>
                  <a:pt x="1561" y="656"/>
                </a:lnTo>
                <a:lnTo>
                  <a:pt x="1573" y="651"/>
                </a:lnTo>
                <a:lnTo>
                  <a:pt x="1586" y="648"/>
                </a:lnTo>
                <a:lnTo>
                  <a:pt x="1597" y="646"/>
                </a:lnTo>
                <a:lnTo>
                  <a:pt x="1609" y="643"/>
                </a:lnTo>
                <a:lnTo>
                  <a:pt x="1622" y="641"/>
                </a:lnTo>
                <a:lnTo>
                  <a:pt x="1633" y="641"/>
                </a:lnTo>
                <a:lnTo>
                  <a:pt x="1646" y="638"/>
                </a:lnTo>
                <a:lnTo>
                  <a:pt x="1657" y="636"/>
                </a:lnTo>
                <a:lnTo>
                  <a:pt x="1671" y="633"/>
                </a:lnTo>
                <a:lnTo>
                  <a:pt x="1682" y="631"/>
                </a:lnTo>
                <a:lnTo>
                  <a:pt x="1693" y="628"/>
                </a:lnTo>
                <a:lnTo>
                  <a:pt x="1706" y="626"/>
                </a:lnTo>
                <a:lnTo>
                  <a:pt x="1718" y="623"/>
                </a:lnTo>
                <a:lnTo>
                  <a:pt x="1731" y="622"/>
                </a:lnTo>
                <a:lnTo>
                  <a:pt x="1742" y="620"/>
                </a:lnTo>
                <a:lnTo>
                  <a:pt x="1754" y="617"/>
                </a:lnTo>
                <a:lnTo>
                  <a:pt x="1767" y="615"/>
                </a:lnTo>
                <a:lnTo>
                  <a:pt x="1778" y="612"/>
                </a:lnTo>
                <a:lnTo>
                  <a:pt x="1791" y="610"/>
                </a:lnTo>
                <a:lnTo>
                  <a:pt x="1803" y="607"/>
                </a:lnTo>
                <a:lnTo>
                  <a:pt x="1814" y="605"/>
                </a:lnTo>
                <a:lnTo>
                  <a:pt x="1827" y="602"/>
                </a:lnTo>
                <a:lnTo>
                  <a:pt x="1839" y="600"/>
                </a:lnTo>
                <a:lnTo>
                  <a:pt x="1852" y="597"/>
                </a:lnTo>
                <a:lnTo>
                  <a:pt x="1863" y="595"/>
                </a:lnTo>
                <a:lnTo>
                  <a:pt x="1876" y="594"/>
                </a:lnTo>
                <a:lnTo>
                  <a:pt x="1888" y="592"/>
                </a:lnTo>
                <a:lnTo>
                  <a:pt x="1899" y="589"/>
                </a:lnTo>
                <a:lnTo>
                  <a:pt x="1912" y="587"/>
                </a:lnTo>
                <a:lnTo>
                  <a:pt x="1923" y="586"/>
                </a:lnTo>
                <a:lnTo>
                  <a:pt x="1937" y="584"/>
                </a:lnTo>
                <a:lnTo>
                  <a:pt x="1948" y="581"/>
                </a:lnTo>
                <a:lnTo>
                  <a:pt x="1959" y="579"/>
                </a:lnTo>
                <a:lnTo>
                  <a:pt x="1972" y="576"/>
                </a:lnTo>
                <a:lnTo>
                  <a:pt x="1984" y="574"/>
                </a:lnTo>
                <a:lnTo>
                  <a:pt x="1997" y="573"/>
                </a:lnTo>
                <a:lnTo>
                  <a:pt x="2008" y="569"/>
                </a:lnTo>
                <a:lnTo>
                  <a:pt x="2021" y="566"/>
                </a:lnTo>
                <a:lnTo>
                  <a:pt x="2033" y="566"/>
                </a:lnTo>
                <a:lnTo>
                  <a:pt x="2044" y="563"/>
                </a:lnTo>
                <a:lnTo>
                  <a:pt x="2057" y="561"/>
                </a:lnTo>
                <a:lnTo>
                  <a:pt x="2069" y="560"/>
                </a:lnTo>
                <a:lnTo>
                  <a:pt x="2082" y="558"/>
                </a:lnTo>
                <a:lnTo>
                  <a:pt x="2093" y="555"/>
                </a:lnTo>
                <a:lnTo>
                  <a:pt x="2105" y="551"/>
                </a:lnTo>
                <a:lnTo>
                  <a:pt x="2118" y="548"/>
                </a:lnTo>
                <a:lnTo>
                  <a:pt x="2129" y="550"/>
                </a:lnTo>
                <a:lnTo>
                  <a:pt x="2142" y="547"/>
                </a:lnTo>
                <a:lnTo>
                  <a:pt x="2154" y="545"/>
                </a:lnTo>
                <a:lnTo>
                  <a:pt x="2165" y="542"/>
                </a:lnTo>
                <a:lnTo>
                  <a:pt x="2178" y="538"/>
                </a:lnTo>
                <a:lnTo>
                  <a:pt x="2189" y="537"/>
                </a:lnTo>
                <a:lnTo>
                  <a:pt x="2202" y="535"/>
                </a:lnTo>
                <a:lnTo>
                  <a:pt x="2214" y="533"/>
                </a:lnTo>
                <a:lnTo>
                  <a:pt x="2227" y="532"/>
                </a:lnTo>
                <a:lnTo>
                  <a:pt x="2238" y="529"/>
                </a:lnTo>
                <a:lnTo>
                  <a:pt x="2250" y="529"/>
                </a:lnTo>
                <a:lnTo>
                  <a:pt x="2263" y="527"/>
                </a:lnTo>
                <a:lnTo>
                  <a:pt x="2274" y="525"/>
                </a:lnTo>
                <a:lnTo>
                  <a:pt x="2287" y="522"/>
                </a:lnTo>
                <a:lnTo>
                  <a:pt x="2299" y="520"/>
                </a:lnTo>
                <a:lnTo>
                  <a:pt x="2310" y="519"/>
                </a:lnTo>
                <a:lnTo>
                  <a:pt x="2323" y="516"/>
                </a:lnTo>
                <a:lnTo>
                  <a:pt x="2335" y="516"/>
                </a:lnTo>
                <a:lnTo>
                  <a:pt x="2348" y="517"/>
                </a:lnTo>
                <a:lnTo>
                  <a:pt x="2359" y="524"/>
                </a:lnTo>
                <a:lnTo>
                  <a:pt x="2372" y="525"/>
                </a:lnTo>
                <a:lnTo>
                  <a:pt x="2384" y="524"/>
                </a:lnTo>
                <a:lnTo>
                  <a:pt x="2395" y="597"/>
                </a:lnTo>
                <a:lnTo>
                  <a:pt x="2408" y="597"/>
                </a:lnTo>
                <a:lnTo>
                  <a:pt x="2420" y="574"/>
                </a:lnTo>
                <a:lnTo>
                  <a:pt x="2433" y="553"/>
                </a:lnTo>
                <a:lnTo>
                  <a:pt x="2444" y="545"/>
                </a:lnTo>
                <a:lnTo>
                  <a:pt x="2455" y="542"/>
                </a:lnTo>
                <a:lnTo>
                  <a:pt x="2468" y="543"/>
                </a:lnTo>
                <a:lnTo>
                  <a:pt x="2480" y="547"/>
                </a:lnTo>
                <a:lnTo>
                  <a:pt x="2493" y="550"/>
                </a:lnTo>
                <a:lnTo>
                  <a:pt x="2504" y="550"/>
                </a:lnTo>
                <a:lnTo>
                  <a:pt x="2517" y="553"/>
                </a:lnTo>
                <a:lnTo>
                  <a:pt x="2529" y="556"/>
                </a:lnTo>
                <a:lnTo>
                  <a:pt x="2540" y="560"/>
                </a:lnTo>
                <a:lnTo>
                  <a:pt x="2553" y="561"/>
                </a:lnTo>
                <a:lnTo>
                  <a:pt x="2565" y="564"/>
                </a:lnTo>
                <a:lnTo>
                  <a:pt x="2578" y="566"/>
                </a:lnTo>
                <a:lnTo>
                  <a:pt x="2589" y="568"/>
                </a:lnTo>
                <a:lnTo>
                  <a:pt x="2601" y="569"/>
                </a:lnTo>
                <a:lnTo>
                  <a:pt x="2614" y="573"/>
                </a:lnTo>
                <a:lnTo>
                  <a:pt x="2625" y="574"/>
                </a:lnTo>
                <a:lnTo>
                  <a:pt x="2638" y="576"/>
                </a:lnTo>
                <a:lnTo>
                  <a:pt x="2650" y="578"/>
                </a:lnTo>
                <a:lnTo>
                  <a:pt x="2661" y="578"/>
                </a:lnTo>
                <a:lnTo>
                  <a:pt x="2674" y="579"/>
                </a:lnTo>
                <a:lnTo>
                  <a:pt x="2685" y="582"/>
                </a:lnTo>
                <a:lnTo>
                  <a:pt x="2699" y="582"/>
                </a:lnTo>
                <a:lnTo>
                  <a:pt x="2710" y="584"/>
                </a:lnTo>
                <a:lnTo>
                  <a:pt x="2723" y="586"/>
                </a:lnTo>
                <a:lnTo>
                  <a:pt x="2734" y="587"/>
                </a:lnTo>
                <a:lnTo>
                  <a:pt x="2746" y="587"/>
                </a:lnTo>
                <a:lnTo>
                  <a:pt x="2759" y="589"/>
                </a:lnTo>
                <a:lnTo>
                  <a:pt x="2770" y="591"/>
                </a:lnTo>
                <a:lnTo>
                  <a:pt x="2783" y="592"/>
                </a:lnTo>
                <a:lnTo>
                  <a:pt x="2795" y="594"/>
                </a:lnTo>
                <a:lnTo>
                  <a:pt x="2806" y="595"/>
                </a:lnTo>
                <a:lnTo>
                  <a:pt x="2819" y="595"/>
                </a:lnTo>
                <a:lnTo>
                  <a:pt x="2831" y="595"/>
                </a:lnTo>
                <a:lnTo>
                  <a:pt x="2844" y="595"/>
                </a:lnTo>
                <a:lnTo>
                  <a:pt x="2855" y="597"/>
                </a:lnTo>
                <a:lnTo>
                  <a:pt x="2868" y="599"/>
                </a:lnTo>
                <a:lnTo>
                  <a:pt x="2880" y="600"/>
                </a:lnTo>
                <a:lnTo>
                  <a:pt x="2891" y="600"/>
                </a:lnTo>
                <a:lnTo>
                  <a:pt x="2904" y="600"/>
                </a:lnTo>
                <a:lnTo>
                  <a:pt x="2916" y="600"/>
                </a:lnTo>
                <a:lnTo>
                  <a:pt x="2929" y="602"/>
                </a:lnTo>
                <a:lnTo>
                  <a:pt x="2940" y="602"/>
                </a:lnTo>
                <a:lnTo>
                  <a:pt x="2951" y="602"/>
                </a:lnTo>
                <a:lnTo>
                  <a:pt x="2965" y="604"/>
                </a:lnTo>
                <a:lnTo>
                  <a:pt x="2976" y="604"/>
                </a:lnTo>
                <a:lnTo>
                  <a:pt x="2989" y="604"/>
                </a:lnTo>
                <a:lnTo>
                  <a:pt x="3000" y="605"/>
                </a:lnTo>
                <a:lnTo>
                  <a:pt x="3012" y="605"/>
                </a:lnTo>
                <a:lnTo>
                  <a:pt x="3025" y="607"/>
                </a:lnTo>
                <a:lnTo>
                  <a:pt x="3036" y="609"/>
                </a:lnTo>
                <a:lnTo>
                  <a:pt x="3049" y="609"/>
                </a:lnTo>
                <a:lnTo>
                  <a:pt x="3061" y="609"/>
                </a:lnTo>
                <a:lnTo>
                  <a:pt x="3074" y="609"/>
                </a:lnTo>
                <a:lnTo>
                  <a:pt x="3085" y="607"/>
                </a:lnTo>
                <a:lnTo>
                  <a:pt x="3097" y="605"/>
                </a:lnTo>
                <a:lnTo>
                  <a:pt x="3110" y="605"/>
                </a:lnTo>
                <a:lnTo>
                  <a:pt x="3121" y="605"/>
                </a:lnTo>
                <a:lnTo>
                  <a:pt x="3134" y="607"/>
                </a:lnTo>
                <a:lnTo>
                  <a:pt x="3146" y="607"/>
                </a:lnTo>
                <a:lnTo>
                  <a:pt x="3157" y="607"/>
                </a:lnTo>
                <a:lnTo>
                  <a:pt x="3170" y="607"/>
                </a:lnTo>
                <a:lnTo>
                  <a:pt x="3182" y="607"/>
                </a:lnTo>
                <a:lnTo>
                  <a:pt x="3195" y="607"/>
                </a:lnTo>
                <a:lnTo>
                  <a:pt x="3206" y="607"/>
                </a:lnTo>
                <a:lnTo>
                  <a:pt x="3219" y="607"/>
                </a:lnTo>
                <a:lnTo>
                  <a:pt x="3230" y="609"/>
                </a:lnTo>
                <a:lnTo>
                  <a:pt x="3242" y="609"/>
                </a:lnTo>
                <a:lnTo>
                  <a:pt x="3255" y="607"/>
                </a:lnTo>
                <a:lnTo>
                  <a:pt x="3266" y="609"/>
                </a:lnTo>
                <a:lnTo>
                  <a:pt x="3279" y="609"/>
                </a:lnTo>
                <a:lnTo>
                  <a:pt x="3291" y="607"/>
                </a:lnTo>
                <a:lnTo>
                  <a:pt x="3302" y="607"/>
                </a:lnTo>
                <a:lnTo>
                  <a:pt x="3315" y="607"/>
                </a:lnTo>
                <a:lnTo>
                  <a:pt x="3327" y="607"/>
                </a:lnTo>
                <a:lnTo>
                  <a:pt x="3340" y="609"/>
                </a:lnTo>
                <a:lnTo>
                  <a:pt x="3351" y="609"/>
                </a:lnTo>
                <a:lnTo>
                  <a:pt x="3364" y="609"/>
                </a:lnTo>
                <a:lnTo>
                  <a:pt x="3376" y="609"/>
                </a:lnTo>
                <a:lnTo>
                  <a:pt x="3387" y="609"/>
                </a:lnTo>
                <a:lnTo>
                  <a:pt x="3400" y="609"/>
                </a:lnTo>
                <a:lnTo>
                  <a:pt x="3412" y="609"/>
                </a:lnTo>
                <a:lnTo>
                  <a:pt x="3425" y="609"/>
                </a:lnTo>
                <a:lnTo>
                  <a:pt x="3436" y="609"/>
                </a:lnTo>
                <a:lnTo>
                  <a:pt x="3447" y="610"/>
                </a:lnTo>
                <a:lnTo>
                  <a:pt x="3461" y="610"/>
                </a:lnTo>
                <a:lnTo>
                  <a:pt x="3472" y="610"/>
                </a:lnTo>
                <a:lnTo>
                  <a:pt x="3485" y="609"/>
                </a:lnTo>
                <a:lnTo>
                  <a:pt x="3496" y="609"/>
                </a:lnTo>
                <a:lnTo>
                  <a:pt x="3508" y="609"/>
                </a:lnTo>
                <a:lnTo>
                  <a:pt x="3521" y="607"/>
                </a:lnTo>
                <a:lnTo>
                  <a:pt x="3532" y="609"/>
                </a:lnTo>
                <a:lnTo>
                  <a:pt x="3545" y="607"/>
                </a:lnTo>
                <a:lnTo>
                  <a:pt x="3557" y="607"/>
                </a:lnTo>
                <a:lnTo>
                  <a:pt x="3570" y="609"/>
                </a:lnTo>
                <a:lnTo>
                  <a:pt x="3581" y="609"/>
                </a:lnTo>
                <a:lnTo>
                  <a:pt x="3593" y="607"/>
                </a:lnTo>
                <a:lnTo>
                  <a:pt x="3606" y="607"/>
                </a:lnTo>
                <a:lnTo>
                  <a:pt x="3617" y="607"/>
                </a:lnTo>
                <a:lnTo>
                  <a:pt x="3630" y="609"/>
                </a:lnTo>
                <a:lnTo>
                  <a:pt x="3642" y="609"/>
                </a:lnTo>
                <a:lnTo>
                  <a:pt x="3653" y="609"/>
                </a:lnTo>
                <a:lnTo>
                  <a:pt x="3666" y="609"/>
                </a:lnTo>
                <a:lnTo>
                  <a:pt x="3678" y="610"/>
                </a:lnTo>
                <a:lnTo>
                  <a:pt x="3691" y="610"/>
                </a:lnTo>
                <a:lnTo>
                  <a:pt x="3702" y="610"/>
                </a:lnTo>
                <a:lnTo>
                  <a:pt x="3715" y="610"/>
                </a:lnTo>
                <a:lnTo>
                  <a:pt x="3727" y="610"/>
                </a:lnTo>
                <a:lnTo>
                  <a:pt x="3738" y="612"/>
                </a:lnTo>
                <a:lnTo>
                  <a:pt x="3751" y="610"/>
                </a:lnTo>
                <a:lnTo>
                  <a:pt x="3762" y="610"/>
                </a:lnTo>
                <a:lnTo>
                  <a:pt x="3775" y="612"/>
                </a:lnTo>
                <a:lnTo>
                  <a:pt x="3787" y="612"/>
                </a:lnTo>
                <a:lnTo>
                  <a:pt x="3798" y="612"/>
                </a:lnTo>
                <a:lnTo>
                  <a:pt x="3811" y="610"/>
                </a:lnTo>
                <a:lnTo>
                  <a:pt x="3823" y="612"/>
                </a:lnTo>
                <a:lnTo>
                  <a:pt x="3836" y="610"/>
                </a:lnTo>
                <a:lnTo>
                  <a:pt x="3847" y="610"/>
                </a:lnTo>
                <a:lnTo>
                  <a:pt x="3859" y="610"/>
                </a:lnTo>
                <a:lnTo>
                  <a:pt x="3872" y="610"/>
                </a:lnTo>
                <a:lnTo>
                  <a:pt x="3883" y="610"/>
                </a:lnTo>
                <a:lnTo>
                  <a:pt x="3896" y="609"/>
                </a:lnTo>
                <a:lnTo>
                  <a:pt x="3908" y="610"/>
                </a:lnTo>
                <a:lnTo>
                  <a:pt x="3921" y="610"/>
                </a:lnTo>
                <a:lnTo>
                  <a:pt x="3932" y="610"/>
                </a:lnTo>
                <a:lnTo>
                  <a:pt x="3944" y="610"/>
                </a:lnTo>
                <a:lnTo>
                  <a:pt x="3957" y="610"/>
                </a:lnTo>
                <a:lnTo>
                  <a:pt x="3968" y="609"/>
                </a:lnTo>
                <a:lnTo>
                  <a:pt x="3981" y="609"/>
                </a:lnTo>
                <a:lnTo>
                  <a:pt x="3992" y="609"/>
                </a:lnTo>
                <a:lnTo>
                  <a:pt x="4004" y="609"/>
                </a:lnTo>
                <a:lnTo>
                  <a:pt x="4017" y="607"/>
                </a:lnTo>
                <a:lnTo>
                  <a:pt x="4028" y="605"/>
                </a:lnTo>
                <a:lnTo>
                  <a:pt x="4041" y="605"/>
                </a:lnTo>
                <a:lnTo>
                  <a:pt x="4053" y="605"/>
                </a:lnTo>
                <a:lnTo>
                  <a:pt x="4066" y="607"/>
                </a:lnTo>
                <a:lnTo>
                  <a:pt x="4077" y="607"/>
                </a:lnTo>
                <a:lnTo>
                  <a:pt x="4089" y="609"/>
                </a:lnTo>
                <a:lnTo>
                  <a:pt x="4102" y="609"/>
                </a:lnTo>
                <a:lnTo>
                  <a:pt x="4113" y="609"/>
                </a:lnTo>
                <a:lnTo>
                  <a:pt x="4126" y="609"/>
                </a:lnTo>
                <a:lnTo>
                  <a:pt x="4138" y="609"/>
                </a:lnTo>
                <a:lnTo>
                  <a:pt x="4149" y="610"/>
                </a:lnTo>
                <a:lnTo>
                  <a:pt x="4162" y="610"/>
                </a:lnTo>
                <a:lnTo>
                  <a:pt x="4174" y="609"/>
                </a:lnTo>
              </a:path>
            </a:pathLst>
          </a:custGeom>
          <a:noFill/>
          <a:ln w="19050" cmpd="sng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" name="Freeform 101"/>
          <p:cNvSpPr>
            <a:spLocks/>
          </p:cNvSpPr>
          <p:nvPr/>
        </p:nvSpPr>
        <p:spPr bwMode="auto">
          <a:xfrm>
            <a:off x="1672431" y="3790000"/>
            <a:ext cx="6626225" cy="2193925"/>
          </a:xfrm>
          <a:custGeom>
            <a:avLst/>
            <a:gdLst>
              <a:gd name="T0" fmla="*/ 60 w 4174"/>
              <a:gd name="T1" fmla="*/ 953 h 1382"/>
              <a:gd name="T2" fmla="*/ 133 w 4174"/>
              <a:gd name="T3" fmla="*/ 953 h 1382"/>
              <a:gd name="T4" fmla="*/ 205 w 4174"/>
              <a:gd name="T5" fmla="*/ 941 h 1382"/>
              <a:gd name="T6" fmla="*/ 279 w 4174"/>
              <a:gd name="T7" fmla="*/ 1382 h 1382"/>
              <a:gd name="T8" fmla="*/ 350 w 4174"/>
              <a:gd name="T9" fmla="*/ 905 h 1382"/>
              <a:gd name="T10" fmla="*/ 424 w 4174"/>
              <a:gd name="T11" fmla="*/ 835 h 1382"/>
              <a:gd name="T12" fmla="*/ 496 w 4174"/>
              <a:gd name="T13" fmla="*/ 788 h 1382"/>
              <a:gd name="T14" fmla="*/ 569 w 4174"/>
              <a:gd name="T15" fmla="*/ 752 h 1382"/>
              <a:gd name="T16" fmla="*/ 641 w 4174"/>
              <a:gd name="T17" fmla="*/ 721 h 1382"/>
              <a:gd name="T18" fmla="*/ 714 w 4174"/>
              <a:gd name="T19" fmla="*/ 696 h 1382"/>
              <a:gd name="T20" fmla="*/ 786 w 4174"/>
              <a:gd name="T21" fmla="*/ 675 h 1382"/>
              <a:gd name="T22" fmla="*/ 860 w 4174"/>
              <a:gd name="T23" fmla="*/ 657 h 1382"/>
              <a:gd name="T24" fmla="*/ 931 w 4174"/>
              <a:gd name="T25" fmla="*/ 641 h 1382"/>
              <a:gd name="T26" fmla="*/ 1005 w 4174"/>
              <a:gd name="T27" fmla="*/ 625 h 1382"/>
              <a:gd name="T28" fmla="*/ 1077 w 4174"/>
              <a:gd name="T29" fmla="*/ 612 h 1382"/>
              <a:gd name="T30" fmla="*/ 1150 w 4174"/>
              <a:gd name="T31" fmla="*/ 595 h 1382"/>
              <a:gd name="T32" fmla="*/ 1222 w 4174"/>
              <a:gd name="T33" fmla="*/ 582 h 1382"/>
              <a:gd name="T34" fmla="*/ 1295 w 4174"/>
              <a:gd name="T35" fmla="*/ 569 h 1382"/>
              <a:gd name="T36" fmla="*/ 1367 w 4174"/>
              <a:gd name="T37" fmla="*/ 558 h 1382"/>
              <a:gd name="T38" fmla="*/ 1440 w 4174"/>
              <a:gd name="T39" fmla="*/ 545 h 1382"/>
              <a:gd name="T40" fmla="*/ 1512 w 4174"/>
              <a:gd name="T41" fmla="*/ 535 h 1382"/>
              <a:gd name="T42" fmla="*/ 1586 w 4174"/>
              <a:gd name="T43" fmla="*/ 524 h 1382"/>
              <a:gd name="T44" fmla="*/ 1657 w 4174"/>
              <a:gd name="T45" fmla="*/ 512 h 1382"/>
              <a:gd name="T46" fmla="*/ 1731 w 4174"/>
              <a:gd name="T47" fmla="*/ 501 h 1382"/>
              <a:gd name="T48" fmla="*/ 1803 w 4174"/>
              <a:gd name="T49" fmla="*/ 493 h 1382"/>
              <a:gd name="T50" fmla="*/ 1876 w 4174"/>
              <a:gd name="T51" fmla="*/ 481 h 1382"/>
              <a:gd name="T52" fmla="*/ 1948 w 4174"/>
              <a:gd name="T53" fmla="*/ 471 h 1382"/>
              <a:gd name="T54" fmla="*/ 2021 w 4174"/>
              <a:gd name="T55" fmla="*/ 465 h 1382"/>
              <a:gd name="T56" fmla="*/ 2093 w 4174"/>
              <a:gd name="T57" fmla="*/ 453 h 1382"/>
              <a:gd name="T58" fmla="*/ 2165 w 4174"/>
              <a:gd name="T59" fmla="*/ 444 h 1382"/>
              <a:gd name="T60" fmla="*/ 2238 w 4174"/>
              <a:gd name="T61" fmla="*/ 437 h 1382"/>
              <a:gd name="T62" fmla="*/ 2310 w 4174"/>
              <a:gd name="T63" fmla="*/ 427 h 1382"/>
              <a:gd name="T64" fmla="*/ 2384 w 4174"/>
              <a:gd name="T65" fmla="*/ 435 h 1382"/>
              <a:gd name="T66" fmla="*/ 2455 w 4174"/>
              <a:gd name="T67" fmla="*/ 442 h 1382"/>
              <a:gd name="T68" fmla="*/ 2529 w 4174"/>
              <a:gd name="T69" fmla="*/ 455 h 1382"/>
              <a:gd name="T70" fmla="*/ 2601 w 4174"/>
              <a:gd name="T71" fmla="*/ 465 h 1382"/>
              <a:gd name="T72" fmla="*/ 2674 w 4174"/>
              <a:gd name="T73" fmla="*/ 470 h 1382"/>
              <a:gd name="T74" fmla="*/ 2746 w 4174"/>
              <a:gd name="T75" fmla="*/ 476 h 1382"/>
              <a:gd name="T76" fmla="*/ 2819 w 4174"/>
              <a:gd name="T77" fmla="*/ 478 h 1382"/>
              <a:gd name="T78" fmla="*/ 2891 w 4174"/>
              <a:gd name="T79" fmla="*/ 479 h 1382"/>
              <a:gd name="T80" fmla="*/ 2965 w 4174"/>
              <a:gd name="T81" fmla="*/ 478 h 1382"/>
              <a:gd name="T82" fmla="*/ 3036 w 4174"/>
              <a:gd name="T83" fmla="*/ 478 h 1382"/>
              <a:gd name="T84" fmla="*/ 3110 w 4174"/>
              <a:gd name="T85" fmla="*/ 475 h 1382"/>
              <a:gd name="T86" fmla="*/ 3182 w 4174"/>
              <a:gd name="T87" fmla="*/ 475 h 1382"/>
              <a:gd name="T88" fmla="*/ 3255 w 4174"/>
              <a:gd name="T89" fmla="*/ 475 h 1382"/>
              <a:gd name="T90" fmla="*/ 3327 w 4174"/>
              <a:gd name="T91" fmla="*/ 471 h 1382"/>
              <a:gd name="T92" fmla="*/ 3400 w 4174"/>
              <a:gd name="T93" fmla="*/ 468 h 1382"/>
              <a:gd name="T94" fmla="*/ 3472 w 4174"/>
              <a:gd name="T95" fmla="*/ 466 h 1382"/>
              <a:gd name="T96" fmla="*/ 3545 w 4174"/>
              <a:gd name="T97" fmla="*/ 463 h 1382"/>
              <a:gd name="T98" fmla="*/ 3617 w 4174"/>
              <a:gd name="T99" fmla="*/ 463 h 1382"/>
              <a:gd name="T100" fmla="*/ 3691 w 4174"/>
              <a:gd name="T101" fmla="*/ 457 h 1382"/>
              <a:gd name="T102" fmla="*/ 3762 w 4174"/>
              <a:gd name="T103" fmla="*/ 455 h 1382"/>
              <a:gd name="T104" fmla="*/ 3836 w 4174"/>
              <a:gd name="T105" fmla="*/ 453 h 1382"/>
              <a:gd name="T106" fmla="*/ 3908 w 4174"/>
              <a:gd name="T107" fmla="*/ 452 h 1382"/>
              <a:gd name="T108" fmla="*/ 3981 w 4174"/>
              <a:gd name="T109" fmla="*/ 447 h 1382"/>
              <a:gd name="T110" fmla="*/ 4053 w 4174"/>
              <a:gd name="T111" fmla="*/ 444 h 1382"/>
              <a:gd name="T112" fmla="*/ 4126 w 4174"/>
              <a:gd name="T113" fmla="*/ 445 h 13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382">
                <a:moveTo>
                  <a:pt x="0" y="954"/>
                </a:moveTo>
                <a:lnTo>
                  <a:pt x="13" y="954"/>
                </a:lnTo>
                <a:lnTo>
                  <a:pt x="24" y="954"/>
                </a:lnTo>
                <a:lnTo>
                  <a:pt x="37" y="953"/>
                </a:lnTo>
                <a:lnTo>
                  <a:pt x="49" y="953"/>
                </a:lnTo>
                <a:lnTo>
                  <a:pt x="60" y="953"/>
                </a:lnTo>
                <a:lnTo>
                  <a:pt x="73" y="953"/>
                </a:lnTo>
                <a:lnTo>
                  <a:pt x="85" y="953"/>
                </a:lnTo>
                <a:lnTo>
                  <a:pt x="98" y="953"/>
                </a:lnTo>
                <a:lnTo>
                  <a:pt x="109" y="954"/>
                </a:lnTo>
                <a:lnTo>
                  <a:pt x="120" y="953"/>
                </a:lnTo>
                <a:lnTo>
                  <a:pt x="133" y="953"/>
                </a:lnTo>
                <a:lnTo>
                  <a:pt x="145" y="951"/>
                </a:lnTo>
                <a:lnTo>
                  <a:pt x="158" y="949"/>
                </a:lnTo>
                <a:lnTo>
                  <a:pt x="169" y="948"/>
                </a:lnTo>
                <a:lnTo>
                  <a:pt x="182" y="939"/>
                </a:lnTo>
                <a:lnTo>
                  <a:pt x="194" y="939"/>
                </a:lnTo>
                <a:lnTo>
                  <a:pt x="205" y="941"/>
                </a:lnTo>
                <a:lnTo>
                  <a:pt x="218" y="951"/>
                </a:lnTo>
                <a:lnTo>
                  <a:pt x="230" y="957"/>
                </a:lnTo>
                <a:lnTo>
                  <a:pt x="243" y="386"/>
                </a:lnTo>
                <a:lnTo>
                  <a:pt x="254" y="0"/>
                </a:lnTo>
                <a:lnTo>
                  <a:pt x="266" y="980"/>
                </a:lnTo>
                <a:lnTo>
                  <a:pt x="279" y="1382"/>
                </a:lnTo>
                <a:lnTo>
                  <a:pt x="290" y="1231"/>
                </a:lnTo>
                <a:lnTo>
                  <a:pt x="303" y="1075"/>
                </a:lnTo>
                <a:lnTo>
                  <a:pt x="315" y="990"/>
                </a:lnTo>
                <a:lnTo>
                  <a:pt x="328" y="948"/>
                </a:lnTo>
                <a:lnTo>
                  <a:pt x="339" y="923"/>
                </a:lnTo>
                <a:lnTo>
                  <a:pt x="350" y="905"/>
                </a:lnTo>
                <a:lnTo>
                  <a:pt x="364" y="889"/>
                </a:lnTo>
                <a:lnTo>
                  <a:pt x="375" y="877"/>
                </a:lnTo>
                <a:lnTo>
                  <a:pt x="388" y="866"/>
                </a:lnTo>
                <a:lnTo>
                  <a:pt x="399" y="856"/>
                </a:lnTo>
                <a:lnTo>
                  <a:pt x="411" y="848"/>
                </a:lnTo>
                <a:lnTo>
                  <a:pt x="424" y="835"/>
                </a:lnTo>
                <a:lnTo>
                  <a:pt x="435" y="825"/>
                </a:lnTo>
                <a:lnTo>
                  <a:pt x="448" y="817"/>
                </a:lnTo>
                <a:lnTo>
                  <a:pt x="460" y="809"/>
                </a:lnTo>
                <a:lnTo>
                  <a:pt x="471" y="801"/>
                </a:lnTo>
                <a:lnTo>
                  <a:pt x="484" y="793"/>
                </a:lnTo>
                <a:lnTo>
                  <a:pt x="496" y="788"/>
                </a:lnTo>
                <a:lnTo>
                  <a:pt x="509" y="780"/>
                </a:lnTo>
                <a:lnTo>
                  <a:pt x="520" y="773"/>
                </a:lnTo>
                <a:lnTo>
                  <a:pt x="533" y="768"/>
                </a:lnTo>
                <a:lnTo>
                  <a:pt x="545" y="762"/>
                </a:lnTo>
                <a:lnTo>
                  <a:pt x="556" y="757"/>
                </a:lnTo>
                <a:lnTo>
                  <a:pt x="569" y="752"/>
                </a:lnTo>
                <a:lnTo>
                  <a:pt x="581" y="744"/>
                </a:lnTo>
                <a:lnTo>
                  <a:pt x="594" y="740"/>
                </a:lnTo>
                <a:lnTo>
                  <a:pt x="605" y="736"/>
                </a:lnTo>
                <a:lnTo>
                  <a:pt x="616" y="731"/>
                </a:lnTo>
                <a:lnTo>
                  <a:pt x="629" y="726"/>
                </a:lnTo>
                <a:lnTo>
                  <a:pt x="641" y="721"/>
                </a:lnTo>
                <a:lnTo>
                  <a:pt x="654" y="716"/>
                </a:lnTo>
                <a:lnTo>
                  <a:pt x="665" y="713"/>
                </a:lnTo>
                <a:lnTo>
                  <a:pt x="678" y="708"/>
                </a:lnTo>
                <a:lnTo>
                  <a:pt x="690" y="703"/>
                </a:lnTo>
                <a:lnTo>
                  <a:pt x="701" y="701"/>
                </a:lnTo>
                <a:lnTo>
                  <a:pt x="714" y="696"/>
                </a:lnTo>
                <a:lnTo>
                  <a:pt x="726" y="693"/>
                </a:lnTo>
                <a:lnTo>
                  <a:pt x="739" y="688"/>
                </a:lnTo>
                <a:lnTo>
                  <a:pt x="750" y="683"/>
                </a:lnTo>
                <a:lnTo>
                  <a:pt x="762" y="682"/>
                </a:lnTo>
                <a:lnTo>
                  <a:pt x="775" y="677"/>
                </a:lnTo>
                <a:lnTo>
                  <a:pt x="786" y="675"/>
                </a:lnTo>
                <a:lnTo>
                  <a:pt x="799" y="670"/>
                </a:lnTo>
                <a:lnTo>
                  <a:pt x="811" y="669"/>
                </a:lnTo>
                <a:lnTo>
                  <a:pt x="824" y="664"/>
                </a:lnTo>
                <a:lnTo>
                  <a:pt x="835" y="661"/>
                </a:lnTo>
                <a:lnTo>
                  <a:pt x="847" y="659"/>
                </a:lnTo>
                <a:lnTo>
                  <a:pt x="860" y="657"/>
                </a:lnTo>
                <a:lnTo>
                  <a:pt x="871" y="652"/>
                </a:lnTo>
                <a:lnTo>
                  <a:pt x="884" y="649"/>
                </a:lnTo>
                <a:lnTo>
                  <a:pt x="895" y="649"/>
                </a:lnTo>
                <a:lnTo>
                  <a:pt x="907" y="646"/>
                </a:lnTo>
                <a:lnTo>
                  <a:pt x="920" y="643"/>
                </a:lnTo>
                <a:lnTo>
                  <a:pt x="931" y="641"/>
                </a:lnTo>
                <a:lnTo>
                  <a:pt x="944" y="638"/>
                </a:lnTo>
                <a:lnTo>
                  <a:pt x="956" y="634"/>
                </a:lnTo>
                <a:lnTo>
                  <a:pt x="967" y="631"/>
                </a:lnTo>
                <a:lnTo>
                  <a:pt x="980" y="630"/>
                </a:lnTo>
                <a:lnTo>
                  <a:pt x="992" y="626"/>
                </a:lnTo>
                <a:lnTo>
                  <a:pt x="1005" y="625"/>
                </a:lnTo>
                <a:lnTo>
                  <a:pt x="1016" y="623"/>
                </a:lnTo>
                <a:lnTo>
                  <a:pt x="1029" y="621"/>
                </a:lnTo>
                <a:lnTo>
                  <a:pt x="1041" y="620"/>
                </a:lnTo>
                <a:lnTo>
                  <a:pt x="1052" y="616"/>
                </a:lnTo>
                <a:lnTo>
                  <a:pt x="1065" y="615"/>
                </a:lnTo>
                <a:lnTo>
                  <a:pt x="1077" y="612"/>
                </a:lnTo>
                <a:lnTo>
                  <a:pt x="1090" y="610"/>
                </a:lnTo>
                <a:lnTo>
                  <a:pt x="1101" y="608"/>
                </a:lnTo>
                <a:lnTo>
                  <a:pt x="1112" y="603"/>
                </a:lnTo>
                <a:lnTo>
                  <a:pt x="1126" y="600"/>
                </a:lnTo>
                <a:lnTo>
                  <a:pt x="1137" y="599"/>
                </a:lnTo>
                <a:lnTo>
                  <a:pt x="1150" y="595"/>
                </a:lnTo>
                <a:lnTo>
                  <a:pt x="1161" y="594"/>
                </a:lnTo>
                <a:lnTo>
                  <a:pt x="1174" y="592"/>
                </a:lnTo>
                <a:lnTo>
                  <a:pt x="1186" y="587"/>
                </a:lnTo>
                <a:lnTo>
                  <a:pt x="1197" y="587"/>
                </a:lnTo>
                <a:lnTo>
                  <a:pt x="1210" y="584"/>
                </a:lnTo>
                <a:lnTo>
                  <a:pt x="1222" y="582"/>
                </a:lnTo>
                <a:lnTo>
                  <a:pt x="1235" y="579"/>
                </a:lnTo>
                <a:lnTo>
                  <a:pt x="1246" y="577"/>
                </a:lnTo>
                <a:lnTo>
                  <a:pt x="1258" y="576"/>
                </a:lnTo>
                <a:lnTo>
                  <a:pt x="1271" y="574"/>
                </a:lnTo>
                <a:lnTo>
                  <a:pt x="1282" y="571"/>
                </a:lnTo>
                <a:lnTo>
                  <a:pt x="1295" y="569"/>
                </a:lnTo>
                <a:lnTo>
                  <a:pt x="1307" y="569"/>
                </a:lnTo>
                <a:lnTo>
                  <a:pt x="1318" y="566"/>
                </a:lnTo>
                <a:lnTo>
                  <a:pt x="1331" y="563"/>
                </a:lnTo>
                <a:lnTo>
                  <a:pt x="1343" y="559"/>
                </a:lnTo>
                <a:lnTo>
                  <a:pt x="1356" y="558"/>
                </a:lnTo>
                <a:lnTo>
                  <a:pt x="1367" y="558"/>
                </a:lnTo>
                <a:lnTo>
                  <a:pt x="1380" y="554"/>
                </a:lnTo>
                <a:lnTo>
                  <a:pt x="1392" y="551"/>
                </a:lnTo>
                <a:lnTo>
                  <a:pt x="1403" y="551"/>
                </a:lnTo>
                <a:lnTo>
                  <a:pt x="1416" y="548"/>
                </a:lnTo>
                <a:lnTo>
                  <a:pt x="1427" y="546"/>
                </a:lnTo>
                <a:lnTo>
                  <a:pt x="1440" y="545"/>
                </a:lnTo>
                <a:lnTo>
                  <a:pt x="1452" y="543"/>
                </a:lnTo>
                <a:lnTo>
                  <a:pt x="1463" y="541"/>
                </a:lnTo>
                <a:lnTo>
                  <a:pt x="1476" y="540"/>
                </a:lnTo>
                <a:lnTo>
                  <a:pt x="1488" y="538"/>
                </a:lnTo>
                <a:lnTo>
                  <a:pt x="1501" y="537"/>
                </a:lnTo>
                <a:lnTo>
                  <a:pt x="1512" y="535"/>
                </a:lnTo>
                <a:lnTo>
                  <a:pt x="1525" y="532"/>
                </a:lnTo>
                <a:lnTo>
                  <a:pt x="1537" y="528"/>
                </a:lnTo>
                <a:lnTo>
                  <a:pt x="1548" y="528"/>
                </a:lnTo>
                <a:lnTo>
                  <a:pt x="1561" y="527"/>
                </a:lnTo>
                <a:lnTo>
                  <a:pt x="1573" y="527"/>
                </a:lnTo>
                <a:lnTo>
                  <a:pt x="1586" y="524"/>
                </a:lnTo>
                <a:lnTo>
                  <a:pt x="1597" y="519"/>
                </a:lnTo>
                <a:lnTo>
                  <a:pt x="1609" y="517"/>
                </a:lnTo>
                <a:lnTo>
                  <a:pt x="1622" y="517"/>
                </a:lnTo>
                <a:lnTo>
                  <a:pt x="1633" y="512"/>
                </a:lnTo>
                <a:lnTo>
                  <a:pt x="1646" y="512"/>
                </a:lnTo>
                <a:lnTo>
                  <a:pt x="1657" y="512"/>
                </a:lnTo>
                <a:lnTo>
                  <a:pt x="1671" y="509"/>
                </a:lnTo>
                <a:lnTo>
                  <a:pt x="1682" y="507"/>
                </a:lnTo>
                <a:lnTo>
                  <a:pt x="1693" y="507"/>
                </a:lnTo>
                <a:lnTo>
                  <a:pt x="1706" y="506"/>
                </a:lnTo>
                <a:lnTo>
                  <a:pt x="1718" y="502"/>
                </a:lnTo>
                <a:lnTo>
                  <a:pt x="1731" y="501"/>
                </a:lnTo>
                <a:lnTo>
                  <a:pt x="1742" y="499"/>
                </a:lnTo>
                <a:lnTo>
                  <a:pt x="1754" y="499"/>
                </a:lnTo>
                <a:lnTo>
                  <a:pt x="1767" y="497"/>
                </a:lnTo>
                <a:lnTo>
                  <a:pt x="1778" y="496"/>
                </a:lnTo>
                <a:lnTo>
                  <a:pt x="1791" y="494"/>
                </a:lnTo>
                <a:lnTo>
                  <a:pt x="1803" y="493"/>
                </a:lnTo>
                <a:lnTo>
                  <a:pt x="1814" y="491"/>
                </a:lnTo>
                <a:lnTo>
                  <a:pt x="1827" y="489"/>
                </a:lnTo>
                <a:lnTo>
                  <a:pt x="1839" y="489"/>
                </a:lnTo>
                <a:lnTo>
                  <a:pt x="1852" y="486"/>
                </a:lnTo>
                <a:lnTo>
                  <a:pt x="1863" y="483"/>
                </a:lnTo>
                <a:lnTo>
                  <a:pt x="1876" y="481"/>
                </a:lnTo>
                <a:lnTo>
                  <a:pt x="1888" y="483"/>
                </a:lnTo>
                <a:lnTo>
                  <a:pt x="1899" y="479"/>
                </a:lnTo>
                <a:lnTo>
                  <a:pt x="1912" y="478"/>
                </a:lnTo>
                <a:lnTo>
                  <a:pt x="1923" y="476"/>
                </a:lnTo>
                <a:lnTo>
                  <a:pt x="1937" y="475"/>
                </a:lnTo>
                <a:lnTo>
                  <a:pt x="1948" y="471"/>
                </a:lnTo>
                <a:lnTo>
                  <a:pt x="1959" y="471"/>
                </a:lnTo>
                <a:lnTo>
                  <a:pt x="1972" y="471"/>
                </a:lnTo>
                <a:lnTo>
                  <a:pt x="1984" y="468"/>
                </a:lnTo>
                <a:lnTo>
                  <a:pt x="1997" y="468"/>
                </a:lnTo>
                <a:lnTo>
                  <a:pt x="2008" y="466"/>
                </a:lnTo>
                <a:lnTo>
                  <a:pt x="2021" y="465"/>
                </a:lnTo>
                <a:lnTo>
                  <a:pt x="2033" y="462"/>
                </a:lnTo>
                <a:lnTo>
                  <a:pt x="2044" y="458"/>
                </a:lnTo>
                <a:lnTo>
                  <a:pt x="2057" y="458"/>
                </a:lnTo>
                <a:lnTo>
                  <a:pt x="2069" y="457"/>
                </a:lnTo>
                <a:lnTo>
                  <a:pt x="2082" y="455"/>
                </a:lnTo>
                <a:lnTo>
                  <a:pt x="2093" y="453"/>
                </a:lnTo>
                <a:lnTo>
                  <a:pt x="2105" y="452"/>
                </a:lnTo>
                <a:lnTo>
                  <a:pt x="2118" y="450"/>
                </a:lnTo>
                <a:lnTo>
                  <a:pt x="2129" y="448"/>
                </a:lnTo>
                <a:lnTo>
                  <a:pt x="2142" y="447"/>
                </a:lnTo>
                <a:lnTo>
                  <a:pt x="2154" y="445"/>
                </a:lnTo>
                <a:lnTo>
                  <a:pt x="2165" y="444"/>
                </a:lnTo>
                <a:lnTo>
                  <a:pt x="2178" y="442"/>
                </a:lnTo>
                <a:lnTo>
                  <a:pt x="2189" y="442"/>
                </a:lnTo>
                <a:lnTo>
                  <a:pt x="2202" y="442"/>
                </a:lnTo>
                <a:lnTo>
                  <a:pt x="2214" y="440"/>
                </a:lnTo>
                <a:lnTo>
                  <a:pt x="2227" y="440"/>
                </a:lnTo>
                <a:lnTo>
                  <a:pt x="2238" y="437"/>
                </a:lnTo>
                <a:lnTo>
                  <a:pt x="2250" y="437"/>
                </a:lnTo>
                <a:lnTo>
                  <a:pt x="2263" y="434"/>
                </a:lnTo>
                <a:lnTo>
                  <a:pt x="2274" y="434"/>
                </a:lnTo>
                <a:lnTo>
                  <a:pt x="2287" y="432"/>
                </a:lnTo>
                <a:lnTo>
                  <a:pt x="2299" y="431"/>
                </a:lnTo>
                <a:lnTo>
                  <a:pt x="2310" y="427"/>
                </a:lnTo>
                <a:lnTo>
                  <a:pt x="2323" y="427"/>
                </a:lnTo>
                <a:lnTo>
                  <a:pt x="2335" y="426"/>
                </a:lnTo>
                <a:lnTo>
                  <a:pt x="2348" y="426"/>
                </a:lnTo>
                <a:lnTo>
                  <a:pt x="2359" y="435"/>
                </a:lnTo>
                <a:lnTo>
                  <a:pt x="2372" y="439"/>
                </a:lnTo>
                <a:lnTo>
                  <a:pt x="2384" y="435"/>
                </a:lnTo>
                <a:lnTo>
                  <a:pt x="2395" y="507"/>
                </a:lnTo>
                <a:lnTo>
                  <a:pt x="2408" y="520"/>
                </a:lnTo>
                <a:lnTo>
                  <a:pt x="2420" y="471"/>
                </a:lnTo>
                <a:lnTo>
                  <a:pt x="2433" y="444"/>
                </a:lnTo>
                <a:lnTo>
                  <a:pt x="2444" y="444"/>
                </a:lnTo>
                <a:lnTo>
                  <a:pt x="2455" y="442"/>
                </a:lnTo>
                <a:lnTo>
                  <a:pt x="2468" y="444"/>
                </a:lnTo>
                <a:lnTo>
                  <a:pt x="2480" y="447"/>
                </a:lnTo>
                <a:lnTo>
                  <a:pt x="2493" y="448"/>
                </a:lnTo>
                <a:lnTo>
                  <a:pt x="2504" y="452"/>
                </a:lnTo>
                <a:lnTo>
                  <a:pt x="2517" y="453"/>
                </a:lnTo>
                <a:lnTo>
                  <a:pt x="2529" y="455"/>
                </a:lnTo>
                <a:lnTo>
                  <a:pt x="2540" y="457"/>
                </a:lnTo>
                <a:lnTo>
                  <a:pt x="2553" y="460"/>
                </a:lnTo>
                <a:lnTo>
                  <a:pt x="2565" y="462"/>
                </a:lnTo>
                <a:lnTo>
                  <a:pt x="2578" y="462"/>
                </a:lnTo>
                <a:lnTo>
                  <a:pt x="2589" y="465"/>
                </a:lnTo>
                <a:lnTo>
                  <a:pt x="2601" y="465"/>
                </a:lnTo>
                <a:lnTo>
                  <a:pt x="2614" y="466"/>
                </a:lnTo>
                <a:lnTo>
                  <a:pt x="2625" y="470"/>
                </a:lnTo>
                <a:lnTo>
                  <a:pt x="2638" y="468"/>
                </a:lnTo>
                <a:lnTo>
                  <a:pt x="2650" y="470"/>
                </a:lnTo>
                <a:lnTo>
                  <a:pt x="2661" y="471"/>
                </a:lnTo>
                <a:lnTo>
                  <a:pt x="2674" y="470"/>
                </a:lnTo>
                <a:lnTo>
                  <a:pt x="2685" y="471"/>
                </a:lnTo>
                <a:lnTo>
                  <a:pt x="2699" y="471"/>
                </a:lnTo>
                <a:lnTo>
                  <a:pt x="2710" y="473"/>
                </a:lnTo>
                <a:lnTo>
                  <a:pt x="2723" y="471"/>
                </a:lnTo>
                <a:lnTo>
                  <a:pt x="2734" y="475"/>
                </a:lnTo>
                <a:lnTo>
                  <a:pt x="2746" y="476"/>
                </a:lnTo>
                <a:lnTo>
                  <a:pt x="2759" y="475"/>
                </a:lnTo>
                <a:lnTo>
                  <a:pt x="2770" y="475"/>
                </a:lnTo>
                <a:lnTo>
                  <a:pt x="2783" y="475"/>
                </a:lnTo>
                <a:lnTo>
                  <a:pt x="2795" y="476"/>
                </a:lnTo>
                <a:lnTo>
                  <a:pt x="2806" y="476"/>
                </a:lnTo>
                <a:lnTo>
                  <a:pt x="2819" y="478"/>
                </a:lnTo>
                <a:lnTo>
                  <a:pt x="2831" y="476"/>
                </a:lnTo>
                <a:lnTo>
                  <a:pt x="2844" y="476"/>
                </a:lnTo>
                <a:lnTo>
                  <a:pt x="2855" y="476"/>
                </a:lnTo>
                <a:lnTo>
                  <a:pt x="2868" y="476"/>
                </a:lnTo>
                <a:lnTo>
                  <a:pt x="2880" y="476"/>
                </a:lnTo>
                <a:lnTo>
                  <a:pt x="2891" y="479"/>
                </a:lnTo>
                <a:lnTo>
                  <a:pt x="2904" y="478"/>
                </a:lnTo>
                <a:lnTo>
                  <a:pt x="2916" y="478"/>
                </a:lnTo>
                <a:lnTo>
                  <a:pt x="2929" y="478"/>
                </a:lnTo>
                <a:lnTo>
                  <a:pt x="2940" y="478"/>
                </a:lnTo>
                <a:lnTo>
                  <a:pt x="2951" y="478"/>
                </a:lnTo>
                <a:lnTo>
                  <a:pt x="2965" y="478"/>
                </a:lnTo>
                <a:lnTo>
                  <a:pt x="2976" y="476"/>
                </a:lnTo>
                <a:lnTo>
                  <a:pt x="2989" y="476"/>
                </a:lnTo>
                <a:lnTo>
                  <a:pt x="3000" y="476"/>
                </a:lnTo>
                <a:lnTo>
                  <a:pt x="3012" y="476"/>
                </a:lnTo>
                <a:lnTo>
                  <a:pt x="3025" y="476"/>
                </a:lnTo>
                <a:lnTo>
                  <a:pt x="3036" y="478"/>
                </a:lnTo>
                <a:lnTo>
                  <a:pt x="3049" y="476"/>
                </a:lnTo>
                <a:lnTo>
                  <a:pt x="3061" y="476"/>
                </a:lnTo>
                <a:lnTo>
                  <a:pt x="3074" y="476"/>
                </a:lnTo>
                <a:lnTo>
                  <a:pt x="3085" y="476"/>
                </a:lnTo>
                <a:lnTo>
                  <a:pt x="3097" y="475"/>
                </a:lnTo>
                <a:lnTo>
                  <a:pt x="3110" y="475"/>
                </a:lnTo>
                <a:lnTo>
                  <a:pt x="3121" y="475"/>
                </a:lnTo>
                <a:lnTo>
                  <a:pt x="3134" y="475"/>
                </a:lnTo>
                <a:lnTo>
                  <a:pt x="3146" y="475"/>
                </a:lnTo>
                <a:lnTo>
                  <a:pt x="3157" y="473"/>
                </a:lnTo>
                <a:lnTo>
                  <a:pt x="3170" y="475"/>
                </a:lnTo>
                <a:lnTo>
                  <a:pt x="3182" y="475"/>
                </a:lnTo>
                <a:lnTo>
                  <a:pt x="3195" y="473"/>
                </a:lnTo>
                <a:lnTo>
                  <a:pt x="3206" y="473"/>
                </a:lnTo>
                <a:lnTo>
                  <a:pt x="3219" y="473"/>
                </a:lnTo>
                <a:lnTo>
                  <a:pt x="3230" y="473"/>
                </a:lnTo>
                <a:lnTo>
                  <a:pt x="3242" y="473"/>
                </a:lnTo>
                <a:lnTo>
                  <a:pt x="3255" y="475"/>
                </a:lnTo>
                <a:lnTo>
                  <a:pt x="3266" y="473"/>
                </a:lnTo>
                <a:lnTo>
                  <a:pt x="3279" y="471"/>
                </a:lnTo>
                <a:lnTo>
                  <a:pt x="3291" y="471"/>
                </a:lnTo>
                <a:lnTo>
                  <a:pt x="3302" y="471"/>
                </a:lnTo>
                <a:lnTo>
                  <a:pt x="3315" y="471"/>
                </a:lnTo>
                <a:lnTo>
                  <a:pt x="3327" y="471"/>
                </a:lnTo>
                <a:lnTo>
                  <a:pt x="3340" y="470"/>
                </a:lnTo>
                <a:lnTo>
                  <a:pt x="3351" y="470"/>
                </a:lnTo>
                <a:lnTo>
                  <a:pt x="3364" y="470"/>
                </a:lnTo>
                <a:lnTo>
                  <a:pt x="3376" y="470"/>
                </a:lnTo>
                <a:lnTo>
                  <a:pt x="3387" y="468"/>
                </a:lnTo>
                <a:lnTo>
                  <a:pt x="3400" y="468"/>
                </a:lnTo>
                <a:lnTo>
                  <a:pt x="3412" y="468"/>
                </a:lnTo>
                <a:lnTo>
                  <a:pt x="3425" y="468"/>
                </a:lnTo>
                <a:lnTo>
                  <a:pt x="3436" y="466"/>
                </a:lnTo>
                <a:lnTo>
                  <a:pt x="3447" y="468"/>
                </a:lnTo>
                <a:lnTo>
                  <a:pt x="3461" y="466"/>
                </a:lnTo>
                <a:lnTo>
                  <a:pt x="3472" y="466"/>
                </a:lnTo>
                <a:lnTo>
                  <a:pt x="3485" y="468"/>
                </a:lnTo>
                <a:lnTo>
                  <a:pt x="3496" y="465"/>
                </a:lnTo>
                <a:lnTo>
                  <a:pt x="3508" y="465"/>
                </a:lnTo>
                <a:lnTo>
                  <a:pt x="3521" y="463"/>
                </a:lnTo>
                <a:lnTo>
                  <a:pt x="3532" y="460"/>
                </a:lnTo>
                <a:lnTo>
                  <a:pt x="3545" y="463"/>
                </a:lnTo>
                <a:lnTo>
                  <a:pt x="3557" y="465"/>
                </a:lnTo>
                <a:lnTo>
                  <a:pt x="3570" y="465"/>
                </a:lnTo>
                <a:lnTo>
                  <a:pt x="3581" y="465"/>
                </a:lnTo>
                <a:lnTo>
                  <a:pt x="3593" y="463"/>
                </a:lnTo>
                <a:lnTo>
                  <a:pt x="3606" y="462"/>
                </a:lnTo>
                <a:lnTo>
                  <a:pt x="3617" y="463"/>
                </a:lnTo>
                <a:lnTo>
                  <a:pt x="3630" y="462"/>
                </a:lnTo>
                <a:lnTo>
                  <a:pt x="3642" y="462"/>
                </a:lnTo>
                <a:lnTo>
                  <a:pt x="3653" y="460"/>
                </a:lnTo>
                <a:lnTo>
                  <a:pt x="3666" y="460"/>
                </a:lnTo>
                <a:lnTo>
                  <a:pt x="3678" y="458"/>
                </a:lnTo>
                <a:lnTo>
                  <a:pt x="3691" y="457"/>
                </a:lnTo>
                <a:lnTo>
                  <a:pt x="3702" y="458"/>
                </a:lnTo>
                <a:lnTo>
                  <a:pt x="3715" y="458"/>
                </a:lnTo>
                <a:lnTo>
                  <a:pt x="3727" y="457"/>
                </a:lnTo>
                <a:lnTo>
                  <a:pt x="3738" y="457"/>
                </a:lnTo>
                <a:lnTo>
                  <a:pt x="3751" y="455"/>
                </a:lnTo>
                <a:lnTo>
                  <a:pt x="3762" y="455"/>
                </a:lnTo>
                <a:lnTo>
                  <a:pt x="3775" y="455"/>
                </a:lnTo>
                <a:lnTo>
                  <a:pt x="3787" y="455"/>
                </a:lnTo>
                <a:lnTo>
                  <a:pt x="3798" y="455"/>
                </a:lnTo>
                <a:lnTo>
                  <a:pt x="3811" y="455"/>
                </a:lnTo>
                <a:lnTo>
                  <a:pt x="3823" y="453"/>
                </a:lnTo>
                <a:lnTo>
                  <a:pt x="3836" y="453"/>
                </a:lnTo>
                <a:lnTo>
                  <a:pt x="3847" y="452"/>
                </a:lnTo>
                <a:lnTo>
                  <a:pt x="3859" y="452"/>
                </a:lnTo>
                <a:lnTo>
                  <a:pt x="3872" y="453"/>
                </a:lnTo>
                <a:lnTo>
                  <a:pt x="3883" y="452"/>
                </a:lnTo>
                <a:lnTo>
                  <a:pt x="3896" y="452"/>
                </a:lnTo>
                <a:lnTo>
                  <a:pt x="3908" y="452"/>
                </a:lnTo>
                <a:lnTo>
                  <a:pt x="3921" y="450"/>
                </a:lnTo>
                <a:lnTo>
                  <a:pt x="3932" y="452"/>
                </a:lnTo>
                <a:lnTo>
                  <a:pt x="3944" y="450"/>
                </a:lnTo>
                <a:lnTo>
                  <a:pt x="3957" y="450"/>
                </a:lnTo>
                <a:lnTo>
                  <a:pt x="3968" y="448"/>
                </a:lnTo>
                <a:lnTo>
                  <a:pt x="3981" y="447"/>
                </a:lnTo>
                <a:lnTo>
                  <a:pt x="3992" y="445"/>
                </a:lnTo>
                <a:lnTo>
                  <a:pt x="4004" y="445"/>
                </a:lnTo>
                <a:lnTo>
                  <a:pt x="4017" y="447"/>
                </a:lnTo>
                <a:lnTo>
                  <a:pt x="4028" y="445"/>
                </a:lnTo>
                <a:lnTo>
                  <a:pt x="4041" y="445"/>
                </a:lnTo>
                <a:lnTo>
                  <a:pt x="4053" y="444"/>
                </a:lnTo>
                <a:lnTo>
                  <a:pt x="4066" y="444"/>
                </a:lnTo>
                <a:lnTo>
                  <a:pt x="4077" y="445"/>
                </a:lnTo>
                <a:lnTo>
                  <a:pt x="4089" y="447"/>
                </a:lnTo>
                <a:lnTo>
                  <a:pt x="4102" y="445"/>
                </a:lnTo>
                <a:lnTo>
                  <a:pt x="4113" y="445"/>
                </a:lnTo>
                <a:lnTo>
                  <a:pt x="4126" y="445"/>
                </a:lnTo>
                <a:lnTo>
                  <a:pt x="4138" y="445"/>
                </a:lnTo>
                <a:lnTo>
                  <a:pt x="4149" y="444"/>
                </a:lnTo>
                <a:lnTo>
                  <a:pt x="4162" y="444"/>
                </a:lnTo>
                <a:lnTo>
                  <a:pt x="4174" y="444"/>
                </a:lnTo>
              </a:path>
            </a:pathLst>
          </a:custGeom>
          <a:noFill/>
          <a:ln w="19050" cmpd="sng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7" name="Freeform 102"/>
          <p:cNvSpPr>
            <a:spLocks/>
          </p:cNvSpPr>
          <p:nvPr/>
        </p:nvSpPr>
        <p:spPr bwMode="auto">
          <a:xfrm>
            <a:off x="1672431" y="4066225"/>
            <a:ext cx="6626225" cy="1973263"/>
          </a:xfrm>
          <a:custGeom>
            <a:avLst/>
            <a:gdLst>
              <a:gd name="T0" fmla="*/ 60 w 4174"/>
              <a:gd name="T1" fmla="*/ 779 h 1243"/>
              <a:gd name="T2" fmla="*/ 133 w 4174"/>
              <a:gd name="T3" fmla="*/ 779 h 1243"/>
              <a:gd name="T4" fmla="*/ 205 w 4174"/>
              <a:gd name="T5" fmla="*/ 770 h 1243"/>
              <a:gd name="T6" fmla="*/ 279 w 4174"/>
              <a:gd name="T7" fmla="*/ 1243 h 1243"/>
              <a:gd name="T8" fmla="*/ 350 w 4174"/>
              <a:gd name="T9" fmla="*/ 798 h 1243"/>
              <a:gd name="T10" fmla="*/ 424 w 4174"/>
              <a:gd name="T11" fmla="*/ 764 h 1243"/>
              <a:gd name="T12" fmla="*/ 496 w 4174"/>
              <a:gd name="T13" fmla="*/ 739 h 1243"/>
              <a:gd name="T14" fmla="*/ 569 w 4174"/>
              <a:gd name="T15" fmla="*/ 718 h 1243"/>
              <a:gd name="T16" fmla="*/ 641 w 4174"/>
              <a:gd name="T17" fmla="*/ 699 h 1243"/>
              <a:gd name="T18" fmla="*/ 714 w 4174"/>
              <a:gd name="T19" fmla="*/ 682 h 1243"/>
              <a:gd name="T20" fmla="*/ 786 w 4174"/>
              <a:gd name="T21" fmla="*/ 668 h 1243"/>
              <a:gd name="T22" fmla="*/ 860 w 4174"/>
              <a:gd name="T23" fmla="*/ 655 h 1243"/>
              <a:gd name="T24" fmla="*/ 931 w 4174"/>
              <a:gd name="T25" fmla="*/ 643 h 1243"/>
              <a:gd name="T26" fmla="*/ 1005 w 4174"/>
              <a:gd name="T27" fmla="*/ 632 h 1243"/>
              <a:gd name="T28" fmla="*/ 1077 w 4174"/>
              <a:gd name="T29" fmla="*/ 622 h 1243"/>
              <a:gd name="T30" fmla="*/ 1150 w 4174"/>
              <a:gd name="T31" fmla="*/ 612 h 1243"/>
              <a:gd name="T32" fmla="*/ 1222 w 4174"/>
              <a:gd name="T33" fmla="*/ 606 h 1243"/>
              <a:gd name="T34" fmla="*/ 1295 w 4174"/>
              <a:gd name="T35" fmla="*/ 593 h 1243"/>
              <a:gd name="T36" fmla="*/ 1367 w 4174"/>
              <a:gd name="T37" fmla="*/ 588 h 1243"/>
              <a:gd name="T38" fmla="*/ 1440 w 4174"/>
              <a:gd name="T39" fmla="*/ 580 h 1243"/>
              <a:gd name="T40" fmla="*/ 1512 w 4174"/>
              <a:gd name="T41" fmla="*/ 571 h 1243"/>
              <a:gd name="T42" fmla="*/ 1586 w 4174"/>
              <a:gd name="T43" fmla="*/ 566 h 1243"/>
              <a:gd name="T44" fmla="*/ 1657 w 4174"/>
              <a:gd name="T45" fmla="*/ 558 h 1243"/>
              <a:gd name="T46" fmla="*/ 1731 w 4174"/>
              <a:gd name="T47" fmla="*/ 550 h 1243"/>
              <a:gd name="T48" fmla="*/ 1803 w 4174"/>
              <a:gd name="T49" fmla="*/ 545 h 1243"/>
              <a:gd name="T50" fmla="*/ 1876 w 4174"/>
              <a:gd name="T51" fmla="*/ 540 h 1243"/>
              <a:gd name="T52" fmla="*/ 1948 w 4174"/>
              <a:gd name="T53" fmla="*/ 532 h 1243"/>
              <a:gd name="T54" fmla="*/ 2021 w 4174"/>
              <a:gd name="T55" fmla="*/ 526 h 1243"/>
              <a:gd name="T56" fmla="*/ 2093 w 4174"/>
              <a:gd name="T57" fmla="*/ 518 h 1243"/>
              <a:gd name="T58" fmla="*/ 2165 w 4174"/>
              <a:gd name="T59" fmla="*/ 511 h 1243"/>
              <a:gd name="T60" fmla="*/ 2238 w 4174"/>
              <a:gd name="T61" fmla="*/ 504 h 1243"/>
              <a:gd name="T62" fmla="*/ 2310 w 4174"/>
              <a:gd name="T63" fmla="*/ 500 h 1243"/>
              <a:gd name="T64" fmla="*/ 2384 w 4174"/>
              <a:gd name="T65" fmla="*/ 511 h 1243"/>
              <a:gd name="T66" fmla="*/ 2455 w 4174"/>
              <a:gd name="T67" fmla="*/ 490 h 1243"/>
              <a:gd name="T68" fmla="*/ 2529 w 4174"/>
              <a:gd name="T69" fmla="*/ 504 h 1243"/>
              <a:gd name="T70" fmla="*/ 2601 w 4174"/>
              <a:gd name="T71" fmla="*/ 511 h 1243"/>
              <a:gd name="T72" fmla="*/ 2674 w 4174"/>
              <a:gd name="T73" fmla="*/ 513 h 1243"/>
              <a:gd name="T74" fmla="*/ 2746 w 4174"/>
              <a:gd name="T75" fmla="*/ 513 h 1243"/>
              <a:gd name="T76" fmla="*/ 2819 w 4174"/>
              <a:gd name="T77" fmla="*/ 511 h 1243"/>
              <a:gd name="T78" fmla="*/ 2891 w 4174"/>
              <a:gd name="T79" fmla="*/ 513 h 1243"/>
              <a:gd name="T80" fmla="*/ 2965 w 4174"/>
              <a:gd name="T81" fmla="*/ 513 h 1243"/>
              <a:gd name="T82" fmla="*/ 3036 w 4174"/>
              <a:gd name="T83" fmla="*/ 508 h 1243"/>
              <a:gd name="T84" fmla="*/ 3110 w 4174"/>
              <a:gd name="T85" fmla="*/ 506 h 1243"/>
              <a:gd name="T86" fmla="*/ 3182 w 4174"/>
              <a:gd name="T87" fmla="*/ 509 h 1243"/>
              <a:gd name="T88" fmla="*/ 3255 w 4174"/>
              <a:gd name="T89" fmla="*/ 504 h 1243"/>
              <a:gd name="T90" fmla="*/ 3327 w 4174"/>
              <a:gd name="T91" fmla="*/ 503 h 1243"/>
              <a:gd name="T92" fmla="*/ 3400 w 4174"/>
              <a:gd name="T93" fmla="*/ 503 h 1243"/>
              <a:gd name="T94" fmla="*/ 3472 w 4174"/>
              <a:gd name="T95" fmla="*/ 503 h 1243"/>
              <a:gd name="T96" fmla="*/ 3545 w 4174"/>
              <a:gd name="T97" fmla="*/ 504 h 1243"/>
              <a:gd name="T98" fmla="*/ 3617 w 4174"/>
              <a:gd name="T99" fmla="*/ 504 h 1243"/>
              <a:gd name="T100" fmla="*/ 3691 w 4174"/>
              <a:gd name="T101" fmla="*/ 501 h 1243"/>
              <a:gd name="T102" fmla="*/ 3762 w 4174"/>
              <a:gd name="T103" fmla="*/ 504 h 1243"/>
              <a:gd name="T104" fmla="*/ 3836 w 4174"/>
              <a:gd name="T105" fmla="*/ 506 h 1243"/>
              <a:gd name="T106" fmla="*/ 3908 w 4174"/>
              <a:gd name="T107" fmla="*/ 504 h 1243"/>
              <a:gd name="T108" fmla="*/ 3981 w 4174"/>
              <a:gd name="T109" fmla="*/ 503 h 1243"/>
              <a:gd name="T110" fmla="*/ 4053 w 4174"/>
              <a:gd name="T111" fmla="*/ 503 h 1243"/>
              <a:gd name="T112" fmla="*/ 4126 w 4174"/>
              <a:gd name="T113" fmla="*/ 504 h 12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243">
                <a:moveTo>
                  <a:pt x="0" y="780"/>
                </a:moveTo>
                <a:lnTo>
                  <a:pt x="13" y="779"/>
                </a:lnTo>
                <a:lnTo>
                  <a:pt x="24" y="780"/>
                </a:lnTo>
                <a:lnTo>
                  <a:pt x="37" y="780"/>
                </a:lnTo>
                <a:lnTo>
                  <a:pt x="49" y="780"/>
                </a:lnTo>
                <a:lnTo>
                  <a:pt x="60" y="779"/>
                </a:lnTo>
                <a:lnTo>
                  <a:pt x="73" y="780"/>
                </a:lnTo>
                <a:lnTo>
                  <a:pt x="85" y="779"/>
                </a:lnTo>
                <a:lnTo>
                  <a:pt x="98" y="777"/>
                </a:lnTo>
                <a:lnTo>
                  <a:pt x="109" y="777"/>
                </a:lnTo>
                <a:lnTo>
                  <a:pt x="120" y="777"/>
                </a:lnTo>
                <a:lnTo>
                  <a:pt x="133" y="779"/>
                </a:lnTo>
                <a:lnTo>
                  <a:pt x="145" y="779"/>
                </a:lnTo>
                <a:lnTo>
                  <a:pt x="158" y="775"/>
                </a:lnTo>
                <a:lnTo>
                  <a:pt x="169" y="774"/>
                </a:lnTo>
                <a:lnTo>
                  <a:pt x="182" y="762"/>
                </a:lnTo>
                <a:lnTo>
                  <a:pt x="194" y="765"/>
                </a:lnTo>
                <a:lnTo>
                  <a:pt x="205" y="770"/>
                </a:lnTo>
                <a:lnTo>
                  <a:pt x="218" y="779"/>
                </a:lnTo>
                <a:lnTo>
                  <a:pt x="230" y="596"/>
                </a:lnTo>
                <a:lnTo>
                  <a:pt x="243" y="0"/>
                </a:lnTo>
                <a:lnTo>
                  <a:pt x="254" y="23"/>
                </a:lnTo>
                <a:lnTo>
                  <a:pt x="266" y="1105"/>
                </a:lnTo>
                <a:lnTo>
                  <a:pt x="279" y="1243"/>
                </a:lnTo>
                <a:lnTo>
                  <a:pt x="290" y="1057"/>
                </a:lnTo>
                <a:lnTo>
                  <a:pt x="303" y="925"/>
                </a:lnTo>
                <a:lnTo>
                  <a:pt x="315" y="862"/>
                </a:lnTo>
                <a:lnTo>
                  <a:pt x="328" y="831"/>
                </a:lnTo>
                <a:lnTo>
                  <a:pt x="339" y="811"/>
                </a:lnTo>
                <a:lnTo>
                  <a:pt x="350" y="798"/>
                </a:lnTo>
                <a:lnTo>
                  <a:pt x="364" y="790"/>
                </a:lnTo>
                <a:lnTo>
                  <a:pt x="375" y="783"/>
                </a:lnTo>
                <a:lnTo>
                  <a:pt x="388" y="777"/>
                </a:lnTo>
                <a:lnTo>
                  <a:pt x="399" y="772"/>
                </a:lnTo>
                <a:lnTo>
                  <a:pt x="411" y="769"/>
                </a:lnTo>
                <a:lnTo>
                  <a:pt x="424" y="764"/>
                </a:lnTo>
                <a:lnTo>
                  <a:pt x="435" y="761"/>
                </a:lnTo>
                <a:lnTo>
                  <a:pt x="448" y="756"/>
                </a:lnTo>
                <a:lnTo>
                  <a:pt x="460" y="752"/>
                </a:lnTo>
                <a:lnTo>
                  <a:pt x="471" y="748"/>
                </a:lnTo>
                <a:lnTo>
                  <a:pt x="484" y="744"/>
                </a:lnTo>
                <a:lnTo>
                  <a:pt x="496" y="739"/>
                </a:lnTo>
                <a:lnTo>
                  <a:pt x="509" y="736"/>
                </a:lnTo>
                <a:lnTo>
                  <a:pt x="520" y="733"/>
                </a:lnTo>
                <a:lnTo>
                  <a:pt x="533" y="730"/>
                </a:lnTo>
                <a:lnTo>
                  <a:pt x="545" y="725"/>
                </a:lnTo>
                <a:lnTo>
                  <a:pt x="556" y="721"/>
                </a:lnTo>
                <a:lnTo>
                  <a:pt x="569" y="718"/>
                </a:lnTo>
                <a:lnTo>
                  <a:pt x="581" y="713"/>
                </a:lnTo>
                <a:lnTo>
                  <a:pt x="594" y="712"/>
                </a:lnTo>
                <a:lnTo>
                  <a:pt x="605" y="708"/>
                </a:lnTo>
                <a:lnTo>
                  <a:pt x="616" y="705"/>
                </a:lnTo>
                <a:lnTo>
                  <a:pt x="629" y="702"/>
                </a:lnTo>
                <a:lnTo>
                  <a:pt x="641" y="699"/>
                </a:lnTo>
                <a:lnTo>
                  <a:pt x="654" y="695"/>
                </a:lnTo>
                <a:lnTo>
                  <a:pt x="665" y="694"/>
                </a:lnTo>
                <a:lnTo>
                  <a:pt x="678" y="690"/>
                </a:lnTo>
                <a:lnTo>
                  <a:pt x="690" y="689"/>
                </a:lnTo>
                <a:lnTo>
                  <a:pt x="701" y="686"/>
                </a:lnTo>
                <a:lnTo>
                  <a:pt x="714" y="682"/>
                </a:lnTo>
                <a:lnTo>
                  <a:pt x="726" y="681"/>
                </a:lnTo>
                <a:lnTo>
                  <a:pt x="739" y="679"/>
                </a:lnTo>
                <a:lnTo>
                  <a:pt x="750" y="676"/>
                </a:lnTo>
                <a:lnTo>
                  <a:pt x="762" y="672"/>
                </a:lnTo>
                <a:lnTo>
                  <a:pt x="775" y="671"/>
                </a:lnTo>
                <a:lnTo>
                  <a:pt x="786" y="668"/>
                </a:lnTo>
                <a:lnTo>
                  <a:pt x="799" y="666"/>
                </a:lnTo>
                <a:lnTo>
                  <a:pt x="811" y="663"/>
                </a:lnTo>
                <a:lnTo>
                  <a:pt x="824" y="661"/>
                </a:lnTo>
                <a:lnTo>
                  <a:pt x="835" y="661"/>
                </a:lnTo>
                <a:lnTo>
                  <a:pt x="847" y="658"/>
                </a:lnTo>
                <a:lnTo>
                  <a:pt x="860" y="655"/>
                </a:lnTo>
                <a:lnTo>
                  <a:pt x="871" y="655"/>
                </a:lnTo>
                <a:lnTo>
                  <a:pt x="884" y="653"/>
                </a:lnTo>
                <a:lnTo>
                  <a:pt x="895" y="648"/>
                </a:lnTo>
                <a:lnTo>
                  <a:pt x="907" y="646"/>
                </a:lnTo>
                <a:lnTo>
                  <a:pt x="920" y="646"/>
                </a:lnTo>
                <a:lnTo>
                  <a:pt x="931" y="643"/>
                </a:lnTo>
                <a:lnTo>
                  <a:pt x="944" y="641"/>
                </a:lnTo>
                <a:lnTo>
                  <a:pt x="956" y="640"/>
                </a:lnTo>
                <a:lnTo>
                  <a:pt x="967" y="638"/>
                </a:lnTo>
                <a:lnTo>
                  <a:pt x="980" y="635"/>
                </a:lnTo>
                <a:lnTo>
                  <a:pt x="992" y="633"/>
                </a:lnTo>
                <a:lnTo>
                  <a:pt x="1005" y="632"/>
                </a:lnTo>
                <a:lnTo>
                  <a:pt x="1016" y="632"/>
                </a:lnTo>
                <a:lnTo>
                  <a:pt x="1029" y="628"/>
                </a:lnTo>
                <a:lnTo>
                  <a:pt x="1041" y="627"/>
                </a:lnTo>
                <a:lnTo>
                  <a:pt x="1052" y="625"/>
                </a:lnTo>
                <a:lnTo>
                  <a:pt x="1065" y="622"/>
                </a:lnTo>
                <a:lnTo>
                  <a:pt x="1077" y="622"/>
                </a:lnTo>
                <a:lnTo>
                  <a:pt x="1090" y="622"/>
                </a:lnTo>
                <a:lnTo>
                  <a:pt x="1101" y="619"/>
                </a:lnTo>
                <a:lnTo>
                  <a:pt x="1112" y="617"/>
                </a:lnTo>
                <a:lnTo>
                  <a:pt x="1126" y="615"/>
                </a:lnTo>
                <a:lnTo>
                  <a:pt x="1137" y="614"/>
                </a:lnTo>
                <a:lnTo>
                  <a:pt x="1150" y="612"/>
                </a:lnTo>
                <a:lnTo>
                  <a:pt x="1161" y="612"/>
                </a:lnTo>
                <a:lnTo>
                  <a:pt x="1174" y="612"/>
                </a:lnTo>
                <a:lnTo>
                  <a:pt x="1186" y="609"/>
                </a:lnTo>
                <a:lnTo>
                  <a:pt x="1197" y="609"/>
                </a:lnTo>
                <a:lnTo>
                  <a:pt x="1210" y="607"/>
                </a:lnTo>
                <a:lnTo>
                  <a:pt x="1222" y="606"/>
                </a:lnTo>
                <a:lnTo>
                  <a:pt x="1235" y="604"/>
                </a:lnTo>
                <a:lnTo>
                  <a:pt x="1246" y="602"/>
                </a:lnTo>
                <a:lnTo>
                  <a:pt x="1258" y="599"/>
                </a:lnTo>
                <a:lnTo>
                  <a:pt x="1271" y="596"/>
                </a:lnTo>
                <a:lnTo>
                  <a:pt x="1282" y="594"/>
                </a:lnTo>
                <a:lnTo>
                  <a:pt x="1295" y="593"/>
                </a:lnTo>
                <a:lnTo>
                  <a:pt x="1307" y="593"/>
                </a:lnTo>
                <a:lnTo>
                  <a:pt x="1318" y="593"/>
                </a:lnTo>
                <a:lnTo>
                  <a:pt x="1331" y="591"/>
                </a:lnTo>
                <a:lnTo>
                  <a:pt x="1343" y="589"/>
                </a:lnTo>
                <a:lnTo>
                  <a:pt x="1356" y="588"/>
                </a:lnTo>
                <a:lnTo>
                  <a:pt x="1367" y="588"/>
                </a:lnTo>
                <a:lnTo>
                  <a:pt x="1380" y="588"/>
                </a:lnTo>
                <a:lnTo>
                  <a:pt x="1392" y="584"/>
                </a:lnTo>
                <a:lnTo>
                  <a:pt x="1403" y="584"/>
                </a:lnTo>
                <a:lnTo>
                  <a:pt x="1416" y="583"/>
                </a:lnTo>
                <a:lnTo>
                  <a:pt x="1427" y="583"/>
                </a:lnTo>
                <a:lnTo>
                  <a:pt x="1440" y="580"/>
                </a:lnTo>
                <a:lnTo>
                  <a:pt x="1452" y="580"/>
                </a:lnTo>
                <a:lnTo>
                  <a:pt x="1463" y="578"/>
                </a:lnTo>
                <a:lnTo>
                  <a:pt x="1476" y="576"/>
                </a:lnTo>
                <a:lnTo>
                  <a:pt x="1488" y="575"/>
                </a:lnTo>
                <a:lnTo>
                  <a:pt x="1501" y="573"/>
                </a:lnTo>
                <a:lnTo>
                  <a:pt x="1512" y="571"/>
                </a:lnTo>
                <a:lnTo>
                  <a:pt x="1525" y="570"/>
                </a:lnTo>
                <a:lnTo>
                  <a:pt x="1537" y="571"/>
                </a:lnTo>
                <a:lnTo>
                  <a:pt x="1548" y="568"/>
                </a:lnTo>
                <a:lnTo>
                  <a:pt x="1561" y="568"/>
                </a:lnTo>
                <a:lnTo>
                  <a:pt x="1573" y="568"/>
                </a:lnTo>
                <a:lnTo>
                  <a:pt x="1586" y="566"/>
                </a:lnTo>
                <a:lnTo>
                  <a:pt x="1597" y="565"/>
                </a:lnTo>
                <a:lnTo>
                  <a:pt x="1609" y="565"/>
                </a:lnTo>
                <a:lnTo>
                  <a:pt x="1622" y="562"/>
                </a:lnTo>
                <a:lnTo>
                  <a:pt x="1633" y="562"/>
                </a:lnTo>
                <a:lnTo>
                  <a:pt x="1646" y="560"/>
                </a:lnTo>
                <a:lnTo>
                  <a:pt x="1657" y="558"/>
                </a:lnTo>
                <a:lnTo>
                  <a:pt x="1671" y="557"/>
                </a:lnTo>
                <a:lnTo>
                  <a:pt x="1682" y="555"/>
                </a:lnTo>
                <a:lnTo>
                  <a:pt x="1693" y="555"/>
                </a:lnTo>
                <a:lnTo>
                  <a:pt x="1706" y="553"/>
                </a:lnTo>
                <a:lnTo>
                  <a:pt x="1718" y="552"/>
                </a:lnTo>
                <a:lnTo>
                  <a:pt x="1731" y="550"/>
                </a:lnTo>
                <a:lnTo>
                  <a:pt x="1742" y="550"/>
                </a:lnTo>
                <a:lnTo>
                  <a:pt x="1754" y="549"/>
                </a:lnTo>
                <a:lnTo>
                  <a:pt x="1767" y="549"/>
                </a:lnTo>
                <a:lnTo>
                  <a:pt x="1778" y="547"/>
                </a:lnTo>
                <a:lnTo>
                  <a:pt x="1791" y="545"/>
                </a:lnTo>
                <a:lnTo>
                  <a:pt x="1803" y="545"/>
                </a:lnTo>
                <a:lnTo>
                  <a:pt x="1814" y="544"/>
                </a:lnTo>
                <a:lnTo>
                  <a:pt x="1827" y="542"/>
                </a:lnTo>
                <a:lnTo>
                  <a:pt x="1839" y="539"/>
                </a:lnTo>
                <a:lnTo>
                  <a:pt x="1852" y="540"/>
                </a:lnTo>
                <a:lnTo>
                  <a:pt x="1863" y="540"/>
                </a:lnTo>
                <a:lnTo>
                  <a:pt x="1876" y="540"/>
                </a:lnTo>
                <a:lnTo>
                  <a:pt x="1888" y="537"/>
                </a:lnTo>
                <a:lnTo>
                  <a:pt x="1899" y="537"/>
                </a:lnTo>
                <a:lnTo>
                  <a:pt x="1912" y="535"/>
                </a:lnTo>
                <a:lnTo>
                  <a:pt x="1923" y="534"/>
                </a:lnTo>
                <a:lnTo>
                  <a:pt x="1937" y="534"/>
                </a:lnTo>
                <a:lnTo>
                  <a:pt x="1948" y="532"/>
                </a:lnTo>
                <a:lnTo>
                  <a:pt x="1959" y="531"/>
                </a:lnTo>
                <a:lnTo>
                  <a:pt x="1972" y="531"/>
                </a:lnTo>
                <a:lnTo>
                  <a:pt x="1984" y="529"/>
                </a:lnTo>
                <a:lnTo>
                  <a:pt x="1997" y="529"/>
                </a:lnTo>
                <a:lnTo>
                  <a:pt x="2008" y="527"/>
                </a:lnTo>
                <a:lnTo>
                  <a:pt x="2021" y="526"/>
                </a:lnTo>
                <a:lnTo>
                  <a:pt x="2033" y="526"/>
                </a:lnTo>
                <a:lnTo>
                  <a:pt x="2044" y="524"/>
                </a:lnTo>
                <a:lnTo>
                  <a:pt x="2057" y="522"/>
                </a:lnTo>
                <a:lnTo>
                  <a:pt x="2069" y="521"/>
                </a:lnTo>
                <a:lnTo>
                  <a:pt x="2082" y="519"/>
                </a:lnTo>
                <a:lnTo>
                  <a:pt x="2093" y="518"/>
                </a:lnTo>
                <a:lnTo>
                  <a:pt x="2105" y="518"/>
                </a:lnTo>
                <a:lnTo>
                  <a:pt x="2118" y="516"/>
                </a:lnTo>
                <a:lnTo>
                  <a:pt x="2129" y="516"/>
                </a:lnTo>
                <a:lnTo>
                  <a:pt x="2142" y="516"/>
                </a:lnTo>
                <a:lnTo>
                  <a:pt x="2154" y="513"/>
                </a:lnTo>
                <a:lnTo>
                  <a:pt x="2165" y="511"/>
                </a:lnTo>
                <a:lnTo>
                  <a:pt x="2178" y="511"/>
                </a:lnTo>
                <a:lnTo>
                  <a:pt x="2189" y="509"/>
                </a:lnTo>
                <a:lnTo>
                  <a:pt x="2202" y="508"/>
                </a:lnTo>
                <a:lnTo>
                  <a:pt x="2214" y="508"/>
                </a:lnTo>
                <a:lnTo>
                  <a:pt x="2227" y="506"/>
                </a:lnTo>
                <a:lnTo>
                  <a:pt x="2238" y="504"/>
                </a:lnTo>
                <a:lnTo>
                  <a:pt x="2250" y="504"/>
                </a:lnTo>
                <a:lnTo>
                  <a:pt x="2263" y="506"/>
                </a:lnTo>
                <a:lnTo>
                  <a:pt x="2274" y="504"/>
                </a:lnTo>
                <a:lnTo>
                  <a:pt x="2287" y="503"/>
                </a:lnTo>
                <a:lnTo>
                  <a:pt x="2299" y="503"/>
                </a:lnTo>
                <a:lnTo>
                  <a:pt x="2310" y="500"/>
                </a:lnTo>
                <a:lnTo>
                  <a:pt x="2323" y="498"/>
                </a:lnTo>
                <a:lnTo>
                  <a:pt x="2335" y="498"/>
                </a:lnTo>
                <a:lnTo>
                  <a:pt x="2348" y="500"/>
                </a:lnTo>
                <a:lnTo>
                  <a:pt x="2359" y="509"/>
                </a:lnTo>
                <a:lnTo>
                  <a:pt x="2372" y="508"/>
                </a:lnTo>
                <a:lnTo>
                  <a:pt x="2384" y="511"/>
                </a:lnTo>
                <a:lnTo>
                  <a:pt x="2395" y="565"/>
                </a:lnTo>
                <a:lnTo>
                  <a:pt x="2408" y="549"/>
                </a:lnTo>
                <a:lnTo>
                  <a:pt x="2420" y="477"/>
                </a:lnTo>
                <a:lnTo>
                  <a:pt x="2433" y="475"/>
                </a:lnTo>
                <a:lnTo>
                  <a:pt x="2444" y="485"/>
                </a:lnTo>
                <a:lnTo>
                  <a:pt x="2455" y="490"/>
                </a:lnTo>
                <a:lnTo>
                  <a:pt x="2468" y="493"/>
                </a:lnTo>
                <a:lnTo>
                  <a:pt x="2480" y="495"/>
                </a:lnTo>
                <a:lnTo>
                  <a:pt x="2493" y="496"/>
                </a:lnTo>
                <a:lnTo>
                  <a:pt x="2504" y="500"/>
                </a:lnTo>
                <a:lnTo>
                  <a:pt x="2517" y="503"/>
                </a:lnTo>
                <a:lnTo>
                  <a:pt x="2529" y="504"/>
                </a:lnTo>
                <a:lnTo>
                  <a:pt x="2540" y="506"/>
                </a:lnTo>
                <a:lnTo>
                  <a:pt x="2553" y="506"/>
                </a:lnTo>
                <a:lnTo>
                  <a:pt x="2565" y="508"/>
                </a:lnTo>
                <a:lnTo>
                  <a:pt x="2578" y="509"/>
                </a:lnTo>
                <a:lnTo>
                  <a:pt x="2589" y="509"/>
                </a:lnTo>
                <a:lnTo>
                  <a:pt x="2601" y="511"/>
                </a:lnTo>
                <a:lnTo>
                  <a:pt x="2614" y="511"/>
                </a:lnTo>
                <a:lnTo>
                  <a:pt x="2625" y="511"/>
                </a:lnTo>
                <a:lnTo>
                  <a:pt x="2638" y="513"/>
                </a:lnTo>
                <a:lnTo>
                  <a:pt x="2650" y="513"/>
                </a:lnTo>
                <a:lnTo>
                  <a:pt x="2661" y="511"/>
                </a:lnTo>
                <a:lnTo>
                  <a:pt x="2674" y="513"/>
                </a:lnTo>
                <a:lnTo>
                  <a:pt x="2685" y="511"/>
                </a:lnTo>
                <a:lnTo>
                  <a:pt x="2699" y="511"/>
                </a:lnTo>
                <a:lnTo>
                  <a:pt x="2710" y="513"/>
                </a:lnTo>
                <a:lnTo>
                  <a:pt x="2723" y="513"/>
                </a:lnTo>
                <a:lnTo>
                  <a:pt x="2734" y="514"/>
                </a:lnTo>
                <a:lnTo>
                  <a:pt x="2746" y="513"/>
                </a:lnTo>
                <a:lnTo>
                  <a:pt x="2759" y="514"/>
                </a:lnTo>
                <a:lnTo>
                  <a:pt x="2770" y="514"/>
                </a:lnTo>
                <a:lnTo>
                  <a:pt x="2783" y="514"/>
                </a:lnTo>
                <a:lnTo>
                  <a:pt x="2795" y="513"/>
                </a:lnTo>
                <a:lnTo>
                  <a:pt x="2806" y="511"/>
                </a:lnTo>
                <a:lnTo>
                  <a:pt x="2819" y="511"/>
                </a:lnTo>
                <a:lnTo>
                  <a:pt x="2831" y="511"/>
                </a:lnTo>
                <a:lnTo>
                  <a:pt x="2844" y="513"/>
                </a:lnTo>
                <a:lnTo>
                  <a:pt x="2855" y="514"/>
                </a:lnTo>
                <a:lnTo>
                  <a:pt x="2868" y="513"/>
                </a:lnTo>
                <a:lnTo>
                  <a:pt x="2880" y="513"/>
                </a:lnTo>
                <a:lnTo>
                  <a:pt x="2891" y="513"/>
                </a:lnTo>
                <a:lnTo>
                  <a:pt x="2904" y="513"/>
                </a:lnTo>
                <a:lnTo>
                  <a:pt x="2916" y="513"/>
                </a:lnTo>
                <a:lnTo>
                  <a:pt x="2929" y="514"/>
                </a:lnTo>
                <a:lnTo>
                  <a:pt x="2940" y="514"/>
                </a:lnTo>
                <a:lnTo>
                  <a:pt x="2951" y="513"/>
                </a:lnTo>
                <a:lnTo>
                  <a:pt x="2965" y="513"/>
                </a:lnTo>
                <a:lnTo>
                  <a:pt x="2976" y="511"/>
                </a:lnTo>
                <a:lnTo>
                  <a:pt x="2989" y="511"/>
                </a:lnTo>
                <a:lnTo>
                  <a:pt x="3000" y="513"/>
                </a:lnTo>
                <a:lnTo>
                  <a:pt x="3012" y="511"/>
                </a:lnTo>
                <a:lnTo>
                  <a:pt x="3025" y="509"/>
                </a:lnTo>
                <a:lnTo>
                  <a:pt x="3036" y="508"/>
                </a:lnTo>
                <a:lnTo>
                  <a:pt x="3049" y="511"/>
                </a:lnTo>
                <a:lnTo>
                  <a:pt x="3061" y="511"/>
                </a:lnTo>
                <a:lnTo>
                  <a:pt x="3074" y="511"/>
                </a:lnTo>
                <a:lnTo>
                  <a:pt x="3085" y="511"/>
                </a:lnTo>
                <a:lnTo>
                  <a:pt x="3097" y="508"/>
                </a:lnTo>
                <a:lnTo>
                  <a:pt x="3110" y="506"/>
                </a:lnTo>
                <a:lnTo>
                  <a:pt x="3121" y="506"/>
                </a:lnTo>
                <a:lnTo>
                  <a:pt x="3134" y="508"/>
                </a:lnTo>
                <a:lnTo>
                  <a:pt x="3146" y="506"/>
                </a:lnTo>
                <a:lnTo>
                  <a:pt x="3157" y="508"/>
                </a:lnTo>
                <a:lnTo>
                  <a:pt x="3170" y="509"/>
                </a:lnTo>
                <a:lnTo>
                  <a:pt x="3182" y="509"/>
                </a:lnTo>
                <a:lnTo>
                  <a:pt x="3195" y="509"/>
                </a:lnTo>
                <a:lnTo>
                  <a:pt x="3206" y="508"/>
                </a:lnTo>
                <a:lnTo>
                  <a:pt x="3219" y="508"/>
                </a:lnTo>
                <a:lnTo>
                  <a:pt x="3230" y="508"/>
                </a:lnTo>
                <a:lnTo>
                  <a:pt x="3242" y="506"/>
                </a:lnTo>
                <a:lnTo>
                  <a:pt x="3255" y="504"/>
                </a:lnTo>
                <a:lnTo>
                  <a:pt x="3266" y="504"/>
                </a:lnTo>
                <a:lnTo>
                  <a:pt x="3279" y="504"/>
                </a:lnTo>
                <a:lnTo>
                  <a:pt x="3291" y="504"/>
                </a:lnTo>
                <a:lnTo>
                  <a:pt x="3302" y="504"/>
                </a:lnTo>
                <a:lnTo>
                  <a:pt x="3315" y="503"/>
                </a:lnTo>
                <a:lnTo>
                  <a:pt x="3327" y="503"/>
                </a:lnTo>
                <a:lnTo>
                  <a:pt x="3340" y="503"/>
                </a:lnTo>
                <a:lnTo>
                  <a:pt x="3351" y="504"/>
                </a:lnTo>
                <a:lnTo>
                  <a:pt x="3364" y="504"/>
                </a:lnTo>
                <a:lnTo>
                  <a:pt x="3376" y="503"/>
                </a:lnTo>
                <a:lnTo>
                  <a:pt x="3387" y="504"/>
                </a:lnTo>
                <a:lnTo>
                  <a:pt x="3400" y="503"/>
                </a:lnTo>
                <a:lnTo>
                  <a:pt x="3412" y="504"/>
                </a:lnTo>
                <a:lnTo>
                  <a:pt x="3425" y="504"/>
                </a:lnTo>
                <a:lnTo>
                  <a:pt x="3436" y="503"/>
                </a:lnTo>
                <a:lnTo>
                  <a:pt x="3447" y="503"/>
                </a:lnTo>
                <a:lnTo>
                  <a:pt x="3461" y="503"/>
                </a:lnTo>
                <a:lnTo>
                  <a:pt x="3472" y="503"/>
                </a:lnTo>
                <a:lnTo>
                  <a:pt x="3485" y="504"/>
                </a:lnTo>
                <a:lnTo>
                  <a:pt x="3496" y="506"/>
                </a:lnTo>
                <a:lnTo>
                  <a:pt x="3508" y="504"/>
                </a:lnTo>
                <a:lnTo>
                  <a:pt x="3521" y="503"/>
                </a:lnTo>
                <a:lnTo>
                  <a:pt x="3532" y="504"/>
                </a:lnTo>
                <a:lnTo>
                  <a:pt x="3545" y="504"/>
                </a:lnTo>
                <a:lnTo>
                  <a:pt x="3557" y="504"/>
                </a:lnTo>
                <a:lnTo>
                  <a:pt x="3570" y="503"/>
                </a:lnTo>
                <a:lnTo>
                  <a:pt x="3581" y="504"/>
                </a:lnTo>
                <a:lnTo>
                  <a:pt x="3593" y="504"/>
                </a:lnTo>
                <a:lnTo>
                  <a:pt x="3606" y="503"/>
                </a:lnTo>
                <a:lnTo>
                  <a:pt x="3617" y="504"/>
                </a:lnTo>
                <a:lnTo>
                  <a:pt x="3630" y="504"/>
                </a:lnTo>
                <a:lnTo>
                  <a:pt x="3642" y="503"/>
                </a:lnTo>
                <a:lnTo>
                  <a:pt x="3653" y="501"/>
                </a:lnTo>
                <a:lnTo>
                  <a:pt x="3666" y="501"/>
                </a:lnTo>
                <a:lnTo>
                  <a:pt x="3678" y="501"/>
                </a:lnTo>
                <a:lnTo>
                  <a:pt x="3691" y="501"/>
                </a:lnTo>
                <a:lnTo>
                  <a:pt x="3702" y="500"/>
                </a:lnTo>
                <a:lnTo>
                  <a:pt x="3715" y="501"/>
                </a:lnTo>
                <a:lnTo>
                  <a:pt x="3727" y="503"/>
                </a:lnTo>
                <a:lnTo>
                  <a:pt x="3738" y="503"/>
                </a:lnTo>
                <a:lnTo>
                  <a:pt x="3751" y="503"/>
                </a:lnTo>
                <a:lnTo>
                  <a:pt x="3762" y="504"/>
                </a:lnTo>
                <a:lnTo>
                  <a:pt x="3775" y="503"/>
                </a:lnTo>
                <a:lnTo>
                  <a:pt x="3787" y="503"/>
                </a:lnTo>
                <a:lnTo>
                  <a:pt x="3798" y="504"/>
                </a:lnTo>
                <a:lnTo>
                  <a:pt x="3811" y="506"/>
                </a:lnTo>
                <a:lnTo>
                  <a:pt x="3823" y="506"/>
                </a:lnTo>
                <a:lnTo>
                  <a:pt x="3836" y="506"/>
                </a:lnTo>
                <a:lnTo>
                  <a:pt x="3847" y="506"/>
                </a:lnTo>
                <a:lnTo>
                  <a:pt x="3859" y="504"/>
                </a:lnTo>
                <a:lnTo>
                  <a:pt x="3872" y="504"/>
                </a:lnTo>
                <a:lnTo>
                  <a:pt x="3883" y="504"/>
                </a:lnTo>
                <a:lnTo>
                  <a:pt x="3896" y="504"/>
                </a:lnTo>
                <a:lnTo>
                  <a:pt x="3908" y="504"/>
                </a:lnTo>
                <a:lnTo>
                  <a:pt x="3921" y="504"/>
                </a:lnTo>
                <a:lnTo>
                  <a:pt x="3932" y="504"/>
                </a:lnTo>
                <a:lnTo>
                  <a:pt x="3944" y="504"/>
                </a:lnTo>
                <a:lnTo>
                  <a:pt x="3957" y="504"/>
                </a:lnTo>
                <a:lnTo>
                  <a:pt x="3968" y="503"/>
                </a:lnTo>
                <a:lnTo>
                  <a:pt x="3981" y="503"/>
                </a:lnTo>
                <a:lnTo>
                  <a:pt x="3992" y="503"/>
                </a:lnTo>
                <a:lnTo>
                  <a:pt x="4004" y="501"/>
                </a:lnTo>
                <a:lnTo>
                  <a:pt x="4017" y="503"/>
                </a:lnTo>
                <a:lnTo>
                  <a:pt x="4028" y="501"/>
                </a:lnTo>
                <a:lnTo>
                  <a:pt x="4041" y="503"/>
                </a:lnTo>
                <a:lnTo>
                  <a:pt x="4053" y="503"/>
                </a:lnTo>
                <a:lnTo>
                  <a:pt x="4066" y="503"/>
                </a:lnTo>
                <a:lnTo>
                  <a:pt x="4077" y="506"/>
                </a:lnTo>
                <a:lnTo>
                  <a:pt x="4089" y="508"/>
                </a:lnTo>
                <a:lnTo>
                  <a:pt x="4102" y="506"/>
                </a:lnTo>
                <a:lnTo>
                  <a:pt x="4113" y="506"/>
                </a:lnTo>
                <a:lnTo>
                  <a:pt x="4126" y="504"/>
                </a:lnTo>
                <a:lnTo>
                  <a:pt x="4138" y="506"/>
                </a:lnTo>
                <a:lnTo>
                  <a:pt x="4149" y="506"/>
                </a:lnTo>
                <a:lnTo>
                  <a:pt x="4162" y="506"/>
                </a:lnTo>
                <a:lnTo>
                  <a:pt x="4174" y="506"/>
                </a:lnTo>
              </a:path>
            </a:pathLst>
          </a:custGeom>
          <a:noFill/>
          <a:ln w="19050" cmpd="sng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8" name="Freeform 103"/>
          <p:cNvSpPr>
            <a:spLocks/>
          </p:cNvSpPr>
          <p:nvPr/>
        </p:nvSpPr>
        <p:spPr bwMode="auto">
          <a:xfrm>
            <a:off x="1672431" y="3758250"/>
            <a:ext cx="6626225" cy="2287588"/>
          </a:xfrm>
          <a:custGeom>
            <a:avLst/>
            <a:gdLst>
              <a:gd name="T0" fmla="*/ 60 w 4174"/>
              <a:gd name="T1" fmla="*/ 973 h 1441"/>
              <a:gd name="T2" fmla="*/ 133 w 4174"/>
              <a:gd name="T3" fmla="*/ 971 h 1441"/>
              <a:gd name="T4" fmla="*/ 205 w 4174"/>
              <a:gd name="T5" fmla="*/ 961 h 1441"/>
              <a:gd name="T6" fmla="*/ 279 w 4174"/>
              <a:gd name="T7" fmla="*/ 1354 h 1441"/>
              <a:gd name="T8" fmla="*/ 350 w 4174"/>
              <a:gd name="T9" fmla="*/ 1005 h 1441"/>
              <a:gd name="T10" fmla="*/ 424 w 4174"/>
              <a:gd name="T11" fmla="*/ 976 h 1441"/>
              <a:gd name="T12" fmla="*/ 496 w 4174"/>
              <a:gd name="T13" fmla="*/ 966 h 1441"/>
              <a:gd name="T14" fmla="*/ 569 w 4174"/>
              <a:gd name="T15" fmla="*/ 955 h 1441"/>
              <a:gd name="T16" fmla="*/ 641 w 4174"/>
              <a:gd name="T17" fmla="*/ 946 h 1441"/>
              <a:gd name="T18" fmla="*/ 714 w 4174"/>
              <a:gd name="T19" fmla="*/ 938 h 1441"/>
              <a:gd name="T20" fmla="*/ 786 w 4174"/>
              <a:gd name="T21" fmla="*/ 930 h 1441"/>
              <a:gd name="T22" fmla="*/ 860 w 4174"/>
              <a:gd name="T23" fmla="*/ 924 h 1441"/>
              <a:gd name="T24" fmla="*/ 931 w 4174"/>
              <a:gd name="T25" fmla="*/ 915 h 1441"/>
              <a:gd name="T26" fmla="*/ 1005 w 4174"/>
              <a:gd name="T27" fmla="*/ 907 h 1441"/>
              <a:gd name="T28" fmla="*/ 1077 w 4174"/>
              <a:gd name="T29" fmla="*/ 902 h 1441"/>
              <a:gd name="T30" fmla="*/ 1150 w 4174"/>
              <a:gd name="T31" fmla="*/ 896 h 1441"/>
              <a:gd name="T32" fmla="*/ 1222 w 4174"/>
              <a:gd name="T33" fmla="*/ 893 h 1441"/>
              <a:gd name="T34" fmla="*/ 1295 w 4174"/>
              <a:gd name="T35" fmla="*/ 886 h 1441"/>
              <a:gd name="T36" fmla="*/ 1367 w 4174"/>
              <a:gd name="T37" fmla="*/ 880 h 1441"/>
              <a:gd name="T38" fmla="*/ 1440 w 4174"/>
              <a:gd name="T39" fmla="*/ 875 h 1441"/>
              <a:gd name="T40" fmla="*/ 1512 w 4174"/>
              <a:gd name="T41" fmla="*/ 871 h 1441"/>
              <a:gd name="T42" fmla="*/ 1586 w 4174"/>
              <a:gd name="T43" fmla="*/ 865 h 1441"/>
              <a:gd name="T44" fmla="*/ 1657 w 4174"/>
              <a:gd name="T45" fmla="*/ 860 h 1441"/>
              <a:gd name="T46" fmla="*/ 1731 w 4174"/>
              <a:gd name="T47" fmla="*/ 853 h 1441"/>
              <a:gd name="T48" fmla="*/ 1803 w 4174"/>
              <a:gd name="T49" fmla="*/ 850 h 1441"/>
              <a:gd name="T50" fmla="*/ 1876 w 4174"/>
              <a:gd name="T51" fmla="*/ 847 h 1441"/>
              <a:gd name="T52" fmla="*/ 1948 w 4174"/>
              <a:gd name="T53" fmla="*/ 842 h 1441"/>
              <a:gd name="T54" fmla="*/ 2021 w 4174"/>
              <a:gd name="T55" fmla="*/ 837 h 1441"/>
              <a:gd name="T56" fmla="*/ 2093 w 4174"/>
              <a:gd name="T57" fmla="*/ 834 h 1441"/>
              <a:gd name="T58" fmla="*/ 2165 w 4174"/>
              <a:gd name="T59" fmla="*/ 831 h 1441"/>
              <a:gd name="T60" fmla="*/ 2238 w 4174"/>
              <a:gd name="T61" fmla="*/ 826 h 1441"/>
              <a:gd name="T62" fmla="*/ 2310 w 4174"/>
              <a:gd name="T63" fmla="*/ 822 h 1441"/>
              <a:gd name="T64" fmla="*/ 2384 w 4174"/>
              <a:gd name="T65" fmla="*/ 832 h 1441"/>
              <a:gd name="T66" fmla="*/ 2455 w 4174"/>
              <a:gd name="T67" fmla="*/ 800 h 1441"/>
              <a:gd name="T68" fmla="*/ 2529 w 4174"/>
              <a:gd name="T69" fmla="*/ 821 h 1441"/>
              <a:gd name="T70" fmla="*/ 2601 w 4174"/>
              <a:gd name="T71" fmla="*/ 826 h 1441"/>
              <a:gd name="T72" fmla="*/ 2674 w 4174"/>
              <a:gd name="T73" fmla="*/ 831 h 1441"/>
              <a:gd name="T74" fmla="*/ 2746 w 4174"/>
              <a:gd name="T75" fmla="*/ 831 h 1441"/>
              <a:gd name="T76" fmla="*/ 2819 w 4174"/>
              <a:gd name="T77" fmla="*/ 832 h 1441"/>
              <a:gd name="T78" fmla="*/ 2891 w 4174"/>
              <a:gd name="T79" fmla="*/ 831 h 1441"/>
              <a:gd name="T80" fmla="*/ 2965 w 4174"/>
              <a:gd name="T81" fmla="*/ 834 h 1441"/>
              <a:gd name="T82" fmla="*/ 3036 w 4174"/>
              <a:gd name="T83" fmla="*/ 832 h 1441"/>
              <a:gd name="T84" fmla="*/ 3110 w 4174"/>
              <a:gd name="T85" fmla="*/ 832 h 1441"/>
              <a:gd name="T86" fmla="*/ 3182 w 4174"/>
              <a:gd name="T87" fmla="*/ 831 h 1441"/>
              <a:gd name="T88" fmla="*/ 3255 w 4174"/>
              <a:gd name="T89" fmla="*/ 834 h 1441"/>
              <a:gd name="T90" fmla="*/ 3327 w 4174"/>
              <a:gd name="T91" fmla="*/ 832 h 1441"/>
              <a:gd name="T92" fmla="*/ 3400 w 4174"/>
              <a:gd name="T93" fmla="*/ 832 h 1441"/>
              <a:gd name="T94" fmla="*/ 3472 w 4174"/>
              <a:gd name="T95" fmla="*/ 832 h 1441"/>
              <a:gd name="T96" fmla="*/ 3545 w 4174"/>
              <a:gd name="T97" fmla="*/ 832 h 1441"/>
              <a:gd name="T98" fmla="*/ 3617 w 4174"/>
              <a:gd name="T99" fmla="*/ 832 h 1441"/>
              <a:gd name="T100" fmla="*/ 3691 w 4174"/>
              <a:gd name="T101" fmla="*/ 831 h 1441"/>
              <a:gd name="T102" fmla="*/ 3762 w 4174"/>
              <a:gd name="T103" fmla="*/ 829 h 1441"/>
              <a:gd name="T104" fmla="*/ 3836 w 4174"/>
              <a:gd name="T105" fmla="*/ 829 h 1441"/>
              <a:gd name="T106" fmla="*/ 3908 w 4174"/>
              <a:gd name="T107" fmla="*/ 829 h 1441"/>
              <a:gd name="T108" fmla="*/ 3981 w 4174"/>
              <a:gd name="T109" fmla="*/ 829 h 1441"/>
              <a:gd name="T110" fmla="*/ 4053 w 4174"/>
              <a:gd name="T111" fmla="*/ 824 h 1441"/>
              <a:gd name="T112" fmla="*/ 4126 w 4174"/>
              <a:gd name="T113" fmla="*/ 826 h 14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441">
                <a:moveTo>
                  <a:pt x="0" y="974"/>
                </a:moveTo>
                <a:lnTo>
                  <a:pt x="13" y="973"/>
                </a:lnTo>
                <a:lnTo>
                  <a:pt x="24" y="974"/>
                </a:lnTo>
                <a:lnTo>
                  <a:pt x="37" y="973"/>
                </a:lnTo>
                <a:lnTo>
                  <a:pt x="49" y="974"/>
                </a:lnTo>
                <a:lnTo>
                  <a:pt x="60" y="973"/>
                </a:lnTo>
                <a:lnTo>
                  <a:pt x="73" y="974"/>
                </a:lnTo>
                <a:lnTo>
                  <a:pt x="85" y="973"/>
                </a:lnTo>
                <a:lnTo>
                  <a:pt x="98" y="971"/>
                </a:lnTo>
                <a:lnTo>
                  <a:pt x="109" y="971"/>
                </a:lnTo>
                <a:lnTo>
                  <a:pt x="120" y="971"/>
                </a:lnTo>
                <a:lnTo>
                  <a:pt x="133" y="971"/>
                </a:lnTo>
                <a:lnTo>
                  <a:pt x="145" y="969"/>
                </a:lnTo>
                <a:lnTo>
                  <a:pt x="158" y="971"/>
                </a:lnTo>
                <a:lnTo>
                  <a:pt x="169" y="969"/>
                </a:lnTo>
                <a:lnTo>
                  <a:pt x="182" y="966"/>
                </a:lnTo>
                <a:lnTo>
                  <a:pt x="194" y="956"/>
                </a:lnTo>
                <a:lnTo>
                  <a:pt x="205" y="961"/>
                </a:lnTo>
                <a:lnTo>
                  <a:pt x="218" y="964"/>
                </a:lnTo>
                <a:lnTo>
                  <a:pt x="230" y="973"/>
                </a:lnTo>
                <a:lnTo>
                  <a:pt x="243" y="632"/>
                </a:lnTo>
                <a:lnTo>
                  <a:pt x="254" y="0"/>
                </a:lnTo>
                <a:lnTo>
                  <a:pt x="266" y="304"/>
                </a:lnTo>
                <a:lnTo>
                  <a:pt x="279" y="1354"/>
                </a:lnTo>
                <a:lnTo>
                  <a:pt x="290" y="1441"/>
                </a:lnTo>
                <a:lnTo>
                  <a:pt x="303" y="1245"/>
                </a:lnTo>
                <a:lnTo>
                  <a:pt x="315" y="1116"/>
                </a:lnTo>
                <a:lnTo>
                  <a:pt x="328" y="1052"/>
                </a:lnTo>
                <a:lnTo>
                  <a:pt x="339" y="1021"/>
                </a:lnTo>
                <a:lnTo>
                  <a:pt x="350" y="1005"/>
                </a:lnTo>
                <a:lnTo>
                  <a:pt x="364" y="995"/>
                </a:lnTo>
                <a:lnTo>
                  <a:pt x="375" y="989"/>
                </a:lnTo>
                <a:lnTo>
                  <a:pt x="388" y="986"/>
                </a:lnTo>
                <a:lnTo>
                  <a:pt x="399" y="981"/>
                </a:lnTo>
                <a:lnTo>
                  <a:pt x="411" y="979"/>
                </a:lnTo>
                <a:lnTo>
                  <a:pt x="424" y="976"/>
                </a:lnTo>
                <a:lnTo>
                  <a:pt x="435" y="974"/>
                </a:lnTo>
                <a:lnTo>
                  <a:pt x="448" y="974"/>
                </a:lnTo>
                <a:lnTo>
                  <a:pt x="460" y="971"/>
                </a:lnTo>
                <a:lnTo>
                  <a:pt x="471" y="969"/>
                </a:lnTo>
                <a:lnTo>
                  <a:pt x="484" y="968"/>
                </a:lnTo>
                <a:lnTo>
                  <a:pt x="496" y="966"/>
                </a:lnTo>
                <a:lnTo>
                  <a:pt x="509" y="963"/>
                </a:lnTo>
                <a:lnTo>
                  <a:pt x="520" y="961"/>
                </a:lnTo>
                <a:lnTo>
                  <a:pt x="533" y="961"/>
                </a:lnTo>
                <a:lnTo>
                  <a:pt x="545" y="958"/>
                </a:lnTo>
                <a:lnTo>
                  <a:pt x="556" y="958"/>
                </a:lnTo>
                <a:lnTo>
                  <a:pt x="569" y="955"/>
                </a:lnTo>
                <a:lnTo>
                  <a:pt x="581" y="953"/>
                </a:lnTo>
                <a:lnTo>
                  <a:pt x="594" y="951"/>
                </a:lnTo>
                <a:lnTo>
                  <a:pt x="605" y="950"/>
                </a:lnTo>
                <a:lnTo>
                  <a:pt x="616" y="950"/>
                </a:lnTo>
                <a:lnTo>
                  <a:pt x="629" y="948"/>
                </a:lnTo>
                <a:lnTo>
                  <a:pt x="641" y="946"/>
                </a:lnTo>
                <a:lnTo>
                  <a:pt x="654" y="945"/>
                </a:lnTo>
                <a:lnTo>
                  <a:pt x="665" y="943"/>
                </a:lnTo>
                <a:lnTo>
                  <a:pt x="678" y="942"/>
                </a:lnTo>
                <a:lnTo>
                  <a:pt x="690" y="942"/>
                </a:lnTo>
                <a:lnTo>
                  <a:pt x="701" y="940"/>
                </a:lnTo>
                <a:lnTo>
                  <a:pt x="714" y="938"/>
                </a:lnTo>
                <a:lnTo>
                  <a:pt x="726" y="937"/>
                </a:lnTo>
                <a:lnTo>
                  <a:pt x="739" y="935"/>
                </a:lnTo>
                <a:lnTo>
                  <a:pt x="750" y="935"/>
                </a:lnTo>
                <a:lnTo>
                  <a:pt x="762" y="933"/>
                </a:lnTo>
                <a:lnTo>
                  <a:pt x="775" y="932"/>
                </a:lnTo>
                <a:lnTo>
                  <a:pt x="786" y="930"/>
                </a:lnTo>
                <a:lnTo>
                  <a:pt x="799" y="930"/>
                </a:lnTo>
                <a:lnTo>
                  <a:pt x="811" y="927"/>
                </a:lnTo>
                <a:lnTo>
                  <a:pt x="824" y="925"/>
                </a:lnTo>
                <a:lnTo>
                  <a:pt x="835" y="925"/>
                </a:lnTo>
                <a:lnTo>
                  <a:pt x="847" y="925"/>
                </a:lnTo>
                <a:lnTo>
                  <a:pt x="860" y="924"/>
                </a:lnTo>
                <a:lnTo>
                  <a:pt x="871" y="922"/>
                </a:lnTo>
                <a:lnTo>
                  <a:pt x="884" y="922"/>
                </a:lnTo>
                <a:lnTo>
                  <a:pt x="895" y="919"/>
                </a:lnTo>
                <a:lnTo>
                  <a:pt x="907" y="919"/>
                </a:lnTo>
                <a:lnTo>
                  <a:pt x="920" y="919"/>
                </a:lnTo>
                <a:lnTo>
                  <a:pt x="931" y="915"/>
                </a:lnTo>
                <a:lnTo>
                  <a:pt x="944" y="914"/>
                </a:lnTo>
                <a:lnTo>
                  <a:pt x="956" y="912"/>
                </a:lnTo>
                <a:lnTo>
                  <a:pt x="967" y="912"/>
                </a:lnTo>
                <a:lnTo>
                  <a:pt x="980" y="911"/>
                </a:lnTo>
                <a:lnTo>
                  <a:pt x="992" y="909"/>
                </a:lnTo>
                <a:lnTo>
                  <a:pt x="1005" y="907"/>
                </a:lnTo>
                <a:lnTo>
                  <a:pt x="1016" y="907"/>
                </a:lnTo>
                <a:lnTo>
                  <a:pt x="1029" y="907"/>
                </a:lnTo>
                <a:lnTo>
                  <a:pt x="1041" y="906"/>
                </a:lnTo>
                <a:lnTo>
                  <a:pt x="1052" y="902"/>
                </a:lnTo>
                <a:lnTo>
                  <a:pt x="1065" y="902"/>
                </a:lnTo>
                <a:lnTo>
                  <a:pt x="1077" y="902"/>
                </a:lnTo>
                <a:lnTo>
                  <a:pt x="1090" y="899"/>
                </a:lnTo>
                <a:lnTo>
                  <a:pt x="1101" y="899"/>
                </a:lnTo>
                <a:lnTo>
                  <a:pt x="1112" y="899"/>
                </a:lnTo>
                <a:lnTo>
                  <a:pt x="1126" y="897"/>
                </a:lnTo>
                <a:lnTo>
                  <a:pt x="1137" y="897"/>
                </a:lnTo>
                <a:lnTo>
                  <a:pt x="1150" y="896"/>
                </a:lnTo>
                <a:lnTo>
                  <a:pt x="1161" y="894"/>
                </a:lnTo>
                <a:lnTo>
                  <a:pt x="1174" y="896"/>
                </a:lnTo>
                <a:lnTo>
                  <a:pt x="1186" y="894"/>
                </a:lnTo>
                <a:lnTo>
                  <a:pt x="1197" y="893"/>
                </a:lnTo>
                <a:lnTo>
                  <a:pt x="1210" y="891"/>
                </a:lnTo>
                <a:lnTo>
                  <a:pt x="1222" y="893"/>
                </a:lnTo>
                <a:lnTo>
                  <a:pt x="1235" y="891"/>
                </a:lnTo>
                <a:lnTo>
                  <a:pt x="1246" y="891"/>
                </a:lnTo>
                <a:lnTo>
                  <a:pt x="1258" y="889"/>
                </a:lnTo>
                <a:lnTo>
                  <a:pt x="1271" y="889"/>
                </a:lnTo>
                <a:lnTo>
                  <a:pt x="1282" y="888"/>
                </a:lnTo>
                <a:lnTo>
                  <a:pt x="1295" y="886"/>
                </a:lnTo>
                <a:lnTo>
                  <a:pt x="1307" y="884"/>
                </a:lnTo>
                <a:lnTo>
                  <a:pt x="1318" y="884"/>
                </a:lnTo>
                <a:lnTo>
                  <a:pt x="1331" y="883"/>
                </a:lnTo>
                <a:lnTo>
                  <a:pt x="1343" y="881"/>
                </a:lnTo>
                <a:lnTo>
                  <a:pt x="1356" y="881"/>
                </a:lnTo>
                <a:lnTo>
                  <a:pt x="1367" y="880"/>
                </a:lnTo>
                <a:lnTo>
                  <a:pt x="1380" y="880"/>
                </a:lnTo>
                <a:lnTo>
                  <a:pt x="1392" y="878"/>
                </a:lnTo>
                <a:lnTo>
                  <a:pt x="1403" y="876"/>
                </a:lnTo>
                <a:lnTo>
                  <a:pt x="1416" y="875"/>
                </a:lnTo>
                <a:lnTo>
                  <a:pt x="1427" y="876"/>
                </a:lnTo>
                <a:lnTo>
                  <a:pt x="1440" y="875"/>
                </a:lnTo>
                <a:lnTo>
                  <a:pt x="1452" y="873"/>
                </a:lnTo>
                <a:lnTo>
                  <a:pt x="1463" y="875"/>
                </a:lnTo>
                <a:lnTo>
                  <a:pt x="1476" y="873"/>
                </a:lnTo>
                <a:lnTo>
                  <a:pt x="1488" y="873"/>
                </a:lnTo>
                <a:lnTo>
                  <a:pt x="1501" y="871"/>
                </a:lnTo>
                <a:lnTo>
                  <a:pt x="1512" y="871"/>
                </a:lnTo>
                <a:lnTo>
                  <a:pt x="1525" y="868"/>
                </a:lnTo>
                <a:lnTo>
                  <a:pt x="1537" y="868"/>
                </a:lnTo>
                <a:lnTo>
                  <a:pt x="1548" y="868"/>
                </a:lnTo>
                <a:lnTo>
                  <a:pt x="1561" y="868"/>
                </a:lnTo>
                <a:lnTo>
                  <a:pt x="1573" y="866"/>
                </a:lnTo>
                <a:lnTo>
                  <a:pt x="1586" y="865"/>
                </a:lnTo>
                <a:lnTo>
                  <a:pt x="1597" y="863"/>
                </a:lnTo>
                <a:lnTo>
                  <a:pt x="1609" y="863"/>
                </a:lnTo>
                <a:lnTo>
                  <a:pt x="1622" y="863"/>
                </a:lnTo>
                <a:lnTo>
                  <a:pt x="1633" y="862"/>
                </a:lnTo>
                <a:lnTo>
                  <a:pt x="1646" y="862"/>
                </a:lnTo>
                <a:lnTo>
                  <a:pt x="1657" y="860"/>
                </a:lnTo>
                <a:lnTo>
                  <a:pt x="1671" y="860"/>
                </a:lnTo>
                <a:lnTo>
                  <a:pt x="1682" y="860"/>
                </a:lnTo>
                <a:lnTo>
                  <a:pt x="1693" y="857"/>
                </a:lnTo>
                <a:lnTo>
                  <a:pt x="1706" y="857"/>
                </a:lnTo>
                <a:lnTo>
                  <a:pt x="1718" y="855"/>
                </a:lnTo>
                <a:lnTo>
                  <a:pt x="1731" y="853"/>
                </a:lnTo>
                <a:lnTo>
                  <a:pt x="1742" y="853"/>
                </a:lnTo>
                <a:lnTo>
                  <a:pt x="1754" y="852"/>
                </a:lnTo>
                <a:lnTo>
                  <a:pt x="1767" y="852"/>
                </a:lnTo>
                <a:lnTo>
                  <a:pt x="1778" y="852"/>
                </a:lnTo>
                <a:lnTo>
                  <a:pt x="1791" y="852"/>
                </a:lnTo>
                <a:lnTo>
                  <a:pt x="1803" y="850"/>
                </a:lnTo>
                <a:lnTo>
                  <a:pt x="1814" y="849"/>
                </a:lnTo>
                <a:lnTo>
                  <a:pt x="1827" y="849"/>
                </a:lnTo>
                <a:lnTo>
                  <a:pt x="1839" y="849"/>
                </a:lnTo>
                <a:lnTo>
                  <a:pt x="1852" y="847"/>
                </a:lnTo>
                <a:lnTo>
                  <a:pt x="1863" y="845"/>
                </a:lnTo>
                <a:lnTo>
                  <a:pt x="1876" y="847"/>
                </a:lnTo>
                <a:lnTo>
                  <a:pt x="1888" y="849"/>
                </a:lnTo>
                <a:lnTo>
                  <a:pt x="1899" y="845"/>
                </a:lnTo>
                <a:lnTo>
                  <a:pt x="1912" y="844"/>
                </a:lnTo>
                <a:lnTo>
                  <a:pt x="1923" y="845"/>
                </a:lnTo>
                <a:lnTo>
                  <a:pt x="1937" y="842"/>
                </a:lnTo>
                <a:lnTo>
                  <a:pt x="1948" y="842"/>
                </a:lnTo>
                <a:lnTo>
                  <a:pt x="1959" y="842"/>
                </a:lnTo>
                <a:lnTo>
                  <a:pt x="1972" y="840"/>
                </a:lnTo>
                <a:lnTo>
                  <a:pt x="1984" y="839"/>
                </a:lnTo>
                <a:lnTo>
                  <a:pt x="1997" y="837"/>
                </a:lnTo>
                <a:lnTo>
                  <a:pt x="2008" y="837"/>
                </a:lnTo>
                <a:lnTo>
                  <a:pt x="2021" y="837"/>
                </a:lnTo>
                <a:lnTo>
                  <a:pt x="2033" y="835"/>
                </a:lnTo>
                <a:lnTo>
                  <a:pt x="2044" y="835"/>
                </a:lnTo>
                <a:lnTo>
                  <a:pt x="2057" y="834"/>
                </a:lnTo>
                <a:lnTo>
                  <a:pt x="2069" y="834"/>
                </a:lnTo>
                <a:lnTo>
                  <a:pt x="2082" y="834"/>
                </a:lnTo>
                <a:lnTo>
                  <a:pt x="2093" y="834"/>
                </a:lnTo>
                <a:lnTo>
                  <a:pt x="2105" y="832"/>
                </a:lnTo>
                <a:lnTo>
                  <a:pt x="2118" y="832"/>
                </a:lnTo>
                <a:lnTo>
                  <a:pt x="2129" y="832"/>
                </a:lnTo>
                <a:lnTo>
                  <a:pt x="2142" y="831"/>
                </a:lnTo>
                <a:lnTo>
                  <a:pt x="2154" y="829"/>
                </a:lnTo>
                <a:lnTo>
                  <a:pt x="2165" y="831"/>
                </a:lnTo>
                <a:lnTo>
                  <a:pt x="2178" y="829"/>
                </a:lnTo>
                <a:lnTo>
                  <a:pt x="2189" y="829"/>
                </a:lnTo>
                <a:lnTo>
                  <a:pt x="2202" y="827"/>
                </a:lnTo>
                <a:lnTo>
                  <a:pt x="2214" y="827"/>
                </a:lnTo>
                <a:lnTo>
                  <a:pt x="2227" y="826"/>
                </a:lnTo>
                <a:lnTo>
                  <a:pt x="2238" y="826"/>
                </a:lnTo>
                <a:lnTo>
                  <a:pt x="2250" y="827"/>
                </a:lnTo>
                <a:lnTo>
                  <a:pt x="2263" y="826"/>
                </a:lnTo>
                <a:lnTo>
                  <a:pt x="2274" y="824"/>
                </a:lnTo>
                <a:lnTo>
                  <a:pt x="2287" y="824"/>
                </a:lnTo>
                <a:lnTo>
                  <a:pt x="2299" y="824"/>
                </a:lnTo>
                <a:lnTo>
                  <a:pt x="2310" y="822"/>
                </a:lnTo>
                <a:lnTo>
                  <a:pt x="2323" y="821"/>
                </a:lnTo>
                <a:lnTo>
                  <a:pt x="2335" y="821"/>
                </a:lnTo>
                <a:lnTo>
                  <a:pt x="2348" y="819"/>
                </a:lnTo>
                <a:lnTo>
                  <a:pt x="2359" y="824"/>
                </a:lnTo>
                <a:lnTo>
                  <a:pt x="2372" y="832"/>
                </a:lnTo>
                <a:lnTo>
                  <a:pt x="2384" y="832"/>
                </a:lnTo>
                <a:lnTo>
                  <a:pt x="2395" y="837"/>
                </a:lnTo>
                <a:lnTo>
                  <a:pt x="2408" y="884"/>
                </a:lnTo>
                <a:lnTo>
                  <a:pt x="2420" y="852"/>
                </a:lnTo>
                <a:lnTo>
                  <a:pt x="2433" y="780"/>
                </a:lnTo>
                <a:lnTo>
                  <a:pt x="2444" y="788"/>
                </a:lnTo>
                <a:lnTo>
                  <a:pt x="2455" y="800"/>
                </a:lnTo>
                <a:lnTo>
                  <a:pt x="2468" y="806"/>
                </a:lnTo>
                <a:lnTo>
                  <a:pt x="2480" y="811"/>
                </a:lnTo>
                <a:lnTo>
                  <a:pt x="2493" y="814"/>
                </a:lnTo>
                <a:lnTo>
                  <a:pt x="2504" y="818"/>
                </a:lnTo>
                <a:lnTo>
                  <a:pt x="2517" y="819"/>
                </a:lnTo>
                <a:lnTo>
                  <a:pt x="2529" y="821"/>
                </a:lnTo>
                <a:lnTo>
                  <a:pt x="2540" y="822"/>
                </a:lnTo>
                <a:lnTo>
                  <a:pt x="2553" y="822"/>
                </a:lnTo>
                <a:lnTo>
                  <a:pt x="2565" y="822"/>
                </a:lnTo>
                <a:lnTo>
                  <a:pt x="2578" y="824"/>
                </a:lnTo>
                <a:lnTo>
                  <a:pt x="2589" y="826"/>
                </a:lnTo>
                <a:lnTo>
                  <a:pt x="2601" y="826"/>
                </a:lnTo>
                <a:lnTo>
                  <a:pt x="2614" y="826"/>
                </a:lnTo>
                <a:lnTo>
                  <a:pt x="2625" y="827"/>
                </a:lnTo>
                <a:lnTo>
                  <a:pt x="2638" y="829"/>
                </a:lnTo>
                <a:lnTo>
                  <a:pt x="2650" y="831"/>
                </a:lnTo>
                <a:lnTo>
                  <a:pt x="2661" y="831"/>
                </a:lnTo>
                <a:lnTo>
                  <a:pt x="2674" y="831"/>
                </a:lnTo>
                <a:lnTo>
                  <a:pt x="2685" y="829"/>
                </a:lnTo>
                <a:lnTo>
                  <a:pt x="2699" y="831"/>
                </a:lnTo>
                <a:lnTo>
                  <a:pt x="2710" y="831"/>
                </a:lnTo>
                <a:lnTo>
                  <a:pt x="2723" y="831"/>
                </a:lnTo>
                <a:lnTo>
                  <a:pt x="2734" y="831"/>
                </a:lnTo>
                <a:lnTo>
                  <a:pt x="2746" y="831"/>
                </a:lnTo>
                <a:lnTo>
                  <a:pt x="2759" y="831"/>
                </a:lnTo>
                <a:lnTo>
                  <a:pt x="2770" y="832"/>
                </a:lnTo>
                <a:lnTo>
                  <a:pt x="2783" y="832"/>
                </a:lnTo>
                <a:lnTo>
                  <a:pt x="2795" y="832"/>
                </a:lnTo>
                <a:lnTo>
                  <a:pt x="2806" y="832"/>
                </a:lnTo>
                <a:lnTo>
                  <a:pt x="2819" y="832"/>
                </a:lnTo>
                <a:lnTo>
                  <a:pt x="2831" y="832"/>
                </a:lnTo>
                <a:lnTo>
                  <a:pt x="2844" y="831"/>
                </a:lnTo>
                <a:lnTo>
                  <a:pt x="2855" y="832"/>
                </a:lnTo>
                <a:lnTo>
                  <a:pt x="2868" y="832"/>
                </a:lnTo>
                <a:lnTo>
                  <a:pt x="2880" y="832"/>
                </a:lnTo>
                <a:lnTo>
                  <a:pt x="2891" y="831"/>
                </a:lnTo>
                <a:lnTo>
                  <a:pt x="2904" y="831"/>
                </a:lnTo>
                <a:lnTo>
                  <a:pt x="2916" y="831"/>
                </a:lnTo>
                <a:lnTo>
                  <a:pt x="2929" y="832"/>
                </a:lnTo>
                <a:lnTo>
                  <a:pt x="2940" y="831"/>
                </a:lnTo>
                <a:lnTo>
                  <a:pt x="2951" y="832"/>
                </a:lnTo>
                <a:lnTo>
                  <a:pt x="2965" y="834"/>
                </a:lnTo>
                <a:lnTo>
                  <a:pt x="2976" y="832"/>
                </a:lnTo>
                <a:lnTo>
                  <a:pt x="2989" y="832"/>
                </a:lnTo>
                <a:lnTo>
                  <a:pt x="3000" y="834"/>
                </a:lnTo>
                <a:lnTo>
                  <a:pt x="3012" y="832"/>
                </a:lnTo>
                <a:lnTo>
                  <a:pt x="3025" y="831"/>
                </a:lnTo>
                <a:lnTo>
                  <a:pt x="3036" y="832"/>
                </a:lnTo>
                <a:lnTo>
                  <a:pt x="3049" y="832"/>
                </a:lnTo>
                <a:lnTo>
                  <a:pt x="3061" y="832"/>
                </a:lnTo>
                <a:lnTo>
                  <a:pt x="3074" y="832"/>
                </a:lnTo>
                <a:lnTo>
                  <a:pt x="3085" y="832"/>
                </a:lnTo>
                <a:lnTo>
                  <a:pt x="3097" y="832"/>
                </a:lnTo>
                <a:lnTo>
                  <a:pt x="3110" y="832"/>
                </a:lnTo>
                <a:lnTo>
                  <a:pt x="3121" y="831"/>
                </a:lnTo>
                <a:lnTo>
                  <a:pt x="3134" y="832"/>
                </a:lnTo>
                <a:lnTo>
                  <a:pt x="3146" y="832"/>
                </a:lnTo>
                <a:lnTo>
                  <a:pt x="3157" y="832"/>
                </a:lnTo>
                <a:lnTo>
                  <a:pt x="3170" y="832"/>
                </a:lnTo>
                <a:lnTo>
                  <a:pt x="3182" y="831"/>
                </a:lnTo>
                <a:lnTo>
                  <a:pt x="3195" y="832"/>
                </a:lnTo>
                <a:lnTo>
                  <a:pt x="3206" y="831"/>
                </a:lnTo>
                <a:lnTo>
                  <a:pt x="3219" y="834"/>
                </a:lnTo>
                <a:lnTo>
                  <a:pt x="3230" y="834"/>
                </a:lnTo>
                <a:lnTo>
                  <a:pt x="3242" y="832"/>
                </a:lnTo>
                <a:lnTo>
                  <a:pt x="3255" y="834"/>
                </a:lnTo>
                <a:lnTo>
                  <a:pt x="3266" y="834"/>
                </a:lnTo>
                <a:lnTo>
                  <a:pt x="3279" y="832"/>
                </a:lnTo>
                <a:lnTo>
                  <a:pt x="3291" y="834"/>
                </a:lnTo>
                <a:lnTo>
                  <a:pt x="3302" y="834"/>
                </a:lnTo>
                <a:lnTo>
                  <a:pt x="3315" y="834"/>
                </a:lnTo>
                <a:lnTo>
                  <a:pt x="3327" y="832"/>
                </a:lnTo>
                <a:lnTo>
                  <a:pt x="3340" y="834"/>
                </a:lnTo>
                <a:lnTo>
                  <a:pt x="3351" y="834"/>
                </a:lnTo>
                <a:lnTo>
                  <a:pt x="3364" y="834"/>
                </a:lnTo>
                <a:lnTo>
                  <a:pt x="3376" y="834"/>
                </a:lnTo>
                <a:lnTo>
                  <a:pt x="3387" y="832"/>
                </a:lnTo>
                <a:lnTo>
                  <a:pt x="3400" y="832"/>
                </a:lnTo>
                <a:lnTo>
                  <a:pt x="3412" y="832"/>
                </a:lnTo>
                <a:lnTo>
                  <a:pt x="3425" y="834"/>
                </a:lnTo>
                <a:lnTo>
                  <a:pt x="3436" y="832"/>
                </a:lnTo>
                <a:lnTo>
                  <a:pt x="3447" y="832"/>
                </a:lnTo>
                <a:lnTo>
                  <a:pt x="3461" y="832"/>
                </a:lnTo>
                <a:lnTo>
                  <a:pt x="3472" y="832"/>
                </a:lnTo>
                <a:lnTo>
                  <a:pt x="3485" y="832"/>
                </a:lnTo>
                <a:lnTo>
                  <a:pt x="3496" y="832"/>
                </a:lnTo>
                <a:lnTo>
                  <a:pt x="3508" y="834"/>
                </a:lnTo>
                <a:lnTo>
                  <a:pt x="3521" y="834"/>
                </a:lnTo>
                <a:lnTo>
                  <a:pt x="3532" y="832"/>
                </a:lnTo>
                <a:lnTo>
                  <a:pt x="3545" y="832"/>
                </a:lnTo>
                <a:lnTo>
                  <a:pt x="3557" y="831"/>
                </a:lnTo>
                <a:lnTo>
                  <a:pt x="3570" y="831"/>
                </a:lnTo>
                <a:lnTo>
                  <a:pt x="3581" y="831"/>
                </a:lnTo>
                <a:lnTo>
                  <a:pt x="3593" y="831"/>
                </a:lnTo>
                <a:lnTo>
                  <a:pt x="3606" y="831"/>
                </a:lnTo>
                <a:lnTo>
                  <a:pt x="3617" y="832"/>
                </a:lnTo>
                <a:lnTo>
                  <a:pt x="3630" y="831"/>
                </a:lnTo>
                <a:lnTo>
                  <a:pt x="3642" y="831"/>
                </a:lnTo>
                <a:lnTo>
                  <a:pt x="3653" y="832"/>
                </a:lnTo>
                <a:lnTo>
                  <a:pt x="3666" y="831"/>
                </a:lnTo>
                <a:lnTo>
                  <a:pt x="3678" y="832"/>
                </a:lnTo>
                <a:lnTo>
                  <a:pt x="3691" y="831"/>
                </a:lnTo>
                <a:lnTo>
                  <a:pt x="3702" y="831"/>
                </a:lnTo>
                <a:lnTo>
                  <a:pt x="3715" y="831"/>
                </a:lnTo>
                <a:lnTo>
                  <a:pt x="3727" y="831"/>
                </a:lnTo>
                <a:lnTo>
                  <a:pt x="3738" y="829"/>
                </a:lnTo>
                <a:lnTo>
                  <a:pt x="3751" y="829"/>
                </a:lnTo>
                <a:lnTo>
                  <a:pt x="3762" y="829"/>
                </a:lnTo>
                <a:lnTo>
                  <a:pt x="3775" y="831"/>
                </a:lnTo>
                <a:lnTo>
                  <a:pt x="3787" y="829"/>
                </a:lnTo>
                <a:lnTo>
                  <a:pt x="3798" y="829"/>
                </a:lnTo>
                <a:lnTo>
                  <a:pt x="3811" y="829"/>
                </a:lnTo>
                <a:lnTo>
                  <a:pt x="3823" y="831"/>
                </a:lnTo>
                <a:lnTo>
                  <a:pt x="3836" y="829"/>
                </a:lnTo>
                <a:lnTo>
                  <a:pt x="3847" y="829"/>
                </a:lnTo>
                <a:lnTo>
                  <a:pt x="3859" y="831"/>
                </a:lnTo>
                <a:lnTo>
                  <a:pt x="3872" y="829"/>
                </a:lnTo>
                <a:lnTo>
                  <a:pt x="3883" y="829"/>
                </a:lnTo>
                <a:lnTo>
                  <a:pt x="3896" y="831"/>
                </a:lnTo>
                <a:lnTo>
                  <a:pt x="3908" y="829"/>
                </a:lnTo>
                <a:lnTo>
                  <a:pt x="3921" y="829"/>
                </a:lnTo>
                <a:lnTo>
                  <a:pt x="3932" y="827"/>
                </a:lnTo>
                <a:lnTo>
                  <a:pt x="3944" y="827"/>
                </a:lnTo>
                <a:lnTo>
                  <a:pt x="3957" y="827"/>
                </a:lnTo>
                <a:lnTo>
                  <a:pt x="3968" y="827"/>
                </a:lnTo>
                <a:lnTo>
                  <a:pt x="3981" y="829"/>
                </a:lnTo>
                <a:lnTo>
                  <a:pt x="3992" y="827"/>
                </a:lnTo>
                <a:lnTo>
                  <a:pt x="4004" y="827"/>
                </a:lnTo>
                <a:lnTo>
                  <a:pt x="4017" y="827"/>
                </a:lnTo>
                <a:lnTo>
                  <a:pt x="4028" y="827"/>
                </a:lnTo>
                <a:lnTo>
                  <a:pt x="4041" y="822"/>
                </a:lnTo>
                <a:lnTo>
                  <a:pt x="4053" y="824"/>
                </a:lnTo>
                <a:lnTo>
                  <a:pt x="4066" y="826"/>
                </a:lnTo>
                <a:lnTo>
                  <a:pt x="4077" y="826"/>
                </a:lnTo>
                <a:lnTo>
                  <a:pt x="4089" y="827"/>
                </a:lnTo>
                <a:lnTo>
                  <a:pt x="4102" y="827"/>
                </a:lnTo>
                <a:lnTo>
                  <a:pt x="4113" y="826"/>
                </a:lnTo>
                <a:lnTo>
                  <a:pt x="4126" y="826"/>
                </a:lnTo>
                <a:lnTo>
                  <a:pt x="4138" y="827"/>
                </a:lnTo>
                <a:lnTo>
                  <a:pt x="4149" y="826"/>
                </a:lnTo>
                <a:lnTo>
                  <a:pt x="4162" y="827"/>
                </a:lnTo>
                <a:lnTo>
                  <a:pt x="4174" y="827"/>
                </a:lnTo>
              </a:path>
            </a:pathLst>
          </a:custGeom>
          <a:noFill/>
          <a:ln w="19050" cmpd="sng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9" name="Freeform 104"/>
          <p:cNvSpPr>
            <a:spLocks/>
          </p:cNvSpPr>
          <p:nvPr/>
        </p:nvSpPr>
        <p:spPr bwMode="auto">
          <a:xfrm>
            <a:off x="1672431" y="3023237"/>
            <a:ext cx="6626225" cy="3294063"/>
          </a:xfrm>
          <a:custGeom>
            <a:avLst/>
            <a:gdLst>
              <a:gd name="T0" fmla="*/ 60 w 4174"/>
              <a:gd name="T1" fmla="*/ 1436 h 2075"/>
              <a:gd name="T2" fmla="*/ 133 w 4174"/>
              <a:gd name="T3" fmla="*/ 1436 h 2075"/>
              <a:gd name="T4" fmla="*/ 205 w 4174"/>
              <a:gd name="T5" fmla="*/ 1426 h 2075"/>
              <a:gd name="T6" fmla="*/ 279 w 4174"/>
              <a:gd name="T7" fmla="*/ 1491 h 2075"/>
              <a:gd name="T8" fmla="*/ 350 w 4174"/>
              <a:gd name="T9" fmla="*/ 1476 h 2075"/>
              <a:gd name="T10" fmla="*/ 424 w 4174"/>
              <a:gd name="T11" fmla="*/ 1445 h 2075"/>
              <a:gd name="T12" fmla="*/ 496 w 4174"/>
              <a:gd name="T13" fmla="*/ 1442 h 2075"/>
              <a:gd name="T14" fmla="*/ 569 w 4174"/>
              <a:gd name="T15" fmla="*/ 1436 h 2075"/>
              <a:gd name="T16" fmla="*/ 641 w 4174"/>
              <a:gd name="T17" fmla="*/ 1432 h 2075"/>
              <a:gd name="T18" fmla="*/ 714 w 4174"/>
              <a:gd name="T19" fmla="*/ 1432 h 2075"/>
              <a:gd name="T20" fmla="*/ 786 w 4174"/>
              <a:gd name="T21" fmla="*/ 1431 h 2075"/>
              <a:gd name="T22" fmla="*/ 860 w 4174"/>
              <a:gd name="T23" fmla="*/ 1427 h 2075"/>
              <a:gd name="T24" fmla="*/ 931 w 4174"/>
              <a:gd name="T25" fmla="*/ 1426 h 2075"/>
              <a:gd name="T26" fmla="*/ 1005 w 4174"/>
              <a:gd name="T27" fmla="*/ 1424 h 2075"/>
              <a:gd name="T28" fmla="*/ 1077 w 4174"/>
              <a:gd name="T29" fmla="*/ 1421 h 2075"/>
              <a:gd name="T30" fmla="*/ 1150 w 4174"/>
              <a:gd name="T31" fmla="*/ 1419 h 2075"/>
              <a:gd name="T32" fmla="*/ 1222 w 4174"/>
              <a:gd name="T33" fmla="*/ 1416 h 2075"/>
              <a:gd name="T34" fmla="*/ 1295 w 4174"/>
              <a:gd name="T35" fmla="*/ 1413 h 2075"/>
              <a:gd name="T36" fmla="*/ 1367 w 4174"/>
              <a:gd name="T37" fmla="*/ 1411 h 2075"/>
              <a:gd name="T38" fmla="*/ 1440 w 4174"/>
              <a:gd name="T39" fmla="*/ 1409 h 2075"/>
              <a:gd name="T40" fmla="*/ 1512 w 4174"/>
              <a:gd name="T41" fmla="*/ 1406 h 2075"/>
              <a:gd name="T42" fmla="*/ 1586 w 4174"/>
              <a:gd name="T43" fmla="*/ 1406 h 2075"/>
              <a:gd name="T44" fmla="*/ 1657 w 4174"/>
              <a:gd name="T45" fmla="*/ 1405 h 2075"/>
              <a:gd name="T46" fmla="*/ 1731 w 4174"/>
              <a:gd name="T47" fmla="*/ 1401 h 2075"/>
              <a:gd name="T48" fmla="*/ 1803 w 4174"/>
              <a:gd name="T49" fmla="*/ 1400 h 2075"/>
              <a:gd name="T50" fmla="*/ 1876 w 4174"/>
              <a:gd name="T51" fmla="*/ 1395 h 2075"/>
              <a:gd name="T52" fmla="*/ 1948 w 4174"/>
              <a:gd name="T53" fmla="*/ 1393 h 2075"/>
              <a:gd name="T54" fmla="*/ 2021 w 4174"/>
              <a:gd name="T55" fmla="*/ 1393 h 2075"/>
              <a:gd name="T56" fmla="*/ 2093 w 4174"/>
              <a:gd name="T57" fmla="*/ 1390 h 2075"/>
              <a:gd name="T58" fmla="*/ 2165 w 4174"/>
              <a:gd name="T59" fmla="*/ 1388 h 2075"/>
              <a:gd name="T60" fmla="*/ 2238 w 4174"/>
              <a:gd name="T61" fmla="*/ 1385 h 2075"/>
              <a:gd name="T62" fmla="*/ 2310 w 4174"/>
              <a:gd name="T63" fmla="*/ 1385 h 2075"/>
              <a:gd name="T64" fmla="*/ 2384 w 4174"/>
              <a:gd name="T65" fmla="*/ 1398 h 2075"/>
              <a:gd name="T66" fmla="*/ 2455 w 4174"/>
              <a:gd name="T67" fmla="*/ 1359 h 2075"/>
              <a:gd name="T68" fmla="*/ 2529 w 4174"/>
              <a:gd name="T69" fmla="*/ 1382 h 2075"/>
              <a:gd name="T70" fmla="*/ 2601 w 4174"/>
              <a:gd name="T71" fmla="*/ 1393 h 2075"/>
              <a:gd name="T72" fmla="*/ 2674 w 4174"/>
              <a:gd name="T73" fmla="*/ 1396 h 2075"/>
              <a:gd name="T74" fmla="*/ 2746 w 4174"/>
              <a:gd name="T75" fmla="*/ 1401 h 2075"/>
              <a:gd name="T76" fmla="*/ 2819 w 4174"/>
              <a:gd name="T77" fmla="*/ 1400 h 2075"/>
              <a:gd name="T78" fmla="*/ 2891 w 4174"/>
              <a:gd name="T79" fmla="*/ 1403 h 2075"/>
              <a:gd name="T80" fmla="*/ 2965 w 4174"/>
              <a:gd name="T81" fmla="*/ 1400 h 2075"/>
              <a:gd name="T82" fmla="*/ 3036 w 4174"/>
              <a:gd name="T83" fmla="*/ 1401 h 2075"/>
              <a:gd name="T84" fmla="*/ 3110 w 4174"/>
              <a:gd name="T85" fmla="*/ 1400 h 2075"/>
              <a:gd name="T86" fmla="*/ 3182 w 4174"/>
              <a:gd name="T87" fmla="*/ 1400 h 2075"/>
              <a:gd name="T88" fmla="*/ 3255 w 4174"/>
              <a:gd name="T89" fmla="*/ 1400 h 2075"/>
              <a:gd name="T90" fmla="*/ 3327 w 4174"/>
              <a:gd name="T91" fmla="*/ 1403 h 2075"/>
              <a:gd name="T92" fmla="*/ 3400 w 4174"/>
              <a:gd name="T93" fmla="*/ 1401 h 2075"/>
              <a:gd name="T94" fmla="*/ 3472 w 4174"/>
              <a:gd name="T95" fmla="*/ 1400 h 2075"/>
              <a:gd name="T96" fmla="*/ 3545 w 4174"/>
              <a:gd name="T97" fmla="*/ 1400 h 2075"/>
              <a:gd name="T98" fmla="*/ 3617 w 4174"/>
              <a:gd name="T99" fmla="*/ 1400 h 2075"/>
              <a:gd name="T100" fmla="*/ 3691 w 4174"/>
              <a:gd name="T101" fmla="*/ 1400 h 2075"/>
              <a:gd name="T102" fmla="*/ 3762 w 4174"/>
              <a:gd name="T103" fmla="*/ 1401 h 2075"/>
              <a:gd name="T104" fmla="*/ 3836 w 4174"/>
              <a:gd name="T105" fmla="*/ 1401 h 2075"/>
              <a:gd name="T106" fmla="*/ 3908 w 4174"/>
              <a:gd name="T107" fmla="*/ 1401 h 2075"/>
              <a:gd name="T108" fmla="*/ 3981 w 4174"/>
              <a:gd name="T109" fmla="*/ 1403 h 2075"/>
              <a:gd name="T110" fmla="*/ 4053 w 4174"/>
              <a:gd name="T111" fmla="*/ 1396 h 2075"/>
              <a:gd name="T112" fmla="*/ 4126 w 4174"/>
              <a:gd name="T113" fmla="*/ 1400 h 20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2075">
                <a:moveTo>
                  <a:pt x="0" y="1436"/>
                </a:moveTo>
                <a:lnTo>
                  <a:pt x="13" y="1437"/>
                </a:lnTo>
                <a:lnTo>
                  <a:pt x="24" y="1437"/>
                </a:lnTo>
                <a:lnTo>
                  <a:pt x="37" y="1437"/>
                </a:lnTo>
                <a:lnTo>
                  <a:pt x="49" y="1436"/>
                </a:lnTo>
                <a:lnTo>
                  <a:pt x="60" y="1436"/>
                </a:lnTo>
                <a:lnTo>
                  <a:pt x="73" y="1436"/>
                </a:lnTo>
                <a:lnTo>
                  <a:pt x="85" y="1436"/>
                </a:lnTo>
                <a:lnTo>
                  <a:pt x="98" y="1436"/>
                </a:lnTo>
                <a:lnTo>
                  <a:pt x="109" y="1436"/>
                </a:lnTo>
                <a:lnTo>
                  <a:pt x="120" y="1436"/>
                </a:lnTo>
                <a:lnTo>
                  <a:pt x="133" y="1436"/>
                </a:lnTo>
                <a:lnTo>
                  <a:pt x="145" y="1436"/>
                </a:lnTo>
                <a:lnTo>
                  <a:pt x="158" y="1436"/>
                </a:lnTo>
                <a:lnTo>
                  <a:pt x="169" y="1432"/>
                </a:lnTo>
                <a:lnTo>
                  <a:pt x="182" y="1432"/>
                </a:lnTo>
                <a:lnTo>
                  <a:pt x="194" y="1421"/>
                </a:lnTo>
                <a:lnTo>
                  <a:pt x="205" y="1426"/>
                </a:lnTo>
                <a:lnTo>
                  <a:pt x="218" y="1431"/>
                </a:lnTo>
                <a:lnTo>
                  <a:pt x="230" y="1439"/>
                </a:lnTo>
                <a:lnTo>
                  <a:pt x="243" y="1396"/>
                </a:lnTo>
                <a:lnTo>
                  <a:pt x="254" y="481"/>
                </a:lnTo>
                <a:lnTo>
                  <a:pt x="266" y="0"/>
                </a:lnTo>
                <a:lnTo>
                  <a:pt x="279" y="1491"/>
                </a:lnTo>
                <a:lnTo>
                  <a:pt x="290" y="2075"/>
                </a:lnTo>
                <a:lnTo>
                  <a:pt x="303" y="1886"/>
                </a:lnTo>
                <a:lnTo>
                  <a:pt x="315" y="1666"/>
                </a:lnTo>
                <a:lnTo>
                  <a:pt x="328" y="1555"/>
                </a:lnTo>
                <a:lnTo>
                  <a:pt x="339" y="1502"/>
                </a:lnTo>
                <a:lnTo>
                  <a:pt x="350" y="1476"/>
                </a:lnTo>
                <a:lnTo>
                  <a:pt x="364" y="1463"/>
                </a:lnTo>
                <a:lnTo>
                  <a:pt x="375" y="1458"/>
                </a:lnTo>
                <a:lnTo>
                  <a:pt x="388" y="1453"/>
                </a:lnTo>
                <a:lnTo>
                  <a:pt x="399" y="1449"/>
                </a:lnTo>
                <a:lnTo>
                  <a:pt x="411" y="1447"/>
                </a:lnTo>
                <a:lnTo>
                  <a:pt x="424" y="1445"/>
                </a:lnTo>
                <a:lnTo>
                  <a:pt x="435" y="1445"/>
                </a:lnTo>
                <a:lnTo>
                  <a:pt x="448" y="1444"/>
                </a:lnTo>
                <a:lnTo>
                  <a:pt x="460" y="1444"/>
                </a:lnTo>
                <a:lnTo>
                  <a:pt x="471" y="1444"/>
                </a:lnTo>
                <a:lnTo>
                  <a:pt x="484" y="1442"/>
                </a:lnTo>
                <a:lnTo>
                  <a:pt x="496" y="1442"/>
                </a:lnTo>
                <a:lnTo>
                  <a:pt x="509" y="1440"/>
                </a:lnTo>
                <a:lnTo>
                  <a:pt x="520" y="1439"/>
                </a:lnTo>
                <a:lnTo>
                  <a:pt x="533" y="1440"/>
                </a:lnTo>
                <a:lnTo>
                  <a:pt x="545" y="1439"/>
                </a:lnTo>
                <a:lnTo>
                  <a:pt x="556" y="1437"/>
                </a:lnTo>
                <a:lnTo>
                  <a:pt x="569" y="1436"/>
                </a:lnTo>
                <a:lnTo>
                  <a:pt x="581" y="1436"/>
                </a:lnTo>
                <a:lnTo>
                  <a:pt x="594" y="1436"/>
                </a:lnTo>
                <a:lnTo>
                  <a:pt x="605" y="1436"/>
                </a:lnTo>
                <a:lnTo>
                  <a:pt x="616" y="1436"/>
                </a:lnTo>
                <a:lnTo>
                  <a:pt x="629" y="1434"/>
                </a:lnTo>
                <a:lnTo>
                  <a:pt x="641" y="1432"/>
                </a:lnTo>
                <a:lnTo>
                  <a:pt x="654" y="1432"/>
                </a:lnTo>
                <a:lnTo>
                  <a:pt x="665" y="1432"/>
                </a:lnTo>
                <a:lnTo>
                  <a:pt x="678" y="1432"/>
                </a:lnTo>
                <a:lnTo>
                  <a:pt x="690" y="1432"/>
                </a:lnTo>
                <a:lnTo>
                  <a:pt x="701" y="1432"/>
                </a:lnTo>
                <a:lnTo>
                  <a:pt x="714" y="1432"/>
                </a:lnTo>
                <a:lnTo>
                  <a:pt x="726" y="1431"/>
                </a:lnTo>
                <a:lnTo>
                  <a:pt x="739" y="1431"/>
                </a:lnTo>
                <a:lnTo>
                  <a:pt x="750" y="1431"/>
                </a:lnTo>
                <a:lnTo>
                  <a:pt x="762" y="1431"/>
                </a:lnTo>
                <a:lnTo>
                  <a:pt x="775" y="1431"/>
                </a:lnTo>
                <a:lnTo>
                  <a:pt x="786" y="1431"/>
                </a:lnTo>
                <a:lnTo>
                  <a:pt x="799" y="1431"/>
                </a:lnTo>
                <a:lnTo>
                  <a:pt x="811" y="1429"/>
                </a:lnTo>
                <a:lnTo>
                  <a:pt x="824" y="1427"/>
                </a:lnTo>
                <a:lnTo>
                  <a:pt x="835" y="1429"/>
                </a:lnTo>
                <a:lnTo>
                  <a:pt x="847" y="1427"/>
                </a:lnTo>
                <a:lnTo>
                  <a:pt x="860" y="1427"/>
                </a:lnTo>
                <a:lnTo>
                  <a:pt x="871" y="1426"/>
                </a:lnTo>
                <a:lnTo>
                  <a:pt x="884" y="1427"/>
                </a:lnTo>
                <a:lnTo>
                  <a:pt x="895" y="1427"/>
                </a:lnTo>
                <a:lnTo>
                  <a:pt x="907" y="1426"/>
                </a:lnTo>
                <a:lnTo>
                  <a:pt x="920" y="1426"/>
                </a:lnTo>
                <a:lnTo>
                  <a:pt x="931" y="1426"/>
                </a:lnTo>
                <a:lnTo>
                  <a:pt x="944" y="1426"/>
                </a:lnTo>
                <a:lnTo>
                  <a:pt x="956" y="1426"/>
                </a:lnTo>
                <a:lnTo>
                  <a:pt x="967" y="1426"/>
                </a:lnTo>
                <a:lnTo>
                  <a:pt x="980" y="1426"/>
                </a:lnTo>
                <a:lnTo>
                  <a:pt x="992" y="1426"/>
                </a:lnTo>
                <a:lnTo>
                  <a:pt x="1005" y="1424"/>
                </a:lnTo>
                <a:lnTo>
                  <a:pt x="1016" y="1424"/>
                </a:lnTo>
                <a:lnTo>
                  <a:pt x="1029" y="1424"/>
                </a:lnTo>
                <a:lnTo>
                  <a:pt x="1041" y="1422"/>
                </a:lnTo>
                <a:lnTo>
                  <a:pt x="1052" y="1422"/>
                </a:lnTo>
                <a:lnTo>
                  <a:pt x="1065" y="1421"/>
                </a:lnTo>
                <a:lnTo>
                  <a:pt x="1077" y="1421"/>
                </a:lnTo>
                <a:lnTo>
                  <a:pt x="1090" y="1421"/>
                </a:lnTo>
                <a:lnTo>
                  <a:pt x="1101" y="1419"/>
                </a:lnTo>
                <a:lnTo>
                  <a:pt x="1112" y="1421"/>
                </a:lnTo>
                <a:lnTo>
                  <a:pt x="1126" y="1421"/>
                </a:lnTo>
                <a:lnTo>
                  <a:pt x="1137" y="1421"/>
                </a:lnTo>
                <a:lnTo>
                  <a:pt x="1150" y="1419"/>
                </a:lnTo>
                <a:lnTo>
                  <a:pt x="1161" y="1419"/>
                </a:lnTo>
                <a:lnTo>
                  <a:pt x="1174" y="1419"/>
                </a:lnTo>
                <a:lnTo>
                  <a:pt x="1186" y="1418"/>
                </a:lnTo>
                <a:lnTo>
                  <a:pt x="1197" y="1416"/>
                </a:lnTo>
                <a:lnTo>
                  <a:pt x="1210" y="1416"/>
                </a:lnTo>
                <a:lnTo>
                  <a:pt x="1222" y="1416"/>
                </a:lnTo>
                <a:lnTo>
                  <a:pt x="1235" y="1416"/>
                </a:lnTo>
                <a:lnTo>
                  <a:pt x="1246" y="1416"/>
                </a:lnTo>
                <a:lnTo>
                  <a:pt x="1258" y="1414"/>
                </a:lnTo>
                <a:lnTo>
                  <a:pt x="1271" y="1414"/>
                </a:lnTo>
                <a:lnTo>
                  <a:pt x="1282" y="1414"/>
                </a:lnTo>
                <a:lnTo>
                  <a:pt x="1295" y="1413"/>
                </a:lnTo>
                <a:lnTo>
                  <a:pt x="1307" y="1413"/>
                </a:lnTo>
                <a:lnTo>
                  <a:pt x="1318" y="1413"/>
                </a:lnTo>
                <a:lnTo>
                  <a:pt x="1331" y="1413"/>
                </a:lnTo>
                <a:lnTo>
                  <a:pt x="1343" y="1414"/>
                </a:lnTo>
                <a:lnTo>
                  <a:pt x="1356" y="1413"/>
                </a:lnTo>
                <a:lnTo>
                  <a:pt x="1367" y="1411"/>
                </a:lnTo>
                <a:lnTo>
                  <a:pt x="1380" y="1409"/>
                </a:lnTo>
                <a:lnTo>
                  <a:pt x="1392" y="1411"/>
                </a:lnTo>
                <a:lnTo>
                  <a:pt x="1403" y="1409"/>
                </a:lnTo>
                <a:lnTo>
                  <a:pt x="1416" y="1409"/>
                </a:lnTo>
                <a:lnTo>
                  <a:pt x="1427" y="1408"/>
                </a:lnTo>
                <a:lnTo>
                  <a:pt x="1440" y="1409"/>
                </a:lnTo>
                <a:lnTo>
                  <a:pt x="1452" y="1408"/>
                </a:lnTo>
                <a:lnTo>
                  <a:pt x="1463" y="1408"/>
                </a:lnTo>
                <a:lnTo>
                  <a:pt x="1476" y="1409"/>
                </a:lnTo>
                <a:lnTo>
                  <a:pt x="1488" y="1409"/>
                </a:lnTo>
                <a:lnTo>
                  <a:pt x="1501" y="1408"/>
                </a:lnTo>
                <a:lnTo>
                  <a:pt x="1512" y="1406"/>
                </a:lnTo>
                <a:lnTo>
                  <a:pt x="1525" y="1405"/>
                </a:lnTo>
                <a:lnTo>
                  <a:pt x="1537" y="1406"/>
                </a:lnTo>
                <a:lnTo>
                  <a:pt x="1548" y="1408"/>
                </a:lnTo>
                <a:lnTo>
                  <a:pt x="1561" y="1408"/>
                </a:lnTo>
                <a:lnTo>
                  <a:pt x="1573" y="1408"/>
                </a:lnTo>
                <a:lnTo>
                  <a:pt x="1586" y="1406"/>
                </a:lnTo>
                <a:lnTo>
                  <a:pt x="1597" y="1406"/>
                </a:lnTo>
                <a:lnTo>
                  <a:pt x="1609" y="1405"/>
                </a:lnTo>
                <a:lnTo>
                  <a:pt x="1622" y="1405"/>
                </a:lnTo>
                <a:lnTo>
                  <a:pt x="1633" y="1406"/>
                </a:lnTo>
                <a:lnTo>
                  <a:pt x="1646" y="1405"/>
                </a:lnTo>
                <a:lnTo>
                  <a:pt x="1657" y="1405"/>
                </a:lnTo>
                <a:lnTo>
                  <a:pt x="1671" y="1405"/>
                </a:lnTo>
                <a:lnTo>
                  <a:pt x="1682" y="1405"/>
                </a:lnTo>
                <a:lnTo>
                  <a:pt x="1693" y="1403"/>
                </a:lnTo>
                <a:lnTo>
                  <a:pt x="1706" y="1403"/>
                </a:lnTo>
                <a:lnTo>
                  <a:pt x="1718" y="1403"/>
                </a:lnTo>
                <a:lnTo>
                  <a:pt x="1731" y="1401"/>
                </a:lnTo>
                <a:lnTo>
                  <a:pt x="1742" y="1401"/>
                </a:lnTo>
                <a:lnTo>
                  <a:pt x="1754" y="1401"/>
                </a:lnTo>
                <a:lnTo>
                  <a:pt x="1767" y="1400"/>
                </a:lnTo>
                <a:lnTo>
                  <a:pt x="1778" y="1400"/>
                </a:lnTo>
                <a:lnTo>
                  <a:pt x="1791" y="1400"/>
                </a:lnTo>
                <a:lnTo>
                  <a:pt x="1803" y="1400"/>
                </a:lnTo>
                <a:lnTo>
                  <a:pt x="1814" y="1398"/>
                </a:lnTo>
                <a:lnTo>
                  <a:pt x="1827" y="1398"/>
                </a:lnTo>
                <a:lnTo>
                  <a:pt x="1839" y="1396"/>
                </a:lnTo>
                <a:lnTo>
                  <a:pt x="1852" y="1396"/>
                </a:lnTo>
                <a:lnTo>
                  <a:pt x="1863" y="1395"/>
                </a:lnTo>
                <a:lnTo>
                  <a:pt x="1876" y="1395"/>
                </a:lnTo>
                <a:lnTo>
                  <a:pt x="1888" y="1395"/>
                </a:lnTo>
                <a:lnTo>
                  <a:pt x="1899" y="1395"/>
                </a:lnTo>
                <a:lnTo>
                  <a:pt x="1912" y="1395"/>
                </a:lnTo>
                <a:lnTo>
                  <a:pt x="1923" y="1395"/>
                </a:lnTo>
                <a:lnTo>
                  <a:pt x="1937" y="1393"/>
                </a:lnTo>
                <a:lnTo>
                  <a:pt x="1948" y="1393"/>
                </a:lnTo>
                <a:lnTo>
                  <a:pt x="1959" y="1393"/>
                </a:lnTo>
                <a:lnTo>
                  <a:pt x="1972" y="1395"/>
                </a:lnTo>
                <a:lnTo>
                  <a:pt x="1984" y="1395"/>
                </a:lnTo>
                <a:lnTo>
                  <a:pt x="1997" y="1393"/>
                </a:lnTo>
                <a:lnTo>
                  <a:pt x="2008" y="1395"/>
                </a:lnTo>
                <a:lnTo>
                  <a:pt x="2021" y="1393"/>
                </a:lnTo>
                <a:lnTo>
                  <a:pt x="2033" y="1391"/>
                </a:lnTo>
                <a:lnTo>
                  <a:pt x="2044" y="1391"/>
                </a:lnTo>
                <a:lnTo>
                  <a:pt x="2057" y="1391"/>
                </a:lnTo>
                <a:lnTo>
                  <a:pt x="2069" y="1390"/>
                </a:lnTo>
                <a:lnTo>
                  <a:pt x="2082" y="1390"/>
                </a:lnTo>
                <a:lnTo>
                  <a:pt x="2093" y="1390"/>
                </a:lnTo>
                <a:lnTo>
                  <a:pt x="2105" y="1390"/>
                </a:lnTo>
                <a:lnTo>
                  <a:pt x="2118" y="1390"/>
                </a:lnTo>
                <a:lnTo>
                  <a:pt x="2129" y="1390"/>
                </a:lnTo>
                <a:lnTo>
                  <a:pt x="2142" y="1388"/>
                </a:lnTo>
                <a:lnTo>
                  <a:pt x="2154" y="1388"/>
                </a:lnTo>
                <a:lnTo>
                  <a:pt x="2165" y="1388"/>
                </a:lnTo>
                <a:lnTo>
                  <a:pt x="2178" y="1388"/>
                </a:lnTo>
                <a:lnTo>
                  <a:pt x="2189" y="1388"/>
                </a:lnTo>
                <a:lnTo>
                  <a:pt x="2202" y="1388"/>
                </a:lnTo>
                <a:lnTo>
                  <a:pt x="2214" y="1387"/>
                </a:lnTo>
                <a:lnTo>
                  <a:pt x="2227" y="1387"/>
                </a:lnTo>
                <a:lnTo>
                  <a:pt x="2238" y="1385"/>
                </a:lnTo>
                <a:lnTo>
                  <a:pt x="2250" y="1385"/>
                </a:lnTo>
                <a:lnTo>
                  <a:pt x="2263" y="1385"/>
                </a:lnTo>
                <a:lnTo>
                  <a:pt x="2274" y="1385"/>
                </a:lnTo>
                <a:lnTo>
                  <a:pt x="2287" y="1385"/>
                </a:lnTo>
                <a:lnTo>
                  <a:pt x="2299" y="1385"/>
                </a:lnTo>
                <a:lnTo>
                  <a:pt x="2310" y="1385"/>
                </a:lnTo>
                <a:lnTo>
                  <a:pt x="2323" y="1383"/>
                </a:lnTo>
                <a:lnTo>
                  <a:pt x="2335" y="1383"/>
                </a:lnTo>
                <a:lnTo>
                  <a:pt x="2348" y="1383"/>
                </a:lnTo>
                <a:lnTo>
                  <a:pt x="2359" y="1393"/>
                </a:lnTo>
                <a:lnTo>
                  <a:pt x="2372" y="1398"/>
                </a:lnTo>
                <a:lnTo>
                  <a:pt x="2384" y="1398"/>
                </a:lnTo>
                <a:lnTo>
                  <a:pt x="2395" y="1409"/>
                </a:lnTo>
                <a:lnTo>
                  <a:pt x="2408" y="1458"/>
                </a:lnTo>
                <a:lnTo>
                  <a:pt x="2420" y="1411"/>
                </a:lnTo>
                <a:lnTo>
                  <a:pt x="2433" y="1334"/>
                </a:lnTo>
                <a:lnTo>
                  <a:pt x="2444" y="1346"/>
                </a:lnTo>
                <a:lnTo>
                  <a:pt x="2455" y="1359"/>
                </a:lnTo>
                <a:lnTo>
                  <a:pt x="2468" y="1365"/>
                </a:lnTo>
                <a:lnTo>
                  <a:pt x="2480" y="1372"/>
                </a:lnTo>
                <a:lnTo>
                  <a:pt x="2493" y="1375"/>
                </a:lnTo>
                <a:lnTo>
                  <a:pt x="2504" y="1378"/>
                </a:lnTo>
                <a:lnTo>
                  <a:pt x="2517" y="1380"/>
                </a:lnTo>
                <a:lnTo>
                  <a:pt x="2529" y="1382"/>
                </a:lnTo>
                <a:lnTo>
                  <a:pt x="2540" y="1385"/>
                </a:lnTo>
                <a:lnTo>
                  <a:pt x="2553" y="1387"/>
                </a:lnTo>
                <a:lnTo>
                  <a:pt x="2565" y="1390"/>
                </a:lnTo>
                <a:lnTo>
                  <a:pt x="2578" y="1391"/>
                </a:lnTo>
                <a:lnTo>
                  <a:pt x="2589" y="1391"/>
                </a:lnTo>
                <a:lnTo>
                  <a:pt x="2601" y="1393"/>
                </a:lnTo>
                <a:lnTo>
                  <a:pt x="2614" y="1393"/>
                </a:lnTo>
                <a:lnTo>
                  <a:pt x="2625" y="1395"/>
                </a:lnTo>
                <a:lnTo>
                  <a:pt x="2638" y="1396"/>
                </a:lnTo>
                <a:lnTo>
                  <a:pt x="2650" y="1395"/>
                </a:lnTo>
                <a:lnTo>
                  <a:pt x="2661" y="1396"/>
                </a:lnTo>
                <a:lnTo>
                  <a:pt x="2674" y="1396"/>
                </a:lnTo>
                <a:lnTo>
                  <a:pt x="2685" y="1396"/>
                </a:lnTo>
                <a:lnTo>
                  <a:pt x="2699" y="1396"/>
                </a:lnTo>
                <a:lnTo>
                  <a:pt x="2710" y="1396"/>
                </a:lnTo>
                <a:lnTo>
                  <a:pt x="2723" y="1400"/>
                </a:lnTo>
                <a:lnTo>
                  <a:pt x="2734" y="1401"/>
                </a:lnTo>
                <a:lnTo>
                  <a:pt x="2746" y="1401"/>
                </a:lnTo>
                <a:lnTo>
                  <a:pt x="2759" y="1401"/>
                </a:lnTo>
                <a:lnTo>
                  <a:pt x="2770" y="1400"/>
                </a:lnTo>
                <a:lnTo>
                  <a:pt x="2783" y="1400"/>
                </a:lnTo>
                <a:lnTo>
                  <a:pt x="2795" y="1401"/>
                </a:lnTo>
                <a:lnTo>
                  <a:pt x="2806" y="1400"/>
                </a:lnTo>
                <a:lnTo>
                  <a:pt x="2819" y="1400"/>
                </a:lnTo>
                <a:lnTo>
                  <a:pt x="2831" y="1400"/>
                </a:lnTo>
                <a:lnTo>
                  <a:pt x="2844" y="1400"/>
                </a:lnTo>
                <a:lnTo>
                  <a:pt x="2855" y="1398"/>
                </a:lnTo>
                <a:lnTo>
                  <a:pt x="2868" y="1401"/>
                </a:lnTo>
                <a:lnTo>
                  <a:pt x="2880" y="1401"/>
                </a:lnTo>
                <a:lnTo>
                  <a:pt x="2891" y="1403"/>
                </a:lnTo>
                <a:lnTo>
                  <a:pt x="2904" y="1401"/>
                </a:lnTo>
                <a:lnTo>
                  <a:pt x="2916" y="1401"/>
                </a:lnTo>
                <a:lnTo>
                  <a:pt x="2929" y="1401"/>
                </a:lnTo>
                <a:lnTo>
                  <a:pt x="2940" y="1401"/>
                </a:lnTo>
                <a:lnTo>
                  <a:pt x="2951" y="1401"/>
                </a:lnTo>
                <a:lnTo>
                  <a:pt x="2965" y="1400"/>
                </a:lnTo>
                <a:lnTo>
                  <a:pt x="2976" y="1400"/>
                </a:lnTo>
                <a:lnTo>
                  <a:pt x="2989" y="1401"/>
                </a:lnTo>
                <a:lnTo>
                  <a:pt x="3000" y="1400"/>
                </a:lnTo>
                <a:lnTo>
                  <a:pt x="3012" y="1400"/>
                </a:lnTo>
                <a:lnTo>
                  <a:pt x="3025" y="1401"/>
                </a:lnTo>
                <a:lnTo>
                  <a:pt x="3036" y="1401"/>
                </a:lnTo>
                <a:lnTo>
                  <a:pt x="3049" y="1400"/>
                </a:lnTo>
                <a:lnTo>
                  <a:pt x="3061" y="1401"/>
                </a:lnTo>
                <a:lnTo>
                  <a:pt x="3074" y="1401"/>
                </a:lnTo>
                <a:lnTo>
                  <a:pt x="3085" y="1400"/>
                </a:lnTo>
                <a:lnTo>
                  <a:pt x="3097" y="1401"/>
                </a:lnTo>
                <a:lnTo>
                  <a:pt x="3110" y="1400"/>
                </a:lnTo>
                <a:lnTo>
                  <a:pt x="3121" y="1400"/>
                </a:lnTo>
                <a:lnTo>
                  <a:pt x="3134" y="1400"/>
                </a:lnTo>
                <a:lnTo>
                  <a:pt x="3146" y="1400"/>
                </a:lnTo>
                <a:lnTo>
                  <a:pt x="3157" y="1400"/>
                </a:lnTo>
                <a:lnTo>
                  <a:pt x="3170" y="1401"/>
                </a:lnTo>
                <a:lnTo>
                  <a:pt x="3182" y="1400"/>
                </a:lnTo>
                <a:lnTo>
                  <a:pt x="3195" y="1401"/>
                </a:lnTo>
                <a:lnTo>
                  <a:pt x="3206" y="1400"/>
                </a:lnTo>
                <a:lnTo>
                  <a:pt x="3219" y="1401"/>
                </a:lnTo>
                <a:lnTo>
                  <a:pt x="3230" y="1401"/>
                </a:lnTo>
                <a:lnTo>
                  <a:pt x="3242" y="1400"/>
                </a:lnTo>
                <a:lnTo>
                  <a:pt x="3255" y="1400"/>
                </a:lnTo>
                <a:lnTo>
                  <a:pt x="3266" y="1401"/>
                </a:lnTo>
                <a:lnTo>
                  <a:pt x="3279" y="1401"/>
                </a:lnTo>
                <a:lnTo>
                  <a:pt x="3291" y="1401"/>
                </a:lnTo>
                <a:lnTo>
                  <a:pt x="3302" y="1401"/>
                </a:lnTo>
                <a:lnTo>
                  <a:pt x="3315" y="1401"/>
                </a:lnTo>
                <a:lnTo>
                  <a:pt x="3327" y="1403"/>
                </a:lnTo>
                <a:lnTo>
                  <a:pt x="3340" y="1403"/>
                </a:lnTo>
                <a:lnTo>
                  <a:pt x="3351" y="1401"/>
                </a:lnTo>
                <a:lnTo>
                  <a:pt x="3364" y="1401"/>
                </a:lnTo>
                <a:lnTo>
                  <a:pt x="3376" y="1401"/>
                </a:lnTo>
                <a:lnTo>
                  <a:pt x="3387" y="1401"/>
                </a:lnTo>
                <a:lnTo>
                  <a:pt x="3400" y="1401"/>
                </a:lnTo>
                <a:lnTo>
                  <a:pt x="3412" y="1401"/>
                </a:lnTo>
                <a:lnTo>
                  <a:pt x="3425" y="1401"/>
                </a:lnTo>
                <a:lnTo>
                  <a:pt x="3436" y="1400"/>
                </a:lnTo>
                <a:lnTo>
                  <a:pt x="3447" y="1400"/>
                </a:lnTo>
                <a:lnTo>
                  <a:pt x="3461" y="1401"/>
                </a:lnTo>
                <a:lnTo>
                  <a:pt x="3472" y="1400"/>
                </a:lnTo>
                <a:lnTo>
                  <a:pt x="3485" y="1400"/>
                </a:lnTo>
                <a:lnTo>
                  <a:pt x="3496" y="1401"/>
                </a:lnTo>
                <a:lnTo>
                  <a:pt x="3508" y="1401"/>
                </a:lnTo>
                <a:lnTo>
                  <a:pt x="3521" y="1401"/>
                </a:lnTo>
                <a:lnTo>
                  <a:pt x="3532" y="1400"/>
                </a:lnTo>
                <a:lnTo>
                  <a:pt x="3545" y="1400"/>
                </a:lnTo>
                <a:lnTo>
                  <a:pt x="3557" y="1401"/>
                </a:lnTo>
                <a:lnTo>
                  <a:pt x="3570" y="1400"/>
                </a:lnTo>
                <a:lnTo>
                  <a:pt x="3581" y="1401"/>
                </a:lnTo>
                <a:lnTo>
                  <a:pt x="3593" y="1400"/>
                </a:lnTo>
                <a:lnTo>
                  <a:pt x="3606" y="1400"/>
                </a:lnTo>
                <a:lnTo>
                  <a:pt x="3617" y="1400"/>
                </a:lnTo>
                <a:lnTo>
                  <a:pt x="3630" y="1400"/>
                </a:lnTo>
                <a:lnTo>
                  <a:pt x="3642" y="1401"/>
                </a:lnTo>
                <a:lnTo>
                  <a:pt x="3653" y="1400"/>
                </a:lnTo>
                <a:lnTo>
                  <a:pt x="3666" y="1400"/>
                </a:lnTo>
                <a:lnTo>
                  <a:pt x="3678" y="1401"/>
                </a:lnTo>
                <a:lnTo>
                  <a:pt x="3691" y="1400"/>
                </a:lnTo>
                <a:lnTo>
                  <a:pt x="3702" y="1400"/>
                </a:lnTo>
                <a:lnTo>
                  <a:pt x="3715" y="1401"/>
                </a:lnTo>
                <a:lnTo>
                  <a:pt x="3727" y="1401"/>
                </a:lnTo>
                <a:lnTo>
                  <a:pt x="3738" y="1401"/>
                </a:lnTo>
                <a:lnTo>
                  <a:pt x="3751" y="1401"/>
                </a:lnTo>
                <a:lnTo>
                  <a:pt x="3762" y="1401"/>
                </a:lnTo>
                <a:lnTo>
                  <a:pt x="3775" y="1401"/>
                </a:lnTo>
                <a:lnTo>
                  <a:pt x="3787" y="1401"/>
                </a:lnTo>
                <a:lnTo>
                  <a:pt x="3798" y="1401"/>
                </a:lnTo>
                <a:lnTo>
                  <a:pt x="3811" y="1401"/>
                </a:lnTo>
                <a:lnTo>
                  <a:pt x="3823" y="1401"/>
                </a:lnTo>
                <a:lnTo>
                  <a:pt x="3836" y="1401"/>
                </a:lnTo>
                <a:lnTo>
                  <a:pt x="3847" y="1400"/>
                </a:lnTo>
                <a:lnTo>
                  <a:pt x="3859" y="1400"/>
                </a:lnTo>
                <a:lnTo>
                  <a:pt x="3872" y="1401"/>
                </a:lnTo>
                <a:lnTo>
                  <a:pt x="3883" y="1401"/>
                </a:lnTo>
                <a:lnTo>
                  <a:pt x="3896" y="1401"/>
                </a:lnTo>
                <a:lnTo>
                  <a:pt x="3908" y="1401"/>
                </a:lnTo>
                <a:lnTo>
                  <a:pt x="3921" y="1403"/>
                </a:lnTo>
                <a:lnTo>
                  <a:pt x="3932" y="1401"/>
                </a:lnTo>
                <a:lnTo>
                  <a:pt x="3944" y="1401"/>
                </a:lnTo>
                <a:lnTo>
                  <a:pt x="3957" y="1401"/>
                </a:lnTo>
                <a:lnTo>
                  <a:pt x="3968" y="1401"/>
                </a:lnTo>
                <a:lnTo>
                  <a:pt x="3981" y="1403"/>
                </a:lnTo>
                <a:lnTo>
                  <a:pt x="3992" y="1401"/>
                </a:lnTo>
                <a:lnTo>
                  <a:pt x="4004" y="1400"/>
                </a:lnTo>
                <a:lnTo>
                  <a:pt x="4017" y="1401"/>
                </a:lnTo>
                <a:lnTo>
                  <a:pt x="4028" y="1400"/>
                </a:lnTo>
                <a:lnTo>
                  <a:pt x="4041" y="1396"/>
                </a:lnTo>
                <a:lnTo>
                  <a:pt x="4053" y="1396"/>
                </a:lnTo>
                <a:lnTo>
                  <a:pt x="4066" y="1398"/>
                </a:lnTo>
                <a:lnTo>
                  <a:pt x="4077" y="1398"/>
                </a:lnTo>
                <a:lnTo>
                  <a:pt x="4089" y="1400"/>
                </a:lnTo>
                <a:lnTo>
                  <a:pt x="4102" y="1400"/>
                </a:lnTo>
                <a:lnTo>
                  <a:pt x="4113" y="1400"/>
                </a:lnTo>
                <a:lnTo>
                  <a:pt x="4126" y="1400"/>
                </a:lnTo>
                <a:lnTo>
                  <a:pt x="4138" y="1400"/>
                </a:lnTo>
                <a:lnTo>
                  <a:pt x="4149" y="1400"/>
                </a:lnTo>
                <a:lnTo>
                  <a:pt x="4162" y="1400"/>
                </a:lnTo>
                <a:lnTo>
                  <a:pt x="4174" y="1400"/>
                </a:lnTo>
              </a:path>
            </a:pathLst>
          </a:custGeom>
          <a:noFill/>
          <a:ln w="19050" cmpd="sng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0" name="Freeform 105"/>
          <p:cNvSpPr>
            <a:spLocks/>
          </p:cNvSpPr>
          <p:nvPr/>
        </p:nvSpPr>
        <p:spPr bwMode="auto">
          <a:xfrm>
            <a:off x="1672431" y="4217037"/>
            <a:ext cx="6619875" cy="1085850"/>
          </a:xfrm>
          <a:custGeom>
            <a:avLst/>
            <a:gdLst>
              <a:gd name="T0" fmla="*/ 67 w 4170"/>
              <a:gd name="T1" fmla="*/ 684 h 684"/>
              <a:gd name="T2" fmla="*/ 138 w 4170"/>
              <a:gd name="T3" fmla="*/ 684 h 684"/>
              <a:gd name="T4" fmla="*/ 212 w 4170"/>
              <a:gd name="T5" fmla="*/ 684 h 684"/>
              <a:gd name="T6" fmla="*/ 285 w 4170"/>
              <a:gd name="T7" fmla="*/ 684 h 684"/>
              <a:gd name="T8" fmla="*/ 360 w 4170"/>
              <a:gd name="T9" fmla="*/ 587 h 684"/>
              <a:gd name="T10" fmla="*/ 434 w 4170"/>
              <a:gd name="T11" fmla="*/ 551 h 684"/>
              <a:gd name="T12" fmla="*/ 505 w 4170"/>
              <a:gd name="T13" fmla="*/ 515 h 684"/>
              <a:gd name="T14" fmla="*/ 579 w 4170"/>
              <a:gd name="T15" fmla="*/ 483 h 684"/>
              <a:gd name="T16" fmla="*/ 654 w 4170"/>
              <a:gd name="T17" fmla="*/ 450 h 684"/>
              <a:gd name="T18" fmla="*/ 727 w 4170"/>
              <a:gd name="T19" fmla="*/ 419 h 684"/>
              <a:gd name="T20" fmla="*/ 801 w 4170"/>
              <a:gd name="T21" fmla="*/ 392 h 684"/>
              <a:gd name="T22" fmla="*/ 873 w 4170"/>
              <a:gd name="T23" fmla="*/ 362 h 684"/>
              <a:gd name="T24" fmla="*/ 948 w 4170"/>
              <a:gd name="T25" fmla="*/ 336 h 684"/>
              <a:gd name="T26" fmla="*/ 1019 w 4170"/>
              <a:gd name="T27" fmla="*/ 310 h 684"/>
              <a:gd name="T28" fmla="*/ 1095 w 4170"/>
              <a:gd name="T29" fmla="*/ 287 h 684"/>
              <a:gd name="T30" fmla="*/ 1166 w 4170"/>
              <a:gd name="T31" fmla="*/ 263 h 684"/>
              <a:gd name="T32" fmla="*/ 1240 w 4170"/>
              <a:gd name="T33" fmla="*/ 241 h 684"/>
              <a:gd name="T34" fmla="*/ 1315 w 4170"/>
              <a:gd name="T35" fmla="*/ 220 h 684"/>
              <a:gd name="T36" fmla="*/ 1387 w 4170"/>
              <a:gd name="T37" fmla="*/ 199 h 684"/>
              <a:gd name="T38" fmla="*/ 1462 w 4170"/>
              <a:gd name="T39" fmla="*/ 179 h 684"/>
              <a:gd name="T40" fmla="*/ 1533 w 4170"/>
              <a:gd name="T41" fmla="*/ 162 h 684"/>
              <a:gd name="T42" fmla="*/ 1609 w 4170"/>
              <a:gd name="T43" fmla="*/ 144 h 684"/>
              <a:gd name="T44" fmla="*/ 1680 w 4170"/>
              <a:gd name="T45" fmla="*/ 127 h 684"/>
              <a:gd name="T46" fmla="*/ 1755 w 4170"/>
              <a:gd name="T47" fmla="*/ 111 h 684"/>
              <a:gd name="T48" fmla="*/ 1829 w 4170"/>
              <a:gd name="T49" fmla="*/ 95 h 684"/>
              <a:gd name="T50" fmla="*/ 1902 w 4170"/>
              <a:gd name="T51" fmla="*/ 80 h 684"/>
              <a:gd name="T52" fmla="*/ 1976 w 4170"/>
              <a:gd name="T53" fmla="*/ 67 h 684"/>
              <a:gd name="T54" fmla="*/ 2049 w 4170"/>
              <a:gd name="T55" fmla="*/ 54 h 684"/>
              <a:gd name="T56" fmla="*/ 2121 w 4170"/>
              <a:gd name="T57" fmla="*/ 41 h 684"/>
              <a:gd name="T58" fmla="*/ 2194 w 4170"/>
              <a:gd name="T59" fmla="*/ 28 h 684"/>
              <a:gd name="T60" fmla="*/ 2269 w 4170"/>
              <a:gd name="T61" fmla="*/ 16 h 684"/>
              <a:gd name="T62" fmla="*/ 2341 w 4170"/>
              <a:gd name="T63" fmla="*/ 5 h 684"/>
              <a:gd name="T64" fmla="*/ 2416 w 4170"/>
              <a:gd name="T65" fmla="*/ 85 h 684"/>
              <a:gd name="T66" fmla="*/ 2490 w 4170"/>
              <a:gd name="T67" fmla="*/ 88 h 684"/>
              <a:gd name="T68" fmla="*/ 2561 w 4170"/>
              <a:gd name="T69" fmla="*/ 90 h 684"/>
              <a:gd name="T70" fmla="*/ 2635 w 4170"/>
              <a:gd name="T71" fmla="*/ 93 h 684"/>
              <a:gd name="T72" fmla="*/ 2708 w 4170"/>
              <a:gd name="T73" fmla="*/ 95 h 684"/>
              <a:gd name="T74" fmla="*/ 2783 w 4170"/>
              <a:gd name="T75" fmla="*/ 98 h 684"/>
              <a:gd name="T76" fmla="*/ 2857 w 4170"/>
              <a:gd name="T77" fmla="*/ 100 h 684"/>
              <a:gd name="T78" fmla="*/ 2930 w 4170"/>
              <a:gd name="T79" fmla="*/ 101 h 684"/>
              <a:gd name="T80" fmla="*/ 3002 w 4170"/>
              <a:gd name="T81" fmla="*/ 104 h 684"/>
              <a:gd name="T82" fmla="*/ 3075 w 4170"/>
              <a:gd name="T83" fmla="*/ 106 h 684"/>
              <a:gd name="T84" fmla="*/ 3149 w 4170"/>
              <a:gd name="T85" fmla="*/ 109 h 684"/>
              <a:gd name="T86" fmla="*/ 3222 w 4170"/>
              <a:gd name="T87" fmla="*/ 111 h 684"/>
              <a:gd name="T88" fmla="*/ 3296 w 4170"/>
              <a:gd name="T89" fmla="*/ 113 h 684"/>
              <a:gd name="T90" fmla="*/ 3371 w 4170"/>
              <a:gd name="T91" fmla="*/ 116 h 684"/>
              <a:gd name="T92" fmla="*/ 3443 w 4170"/>
              <a:gd name="T93" fmla="*/ 117 h 684"/>
              <a:gd name="T94" fmla="*/ 3518 w 4170"/>
              <a:gd name="T95" fmla="*/ 121 h 684"/>
              <a:gd name="T96" fmla="*/ 3589 w 4170"/>
              <a:gd name="T97" fmla="*/ 122 h 684"/>
              <a:gd name="T98" fmla="*/ 3665 w 4170"/>
              <a:gd name="T99" fmla="*/ 124 h 684"/>
              <a:gd name="T100" fmla="*/ 3736 w 4170"/>
              <a:gd name="T101" fmla="*/ 127 h 684"/>
              <a:gd name="T102" fmla="*/ 3810 w 4170"/>
              <a:gd name="T103" fmla="*/ 129 h 684"/>
              <a:gd name="T104" fmla="*/ 3885 w 4170"/>
              <a:gd name="T105" fmla="*/ 131 h 684"/>
              <a:gd name="T106" fmla="*/ 3957 w 4170"/>
              <a:gd name="T107" fmla="*/ 134 h 684"/>
              <a:gd name="T108" fmla="*/ 4030 w 4170"/>
              <a:gd name="T109" fmla="*/ 135 h 684"/>
              <a:gd name="T110" fmla="*/ 4105 w 4170"/>
              <a:gd name="T111" fmla="*/ 137 h 6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684">
                <a:moveTo>
                  <a:pt x="0" y="684"/>
                </a:moveTo>
                <a:lnTo>
                  <a:pt x="8" y="684"/>
                </a:lnTo>
                <a:lnTo>
                  <a:pt x="16" y="684"/>
                </a:lnTo>
                <a:lnTo>
                  <a:pt x="26" y="684"/>
                </a:lnTo>
                <a:lnTo>
                  <a:pt x="34" y="684"/>
                </a:lnTo>
                <a:lnTo>
                  <a:pt x="40" y="684"/>
                </a:lnTo>
                <a:lnTo>
                  <a:pt x="49" y="684"/>
                </a:lnTo>
                <a:lnTo>
                  <a:pt x="57" y="684"/>
                </a:lnTo>
                <a:lnTo>
                  <a:pt x="67" y="684"/>
                </a:lnTo>
                <a:lnTo>
                  <a:pt x="75" y="684"/>
                </a:lnTo>
                <a:lnTo>
                  <a:pt x="81" y="684"/>
                </a:lnTo>
                <a:lnTo>
                  <a:pt x="89" y="684"/>
                </a:lnTo>
                <a:lnTo>
                  <a:pt x="98" y="684"/>
                </a:lnTo>
                <a:lnTo>
                  <a:pt x="107" y="684"/>
                </a:lnTo>
                <a:lnTo>
                  <a:pt x="116" y="684"/>
                </a:lnTo>
                <a:lnTo>
                  <a:pt x="122" y="684"/>
                </a:lnTo>
                <a:lnTo>
                  <a:pt x="130" y="684"/>
                </a:lnTo>
                <a:lnTo>
                  <a:pt x="138" y="684"/>
                </a:lnTo>
                <a:lnTo>
                  <a:pt x="148" y="684"/>
                </a:lnTo>
                <a:lnTo>
                  <a:pt x="156" y="684"/>
                </a:lnTo>
                <a:lnTo>
                  <a:pt x="163" y="684"/>
                </a:lnTo>
                <a:lnTo>
                  <a:pt x="171" y="684"/>
                </a:lnTo>
                <a:lnTo>
                  <a:pt x="179" y="684"/>
                </a:lnTo>
                <a:lnTo>
                  <a:pt x="189" y="684"/>
                </a:lnTo>
                <a:lnTo>
                  <a:pt x="197" y="684"/>
                </a:lnTo>
                <a:lnTo>
                  <a:pt x="204" y="684"/>
                </a:lnTo>
                <a:lnTo>
                  <a:pt x="212" y="684"/>
                </a:lnTo>
                <a:lnTo>
                  <a:pt x="220" y="684"/>
                </a:lnTo>
                <a:lnTo>
                  <a:pt x="230" y="684"/>
                </a:lnTo>
                <a:lnTo>
                  <a:pt x="238" y="684"/>
                </a:lnTo>
                <a:lnTo>
                  <a:pt x="244" y="684"/>
                </a:lnTo>
                <a:lnTo>
                  <a:pt x="253" y="684"/>
                </a:lnTo>
                <a:lnTo>
                  <a:pt x="261" y="684"/>
                </a:lnTo>
                <a:lnTo>
                  <a:pt x="271" y="684"/>
                </a:lnTo>
                <a:lnTo>
                  <a:pt x="279" y="684"/>
                </a:lnTo>
                <a:lnTo>
                  <a:pt x="285" y="684"/>
                </a:lnTo>
                <a:lnTo>
                  <a:pt x="293" y="684"/>
                </a:lnTo>
                <a:lnTo>
                  <a:pt x="302" y="684"/>
                </a:lnTo>
                <a:lnTo>
                  <a:pt x="311" y="684"/>
                </a:lnTo>
                <a:lnTo>
                  <a:pt x="319" y="684"/>
                </a:lnTo>
                <a:lnTo>
                  <a:pt x="326" y="684"/>
                </a:lnTo>
                <a:lnTo>
                  <a:pt x="334" y="684"/>
                </a:lnTo>
                <a:lnTo>
                  <a:pt x="342" y="597"/>
                </a:lnTo>
                <a:lnTo>
                  <a:pt x="352" y="592"/>
                </a:lnTo>
                <a:lnTo>
                  <a:pt x="360" y="587"/>
                </a:lnTo>
                <a:lnTo>
                  <a:pt x="367" y="584"/>
                </a:lnTo>
                <a:lnTo>
                  <a:pt x="375" y="579"/>
                </a:lnTo>
                <a:lnTo>
                  <a:pt x="383" y="576"/>
                </a:lnTo>
                <a:lnTo>
                  <a:pt x="393" y="571"/>
                </a:lnTo>
                <a:lnTo>
                  <a:pt x="401" y="568"/>
                </a:lnTo>
                <a:lnTo>
                  <a:pt x="408" y="563"/>
                </a:lnTo>
                <a:lnTo>
                  <a:pt x="416" y="560"/>
                </a:lnTo>
                <a:lnTo>
                  <a:pt x="424" y="555"/>
                </a:lnTo>
                <a:lnTo>
                  <a:pt x="434" y="551"/>
                </a:lnTo>
                <a:lnTo>
                  <a:pt x="442" y="546"/>
                </a:lnTo>
                <a:lnTo>
                  <a:pt x="448" y="543"/>
                </a:lnTo>
                <a:lnTo>
                  <a:pt x="457" y="540"/>
                </a:lnTo>
                <a:lnTo>
                  <a:pt x="465" y="535"/>
                </a:lnTo>
                <a:lnTo>
                  <a:pt x="474" y="532"/>
                </a:lnTo>
                <a:lnTo>
                  <a:pt x="483" y="527"/>
                </a:lnTo>
                <a:lnTo>
                  <a:pt x="489" y="524"/>
                </a:lnTo>
                <a:lnTo>
                  <a:pt x="497" y="520"/>
                </a:lnTo>
                <a:lnTo>
                  <a:pt x="505" y="515"/>
                </a:lnTo>
                <a:lnTo>
                  <a:pt x="515" y="512"/>
                </a:lnTo>
                <a:lnTo>
                  <a:pt x="523" y="509"/>
                </a:lnTo>
                <a:lnTo>
                  <a:pt x="532" y="504"/>
                </a:lnTo>
                <a:lnTo>
                  <a:pt x="538" y="501"/>
                </a:lnTo>
                <a:lnTo>
                  <a:pt x="546" y="498"/>
                </a:lnTo>
                <a:lnTo>
                  <a:pt x="556" y="494"/>
                </a:lnTo>
                <a:lnTo>
                  <a:pt x="564" y="489"/>
                </a:lnTo>
                <a:lnTo>
                  <a:pt x="572" y="486"/>
                </a:lnTo>
                <a:lnTo>
                  <a:pt x="579" y="483"/>
                </a:lnTo>
                <a:lnTo>
                  <a:pt x="587" y="480"/>
                </a:lnTo>
                <a:lnTo>
                  <a:pt x="597" y="475"/>
                </a:lnTo>
                <a:lnTo>
                  <a:pt x="605" y="471"/>
                </a:lnTo>
                <a:lnTo>
                  <a:pt x="613" y="468"/>
                </a:lnTo>
                <a:lnTo>
                  <a:pt x="620" y="465"/>
                </a:lnTo>
                <a:lnTo>
                  <a:pt x="628" y="462"/>
                </a:lnTo>
                <a:lnTo>
                  <a:pt x="638" y="457"/>
                </a:lnTo>
                <a:lnTo>
                  <a:pt x="646" y="454"/>
                </a:lnTo>
                <a:lnTo>
                  <a:pt x="654" y="450"/>
                </a:lnTo>
                <a:lnTo>
                  <a:pt x="661" y="447"/>
                </a:lnTo>
                <a:lnTo>
                  <a:pt x="669" y="444"/>
                </a:lnTo>
                <a:lnTo>
                  <a:pt x="678" y="440"/>
                </a:lnTo>
                <a:lnTo>
                  <a:pt x="687" y="437"/>
                </a:lnTo>
                <a:lnTo>
                  <a:pt x="695" y="434"/>
                </a:lnTo>
                <a:lnTo>
                  <a:pt x="701" y="431"/>
                </a:lnTo>
                <a:lnTo>
                  <a:pt x="709" y="427"/>
                </a:lnTo>
                <a:lnTo>
                  <a:pt x="719" y="423"/>
                </a:lnTo>
                <a:lnTo>
                  <a:pt x="727" y="419"/>
                </a:lnTo>
                <a:lnTo>
                  <a:pt x="736" y="416"/>
                </a:lnTo>
                <a:lnTo>
                  <a:pt x="742" y="413"/>
                </a:lnTo>
                <a:lnTo>
                  <a:pt x="750" y="409"/>
                </a:lnTo>
                <a:lnTo>
                  <a:pt x="760" y="406"/>
                </a:lnTo>
                <a:lnTo>
                  <a:pt x="768" y="403"/>
                </a:lnTo>
                <a:lnTo>
                  <a:pt x="776" y="400"/>
                </a:lnTo>
                <a:lnTo>
                  <a:pt x="783" y="396"/>
                </a:lnTo>
                <a:lnTo>
                  <a:pt x="791" y="393"/>
                </a:lnTo>
                <a:lnTo>
                  <a:pt x="801" y="392"/>
                </a:lnTo>
                <a:lnTo>
                  <a:pt x="809" y="388"/>
                </a:lnTo>
                <a:lnTo>
                  <a:pt x="817" y="385"/>
                </a:lnTo>
                <a:lnTo>
                  <a:pt x="824" y="382"/>
                </a:lnTo>
                <a:lnTo>
                  <a:pt x="832" y="378"/>
                </a:lnTo>
                <a:lnTo>
                  <a:pt x="842" y="375"/>
                </a:lnTo>
                <a:lnTo>
                  <a:pt x="850" y="372"/>
                </a:lnTo>
                <a:lnTo>
                  <a:pt x="856" y="369"/>
                </a:lnTo>
                <a:lnTo>
                  <a:pt x="866" y="365"/>
                </a:lnTo>
                <a:lnTo>
                  <a:pt x="873" y="362"/>
                </a:lnTo>
                <a:lnTo>
                  <a:pt x="882" y="361"/>
                </a:lnTo>
                <a:lnTo>
                  <a:pt x="891" y="357"/>
                </a:lnTo>
                <a:lnTo>
                  <a:pt x="897" y="354"/>
                </a:lnTo>
                <a:lnTo>
                  <a:pt x="907" y="351"/>
                </a:lnTo>
                <a:lnTo>
                  <a:pt x="913" y="347"/>
                </a:lnTo>
                <a:lnTo>
                  <a:pt x="923" y="344"/>
                </a:lnTo>
                <a:lnTo>
                  <a:pt x="931" y="343"/>
                </a:lnTo>
                <a:lnTo>
                  <a:pt x="938" y="339"/>
                </a:lnTo>
                <a:lnTo>
                  <a:pt x="948" y="336"/>
                </a:lnTo>
                <a:lnTo>
                  <a:pt x="954" y="333"/>
                </a:lnTo>
                <a:lnTo>
                  <a:pt x="964" y="331"/>
                </a:lnTo>
                <a:lnTo>
                  <a:pt x="972" y="328"/>
                </a:lnTo>
                <a:lnTo>
                  <a:pt x="979" y="325"/>
                </a:lnTo>
                <a:lnTo>
                  <a:pt x="988" y="321"/>
                </a:lnTo>
                <a:lnTo>
                  <a:pt x="995" y="320"/>
                </a:lnTo>
                <a:lnTo>
                  <a:pt x="1005" y="316"/>
                </a:lnTo>
                <a:lnTo>
                  <a:pt x="1013" y="313"/>
                </a:lnTo>
                <a:lnTo>
                  <a:pt x="1019" y="310"/>
                </a:lnTo>
                <a:lnTo>
                  <a:pt x="1029" y="308"/>
                </a:lnTo>
                <a:lnTo>
                  <a:pt x="1036" y="305"/>
                </a:lnTo>
                <a:lnTo>
                  <a:pt x="1044" y="302"/>
                </a:lnTo>
                <a:lnTo>
                  <a:pt x="1054" y="300"/>
                </a:lnTo>
                <a:lnTo>
                  <a:pt x="1060" y="297"/>
                </a:lnTo>
                <a:lnTo>
                  <a:pt x="1070" y="294"/>
                </a:lnTo>
                <a:lnTo>
                  <a:pt x="1077" y="292"/>
                </a:lnTo>
                <a:lnTo>
                  <a:pt x="1085" y="289"/>
                </a:lnTo>
                <a:lnTo>
                  <a:pt x="1095" y="287"/>
                </a:lnTo>
                <a:lnTo>
                  <a:pt x="1101" y="284"/>
                </a:lnTo>
                <a:lnTo>
                  <a:pt x="1111" y="281"/>
                </a:lnTo>
                <a:lnTo>
                  <a:pt x="1117" y="279"/>
                </a:lnTo>
                <a:lnTo>
                  <a:pt x="1126" y="276"/>
                </a:lnTo>
                <a:lnTo>
                  <a:pt x="1135" y="274"/>
                </a:lnTo>
                <a:lnTo>
                  <a:pt x="1142" y="271"/>
                </a:lnTo>
                <a:lnTo>
                  <a:pt x="1152" y="268"/>
                </a:lnTo>
                <a:lnTo>
                  <a:pt x="1158" y="266"/>
                </a:lnTo>
                <a:lnTo>
                  <a:pt x="1166" y="263"/>
                </a:lnTo>
                <a:lnTo>
                  <a:pt x="1176" y="261"/>
                </a:lnTo>
                <a:lnTo>
                  <a:pt x="1183" y="258"/>
                </a:lnTo>
                <a:lnTo>
                  <a:pt x="1192" y="256"/>
                </a:lnTo>
                <a:lnTo>
                  <a:pt x="1199" y="253"/>
                </a:lnTo>
                <a:lnTo>
                  <a:pt x="1207" y="251"/>
                </a:lnTo>
                <a:lnTo>
                  <a:pt x="1217" y="248"/>
                </a:lnTo>
                <a:lnTo>
                  <a:pt x="1223" y="246"/>
                </a:lnTo>
                <a:lnTo>
                  <a:pt x="1233" y="243"/>
                </a:lnTo>
                <a:lnTo>
                  <a:pt x="1240" y="241"/>
                </a:lnTo>
                <a:lnTo>
                  <a:pt x="1248" y="238"/>
                </a:lnTo>
                <a:lnTo>
                  <a:pt x="1258" y="237"/>
                </a:lnTo>
                <a:lnTo>
                  <a:pt x="1264" y="233"/>
                </a:lnTo>
                <a:lnTo>
                  <a:pt x="1274" y="232"/>
                </a:lnTo>
                <a:lnTo>
                  <a:pt x="1281" y="228"/>
                </a:lnTo>
                <a:lnTo>
                  <a:pt x="1289" y="227"/>
                </a:lnTo>
                <a:lnTo>
                  <a:pt x="1299" y="224"/>
                </a:lnTo>
                <a:lnTo>
                  <a:pt x="1305" y="222"/>
                </a:lnTo>
                <a:lnTo>
                  <a:pt x="1315" y="220"/>
                </a:lnTo>
                <a:lnTo>
                  <a:pt x="1323" y="217"/>
                </a:lnTo>
                <a:lnTo>
                  <a:pt x="1330" y="215"/>
                </a:lnTo>
                <a:lnTo>
                  <a:pt x="1339" y="212"/>
                </a:lnTo>
                <a:lnTo>
                  <a:pt x="1346" y="210"/>
                </a:lnTo>
                <a:lnTo>
                  <a:pt x="1356" y="209"/>
                </a:lnTo>
                <a:lnTo>
                  <a:pt x="1364" y="206"/>
                </a:lnTo>
                <a:lnTo>
                  <a:pt x="1370" y="204"/>
                </a:lnTo>
                <a:lnTo>
                  <a:pt x="1380" y="202"/>
                </a:lnTo>
                <a:lnTo>
                  <a:pt x="1387" y="199"/>
                </a:lnTo>
                <a:lnTo>
                  <a:pt x="1396" y="197"/>
                </a:lnTo>
                <a:lnTo>
                  <a:pt x="1405" y="196"/>
                </a:lnTo>
                <a:lnTo>
                  <a:pt x="1411" y="193"/>
                </a:lnTo>
                <a:lnTo>
                  <a:pt x="1421" y="191"/>
                </a:lnTo>
                <a:lnTo>
                  <a:pt x="1427" y="189"/>
                </a:lnTo>
                <a:lnTo>
                  <a:pt x="1437" y="186"/>
                </a:lnTo>
                <a:lnTo>
                  <a:pt x="1445" y="184"/>
                </a:lnTo>
                <a:lnTo>
                  <a:pt x="1452" y="183"/>
                </a:lnTo>
                <a:lnTo>
                  <a:pt x="1462" y="179"/>
                </a:lnTo>
                <a:lnTo>
                  <a:pt x="1468" y="178"/>
                </a:lnTo>
                <a:lnTo>
                  <a:pt x="1478" y="176"/>
                </a:lnTo>
                <a:lnTo>
                  <a:pt x="1486" y="175"/>
                </a:lnTo>
                <a:lnTo>
                  <a:pt x="1493" y="171"/>
                </a:lnTo>
                <a:lnTo>
                  <a:pt x="1502" y="170"/>
                </a:lnTo>
                <a:lnTo>
                  <a:pt x="1509" y="168"/>
                </a:lnTo>
                <a:lnTo>
                  <a:pt x="1519" y="165"/>
                </a:lnTo>
                <a:lnTo>
                  <a:pt x="1527" y="163"/>
                </a:lnTo>
                <a:lnTo>
                  <a:pt x="1533" y="162"/>
                </a:lnTo>
                <a:lnTo>
                  <a:pt x="1543" y="160"/>
                </a:lnTo>
                <a:lnTo>
                  <a:pt x="1550" y="158"/>
                </a:lnTo>
                <a:lnTo>
                  <a:pt x="1560" y="155"/>
                </a:lnTo>
                <a:lnTo>
                  <a:pt x="1568" y="153"/>
                </a:lnTo>
                <a:lnTo>
                  <a:pt x="1574" y="152"/>
                </a:lnTo>
                <a:lnTo>
                  <a:pt x="1584" y="150"/>
                </a:lnTo>
                <a:lnTo>
                  <a:pt x="1591" y="148"/>
                </a:lnTo>
                <a:lnTo>
                  <a:pt x="1599" y="145"/>
                </a:lnTo>
                <a:lnTo>
                  <a:pt x="1609" y="144"/>
                </a:lnTo>
                <a:lnTo>
                  <a:pt x="1615" y="142"/>
                </a:lnTo>
                <a:lnTo>
                  <a:pt x="1625" y="140"/>
                </a:lnTo>
                <a:lnTo>
                  <a:pt x="1633" y="139"/>
                </a:lnTo>
                <a:lnTo>
                  <a:pt x="1640" y="137"/>
                </a:lnTo>
                <a:lnTo>
                  <a:pt x="1648" y="134"/>
                </a:lnTo>
                <a:lnTo>
                  <a:pt x="1656" y="132"/>
                </a:lnTo>
                <a:lnTo>
                  <a:pt x="1666" y="131"/>
                </a:lnTo>
                <a:lnTo>
                  <a:pt x="1674" y="129"/>
                </a:lnTo>
                <a:lnTo>
                  <a:pt x="1680" y="127"/>
                </a:lnTo>
                <a:lnTo>
                  <a:pt x="1688" y="126"/>
                </a:lnTo>
                <a:lnTo>
                  <a:pt x="1697" y="124"/>
                </a:lnTo>
                <a:lnTo>
                  <a:pt x="1706" y="121"/>
                </a:lnTo>
                <a:lnTo>
                  <a:pt x="1715" y="119"/>
                </a:lnTo>
                <a:lnTo>
                  <a:pt x="1721" y="117"/>
                </a:lnTo>
                <a:lnTo>
                  <a:pt x="1729" y="116"/>
                </a:lnTo>
                <a:lnTo>
                  <a:pt x="1739" y="114"/>
                </a:lnTo>
                <a:lnTo>
                  <a:pt x="1747" y="113"/>
                </a:lnTo>
                <a:lnTo>
                  <a:pt x="1755" y="111"/>
                </a:lnTo>
                <a:lnTo>
                  <a:pt x="1762" y="109"/>
                </a:lnTo>
                <a:lnTo>
                  <a:pt x="1770" y="108"/>
                </a:lnTo>
                <a:lnTo>
                  <a:pt x="1780" y="106"/>
                </a:lnTo>
                <a:lnTo>
                  <a:pt x="1788" y="104"/>
                </a:lnTo>
                <a:lnTo>
                  <a:pt x="1796" y="103"/>
                </a:lnTo>
                <a:lnTo>
                  <a:pt x="1803" y="101"/>
                </a:lnTo>
                <a:lnTo>
                  <a:pt x="1811" y="100"/>
                </a:lnTo>
                <a:lnTo>
                  <a:pt x="1821" y="98"/>
                </a:lnTo>
                <a:lnTo>
                  <a:pt x="1829" y="95"/>
                </a:lnTo>
                <a:lnTo>
                  <a:pt x="1835" y="93"/>
                </a:lnTo>
                <a:lnTo>
                  <a:pt x="1844" y="91"/>
                </a:lnTo>
                <a:lnTo>
                  <a:pt x="1852" y="90"/>
                </a:lnTo>
                <a:lnTo>
                  <a:pt x="1861" y="88"/>
                </a:lnTo>
                <a:lnTo>
                  <a:pt x="1870" y="86"/>
                </a:lnTo>
                <a:lnTo>
                  <a:pt x="1876" y="85"/>
                </a:lnTo>
                <a:lnTo>
                  <a:pt x="1884" y="83"/>
                </a:lnTo>
                <a:lnTo>
                  <a:pt x="1892" y="82"/>
                </a:lnTo>
                <a:lnTo>
                  <a:pt x="1902" y="80"/>
                </a:lnTo>
                <a:lnTo>
                  <a:pt x="1910" y="80"/>
                </a:lnTo>
                <a:lnTo>
                  <a:pt x="1917" y="78"/>
                </a:lnTo>
                <a:lnTo>
                  <a:pt x="1925" y="77"/>
                </a:lnTo>
                <a:lnTo>
                  <a:pt x="1933" y="75"/>
                </a:lnTo>
                <a:lnTo>
                  <a:pt x="1943" y="73"/>
                </a:lnTo>
                <a:lnTo>
                  <a:pt x="1951" y="72"/>
                </a:lnTo>
                <a:lnTo>
                  <a:pt x="1958" y="70"/>
                </a:lnTo>
                <a:lnTo>
                  <a:pt x="1966" y="69"/>
                </a:lnTo>
                <a:lnTo>
                  <a:pt x="1976" y="67"/>
                </a:lnTo>
                <a:lnTo>
                  <a:pt x="1984" y="65"/>
                </a:lnTo>
                <a:lnTo>
                  <a:pt x="1992" y="64"/>
                </a:lnTo>
                <a:lnTo>
                  <a:pt x="1999" y="62"/>
                </a:lnTo>
                <a:lnTo>
                  <a:pt x="2007" y="60"/>
                </a:lnTo>
                <a:lnTo>
                  <a:pt x="2015" y="59"/>
                </a:lnTo>
                <a:lnTo>
                  <a:pt x="2023" y="57"/>
                </a:lnTo>
                <a:lnTo>
                  <a:pt x="2033" y="55"/>
                </a:lnTo>
                <a:lnTo>
                  <a:pt x="2039" y="55"/>
                </a:lnTo>
                <a:lnTo>
                  <a:pt x="2049" y="54"/>
                </a:lnTo>
                <a:lnTo>
                  <a:pt x="2056" y="52"/>
                </a:lnTo>
                <a:lnTo>
                  <a:pt x="2065" y="51"/>
                </a:lnTo>
                <a:lnTo>
                  <a:pt x="2074" y="49"/>
                </a:lnTo>
                <a:lnTo>
                  <a:pt x="2080" y="47"/>
                </a:lnTo>
                <a:lnTo>
                  <a:pt x="2090" y="46"/>
                </a:lnTo>
                <a:lnTo>
                  <a:pt x="2096" y="44"/>
                </a:lnTo>
                <a:lnTo>
                  <a:pt x="2106" y="42"/>
                </a:lnTo>
                <a:lnTo>
                  <a:pt x="2113" y="42"/>
                </a:lnTo>
                <a:lnTo>
                  <a:pt x="2121" y="41"/>
                </a:lnTo>
                <a:lnTo>
                  <a:pt x="2131" y="39"/>
                </a:lnTo>
                <a:lnTo>
                  <a:pt x="2137" y="38"/>
                </a:lnTo>
                <a:lnTo>
                  <a:pt x="2147" y="36"/>
                </a:lnTo>
                <a:lnTo>
                  <a:pt x="2154" y="34"/>
                </a:lnTo>
                <a:lnTo>
                  <a:pt x="2163" y="34"/>
                </a:lnTo>
                <a:lnTo>
                  <a:pt x="2171" y="33"/>
                </a:lnTo>
                <a:lnTo>
                  <a:pt x="2178" y="31"/>
                </a:lnTo>
                <a:lnTo>
                  <a:pt x="2188" y="29"/>
                </a:lnTo>
                <a:lnTo>
                  <a:pt x="2194" y="28"/>
                </a:lnTo>
                <a:lnTo>
                  <a:pt x="2202" y="26"/>
                </a:lnTo>
                <a:lnTo>
                  <a:pt x="2212" y="26"/>
                </a:lnTo>
                <a:lnTo>
                  <a:pt x="2220" y="25"/>
                </a:lnTo>
                <a:lnTo>
                  <a:pt x="2229" y="23"/>
                </a:lnTo>
                <a:lnTo>
                  <a:pt x="2235" y="21"/>
                </a:lnTo>
                <a:lnTo>
                  <a:pt x="2243" y="20"/>
                </a:lnTo>
                <a:lnTo>
                  <a:pt x="2251" y="20"/>
                </a:lnTo>
                <a:lnTo>
                  <a:pt x="2261" y="18"/>
                </a:lnTo>
                <a:lnTo>
                  <a:pt x="2269" y="16"/>
                </a:lnTo>
                <a:lnTo>
                  <a:pt x="2278" y="15"/>
                </a:lnTo>
                <a:lnTo>
                  <a:pt x="2284" y="15"/>
                </a:lnTo>
                <a:lnTo>
                  <a:pt x="2292" y="13"/>
                </a:lnTo>
                <a:lnTo>
                  <a:pt x="2300" y="11"/>
                </a:lnTo>
                <a:lnTo>
                  <a:pt x="2310" y="10"/>
                </a:lnTo>
                <a:lnTo>
                  <a:pt x="2317" y="8"/>
                </a:lnTo>
                <a:lnTo>
                  <a:pt x="2326" y="8"/>
                </a:lnTo>
                <a:lnTo>
                  <a:pt x="2335" y="7"/>
                </a:lnTo>
                <a:lnTo>
                  <a:pt x="2341" y="5"/>
                </a:lnTo>
                <a:lnTo>
                  <a:pt x="2351" y="3"/>
                </a:lnTo>
                <a:lnTo>
                  <a:pt x="2357" y="3"/>
                </a:lnTo>
                <a:lnTo>
                  <a:pt x="2366" y="2"/>
                </a:lnTo>
                <a:lnTo>
                  <a:pt x="2375" y="0"/>
                </a:lnTo>
                <a:lnTo>
                  <a:pt x="2382" y="0"/>
                </a:lnTo>
                <a:lnTo>
                  <a:pt x="2390" y="85"/>
                </a:lnTo>
                <a:lnTo>
                  <a:pt x="2400" y="85"/>
                </a:lnTo>
                <a:lnTo>
                  <a:pt x="2408" y="85"/>
                </a:lnTo>
                <a:lnTo>
                  <a:pt x="2416" y="85"/>
                </a:lnTo>
                <a:lnTo>
                  <a:pt x="2424" y="86"/>
                </a:lnTo>
                <a:lnTo>
                  <a:pt x="2433" y="86"/>
                </a:lnTo>
                <a:lnTo>
                  <a:pt x="2439" y="86"/>
                </a:lnTo>
                <a:lnTo>
                  <a:pt x="2449" y="86"/>
                </a:lnTo>
                <a:lnTo>
                  <a:pt x="2455" y="86"/>
                </a:lnTo>
                <a:lnTo>
                  <a:pt x="2464" y="86"/>
                </a:lnTo>
                <a:lnTo>
                  <a:pt x="2473" y="88"/>
                </a:lnTo>
                <a:lnTo>
                  <a:pt x="2480" y="88"/>
                </a:lnTo>
                <a:lnTo>
                  <a:pt x="2490" y="88"/>
                </a:lnTo>
                <a:lnTo>
                  <a:pt x="2498" y="88"/>
                </a:lnTo>
                <a:lnTo>
                  <a:pt x="2506" y="88"/>
                </a:lnTo>
                <a:lnTo>
                  <a:pt x="2513" y="88"/>
                </a:lnTo>
                <a:lnTo>
                  <a:pt x="2521" y="90"/>
                </a:lnTo>
                <a:lnTo>
                  <a:pt x="2529" y="90"/>
                </a:lnTo>
                <a:lnTo>
                  <a:pt x="2539" y="90"/>
                </a:lnTo>
                <a:lnTo>
                  <a:pt x="2547" y="90"/>
                </a:lnTo>
                <a:lnTo>
                  <a:pt x="2555" y="90"/>
                </a:lnTo>
                <a:lnTo>
                  <a:pt x="2561" y="90"/>
                </a:lnTo>
                <a:lnTo>
                  <a:pt x="2570" y="91"/>
                </a:lnTo>
                <a:lnTo>
                  <a:pt x="2578" y="91"/>
                </a:lnTo>
                <a:lnTo>
                  <a:pt x="2588" y="91"/>
                </a:lnTo>
                <a:lnTo>
                  <a:pt x="2594" y="91"/>
                </a:lnTo>
                <a:lnTo>
                  <a:pt x="2604" y="91"/>
                </a:lnTo>
                <a:lnTo>
                  <a:pt x="2610" y="91"/>
                </a:lnTo>
                <a:lnTo>
                  <a:pt x="2620" y="91"/>
                </a:lnTo>
                <a:lnTo>
                  <a:pt x="2627" y="93"/>
                </a:lnTo>
                <a:lnTo>
                  <a:pt x="2635" y="93"/>
                </a:lnTo>
                <a:lnTo>
                  <a:pt x="2645" y="93"/>
                </a:lnTo>
                <a:lnTo>
                  <a:pt x="2651" y="93"/>
                </a:lnTo>
                <a:lnTo>
                  <a:pt x="2661" y="93"/>
                </a:lnTo>
                <a:lnTo>
                  <a:pt x="2668" y="93"/>
                </a:lnTo>
                <a:lnTo>
                  <a:pt x="2676" y="95"/>
                </a:lnTo>
                <a:lnTo>
                  <a:pt x="2685" y="95"/>
                </a:lnTo>
                <a:lnTo>
                  <a:pt x="2692" y="95"/>
                </a:lnTo>
                <a:lnTo>
                  <a:pt x="2702" y="95"/>
                </a:lnTo>
                <a:lnTo>
                  <a:pt x="2708" y="95"/>
                </a:lnTo>
                <a:lnTo>
                  <a:pt x="2718" y="95"/>
                </a:lnTo>
                <a:lnTo>
                  <a:pt x="2726" y="96"/>
                </a:lnTo>
                <a:lnTo>
                  <a:pt x="2733" y="96"/>
                </a:lnTo>
                <a:lnTo>
                  <a:pt x="2743" y="96"/>
                </a:lnTo>
                <a:lnTo>
                  <a:pt x="2749" y="96"/>
                </a:lnTo>
                <a:lnTo>
                  <a:pt x="2759" y="96"/>
                </a:lnTo>
                <a:lnTo>
                  <a:pt x="2765" y="96"/>
                </a:lnTo>
                <a:lnTo>
                  <a:pt x="2774" y="96"/>
                </a:lnTo>
                <a:lnTo>
                  <a:pt x="2783" y="98"/>
                </a:lnTo>
                <a:lnTo>
                  <a:pt x="2790" y="98"/>
                </a:lnTo>
                <a:lnTo>
                  <a:pt x="2798" y="98"/>
                </a:lnTo>
                <a:lnTo>
                  <a:pt x="2808" y="98"/>
                </a:lnTo>
                <a:lnTo>
                  <a:pt x="2816" y="98"/>
                </a:lnTo>
                <a:lnTo>
                  <a:pt x="2824" y="98"/>
                </a:lnTo>
                <a:lnTo>
                  <a:pt x="2831" y="100"/>
                </a:lnTo>
                <a:lnTo>
                  <a:pt x="2839" y="100"/>
                </a:lnTo>
                <a:lnTo>
                  <a:pt x="2849" y="100"/>
                </a:lnTo>
                <a:lnTo>
                  <a:pt x="2857" y="100"/>
                </a:lnTo>
                <a:lnTo>
                  <a:pt x="2865" y="100"/>
                </a:lnTo>
                <a:lnTo>
                  <a:pt x="2871" y="100"/>
                </a:lnTo>
                <a:lnTo>
                  <a:pt x="2880" y="101"/>
                </a:lnTo>
                <a:lnTo>
                  <a:pt x="2889" y="101"/>
                </a:lnTo>
                <a:lnTo>
                  <a:pt x="2898" y="101"/>
                </a:lnTo>
                <a:lnTo>
                  <a:pt x="2904" y="101"/>
                </a:lnTo>
                <a:lnTo>
                  <a:pt x="2912" y="101"/>
                </a:lnTo>
                <a:lnTo>
                  <a:pt x="2920" y="101"/>
                </a:lnTo>
                <a:lnTo>
                  <a:pt x="2930" y="101"/>
                </a:lnTo>
                <a:lnTo>
                  <a:pt x="2938" y="103"/>
                </a:lnTo>
                <a:lnTo>
                  <a:pt x="2945" y="103"/>
                </a:lnTo>
                <a:lnTo>
                  <a:pt x="2953" y="103"/>
                </a:lnTo>
                <a:lnTo>
                  <a:pt x="2961" y="103"/>
                </a:lnTo>
                <a:lnTo>
                  <a:pt x="2971" y="103"/>
                </a:lnTo>
                <a:lnTo>
                  <a:pt x="2979" y="103"/>
                </a:lnTo>
                <a:lnTo>
                  <a:pt x="2986" y="104"/>
                </a:lnTo>
                <a:lnTo>
                  <a:pt x="2994" y="104"/>
                </a:lnTo>
                <a:lnTo>
                  <a:pt x="3002" y="104"/>
                </a:lnTo>
                <a:lnTo>
                  <a:pt x="3012" y="104"/>
                </a:lnTo>
                <a:lnTo>
                  <a:pt x="3020" y="104"/>
                </a:lnTo>
                <a:lnTo>
                  <a:pt x="3027" y="104"/>
                </a:lnTo>
                <a:lnTo>
                  <a:pt x="3035" y="104"/>
                </a:lnTo>
                <a:lnTo>
                  <a:pt x="3044" y="106"/>
                </a:lnTo>
                <a:lnTo>
                  <a:pt x="3053" y="106"/>
                </a:lnTo>
                <a:lnTo>
                  <a:pt x="3061" y="106"/>
                </a:lnTo>
                <a:lnTo>
                  <a:pt x="3067" y="106"/>
                </a:lnTo>
                <a:lnTo>
                  <a:pt x="3075" y="106"/>
                </a:lnTo>
                <a:lnTo>
                  <a:pt x="3085" y="106"/>
                </a:lnTo>
                <a:lnTo>
                  <a:pt x="3093" y="108"/>
                </a:lnTo>
                <a:lnTo>
                  <a:pt x="3102" y="108"/>
                </a:lnTo>
                <a:lnTo>
                  <a:pt x="3108" y="108"/>
                </a:lnTo>
                <a:lnTo>
                  <a:pt x="3116" y="108"/>
                </a:lnTo>
                <a:lnTo>
                  <a:pt x="3126" y="108"/>
                </a:lnTo>
                <a:lnTo>
                  <a:pt x="3134" y="108"/>
                </a:lnTo>
                <a:lnTo>
                  <a:pt x="3142" y="108"/>
                </a:lnTo>
                <a:lnTo>
                  <a:pt x="3149" y="109"/>
                </a:lnTo>
                <a:lnTo>
                  <a:pt x="3157" y="109"/>
                </a:lnTo>
                <a:lnTo>
                  <a:pt x="3167" y="109"/>
                </a:lnTo>
                <a:lnTo>
                  <a:pt x="3173" y="109"/>
                </a:lnTo>
                <a:lnTo>
                  <a:pt x="3182" y="109"/>
                </a:lnTo>
                <a:lnTo>
                  <a:pt x="3191" y="109"/>
                </a:lnTo>
                <a:lnTo>
                  <a:pt x="3198" y="111"/>
                </a:lnTo>
                <a:lnTo>
                  <a:pt x="3208" y="111"/>
                </a:lnTo>
                <a:lnTo>
                  <a:pt x="3214" y="111"/>
                </a:lnTo>
                <a:lnTo>
                  <a:pt x="3222" y="111"/>
                </a:lnTo>
                <a:lnTo>
                  <a:pt x="3232" y="111"/>
                </a:lnTo>
                <a:lnTo>
                  <a:pt x="3239" y="111"/>
                </a:lnTo>
                <a:lnTo>
                  <a:pt x="3248" y="111"/>
                </a:lnTo>
                <a:lnTo>
                  <a:pt x="3255" y="113"/>
                </a:lnTo>
                <a:lnTo>
                  <a:pt x="3263" y="113"/>
                </a:lnTo>
                <a:lnTo>
                  <a:pt x="3273" y="113"/>
                </a:lnTo>
                <a:lnTo>
                  <a:pt x="3279" y="113"/>
                </a:lnTo>
                <a:lnTo>
                  <a:pt x="3289" y="113"/>
                </a:lnTo>
                <a:lnTo>
                  <a:pt x="3296" y="113"/>
                </a:lnTo>
                <a:lnTo>
                  <a:pt x="3304" y="114"/>
                </a:lnTo>
                <a:lnTo>
                  <a:pt x="3314" y="114"/>
                </a:lnTo>
                <a:lnTo>
                  <a:pt x="3320" y="114"/>
                </a:lnTo>
                <a:lnTo>
                  <a:pt x="3330" y="114"/>
                </a:lnTo>
                <a:lnTo>
                  <a:pt x="3337" y="114"/>
                </a:lnTo>
                <a:lnTo>
                  <a:pt x="3345" y="114"/>
                </a:lnTo>
                <a:lnTo>
                  <a:pt x="3354" y="114"/>
                </a:lnTo>
                <a:lnTo>
                  <a:pt x="3361" y="116"/>
                </a:lnTo>
                <a:lnTo>
                  <a:pt x="3371" y="116"/>
                </a:lnTo>
                <a:lnTo>
                  <a:pt x="3377" y="116"/>
                </a:lnTo>
                <a:lnTo>
                  <a:pt x="3385" y="116"/>
                </a:lnTo>
                <a:lnTo>
                  <a:pt x="3395" y="116"/>
                </a:lnTo>
                <a:lnTo>
                  <a:pt x="3402" y="116"/>
                </a:lnTo>
                <a:lnTo>
                  <a:pt x="3412" y="117"/>
                </a:lnTo>
                <a:lnTo>
                  <a:pt x="3418" y="117"/>
                </a:lnTo>
                <a:lnTo>
                  <a:pt x="3426" y="117"/>
                </a:lnTo>
                <a:lnTo>
                  <a:pt x="3436" y="117"/>
                </a:lnTo>
                <a:lnTo>
                  <a:pt x="3443" y="117"/>
                </a:lnTo>
                <a:lnTo>
                  <a:pt x="3452" y="117"/>
                </a:lnTo>
                <a:lnTo>
                  <a:pt x="3461" y="117"/>
                </a:lnTo>
                <a:lnTo>
                  <a:pt x="3467" y="119"/>
                </a:lnTo>
                <a:lnTo>
                  <a:pt x="3477" y="119"/>
                </a:lnTo>
                <a:lnTo>
                  <a:pt x="3483" y="119"/>
                </a:lnTo>
                <a:lnTo>
                  <a:pt x="3493" y="119"/>
                </a:lnTo>
                <a:lnTo>
                  <a:pt x="3501" y="119"/>
                </a:lnTo>
                <a:lnTo>
                  <a:pt x="3508" y="119"/>
                </a:lnTo>
                <a:lnTo>
                  <a:pt x="3518" y="121"/>
                </a:lnTo>
                <a:lnTo>
                  <a:pt x="3524" y="121"/>
                </a:lnTo>
                <a:lnTo>
                  <a:pt x="3534" y="121"/>
                </a:lnTo>
                <a:lnTo>
                  <a:pt x="3542" y="121"/>
                </a:lnTo>
                <a:lnTo>
                  <a:pt x="3549" y="121"/>
                </a:lnTo>
                <a:lnTo>
                  <a:pt x="3558" y="121"/>
                </a:lnTo>
                <a:lnTo>
                  <a:pt x="3565" y="121"/>
                </a:lnTo>
                <a:lnTo>
                  <a:pt x="3575" y="122"/>
                </a:lnTo>
                <a:lnTo>
                  <a:pt x="3583" y="122"/>
                </a:lnTo>
                <a:lnTo>
                  <a:pt x="3589" y="122"/>
                </a:lnTo>
                <a:lnTo>
                  <a:pt x="3599" y="122"/>
                </a:lnTo>
                <a:lnTo>
                  <a:pt x="3606" y="122"/>
                </a:lnTo>
                <a:lnTo>
                  <a:pt x="3616" y="122"/>
                </a:lnTo>
                <a:lnTo>
                  <a:pt x="3624" y="122"/>
                </a:lnTo>
                <a:lnTo>
                  <a:pt x="3630" y="124"/>
                </a:lnTo>
                <a:lnTo>
                  <a:pt x="3640" y="124"/>
                </a:lnTo>
                <a:lnTo>
                  <a:pt x="3647" y="124"/>
                </a:lnTo>
                <a:lnTo>
                  <a:pt x="3656" y="124"/>
                </a:lnTo>
                <a:lnTo>
                  <a:pt x="3665" y="124"/>
                </a:lnTo>
                <a:lnTo>
                  <a:pt x="3671" y="124"/>
                </a:lnTo>
                <a:lnTo>
                  <a:pt x="3681" y="126"/>
                </a:lnTo>
                <a:lnTo>
                  <a:pt x="3687" y="126"/>
                </a:lnTo>
                <a:lnTo>
                  <a:pt x="3696" y="126"/>
                </a:lnTo>
                <a:lnTo>
                  <a:pt x="3705" y="126"/>
                </a:lnTo>
                <a:lnTo>
                  <a:pt x="3712" y="126"/>
                </a:lnTo>
                <a:lnTo>
                  <a:pt x="3722" y="126"/>
                </a:lnTo>
                <a:lnTo>
                  <a:pt x="3728" y="126"/>
                </a:lnTo>
                <a:lnTo>
                  <a:pt x="3736" y="127"/>
                </a:lnTo>
                <a:lnTo>
                  <a:pt x="3746" y="127"/>
                </a:lnTo>
                <a:lnTo>
                  <a:pt x="3753" y="127"/>
                </a:lnTo>
                <a:lnTo>
                  <a:pt x="3762" y="127"/>
                </a:lnTo>
                <a:lnTo>
                  <a:pt x="3769" y="127"/>
                </a:lnTo>
                <a:lnTo>
                  <a:pt x="3777" y="127"/>
                </a:lnTo>
                <a:lnTo>
                  <a:pt x="3787" y="127"/>
                </a:lnTo>
                <a:lnTo>
                  <a:pt x="3793" y="129"/>
                </a:lnTo>
                <a:lnTo>
                  <a:pt x="3803" y="129"/>
                </a:lnTo>
                <a:lnTo>
                  <a:pt x="3810" y="129"/>
                </a:lnTo>
                <a:lnTo>
                  <a:pt x="3818" y="129"/>
                </a:lnTo>
                <a:lnTo>
                  <a:pt x="3828" y="129"/>
                </a:lnTo>
                <a:lnTo>
                  <a:pt x="3834" y="129"/>
                </a:lnTo>
                <a:lnTo>
                  <a:pt x="3844" y="131"/>
                </a:lnTo>
                <a:lnTo>
                  <a:pt x="3851" y="131"/>
                </a:lnTo>
                <a:lnTo>
                  <a:pt x="3859" y="131"/>
                </a:lnTo>
                <a:lnTo>
                  <a:pt x="3868" y="131"/>
                </a:lnTo>
                <a:lnTo>
                  <a:pt x="3875" y="131"/>
                </a:lnTo>
                <a:lnTo>
                  <a:pt x="3885" y="131"/>
                </a:lnTo>
                <a:lnTo>
                  <a:pt x="3891" y="131"/>
                </a:lnTo>
                <a:lnTo>
                  <a:pt x="3899" y="132"/>
                </a:lnTo>
                <a:lnTo>
                  <a:pt x="3909" y="132"/>
                </a:lnTo>
                <a:lnTo>
                  <a:pt x="3916" y="132"/>
                </a:lnTo>
                <a:lnTo>
                  <a:pt x="3926" y="132"/>
                </a:lnTo>
                <a:lnTo>
                  <a:pt x="3932" y="132"/>
                </a:lnTo>
                <a:lnTo>
                  <a:pt x="3940" y="132"/>
                </a:lnTo>
                <a:lnTo>
                  <a:pt x="3948" y="132"/>
                </a:lnTo>
                <a:lnTo>
                  <a:pt x="3957" y="134"/>
                </a:lnTo>
                <a:lnTo>
                  <a:pt x="3966" y="134"/>
                </a:lnTo>
                <a:lnTo>
                  <a:pt x="3975" y="134"/>
                </a:lnTo>
                <a:lnTo>
                  <a:pt x="3983" y="134"/>
                </a:lnTo>
                <a:lnTo>
                  <a:pt x="3989" y="134"/>
                </a:lnTo>
                <a:lnTo>
                  <a:pt x="3997" y="134"/>
                </a:lnTo>
                <a:lnTo>
                  <a:pt x="4007" y="134"/>
                </a:lnTo>
                <a:lnTo>
                  <a:pt x="4015" y="135"/>
                </a:lnTo>
                <a:lnTo>
                  <a:pt x="4023" y="135"/>
                </a:lnTo>
                <a:lnTo>
                  <a:pt x="4030" y="135"/>
                </a:lnTo>
                <a:lnTo>
                  <a:pt x="4038" y="135"/>
                </a:lnTo>
                <a:lnTo>
                  <a:pt x="4048" y="135"/>
                </a:lnTo>
                <a:lnTo>
                  <a:pt x="4056" y="135"/>
                </a:lnTo>
                <a:lnTo>
                  <a:pt x="4064" y="137"/>
                </a:lnTo>
                <a:lnTo>
                  <a:pt x="4071" y="137"/>
                </a:lnTo>
                <a:lnTo>
                  <a:pt x="4079" y="137"/>
                </a:lnTo>
                <a:lnTo>
                  <a:pt x="4089" y="137"/>
                </a:lnTo>
                <a:lnTo>
                  <a:pt x="4097" y="137"/>
                </a:lnTo>
                <a:lnTo>
                  <a:pt x="4105" y="137"/>
                </a:lnTo>
                <a:lnTo>
                  <a:pt x="4112" y="137"/>
                </a:lnTo>
                <a:lnTo>
                  <a:pt x="4120" y="139"/>
                </a:lnTo>
                <a:lnTo>
                  <a:pt x="4130" y="139"/>
                </a:lnTo>
                <a:lnTo>
                  <a:pt x="4138" y="139"/>
                </a:lnTo>
                <a:lnTo>
                  <a:pt x="4146" y="139"/>
                </a:lnTo>
                <a:lnTo>
                  <a:pt x="4152" y="139"/>
                </a:lnTo>
                <a:lnTo>
                  <a:pt x="4161" y="139"/>
                </a:lnTo>
                <a:lnTo>
                  <a:pt x="4170" y="139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1" name="Freeform 106"/>
          <p:cNvSpPr>
            <a:spLocks/>
          </p:cNvSpPr>
          <p:nvPr/>
        </p:nvSpPr>
        <p:spPr bwMode="auto">
          <a:xfrm>
            <a:off x="1672431" y="4356737"/>
            <a:ext cx="6619875" cy="946150"/>
          </a:xfrm>
          <a:custGeom>
            <a:avLst/>
            <a:gdLst>
              <a:gd name="T0" fmla="*/ 67 w 4170"/>
              <a:gd name="T1" fmla="*/ 596 h 596"/>
              <a:gd name="T2" fmla="*/ 138 w 4170"/>
              <a:gd name="T3" fmla="*/ 596 h 596"/>
              <a:gd name="T4" fmla="*/ 212 w 4170"/>
              <a:gd name="T5" fmla="*/ 596 h 596"/>
              <a:gd name="T6" fmla="*/ 285 w 4170"/>
              <a:gd name="T7" fmla="*/ 596 h 596"/>
              <a:gd name="T8" fmla="*/ 360 w 4170"/>
              <a:gd name="T9" fmla="*/ 462 h 596"/>
              <a:gd name="T10" fmla="*/ 434 w 4170"/>
              <a:gd name="T11" fmla="*/ 437 h 596"/>
              <a:gd name="T12" fmla="*/ 505 w 4170"/>
              <a:gd name="T13" fmla="*/ 413 h 596"/>
              <a:gd name="T14" fmla="*/ 579 w 4170"/>
              <a:gd name="T15" fmla="*/ 390 h 596"/>
              <a:gd name="T16" fmla="*/ 654 w 4170"/>
              <a:gd name="T17" fmla="*/ 367 h 596"/>
              <a:gd name="T18" fmla="*/ 727 w 4170"/>
              <a:gd name="T19" fmla="*/ 346 h 596"/>
              <a:gd name="T20" fmla="*/ 801 w 4170"/>
              <a:gd name="T21" fmla="*/ 325 h 596"/>
              <a:gd name="T22" fmla="*/ 873 w 4170"/>
              <a:gd name="T23" fmla="*/ 305 h 596"/>
              <a:gd name="T24" fmla="*/ 948 w 4170"/>
              <a:gd name="T25" fmla="*/ 284 h 596"/>
              <a:gd name="T26" fmla="*/ 1019 w 4170"/>
              <a:gd name="T27" fmla="*/ 266 h 596"/>
              <a:gd name="T28" fmla="*/ 1095 w 4170"/>
              <a:gd name="T29" fmla="*/ 246 h 596"/>
              <a:gd name="T30" fmla="*/ 1166 w 4170"/>
              <a:gd name="T31" fmla="*/ 228 h 596"/>
              <a:gd name="T32" fmla="*/ 1240 w 4170"/>
              <a:gd name="T33" fmla="*/ 211 h 596"/>
              <a:gd name="T34" fmla="*/ 1315 w 4170"/>
              <a:gd name="T35" fmla="*/ 194 h 596"/>
              <a:gd name="T36" fmla="*/ 1387 w 4170"/>
              <a:gd name="T37" fmla="*/ 178 h 596"/>
              <a:gd name="T38" fmla="*/ 1462 w 4170"/>
              <a:gd name="T39" fmla="*/ 162 h 596"/>
              <a:gd name="T40" fmla="*/ 1533 w 4170"/>
              <a:gd name="T41" fmla="*/ 147 h 596"/>
              <a:gd name="T42" fmla="*/ 1609 w 4170"/>
              <a:gd name="T43" fmla="*/ 132 h 596"/>
              <a:gd name="T44" fmla="*/ 1680 w 4170"/>
              <a:gd name="T45" fmla="*/ 118 h 596"/>
              <a:gd name="T46" fmla="*/ 1755 w 4170"/>
              <a:gd name="T47" fmla="*/ 103 h 596"/>
              <a:gd name="T48" fmla="*/ 1829 w 4170"/>
              <a:gd name="T49" fmla="*/ 90 h 596"/>
              <a:gd name="T50" fmla="*/ 1902 w 4170"/>
              <a:gd name="T51" fmla="*/ 77 h 596"/>
              <a:gd name="T52" fmla="*/ 1976 w 4170"/>
              <a:gd name="T53" fmla="*/ 64 h 596"/>
              <a:gd name="T54" fmla="*/ 2049 w 4170"/>
              <a:gd name="T55" fmla="*/ 52 h 596"/>
              <a:gd name="T56" fmla="*/ 2121 w 4170"/>
              <a:gd name="T57" fmla="*/ 39 h 596"/>
              <a:gd name="T58" fmla="*/ 2194 w 4170"/>
              <a:gd name="T59" fmla="*/ 28 h 596"/>
              <a:gd name="T60" fmla="*/ 2269 w 4170"/>
              <a:gd name="T61" fmla="*/ 18 h 596"/>
              <a:gd name="T62" fmla="*/ 2341 w 4170"/>
              <a:gd name="T63" fmla="*/ 7 h 596"/>
              <a:gd name="T64" fmla="*/ 2416 w 4170"/>
              <a:gd name="T65" fmla="*/ 127 h 596"/>
              <a:gd name="T66" fmla="*/ 2490 w 4170"/>
              <a:gd name="T67" fmla="*/ 129 h 596"/>
              <a:gd name="T68" fmla="*/ 2561 w 4170"/>
              <a:gd name="T69" fmla="*/ 132 h 596"/>
              <a:gd name="T70" fmla="*/ 2635 w 4170"/>
              <a:gd name="T71" fmla="*/ 134 h 596"/>
              <a:gd name="T72" fmla="*/ 2708 w 4170"/>
              <a:gd name="T73" fmla="*/ 136 h 596"/>
              <a:gd name="T74" fmla="*/ 2783 w 4170"/>
              <a:gd name="T75" fmla="*/ 137 h 596"/>
              <a:gd name="T76" fmla="*/ 2857 w 4170"/>
              <a:gd name="T77" fmla="*/ 139 h 596"/>
              <a:gd name="T78" fmla="*/ 2930 w 4170"/>
              <a:gd name="T79" fmla="*/ 140 h 596"/>
              <a:gd name="T80" fmla="*/ 3002 w 4170"/>
              <a:gd name="T81" fmla="*/ 142 h 596"/>
              <a:gd name="T82" fmla="*/ 3075 w 4170"/>
              <a:gd name="T83" fmla="*/ 144 h 596"/>
              <a:gd name="T84" fmla="*/ 3149 w 4170"/>
              <a:gd name="T85" fmla="*/ 145 h 596"/>
              <a:gd name="T86" fmla="*/ 3222 w 4170"/>
              <a:gd name="T87" fmla="*/ 149 h 596"/>
              <a:gd name="T88" fmla="*/ 3296 w 4170"/>
              <a:gd name="T89" fmla="*/ 150 h 596"/>
              <a:gd name="T90" fmla="*/ 3371 w 4170"/>
              <a:gd name="T91" fmla="*/ 152 h 596"/>
              <a:gd name="T92" fmla="*/ 3443 w 4170"/>
              <a:gd name="T93" fmla="*/ 153 h 596"/>
              <a:gd name="T94" fmla="*/ 3518 w 4170"/>
              <a:gd name="T95" fmla="*/ 155 h 596"/>
              <a:gd name="T96" fmla="*/ 3589 w 4170"/>
              <a:gd name="T97" fmla="*/ 157 h 596"/>
              <a:gd name="T98" fmla="*/ 3665 w 4170"/>
              <a:gd name="T99" fmla="*/ 158 h 596"/>
              <a:gd name="T100" fmla="*/ 3736 w 4170"/>
              <a:gd name="T101" fmla="*/ 160 h 596"/>
              <a:gd name="T102" fmla="*/ 3810 w 4170"/>
              <a:gd name="T103" fmla="*/ 162 h 596"/>
              <a:gd name="T104" fmla="*/ 3885 w 4170"/>
              <a:gd name="T105" fmla="*/ 163 h 596"/>
              <a:gd name="T106" fmla="*/ 3957 w 4170"/>
              <a:gd name="T107" fmla="*/ 165 h 596"/>
              <a:gd name="T108" fmla="*/ 4030 w 4170"/>
              <a:gd name="T109" fmla="*/ 167 h 596"/>
              <a:gd name="T110" fmla="*/ 4105 w 4170"/>
              <a:gd name="T111" fmla="*/ 168 h 5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596">
                <a:moveTo>
                  <a:pt x="0" y="596"/>
                </a:moveTo>
                <a:lnTo>
                  <a:pt x="8" y="596"/>
                </a:lnTo>
                <a:lnTo>
                  <a:pt x="16" y="596"/>
                </a:lnTo>
                <a:lnTo>
                  <a:pt x="26" y="596"/>
                </a:lnTo>
                <a:lnTo>
                  <a:pt x="34" y="596"/>
                </a:lnTo>
                <a:lnTo>
                  <a:pt x="40" y="596"/>
                </a:lnTo>
                <a:lnTo>
                  <a:pt x="49" y="596"/>
                </a:lnTo>
                <a:lnTo>
                  <a:pt x="57" y="596"/>
                </a:lnTo>
                <a:lnTo>
                  <a:pt x="67" y="596"/>
                </a:lnTo>
                <a:lnTo>
                  <a:pt x="75" y="596"/>
                </a:lnTo>
                <a:lnTo>
                  <a:pt x="81" y="596"/>
                </a:lnTo>
                <a:lnTo>
                  <a:pt x="89" y="596"/>
                </a:lnTo>
                <a:lnTo>
                  <a:pt x="98" y="596"/>
                </a:lnTo>
                <a:lnTo>
                  <a:pt x="107" y="596"/>
                </a:lnTo>
                <a:lnTo>
                  <a:pt x="116" y="596"/>
                </a:lnTo>
                <a:lnTo>
                  <a:pt x="122" y="596"/>
                </a:lnTo>
                <a:lnTo>
                  <a:pt x="130" y="596"/>
                </a:lnTo>
                <a:lnTo>
                  <a:pt x="138" y="596"/>
                </a:lnTo>
                <a:lnTo>
                  <a:pt x="148" y="596"/>
                </a:lnTo>
                <a:lnTo>
                  <a:pt x="156" y="596"/>
                </a:lnTo>
                <a:lnTo>
                  <a:pt x="163" y="596"/>
                </a:lnTo>
                <a:lnTo>
                  <a:pt x="171" y="596"/>
                </a:lnTo>
                <a:lnTo>
                  <a:pt x="179" y="596"/>
                </a:lnTo>
                <a:lnTo>
                  <a:pt x="189" y="596"/>
                </a:lnTo>
                <a:lnTo>
                  <a:pt x="197" y="596"/>
                </a:lnTo>
                <a:lnTo>
                  <a:pt x="204" y="596"/>
                </a:lnTo>
                <a:lnTo>
                  <a:pt x="212" y="596"/>
                </a:lnTo>
                <a:lnTo>
                  <a:pt x="220" y="596"/>
                </a:lnTo>
                <a:lnTo>
                  <a:pt x="230" y="596"/>
                </a:lnTo>
                <a:lnTo>
                  <a:pt x="238" y="596"/>
                </a:lnTo>
                <a:lnTo>
                  <a:pt x="244" y="596"/>
                </a:lnTo>
                <a:lnTo>
                  <a:pt x="253" y="596"/>
                </a:lnTo>
                <a:lnTo>
                  <a:pt x="261" y="596"/>
                </a:lnTo>
                <a:lnTo>
                  <a:pt x="271" y="596"/>
                </a:lnTo>
                <a:lnTo>
                  <a:pt x="279" y="596"/>
                </a:lnTo>
                <a:lnTo>
                  <a:pt x="285" y="596"/>
                </a:lnTo>
                <a:lnTo>
                  <a:pt x="293" y="596"/>
                </a:lnTo>
                <a:lnTo>
                  <a:pt x="302" y="596"/>
                </a:lnTo>
                <a:lnTo>
                  <a:pt x="311" y="596"/>
                </a:lnTo>
                <a:lnTo>
                  <a:pt x="319" y="596"/>
                </a:lnTo>
                <a:lnTo>
                  <a:pt x="326" y="596"/>
                </a:lnTo>
                <a:lnTo>
                  <a:pt x="334" y="596"/>
                </a:lnTo>
                <a:lnTo>
                  <a:pt x="342" y="468"/>
                </a:lnTo>
                <a:lnTo>
                  <a:pt x="352" y="465"/>
                </a:lnTo>
                <a:lnTo>
                  <a:pt x="360" y="462"/>
                </a:lnTo>
                <a:lnTo>
                  <a:pt x="367" y="460"/>
                </a:lnTo>
                <a:lnTo>
                  <a:pt x="375" y="457"/>
                </a:lnTo>
                <a:lnTo>
                  <a:pt x="383" y="454"/>
                </a:lnTo>
                <a:lnTo>
                  <a:pt x="393" y="450"/>
                </a:lnTo>
                <a:lnTo>
                  <a:pt x="401" y="449"/>
                </a:lnTo>
                <a:lnTo>
                  <a:pt x="408" y="445"/>
                </a:lnTo>
                <a:lnTo>
                  <a:pt x="416" y="442"/>
                </a:lnTo>
                <a:lnTo>
                  <a:pt x="424" y="441"/>
                </a:lnTo>
                <a:lnTo>
                  <a:pt x="434" y="437"/>
                </a:lnTo>
                <a:lnTo>
                  <a:pt x="442" y="434"/>
                </a:lnTo>
                <a:lnTo>
                  <a:pt x="448" y="432"/>
                </a:lnTo>
                <a:lnTo>
                  <a:pt x="457" y="429"/>
                </a:lnTo>
                <a:lnTo>
                  <a:pt x="465" y="426"/>
                </a:lnTo>
                <a:lnTo>
                  <a:pt x="474" y="424"/>
                </a:lnTo>
                <a:lnTo>
                  <a:pt x="483" y="421"/>
                </a:lnTo>
                <a:lnTo>
                  <a:pt x="489" y="419"/>
                </a:lnTo>
                <a:lnTo>
                  <a:pt x="497" y="416"/>
                </a:lnTo>
                <a:lnTo>
                  <a:pt x="505" y="413"/>
                </a:lnTo>
                <a:lnTo>
                  <a:pt x="515" y="411"/>
                </a:lnTo>
                <a:lnTo>
                  <a:pt x="523" y="408"/>
                </a:lnTo>
                <a:lnTo>
                  <a:pt x="532" y="406"/>
                </a:lnTo>
                <a:lnTo>
                  <a:pt x="538" y="403"/>
                </a:lnTo>
                <a:lnTo>
                  <a:pt x="546" y="400"/>
                </a:lnTo>
                <a:lnTo>
                  <a:pt x="556" y="398"/>
                </a:lnTo>
                <a:lnTo>
                  <a:pt x="564" y="395"/>
                </a:lnTo>
                <a:lnTo>
                  <a:pt x="572" y="393"/>
                </a:lnTo>
                <a:lnTo>
                  <a:pt x="579" y="390"/>
                </a:lnTo>
                <a:lnTo>
                  <a:pt x="587" y="388"/>
                </a:lnTo>
                <a:lnTo>
                  <a:pt x="597" y="385"/>
                </a:lnTo>
                <a:lnTo>
                  <a:pt x="605" y="382"/>
                </a:lnTo>
                <a:lnTo>
                  <a:pt x="613" y="380"/>
                </a:lnTo>
                <a:lnTo>
                  <a:pt x="620" y="377"/>
                </a:lnTo>
                <a:lnTo>
                  <a:pt x="628" y="375"/>
                </a:lnTo>
                <a:lnTo>
                  <a:pt x="638" y="372"/>
                </a:lnTo>
                <a:lnTo>
                  <a:pt x="646" y="370"/>
                </a:lnTo>
                <a:lnTo>
                  <a:pt x="654" y="367"/>
                </a:lnTo>
                <a:lnTo>
                  <a:pt x="661" y="366"/>
                </a:lnTo>
                <a:lnTo>
                  <a:pt x="669" y="362"/>
                </a:lnTo>
                <a:lnTo>
                  <a:pt x="678" y="361"/>
                </a:lnTo>
                <a:lnTo>
                  <a:pt x="687" y="357"/>
                </a:lnTo>
                <a:lnTo>
                  <a:pt x="695" y="356"/>
                </a:lnTo>
                <a:lnTo>
                  <a:pt x="701" y="352"/>
                </a:lnTo>
                <a:lnTo>
                  <a:pt x="709" y="351"/>
                </a:lnTo>
                <a:lnTo>
                  <a:pt x="719" y="348"/>
                </a:lnTo>
                <a:lnTo>
                  <a:pt x="727" y="346"/>
                </a:lnTo>
                <a:lnTo>
                  <a:pt x="736" y="344"/>
                </a:lnTo>
                <a:lnTo>
                  <a:pt x="742" y="341"/>
                </a:lnTo>
                <a:lnTo>
                  <a:pt x="750" y="339"/>
                </a:lnTo>
                <a:lnTo>
                  <a:pt x="760" y="336"/>
                </a:lnTo>
                <a:lnTo>
                  <a:pt x="768" y="335"/>
                </a:lnTo>
                <a:lnTo>
                  <a:pt x="776" y="331"/>
                </a:lnTo>
                <a:lnTo>
                  <a:pt x="783" y="330"/>
                </a:lnTo>
                <a:lnTo>
                  <a:pt x="791" y="326"/>
                </a:lnTo>
                <a:lnTo>
                  <a:pt x="801" y="325"/>
                </a:lnTo>
                <a:lnTo>
                  <a:pt x="809" y="323"/>
                </a:lnTo>
                <a:lnTo>
                  <a:pt x="817" y="320"/>
                </a:lnTo>
                <a:lnTo>
                  <a:pt x="824" y="318"/>
                </a:lnTo>
                <a:lnTo>
                  <a:pt x="832" y="315"/>
                </a:lnTo>
                <a:lnTo>
                  <a:pt x="842" y="313"/>
                </a:lnTo>
                <a:lnTo>
                  <a:pt x="850" y="312"/>
                </a:lnTo>
                <a:lnTo>
                  <a:pt x="856" y="308"/>
                </a:lnTo>
                <a:lnTo>
                  <a:pt x="866" y="307"/>
                </a:lnTo>
                <a:lnTo>
                  <a:pt x="873" y="305"/>
                </a:lnTo>
                <a:lnTo>
                  <a:pt x="882" y="302"/>
                </a:lnTo>
                <a:lnTo>
                  <a:pt x="891" y="300"/>
                </a:lnTo>
                <a:lnTo>
                  <a:pt x="897" y="297"/>
                </a:lnTo>
                <a:lnTo>
                  <a:pt x="907" y="295"/>
                </a:lnTo>
                <a:lnTo>
                  <a:pt x="913" y="294"/>
                </a:lnTo>
                <a:lnTo>
                  <a:pt x="923" y="290"/>
                </a:lnTo>
                <a:lnTo>
                  <a:pt x="931" y="289"/>
                </a:lnTo>
                <a:lnTo>
                  <a:pt x="938" y="287"/>
                </a:lnTo>
                <a:lnTo>
                  <a:pt x="948" y="284"/>
                </a:lnTo>
                <a:lnTo>
                  <a:pt x="954" y="282"/>
                </a:lnTo>
                <a:lnTo>
                  <a:pt x="964" y="281"/>
                </a:lnTo>
                <a:lnTo>
                  <a:pt x="972" y="277"/>
                </a:lnTo>
                <a:lnTo>
                  <a:pt x="979" y="276"/>
                </a:lnTo>
                <a:lnTo>
                  <a:pt x="988" y="274"/>
                </a:lnTo>
                <a:lnTo>
                  <a:pt x="995" y="271"/>
                </a:lnTo>
                <a:lnTo>
                  <a:pt x="1005" y="269"/>
                </a:lnTo>
                <a:lnTo>
                  <a:pt x="1013" y="268"/>
                </a:lnTo>
                <a:lnTo>
                  <a:pt x="1019" y="266"/>
                </a:lnTo>
                <a:lnTo>
                  <a:pt x="1029" y="263"/>
                </a:lnTo>
                <a:lnTo>
                  <a:pt x="1036" y="261"/>
                </a:lnTo>
                <a:lnTo>
                  <a:pt x="1044" y="259"/>
                </a:lnTo>
                <a:lnTo>
                  <a:pt x="1054" y="256"/>
                </a:lnTo>
                <a:lnTo>
                  <a:pt x="1060" y="255"/>
                </a:lnTo>
                <a:lnTo>
                  <a:pt x="1070" y="253"/>
                </a:lnTo>
                <a:lnTo>
                  <a:pt x="1077" y="251"/>
                </a:lnTo>
                <a:lnTo>
                  <a:pt x="1085" y="248"/>
                </a:lnTo>
                <a:lnTo>
                  <a:pt x="1095" y="246"/>
                </a:lnTo>
                <a:lnTo>
                  <a:pt x="1101" y="245"/>
                </a:lnTo>
                <a:lnTo>
                  <a:pt x="1111" y="243"/>
                </a:lnTo>
                <a:lnTo>
                  <a:pt x="1117" y="240"/>
                </a:lnTo>
                <a:lnTo>
                  <a:pt x="1126" y="238"/>
                </a:lnTo>
                <a:lnTo>
                  <a:pt x="1135" y="237"/>
                </a:lnTo>
                <a:lnTo>
                  <a:pt x="1142" y="235"/>
                </a:lnTo>
                <a:lnTo>
                  <a:pt x="1152" y="233"/>
                </a:lnTo>
                <a:lnTo>
                  <a:pt x="1158" y="230"/>
                </a:lnTo>
                <a:lnTo>
                  <a:pt x="1166" y="228"/>
                </a:lnTo>
                <a:lnTo>
                  <a:pt x="1176" y="227"/>
                </a:lnTo>
                <a:lnTo>
                  <a:pt x="1183" y="225"/>
                </a:lnTo>
                <a:lnTo>
                  <a:pt x="1192" y="224"/>
                </a:lnTo>
                <a:lnTo>
                  <a:pt x="1199" y="220"/>
                </a:lnTo>
                <a:lnTo>
                  <a:pt x="1207" y="219"/>
                </a:lnTo>
                <a:lnTo>
                  <a:pt x="1217" y="217"/>
                </a:lnTo>
                <a:lnTo>
                  <a:pt x="1223" y="215"/>
                </a:lnTo>
                <a:lnTo>
                  <a:pt x="1233" y="214"/>
                </a:lnTo>
                <a:lnTo>
                  <a:pt x="1240" y="211"/>
                </a:lnTo>
                <a:lnTo>
                  <a:pt x="1248" y="209"/>
                </a:lnTo>
                <a:lnTo>
                  <a:pt x="1258" y="207"/>
                </a:lnTo>
                <a:lnTo>
                  <a:pt x="1264" y="206"/>
                </a:lnTo>
                <a:lnTo>
                  <a:pt x="1274" y="204"/>
                </a:lnTo>
                <a:lnTo>
                  <a:pt x="1281" y="202"/>
                </a:lnTo>
                <a:lnTo>
                  <a:pt x="1289" y="201"/>
                </a:lnTo>
                <a:lnTo>
                  <a:pt x="1299" y="197"/>
                </a:lnTo>
                <a:lnTo>
                  <a:pt x="1305" y="196"/>
                </a:lnTo>
                <a:lnTo>
                  <a:pt x="1315" y="194"/>
                </a:lnTo>
                <a:lnTo>
                  <a:pt x="1323" y="193"/>
                </a:lnTo>
                <a:lnTo>
                  <a:pt x="1330" y="191"/>
                </a:lnTo>
                <a:lnTo>
                  <a:pt x="1339" y="189"/>
                </a:lnTo>
                <a:lnTo>
                  <a:pt x="1346" y="188"/>
                </a:lnTo>
                <a:lnTo>
                  <a:pt x="1356" y="184"/>
                </a:lnTo>
                <a:lnTo>
                  <a:pt x="1364" y="183"/>
                </a:lnTo>
                <a:lnTo>
                  <a:pt x="1370" y="181"/>
                </a:lnTo>
                <a:lnTo>
                  <a:pt x="1380" y="180"/>
                </a:lnTo>
                <a:lnTo>
                  <a:pt x="1387" y="178"/>
                </a:lnTo>
                <a:lnTo>
                  <a:pt x="1396" y="176"/>
                </a:lnTo>
                <a:lnTo>
                  <a:pt x="1405" y="175"/>
                </a:lnTo>
                <a:lnTo>
                  <a:pt x="1411" y="173"/>
                </a:lnTo>
                <a:lnTo>
                  <a:pt x="1421" y="171"/>
                </a:lnTo>
                <a:lnTo>
                  <a:pt x="1427" y="170"/>
                </a:lnTo>
                <a:lnTo>
                  <a:pt x="1437" y="168"/>
                </a:lnTo>
                <a:lnTo>
                  <a:pt x="1445" y="165"/>
                </a:lnTo>
                <a:lnTo>
                  <a:pt x="1452" y="163"/>
                </a:lnTo>
                <a:lnTo>
                  <a:pt x="1462" y="162"/>
                </a:lnTo>
                <a:lnTo>
                  <a:pt x="1468" y="160"/>
                </a:lnTo>
                <a:lnTo>
                  <a:pt x="1478" y="158"/>
                </a:lnTo>
                <a:lnTo>
                  <a:pt x="1486" y="157"/>
                </a:lnTo>
                <a:lnTo>
                  <a:pt x="1493" y="155"/>
                </a:lnTo>
                <a:lnTo>
                  <a:pt x="1502" y="153"/>
                </a:lnTo>
                <a:lnTo>
                  <a:pt x="1509" y="152"/>
                </a:lnTo>
                <a:lnTo>
                  <a:pt x="1519" y="150"/>
                </a:lnTo>
                <a:lnTo>
                  <a:pt x="1527" y="149"/>
                </a:lnTo>
                <a:lnTo>
                  <a:pt x="1533" y="147"/>
                </a:lnTo>
                <a:lnTo>
                  <a:pt x="1543" y="145"/>
                </a:lnTo>
                <a:lnTo>
                  <a:pt x="1550" y="144"/>
                </a:lnTo>
                <a:lnTo>
                  <a:pt x="1560" y="142"/>
                </a:lnTo>
                <a:lnTo>
                  <a:pt x="1568" y="140"/>
                </a:lnTo>
                <a:lnTo>
                  <a:pt x="1574" y="139"/>
                </a:lnTo>
                <a:lnTo>
                  <a:pt x="1584" y="137"/>
                </a:lnTo>
                <a:lnTo>
                  <a:pt x="1591" y="136"/>
                </a:lnTo>
                <a:lnTo>
                  <a:pt x="1599" y="134"/>
                </a:lnTo>
                <a:lnTo>
                  <a:pt x="1609" y="132"/>
                </a:lnTo>
                <a:lnTo>
                  <a:pt x="1615" y="131"/>
                </a:lnTo>
                <a:lnTo>
                  <a:pt x="1625" y="129"/>
                </a:lnTo>
                <a:lnTo>
                  <a:pt x="1633" y="127"/>
                </a:lnTo>
                <a:lnTo>
                  <a:pt x="1640" y="126"/>
                </a:lnTo>
                <a:lnTo>
                  <a:pt x="1648" y="124"/>
                </a:lnTo>
                <a:lnTo>
                  <a:pt x="1656" y="122"/>
                </a:lnTo>
                <a:lnTo>
                  <a:pt x="1666" y="121"/>
                </a:lnTo>
                <a:lnTo>
                  <a:pt x="1674" y="119"/>
                </a:lnTo>
                <a:lnTo>
                  <a:pt x="1680" y="118"/>
                </a:lnTo>
                <a:lnTo>
                  <a:pt x="1688" y="116"/>
                </a:lnTo>
                <a:lnTo>
                  <a:pt x="1697" y="114"/>
                </a:lnTo>
                <a:lnTo>
                  <a:pt x="1706" y="113"/>
                </a:lnTo>
                <a:lnTo>
                  <a:pt x="1715" y="111"/>
                </a:lnTo>
                <a:lnTo>
                  <a:pt x="1721" y="109"/>
                </a:lnTo>
                <a:lnTo>
                  <a:pt x="1729" y="108"/>
                </a:lnTo>
                <a:lnTo>
                  <a:pt x="1739" y="106"/>
                </a:lnTo>
                <a:lnTo>
                  <a:pt x="1747" y="105"/>
                </a:lnTo>
                <a:lnTo>
                  <a:pt x="1755" y="103"/>
                </a:lnTo>
                <a:lnTo>
                  <a:pt x="1762" y="101"/>
                </a:lnTo>
                <a:lnTo>
                  <a:pt x="1770" y="101"/>
                </a:lnTo>
                <a:lnTo>
                  <a:pt x="1780" y="100"/>
                </a:lnTo>
                <a:lnTo>
                  <a:pt x="1788" y="98"/>
                </a:lnTo>
                <a:lnTo>
                  <a:pt x="1796" y="96"/>
                </a:lnTo>
                <a:lnTo>
                  <a:pt x="1803" y="95"/>
                </a:lnTo>
                <a:lnTo>
                  <a:pt x="1811" y="93"/>
                </a:lnTo>
                <a:lnTo>
                  <a:pt x="1821" y="91"/>
                </a:lnTo>
                <a:lnTo>
                  <a:pt x="1829" y="90"/>
                </a:lnTo>
                <a:lnTo>
                  <a:pt x="1835" y="88"/>
                </a:lnTo>
                <a:lnTo>
                  <a:pt x="1844" y="87"/>
                </a:lnTo>
                <a:lnTo>
                  <a:pt x="1852" y="85"/>
                </a:lnTo>
                <a:lnTo>
                  <a:pt x="1861" y="85"/>
                </a:lnTo>
                <a:lnTo>
                  <a:pt x="1870" y="83"/>
                </a:lnTo>
                <a:lnTo>
                  <a:pt x="1876" y="82"/>
                </a:lnTo>
                <a:lnTo>
                  <a:pt x="1884" y="80"/>
                </a:lnTo>
                <a:lnTo>
                  <a:pt x="1892" y="78"/>
                </a:lnTo>
                <a:lnTo>
                  <a:pt x="1902" y="77"/>
                </a:lnTo>
                <a:lnTo>
                  <a:pt x="1910" y="75"/>
                </a:lnTo>
                <a:lnTo>
                  <a:pt x="1917" y="74"/>
                </a:lnTo>
                <a:lnTo>
                  <a:pt x="1925" y="72"/>
                </a:lnTo>
                <a:lnTo>
                  <a:pt x="1933" y="72"/>
                </a:lnTo>
                <a:lnTo>
                  <a:pt x="1943" y="70"/>
                </a:lnTo>
                <a:lnTo>
                  <a:pt x="1951" y="69"/>
                </a:lnTo>
                <a:lnTo>
                  <a:pt x="1958" y="67"/>
                </a:lnTo>
                <a:lnTo>
                  <a:pt x="1966" y="65"/>
                </a:lnTo>
                <a:lnTo>
                  <a:pt x="1976" y="64"/>
                </a:lnTo>
                <a:lnTo>
                  <a:pt x="1984" y="62"/>
                </a:lnTo>
                <a:lnTo>
                  <a:pt x="1992" y="62"/>
                </a:lnTo>
                <a:lnTo>
                  <a:pt x="1999" y="60"/>
                </a:lnTo>
                <a:lnTo>
                  <a:pt x="2007" y="59"/>
                </a:lnTo>
                <a:lnTo>
                  <a:pt x="2015" y="57"/>
                </a:lnTo>
                <a:lnTo>
                  <a:pt x="2023" y="56"/>
                </a:lnTo>
                <a:lnTo>
                  <a:pt x="2033" y="54"/>
                </a:lnTo>
                <a:lnTo>
                  <a:pt x="2039" y="54"/>
                </a:lnTo>
                <a:lnTo>
                  <a:pt x="2049" y="52"/>
                </a:lnTo>
                <a:lnTo>
                  <a:pt x="2056" y="51"/>
                </a:lnTo>
                <a:lnTo>
                  <a:pt x="2065" y="49"/>
                </a:lnTo>
                <a:lnTo>
                  <a:pt x="2074" y="47"/>
                </a:lnTo>
                <a:lnTo>
                  <a:pt x="2080" y="46"/>
                </a:lnTo>
                <a:lnTo>
                  <a:pt x="2090" y="46"/>
                </a:lnTo>
                <a:lnTo>
                  <a:pt x="2096" y="44"/>
                </a:lnTo>
                <a:lnTo>
                  <a:pt x="2106" y="43"/>
                </a:lnTo>
                <a:lnTo>
                  <a:pt x="2113" y="41"/>
                </a:lnTo>
                <a:lnTo>
                  <a:pt x="2121" y="39"/>
                </a:lnTo>
                <a:lnTo>
                  <a:pt x="2131" y="39"/>
                </a:lnTo>
                <a:lnTo>
                  <a:pt x="2137" y="38"/>
                </a:lnTo>
                <a:lnTo>
                  <a:pt x="2147" y="36"/>
                </a:lnTo>
                <a:lnTo>
                  <a:pt x="2154" y="34"/>
                </a:lnTo>
                <a:lnTo>
                  <a:pt x="2163" y="34"/>
                </a:lnTo>
                <a:lnTo>
                  <a:pt x="2171" y="33"/>
                </a:lnTo>
                <a:lnTo>
                  <a:pt x="2178" y="31"/>
                </a:lnTo>
                <a:lnTo>
                  <a:pt x="2188" y="29"/>
                </a:lnTo>
                <a:lnTo>
                  <a:pt x="2194" y="28"/>
                </a:lnTo>
                <a:lnTo>
                  <a:pt x="2202" y="28"/>
                </a:lnTo>
                <a:lnTo>
                  <a:pt x="2212" y="26"/>
                </a:lnTo>
                <a:lnTo>
                  <a:pt x="2220" y="25"/>
                </a:lnTo>
                <a:lnTo>
                  <a:pt x="2229" y="23"/>
                </a:lnTo>
                <a:lnTo>
                  <a:pt x="2235" y="23"/>
                </a:lnTo>
                <a:lnTo>
                  <a:pt x="2243" y="21"/>
                </a:lnTo>
                <a:lnTo>
                  <a:pt x="2251" y="20"/>
                </a:lnTo>
                <a:lnTo>
                  <a:pt x="2261" y="18"/>
                </a:lnTo>
                <a:lnTo>
                  <a:pt x="2269" y="18"/>
                </a:lnTo>
                <a:lnTo>
                  <a:pt x="2278" y="16"/>
                </a:lnTo>
                <a:lnTo>
                  <a:pt x="2284" y="15"/>
                </a:lnTo>
                <a:lnTo>
                  <a:pt x="2292" y="13"/>
                </a:lnTo>
                <a:lnTo>
                  <a:pt x="2300" y="13"/>
                </a:lnTo>
                <a:lnTo>
                  <a:pt x="2310" y="12"/>
                </a:lnTo>
                <a:lnTo>
                  <a:pt x="2317" y="10"/>
                </a:lnTo>
                <a:lnTo>
                  <a:pt x="2326" y="8"/>
                </a:lnTo>
                <a:lnTo>
                  <a:pt x="2335" y="8"/>
                </a:lnTo>
                <a:lnTo>
                  <a:pt x="2341" y="7"/>
                </a:lnTo>
                <a:lnTo>
                  <a:pt x="2351" y="5"/>
                </a:lnTo>
                <a:lnTo>
                  <a:pt x="2357" y="3"/>
                </a:lnTo>
                <a:lnTo>
                  <a:pt x="2366" y="3"/>
                </a:lnTo>
                <a:lnTo>
                  <a:pt x="2375" y="2"/>
                </a:lnTo>
                <a:lnTo>
                  <a:pt x="2382" y="0"/>
                </a:lnTo>
                <a:lnTo>
                  <a:pt x="2390" y="127"/>
                </a:lnTo>
                <a:lnTo>
                  <a:pt x="2400" y="127"/>
                </a:lnTo>
                <a:lnTo>
                  <a:pt x="2408" y="127"/>
                </a:lnTo>
                <a:lnTo>
                  <a:pt x="2416" y="127"/>
                </a:lnTo>
                <a:lnTo>
                  <a:pt x="2424" y="127"/>
                </a:lnTo>
                <a:lnTo>
                  <a:pt x="2433" y="129"/>
                </a:lnTo>
                <a:lnTo>
                  <a:pt x="2439" y="129"/>
                </a:lnTo>
                <a:lnTo>
                  <a:pt x="2449" y="129"/>
                </a:lnTo>
                <a:lnTo>
                  <a:pt x="2455" y="129"/>
                </a:lnTo>
                <a:lnTo>
                  <a:pt x="2464" y="129"/>
                </a:lnTo>
                <a:lnTo>
                  <a:pt x="2473" y="129"/>
                </a:lnTo>
                <a:lnTo>
                  <a:pt x="2480" y="129"/>
                </a:lnTo>
                <a:lnTo>
                  <a:pt x="2490" y="129"/>
                </a:lnTo>
                <a:lnTo>
                  <a:pt x="2498" y="131"/>
                </a:lnTo>
                <a:lnTo>
                  <a:pt x="2506" y="131"/>
                </a:lnTo>
                <a:lnTo>
                  <a:pt x="2513" y="131"/>
                </a:lnTo>
                <a:lnTo>
                  <a:pt x="2521" y="131"/>
                </a:lnTo>
                <a:lnTo>
                  <a:pt x="2529" y="131"/>
                </a:lnTo>
                <a:lnTo>
                  <a:pt x="2539" y="131"/>
                </a:lnTo>
                <a:lnTo>
                  <a:pt x="2547" y="131"/>
                </a:lnTo>
                <a:lnTo>
                  <a:pt x="2555" y="131"/>
                </a:lnTo>
                <a:lnTo>
                  <a:pt x="2561" y="132"/>
                </a:lnTo>
                <a:lnTo>
                  <a:pt x="2570" y="132"/>
                </a:lnTo>
                <a:lnTo>
                  <a:pt x="2578" y="132"/>
                </a:lnTo>
                <a:lnTo>
                  <a:pt x="2588" y="132"/>
                </a:lnTo>
                <a:lnTo>
                  <a:pt x="2594" y="132"/>
                </a:lnTo>
                <a:lnTo>
                  <a:pt x="2604" y="132"/>
                </a:lnTo>
                <a:lnTo>
                  <a:pt x="2610" y="132"/>
                </a:lnTo>
                <a:lnTo>
                  <a:pt x="2620" y="132"/>
                </a:lnTo>
                <a:lnTo>
                  <a:pt x="2627" y="134"/>
                </a:lnTo>
                <a:lnTo>
                  <a:pt x="2635" y="134"/>
                </a:lnTo>
                <a:lnTo>
                  <a:pt x="2645" y="134"/>
                </a:lnTo>
                <a:lnTo>
                  <a:pt x="2651" y="134"/>
                </a:lnTo>
                <a:lnTo>
                  <a:pt x="2661" y="134"/>
                </a:lnTo>
                <a:lnTo>
                  <a:pt x="2668" y="134"/>
                </a:lnTo>
                <a:lnTo>
                  <a:pt x="2676" y="134"/>
                </a:lnTo>
                <a:lnTo>
                  <a:pt x="2685" y="134"/>
                </a:lnTo>
                <a:lnTo>
                  <a:pt x="2692" y="136"/>
                </a:lnTo>
                <a:lnTo>
                  <a:pt x="2702" y="136"/>
                </a:lnTo>
                <a:lnTo>
                  <a:pt x="2708" y="136"/>
                </a:lnTo>
                <a:lnTo>
                  <a:pt x="2718" y="136"/>
                </a:lnTo>
                <a:lnTo>
                  <a:pt x="2726" y="136"/>
                </a:lnTo>
                <a:lnTo>
                  <a:pt x="2733" y="136"/>
                </a:lnTo>
                <a:lnTo>
                  <a:pt x="2743" y="136"/>
                </a:lnTo>
                <a:lnTo>
                  <a:pt x="2749" y="136"/>
                </a:lnTo>
                <a:lnTo>
                  <a:pt x="2759" y="137"/>
                </a:lnTo>
                <a:lnTo>
                  <a:pt x="2765" y="137"/>
                </a:lnTo>
                <a:lnTo>
                  <a:pt x="2774" y="137"/>
                </a:lnTo>
                <a:lnTo>
                  <a:pt x="2783" y="137"/>
                </a:lnTo>
                <a:lnTo>
                  <a:pt x="2790" y="137"/>
                </a:lnTo>
                <a:lnTo>
                  <a:pt x="2798" y="137"/>
                </a:lnTo>
                <a:lnTo>
                  <a:pt x="2808" y="137"/>
                </a:lnTo>
                <a:lnTo>
                  <a:pt x="2816" y="137"/>
                </a:lnTo>
                <a:lnTo>
                  <a:pt x="2824" y="139"/>
                </a:lnTo>
                <a:lnTo>
                  <a:pt x="2831" y="139"/>
                </a:lnTo>
                <a:lnTo>
                  <a:pt x="2839" y="139"/>
                </a:lnTo>
                <a:lnTo>
                  <a:pt x="2849" y="139"/>
                </a:lnTo>
                <a:lnTo>
                  <a:pt x="2857" y="139"/>
                </a:lnTo>
                <a:lnTo>
                  <a:pt x="2865" y="139"/>
                </a:lnTo>
                <a:lnTo>
                  <a:pt x="2871" y="139"/>
                </a:lnTo>
                <a:lnTo>
                  <a:pt x="2880" y="139"/>
                </a:lnTo>
                <a:lnTo>
                  <a:pt x="2889" y="140"/>
                </a:lnTo>
                <a:lnTo>
                  <a:pt x="2898" y="140"/>
                </a:lnTo>
                <a:lnTo>
                  <a:pt x="2904" y="140"/>
                </a:lnTo>
                <a:lnTo>
                  <a:pt x="2912" y="140"/>
                </a:lnTo>
                <a:lnTo>
                  <a:pt x="2920" y="140"/>
                </a:lnTo>
                <a:lnTo>
                  <a:pt x="2930" y="140"/>
                </a:lnTo>
                <a:lnTo>
                  <a:pt x="2938" y="140"/>
                </a:lnTo>
                <a:lnTo>
                  <a:pt x="2945" y="140"/>
                </a:lnTo>
                <a:lnTo>
                  <a:pt x="2953" y="142"/>
                </a:lnTo>
                <a:lnTo>
                  <a:pt x="2961" y="142"/>
                </a:lnTo>
                <a:lnTo>
                  <a:pt x="2971" y="142"/>
                </a:lnTo>
                <a:lnTo>
                  <a:pt x="2979" y="142"/>
                </a:lnTo>
                <a:lnTo>
                  <a:pt x="2986" y="142"/>
                </a:lnTo>
                <a:lnTo>
                  <a:pt x="2994" y="142"/>
                </a:lnTo>
                <a:lnTo>
                  <a:pt x="3002" y="142"/>
                </a:lnTo>
                <a:lnTo>
                  <a:pt x="3012" y="142"/>
                </a:lnTo>
                <a:lnTo>
                  <a:pt x="3020" y="144"/>
                </a:lnTo>
                <a:lnTo>
                  <a:pt x="3027" y="144"/>
                </a:lnTo>
                <a:lnTo>
                  <a:pt x="3035" y="144"/>
                </a:lnTo>
                <a:lnTo>
                  <a:pt x="3044" y="144"/>
                </a:lnTo>
                <a:lnTo>
                  <a:pt x="3053" y="144"/>
                </a:lnTo>
                <a:lnTo>
                  <a:pt x="3061" y="144"/>
                </a:lnTo>
                <a:lnTo>
                  <a:pt x="3067" y="144"/>
                </a:lnTo>
                <a:lnTo>
                  <a:pt x="3075" y="144"/>
                </a:lnTo>
                <a:lnTo>
                  <a:pt x="3085" y="144"/>
                </a:lnTo>
                <a:lnTo>
                  <a:pt x="3093" y="145"/>
                </a:lnTo>
                <a:lnTo>
                  <a:pt x="3102" y="145"/>
                </a:lnTo>
                <a:lnTo>
                  <a:pt x="3108" y="145"/>
                </a:lnTo>
                <a:lnTo>
                  <a:pt x="3116" y="145"/>
                </a:lnTo>
                <a:lnTo>
                  <a:pt x="3126" y="145"/>
                </a:lnTo>
                <a:lnTo>
                  <a:pt x="3134" y="145"/>
                </a:lnTo>
                <a:lnTo>
                  <a:pt x="3142" y="145"/>
                </a:lnTo>
                <a:lnTo>
                  <a:pt x="3149" y="145"/>
                </a:lnTo>
                <a:lnTo>
                  <a:pt x="3157" y="147"/>
                </a:lnTo>
                <a:lnTo>
                  <a:pt x="3167" y="147"/>
                </a:lnTo>
                <a:lnTo>
                  <a:pt x="3173" y="147"/>
                </a:lnTo>
                <a:lnTo>
                  <a:pt x="3182" y="147"/>
                </a:lnTo>
                <a:lnTo>
                  <a:pt x="3191" y="147"/>
                </a:lnTo>
                <a:lnTo>
                  <a:pt x="3198" y="147"/>
                </a:lnTo>
                <a:lnTo>
                  <a:pt x="3208" y="147"/>
                </a:lnTo>
                <a:lnTo>
                  <a:pt x="3214" y="147"/>
                </a:lnTo>
                <a:lnTo>
                  <a:pt x="3222" y="149"/>
                </a:lnTo>
                <a:lnTo>
                  <a:pt x="3232" y="149"/>
                </a:lnTo>
                <a:lnTo>
                  <a:pt x="3239" y="149"/>
                </a:lnTo>
                <a:lnTo>
                  <a:pt x="3248" y="149"/>
                </a:lnTo>
                <a:lnTo>
                  <a:pt x="3255" y="149"/>
                </a:lnTo>
                <a:lnTo>
                  <a:pt x="3263" y="149"/>
                </a:lnTo>
                <a:lnTo>
                  <a:pt x="3273" y="149"/>
                </a:lnTo>
                <a:lnTo>
                  <a:pt x="3279" y="149"/>
                </a:lnTo>
                <a:lnTo>
                  <a:pt x="3289" y="149"/>
                </a:lnTo>
                <a:lnTo>
                  <a:pt x="3296" y="150"/>
                </a:lnTo>
                <a:lnTo>
                  <a:pt x="3304" y="150"/>
                </a:lnTo>
                <a:lnTo>
                  <a:pt x="3314" y="150"/>
                </a:lnTo>
                <a:lnTo>
                  <a:pt x="3320" y="150"/>
                </a:lnTo>
                <a:lnTo>
                  <a:pt x="3330" y="150"/>
                </a:lnTo>
                <a:lnTo>
                  <a:pt x="3337" y="150"/>
                </a:lnTo>
                <a:lnTo>
                  <a:pt x="3345" y="150"/>
                </a:lnTo>
                <a:lnTo>
                  <a:pt x="3354" y="150"/>
                </a:lnTo>
                <a:lnTo>
                  <a:pt x="3361" y="152"/>
                </a:lnTo>
                <a:lnTo>
                  <a:pt x="3371" y="152"/>
                </a:lnTo>
                <a:lnTo>
                  <a:pt x="3377" y="152"/>
                </a:lnTo>
                <a:lnTo>
                  <a:pt x="3385" y="152"/>
                </a:lnTo>
                <a:lnTo>
                  <a:pt x="3395" y="152"/>
                </a:lnTo>
                <a:lnTo>
                  <a:pt x="3402" y="152"/>
                </a:lnTo>
                <a:lnTo>
                  <a:pt x="3412" y="152"/>
                </a:lnTo>
                <a:lnTo>
                  <a:pt x="3418" y="152"/>
                </a:lnTo>
                <a:lnTo>
                  <a:pt x="3426" y="153"/>
                </a:lnTo>
                <a:lnTo>
                  <a:pt x="3436" y="153"/>
                </a:lnTo>
                <a:lnTo>
                  <a:pt x="3443" y="153"/>
                </a:lnTo>
                <a:lnTo>
                  <a:pt x="3452" y="153"/>
                </a:lnTo>
                <a:lnTo>
                  <a:pt x="3461" y="153"/>
                </a:lnTo>
                <a:lnTo>
                  <a:pt x="3467" y="153"/>
                </a:lnTo>
                <a:lnTo>
                  <a:pt x="3477" y="153"/>
                </a:lnTo>
                <a:lnTo>
                  <a:pt x="3483" y="153"/>
                </a:lnTo>
                <a:lnTo>
                  <a:pt x="3493" y="153"/>
                </a:lnTo>
                <a:lnTo>
                  <a:pt x="3501" y="155"/>
                </a:lnTo>
                <a:lnTo>
                  <a:pt x="3508" y="155"/>
                </a:lnTo>
                <a:lnTo>
                  <a:pt x="3518" y="155"/>
                </a:lnTo>
                <a:lnTo>
                  <a:pt x="3524" y="155"/>
                </a:lnTo>
                <a:lnTo>
                  <a:pt x="3534" y="155"/>
                </a:lnTo>
                <a:lnTo>
                  <a:pt x="3542" y="155"/>
                </a:lnTo>
                <a:lnTo>
                  <a:pt x="3549" y="155"/>
                </a:lnTo>
                <a:lnTo>
                  <a:pt x="3558" y="155"/>
                </a:lnTo>
                <a:lnTo>
                  <a:pt x="3565" y="157"/>
                </a:lnTo>
                <a:lnTo>
                  <a:pt x="3575" y="157"/>
                </a:lnTo>
                <a:lnTo>
                  <a:pt x="3583" y="157"/>
                </a:lnTo>
                <a:lnTo>
                  <a:pt x="3589" y="157"/>
                </a:lnTo>
                <a:lnTo>
                  <a:pt x="3599" y="157"/>
                </a:lnTo>
                <a:lnTo>
                  <a:pt x="3606" y="157"/>
                </a:lnTo>
                <a:lnTo>
                  <a:pt x="3616" y="157"/>
                </a:lnTo>
                <a:lnTo>
                  <a:pt x="3624" y="157"/>
                </a:lnTo>
                <a:lnTo>
                  <a:pt x="3630" y="157"/>
                </a:lnTo>
                <a:lnTo>
                  <a:pt x="3640" y="158"/>
                </a:lnTo>
                <a:lnTo>
                  <a:pt x="3647" y="158"/>
                </a:lnTo>
                <a:lnTo>
                  <a:pt x="3656" y="158"/>
                </a:lnTo>
                <a:lnTo>
                  <a:pt x="3665" y="158"/>
                </a:lnTo>
                <a:lnTo>
                  <a:pt x="3671" y="158"/>
                </a:lnTo>
                <a:lnTo>
                  <a:pt x="3681" y="158"/>
                </a:lnTo>
                <a:lnTo>
                  <a:pt x="3687" y="158"/>
                </a:lnTo>
                <a:lnTo>
                  <a:pt x="3696" y="158"/>
                </a:lnTo>
                <a:lnTo>
                  <a:pt x="3705" y="160"/>
                </a:lnTo>
                <a:lnTo>
                  <a:pt x="3712" y="160"/>
                </a:lnTo>
                <a:lnTo>
                  <a:pt x="3722" y="160"/>
                </a:lnTo>
                <a:lnTo>
                  <a:pt x="3728" y="160"/>
                </a:lnTo>
                <a:lnTo>
                  <a:pt x="3736" y="160"/>
                </a:lnTo>
                <a:lnTo>
                  <a:pt x="3746" y="160"/>
                </a:lnTo>
                <a:lnTo>
                  <a:pt x="3753" y="160"/>
                </a:lnTo>
                <a:lnTo>
                  <a:pt x="3762" y="160"/>
                </a:lnTo>
                <a:lnTo>
                  <a:pt x="3769" y="160"/>
                </a:lnTo>
                <a:lnTo>
                  <a:pt x="3777" y="162"/>
                </a:lnTo>
                <a:lnTo>
                  <a:pt x="3787" y="162"/>
                </a:lnTo>
                <a:lnTo>
                  <a:pt x="3793" y="162"/>
                </a:lnTo>
                <a:lnTo>
                  <a:pt x="3803" y="162"/>
                </a:lnTo>
                <a:lnTo>
                  <a:pt x="3810" y="162"/>
                </a:lnTo>
                <a:lnTo>
                  <a:pt x="3818" y="162"/>
                </a:lnTo>
                <a:lnTo>
                  <a:pt x="3828" y="162"/>
                </a:lnTo>
                <a:lnTo>
                  <a:pt x="3834" y="162"/>
                </a:lnTo>
                <a:lnTo>
                  <a:pt x="3844" y="163"/>
                </a:lnTo>
                <a:lnTo>
                  <a:pt x="3851" y="163"/>
                </a:lnTo>
                <a:lnTo>
                  <a:pt x="3859" y="163"/>
                </a:lnTo>
                <a:lnTo>
                  <a:pt x="3868" y="163"/>
                </a:lnTo>
                <a:lnTo>
                  <a:pt x="3875" y="163"/>
                </a:lnTo>
                <a:lnTo>
                  <a:pt x="3885" y="163"/>
                </a:lnTo>
                <a:lnTo>
                  <a:pt x="3891" y="163"/>
                </a:lnTo>
                <a:lnTo>
                  <a:pt x="3899" y="163"/>
                </a:lnTo>
                <a:lnTo>
                  <a:pt x="3909" y="163"/>
                </a:lnTo>
                <a:lnTo>
                  <a:pt x="3916" y="165"/>
                </a:lnTo>
                <a:lnTo>
                  <a:pt x="3926" y="165"/>
                </a:lnTo>
                <a:lnTo>
                  <a:pt x="3932" y="165"/>
                </a:lnTo>
                <a:lnTo>
                  <a:pt x="3940" y="165"/>
                </a:lnTo>
                <a:lnTo>
                  <a:pt x="3948" y="165"/>
                </a:lnTo>
                <a:lnTo>
                  <a:pt x="3957" y="165"/>
                </a:lnTo>
                <a:lnTo>
                  <a:pt x="3966" y="165"/>
                </a:lnTo>
                <a:lnTo>
                  <a:pt x="3975" y="165"/>
                </a:lnTo>
                <a:lnTo>
                  <a:pt x="3983" y="165"/>
                </a:lnTo>
                <a:lnTo>
                  <a:pt x="3989" y="167"/>
                </a:lnTo>
                <a:lnTo>
                  <a:pt x="3997" y="167"/>
                </a:lnTo>
                <a:lnTo>
                  <a:pt x="4007" y="167"/>
                </a:lnTo>
                <a:lnTo>
                  <a:pt x="4015" y="167"/>
                </a:lnTo>
                <a:lnTo>
                  <a:pt x="4023" y="167"/>
                </a:lnTo>
                <a:lnTo>
                  <a:pt x="4030" y="167"/>
                </a:lnTo>
                <a:lnTo>
                  <a:pt x="4038" y="167"/>
                </a:lnTo>
                <a:lnTo>
                  <a:pt x="4048" y="167"/>
                </a:lnTo>
                <a:lnTo>
                  <a:pt x="4056" y="168"/>
                </a:lnTo>
                <a:lnTo>
                  <a:pt x="4064" y="168"/>
                </a:lnTo>
                <a:lnTo>
                  <a:pt x="4071" y="168"/>
                </a:lnTo>
                <a:lnTo>
                  <a:pt x="4079" y="168"/>
                </a:lnTo>
                <a:lnTo>
                  <a:pt x="4089" y="168"/>
                </a:lnTo>
                <a:lnTo>
                  <a:pt x="4097" y="168"/>
                </a:lnTo>
                <a:lnTo>
                  <a:pt x="4105" y="168"/>
                </a:lnTo>
                <a:lnTo>
                  <a:pt x="4112" y="168"/>
                </a:lnTo>
                <a:lnTo>
                  <a:pt x="4120" y="168"/>
                </a:lnTo>
                <a:lnTo>
                  <a:pt x="4130" y="170"/>
                </a:lnTo>
                <a:lnTo>
                  <a:pt x="4138" y="170"/>
                </a:lnTo>
                <a:lnTo>
                  <a:pt x="4146" y="170"/>
                </a:lnTo>
                <a:lnTo>
                  <a:pt x="4152" y="170"/>
                </a:lnTo>
                <a:lnTo>
                  <a:pt x="4161" y="170"/>
                </a:lnTo>
                <a:lnTo>
                  <a:pt x="4170" y="17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2" name="Freeform 107"/>
          <p:cNvSpPr>
            <a:spLocks/>
          </p:cNvSpPr>
          <p:nvPr/>
        </p:nvSpPr>
        <p:spPr bwMode="auto">
          <a:xfrm>
            <a:off x="1672431" y="4804412"/>
            <a:ext cx="6619875" cy="498475"/>
          </a:xfrm>
          <a:custGeom>
            <a:avLst/>
            <a:gdLst>
              <a:gd name="T0" fmla="*/ 67 w 4170"/>
              <a:gd name="T1" fmla="*/ 314 h 314"/>
              <a:gd name="T2" fmla="*/ 138 w 4170"/>
              <a:gd name="T3" fmla="*/ 314 h 314"/>
              <a:gd name="T4" fmla="*/ 212 w 4170"/>
              <a:gd name="T5" fmla="*/ 314 h 314"/>
              <a:gd name="T6" fmla="*/ 285 w 4170"/>
              <a:gd name="T7" fmla="*/ 314 h 314"/>
              <a:gd name="T8" fmla="*/ 360 w 4170"/>
              <a:gd name="T9" fmla="*/ 274 h 314"/>
              <a:gd name="T10" fmla="*/ 434 w 4170"/>
              <a:gd name="T11" fmla="*/ 263 h 314"/>
              <a:gd name="T12" fmla="*/ 505 w 4170"/>
              <a:gd name="T13" fmla="*/ 250 h 314"/>
              <a:gd name="T14" fmla="*/ 579 w 4170"/>
              <a:gd name="T15" fmla="*/ 238 h 314"/>
              <a:gd name="T16" fmla="*/ 654 w 4170"/>
              <a:gd name="T17" fmla="*/ 227 h 314"/>
              <a:gd name="T18" fmla="*/ 727 w 4170"/>
              <a:gd name="T19" fmla="*/ 214 h 314"/>
              <a:gd name="T20" fmla="*/ 801 w 4170"/>
              <a:gd name="T21" fmla="*/ 203 h 314"/>
              <a:gd name="T22" fmla="*/ 873 w 4170"/>
              <a:gd name="T23" fmla="*/ 193 h 314"/>
              <a:gd name="T24" fmla="*/ 948 w 4170"/>
              <a:gd name="T25" fmla="*/ 181 h 314"/>
              <a:gd name="T26" fmla="*/ 1019 w 4170"/>
              <a:gd name="T27" fmla="*/ 170 h 314"/>
              <a:gd name="T28" fmla="*/ 1095 w 4170"/>
              <a:gd name="T29" fmla="*/ 160 h 314"/>
              <a:gd name="T30" fmla="*/ 1166 w 4170"/>
              <a:gd name="T31" fmla="*/ 149 h 314"/>
              <a:gd name="T32" fmla="*/ 1240 w 4170"/>
              <a:gd name="T33" fmla="*/ 139 h 314"/>
              <a:gd name="T34" fmla="*/ 1315 w 4170"/>
              <a:gd name="T35" fmla="*/ 129 h 314"/>
              <a:gd name="T36" fmla="*/ 1387 w 4170"/>
              <a:gd name="T37" fmla="*/ 119 h 314"/>
              <a:gd name="T38" fmla="*/ 1462 w 4170"/>
              <a:gd name="T39" fmla="*/ 110 h 314"/>
              <a:gd name="T40" fmla="*/ 1533 w 4170"/>
              <a:gd name="T41" fmla="*/ 100 h 314"/>
              <a:gd name="T42" fmla="*/ 1609 w 4170"/>
              <a:gd name="T43" fmla="*/ 90 h 314"/>
              <a:gd name="T44" fmla="*/ 1680 w 4170"/>
              <a:gd name="T45" fmla="*/ 80 h 314"/>
              <a:gd name="T46" fmla="*/ 1755 w 4170"/>
              <a:gd name="T47" fmla="*/ 72 h 314"/>
              <a:gd name="T48" fmla="*/ 1829 w 4170"/>
              <a:gd name="T49" fmla="*/ 62 h 314"/>
              <a:gd name="T50" fmla="*/ 1902 w 4170"/>
              <a:gd name="T51" fmla="*/ 54 h 314"/>
              <a:gd name="T52" fmla="*/ 1976 w 4170"/>
              <a:gd name="T53" fmla="*/ 46 h 314"/>
              <a:gd name="T54" fmla="*/ 2049 w 4170"/>
              <a:gd name="T55" fmla="*/ 38 h 314"/>
              <a:gd name="T56" fmla="*/ 2121 w 4170"/>
              <a:gd name="T57" fmla="*/ 28 h 314"/>
              <a:gd name="T58" fmla="*/ 2194 w 4170"/>
              <a:gd name="T59" fmla="*/ 20 h 314"/>
              <a:gd name="T60" fmla="*/ 2269 w 4170"/>
              <a:gd name="T61" fmla="*/ 13 h 314"/>
              <a:gd name="T62" fmla="*/ 2341 w 4170"/>
              <a:gd name="T63" fmla="*/ 5 h 314"/>
              <a:gd name="T64" fmla="*/ 2416 w 4170"/>
              <a:gd name="T65" fmla="*/ 36 h 314"/>
              <a:gd name="T66" fmla="*/ 2490 w 4170"/>
              <a:gd name="T67" fmla="*/ 38 h 314"/>
              <a:gd name="T68" fmla="*/ 2561 w 4170"/>
              <a:gd name="T69" fmla="*/ 38 h 314"/>
              <a:gd name="T70" fmla="*/ 2635 w 4170"/>
              <a:gd name="T71" fmla="*/ 39 h 314"/>
              <a:gd name="T72" fmla="*/ 2708 w 4170"/>
              <a:gd name="T73" fmla="*/ 41 h 314"/>
              <a:gd name="T74" fmla="*/ 2783 w 4170"/>
              <a:gd name="T75" fmla="*/ 41 h 314"/>
              <a:gd name="T76" fmla="*/ 2857 w 4170"/>
              <a:gd name="T77" fmla="*/ 43 h 314"/>
              <a:gd name="T78" fmla="*/ 2930 w 4170"/>
              <a:gd name="T79" fmla="*/ 44 h 314"/>
              <a:gd name="T80" fmla="*/ 3002 w 4170"/>
              <a:gd name="T81" fmla="*/ 44 h 314"/>
              <a:gd name="T82" fmla="*/ 3075 w 4170"/>
              <a:gd name="T83" fmla="*/ 46 h 314"/>
              <a:gd name="T84" fmla="*/ 3149 w 4170"/>
              <a:gd name="T85" fmla="*/ 46 h 314"/>
              <a:gd name="T86" fmla="*/ 3222 w 4170"/>
              <a:gd name="T87" fmla="*/ 48 h 314"/>
              <a:gd name="T88" fmla="*/ 3296 w 4170"/>
              <a:gd name="T89" fmla="*/ 49 h 314"/>
              <a:gd name="T90" fmla="*/ 3371 w 4170"/>
              <a:gd name="T91" fmla="*/ 49 h 314"/>
              <a:gd name="T92" fmla="*/ 3443 w 4170"/>
              <a:gd name="T93" fmla="*/ 51 h 314"/>
              <a:gd name="T94" fmla="*/ 3518 w 4170"/>
              <a:gd name="T95" fmla="*/ 53 h 314"/>
              <a:gd name="T96" fmla="*/ 3589 w 4170"/>
              <a:gd name="T97" fmla="*/ 53 h 314"/>
              <a:gd name="T98" fmla="*/ 3665 w 4170"/>
              <a:gd name="T99" fmla="*/ 54 h 314"/>
              <a:gd name="T100" fmla="*/ 3736 w 4170"/>
              <a:gd name="T101" fmla="*/ 56 h 314"/>
              <a:gd name="T102" fmla="*/ 3810 w 4170"/>
              <a:gd name="T103" fmla="*/ 56 h 314"/>
              <a:gd name="T104" fmla="*/ 3885 w 4170"/>
              <a:gd name="T105" fmla="*/ 57 h 314"/>
              <a:gd name="T106" fmla="*/ 3957 w 4170"/>
              <a:gd name="T107" fmla="*/ 57 h 314"/>
              <a:gd name="T108" fmla="*/ 4030 w 4170"/>
              <a:gd name="T109" fmla="*/ 59 h 314"/>
              <a:gd name="T110" fmla="*/ 4105 w 4170"/>
              <a:gd name="T111" fmla="*/ 61 h 3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314">
                <a:moveTo>
                  <a:pt x="0" y="314"/>
                </a:moveTo>
                <a:lnTo>
                  <a:pt x="8" y="314"/>
                </a:lnTo>
                <a:lnTo>
                  <a:pt x="16" y="314"/>
                </a:lnTo>
                <a:lnTo>
                  <a:pt x="26" y="314"/>
                </a:lnTo>
                <a:lnTo>
                  <a:pt x="34" y="314"/>
                </a:lnTo>
                <a:lnTo>
                  <a:pt x="40" y="314"/>
                </a:lnTo>
                <a:lnTo>
                  <a:pt x="49" y="314"/>
                </a:lnTo>
                <a:lnTo>
                  <a:pt x="57" y="314"/>
                </a:lnTo>
                <a:lnTo>
                  <a:pt x="67" y="314"/>
                </a:lnTo>
                <a:lnTo>
                  <a:pt x="75" y="314"/>
                </a:lnTo>
                <a:lnTo>
                  <a:pt x="81" y="314"/>
                </a:lnTo>
                <a:lnTo>
                  <a:pt x="89" y="314"/>
                </a:lnTo>
                <a:lnTo>
                  <a:pt x="98" y="314"/>
                </a:lnTo>
                <a:lnTo>
                  <a:pt x="107" y="314"/>
                </a:lnTo>
                <a:lnTo>
                  <a:pt x="116" y="314"/>
                </a:lnTo>
                <a:lnTo>
                  <a:pt x="122" y="314"/>
                </a:lnTo>
                <a:lnTo>
                  <a:pt x="130" y="314"/>
                </a:lnTo>
                <a:lnTo>
                  <a:pt x="138" y="314"/>
                </a:lnTo>
                <a:lnTo>
                  <a:pt x="148" y="314"/>
                </a:lnTo>
                <a:lnTo>
                  <a:pt x="156" y="314"/>
                </a:lnTo>
                <a:lnTo>
                  <a:pt x="163" y="314"/>
                </a:lnTo>
                <a:lnTo>
                  <a:pt x="171" y="314"/>
                </a:lnTo>
                <a:lnTo>
                  <a:pt x="179" y="314"/>
                </a:lnTo>
                <a:lnTo>
                  <a:pt x="189" y="314"/>
                </a:lnTo>
                <a:lnTo>
                  <a:pt x="197" y="314"/>
                </a:lnTo>
                <a:lnTo>
                  <a:pt x="204" y="314"/>
                </a:lnTo>
                <a:lnTo>
                  <a:pt x="212" y="314"/>
                </a:lnTo>
                <a:lnTo>
                  <a:pt x="220" y="314"/>
                </a:lnTo>
                <a:lnTo>
                  <a:pt x="230" y="314"/>
                </a:lnTo>
                <a:lnTo>
                  <a:pt x="238" y="314"/>
                </a:lnTo>
                <a:lnTo>
                  <a:pt x="244" y="314"/>
                </a:lnTo>
                <a:lnTo>
                  <a:pt x="253" y="314"/>
                </a:lnTo>
                <a:lnTo>
                  <a:pt x="261" y="314"/>
                </a:lnTo>
                <a:lnTo>
                  <a:pt x="271" y="314"/>
                </a:lnTo>
                <a:lnTo>
                  <a:pt x="279" y="314"/>
                </a:lnTo>
                <a:lnTo>
                  <a:pt x="285" y="314"/>
                </a:lnTo>
                <a:lnTo>
                  <a:pt x="293" y="314"/>
                </a:lnTo>
                <a:lnTo>
                  <a:pt x="302" y="314"/>
                </a:lnTo>
                <a:lnTo>
                  <a:pt x="311" y="314"/>
                </a:lnTo>
                <a:lnTo>
                  <a:pt x="319" y="314"/>
                </a:lnTo>
                <a:lnTo>
                  <a:pt x="326" y="314"/>
                </a:lnTo>
                <a:lnTo>
                  <a:pt x="334" y="314"/>
                </a:lnTo>
                <a:lnTo>
                  <a:pt x="342" y="278"/>
                </a:lnTo>
                <a:lnTo>
                  <a:pt x="352" y="276"/>
                </a:lnTo>
                <a:lnTo>
                  <a:pt x="360" y="274"/>
                </a:lnTo>
                <a:lnTo>
                  <a:pt x="367" y="274"/>
                </a:lnTo>
                <a:lnTo>
                  <a:pt x="375" y="273"/>
                </a:lnTo>
                <a:lnTo>
                  <a:pt x="383" y="271"/>
                </a:lnTo>
                <a:lnTo>
                  <a:pt x="393" y="269"/>
                </a:lnTo>
                <a:lnTo>
                  <a:pt x="401" y="268"/>
                </a:lnTo>
                <a:lnTo>
                  <a:pt x="408" y="266"/>
                </a:lnTo>
                <a:lnTo>
                  <a:pt x="416" y="266"/>
                </a:lnTo>
                <a:lnTo>
                  <a:pt x="424" y="265"/>
                </a:lnTo>
                <a:lnTo>
                  <a:pt x="434" y="263"/>
                </a:lnTo>
                <a:lnTo>
                  <a:pt x="442" y="261"/>
                </a:lnTo>
                <a:lnTo>
                  <a:pt x="448" y="260"/>
                </a:lnTo>
                <a:lnTo>
                  <a:pt x="457" y="258"/>
                </a:lnTo>
                <a:lnTo>
                  <a:pt x="465" y="256"/>
                </a:lnTo>
                <a:lnTo>
                  <a:pt x="474" y="256"/>
                </a:lnTo>
                <a:lnTo>
                  <a:pt x="483" y="255"/>
                </a:lnTo>
                <a:lnTo>
                  <a:pt x="489" y="253"/>
                </a:lnTo>
                <a:lnTo>
                  <a:pt x="497" y="252"/>
                </a:lnTo>
                <a:lnTo>
                  <a:pt x="505" y="250"/>
                </a:lnTo>
                <a:lnTo>
                  <a:pt x="515" y="248"/>
                </a:lnTo>
                <a:lnTo>
                  <a:pt x="523" y="248"/>
                </a:lnTo>
                <a:lnTo>
                  <a:pt x="532" y="247"/>
                </a:lnTo>
                <a:lnTo>
                  <a:pt x="538" y="245"/>
                </a:lnTo>
                <a:lnTo>
                  <a:pt x="546" y="243"/>
                </a:lnTo>
                <a:lnTo>
                  <a:pt x="556" y="242"/>
                </a:lnTo>
                <a:lnTo>
                  <a:pt x="564" y="242"/>
                </a:lnTo>
                <a:lnTo>
                  <a:pt x="572" y="240"/>
                </a:lnTo>
                <a:lnTo>
                  <a:pt x="579" y="238"/>
                </a:lnTo>
                <a:lnTo>
                  <a:pt x="587" y="237"/>
                </a:lnTo>
                <a:lnTo>
                  <a:pt x="597" y="235"/>
                </a:lnTo>
                <a:lnTo>
                  <a:pt x="605" y="234"/>
                </a:lnTo>
                <a:lnTo>
                  <a:pt x="613" y="234"/>
                </a:lnTo>
                <a:lnTo>
                  <a:pt x="620" y="232"/>
                </a:lnTo>
                <a:lnTo>
                  <a:pt x="628" y="230"/>
                </a:lnTo>
                <a:lnTo>
                  <a:pt x="638" y="229"/>
                </a:lnTo>
                <a:lnTo>
                  <a:pt x="646" y="227"/>
                </a:lnTo>
                <a:lnTo>
                  <a:pt x="654" y="227"/>
                </a:lnTo>
                <a:lnTo>
                  <a:pt x="661" y="225"/>
                </a:lnTo>
                <a:lnTo>
                  <a:pt x="669" y="224"/>
                </a:lnTo>
                <a:lnTo>
                  <a:pt x="678" y="222"/>
                </a:lnTo>
                <a:lnTo>
                  <a:pt x="687" y="221"/>
                </a:lnTo>
                <a:lnTo>
                  <a:pt x="695" y="221"/>
                </a:lnTo>
                <a:lnTo>
                  <a:pt x="701" y="219"/>
                </a:lnTo>
                <a:lnTo>
                  <a:pt x="709" y="217"/>
                </a:lnTo>
                <a:lnTo>
                  <a:pt x="719" y="216"/>
                </a:lnTo>
                <a:lnTo>
                  <a:pt x="727" y="214"/>
                </a:lnTo>
                <a:lnTo>
                  <a:pt x="736" y="214"/>
                </a:lnTo>
                <a:lnTo>
                  <a:pt x="742" y="212"/>
                </a:lnTo>
                <a:lnTo>
                  <a:pt x="750" y="211"/>
                </a:lnTo>
                <a:lnTo>
                  <a:pt x="760" y="209"/>
                </a:lnTo>
                <a:lnTo>
                  <a:pt x="768" y="209"/>
                </a:lnTo>
                <a:lnTo>
                  <a:pt x="776" y="207"/>
                </a:lnTo>
                <a:lnTo>
                  <a:pt x="783" y="206"/>
                </a:lnTo>
                <a:lnTo>
                  <a:pt x="791" y="204"/>
                </a:lnTo>
                <a:lnTo>
                  <a:pt x="801" y="203"/>
                </a:lnTo>
                <a:lnTo>
                  <a:pt x="809" y="203"/>
                </a:lnTo>
                <a:lnTo>
                  <a:pt x="817" y="201"/>
                </a:lnTo>
                <a:lnTo>
                  <a:pt x="824" y="199"/>
                </a:lnTo>
                <a:lnTo>
                  <a:pt x="832" y="198"/>
                </a:lnTo>
                <a:lnTo>
                  <a:pt x="842" y="198"/>
                </a:lnTo>
                <a:lnTo>
                  <a:pt x="850" y="196"/>
                </a:lnTo>
                <a:lnTo>
                  <a:pt x="856" y="194"/>
                </a:lnTo>
                <a:lnTo>
                  <a:pt x="866" y="193"/>
                </a:lnTo>
                <a:lnTo>
                  <a:pt x="873" y="193"/>
                </a:lnTo>
                <a:lnTo>
                  <a:pt x="882" y="191"/>
                </a:lnTo>
                <a:lnTo>
                  <a:pt x="891" y="190"/>
                </a:lnTo>
                <a:lnTo>
                  <a:pt x="897" y="188"/>
                </a:lnTo>
                <a:lnTo>
                  <a:pt x="907" y="188"/>
                </a:lnTo>
                <a:lnTo>
                  <a:pt x="913" y="186"/>
                </a:lnTo>
                <a:lnTo>
                  <a:pt x="923" y="185"/>
                </a:lnTo>
                <a:lnTo>
                  <a:pt x="931" y="183"/>
                </a:lnTo>
                <a:lnTo>
                  <a:pt x="938" y="183"/>
                </a:lnTo>
                <a:lnTo>
                  <a:pt x="948" y="181"/>
                </a:lnTo>
                <a:lnTo>
                  <a:pt x="954" y="180"/>
                </a:lnTo>
                <a:lnTo>
                  <a:pt x="964" y="178"/>
                </a:lnTo>
                <a:lnTo>
                  <a:pt x="972" y="178"/>
                </a:lnTo>
                <a:lnTo>
                  <a:pt x="979" y="176"/>
                </a:lnTo>
                <a:lnTo>
                  <a:pt x="988" y="175"/>
                </a:lnTo>
                <a:lnTo>
                  <a:pt x="995" y="173"/>
                </a:lnTo>
                <a:lnTo>
                  <a:pt x="1005" y="173"/>
                </a:lnTo>
                <a:lnTo>
                  <a:pt x="1013" y="172"/>
                </a:lnTo>
                <a:lnTo>
                  <a:pt x="1019" y="170"/>
                </a:lnTo>
                <a:lnTo>
                  <a:pt x="1029" y="168"/>
                </a:lnTo>
                <a:lnTo>
                  <a:pt x="1036" y="168"/>
                </a:lnTo>
                <a:lnTo>
                  <a:pt x="1044" y="167"/>
                </a:lnTo>
                <a:lnTo>
                  <a:pt x="1054" y="165"/>
                </a:lnTo>
                <a:lnTo>
                  <a:pt x="1060" y="165"/>
                </a:lnTo>
                <a:lnTo>
                  <a:pt x="1070" y="163"/>
                </a:lnTo>
                <a:lnTo>
                  <a:pt x="1077" y="162"/>
                </a:lnTo>
                <a:lnTo>
                  <a:pt x="1085" y="160"/>
                </a:lnTo>
                <a:lnTo>
                  <a:pt x="1095" y="160"/>
                </a:lnTo>
                <a:lnTo>
                  <a:pt x="1101" y="159"/>
                </a:lnTo>
                <a:lnTo>
                  <a:pt x="1111" y="157"/>
                </a:lnTo>
                <a:lnTo>
                  <a:pt x="1117" y="155"/>
                </a:lnTo>
                <a:lnTo>
                  <a:pt x="1126" y="155"/>
                </a:lnTo>
                <a:lnTo>
                  <a:pt x="1135" y="154"/>
                </a:lnTo>
                <a:lnTo>
                  <a:pt x="1142" y="152"/>
                </a:lnTo>
                <a:lnTo>
                  <a:pt x="1152" y="152"/>
                </a:lnTo>
                <a:lnTo>
                  <a:pt x="1158" y="150"/>
                </a:lnTo>
                <a:lnTo>
                  <a:pt x="1166" y="149"/>
                </a:lnTo>
                <a:lnTo>
                  <a:pt x="1176" y="149"/>
                </a:lnTo>
                <a:lnTo>
                  <a:pt x="1183" y="147"/>
                </a:lnTo>
                <a:lnTo>
                  <a:pt x="1192" y="145"/>
                </a:lnTo>
                <a:lnTo>
                  <a:pt x="1199" y="144"/>
                </a:lnTo>
                <a:lnTo>
                  <a:pt x="1207" y="144"/>
                </a:lnTo>
                <a:lnTo>
                  <a:pt x="1217" y="142"/>
                </a:lnTo>
                <a:lnTo>
                  <a:pt x="1223" y="141"/>
                </a:lnTo>
                <a:lnTo>
                  <a:pt x="1233" y="141"/>
                </a:lnTo>
                <a:lnTo>
                  <a:pt x="1240" y="139"/>
                </a:lnTo>
                <a:lnTo>
                  <a:pt x="1248" y="137"/>
                </a:lnTo>
                <a:lnTo>
                  <a:pt x="1258" y="137"/>
                </a:lnTo>
                <a:lnTo>
                  <a:pt x="1264" y="136"/>
                </a:lnTo>
                <a:lnTo>
                  <a:pt x="1274" y="134"/>
                </a:lnTo>
                <a:lnTo>
                  <a:pt x="1281" y="132"/>
                </a:lnTo>
                <a:lnTo>
                  <a:pt x="1289" y="132"/>
                </a:lnTo>
                <a:lnTo>
                  <a:pt x="1299" y="131"/>
                </a:lnTo>
                <a:lnTo>
                  <a:pt x="1305" y="129"/>
                </a:lnTo>
                <a:lnTo>
                  <a:pt x="1315" y="129"/>
                </a:lnTo>
                <a:lnTo>
                  <a:pt x="1323" y="128"/>
                </a:lnTo>
                <a:lnTo>
                  <a:pt x="1330" y="126"/>
                </a:lnTo>
                <a:lnTo>
                  <a:pt x="1339" y="126"/>
                </a:lnTo>
                <a:lnTo>
                  <a:pt x="1346" y="124"/>
                </a:lnTo>
                <a:lnTo>
                  <a:pt x="1356" y="123"/>
                </a:lnTo>
                <a:lnTo>
                  <a:pt x="1364" y="123"/>
                </a:lnTo>
                <a:lnTo>
                  <a:pt x="1370" y="121"/>
                </a:lnTo>
                <a:lnTo>
                  <a:pt x="1380" y="119"/>
                </a:lnTo>
                <a:lnTo>
                  <a:pt x="1387" y="119"/>
                </a:lnTo>
                <a:lnTo>
                  <a:pt x="1396" y="118"/>
                </a:lnTo>
                <a:lnTo>
                  <a:pt x="1405" y="116"/>
                </a:lnTo>
                <a:lnTo>
                  <a:pt x="1411" y="116"/>
                </a:lnTo>
                <a:lnTo>
                  <a:pt x="1421" y="115"/>
                </a:lnTo>
                <a:lnTo>
                  <a:pt x="1427" y="113"/>
                </a:lnTo>
                <a:lnTo>
                  <a:pt x="1437" y="113"/>
                </a:lnTo>
                <a:lnTo>
                  <a:pt x="1445" y="111"/>
                </a:lnTo>
                <a:lnTo>
                  <a:pt x="1452" y="110"/>
                </a:lnTo>
                <a:lnTo>
                  <a:pt x="1462" y="110"/>
                </a:lnTo>
                <a:lnTo>
                  <a:pt x="1468" y="108"/>
                </a:lnTo>
                <a:lnTo>
                  <a:pt x="1478" y="106"/>
                </a:lnTo>
                <a:lnTo>
                  <a:pt x="1486" y="106"/>
                </a:lnTo>
                <a:lnTo>
                  <a:pt x="1493" y="105"/>
                </a:lnTo>
                <a:lnTo>
                  <a:pt x="1502" y="103"/>
                </a:lnTo>
                <a:lnTo>
                  <a:pt x="1509" y="103"/>
                </a:lnTo>
                <a:lnTo>
                  <a:pt x="1519" y="101"/>
                </a:lnTo>
                <a:lnTo>
                  <a:pt x="1527" y="100"/>
                </a:lnTo>
                <a:lnTo>
                  <a:pt x="1533" y="100"/>
                </a:lnTo>
                <a:lnTo>
                  <a:pt x="1543" y="98"/>
                </a:lnTo>
                <a:lnTo>
                  <a:pt x="1550" y="98"/>
                </a:lnTo>
                <a:lnTo>
                  <a:pt x="1560" y="97"/>
                </a:lnTo>
                <a:lnTo>
                  <a:pt x="1568" y="95"/>
                </a:lnTo>
                <a:lnTo>
                  <a:pt x="1574" y="95"/>
                </a:lnTo>
                <a:lnTo>
                  <a:pt x="1584" y="93"/>
                </a:lnTo>
                <a:lnTo>
                  <a:pt x="1591" y="92"/>
                </a:lnTo>
                <a:lnTo>
                  <a:pt x="1599" y="92"/>
                </a:lnTo>
                <a:lnTo>
                  <a:pt x="1609" y="90"/>
                </a:lnTo>
                <a:lnTo>
                  <a:pt x="1615" y="88"/>
                </a:lnTo>
                <a:lnTo>
                  <a:pt x="1625" y="88"/>
                </a:lnTo>
                <a:lnTo>
                  <a:pt x="1633" y="87"/>
                </a:lnTo>
                <a:lnTo>
                  <a:pt x="1640" y="87"/>
                </a:lnTo>
                <a:lnTo>
                  <a:pt x="1648" y="85"/>
                </a:lnTo>
                <a:lnTo>
                  <a:pt x="1656" y="84"/>
                </a:lnTo>
                <a:lnTo>
                  <a:pt x="1666" y="84"/>
                </a:lnTo>
                <a:lnTo>
                  <a:pt x="1674" y="82"/>
                </a:lnTo>
                <a:lnTo>
                  <a:pt x="1680" y="80"/>
                </a:lnTo>
                <a:lnTo>
                  <a:pt x="1688" y="80"/>
                </a:lnTo>
                <a:lnTo>
                  <a:pt x="1697" y="79"/>
                </a:lnTo>
                <a:lnTo>
                  <a:pt x="1706" y="79"/>
                </a:lnTo>
                <a:lnTo>
                  <a:pt x="1715" y="77"/>
                </a:lnTo>
                <a:lnTo>
                  <a:pt x="1721" y="75"/>
                </a:lnTo>
                <a:lnTo>
                  <a:pt x="1729" y="75"/>
                </a:lnTo>
                <a:lnTo>
                  <a:pt x="1739" y="74"/>
                </a:lnTo>
                <a:lnTo>
                  <a:pt x="1747" y="72"/>
                </a:lnTo>
                <a:lnTo>
                  <a:pt x="1755" y="72"/>
                </a:lnTo>
                <a:lnTo>
                  <a:pt x="1762" y="70"/>
                </a:lnTo>
                <a:lnTo>
                  <a:pt x="1770" y="70"/>
                </a:lnTo>
                <a:lnTo>
                  <a:pt x="1780" y="69"/>
                </a:lnTo>
                <a:lnTo>
                  <a:pt x="1788" y="67"/>
                </a:lnTo>
                <a:lnTo>
                  <a:pt x="1796" y="67"/>
                </a:lnTo>
                <a:lnTo>
                  <a:pt x="1803" y="66"/>
                </a:lnTo>
                <a:lnTo>
                  <a:pt x="1811" y="66"/>
                </a:lnTo>
                <a:lnTo>
                  <a:pt x="1821" y="64"/>
                </a:lnTo>
                <a:lnTo>
                  <a:pt x="1829" y="62"/>
                </a:lnTo>
                <a:lnTo>
                  <a:pt x="1835" y="62"/>
                </a:lnTo>
                <a:lnTo>
                  <a:pt x="1844" y="61"/>
                </a:lnTo>
                <a:lnTo>
                  <a:pt x="1852" y="61"/>
                </a:lnTo>
                <a:lnTo>
                  <a:pt x="1861" y="59"/>
                </a:lnTo>
                <a:lnTo>
                  <a:pt x="1870" y="57"/>
                </a:lnTo>
                <a:lnTo>
                  <a:pt x="1876" y="57"/>
                </a:lnTo>
                <a:lnTo>
                  <a:pt x="1884" y="56"/>
                </a:lnTo>
                <a:lnTo>
                  <a:pt x="1892" y="56"/>
                </a:lnTo>
                <a:lnTo>
                  <a:pt x="1902" y="54"/>
                </a:lnTo>
                <a:lnTo>
                  <a:pt x="1910" y="53"/>
                </a:lnTo>
                <a:lnTo>
                  <a:pt x="1917" y="53"/>
                </a:lnTo>
                <a:lnTo>
                  <a:pt x="1925" y="51"/>
                </a:lnTo>
                <a:lnTo>
                  <a:pt x="1933" y="51"/>
                </a:lnTo>
                <a:lnTo>
                  <a:pt x="1943" y="49"/>
                </a:lnTo>
                <a:lnTo>
                  <a:pt x="1951" y="48"/>
                </a:lnTo>
                <a:lnTo>
                  <a:pt x="1958" y="48"/>
                </a:lnTo>
                <a:lnTo>
                  <a:pt x="1966" y="46"/>
                </a:lnTo>
                <a:lnTo>
                  <a:pt x="1976" y="46"/>
                </a:lnTo>
                <a:lnTo>
                  <a:pt x="1984" y="44"/>
                </a:lnTo>
                <a:lnTo>
                  <a:pt x="1992" y="44"/>
                </a:lnTo>
                <a:lnTo>
                  <a:pt x="1999" y="43"/>
                </a:lnTo>
                <a:lnTo>
                  <a:pt x="2007" y="41"/>
                </a:lnTo>
                <a:lnTo>
                  <a:pt x="2015" y="41"/>
                </a:lnTo>
                <a:lnTo>
                  <a:pt x="2023" y="39"/>
                </a:lnTo>
                <a:lnTo>
                  <a:pt x="2033" y="39"/>
                </a:lnTo>
                <a:lnTo>
                  <a:pt x="2039" y="38"/>
                </a:lnTo>
                <a:lnTo>
                  <a:pt x="2049" y="38"/>
                </a:lnTo>
                <a:lnTo>
                  <a:pt x="2056" y="36"/>
                </a:lnTo>
                <a:lnTo>
                  <a:pt x="2065" y="35"/>
                </a:lnTo>
                <a:lnTo>
                  <a:pt x="2074" y="35"/>
                </a:lnTo>
                <a:lnTo>
                  <a:pt x="2080" y="33"/>
                </a:lnTo>
                <a:lnTo>
                  <a:pt x="2090" y="33"/>
                </a:lnTo>
                <a:lnTo>
                  <a:pt x="2096" y="31"/>
                </a:lnTo>
                <a:lnTo>
                  <a:pt x="2106" y="31"/>
                </a:lnTo>
                <a:lnTo>
                  <a:pt x="2113" y="30"/>
                </a:lnTo>
                <a:lnTo>
                  <a:pt x="2121" y="28"/>
                </a:lnTo>
                <a:lnTo>
                  <a:pt x="2131" y="28"/>
                </a:lnTo>
                <a:lnTo>
                  <a:pt x="2137" y="26"/>
                </a:lnTo>
                <a:lnTo>
                  <a:pt x="2147" y="26"/>
                </a:lnTo>
                <a:lnTo>
                  <a:pt x="2154" y="25"/>
                </a:lnTo>
                <a:lnTo>
                  <a:pt x="2163" y="25"/>
                </a:lnTo>
                <a:lnTo>
                  <a:pt x="2171" y="23"/>
                </a:lnTo>
                <a:lnTo>
                  <a:pt x="2178" y="23"/>
                </a:lnTo>
                <a:lnTo>
                  <a:pt x="2188" y="22"/>
                </a:lnTo>
                <a:lnTo>
                  <a:pt x="2194" y="20"/>
                </a:lnTo>
                <a:lnTo>
                  <a:pt x="2202" y="20"/>
                </a:lnTo>
                <a:lnTo>
                  <a:pt x="2212" y="18"/>
                </a:lnTo>
                <a:lnTo>
                  <a:pt x="2220" y="18"/>
                </a:lnTo>
                <a:lnTo>
                  <a:pt x="2229" y="17"/>
                </a:lnTo>
                <a:lnTo>
                  <a:pt x="2235" y="17"/>
                </a:lnTo>
                <a:lnTo>
                  <a:pt x="2243" y="15"/>
                </a:lnTo>
                <a:lnTo>
                  <a:pt x="2251" y="15"/>
                </a:lnTo>
                <a:lnTo>
                  <a:pt x="2261" y="13"/>
                </a:lnTo>
                <a:lnTo>
                  <a:pt x="2269" y="13"/>
                </a:lnTo>
                <a:lnTo>
                  <a:pt x="2278" y="12"/>
                </a:lnTo>
                <a:lnTo>
                  <a:pt x="2284" y="10"/>
                </a:lnTo>
                <a:lnTo>
                  <a:pt x="2292" y="10"/>
                </a:lnTo>
                <a:lnTo>
                  <a:pt x="2300" y="8"/>
                </a:lnTo>
                <a:lnTo>
                  <a:pt x="2310" y="8"/>
                </a:lnTo>
                <a:lnTo>
                  <a:pt x="2317" y="7"/>
                </a:lnTo>
                <a:lnTo>
                  <a:pt x="2326" y="7"/>
                </a:lnTo>
                <a:lnTo>
                  <a:pt x="2335" y="5"/>
                </a:lnTo>
                <a:lnTo>
                  <a:pt x="2341" y="5"/>
                </a:lnTo>
                <a:lnTo>
                  <a:pt x="2351" y="4"/>
                </a:lnTo>
                <a:lnTo>
                  <a:pt x="2357" y="4"/>
                </a:lnTo>
                <a:lnTo>
                  <a:pt x="2366" y="2"/>
                </a:lnTo>
                <a:lnTo>
                  <a:pt x="2375" y="2"/>
                </a:lnTo>
                <a:lnTo>
                  <a:pt x="2382" y="0"/>
                </a:lnTo>
                <a:lnTo>
                  <a:pt x="2390" y="36"/>
                </a:lnTo>
                <a:lnTo>
                  <a:pt x="2400" y="36"/>
                </a:lnTo>
                <a:lnTo>
                  <a:pt x="2408" y="36"/>
                </a:lnTo>
                <a:lnTo>
                  <a:pt x="2416" y="36"/>
                </a:lnTo>
                <a:lnTo>
                  <a:pt x="2424" y="36"/>
                </a:lnTo>
                <a:lnTo>
                  <a:pt x="2433" y="36"/>
                </a:lnTo>
                <a:lnTo>
                  <a:pt x="2439" y="36"/>
                </a:lnTo>
                <a:lnTo>
                  <a:pt x="2449" y="36"/>
                </a:lnTo>
                <a:lnTo>
                  <a:pt x="2455" y="36"/>
                </a:lnTo>
                <a:lnTo>
                  <a:pt x="2464" y="36"/>
                </a:lnTo>
                <a:lnTo>
                  <a:pt x="2473" y="36"/>
                </a:lnTo>
                <a:lnTo>
                  <a:pt x="2480" y="36"/>
                </a:lnTo>
                <a:lnTo>
                  <a:pt x="2490" y="38"/>
                </a:lnTo>
                <a:lnTo>
                  <a:pt x="2498" y="38"/>
                </a:lnTo>
                <a:lnTo>
                  <a:pt x="2506" y="38"/>
                </a:lnTo>
                <a:lnTo>
                  <a:pt x="2513" y="38"/>
                </a:lnTo>
                <a:lnTo>
                  <a:pt x="2521" y="38"/>
                </a:lnTo>
                <a:lnTo>
                  <a:pt x="2529" y="38"/>
                </a:lnTo>
                <a:lnTo>
                  <a:pt x="2539" y="38"/>
                </a:lnTo>
                <a:lnTo>
                  <a:pt x="2547" y="38"/>
                </a:lnTo>
                <a:lnTo>
                  <a:pt x="2555" y="38"/>
                </a:lnTo>
                <a:lnTo>
                  <a:pt x="2561" y="38"/>
                </a:lnTo>
                <a:lnTo>
                  <a:pt x="2570" y="38"/>
                </a:lnTo>
                <a:lnTo>
                  <a:pt x="2578" y="38"/>
                </a:lnTo>
                <a:lnTo>
                  <a:pt x="2588" y="38"/>
                </a:lnTo>
                <a:lnTo>
                  <a:pt x="2594" y="39"/>
                </a:lnTo>
                <a:lnTo>
                  <a:pt x="2604" y="39"/>
                </a:lnTo>
                <a:lnTo>
                  <a:pt x="2610" y="39"/>
                </a:lnTo>
                <a:lnTo>
                  <a:pt x="2620" y="39"/>
                </a:lnTo>
                <a:lnTo>
                  <a:pt x="2627" y="39"/>
                </a:lnTo>
                <a:lnTo>
                  <a:pt x="2635" y="39"/>
                </a:lnTo>
                <a:lnTo>
                  <a:pt x="2645" y="39"/>
                </a:lnTo>
                <a:lnTo>
                  <a:pt x="2651" y="39"/>
                </a:lnTo>
                <a:lnTo>
                  <a:pt x="2661" y="39"/>
                </a:lnTo>
                <a:lnTo>
                  <a:pt x="2668" y="39"/>
                </a:lnTo>
                <a:lnTo>
                  <a:pt x="2676" y="39"/>
                </a:lnTo>
                <a:lnTo>
                  <a:pt x="2685" y="39"/>
                </a:lnTo>
                <a:lnTo>
                  <a:pt x="2692" y="39"/>
                </a:lnTo>
                <a:lnTo>
                  <a:pt x="2702" y="39"/>
                </a:lnTo>
                <a:lnTo>
                  <a:pt x="2708" y="41"/>
                </a:lnTo>
                <a:lnTo>
                  <a:pt x="2718" y="41"/>
                </a:lnTo>
                <a:lnTo>
                  <a:pt x="2726" y="41"/>
                </a:lnTo>
                <a:lnTo>
                  <a:pt x="2733" y="41"/>
                </a:lnTo>
                <a:lnTo>
                  <a:pt x="2743" y="41"/>
                </a:lnTo>
                <a:lnTo>
                  <a:pt x="2749" y="41"/>
                </a:lnTo>
                <a:lnTo>
                  <a:pt x="2759" y="41"/>
                </a:lnTo>
                <a:lnTo>
                  <a:pt x="2765" y="41"/>
                </a:lnTo>
                <a:lnTo>
                  <a:pt x="2774" y="41"/>
                </a:lnTo>
                <a:lnTo>
                  <a:pt x="2783" y="41"/>
                </a:lnTo>
                <a:lnTo>
                  <a:pt x="2790" y="41"/>
                </a:lnTo>
                <a:lnTo>
                  <a:pt x="2798" y="41"/>
                </a:lnTo>
                <a:lnTo>
                  <a:pt x="2808" y="41"/>
                </a:lnTo>
                <a:lnTo>
                  <a:pt x="2816" y="43"/>
                </a:lnTo>
                <a:lnTo>
                  <a:pt x="2824" y="43"/>
                </a:lnTo>
                <a:lnTo>
                  <a:pt x="2831" y="43"/>
                </a:lnTo>
                <a:lnTo>
                  <a:pt x="2839" y="43"/>
                </a:lnTo>
                <a:lnTo>
                  <a:pt x="2849" y="43"/>
                </a:lnTo>
                <a:lnTo>
                  <a:pt x="2857" y="43"/>
                </a:lnTo>
                <a:lnTo>
                  <a:pt x="2865" y="43"/>
                </a:lnTo>
                <a:lnTo>
                  <a:pt x="2871" y="43"/>
                </a:lnTo>
                <a:lnTo>
                  <a:pt x="2880" y="43"/>
                </a:lnTo>
                <a:lnTo>
                  <a:pt x="2889" y="43"/>
                </a:lnTo>
                <a:lnTo>
                  <a:pt x="2898" y="43"/>
                </a:lnTo>
                <a:lnTo>
                  <a:pt x="2904" y="43"/>
                </a:lnTo>
                <a:lnTo>
                  <a:pt x="2912" y="43"/>
                </a:lnTo>
                <a:lnTo>
                  <a:pt x="2920" y="43"/>
                </a:lnTo>
                <a:lnTo>
                  <a:pt x="2930" y="44"/>
                </a:lnTo>
                <a:lnTo>
                  <a:pt x="2938" y="44"/>
                </a:lnTo>
                <a:lnTo>
                  <a:pt x="2945" y="44"/>
                </a:lnTo>
                <a:lnTo>
                  <a:pt x="2953" y="44"/>
                </a:lnTo>
                <a:lnTo>
                  <a:pt x="2961" y="44"/>
                </a:lnTo>
                <a:lnTo>
                  <a:pt x="2971" y="44"/>
                </a:lnTo>
                <a:lnTo>
                  <a:pt x="2979" y="44"/>
                </a:lnTo>
                <a:lnTo>
                  <a:pt x="2986" y="44"/>
                </a:lnTo>
                <a:lnTo>
                  <a:pt x="2994" y="44"/>
                </a:lnTo>
                <a:lnTo>
                  <a:pt x="3002" y="44"/>
                </a:lnTo>
                <a:lnTo>
                  <a:pt x="3012" y="44"/>
                </a:lnTo>
                <a:lnTo>
                  <a:pt x="3020" y="44"/>
                </a:lnTo>
                <a:lnTo>
                  <a:pt x="3027" y="44"/>
                </a:lnTo>
                <a:lnTo>
                  <a:pt x="3035" y="44"/>
                </a:lnTo>
                <a:lnTo>
                  <a:pt x="3044" y="46"/>
                </a:lnTo>
                <a:lnTo>
                  <a:pt x="3053" y="46"/>
                </a:lnTo>
                <a:lnTo>
                  <a:pt x="3061" y="46"/>
                </a:lnTo>
                <a:lnTo>
                  <a:pt x="3067" y="46"/>
                </a:lnTo>
                <a:lnTo>
                  <a:pt x="3075" y="46"/>
                </a:lnTo>
                <a:lnTo>
                  <a:pt x="3085" y="46"/>
                </a:lnTo>
                <a:lnTo>
                  <a:pt x="3093" y="46"/>
                </a:lnTo>
                <a:lnTo>
                  <a:pt x="3102" y="46"/>
                </a:lnTo>
                <a:lnTo>
                  <a:pt x="3108" y="46"/>
                </a:lnTo>
                <a:lnTo>
                  <a:pt x="3116" y="46"/>
                </a:lnTo>
                <a:lnTo>
                  <a:pt x="3126" y="46"/>
                </a:lnTo>
                <a:lnTo>
                  <a:pt x="3134" y="46"/>
                </a:lnTo>
                <a:lnTo>
                  <a:pt x="3142" y="46"/>
                </a:lnTo>
                <a:lnTo>
                  <a:pt x="3149" y="46"/>
                </a:lnTo>
                <a:lnTo>
                  <a:pt x="3157" y="48"/>
                </a:lnTo>
                <a:lnTo>
                  <a:pt x="3167" y="48"/>
                </a:lnTo>
                <a:lnTo>
                  <a:pt x="3173" y="48"/>
                </a:lnTo>
                <a:lnTo>
                  <a:pt x="3182" y="48"/>
                </a:lnTo>
                <a:lnTo>
                  <a:pt x="3191" y="48"/>
                </a:lnTo>
                <a:lnTo>
                  <a:pt x="3198" y="48"/>
                </a:lnTo>
                <a:lnTo>
                  <a:pt x="3208" y="48"/>
                </a:lnTo>
                <a:lnTo>
                  <a:pt x="3214" y="48"/>
                </a:lnTo>
                <a:lnTo>
                  <a:pt x="3222" y="48"/>
                </a:lnTo>
                <a:lnTo>
                  <a:pt x="3232" y="48"/>
                </a:lnTo>
                <a:lnTo>
                  <a:pt x="3239" y="48"/>
                </a:lnTo>
                <a:lnTo>
                  <a:pt x="3248" y="48"/>
                </a:lnTo>
                <a:lnTo>
                  <a:pt x="3255" y="48"/>
                </a:lnTo>
                <a:lnTo>
                  <a:pt x="3263" y="48"/>
                </a:lnTo>
                <a:lnTo>
                  <a:pt x="3273" y="49"/>
                </a:lnTo>
                <a:lnTo>
                  <a:pt x="3279" y="49"/>
                </a:lnTo>
                <a:lnTo>
                  <a:pt x="3289" y="49"/>
                </a:lnTo>
                <a:lnTo>
                  <a:pt x="3296" y="49"/>
                </a:lnTo>
                <a:lnTo>
                  <a:pt x="3304" y="49"/>
                </a:lnTo>
                <a:lnTo>
                  <a:pt x="3314" y="49"/>
                </a:lnTo>
                <a:lnTo>
                  <a:pt x="3320" y="49"/>
                </a:lnTo>
                <a:lnTo>
                  <a:pt x="3330" y="49"/>
                </a:lnTo>
                <a:lnTo>
                  <a:pt x="3337" y="49"/>
                </a:lnTo>
                <a:lnTo>
                  <a:pt x="3345" y="49"/>
                </a:lnTo>
                <a:lnTo>
                  <a:pt x="3354" y="49"/>
                </a:lnTo>
                <a:lnTo>
                  <a:pt x="3361" y="49"/>
                </a:lnTo>
                <a:lnTo>
                  <a:pt x="3371" y="49"/>
                </a:lnTo>
                <a:lnTo>
                  <a:pt x="3377" y="49"/>
                </a:lnTo>
                <a:lnTo>
                  <a:pt x="3385" y="51"/>
                </a:lnTo>
                <a:lnTo>
                  <a:pt x="3395" y="51"/>
                </a:lnTo>
                <a:lnTo>
                  <a:pt x="3402" y="51"/>
                </a:lnTo>
                <a:lnTo>
                  <a:pt x="3412" y="51"/>
                </a:lnTo>
                <a:lnTo>
                  <a:pt x="3418" y="51"/>
                </a:lnTo>
                <a:lnTo>
                  <a:pt x="3426" y="51"/>
                </a:lnTo>
                <a:lnTo>
                  <a:pt x="3436" y="51"/>
                </a:lnTo>
                <a:lnTo>
                  <a:pt x="3443" y="51"/>
                </a:lnTo>
                <a:lnTo>
                  <a:pt x="3452" y="51"/>
                </a:lnTo>
                <a:lnTo>
                  <a:pt x="3461" y="51"/>
                </a:lnTo>
                <a:lnTo>
                  <a:pt x="3467" y="51"/>
                </a:lnTo>
                <a:lnTo>
                  <a:pt x="3477" y="51"/>
                </a:lnTo>
                <a:lnTo>
                  <a:pt x="3483" y="51"/>
                </a:lnTo>
                <a:lnTo>
                  <a:pt x="3493" y="51"/>
                </a:lnTo>
                <a:lnTo>
                  <a:pt x="3501" y="53"/>
                </a:lnTo>
                <a:lnTo>
                  <a:pt x="3508" y="53"/>
                </a:lnTo>
                <a:lnTo>
                  <a:pt x="3518" y="53"/>
                </a:lnTo>
                <a:lnTo>
                  <a:pt x="3524" y="53"/>
                </a:lnTo>
                <a:lnTo>
                  <a:pt x="3534" y="53"/>
                </a:lnTo>
                <a:lnTo>
                  <a:pt x="3542" y="53"/>
                </a:lnTo>
                <a:lnTo>
                  <a:pt x="3549" y="53"/>
                </a:lnTo>
                <a:lnTo>
                  <a:pt x="3558" y="53"/>
                </a:lnTo>
                <a:lnTo>
                  <a:pt x="3565" y="53"/>
                </a:lnTo>
                <a:lnTo>
                  <a:pt x="3575" y="53"/>
                </a:lnTo>
                <a:lnTo>
                  <a:pt x="3583" y="53"/>
                </a:lnTo>
                <a:lnTo>
                  <a:pt x="3589" y="53"/>
                </a:lnTo>
                <a:lnTo>
                  <a:pt x="3599" y="53"/>
                </a:lnTo>
                <a:lnTo>
                  <a:pt x="3606" y="53"/>
                </a:lnTo>
                <a:lnTo>
                  <a:pt x="3616" y="54"/>
                </a:lnTo>
                <a:lnTo>
                  <a:pt x="3624" y="54"/>
                </a:lnTo>
                <a:lnTo>
                  <a:pt x="3630" y="54"/>
                </a:lnTo>
                <a:lnTo>
                  <a:pt x="3640" y="54"/>
                </a:lnTo>
                <a:lnTo>
                  <a:pt x="3647" y="54"/>
                </a:lnTo>
                <a:lnTo>
                  <a:pt x="3656" y="54"/>
                </a:lnTo>
                <a:lnTo>
                  <a:pt x="3665" y="54"/>
                </a:lnTo>
                <a:lnTo>
                  <a:pt x="3671" y="54"/>
                </a:lnTo>
                <a:lnTo>
                  <a:pt x="3681" y="54"/>
                </a:lnTo>
                <a:lnTo>
                  <a:pt x="3687" y="54"/>
                </a:lnTo>
                <a:lnTo>
                  <a:pt x="3696" y="54"/>
                </a:lnTo>
                <a:lnTo>
                  <a:pt x="3705" y="54"/>
                </a:lnTo>
                <a:lnTo>
                  <a:pt x="3712" y="54"/>
                </a:lnTo>
                <a:lnTo>
                  <a:pt x="3722" y="54"/>
                </a:lnTo>
                <a:lnTo>
                  <a:pt x="3728" y="54"/>
                </a:lnTo>
                <a:lnTo>
                  <a:pt x="3736" y="56"/>
                </a:lnTo>
                <a:lnTo>
                  <a:pt x="3746" y="56"/>
                </a:lnTo>
                <a:lnTo>
                  <a:pt x="3753" y="56"/>
                </a:lnTo>
                <a:lnTo>
                  <a:pt x="3762" y="56"/>
                </a:lnTo>
                <a:lnTo>
                  <a:pt x="3769" y="56"/>
                </a:lnTo>
                <a:lnTo>
                  <a:pt x="3777" y="56"/>
                </a:lnTo>
                <a:lnTo>
                  <a:pt x="3787" y="56"/>
                </a:lnTo>
                <a:lnTo>
                  <a:pt x="3793" y="56"/>
                </a:lnTo>
                <a:lnTo>
                  <a:pt x="3803" y="56"/>
                </a:lnTo>
                <a:lnTo>
                  <a:pt x="3810" y="56"/>
                </a:lnTo>
                <a:lnTo>
                  <a:pt x="3818" y="56"/>
                </a:lnTo>
                <a:lnTo>
                  <a:pt x="3828" y="56"/>
                </a:lnTo>
                <a:lnTo>
                  <a:pt x="3834" y="56"/>
                </a:lnTo>
                <a:lnTo>
                  <a:pt x="3844" y="56"/>
                </a:lnTo>
                <a:lnTo>
                  <a:pt x="3851" y="57"/>
                </a:lnTo>
                <a:lnTo>
                  <a:pt x="3859" y="57"/>
                </a:lnTo>
                <a:lnTo>
                  <a:pt x="3868" y="57"/>
                </a:lnTo>
                <a:lnTo>
                  <a:pt x="3875" y="57"/>
                </a:lnTo>
                <a:lnTo>
                  <a:pt x="3885" y="57"/>
                </a:lnTo>
                <a:lnTo>
                  <a:pt x="3891" y="57"/>
                </a:lnTo>
                <a:lnTo>
                  <a:pt x="3899" y="57"/>
                </a:lnTo>
                <a:lnTo>
                  <a:pt x="3909" y="57"/>
                </a:lnTo>
                <a:lnTo>
                  <a:pt x="3916" y="57"/>
                </a:lnTo>
                <a:lnTo>
                  <a:pt x="3926" y="57"/>
                </a:lnTo>
                <a:lnTo>
                  <a:pt x="3932" y="57"/>
                </a:lnTo>
                <a:lnTo>
                  <a:pt x="3940" y="57"/>
                </a:lnTo>
                <a:lnTo>
                  <a:pt x="3948" y="57"/>
                </a:lnTo>
                <a:lnTo>
                  <a:pt x="3957" y="57"/>
                </a:lnTo>
                <a:lnTo>
                  <a:pt x="3966" y="57"/>
                </a:lnTo>
                <a:lnTo>
                  <a:pt x="3975" y="59"/>
                </a:lnTo>
                <a:lnTo>
                  <a:pt x="3983" y="59"/>
                </a:lnTo>
                <a:lnTo>
                  <a:pt x="3989" y="59"/>
                </a:lnTo>
                <a:lnTo>
                  <a:pt x="3997" y="59"/>
                </a:lnTo>
                <a:lnTo>
                  <a:pt x="4007" y="59"/>
                </a:lnTo>
                <a:lnTo>
                  <a:pt x="4015" y="59"/>
                </a:lnTo>
                <a:lnTo>
                  <a:pt x="4023" y="59"/>
                </a:lnTo>
                <a:lnTo>
                  <a:pt x="4030" y="59"/>
                </a:lnTo>
                <a:lnTo>
                  <a:pt x="4038" y="59"/>
                </a:lnTo>
                <a:lnTo>
                  <a:pt x="4048" y="59"/>
                </a:lnTo>
                <a:lnTo>
                  <a:pt x="4056" y="59"/>
                </a:lnTo>
                <a:lnTo>
                  <a:pt x="4064" y="59"/>
                </a:lnTo>
                <a:lnTo>
                  <a:pt x="4071" y="59"/>
                </a:lnTo>
                <a:lnTo>
                  <a:pt x="4079" y="59"/>
                </a:lnTo>
                <a:lnTo>
                  <a:pt x="4089" y="61"/>
                </a:lnTo>
                <a:lnTo>
                  <a:pt x="4097" y="61"/>
                </a:lnTo>
                <a:lnTo>
                  <a:pt x="4105" y="61"/>
                </a:lnTo>
                <a:lnTo>
                  <a:pt x="4112" y="61"/>
                </a:lnTo>
                <a:lnTo>
                  <a:pt x="4120" y="61"/>
                </a:lnTo>
                <a:lnTo>
                  <a:pt x="4130" y="61"/>
                </a:lnTo>
                <a:lnTo>
                  <a:pt x="4138" y="61"/>
                </a:lnTo>
                <a:lnTo>
                  <a:pt x="4146" y="61"/>
                </a:lnTo>
                <a:lnTo>
                  <a:pt x="4152" y="61"/>
                </a:lnTo>
                <a:lnTo>
                  <a:pt x="4161" y="61"/>
                </a:lnTo>
                <a:lnTo>
                  <a:pt x="4170" y="61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3" name="Freeform 108"/>
          <p:cNvSpPr>
            <a:spLocks/>
          </p:cNvSpPr>
          <p:nvPr/>
        </p:nvSpPr>
        <p:spPr bwMode="auto">
          <a:xfrm>
            <a:off x="1672431" y="5050475"/>
            <a:ext cx="6619875" cy="252413"/>
          </a:xfrm>
          <a:custGeom>
            <a:avLst/>
            <a:gdLst>
              <a:gd name="T0" fmla="*/ 67 w 4170"/>
              <a:gd name="T1" fmla="*/ 159 h 159"/>
              <a:gd name="T2" fmla="*/ 138 w 4170"/>
              <a:gd name="T3" fmla="*/ 159 h 159"/>
              <a:gd name="T4" fmla="*/ 212 w 4170"/>
              <a:gd name="T5" fmla="*/ 159 h 159"/>
              <a:gd name="T6" fmla="*/ 285 w 4170"/>
              <a:gd name="T7" fmla="*/ 159 h 159"/>
              <a:gd name="T8" fmla="*/ 360 w 4170"/>
              <a:gd name="T9" fmla="*/ 150 h 159"/>
              <a:gd name="T10" fmla="*/ 434 w 4170"/>
              <a:gd name="T11" fmla="*/ 144 h 159"/>
              <a:gd name="T12" fmla="*/ 505 w 4170"/>
              <a:gd name="T13" fmla="*/ 137 h 159"/>
              <a:gd name="T14" fmla="*/ 579 w 4170"/>
              <a:gd name="T15" fmla="*/ 132 h 159"/>
              <a:gd name="T16" fmla="*/ 654 w 4170"/>
              <a:gd name="T17" fmla="*/ 126 h 159"/>
              <a:gd name="T18" fmla="*/ 727 w 4170"/>
              <a:gd name="T19" fmla="*/ 119 h 159"/>
              <a:gd name="T20" fmla="*/ 801 w 4170"/>
              <a:gd name="T21" fmla="*/ 114 h 159"/>
              <a:gd name="T22" fmla="*/ 873 w 4170"/>
              <a:gd name="T23" fmla="*/ 108 h 159"/>
              <a:gd name="T24" fmla="*/ 948 w 4170"/>
              <a:gd name="T25" fmla="*/ 101 h 159"/>
              <a:gd name="T26" fmla="*/ 1019 w 4170"/>
              <a:gd name="T27" fmla="*/ 97 h 159"/>
              <a:gd name="T28" fmla="*/ 1095 w 4170"/>
              <a:gd name="T29" fmla="*/ 90 h 159"/>
              <a:gd name="T30" fmla="*/ 1166 w 4170"/>
              <a:gd name="T31" fmla="*/ 85 h 159"/>
              <a:gd name="T32" fmla="*/ 1240 w 4170"/>
              <a:gd name="T33" fmla="*/ 80 h 159"/>
              <a:gd name="T34" fmla="*/ 1315 w 4170"/>
              <a:gd name="T35" fmla="*/ 74 h 159"/>
              <a:gd name="T36" fmla="*/ 1387 w 4170"/>
              <a:gd name="T37" fmla="*/ 69 h 159"/>
              <a:gd name="T38" fmla="*/ 1462 w 4170"/>
              <a:gd name="T39" fmla="*/ 64 h 159"/>
              <a:gd name="T40" fmla="*/ 1533 w 4170"/>
              <a:gd name="T41" fmla="*/ 57 h 159"/>
              <a:gd name="T42" fmla="*/ 1609 w 4170"/>
              <a:gd name="T43" fmla="*/ 52 h 159"/>
              <a:gd name="T44" fmla="*/ 1680 w 4170"/>
              <a:gd name="T45" fmla="*/ 48 h 159"/>
              <a:gd name="T46" fmla="*/ 1755 w 4170"/>
              <a:gd name="T47" fmla="*/ 43 h 159"/>
              <a:gd name="T48" fmla="*/ 1829 w 4170"/>
              <a:gd name="T49" fmla="*/ 36 h 159"/>
              <a:gd name="T50" fmla="*/ 1902 w 4170"/>
              <a:gd name="T51" fmla="*/ 31 h 159"/>
              <a:gd name="T52" fmla="*/ 1976 w 4170"/>
              <a:gd name="T53" fmla="*/ 26 h 159"/>
              <a:gd name="T54" fmla="*/ 2049 w 4170"/>
              <a:gd name="T55" fmla="*/ 21 h 159"/>
              <a:gd name="T56" fmla="*/ 2121 w 4170"/>
              <a:gd name="T57" fmla="*/ 17 h 159"/>
              <a:gd name="T58" fmla="*/ 2194 w 4170"/>
              <a:gd name="T59" fmla="*/ 12 h 159"/>
              <a:gd name="T60" fmla="*/ 2269 w 4170"/>
              <a:gd name="T61" fmla="*/ 7 h 159"/>
              <a:gd name="T62" fmla="*/ 2341 w 4170"/>
              <a:gd name="T63" fmla="*/ 2 h 159"/>
              <a:gd name="T64" fmla="*/ 2416 w 4170"/>
              <a:gd name="T65" fmla="*/ 7 h 159"/>
              <a:gd name="T66" fmla="*/ 2490 w 4170"/>
              <a:gd name="T67" fmla="*/ 7 h 159"/>
              <a:gd name="T68" fmla="*/ 2561 w 4170"/>
              <a:gd name="T69" fmla="*/ 8 h 159"/>
              <a:gd name="T70" fmla="*/ 2635 w 4170"/>
              <a:gd name="T71" fmla="*/ 8 h 159"/>
              <a:gd name="T72" fmla="*/ 2708 w 4170"/>
              <a:gd name="T73" fmla="*/ 8 h 159"/>
              <a:gd name="T74" fmla="*/ 2783 w 4170"/>
              <a:gd name="T75" fmla="*/ 10 h 159"/>
              <a:gd name="T76" fmla="*/ 2857 w 4170"/>
              <a:gd name="T77" fmla="*/ 10 h 159"/>
              <a:gd name="T78" fmla="*/ 2930 w 4170"/>
              <a:gd name="T79" fmla="*/ 12 h 159"/>
              <a:gd name="T80" fmla="*/ 3002 w 4170"/>
              <a:gd name="T81" fmla="*/ 12 h 159"/>
              <a:gd name="T82" fmla="*/ 3075 w 4170"/>
              <a:gd name="T83" fmla="*/ 12 h 159"/>
              <a:gd name="T84" fmla="*/ 3149 w 4170"/>
              <a:gd name="T85" fmla="*/ 13 h 159"/>
              <a:gd name="T86" fmla="*/ 3222 w 4170"/>
              <a:gd name="T87" fmla="*/ 13 h 159"/>
              <a:gd name="T88" fmla="*/ 3296 w 4170"/>
              <a:gd name="T89" fmla="*/ 13 h 159"/>
              <a:gd name="T90" fmla="*/ 3371 w 4170"/>
              <a:gd name="T91" fmla="*/ 15 h 159"/>
              <a:gd name="T92" fmla="*/ 3443 w 4170"/>
              <a:gd name="T93" fmla="*/ 15 h 159"/>
              <a:gd name="T94" fmla="*/ 3518 w 4170"/>
              <a:gd name="T95" fmla="*/ 15 h 159"/>
              <a:gd name="T96" fmla="*/ 3589 w 4170"/>
              <a:gd name="T97" fmla="*/ 17 h 159"/>
              <a:gd name="T98" fmla="*/ 3665 w 4170"/>
              <a:gd name="T99" fmla="*/ 17 h 159"/>
              <a:gd name="T100" fmla="*/ 3736 w 4170"/>
              <a:gd name="T101" fmla="*/ 17 h 159"/>
              <a:gd name="T102" fmla="*/ 3810 w 4170"/>
              <a:gd name="T103" fmla="*/ 18 h 159"/>
              <a:gd name="T104" fmla="*/ 3885 w 4170"/>
              <a:gd name="T105" fmla="*/ 18 h 159"/>
              <a:gd name="T106" fmla="*/ 3957 w 4170"/>
              <a:gd name="T107" fmla="*/ 18 h 159"/>
              <a:gd name="T108" fmla="*/ 4030 w 4170"/>
              <a:gd name="T109" fmla="*/ 20 h 159"/>
              <a:gd name="T110" fmla="*/ 4105 w 4170"/>
              <a:gd name="T111" fmla="*/ 20 h 1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159">
                <a:moveTo>
                  <a:pt x="0" y="159"/>
                </a:moveTo>
                <a:lnTo>
                  <a:pt x="8" y="159"/>
                </a:lnTo>
                <a:lnTo>
                  <a:pt x="16" y="159"/>
                </a:lnTo>
                <a:lnTo>
                  <a:pt x="26" y="159"/>
                </a:lnTo>
                <a:lnTo>
                  <a:pt x="34" y="159"/>
                </a:lnTo>
                <a:lnTo>
                  <a:pt x="40" y="159"/>
                </a:lnTo>
                <a:lnTo>
                  <a:pt x="49" y="159"/>
                </a:lnTo>
                <a:lnTo>
                  <a:pt x="57" y="159"/>
                </a:lnTo>
                <a:lnTo>
                  <a:pt x="67" y="159"/>
                </a:lnTo>
                <a:lnTo>
                  <a:pt x="75" y="159"/>
                </a:lnTo>
                <a:lnTo>
                  <a:pt x="81" y="159"/>
                </a:lnTo>
                <a:lnTo>
                  <a:pt x="89" y="159"/>
                </a:lnTo>
                <a:lnTo>
                  <a:pt x="98" y="159"/>
                </a:lnTo>
                <a:lnTo>
                  <a:pt x="107" y="159"/>
                </a:lnTo>
                <a:lnTo>
                  <a:pt x="116" y="159"/>
                </a:lnTo>
                <a:lnTo>
                  <a:pt x="122" y="159"/>
                </a:lnTo>
                <a:lnTo>
                  <a:pt x="130" y="159"/>
                </a:lnTo>
                <a:lnTo>
                  <a:pt x="138" y="159"/>
                </a:lnTo>
                <a:lnTo>
                  <a:pt x="148" y="159"/>
                </a:lnTo>
                <a:lnTo>
                  <a:pt x="156" y="159"/>
                </a:lnTo>
                <a:lnTo>
                  <a:pt x="163" y="159"/>
                </a:lnTo>
                <a:lnTo>
                  <a:pt x="171" y="159"/>
                </a:lnTo>
                <a:lnTo>
                  <a:pt x="179" y="159"/>
                </a:lnTo>
                <a:lnTo>
                  <a:pt x="189" y="159"/>
                </a:lnTo>
                <a:lnTo>
                  <a:pt x="197" y="159"/>
                </a:lnTo>
                <a:lnTo>
                  <a:pt x="204" y="159"/>
                </a:lnTo>
                <a:lnTo>
                  <a:pt x="212" y="159"/>
                </a:lnTo>
                <a:lnTo>
                  <a:pt x="220" y="159"/>
                </a:lnTo>
                <a:lnTo>
                  <a:pt x="230" y="159"/>
                </a:lnTo>
                <a:lnTo>
                  <a:pt x="238" y="159"/>
                </a:lnTo>
                <a:lnTo>
                  <a:pt x="244" y="159"/>
                </a:lnTo>
                <a:lnTo>
                  <a:pt x="253" y="159"/>
                </a:lnTo>
                <a:lnTo>
                  <a:pt x="261" y="159"/>
                </a:lnTo>
                <a:lnTo>
                  <a:pt x="271" y="159"/>
                </a:lnTo>
                <a:lnTo>
                  <a:pt x="279" y="159"/>
                </a:lnTo>
                <a:lnTo>
                  <a:pt x="285" y="159"/>
                </a:lnTo>
                <a:lnTo>
                  <a:pt x="293" y="159"/>
                </a:lnTo>
                <a:lnTo>
                  <a:pt x="302" y="159"/>
                </a:lnTo>
                <a:lnTo>
                  <a:pt x="311" y="159"/>
                </a:lnTo>
                <a:lnTo>
                  <a:pt x="319" y="159"/>
                </a:lnTo>
                <a:lnTo>
                  <a:pt x="326" y="159"/>
                </a:lnTo>
                <a:lnTo>
                  <a:pt x="334" y="159"/>
                </a:lnTo>
                <a:lnTo>
                  <a:pt x="342" y="152"/>
                </a:lnTo>
                <a:lnTo>
                  <a:pt x="352" y="152"/>
                </a:lnTo>
                <a:lnTo>
                  <a:pt x="360" y="150"/>
                </a:lnTo>
                <a:lnTo>
                  <a:pt x="367" y="150"/>
                </a:lnTo>
                <a:lnTo>
                  <a:pt x="375" y="149"/>
                </a:lnTo>
                <a:lnTo>
                  <a:pt x="383" y="149"/>
                </a:lnTo>
                <a:lnTo>
                  <a:pt x="393" y="147"/>
                </a:lnTo>
                <a:lnTo>
                  <a:pt x="401" y="147"/>
                </a:lnTo>
                <a:lnTo>
                  <a:pt x="408" y="147"/>
                </a:lnTo>
                <a:lnTo>
                  <a:pt x="416" y="145"/>
                </a:lnTo>
                <a:lnTo>
                  <a:pt x="424" y="145"/>
                </a:lnTo>
                <a:lnTo>
                  <a:pt x="434" y="144"/>
                </a:lnTo>
                <a:lnTo>
                  <a:pt x="442" y="144"/>
                </a:lnTo>
                <a:lnTo>
                  <a:pt x="448" y="142"/>
                </a:lnTo>
                <a:lnTo>
                  <a:pt x="457" y="142"/>
                </a:lnTo>
                <a:lnTo>
                  <a:pt x="465" y="142"/>
                </a:lnTo>
                <a:lnTo>
                  <a:pt x="474" y="141"/>
                </a:lnTo>
                <a:lnTo>
                  <a:pt x="483" y="141"/>
                </a:lnTo>
                <a:lnTo>
                  <a:pt x="489" y="139"/>
                </a:lnTo>
                <a:lnTo>
                  <a:pt x="497" y="139"/>
                </a:lnTo>
                <a:lnTo>
                  <a:pt x="505" y="137"/>
                </a:lnTo>
                <a:lnTo>
                  <a:pt x="515" y="137"/>
                </a:lnTo>
                <a:lnTo>
                  <a:pt x="523" y="137"/>
                </a:lnTo>
                <a:lnTo>
                  <a:pt x="532" y="136"/>
                </a:lnTo>
                <a:lnTo>
                  <a:pt x="538" y="136"/>
                </a:lnTo>
                <a:lnTo>
                  <a:pt x="546" y="134"/>
                </a:lnTo>
                <a:lnTo>
                  <a:pt x="556" y="134"/>
                </a:lnTo>
                <a:lnTo>
                  <a:pt x="564" y="134"/>
                </a:lnTo>
                <a:lnTo>
                  <a:pt x="572" y="132"/>
                </a:lnTo>
                <a:lnTo>
                  <a:pt x="579" y="132"/>
                </a:lnTo>
                <a:lnTo>
                  <a:pt x="587" y="131"/>
                </a:lnTo>
                <a:lnTo>
                  <a:pt x="597" y="131"/>
                </a:lnTo>
                <a:lnTo>
                  <a:pt x="605" y="129"/>
                </a:lnTo>
                <a:lnTo>
                  <a:pt x="613" y="129"/>
                </a:lnTo>
                <a:lnTo>
                  <a:pt x="620" y="129"/>
                </a:lnTo>
                <a:lnTo>
                  <a:pt x="628" y="128"/>
                </a:lnTo>
                <a:lnTo>
                  <a:pt x="638" y="128"/>
                </a:lnTo>
                <a:lnTo>
                  <a:pt x="646" y="126"/>
                </a:lnTo>
                <a:lnTo>
                  <a:pt x="654" y="126"/>
                </a:lnTo>
                <a:lnTo>
                  <a:pt x="661" y="126"/>
                </a:lnTo>
                <a:lnTo>
                  <a:pt x="669" y="124"/>
                </a:lnTo>
                <a:lnTo>
                  <a:pt x="678" y="124"/>
                </a:lnTo>
                <a:lnTo>
                  <a:pt x="687" y="123"/>
                </a:lnTo>
                <a:lnTo>
                  <a:pt x="695" y="123"/>
                </a:lnTo>
                <a:lnTo>
                  <a:pt x="701" y="123"/>
                </a:lnTo>
                <a:lnTo>
                  <a:pt x="709" y="121"/>
                </a:lnTo>
                <a:lnTo>
                  <a:pt x="719" y="121"/>
                </a:lnTo>
                <a:lnTo>
                  <a:pt x="727" y="119"/>
                </a:lnTo>
                <a:lnTo>
                  <a:pt x="736" y="119"/>
                </a:lnTo>
                <a:lnTo>
                  <a:pt x="742" y="118"/>
                </a:lnTo>
                <a:lnTo>
                  <a:pt x="750" y="118"/>
                </a:lnTo>
                <a:lnTo>
                  <a:pt x="760" y="118"/>
                </a:lnTo>
                <a:lnTo>
                  <a:pt x="768" y="116"/>
                </a:lnTo>
                <a:lnTo>
                  <a:pt x="776" y="116"/>
                </a:lnTo>
                <a:lnTo>
                  <a:pt x="783" y="114"/>
                </a:lnTo>
                <a:lnTo>
                  <a:pt x="791" y="114"/>
                </a:lnTo>
                <a:lnTo>
                  <a:pt x="801" y="114"/>
                </a:lnTo>
                <a:lnTo>
                  <a:pt x="809" y="113"/>
                </a:lnTo>
                <a:lnTo>
                  <a:pt x="817" y="113"/>
                </a:lnTo>
                <a:lnTo>
                  <a:pt x="824" y="111"/>
                </a:lnTo>
                <a:lnTo>
                  <a:pt x="832" y="111"/>
                </a:lnTo>
                <a:lnTo>
                  <a:pt x="842" y="111"/>
                </a:lnTo>
                <a:lnTo>
                  <a:pt x="850" y="110"/>
                </a:lnTo>
                <a:lnTo>
                  <a:pt x="856" y="110"/>
                </a:lnTo>
                <a:lnTo>
                  <a:pt x="866" y="108"/>
                </a:lnTo>
                <a:lnTo>
                  <a:pt x="873" y="108"/>
                </a:lnTo>
                <a:lnTo>
                  <a:pt x="882" y="108"/>
                </a:lnTo>
                <a:lnTo>
                  <a:pt x="891" y="106"/>
                </a:lnTo>
                <a:lnTo>
                  <a:pt x="897" y="106"/>
                </a:lnTo>
                <a:lnTo>
                  <a:pt x="907" y="105"/>
                </a:lnTo>
                <a:lnTo>
                  <a:pt x="913" y="105"/>
                </a:lnTo>
                <a:lnTo>
                  <a:pt x="923" y="105"/>
                </a:lnTo>
                <a:lnTo>
                  <a:pt x="931" y="103"/>
                </a:lnTo>
                <a:lnTo>
                  <a:pt x="938" y="103"/>
                </a:lnTo>
                <a:lnTo>
                  <a:pt x="948" y="101"/>
                </a:lnTo>
                <a:lnTo>
                  <a:pt x="954" y="101"/>
                </a:lnTo>
                <a:lnTo>
                  <a:pt x="964" y="101"/>
                </a:lnTo>
                <a:lnTo>
                  <a:pt x="972" y="100"/>
                </a:lnTo>
                <a:lnTo>
                  <a:pt x="979" y="100"/>
                </a:lnTo>
                <a:lnTo>
                  <a:pt x="988" y="98"/>
                </a:lnTo>
                <a:lnTo>
                  <a:pt x="995" y="98"/>
                </a:lnTo>
                <a:lnTo>
                  <a:pt x="1005" y="98"/>
                </a:lnTo>
                <a:lnTo>
                  <a:pt x="1013" y="97"/>
                </a:lnTo>
                <a:lnTo>
                  <a:pt x="1019" y="97"/>
                </a:lnTo>
                <a:lnTo>
                  <a:pt x="1029" y="97"/>
                </a:lnTo>
                <a:lnTo>
                  <a:pt x="1036" y="95"/>
                </a:lnTo>
                <a:lnTo>
                  <a:pt x="1044" y="95"/>
                </a:lnTo>
                <a:lnTo>
                  <a:pt x="1054" y="93"/>
                </a:lnTo>
                <a:lnTo>
                  <a:pt x="1060" y="93"/>
                </a:lnTo>
                <a:lnTo>
                  <a:pt x="1070" y="93"/>
                </a:lnTo>
                <a:lnTo>
                  <a:pt x="1077" y="92"/>
                </a:lnTo>
                <a:lnTo>
                  <a:pt x="1085" y="92"/>
                </a:lnTo>
                <a:lnTo>
                  <a:pt x="1095" y="90"/>
                </a:lnTo>
                <a:lnTo>
                  <a:pt x="1101" y="90"/>
                </a:lnTo>
                <a:lnTo>
                  <a:pt x="1111" y="90"/>
                </a:lnTo>
                <a:lnTo>
                  <a:pt x="1117" y="88"/>
                </a:lnTo>
                <a:lnTo>
                  <a:pt x="1126" y="88"/>
                </a:lnTo>
                <a:lnTo>
                  <a:pt x="1135" y="87"/>
                </a:lnTo>
                <a:lnTo>
                  <a:pt x="1142" y="87"/>
                </a:lnTo>
                <a:lnTo>
                  <a:pt x="1152" y="87"/>
                </a:lnTo>
                <a:lnTo>
                  <a:pt x="1158" y="85"/>
                </a:lnTo>
                <a:lnTo>
                  <a:pt x="1166" y="85"/>
                </a:lnTo>
                <a:lnTo>
                  <a:pt x="1176" y="85"/>
                </a:lnTo>
                <a:lnTo>
                  <a:pt x="1183" y="83"/>
                </a:lnTo>
                <a:lnTo>
                  <a:pt x="1192" y="83"/>
                </a:lnTo>
                <a:lnTo>
                  <a:pt x="1199" y="82"/>
                </a:lnTo>
                <a:lnTo>
                  <a:pt x="1207" y="82"/>
                </a:lnTo>
                <a:lnTo>
                  <a:pt x="1217" y="82"/>
                </a:lnTo>
                <a:lnTo>
                  <a:pt x="1223" y="80"/>
                </a:lnTo>
                <a:lnTo>
                  <a:pt x="1233" y="80"/>
                </a:lnTo>
                <a:lnTo>
                  <a:pt x="1240" y="80"/>
                </a:lnTo>
                <a:lnTo>
                  <a:pt x="1248" y="79"/>
                </a:lnTo>
                <a:lnTo>
                  <a:pt x="1258" y="79"/>
                </a:lnTo>
                <a:lnTo>
                  <a:pt x="1264" y="77"/>
                </a:lnTo>
                <a:lnTo>
                  <a:pt x="1274" y="77"/>
                </a:lnTo>
                <a:lnTo>
                  <a:pt x="1281" y="77"/>
                </a:lnTo>
                <a:lnTo>
                  <a:pt x="1289" y="75"/>
                </a:lnTo>
                <a:lnTo>
                  <a:pt x="1299" y="75"/>
                </a:lnTo>
                <a:lnTo>
                  <a:pt x="1305" y="75"/>
                </a:lnTo>
                <a:lnTo>
                  <a:pt x="1315" y="74"/>
                </a:lnTo>
                <a:lnTo>
                  <a:pt x="1323" y="74"/>
                </a:lnTo>
                <a:lnTo>
                  <a:pt x="1330" y="72"/>
                </a:lnTo>
                <a:lnTo>
                  <a:pt x="1339" y="72"/>
                </a:lnTo>
                <a:lnTo>
                  <a:pt x="1346" y="72"/>
                </a:lnTo>
                <a:lnTo>
                  <a:pt x="1356" y="70"/>
                </a:lnTo>
                <a:lnTo>
                  <a:pt x="1364" y="70"/>
                </a:lnTo>
                <a:lnTo>
                  <a:pt x="1370" y="70"/>
                </a:lnTo>
                <a:lnTo>
                  <a:pt x="1380" y="69"/>
                </a:lnTo>
                <a:lnTo>
                  <a:pt x="1387" y="69"/>
                </a:lnTo>
                <a:lnTo>
                  <a:pt x="1396" y="67"/>
                </a:lnTo>
                <a:lnTo>
                  <a:pt x="1405" y="67"/>
                </a:lnTo>
                <a:lnTo>
                  <a:pt x="1411" y="67"/>
                </a:lnTo>
                <a:lnTo>
                  <a:pt x="1421" y="66"/>
                </a:lnTo>
                <a:lnTo>
                  <a:pt x="1427" y="66"/>
                </a:lnTo>
                <a:lnTo>
                  <a:pt x="1437" y="66"/>
                </a:lnTo>
                <a:lnTo>
                  <a:pt x="1445" y="64"/>
                </a:lnTo>
                <a:lnTo>
                  <a:pt x="1452" y="64"/>
                </a:lnTo>
                <a:lnTo>
                  <a:pt x="1462" y="64"/>
                </a:lnTo>
                <a:lnTo>
                  <a:pt x="1468" y="62"/>
                </a:lnTo>
                <a:lnTo>
                  <a:pt x="1478" y="62"/>
                </a:lnTo>
                <a:lnTo>
                  <a:pt x="1486" y="61"/>
                </a:lnTo>
                <a:lnTo>
                  <a:pt x="1493" y="61"/>
                </a:lnTo>
                <a:lnTo>
                  <a:pt x="1502" y="61"/>
                </a:lnTo>
                <a:lnTo>
                  <a:pt x="1509" y="59"/>
                </a:lnTo>
                <a:lnTo>
                  <a:pt x="1519" y="59"/>
                </a:lnTo>
                <a:lnTo>
                  <a:pt x="1527" y="59"/>
                </a:lnTo>
                <a:lnTo>
                  <a:pt x="1533" y="57"/>
                </a:lnTo>
                <a:lnTo>
                  <a:pt x="1543" y="57"/>
                </a:lnTo>
                <a:lnTo>
                  <a:pt x="1550" y="57"/>
                </a:lnTo>
                <a:lnTo>
                  <a:pt x="1560" y="56"/>
                </a:lnTo>
                <a:lnTo>
                  <a:pt x="1568" y="56"/>
                </a:lnTo>
                <a:lnTo>
                  <a:pt x="1574" y="54"/>
                </a:lnTo>
                <a:lnTo>
                  <a:pt x="1584" y="54"/>
                </a:lnTo>
                <a:lnTo>
                  <a:pt x="1591" y="54"/>
                </a:lnTo>
                <a:lnTo>
                  <a:pt x="1599" y="52"/>
                </a:lnTo>
                <a:lnTo>
                  <a:pt x="1609" y="52"/>
                </a:lnTo>
                <a:lnTo>
                  <a:pt x="1615" y="52"/>
                </a:lnTo>
                <a:lnTo>
                  <a:pt x="1625" y="51"/>
                </a:lnTo>
                <a:lnTo>
                  <a:pt x="1633" y="51"/>
                </a:lnTo>
                <a:lnTo>
                  <a:pt x="1640" y="51"/>
                </a:lnTo>
                <a:lnTo>
                  <a:pt x="1648" y="49"/>
                </a:lnTo>
                <a:lnTo>
                  <a:pt x="1656" y="49"/>
                </a:lnTo>
                <a:lnTo>
                  <a:pt x="1666" y="49"/>
                </a:lnTo>
                <a:lnTo>
                  <a:pt x="1674" y="48"/>
                </a:lnTo>
                <a:lnTo>
                  <a:pt x="1680" y="48"/>
                </a:lnTo>
                <a:lnTo>
                  <a:pt x="1688" y="46"/>
                </a:lnTo>
                <a:lnTo>
                  <a:pt x="1697" y="46"/>
                </a:lnTo>
                <a:lnTo>
                  <a:pt x="1706" y="46"/>
                </a:lnTo>
                <a:lnTo>
                  <a:pt x="1715" y="44"/>
                </a:lnTo>
                <a:lnTo>
                  <a:pt x="1721" y="44"/>
                </a:lnTo>
                <a:lnTo>
                  <a:pt x="1729" y="44"/>
                </a:lnTo>
                <a:lnTo>
                  <a:pt x="1739" y="43"/>
                </a:lnTo>
                <a:lnTo>
                  <a:pt x="1747" y="43"/>
                </a:lnTo>
                <a:lnTo>
                  <a:pt x="1755" y="43"/>
                </a:lnTo>
                <a:lnTo>
                  <a:pt x="1762" y="41"/>
                </a:lnTo>
                <a:lnTo>
                  <a:pt x="1770" y="41"/>
                </a:lnTo>
                <a:lnTo>
                  <a:pt x="1780" y="41"/>
                </a:lnTo>
                <a:lnTo>
                  <a:pt x="1788" y="39"/>
                </a:lnTo>
                <a:lnTo>
                  <a:pt x="1796" y="39"/>
                </a:lnTo>
                <a:lnTo>
                  <a:pt x="1803" y="39"/>
                </a:lnTo>
                <a:lnTo>
                  <a:pt x="1811" y="38"/>
                </a:lnTo>
                <a:lnTo>
                  <a:pt x="1821" y="38"/>
                </a:lnTo>
                <a:lnTo>
                  <a:pt x="1829" y="36"/>
                </a:lnTo>
                <a:lnTo>
                  <a:pt x="1835" y="36"/>
                </a:lnTo>
                <a:lnTo>
                  <a:pt x="1844" y="36"/>
                </a:lnTo>
                <a:lnTo>
                  <a:pt x="1852" y="35"/>
                </a:lnTo>
                <a:lnTo>
                  <a:pt x="1861" y="35"/>
                </a:lnTo>
                <a:lnTo>
                  <a:pt x="1870" y="35"/>
                </a:lnTo>
                <a:lnTo>
                  <a:pt x="1876" y="33"/>
                </a:lnTo>
                <a:lnTo>
                  <a:pt x="1884" y="33"/>
                </a:lnTo>
                <a:lnTo>
                  <a:pt x="1892" y="33"/>
                </a:lnTo>
                <a:lnTo>
                  <a:pt x="1902" y="31"/>
                </a:lnTo>
                <a:lnTo>
                  <a:pt x="1910" y="31"/>
                </a:lnTo>
                <a:lnTo>
                  <a:pt x="1917" y="31"/>
                </a:lnTo>
                <a:lnTo>
                  <a:pt x="1925" y="30"/>
                </a:lnTo>
                <a:lnTo>
                  <a:pt x="1933" y="30"/>
                </a:lnTo>
                <a:lnTo>
                  <a:pt x="1943" y="30"/>
                </a:lnTo>
                <a:lnTo>
                  <a:pt x="1951" y="28"/>
                </a:lnTo>
                <a:lnTo>
                  <a:pt x="1958" y="28"/>
                </a:lnTo>
                <a:lnTo>
                  <a:pt x="1966" y="28"/>
                </a:lnTo>
                <a:lnTo>
                  <a:pt x="1976" y="26"/>
                </a:lnTo>
                <a:lnTo>
                  <a:pt x="1984" y="26"/>
                </a:lnTo>
                <a:lnTo>
                  <a:pt x="1992" y="26"/>
                </a:lnTo>
                <a:lnTo>
                  <a:pt x="1999" y="25"/>
                </a:lnTo>
                <a:lnTo>
                  <a:pt x="2007" y="25"/>
                </a:lnTo>
                <a:lnTo>
                  <a:pt x="2015" y="25"/>
                </a:lnTo>
                <a:lnTo>
                  <a:pt x="2023" y="23"/>
                </a:lnTo>
                <a:lnTo>
                  <a:pt x="2033" y="23"/>
                </a:lnTo>
                <a:lnTo>
                  <a:pt x="2039" y="23"/>
                </a:lnTo>
                <a:lnTo>
                  <a:pt x="2049" y="21"/>
                </a:lnTo>
                <a:lnTo>
                  <a:pt x="2056" y="21"/>
                </a:lnTo>
                <a:lnTo>
                  <a:pt x="2065" y="21"/>
                </a:lnTo>
                <a:lnTo>
                  <a:pt x="2074" y="20"/>
                </a:lnTo>
                <a:lnTo>
                  <a:pt x="2080" y="20"/>
                </a:lnTo>
                <a:lnTo>
                  <a:pt x="2090" y="20"/>
                </a:lnTo>
                <a:lnTo>
                  <a:pt x="2096" y="18"/>
                </a:lnTo>
                <a:lnTo>
                  <a:pt x="2106" y="18"/>
                </a:lnTo>
                <a:lnTo>
                  <a:pt x="2113" y="18"/>
                </a:lnTo>
                <a:lnTo>
                  <a:pt x="2121" y="17"/>
                </a:lnTo>
                <a:lnTo>
                  <a:pt x="2131" y="17"/>
                </a:lnTo>
                <a:lnTo>
                  <a:pt x="2137" y="17"/>
                </a:lnTo>
                <a:lnTo>
                  <a:pt x="2147" y="15"/>
                </a:lnTo>
                <a:lnTo>
                  <a:pt x="2154" y="15"/>
                </a:lnTo>
                <a:lnTo>
                  <a:pt x="2163" y="15"/>
                </a:lnTo>
                <a:lnTo>
                  <a:pt x="2171" y="13"/>
                </a:lnTo>
                <a:lnTo>
                  <a:pt x="2178" y="13"/>
                </a:lnTo>
                <a:lnTo>
                  <a:pt x="2188" y="13"/>
                </a:lnTo>
                <a:lnTo>
                  <a:pt x="2194" y="12"/>
                </a:lnTo>
                <a:lnTo>
                  <a:pt x="2202" y="12"/>
                </a:lnTo>
                <a:lnTo>
                  <a:pt x="2212" y="12"/>
                </a:lnTo>
                <a:lnTo>
                  <a:pt x="2220" y="10"/>
                </a:lnTo>
                <a:lnTo>
                  <a:pt x="2229" y="10"/>
                </a:lnTo>
                <a:lnTo>
                  <a:pt x="2235" y="10"/>
                </a:lnTo>
                <a:lnTo>
                  <a:pt x="2243" y="8"/>
                </a:lnTo>
                <a:lnTo>
                  <a:pt x="2251" y="8"/>
                </a:lnTo>
                <a:lnTo>
                  <a:pt x="2261" y="8"/>
                </a:lnTo>
                <a:lnTo>
                  <a:pt x="2269" y="7"/>
                </a:lnTo>
                <a:lnTo>
                  <a:pt x="2278" y="7"/>
                </a:lnTo>
                <a:lnTo>
                  <a:pt x="2284" y="7"/>
                </a:lnTo>
                <a:lnTo>
                  <a:pt x="2292" y="5"/>
                </a:lnTo>
                <a:lnTo>
                  <a:pt x="2300" y="5"/>
                </a:lnTo>
                <a:lnTo>
                  <a:pt x="2310" y="5"/>
                </a:lnTo>
                <a:lnTo>
                  <a:pt x="2317" y="4"/>
                </a:lnTo>
                <a:lnTo>
                  <a:pt x="2326" y="4"/>
                </a:lnTo>
                <a:lnTo>
                  <a:pt x="2335" y="4"/>
                </a:lnTo>
                <a:lnTo>
                  <a:pt x="2341" y="2"/>
                </a:lnTo>
                <a:lnTo>
                  <a:pt x="2351" y="2"/>
                </a:lnTo>
                <a:lnTo>
                  <a:pt x="2357" y="2"/>
                </a:lnTo>
                <a:lnTo>
                  <a:pt x="2366" y="2"/>
                </a:lnTo>
                <a:lnTo>
                  <a:pt x="2375" y="0"/>
                </a:lnTo>
                <a:lnTo>
                  <a:pt x="2382" y="0"/>
                </a:lnTo>
                <a:lnTo>
                  <a:pt x="2390" y="7"/>
                </a:lnTo>
                <a:lnTo>
                  <a:pt x="2400" y="7"/>
                </a:lnTo>
                <a:lnTo>
                  <a:pt x="2408" y="7"/>
                </a:lnTo>
                <a:lnTo>
                  <a:pt x="2416" y="7"/>
                </a:lnTo>
                <a:lnTo>
                  <a:pt x="2424" y="7"/>
                </a:lnTo>
                <a:lnTo>
                  <a:pt x="2433" y="7"/>
                </a:lnTo>
                <a:lnTo>
                  <a:pt x="2439" y="7"/>
                </a:lnTo>
                <a:lnTo>
                  <a:pt x="2449" y="7"/>
                </a:lnTo>
                <a:lnTo>
                  <a:pt x="2455" y="7"/>
                </a:lnTo>
                <a:lnTo>
                  <a:pt x="2464" y="7"/>
                </a:lnTo>
                <a:lnTo>
                  <a:pt x="2473" y="7"/>
                </a:lnTo>
                <a:lnTo>
                  <a:pt x="2480" y="7"/>
                </a:lnTo>
                <a:lnTo>
                  <a:pt x="2490" y="7"/>
                </a:lnTo>
                <a:lnTo>
                  <a:pt x="2498" y="7"/>
                </a:lnTo>
                <a:lnTo>
                  <a:pt x="2506" y="7"/>
                </a:lnTo>
                <a:lnTo>
                  <a:pt x="2513" y="7"/>
                </a:lnTo>
                <a:lnTo>
                  <a:pt x="2521" y="7"/>
                </a:lnTo>
                <a:lnTo>
                  <a:pt x="2529" y="8"/>
                </a:lnTo>
                <a:lnTo>
                  <a:pt x="2539" y="8"/>
                </a:lnTo>
                <a:lnTo>
                  <a:pt x="2547" y="8"/>
                </a:lnTo>
                <a:lnTo>
                  <a:pt x="2555" y="8"/>
                </a:lnTo>
                <a:lnTo>
                  <a:pt x="2561" y="8"/>
                </a:lnTo>
                <a:lnTo>
                  <a:pt x="2570" y="8"/>
                </a:lnTo>
                <a:lnTo>
                  <a:pt x="2578" y="8"/>
                </a:lnTo>
                <a:lnTo>
                  <a:pt x="2588" y="8"/>
                </a:lnTo>
                <a:lnTo>
                  <a:pt x="2594" y="8"/>
                </a:lnTo>
                <a:lnTo>
                  <a:pt x="2604" y="8"/>
                </a:lnTo>
                <a:lnTo>
                  <a:pt x="2610" y="8"/>
                </a:lnTo>
                <a:lnTo>
                  <a:pt x="2620" y="8"/>
                </a:lnTo>
                <a:lnTo>
                  <a:pt x="2627" y="8"/>
                </a:lnTo>
                <a:lnTo>
                  <a:pt x="2635" y="8"/>
                </a:lnTo>
                <a:lnTo>
                  <a:pt x="2645" y="8"/>
                </a:lnTo>
                <a:lnTo>
                  <a:pt x="2651" y="8"/>
                </a:lnTo>
                <a:lnTo>
                  <a:pt x="2661" y="8"/>
                </a:lnTo>
                <a:lnTo>
                  <a:pt x="2668" y="8"/>
                </a:lnTo>
                <a:lnTo>
                  <a:pt x="2676" y="8"/>
                </a:lnTo>
                <a:lnTo>
                  <a:pt x="2685" y="8"/>
                </a:lnTo>
                <a:lnTo>
                  <a:pt x="2692" y="8"/>
                </a:lnTo>
                <a:lnTo>
                  <a:pt x="2702" y="8"/>
                </a:lnTo>
                <a:lnTo>
                  <a:pt x="2708" y="8"/>
                </a:lnTo>
                <a:lnTo>
                  <a:pt x="2718" y="8"/>
                </a:lnTo>
                <a:lnTo>
                  <a:pt x="2726" y="10"/>
                </a:lnTo>
                <a:lnTo>
                  <a:pt x="2733" y="10"/>
                </a:lnTo>
                <a:lnTo>
                  <a:pt x="2743" y="10"/>
                </a:lnTo>
                <a:lnTo>
                  <a:pt x="2749" y="10"/>
                </a:lnTo>
                <a:lnTo>
                  <a:pt x="2759" y="10"/>
                </a:lnTo>
                <a:lnTo>
                  <a:pt x="2765" y="10"/>
                </a:lnTo>
                <a:lnTo>
                  <a:pt x="2774" y="10"/>
                </a:lnTo>
                <a:lnTo>
                  <a:pt x="2783" y="10"/>
                </a:lnTo>
                <a:lnTo>
                  <a:pt x="2790" y="10"/>
                </a:lnTo>
                <a:lnTo>
                  <a:pt x="2798" y="10"/>
                </a:lnTo>
                <a:lnTo>
                  <a:pt x="2808" y="10"/>
                </a:lnTo>
                <a:lnTo>
                  <a:pt x="2816" y="10"/>
                </a:lnTo>
                <a:lnTo>
                  <a:pt x="2824" y="10"/>
                </a:lnTo>
                <a:lnTo>
                  <a:pt x="2831" y="10"/>
                </a:lnTo>
                <a:lnTo>
                  <a:pt x="2839" y="10"/>
                </a:lnTo>
                <a:lnTo>
                  <a:pt x="2849" y="10"/>
                </a:lnTo>
                <a:lnTo>
                  <a:pt x="2857" y="10"/>
                </a:lnTo>
                <a:lnTo>
                  <a:pt x="2865" y="10"/>
                </a:lnTo>
                <a:lnTo>
                  <a:pt x="2871" y="10"/>
                </a:lnTo>
                <a:lnTo>
                  <a:pt x="2880" y="10"/>
                </a:lnTo>
                <a:lnTo>
                  <a:pt x="2889" y="10"/>
                </a:lnTo>
                <a:lnTo>
                  <a:pt x="2898" y="10"/>
                </a:lnTo>
                <a:lnTo>
                  <a:pt x="2904" y="10"/>
                </a:lnTo>
                <a:lnTo>
                  <a:pt x="2912" y="10"/>
                </a:lnTo>
                <a:lnTo>
                  <a:pt x="2920" y="10"/>
                </a:lnTo>
                <a:lnTo>
                  <a:pt x="2930" y="12"/>
                </a:lnTo>
                <a:lnTo>
                  <a:pt x="2938" y="12"/>
                </a:lnTo>
                <a:lnTo>
                  <a:pt x="2945" y="12"/>
                </a:lnTo>
                <a:lnTo>
                  <a:pt x="2953" y="12"/>
                </a:lnTo>
                <a:lnTo>
                  <a:pt x="2961" y="12"/>
                </a:lnTo>
                <a:lnTo>
                  <a:pt x="2971" y="12"/>
                </a:lnTo>
                <a:lnTo>
                  <a:pt x="2979" y="12"/>
                </a:lnTo>
                <a:lnTo>
                  <a:pt x="2986" y="12"/>
                </a:lnTo>
                <a:lnTo>
                  <a:pt x="2994" y="12"/>
                </a:lnTo>
                <a:lnTo>
                  <a:pt x="3002" y="12"/>
                </a:lnTo>
                <a:lnTo>
                  <a:pt x="3012" y="12"/>
                </a:lnTo>
                <a:lnTo>
                  <a:pt x="3020" y="12"/>
                </a:lnTo>
                <a:lnTo>
                  <a:pt x="3027" y="12"/>
                </a:lnTo>
                <a:lnTo>
                  <a:pt x="3035" y="12"/>
                </a:lnTo>
                <a:lnTo>
                  <a:pt x="3044" y="12"/>
                </a:lnTo>
                <a:lnTo>
                  <a:pt x="3053" y="12"/>
                </a:lnTo>
                <a:lnTo>
                  <a:pt x="3061" y="12"/>
                </a:lnTo>
                <a:lnTo>
                  <a:pt x="3067" y="12"/>
                </a:lnTo>
                <a:lnTo>
                  <a:pt x="3075" y="12"/>
                </a:lnTo>
                <a:lnTo>
                  <a:pt x="3085" y="12"/>
                </a:lnTo>
                <a:lnTo>
                  <a:pt x="3093" y="12"/>
                </a:lnTo>
                <a:lnTo>
                  <a:pt x="3102" y="12"/>
                </a:lnTo>
                <a:lnTo>
                  <a:pt x="3108" y="12"/>
                </a:lnTo>
                <a:lnTo>
                  <a:pt x="3116" y="12"/>
                </a:lnTo>
                <a:lnTo>
                  <a:pt x="3126" y="12"/>
                </a:lnTo>
                <a:lnTo>
                  <a:pt x="3134" y="12"/>
                </a:lnTo>
                <a:lnTo>
                  <a:pt x="3142" y="13"/>
                </a:lnTo>
                <a:lnTo>
                  <a:pt x="3149" y="13"/>
                </a:lnTo>
                <a:lnTo>
                  <a:pt x="3157" y="13"/>
                </a:lnTo>
                <a:lnTo>
                  <a:pt x="3167" y="13"/>
                </a:lnTo>
                <a:lnTo>
                  <a:pt x="3173" y="13"/>
                </a:lnTo>
                <a:lnTo>
                  <a:pt x="3182" y="13"/>
                </a:lnTo>
                <a:lnTo>
                  <a:pt x="3191" y="13"/>
                </a:lnTo>
                <a:lnTo>
                  <a:pt x="3198" y="13"/>
                </a:lnTo>
                <a:lnTo>
                  <a:pt x="3208" y="13"/>
                </a:lnTo>
                <a:lnTo>
                  <a:pt x="3214" y="13"/>
                </a:lnTo>
                <a:lnTo>
                  <a:pt x="3222" y="13"/>
                </a:lnTo>
                <a:lnTo>
                  <a:pt x="3232" y="13"/>
                </a:lnTo>
                <a:lnTo>
                  <a:pt x="3239" y="13"/>
                </a:lnTo>
                <a:lnTo>
                  <a:pt x="3248" y="13"/>
                </a:lnTo>
                <a:lnTo>
                  <a:pt x="3255" y="13"/>
                </a:lnTo>
                <a:lnTo>
                  <a:pt x="3263" y="13"/>
                </a:lnTo>
                <a:lnTo>
                  <a:pt x="3273" y="13"/>
                </a:lnTo>
                <a:lnTo>
                  <a:pt x="3279" y="13"/>
                </a:lnTo>
                <a:lnTo>
                  <a:pt x="3289" y="13"/>
                </a:lnTo>
                <a:lnTo>
                  <a:pt x="3296" y="13"/>
                </a:lnTo>
                <a:lnTo>
                  <a:pt x="3304" y="13"/>
                </a:lnTo>
                <a:lnTo>
                  <a:pt x="3314" y="13"/>
                </a:lnTo>
                <a:lnTo>
                  <a:pt x="3320" y="13"/>
                </a:lnTo>
                <a:lnTo>
                  <a:pt x="3330" y="13"/>
                </a:lnTo>
                <a:lnTo>
                  <a:pt x="3337" y="13"/>
                </a:lnTo>
                <a:lnTo>
                  <a:pt x="3345" y="15"/>
                </a:lnTo>
                <a:lnTo>
                  <a:pt x="3354" y="15"/>
                </a:lnTo>
                <a:lnTo>
                  <a:pt x="3361" y="15"/>
                </a:lnTo>
                <a:lnTo>
                  <a:pt x="3371" y="15"/>
                </a:lnTo>
                <a:lnTo>
                  <a:pt x="3377" y="15"/>
                </a:lnTo>
                <a:lnTo>
                  <a:pt x="3385" y="15"/>
                </a:lnTo>
                <a:lnTo>
                  <a:pt x="3395" y="15"/>
                </a:lnTo>
                <a:lnTo>
                  <a:pt x="3402" y="15"/>
                </a:lnTo>
                <a:lnTo>
                  <a:pt x="3412" y="15"/>
                </a:lnTo>
                <a:lnTo>
                  <a:pt x="3418" y="15"/>
                </a:lnTo>
                <a:lnTo>
                  <a:pt x="3426" y="15"/>
                </a:lnTo>
                <a:lnTo>
                  <a:pt x="3436" y="15"/>
                </a:lnTo>
                <a:lnTo>
                  <a:pt x="3443" y="15"/>
                </a:lnTo>
                <a:lnTo>
                  <a:pt x="3452" y="15"/>
                </a:lnTo>
                <a:lnTo>
                  <a:pt x="3461" y="15"/>
                </a:lnTo>
                <a:lnTo>
                  <a:pt x="3467" y="15"/>
                </a:lnTo>
                <a:lnTo>
                  <a:pt x="3477" y="15"/>
                </a:lnTo>
                <a:lnTo>
                  <a:pt x="3483" y="15"/>
                </a:lnTo>
                <a:lnTo>
                  <a:pt x="3493" y="15"/>
                </a:lnTo>
                <a:lnTo>
                  <a:pt x="3501" y="15"/>
                </a:lnTo>
                <a:lnTo>
                  <a:pt x="3508" y="15"/>
                </a:lnTo>
                <a:lnTo>
                  <a:pt x="3518" y="15"/>
                </a:lnTo>
                <a:lnTo>
                  <a:pt x="3524" y="15"/>
                </a:lnTo>
                <a:lnTo>
                  <a:pt x="3534" y="15"/>
                </a:lnTo>
                <a:lnTo>
                  <a:pt x="3542" y="15"/>
                </a:lnTo>
                <a:lnTo>
                  <a:pt x="3549" y="15"/>
                </a:lnTo>
                <a:lnTo>
                  <a:pt x="3558" y="17"/>
                </a:lnTo>
                <a:lnTo>
                  <a:pt x="3565" y="17"/>
                </a:lnTo>
                <a:lnTo>
                  <a:pt x="3575" y="17"/>
                </a:lnTo>
                <a:lnTo>
                  <a:pt x="3583" y="17"/>
                </a:lnTo>
                <a:lnTo>
                  <a:pt x="3589" y="17"/>
                </a:lnTo>
                <a:lnTo>
                  <a:pt x="3599" y="17"/>
                </a:lnTo>
                <a:lnTo>
                  <a:pt x="3606" y="17"/>
                </a:lnTo>
                <a:lnTo>
                  <a:pt x="3616" y="17"/>
                </a:lnTo>
                <a:lnTo>
                  <a:pt x="3624" y="17"/>
                </a:lnTo>
                <a:lnTo>
                  <a:pt x="3630" y="17"/>
                </a:lnTo>
                <a:lnTo>
                  <a:pt x="3640" y="17"/>
                </a:lnTo>
                <a:lnTo>
                  <a:pt x="3647" y="17"/>
                </a:lnTo>
                <a:lnTo>
                  <a:pt x="3656" y="17"/>
                </a:lnTo>
                <a:lnTo>
                  <a:pt x="3665" y="17"/>
                </a:lnTo>
                <a:lnTo>
                  <a:pt x="3671" y="17"/>
                </a:lnTo>
                <a:lnTo>
                  <a:pt x="3681" y="17"/>
                </a:lnTo>
                <a:lnTo>
                  <a:pt x="3687" y="17"/>
                </a:lnTo>
                <a:lnTo>
                  <a:pt x="3696" y="17"/>
                </a:lnTo>
                <a:lnTo>
                  <a:pt x="3705" y="17"/>
                </a:lnTo>
                <a:lnTo>
                  <a:pt x="3712" y="17"/>
                </a:lnTo>
                <a:lnTo>
                  <a:pt x="3722" y="17"/>
                </a:lnTo>
                <a:lnTo>
                  <a:pt x="3728" y="17"/>
                </a:lnTo>
                <a:lnTo>
                  <a:pt x="3736" y="17"/>
                </a:lnTo>
                <a:lnTo>
                  <a:pt x="3746" y="17"/>
                </a:lnTo>
                <a:lnTo>
                  <a:pt x="3753" y="17"/>
                </a:lnTo>
                <a:lnTo>
                  <a:pt x="3762" y="17"/>
                </a:lnTo>
                <a:lnTo>
                  <a:pt x="3769" y="18"/>
                </a:lnTo>
                <a:lnTo>
                  <a:pt x="3777" y="18"/>
                </a:lnTo>
                <a:lnTo>
                  <a:pt x="3787" y="18"/>
                </a:lnTo>
                <a:lnTo>
                  <a:pt x="3793" y="18"/>
                </a:lnTo>
                <a:lnTo>
                  <a:pt x="3803" y="18"/>
                </a:lnTo>
                <a:lnTo>
                  <a:pt x="3810" y="18"/>
                </a:lnTo>
                <a:lnTo>
                  <a:pt x="3818" y="18"/>
                </a:lnTo>
                <a:lnTo>
                  <a:pt x="3828" y="18"/>
                </a:lnTo>
                <a:lnTo>
                  <a:pt x="3834" y="18"/>
                </a:lnTo>
                <a:lnTo>
                  <a:pt x="3844" y="18"/>
                </a:lnTo>
                <a:lnTo>
                  <a:pt x="3851" y="18"/>
                </a:lnTo>
                <a:lnTo>
                  <a:pt x="3859" y="18"/>
                </a:lnTo>
                <a:lnTo>
                  <a:pt x="3868" y="18"/>
                </a:lnTo>
                <a:lnTo>
                  <a:pt x="3875" y="18"/>
                </a:lnTo>
                <a:lnTo>
                  <a:pt x="3885" y="18"/>
                </a:lnTo>
                <a:lnTo>
                  <a:pt x="3891" y="18"/>
                </a:lnTo>
                <a:lnTo>
                  <a:pt x="3899" y="18"/>
                </a:lnTo>
                <a:lnTo>
                  <a:pt x="3909" y="18"/>
                </a:lnTo>
                <a:lnTo>
                  <a:pt x="3916" y="18"/>
                </a:lnTo>
                <a:lnTo>
                  <a:pt x="3926" y="18"/>
                </a:lnTo>
                <a:lnTo>
                  <a:pt x="3932" y="18"/>
                </a:lnTo>
                <a:lnTo>
                  <a:pt x="3940" y="18"/>
                </a:lnTo>
                <a:lnTo>
                  <a:pt x="3948" y="18"/>
                </a:lnTo>
                <a:lnTo>
                  <a:pt x="3957" y="18"/>
                </a:lnTo>
                <a:lnTo>
                  <a:pt x="3966" y="18"/>
                </a:lnTo>
                <a:lnTo>
                  <a:pt x="3975" y="18"/>
                </a:lnTo>
                <a:lnTo>
                  <a:pt x="3983" y="18"/>
                </a:lnTo>
                <a:lnTo>
                  <a:pt x="3989" y="20"/>
                </a:lnTo>
                <a:lnTo>
                  <a:pt x="3997" y="20"/>
                </a:lnTo>
                <a:lnTo>
                  <a:pt x="4007" y="20"/>
                </a:lnTo>
                <a:lnTo>
                  <a:pt x="4015" y="20"/>
                </a:lnTo>
                <a:lnTo>
                  <a:pt x="4023" y="20"/>
                </a:lnTo>
                <a:lnTo>
                  <a:pt x="4030" y="20"/>
                </a:lnTo>
                <a:lnTo>
                  <a:pt x="4038" y="20"/>
                </a:lnTo>
                <a:lnTo>
                  <a:pt x="4048" y="20"/>
                </a:lnTo>
                <a:lnTo>
                  <a:pt x="4056" y="20"/>
                </a:lnTo>
                <a:lnTo>
                  <a:pt x="4064" y="20"/>
                </a:lnTo>
                <a:lnTo>
                  <a:pt x="4071" y="20"/>
                </a:lnTo>
                <a:lnTo>
                  <a:pt x="4079" y="20"/>
                </a:lnTo>
                <a:lnTo>
                  <a:pt x="4089" y="20"/>
                </a:lnTo>
                <a:lnTo>
                  <a:pt x="4097" y="20"/>
                </a:lnTo>
                <a:lnTo>
                  <a:pt x="4105" y="20"/>
                </a:lnTo>
                <a:lnTo>
                  <a:pt x="4112" y="20"/>
                </a:lnTo>
                <a:lnTo>
                  <a:pt x="4120" y="20"/>
                </a:lnTo>
                <a:lnTo>
                  <a:pt x="4130" y="20"/>
                </a:lnTo>
                <a:lnTo>
                  <a:pt x="4138" y="20"/>
                </a:lnTo>
                <a:lnTo>
                  <a:pt x="4146" y="20"/>
                </a:lnTo>
                <a:lnTo>
                  <a:pt x="4152" y="20"/>
                </a:lnTo>
                <a:lnTo>
                  <a:pt x="4161" y="20"/>
                </a:lnTo>
                <a:lnTo>
                  <a:pt x="4170" y="2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4" name="Freeform 109"/>
          <p:cNvSpPr>
            <a:spLocks/>
          </p:cNvSpPr>
          <p:nvPr/>
        </p:nvSpPr>
        <p:spPr bwMode="auto">
          <a:xfrm>
            <a:off x="1672431" y="5175887"/>
            <a:ext cx="6619875" cy="149225"/>
          </a:xfrm>
          <a:custGeom>
            <a:avLst/>
            <a:gdLst>
              <a:gd name="T0" fmla="*/ 67 w 4170"/>
              <a:gd name="T1" fmla="*/ 80 h 94"/>
              <a:gd name="T2" fmla="*/ 138 w 4170"/>
              <a:gd name="T3" fmla="*/ 80 h 94"/>
              <a:gd name="T4" fmla="*/ 212 w 4170"/>
              <a:gd name="T5" fmla="*/ 80 h 94"/>
              <a:gd name="T6" fmla="*/ 285 w 4170"/>
              <a:gd name="T7" fmla="*/ 80 h 94"/>
              <a:gd name="T8" fmla="*/ 360 w 4170"/>
              <a:gd name="T9" fmla="*/ 94 h 94"/>
              <a:gd name="T10" fmla="*/ 434 w 4170"/>
              <a:gd name="T11" fmla="*/ 91 h 94"/>
              <a:gd name="T12" fmla="*/ 505 w 4170"/>
              <a:gd name="T13" fmla="*/ 88 h 94"/>
              <a:gd name="T14" fmla="*/ 579 w 4170"/>
              <a:gd name="T15" fmla="*/ 84 h 94"/>
              <a:gd name="T16" fmla="*/ 654 w 4170"/>
              <a:gd name="T17" fmla="*/ 81 h 94"/>
              <a:gd name="T18" fmla="*/ 727 w 4170"/>
              <a:gd name="T19" fmla="*/ 78 h 94"/>
              <a:gd name="T20" fmla="*/ 801 w 4170"/>
              <a:gd name="T21" fmla="*/ 75 h 94"/>
              <a:gd name="T22" fmla="*/ 873 w 4170"/>
              <a:gd name="T23" fmla="*/ 71 h 94"/>
              <a:gd name="T24" fmla="*/ 948 w 4170"/>
              <a:gd name="T25" fmla="*/ 68 h 94"/>
              <a:gd name="T26" fmla="*/ 1019 w 4170"/>
              <a:gd name="T27" fmla="*/ 66 h 94"/>
              <a:gd name="T28" fmla="*/ 1095 w 4170"/>
              <a:gd name="T29" fmla="*/ 63 h 94"/>
              <a:gd name="T30" fmla="*/ 1166 w 4170"/>
              <a:gd name="T31" fmla="*/ 60 h 94"/>
              <a:gd name="T32" fmla="*/ 1240 w 4170"/>
              <a:gd name="T33" fmla="*/ 57 h 94"/>
              <a:gd name="T34" fmla="*/ 1315 w 4170"/>
              <a:gd name="T35" fmla="*/ 53 h 94"/>
              <a:gd name="T36" fmla="*/ 1387 w 4170"/>
              <a:gd name="T37" fmla="*/ 52 h 94"/>
              <a:gd name="T38" fmla="*/ 1462 w 4170"/>
              <a:gd name="T39" fmla="*/ 49 h 94"/>
              <a:gd name="T40" fmla="*/ 1533 w 4170"/>
              <a:gd name="T41" fmla="*/ 45 h 94"/>
              <a:gd name="T42" fmla="*/ 1609 w 4170"/>
              <a:gd name="T43" fmla="*/ 44 h 94"/>
              <a:gd name="T44" fmla="*/ 1680 w 4170"/>
              <a:gd name="T45" fmla="*/ 40 h 94"/>
              <a:gd name="T46" fmla="*/ 1755 w 4170"/>
              <a:gd name="T47" fmla="*/ 37 h 94"/>
              <a:gd name="T48" fmla="*/ 1829 w 4170"/>
              <a:gd name="T49" fmla="*/ 34 h 94"/>
              <a:gd name="T50" fmla="*/ 1902 w 4170"/>
              <a:gd name="T51" fmla="*/ 32 h 94"/>
              <a:gd name="T52" fmla="*/ 1976 w 4170"/>
              <a:gd name="T53" fmla="*/ 29 h 94"/>
              <a:gd name="T54" fmla="*/ 2049 w 4170"/>
              <a:gd name="T55" fmla="*/ 26 h 94"/>
              <a:gd name="T56" fmla="*/ 2121 w 4170"/>
              <a:gd name="T57" fmla="*/ 24 h 94"/>
              <a:gd name="T58" fmla="*/ 2194 w 4170"/>
              <a:gd name="T59" fmla="*/ 21 h 94"/>
              <a:gd name="T60" fmla="*/ 2269 w 4170"/>
              <a:gd name="T61" fmla="*/ 19 h 94"/>
              <a:gd name="T62" fmla="*/ 2341 w 4170"/>
              <a:gd name="T63" fmla="*/ 16 h 94"/>
              <a:gd name="T64" fmla="*/ 2416 w 4170"/>
              <a:gd name="T65" fmla="*/ 0 h 94"/>
              <a:gd name="T66" fmla="*/ 2490 w 4170"/>
              <a:gd name="T67" fmla="*/ 1 h 94"/>
              <a:gd name="T68" fmla="*/ 2561 w 4170"/>
              <a:gd name="T69" fmla="*/ 1 h 94"/>
              <a:gd name="T70" fmla="*/ 2635 w 4170"/>
              <a:gd name="T71" fmla="*/ 1 h 94"/>
              <a:gd name="T72" fmla="*/ 2708 w 4170"/>
              <a:gd name="T73" fmla="*/ 1 h 94"/>
              <a:gd name="T74" fmla="*/ 2783 w 4170"/>
              <a:gd name="T75" fmla="*/ 1 h 94"/>
              <a:gd name="T76" fmla="*/ 2857 w 4170"/>
              <a:gd name="T77" fmla="*/ 1 h 94"/>
              <a:gd name="T78" fmla="*/ 2930 w 4170"/>
              <a:gd name="T79" fmla="*/ 3 h 94"/>
              <a:gd name="T80" fmla="*/ 3002 w 4170"/>
              <a:gd name="T81" fmla="*/ 3 h 94"/>
              <a:gd name="T82" fmla="*/ 3075 w 4170"/>
              <a:gd name="T83" fmla="*/ 3 h 94"/>
              <a:gd name="T84" fmla="*/ 3149 w 4170"/>
              <a:gd name="T85" fmla="*/ 3 h 94"/>
              <a:gd name="T86" fmla="*/ 3222 w 4170"/>
              <a:gd name="T87" fmla="*/ 3 h 94"/>
              <a:gd name="T88" fmla="*/ 3296 w 4170"/>
              <a:gd name="T89" fmla="*/ 4 h 94"/>
              <a:gd name="T90" fmla="*/ 3371 w 4170"/>
              <a:gd name="T91" fmla="*/ 4 h 94"/>
              <a:gd name="T92" fmla="*/ 3443 w 4170"/>
              <a:gd name="T93" fmla="*/ 4 h 94"/>
              <a:gd name="T94" fmla="*/ 3518 w 4170"/>
              <a:gd name="T95" fmla="*/ 4 h 94"/>
              <a:gd name="T96" fmla="*/ 3589 w 4170"/>
              <a:gd name="T97" fmla="*/ 4 h 94"/>
              <a:gd name="T98" fmla="*/ 3665 w 4170"/>
              <a:gd name="T99" fmla="*/ 6 h 94"/>
              <a:gd name="T100" fmla="*/ 3736 w 4170"/>
              <a:gd name="T101" fmla="*/ 6 h 94"/>
              <a:gd name="T102" fmla="*/ 3810 w 4170"/>
              <a:gd name="T103" fmla="*/ 6 h 94"/>
              <a:gd name="T104" fmla="*/ 3885 w 4170"/>
              <a:gd name="T105" fmla="*/ 6 h 94"/>
              <a:gd name="T106" fmla="*/ 3957 w 4170"/>
              <a:gd name="T107" fmla="*/ 6 h 94"/>
              <a:gd name="T108" fmla="*/ 4030 w 4170"/>
              <a:gd name="T109" fmla="*/ 6 h 94"/>
              <a:gd name="T110" fmla="*/ 4105 w 4170"/>
              <a:gd name="T111" fmla="*/ 8 h 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94">
                <a:moveTo>
                  <a:pt x="0" y="80"/>
                </a:moveTo>
                <a:lnTo>
                  <a:pt x="8" y="80"/>
                </a:lnTo>
                <a:lnTo>
                  <a:pt x="16" y="80"/>
                </a:lnTo>
                <a:lnTo>
                  <a:pt x="26" y="80"/>
                </a:lnTo>
                <a:lnTo>
                  <a:pt x="34" y="80"/>
                </a:lnTo>
                <a:lnTo>
                  <a:pt x="40" y="80"/>
                </a:lnTo>
                <a:lnTo>
                  <a:pt x="49" y="80"/>
                </a:lnTo>
                <a:lnTo>
                  <a:pt x="57" y="80"/>
                </a:lnTo>
                <a:lnTo>
                  <a:pt x="67" y="80"/>
                </a:lnTo>
                <a:lnTo>
                  <a:pt x="75" y="80"/>
                </a:lnTo>
                <a:lnTo>
                  <a:pt x="81" y="80"/>
                </a:lnTo>
                <a:lnTo>
                  <a:pt x="89" y="80"/>
                </a:lnTo>
                <a:lnTo>
                  <a:pt x="98" y="80"/>
                </a:lnTo>
                <a:lnTo>
                  <a:pt x="107" y="80"/>
                </a:lnTo>
                <a:lnTo>
                  <a:pt x="116" y="80"/>
                </a:lnTo>
                <a:lnTo>
                  <a:pt x="122" y="80"/>
                </a:lnTo>
                <a:lnTo>
                  <a:pt x="130" y="80"/>
                </a:lnTo>
                <a:lnTo>
                  <a:pt x="138" y="80"/>
                </a:lnTo>
                <a:lnTo>
                  <a:pt x="148" y="80"/>
                </a:lnTo>
                <a:lnTo>
                  <a:pt x="156" y="80"/>
                </a:lnTo>
                <a:lnTo>
                  <a:pt x="163" y="80"/>
                </a:lnTo>
                <a:lnTo>
                  <a:pt x="171" y="80"/>
                </a:lnTo>
                <a:lnTo>
                  <a:pt x="179" y="80"/>
                </a:lnTo>
                <a:lnTo>
                  <a:pt x="189" y="80"/>
                </a:lnTo>
                <a:lnTo>
                  <a:pt x="197" y="80"/>
                </a:lnTo>
                <a:lnTo>
                  <a:pt x="204" y="80"/>
                </a:lnTo>
                <a:lnTo>
                  <a:pt x="212" y="80"/>
                </a:lnTo>
                <a:lnTo>
                  <a:pt x="220" y="80"/>
                </a:lnTo>
                <a:lnTo>
                  <a:pt x="230" y="80"/>
                </a:lnTo>
                <a:lnTo>
                  <a:pt x="238" y="80"/>
                </a:lnTo>
                <a:lnTo>
                  <a:pt x="244" y="80"/>
                </a:lnTo>
                <a:lnTo>
                  <a:pt x="253" y="80"/>
                </a:lnTo>
                <a:lnTo>
                  <a:pt x="261" y="80"/>
                </a:lnTo>
                <a:lnTo>
                  <a:pt x="271" y="80"/>
                </a:lnTo>
                <a:lnTo>
                  <a:pt x="279" y="80"/>
                </a:lnTo>
                <a:lnTo>
                  <a:pt x="285" y="80"/>
                </a:lnTo>
                <a:lnTo>
                  <a:pt x="293" y="80"/>
                </a:lnTo>
                <a:lnTo>
                  <a:pt x="302" y="80"/>
                </a:lnTo>
                <a:lnTo>
                  <a:pt x="311" y="80"/>
                </a:lnTo>
                <a:lnTo>
                  <a:pt x="319" y="80"/>
                </a:lnTo>
                <a:lnTo>
                  <a:pt x="326" y="80"/>
                </a:lnTo>
                <a:lnTo>
                  <a:pt x="334" y="80"/>
                </a:lnTo>
                <a:lnTo>
                  <a:pt x="342" y="94"/>
                </a:lnTo>
                <a:lnTo>
                  <a:pt x="352" y="94"/>
                </a:lnTo>
                <a:lnTo>
                  <a:pt x="360" y="94"/>
                </a:lnTo>
                <a:lnTo>
                  <a:pt x="367" y="93"/>
                </a:lnTo>
                <a:lnTo>
                  <a:pt x="375" y="93"/>
                </a:lnTo>
                <a:lnTo>
                  <a:pt x="383" y="93"/>
                </a:lnTo>
                <a:lnTo>
                  <a:pt x="393" y="93"/>
                </a:lnTo>
                <a:lnTo>
                  <a:pt x="401" y="91"/>
                </a:lnTo>
                <a:lnTo>
                  <a:pt x="408" y="91"/>
                </a:lnTo>
                <a:lnTo>
                  <a:pt x="416" y="91"/>
                </a:lnTo>
                <a:lnTo>
                  <a:pt x="424" y="91"/>
                </a:lnTo>
                <a:lnTo>
                  <a:pt x="434" y="91"/>
                </a:lnTo>
                <a:lnTo>
                  <a:pt x="442" y="89"/>
                </a:lnTo>
                <a:lnTo>
                  <a:pt x="448" y="89"/>
                </a:lnTo>
                <a:lnTo>
                  <a:pt x="457" y="89"/>
                </a:lnTo>
                <a:lnTo>
                  <a:pt x="465" y="89"/>
                </a:lnTo>
                <a:lnTo>
                  <a:pt x="474" y="89"/>
                </a:lnTo>
                <a:lnTo>
                  <a:pt x="483" y="88"/>
                </a:lnTo>
                <a:lnTo>
                  <a:pt x="489" y="88"/>
                </a:lnTo>
                <a:lnTo>
                  <a:pt x="497" y="88"/>
                </a:lnTo>
                <a:lnTo>
                  <a:pt x="505" y="88"/>
                </a:lnTo>
                <a:lnTo>
                  <a:pt x="515" y="86"/>
                </a:lnTo>
                <a:lnTo>
                  <a:pt x="523" y="86"/>
                </a:lnTo>
                <a:lnTo>
                  <a:pt x="532" y="86"/>
                </a:lnTo>
                <a:lnTo>
                  <a:pt x="538" y="86"/>
                </a:lnTo>
                <a:lnTo>
                  <a:pt x="546" y="86"/>
                </a:lnTo>
                <a:lnTo>
                  <a:pt x="556" y="84"/>
                </a:lnTo>
                <a:lnTo>
                  <a:pt x="564" y="84"/>
                </a:lnTo>
                <a:lnTo>
                  <a:pt x="572" y="84"/>
                </a:lnTo>
                <a:lnTo>
                  <a:pt x="579" y="84"/>
                </a:lnTo>
                <a:lnTo>
                  <a:pt x="587" y="84"/>
                </a:lnTo>
                <a:lnTo>
                  <a:pt x="597" y="83"/>
                </a:lnTo>
                <a:lnTo>
                  <a:pt x="605" y="83"/>
                </a:lnTo>
                <a:lnTo>
                  <a:pt x="613" y="83"/>
                </a:lnTo>
                <a:lnTo>
                  <a:pt x="620" y="83"/>
                </a:lnTo>
                <a:lnTo>
                  <a:pt x="628" y="81"/>
                </a:lnTo>
                <a:lnTo>
                  <a:pt x="638" y="81"/>
                </a:lnTo>
                <a:lnTo>
                  <a:pt x="646" y="81"/>
                </a:lnTo>
                <a:lnTo>
                  <a:pt x="654" y="81"/>
                </a:lnTo>
                <a:lnTo>
                  <a:pt x="661" y="81"/>
                </a:lnTo>
                <a:lnTo>
                  <a:pt x="669" y="80"/>
                </a:lnTo>
                <a:lnTo>
                  <a:pt x="678" y="80"/>
                </a:lnTo>
                <a:lnTo>
                  <a:pt x="687" y="80"/>
                </a:lnTo>
                <a:lnTo>
                  <a:pt x="695" y="80"/>
                </a:lnTo>
                <a:lnTo>
                  <a:pt x="701" y="80"/>
                </a:lnTo>
                <a:lnTo>
                  <a:pt x="709" y="78"/>
                </a:lnTo>
                <a:lnTo>
                  <a:pt x="719" y="78"/>
                </a:lnTo>
                <a:lnTo>
                  <a:pt x="727" y="78"/>
                </a:lnTo>
                <a:lnTo>
                  <a:pt x="736" y="78"/>
                </a:lnTo>
                <a:lnTo>
                  <a:pt x="742" y="78"/>
                </a:lnTo>
                <a:lnTo>
                  <a:pt x="750" y="76"/>
                </a:lnTo>
                <a:lnTo>
                  <a:pt x="760" y="76"/>
                </a:lnTo>
                <a:lnTo>
                  <a:pt x="768" y="76"/>
                </a:lnTo>
                <a:lnTo>
                  <a:pt x="776" y="76"/>
                </a:lnTo>
                <a:lnTo>
                  <a:pt x="783" y="76"/>
                </a:lnTo>
                <a:lnTo>
                  <a:pt x="791" y="75"/>
                </a:lnTo>
                <a:lnTo>
                  <a:pt x="801" y="75"/>
                </a:lnTo>
                <a:lnTo>
                  <a:pt x="809" y="75"/>
                </a:lnTo>
                <a:lnTo>
                  <a:pt x="817" y="75"/>
                </a:lnTo>
                <a:lnTo>
                  <a:pt x="824" y="75"/>
                </a:lnTo>
                <a:lnTo>
                  <a:pt x="832" y="73"/>
                </a:lnTo>
                <a:lnTo>
                  <a:pt x="842" y="73"/>
                </a:lnTo>
                <a:lnTo>
                  <a:pt x="850" y="73"/>
                </a:lnTo>
                <a:lnTo>
                  <a:pt x="856" y="73"/>
                </a:lnTo>
                <a:lnTo>
                  <a:pt x="866" y="71"/>
                </a:lnTo>
                <a:lnTo>
                  <a:pt x="873" y="71"/>
                </a:lnTo>
                <a:lnTo>
                  <a:pt x="882" y="71"/>
                </a:lnTo>
                <a:lnTo>
                  <a:pt x="891" y="71"/>
                </a:lnTo>
                <a:lnTo>
                  <a:pt x="897" y="71"/>
                </a:lnTo>
                <a:lnTo>
                  <a:pt x="907" y="70"/>
                </a:lnTo>
                <a:lnTo>
                  <a:pt x="913" y="70"/>
                </a:lnTo>
                <a:lnTo>
                  <a:pt x="923" y="70"/>
                </a:lnTo>
                <a:lnTo>
                  <a:pt x="931" y="70"/>
                </a:lnTo>
                <a:lnTo>
                  <a:pt x="938" y="70"/>
                </a:lnTo>
                <a:lnTo>
                  <a:pt x="948" y="68"/>
                </a:lnTo>
                <a:lnTo>
                  <a:pt x="954" y="68"/>
                </a:lnTo>
                <a:lnTo>
                  <a:pt x="964" y="68"/>
                </a:lnTo>
                <a:lnTo>
                  <a:pt x="972" y="68"/>
                </a:lnTo>
                <a:lnTo>
                  <a:pt x="979" y="68"/>
                </a:lnTo>
                <a:lnTo>
                  <a:pt x="988" y="66"/>
                </a:lnTo>
                <a:lnTo>
                  <a:pt x="995" y="66"/>
                </a:lnTo>
                <a:lnTo>
                  <a:pt x="1005" y="66"/>
                </a:lnTo>
                <a:lnTo>
                  <a:pt x="1013" y="66"/>
                </a:lnTo>
                <a:lnTo>
                  <a:pt x="1019" y="66"/>
                </a:lnTo>
                <a:lnTo>
                  <a:pt x="1029" y="65"/>
                </a:lnTo>
                <a:lnTo>
                  <a:pt x="1036" y="65"/>
                </a:lnTo>
                <a:lnTo>
                  <a:pt x="1044" y="65"/>
                </a:lnTo>
                <a:lnTo>
                  <a:pt x="1054" y="65"/>
                </a:lnTo>
                <a:lnTo>
                  <a:pt x="1060" y="65"/>
                </a:lnTo>
                <a:lnTo>
                  <a:pt x="1070" y="63"/>
                </a:lnTo>
                <a:lnTo>
                  <a:pt x="1077" y="63"/>
                </a:lnTo>
                <a:lnTo>
                  <a:pt x="1085" y="63"/>
                </a:lnTo>
                <a:lnTo>
                  <a:pt x="1095" y="63"/>
                </a:lnTo>
                <a:lnTo>
                  <a:pt x="1101" y="63"/>
                </a:lnTo>
                <a:lnTo>
                  <a:pt x="1111" y="62"/>
                </a:lnTo>
                <a:lnTo>
                  <a:pt x="1117" y="62"/>
                </a:lnTo>
                <a:lnTo>
                  <a:pt x="1126" y="62"/>
                </a:lnTo>
                <a:lnTo>
                  <a:pt x="1135" y="62"/>
                </a:lnTo>
                <a:lnTo>
                  <a:pt x="1142" y="62"/>
                </a:lnTo>
                <a:lnTo>
                  <a:pt x="1152" y="60"/>
                </a:lnTo>
                <a:lnTo>
                  <a:pt x="1158" y="60"/>
                </a:lnTo>
                <a:lnTo>
                  <a:pt x="1166" y="60"/>
                </a:lnTo>
                <a:lnTo>
                  <a:pt x="1176" y="60"/>
                </a:lnTo>
                <a:lnTo>
                  <a:pt x="1183" y="60"/>
                </a:lnTo>
                <a:lnTo>
                  <a:pt x="1192" y="58"/>
                </a:lnTo>
                <a:lnTo>
                  <a:pt x="1199" y="58"/>
                </a:lnTo>
                <a:lnTo>
                  <a:pt x="1207" y="58"/>
                </a:lnTo>
                <a:lnTo>
                  <a:pt x="1217" y="58"/>
                </a:lnTo>
                <a:lnTo>
                  <a:pt x="1223" y="58"/>
                </a:lnTo>
                <a:lnTo>
                  <a:pt x="1233" y="57"/>
                </a:lnTo>
                <a:lnTo>
                  <a:pt x="1240" y="57"/>
                </a:lnTo>
                <a:lnTo>
                  <a:pt x="1248" y="57"/>
                </a:lnTo>
                <a:lnTo>
                  <a:pt x="1258" y="57"/>
                </a:lnTo>
                <a:lnTo>
                  <a:pt x="1264" y="57"/>
                </a:lnTo>
                <a:lnTo>
                  <a:pt x="1274" y="55"/>
                </a:lnTo>
                <a:lnTo>
                  <a:pt x="1281" y="55"/>
                </a:lnTo>
                <a:lnTo>
                  <a:pt x="1289" y="55"/>
                </a:lnTo>
                <a:lnTo>
                  <a:pt x="1299" y="55"/>
                </a:lnTo>
                <a:lnTo>
                  <a:pt x="1305" y="55"/>
                </a:lnTo>
                <a:lnTo>
                  <a:pt x="1315" y="53"/>
                </a:lnTo>
                <a:lnTo>
                  <a:pt x="1323" y="53"/>
                </a:lnTo>
                <a:lnTo>
                  <a:pt x="1330" y="53"/>
                </a:lnTo>
                <a:lnTo>
                  <a:pt x="1339" y="53"/>
                </a:lnTo>
                <a:lnTo>
                  <a:pt x="1346" y="53"/>
                </a:lnTo>
                <a:lnTo>
                  <a:pt x="1356" y="52"/>
                </a:lnTo>
                <a:lnTo>
                  <a:pt x="1364" y="52"/>
                </a:lnTo>
                <a:lnTo>
                  <a:pt x="1370" y="52"/>
                </a:lnTo>
                <a:lnTo>
                  <a:pt x="1380" y="52"/>
                </a:lnTo>
                <a:lnTo>
                  <a:pt x="1387" y="52"/>
                </a:lnTo>
                <a:lnTo>
                  <a:pt x="1396" y="52"/>
                </a:lnTo>
                <a:lnTo>
                  <a:pt x="1405" y="50"/>
                </a:lnTo>
                <a:lnTo>
                  <a:pt x="1411" y="50"/>
                </a:lnTo>
                <a:lnTo>
                  <a:pt x="1421" y="50"/>
                </a:lnTo>
                <a:lnTo>
                  <a:pt x="1427" y="50"/>
                </a:lnTo>
                <a:lnTo>
                  <a:pt x="1437" y="50"/>
                </a:lnTo>
                <a:lnTo>
                  <a:pt x="1445" y="49"/>
                </a:lnTo>
                <a:lnTo>
                  <a:pt x="1452" y="49"/>
                </a:lnTo>
                <a:lnTo>
                  <a:pt x="1462" y="49"/>
                </a:lnTo>
                <a:lnTo>
                  <a:pt x="1468" y="49"/>
                </a:lnTo>
                <a:lnTo>
                  <a:pt x="1478" y="49"/>
                </a:lnTo>
                <a:lnTo>
                  <a:pt x="1486" y="47"/>
                </a:lnTo>
                <a:lnTo>
                  <a:pt x="1493" y="47"/>
                </a:lnTo>
                <a:lnTo>
                  <a:pt x="1502" y="47"/>
                </a:lnTo>
                <a:lnTo>
                  <a:pt x="1509" y="47"/>
                </a:lnTo>
                <a:lnTo>
                  <a:pt x="1519" y="47"/>
                </a:lnTo>
                <a:lnTo>
                  <a:pt x="1527" y="45"/>
                </a:lnTo>
                <a:lnTo>
                  <a:pt x="1533" y="45"/>
                </a:lnTo>
                <a:lnTo>
                  <a:pt x="1543" y="45"/>
                </a:lnTo>
                <a:lnTo>
                  <a:pt x="1550" y="45"/>
                </a:lnTo>
                <a:lnTo>
                  <a:pt x="1560" y="45"/>
                </a:lnTo>
                <a:lnTo>
                  <a:pt x="1568" y="44"/>
                </a:lnTo>
                <a:lnTo>
                  <a:pt x="1574" y="44"/>
                </a:lnTo>
                <a:lnTo>
                  <a:pt x="1584" y="44"/>
                </a:lnTo>
                <a:lnTo>
                  <a:pt x="1591" y="44"/>
                </a:lnTo>
                <a:lnTo>
                  <a:pt x="1599" y="44"/>
                </a:lnTo>
                <a:lnTo>
                  <a:pt x="1609" y="44"/>
                </a:lnTo>
                <a:lnTo>
                  <a:pt x="1615" y="42"/>
                </a:lnTo>
                <a:lnTo>
                  <a:pt x="1625" y="42"/>
                </a:lnTo>
                <a:lnTo>
                  <a:pt x="1633" y="42"/>
                </a:lnTo>
                <a:lnTo>
                  <a:pt x="1640" y="42"/>
                </a:lnTo>
                <a:lnTo>
                  <a:pt x="1648" y="42"/>
                </a:lnTo>
                <a:lnTo>
                  <a:pt x="1656" y="40"/>
                </a:lnTo>
                <a:lnTo>
                  <a:pt x="1666" y="40"/>
                </a:lnTo>
                <a:lnTo>
                  <a:pt x="1674" y="40"/>
                </a:lnTo>
                <a:lnTo>
                  <a:pt x="1680" y="40"/>
                </a:lnTo>
                <a:lnTo>
                  <a:pt x="1688" y="40"/>
                </a:lnTo>
                <a:lnTo>
                  <a:pt x="1697" y="39"/>
                </a:lnTo>
                <a:lnTo>
                  <a:pt x="1706" y="39"/>
                </a:lnTo>
                <a:lnTo>
                  <a:pt x="1715" y="39"/>
                </a:lnTo>
                <a:lnTo>
                  <a:pt x="1721" y="39"/>
                </a:lnTo>
                <a:lnTo>
                  <a:pt x="1729" y="39"/>
                </a:lnTo>
                <a:lnTo>
                  <a:pt x="1739" y="37"/>
                </a:lnTo>
                <a:lnTo>
                  <a:pt x="1747" y="37"/>
                </a:lnTo>
                <a:lnTo>
                  <a:pt x="1755" y="37"/>
                </a:lnTo>
                <a:lnTo>
                  <a:pt x="1762" y="37"/>
                </a:lnTo>
                <a:lnTo>
                  <a:pt x="1770" y="37"/>
                </a:lnTo>
                <a:lnTo>
                  <a:pt x="1780" y="37"/>
                </a:lnTo>
                <a:lnTo>
                  <a:pt x="1788" y="35"/>
                </a:lnTo>
                <a:lnTo>
                  <a:pt x="1796" y="35"/>
                </a:lnTo>
                <a:lnTo>
                  <a:pt x="1803" y="35"/>
                </a:lnTo>
                <a:lnTo>
                  <a:pt x="1811" y="35"/>
                </a:lnTo>
                <a:lnTo>
                  <a:pt x="1821" y="35"/>
                </a:lnTo>
                <a:lnTo>
                  <a:pt x="1829" y="34"/>
                </a:lnTo>
                <a:lnTo>
                  <a:pt x="1835" y="34"/>
                </a:lnTo>
                <a:lnTo>
                  <a:pt x="1844" y="34"/>
                </a:lnTo>
                <a:lnTo>
                  <a:pt x="1852" y="34"/>
                </a:lnTo>
                <a:lnTo>
                  <a:pt x="1861" y="34"/>
                </a:lnTo>
                <a:lnTo>
                  <a:pt x="1870" y="34"/>
                </a:lnTo>
                <a:lnTo>
                  <a:pt x="1876" y="32"/>
                </a:lnTo>
                <a:lnTo>
                  <a:pt x="1884" y="32"/>
                </a:lnTo>
                <a:lnTo>
                  <a:pt x="1892" y="32"/>
                </a:lnTo>
                <a:lnTo>
                  <a:pt x="1902" y="32"/>
                </a:lnTo>
                <a:lnTo>
                  <a:pt x="1910" y="32"/>
                </a:lnTo>
                <a:lnTo>
                  <a:pt x="1917" y="31"/>
                </a:lnTo>
                <a:lnTo>
                  <a:pt x="1925" y="31"/>
                </a:lnTo>
                <a:lnTo>
                  <a:pt x="1933" y="31"/>
                </a:lnTo>
                <a:lnTo>
                  <a:pt x="1943" y="31"/>
                </a:lnTo>
                <a:lnTo>
                  <a:pt x="1951" y="31"/>
                </a:lnTo>
                <a:lnTo>
                  <a:pt x="1958" y="29"/>
                </a:lnTo>
                <a:lnTo>
                  <a:pt x="1966" y="29"/>
                </a:lnTo>
                <a:lnTo>
                  <a:pt x="1976" y="29"/>
                </a:lnTo>
                <a:lnTo>
                  <a:pt x="1984" y="29"/>
                </a:lnTo>
                <a:lnTo>
                  <a:pt x="1992" y="29"/>
                </a:lnTo>
                <a:lnTo>
                  <a:pt x="1999" y="29"/>
                </a:lnTo>
                <a:lnTo>
                  <a:pt x="2007" y="27"/>
                </a:lnTo>
                <a:lnTo>
                  <a:pt x="2015" y="27"/>
                </a:lnTo>
                <a:lnTo>
                  <a:pt x="2023" y="27"/>
                </a:lnTo>
                <a:lnTo>
                  <a:pt x="2033" y="27"/>
                </a:lnTo>
                <a:lnTo>
                  <a:pt x="2039" y="27"/>
                </a:lnTo>
                <a:lnTo>
                  <a:pt x="2049" y="26"/>
                </a:lnTo>
                <a:lnTo>
                  <a:pt x="2056" y="26"/>
                </a:lnTo>
                <a:lnTo>
                  <a:pt x="2065" y="26"/>
                </a:lnTo>
                <a:lnTo>
                  <a:pt x="2074" y="26"/>
                </a:lnTo>
                <a:lnTo>
                  <a:pt x="2080" y="26"/>
                </a:lnTo>
                <a:lnTo>
                  <a:pt x="2090" y="26"/>
                </a:lnTo>
                <a:lnTo>
                  <a:pt x="2096" y="24"/>
                </a:lnTo>
                <a:lnTo>
                  <a:pt x="2106" y="24"/>
                </a:lnTo>
                <a:lnTo>
                  <a:pt x="2113" y="24"/>
                </a:lnTo>
                <a:lnTo>
                  <a:pt x="2121" y="24"/>
                </a:lnTo>
                <a:lnTo>
                  <a:pt x="2131" y="24"/>
                </a:lnTo>
                <a:lnTo>
                  <a:pt x="2137" y="22"/>
                </a:lnTo>
                <a:lnTo>
                  <a:pt x="2147" y="22"/>
                </a:lnTo>
                <a:lnTo>
                  <a:pt x="2154" y="22"/>
                </a:lnTo>
                <a:lnTo>
                  <a:pt x="2163" y="22"/>
                </a:lnTo>
                <a:lnTo>
                  <a:pt x="2171" y="22"/>
                </a:lnTo>
                <a:lnTo>
                  <a:pt x="2178" y="22"/>
                </a:lnTo>
                <a:lnTo>
                  <a:pt x="2188" y="21"/>
                </a:lnTo>
                <a:lnTo>
                  <a:pt x="2194" y="21"/>
                </a:lnTo>
                <a:lnTo>
                  <a:pt x="2202" y="21"/>
                </a:lnTo>
                <a:lnTo>
                  <a:pt x="2212" y="21"/>
                </a:lnTo>
                <a:lnTo>
                  <a:pt x="2220" y="21"/>
                </a:lnTo>
                <a:lnTo>
                  <a:pt x="2229" y="21"/>
                </a:lnTo>
                <a:lnTo>
                  <a:pt x="2235" y="19"/>
                </a:lnTo>
                <a:lnTo>
                  <a:pt x="2243" y="19"/>
                </a:lnTo>
                <a:lnTo>
                  <a:pt x="2251" y="19"/>
                </a:lnTo>
                <a:lnTo>
                  <a:pt x="2261" y="19"/>
                </a:lnTo>
                <a:lnTo>
                  <a:pt x="2269" y="19"/>
                </a:lnTo>
                <a:lnTo>
                  <a:pt x="2278" y="18"/>
                </a:lnTo>
                <a:lnTo>
                  <a:pt x="2284" y="18"/>
                </a:lnTo>
                <a:lnTo>
                  <a:pt x="2292" y="18"/>
                </a:lnTo>
                <a:lnTo>
                  <a:pt x="2300" y="18"/>
                </a:lnTo>
                <a:lnTo>
                  <a:pt x="2310" y="18"/>
                </a:lnTo>
                <a:lnTo>
                  <a:pt x="2317" y="18"/>
                </a:lnTo>
                <a:lnTo>
                  <a:pt x="2326" y="16"/>
                </a:lnTo>
                <a:lnTo>
                  <a:pt x="2335" y="16"/>
                </a:lnTo>
                <a:lnTo>
                  <a:pt x="2341" y="16"/>
                </a:lnTo>
                <a:lnTo>
                  <a:pt x="2351" y="16"/>
                </a:lnTo>
                <a:lnTo>
                  <a:pt x="2357" y="16"/>
                </a:lnTo>
                <a:lnTo>
                  <a:pt x="2366" y="16"/>
                </a:lnTo>
                <a:lnTo>
                  <a:pt x="2375" y="14"/>
                </a:lnTo>
                <a:lnTo>
                  <a:pt x="2382" y="14"/>
                </a:lnTo>
                <a:lnTo>
                  <a:pt x="2390" y="0"/>
                </a:lnTo>
                <a:lnTo>
                  <a:pt x="2400" y="0"/>
                </a:lnTo>
                <a:lnTo>
                  <a:pt x="2408" y="0"/>
                </a:lnTo>
                <a:lnTo>
                  <a:pt x="2416" y="0"/>
                </a:lnTo>
                <a:lnTo>
                  <a:pt x="2424" y="0"/>
                </a:lnTo>
                <a:lnTo>
                  <a:pt x="2433" y="0"/>
                </a:lnTo>
                <a:lnTo>
                  <a:pt x="2439" y="0"/>
                </a:lnTo>
                <a:lnTo>
                  <a:pt x="2449" y="0"/>
                </a:lnTo>
                <a:lnTo>
                  <a:pt x="2455" y="0"/>
                </a:lnTo>
                <a:lnTo>
                  <a:pt x="2464" y="0"/>
                </a:lnTo>
                <a:lnTo>
                  <a:pt x="2473" y="1"/>
                </a:lnTo>
                <a:lnTo>
                  <a:pt x="2480" y="1"/>
                </a:lnTo>
                <a:lnTo>
                  <a:pt x="2490" y="1"/>
                </a:lnTo>
                <a:lnTo>
                  <a:pt x="2498" y="1"/>
                </a:lnTo>
                <a:lnTo>
                  <a:pt x="2506" y="1"/>
                </a:lnTo>
                <a:lnTo>
                  <a:pt x="2513" y="1"/>
                </a:lnTo>
                <a:lnTo>
                  <a:pt x="2521" y="1"/>
                </a:lnTo>
                <a:lnTo>
                  <a:pt x="2529" y="1"/>
                </a:lnTo>
                <a:lnTo>
                  <a:pt x="2539" y="1"/>
                </a:lnTo>
                <a:lnTo>
                  <a:pt x="2547" y="1"/>
                </a:lnTo>
                <a:lnTo>
                  <a:pt x="2555" y="1"/>
                </a:lnTo>
                <a:lnTo>
                  <a:pt x="2561" y="1"/>
                </a:lnTo>
                <a:lnTo>
                  <a:pt x="2570" y="1"/>
                </a:lnTo>
                <a:lnTo>
                  <a:pt x="2578" y="1"/>
                </a:lnTo>
                <a:lnTo>
                  <a:pt x="2588" y="1"/>
                </a:lnTo>
                <a:lnTo>
                  <a:pt x="2594" y="1"/>
                </a:lnTo>
                <a:lnTo>
                  <a:pt x="2604" y="1"/>
                </a:lnTo>
                <a:lnTo>
                  <a:pt x="2610" y="1"/>
                </a:lnTo>
                <a:lnTo>
                  <a:pt x="2620" y="1"/>
                </a:lnTo>
                <a:lnTo>
                  <a:pt x="2627" y="1"/>
                </a:lnTo>
                <a:lnTo>
                  <a:pt x="2635" y="1"/>
                </a:lnTo>
                <a:lnTo>
                  <a:pt x="2645" y="1"/>
                </a:lnTo>
                <a:lnTo>
                  <a:pt x="2651" y="1"/>
                </a:lnTo>
                <a:lnTo>
                  <a:pt x="2661" y="1"/>
                </a:lnTo>
                <a:lnTo>
                  <a:pt x="2668" y="1"/>
                </a:lnTo>
                <a:lnTo>
                  <a:pt x="2676" y="1"/>
                </a:lnTo>
                <a:lnTo>
                  <a:pt x="2685" y="1"/>
                </a:lnTo>
                <a:lnTo>
                  <a:pt x="2692" y="1"/>
                </a:lnTo>
                <a:lnTo>
                  <a:pt x="2702" y="1"/>
                </a:lnTo>
                <a:lnTo>
                  <a:pt x="2708" y="1"/>
                </a:lnTo>
                <a:lnTo>
                  <a:pt x="2718" y="1"/>
                </a:lnTo>
                <a:lnTo>
                  <a:pt x="2726" y="1"/>
                </a:lnTo>
                <a:lnTo>
                  <a:pt x="2733" y="1"/>
                </a:lnTo>
                <a:lnTo>
                  <a:pt x="2743" y="1"/>
                </a:lnTo>
                <a:lnTo>
                  <a:pt x="2749" y="1"/>
                </a:lnTo>
                <a:lnTo>
                  <a:pt x="2759" y="1"/>
                </a:lnTo>
                <a:lnTo>
                  <a:pt x="2765" y="1"/>
                </a:lnTo>
                <a:lnTo>
                  <a:pt x="2774" y="1"/>
                </a:lnTo>
                <a:lnTo>
                  <a:pt x="2783" y="1"/>
                </a:lnTo>
                <a:lnTo>
                  <a:pt x="2790" y="1"/>
                </a:lnTo>
                <a:lnTo>
                  <a:pt x="2798" y="1"/>
                </a:lnTo>
                <a:lnTo>
                  <a:pt x="2808" y="1"/>
                </a:lnTo>
                <a:lnTo>
                  <a:pt x="2816" y="1"/>
                </a:lnTo>
                <a:lnTo>
                  <a:pt x="2824" y="1"/>
                </a:lnTo>
                <a:lnTo>
                  <a:pt x="2831" y="1"/>
                </a:lnTo>
                <a:lnTo>
                  <a:pt x="2839" y="1"/>
                </a:lnTo>
                <a:lnTo>
                  <a:pt x="2849" y="1"/>
                </a:lnTo>
                <a:lnTo>
                  <a:pt x="2857" y="1"/>
                </a:lnTo>
                <a:lnTo>
                  <a:pt x="2865" y="3"/>
                </a:lnTo>
                <a:lnTo>
                  <a:pt x="2871" y="3"/>
                </a:lnTo>
                <a:lnTo>
                  <a:pt x="2880" y="3"/>
                </a:lnTo>
                <a:lnTo>
                  <a:pt x="2889" y="3"/>
                </a:lnTo>
                <a:lnTo>
                  <a:pt x="2898" y="3"/>
                </a:lnTo>
                <a:lnTo>
                  <a:pt x="2904" y="3"/>
                </a:lnTo>
                <a:lnTo>
                  <a:pt x="2912" y="3"/>
                </a:lnTo>
                <a:lnTo>
                  <a:pt x="2920" y="3"/>
                </a:lnTo>
                <a:lnTo>
                  <a:pt x="2930" y="3"/>
                </a:lnTo>
                <a:lnTo>
                  <a:pt x="2938" y="3"/>
                </a:lnTo>
                <a:lnTo>
                  <a:pt x="2945" y="3"/>
                </a:lnTo>
                <a:lnTo>
                  <a:pt x="2953" y="3"/>
                </a:lnTo>
                <a:lnTo>
                  <a:pt x="2961" y="3"/>
                </a:lnTo>
                <a:lnTo>
                  <a:pt x="2971" y="3"/>
                </a:lnTo>
                <a:lnTo>
                  <a:pt x="2979" y="3"/>
                </a:lnTo>
                <a:lnTo>
                  <a:pt x="2986" y="3"/>
                </a:lnTo>
                <a:lnTo>
                  <a:pt x="2994" y="3"/>
                </a:lnTo>
                <a:lnTo>
                  <a:pt x="3002" y="3"/>
                </a:lnTo>
                <a:lnTo>
                  <a:pt x="3012" y="3"/>
                </a:lnTo>
                <a:lnTo>
                  <a:pt x="3020" y="3"/>
                </a:lnTo>
                <a:lnTo>
                  <a:pt x="3027" y="3"/>
                </a:lnTo>
                <a:lnTo>
                  <a:pt x="3035" y="3"/>
                </a:lnTo>
                <a:lnTo>
                  <a:pt x="3044" y="3"/>
                </a:lnTo>
                <a:lnTo>
                  <a:pt x="3053" y="3"/>
                </a:lnTo>
                <a:lnTo>
                  <a:pt x="3061" y="3"/>
                </a:lnTo>
                <a:lnTo>
                  <a:pt x="3067" y="3"/>
                </a:lnTo>
                <a:lnTo>
                  <a:pt x="3075" y="3"/>
                </a:lnTo>
                <a:lnTo>
                  <a:pt x="3085" y="3"/>
                </a:lnTo>
                <a:lnTo>
                  <a:pt x="3093" y="3"/>
                </a:lnTo>
                <a:lnTo>
                  <a:pt x="3102" y="3"/>
                </a:lnTo>
                <a:lnTo>
                  <a:pt x="3108" y="3"/>
                </a:lnTo>
                <a:lnTo>
                  <a:pt x="3116" y="3"/>
                </a:lnTo>
                <a:lnTo>
                  <a:pt x="3126" y="3"/>
                </a:lnTo>
                <a:lnTo>
                  <a:pt x="3134" y="3"/>
                </a:lnTo>
                <a:lnTo>
                  <a:pt x="3142" y="3"/>
                </a:lnTo>
                <a:lnTo>
                  <a:pt x="3149" y="3"/>
                </a:lnTo>
                <a:lnTo>
                  <a:pt x="3157" y="3"/>
                </a:lnTo>
                <a:lnTo>
                  <a:pt x="3167" y="3"/>
                </a:lnTo>
                <a:lnTo>
                  <a:pt x="3173" y="3"/>
                </a:lnTo>
                <a:lnTo>
                  <a:pt x="3182" y="3"/>
                </a:lnTo>
                <a:lnTo>
                  <a:pt x="3191" y="3"/>
                </a:lnTo>
                <a:lnTo>
                  <a:pt x="3198" y="3"/>
                </a:lnTo>
                <a:lnTo>
                  <a:pt x="3208" y="3"/>
                </a:lnTo>
                <a:lnTo>
                  <a:pt x="3214" y="3"/>
                </a:lnTo>
                <a:lnTo>
                  <a:pt x="3222" y="3"/>
                </a:lnTo>
                <a:lnTo>
                  <a:pt x="3232" y="3"/>
                </a:lnTo>
                <a:lnTo>
                  <a:pt x="3239" y="3"/>
                </a:lnTo>
                <a:lnTo>
                  <a:pt x="3248" y="3"/>
                </a:lnTo>
                <a:lnTo>
                  <a:pt x="3255" y="4"/>
                </a:lnTo>
                <a:lnTo>
                  <a:pt x="3263" y="4"/>
                </a:lnTo>
                <a:lnTo>
                  <a:pt x="3273" y="4"/>
                </a:lnTo>
                <a:lnTo>
                  <a:pt x="3279" y="4"/>
                </a:lnTo>
                <a:lnTo>
                  <a:pt x="3289" y="4"/>
                </a:lnTo>
                <a:lnTo>
                  <a:pt x="3296" y="4"/>
                </a:lnTo>
                <a:lnTo>
                  <a:pt x="3304" y="4"/>
                </a:lnTo>
                <a:lnTo>
                  <a:pt x="3314" y="4"/>
                </a:lnTo>
                <a:lnTo>
                  <a:pt x="3320" y="4"/>
                </a:lnTo>
                <a:lnTo>
                  <a:pt x="3330" y="4"/>
                </a:lnTo>
                <a:lnTo>
                  <a:pt x="3337" y="4"/>
                </a:lnTo>
                <a:lnTo>
                  <a:pt x="3345" y="4"/>
                </a:lnTo>
                <a:lnTo>
                  <a:pt x="3354" y="4"/>
                </a:lnTo>
                <a:lnTo>
                  <a:pt x="3361" y="4"/>
                </a:lnTo>
                <a:lnTo>
                  <a:pt x="3371" y="4"/>
                </a:lnTo>
                <a:lnTo>
                  <a:pt x="3377" y="4"/>
                </a:lnTo>
                <a:lnTo>
                  <a:pt x="3385" y="4"/>
                </a:lnTo>
                <a:lnTo>
                  <a:pt x="3395" y="4"/>
                </a:lnTo>
                <a:lnTo>
                  <a:pt x="3402" y="4"/>
                </a:lnTo>
                <a:lnTo>
                  <a:pt x="3412" y="4"/>
                </a:lnTo>
                <a:lnTo>
                  <a:pt x="3418" y="4"/>
                </a:lnTo>
                <a:lnTo>
                  <a:pt x="3426" y="4"/>
                </a:lnTo>
                <a:lnTo>
                  <a:pt x="3436" y="4"/>
                </a:lnTo>
                <a:lnTo>
                  <a:pt x="3443" y="4"/>
                </a:lnTo>
                <a:lnTo>
                  <a:pt x="3452" y="4"/>
                </a:lnTo>
                <a:lnTo>
                  <a:pt x="3461" y="4"/>
                </a:lnTo>
                <a:lnTo>
                  <a:pt x="3467" y="4"/>
                </a:lnTo>
                <a:lnTo>
                  <a:pt x="3477" y="4"/>
                </a:lnTo>
                <a:lnTo>
                  <a:pt x="3483" y="4"/>
                </a:lnTo>
                <a:lnTo>
                  <a:pt x="3493" y="4"/>
                </a:lnTo>
                <a:lnTo>
                  <a:pt x="3501" y="4"/>
                </a:lnTo>
                <a:lnTo>
                  <a:pt x="3508" y="4"/>
                </a:lnTo>
                <a:lnTo>
                  <a:pt x="3518" y="4"/>
                </a:lnTo>
                <a:lnTo>
                  <a:pt x="3524" y="4"/>
                </a:lnTo>
                <a:lnTo>
                  <a:pt x="3534" y="4"/>
                </a:lnTo>
                <a:lnTo>
                  <a:pt x="3542" y="4"/>
                </a:lnTo>
                <a:lnTo>
                  <a:pt x="3549" y="4"/>
                </a:lnTo>
                <a:lnTo>
                  <a:pt x="3558" y="4"/>
                </a:lnTo>
                <a:lnTo>
                  <a:pt x="3565" y="4"/>
                </a:lnTo>
                <a:lnTo>
                  <a:pt x="3575" y="4"/>
                </a:lnTo>
                <a:lnTo>
                  <a:pt x="3583" y="4"/>
                </a:lnTo>
                <a:lnTo>
                  <a:pt x="3589" y="4"/>
                </a:lnTo>
                <a:lnTo>
                  <a:pt x="3599" y="4"/>
                </a:lnTo>
                <a:lnTo>
                  <a:pt x="3606" y="4"/>
                </a:lnTo>
                <a:lnTo>
                  <a:pt x="3616" y="4"/>
                </a:lnTo>
                <a:lnTo>
                  <a:pt x="3624" y="4"/>
                </a:lnTo>
                <a:lnTo>
                  <a:pt x="3630" y="4"/>
                </a:lnTo>
                <a:lnTo>
                  <a:pt x="3640" y="4"/>
                </a:lnTo>
                <a:lnTo>
                  <a:pt x="3647" y="4"/>
                </a:lnTo>
                <a:lnTo>
                  <a:pt x="3656" y="4"/>
                </a:lnTo>
                <a:lnTo>
                  <a:pt x="3665" y="6"/>
                </a:lnTo>
                <a:lnTo>
                  <a:pt x="3671" y="6"/>
                </a:lnTo>
                <a:lnTo>
                  <a:pt x="3681" y="6"/>
                </a:lnTo>
                <a:lnTo>
                  <a:pt x="3687" y="6"/>
                </a:lnTo>
                <a:lnTo>
                  <a:pt x="3696" y="6"/>
                </a:lnTo>
                <a:lnTo>
                  <a:pt x="3705" y="6"/>
                </a:lnTo>
                <a:lnTo>
                  <a:pt x="3712" y="6"/>
                </a:lnTo>
                <a:lnTo>
                  <a:pt x="3722" y="6"/>
                </a:lnTo>
                <a:lnTo>
                  <a:pt x="3728" y="6"/>
                </a:lnTo>
                <a:lnTo>
                  <a:pt x="3736" y="6"/>
                </a:lnTo>
                <a:lnTo>
                  <a:pt x="3746" y="6"/>
                </a:lnTo>
                <a:lnTo>
                  <a:pt x="3753" y="6"/>
                </a:lnTo>
                <a:lnTo>
                  <a:pt x="3762" y="6"/>
                </a:lnTo>
                <a:lnTo>
                  <a:pt x="3769" y="6"/>
                </a:lnTo>
                <a:lnTo>
                  <a:pt x="3777" y="6"/>
                </a:lnTo>
                <a:lnTo>
                  <a:pt x="3787" y="6"/>
                </a:lnTo>
                <a:lnTo>
                  <a:pt x="3793" y="6"/>
                </a:lnTo>
                <a:lnTo>
                  <a:pt x="3803" y="6"/>
                </a:lnTo>
                <a:lnTo>
                  <a:pt x="3810" y="6"/>
                </a:lnTo>
                <a:lnTo>
                  <a:pt x="3818" y="6"/>
                </a:lnTo>
                <a:lnTo>
                  <a:pt x="3828" y="6"/>
                </a:lnTo>
                <a:lnTo>
                  <a:pt x="3834" y="6"/>
                </a:lnTo>
                <a:lnTo>
                  <a:pt x="3844" y="6"/>
                </a:lnTo>
                <a:lnTo>
                  <a:pt x="3851" y="6"/>
                </a:lnTo>
                <a:lnTo>
                  <a:pt x="3859" y="6"/>
                </a:lnTo>
                <a:lnTo>
                  <a:pt x="3868" y="6"/>
                </a:lnTo>
                <a:lnTo>
                  <a:pt x="3875" y="6"/>
                </a:lnTo>
                <a:lnTo>
                  <a:pt x="3885" y="6"/>
                </a:lnTo>
                <a:lnTo>
                  <a:pt x="3891" y="6"/>
                </a:lnTo>
                <a:lnTo>
                  <a:pt x="3899" y="6"/>
                </a:lnTo>
                <a:lnTo>
                  <a:pt x="3909" y="6"/>
                </a:lnTo>
                <a:lnTo>
                  <a:pt x="3916" y="6"/>
                </a:lnTo>
                <a:lnTo>
                  <a:pt x="3926" y="6"/>
                </a:lnTo>
                <a:lnTo>
                  <a:pt x="3932" y="6"/>
                </a:lnTo>
                <a:lnTo>
                  <a:pt x="3940" y="6"/>
                </a:lnTo>
                <a:lnTo>
                  <a:pt x="3948" y="6"/>
                </a:lnTo>
                <a:lnTo>
                  <a:pt x="3957" y="6"/>
                </a:lnTo>
                <a:lnTo>
                  <a:pt x="3966" y="6"/>
                </a:lnTo>
                <a:lnTo>
                  <a:pt x="3975" y="6"/>
                </a:lnTo>
                <a:lnTo>
                  <a:pt x="3983" y="6"/>
                </a:lnTo>
                <a:lnTo>
                  <a:pt x="3989" y="6"/>
                </a:lnTo>
                <a:lnTo>
                  <a:pt x="3997" y="6"/>
                </a:lnTo>
                <a:lnTo>
                  <a:pt x="4007" y="6"/>
                </a:lnTo>
                <a:lnTo>
                  <a:pt x="4015" y="6"/>
                </a:lnTo>
                <a:lnTo>
                  <a:pt x="4023" y="6"/>
                </a:lnTo>
                <a:lnTo>
                  <a:pt x="4030" y="6"/>
                </a:lnTo>
                <a:lnTo>
                  <a:pt x="4038" y="6"/>
                </a:lnTo>
                <a:lnTo>
                  <a:pt x="4048" y="6"/>
                </a:lnTo>
                <a:lnTo>
                  <a:pt x="4056" y="6"/>
                </a:lnTo>
                <a:lnTo>
                  <a:pt x="4064" y="6"/>
                </a:lnTo>
                <a:lnTo>
                  <a:pt x="4071" y="8"/>
                </a:lnTo>
                <a:lnTo>
                  <a:pt x="4079" y="8"/>
                </a:lnTo>
                <a:lnTo>
                  <a:pt x="4089" y="8"/>
                </a:lnTo>
                <a:lnTo>
                  <a:pt x="4097" y="8"/>
                </a:lnTo>
                <a:lnTo>
                  <a:pt x="4105" y="8"/>
                </a:lnTo>
                <a:lnTo>
                  <a:pt x="4112" y="8"/>
                </a:lnTo>
                <a:lnTo>
                  <a:pt x="4120" y="8"/>
                </a:lnTo>
                <a:lnTo>
                  <a:pt x="4130" y="8"/>
                </a:lnTo>
                <a:lnTo>
                  <a:pt x="4138" y="8"/>
                </a:lnTo>
                <a:lnTo>
                  <a:pt x="4146" y="8"/>
                </a:lnTo>
                <a:lnTo>
                  <a:pt x="4152" y="8"/>
                </a:lnTo>
                <a:lnTo>
                  <a:pt x="4161" y="8"/>
                </a:lnTo>
                <a:lnTo>
                  <a:pt x="4170" y="8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5" name="Line 52"/>
          <p:cNvSpPr>
            <a:spLocks noChangeShapeType="1"/>
          </p:cNvSpPr>
          <p:nvPr/>
        </p:nvSpPr>
        <p:spPr bwMode="auto">
          <a:xfrm>
            <a:off x="1227137" y="5693414"/>
            <a:ext cx="697230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6" name="Line 54"/>
          <p:cNvSpPr>
            <a:spLocks noChangeShapeType="1"/>
          </p:cNvSpPr>
          <p:nvPr/>
        </p:nvSpPr>
        <p:spPr bwMode="auto">
          <a:xfrm>
            <a:off x="1662112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7" name="Line 55"/>
          <p:cNvSpPr>
            <a:spLocks noChangeShapeType="1"/>
          </p:cNvSpPr>
          <p:nvPr/>
        </p:nvSpPr>
        <p:spPr bwMode="auto">
          <a:xfrm>
            <a:off x="209708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8" name="Line 56"/>
          <p:cNvSpPr>
            <a:spLocks noChangeShapeType="1"/>
          </p:cNvSpPr>
          <p:nvPr/>
        </p:nvSpPr>
        <p:spPr bwMode="auto">
          <a:xfrm>
            <a:off x="2532062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19" name="Line 57"/>
          <p:cNvSpPr>
            <a:spLocks noChangeShapeType="1"/>
          </p:cNvSpPr>
          <p:nvPr/>
        </p:nvSpPr>
        <p:spPr bwMode="auto">
          <a:xfrm>
            <a:off x="2970212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0" name="Line 58"/>
          <p:cNvSpPr>
            <a:spLocks noChangeShapeType="1"/>
          </p:cNvSpPr>
          <p:nvPr/>
        </p:nvSpPr>
        <p:spPr bwMode="auto">
          <a:xfrm>
            <a:off x="340518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1" name="Line 59"/>
          <p:cNvSpPr>
            <a:spLocks noChangeShapeType="1"/>
          </p:cNvSpPr>
          <p:nvPr/>
        </p:nvSpPr>
        <p:spPr bwMode="auto">
          <a:xfrm>
            <a:off x="3840162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2" name="Line 60"/>
          <p:cNvSpPr>
            <a:spLocks noChangeShapeType="1"/>
          </p:cNvSpPr>
          <p:nvPr/>
        </p:nvSpPr>
        <p:spPr bwMode="auto">
          <a:xfrm>
            <a:off x="427513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3" name="Line 61"/>
          <p:cNvSpPr>
            <a:spLocks noChangeShapeType="1"/>
          </p:cNvSpPr>
          <p:nvPr/>
        </p:nvSpPr>
        <p:spPr bwMode="auto">
          <a:xfrm>
            <a:off x="471328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4" name="Line 62"/>
          <p:cNvSpPr>
            <a:spLocks noChangeShapeType="1"/>
          </p:cNvSpPr>
          <p:nvPr/>
        </p:nvSpPr>
        <p:spPr bwMode="auto">
          <a:xfrm>
            <a:off x="5148262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5" name="Line 63"/>
          <p:cNvSpPr>
            <a:spLocks noChangeShapeType="1"/>
          </p:cNvSpPr>
          <p:nvPr/>
        </p:nvSpPr>
        <p:spPr bwMode="auto">
          <a:xfrm>
            <a:off x="558323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6" name="Line 64"/>
          <p:cNvSpPr>
            <a:spLocks noChangeShapeType="1"/>
          </p:cNvSpPr>
          <p:nvPr/>
        </p:nvSpPr>
        <p:spPr bwMode="auto">
          <a:xfrm>
            <a:off x="602138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7" name="Line 65"/>
          <p:cNvSpPr>
            <a:spLocks noChangeShapeType="1"/>
          </p:cNvSpPr>
          <p:nvPr/>
        </p:nvSpPr>
        <p:spPr bwMode="auto">
          <a:xfrm>
            <a:off x="6456362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8" name="Line 66"/>
          <p:cNvSpPr>
            <a:spLocks noChangeShapeType="1"/>
          </p:cNvSpPr>
          <p:nvPr/>
        </p:nvSpPr>
        <p:spPr bwMode="auto">
          <a:xfrm>
            <a:off x="689133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29" name="Line 67"/>
          <p:cNvSpPr>
            <a:spLocks noChangeShapeType="1"/>
          </p:cNvSpPr>
          <p:nvPr/>
        </p:nvSpPr>
        <p:spPr bwMode="auto">
          <a:xfrm>
            <a:off x="7327900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0" name="Line 68"/>
          <p:cNvSpPr>
            <a:spLocks noChangeShapeType="1"/>
          </p:cNvSpPr>
          <p:nvPr/>
        </p:nvSpPr>
        <p:spPr bwMode="auto">
          <a:xfrm>
            <a:off x="7764462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1" name="Line 69"/>
          <p:cNvSpPr>
            <a:spLocks noChangeShapeType="1"/>
          </p:cNvSpPr>
          <p:nvPr/>
        </p:nvSpPr>
        <p:spPr bwMode="auto">
          <a:xfrm>
            <a:off x="8199437" y="5688651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2" name="Line 73"/>
          <p:cNvSpPr>
            <a:spLocks noChangeShapeType="1"/>
          </p:cNvSpPr>
          <p:nvPr/>
        </p:nvSpPr>
        <p:spPr bwMode="auto">
          <a:xfrm>
            <a:off x="2097087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3" name="Line 74"/>
          <p:cNvSpPr>
            <a:spLocks noChangeShapeType="1"/>
          </p:cNvSpPr>
          <p:nvPr/>
        </p:nvSpPr>
        <p:spPr bwMode="auto">
          <a:xfrm>
            <a:off x="2970212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4" name="Line 75"/>
          <p:cNvSpPr>
            <a:spLocks noChangeShapeType="1"/>
          </p:cNvSpPr>
          <p:nvPr/>
        </p:nvSpPr>
        <p:spPr bwMode="auto">
          <a:xfrm>
            <a:off x="3840162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5" name="Line 76"/>
          <p:cNvSpPr>
            <a:spLocks noChangeShapeType="1"/>
          </p:cNvSpPr>
          <p:nvPr/>
        </p:nvSpPr>
        <p:spPr bwMode="auto">
          <a:xfrm>
            <a:off x="4713287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6" name="Line 77"/>
          <p:cNvSpPr>
            <a:spLocks noChangeShapeType="1"/>
          </p:cNvSpPr>
          <p:nvPr/>
        </p:nvSpPr>
        <p:spPr bwMode="auto">
          <a:xfrm>
            <a:off x="5583237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7" name="Line 78"/>
          <p:cNvSpPr>
            <a:spLocks noChangeShapeType="1"/>
          </p:cNvSpPr>
          <p:nvPr/>
        </p:nvSpPr>
        <p:spPr bwMode="auto">
          <a:xfrm>
            <a:off x="6456362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8" name="Line 79"/>
          <p:cNvSpPr>
            <a:spLocks noChangeShapeType="1"/>
          </p:cNvSpPr>
          <p:nvPr/>
        </p:nvSpPr>
        <p:spPr bwMode="auto">
          <a:xfrm>
            <a:off x="7327900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39" name="Line 80"/>
          <p:cNvSpPr>
            <a:spLocks noChangeShapeType="1"/>
          </p:cNvSpPr>
          <p:nvPr/>
        </p:nvSpPr>
        <p:spPr bwMode="auto">
          <a:xfrm>
            <a:off x="8199437" y="56775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40" name="Rectangle 83"/>
          <p:cNvSpPr>
            <a:spLocks noChangeArrowheads="1"/>
          </p:cNvSpPr>
          <p:nvPr/>
        </p:nvSpPr>
        <p:spPr bwMode="auto">
          <a:xfrm>
            <a:off x="2084387" y="5755326"/>
            <a:ext cx="10264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1" name="Rectangle 84"/>
          <p:cNvSpPr>
            <a:spLocks noChangeArrowheads="1"/>
          </p:cNvSpPr>
          <p:nvPr/>
        </p:nvSpPr>
        <p:spPr bwMode="auto">
          <a:xfrm>
            <a:off x="2941637" y="5755326"/>
            <a:ext cx="20528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5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2" name="Rectangle 85"/>
          <p:cNvSpPr>
            <a:spLocks noChangeArrowheads="1"/>
          </p:cNvSpPr>
          <p:nvPr/>
        </p:nvSpPr>
        <p:spPr bwMode="auto">
          <a:xfrm>
            <a:off x="3795712" y="5755326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10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3" name="Rectangle 86"/>
          <p:cNvSpPr>
            <a:spLocks noChangeArrowheads="1"/>
          </p:cNvSpPr>
          <p:nvPr/>
        </p:nvSpPr>
        <p:spPr bwMode="auto">
          <a:xfrm>
            <a:off x="4668837" y="5755326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15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4" name="Rectangle 87"/>
          <p:cNvSpPr>
            <a:spLocks noChangeArrowheads="1"/>
          </p:cNvSpPr>
          <p:nvPr/>
        </p:nvSpPr>
        <p:spPr bwMode="auto">
          <a:xfrm>
            <a:off x="5540375" y="5755326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20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5" name="Rectangle 88"/>
          <p:cNvSpPr>
            <a:spLocks noChangeArrowheads="1"/>
          </p:cNvSpPr>
          <p:nvPr/>
        </p:nvSpPr>
        <p:spPr bwMode="auto">
          <a:xfrm>
            <a:off x="6413500" y="5755326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25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6" name="Rectangle 89"/>
          <p:cNvSpPr>
            <a:spLocks noChangeArrowheads="1"/>
          </p:cNvSpPr>
          <p:nvPr/>
        </p:nvSpPr>
        <p:spPr bwMode="auto">
          <a:xfrm>
            <a:off x="7283450" y="5755326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30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7" name="Rectangle 90"/>
          <p:cNvSpPr>
            <a:spLocks noChangeArrowheads="1"/>
          </p:cNvSpPr>
          <p:nvPr/>
        </p:nvSpPr>
        <p:spPr bwMode="auto">
          <a:xfrm>
            <a:off x="8156575" y="5755326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  <a:latin typeface="Arial Black"/>
                <a:cs typeface="Arial Black"/>
              </a:rPr>
              <a:t>350</a:t>
            </a:r>
            <a:endParaRPr lang="es-ES" sz="1200">
              <a:latin typeface="Arial Black"/>
              <a:cs typeface="Arial Black"/>
            </a:endParaRPr>
          </a:p>
        </p:txBody>
      </p:sp>
      <p:sp>
        <p:nvSpPr>
          <p:cNvPr id="48" name="Rectangle 96"/>
          <p:cNvSpPr>
            <a:spLocks noChangeArrowheads="1"/>
          </p:cNvSpPr>
          <p:nvPr/>
        </p:nvSpPr>
        <p:spPr bwMode="auto">
          <a:xfrm>
            <a:off x="4448175" y="6012502"/>
            <a:ext cx="118572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600" b="1" dirty="0" smtClean="0">
                <a:solidFill>
                  <a:srgbClr val="000000"/>
                </a:solidFill>
                <a:latin typeface="Arial Black"/>
                <a:cs typeface="Arial Black"/>
              </a:rPr>
              <a:t>Time (</a:t>
            </a:r>
            <a:r>
              <a:rPr lang="es-ES" sz="1600" b="1" dirty="0" err="1" smtClean="0">
                <a:solidFill>
                  <a:srgbClr val="000000"/>
                </a:solidFill>
                <a:latin typeface="Arial Black"/>
                <a:cs typeface="Arial Black"/>
              </a:rPr>
              <a:t>sec</a:t>
            </a:r>
            <a:r>
              <a:rPr lang="es-ES" sz="1600" b="1" dirty="0" smtClean="0">
                <a:solidFill>
                  <a:srgbClr val="000000"/>
                </a:solidFill>
                <a:latin typeface="Arial Black"/>
                <a:cs typeface="Arial Black"/>
              </a:rPr>
              <a:t>)</a:t>
            </a:r>
            <a:endParaRPr lang="es-ES" sz="1600" dirty="0">
              <a:latin typeface="Arial Black"/>
              <a:cs typeface="Arial Black"/>
            </a:endParaRPr>
          </a:p>
        </p:txBody>
      </p:sp>
      <p:sp>
        <p:nvSpPr>
          <p:cNvPr id="49" name="Line 12"/>
          <p:cNvSpPr>
            <a:spLocks noChangeShapeType="1"/>
          </p:cNvSpPr>
          <p:nvPr/>
        </p:nvSpPr>
        <p:spPr bwMode="auto">
          <a:xfrm flipV="1">
            <a:off x="1249362" y="3226437"/>
            <a:ext cx="15875" cy="2486026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0" name="Line 18"/>
          <p:cNvSpPr>
            <a:spLocks noChangeShapeType="1"/>
          </p:cNvSpPr>
          <p:nvPr/>
        </p:nvSpPr>
        <p:spPr bwMode="auto">
          <a:xfrm flipH="1">
            <a:off x="1223962" y="5523550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1" name="Line 19"/>
          <p:cNvSpPr>
            <a:spLocks noChangeShapeType="1"/>
          </p:cNvSpPr>
          <p:nvPr/>
        </p:nvSpPr>
        <p:spPr bwMode="auto">
          <a:xfrm flipH="1">
            <a:off x="1236662" y="531558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2" name="Line 20"/>
          <p:cNvSpPr>
            <a:spLocks noChangeShapeType="1"/>
          </p:cNvSpPr>
          <p:nvPr/>
        </p:nvSpPr>
        <p:spPr bwMode="auto">
          <a:xfrm flipH="1">
            <a:off x="1249362" y="5096512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3" name="Line 21"/>
          <p:cNvSpPr>
            <a:spLocks noChangeShapeType="1"/>
          </p:cNvSpPr>
          <p:nvPr/>
        </p:nvSpPr>
        <p:spPr bwMode="auto">
          <a:xfrm flipH="1">
            <a:off x="1249362" y="4888550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4" name="Line 22"/>
          <p:cNvSpPr>
            <a:spLocks noChangeShapeType="1"/>
          </p:cNvSpPr>
          <p:nvPr/>
        </p:nvSpPr>
        <p:spPr bwMode="auto">
          <a:xfrm flipH="1">
            <a:off x="1249362" y="4679000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5" name="Line 23"/>
          <p:cNvSpPr>
            <a:spLocks noChangeShapeType="1"/>
          </p:cNvSpPr>
          <p:nvPr/>
        </p:nvSpPr>
        <p:spPr bwMode="auto">
          <a:xfrm flipH="1">
            <a:off x="1249362" y="4472625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6" name="Line 24"/>
          <p:cNvSpPr>
            <a:spLocks noChangeShapeType="1"/>
          </p:cNvSpPr>
          <p:nvPr/>
        </p:nvSpPr>
        <p:spPr bwMode="auto">
          <a:xfrm flipH="1">
            <a:off x="1249362" y="4264662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7" name="Line 25"/>
          <p:cNvSpPr>
            <a:spLocks noChangeShapeType="1"/>
          </p:cNvSpPr>
          <p:nvPr/>
        </p:nvSpPr>
        <p:spPr bwMode="auto">
          <a:xfrm flipH="1">
            <a:off x="1249362" y="405828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8" name="Line 26"/>
          <p:cNvSpPr>
            <a:spLocks noChangeShapeType="1"/>
          </p:cNvSpPr>
          <p:nvPr/>
        </p:nvSpPr>
        <p:spPr bwMode="auto">
          <a:xfrm flipH="1">
            <a:off x="1249362" y="3850325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59" name="Line 27"/>
          <p:cNvSpPr>
            <a:spLocks noChangeShapeType="1"/>
          </p:cNvSpPr>
          <p:nvPr/>
        </p:nvSpPr>
        <p:spPr bwMode="auto">
          <a:xfrm flipH="1">
            <a:off x="1249362" y="3640775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0" name="Line 28"/>
          <p:cNvSpPr>
            <a:spLocks noChangeShapeType="1"/>
          </p:cNvSpPr>
          <p:nvPr/>
        </p:nvSpPr>
        <p:spPr bwMode="auto">
          <a:xfrm flipH="1">
            <a:off x="1249362" y="3432812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1" name="Line 29"/>
          <p:cNvSpPr>
            <a:spLocks noChangeShapeType="1"/>
          </p:cNvSpPr>
          <p:nvPr/>
        </p:nvSpPr>
        <p:spPr bwMode="auto">
          <a:xfrm flipH="1">
            <a:off x="1249362" y="322643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2" name="Line 35"/>
          <p:cNvSpPr>
            <a:spLocks noChangeShapeType="1"/>
          </p:cNvSpPr>
          <p:nvPr/>
        </p:nvSpPr>
        <p:spPr bwMode="auto">
          <a:xfrm flipH="1">
            <a:off x="1216025" y="531558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3" name="Line 36"/>
          <p:cNvSpPr>
            <a:spLocks noChangeShapeType="1"/>
          </p:cNvSpPr>
          <p:nvPr/>
        </p:nvSpPr>
        <p:spPr bwMode="auto">
          <a:xfrm flipH="1">
            <a:off x="1228725" y="4888550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4" name="Line 37"/>
          <p:cNvSpPr>
            <a:spLocks noChangeShapeType="1"/>
          </p:cNvSpPr>
          <p:nvPr/>
        </p:nvSpPr>
        <p:spPr bwMode="auto">
          <a:xfrm flipH="1">
            <a:off x="1228725" y="4472625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5" name="Line 38"/>
          <p:cNvSpPr>
            <a:spLocks noChangeShapeType="1"/>
          </p:cNvSpPr>
          <p:nvPr/>
        </p:nvSpPr>
        <p:spPr bwMode="auto">
          <a:xfrm flipH="1">
            <a:off x="1228725" y="405828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6" name="Line 39"/>
          <p:cNvSpPr>
            <a:spLocks noChangeShapeType="1"/>
          </p:cNvSpPr>
          <p:nvPr/>
        </p:nvSpPr>
        <p:spPr bwMode="auto">
          <a:xfrm flipH="1">
            <a:off x="1228725" y="3640775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7" name="Line 40"/>
          <p:cNvSpPr>
            <a:spLocks noChangeShapeType="1"/>
          </p:cNvSpPr>
          <p:nvPr/>
        </p:nvSpPr>
        <p:spPr bwMode="auto">
          <a:xfrm flipH="1">
            <a:off x="1228725" y="322643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>
              <a:latin typeface="Arial Black"/>
              <a:cs typeface="Arial Black"/>
            </a:endParaRPr>
          </a:p>
        </p:txBody>
      </p:sp>
      <p:sp>
        <p:nvSpPr>
          <p:cNvPr id="68" name="Rectangle 45"/>
          <p:cNvSpPr>
            <a:spLocks noChangeArrowheads="1"/>
          </p:cNvSpPr>
          <p:nvPr/>
        </p:nvSpPr>
        <p:spPr bwMode="auto">
          <a:xfrm>
            <a:off x="1087437" y="5212400"/>
            <a:ext cx="10264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dirty="0">
                <a:solidFill>
                  <a:srgbClr val="000000"/>
                </a:solidFill>
                <a:latin typeface="Arial Black"/>
                <a:cs typeface="Arial Black"/>
              </a:rPr>
              <a:t>0</a:t>
            </a:r>
            <a:endParaRPr lang="es-ES" sz="1200" dirty="0">
              <a:latin typeface="Arial Black"/>
              <a:cs typeface="Arial Black"/>
            </a:endParaRPr>
          </a:p>
        </p:txBody>
      </p:sp>
      <p:sp>
        <p:nvSpPr>
          <p:cNvPr id="69" name="Rectangle 46"/>
          <p:cNvSpPr>
            <a:spLocks noChangeArrowheads="1"/>
          </p:cNvSpPr>
          <p:nvPr/>
        </p:nvSpPr>
        <p:spPr bwMode="auto">
          <a:xfrm>
            <a:off x="1012825" y="4791712"/>
            <a:ext cx="20528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dirty="0">
                <a:solidFill>
                  <a:srgbClr val="000000"/>
                </a:solidFill>
                <a:latin typeface="Arial Black"/>
                <a:cs typeface="Arial Black"/>
              </a:rPr>
              <a:t>50</a:t>
            </a:r>
            <a:endParaRPr lang="es-ES" sz="1200" dirty="0">
              <a:latin typeface="Arial Black"/>
              <a:cs typeface="Arial Black"/>
            </a:endParaRPr>
          </a:p>
        </p:txBody>
      </p:sp>
      <p:sp>
        <p:nvSpPr>
          <p:cNvPr id="70" name="Rectangle 47"/>
          <p:cNvSpPr>
            <a:spLocks noChangeArrowheads="1"/>
          </p:cNvSpPr>
          <p:nvPr/>
        </p:nvSpPr>
        <p:spPr bwMode="auto">
          <a:xfrm>
            <a:off x="908050" y="4374200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dirty="0">
                <a:solidFill>
                  <a:srgbClr val="000000"/>
                </a:solidFill>
                <a:latin typeface="Arial Black"/>
                <a:cs typeface="Arial Black"/>
              </a:rPr>
              <a:t>100</a:t>
            </a:r>
            <a:endParaRPr lang="es-ES" sz="1200" dirty="0">
              <a:latin typeface="Arial Black"/>
              <a:cs typeface="Arial Black"/>
            </a:endParaRPr>
          </a:p>
        </p:txBody>
      </p:sp>
      <p:sp>
        <p:nvSpPr>
          <p:cNvPr id="71" name="Rectangle 48"/>
          <p:cNvSpPr>
            <a:spLocks noChangeArrowheads="1"/>
          </p:cNvSpPr>
          <p:nvPr/>
        </p:nvSpPr>
        <p:spPr bwMode="auto">
          <a:xfrm>
            <a:off x="901700" y="3953512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dirty="0">
                <a:solidFill>
                  <a:srgbClr val="000000"/>
                </a:solidFill>
                <a:latin typeface="Arial Black"/>
                <a:cs typeface="Arial Black"/>
              </a:rPr>
              <a:t>150</a:t>
            </a:r>
            <a:endParaRPr lang="es-ES" sz="1200" dirty="0">
              <a:latin typeface="Arial Black"/>
              <a:cs typeface="Arial Black"/>
            </a:endParaRPr>
          </a:p>
        </p:txBody>
      </p:sp>
      <p:sp>
        <p:nvSpPr>
          <p:cNvPr id="72" name="Rectangle 49"/>
          <p:cNvSpPr>
            <a:spLocks noChangeArrowheads="1"/>
          </p:cNvSpPr>
          <p:nvPr/>
        </p:nvSpPr>
        <p:spPr bwMode="auto">
          <a:xfrm>
            <a:off x="914400" y="3537587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dirty="0">
                <a:solidFill>
                  <a:srgbClr val="000000"/>
                </a:solidFill>
                <a:latin typeface="Arial Black"/>
                <a:cs typeface="Arial Black"/>
              </a:rPr>
              <a:t>200</a:t>
            </a:r>
            <a:endParaRPr lang="es-ES" sz="1200" dirty="0">
              <a:latin typeface="Arial Black"/>
              <a:cs typeface="Arial Black"/>
            </a:endParaRPr>
          </a:p>
        </p:txBody>
      </p:sp>
      <p:sp>
        <p:nvSpPr>
          <p:cNvPr id="73" name="Rectangle 50"/>
          <p:cNvSpPr>
            <a:spLocks noChangeArrowheads="1"/>
          </p:cNvSpPr>
          <p:nvPr/>
        </p:nvSpPr>
        <p:spPr bwMode="auto">
          <a:xfrm>
            <a:off x="901700" y="3129600"/>
            <a:ext cx="30792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dirty="0">
                <a:solidFill>
                  <a:srgbClr val="000000"/>
                </a:solidFill>
                <a:latin typeface="Arial Black"/>
                <a:cs typeface="Arial Black"/>
              </a:rPr>
              <a:t>250</a:t>
            </a:r>
            <a:endParaRPr lang="es-ES" sz="1200" dirty="0">
              <a:latin typeface="Arial Black"/>
              <a:cs typeface="Arial Black"/>
            </a:endParaRPr>
          </a:p>
        </p:txBody>
      </p:sp>
      <p:sp>
        <p:nvSpPr>
          <p:cNvPr id="74" name="Rectangle 94"/>
          <p:cNvSpPr>
            <a:spLocks noChangeArrowheads="1"/>
          </p:cNvSpPr>
          <p:nvPr/>
        </p:nvSpPr>
        <p:spPr bwMode="auto">
          <a:xfrm rot="16200000">
            <a:off x="-154489" y="4229014"/>
            <a:ext cx="164458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600" b="1" dirty="0" smtClean="0">
                <a:solidFill>
                  <a:srgbClr val="000000"/>
                </a:solidFill>
                <a:latin typeface="Arial Black"/>
                <a:cs typeface="Arial Black"/>
              </a:rPr>
              <a:t>Response (RU)</a:t>
            </a:r>
            <a:endParaRPr lang="es-ES" sz="1600" dirty="0">
              <a:latin typeface="Arial Black"/>
              <a:cs typeface="Arial Black"/>
            </a:endParaRPr>
          </a:p>
        </p:txBody>
      </p:sp>
    </p:spTree>
    <p:extLst>
      <p:ext uri="{BB962C8B-B14F-4D97-AF65-F5344CB8AC3E}">
        <p14:creationId xmlns:p14="http://schemas.microsoft.com/office/powerpoint/2010/main" val="27530749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ure2A</a:t>
            </a:r>
            <a:endParaRPr lang="en-US" dirty="0"/>
          </a:p>
        </p:txBody>
      </p:sp>
      <p:sp>
        <p:nvSpPr>
          <p:cNvPr id="5" name="AutoShape 3"/>
          <p:cNvSpPr>
            <a:spLocks noChangeAspect="1" noChangeArrowheads="1" noTextEdit="1"/>
          </p:cNvSpPr>
          <p:nvPr/>
        </p:nvSpPr>
        <p:spPr bwMode="auto">
          <a:xfrm>
            <a:off x="324645" y="2005014"/>
            <a:ext cx="8229601" cy="4648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7" name="Line 5"/>
          <p:cNvSpPr>
            <a:spLocks noChangeShapeType="1"/>
          </p:cNvSpPr>
          <p:nvPr/>
        </p:nvSpPr>
        <p:spPr bwMode="auto">
          <a:xfrm flipV="1">
            <a:off x="635795" y="2206627"/>
            <a:ext cx="1588" cy="41671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8" name="Line 6"/>
          <p:cNvSpPr>
            <a:spLocks noChangeShapeType="1"/>
          </p:cNvSpPr>
          <p:nvPr/>
        </p:nvSpPr>
        <p:spPr bwMode="auto">
          <a:xfrm flipH="1">
            <a:off x="619920" y="6373814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" name="Line 7"/>
          <p:cNvSpPr>
            <a:spLocks noChangeShapeType="1"/>
          </p:cNvSpPr>
          <p:nvPr/>
        </p:nvSpPr>
        <p:spPr bwMode="auto">
          <a:xfrm flipH="1">
            <a:off x="619920" y="614362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0" name="Line 8"/>
          <p:cNvSpPr>
            <a:spLocks noChangeShapeType="1"/>
          </p:cNvSpPr>
          <p:nvPr/>
        </p:nvSpPr>
        <p:spPr bwMode="auto">
          <a:xfrm flipH="1">
            <a:off x="619920" y="5911852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1" name="Line 9"/>
          <p:cNvSpPr>
            <a:spLocks noChangeShapeType="1"/>
          </p:cNvSpPr>
          <p:nvPr/>
        </p:nvSpPr>
        <p:spPr bwMode="auto">
          <a:xfrm flipH="1">
            <a:off x="619920" y="568007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2" name="Line 10"/>
          <p:cNvSpPr>
            <a:spLocks noChangeShapeType="1"/>
          </p:cNvSpPr>
          <p:nvPr/>
        </p:nvSpPr>
        <p:spPr bwMode="auto">
          <a:xfrm flipH="1">
            <a:off x="619920" y="5448302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3" name="Line 11"/>
          <p:cNvSpPr>
            <a:spLocks noChangeShapeType="1"/>
          </p:cNvSpPr>
          <p:nvPr/>
        </p:nvSpPr>
        <p:spPr bwMode="auto">
          <a:xfrm flipH="1">
            <a:off x="619920" y="5218114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4" name="Line 12"/>
          <p:cNvSpPr>
            <a:spLocks noChangeShapeType="1"/>
          </p:cNvSpPr>
          <p:nvPr/>
        </p:nvSpPr>
        <p:spPr bwMode="auto">
          <a:xfrm flipH="1">
            <a:off x="619920" y="4986339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5" name="Line 13"/>
          <p:cNvSpPr>
            <a:spLocks noChangeShapeType="1"/>
          </p:cNvSpPr>
          <p:nvPr/>
        </p:nvSpPr>
        <p:spPr bwMode="auto">
          <a:xfrm flipH="1">
            <a:off x="619920" y="4754564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6" name="Line 14"/>
          <p:cNvSpPr>
            <a:spLocks noChangeShapeType="1"/>
          </p:cNvSpPr>
          <p:nvPr/>
        </p:nvSpPr>
        <p:spPr bwMode="auto">
          <a:xfrm flipH="1">
            <a:off x="619920" y="4522789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7" name="Line 15"/>
          <p:cNvSpPr>
            <a:spLocks noChangeShapeType="1"/>
          </p:cNvSpPr>
          <p:nvPr/>
        </p:nvSpPr>
        <p:spPr bwMode="auto">
          <a:xfrm flipH="1">
            <a:off x="619920" y="4291014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8" name="Line 16"/>
          <p:cNvSpPr>
            <a:spLocks noChangeShapeType="1"/>
          </p:cNvSpPr>
          <p:nvPr/>
        </p:nvSpPr>
        <p:spPr bwMode="auto">
          <a:xfrm flipH="1">
            <a:off x="619920" y="406082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9" name="Line 17"/>
          <p:cNvSpPr>
            <a:spLocks noChangeShapeType="1"/>
          </p:cNvSpPr>
          <p:nvPr/>
        </p:nvSpPr>
        <p:spPr bwMode="auto">
          <a:xfrm flipH="1">
            <a:off x="619920" y="3827464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0" name="Line 18"/>
          <p:cNvSpPr>
            <a:spLocks noChangeShapeType="1"/>
          </p:cNvSpPr>
          <p:nvPr/>
        </p:nvSpPr>
        <p:spPr bwMode="auto">
          <a:xfrm flipH="1">
            <a:off x="619920" y="359727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1" name="Line 19"/>
          <p:cNvSpPr>
            <a:spLocks noChangeShapeType="1"/>
          </p:cNvSpPr>
          <p:nvPr/>
        </p:nvSpPr>
        <p:spPr bwMode="auto">
          <a:xfrm flipH="1">
            <a:off x="619920" y="3363914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2" name="Line 20"/>
          <p:cNvSpPr>
            <a:spLocks noChangeShapeType="1"/>
          </p:cNvSpPr>
          <p:nvPr/>
        </p:nvSpPr>
        <p:spPr bwMode="auto">
          <a:xfrm flipH="1">
            <a:off x="619920" y="313372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3" name="Line 21"/>
          <p:cNvSpPr>
            <a:spLocks noChangeShapeType="1"/>
          </p:cNvSpPr>
          <p:nvPr/>
        </p:nvSpPr>
        <p:spPr bwMode="auto">
          <a:xfrm flipH="1">
            <a:off x="619920" y="2903539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4" name="Line 22"/>
          <p:cNvSpPr>
            <a:spLocks noChangeShapeType="1"/>
          </p:cNvSpPr>
          <p:nvPr/>
        </p:nvSpPr>
        <p:spPr bwMode="auto">
          <a:xfrm flipH="1">
            <a:off x="619920" y="267017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5" name="Line 23"/>
          <p:cNvSpPr>
            <a:spLocks noChangeShapeType="1"/>
          </p:cNvSpPr>
          <p:nvPr/>
        </p:nvSpPr>
        <p:spPr bwMode="auto">
          <a:xfrm flipH="1">
            <a:off x="619920" y="2439989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6" name="Line 24"/>
          <p:cNvSpPr>
            <a:spLocks noChangeShapeType="1"/>
          </p:cNvSpPr>
          <p:nvPr/>
        </p:nvSpPr>
        <p:spPr bwMode="auto">
          <a:xfrm flipH="1">
            <a:off x="619920" y="2206627"/>
            <a:ext cx="2063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7" name="Line 25"/>
          <p:cNvSpPr>
            <a:spLocks noChangeShapeType="1"/>
          </p:cNvSpPr>
          <p:nvPr/>
        </p:nvSpPr>
        <p:spPr bwMode="auto">
          <a:xfrm flipH="1">
            <a:off x="599282" y="6373814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8" name="Line 26"/>
          <p:cNvSpPr>
            <a:spLocks noChangeShapeType="1"/>
          </p:cNvSpPr>
          <p:nvPr/>
        </p:nvSpPr>
        <p:spPr bwMode="auto">
          <a:xfrm flipH="1">
            <a:off x="599282" y="5911852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29" name="Line 27"/>
          <p:cNvSpPr>
            <a:spLocks noChangeShapeType="1"/>
          </p:cNvSpPr>
          <p:nvPr/>
        </p:nvSpPr>
        <p:spPr bwMode="auto">
          <a:xfrm flipH="1">
            <a:off x="599282" y="5448302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0" name="Line 28"/>
          <p:cNvSpPr>
            <a:spLocks noChangeShapeType="1"/>
          </p:cNvSpPr>
          <p:nvPr/>
        </p:nvSpPr>
        <p:spPr bwMode="auto">
          <a:xfrm flipH="1">
            <a:off x="599282" y="4986339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1" name="Line 29"/>
          <p:cNvSpPr>
            <a:spLocks noChangeShapeType="1"/>
          </p:cNvSpPr>
          <p:nvPr/>
        </p:nvSpPr>
        <p:spPr bwMode="auto">
          <a:xfrm flipH="1">
            <a:off x="599282" y="4522789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2" name="Line 30"/>
          <p:cNvSpPr>
            <a:spLocks noChangeShapeType="1"/>
          </p:cNvSpPr>
          <p:nvPr/>
        </p:nvSpPr>
        <p:spPr bwMode="auto">
          <a:xfrm flipH="1">
            <a:off x="599282" y="406082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3" name="Line 31"/>
          <p:cNvSpPr>
            <a:spLocks noChangeShapeType="1"/>
          </p:cNvSpPr>
          <p:nvPr/>
        </p:nvSpPr>
        <p:spPr bwMode="auto">
          <a:xfrm flipH="1">
            <a:off x="599282" y="359727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4" name="Line 32"/>
          <p:cNvSpPr>
            <a:spLocks noChangeShapeType="1"/>
          </p:cNvSpPr>
          <p:nvPr/>
        </p:nvSpPr>
        <p:spPr bwMode="auto">
          <a:xfrm flipH="1">
            <a:off x="599282" y="313372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5" name="Line 33"/>
          <p:cNvSpPr>
            <a:spLocks noChangeShapeType="1"/>
          </p:cNvSpPr>
          <p:nvPr/>
        </p:nvSpPr>
        <p:spPr bwMode="auto">
          <a:xfrm flipH="1">
            <a:off x="599282" y="267017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6" name="Line 34"/>
          <p:cNvSpPr>
            <a:spLocks noChangeShapeType="1"/>
          </p:cNvSpPr>
          <p:nvPr/>
        </p:nvSpPr>
        <p:spPr bwMode="auto">
          <a:xfrm flipH="1">
            <a:off x="599282" y="2206627"/>
            <a:ext cx="52388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37" name="Rectangle 35"/>
          <p:cNvSpPr>
            <a:spLocks noChangeArrowheads="1"/>
          </p:cNvSpPr>
          <p:nvPr/>
        </p:nvSpPr>
        <p:spPr bwMode="auto">
          <a:xfrm>
            <a:off x="415132" y="6326189"/>
            <a:ext cx="2809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-150</a:t>
            </a:r>
            <a:endParaRPr lang="es-ES" sz="1200"/>
          </a:p>
        </p:txBody>
      </p:sp>
      <p:sp>
        <p:nvSpPr>
          <p:cNvPr id="38" name="Rectangle 36"/>
          <p:cNvSpPr>
            <a:spLocks noChangeArrowheads="1"/>
          </p:cNvSpPr>
          <p:nvPr/>
        </p:nvSpPr>
        <p:spPr bwMode="auto">
          <a:xfrm>
            <a:off x="415132" y="5865814"/>
            <a:ext cx="2809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-100</a:t>
            </a:r>
            <a:endParaRPr lang="es-ES" sz="1200"/>
          </a:p>
        </p:txBody>
      </p:sp>
      <p:sp>
        <p:nvSpPr>
          <p:cNvPr id="39" name="Rectangle 37"/>
          <p:cNvSpPr>
            <a:spLocks noChangeArrowheads="1"/>
          </p:cNvSpPr>
          <p:nvPr/>
        </p:nvSpPr>
        <p:spPr bwMode="auto">
          <a:xfrm>
            <a:off x="451645" y="5402264"/>
            <a:ext cx="2032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-50</a:t>
            </a:r>
            <a:endParaRPr lang="es-ES" sz="1200"/>
          </a:p>
        </p:txBody>
      </p:sp>
      <p:sp>
        <p:nvSpPr>
          <p:cNvPr id="40" name="Rectangle 38"/>
          <p:cNvSpPr>
            <a:spLocks noChangeArrowheads="1"/>
          </p:cNvSpPr>
          <p:nvPr/>
        </p:nvSpPr>
        <p:spPr bwMode="auto">
          <a:xfrm>
            <a:off x="508795" y="4938714"/>
            <a:ext cx="777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0</a:t>
            </a:r>
            <a:endParaRPr lang="es-ES" sz="1200"/>
          </a:p>
        </p:txBody>
      </p:sp>
      <p:sp>
        <p:nvSpPr>
          <p:cNvPr id="41" name="Rectangle 39"/>
          <p:cNvSpPr>
            <a:spLocks noChangeArrowheads="1"/>
          </p:cNvSpPr>
          <p:nvPr/>
        </p:nvSpPr>
        <p:spPr bwMode="auto">
          <a:xfrm>
            <a:off x="472282" y="4475164"/>
            <a:ext cx="15557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50</a:t>
            </a:r>
            <a:endParaRPr lang="es-ES" sz="1200"/>
          </a:p>
        </p:txBody>
      </p:sp>
      <p:sp>
        <p:nvSpPr>
          <p:cNvPr id="42" name="Rectangle 40"/>
          <p:cNvSpPr>
            <a:spLocks noChangeArrowheads="1"/>
          </p:cNvSpPr>
          <p:nvPr/>
        </p:nvSpPr>
        <p:spPr bwMode="auto">
          <a:xfrm>
            <a:off x="437357" y="4014789"/>
            <a:ext cx="2333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100</a:t>
            </a:r>
            <a:endParaRPr lang="es-ES" sz="1200"/>
          </a:p>
        </p:txBody>
      </p:sp>
      <p:sp>
        <p:nvSpPr>
          <p:cNvPr id="43" name="Rectangle 41"/>
          <p:cNvSpPr>
            <a:spLocks noChangeArrowheads="1"/>
          </p:cNvSpPr>
          <p:nvPr/>
        </p:nvSpPr>
        <p:spPr bwMode="auto">
          <a:xfrm>
            <a:off x="437357" y="3551239"/>
            <a:ext cx="2333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150</a:t>
            </a:r>
            <a:endParaRPr lang="es-ES" sz="1200"/>
          </a:p>
        </p:txBody>
      </p:sp>
      <p:sp>
        <p:nvSpPr>
          <p:cNvPr id="44" name="Rectangle 42"/>
          <p:cNvSpPr>
            <a:spLocks noChangeArrowheads="1"/>
          </p:cNvSpPr>
          <p:nvPr/>
        </p:nvSpPr>
        <p:spPr bwMode="auto">
          <a:xfrm>
            <a:off x="437357" y="3087689"/>
            <a:ext cx="2333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200</a:t>
            </a:r>
            <a:endParaRPr lang="es-ES" sz="1200"/>
          </a:p>
        </p:txBody>
      </p:sp>
      <p:sp>
        <p:nvSpPr>
          <p:cNvPr id="45" name="Rectangle 43"/>
          <p:cNvSpPr>
            <a:spLocks noChangeArrowheads="1"/>
          </p:cNvSpPr>
          <p:nvPr/>
        </p:nvSpPr>
        <p:spPr bwMode="auto">
          <a:xfrm>
            <a:off x="437357" y="2624139"/>
            <a:ext cx="2333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250</a:t>
            </a:r>
            <a:endParaRPr lang="es-ES" sz="1200"/>
          </a:p>
        </p:txBody>
      </p:sp>
      <p:sp>
        <p:nvSpPr>
          <p:cNvPr id="46" name="Rectangle 44"/>
          <p:cNvSpPr>
            <a:spLocks noChangeArrowheads="1"/>
          </p:cNvSpPr>
          <p:nvPr/>
        </p:nvSpPr>
        <p:spPr bwMode="auto">
          <a:xfrm>
            <a:off x="437357" y="2160589"/>
            <a:ext cx="2333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300</a:t>
            </a:r>
            <a:endParaRPr lang="es-ES" sz="1200"/>
          </a:p>
        </p:txBody>
      </p:sp>
      <p:sp>
        <p:nvSpPr>
          <p:cNvPr id="47" name="Line 45"/>
          <p:cNvSpPr>
            <a:spLocks noChangeShapeType="1"/>
          </p:cNvSpPr>
          <p:nvPr/>
        </p:nvSpPr>
        <p:spPr bwMode="auto">
          <a:xfrm>
            <a:off x="635795" y="6373814"/>
            <a:ext cx="6721476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48" name="Line 46"/>
          <p:cNvSpPr>
            <a:spLocks noChangeShapeType="1"/>
          </p:cNvSpPr>
          <p:nvPr/>
        </p:nvSpPr>
        <p:spPr bwMode="auto">
          <a:xfrm>
            <a:off x="635795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49" name="Line 47"/>
          <p:cNvSpPr>
            <a:spLocks noChangeShapeType="1"/>
          </p:cNvSpPr>
          <p:nvPr/>
        </p:nvSpPr>
        <p:spPr bwMode="auto">
          <a:xfrm>
            <a:off x="1115220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0" name="Line 48"/>
          <p:cNvSpPr>
            <a:spLocks noChangeShapeType="1"/>
          </p:cNvSpPr>
          <p:nvPr/>
        </p:nvSpPr>
        <p:spPr bwMode="auto">
          <a:xfrm>
            <a:off x="1594645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1" name="Line 49"/>
          <p:cNvSpPr>
            <a:spLocks noChangeShapeType="1"/>
          </p:cNvSpPr>
          <p:nvPr/>
        </p:nvSpPr>
        <p:spPr bwMode="auto">
          <a:xfrm>
            <a:off x="2072482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2" name="Line 50"/>
          <p:cNvSpPr>
            <a:spLocks noChangeShapeType="1"/>
          </p:cNvSpPr>
          <p:nvPr/>
        </p:nvSpPr>
        <p:spPr bwMode="auto">
          <a:xfrm>
            <a:off x="2555082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3" name="Line 51"/>
          <p:cNvSpPr>
            <a:spLocks noChangeShapeType="1"/>
          </p:cNvSpPr>
          <p:nvPr/>
        </p:nvSpPr>
        <p:spPr bwMode="auto">
          <a:xfrm>
            <a:off x="3034507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4" name="Line 52"/>
          <p:cNvSpPr>
            <a:spLocks noChangeShapeType="1"/>
          </p:cNvSpPr>
          <p:nvPr/>
        </p:nvSpPr>
        <p:spPr bwMode="auto">
          <a:xfrm>
            <a:off x="3513932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5" name="Line 53"/>
          <p:cNvSpPr>
            <a:spLocks noChangeShapeType="1"/>
          </p:cNvSpPr>
          <p:nvPr/>
        </p:nvSpPr>
        <p:spPr bwMode="auto">
          <a:xfrm>
            <a:off x="3994945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6" name="Line 54"/>
          <p:cNvSpPr>
            <a:spLocks noChangeShapeType="1"/>
          </p:cNvSpPr>
          <p:nvPr/>
        </p:nvSpPr>
        <p:spPr bwMode="auto">
          <a:xfrm>
            <a:off x="4474370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7" name="Line 55"/>
          <p:cNvSpPr>
            <a:spLocks noChangeShapeType="1"/>
          </p:cNvSpPr>
          <p:nvPr/>
        </p:nvSpPr>
        <p:spPr bwMode="auto">
          <a:xfrm>
            <a:off x="4953795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8" name="Line 56"/>
          <p:cNvSpPr>
            <a:spLocks noChangeShapeType="1"/>
          </p:cNvSpPr>
          <p:nvPr/>
        </p:nvSpPr>
        <p:spPr bwMode="auto">
          <a:xfrm>
            <a:off x="5433220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9" name="Line 57"/>
          <p:cNvSpPr>
            <a:spLocks noChangeShapeType="1"/>
          </p:cNvSpPr>
          <p:nvPr/>
        </p:nvSpPr>
        <p:spPr bwMode="auto">
          <a:xfrm>
            <a:off x="5914233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0" name="Line 58"/>
          <p:cNvSpPr>
            <a:spLocks noChangeShapeType="1"/>
          </p:cNvSpPr>
          <p:nvPr/>
        </p:nvSpPr>
        <p:spPr bwMode="auto">
          <a:xfrm>
            <a:off x="6393658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1" name="Line 59"/>
          <p:cNvSpPr>
            <a:spLocks noChangeShapeType="1"/>
          </p:cNvSpPr>
          <p:nvPr/>
        </p:nvSpPr>
        <p:spPr bwMode="auto">
          <a:xfrm>
            <a:off x="6873083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2" name="Line 60"/>
          <p:cNvSpPr>
            <a:spLocks noChangeShapeType="1"/>
          </p:cNvSpPr>
          <p:nvPr/>
        </p:nvSpPr>
        <p:spPr bwMode="auto">
          <a:xfrm>
            <a:off x="7355683" y="6369052"/>
            <a:ext cx="1588" cy="206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3" name="Line 61"/>
          <p:cNvSpPr>
            <a:spLocks noChangeShapeType="1"/>
          </p:cNvSpPr>
          <p:nvPr/>
        </p:nvSpPr>
        <p:spPr bwMode="auto">
          <a:xfrm>
            <a:off x="635795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4" name="Line 62"/>
          <p:cNvSpPr>
            <a:spLocks noChangeShapeType="1"/>
          </p:cNvSpPr>
          <p:nvPr/>
        </p:nvSpPr>
        <p:spPr bwMode="auto">
          <a:xfrm>
            <a:off x="1594645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5" name="Line 63"/>
          <p:cNvSpPr>
            <a:spLocks noChangeShapeType="1"/>
          </p:cNvSpPr>
          <p:nvPr/>
        </p:nvSpPr>
        <p:spPr bwMode="auto">
          <a:xfrm>
            <a:off x="2555082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6" name="Line 64"/>
          <p:cNvSpPr>
            <a:spLocks noChangeShapeType="1"/>
          </p:cNvSpPr>
          <p:nvPr/>
        </p:nvSpPr>
        <p:spPr bwMode="auto">
          <a:xfrm>
            <a:off x="3513932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7" name="Line 65"/>
          <p:cNvSpPr>
            <a:spLocks noChangeShapeType="1"/>
          </p:cNvSpPr>
          <p:nvPr/>
        </p:nvSpPr>
        <p:spPr bwMode="auto">
          <a:xfrm>
            <a:off x="4474370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8" name="Line 66"/>
          <p:cNvSpPr>
            <a:spLocks noChangeShapeType="1"/>
          </p:cNvSpPr>
          <p:nvPr/>
        </p:nvSpPr>
        <p:spPr bwMode="auto">
          <a:xfrm>
            <a:off x="5433220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69" name="Line 67"/>
          <p:cNvSpPr>
            <a:spLocks noChangeShapeType="1"/>
          </p:cNvSpPr>
          <p:nvPr/>
        </p:nvSpPr>
        <p:spPr bwMode="auto">
          <a:xfrm>
            <a:off x="6393658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70" name="Line 68"/>
          <p:cNvSpPr>
            <a:spLocks noChangeShapeType="1"/>
          </p:cNvSpPr>
          <p:nvPr/>
        </p:nvSpPr>
        <p:spPr bwMode="auto">
          <a:xfrm>
            <a:off x="7355683" y="6357939"/>
            <a:ext cx="1588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71" name="Rectangle 69"/>
          <p:cNvSpPr>
            <a:spLocks noChangeArrowheads="1"/>
          </p:cNvSpPr>
          <p:nvPr/>
        </p:nvSpPr>
        <p:spPr bwMode="auto">
          <a:xfrm>
            <a:off x="581820" y="6435727"/>
            <a:ext cx="2809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-200</a:t>
            </a:r>
            <a:endParaRPr lang="es-ES" sz="1200"/>
          </a:p>
        </p:txBody>
      </p:sp>
      <p:sp>
        <p:nvSpPr>
          <p:cNvPr id="72" name="Rectangle 70"/>
          <p:cNvSpPr>
            <a:spLocks noChangeArrowheads="1"/>
          </p:cNvSpPr>
          <p:nvPr/>
        </p:nvSpPr>
        <p:spPr bwMode="auto">
          <a:xfrm>
            <a:off x="1539082" y="6435727"/>
            <a:ext cx="2809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-150</a:t>
            </a:r>
            <a:endParaRPr lang="es-ES" sz="1200"/>
          </a:p>
        </p:txBody>
      </p:sp>
      <p:sp>
        <p:nvSpPr>
          <p:cNvPr id="73" name="Rectangle 71"/>
          <p:cNvSpPr>
            <a:spLocks noChangeArrowheads="1"/>
          </p:cNvSpPr>
          <p:nvPr/>
        </p:nvSpPr>
        <p:spPr bwMode="auto">
          <a:xfrm>
            <a:off x="2501107" y="6435727"/>
            <a:ext cx="2809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-100</a:t>
            </a:r>
            <a:endParaRPr lang="es-ES" sz="1200"/>
          </a:p>
        </p:txBody>
      </p:sp>
      <p:sp>
        <p:nvSpPr>
          <p:cNvPr id="74" name="Rectangle 72"/>
          <p:cNvSpPr>
            <a:spLocks noChangeArrowheads="1"/>
          </p:cNvSpPr>
          <p:nvPr/>
        </p:nvSpPr>
        <p:spPr bwMode="auto">
          <a:xfrm>
            <a:off x="3474245" y="6435727"/>
            <a:ext cx="2032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-50</a:t>
            </a:r>
            <a:endParaRPr lang="es-ES" sz="1200"/>
          </a:p>
        </p:txBody>
      </p:sp>
      <p:sp>
        <p:nvSpPr>
          <p:cNvPr id="75" name="Rectangle 73"/>
          <p:cNvSpPr>
            <a:spLocks noChangeArrowheads="1"/>
          </p:cNvSpPr>
          <p:nvPr/>
        </p:nvSpPr>
        <p:spPr bwMode="auto">
          <a:xfrm>
            <a:off x="4461670" y="6435727"/>
            <a:ext cx="777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0</a:t>
            </a:r>
            <a:endParaRPr lang="es-ES" sz="1200"/>
          </a:p>
        </p:txBody>
      </p:sp>
      <p:sp>
        <p:nvSpPr>
          <p:cNvPr id="76" name="Rectangle 74"/>
          <p:cNvSpPr>
            <a:spLocks noChangeArrowheads="1"/>
          </p:cNvSpPr>
          <p:nvPr/>
        </p:nvSpPr>
        <p:spPr bwMode="auto">
          <a:xfrm>
            <a:off x="5404645" y="6435727"/>
            <a:ext cx="15557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50</a:t>
            </a:r>
            <a:endParaRPr lang="es-ES" sz="1200"/>
          </a:p>
        </p:txBody>
      </p:sp>
      <p:sp>
        <p:nvSpPr>
          <p:cNvPr id="77" name="Rectangle 75"/>
          <p:cNvSpPr>
            <a:spLocks noChangeArrowheads="1"/>
          </p:cNvSpPr>
          <p:nvPr/>
        </p:nvSpPr>
        <p:spPr bwMode="auto">
          <a:xfrm>
            <a:off x="6349208" y="6435727"/>
            <a:ext cx="2333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100</a:t>
            </a:r>
            <a:endParaRPr lang="es-ES" sz="1200"/>
          </a:p>
        </p:txBody>
      </p:sp>
      <p:sp>
        <p:nvSpPr>
          <p:cNvPr id="78" name="Rectangle 76"/>
          <p:cNvSpPr>
            <a:spLocks noChangeArrowheads="1"/>
          </p:cNvSpPr>
          <p:nvPr/>
        </p:nvSpPr>
        <p:spPr bwMode="auto">
          <a:xfrm>
            <a:off x="7311233" y="6435727"/>
            <a:ext cx="2333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150</a:t>
            </a:r>
            <a:endParaRPr lang="es-ES" sz="1200"/>
          </a:p>
        </p:txBody>
      </p:sp>
      <p:sp>
        <p:nvSpPr>
          <p:cNvPr id="80" name="Rectangle 78"/>
          <p:cNvSpPr>
            <a:spLocks noChangeArrowheads="1"/>
          </p:cNvSpPr>
          <p:nvPr/>
        </p:nvSpPr>
        <p:spPr bwMode="auto">
          <a:xfrm>
            <a:off x="7398545" y="6557964"/>
            <a:ext cx="635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s</a:t>
            </a:r>
            <a:endParaRPr lang="es-ES" sz="1200"/>
          </a:p>
        </p:txBody>
      </p:sp>
      <p:sp>
        <p:nvSpPr>
          <p:cNvPr id="81" name="Rectangle 79"/>
          <p:cNvSpPr>
            <a:spLocks noChangeArrowheads="1"/>
          </p:cNvSpPr>
          <p:nvPr/>
        </p:nvSpPr>
        <p:spPr bwMode="auto">
          <a:xfrm>
            <a:off x="3809207" y="6557964"/>
            <a:ext cx="31591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b="1">
                <a:solidFill>
                  <a:srgbClr val="000000"/>
                </a:solidFill>
              </a:rPr>
              <a:t>Time</a:t>
            </a:r>
            <a:endParaRPr lang="es-ES" sz="1200"/>
          </a:p>
        </p:txBody>
      </p:sp>
      <p:sp>
        <p:nvSpPr>
          <p:cNvPr id="82" name="Rectangle 80"/>
          <p:cNvSpPr>
            <a:spLocks noChangeArrowheads="1"/>
          </p:cNvSpPr>
          <p:nvPr/>
        </p:nvSpPr>
        <p:spPr bwMode="auto">
          <a:xfrm>
            <a:off x="411957" y="2038352"/>
            <a:ext cx="1825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>
                <a:solidFill>
                  <a:srgbClr val="000000"/>
                </a:solidFill>
              </a:rPr>
              <a:t>RU</a:t>
            </a:r>
            <a:endParaRPr lang="es-ES" sz="1200"/>
          </a:p>
        </p:txBody>
      </p:sp>
      <p:sp>
        <p:nvSpPr>
          <p:cNvPr id="83" name="Rectangle 81"/>
          <p:cNvSpPr>
            <a:spLocks noChangeArrowheads="1"/>
          </p:cNvSpPr>
          <p:nvPr/>
        </p:nvSpPr>
        <p:spPr bwMode="auto">
          <a:xfrm rot="5400000">
            <a:off x="-48418" y="4540251"/>
            <a:ext cx="65405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sz="1200" b="1">
                <a:solidFill>
                  <a:srgbClr val="000000"/>
                </a:solidFill>
              </a:rPr>
              <a:t>Resp. Diff.</a:t>
            </a:r>
            <a:endParaRPr lang="es-ES" sz="1200"/>
          </a:p>
        </p:txBody>
      </p:sp>
      <p:sp>
        <p:nvSpPr>
          <p:cNvPr id="95" name="Freeform 93"/>
          <p:cNvSpPr>
            <a:spLocks/>
          </p:cNvSpPr>
          <p:nvPr/>
        </p:nvSpPr>
        <p:spPr bwMode="auto">
          <a:xfrm>
            <a:off x="672307" y="3141664"/>
            <a:ext cx="6626226" cy="2679700"/>
          </a:xfrm>
          <a:custGeom>
            <a:avLst/>
            <a:gdLst>
              <a:gd name="T0" fmla="*/ 60 w 4174"/>
              <a:gd name="T1" fmla="*/ 1162 h 1688"/>
              <a:gd name="T2" fmla="*/ 133 w 4174"/>
              <a:gd name="T3" fmla="*/ 1162 h 1688"/>
              <a:gd name="T4" fmla="*/ 205 w 4174"/>
              <a:gd name="T5" fmla="*/ 1155 h 1688"/>
              <a:gd name="T6" fmla="*/ 279 w 4174"/>
              <a:gd name="T7" fmla="*/ 1284 h 1688"/>
              <a:gd name="T8" fmla="*/ 350 w 4174"/>
              <a:gd name="T9" fmla="*/ 1135 h 1688"/>
              <a:gd name="T10" fmla="*/ 424 w 4174"/>
              <a:gd name="T11" fmla="*/ 1060 h 1688"/>
              <a:gd name="T12" fmla="*/ 496 w 4174"/>
              <a:gd name="T13" fmla="*/ 1008 h 1688"/>
              <a:gd name="T14" fmla="*/ 569 w 4174"/>
              <a:gd name="T15" fmla="*/ 959 h 1688"/>
              <a:gd name="T16" fmla="*/ 641 w 4174"/>
              <a:gd name="T17" fmla="*/ 918 h 1688"/>
              <a:gd name="T18" fmla="*/ 714 w 4174"/>
              <a:gd name="T19" fmla="*/ 887 h 1688"/>
              <a:gd name="T20" fmla="*/ 786 w 4174"/>
              <a:gd name="T21" fmla="*/ 863 h 1688"/>
              <a:gd name="T22" fmla="*/ 860 w 4174"/>
              <a:gd name="T23" fmla="*/ 842 h 1688"/>
              <a:gd name="T24" fmla="*/ 931 w 4174"/>
              <a:gd name="T25" fmla="*/ 817 h 1688"/>
              <a:gd name="T26" fmla="*/ 1005 w 4174"/>
              <a:gd name="T27" fmla="*/ 799 h 1688"/>
              <a:gd name="T28" fmla="*/ 1077 w 4174"/>
              <a:gd name="T29" fmla="*/ 773 h 1688"/>
              <a:gd name="T30" fmla="*/ 1150 w 4174"/>
              <a:gd name="T31" fmla="*/ 754 h 1688"/>
              <a:gd name="T32" fmla="*/ 1222 w 4174"/>
              <a:gd name="T33" fmla="*/ 734 h 1688"/>
              <a:gd name="T34" fmla="*/ 1295 w 4174"/>
              <a:gd name="T35" fmla="*/ 716 h 1688"/>
              <a:gd name="T36" fmla="*/ 1367 w 4174"/>
              <a:gd name="T37" fmla="*/ 698 h 1688"/>
              <a:gd name="T38" fmla="*/ 1440 w 4174"/>
              <a:gd name="T39" fmla="*/ 680 h 1688"/>
              <a:gd name="T40" fmla="*/ 1512 w 4174"/>
              <a:gd name="T41" fmla="*/ 666 h 1688"/>
              <a:gd name="T42" fmla="*/ 1586 w 4174"/>
              <a:gd name="T43" fmla="*/ 648 h 1688"/>
              <a:gd name="T44" fmla="*/ 1657 w 4174"/>
              <a:gd name="T45" fmla="*/ 636 h 1688"/>
              <a:gd name="T46" fmla="*/ 1731 w 4174"/>
              <a:gd name="T47" fmla="*/ 622 h 1688"/>
              <a:gd name="T48" fmla="*/ 1803 w 4174"/>
              <a:gd name="T49" fmla="*/ 607 h 1688"/>
              <a:gd name="T50" fmla="*/ 1876 w 4174"/>
              <a:gd name="T51" fmla="*/ 594 h 1688"/>
              <a:gd name="T52" fmla="*/ 1948 w 4174"/>
              <a:gd name="T53" fmla="*/ 581 h 1688"/>
              <a:gd name="T54" fmla="*/ 2021 w 4174"/>
              <a:gd name="T55" fmla="*/ 566 h 1688"/>
              <a:gd name="T56" fmla="*/ 2093 w 4174"/>
              <a:gd name="T57" fmla="*/ 555 h 1688"/>
              <a:gd name="T58" fmla="*/ 2165 w 4174"/>
              <a:gd name="T59" fmla="*/ 542 h 1688"/>
              <a:gd name="T60" fmla="*/ 2238 w 4174"/>
              <a:gd name="T61" fmla="*/ 529 h 1688"/>
              <a:gd name="T62" fmla="*/ 2310 w 4174"/>
              <a:gd name="T63" fmla="*/ 519 h 1688"/>
              <a:gd name="T64" fmla="*/ 2384 w 4174"/>
              <a:gd name="T65" fmla="*/ 524 h 1688"/>
              <a:gd name="T66" fmla="*/ 2455 w 4174"/>
              <a:gd name="T67" fmla="*/ 542 h 1688"/>
              <a:gd name="T68" fmla="*/ 2529 w 4174"/>
              <a:gd name="T69" fmla="*/ 556 h 1688"/>
              <a:gd name="T70" fmla="*/ 2601 w 4174"/>
              <a:gd name="T71" fmla="*/ 569 h 1688"/>
              <a:gd name="T72" fmla="*/ 2674 w 4174"/>
              <a:gd name="T73" fmla="*/ 579 h 1688"/>
              <a:gd name="T74" fmla="*/ 2746 w 4174"/>
              <a:gd name="T75" fmla="*/ 587 h 1688"/>
              <a:gd name="T76" fmla="*/ 2819 w 4174"/>
              <a:gd name="T77" fmla="*/ 595 h 1688"/>
              <a:gd name="T78" fmla="*/ 2891 w 4174"/>
              <a:gd name="T79" fmla="*/ 600 h 1688"/>
              <a:gd name="T80" fmla="*/ 2965 w 4174"/>
              <a:gd name="T81" fmla="*/ 604 h 1688"/>
              <a:gd name="T82" fmla="*/ 3036 w 4174"/>
              <a:gd name="T83" fmla="*/ 609 h 1688"/>
              <a:gd name="T84" fmla="*/ 3110 w 4174"/>
              <a:gd name="T85" fmla="*/ 605 h 1688"/>
              <a:gd name="T86" fmla="*/ 3182 w 4174"/>
              <a:gd name="T87" fmla="*/ 607 h 1688"/>
              <a:gd name="T88" fmla="*/ 3255 w 4174"/>
              <a:gd name="T89" fmla="*/ 607 h 1688"/>
              <a:gd name="T90" fmla="*/ 3327 w 4174"/>
              <a:gd name="T91" fmla="*/ 607 h 1688"/>
              <a:gd name="T92" fmla="*/ 3400 w 4174"/>
              <a:gd name="T93" fmla="*/ 609 h 1688"/>
              <a:gd name="T94" fmla="*/ 3472 w 4174"/>
              <a:gd name="T95" fmla="*/ 610 h 1688"/>
              <a:gd name="T96" fmla="*/ 3545 w 4174"/>
              <a:gd name="T97" fmla="*/ 607 h 1688"/>
              <a:gd name="T98" fmla="*/ 3617 w 4174"/>
              <a:gd name="T99" fmla="*/ 607 h 1688"/>
              <a:gd name="T100" fmla="*/ 3691 w 4174"/>
              <a:gd name="T101" fmla="*/ 610 h 1688"/>
              <a:gd name="T102" fmla="*/ 3762 w 4174"/>
              <a:gd name="T103" fmla="*/ 610 h 1688"/>
              <a:gd name="T104" fmla="*/ 3836 w 4174"/>
              <a:gd name="T105" fmla="*/ 610 h 1688"/>
              <a:gd name="T106" fmla="*/ 3908 w 4174"/>
              <a:gd name="T107" fmla="*/ 610 h 1688"/>
              <a:gd name="T108" fmla="*/ 3981 w 4174"/>
              <a:gd name="T109" fmla="*/ 609 h 1688"/>
              <a:gd name="T110" fmla="*/ 4053 w 4174"/>
              <a:gd name="T111" fmla="*/ 605 h 1688"/>
              <a:gd name="T112" fmla="*/ 4126 w 4174"/>
              <a:gd name="T113" fmla="*/ 609 h 16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688">
                <a:moveTo>
                  <a:pt x="0" y="1162"/>
                </a:moveTo>
                <a:lnTo>
                  <a:pt x="13" y="1162"/>
                </a:lnTo>
                <a:lnTo>
                  <a:pt x="24" y="1163"/>
                </a:lnTo>
                <a:lnTo>
                  <a:pt x="37" y="1163"/>
                </a:lnTo>
                <a:lnTo>
                  <a:pt x="49" y="1162"/>
                </a:lnTo>
                <a:lnTo>
                  <a:pt x="60" y="1162"/>
                </a:lnTo>
                <a:lnTo>
                  <a:pt x="73" y="1162"/>
                </a:lnTo>
                <a:lnTo>
                  <a:pt x="85" y="1162"/>
                </a:lnTo>
                <a:lnTo>
                  <a:pt x="98" y="1162"/>
                </a:lnTo>
                <a:lnTo>
                  <a:pt x="109" y="1162"/>
                </a:lnTo>
                <a:lnTo>
                  <a:pt x="120" y="1162"/>
                </a:lnTo>
                <a:lnTo>
                  <a:pt x="133" y="1162"/>
                </a:lnTo>
                <a:lnTo>
                  <a:pt x="145" y="1162"/>
                </a:lnTo>
                <a:lnTo>
                  <a:pt x="158" y="1165"/>
                </a:lnTo>
                <a:lnTo>
                  <a:pt x="169" y="1162"/>
                </a:lnTo>
                <a:lnTo>
                  <a:pt x="182" y="1153"/>
                </a:lnTo>
                <a:lnTo>
                  <a:pt x="194" y="1152"/>
                </a:lnTo>
                <a:lnTo>
                  <a:pt x="205" y="1155"/>
                </a:lnTo>
                <a:lnTo>
                  <a:pt x="218" y="1165"/>
                </a:lnTo>
                <a:lnTo>
                  <a:pt x="230" y="1171"/>
                </a:lnTo>
                <a:lnTo>
                  <a:pt x="243" y="941"/>
                </a:lnTo>
                <a:lnTo>
                  <a:pt x="254" y="77"/>
                </a:lnTo>
                <a:lnTo>
                  <a:pt x="266" y="0"/>
                </a:lnTo>
                <a:lnTo>
                  <a:pt x="279" y="1284"/>
                </a:lnTo>
                <a:lnTo>
                  <a:pt x="290" y="1688"/>
                </a:lnTo>
                <a:lnTo>
                  <a:pt x="303" y="1491"/>
                </a:lnTo>
                <a:lnTo>
                  <a:pt x="315" y="1302"/>
                </a:lnTo>
                <a:lnTo>
                  <a:pt x="328" y="1207"/>
                </a:lnTo>
                <a:lnTo>
                  <a:pt x="339" y="1162"/>
                </a:lnTo>
                <a:lnTo>
                  <a:pt x="350" y="1135"/>
                </a:lnTo>
                <a:lnTo>
                  <a:pt x="364" y="1119"/>
                </a:lnTo>
                <a:lnTo>
                  <a:pt x="375" y="1104"/>
                </a:lnTo>
                <a:lnTo>
                  <a:pt x="388" y="1091"/>
                </a:lnTo>
                <a:lnTo>
                  <a:pt x="399" y="1082"/>
                </a:lnTo>
                <a:lnTo>
                  <a:pt x="411" y="1070"/>
                </a:lnTo>
                <a:lnTo>
                  <a:pt x="424" y="1060"/>
                </a:lnTo>
                <a:lnTo>
                  <a:pt x="435" y="1051"/>
                </a:lnTo>
                <a:lnTo>
                  <a:pt x="448" y="1042"/>
                </a:lnTo>
                <a:lnTo>
                  <a:pt x="460" y="1034"/>
                </a:lnTo>
                <a:lnTo>
                  <a:pt x="471" y="1024"/>
                </a:lnTo>
                <a:lnTo>
                  <a:pt x="484" y="1016"/>
                </a:lnTo>
                <a:lnTo>
                  <a:pt x="496" y="1008"/>
                </a:lnTo>
                <a:lnTo>
                  <a:pt x="509" y="1000"/>
                </a:lnTo>
                <a:lnTo>
                  <a:pt x="520" y="990"/>
                </a:lnTo>
                <a:lnTo>
                  <a:pt x="533" y="984"/>
                </a:lnTo>
                <a:lnTo>
                  <a:pt x="545" y="976"/>
                </a:lnTo>
                <a:lnTo>
                  <a:pt x="556" y="966"/>
                </a:lnTo>
                <a:lnTo>
                  <a:pt x="569" y="959"/>
                </a:lnTo>
                <a:lnTo>
                  <a:pt x="581" y="951"/>
                </a:lnTo>
                <a:lnTo>
                  <a:pt x="594" y="945"/>
                </a:lnTo>
                <a:lnTo>
                  <a:pt x="605" y="936"/>
                </a:lnTo>
                <a:lnTo>
                  <a:pt x="616" y="932"/>
                </a:lnTo>
                <a:lnTo>
                  <a:pt x="629" y="925"/>
                </a:lnTo>
                <a:lnTo>
                  <a:pt x="641" y="918"/>
                </a:lnTo>
                <a:lnTo>
                  <a:pt x="654" y="912"/>
                </a:lnTo>
                <a:lnTo>
                  <a:pt x="665" y="909"/>
                </a:lnTo>
                <a:lnTo>
                  <a:pt x="678" y="904"/>
                </a:lnTo>
                <a:lnTo>
                  <a:pt x="690" y="901"/>
                </a:lnTo>
                <a:lnTo>
                  <a:pt x="701" y="894"/>
                </a:lnTo>
                <a:lnTo>
                  <a:pt x="714" y="887"/>
                </a:lnTo>
                <a:lnTo>
                  <a:pt x="726" y="884"/>
                </a:lnTo>
                <a:lnTo>
                  <a:pt x="739" y="879"/>
                </a:lnTo>
                <a:lnTo>
                  <a:pt x="750" y="874"/>
                </a:lnTo>
                <a:lnTo>
                  <a:pt x="762" y="870"/>
                </a:lnTo>
                <a:lnTo>
                  <a:pt x="775" y="866"/>
                </a:lnTo>
                <a:lnTo>
                  <a:pt x="786" y="863"/>
                </a:lnTo>
                <a:lnTo>
                  <a:pt x="799" y="860"/>
                </a:lnTo>
                <a:lnTo>
                  <a:pt x="811" y="856"/>
                </a:lnTo>
                <a:lnTo>
                  <a:pt x="824" y="852"/>
                </a:lnTo>
                <a:lnTo>
                  <a:pt x="835" y="848"/>
                </a:lnTo>
                <a:lnTo>
                  <a:pt x="847" y="845"/>
                </a:lnTo>
                <a:lnTo>
                  <a:pt x="860" y="842"/>
                </a:lnTo>
                <a:lnTo>
                  <a:pt x="871" y="837"/>
                </a:lnTo>
                <a:lnTo>
                  <a:pt x="884" y="834"/>
                </a:lnTo>
                <a:lnTo>
                  <a:pt x="895" y="829"/>
                </a:lnTo>
                <a:lnTo>
                  <a:pt x="907" y="825"/>
                </a:lnTo>
                <a:lnTo>
                  <a:pt x="920" y="822"/>
                </a:lnTo>
                <a:lnTo>
                  <a:pt x="931" y="817"/>
                </a:lnTo>
                <a:lnTo>
                  <a:pt x="944" y="814"/>
                </a:lnTo>
                <a:lnTo>
                  <a:pt x="956" y="812"/>
                </a:lnTo>
                <a:lnTo>
                  <a:pt x="967" y="809"/>
                </a:lnTo>
                <a:lnTo>
                  <a:pt x="980" y="806"/>
                </a:lnTo>
                <a:lnTo>
                  <a:pt x="992" y="803"/>
                </a:lnTo>
                <a:lnTo>
                  <a:pt x="1005" y="799"/>
                </a:lnTo>
                <a:lnTo>
                  <a:pt x="1016" y="796"/>
                </a:lnTo>
                <a:lnTo>
                  <a:pt x="1029" y="793"/>
                </a:lnTo>
                <a:lnTo>
                  <a:pt x="1041" y="788"/>
                </a:lnTo>
                <a:lnTo>
                  <a:pt x="1052" y="783"/>
                </a:lnTo>
                <a:lnTo>
                  <a:pt x="1065" y="778"/>
                </a:lnTo>
                <a:lnTo>
                  <a:pt x="1077" y="773"/>
                </a:lnTo>
                <a:lnTo>
                  <a:pt x="1090" y="770"/>
                </a:lnTo>
                <a:lnTo>
                  <a:pt x="1101" y="767"/>
                </a:lnTo>
                <a:lnTo>
                  <a:pt x="1112" y="763"/>
                </a:lnTo>
                <a:lnTo>
                  <a:pt x="1126" y="760"/>
                </a:lnTo>
                <a:lnTo>
                  <a:pt x="1137" y="757"/>
                </a:lnTo>
                <a:lnTo>
                  <a:pt x="1150" y="754"/>
                </a:lnTo>
                <a:lnTo>
                  <a:pt x="1161" y="749"/>
                </a:lnTo>
                <a:lnTo>
                  <a:pt x="1174" y="747"/>
                </a:lnTo>
                <a:lnTo>
                  <a:pt x="1186" y="744"/>
                </a:lnTo>
                <a:lnTo>
                  <a:pt x="1197" y="741"/>
                </a:lnTo>
                <a:lnTo>
                  <a:pt x="1210" y="737"/>
                </a:lnTo>
                <a:lnTo>
                  <a:pt x="1222" y="734"/>
                </a:lnTo>
                <a:lnTo>
                  <a:pt x="1235" y="731"/>
                </a:lnTo>
                <a:lnTo>
                  <a:pt x="1246" y="729"/>
                </a:lnTo>
                <a:lnTo>
                  <a:pt x="1258" y="726"/>
                </a:lnTo>
                <a:lnTo>
                  <a:pt x="1271" y="723"/>
                </a:lnTo>
                <a:lnTo>
                  <a:pt x="1282" y="719"/>
                </a:lnTo>
                <a:lnTo>
                  <a:pt x="1295" y="716"/>
                </a:lnTo>
                <a:lnTo>
                  <a:pt x="1307" y="715"/>
                </a:lnTo>
                <a:lnTo>
                  <a:pt x="1318" y="711"/>
                </a:lnTo>
                <a:lnTo>
                  <a:pt x="1331" y="708"/>
                </a:lnTo>
                <a:lnTo>
                  <a:pt x="1343" y="705"/>
                </a:lnTo>
                <a:lnTo>
                  <a:pt x="1356" y="703"/>
                </a:lnTo>
                <a:lnTo>
                  <a:pt x="1367" y="698"/>
                </a:lnTo>
                <a:lnTo>
                  <a:pt x="1380" y="697"/>
                </a:lnTo>
                <a:lnTo>
                  <a:pt x="1392" y="693"/>
                </a:lnTo>
                <a:lnTo>
                  <a:pt x="1403" y="690"/>
                </a:lnTo>
                <a:lnTo>
                  <a:pt x="1416" y="687"/>
                </a:lnTo>
                <a:lnTo>
                  <a:pt x="1427" y="684"/>
                </a:lnTo>
                <a:lnTo>
                  <a:pt x="1440" y="680"/>
                </a:lnTo>
                <a:lnTo>
                  <a:pt x="1452" y="679"/>
                </a:lnTo>
                <a:lnTo>
                  <a:pt x="1463" y="675"/>
                </a:lnTo>
                <a:lnTo>
                  <a:pt x="1476" y="674"/>
                </a:lnTo>
                <a:lnTo>
                  <a:pt x="1488" y="671"/>
                </a:lnTo>
                <a:lnTo>
                  <a:pt x="1501" y="667"/>
                </a:lnTo>
                <a:lnTo>
                  <a:pt x="1512" y="666"/>
                </a:lnTo>
                <a:lnTo>
                  <a:pt x="1525" y="664"/>
                </a:lnTo>
                <a:lnTo>
                  <a:pt x="1537" y="661"/>
                </a:lnTo>
                <a:lnTo>
                  <a:pt x="1548" y="657"/>
                </a:lnTo>
                <a:lnTo>
                  <a:pt x="1561" y="656"/>
                </a:lnTo>
                <a:lnTo>
                  <a:pt x="1573" y="651"/>
                </a:lnTo>
                <a:lnTo>
                  <a:pt x="1586" y="648"/>
                </a:lnTo>
                <a:lnTo>
                  <a:pt x="1597" y="646"/>
                </a:lnTo>
                <a:lnTo>
                  <a:pt x="1609" y="643"/>
                </a:lnTo>
                <a:lnTo>
                  <a:pt x="1622" y="641"/>
                </a:lnTo>
                <a:lnTo>
                  <a:pt x="1633" y="641"/>
                </a:lnTo>
                <a:lnTo>
                  <a:pt x="1646" y="638"/>
                </a:lnTo>
                <a:lnTo>
                  <a:pt x="1657" y="636"/>
                </a:lnTo>
                <a:lnTo>
                  <a:pt x="1671" y="633"/>
                </a:lnTo>
                <a:lnTo>
                  <a:pt x="1682" y="631"/>
                </a:lnTo>
                <a:lnTo>
                  <a:pt x="1693" y="628"/>
                </a:lnTo>
                <a:lnTo>
                  <a:pt x="1706" y="626"/>
                </a:lnTo>
                <a:lnTo>
                  <a:pt x="1718" y="623"/>
                </a:lnTo>
                <a:lnTo>
                  <a:pt x="1731" y="622"/>
                </a:lnTo>
                <a:lnTo>
                  <a:pt x="1742" y="620"/>
                </a:lnTo>
                <a:lnTo>
                  <a:pt x="1754" y="617"/>
                </a:lnTo>
                <a:lnTo>
                  <a:pt x="1767" y="615"/>
                </a:lnTo>
                <a:lnTo>
                  <a:pt x="1778" y="612"/>
                </a:lnTo>
                <a:lnTo>
                  <a:pt x="1791" y="610"/>
                </a:lnTo>
                <a:lnTo>
                  <a:pt x="1803" y="607"/>
                </a:lnTo>
                <a:lnTo>
                  <a:pt x="1814" y="605"/>
                </a:lnTo>
                <a:lnTo>
                  <a:pt x="1827" y="602"/>
                </a:lnTo>
                <a:lnTo>
                  <a:pt x="1839" y="600"/>
                </a:lnTo>
                <a:lnTo>
                  <a:pt x="1852" y="597"/>
                </a:lnTo>
                <a:lnTo>
                  <a:pt x="1863" y="595"/>
                </a:lnTo>
                <a:lnTo>
                  <a:pt x="1876" y="594"/>
                </a:lnTo>
                <a:lnTo>
                  <a:pt x="1888" y="592"/>
                </a:lnTo>
                <a:lnTo>
                  <a:pt x="1899" y="589"/>
                </a:lnTo>
                <a:lnTo>
                  <a:pt x="1912" y="587"/>
                </a:lnTo>
                <a:lnTo>
                  <a:pt x="1923" y="586"/>
                </a:lnTo>
                <a:lnTo>
                  <a:pt x="1937" y="584"/>
                </a:lnTo>
                <a:lnTo>
                  <a:pt x="1948" y="581"/>
                </a:lnTo>
                <a:lnTo>
                  <a:pt x="1959" y="579"/>
                </a:lnTo>
                <a:lnTo>
                  <a:pt x="1972" y="576"/>
                </a:lnTo>
                <a:lnTo>
                  <a:pt x="1984" y="574"/>
                </a:lnTo>
                <a:lnTo>
                  <a:pt x="1997" y="573"/>
                </a:lnTo>
                <a:lnTo>
                  <a:pt x="2008" y="569"/>
                </a:lnTo>
                <a:lnTo>
                  <a:pt x="2021" y="566"/>
                </a:lnTo>
                <a:lnTo>
                  <a:pt x="2033" y="566"/>
                </a:lnTo>
                <a:lnTo>
                  <a:pt x="2044" y="563"/>
                </a:lnTo>
                <a:lnTo>
                  <a:pt x="2057" y="561"/>
                </a:lnTo>
                <a:lnTo>
                  <a:pt x="2069" y="560"/>
                </a:lnTo>
                <a:lnTo>
                  <a:pt x="2082" y="558"/>
                </a:lnTo>
                <a:lnTo>
                  <a:pt x="2093" y="555"/>
                </a:lnTo>
                <a:lnTo>
                  <a:pt x="2105" y="551"/>
                </a:lnTo>
                <a:lnTo>
                  <a:pt x="2118" y="548"/>
                </a:lnTo>
                <a:lnTo>
                  <a:pt x="2129" y="550"/>
                </a:lnTo>
                <a:lnTo>
                  <a:pt x="2142" y="547"/>
                </a:lnTo>
                <a:lnTo>
                  <a:pt x="2154" y="545"/>
                </a:lnTo>
                <a:lnTo>
                  <a:pt x="2165" y="542"/>
                </a:lnTo>
                <a:lnTo>
                  <a:pt x="2178" y="538"/>
                </a:lnTo>
                <a:lnTo>
                  <a:pt x="2189" y="537"/>
                </a:lnTo>
                <a:lnTo>
                  <a:pt x="2202" y="535"/>
                </a:lnTo>
                <a:lnTo>
                  <a:pt x="2214" y="533"/>
                </a:lnTo>
                <a:lnTo>
                  <a:pt x="2227" y="532"/>
                </a:lnTo>
                <a:lnTo>
                  <a:pt x="2238" y="529"/>
                </a:lnTo>
                <a:lnTo>
                  <a:pt x="2250" y="529"/>
                </a:lnTo>
                <a:lnTo>
                  <a:pt x="2263" y="527"/>
                </a:lnTo>
                <a:lnTo>
                  <a:pt x="2274" y="525"/>
                </a:lnTo>
                <a:lnTo>
                  <a:pt x="2287" y="522"/>
                </a:lnTo>
                <a:lnTo>
                  <a:pt x="2299" y="520"/>
                </a:lnTo>
                <a:lnTo>
                  <a:pt x="2310" y="519"/>
                </a:lnTo>
                <a:lnTo>
                  <a:pt x="2323" y="516"/>
                </a:lnTo>
                <a:lnTo>
                  <a:pt x="2335" y="516"/>
                </a:lnTo>
                <a:lnTo>
                  <a:pt x="2348" y="517"/>
                </a:lnTo>
                <a:lnTo>
                  <a:pt x="2359" y="524"/>
                </a:lnTo>
                <a:lnTo>
                  <a:pt x="2372" y="525"/>
                </a:lnTo>
                <a:lnTo>
                  <a:pt x="2384" y="524"/>
                </a:lnTo>
                <a:lnTo>
                  <a:pt x="2395" y="597"/>
                </a:lnTo>
                <a:lnTo>
                  <a:pt x="2408" y="597"/>
                </a:lnTo>
                <a:lnTo>
                  <a:pt x="2420" y="574"/>
                </a:lnTo>
                <a:lnTo>
                  <a:pt x="2433" y="553"/>
                </a:lnTo>
                <a:lnTo>
                  <a:pt x="2444" y="545"/>
                </a:lnTo>
                <a:lnTo>
                  <a:pt x="2455" y="542"/>
                </a:lnTo>
                <a:lnTo>
                  <a:pt x="2468" y="543"/>
                </a:lnTo>
                <a:lnTo>
                  <a:pt x="2480" y="547"/>
                </a:lnTo>
                <a:lnTo>
                  <a:pt x="2493" y="550"/>
                </a:lnTo>
                <a:lnTo>
                  <a:pt x="2504" y="550"/>
                </a:lnTo>
                <a:lnTo>
                  <a:pt x="2517" y="553"/>
                </a:lnTo>
                <a:lnTo>
                  <a:pt x="2529" y="556"/>
                </a:lnTo>
                <a:lnTo>
                  <a:pt x="2540" y="560"/>
                </a:lnTo>
                <a:lnTo>
                  <a:pt x="2553" y="561"/>
                </a:lnTo>
                <a:lnTo>
                  <a:pt x="2565" y="564"/>
                </a:lnTo>
                <a:lnTo>
                  <a:pt x="2578" y="566"/>
                </a:lnTo>
                <a:lnTo>
                  <a:pt x="2589" y="568"/>
                </a:lnTo>
                <a:lnTo>
                  <a:pt x="2601" y="569"/>
                </a:lnTo>
                <a:lnTo>
                  <a:pt x="2614" y="573"/>
                </a:lnTo>
                <a:lnTo>
                  <a:pt x="2625" y="574"/>
                </a:lnTo>
                <a:lnTo>
                  <a:pt x="2638" y="576"/>
                </a:lnTo>
                <a:lnTo>
                  <a:pt x="2650" y="578"/>
                </a:lnTo>
                <a:lnTo>
                  <a:pt x="2661" y="578"/>
                </a:lnTo>
                <a:lnTo>
                  <a:pt x="2674" y="579"/>
                </a:lnTo>
                <a:lnTo>
                  <a:pt x="2685" y="582"/>
                </a:lnTo>
                <a:lnTo>
                  <a:pt x="2699" y="582"/>
                </a:lnTo>
                <a:lnTo>
                  <a:pt x="2710" y="584"/>
                </a:lnTo>
                <a:lnTo>
                  <a:pt x="2723" y="586"/>
                </a:lnTo>
                <a:lnTo>
                  <a:pt x="2734" y="587"/>
                </a:lnTo>
                <a:lnTo>
                  <a:pt x="2746" y="587"/>
                </a:lnTo>
                <a:lnTo>
                  <a:pt x="2759" y="589"/>
                </a:lnTo>
                <a:lnTo>
                  <a:pt x="2770" y="591"/>
                </a:lnTo>
                <a:lnTo>
                  <a:pt x="2783" y="592"/>
                </a:lnTo>
                <a:lnTo>
                  <a:pt x="2795" y="594"/>
                </a:lnTo>
                <a:lnTo>
                  <a:pt x="2806" y="595"/>
                </a:lnTo>
                <a:lnTo>
                  <a:pt x="2819" y="595"/>
                </a:lnTo>
                <a:lnTo>
                  <a:pt x="2831" y="595"/>
                </a:lnTo>
                <a:lnTo>
                  <a:pt x="2844" y="595"/>
                </a:lnTo>
                <a:lnTo>
                  <a:pt x="2855" y="597"/>
                </a:lnTo>
                <a:lnTo>
                  <a:pt x="2868" y="599"/>
                </a:lnTo>
                <a:lnTo>
                  <a:pt x="2880" y="600"/>
                </a:lnTo>
                <a:lnTo>
                  <a:pt x="2891" y="600"/>
                </a:lnTo>
                <a:lnTo>
                  <a:pt x="2904" y="600"/>
                </a:lnTo>
                <a:lnTo>
                  <a:pt x="2916" y="600"/>
                </a:lnTo>
                <a:lnTo>
                  <a:pt x="2929" y="602"/>
                </a:lnTo>
                <a:lnTo>
                  <a:pt x="2940" y="602"/>
                </a:lnTo>
                <a:lnTo>
                  <a:pt x="2951" y="602"/>
                </a:lnTo>
                <a:lnTo>
                  <a:pt x="2965" y="604"/>
                </a:lnTo>
                <a:lnTo>
                  <a:pt x="2976" y="604"/>
                </a:lnTo>
                <a:lnTo>
                  <a:pt x="2989" y="604"/>
                </a:lnTo>
                <a:lnTo>
                  <a:pt x="3000" y="605"/>
                </a:lnTo>
                <a:lnTo>
                  <a:pt x="3012" y="605"/>
                </a:lnTo>
                <a:lnTo>
                  <a:pt x="3025" y="607"/>
                </a:lnTo>
                <a:lnTo>
                  <a:pt x="3036" y="609"/>
                </a:lnTo>
                <a:lnTo>
                  <a:pt x="3049" y="609"/>
                </a:lnTo>
                <a:lnTo>
                  <a:pt x="3061" y="609"/>
                </a:lnTo>
                <a:lnTo>
                  <a:pt x="3074" y="609"/>
                </a:lnTo>
                <a:lnTo>
                  <a:pt x="3085" y="607"/>
                </a:lnTo>
                <a:lnTo>
                  <a:pt x="3097" y="605"/>
                </a:lnTo>
                <a:lnTo>
                  <a:pt x="3110" y="605"/>
                </a:lnTo>
                <a:lnTo>
                  <a:pt x="3121" y="605"/>
                </a:lnTo>
                <a:lnTo>
                  <a:pt x="3134" y="607"/>
                </a:lnTo>
                <a:lnTo>
                  <a:pt x="3146" y="607"/>
                </a:lnTo>
                <a:lnTo>
                  <a:pt x="3157" y="607"/>
                </a:lnTo>
                <a:lnTo>
                  <a:pt x="3170" y="607"/>
                </a:lnTo>
                <a:lnTo>
                  <a:pt x="3182" y="607"/>
                </a:lnTo>
                <a:lnTo>
                  <a:pt x="3195" y="607"/>
                </a:lnTo>
                <a:lnTo>
                  <a:pt x="3206" y="607"/>
                </a:lnTo>
                <a:lnTo>
                  <a:pt x="3219" y="607"/>
                </a:lnTo>
                <a:lnTo>
                  <a:pt x="3230" y="609"/>
                </a:lnTo>
                <a:lnTo>
                  <a:pt x="3242" y="609"/>
                </a:lnTo>
                <a:lnTo>
                  <a:pt x="3255" y="607"/>
                </a:lnTo>
                <a:lnTo>
                  <a:pt x="3266" y="609"/>
                </a:lnTo>
                <a:lnTo>
                  <a:pt x="3279" y="609"/>
                </a:lnTo>
                <a:lnTo>
                  <a:pt x="3291" y="607"/>
                </a:lnTo>
                <a:lnTo>
                  <a:pt x="3302" y="607"/>
                </a:lnTo>
                <a:lnTo>
                  <a:pt x="3315" y="607"/>
                </a:lnTo>
                <a:lnTo>
                  <a:pt x="3327" y="607"/>
                </a:lnTo>
                <a:lnTo>
                  <a:pt x="3340" y="609"/>
                </a:lnTo>
                <a:lnTo>
                  <a:pt x="3351" y="609"/>
                </a:lnTo>
                <a:lnTo>
                  <a:pt x="3364" y="609"/>
                </a:lnTo>
                <a:lnTo>
                  <a:pt x="3376" y="609"/>
                </a:lnTo>
                <a:lnTo>
                  <a:pt x="3387" y="609"/>
                </a:lnTo>
                <a:lnTo>
                  <a:pt x="3400" y="609"/>
                </a:lnTo>
                <a:lnTo>
                  <a:pt x="3412" y="609"/>
                </a:lnTo>
                <a:lnTo>
                  <a:pt x="3425" y="609"/>
                </a:lnTo>
                <a:lnTo>
                  <a:pt x="3436" y="609"/>
                </a:lnTo>
                <a:lnTo>
                  <a:pt x="3447" y="610"/>
                </a:lnTo>
                <a:lnTo>
                  <a:pt x="3461" y="610"/>
                </a:lnTo>
                <a:lnTo>
                  <a:pt x="3472" y="610"/>
                </a:lnTo>
                <a:lnTo>
                  <a:pt x="3485" y="609"/>
                </a:lnTo>
                <a:lnTo>
                  <a:pt x="3496" y="609"/>
                </a:lnTo>
                <a:lnTo>
                  <a:pt x="3508" y="609"/>
                </a:lnTo>
                <a:lnTo>
                  <a:pt x="3521" y="607"/>
                </a:lnTo>
                <a:lnTo>
                  <a:pt x="3532" y="609"/>
                </a:lnTo>
                <a:lnTo>
                  <a:pt x="3545" y="607"/>
                </a:lnTo>
                <a:lnTo>
                  <a:pt x="3557" y="607"/>
                </a:lnTo>
                <a:lnTo>
                  <a:pt x="3570" y="609"/>
                </a:lnTo>
                <a:lnTo>
                  <a:pt x="3581" y="609"/>
                </a:lnTo>
                <a:lnTo>
                  <a:pt x="3593" y="607"/>
                </a:lnTo>
                <a:lnTo>
                  <a:pt x="3606" y="607"/>
                </a:lnTo>
                <a:lnTo>
                  <a:pt x="3617" y="607"/>
                </a:lnTo>
                <a:lnTo>
                  <a:pt x="3630" y="609"/>
                </a:lnTo>
                <a:lnTo>
                  <a:pt x="3642" y="609"/>
                </a:lnTo>
                <a:lnTo>
                  <a:pt x="3653" y="609"/>
                </a:lnTo>
                <a:lnTo>
                  <a:pt x="3666" y="609"/>
                </a:lnTo>
                <a:lnTo>
                  <a:pt x="3678" y="610"/>
                </a:lnTo>
                <a:lnTo>
                  <a:pt x="3691" y="610"/>
                </a:lnTo>
                <a:lnTo>
                  <a:pt x="3702" y="610"/>
                </a:lnTo>
                <a:lnTo>
                  <a:pt x="3715" y="610"/>
                </a:lnTo>
                <a:lnTo>
                  <a:pt x="3727" y="610"/>
                </a:lnTo>
                <a:lnTo>
                  <a:pt x="3738" y="612"/>
                </a:lnTo>
                <a:lnTo>
                  <a:pt x="3751" y="610"/>
                </a:lnTo>
                <a:lnTo>
                  <a:pt x="3762" y="610"/>
                </a:lnTo>
                <a:lnTo>
                  <a:pt x="3775" y="612"/>
                </a:lnTo>
                <a:lnTo>
                  <a:pt x="3787" y="612"/>
                </a:lnTo>
                <a:lnTo>
                  <a:pt x="3798" y="612"/>
                </a:lnTo>
                <a:lnTo>
                  <a:pt x="3811" y="610"/>
                </a:lnTo>
                <a:lnTo>
                  <a:pt x="3823" y="612"/>
                </a:lnTo>
                <a:lnTo>
                  <a:pt x="3836" y="610"/>
                </a:lnTo>
                <a:lnTo>
                  <a:pt x="3847" y="610"/>
                </a:lnTo>
                <a:lnTo>
                  <a:pt x="3859" y="610"/>
                </a:lnTo>
                <a:lnTo>
                  <a:pt x="3872" y="610"/>
                </a:lnTo>
                <a:lnTo>
                  <a:pt x="3883" y="610"/>
                </a:lnTo>
                <a:lnTo>
                  <a:pt x="3896" y="609"/>
                </a:lnTo>
                <a:lnTo>
                  <a:pt x="3908" y="610"/>
                </a:lnTo>
                <a:lnTo>
                  <a:pt x="3921" y="610"/>
                </a:lnTo>
                <a:lnTo>
                  <a:pt x="3932" y="610"/>
                </a:lnTo>
                <a:lnTo>
                  <a:pt x="3944" y="610"/>
                </a:lnTo>
                <a:lnTo>
                  <a:pt x="3957" y="610"/>
                </a:lnTo>
                <a:lnTo>
                  <a:pt x="3968" y="609"/>
                </a:lnTo>
                <a:lnTo>
                  <a:pt x="3981" y="609"/>
                </a:lnTo>
                <a:lnTo>
                  <a:pt x="3992" y="609"/>
                </a:lnTo>
                <a:lnTo>
                  <a:pt x="4004" y="609"/>
                </a:lnTo>
                <a:lnTo>
                  <a:pt x="4017" y="607"/>
                </a:lnTo>
                <a:lnTo>
                  <a:pt x="4028" y="605"/>
                </a:lnTo>
                <a:lnTo>
                  <a:pt x="4041" y="605"/>
                </a:lnTo>
                <a:lnTo>
                  <a:pt x="4053" y="605"/>
                </a:lnTo>
                <a:lnTo>
                  <a:pt x="4066" y="607"/>
                </a:lnTo>
                <a:lnTo>
                  <a:pt x="4077" y="607"/>
                </a:lnTo>
                <a:lnTo>
                  <a:pt x="4089" y="609"/>
                </a:lnTo>
                <a:lnTo>
                  <a:pt x="4102" y="609"/>
                </a:lnTo>
                <a:lnTo>
                  <a:pt x="4113" y="609"/>
                </a:lnTo>
                <a:lnTo>
                  <a:pt x="4126" y="609"/>
                </a:lnTo>
                <a:lnTo>
                  <a:pt x="4138" y="609"/>
                </a:lnTo>
                <a:lnTo>
                  <a:pt x="4149" y="610"/>
                </a:lnTo>
                <a:lnTo>
                  <a:pt x="4162" y="610"/>
                </a:lnTo>
                <a:lnTo>
                  <a:pt x="4174" y="609"/>
                </a:lnTo>
              </a:path>
            </a:pathLst>
          </a:custGeom>
          <a:noFill/>
          <a:ln w="0">
            <a:solidFill>
              <a:srgbClr val="000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6" name="Freeform 94"/>
          <p:cNvSpPr>
            <a:spLocks/>
          </p:cNvSpPr>
          <p:nvPr/>
        </p:nvSpPr>
        <p:spPr bwMode="auto">
          <a:xfrm>
            <a:off x="672307" y="3473452"/>
            <a:ext cx="6626226" cy="2193925"/>
          </a:xfrm>
          <a:custGeom>
            <a:avLst/>
            <a:gdLst>
              <a:gd name="T0" fmla="*/ 60 w 4174"/>
              <a:gd name="T1" fmla="*/ 953 h 1382"/>
              <a:gd name="T2" fmla="*/ 133 w 4174"/>
              <a:gd name="T3" fmla="*/ 953 h 1382"/>
              <a:gd name="T4" fmla="*/ 205 w 4174"/>
              <a:gd name="T5" fmla="*/ 941 h 1382"/>
              <a:gd name="T6" fmla="*/ 279 w 4174"/>
              <a:gd name="T7" fmla="*/ 1382 h 1382"/>
              <a:gd name="T8" fmla="*/ 350 w 4174"/>
              <a:gd name="T9" fmla="*/ 905 h 1382"/>
              <a:gd name="T10" fmla="*/ 424 w 4174"/>
              <a:gd name="T11" fmla="*/ 835 h 1382"/>
              <a:gd name="T12" fmla="*/ 496 w 4174"/>
              <a:gd name="T13" fmla="*/ 788 h 1382"/>
              <a:gd name="T14" fmla="*/ 569 w 4174"/>
              <a:gd name="T15" fmla="*/ 752 h 1382"/>
              <a:gd name="T16" fmla="*/ 641 w 4174"/>
              <a:gd name="T17" fmla="*/ 721 h 1382"/>
              <a:gd name="T18" fmla="*/ 714 w 4174"/>
              <a:gd name="T19" fmla="*/ 696 h 1382"/>
              <a:gd name="T20" fmla="*/ 786 w 4174"/>
              <a:gd name="T21" fmla="*/ 675 h 1382"/>
              <a:gd name="T22" fmla="*/ 860 w 4174"/>
              <a:gd name="T23" fmla="*/ 657 h 1382"/>
              <a:gd name="T24" fmla="*/ 931 w 4174"/>
              <a:gd name="T25" fmla="*/ 641 h 1382"/>
              <a:gd name="T26" fmla="*/ 1005 w 4174"/>
              <a:gd name="T27" fmla="*/ 625 h 1382"/>
              <a:gd name="T28" fmla="*/ 1077 w 4174"/>
              <a:gd name="T29" fmla="*/ 612 h 1382"/>
              <a:gd name="T30" fmla="*/ 1150 w 4174"/>
              <a:gd name="T31" fmla="*/ 595 h 1382"/>
              <a:gd name="T32" fmla="*/ 1222 w 4174"/>
              <a:gd name="T33" fmla="*/ 582 h 1382"/>
              <a:gd name="T34" fmla="*/ 1295 w 4174"/>
              <a:gd name="T35" fmla="*/ 569 h 1382"/>
              <a:gd name="T36" fmla="*/ 1367 w 4174"/>
              <a:gd name="T37" fmla="*/ 558 h 1382"/>
              <a:gd name="T38" fmla="*/ 1440 w 4174"/>
              <a:gd name="T39" fmla="*/ 545 h 1382"/>
              <a:gd name="T40" fmla="*/ 1512 w 4174"/>
              <a:gd name="T41" fmla="*/ 535 h 1382"/>
              <a:gd name="T42" fmla="*/ 1586 w 4174"/>
              <a:gd name="T43" fmla="*/ 524 h 1382"/>
              <a:gd name="T44" fmla="*/ 1657 w 4174"/>
              <a:gd name="T45" fmla="*/ 512 h 1382"/>
              <a:gd name="T46" fmla="*/ 1731 w 4174"/>
              <a:gd name="T47" fmla="*/ 501 h 1382"/>
              <a:gd name="T48" fmla="*/ 1803 w 4174"/>
              <a:gd name="T49" fmla="*/ 493 h 1382"/>
              <a:gd name="T50" fmla="*/ 1876 w 4174"/>
              <a:gd name="T51" fmla="*/ 481 h 1382"/>
              <a:gd name="T52" fmla="*/ 1948 w 4174"/>
              <a:gd name="T53" fmla="*/ 471 h 1382"/>
              <a:gd name="T54" fmla="*/ 2021 w 4174"/>
              <a:gd name="T55" fmla="*/ 465 h 1382"/>
              <a:gd name="T56" fmla="*/ 2093 w 4174"/>
              <a:gd name="T57" fmla="*/ 453 h 1382"/>
              <a:gd name="T58" fmla="*/ 2165 w 4174"/>
              <a:gd name="T59" fmla="*/ 444 h 1382"/>
              <a:gd name="T60" fmla="*/ 2238 w 4174"/>
              <a:gd name="T61" fmla="*/ 437 h 1382"/>
              <a:gd name="T62" fmla="*/ 2310 w 4174"/>
              <a:gd name="T63" fmla="*/ 427 h 1382"/>
              <a:gd name="T64" fmla="*/ 2384 w 4174"/>
              <a:gd name="T65" fmla="*/ 435 h 1382"/>
              <a:gd name="T66" fmla="*/ 2455 w 4174"/>
              <a:gd name="T67" fmla="*/ 442 h 1382"/>
              <a:gd name="T68" fmla="*/ 2529 w 4174"/>
              <a:gd name="T69" fmla="*/ 455 h 1382"/>
              <a:gd name="T70" fmla="*/ 2601 w 4174"/>
              <a:gd name="T71" fmla="*/ 465 h 1382"/>
              <a:gd name="T72" fmla="*/ 2674 w 4174"/>
              <a:gd name="T73" fmla="*/ 470 h 1382"/>
              <a:gd name="T74" fmla="*/ 2746 w 4174"/>
              <a:gd name="T75" fmla="*/ 476 h 1382"/>
              <a:gd name="T76" fmla="*/ 2819 w 4174"/>
              <a:gd name="T77" fmla="*/ 478 h 1382"/>
              <a:gd name="T78" fmla="*/ 2891 w 4174"/>
              <a:gd name="T79" fmla="*/ 479 h 1382"/>
              <a:gd name="T80" fmla="*/ 2965 w 4174"/>
              <a:gd name="T81" fmla="*/ 478 h 1382"/>
              <a:gd name="T82" fmla="*/ 3036 w 4174"/>
              <a:gd name="T83" fmla="*/ 478 h 1382"/>
              <a:gd name="T84" fmla="*/ 3110 w 4174"/>
              <a:gd name="T85" fmla="*/ 475 h 1382"/>
              <a:gd name="T86" fmla="*/ 3182 w 4174"/>
              <a:gd name="T87" fmla="*/ 475 h 1382"/>
              <a:gd name="T88" fmla="*/ 3255 w 4174"/>
              <a:gd name="T89" fmla="*/ 475 h 1382"/>
              <a:gd name="T90" fmla="*/ 3327 w 4174"/>
              <a:gd name="T91" fmla="*/ 471 h 1382"/>
              <a:gd name="T92" fmla="*/ 3400 w 4174"/>
              <a:gd name="T93" fmla="*/ 468 h 1382"/>
              <a:gd name="T94" fmla="*/ 3472 w 4174"/>
              <a:gd name="T95" fmla="*/ 466 h 1382"/>
              <a:gd name="T96" fmla="*/ 3545 w 4174"/>
              <a:gd name="T97" fmla="*/ 463 h 1382"/>
              <a:gd name="T98" fmla="*/ 3617 w 4174"/>
              <a:gd name="T99" fmla="*/ 463 h 1382"/>
              <a:gd name="T100" fmla="*/ 3691 w 4174"/>
              <a:gd name="T101" fmla="*/ 457 h 1382"/>
              <a:gd name="T102" fmla="*/ 3762 w 4174"/>
              <a:gd name="T103" fmla="*/ 455 h 1382"/>
              <a:gd name="T104" fmla="*/ 3836 w 4174"/>
              <a:gd name="T105" fmla="*/ 453 h 1382"/>
              <a:gd name="T106" fmla="*/ 3908 w 4174"/>
              <a:gd name="T107" fmla="*/ 452 h 1382"/>
              <a:gd name="T108" fmla="*/ 3981 w 4174"/>
              <a:gd name="T109" fmla="*/ 447 h 1382"/>
              <a:gd name="T110" fmla="*/ 4053 w 4174"/>
              <a:gd name="T111" fmla="*/ 444 h 1382"/>
              <a:gd name="T112" fmla="*/ 4126 w 4174"/>
              <a:gd name="T113" fmla="*/ 445 h 13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382">
                <a:moveTo>
                  <a:pt x="0" y="954"/>
                </a:moveTo>
                <a:lnTo>
                  <a:pt x="13" y="954"/>
                </a:lnTo>
                <a:lnTo>
                  <a:pt x="24" y="954"/>
                </a:lnTo>
                <a:lnTo>
                  <a:pt x="37" y="953"/>
                </a:lnTo>
                <a:lnTo>
                  <a:pt x="49" y="953"/>
                </a:lnTo>
                <a:lnTo>
                  <a:pt x="60" y="953"/>
                </a:lnTo>
                <a:lnTo>
                  <a:pt x="73" y="953"/>
                </a:lnTo>
                <a:lnTo>
                  <a:pt x="85" y="953"/>
                </a:lnTo>
                <a:lnTo>
                  <a:pt x="98" y="953"/>
                </a:lnTo>
                <a:lnTo>
                  <a:pt x="109" y="954"/>
                </a:lnTo>
                <a:lnTo>
                  <a:pt x="120" y="953"/>
                </a:lnTo>
                <a:lnTo>
                  <a:pt x="133" y="953"/>
                </a:lnTo>
                <a:lnTo>
                  <a:pt x="145" y="951"/>
                </a:lnTo>
                <a:lnTo>
                  <a:pt x="158" y="949"/>
                </a:lnTo>
                <a:lnTo>
                  <a:pt x="169" y="948"/>
                </a:lnTo>
                <a:lnTo>
                  <a:pt x="182" y="939"/>
                </a:lnTo>
                <a:lnTo>
                  <a:pt x="194" y="939"/>
                </a:lnTo>
                <a:lnTo>
                  <a:pt x="205" y="941"/>
                </a:lnTo>
                <a:lnTo>
                  <a:pt x="218" y="951"/>
                </a:lnTo>
                <a:lnTo>
                  <a:pt x="230" y="957"/>
                </a:lnTo>
                <a:lnTo>
                  <a:pt x="243" y="386"/>
                </a:lnTo>
                <a:lnTo>
                  <a:pt x="254" y="0"/>
                </a:lnTo>
                <a:lnTo>
                  <a:pt x="266" y="980"/>
                </a:lnTo>
                <a:lnTo>
                  <a:pt x="279" y="1382"/>
                </a:lnTo>
                <a:lnTo>
                  <a:pt x="290" y="1231"/>
                </a:lnTo>
                <a:lnTo>
                  <a:pt x="303" y="1075"/>
                </a:lnTo>
                <a:lnTo>
                  <a:pt x="315" y="990"/>
                </a:lnTo>
                <a:lnTo>
                  <a:pt x="328" y="948"/>
                </a:lnTo>
                <a:lnTo>
                  <a:pt x="339" y="923"/>
                </a:lnTo>
                <a:lnTo>
                  <a:pt x="350" y="905"/>
                </a:lnTo>
                <a:lnTo>
                  <a:pt x="364" y="889"/>
                </a:lnTo>
                <a:lnTo>
                  <a:pt x="375" y="877"/>
                </a:lnTo>
                <a:lnTo>
                  <a:pt x="388" y="866"/>
                </a:lnTo>
                <a:lnTo>
                  <a:pt x="399" y="856"/>
                </a:lnTo>
                <a:lnTo>
                  <a:pt x="411" y="848"/>
                </a:lnTo>
                <a:lnTo>
                  <a:pt x="424" y="835"/>
                </a:lnTo>
                <a:lnTo>
                  <a:pt x="435" y="825"/>
                </a:lnTo>
                <a:lnTo>
                  <a:pt x="448" y="817"/>
                </a:lnTo>
                <a:lnTo>
                  <a:pt x="460" y="809"/>
                </a:lnTo>
                <a:lnTo>
                  <a:pt x="471" y="801"/>
                </a:lnTo>
                <a:lnTo>
                  <a:pt x="484" y="793"/>
                </a:lnTo>
                <a:lnTo>
                  <a:pt x="496" y="788"/>
                </a:lnTo>
                <a:lnTo>
                  <a:pt x="509" y="780"/>
                </a:lnTo>
                <a:lnTo>
                  <a:pt x="520" y="773"/>
                </a:lnTo>
                <a:lnTo>
                  <a:pt x="533" y="768"/>
                </a:lnTo>
                <a:lnTo>
                  <a:pt x="545" y="762"/>
                </a:lnTo>
                <a:lnTo>
                  <a:pt x="556" y="757"/>
                </a:lnTo>
                <a:lnTo>
                  <a:pt x="569" y="752"/>
                </a:lnTo>
                <a:lnTo>
                  <a:pt x="581" y="744"/>
                </a:lnTo>
                <a:lnTo>
                  <a:pt x="594" y="740"/>
                </a:lnTo>
                <a:lnTo>
                  <a:pt x="605" y="736"/>
                </a:lnTo>
                <a:lnTo>
                  <a:pt x="616" y="731"/>
                </a:lnTo>
                <a:lnTo>
                  <a:pt x="629" y="726"/>
                </a:lnTo>
                <a:lnTo>
                  <a:pt x="641" y="721"/>
                </a:lnTo>
                <a:lnTo>
                  <a:pt x="654" y="716"/>
                </a:lnTo>
                <a:lnTo>
                  <a:pt x="665" y="713"/>
                </a:lnTo>
                <a:lnTo>
                  <a:pt x="678" y="708"/>
                </a:lnTo>
                <a:lnTo>
                  <a:pt x="690" y="703"/>
                </a:lnTo>
                <a:lnTo>
                  <a:pt x="701" y="701"/>
                </a:lnTo>
                <a:lnTo>
                  <a:pt x="714" y="696"/>
                </a:lnTo>
                <a:lnTo>
                  <a:pt x="726" y="693"/>
                </a:lnTo>
                <a:lnTo>
                  <a:pt x="739" y="688"/>
                </a:lnTo>
                <a:lnTo>
                  <a:pt x="750" y="683"/>
                </a:lnTo>
                <a:lnTo>
                  <a:pt x="762" y="682"/>
                </a:lnTo>
                <a:lnTo>
                  <a:pt x="775" y="677"/>
                </a:lnTo>
                <a:lnTo>
                  <a:pt x="786" y="675"/>
                </a:lnTo>
                <a:lnTo>
                  <a:pt x="799" y="670"/>
                </a:lnTo>
                <a:lnTo>
                  <a:pt x="811" y="669"/>
                </a:lnTo>
                <a:lnTo>
                  <a:pt x="824" y="664"/>
                </a:lnTo>
                <a:lnTo>
                  <a:pt x="835" y="661"/>
                </a:lnTo>
                <a:lnTo>
                  <a:pt x="847" y="659"/>
                </a:lnTo>
                <a:lnTo>
                  <a:pt x="860" y="657"/>
                </a:lnTo>
                <a:lnTo>
                  <a:pt x="871" y="652"/>
                </a:lnTo>
                <a:lnTo>
                  <a:pt x="884" y="649"/>
                </a:lnTo>
                <a:lnTo>
                  <a:pt x="895" y="649"/>
                </a:lnTo>
                <a:lnTo>
                  <a:pt x="907" y="646"/>
                </a:lnTo>
                <a:lnTo>
                  <a:pt x="920" y="643"/>
                </a:lnTo>
                <a:lnTo>
                  <a:pt x="931" y="641"/>
                </a:lnTo>
                <a:lnTo>
                  <a:pt x="944" y="638"/>
                </a:lnTo>
                <a:lnTo>
                  <a:pt x="956" y="634"/>
                </a:lnTo>
                <a:lnTo>
                  <a:pt x="967" y="631"/>
                </a:lnTo>
                <a:lnTo>
                  <a:pt x="980" y="630"/>
                </a:lnTo>
                <a:lnTo>
                  <a:pt x="992" y="626"/>
                </a:lnTo>
                <a:lnTo>
                  <a:pt x="1005" y="625"/>
                </a:lnTo>
                <a:lnTo>
                  <a:pt x="1016" y="623"/>
                </a:lnTo>
                <a:lnTo>
                  <a:pt x="1029" y="621"/>
                </a:lnTo>
                <a:lnTo>
                  <a:pt x="1041" y="620"/>
                </a:lnTo>
                <a:lnTo>
                  <a:pt x="1052" y="616"/>
                </a:lnTo>
                <a:lnTo>
                  <a:pt x="1065" y="615"/>
                </a:lnTo>
                <a:lnTo>
                  <a:pt x="1077" y="612"/>
                </a:lnTo>
                <a:lnTo>
                  <a:pt x="1090" y="610"/>
                </a:lnTo>
                <a:lnTo>
                  <a:pt x="1101" y="608"/>
                </a:lnTo>
                <a:lnTo>
                  <a:pt x="1112" y="603"/>
                </a:lnTo>
                <a:lnTo>
                  <a:pt x="1126" y="600"/>
                </a:lnTo>
                <a:lnTo>
                  <a:pt x="1137" y="599"/>
                </a:lnTo>
                <a:lnTo>
                  <a:pt x="1150" y="595"/>
                </a:lnTo>
                <a:lnTo>
                  <a:pt x="1161" y="594"/>
                </a:lnTo>
                <a:lnTo>
                  <a:pt x="1174" y="592"/>
                </a:lnTo>
                <a:lnTo>
                  <a:pt x="1186" y="587"/>
                </a:lnTo>
                <a:lnTo>
                  <a:pt x="1197" y="587"/>
                </a:lnTo>
                <a:lnTo>
                  <a:pt x="1210" y="584"/>
                </a:lnTo>
                <a:lnTo>
                  <a:pt x="1222" y="582"/>
                </a:lnTo>
                <a:lnTo>
                  <a:pt x="1235" y="579"/>
                </a:lnTo>
                <a:lnTo>
                  <a:pt x="1246" y="577"/>
                </a:lnTo>
                <a:lnTo>
                  <a:pt x="1258" y="576"/>
                </a:lnTo>
                <a:lnTo>
                  <a:pt x="1271" y="574"/>
                </a:lnTo>
                <a:lnTo>
                  <a:pt x="1282" y="571"/>
                </a:lnTo>
                <a:lnTo>
                  <a:pt x="1295" y="569"/>
                </a:lnTo>
                <a:lnTo>
                  <a:pt x="1307" y="569"/>
                </a:lnTo>
                <a:lnTo>
                  <a:pt x="1318" y="566"/>
                </a:lnTo>
                <a:lnTo>
                  <a:pt x="1331" y="563"/>
                </a:lnTo>
                <a:lnTo>
                  <a:pt x="1343" y="559"/>
                </a:lnTo>
                <a:lnTo>
                  <a:pt x="1356" y="558"/>
                </a:lnTo>
                <a:lnTo>
                  <a:pt x="1367" y="558"/>
                </a:lnTo>
                <a:lnTo>
                  <a:pt x="1380" y="554"/>
                </a:lnTo>
                <a:lnTo>
                  <a:pt x="1392" y="551"/>
                </a:lnTo>
                <a:lnTo>
                  <a:pt x="1403" y="551"/>
                </a:lnTo>
                <a:lnTo>
                  <a:pt x="1416" y="548"/>
                </a:lnTo>
                <a:lnTo>
                  <a:pt x="1427" y="546"/>
                </a:lnTo>
                <a:lnTo>
                  <a:pt x="1440" y="545"/>
                </a:lnTo>
                <a:lnTo>
                  <a:pt x="1452" y="543"/>
                </a:lnTo>
                <a:lnTo>
                  <a:pt x="1463" y="541"/>
                </a:lnTo>
                <a:lnTo>
                  <a:pt x="1476" y="540"/>
                </a:lnTo>
                <a:lnTo>
                  <a:pt x="1488" y="538"/>
                </a:lnTo>
                <a:lnTo>
                  <a:pt x="1501" y="537"/>
                </a:lnTo>
                <a:lnTo>
                  <a:pt x="1512" y="535"/>
                </a:lnTo>
                <a:lnTo>
                  <a:pt x="1525" y="532"/>
                </a:lnTo>
                <a:lnTo>
                  <a:pt x="1537" y="528"/>
                </a:lnTo>
                <a:lnTo>
                  <a:pt x="1548" y="528"/>
                </a:lnTo>
                <a:lnTo>
                  <a:pt x="1561" y="527"/>
                </a:lnTo>
                <a:lnTo>
                  <a:pt x="1573" y="527"/>
                </a:lnTo>
                <a:lnTo>
                  <a:pt x="1586" y="524"/>
                </a:lnTo>
                <a:lnTo>
                  <a:pt x="1597" y="519"/>
                </a:lnTo>
                <a:lnTo>
                  <a:pt x="1609" y="517"/>
                </a:lnTo>
                <a:lnTo>
                  <a:pt x="1622" y="517"/>
                </a:lnTo>
                <a:lnTo>
                  <a:pt x="1633" y="512"/>
                </a:lnTo>
                <a:lnTo>
                  <a:pt x="1646" y="512"/>
                </a:lnTo>
                <a:lnTo>
                  <a:pt x="1657" y="512"/>
                </a:lnTo>
                <a:lnTo>
                  <a:pt x="1671" y="509"/>
                </a:lnTo>
                <a:lnTo>
                  <a:pt x="1682" y="507"/>
                </a:lnTo>
                <a:lnTo>
                  <a:pt x="1693" y="507"/>
                </a:lnTo>
                <a:lnTo>
                  <a:pt x="1706" y="506"/>
                </a:lnTo>
                <a:lnTo>
                  <a:pt x="1718" y="502"/>
                </a:lnTo>
                <a:lnTo>
                  <a:pt x="1731" y="501"/>
                </a:lnTo>
                <a:lnTo>
                  <a:pt x="1742" y="499"/>
                </a:lnTo>
                <a:lnTo>
                  <a:pt x="1754" y="499"/>
                </a:lnTo>
                <a:lnTo>
                  <a:pt x="1767" y="497"/>
                </a:lnTo>
                <a:lnTo>
                  <a:pt x="1778" y="496"/>
                </a:lnTo>
                <a:lnTo>
                  <a:pt x="1791" y="494"/>
                </a:lnTo>
                <a:lnTo>
                  <a:pt x="1803" y="493"/>
                </a:lnTo>
                <a:lnTo>
                  <a:pt x="1814" y="491"/>
                </a:lnTo>
                <a:lnTo>
                  <a:pt x="1827" y="489"/>
                </a:lnTo>
                <a:lnTo>
                  <a:pt x="1839" y="489"/>
                </a:lnTo>
                <a:lnTo>
                  <a:pt x="1852" y="486"/>
                </a:lnTo>
                <a:lnTo>
                  <a:pt x="1863" y="483"/>
                </a:lnTo>
                <a:lnTo>
                  <a:pt x="1876" y="481"/>
                </a:lnTo>
                <a:lnTo>
                  <a:pt x="1888" y="483"/>
                </a:lnTo>
                <a:lnTo>
                  <a:pt x="1899" y="479"/>
                </a:lnTo>
                <a:lnTo>
                  <a:pt x="1912" y="478"/>
                </a:lnTo>
                <a:lnTo>
                  <a:pt x="1923" y="476"/>
                </a:lnTo>
                <a:lnTo>
                  <a:pt x="1937" y="475"/>
                </a:lnTo>
                <a:lnTo>
                  <a:pt x="1948" y="471"/>
                </a:lnTo>
                <a:lnTo>
                  <a:pt x="1959" y="471"/>
                </a:lnTo>
                <a:lnTo>
                  <a:pt x="1972" y="471"/>
                </a:lnTo>
                <a:lnTo>
                  <a:pt x="1984" y="468"/>
                </a:lnTo>
                <a:lnTo>
                  <a:pt x="1997" y="468"/>
                </a:lnTo>
                <a:lnTo>
                  <a:pt x="2008" y="466"/>
                </a:lnTo>
                <a:lnTo>
                  <a:pt x="2021" y="465"/>
                </a:lnTo>
                <a:lnTo>
                  <a:pt x="2033" y="462"/>
                </a:lnTo>
                <a:lnTo>
                  <a:pt x="2044" y="458"/>
                </a:lnTo>
                <a:lnTo>
                  <a:pt x="2057" y="458"/>
                </a:lnTo>
                <a:lnTo>
                  <a:pt x="2069" y="457"/>
                </a:lnTo>
                <a:lnTo>
                  <a:pt x="2082" y="455"/>
                </a:lnTo>
                <a:lnTo>
                  <a:pt x="2093" y="453"/>
                </a:lnTo>
                <a:lnTo>
                  <a:pt x="2105" y="452"/>
                </a:lnTo>
                <a:lnTo>
                  <a:pt x="2118" y="450"/>
                </a:lnTo>
                <a:lnTo>
                  <a:pt x="2129" y="448"/>
                </a:lnTo>
                <a:lnTo>
                  <a:pt x="2142" y="447"/>
                </a:lnTo>
                <a:lnTo>
                  <a:pt x="2154" y="445"/>
                </a:lnTo>
                <a:lnTo>
                  <a:pt x="2165" y="444"/>
                </a:lnTo>
                <a:lnTo>
                  <a:pt x="2178" y="442"/>
                </a:lnTo>
                <a:lnTo>
                  <a:pt x="2189" y="442"/>
                </a:lnTo>
                <a:lnTo>
                  <a:pt x="2202" y="442"/>
                </a:lnTo>
                <a:lnTo>
                  <a:pt x="2214" y="440"/>
                </a:lnTo>
                <a:lnTo>
                  <a:pt x="2227" y="440"/>
                </a:lnTo>
                <a:lnTo>
                  <a:pt x="2238" y="437"/>
                </a:lnTo>
                <a:lnTo>
                  <a:pt x="2250" y="437"/>
                </a:lnTo>
                <a:lnTo>
                  <a:pt x="2263" y="434"/>
                </a:lnTo>
                <a:lnTo>
                  <a:pt x="2274" y="434"/>
                </a:lnTo>
                <a:lnTo>
                  <a:pt x="2287" y="432"/>
                </a:lnTo>
                <a:lnTo>
                  <a:pt x="2299" y="431"/>
                </a:lnTo>
                <a:lnTo>
                  <a:pt x="2310" y="427"/>
                </a:lnTo>
                <a:lnTo>
                  <a:pt x="2323" y="427"/>
                </a:lnTo>
                <a:lnTo>
                  <a:pt x="2335" y="426"/>
                </a:lnTo>
                <a:lnTo>
                  <a:pt x="2348" y="426"/>
                </a:lnTo>
                <a:lnTo>
                  <a:pt x="2359" y="435"/>
                </a:lnTo>
                <a:lnTo>
                  <a:pt x="2372" y="439"/>
                </a:lnTo>
                <a:lnTo>
                  <a:pt x="2384" y="435"/>
                </a:lnTo>
                <a:lnTo>
                  <a:pt x="2395" y="507"/>
                </a:lnTo>
                <a:lnTo>
                  <a:pt x="2408" y="520"/>
                </a:lnTo>
                <a:lnTo>
                  <a:pt x="2420" y="471"/>
                </a:lnTo>
                <a:lnTo>
                  <a:pt x="2433" y="444"/>
                </a:lnTo>
                <a:lnTo>
                  <a:pt x="2444" y="444"/>
                </a:lnTo>
                <a:lnTo>
                  <a:pt x="2455" y="442"/>
                </a:lnTo>
                <a:lnTo>
                  <a:pt x="2468" y="444"/>
                </a:lnTo>
                <a:lnTo>
                  <a:pt x="2480" y="447"/>
                </a:lnTo>
                <a:lnTo>
                  <a:pt x="2493" y="448"/>
                </a:lnTo>
                <a:lnTo>
                  <a:pt x="2504" y="452"/>
                </a:lnTo>
                <a:lnTo>
                  <a:pt x="2517" y="453"/>
                </a:lnTo>
                <a:lnTo>
                  <a:pt x="2529" y="455"/>
                </a:lnTo>
                <a:lnTo>
                  <a:pt x="2540" y="457"/>
                </a:lnTo>
                <a:lnTo>
                  <a:pt x="2553" y="460"/>
                </a:lnTo>
                <a:lnTo>
                  <a:pt x="2565" y="462"/>
                </a:lnTo>
                <a:lnTo>
                  <a:pt x="2578" y="462"/>
                </a:lnTo>
                <a:lnTo>
                  <a:pt x="2589" y="465"/>
                </a:lnTo>
                <a:lnTo>
                  <a:pt x="2601" y="465"/>
                </a:lnTo>
                <a:lnTo>
                  <a:pt x="2614" y="466"/>
                </a:lnTo>
                <a:lnTo>
                  <a:pt x="2625" y="470"/>
                </a:lnTo>
                <a:lnTo>
                  <a:pt x="2638" y="468"/>
                </a:lnTo>
                <a:lnTo>
                  <a:pt x="2650" y="470"/>
                </a:lnTo>
                <a:lnTo>
                  <a:pt x="2661" y="471"/>
                </a:lnTo>
                <a:lnTo>
                  <a:pt x="2674" y="470"/>
                </a:lnTo>
                <a:lnTo>
                  <a:pt x="2685" y="471"/>
                </a:lnTo>
                <a:lnTo>
                  <a:pt x="2699" y="471"/>
                </a:lnTo>
                <a:lnTo>
                  <a:pt x="2710" y="473"/>
                </a:lnTo>
                <a:lnTo>
                  <a:pt x="2723" y="471"/>
                </a:lnTo>
                <a:lnTo>
                  <a:pt x="2734" y="475"/>
                </a:lnTo>
                <a:lnTo>
                  <a:pt x="2746" y="476"/>
                </a:lnTo>
                <a:lnTo>
                  <a:pt x="2759" y="475"/>
                </a:lnTo>
                <a:lnTo>
                  <a:pt x="2770" y="475"/>
                </a:lnTo>
                <a:lnTo>
                  <a:pt x="2783" y="475"/>
                </a:lnTo>
                <a:lnTo>
                  <a:pt x="2795" y="476"/>
                </a:lnTo>
                <a:lnTo>
                  <a:pt x="2806" y="476"/>
                </a:lnTo>
                <a:lnTo>
                  <a:pt x="2819" y="478"/>
                </a:lnTo>
                <a:lnTo>
                  <a:pt x="2831" y="476"/>
                </a:lnTo>
                <a:lnTo>
                  <a:pt x="2844" y="476"/>
                </a:lnTo>
                <a:lnTo>
                  <a:pt x="2855" y="476"/>
                </a:lnTo>
                <a:lnTo>
                  <a:pt x="2868" y="476"/>
                </a:lnTo>
                <a:lnTo>
                  <a:pt x="2880" y="476"/>
                </a:lnTo>
                <a:lnTo>
                  <a:pt x="2891" y="479"/>
                </a:lnTo>
                <a:lnTo>
                  <a:pt x="2904" y="478"/>
                </a:lnTo>
                <a:lnTo>
                  <a:pt x="2916" y="478"/>
                </a:lnTo>
                <a:lnTo>
                  <a:pt x="2929" y="478"/>
                </a:lnTo>
                <a:lnTo>
                  <a:pt x="2940" y="478"/>
                </a:lnTo>
                <a:lnTo>
                  <a:pt x="2951" y="478"/>
                </a:lnTo>
                <a:lnTo>
                  <a:pt x="2965" y="478"/>
                </a:lnTo>
                <a:lnTo>
                  <a:pt x="2976" y="476"/>
                </a:lnTo>
                <a:lnTo>
                  <a:pt x="2989" y="476"/>
                </a:lnTo>
                <a:lnTo>
                  <a:pt x="3000" y="476"/>
                </a:lnTo>
                <a:lnTo>
                  <a:pt x="3012" y="476"/>
                </a:lnTo>
                <a:lnTo>
                  <a:pt x="3025" y="476"/>
                </a:lnTo>
                <a:lnTo>
                  <a:pt x="3036" y="478"/>
                </a:lnTo>
                <a:lnTo>
                  <a:pt x="3049" y="476"/>
                </a:lnTo>
                <a:lnTo>
                  <a:pt x="3061" y="476"/>
                </a:lnTo>
                <a:lnTo>
                  <a:pt x="3074" y="476"/>
                </a:lnTo>
                <a:lnTo>
                  <a:pt x="3085" y="476"/>
                </a:lnTo>
                <a:lnTo>
                  <a:pt x="3097" y="475"/>
                </a:lnTo>
                <a:lnTo>
                  <a:pt x="3110" y="475"/>
                </a:lnTo>
                <a:lnTo>
                  <a:pt x="3121" y="475"/>
                </a:lnTo>
                <a:lnTo>
                  <a:pt x="3134" y="475"/>
                </a:lnTo>
                <a:lnTo>
                  <a:pt x="3146" y="475"/>
                </a:lnTo>
                <a:lnTo>
                  <a:pt x="3157" y="473"/>
                </a:lnTo>
                <a:lnTo>
                  <a:pt x="3170" y="475"/>
                </a:lnTo>
                <a:lnTo>
                  <a:pt x="3182" y="475"/>
                </a:lnTo>
                <a:lnTo>
                  <a:pt x="3195" y="473"/>
                </a:lnTo>
                <a:lnTo>
                  <a:pt x="3206" y="473"/>
                </a:lnTo>
                <a:lnTo>
                  <a:pt x="3219" y="473"/>
                </a:lnTo>
                <a:lnTo>
                  <a:pt x="3230" y="473"/>
                </a:lnTo>
                <a:lnTo>
                  <a:pt x="3242" y="473"/>
                </a:lnTo>
                <a:lnTo>
                  <a:pt x="3255" y="475"/>
                </a:lnTo>
                <a:lnTo>
                  <a:pt x="3266" y="473"/>
                </a:lnTo>
                <a:lnTo>
                  <a:pt x="3279" y="471"/>
                </a:lnTo>
                <a:lnTo>
                  <a:pt x="3291" y="471"/>
                </a:lnTo>
                <a:lnTo>
                  <a:pt x="3302" y="471"/>
                </a:lnTo>
                <a:lnTo>
                  <a:pt x="3315" y="471"/>
                </a:lnTo>
                <a:lnTo>
                  <a:pt x="3327" y="471"/>
                </a:lnTo>
                <a:lnTo>
                  <a:pt x="3340" y="470"/>
                </a:lnTo>
                <a:lnTo>
                  <a:pt x="3351" y="470"/>
                </a:lnTo>
                <a:lnTo>
                  <a:pt x="3364" y="470"/>
                </a:lnTo>
                <a:lnTo>
                  <a:pt x="3376" y="470"/>
                </a:lnTo>
                <a:lnTo>
                  <a:pt x="3387" y="468"/>
                </a:lnTo>
                <a:lnTo>
                  <a:pt x="3400" y="468"/>
                </a:lnTo>
                <a:lnTo>
                  <a:pt x="3412" y="468"/>
                </a:lnTo>
                <a:lnTo>
                  <a:pt x="3425" y="468"/>
                </a:lnTo>
                <a:lnTo>
                  <a:pt x="3436" y="466"/>
                </a:lnTo>
                <a:lnTo>
                  <a:pt x="3447" y="468"/>
                </a:lnTo>
                <a:lnTo>
                  <a:pt x="3461" y="466"/>
                </a:lnTo>
                <a:lnTo>
                  <a:pt x="3472" y="466"/>
                </a:lnTo>
                <a:lnTo>
                  <a:pt x="3485" y="468"/>
                </a:lnTo>
                <a:lnTo>
                  <a:pt x="3496" y="465"/>
                </a:lnTo>
                <a:lnTo>
                  <a:pt x="3508" y="465"/>
                </a:lnTo>
                <a:lnTo>
                  <a:pt x="3521" y="463"/>
                </a:lnTo>
                <a:lnTo>
                  <a:pt x="3532" y="460"/>
                </a:lnTo>
                <a:lnTo>
                  <a:pt x="3545" y="463"/>
                </a:lnTo>
                <a:lnTo>
                  <a:pt x="3557" y="465"/>
                </a:lnTo>
                <a:lnTo>
                  <a:pt x="3570" y="465"/>
                </a:lnTo>
                <a:lnTo>
                  <a:pt x="3581" y="465"/>
                </a:lnTo>
                <a:lnTo>
                  <a:pt x="3593" y="463"/>
                </a:lnTo>
                <a:lnTo>
                  <a:pt x="3606" y="462"/>
                </a:lnTo>
                <a:lnTo>
                  <a:pt x="3617" y="463"/>
                </a:lnTo>
                <a:lnTo>
                  <a:pt x="3630" y="462"/>
                </a:lnTo>
                <a:lnTo>
                  <a:pt x="3642" y="462"/>
                </a:lnTo>
                <a:lnTo>
                  <a:pt x="3653" y="460"/>
                </a:lnTo>
                <a:lnTo>
                  <a:pt x="3666" y="460"/>
                </a:lnTo>
                <a:lnTo>
                  <a:pt x="3678" y="458"/>
                </a:lnTo>
                <a:lnTo>
                  <a:pt x="3691" y="457"/>
                </a:lnTo>
                <a:lnTo>
                  <a:pt x="3702" y="458"/>
                </a:lnTo>
                <a:lnTo>
                  <a:pt x="3715" y="458"/>
                </a:lnTo>
                <a:lnTo>
                  <a:pt x="3727" y="457"/>
                </a:lnTo>
                <a:lnTo>
                  <a:pt x="3738" y="457"/>
                </a:lnTo>
                <a:lnTo>
                  <a:pt x="3751" y="455"/>
                </a:lnTo>
                <a:lnTo>
                  <a:pt x="3762" y="455"/>
                </a:lnTo>
                <a:lnTo>
                  <a:pt x="3775" y="455"/>
                </a:lnTo>
                <a:lnTo>
                  <a:pt x="3787" y="455"/>
                </a:lnTo>
                <a:lnTo>
                  <a:pt x="3798" y="455"/>
                </a:lnTo>
                <a:lnTo>
                  <a:pt x="3811" y="455"/>
                </a:lnTo>
                <a:lnTo>
                  <a:pt x="3823" y="453"/>
                </a:lnTo>
                <a:lnTo>
                  <a:pt x="3836" y="453"/>
                </a:lnTo>
                <a:lnTo>
                  <a:pt x="3847" y="452"/>
                </a:lnTo>
                <a:lnTo>
                  <a:pt x="3859" y="452"/>
                </a:lnTo>
                <a:lnTo>
                  <a:pt x="3872" y="453"/>
                </a:lnTo>
                <a:lnTo>
                  <a:pt x="3883" y="452"/>
                </a:lnTo>
                <a:lnTo>
                  <a:pt x="3896" y="452"/>
                </a:lnTo>
                <a:lnTo>
                  <a:pt x="3908" y="452"/>
                </a:lnTo>
                <a:lnTo>
                  <a:pt x="3921" y="450"/>
                </a:lnTo>
                <a:lnTo>
                  <a:pt x="3932" y="452"/>
                </a:lnTo>
                <a:lnTo>
                  <a:pt x="3944" y="450"/>
                </a:lnTo>
                <a:lnTo>
                  <a:pt x="3957" y="450"/>
                </a:lnTo>
                <a:lnTo>
                  <a:pt x="3968" y="448"/>
                </a:lnTo>
                <a:lnTo>
                  <a:pt x="3981" y="447"/>
                </a:lnTo>
                <a:lnTo>
                  <a:pt x="3992" y="445"/>
                </a:lnTo>
                <a:lnTo>
                  <a:pt x="4004" y="445"/>
                </a:lnTo>
                <a:lnTo>
                  <a:pt x="4017" y="447"/>
                </a:lnTo>
                <a:lnTo>
                  <a:pt x="4028" y="445"/>
                </a:lnTo>
                <a:lnTo>
                  <a:pt x="4041" y="445"/>
                </a:lnTo>
                <a:lnTo>
                  <a:pt x="4053" y="444"/>
                </a:lnTo>
                <a:lnTo>
                  <a:pt x="4066" y="444"/>
                </a:lnTo>
                <a:lnTo>
                  <a:pt x="4077" y="445"/>
                </a:lnTo>
                <a:lnTo>
                  <a:pt x="4089" y="447"/>
                </a:lnTo>
                <a:lnTo>
                  <a:pt x="4102" y="445"/>
                </a:lnTo>
                <a:lnTo>
                  <a:pt x="4113" y="445"/>
                </a:lnTo>
                <a:lnTo>
                  <a:pt x="4126" y="445"/>
                </a:lnTo>
                <a:lnTo>
                  <a:pt x="4138" y="445"/>
                </a:lnTo>
                <a:lnTo>
                  <a:pt x="4149" y="444"/>
                </a:lnTo>
                <a:lnTo>
                  <a:pt x="4162" y="444"/>
                </a:lnTo>
                <a:lnTo>
                  <a:pt x="4174" y="444"/>
                </a:lnTo>
              </a:path>
            </a:pathLst>
          </a:custGeom>
          <a:noFill/>
          <a:ln w="0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7" name="Freeform 95"/>
          <p:cNvSpPr>
            <a:spLocks/>
          </p:cNvSpPr>
          <p:nvPr/>
        </p:nvSpPr>
        <p:spPr bwMode="auto">
          <a:xfrm>
            <a:off x="672307" y="3749677"/>
            <a:ext cx="6626226" cy="1973263"/>
          </a:xfrm>
          <a:custGeom>
            <a:avLst/>
            <a:gdLst>
              <a:gd name="T0" fmla="*/ 60 w 4174"/>
              <a:gd name="T1" fmla="*/ 779 h 1243"/>
              <a:gd name="T2" fmla="*/ 133 w 4174"/>
              <a:gd name="T3" fmla="*/ 779 h 1243"/>
              <a:gd name="T4" fmla="*/ 205 w 4174"/>
              <a:gd name="T5" fmla="*/ 770 h 1243"/>
              <a:gd name="T6" fmla="*/ 279 w 4174"/>
              <a:gd name="T7" fmla="*/ 1243 h 1243"/>
              <a:gd name="T8" fmla="*/ 350 w 4174"/>
              <a:gd name="T9" fmla="*/ 798 h 1243"/>
              <a:gd name="T10" fmla="*/ 424 w 4174"/>
              <a:gd name="T11" fmla="*/ 764 h 1243"/>
              <a:gd name="T12" fmla="*/ 496 w 4174"/>
              <a:gd name="T13" fmla="*/ 739 h 1243"/>
              <a:gd name="T14" fmla="*/ 569 w 4174"/>
              <a:gd name="T15" fmla="*/ 718 h 1243"/>
              <a:gd name="T16" fmla="*/ 641 w 4174"/>
              <a:gd name="T17" fmla="*/ 699 h 1243"/>
              <a:gd name="T18" fmla="*/ 714 w 4174"/>
              <a:gd name="T19" fmla="*/ 682 h 1243"/>
              <a:gd name="T20" fmla="*/ 786 w 4174"/>
              <a:gd name="T21" fmla="*/ 668 h 1243"/>
              <a:gd name="T22" fmla="*/ 860 w 4174"/>
              <a:gd name="T23" fmla="*/ 655 h 1243"/>
              <a:gd name="T24" fmla="*/ 931 w 4174"/>
              <a:gd name="T25" fmla="*/ 643 h 1243"/>
              <a:gd name="T26" fmla="*/ 1005 w 4174"/>
              <a:gd name="T27" fmla="*/ 632 h 1243"/>
              <a:gd name="T28" fmla="*/ 1077 w 4174"/>
              <a:gd name="T29" fmla="*/ 622 h 1243"/>
              <a:gd name="T30" fmla="*/ 1150 w 4174"/>
              <a:gd name="T31" fmla="*/ 612 h 1243"/>
              <a:gd name="T32" fmla="*/ 1222 w 4174"/>
              <a:gd name="T33" fmla="*/ 606 h 1243"/>
              <a:gd name="T34" fmla="*/ 1295 w 4174"/>
              <a:gd name="T35" fmla="*/ 593 h 1243"/>
              <a:gd name="T36" fmla="*/ 1367 w 4174"/>
              <a:gd name="T37" fmla="*/ 588 h 1243"/>
              <a:gd name="T38" fmla="*/ 1440 w 4174"/>
              <a:gd name="T39" fmla="*/ 580 h 1243"/>
              <a:gd name="T40" fmla="*/ 1512 w 4174"/>
              <a:gd name="T41" fmla="*/ 571 h 1243"/>
              <a:gd name="T42" fmla="*/ 1586 w 4174"/>
              <a:gd name="T43" fmla="*/ 566 h 1243"/>
              <a:gd name="T44" fmla="*/ 1657 w 4174"/>
              <a:gd name="T45" fmla="*/ 558 h 1243"/>
              <a:gd name="T46" fmla="*/ 1731 w 4174"/>
              <a:gd name="T47" fmla="*/ 550 h 1243"/>
              <a:gd name="T48" fmla="*/ 1803 w 4174"/>
              <a:gd name="T49" fmla="*/ 545 h 1243"/>
              <a:gd name="T50" fmla="*/ 1876 w 4174"/>
              <a:gd name="T51" fmla="*/ 540 h 1243"/>
              <a:gd name="T52" fmla="*/ 1948 w 4174"/>
              <a:gd name="T53" fmla="*/ 532 h 1243"/>
              <a:gd name="T54" fmla="*/ 2021 w 4174"/>
              <a:gd name="T55" fmla="*/ 526 h 1243"/>
              <a:gd name="T56" fmla="*/ 2093 w 4174"/>
              <a:gd name="T57" fmla="*/ 518 h 1243"/>
              <a:gd name="T58" fmla="*/ 2165 w 4174"/>
              <a:gd name="T59" fmla="*/ 511 h 1243"/>
              <a:gd name="T60" fmla="*/ 2238 w 4174"/>
              <a:gd name="T61" fmla="*/ 504 h 1243"/>
              <a:gd name="T62" fmla="*/ 2310 w 4174"/>
              <a:gd name="T63" fmla="*/ 500 h 1243"/>
              <a:gd name="T64" fmla="*/ 2384 w 4174"/>
              <a:gd name="T65" fmla="*/ 511 h 1243"/>
              <a:gd name="T66" fmla="*/ 2455 w 4174"/>
              <a:gd name="T67" fmla="*/ 490 h 1243"/>
              <a:gd name="T68" fmla="*/ 2529 w 4174"/>
              <a:gd name="T69" fmla="*/ 504 h 1243"/>
              <a:gd name="T70" fmla="*/ 2601 w 4174"/>
              <a:gd name="T71" fmla="*/ 511 h 1243"/>
              <a:gd name="T72" fmla="*/ 2674 w 4174"/>
              <a:gd name="T73" fmla="*/ 513 h 1243"/>
              <a:gd name="T74" fmla="*/ 2746 w 4174"/>
              <a:gd name="T75" fmla="*/ 513 h 1243"/>
              <a:gd name="T76" fmla="*/ 2819 w 4174"/>
              <a:gd name="T77" fmla="*/ 511 h 1243"/>
              <a:gd name="T78" fmla="*/ 2891 w 4174"/>
              <a:gd name="T79" fmla="*/ 513 h 1243"/>
              <a:gd name="T80" fmla="*/ 2965 w 4174"/>
              <a:gd name="T81" fmla="*/ 513 h 1243"/>
              <a:gd name="T82" fmla="*/ 3036 w 4174"/>
              <a:gd name="T83" fmla="*/ 508 h 1243"/>
              <a:gd name="T84" fmla="*/ 3110 w 4174"/>
              <a:gd name="T85" fmla="*/ 506 h 1243"/>
              <a:gd name="T86" fmla="*/ 3182 w 4174"/>
              <a:gd name="T87" fmla="*/ 509 h 1243"/>
              <a:gd name="T88" fmla="*/ 3255 w 4174"/>
              <a:gd name="T89" fmla="*/ 504 h 1243"/>
              <a:gd name="T90" fmla="*/ 3327 w 4174"/>
              <a:gd name="T91" fmla="*/ 503 h 1243"/>
              <a:gd name="T92" fmla="*/ 3400 w 4174"/>
              <a:gd name="T93" fmla="*/ 503 h 1243"/>
              <a:gd name="T94" fmla="*/ 3472 w 4174"/>
              <a:gd name="T95" fmla="*/ 503 h 1243"/>
              <a:gd name="T96" fmla="*/ 3545 w 4174"/>
              <a:gd name="T97" fmla="*/ 504 h 1243"/>
              <a:gd name="T98" fmla="*/ 3617 w 4174"/>
              <a:gd name="T99" fmla="*/ 504 h 1243"/>
              <a:gd name="T100" fmla="*/ 3691 w 4174"/>
              <a:gd name="T101" fmla="*/ 501 h 1243"/>
              <a:gd name="T102" fmla="*/ 3762 w 4174"/>
              <a:gd name="T103" fmla="*/ 504 h 1243"/>
              <a:gd name="T104" fmla="*/ 3836 w 4174"/>
              <a:gd name="T105" fmla="*/ 506 h 1243"/>
              <a:gd name="T106" fmla="*/ 3908 w 4174"/>
              <a:gd name="T107" fmla="*/ 504 h 1243"/>
              <a:gd name="T108" fmla="*/ 3981 w 4174"/>
              <a:gd name="T109" fmla="*/ 503 h 1243"/>
              <a:gd name="T110" fmla="*/ 4053 w 4174"/>
              <a:gd name="T111" fmla="*/ 503 h 1243"/>
              <a:gd name="T112" fmla="*/ 4126 w 4174"/>
              <a:gd name="T113" fmla="*/ 504 h 12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243">
                <a:moveTo>
                  <a:pt x="0" y="780"/>
                </a:moveTo>
                <a:lnTo>
                  <a:pt x="13" y="779"/>
                </a:lnTo>
                <a:lnTo>
                  <a:pt x="24" y="780"/>
                </a:lnTo>
                <a:lnTo>
                  <a:pt x="37" y="780"/>
                </a:lnTo>
                <a:lnTo>
                  <a:pt x="49" y="780"/>
                </a:lnTo>
                <a:lnTo>
                  <a:pt x="60" y="779"/>
                </a:lnTo>
                <a:lnTo>
                  <a:pt x="73" y="780"/>
                </a:lnTo>
                <a:lnTo>
                  <a:pt x="85" y="779"/>
                </a:lnTo>
                <a:lnTo>
                  <a:pt x="98" y="777"/>
                </a:lnTo>
                <a:lnTo>
                  <a:pt x="109" y="777"/>
                </a:lnTo>
                <a:lnTo>
                  <a:pt x="120" y="777"/>
                </a:lnTo>
                <a:lnTo>
                  <a:pt x="133" y="779"/>
                </a:lnTo>
                <a:lnTo>
                  <a:pt x="145" y="779"/>
                </a:lnTo>
                <a:lnTo>
                  <a:pt x="158" y="775"/>
                </a:lnTo>
                <a:lnTo>
                  <a:pt x="169" y="774"/>
                </a:lnTo>
                <a:lnTo>
                  <a:pt x="182" y="762"/>
                </a:lnTo>
                <a:lnTo>
                  <a:pt x="194" y="765"/>
                </a:lnTo>
                <a:lnTo>
                  <a:pt x="205" y="770"/>
                </a:lnTo>
                <a:lnTo>
                  <a:pt x="218" y="779"/>
                </a:lnTo>
                <a:lnTo>
                  <a:pt x="230" y="596"/>
                </a:lnTo>
                <a:lnTo>
                  <a:pt x="243" y="0"/>
                </a:lnTo>
                <a:lnTo>
                  <a:pt x="254" y="23"/>
                </a:lnTo>
                <a:lnTo>
                  <a:pt x="266" y="1105"/>
                </a:lnTo>
                <a:lnTo>
                  <a:pt x="279" y="1243"/>
                </a:lnTo>
                <a:lnTo>
                  <a:pt x="290" y="1057"/>
                </a:lnTo>
                <a:lnTo>
                  <a:pt x="303" y="925"/>
                </a:lnTo>
                <a:lnTo>
                  <a:pt x="315" y="862"/>
                </a:lnTo>
                <a:lnTo>
                  <a:pt x="328" y="831"/>
                </a:lnTo>
                <a:lnTo>
                  <a:pt x="339" y="811"/>
                </a:lnTo>
                <a:lnTo>
                  <a:pt x="350" y="798"/>
                </a:lnTo>
                <a:lnTo>
                  <a:pt x="364" y="790"/>
                </a:lnTo>
                <a:lnTo>
                  <a:pt x="375" y="783"/>
                </a:lnTo>
                <a:lnTo>
                  <a:pt x="388" y="777"/>
                </a:lnTo>
                <a:lnTo>
                  <a:pt x="399" y="772"/>
                </a:lnTo>
                <a:lnTo>
                  <a:pt x="411" y="769"/>
                </a:lnTo>
                <a:lnTo>
                  <a:pt x="424" y="764"/>
                </a:lnTo>
                <a:lnTo>
                  <a:pt x="435" y="761"/>
                </a:lnTo>
                <a:lnTo>
                  <a:pt x="448" y="756"/>
                </a:lnTo>
                <a:lnTo>
                  <a:pt x="460" y="752"/>
                </a:lnTo>
                <a:lnTo>
                  <a:pt x="471" y="748"/>
                </a:lnTo>
                <a:lnTo>
                  <a:pt x="484" y="744"/>
                </a:lnTo>
                <a:lnTo>
                  <a:pt x="496" y="739"/>
                </a:lnTo>
                <a:lnTo>
                  <a:pt x="509" y="736"/>
                </a:lnTo>
                <a:lnTo>
                  <a:pt x="520" y="733"/>
                </a:lnTo>
                <a:lnTo>
                  <a:pt x="533" y="730"/>
                </a:lnTo>
                <a:lnTo>
                  <a:pt x="545" y="725"/>
                </a:lnTo>
                <a:lnTo>
                  <a:pt x="556" y="721"/>
                </a:lnTo>
                <a:lnTo>
                  <a:pt x="569" y="718"/>
                </a:lnTo>
                <a:lnTo>
                  <a:pt x="581" y="713"/>
                </a:lnTo>
                <a:lnTo>
                  <a:pt x="594" y="712"/>
                </a:lnTo>
                <a:lnTo>
                  <a:pt x="605" y="708"/>
                </a:lnTo>
                <a:lnTo>
                  <a:pt x="616" y="705"/>
                </a:lnTo>
                <a:lnTo>
                  <a:pt x="629" y="702"/>
                </a:lnTo>
                <a:lnTo>
                  <a:pt x="641" y="699"/>
                </a:lnTo>
                <a:lnTo>
                  <a:pt x="654" y="695"/>
                </a:lnTo>
                <a:lnTo>
                  <a:pt x="665" y="694"/>
                </a:lnTo>
                <a:lnTo>
                  <a:pt x="678" y="690"/>
                </a:lnTo>
                <a:lnTo>
                  <a:pt x="690" y="689"/>
                </a:lnTo>
                <a:lnTo>
                  <a:pt x="701" y="686"/>
                </a:lnTo>
                <a:lnTo>
                  <a:pt x="714" y="682"/>
                </a:lnTo>
                <a:lnTo>
                  <a:pt x="726" y="681"/>
                </a:lnTo>
                <a:lnTo>
                  <a:pt x="739" y="679"/>
                </a:lnTo>
                <a:lnTo>
                  <a:pt x="750" y="676"/>
                </a:lnTo>
                <a:lnTo>
                  <a:pt x="762" y="672"/>
                </a:lnTo>
                <a:lnTo>
                  <a:pt x="775" y="671"/>
                </a:lnTo>
                <a:lnTo>
                  <a:pt x="786" y="668"/>
                </a:lnTo>
                <a:lnTo>
                  <a:pt x="799" y="666"/>
                </a:lnTo>
                <a:lnTo>
                  <a:pt x="811" y="663"/>
                </a:lnTo>
                <a:lnTo>
                  <a:pt x="824" y="661"/>
                </a:lnTo>
                <a:lnTo>
                  <a:pt x="835" y="661"/>
                </a:lnTo>
                <a:lnTo>
                  <a:pt x="847" y="658"/>
                </a:lnTo>
                <a:lnTo>
                  <a:pt x="860" y="655"/>
                </a:lnTo>
                <a:lnTo>
                  <a:pt x="871" y="655"/>
                </a:lnTo>
                <a:lnTo>
                  <a:pt x="884" y="653"/>
                </a:lnTo>
                <a:lnTo>
                  <a:pt x="895" y="648"/>
                </a:lnTo>
                <a:lnTo>
                  <a:pt x="907" y="646"/>
                </a:lnTo>
                <a:lnTo>
                  <a:pt x="920" y="646"/>
                </a:lnTo>
                <a:lnTo>
                  <a:pt x="931" y="643"/>
                </a:lnTo>
                <a:lnTo>
                  <a:pt x="944" y="641"/>
                </a:lnTo>
                <a:lnTo>
                  <a:pt x="956" y="640"/>
                </a:lnTo>
                <a:lnTo>
                  <a:pt x="967" y="638"/>
                </a:lnTo>
                <a:lnTo>
                  <a:pt x="980" y="635"/>
                </a:lnTo>
                <a:lnTo>
                  <a:pt x="992" y="633"/>
                </a:lnTo>
                <a:lnTo>
                  <a:pt x="1005" y="632"/>
                </a:lnTo>
                <a:lnTo>
                  <a:pt x="1016" y="632"/>
                </a:lnTo>
                <a:lnTo>
                  <a:pt x="1029" y="628"/>
                </a:lnTo>
                <a:lnTo>
                  <a:pt x="1041" y="627"/>
                </a:lnTo>
                <a:lnTo>
                  <a:pt x="1052" y="625"/>
                </a:lnTo>
                <a:lnTo>
                  <a:pt x="1065" y="622"/>
                </a:lnTo>
                <a:lnTo>
                  <a:pt x="1077" y="622"/>
                </a:lnTo>
                <a:lnTo>
                  <a:pt x="1090" y="622"/>
                </a:lnTo>
                <a:lnTo>
                  <a:pt x="1101" y="619"/>
                </a:lnTo>
                <a:lnTo>
                  <a:pt x="1112" y="617"/>
                </a:lnTo>
                <a:lnTo>
                  <a:pt x="1126" y="615"/>
                </a:lnTo>
                <a:lnTo>
                  <a:pt x="1137" y="614"/>
                </a:lnTo>
                <a:lnTo>
                  <a:pt x="1150" y="612"/>
                </a:lnTo>
                <a:lnTo>
                  <a:pt x="1161" y="612"/>
                </a:lnTo>
                <a:lnTo>
                  <a:pt x="1174" y="612"/>
                </a:lnTo>
                <a:lnTo>
                  <a:pt x="1186" y="609"/>
                </a:lnTo>
                <a:lnTo>
                  <a:pt x="1197" y="609"/>
                </a:lnTo>
                <a:lnTo>
                  <a:pt x="1210" y="607"/>
                </a:lnTo>
                <a:lnTo>
                  <a:pt x="1222" y="606"/>
                </a:lnTo>
                <a:lnTo>
                  <a:pt x="1235" y="604"/>
                </a:lnTo>
                <a:lnTo>
                  <a:pt x="1246" y="602"/>
                </a:lnTo>
                <a:lnTo>
                  <a:pt x="1258" y="599"/>
                </a:lnTo>
                <a:lnTo>
                  <a:pt x="1271" y="596"/>
                </a:lnTo>
                <a:lnTo>
                  <a:pt x="1282" y="594"/>
                </a:lnTo>
                <a:lnTo>
                  <a:pt x="1295" y="593"/>
                </a:lnTo>
                <a:lnTo>
                  <a:pt x="1307" y="593"/>
                </a:lnTo>
                <a:lnTo>
                  <a:pt x="1318" y="593"/>
                </a:lnTo>
                <a:lnTo>
                  <a:pt x="1331" y="591"/>
                </a:lnTo>
                <a:lnTo>
                  <a:pt x="1343" y="589"/>
                </a:lnTo>
                <a:lnTo>
                  <a:pt x="1356" y="588"/>
                </a:lnTo>
                <a:lnTo>
                  <a:pt x="1367" y="588"/>
                </a:lnTo>
                <a:lnTo>
                  <a:pt x="1380" y="588"/>
                </a:lnTo>
                <a:lnTo>
                  <a:pt x="1392" y="584"/>
                </a:lnTo>
                <a:lnTo>
                  <a:pt x="1403" y="584"/>
                </a:lnTo>
                <a:lnTo>
                  <a:pt x="1416" y="583"/>
                </a:lnTo>
                <a:lnTo>
                  <a:pt x="1427" y="583"/>
                </a:lnTo>
                <a:lnTo>
                  <a:pt x="1440" y="580"/>
                </a:lnTo>
                <a:lnTo>
                  <a:pt x="1452" y="580"/>
                </a:lnTo>
                <a:lnTo>
                  <a:pt x="1463" y="578"/>
                </a:lnTo>
                <a:lnTo>
                  <a:pt x="1476" y="576"/>
                </a:lnTo>
                <a:lnTo>
                  <a:pt x="1488" y="575"/>
                </a:lnTo>
                <a:lnTo>
                  <a:pt x="1501" y="573"/>
                </a:lnTo>
                <a:lnTo>
                  <a:pt x="1512" y="571"/>
                </a:lnTo>
                <a:lnTo>
                  <a:pt x="1525" y="570"/>
                </a:lnTo>
                <a:lnTo>
                  <a:pt x="1537" y="571"/>
                </a:lnTo>
                <a:lnTo>
                  <a:pt x="1548" y="568"/>
                </a:lnTo>
                <a:lnTo>
                  <a:pt x="1561" y="568"/>
                </a:lnTo>
                <a:lnTo>
                  <a:pt x="1573" y="568"/>
                </a:lnTo>
                <a:lnTo>
                  <a:pt x="1586" y="566"/>
                </a:lnTo>
                <a:lnTo>
                  <a:pt x="1597" y="565"/>
                </a:lnTo>
                <a:lnTo>
                  <a:pt x="1609" y="565"/>
                </a:lnTo>
                <a:lnTo>
                  <a:pt x="1622" y="562"/>
                </a:lnTo>
                <a:lnTo>
                  <a:pt x="1633" y="562"/>
                </a:lnTo>
                <a:lnTo>
                  <a:pt x="1646" y="560"/>
                </a:lnTo>
                <a:lnTo>
                  <a:pt x="1657" y="558"/>
                </a:lnTo>
                <a:lnTo>
                  <a:pt x="1671" y="557"/>
                </a:lnTo>
                <a:lnTo>
                  <a:pt x="1682" y="555"/>
                </a:lnTo>
                <a:lnTo>
                  <a:pt x="1693" y="555"/>
                </a:lnTo>
                <a:lnTo>
                  <a:pt x="1706" y="553"/>
                </a:lnTo>
                <a:lnTo>
                  <a:pt x="1718" y="552"/>
                </a:lnTo>
                <a:lnTo>
                  <a:pt x="1731" y="550"/>
                </a:lnTo>
                <a:lnTo>
                  <a:pt x="1742" y="550"/>
                </a:lnTo>
                <a:lnTo>
                  <a:pt x="1754" y="549"/>
                </a:lnTo>
                <a:lnTo>
                  <a:pt x="1767" y="549"/>
                </a:lnTo>
                <a:lnTo>
                  <a:pt x="1778" y="547"/>
                </a:lnTo>
                <a:lnTo>
                  <a:pt x="1791" y="545"/>
                </a:lnTo>
                <a:lnTo>
                  <a:pt x="1803" y="545"/>
                </a:lnTo>
                <a:lnTo>
                  <a:pt x="1814" y="544"/>
                </a:lnTo>
                <a:lnTo>
                  <a:pt x="1827" y="542"/>
                </a:lnTo>
                <a:lnTo>
                  <a:pt x="1839" y="539"/>
                </a:lnTo>
                <a:lnTo>
                  <a:pt x="1852" y="540"/>
                </a:lnTo>
                <a:lnTo>
                  <a:pt x="1863" y="540"/>
                </a:lnTo>
                <a:lnTo>
                  <a:pt x="1876" y="540"/>
                </a:lnTo>
                <a:lnTo>
                  <a:pt x="1888" y="537"/>
                </a:lnTo>
                <a:lnTo>
                  <a:pt x="1899" y="537"/>
                </a:lnTo>
                <a:lnTo>
                  <a:pt x="1912" y="535"/>
                </a:lnTo>
                <a:lnTo>
                  <a:pt x="1923" y="534"/>
                </a:lnTo>
                <a:lnTo>
                  <a:pt x="1937" y="534"/>
                </a:lnTo>
                <a:lnTo>
                  <a:pt x="1948" y="532"/>
                </a:lnTo>
                <a:lnTo>
                  <a:pt x="1959" y="531"/>
                </a:lnTo>
                <a:lnTo>
                  <a:pt x="1972" y="531"/>
                </a:lnTo>
                <a:lnTo>
                  <a:pt x="1984" y="529"/>
                </a:lnTo>
                <a:lnTo>
                  <a:pt x="1997" y="529"/>
                </a:lnTo>
                <a:lnTo>
                  <a:pt x="2008" y="527"/>
                </a:lnTo>
                <a:lnTo>
                  <a:pt x="2021" y="526"/>
                </a:lnTo>
                <a:lnTo>
                  <a:pt x="2033" y="526"/>
                </a:lnTo>
                <a:lnTo>
                  <a:pt x="2044" y="524"/>
                </a:lnTo>
                <a:lnTo>
                  <a:pt x="2057" y="522"/>
                </a:lnTo>
                <a:lnTo>
                  <a:pt x="2069" y="521"/>
                </a:lnTo>
                <a:lnTo>
                  <a:pt x="2082" y="519"/>
                </a:lnTo>
                <a:lnTo>
                  <a:pt x="2093" y="518"/>
                </a:lnTo>
                <a:lnTo>
                  <a:pt x="2105" y="518"/>
                </a:lnTo>
                <a:lnTo>
                  <a:pt x="2118" y="516"/>
                </a:lnTo>
                <a:lnTo>
                  <a:pt x="2129" y="516"/>
                </a:lnTo>
                <a:lnTo>
                  <a:pt x="2142" y="516"/>
                </a:lnTo>
                <a:lnTo>
                  <a:pt x="2154" y="513"/>
                </a:lnTo>
                <a:lnTo>
                  <a:pt x="2165" y="511"/>
                </a:lnTo>
                <a:lnTo>
                  <a:pt x="2178" y="511"/>
                </a:lnTo>
                <a:lnTo>
                  <a:pt x="2189" y="509"/>
                </a:lnTo>
                <a:lnTo>
                  <a:pt x="2202" y="508"/>
                </a:lnTo>
                <a:lnTo>
                  <a:pt x="2214" y="508"/>
                </a:lnTo>
                <a:lnTo>
                  <a:pt x="2227" y="506"/>
                </a:lnTo>
                <a:lnTo>
                  <a:pt x="2238" y="504"/>
                </a:lnTo>
                <a:lnTo>
                  <a:pt x="2250" y="504"/>
                </a:lnTo>
                <a:lnTo>
                  <a:pt x="2263" y="506"/>
                </a:lnTo>
                <a:lnTo>
                  <a:pt x="2274" y="504"/>
                </a:lnTo>
                <a:lnTo>
                  <a:pt x="2287" y="503"/>
                </a:lnTo>
                <a:lnTo>
                  <a:pt x="2299" y="503"/>
                </a:lnTo>
                <a:lnTo>
                  <a:pt x="2310" y="500"/>
                </a:lnTo>
                <a:lnTo>
                  <a:pt x="2323" y="498"/>
                </a:lnTo>
                <a:lnTo>
                  <a:pt x="2335" y="498"/>
                </a:lnTo>
                <a:lnTo>
                  <a:pt x="2348" y="500"/>
                </a:lnTo>
                <a:lnTo>
                  <a:pt x="2359" y="509"/>
                </a:lnTo>
                <a:lnTo>
                  <a:pt x="2372" y="508"/>
                </a:lnTo>
                <a:lnTo>
                  <a:pt x="2384" y="511"/>
                </a:lnTo>
                <a:lnTo>
                  <a:pt x="2395" y="565"/>
                </a:lnTo>
                <a:lnTo>
                  <a:pt x="2408" y="549"/>
                </a:lnTo>
                <a:lnTo>
                  <a:pt x="2420" y="477"/>
                </a:lnTo>
                <a:lnTo>
                  <a:pt x="2433" y="475"/>
                </a:lnTo>
                <a:lnTo>
                  <a:pt x="2444" y="485"/>
                </a:lnTo>
                <a:lnTo>
                  <a:pt x="2455" y="490"/>
                </a:lnTo>
                <a:lnTo>
                  <a:pt x="2468" y="493"/>
                </a:lnTo>
                <a:lnTo>
                  <a:pt x="2480" y="495"/>
                </a:lnTo>
                <a:lnTo>
                  <a:pt x="2493" y="496"/>
                </a:lnTo>
                <a:lnTo>
                  <a:pt x="2504" y="500"/>
                </a:lnTo>
                <a:lnTo>
                  <a:pt x="2517" y="503"/>
                </a:lnTo>
                <a:lnTo>
                  <a:pt x="2529" y="504"/>
                </a:lnTo>
                <a:lnTo>
                  <a:pt x="2540" y="506"/>
                </a:lnTo>
                <a:lnTo>
                  <a:pt x="2553" y="506"/>
                </a:lnTo>
                <a:lnTo>
                  <a:pt x="2565" y="508"/>
                </a:lnTo>
                <a:lnTo>
                  <a:pt x="2578" y="509"/>
                </a:lnTo>
                <a:lnTo>
                  <a:pt x="2589" y="509"/>
                </a:lnTo>
                <a:lnTo>
                  <a:pt x="2601" y="511"/>
                </a:lnTo>
                <a:lnTo>
                  <a:pt x="2614" y="511"/>
                </a:lnTo>
                <a:lnTo>
                  <a:pt x="2625" y="511"/>
                </a:lnTo>
                <a:lnTo>
                  <a:pt x="2638" y="513"/>
                </a:lnTo>
                <a:lnTo>
                  <a:pt x="2650" y="513"/>
                </a:lnTo>
                <a:lnTo>
                  <a:pt x="2661" y="511"/>
                </a:lnTo>
                <a:lnTo>
                  <a:pt x="2674" y="513"/>
                </a:lnTo>
                <a:lnTo>
                  <a:pt x="2685" y="511"/>
                </a:lnTo>
                <a:lnTo>
                  <a:pt x="2699" y="511"/>
                </a:lnTo>
                <a:lnTo>
                  <a:pt x="2710" y="513"/>
                </a:lnTo>
                <a:lnTo>
                  <a:pt x="2723" y="513"/>
                </a:lnTo>
                <a:lnTo>
                  <a:pt x="2734" y="514"/>
                </a:lnTo>
                <a:lnTo>
                  <a:pt x="2746" y="513"/>
                </a:lnTo>
                <a:lnTo>
                  <a:pt x="2759" y="514"/>
                </a:lnTo>
                <a:lnTo>
                  <a:pt x="2770" y="514"/>
                </a:lnTo>
                <a:lnTo>
                  <a:pt x="2783" y="514"/>
                </a:lnTo>
                <a:lnTo>
                  <a:pt x="2795" y="513"/>
                </a:lnTo>
                <a:lnTo>
                  <a:pt x="2806" y="511"/>
                </a:lnTo>
                <a:lnTo>
                  <a:pt x="2819" y="511"/>
                </a:lnTo>
                <a:lnTo>
                  <a:pt x="2831" y="511"/>
                </a:lnTo>
                <a:lnTo>
                  <a:pt x="2844" y="513"/>
                </a:lnTo>
                <a:lnTo>
                  <a:pt x="2855" y="514"/>
                </a:lnTo>
                <a:lnTo>
                  <a:pt x="2868" y="513"/>
                </a:lnTo>
                <a:lnTo>
                  <a:pt x="2880" y="513"/>
                </a:lnTo>
                <a:lnTo>
                  <a:pt x="2891" y="513"/>
                </a:lnTo>
                <a:lnTo>
                  <a:pt x="2904" y="513"/>
                </a:lnTo>
                <a:lnTo>
                  <a:pt x="2916" y="513"/>
                </a:lnTo>
                <a:lnTo>
                  <a:pt x="2929" y="514"/>
                </a:lnTo>
                <a:lnTo>
                  <a:pt x="2940" y="514"/>
                </a:lnTo>
                <a:lnTo>
                  <a:pt x="2951" y="513"/>
                </a:lnTo>
                <a:lnTo>
                  <a:pt x="2965" y="513"/>
                </a:lnTo>
                <a:lnTo>
                  <a:pt x="2976" y="511"/>
                </a:lnTo>
                <a:lnTo>
                  <a:pt x="2989" y="511"/>
                </a:lnTo>
                <a:lnTo>
                  <a:pt x="3000" y="513"/>
                </a:lnTo>
                <a:lnTo>
                  <a:pt x="3012" y="511"/>
                </a:lnTo>
                <a:lnTo>
                  <a:pt x="3025" y="509"/>
                </a:lnTo>
                <a:lnTo>
                  <a:pt x="3036" y="508"/>
                </a:lnTo>
                <a:lnTo>
                  <a:pt x="3049" y="511"/>
                </a:lnTo>
                <a:lnTo>
                  <a:pt x="3061" y="511"/>
                </a:lnTo>
                <a:lnTo>
                  <a:pt x="3074" y="511"/>
                </a:lnTo>
                <a:lnTo>
                  <a:pt x="3085" y="511"/>
                </a:lnTo>
                <a:lnTo>
                  <a:pt x="3097" y="508"/>
                </a:lnTo>
                <a:lnTo>
                  <a:pt x="3110" y="506"/>
                </a:lnTo>
                <a:lnTo>
                  <a:pt x="3121" y="506"/>
                </a:lnTo>
                <a:lnTo>
                  <a:pt x="3134" y="508"/>
                </a:lnTo>
                <a:lnTo>
                  <a:pt x="3146" y="506"/>
                </a:lnTo>
                <a:lnTo>
                  <a:pt x="3157" y="508"/>
                </a:lnTo>
                <a:lnTo>
                  <a:pt x="3170" y="509"/>
                </a:lnTo>
                <a:lnTo>
                  <a:pt x="3182" y="509"/>
                </a:lnTo>
                <a:lnTo>
                  <a:pt x="3195" y="509"/>
                </a:lnTo>
                <a:lnTo>
                  <a:pt x="3206" y="508"/>
                </a:lnTo>
                <a:lnTo>
                  <a:pt x="3219" y="508"/>
                </a:lnTo>
                <a:lnTo>
                  <a:pt x="3230" y="508"/>
                </a:lnTo>
                <a:lnTo>
                  <a:pt x="3242" y="506"/>
                </a:lnTo>
                <a:lnTo>
                  <a:pt x="3255" y="504"/>
                </a:lnTo>
                <a:lnTo>
                  <a:pt x="3266" y="504"/>
                </a:lnTo>
                <a:lnTo>
                  <a:pt x="3279" y="504"/>
                </a:lnTo>
                <a:lnTo>
                  <a:pt x="3291" y="504"/>
                </a:lnTo>
                <a:lnTo>
                  <a:pt x="3302" y="504"/>
                </a:lnTo>
                <a:lnTo>
                  <a:pt x="3315" y="503"/>
                </a:lnTo>
                <a:lnTo>
                  <a:pt x="3327" y="503"/>
                </a:lnTo>
                <a:lnTo>
                  <a:pt x="3340" y="503"/>
                </a:lnTo>
                <a:lnTo>
                  <a:pt x="3351" y="504"/>
                </a:lnTo>
                <a:lnTo>
                  <a:pt x="3364" y="504"/>
                </a:lnTo>
                <a:lnTo>
                  <a:pt x="3376" y="503"/>
                </a:lnTo>
                <a:lnTo>
                  <a:pt x="3387" y="504"/>
                </a:lnTo>
                <a:lnTo>
                  <a:pt x="3400" y="503"/>
                </a:lnTo>
                <a:lnTo>
                  <a:pt x="3412" y="504"/>
                </a:lnTo>
                <a:lnTo>
                  <a:pt x="3425" y="504"/>
                </a:lnTo>
                <a:lnTo>
                  <a:pt x="3436" y="503"/>
                </a:lnTo>
                <a:lnTo>
                  <a:pt x="3447" y="503"/>
                </a:lnTo>
                <a:lnTo>
                  <a:pt x="3461" y="503"/>
                </a:lnTo>
                <a:lnTo>
                  <a:pt x="3472" y="503"/>
                </a:lnTo>
                <a:lnTo>
                  <a:pt x="3485" y="504"/>
                </a:lnTo>
                <a:lnTo>
                  <a:pt x="3496" y="506"/>
                </a:lnTo>
                <a:lnTo>
                  <a:pt x="3508" y="504"/>
                </a:lnTo>
                <a:lnTo>
                  <a:pt x="3521" y="503"/>
                </a:lnTo>
                <a:lnTo>
                  <a:pt x="3532" y="504"/>
                </a:lnTo>
                <a:lnTo>
                  <a:pt x="3545" y="504"/>
                </a:lnTo>
                <a:lnTo>
                  <a:pt x="3557" y="504"/>
                </a:lnTo>
                <a:lnTo>
                  <a:pt x="3570" y="503"/>
                </a:lnTo>
                <a:lnTo>
                  <a:pt x="3581" y="504"/>
                </a:lnTo>
                <a:lnTo>
                  <a:pt x="3593" y="504"/>
                </a:lnTo>
                <a:lnTo>
                  <a:pt x="3606" y="503"/>
                </a:lnTo>
                <a:lnTo>
                  <a:pt x="3617" y="504"/>
                </a:lnTo>
                <a:lnTo>
                  <a:pt x="3630" y="504"/>
                </a:lnTo>
                <a:lnTo>
                  <a:pt x="3642" y="503"/>
                </a:lnTo>
                <a:lnTo>
                  <a:pt x="3653" y="501"/>
                </a:lnTo>
                <a:lnTo>
                  <a:pt x="3666" y="501"/>
                </a:lnTo>
                <a:lnTo>
                  <a:pt x="3678" y="501"/>
                </a:lnTo>
                <a:lnTo>
                  <a:pt x="3691" y="501"/>
                </a:lnTo>
                <a:lnTo>
                  <a:pt x="3702" y="500"/>
                </a:lnTo>
                <a:lnTo>
                  <a:pt x="3715" y="501"/>
                </a:lnTo>
                <a:lnTo>
                  <a:pt x="3727" y="503"/>
                </a:lnTo>
                <a:lnTo>
                  <a:pt x="3738" y="503"/>
                </a:lnTo>
                <a:lnTo>
                  <a:pt x="3751" y="503"/>
                </a:lnTo>
                <a:lnTo>
                  <a:pt x="3762" y="504"/>
                </a:lnTo>
                <a:lnTo>
                  <a:pt x="3775" y="503"/>
                </a:lnTo>
                <a:lnTo>
                  <a:pt x="3787" y="503"/>
                </a:lnTo>
                <a:lnTo>
                  <a:pt x="3798" y="504"/>
                </a:lnTo>
                <a:lnTo>
                  <a:pt x="3811" y="506"/>
                </a:lnTo>
                <a:lnTo>
                  <a:pt x="3823" y="506"/>
                </a:lnTo>
                <a:lnTo>
                  <a:pt x="3836" y="506"/>
                </a:lnTo>
                <a:lnTo>
                  <a:pt x="3847" y="506"/>
                </a:lnTo>
                <a:lnTo>
                  <a:pt x="3859" y="504"/>
                </a:lnTo>
                <a:lnTo>
                  <a:pt x="3872" y="504"/>
                </a:lnTo>
                <a:lnTo>
                  <a:pt x="3883" y="504"/>
                </a:lnTo>
                <a:lnTo>
                  <a:pt x="3896" y="504"/>
                </a:lnTo>
                <a:lnTo>
                  <a:pt x="3908" y="504"/>
                </a:lnTo>
                <a:lnTo>
                  <a:pt x="3921" y="504"/>
                </a:lnTo>
                <a:lnTo>
                  <a:pt x="3932" y="504"/>
                </a:lnTo>
                <a:lnTo>
                  <a:pt x="3944" y="504"/>
                </a:lnTo>
                <a:lnTo>
                  <a:pt x="3957" y="504"/>
                </a:lnTo>
                <a:lnTo>
                  <a:pt x="3968" y="503"/>
                </a:lnTo>
                <a:lnTo>
                  <a:pt x="3981" y="503"/>
                </a:lnTo>
                <a:lnTo>
                  <a:pt x="3992" y="503"/>
                </a:lnTo>
                <a:lnTo>
                  <a:pt x="4004" y="501"/>
                </a:lnTo>
                <a:lnTo>
                  <a:pt x="4017" y="503"/>
                </a:lnTo>
                <a:lnTo>
                  <a:pt x="4028" y="501"/>
                </a:lnTo>
                <a:lnTo>
                  <a:pt x="4041" y="503"/>
                </a:lnTo>
                <a:lnTo>
                  <a:pt x="4053" y="503"/>
                </a:lnTo>
                <a:lnTo>
                  <a:pt x="4066" y="503"/>
                </a:lnTo>
                <a:lnTo>
                  <a:pt x="4077" y="506"/>
                </a:lnTo>
                <a:lnTo>
                  <a:pt x="4089" y="508"/>
                </a:lnTo>
                <a:lnTo>
                  <a:pt x="4102" y="506"/>
                </a:lnTo>
                <a:lnTo>
                  <a:pt x="4113" y="506"/>
                </a:lnTo>
                <a:lnTo>
                  <a:pt x="4126" y="504"/>
                </a:lnTo>
                <a:lnTo>
                  <a:pt x="4138" y="506"/>
                </a:lnTo>
                <a:lnTo>
                  <a:pt x="4149" y="506"/>
                </a:lnTo>
                <a:lnTo>
                  <a:pt x="4162" y="506"/>
                </a:lnTo>
                <a:lnTo>
                  <a:pt x="4174" y="506"/>
                </a:lnTo>
              </a:path>
            </a:pathLst>
          </a:custGeom>
          <a:noFill/>
          <a:ln w="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8" name="Freeform 96"/>
          <p:cNvSpPr>
            <a:spLocks/>
          </p:cNvSpPr>
          <p:nvPr/>
        </p:nvSpPr>
        <p:spPr bwMode="auto">
          <a:xfrm>
            <a:off x="672307" y="3441702"/>
            <a:ext cx="6626226" cy="2287588"/>
          </a:xfrm>
          <a:custGeom>
            <a:avLst/>
            <a:gdLst>
              <a:gd name="T0" fmla="*/ 60 w 4174"/>
              <a:gd name="T1" fmla="*/ 973 h 1441"/>
              <a:gd name="T2" fmla="*/ 133 w 4174"/>
              <a:gd name="T3" fmla="*/ 971 h 1441"/>
              <a:gd name="T4" fmla="*/ 205 w 4174"/>
              <a:gd name="T5" fmla="*/ 961 h 1441"/>
              <a:gd name="T6" fmla="*/ 279 w 4174"/>
              <a:gd name="T7" fmla="*/ 1354 h 1441"/>
              <a:gd name="T8" fmla="*/ 350 w 4174"/>
              <a:gd name="T9" fmla="*/ 1005 h 1441"/>
              <a:gd name="T10" fmla="*/ 424 w 4174"/>
              <a:gd name="T11" fmla="*/ 976 h 1441"/>
              <a:gd name="T12" fmla="*/ 496 w 4174"/>
              <a:gd name="T13" fmla="*/ 966 h 1441"/>
              <a:gd name="T14" fmla="*/ 569 w 4174"/>
              <a:gd name="T15" fmla="*/ 955 h 1441"/>
              <a:gd name="T16" fmla="*/ 641 w 4174"/>
              <a:gd name="T17" fmla="*/ 946 h 1441"/>
              <a:gd name="T18" fmla="*/ 714 w 4174"/>
              <a:gd name="T19" fmla="*/ 938 h 1441"/>
              <a:gd name="T20" fmla="*/ 786 w 4174"/>
              <a:gd name="T21" fmla="*/ 930 h 1441"/>
              <a:gd name="T22" fmla="*/ 860 w 4174"/>
              <a:gd name="T23" fmla="*/ 924 h 1441"/>
              <a:gd name="T24" fmla="*/ 931 w 4174"/>
              <a:gd name="T25" fmla="*/ 915 h 1441"/>
              <a:gd name="T26" fmla="*/ 1005 w 4174"/>
              <a:gd name="T27" fmla="*/ 907 h 1441"/>
              <a:gd name="T28" fmla="*/ 1077 w 4174"/>
              <a:gd name="T29" fmla="*/ 902 h 1441"/>
              <a:gd name="T30" fmla="*/ 1150 w 4174"/>
              <a:gd name="T31" fmla="*/ 896 h 1441"/>
              <a:gd name="T32" fmla="*/ 1222 w 4174"/>
              <a:gd name="T33" fmla="*/ 893 h 1441"/>
              <a:gd name="T34" fmla="*/ 1295 w 4174"/>
              <a:gd name="T35" fmla="*/ 886 h 1441"/>
              <a:gd name="T36" fmla="*/ 1367 w 4174"/>
              <a:gd name="T37" fmla="*/ 880 h 1441"/>
              <a:gd name="T38" fmla="*/ 1440 w 4174"/>
              <a:gd name="T39" fmla="*/ 875 h 1441"/>
              <a:gd name="T40" fmla="*/ 1512 w 4174"/>
              <a:gd name="T41" fmla="*/ 871 h 1441"/>
              <a:gd name="T42" fmla="*/ 1586 w 4174"/>
              <a:gd name="T43" fmla="*/ 865 h 1441"/>
              <a:gd name="T44" fmla="*/ 1657 w 4174"/>
              <a:gd name="T45" fmla="*/ 860 h 1441"/>
              <a:gd name="T46" fmla="*/ 1731 w 4174"/>
              <a:gd name="T47" fmla="*/ 853 h 1441"/>
              <a:gd name="T48" fmla="*/ 1803 w 4174"/>
              <a:gd name="T49" fmla="*/ 850 h 1441"/>
              <a:gd name="T50" fmla="*/ 1876 w 4174"/>
              <a:gd name="T51" fmla="*/ 847 h 1441"/>
              <a:gd name="T52" fmla="*/ 1948 w 4174"/>
              <a:gd name="T53" fmla="*/ 842 h 1441"/>
              <a:gd name="T54" fmla="*/ 2021 w 4174"/>
              <a:gd name="T55" fmla="*/ 837 h 1441"/>
              <a:gd name="T56" fmla="*/ 2093 w 4174"/>
              <a:gd name="T57" fmla="*/ 834 h 1441"/>
              <a:gd name="T58" fmla="*/ 2165 w 4174"/>
              <a:gd name="T59" fmla="*/ 831 h 1441"/>
              <a:gd name="T60" fmla="*/ 2238 w 4174"/>
              <a:gd name="T61" fmla="*/ 826 h 1441"/>
              <a:gd name="T62" fmla="*/ 2310 w 4174"/>
              <a:gd name="T63" fmla="*/ 822 h 1441"/>
              <a:gd name="T64" fmla="*/ 2384 w 4174"/>
              <a:gd name="T65" fmla="*/ 832 h 1441"/>
              <a:gd name="T66" fmla="*/ 2455 w 4174"/>
              <a:gd name="T67" fmla="*/ 800 h 1441"/>
              <a:gd name="T68" fmla="*/ 2529 w 4174"/>
              <a:gd name="T69" fmla="*/ 821 h 1441"/>
              <a:gd name="T70" fmla="*/ 2601 w 4174"/>
              <a:gd name="T71" fmla="*/ 826 h 1441"/>
              <a:gd name="T72" fmla="*/ 2674 w 4174"/>
              <a:gd name="T73" fmla="*/ 831 h 1441"/>
              <a:gd name="T74" fmla="*/ 2746 w 4174"/>
              <a:gd name="T75" fmla="*/ 831 h 1441"/>
              <a:gd name="T76" fmla="*/ 2819 w 4174"/>
              <a:gd name="T77" fmla="*/ 832 h 1441"/>
              <a:gd name="T78" fmla="*/ 2891 w 4174"/>
              <a:gd name="T79" fmla="*/ 831 h 1441"/>
              <a:gd name="T80" fmla="*/ 2965 w 4174"/>
              <a:gd name="T81" fmla="*/ 834 h 1441"/>
              <a:gd name="T82" fmla="*/ 3036 w 4174"/>
              <a:gd name="T83" fmla="*/ 832 h 1441"/>
              <a:gd name="T84" fmla="*/ 3110 w 4174"/>
              <a:gd name="T85" fmla="*/ 832 h 1441"/>
              <a:gd name="T86" fmla="*/ 3182 w 4174"/>
              <a:gd name="T87" fmla="*/ 831 h 1441"/>
              <a:gd name="T88" fmla="*/ 3255 w 4174"/>
              <a:gd name="T89" fmla="*/ 834 h 1441"/>
              <a:gd name="T90" fmla="*/ 3327 w 4174"/>
              <a:gd name="T91" fmla="*/ 832 h 1441"/>
              <a:gd name="T92" fmla="*/ 3400 w 4174"/>
              <a:gd name="T93" fmla="*/ 832 h 1441"/>
              <a:gd name="T94" fmla="*/ 3472 w 4174"/>
              <a:gd name="T95" fmla="*/ 832 h 1441"/>
              <a:gd name="T96" fmla="*/ 3545 w 4174"/>
              <a:gd name="T97" fmla="*/ 832 h 1441"/>
              <a:gd name="T98" fmla="*/ 3617 w 4174"/>
              <a:gd name="T99" fmla="*/ 832 h 1441"/>
              <a:gd name="T100" fmla="*/ 3691 w 4174"/>
              <a:gd name="T101" fmla="*/ 831 h 1441"/>
              <a:gd name="T102" fmla="*/ 3762 w 4174"/>
              <a:gd name="T103" fmla="*/ 829 h 1441"/>
              <a:gd name="T104" fmla="*/ 3836 w 4174"/>
              <a:gd name="T105" fmla="*/ 829 h 1441"/>
              <a:gd name="T106" fmla="*/ 3908 w 4174"/>
              <a:gd name="T107" fmla="*/ 829 h 1441"/>
              <a:gd name="T108" fmla="*/ 3981 w 4174"/>
              <a:gd name="T109" fmla="*/ 829 h 1441"/>
              <a:gd name="T110" fmla="*/ 4053 w 4174"/>
              <a:gd name="T111" fmla="*/ 824 h 1441"/>
              <a:gd name="T112" fmla="*/ 4126 w 4174"/>
              <a:gd name="T113" fmla="*/ 826 h 14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1441">
                <a:moveTo>
                  <a:pt x="0" y="974"/>
                </a:moveTo>
                <a:lnTo>
                  <a:pt x="13" y="973"/>
                </a:lnTo>
                <a:lnTo>
                  <a:pt x="24" y="974"/>
                </a:lnTo>
                <a:lnTo>
                  <a:pt x="37" y="973"/>
                </a:lnTo>
                <a:lnTo>
                  <a:pt x="49" y="974"/>
                </a:lnTo>
                <a:lnTo>
                  <a:pt x="60" y="973"/>
                </a:lnTo>
                <a:lnTo>
                  <a:pt x="73" y="974"/>
                </a:lnTo>
                <a:lnTo>
                  <a:pt x="85" y="973"/>
                </a:lnTo>
                <a:lnTo>
                  <a:pt x="98" y="971"/>
                </a:lnTo>
                <a:lnTo>
                  <a:pt x="109" y="971"/>
                </a:lnTo>
                <a:lnTo>
                  <a:pt x="120" y="971"/>
                </a:lnTo>
                <a:lnTo>
                  <a:pt x="133" y="971"/>
                </a:lnTo>
                <a:lnTo>
                  <a:pt x="145" y="969"/>
                </a:lnTo>
                <a:lnTo>
                  <a:pt x="158" y="971"/>
                </a:lnTo>
                <a:lnTo>
                  <a:pt x="169" y="969"/>
                </a:lnTo>
                <a:lnTo>
                  <a:pt x="182" y="966"/>
                </a:lnTo>
                <a:lnTo>
                  <a:pt x="194" y="956"/>
                </a:lnTo>
                <a:lnTo>
                  <a:pt x="205" y="961"/>
                </a:lnTo>
                <a:lnTo>
                  <a:pt x="218" y="964"/>
                </a:lnTo>
                <a:lnTo>
                  <a:pt x="230" y="973"/>
                </a:lnTo>
                <a:lnTo>
                  <a:pt x="243" y="632"/>
                </a:lnTo>
                <a:lnTo>
                  <a:pt x="254" y="0"/>
                </a:lnTo>
                <a:lnTo>
                  <a:pt x="266" y="304"/>
                </a:lnTo>
                <a:lnTo>
                  <a:pt x="279" y="1354"/>
                </a:lnTo>
                <a:lnTo>
                  <a:pt x="290" y="1441"/>
                </a:lnTo>
                <a:lnTo>
                  <a:pt x="303" y="1245"/>
                </a:lnTo>
                <a:lnTo>
                  <a:pt x="315" y="1116"/>
                </a:lnTo>
                <a:lnTo>
                  <a:pt x="328" y="1052"/>
                </a:lnTo>
                <a:lnTo>
                  <a:pt x="339" y="1021"/>
                </a:lnTo>
                <a:lnTo>
                  <a:pt x="350" y="1005"/>
                </a:lnTo>
                <a:lnTo>
                  <a:pt x="364" y="995"/>
                </a:lnTo>
                <a:lnTo>
                  <a:pt x="375" y="989"/>
                </a:lnTo>
                <a:lnTo>
                  <a:pt x="388" y="986"/>
                </a:lnTo>
                <a:lnTo>
                  <a:pt x="399" y="981"/>
                </a:lnTo>
                <a:lnTo>
                  <a:pt x="411" y="979"/>
                </a:lnTo>
                <a:lnTo>
                  <a:pt x="424" y="976"/>
                </a:lnTo>
                <a:lnTo>
                  <a:pt x="435" y="974"/>
                </a:lnTo>
                <a:lnTo>
                  <a:pt x="448" y="974"/>
                </a:lnTo>
                <a:lnTo>
                  <a:pt x="460" y="971"/>
                </a:lnTo>
                <a:lnTo>
                  <a:pt x="471" y="969"/>
                </a:lnTo>
                <a:lnTo>
                  <a:pt x="484" y="968"/>
                </a:lnTo>
                <a:lnTo>
                  <a:pt x="496" y="966"/>
                </a:lnTo>
                <a:lnTo>
                  <a:pt x="509" y="963"/>
                </a:lnTo>
                <a:lnTo>
                  <a:pt x="520" y="961"/>
                </a:lnTo>
                <a:lnTo>
                  <a:pt x="533" y="961"/>
                </a:lnTo>
                <a:lnTo>
                  <a:pt x="545" y="958"/>
                </a:lnTo>
                <a:lnTo>
                  <a:pt x="556" y="958"/>
                </a:lnTo>
                <a:lnTo>
                  <a:pt x="569" y="955"/>
                </a:lnTo>
                <a:lnTo>
                  <a:pt x="581" y="953"/>
                </a:lnTo>
                <a:lnTo>
                  <a:pt x="594" y="951"/>
                </a:lnTo>
                <a:lnTo>
                  <a:pt x="605" y="950"/>
                </a:lnTo>
                <a:lnTo>
                  <a:pt x="616" y="950"/>
                </a:lnTo>
                <a:lnTo>
                  <a:pt x="629" y="948"/>
                </a:lnTo>
                <a:lnTo>
                  <a:pt x="641" y="946"/>
                </a:lnTo>
                <a:lnTo>
                  <a:pt x="654" y="945"/>
                </a:lnTo>
                <a:lnTo>
                  <a:pt x="665" y="943"/>
                </a:lnTo>
                <a:lnTo>
                  <a:pt x="678" y="942"/>
                </a:lnTo>
                <a:lnTo>
                  <a:pt x="690" y="942"/>
                </a:lnTo>
                <a:lnTo>
                  <a:pt x="701" y="940"/>
                </a:lnTo>
                <a:lnTo>
                  <a:pt x="714" y="938"/>
                </a:lnTo>
                <a:lnTo>
                  <a:pt x="726" y="937"/>
                </a:lnTo>
                <a:lnTo>
                  <a:pt x="739" y="935"/>
                </a:lnTo>
                <a:lnTo>
                  <a:pt x="750" y="935"/>
                </a:lnTo>
                <a:lnTo>
                  <a:pt x="762" y="933"/>
                </a:lnTo>
                <a:lnTo>
                  <a:pt x="775" y="932"/>
                </a:lnTo>
                <a:lnTo>
                  <a:pt x="786" y="930"/>
                </a:lnTo>
                <a:lnTo>
                  <a:pt x="799" y="930"/>
                </a:lnTo>
                <a:lnTo>
                  <a:pt x="811" y="927"/>
                </a:lnTo>
                <a:lnTo>
                  <a:pt x="824" y="925"/>
                </a:lnTo>
                <a:lnTo>
                  <a:pt x="835" y="925"/>
                </a:lnTo>
                <a:lnTo>
                  <a:pt x="847" y="925"/>
                </a:lnTo>
                <a:lnTo>
                  <a:pt x="860" y="924"/>
                </a:lnTo>
                <a:lnTo>
                  <a:pt x="871" y="922"/>
                </a:lnTo>
                <a:lnTo>
                  <a:pt x="884" y="922"/>
                </a:lnTo>
                <a:lnTo>
                  <a:pt x="895" y="919"/>
                </a:lnTo>
                <a:lnTo>
                  <a:pt x="907" y="919"/>
                </a:lnTo>
                <a:lnTo>
                  <a:pt x="920" y="919"/>
                </a:lnTo>
                <a:lnTo>
                  <a:pt x="931" y="915"/>
                </a:lnTo>
                <a:lnTo>
                  <a:pt x="944" y="914"/>
                </a:lnTo>
                <a:lnTo>
                  <a:pt x="956" y="912"/>
                </a:lnTo>
                <a:lnTo>
                  <a:pt x="967" y="912"/>
                </a:lnTo>
                <a:lnTo>
                  <a:pt x="980" y="911"/>
                </a:lnTo>
                <a:lnTo>
                  <a:pt x="992" y="909"/>
                </a:lnTo>
                <a:lnTo>
                  <a:pt x="1005" y="907"/>
                </a:lnTo>
                <a:lnTo>
                  <a:pt x="1016" y="907"/>
                </a:lnTo>
                <a:lnTo>
                  <a:pt x="1029" y="907"/>
                </a:lnTo>
                <a:lnTo>
                  <a:pt x="1041" y="906"/>
                </a:lnTo>
                <a:lnTo>
                  <a:pt x="1052" y="902"/>
                </a:lnTo>
                <a:lnTo>
                  <a:pt x="1065" y="902"/>
                </a:lnTo>
                <a:lnTo>
                  <a:pt x="1077" y="902"/>
                </a:lnTo>
                <a:lnTo>
                  <a:pt x="1090" y="899"/>
                </a:lnTo>
                <a:lnTo>
                  <a:pt x="1101" y="899"/>
                </a:lnTo>
                <a:lnTo>
                  <a:pt x="1112" y="899"/>
                </a:lnTo>
                <a:lnTo>
                  <a:pt x="1126" y="897"/>
                </a:lnTo>
                <a:lnTo>
                  <a:pt x="1137" y="897"/>
                </a:lnTo>
                <a:lnTo>
                  <a:pt x="1150" y="896"/>
                </a:lnTo>
                <a:lnTo>
                  <a:pt x="1161" y="894"/>
                </a:lnTo>
                <a:lnTo>
                  <a:pt x="1174" y="896"/>
                </a:lnTo>
                <a:lnTo>
                  <a:pt x="1186" y="894"/>
                </a:lnTo>
                <a:lnTo>
                  <a:pt x="1197" y="893"/>
                </a:lnTo>
                <a:lnTo>
                  <a:pt x="1210" y="891"/>
                </a:lnTo>
                <a:lnTo>
                  <a:pt x="1222" y="893"/>
                </a:lnTo>
                <a:lnTo>
                  <a:pt x="1235" y="891"/>
                </a:lnTo>
                <a:lnTo>
                  <a:pt x="1246" y="891"/>
                </a:lnTo>
                <a:lnTo>
                  <a:pt x="1258" y="889"/>
                </a:lnTo>
                <a:lnTo>
                  <a:pt x="1271" y="889"/>
                </a:lnTo>
                <a:lnTo>
                  <a:pt x="1282" y="888"/>
                </a:lnTo>
                <a:lnTo>
                  <a:pt x="1295" y="886"/>
                </a:lnTo>
                <a:lnTo>
                  <a:pt x="1307" y="884"/>
                </a:lnTo>
                <a:lnTo>
                  <a:pt x="1318" y="884"/>
                </a:lnTo>
                <a:lnTo>
                  <a:pt x="1331" y="883"/>
                </a:lnTo>
                <a:lnTo>
                  <a:pt x="1343" y="881"/>
                </a:lnTo>
                <a:lnTo>
                  <a:pt x="1356" y="881"/>
                </a:lnTo>
                <a:lnTo>
                  <a:pt x="1367" y="880"/>
                </a:lnTo>
                <a:lnTo>
                  <a:pt x="1380" y="880"/>
                </a:lnTo>
                <a:lnTo>
                  <a:pt x="1392" y="878"/>
                </a:lnTo>
                <a:lnTo>
                  <a:pt x="1403" y="876"/>
                </a:lnTo>
                <a:lnTo>
                  <a:pt x="1416" y="875"/>
                </a:lnTo>
                <a:lnTo>
                  <a:pt x="1427" y="876"/>
                </a:lnTo>
                <a:lnTo>
                  <a:pt x="1440" y="875"/>
                </a:lnTo>
                <a:lnTo>
                  <a:pt x="1452" y="873"/>
                </a:lnTo>
                <a:lnTo>
                  <a:pt x="1463" y="875"/>
                </a:lnTo>
                <a:lnTo>
                  <a:pt x="1476" y="873"/>
                </a:lnTo>
                <a:lnTo>
                  <a:pt x="1488" y="873"/>
                </a:lnTo>
                <a:lnTo>
                  <a:pt x="1501" y="871"/>
                </a:lnTo>
                <a:lnTo>
                  <a:pt x="1512" y="871"/>
                </a:lnTo>
                <a:lnTo>
                  <a:pt x="1525" y="868"/>
                </a:lnTo>
                <a:lnTo>
                  <a:pt x="1537" y="868"/>
                </a:lnTo>
                <a:lnTo>
                  <a:pt x="1548" y="868"/>
                </a:lnTo>
                <a:lnTo>
                  <a:pt x="1561" y="868"/>
                </a:lnTo>
                <a:lnTo>
                  <a:pt x="1573" y="866"/>
                </a:lnTo>
                <a:lnTo>
                  <a:pt x="1586" y="865"/>
                </a:lnTo>
                <a:lnTo>
                  <a:pt x="1597" y="863"/>
                </a:lnTo>
                <a:lnTo>
                  <a:pt x="1609" y="863"/>
                </a:lnTo>
                <a:lnTo>
                  <a:pt x="1622" y="863"/>
                </a:lnTo>
                <a:lnTo>
                  <a:pt x="1633" y="862"/>
                </a:lnTo>
                <a:lnTo>
                  <a:pt x="1646" y="862"/>
                </a:lnTo>
                <a:lnTo>
                  <a:pt x="1657" y="860"/>
                </a:lnTo>
                <a:lnTo>
                  <a:pt x="1671" y="860"/>
                </a:lnTo>
                <a:lnTo>
                  <a:pt x="1682" y="860"/>
                </a:lnTo>
                <a:lnTo>
                  <a:pt x="1693" y="857"/>
                </a:lnTo>
                <a:lnTo>
                  <a:pt x="1706" y="857"/>
                </a:lnTo>
                <a:lnTo>
                  <a:pt x="1718" y="855"/>
                </a:lnTo>
                <a:lnTo>
                  <a:pt x="1731" y="853"/>
                </a:lnTo>
                <a:lnTo>
                  <a:pt x="1742" y="853"/>
                </a:lnTo>
                <a:lnTo>
                  <a:pt x="1754" y="852"/>
                </a:lnTo>
                <a:lnTo>
                  <a:pt x="1767" y="852"/>
                </a:lnTo>
                <a:lnTo>
                  <a:pt x="1778" y="852"/>
                </a:lnTo>
                <a:lnTo>
                  <a:pt x="1791" y="852"/>
                </a:lnTo>
                <a:lnTo>
                  <a:pt x="1803" y="850"/>
                </a:lnTo>
                <a:lnTo>
                  <a:pt x="1814" y="849"/>
                </a:lnTo>
                <a:lnTo>
                  <a:pt x="1827" y="849"/>
                </a:lnTo>
                <a:lnTo>
                  <a:pt x="1839" y="849"/>
                </a:lnTo>
                <a:lnTo>
                  <a:pt x="1852" y="847"/>
                </a:lnTo>
                <a:lnTo>
                  <a:pt x="1863" y="845"/>
                </a:lnTo>
                <a:lnTo>
                  <a:pt x="1876" y="847"/>
                </a:lnTo>
                <a:lnTo>
                  <a:pt x="1888" y="849"/>
                </a:lnTo>
                <a:lnTo>
                  <a:pt x="1899" y="845"/>
                </a:lnTo>
                <a:lnTo>
                  <a:pt x="1912" y="844"/>
                </a:lnTo>
                <a:lnTo>
                  <a:pt x="1923" y="845"/>
                </a:lnTo>
                <a:lnTo>
                  <a:pt x="1937" y="842"/>
                </a:lnTo>
                <a:lnTo>
                  <a:pt x="1948" y="842"/>
                </a:lnTo>
                <a:lnTo>
                  <a:pt x="1959" y="842"/>
                </a:lnTo>
                <a:lnTo>
                  <a:pt x="1972" y="840"/>
                </a:lnTo>
                <a:lnTo>
                  <a:pt x="1984" y="839"/>
                </a:lnTo>
                <a:lnTo>
                  <a:pt x="1997" y="837"/>
                </a:lnTo>
                <a:lnTo>
                  <a:pt x="2008" y="837"/>
                </a:lnTo>
                <a:lnTo>
                  <a:pt x="2021" y="837"/>
                </a:lnTo>
                <a:lnTo>
                  <a:pt x="2033" y="835"/>
                </a:lnTo>
                <a:lnTo>
                  <a:pt x="2044" y="835"/>
                </a:lnTo>
                <a:lnTo>
                  <a:pt x="2057" y="834"/>
                </a:lnTo>
                <a:lnTo>
                  <a:pt x="2069" y="834"/>
                </a:lnTo>
                <a:lnTo>
                  <a:pt x="2082" y="834"/>
                </a:lnTo>
                <a:lnTo>
                  <a:pt x="2093" y="834"/>
                </a:lnTo>
                <a:lnTo>
                  <a:pt x="2105" y="832"/>
                </a:lnTo>
                <a:lnTo>
                  <a:pt x="2118" y="832"/>
                </a:lnTo>
                <a:lnTo>
                  <a:pt x="2129" y="832"/>
                </a:lnTo>
                <a:lnTo>
                  <a:pt x="2142" y="831"/>
                </a:lnTo>
                <a:lnTo>
                  <a:pt x="2154" y="829"/>
                </a:lnTo>
                <a:lnTo>
                  <a:pt x="2165" y="831"/>
                </a:lnTo>
                <a:lnTo>
                  <a:pt x="2178" y="829"/>
                </a:lnTo>
                <a:lnTo>
                  <a:pt x="2189" y="829"/>
                </a:lnTo>
                <a:lnTo>
                  <a:pt x="2202" y="827"/>
                </a:lnTo>
                <a:lnTo>
                  <a:pt x="2214" y="827"/>
                </a:lnTo>
                <a:lnTo>
                  <a:pt x="2227" y="826"/>
                </a:lnTo>
                <a:lnTo>
                  <a:pt x="2238" y="826"/>
                </a:lnTo>
                <a:lnTo>
                  <a:pt x="2250" y="827"/>
                </a:lnTo>
                <a:lnTo>
                  <a:pt x="2263" y="826"/>
                </a:lnTo>
                <a:lnTo>
                  <a:pt x="2274" y="824"/>
                </a:lnTo>
                <a:lnTo>
                  <a:pt x="2287" y="824"/>
                </a:lnTo>
                <a:lnTo>
                  <a:pt x="2299" y="824"/>
                </a:lnTo>
                <a:lnTo>
                  <a:pt x="2310" y="822"/>
                </a:lnTo>
                <a:lnTo>
                  <a:pt x="2323" y="821"/>
                </a:lnTo>
                <a:lnTo>
                  <a:pt x="2335" y="821"/>
                </a:lnTo>
                <a:lnTo>
                  <a:pt x="2348" y="819"/>
                </a:lnTo>
                <a:lnTo>
                  <a:pt x="2359" y="824"/>
                </a:lnTo>
                <a:lnTo>
                  <a:pt x="2372" y="832"/>
                </a:lnTo>
                <a:lnTo>
                  <a:pt x="2384" y="832"/>
                </a:lnTo>
                <a:lnTo>
                  <a:pt x="2395" y="837"/>
                </a:lnTo>
                <a:lnTo>
                  <a:pt x="2408" y="884"/>
                </a:lnTo>
                <a:lnTo>
                  <a:pt x="2420" y="852"/>
                </a:lnTo>
                <a:lnTo>
                  <a:pt x="2433" y="780"/>
                </a:lnTo>
                <a:lnTo>
                  <a:pt x="2444" y="788"/>
                </a:lnTo>
                <a:lnTo>
                  <a:pt x="2455" y="800"/>
                </a:lnTo>
                <a:lnTo>
                  <a:pt x="2468" y="806"/>
                </a:lnTo>
                <a:lnTo>
                  <a:pt x="2480" y="811"/>
                </a:lnTo>
                <a:lnTo>
                  <a:pt x="2493" y="814"/>
                </a:lnTo>
                <a:lnTo>
                  <a:pt x="2504" y="818"/>
                </a:lnTo>
                <a:lnTo>
                  <a:pt x="2517" y="819"/>
                </a:lnTo>
                <a:lnTo>
                  <a:pt x="2529" y="821"/>
                </a:lnTo>
                <a:lnTo>
                  <a:pt x="2540" y="822"/>
                </a:lnTo>
                <a:lnTo>
                  <a:pt x="2553" y="822"/>
                </a:lnTo>
                <a:lnTo>
                  <a:pt x="2565" y="822"/>
                </a:lnTo>
                <a:lnTo>
                  <a:pt x="2578" y="824"/>
                </a:lnTo>
                <a:lnTo>
                  <a:pt x="2589" y="826"/>
                </a:lnTo>
                <a:lnTo>
                  <a:pt x="2601" y="826"/>
                </a:lnTo>
                <a:lnTo>
                  <a:pt x="2614" y="826"/>
                </a:lnTo>
                <a:lnTo>
                  <a:pt x="2625" y="827"/>
                </a:lnTo>
                <a:lnTo>
                  <a:pt x="2638" y="829"/>
                </a:lnTo>
                <a:lnTo>
                  <a:pt x="2650" y="831"/>
                </a:lnTo>
                <a:lnTo>
                  <a:pt x="2661" y="831"/>
                </a:lnTo>
                <a:lnTo>
                  <a:pt x="2674" y="831"/>
                </a:lnTo>
                <a:lnTo>
                  <a:pt x="2685" y="829"/>
                </a:lnTo>
                <a:lnTo>
                  <a:pt x="2699" y="831"/>
                </a:lnTo>
                <a:lnTo>
                  <a:pt x="2710" y="831"/>
                </a:lnTo>
                <a:lnTo>
                  <a:pt x="2723" y="831"/>
                </a:lnTo>
                <a:lnTo>
                  <a:pt x="2734" y="831"/>
                </a:lnTo>
                <a:lnTo>
                  <a:pt x="2746" y="831"/>
                </a:lnTo>
                <a:lnTo>
                  <a:pt x="2759" y="831"/>
                </a:lnTo>
                <a:lnTo>
                  <a:pt x="2770" y="832"/>
                </a:lnTo>
                <a:lnTo>
                  <a:pt x="2783" y="832"/>
                </a:lnTo>
                <a:lnTo>
                  <a:pt x="2795" y="832"/>
                </a:lnTo>
                <a:lnTo>
                  <a:pt x="2806" y="832"/>
                </a:lnTo>
                <a:lnTo>
                  <a:pt x="2819" y="832"/>
                </a:lnTo>
                <a:lnTo>
                  <a:pt x="2831" y="832"/>
                </a:lnTo>
                <a:lnTo>
                  <a:pt x="2844" y="831"/>
                </a:lnTo>
                <a:lnTo>
                  <a:pt x="2855" y="832"/>
                </a:lnTo>
                <a:lnTo>
                  <a:pt x="2868" y="832"/>
                </a:lnTo>
                <a:lnTo>
                  <a:pt x="2880" y="832"/>
                </a:lnTo>
                <a:lnTo>
                  <a:pt x="2891" y="831"/>
                </a:lnTo>
                <a:lnTo>
                  <a:pt x="2904" y="831"/>
                </a:lnTo>
                <a:lnTo>
                  <a:pt x="2916" y="831"/>
                </a:lnTo>
                <a:lnTo>
                  <a:pt x="2929" y="832"/>
                </a:lnTo>
                <a:lnTo>
                  <a:pt x="2940" y="831"/>
                </a:lnTo>
                <a:lnTo>
                  <a:pt x="2951" y="832"/>
                </a:lnTo>
                <a:lnTo>
                  <a:pt x="2965" y="834"/>
                </a:lnTo>
                <a:lnTo>
                  <a:pt x="2976" y="832"/>
                </a:lnTo>
                <a:lnTo>
                  <a:pt x="2989" y="832"/>
                </a:lnTo>
                <a:lnTo>
                  <a:pt x="3000" y="834"/>
                </a:lnTo>
                <a:lnTo>
                  <a:pt x="3012" y="832"/>
                </a:lnTo>
                <a:lnTo>
                  <a:pt x="3025" y="831"/>
                </a:lnTo>
                <a:lnTo>
                  <a:pt x="3036" y="832"/>
                </a:lnTo>
                <a:lnTo>
                  <a:pt x="3049" y="832"/>
                </a:lnTo>
                <a:lnTo>
                  <a:pt x="3061" y="832"/>
                </a:lnTo>
                <a:lnTo>
                  <a:pt x="3074" y="832"/>
                </a:lnTo>
                <a:lnTo>
                  <a:pt x="3085" y="832"/>
                </a:lnTo>
                <a:lnTo>
                  <a:pt x="3097" y="832"/>
                </a:lnTo>
                <a:lnTo>
                  <a:pt x="3110" y="832"/>
                </a:lnTo>
                <a:lnTo>
                  <a:pt x="3121" y="831"/>
                </a:lnTo>
                <a:lnTo>
                  <a:pt x="3134" y="832"/>
                </a:lnTo>
                <a:lnTo>
                  <a:pt x="3146" y="832"/>
                </a:lnTo>
                <a:lnTo>
                  <a:pt x="3157" y="832"/>
                </a:lnTo>
                <a:lnTo>
                  <a:pt x="3170" y="832"/>
                </a:lnTo>
                <a:lnTo>
                  <a:pt x="3182" y="831"/>
                </a:lnTo>
                <a:lnTo>
                  <a:pt x="3195" y="832"/>
                </a:lnTo>
                <a:lnTo>
                  <a:pt x="3206" y="831"/>
                </a:lnTo>
                <a:lnTo>
                  <a:pt x="3219" y="834"/>
                </a:lnTo>
                <a:lnTo>
                  <a:pt x="3230" y="834"/>
                </a:lnTo>
                <a:lnTo>
                  <a:pt x="3242" y="832"/>
                </a:lnTo>
                <a:lnTo>
                  <a:pt x="3255" y="834"/>
                </a:lnTo>
                <a:lnTo>
                  <a:pt x="3266" y="834"/>
                </a:lnTo>
                <a:lnTo>
                  <a:pt x="3279" y="832"/>
                </a:lnTo>
                <a:lnTo>
                  <a:pt x="3291" y="834"/>
                </a:lnTo>
                <a:lnTo>
                  <a:pt x="3302" y="834"/>
                </a:lnTo>
                <a:lnTo>
                  <a:pt x="3315" y="834"/>
                </a:lnTo>
                <a:lnTo>
                  <a:pt x="3327" y="832"/>
                </a:lnTo>
                <a:lnTo>
                  <a:pt x="3340" y="834"/>
                </a:lnTo>
                <a:lnTo>
                  <a:pt x="3351" y="834"/>
                </a:lnTo>
                <a:lnTo>
                  <a:pt x="3364" y="834"/>
                </a:lnTo>
                <a:lnTo>
                  <a:pt x="3376" y="834"/>
                </a:lnTo>
                <a:lnTo>
                  <a:pt x="3387" y="832"/>
                </a:lnTo>
                <a:lnTo>
                  <a:pt x="3400" y="832"/>
                </a:lnTo>
                <a:lnTo>
                  <a:pt x="3412" y="832"/>
                </a:lnTo>
                <a:lnTo>
                  <a:pt x="3425" y="834"/>
                </a:lnTo>
                <a:lnTo>
                  <a:pt x="3436" y="832"/>
                </a:lnTo>
                <a:lnTo>
                  <a:pt x="3447" y="832"/>
                </a:lnTo>
                <a:lnTo>
                  <a:pt x="3461" y="832"/>
                </a:lnTo>
                <a:lnTo>
                  <a:pt x="3472" y="832"/>
                </a:lnTo>
                <a:lnTo>
                  <a:pt x="3485" y="832"/>
                </a:lnTo>
                <a:lnTo>
                  <a:pt x="3496" y="832"/>
                </a:lnTo>
                <a:lnTo>
                  <a:pt x="3508" y="834"/>
                </a:lnTo>
                <a:lnTo>
                  <a:pt x="3521" y="834"/>
                </a:lnTo>
                <a:lnTo>
                  <a:pt x="3532" y="832"/>
                </a:lnTo>
                <a:lnTo>
                  <a:pt x="3545" y="832"/>
                </a:lnTo>
                <a:lnTo>
                  <a:pt x="3557" y="831"/>
                </a:lnTo>
                <a:lnTo>
                  <a:pt x="3570" y="831"/>
                </a:lnTo>
                <a:lnTo>
                  <a:pt x="3581" y="831"/>
                </a:lnTo>
                <a:lnTo>
                  <a:pt x="3593" y="831"/>
                </a:lnTo>
                <a:lnTo>
                  <a:pt x="3606" y="831"/>
                </a:lnTo>
                <a:lnTo>
                  <a:pt x="3617" y="832"/>
                </a:lnTo>
                <a:lnTo>
                  <a:pt x="3630" y="831"/>
                </a:lnTo>
                <a:lnTo>
                  <a:pt x="3642" y="831"/>
                </a:lnTo>
                <a:lnTo>
                  <a:pt x="3653" y="832"/>
                </a:lnTo>
                <a:lnTo>
                  <a:pt x="3666" y="831"/>
                </a:lnTo>
                <a:lnTo>
                  <a:pt x="3678" y="832"/>
                </a:lnTo>
                <a:lnTo>
                  <a:pt x="3691" y="831"/>
                </a:lnTo>
                <a:lnTo>
                  <a:pt x="3702" y="831"/>
                </a:lnTo>
                <a:lnTo>
                  <a:pt x="3715" y="831"/>
                </a:lnTo>
                <a:lnTo>
                  <a:pt x="3727" y="831"/>
                </a:lnTo>
                <a:lnTo>
                  <a:pt x="3738" y="829"/>
                </a:lnTo>
                <a:lnTo>
                  <a:pt x="3751" y="829"/>
                </a:lnTo>
                <a:lnTo>
                  <a:pt x="3762" y="829"/>
                </a:lnTo>
                <a:lnTo>
                  <a:pt x="3775" y="831"/>
                </a:lnTo>
                <a:lnTo>
                  <a:pt x="3787" y="829"/>
                </a:lnTo>
                <a:lnTo>
                  <a:pt x="3798" y="829"/>
                </a:lnTo>
                <a:lnTo>
                  <a:pt x="3811" y="829"/>
                </a:lnTo>
                <a:lnTo>
                  <a:pt x="3823" y="831"/>
                </a:lnTo>
                <a:lnTo>
                  <a:pt x="3836" y="829"/>
                </a:lnTo>
                <a:lnTo>
                  <a:pt x="3847" y="829"/>
                </a:lnTo>
                <a:lnTo>
                  <a:pt x="3859" y="831"/>
                </a:lnTo>
                <a:lnTo>
                  <a:pt x="3872" y="829"/>
                </a:lnTo>
                <a:lnTo>
                  <a:pt x="3883" y="829"/>
                </a:lnTo>
                <a:lnTo>
                  <a:pt x="3896" y="831"/>
                </a:lnTo>
                <a:lnTo>
                  <a:pt x="3908" y="829"/>
                </a:lnTo>
                <a:lnTo>
                  <a:pt x="3921" y="829"/>
                </a:lnTo>
                <a:lnTo>
                  <a:pt x="3932" y="827"/>
                </a:lnTo>
                <a:lnTo>
                  <a:pt x="3944" y="827"/>
                </a:lnTo>
                <a:lnTo>
                  <a:pt x="3957" y="827"/>
                </a:lnTo>
                <a:lnTo>
                  <a:pt x="3968" y="827"/>
                </a:lnTo>
                <a:lnTo>
                  <a:pt x="3981" y="829"/>
                </a:lnTo>
                <a:lnTo>
                  <a:pt x="3992" y="827"/>
                </a:lnTo>
                <a:lnTo>
                  <a:pt x="4004" y="827"/>
                </a:lnTo>
                <a:lnTo>
                  <a:pt x="4017" y="827"/>
                </a:lnTo>
                <a:lnTo>
                  <a:pt x="4028" y="827"/>
                </a:lnTo>
                <a:lnTo>
                  <a:pt x="4041" y="822"/>
                </a:lnTo>
                <a:lnTo>
                  <a:pt x="4053" y="824"/>
                </a:lnTo>
                <a:lnTo>
                  <a:pt x="4066" y="826"/>
                </a:lnTo>
                <a:lnTo>
                  <a:pt x="4077" y="826"/>
                </a:lnTo>
                <a:lnTo>
                  <a:pt x="4089" y="827"/>
                </a:lnTo>
                <a:lnTo>
                  <a:pt x="4102" y="827"/>
                </a:lnTo>
                <a:lnTo>
                  <a:pt x="4113" y="826"/>
                </a:lnTo>
                <a:lnTo>
                  <a:pt x="4126" y="826"/>
                </a:lnTo>
                <a:lnTo>
                  <a:pt x="4138" y="827"/>
                </a:lnTo>
                <a:lnTo>
                  <a:pt x="4149" y="826"/>
                </a:lnTo>
                <a:lnTo>
                  <a:pt x="4162" y="827"/>
                </a:lnTo>
                <a:lnTo>
                  <a:pt x="4174" y="827"/>
                </a:lnTo>
              </a:path>
            </a:pathLst>
          </a:custGeom>
          <a:noFill/>
          <a:ln w="0">
            <a:solidFill>
              <a:srgbClr val="00FF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9" name="Freeform 97"/>
          <p:cNvSpPr>
            <a:spLocks/>
          </p:cNvSpPr>
          <p:nvPr/>
        </p:nvSpPr>
        <p:spPr bwMode="auto">
          <a:xfrm>
            <a:off x="672307" y="2706689"/>
            <a:ext cx="6626226" cy="3294063"/>
          </a:xfrm>
          <a:custGeom>
            <a:avLst/>
            <a:gdLst>
              <a:gd name="T0" fmla="*/ 60 w 4174"/>
              <a:gd name="T1" fmla="*/ 1436 h 2075"/>
              <a:gd name="T2" fmla="*/ 133 w 4174"/>
              <a:gd name="T3" fmla="*/ 1436 h 2075"/>
              <a:gd name="T4" fmla="*/ 205 w 4174"/>
              <a:gd name="T5" fmla="*/ 1426 h 2075"/>
              <a:gd name="T6" fmla="*/ 279 w 4174"/>
              <a:gd name="T7" fmla="*/ 1491 h 2075"/>
              <a:gd name="T8" fmla="*/ 350 w 4174"/>
              <a:gd name="T9" fmla="*/ 1476 h 2075"/>
              <a:gd name="T10" fmla="*/ 424 w 4174"/>
              <a:gd name="T11" fmla="*/ 1445 h 2075"/>
              <a:gd name="T12" fmla="*/ 496 w 4174"/>
              <a:gd name="T13" fmla="*/ 1442 h 2075"/>
              <a:gd name="T14" fmla="*/ 569 w 4174"/>
              <a:gd name="T15" fmla="*/ 1436 h 2075"/>
              <a:gd name="T16" fmla="*/ 641 w 4174"/>
              <a:gd name="T17" fmla="*/ 1432 h 2075"/>
              <a:gd name="T18" fmla="*/ 714 w 4174"/>
              <a:gd name="T19" fmla="*/ 1432 h 2075"/>
              <a:gd name="T20" fmla="*/ 786 w 4174"/>
              <a:gd name="T21" fmla="*/ 1431 h 2075"/>
              <a:gd name="T22" fmla="*/ 860 w 4174"/>
              <a:gd name="T23" fmla="*/ 1427 h 2075"/>
              <a:gd name="T24" fmla="*/ 931 w 4174"/>
              <a:gd name="T25" fmla="*/ 1426 h 2075"/>
              <a:gd name="T26" fmla="*/ 1005 w 4174"/>
              <a:gd name="T27" fmla="*/ 1424 h 2075"/>
              <a:gd name="T28" fmla="*/ 1077 w 4174"/>
              <a:gd name="T29" fmla="*/ 1421 h 2075"/>
              <a:gd name="T30" fmla="*/ 1150 w 4174"/>
              <a:gd name="T31" fmla="*/ 1419 h 2075"/>
              <a:gd name="T32" fmla="*/ 1222 w 4174"/>
              <a:gd name="T33" fmla="*/ 1416 h 2075"/>
              <a:gd name="T34" fmla="*/ 1295 w 4174"/>
              <a:gd name="T35" fmla="*/ 1413 h 2075"/>
              <a:gd name="T36" fmla="*/ 1367 w 4174"/>
              <a:gd name="T37" fmla="*/ 1411 h 2075"/>
              <a:gd name="T38" fmla="*/ 1440 w 4174"/>
              <a:gd name="T39" fmla="*/ 1409 h 2075"/>
              <a:gd name="T40" fmla="*/ 1512 w 4174"/>
              <a:gd name="T41" fmla="*/ 1406 h 2075"/>
              <a:gd name="T42" fmla="*/ 1586 w 4174"/>
              <a:gd name="T43" fmla="*/ 1406 h 2075"/>
              <a:gd name="T44" fmla="*/ 1657 w 4174"/>
              <a:gd name="T45" fmla="*/ 1405 h 2075"/>
              <a:gd name="T46" fmla="*/ 1731 w 4174"/>
              <a:gd name="T47" fmla="*/ 1401 h 2075"/>
              <a:gd name="T48" fmla="*/ 1803 w 4174"/>
              <a:gd name="T49" fmla="*/ 1400 h 2075"/>
              <a:gd name="T50" fmla="*/ 1876 w 4174"/>
              <a:gd name="T51" fmla="*/ 1395 h 2075"/>
              <a:gd name="T52" fmla="*/ 1948 w 4174"/>
              <a:gd name="T53" fmla="*/ 1393 h 2075"/>
              <a:gd name="T54" fmla="*/ 2021 w 4174"/>
              <a:gd name="T55" fmla="*/ 1393 h 2075"/>
              <a:gd name="T56" fmla="*/ 2093 w 4174"/>
              <a:gd name="T57" fmla="*/ 1390 h 2075"/>
              <a:gd name="T58" fmla="*/ 2165 w 4174"/>
              <a:gd name="T59" fmla="*/ 1388 h 2075"/>
              <a:gd name="T60" fmla="*/ 2238 w 4174"/>
              <a:gd name="T61" fmla="*/ 1385 h 2075"/>
              <a:gd name="T62" fmla="*/ 2310 w 4174"/>
              <a:gd name="T63" fmla="*/ 1385 h 2075"/>
              <a:gd name="T64" fmla="*/ 2384 w 4174"/>
              <a:gd name="T65" fmla="*/ 1398 h 2075"/>
              <a:gd name="T66" fmla="*/ 2455 w 4174"/>
              <a:gd name="T67" fmla="*/ 1359 h 2075"/>
              <a:gd name="T68" fmla="*/ 2529 w 4174"/>
              <a:gd name="T69" fmla="*/ 1382 h 2075"/>
              <a:gd name="T70" fmla="*/ 2601 w 4174"/>
              <a:gd name="T71" fmla="*/ 1393 h 2075"/>
              <a:gd name="T72" fmla="*/ 2674 w 4174"/>
              <a:gd name="T73" fmla="*/ 1396 h 2075"/>
              <a:gd name="T74" fmla="*/ 2746 w 4174"/>
              <a:gd name="T75" fmla="*/ 1401 h 2075"/>
              <a:gd name="T76" fmla="*/ 2819 w 4174"/>
              <a:gd name="T77" fmla="*/ 1400 h 2075"/>
              <a:gd name="T78" fmla="*/ 2891 w 4174"/>
              <a:gd name="T79" fmla="*/ 1403 h 2075"/>
              <a:gd name="T80" fmla="*/ 2965 w 4174"/>
              <a:gd name="T81" fmla="*/ 1400 h 2075"/>
              <a:gd name="T82" fmla="*/ 3036 w 4174"/>
              <a:gd name="T83" fmla="*/ 1401 h 2075"/>
              <a:gd name="T84" fmla="*/ 3110 w 4174"/>
              <a:gd name="T85" fmla="*/ 1400 h 2075"/>
              <a:gd name="T86" fmla="*/ 3182 w 4174"/>
              <a:gd name="T87" fmla="*/ 1400 h 2075"/>
              <a:gd name="T88" fmla="*/ 3255 w 4174"/>
              <a:gd name="T89" fmla="*/ 1400 h 2075"/>
              <a:gd name="T90" fmla="*/ 3327 w 4174"/>
              <a:gd name="T91" fmla="*/ 1403 h 2075"/>
              <a:gd name="T92" fmla="*/ 3400 w 4174"/>
              <a:gd name="T93" fmla="*/ 1401 h 2075"/>
              <a:gd name="T94" fmla="*/ 3472 w 4174"/>
              <a:gd name="T95" fmla="*/ 1400 h 2075"/>
              <a:gd name="T96" fmla="*/ 3545 w 4174"/>
              <a:gd name="T97" fmla="*/ 1400 h 2075"/>
              <a:gd name="T98" fmla="*/ 3617 w 4174"/>
              <a:gd name="T99" fmla="*/ 1400 h 2075"/>
              <a:gd name="T100" fmla="*/ 3691 w 4174"/>
              <a:gd name="T101" fmla="*/ 1400 h 2075"/>
              <a:gd name="T102" fmla="*/ 3762 w 4174"/>
              <a:gd name="T103" fmla="*/ 1401 h 2075"/>
              <a:gd name="T104" fmla="*/ 3836 w 4174"/>
              <a:gd name="T105" fmla="*/ 1401 h 2075"/>
              <a:gd name="T106" fmla="*/ 3908 w 4174"/>
              <a:gd name="T107" fmla="*/ 1401 h 2075"/>
              <a:gd name="T108" fmla="*/ 3981 w 4174"/>
              <a:gd name="T109" fmla="*/ 1403 h 2075"/>
              <a:gd name="T110" fmla="*/ 4053 w 4174"/>
              <a:gd name="T111" fmla="*/ 1396 h 2075"/>
              <a:gd name="T112" fmla="*/ 4126 w 4174"/>
              <a:gd name="T113" fmla="*/ 1400 h 20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174" h="2075">
                <a:moveTo>
                  <a:pt x="0" y="1436"/>
                </a:moveTo>
                <a:lnTo>
                  <a:pt x="13" y="1437"/>
                </a:lnTo>
                <a:lnTo>
                  <a:pt x="24" y="1437"/>
                </a:lnTo>
                <a:lnTo>
                  <a:pt x="37" y="1437"/>
                </a:lnTo>
                <a:lnTo>
                  <a:pt x="49" y="1436"/>
                </a:lnTo>
                <a:lnTo>
                  <a:pt x="60" y="1436"/>
                </a:lnTo>
                <a:lnTo>
                  <a:pt x="73" y="1436"/>
                </a:lnTo>
                <a:lnTo>
                  <a:pt x="85" y="1436"/>
                </a:lnTo>
                <a:lnTo>
                  <a:pt x="98" y="1436"/>
                </a:lnTo>
                <a:lnTo>
                  <a:pt x="109" y="1436"/>
                </a:lnTo>
                <a:lnTo>
                  <a:pt x="120" y="1436"/>
                </a:lnTo>
                <a:lnTo>
                  <a:pt x="133" y="1436"/>
                </a:lnTo>
                <a:lnTo>
                  <a:pt x="145" y="1436"/>
                </a:lnTo>
                <a:lnTo>
                  <a:pt x="158" y="1436"/>
                </a:lnTo>
                <a:lnTo>
                  <a:pt x="169" y="1432"/>
                </a:lnTo>
                <a:lnTo>
                  <a:pt x="182" y="1432"/>
                </a:lnTo>
                <a:lnTo>
                  <a:pt x="194" y="1421"/>
                </a:lnTo>
                <a:lnTo>
                  <a:pt x="205" y="1426"/>
                </a:lnTo>
                <a:lnTo>
                  <a:pt x="218" y="1431"/>
                </a:lnTo>
                <a:lnTo>
                  <a:pt x="230" y="1439"/>
                </a:lnTo>
                <a:lnTo>
                  <a:pt x="243" y="1396"/>
                </a:lnTo>
                <a:lnTo>
                  <a:pt x="254" y="481"/>
                </a:lnTo>
                <a:lnTo>
                  <a:pt x="266" y="0"/>
                </a:lnTo>
                <a:lnTo>
                  <a:pt x="279" y="1491"/>
                </a:lnTo>
                <a:lnTo>
                  <a:pt x="290" y="2075"/>
                </a:lnTo>
                <a:lnTo>
                  <a:pt x="303" y="1886"/>
                </a:lnTo>
                <a:lnTo>
                  <a:pt x="315" y="1666"/>
                </a:lnTo>
                <a:lnTo>
                  <a:pt x="328" y="1555"/>
                </a:lnTo>
                <a:lnTo>
                  <a:pt x="339" y="1502"/>
                </a:lnTo>
                <a:lnTo>
                  <a:pt x="350" y="1476"/>
                </a:lnTo>
                <a:lnTo>
                  <a:pt x="364" y="1463"/>
                </a:lnTo>
                <a:lnTo>
                  <a:pt x="375" y="1458"/>
                </a:lnTo>
                <a:lnTo>
                  <a:pt x="388" y="1453"/>
                </a:lnTo>
                <a:lnTo>
                  <a:pt x="399" y="1449"/>
                </a:lnTo>
                <a:lnTo>
                  <a:pt x="411" y="1447"/>
                </a:lnTo>
                <a:lnTo>
                  <a:pt x="424" y="1445"/>
                </a:lnTo>
                <a:lnTo>
                  <a:pt x="435" y="1445"/>
                </a:lnTo>
                <a:lnTo>
                  <a:pt x="448" y="1444"/>
                </a:lnTo>
                <a:lnTo>
                  <a:pt x="460" y="1444"/>
                </a:lnTo>
                <a:lnTo>
                  <a:pt x="471" y="1444"/>
                </a:lnTo>
                <a:lnTo>
                  <a:pt x="484" y="1442"/>
                </a:lnTo>
                <a:lnTo>
                  <a:pt x="496" y="1442"/>
                </a:lnTo>
                <a:lnTo>
                  <a:pt x="509" y="1440"/>
                </a:lnTo>
                <a:lnTo>
                  <a:pt x="520" y="1439"/>
                </a:lnTo>
                <a:lnTo>
                  <a:pt x="533" y="1440"/>
                </a:lnTo>
                <a:lnTo>
                  <a:pt x="545" y="1439"/>
                </a:lnTo>
                <a:lnTo>
                  <a:pt x="556" y="1437"/>
                </a:lnTo>
                <a:lnTo>
                  <a:pt x="569" y="1436"/>
                </a:lnTo>
                <a:lnTo>
                  <a:pt x="581" y="1436"/>
                </a:lnTo>
                <a:lnTo>
                  <a:pt x="594" y="1436"/>
                </a:lnTo>
                <a:lnTo>
                  <a:pt x="605" y="1436"/>
                </a:lnTo>
                <a:lnTo>
                  <a:pt x="616" y="1436"/>
                </a:lnTo>
                <a:lnTo>
                  <a:pt x="629" y="1434"/>
                </a:lnTo>
                <a:lnTo>
                  <a:pt x="641" y="1432"/>
                </a:lnTo>
                <a:lnTo>
                  <a:pt x="654" y="1432"/>
                </a:lnTo>
                <a:lnTo>
                  <a:pt x="665" y="1432"/>
                </a:lnTo>
                <a:lnTo>
                  <a:pt x="678" y="1432"/>
                </a:lnTo>
                <a:lnTo>
                  <a:pt x="690" y="1432"/>
                </a:lnTo>
                <a:lnTo>
                  <a:pt x="701" y="1432"/>
                </a:lnTo>
                <a:lnTo>
                  <a:pt x="714" y="1432"/>
                </a:lnTo>
                <a:lnTo>
                  <a:pt x="726" y="1431"/>
                </a:lnTo>
                <a:lnTo>
                  <a:pt x="739" y="1431"/>
                </a:lnTo>
                <a:lnTo>
                  <a:pt x="750" y="1431"/>
                </a:lnTo>
                <a:lnTo>
                  <a:pt x="762" y="1431"/>
                </a:lnTo>
                <a:lnTo>
                  <a:pt x="775" y="1431"/>
                </a:lnTo>
                <a:lnTo>
                  <a:pt x="786" y="1431"/>
                </a:lnTo>
                <a:lnTo>
                  <a:pt x="799" y="1431"/>
                </a:lnTo>
                <a:lnTo>
                  <a:pt x="811" y="1429"/>
                </a:lnTo>
                <a:lnTo>
                  <a:pt x="824" y="1427"/>
                </a:lnTo>
                <a:lnTo>
                  <a:pt x="835" y="1429"/>
                </a:lnTo>
                <a:lnTo>
                  <a:pt x="847" y="1427"/>
                </a:lnTo>
                <a:lnTo>
                  <a:pt x="860" y="1427"/>
                </a:lnTo>
                <a:lnTo>
                  <a:pt x="871" y="1426"/>
                </a:lnTo>
                <a:lnTo>
                  <a:pt x="884" y="1427"/>
                </a:lnTo>
                <a:lnTo>
                  <a:pt x="895" y="1427"/>
                </a:lnTo>
                <a:lnTo>
                  <a:pt x="907" y="1426"/>
                </a:lnTo>
                <a:lnTo>
                  <a:pt x="920" y="1426"/>
                </a:lnTo>
                <a:lnTo>
                  <a:pt x="931" y="1426"/>
                </a:lnTo>
                <a:lnTo>
                  <a:pt x="944" y="1426"/>
                </a:lnTo>
                <a:lnTo>
                  <a:pt x="956" y="1426"/>
                </a:lnTo>
                <a:lnTo>
                  <a:pt x="967" y="1426"/>
                </a:lnTo>
                <a:lnTo>
                  <a:pt x="980" y="1426"/>
                </a:lnTo>
                <a:lnTo>
                  <a:pt x="992" y="1426"/>
                </a:lnTo>
                <a:lnTo>
                  <a:pt x="1005" y="1424"/>
                </a:lnTo>
                <a:lnTo>
                  <a:pt x="1016" y="1424"/>
                </a:lnTo>
                <a:lnTo>
                  <a:pt x="1029" y="1424"/>
                </a:lnTo>
                <a:lnTo>
                  <a:pt x="1041" y="1422"/>
                </a:lnTo>
                <a:lnTo>
                  <a:pt x="1052" y="1422"/>
                </a:lnTo>
                <a:lnTo>
                  <a:pt x="1065" y="1421"/>
                </a:lnTo>
                <a:lnTo>
                  <a:pt x="1077" y="1421"/>
                </a:lnTo>
                <a:lnTo>
                  <a:pt x="1090" y="1421"/>
                </a:lnTo>
                <a:lnTo>
                  <a:pt x="1101" y="1419"/>
                </a:lnTo>
                <a:lnTo>
                  <a:pt x="1112" y="1421"/>
                </a:lnTo>
                <a:lnTo>
                  <a:pt x="1126" y="1421"/>
                </a:lnTo>
                <a:lnTo>
                  <a:pt x="1137" y="1421"/>
                </a:lnTo>
                <a:lnTo>
                  <a:pt x="1150" y="1419"/>
                </a:lnTo>
                <a:lnTo>
                  <a:pt x="1161" y="1419"/>
                </a:lnTo>
                <a:lnTo>
                  <a:pt x="1174" y="1419"/>
                </a:lnTo>
                <a:lnTo>
                  <a:pt x="1186" y="1418"/>
                </a:lnTo>
                <a:lnTo>
                  <a:pt x="1197" y="1416"/>
                </a:lnTo>
                <a:lnTo>
                  <a:pt x="1210" y="1416"/>
                </a:lnTo>
                <a:lnTo>
                  <a:pt x="1222" y="1416"/>
                </a:lnTo>
                <a:lnTo>
                  <a:pt x="1235" y="1416"/>
                </a:lnTo>
                <a:lnTo>
                  <a:pt x="1246" y="1416"/>
                </a:lnTo>
                <a:lnTo>
                  <a:pt x="1258" y="1414"/>
                </a:lnTo>
                <a:lnTo>
                  <a:pt x="1271" y="1414"/>
                </a:lnTo>
                <a:lnTo>
                  <a:pt x="1282" y="1414"/>
                </a:lnTo>
                <a:lnTo>
                  <a:pt x="1295" y="1413"/>
                </a:lnTo>
                <a:lnTo>
                  <a:pt x="1307" y="1413"/>
                </a:lnTo>
                <a:lnTo>
                  <a:pt x="1318" y="1413"/>
                </a:lnTo>
                <a:lnTo>
                  <a:pt x="1331" y="1413"/>
                </a:lnTo>
                <a:lnTo>
                  <a:pt x="1343" y="1414"/>
                </a:lnTo>
                <a:lnTo>
                  <a:pt x="1356" y="1413"/>
                </a:lnTo>
                <a:lnTo>
                  <a:pt x="1367" y="1411"/>
                </a:lnTo>
                <a:lnTo>
                  <a:pt x="1380" y="1409"/>
                </a:lnTo>
                <a:lnTo>
                  <a:pt x="1392" y="1411"/>
                </a:lnTo>
                <a:lnTo>
                  <a:pt x="1403" y="1409"/>
                </a:lnTo>
                <a:lnTo>
                  <a:pt x="1416" y="1409"/>
                </a:lnTo>
                <a:lnTo>
                  <a:pt x="1427" y="1408"/>
                </a:lnTo>
                <a:lnTo>
                  <a:pt x="1440" y="1409"/>
                </a:lnTo>
                <a:lnTo>
                  <a:pt x="1452" y="1408"/>
                </a:lnTo>
                <a:lnTo>
                  <a:pt x="1463" y="1408"/>
                </a:lnTo>
                <a:lnTo>
                  <a:pt x="1476" y="1409"/>
                </a:lnTo>
                <a:lnTo>
                  <a:pt x="1488" y="1409"/>
                </a:lnTo>
                <a:lnTo>
                  <a:pt x="1501" y="1408"/>
                </a:lnTo>
                <a:lnTo>
                  <a:pt x="1512" y="1406"/>
                </a:lnTo>
                <a:lnTo>
                  <a:pt x="1525" y="1405"/>
                </a:lnTo>
                <a:lnTo>
                  <a:pt x="1537" y="1406"/>
                </a:lnTo>
                <a:lnTo>
                  <a:pt x="1548" y="1408"/>
                </a:lnTo>
                <a:lnTo>
                  <a:pt x="1561" y="1408"/>
                </a:lnTo>
                <a:lnTo>
                  <a:pt x="1573" y="1408"/>
                </a:lnTo>
                <a:lnTo>
                  <a:pt x="1586" y="1406"/>
                </a:lnTo>
                <a:lnTo>
                  <a:pt x="1597" y="1406"/>
                </a:lnTo>
                <a:lnTo>
                  <a:pt x="1609" y="1405"/>
                </a:lnTo>
                <a:lnTo>
                  <a:pt x="1622" y="1405"/>
                </a:lnTo>
                <a:lnTo>
                  <a:pt x="1633" y="1406"/>
                </a:lnTo>
                <a:lnTo>
                  <a:pt x="1646" y="1405"/>
                </a:lnTo>
                <a:lnTo>
                  <a:pt x="1657" y="1405"/>
                </a:lnTo>
                <a:lnTo>
                  <a:pt x="1671" y="1405"/>
                </a:lnTo>
                <a:lnTo>
                  <a:pt x="1682" y="1405"/>
                </a:lnTo>
                <a:lnTo>
                  <a:pt x="1693" y="1403"/>
                </a:lnTo>
                <a:lnTo>
                  <a:pt x="1706" y="1403"/>
                </a:lnTo>
                <a:lnTo>
                  <a:pt x="1718" y="1403"/>
                </a:lnTo>
                <a:lnTo>
                  <a:pt x="1731" y="1401"/>
                </a:lnTo>
                <a:lnTo>
                  <a:pt x="1742" y="1401"/>
                </a:lnTo>
                <a:lnTo>
                  <a:pt x="1754" y="1401"/>
                </a:lnTo>
                <a:lnTo>
                  <a:pt x="1767" y="1400"/>
                </a:lnTo>
                <a:lnTo>
                  <a:pt x="1778" y="1400"/>
                </a:lnTo>
                <a:lnTo>
                  <a:pt x="1791" y="1400"/>
                </a:lnTo>
                <a:lnTo>
                  <a:pt x="1803" y="1400"/>
                </a:lnTo>
                <a:lnTo>
                  <a:pt x="1814" y="1398"/>
                </a:lnTo>
                <a:lnTo>
                  <a:pt x="1827" y="1398"/>
                </a:lnTo>
                <a:lnTo>
                  <a:pt x="1839" y="1396"/>
                </a:lnTo>
                <a:lnTo>
                  <a:pt x="1852" y="1396"/>
                </a:lnTo>
                <a:lnTo>
                  <a:pt x="1863" y="1395"/>
                </a:lnTo>
                <a:lnTo>
                  <a:pt x="1876" y="1395"/>
                </a:lnTo>
                <a:lnTo>
                  <a:pt x="1888" y="1395"/>
                </a:lnTo>
                <a:lnTo>
                  <a:pt x="1899" y="1395"/>
                </a:lnTo>
                <a:lnTo>
                  <a:pt x="1912" y="1395"/>
                </a:lnTo>
                <a:lnTo>
                  <a:pt x="1923" y="1395"/>
                </a:lnTo>
                <a:lnTo>
                  <a:pt x="1937" y="1393"/>
                </a:lnTo>
                <a:lnTo>
                  <a:pt x="1948" y="1393"/>
                </a:lnTo>
                <a:lnTo>
                  <a:pt x="1959" y="1393"/>
                </a:lnTo>
                <a:lnTo>
                  <a:pt x="1972" y="1395"/>
                </a:lnTo>
                <a:lnTo>
                  <a:pt x="1984" y="1395"/>
                </a:lnTo>
                <a:lnTo>
                  <a:pt x="1997" y="1393"/>
                </a:lnTo>
                <a:lnTo>
                  <a:pt x="2008" y="1395"/>
                </a:lnTo>
                <a:lnTo>
                  <a:pt x="2021" y="1393"/>
                </a:lnTo>
                <a:lnTo>
                  <a:pt x="2033" y="1391"/>
                </a:lnTo>
                <a:lnTo>
                  <a:pt x="2044" y="1391"/>
                </a:lnTo>
                <a:lnTo>
                  <a:pt x="2057" y="1391"/>
                </a:lnTo>
                <a:lnTo>
                  <a:pt x="2069" y="1390"/>
                </a:lnTo>
                <a:lnTo>
                  <a:pt x="2082" y="1390"/>
                </a:lnTo>
                <a:lnTo>
                  <a:pt x="2093" y="1390"/>
                </a:lnTo>
                <a:lnTo>
                  <a:pt x="2105" y="1390"/>
                </a:lnTo>
                <a:lnTo>
                  <a:pt x="2118" y="1390"/>
                </a:lnTo>
                <a:lnTo>
                  <a:pt x="2129" y="1390"/>
                </a:lnTo>
                <a:lnTo>
                  <a:pt x="2142" y="1388"/>
                </a:lnTo>
                <a:lnTo>
                  <a:pt x="2154" y="1388"/>
                </a:lnTo>
                <a:lnTo>
                  <a:pt x="2165" y="1388"/>
                </a:lnTo>
                <a:lnTo>
                  <a:pt x="2178" y="1388"/>
                </a:lnTo>
                <a:lnTo>
                  <a:pt x="2189" y="1388"/>
                </a:lnTo>
                <a:lnTo>
                  <a:pt x="2202" y="1388"/>
                </a:lnTo>
                <a:lnTo>
                  <a:pt x="2214" y="1387"/>
                </a:lnTo>
                <a:lnTo>
                  <a:pt x="2227" y="1387"/>
                </a:lnTo>
                <a:lnTo>
                  <a:pt x="2238" y="1385"/>
                </a:lnTo>
                <a:lnTo>
                  <a:pt x="2250" y="1385"/>
                </a:lnTo>
                <a:lnTo>
                  <a:pt x="2263" y="1385"/>
                </a:lnTo>
                <a:lnTo>
                  <a:pt x="2274" y="1385"/>
                </a:lnTo>
                <a:lnTo>
                  <a:pt x="2287" y="1385"/>
                </a:lnTo>
                <a:lnTo>
                  <a:pt x="2299" y="1385"/>
                </a:lnTo>
                <a:lnTo>
                  <a:pt x="2310" y="1385"/>
                </a:lnTo>
                <a:lnTo>
                  <a:pt x="2323" y="1383"/>
                </a:lnTo>
                <a:lnTo>
                  <a:pt x="2335" y="1383"/>
                </a:lnTo>
                <a:lnTo>
                  <a:pt x="2348" y="1383"/>
                </a:lnTo>
                <a:lnTo>
                  <a:pt x="2359" y="1393"/>
                </a:lnTo>
                <a:lnTo>
                  <a:pt x="2372" y="1398"/>
                </a:lnTo>
                <a:lnTo>
                  <a:pt x="2384" y="1398"/>
                </a:lnTo>
                <a:lnTo>
                  <a:pt x="2395" y="1409"/>
                </a:lnTo>
                <a:lnTo>
                  <a:pt x="2408" y="1458"/>
                </a:lnTo>
                <a:lnTo>
                  <a:pt x="2420" y="1411"/>
                </a:lnTo>
                <a:lnTo>
                  <a:pt x="2433" y="1334"/>
                </a:lnTo>
                <a:lnTo>
                  <a:pt x="2444" y="1346"/>
                </a:lnTo>
                <a:lnTo>
                  <a:pt x="2455" y="1359"/>
                </a:lnTo>
                <a:lnTo>
                  <a:pt x="2468" y="1365"/>
                </a:lnTo>
                <a:lnTo>
                  <a:pt x="2480" y="1372"/>
                </a:lnTo>
                <a:lnTo>
                  <a:pt x="2493" y="1375"/>
                </a:lnTo>
                <a:lnTo>
                  <a:pt x="2504" y="1378"/>
                </a:lnTo>
                <a:lnTo>
                  <a:pt x="2517" y="1380"/>
                </a:lnTo>
                <a:lnTo>
                  <a:pt x="2529" y="1382"/>
                </a:lnTo>
                <a:lnTo>
                  <a:pt x="2540" y="1385"/>
                </a:lnTo>
                <a:lnTo>
                  <a:pt x="2553" y="1387"/>
                </a:lnTo>
                <a:lnTo>
                  <a:pt x="2565" y="1390"/>
                </a:lnTo>
                <a:lnTo>
                  <a:pt x="2578" y="1391"/>
                </a:lnTo>
                <a:lnTo>
                  <a:pt x="2589" y="1391"/>
                </a:lnTo>
                <a:lnTo>
                  <a:pt x="2601" y="1393"/>
                </a:lnTo>
                <a:lnTo>
                  <a:pt x="2614" y="1393"/>
                </a:lnTo>
                <a:lnTo>
                  <a:pt x="2625" y="1395"/>
                </a:lnTo>
                <a:lnTo>
                  <a:pt x="2638" y="1396"/>
                </a:lnTo>
                <a:lnTo>
                  <a:pt x="2650" y="1395"/>
                </a:lnTo>
                <a:lnTo>
                  <a:pt x="2661" y="1396"/>
                </a:lnTo>
                <a:lnTo>
                  <a:pt x="2674" y="1396"/>
                </a:lnTo>
                <a:lnTo>
                  <a:pt x="2685" y="1396"/>
                </a:lnTo>
                <a:lnTo>
                  <a:pt x="2699" y="1396"/>
                </a:lnTo>
                <a:lnTo>
                  <a:pt x="2710" y="1396"/>
                </a:lnTo>
                <a:lnTo>
                  <a:pt x="2723" y="1400"/>
                </a:lnTo>
                <a:lnTo>
                  <a:pt x="2734" y="1401"/>
                </a:lnTo>
                <a:lnTo>
                  <a:pt x="2746" y="1401"/>
                </a:lnTo>
                <a:lnTo>
                  <a:pt x="2759" y="1401"/>
                </a:lnTo>
                <a:lnTo>
                  <a:pt x="2770" y="1400"/>
                </a:lnTo>
                <a:lnTo>
                  <a:pt x="2783" y="1400"/>
                </a:lnTo>
                <a:lnTo>
                  <a:pt x="2795" y="1401"/>
                </a:lnTo>
                <a:lnTo>
                  <a:pt x="2806" y="1400"/>
                </a:lnTo>
                <a:lnTo>
                  <a:pt x="2819" y="1400"/>
                </a:lnTo>
                <a:lnTo>
                  <a:pt x="2831" y="1400"/>
                </a:lnTo>
                <a:lnTo>
                  <a:pt x="2844" y="1400"/>
                </a:lnTo>
                <a:lnTo>
                  <a:pt x="2855" y="1398"/>
                </a:lnTo>
                <a:lnTo>
                  <a:pt x="2868" y="1401"/>
                </a:lnTo>
                <a:lnTo>
                  <a:pt x="2880" y="1401"/>
                </a:lnTo>
                <a:lnTo>
                  <a:pt x="2891" y="1403"/>
                </a:lnTo>
                <a:lnTo>
                  <a:pt x="2904" y="1401"/>
                </a:lnTo>
                <a:lnTo>
                  <a:pt x="2916" y="1401"/>
                </a:lnTo>
                <a:lnTo>
                  <a:pt x="2929" y="1401"/>
                </a:lnTo>
                <a:lnTo>
                  <a:pt x="2940" y="1401"/>
                </a:lnTo>
                <a:lnTo>
                  <a:pt x="2951" y="1401"/>
                </a:lnTo>
                <a:lnTo>
                  <a:pt x="2965" y="1400"/>
                </a:lnTo>
                <a:lnTo>
                  <a:pt x="2976" y="1400"/>
                </a:lnTo>
                <a:lnTo>
                  <a:pt x="2989" y="1401"/>
                </a:lnTo>
                <a:lnTo>
                  <a:pt x="3000" y="1400"/>
                </a:lnTo>
                <a:lnTo>
                  <a:pt x="3012" y="1400"/>
                </a:lnTo>
                <a:lnTo>
                  <a:pt x="3025" y="1401"/>
                </a:lnTo>
                <a:lnTo>
                  <a:pt x="3036" y="1401"/>
                </a:lnTo>
                <a:lnTo>
                  <a:pt x="3049" y="1400"/>
                </a:lnTo>
                <a:lnTo>
                  <a:pt x="3061" y="1401"/>
                </a:lnTo>
                <a:lnTo>
                  <a:pt x="3074" y="1401"/>
                </a:lnTo>
                <a:lnTo>
                  <a:pt x="3085" y="1400"/>
                </a:lnTo>
                <a:lnTo>
                  <a:pt x="3097" y="1401"/>
                </a:lnTo>
                <a:lnTo>
                  <a:pt x="3110" y="1400"/>
                </a:lnTo>
                <a:lnTo>
                  <a:pt x="3121" y="1400"/>
                </a:lnTo>
                <a:lnTo>
                  <a:pt x="3134" y="1400"/>
                </a:lnTo>
                <a:lnTo>
                  <a:pt x="3146" y="1400"/>
                </a:lnTo>
                <a:lnTo>
                  <a:pt x="3157" y="1400"/>
                </a:lnTo>
                <a:lnTo>
                  <a:pt x="3170" y="1401"/>
                </a:lnTo>
                <a:lnTo>
                  <a:pt x="3182" y="1400"/>
                </a:lnTo>
                <a:lnTo>
                  <a:pt x="3195" y="1401"/>
                </a:lnTo>
                <a:lnTo>
                  <a:pt x="3206" y="1400"/>
                </a:lnTo>
                <a:lnTo>
                  <a:pt x="3219" y="1401"/>
                </a:lnTo>
                <a:lnTo>
                  <a:pt x="3230" y="1401"/>
                </a:lnTo>
                <a:lnTo>
                  <a:pt x="3242" y="1400"/>
                </a:lnTo>
                <a:lnTo>
                  <a:pt x="3255" y="1400"/>
                </a:lnTo>
                <a:lnTo>
                  <a:pt x="3266" y="1401"/>
                </a:lnTo>
                <a:lnTo>
                  <a:pt x="3279" y="1401"/>
                </a:lnTo>
                <a:lnTo>
                  <a:pt x="3291" y="1401"/>
                </a:lnTo>
                <a:lnTo>
                  <a:pt x="3302" y="1401"/>
                </a:lnTo>
                <a:lnTo>
                  <a:pt x="3315" y="1401"/>
                </a:lnTo>
                <a:lnTo>
                  <a:pt x="3327" y="1403"/>
                </a:lnTo>
                <a:lnTo>
                  <a:pt x="3340" y="1403"/>
                </a:lnTo>
                <a:lnTo>
                  <a:pt x="3351" y="1401"/>
                </a:lnTo>
                <a:lnTo>
                  <a:pt x="3364" y="1401"/>
                </a:lnTo>
                <a:lnTo>
                  <a:pt x="3376" y="1401"/>
                </a:lnTo>
                <a:lnTo>
                  <a:pt x="3387" y="1401"/>
                </a:lnTo>
                <a:lnTo>
                  <a:pt x="3400" y="1401"/>
                </a:lnTo>
                <a:lnTo>
                  <a:pt x="3412" y="1401"/>
                </a:lnTo>
                <a:lnTo>
                  <a:pt x="3425" y="1401"/>
                </a:lnTo>
                <a:lnTo>
                  <a:pt x="3436" y="1400"/>
                </a:lnTo>
                <a:lnTo>
                  <a:pt x="3447" y="1400"/>
                </a:lnTo>
                <a:lnTo>
                  <a:pt x="3461" y="1401"/>
                </a:lnTo>
                <a:lnTo>
                  <a:pt x="3472" y="1400"/>
                </a:lnTo>
                <a:lnTo>
                  <a:pt x="3485" y="1400"/>
                </a:lnTo>
                <a:lnTo>
                  <a:pt x="3496" y="1401"/>
                </a:lnTo>
                <a:lnTo>
                  <a:pt x="3508" y="1401"/>
                </a:lnTo>
                <a:lnTo>
                  <a:pt x="3521" y="1401"/>
                </a:lnTo>
                <a:lnTo>
                  <a:pt x="3532" y="1400"/>
                </a:lnTo>
                <a:lnTo>
                  <a:pt x="3545" y="1400"/>
                </a:lnTo>
                <a:lnTo>
                  <a:pt x="3557" y="1401"/>
                </a:lnTo>
                <a:lnTo>
                  <a:pt x="3570" y="1400"/>
                </a:lnTo>
                <a:lnTo>
                  <a:pt x="3581" y="1401"/>
                </a:lnTo>
                <a:lnTo>
                  <a:pt x="3593" y="1400"/>
                </a:lnTo>
                <a:lnTo>
                  <a:pt x="3606" y="1400"/>
                </a:lnTo>
                <a:lnTo>
                  <a:pt x="3617" y="1400"/>
                </a:lnTo>
                <a:lnTo>
                  <a:pt x="3630" y="1400"/>
                </a:lnTo>
                <a:lnTo>
                  <a:pt x="3642" y="1401"/>
                </a:lnTo>
                <a:lnTo>
                  <a:pt x="3653" y="1400"/>
                </a:lnTo>
                <a:lnTo>
                  <a:pt x="3666" y="1400"/>
                </a:lnTo>
                <a:lnTo>
                  <a:pt x="3678" y="1401"/>
                </a:lnTo>
                <a:lnTo>
                  <a:pt x="3691" y="1400"/>
                </a:lnTo>
                <a:lnTo>
                  <a:pt x="3702" y="1400"/>
                </a:lnTo>
                <a:lnTo>
                  <a:pt x="3715" y="1401"/>
                </a:lnTo>
                <a:lnTo>
                  <a:pt x="3727" y="1401"/>
                </a:lnTo>
                <a:lnTo>
                  <a:pt x="3738" y="1401"/>
                </a:lnTo>
                <a:lnTo>
                  <a:pt x="3751" y="1401"/>
                </a:lnTo>
                <a:lnTo>
                  <a:pt x="3762" y="1401"/>
                </a:lnTo>
                <a:lnTo>
                  <a:pt x="3775" y="1401"/>
                </a:lnTo>
                <a:lnTo>
                  <a:pt x="3787" y="1401"/>
                </a:lnTo>
                <a:lnTo>
                  <a:pt x="3798" y="1401"/>
                </a:lnTo>
                <a:lnTo>
                  <a:pt x="3811" y="1401"/>
                </a:lnTo>
                <a:lnTo>
                  <a:pt x="3823" y="1401"/>
                </a:lnTo>
                <a:lnTo>
                  <a:pt x="3836" y="1401"/>
                </a:lnTo>
                <a:lnTo>
                  <a:pt x="3847" y="1400"/>
                </a:lnTo>
                <a:lnTo>
                  <a:pt x="3859" y="1400"/>
                </a:lnTo>
                <a:lnTo>
                  <a:pt x="3872" y="1401"/>
                </a:lnTo>
                <a:lnTo>
                  <a:pt x="3883" y="1401"/>
                </a:lnTo>
                <a:lnTo>
                  <a:pt x="3896" y="1401"/>
                </a:lnTo>
                <a:lnTo>
                  <a:pt x="3908" y="1401"/>
                </a:lnTo>
                <a:lnTo>
                  <a:pt x="3921" y="1403"/>
                </a:lnTo>
                <a:lnTo>
                  <a:pt x="3932" y="1401"/>
                </a:lnTo>
                <a:lnTo>
                  <a:pt x="3944" y="1401"/>
                </a:lnTo>
                <a:lnTo>
                  <a:pt x="3957" y="1401"/>
                </a:lnTo>
                <a:lnTo>
                  <a:pt x="3968" y="1401"/>
                </a:lnTo>
                <a:lnTo>
                  <a:pt x="3981" y="1403"/>
                </a:lnTo>
                <a:lnTo>
                  <a:pt x="3992" y="1401"/>
                </a:lnTo>
                <a:lnTo>
                  <a:pt x="4004" y="1400"/>
                </a:lnTo>
                <a:lnTo>
                  <a:pt x="4017" y="1401"/>
                </a:lnTo>
                <a:lnTo>
                  <a:pt x="4028" y="1400"/>
                </a:lnTo>
                <a:lnTo>
                  <a:pt x="4041" y="1396"/>
                </a:lnTo>
                <a:lnTo>
                  <a:pt x="4053" y="1396"/>
                </a:lnTo>
                <a:lnTo>
                  <a:pt x="4066" y="1398"/>
                </a:lnTo>
                <a:lnTo>
                  <a:pt x="4077" y="1398"/>
                </a:lnTo>
                <a:lnTo>
                  <a:pt x="4089" y="1400"/>
                </a:lnTo>
                <a:lnTo>
                  <a:pt x="4102" y="1400"/>
                </a:lnTo>
                <a:lnTo>
                  <a:pt x="4113" y="1400"/>
                </a:lnTo>
                <a:lnTo>
                  <a:pt x="4126" y="1400"/>
                </a:lnTo>
                <a:lnTo>
                  <a:pt x="4138" y="1400"/>
                </a:lnTo>
                <a:lnTo>
                  <a:pt x="4149" y="1400"/>
                </a:lnTo>
                <a:lnTo>
                  <a:pt x="4162" y="1400"/>
                </a:lnTo>
                <a:lnTo>
                  <a:pt x="4174" y="1400"/>
                </a:lnTo>
              </a:path>
            </a:pathLst>
          </a:custGeom>
          <a:noFill/>
          <a:ln w="0">
            <a:solidFill>
              <a:srgbClr val="8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00" name="Freeform 98"/>
          <p:cNvSpPr>
            <a:spLocks/>
          </p:cNvSpPr>
          <p:nvPr/>
        </p:nvSpPr>
        <p:spPr bwMode="auto">
          <a:xfrm>
            <a:off x="672307" y="3900489"/>
            <a:ext cx="6619876" cy="1085850"/>
          </a:xfrm>
          <a:custGeom>
            <a:avLst/>
            <a:gdLst>
              <a:gd name="T0" fmla="*/ 67 w 4170"/>
              <a:gd name="T1" fmla="*/ 684 h 684"/>
              <a:gd name="T2" fmla="*/ 138 w 4170"/>
              <a:gd name="T3" fmla="*/ 684 h 684"/>
              <a:gd name="T4" fmla="*/ 212 w 4170"/>
              <a:gd name="T5" fmla="*/ 684 h 684"/>
              <a:gd name="T6" fmla="*/ 285 w 4170"/>
              <a:gd name="T7" fmla="*/ 684 h 684"/>
              <a:gd name="T8" fmla="*/ 360 w 4170"/>
              <a:gd name="T9" fmla="*/ 587 h 684"/>
              <a:gd name="T10" fmla="*/ 434 w 4170"/>
              <a:gd name="T11" fmla="*/ 551 h 684"/>
              <a:gd name="T12" fmla="*/ 505 w 4170"/>
              <a:gd name="T13" fmla="*/ 515 h 684"/>
              <a:gd name="T14" fmla="*/ 579 w 4170"/>
              <a:gd name="T15" fmla="*/ 483 h 684"/>
              <a:gd name="T16" fmla="*/ 654 w 4170"/>
              <a:gd name="T17" fmla="*/ 450 h 684"/>
              <a:gd name="T18" fmla="*/ 727 w 4170"/>
              <a:gd name="T19" fmla="*/ 419 h 684"/>
              <a:gd name="T20" fmla="*/ 801 w 4170"/>
              <a:gd name="T21" fmla="*/ 392 h 684"/>
              <a:gd name="T22" fmla="*/ 873 w 4170"/>
              <a:gd name="T23" fmla="*/ 362 h 684"/>
              <a:gd name="T24" fmla="*/ 948 w 4170"/>
              <a:gd name="T25" fmla="*/ 336 h 684"/>
              <a:gd name="T26" fmla="*/ 1019 w 4170"/>
              <a:gd name="T27" fmla="*/ 310 h 684"/>
              <a:gd name="T28" fmla="*/ 1095 w 4170"/>
              <a:gd name="T29" fmla="*/ 287 h 684"/>
              <a:gd name="T30" fmla="*/ 1166 w 4170"/>
              <a:gd name="T31" fmla="*/ 263 h 684"/>
              <a:gd name="T32" fmla="*/ 1240 w 4170"/>
              <a:gd name="T33" fmla="*/ 241 h 684"/>
              <a:gd name="T34" fmla="*/ 1315 w 4170"/>
              <a:gd name="T35" fmla="*/ 220 h 684"/>
              <a:gd name="T36" fmla="*/ 1387 w 4170"/>
              <a:gd name="T37" fmla="*/ 199 h 684"/>
              <a:gd name="T38" fmla="*/ 1462 w 4170"/>
              <a:gd name="T39" fmla="*/ 179 h 684"/>
              <a:gd name="T40" fmla="*/ 1533 w 4170"/>
              <a:gd name="T41" fmla="*/ 162 h 684"/>
              <a:gd name="T42" fmla="*/ 1609 w 4170"/>
              <a:gd name="T43" fmla="*/ 144 h 684"/>
              <a:gd name="T44" fmla="*/ 1680 w 4170"/>
              <a:gd name="T45" fmla="*/ 127 h 684"/>
              <a:gd name="T46" fmla="*/ 1755 w 4170"/>
              <a:gd name="T47" fmla="*/ 111 h 684"/>
              <a:gd name="T48" fmla="*/ 1829 w 4170"/>
              <a:gd name="T49" fmla="*/ 95 h 684"/>
              <a:gd name="T50" fmla="*/ 1902 w 4170"/>
              <a:gd name="T51" fmla="*/ 80 h 684"/>
              <a:gd name="T52" fmla="*/ 1976 w 4170"/>
              <a:gd name="T53" fmla="*/ 67 h 684"/>
              <a:gd name="T54" fmla="*/ 2049 w 4170"/>
              <a:gd name="T55" fmla="*/ 54 h 684"/>
              <a:gd name="T56" fmla="*/ 2121 w 4170"/>
              <a:gd name="T57" fmla="*/ 41 h 684"/>
              <a:gd name="T58" fmla="*/ 2194 w 4170"/>
              <a:gd name="T59" fmla="*/ 28 h 684"/>
              <a:gd name="T60" fmla="*/ 2269 w 4170"/>
              <a:gd name="T61" fmla="*/ 16 h 684"/>
              <a:gd name="T62" fmla="*/ 2341 w 4170"/>
              <a:gd name="T63" fmla="*/ 5 h 684"/>
              <a:gd name="T64" fmla="*/ 2416 w 4170"/>
              <a:gd name="T65" fmla="*/ 85 h 684"/>
              <a:gd name="T66" fmla="*/ 2490 w 4170"/>
              <a:gd name="T67" fmla="*/ 88 h 684"/>
              <a:gd name="T68" fmla="*/ 2561 w 4170"/>
              <a:gd name="T69" fmla="*/ 90 h 684"/>
              <a:gd name="T70" fmla="*/ 2635 w 4170"/>
              <a:gd name="T71" fmla="*/ 93 h 684"/>
              <a:gd name="T72" fmla="*/ 2708 w 4170"/>
              <a:gd name="T73" fmla="*/ 95 h 684"/>
              <a:gd name="T74" fmla="*/ 2783 w 4170"/>
              <a:gd name="T75" fmla="*/ 98 h 684"/>
              <a:gd name="T76" fmla="*/ 2857 w 4170"/>
              <a:gd name="T77" fmla="*/ 100 h 684"/>
              <a:gd name="T78" fmla="*/ 2930 w 4170"/>
              <a:gd name="T79" fmla="*/ 101 h 684"/>
              <a:gd name="T80" fmla="*/ 3002 w 4170"/>
              <a:gd name="T81" fmla="*/ 104 h 684"/>
              <a:gd name="T82" fmla="*/ 3075 w 4170"/>
              <a:gd name="T83" fmla="*/ 106 h 684"/>
              <a:gd name="T84" fmla="*/ 3149 w 4170"/>
              <a:gd name="T85" fmla="*/ 109 h 684"/>
              <a:gd name="T86" fmla="*/ 3222 w 4170"/>
              <a:gd name="T87" fmla="*/ 111 h 684"/>
              <a:gd name="T88" fmla="*/ 3296 w 4170"/>
              <a:gd name="T89" fmla="*/ 113 h 684"/>
              <a:gd name="T90" fmla="*/ 3371 w 4170"/>
              <a:gd name="T91" fmla="*/ 116 h 684"/>
              <a:gd name="T92" fmla="*/ 3443 w 4170"/>
              <a:gd name="T93" fmla="*/ 117 h 684"/>
              <a:gd name="T94" fmla="*/ 3518 w 4170"/>
              <a:gd name="T95" fmla="*/ 121 h 684"/>
              <a:gd name="T96" fmla="*/ 3589 w 4170"/>
              <a:gd name="T97" fmla="*/ 122 h 684"/>
              <a:gd name="T98" fmla="*/ 3665 w 4170"/>
              <a:gd name="T99" fmla="*/ 124 h 684"/>
              <a:gd name="T100" fmla="*/ 3736 w 4170"/>
              <a:gd name="T101" fmla="*/ 127 h 684"/>
              <a:gd name="T102" fmla="*/ 3810 w 4170"/>
              <a:gd name="T103" fmla="*/ 129 h 684"/>
              <a:gd name="T104" fmla="*/ 3885 w 4170"/>
              <a:gd name="T105" fmla="*/ 131 h 684"/>
              <a:gd name="T106" fmla="*/ 3957 w 4170"/>
              <a:gd name="T107" fmla="*/ 134 h 684"/>
              <a:gd name="T108" fmla="*/ 4030 w 4170"/>
              <a:gd name="T109" fmla="*/ 135 h 684"/>
              <a:gd name="T110" fmla="*/ 4105 w 4170"/>
              <a:gd name="T111" fmla="*/ 137 h 6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684">
                <a:moveTo>
                  <a:pt x="0" y="684"/>
                </a:moveTo>
                <a:lnTo>
                  <a:pt x="8" y="684"/>
                </a:lnTo>
                <a:lnTo>
                  <a:pt x="16" y="684"/>
                </a:lnTo>
                <a:lnTo>
                  <a:pt x="26" y="684"/>
                </a:lnTo>
                <a:lnTo>
                  <a:pt x="34" y="684"/>
                </a:lnTo>
                <a:lnTo>
                  <a:pt x="40" y="684"/>
                </a:lnTo>
                <a:lnTo>
                  <a:pt x="49" y="684"/>
                </a:lnTo>
                <a:lnTo>
                  <a:pt x="57" y="684"/>
                </a:lnTo>
                <a:lnTo>
                  <a:pt x="67" y="684"/>
                </a:lnTo>
                <a:lnTo>
                  <a:pt x="75" y="684"/>
                </a:lnTo>
                <a:lnTo>
                  <a:pt x="81" y="684"/>
                </a:lnTo>
                <a:lnTo>
                  <a:pt x="89" y="684"/>
                </a:lnTo>
                <a:lnTo>
                  <a:pt x="98" y="684"/>
                </a:lnTo>
                <a:lnTo>
                  <a:pt x="107" y="684"/>
                </a:lnTo>
                <a:lnTo>
                  <a:pt x="116" y="684"/>
                </a:lnTo>
                <a:lnTo>
                  <a:pt x="122" y="684"/>
                </a:lnTo>
                <a:lnTo>
                  <a:pt x="130" y="684"/>
                </a:lnTo>
                <a:lnTo>
                  <a:pt x="138" y="684"/>
                </a:lnTo>
                <a:lnTo>
                  <a:pt x="148" y="684"/>
                </a:lnTo>
                <a:lnTo>
                  <a:pt x="156" y="684"/>
                </a:lnTo>
                <a:lnTo>
                  <a:pt x="163" y="684"/>
                </a:lnTo>
                <a:lnTo>
                  <a:pt x="171" y="684"/>
                </a:lnTo>
                <a:lnTo>
                  <a:pt x="179" y="684"/>
                </a:lnTo>
                <a:lnTo>
                  <a:pt x="189" y="684"/>
                </a:lnTo>
                <a:lnTo>
                  <a:pt x="197" y="684"/>
                </a:lnTo>
                <a:lnTo>
                  <a:pt x="204" y="684"/>
                </a:lnTo>
                <a:lnTo>
                  <a:pt x="212" y="684"/>
                </a:lnTo>
                <a:lnTo>
                  <a:pt x="220" y="684"/>
                </a:lnTo>
                <a:lnTo>
                  <a:pt x="230" y="684"/>
                </a:lnTo>
                <a:lnTo>
                  <a:pt x="238" y="684"/>
                </a:lnTo>
                <a:lnTo>
                  <a:pt x="244" y="684"/>
                </a:lnTo>
                <a:lnTo>
                  <a:pt x="253" y="684"/>
                </a:lnTo>
                <a:lnTo>
                  <a:pt x="261" y="684"/>
                </a:lnTo>
                <a:lnTo>
                  <a:pt x="271" y="684"/>
                </a:lnTo>
                <a:lnTo>
                  <a:pt x="279" y="684"/>
                </a:lnTo>
                <a:lnTo>
                  <a:pt x="285" y="684"/>
                </a:lnTo>
                <a:lnTo>
                  <a:pt x="293" y="684"/>
                </a:lnTo>
                <a:lnTo>
                  <a:pt x="302" y="684"/>
                </a:lnTo>
                <a:lnTo>
                  <a:pt x="311" y="684"/>
                </a:lnTo>
                <a:lnTo>
                  <a:pt x="319" y="684"/>
                </a:lnTo>
                <a:lnTo>
                  <a:pt x="326" y="684"/>
                </a:lnTo>
                <a:lnTo>
                  <a:pt x="334" y="684"/>
                </a:lnTo>
                <a:lnTo>
                  <a:pt x="342" y="597"/>
                </a:lnTo>
                <a:lnTo>
                  <a:pt x="352" y="592"/>
                </a:lnTo>
                <a:lnTo>
                  <a:pt x="360" y="587"/>
                </a:lnTo>
                <a:lnTo>
                  <a:pt x="367" y="584"/>
                </a:lnTo>
                <a:lnTo>
                  <a:pt x="375" y="579"/>
                </a:lnTo>
                <a:lnTo>
                  <a:pt x="383" y="576"/>
                </a:lnTo>
                <a:lnTo>
                  <a:pt x="393" y="571"/>
                </a:lnTo>
                <a:lnTo>
                  <a:pt x="401" y="568"/>
                </a:lnTo>
                <a:lnTo>
                  <a:pt x="408" y="563"/>
                </a:lnTo>
                <a:lnTo>
                  <a:pt x="416" y="560"/>
                </a:lnTo>
                <a:lnTo>
                  <a:pt x="424" y="555"/>
                </a:lnTo>
                <a:lnTo>
                  <a:pt x="434" y="551"/>
                </a:lnTo>
                <a:lnTo>
                  <a:pt x="442" y="546"/>
                </a:lnTo>
                <a:lnTo>
                  <a:pt x="448" y="543"/>
                </a:lnTo>
                <a:lnTo>
                  <a:pt x="457" y="540"/>
                </a:lnTo>
                <a:lnTo>
                  <a:pt x="465" y="535"/>
                </a:lnTo>
                <a:lnTo>
                  <a:pt x="474" y="532"/>
                </a:lnTo>
                <a:lnTo>
                  <a:pt x="483" y="527"/>
                </a:lnTo>
                <a:lnTo>
                  <a:pt x="489" y="524"/>
                </a:lnTo>
                <a:lnTo>
                  <a:pt x="497" y="520"/>
                </a:lnTo>
                <a:lnTo>
                  <a:pt x="505" y="515"/>
                </a:lnTo>
                <a:lnTo>
                  <a:pt x="515" y="512"/>
                </a:lnTo>
                <a:lnTo>
                  <a:pt x="523" y="509"/>
                </a:lnTo>
                <a:lnTo>
                  <a:pt x="532" y="504"/>
                </a:lnTo>
                <a:lnTo>
                  <a:pt x="538" y="501"/>
                </a:lnTo>
                <a:lnTo>
                  <a:pt x="546" y="498"/>
                </a:lnTo>
                <a:lnTo>
                  <a:pt x="556" y="494"/>
                </a:lnTo>
                <a:lnTo>
                  <a:pt x="564" y="489"/>
                </a:lnTo>
                <a:lnTo>
                  <a:pt x="572" y="486"/>
                </a:lnTo>
                <a:lnTo>
                  <a:pt x="579" y="483"/>
                </a:lnTo>
                <a:lnTo>
                  <a:pt x="587" y="480"/>
                </a:lnTo>
                <a:lnTo>
                  <a:pt x="597" y="475"/>
                </a:lnTo>
                <a:lnTo>
                  <a:pt x="605" y="471"/>
                </a:lnTo>
                <a:lnTo>
                  <a:pt x="613" y="468"/>
                </a:lnTo>
                <a:lnTo>
                  <a:pt x="620" y="465"/>
                </a:lnTo>
                <a:lnTo>
                  <a:pt x="628" y="462"/>
                </a:lnTo>
                <a:lnTo>
                  <a:pt x="638" y="457"/>
                </a:lnTo>
                <a:lnTo>
                  <a:pt x="646" y="454"/>
                </a:lnTo>
                <a:lnTo>
                  <a:pt x="654" y="450"/>
                </a:lnTo>
                <a:lnTo>
                  <a:pt x="661" y="447"/>
                </a:lnTo>
                <a:lnTo>
                  <a:pt x="669" y="444"/>
                </a:lnTo>
                <a:lnTo>
                  <a:pt x="678" y="440"/>
                </a:lnTo>
                <a:lnTo>
                  <a:pt x="687" y="437"/>
                </a:lnTo>
                <a:lnTo>
                  <a:pt x="695" y="434"/>
                </a:lnTo>
                <a:lnTo>
                  <a:pt x="701" y="431"/>
                </a:lnTo>
                <a:lnTo>
                  <a:pt x="709" y="427"/>
                </a:lnTo>
                <a:lnTo>
                  <a:pt x="719" y="423"/>
                </a:lnTo>
                <a:lnTo>
                  <a:pt x="727" y="419"/>
                </a:lnTo>
                <a:lnTo>
                  <a:pt x="736" y="416"/>
                </a:lnTo>
                <a:lnTo>
                  <a:pt x="742" y="413"/>
                </a:lnTo>
                <a:lnTo>
                  <a:pt x="750" y="409"/>
                </a:lnTo>
                <a:lnTo>
                  <a:pt x="760" y="406"/>
                </a:lnTo>
                <a:lnTo>
                  <a:pt x="768" y="403"/>
                </a:lnTo>
                <a:lnTo>
                  <a:pt x="776" y="400"/>
                </a:lnTo>
                <a:lnTo>
                  <a:pt x="783" y="396"/>
                </a:lnTo>
                <a:lnTo>
                  <a:pt x="791" y="393"/>
                </a:lnTo>
                <a:lnTo>
                  <a:pt x="801" y="392"/>
                </a:lnTo>
                <a:lnTo>
                  <a:pt x="809" y="388"/>
                </a:lnTo>
                <a:lnTo>
                  <a:pt x="817" y="385"/>
                </a:lnTo>
                <a:lnTo>
                  <a:pt x="824" y="382"/>
                </a:lnTo>
                <a:lnTo>
                  <a:pt x="832" y="378"/>
                </a:lnTo>
                <a:lnTo>
                  <a:pt x="842" y="375"/>
                </a:lnTo>
                <a:lnTo>
                  <a:pt x="850" y="372"/>
                </a:lnTo>
                <a:lnTo>
                  <a:pt x="856" y="369"/>
                </a:lnTo>
                <a:lnTo>
                  <a:pt x="866" y="365"/>
                </a:lnTo>
                <a:lnTo>
                  <a:pt x="873" y="362"/>
                </a:lnTo>
                <a:lnTo>
                  <a:pt x="882" y="361"/>
                </a:lnTo>
                <a:lnTo>
                  <a:pt x="891" y="357"/>
                </a:lnTo>
                <a:lnTo>
                  <a:pt x="897" y="354"/>
                </a:lnTo>
                <a:lnTo>
                  <a:pt x="907" y="351"/>
                </a:lnTo>
                <a:lnTo>
                  <a:pt x="913" y="347"/>
                </a:lnTo>
                <a:lnTo>
                  <a:pt x="923" y="344"/>
                </a:lnTo>
                <a:lnTo>
                  <a:pt x="931" y="343"/>
                </a:lnTo>
                <a:lnTo>
                  <a:pt x="938" y="339"/>
                </a:lnTo>
                <a:lnTo>
                  <a:pt x="948" y="336"/>
                </a:lnTo>
                <a:lnTo>
                  <a:pt x="954" y="333"/>
                </a:lnTo>
                <a:lnTo>
                  <a:pt x="964" y="331"/>
                </a:lnTo>
                <a:lnTo>
                  <a:pt x="972" y="328"/>
                </a:lnTo>
                <a:lnTo>
                  <a:pt x="979" y="325"/>
                </a:lnTo>
                <a:lnTo>
                  <a:pt x="988" y="321"/>
                </a:lnTo>
                <a:lnTo>
                  <a:pt x="995" y="320"/>
                </a:lnTo>
                <a:lnTo>
                  <a:pt x="1005" y="316"/>
                </a:lnTo>
                <a:lnTo>
                  <a:pt x="1013" y="313"/>
                </a:lnTo>
                <a:lnTo>
                  <a:pt x="1019" y="310"/>
                </a:lnTo>
                <a:lnTo>
                  <a:pt x="1029" y="308"/>
                </a:lnTo>
                <a:lnTo>
                  <a:pt x="1036" y="305"/>
                </a:lnTo>
                <a:lnTo>
                  <a:pt x="1044" y="302"/>
                </a:lnTo>
                <a:lnTo>
                  <a:pt x="1054" y="300"/>
                </a:lnTo>
                <a:lnTo>
                  <a:pt x="1060" y="297"/>
                </a:lnTo>
                <a:lnTo>
                  <a:pt x="1070" y="294"/>
                </a:lnTo>
                <a:lnTo>
                  <a:pt x="1077" y="292"/>
                </a:lnTo>
                <a:lnTo>
                  <a:pt x="1085" y="289"/>
                </a:lnTo>
                <a:lnTo>
                  <a:pt x="1095" y="287"/>
                </a:lnTo>
                <a:lnTo>
                  <a:pt x="1101" y="284"/>
                </a:lnTo>
                <a:lnTo>
                  <a:pt x="1111" y="281"/>
                </a:lnTo>
                <a:lnTo>
                  <a:pt x="1117" y="279"/>
                </a:lnTo>
                <a:lnTo>
                  <a:pt x="1126" y="276"/>
                </a:lnTo>
                <a:lnTo>
                  <a:pt x="1135" y="274"/>
                </a:lnTo>
                <a:lnTo>
                  <a:pt x="1142" y="271"/>
                </a:lnTo>
                <a:lnTo>
                  <a:pt x="1152" y="268"/>
                </a:lnTo>
                <a:lnTo>
                  <a:pt x="1158" y="266"/>
                </a:lnTo>
                <a:lnTo>
                  <a:pt x="1166" y="263"/>
                </a:lnTo>
                <a:lnTo>
                  <a:pt x="1176" y="261"/>
                </a:lnTo>
                <a:lnTo>
                  <a:pt x="1183" y="258"/>
                </a:lnTo>
                <a:lnTo>
                  <a:pt x="1192" y="256"/>
                </a:lnTo>
                <a:lnTo>
                  <a:pt x="1199" y="253"/>
                </a:lnTo>
                <a:lnTo>
                  <a:pt x="1207" y="251"/>
                </a:lnTo>
                <a:lnTo>
                  <a:pt x="1217" y="248"/>
                </a:lnTo>
                <a:lnTo>
                  <a:pt x="1223" y="246"/>
                </a:lnTo>
                <a:lnTo>
                  <a:pt x="1233" y="243"/>
                </a:lnTo>
                <a:lnTo>
                  <a:pt x="1240" y="241"/>
                </a:lnTo>
                <a:lnTo>
                  <a:pt x="1248" y="238"/>
                </a:lnTo>
                <a:lnTo>
                  <a:pt x="1258" y="237"/>
                </a:lnTo>
                <a:lnTo>
                  <a:pt x="1264" y="233"/>
                </a:lnTo>
                <a:lnTo>
                  <a:pt x="1274" y="232"/>
                </a:lnTo>
                <a:lnTo>
                  <a:pt x="1281" y="228"/>
                </a:lnTo>
                <a:lnTo>
                  <a:pt x="1289" y="227"/>
                </a:lnTo>
                <a:lnTo>
                  <a:pt x="1299" y="224"/>
                </a:lnTo>
                <a:lnTo>
                  <a:pt x="1305" y="222"/>
                </a:lnTo>
                <a:lnTo>
                  <a:pt x="1315" y="220"/>
                </a:lnTo>
                <a:lnTo>
                  <a:pt x="1323" y="217"/>
                </a:lnTo>
                <a:lnTo>
                  <a:pt x="1330" y="215"/>
                </a:lnTo>
                <a:lnTo>
                  <a:pt x="1339" y="212"/>
                </a:lnTo>
                <a:lnTo>
                  <a:pt x="1346" y="210"/>
                </a:lnTo>
                <a:lnTo>
                  <a:pt x="1356" y="209"/>
                </a:lnTo>
                <a:lnTo>
                  <a:pt x="1364" y="206"/>
                </a:lnTo>
                <a:lnTo>
                  <a:pt x="1370" y="204"/>
                </a:lnTo>
                <a:lnTo>
                  <a:pt x="1380" y="202"/>
                </a:lnTo>
                <a:lnTo>
                  <a:pt x="1387" y="199"/>
                </a:lnTo>
                <a:lnTo>
                  <a:pt x="1396" y="197"/>
                </a:lnTo>
                <a:lnTo>
                  <a:pt x="1405" y="196"/>
                </a:lnTo>
                <a:lnTo>
                  <a:pt x="1411" y="193"/>
                </a:lnTo>
                <a:lnTo>
                  <a:pt x="1421" y="191"/>
                </a:lnTo>
                <a:lnTo>
                  <a:pt x="1427" y="189"/>
                </a:lnTo>
                <a:lnTo>
                  <a:pt x="1437" y="186"/>
                </a:lnTo>
                <a:lnTo>
                  <a:pt x="1445" y="184"/>
                </a:lnTo>
                <a:lnTo>
                  <a:pt x="1452" y="183"/>
                </a:lnTo>
                <a:lnTo>
                  <a:pt x="1462" y="179"/>
                </a:lnTo>
                <a:lnTo>
                  <a:pt x="1468" y="178"/>
                </a:lnTo>
                <a:lnTo>
                  <a:pt x="1478" y="176"/>
                </a:lnTo>
                <a:lnTo>
                  <a:pt x="1486" y="175"/>
                </a:lnTo>
                <a:lnTo>
                  <a:pt x="1493" y="171"/>
                </a:lnTo>
                <a:lnTo>
                  <a:pt x="1502" y="170"/>
                </a:lnTo>
                <a:lnTo>
                  <a:pt x="1509" y="168"/>
                </a:lnTo>
                <a:lnTo>
                  <a:pt x="1519" y="165"/>
                </a:lnTo>
                <a:lnTo>
                  <a:pt x="1527" y="163"/>
                </a:lnTo>
                <a:lnTo>
                  <a:pt x="1533" y="162"/>
                </a:lnTo>
                <a:lnTo>
                  <a:pt x="1543" y="160"/>
                </a:lnTo>
                <a:lnTo>
                  <a:pt x="1550" y="158"/>
                </a:lnTo>
                <a:lnTo>
                  <a:pt x="1560" y="155"/>
                </a:lnTo>
                <a:lnTo>
                  <a:pt x="1568" y="153"/>
                </a:lnTo>
                <a:lnTo>
                  <a:pt x="1574" y="152"/>
                </a:lnTo>
                <a:lnTo>
                  <a:pt x="1584" y="150"/>
                </a:lnTo>
                <a:lnTo>
                  <a:pt x="1591" y="148"/>
                </a:lnTo>
                <a:lnTo>
                  <a:pt x="1599" y="145"/>
                </a:lnTo>
                <a:lnTo>
                  <a:pt x="1609" y="144"/>
                </a:lnTo>
                <a:lnTo>
                  <a:pt x="1615" y="142"/>
                </a:lnTo>
                <a:lnTo>
                  <a:pt x="1625" y="140"/>
                </a:lnTo>
                <a:lnTo>
                  <a:pt x="1633" y="139"/>
                </a:lnTo>
                <a:lnTo>
                  <a:pt x="1640" y="137"/>
                </a:lnTo>
                <a:lnTo>
                  <a:pt x="1648" y="134"/>
                </a:lnTo>
                <a:lnTo>
                  <a:pt x="1656" y="132"/>
                </a:lnTo>
                <a:lnTo>
                  <a:pt x="1666" y="131"/>
                </a:lnTo>
                <a:lnTo>
                  <a:pt x="1674" y="129"/>
                </a:lnTo>
                <a:lnTo>
                  <a:pt x="1680" y="127"/>
                </a:lnTo>
                <a:lnTo>
                  <a:pt x="1688" y="126"/>
                </a:lnTo>
                <a:lnTo>
                  <a:pt x="1697" y="124"/>
                </a:lnTo>
                <a:lnTo>
                  <a:pt x="1706" y="121"/>
                </a:lnTo>
                <a:lnTo>
                  <a:pt x="1715" y="119"/>
                </a:lnTo>
                <a:lnTo>
                  <a:pt x="1721" y="117"/>
                </a:lnTo>
                <a:lnTo>
                  <a:pt x="1729" y="116"/>
                </a:lnTo>
                <a:lnTo>
                  <a:pt x="1739" y="114"/>
                </a:lnTo>
                <a:lnTo>
                  <a:pt x="1747" y="113"/>
                </a:lnTo>
                <a:lnTo>
                  <a:pt x="1755" y="111"/>
                </a:lnTo>
                <a:lnTo>
                  <a:pt x="1762" y="109"/>
                </a:lnTo>
                <a:lnTo>
                  <a:pt x="1770" y="108"/>
                </a:lnTo>
                <a:lnTo>
                  <a:pt x="1780" y="106"/>
                </a:lnTo>
                <a:lnTo>
                  <a:pt x="1788" y="104"/>
                </a:lnTo>
                <a:lnTo>
                  <a:pt x="1796" y="103"/>
                </a:lnTo>
                <a:lnTo>
                  <a:pt x="1803" y="101"/>
                </a:lnTo>
                <a:lnTo>
                  <a:pt x="1811" y="100"/>
                </a:lnTo>
                <a:lnTo>
                  <a:pt x="1821" y="98"/>
                </a:lnTo>
                <a:lnTo>
                  <a:pt x="1829" y="95"/>
                </a:lnTo>
                <a:lnTo>
                  <a:pt x="1835" y="93"/>
                </a:lnTo>
                <a:lnTo>
                  <a:pt x="1844" y="91"/>
                </a:lnTo>
                <a:lnTo>
                  <a:pt x="1852" y="90"/>
                </a:lnTo>
                <a:lnTo>
                  <a:pt x="1861" y="88"/>
                </a:lnTo>
                <a:lnTo>
                  <a:pt x="1870" y="86"/>
                </a:lnTo>
                <a:lnTo>
                  <a:pt x="1876" y="85"/>
                </a:lnTo>
                <a:lnTo>
                  <a:pt x="1884" y="83"/>
                </a:lnTo>
                <a:lnTo>
                  <a:pt x="1892" y="82"/>
                </a:lnTo>
                <a:lnTo>
                  <a:pt x="1902" y="80"/>
                </a:lnTo>
                <a:lnTo>
                  <a:pt x="1910" y="80"/>
                </a:lnTo>
                <a:lnTo>
                  <a:pt x="1917" y="78"/>
                </a:lnTo>
                <a:lnTo>
                  <a:pt x="1925" y="77"/>
                </a:lnTo>
                <a:lnTo>
                  <a:pt x="1933" y="75"/>
                </a:lnTo>
                <a:lnTo>
                  <a:pt x="1943" y="73"/>
                </a:lnTo>
                <a:lnTo>
                  <a:pt x="1951" y="72"/>
                </a:lnTo>
                <a:lnTo>
                  <a:pt x="1958" y="70"/>
                </a:lnTo>
                <a:lnTo>
                  <a:pt x="1966" y="69"/>
                </a:lnTo>
                <a:lnTo>
                  <a:pt x="1976" y="67"/>
                </a:lnTo>
                <a:lnTo>
                  <a:pt x="1984" y="65"/>
                </a:lnTo>
                <a:lnTo>
                  <a:pt x="1992" y="64"/>
                </a:lnTo>
                <a:lnTo>
                  <a:pt x="1999" y="62"/>
                </a:lnTo>
                <a:lnTo>
                  <a:pt x="2007" y="60"/>
                </a:lnTo>
                <a:lnTo>
                  <a:pt x="2015" y="59"/>
                </a:lnTo>
                <a:lnTo>
                  <a:pt x="2023" y="57"/>
                </a:lnTo>
                <a:lnTo>
                  <a:pt x="2033" y="55"/>
                </a:lnTo>
                <a:lnTo>
                  <a:pt x="2039" y="55"/>
                </a:lnTo>
                <a:lnTo>
                  <a:pt x="2049" y="54"/>
                </a:lnTo>
                <a:lnTo>
                  <a:pt x="2056" y="52"/>
                </a:lnTo>
                <a:lnTo>
                  <a:pt x="2065" y="51"/>
                </a:lnTo>
                <a:lnTo>
                  <a:pt x="2074" y="49"/>
                </a:lnTo>
                <a:lnTo>
                  <a:pt x="2080" y="47"/>
                </a:lnTo>
                <a:lnTo>
                  <a:pt x="2090" y="46"/>
                </a:lnTo>
                <a:lnTo>
                  <a:pt x="2096" y="44"/>
                </a:lnTo>
                <a:lnTo>
                  <a:pt x="2106" y="42"/>
                </a:lnTo>
                <a:lnTo>
                  <a:pt x="2113" y="42"/>
                </a:lnTo>
                <a:lnTo>
                  <a:pt x="2121" y="41"/>
                </a:lnTo>
                <a:lnTo>
                  <a:pt x="2131" y="39"/>
                </a:lnTo>
                <a:lnTo>
                  <a:pt x="2137" y="38"/>
                </a:lnTo>
                <a:lnTo>
                  <a:pt x="2147" y="36"/>
                </a:lnTo>
                <a:lnTo>
                  <a:pt x="2154" y="34"/>
                </a:lnTo>
                <a:lnTo>
                  <a:pt x="2163" y="34"/>
                </a:lnTo>
                <a:lnTo>
                  <a:pt x="2171" y="33"/>
                </a:lnTo>
                <a:lnTo>
                  <a:pt x="2178" y="31"/>
                </a:lnTo>
                <a:lnTo>
                  <a:pt x="2188" y="29"/>
                </a:lnTo>
                <a:lnTo>
                  <a:pt x="2194" y="28"/>
                </a:lnTo>
                <a:lnTo>
                  <a:pt x="2202" y="26"/>
                </a:lnTo>
                <a:lnTo>
                  <a:pt x="2212" y="26"/>
                </a:lnTo>
                <a:lnTo>
                  <a:pt x="2220" y="25"/>
                </a:lnTo>
                <a:lnTo>
                  <a:pt x="2229" y="23"/>
                </a:lnTo>
                <a:lnTo>
                  <a:pt x="2235" y="21"/>
                </a:lnTo>
                <a:lnTo>
                  <a:pt x="2243" y="20"/>
                </a:lnTo>
                <a:lnTo>
                  <a:pt x="2251" y="20"/>
                </a:lnTo>
                <a:lnTo>
                  <a:pt x="2261" y="18"/>
                </a:lnTo>
                <a:lnTo>
                  <a:pt x="2269" y="16"/>
                </a:lnTo>
                <a:lnTo>
                  <a:pt x="2278" y="15"/>
                </a:lnTo>
                <a:lnTo>
                  <a:pt x="2284" y="15"/>
                </a:lnTo>
                <a:lnTo>
                  <a:pt x="2292" y="13"/>
                </a:lnTo>
                <a:lnTo>
                  <a:pt x="2300" y="11"/>
                </a:lnTo>
                <a:lnTo>
                  <a:pt x="2310" y="10"/>
                </a:lnTo>
                <a:lnTo>
                  <a:pt x="2317" y="8"/>
                </a:lnTo>
                <a:lnTo>
                  <a:pt x="2326" y="8"/>
                </a:lnTo>
                <a:lnTo>
                  <a:pt x="2335" y="7"/>
                </a:lnTo>
                <a:lnTo>
                  <a:pt x="2341" y="5"/>
                </a:lnTo>
                <a:lnTo>
                  <a:pt x="2351" y="3"/>
                </a:lnTo>
                <a:lnTo>
                  <a:pt x="2357" y="3"/>
                </a:lnTo>
                <a:lnTo>
                  <a:pt x="2366" y="2"/>
                </a:lnTo>
                <a:lnTo>
                  <a:pt x="2375" y="0"/>
                </a:lnTo>
                <a:lnTo>
                  <a:pt x="2382" y="0"/>
                </a:lnTo>
                <a:lnTo>
                  <a:pt x="2390" y="85"/>
                </a:lnTo>
                <a:lnTo>
                  <a:pt x="2400" y="85"/>
                </a:lnTo>
                <a:lnTo>
                  <a:pt x="2408" y="85"/>
                </a:lnTo>
                <a:lnTo>
                  <a:pt x="2416" y="85"/>
                </a:lnTo>
                <a:lnTo>
                  <a:pt x="2424" y="86"/>
                </a:lnTo>
                <a:lnTo>
                  <a:pt x="2433" y="86"/>
                </a:lnTo>
                <a:lnTo>
                  <a:pt x="2439" y="86"/>
                </a:lnTo>
                <a:lnTo>
                  <a:pt x="2449" y="86"/>
                </a:lnTo>
                <a:lnTo>
                  <a:pt x="2455" y="86"/>
                </a:lnTo>
                <a:lnTo>
                  <a:pt x="2464" y="86"/>
                </a:lnTo>
                <a:lnTo>
                  <a:pt x="2473" y="88"/>
                </a:lnTo>
                <a:lnTo>
                  <a:pt x="2480" y="88"/>
                </a:lnTo>
                <a:lnTo>
                  <a:pt x="2490" y="88"/>
                </a:lnTo>
                <a:lnTo>
                  <a:pt x="2498" y="88"/>
                </a:lnTo>
                <a:lnTo>
                  <a:pt x="2506" y="88"/>
                </a:lnTo>
                <a:lnTo>
                  <a:pt x="2513" y="88"/>
                </a:lnTo>
                <a:lnTo>
                  <a:pt x="2521" y="90"/>
                </a:lnTo>
                <a:lnTo>
                  <a:pt x="2529" y="90"/>
                </a:lnTo>
                <a:lnTo>
                  <a:pt x="2539" y="90"/>
                </a:lnTo>
                <a:lnTo>
                  <a:pt x="2547" y="90"/>
                </a:lnTo>
                <a:lnTo>
                  <a:pt x="2555" y="90"/>
                </a:lnTo>
                <a:lnTo>
                  <a:pt x="2561" y="90"/>
                </a:lnTo>
                <a:lnTo>
                  <a:pt x="2570" y="91"/>
                </a:lnTo>
                <a:lnTo>
                  <a:pt x="2578" y="91"/>
                </a:lnTo>
                <a:lnTo>
                  <a:pt x="2588" y="91"/>
                </a:lnTo>
                <a:lnTo>
                  <a:pt x="2594" y="91"/>
                </a:lnTo>
                <a:lnTo>
                  <a:pt x="2604" y="91"/>
                </a:lnTo>
                <a:lnTo>
                  <a:pt x="2610" y="91"/>
                </a:lnTo>
                <a:lnTo>
                  <a:pt x="2620" y="91"/>
                </a:lnTo>
                <a:lnTo>
                  <a:pt x="2627" y="93"/>
                </a:lnTo>
                <a:lnTo>
                  <a:pt x="2635" y="93"/>
                </a:lnTo>
                <a:lnTo>
                  <a:pt x="2645" y="93"/>
                </a:lnTo>
                <a:lnTo>
                  <a:pt x="2651" y="93"/>
                </a:lnTo>
                <a:lnTo>
                  <a:pt x="2661" y="93"/>
                </a:lnTo>
                <a:lnTo>
                  <a:pt x="2668" y="93"/>
                </a:lnTo>
                <a:lnTo>
                  <a:pt x="2676" y="95"/>
                </a:lnTo>
                <a:lnTo>
                  <a:pt x="2685" y="95"/>
                </a:lnTo>
                <a:lnTo>
                  <a:pt x="2692" y="95"/>
                </a:lnTo>
                <a:lnTo>
                  <a:pt x="2702" y="95"/>
                </a:lnTo>
                <a:lnTo>
                  <a:pt x="2708" y="95"/>
                </a:lnTo>
                <a:lnTo>
                  <a:pt x="2718" y="95"/>
                </a:lnTo>
                <a:lnTo>
                  <a:pt x="2726" y="96"/>
                </a:lnTo>
                <a:lnTo>
                  <a:pt x="2733" y="96"/>
                </a:lnTo>
                <a:lnTo>
                  <a:pt x="2743" y="96"/>
                </a:lnTo>
                <a:lnTo>
                  <a:pt x="2749" y="96"/>
                </a:lnTo>
                <a:lnTo>
                  <a:pt x="2759" y="96"/>
                </a:lnTo>
                <a:lnTo>
                  <a:pt x="2765" y="96"/>
                </a:lnTo>
                <a:lnTo>
                  <a:pt x="2774" y="96"/>
                </a:lnTo>
                <a:lnTo>
                  <a:pt x="2783" y="98"/>
                </a:lnTo>
                <a:lnTo>
                  <a:pt x="2790" y="98"/>
                </a:lnTo>
                <a:lnTo>
                  <a:pt x="2798" y="98"/>
                </a:lnTo>
                <a:lnTo>
                  <a:pt x="2808" y="98"/>
                </a:lnTo>
                <a:lnTo>
                  <a:pt x="2816" y="98"/>
                </a:lnTo>
                <a:lnTo>
                  <a:pt x="2824" y="98"/>
                </a:lnTo>
                <a:lnTo>
                  <a:pt x="2831" y="100"/>
                </a:lnTo>
                <a:lnTo>
                  <a:pt x="2839" y="100"/>
                </a:lnTo>
                <a:lnTo>
                  <a:pt x="2849" y="100"/>
                </a:lnTo>
                <a:lnTo>
                  <a:pt x="2857" y="100"/>
                </a:lnTo>
                <a:lnTo>
                  <a:pt x="2865" y="100"/>
                </a:lnTo>
                <a:lnTo>
                  <a:pt x="2871" y="100"/>
                </a:lnTo>
                <a:lnTo>
                  <a:pt x="2880" y="101"/>
                </a:lnTo>
                <a:lnTo>
                  <a:pt x="2889" y="101"/>
                </a:lnTo>
                <a:lnTo>
                  <a:pt x="2898" y="101"/>
                </a:lnTo>
                <a:lnTo>
                  <a:pt x="2904" y="101"/>
                </a:lnTo>
                <a:lnTo>
                  <a:pt x="2912" y="101"/>
                </a:lnTo>
                <a:lnTo>
                  <a:pt x="2920" y="101"/>
                </a:lnTo>
                <a:lnTo>
                  <a:pt x="2930" y="101"/>
                </a:lnTo>
                <a:lnTo>
                  <a:pt x="2938" y="103"/>
                </a:lnTo>
                <a:lnTo>
                  <a:pt x="2945" y="103"/>
                </a:lnTo>
                <a:lnTo>
                  <a:pt x="2953" y="103"/>
                </a:lnTo>
                <a:lnTo>
                  <a:pt x="2961" y="103"/>
                </a:lnTo>
                <a:lnTo>
                  <a:pt x="2971" y="103"/>
                </a:lnTo>
                <a:lnTo>
                  <a:pt x="2979" y="103"/>
                </a:lnTo>
                <a:lnTo>
                  <a:pt x="2986" y="104"/>
                </a:lnTo>
                <a:lnTo>
                  <a:pt x="2994" y="104"/>
                </a:lnTo>
                <a:lnTo>
                  <a:pt x="3002" y="104"/>
                </a:lnTo>
                <a:lnTo>
                  <a:pt x="3012" y="104"/>
                </a:lnTo>
                <a:lnTo>
                  <a:pt x="3020" y="104"/>
                </a:lnTo>
                <a:lnTo>
                  <a:pt x="3027" y="104"/>
                </a:lnTo>
                <a:lnTo>
                  <a:pt x="3035" y="104"/>
                </a:lnTo>
                <a:lnTo>
                  <a:pt x="3044" y="106"/>
                </a:lnTo>
                <a:lnTo>
                  <a:pt x="3053" y="106"/>
                </a:lnTo>
                <a:lnTo>
                  <a:pt x="3061" y="106"/>
                </a:lnTo>
                <a:lnTo>
                  <a:pt x="3067" y="106"/>
                </a:lnTo>
                <a:lnTo>
                  <a:pt x="3075" y="106"/>
                </a:lnTo>
                <a:lnTo>
                  <a:pt x="3085" y="106"/>
                </a:lnTo>
                <a:lnTo>
                  <a:pt x="3093" y="108"/>
                </a:lnTo>
                <a:lnTo>
                  <a:pt x="3102" y="108"/>
                </a:lnTo>
                <a:lnTo>
                  <a:pt x="3108" y="108"/>
                </a:lnTo>
                <a:lnTo>
                  <a:pt x="3116" y="108"/>
                </a:lnTo>
                <a:lnTo>
                  <a:pt x="3126" y="108"/>
                </a:lnTo>
                <a:lnTo>
                  <a:pt x="3134" y="108"/>
                </a:lnTo>
                <a:lnTo>
                  <a:pt x="3142" y="108"/>
                </a:lnTo>
                <a:lnTo>
                  <a:pt x="3149" y="109"/>
                </a:lnTo>
                <a:lnTo>
                  <a:pt x="3157" y="109"/>
                </a:lnTo>
                <a:lnTo>
                  <a:pt x="3167" y="109"/>
                </a:lnTo>
                <a:lnTo>
                  <a:pt x="3173" y="109"/>
                </a:lnTo>
                <a:lnTo>
                  <a:pt x="3182" y="109"/>
                </a:lnTo>
                <a:lnTo>
                  <a:pt x="3191" y="109"/>
                </a:lnTo>
                <a:lnTo>
                  <a:pt x="3198" y="111"/>
                </a:lnTo>
                <a:lnTo>
                  <a:pt x="3208" y="111"/>
                </a:lnTo>
                <a:lnTo>
                  <a:pt x="3214" y="111"/>
                </a:lnTo>
                <a:lnTo>
                  <a:pt x="3222" y="111"/>
                </a:lnTo>
                <a:lnTo>
                  <a:pt x="3232" y="111"/>
                </a:lnTo>
                <a:lnTo>
                  <a:pt x="3239" y="111"/>
                </a:lnTo>
                <a:lnTo>
                  <a:pt x="3248" y="111"/>
                </a:lnTo>
                <a:lnTo>
                  <a:pt x="3255" y="113"/>
                </a:lnTo>
                <a:lnTo>
                  <a:pt x="3263" y="113"/>
                </a:lnTo>
                <a:lnTo>
                  <a:pt x="3273" y="113"/>
                </a:lnTo>
                <a:lnTo>
                  <a:pt x="3279" y="113"/>
                </a:lnTo>
                <a:lnTo>
                  <a:pt x="3289" y="113"/>
                </a:lnTo>
                <a:lnTo>
                  <a:pt x="3296" y="113"/>
                </a:lnTo>
                <a:lnTo>
                  <a:pt x="3304" y="114"/>
                </a:lnTo>
                <a:lnTo>
                  <a:pt x="3314" y="114"/>
                </a:lnTo>
                <a:lnTo>
                  <a:pt x="3320" y="114"/>
                </a:lnTo>
                <a:lnTo>
                  <a:pt x="3330" y="114"/>
                </a:lnTo>
                <a:lnTo>
                  <a:pt x="3337" y="114"/>
                </a:lnTo>
                <a:lnTo>
                  <a:pt x="3345" y="114"/>
                </a:lnTo>
                <a:lnTo>
                  <a:pt x="3354" y="114"/>
                </a:lnTo>
                <a:lnTo>
                  <a:pt x="3361" y="116"/>
                </a:lnTo>
                <a:lnTo>
                  <a:pt x="3371" y="116"/>
                </a:lnTo>
                <a:lnTo>
                  <a:pt x="3377" y="116"/>
                </a:lnTo>
                <a:lnTo>
                  <a:pt x="3385" y="116"/>
                </a:lnTo>
                <a:lnTo>
                  <a:pt x="3395" y="116"/>
                </a:lnTo>
                <a:lnTo>
                  <a:pt x="3402" y="116"/>
                </a:lnTo>
                <a:lnTo>
                  <a:pt x="3412" y="117"/>
                </a:lnTo>
                <a:lnTo>
                  <a:pt x="3418" y="117"/>
                </a:lnTo>
                <a:lnTo>
                  <a:pt x="3426" y="117"/>
                </a:lnTo>
                <a:lnTo>
                  <a:pt x="3436" y="117"/>
                </a:lnTo>
                <a:lnTo>
                  <a:pt x="3443" y="117"/>
                </a:lnTo>
                <a:lnTo>
                  <a:pt x="3452" y="117"/>
                </a:lnTo>
                <a:lnTo>
                  <a:pt x="3461" y="117"/>
                </a:lnTo>
                <a:lnTo>
                  <a:pt x="3467" y="119"/>
                </a:lnTo>
                <a:lnTo>
                  <a:pt x="3477" y="119"/>
                </a:lnTo>
                <a:lnTo>
                  <a:pt x="3483" y="119"/>
                </a:lnTo>
                <a:lnTo>
                  <a:pt x="3493" y="119"/>
                </a:lnTo>
                <a:lnTo>
                  <a:pt x="3501" y="119"/>
                </a:lnTo>
                <a:lnTo>
                  <a:pt x="3508" y="119"/>
                </a:lnTo>
                <a:lnTo>
                  <a:pt x="3518" y="121"/>
                </a:lnTo>
                <a:lnTo>
                  <a:pt x="3524" y="121"/>
                </a:lnTo>
                <a:lnTo>
                  <a:pt x="3534" y="121"/>
                </a:lnTo>
                <a:lnTo>
                  <a:pt x="3542" y="121"/>
                </a:lnTo>
                <a:lnTo>
                  <a:pt x="3549" y="121"/>
                </a:lnTo>
                <a:lnTo>
                  <a:pt x="3558" y="121"/>
                </a:lnTo>
                <a:lnTo>
                  <a:pt x="3565" y="121"/>
                </a:lnTo>
                <a:lnTo>
                  <a:pt x="3575" y="122"/>
                </a:lnTo>
                <a:lnTo>
                  <a:pt x="3583" y="122"/>
                </a:lnTo>
                <a:lnTo>
                  <a:pt x="3589" y="122"/>
                </a:lnTo>
                <a:lnTo>
                  <a:pt x="3599" y="122"/>
                </a:lnTo>
                <a:lnTo>
                  <a:pt x="3606" y="122"/>
                </a:lnTo>
                <a:lnTo>
                  <a:pt x="3616" y="122"/>
                </a:lnTo>
                <a:lnTo>
                  <a:pt x="3624" y="122"/>
                </a:lnTo>
                <a:lnTo>
                  <a:pt x="3630" y="124"/>
                </a:lnTo>
                <a:lnTo>
                  <a:pt x="3640" y="124"/>
                </a:lnTo>
                <a:lnTo>
                  <a:pt x="3647" y="124"/>
                </a:lnTo>
                <a:lnTo>
                  <a:pt x="3656" y="124"/>
                </a:lnTo>
                <a:lnTo>
                  <a:pt x="3665" y="124"/>
                </a:lnTo>
                <a:lnTo>
                  <a:pt x="3671" y="124"/>
                </a:lnTo>
                <a:lnTo>
                  <a:pt x="3681" y="126"/>
                </a:lnTo>
                <a:lnTo>
                  <a:pt x="3687" y="126"/>
                </a:lnTo>
                <a:lnTo>
                  <a:pt x="3696" y="126"/>
                </a:lnTo>
                <a:lnTo>
                  <a:pt x="3705" y="126"/>
                </a:lnTo>
                <a:lnTo>
                  <a:pt x="3712" y="126"/>
                </a:lnTo>
                <a:lnTo>
                  <a:pt x="3722" y="126"/>
                </a:lnTo>
                <a:lnTo>
                  <a:pt x="3728" y="126"/>
                </a:lnTo>
                <a:lnTo>
                  <a:pt x="3736" y="127"/>
                </a:lnTo>
                <a:lnTo>
                  <a:pt x="3746" y="127"/>
                </a:lnTo>
                <a:lnTo>
                  <a:pt x="3753" y="127"/>
                </a:lnTo>
                <a:lnTo>
                  <a:pt x="3762" y="127"/>
                </a:lnTo>
                <a:lnTo>
                  <a:pt x="3769" y="127"/>
                </a:lnTo>
                <a:lnTo>
                  <a:pt x="3777" y="127"/>
                </a:lnTo>
                <a:lnTo>
                  <a:pt x="3787" y="127"/>
                </a:lnTo>
                <a:lnTo>
                  <a:pt x="3793" y="129"/>
                </a:lnTo>
                <a:lnTo>
                  <a:pt x="3803" y="129"/>
                </a:lnTo>
                <a:lnTo>
                  <a:pt x="3810" y="129"/>
                </a:lnTo>
                <a:lnTo>
                  <a:pt x="3818" y="129"/>
                </a:lnTo>
                <a:lnTo>
                  <a:pt x="3828" y="129"/>
                </a:lnTo>
                <a:lnTo>
                  <a:pt x="3834" y="129"/>
                </a:lnTo>
                <a:lnTo>
                  <a:pt x="3844" y="131"/>
                </a:lnTo>
                <a:lnTo>
                  <a:pt x="3851" y="131"/>
                </a:lnTo>
                <a:lnTo>
                  <a:pt x="3859" y="131"/>
                </a:lnTo>
                <a:lnTo>
                  <a:pt x="3868" y="131"/>
                </a:lnTo>
                <a:lnTo>
                  <a:pt x="3875" y="131"/>
                </a:lnTo>
                <a:lnTo>
                  <a:pt x="3885" y="131"/>
                </a:lnTo>
                <a:lnTo>
                  <a:pt x="3891" y="131"/>
                </a:lnTo>
                <a:lnTo>
                  <a:pt x="3899" y="132"/>
                </a:lnTo>
                <a:lnTo>
                  <a:pt x="3909" y="132"/>
                </a:lnTo>
                <a:lnTo>
                  <a:pt x="3916" y="132"/>
                </a:lnTo>
                <a:lnTo>
                  <a:pt x="3926" y="132"/>
                </a:lnTo>
                <a:lnTo>
                  <a:pt x="3932" y="132"/>
                </a:lnTo>
                <a:lnTo>
                  <a:pt x="3940" y="132"/>
                </a:lnTo>
                <a:lnTo>
                  <a:pt x="3948" y="132"/>
                </a:lnTo>
                <a:lnTo>
                  <a:pt x="3957" y="134"/>
                </a:lnTo>
                <a:lnTo>
                  <a:pt x="3966" y="134"/>
                </a:lnTo>
                <a:lnTo>
                  <a:pt x="3975" y="134"/>
                </a:lnTo>
                <a:lnTo>
                  <a:pt x="3983" y="134"/>
                </a:lnTo>
                <a:lnTo>
                  <a:pt x="3989" y="134"/>
                </a:lnTo>
                <a:lnTo>
                  <a:pt x="3997" y="134"/>
                </a:lnTo>
                <a:lnTo>
                  <a:pt x="4007" y="134"/>
                </a:lnTo>
                <a:lnTo>
                  <a:pt x="4015" y="135"/>
                </a:lnTo>
                <a:lnTo>
                  <a:pt x="4023" y="135"/>
                </a:lnTo>
                <a:lnTo>
                  <a:pt x="4030" y="135"/>
                </a:lnTo>
                <a:lnTo>
                  <a:pt x="4038" y="135"/>
                </a:lnTo>
                <a:lnTo>
                  <a:pt x="4048" y="135"/>
                </a:lnTo>
                <a:lnTo>
                  <a:pt x="4056" y="135"/>
                </a:lnTo>
                <a:lnTo>
                  <a:pt x="4064" y="137"/>
                </a:lnTo>
                <a:lnTo>
                  <a:pt x="4071" y="137"/>
                </a:lnTo>
                <a:lnTo>
                  <a:pt x="4079" y="137"/>
                </a:lnTo>
                <a:lnTo>
                  <a:pt x="4089" y="137"/>
                </a:lnTo>
                <a:lnTo>
                  <a:pt x="4097" y="137"/>
                </a:lnTo>
                <a:lnTo>
                  <a:pt x="4105" y="137"/>
                </a:lnTo>
                <a:lnTo>
                  <a:pt x="4112" y="137"/>
                </a:lnTo>
                <a:lnTo>
                  <a:pt x="4120" y="139"/>
                </a:lnTo>
                <a:lnTo>
                  <a:pt x="4130" y="139"/>
                </a:lnTo>
                <a:lnTo>
                  <a:pt x="4138" y="139"/>
                </a:lnTo>
                <a:lnTo>
                  <a:pt x="4146" y="139"/>
                </a:lnTo>
                <a:lnTo>
                  <a:pt x="4152" y="139"/>
                </a:lnTo>
                <a:lnTo>
                  <a:pt x="4161" y="139"/>
                </a:lnTo>
                <a:lnTo>
                  <a:pt x="4170" y="139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01" name="Freeform 99"/>
          <p:cNvSpPr>
            <a:spLocks/>
          </p:cNvSpPr>
          <p:nvPr/>
        </p:nvSpPr>
        <p:spPr bwMode="auto">
          <a:xfrm>
            <a:off x="672307" y="4040189"/>
            <a:ext cx="6619876" cy="946150"/>
          </a:xfrm>
          <a:custGeom>
            <a:avLst/>
            <a:gdLst>
              <a:gd name="T0" fmla="*/ 67 w 4170"/>
              <a:gd name="T1" fmla="*/ 596 h 596"/>
              <a:gd name="T2" fmla="*/ 138 w 4170"/>
              <a:gd name="T3" fmla="*/ 596 h 596"/>
              <a:gd name="T4" fmla="*/ 212 w 4170"/>
              <a:gd name="T5" fmla="*/ 596 h 596"/>
              <a:gd name="T6" fmla="*/ 285 w 4170"/>
              <a:gd name="T7" fmla="*/ 596 h 596"/>
              <a:gd name="T8" fmla="*/ 360 w 4170"/>
              <a:gd name="T9" fmla="*/ 462 h 596"/>
              <a:gd name="T10" fmla="*/ 434 w 4170"/>
              <a:gd name="T11" fmla="*/ 437 h 596"/>
              <a:gd name="T12" fmla="*/ 505 w 4170"/>
              <a:gd name="T13" fmla="*/ 413 h 596"/>
              <a:gd name="T14" fmla="*/ 579 w 4170"/>
              <a:gd name="T15" fmla="*/ 390 h 596"/>
              <a:gd name="T16" fmla="*/ 654 w 4170"/>
              <a:gd name="T17" fmla="*/ 367 h 596"/>
              <a:gd name="T18" fmla="*/ 727 w 4170"/>
              <a:gd name="T19" fmla="*/ 346 h 596"/>
              <a:gd name="T20" fmla="*/ 801 w 4170"/>
              <a:gd name="T21" fmla="*/ 325 h 596"/>
              <a:gd name="T22" fmla="*/ 873 w 4170"/>
              <a:gd name="T23" fmla="*/ 305 h 596"/>
              <a:gd name="T24" fmla="*/ 948 w 4170"/>
              <a:gd name="T25" fmla="*/ 284 h 596"/>
              <a:gd name="T26" fmla="*/ 1019 w 4170"/>
              <a:gd name="T27" fmla="*/ 266 h 596"/>
              <a:gd name="T28" fmla="*/ 1095 w 4170"/>
              <a:gd name="T29" fmla="*/ 246 h 596"/>
              <a:gd name="T30" fmla="*/ 1166 w 4170"/>
              <a:gd name="T31" fmla="*/ 228 h 596"/>
              <a:gd name="T32" fmla="*/ 1240 w 4170"/>
              <a:gd name="T33" fmla="*/ 211 h 596"/>
              <a:gd name="T34" fmla="*/ 1315 w 4170"/>
              <a:gd name="T35" fmla="*/ 194 h 596"/>
              <a:gd name="T36" fmla="*/ 1387 w 4170"/>
              <a:gd name="T37" fmla="*/ 178 h 596"/>
              <a:gd name="T38" fmla="*/ 1462 w 4170"/>
              <a:gd name="T39" fmla="*/ 162 h 596"/>
              <a:gd name="T40" fmla="*/ 1533 w 4170"/>
              <a:gd name="T41" fmla="*/ 147 h 596"/>
              <a:gd name="T42" fmla="*/ 1609 w 4170"/>
              <a:gd name="T43" fmla="*/ 132 h 596"/>
              <a:gd name="T44" fmla="*/ 1680 w 4170"/>
              <a:gd name="T45" fmla="*/ 118 h 596"/>
              <a:gd name="T46" fmla="*/ 1755 w 4170"/>
              <a:gd name="T47" fmla="*/ 103 h 596"/>
              <a:gd name="T48" fmla="*/ 1829 w 4170"/>
              <a:gd name="T49" fmla="*/ 90 h 596"/>
              <a:gd name="T50" fmla="*/ 1902 w 4170"/>
              <a:gd name="T51" fmla="*/ 77 h 596"/>
              <a:gd name="T52" fmla="*/ 1976 w 4170"/>
              <a:gd name="T53" fmla="*/ 64 h 596"/>
              <a:gd name="T54" fmla="*/ 2049 w 4170"/>
              <a:gd name="T55" fmla="*/ 52 h 596"/>
              <a:gd name="T56" fmla="*/ 2121 w 4170"/>
              <a:gd name="T57" fmla="*/ 39 h 596"/>
              <a:gd name="T58" fmla="*/ 2194 w 4170"/>
              <a:gd name="T59" fmla="*/ 28 h 596"/>
              <a:gd name="T60" fmla="*/ 2269 w 4170"/>
              <a:gd name="T61" fmla="*/ 18 h 596"/>
              <a:gd name="T62" fmla="*/ 2341 w 4170"/>
              <a:gd name="T63" fmla="*/ 7 h 596"/>
              <a:gd name="T64" fmla="*/ 2416 w 4170"/>
              <a:gd name="T65" fmla="*/ 127 h 596"/>
              <a:gd name="T66" fmla="*/ 2490 w 4170"/>
              <a:gd name="T67" fmla="*/ 129 h 596"/>
              <a:gd name="T68" fmla="*/ 2561 w 4170"/>
              <a:gd name="T69" fmla="*/ 132 h 596"/>
              <a:gd name="T70" fmla="*/ 2635 w 4170"/>
              <a:gd name="T71" fmla="*/ 134 h 596"/>
              <a:gd name="T72" fmla="*/ 2708 w 4170"/>
              <a:gd name="T73" fmla="*/ 136 h 596"/>
              <a:gd name="T74" fmla="*/ 2783 w 4170"/>
              <a:gd name="T75" fmla="*/ 137 h 596"/>
              <a:gd name="T76" fmla="*/ 2857 w 4170"/>
              <a:gd name="T77" fmla="*/ 139 h 596"/>
              <a:gd name="T78" fmla="*/ 2930 w 4170"/>
              <a:gd name="T79" fmla="*/ 140 h 596"/>
              <a:gd name="T80" fmla="*/ 3002 w 4170"/>
              <a:gd name="T81" fmla="*/ 142 h 596"/>
              <a:gd name="T82" fmla="*/ 3075 w 4170"/>
              <a:gd name="T83" fmla="*/ 144 h 596"/>
              <a:gd name="T84" fmla="*/ 3149 w 4170"/>
              <a:gd name="T85" fmla="*/ 145 h 596"/>
              <a:gd name="T86" fmla="*/ 3222 w 4170"/>
              <a:gd name="T87" fmla="*/ 149 h 596"/>
              <a:gd name="T88" fmla="*/ 3296 w 4170"/>
              <a:gd name="T89" fmla="*/ 150 h 596"/>
              <a:gd name="T90" fmla="*/ 3371 w 4170"/>
              <a:gd name="T91" fmla="*/ 152 h 596"/>
              <a:gd name="T92" fmla="*/ 3443 w 4170"/>
              <a:gd name="T93" fmla="*/ 153 h 596"/>
              <a:gd name="T94" fmla="*/ 3518 w 4170"/>
              <a:gd name="T95" fmla="*/ 155 h 596"/>
              <a:gd name="T96" fmla="*/ 3589 w 4170"/>
              <a:gd name="T97" fmla="*/ 157 h 596"/>
              <a:gd name="T98" fmla="*/ 3665 w 4170"/>
              <a:gd name="T99" fmla="*/ 158 h 596"/>
              <a:gd name="T100" fmla="*/ 3736 w 4170"/>
              <a:gd name="T101" fmla="*/ 160 h 596"/>
              <a:gd name="T102" fmla="*/ 3810 w 4170"/>
              <a:gd name="T103" fmla="*/ 162 h 596"/>
              <a:gd name="T104" fmla="*/ 3885 w 4170"/>
              <a:gd name="T105" fmla="*/ 163 h 596"/>
              <a:gd name="T106" fmla="*/ 3957 w 4170"/>
              <a:gd name="T107" fmla="*/ 165 h 596"/>
              <a:gd name="T108" fmla="*/ 4030 w 4170"/>
              <a:gd name="T109" fmla="*/ 167 h 596"/>
              <a:gd name="T110" fmla="*/ 4105 w 4170"/>
              <a:gd name="T111" fmla="*/ 168 h 5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596">
                <a:moveTo>
                  <a:pt x="0" y="596"/>
                </a:moveTo>
                <a:lnTo>
                  <a:pt x="8" y="596"/>
                </a:lnTo>
                <a:lnTo>
                  <a:pt x="16" y="596"/>
                </a:lnTo>
                <a:lnTo>
                  <a:pt x="26" y="596"/>
                </a:lnTo>
                <a:lnTo>
                  <a:pt x="34" y="596"/>
                </a:lnTo>
                <a:lnTo>
                  <a:pt x="40" y="596"/>
                </a:lnTo>
                <a:lnTo>
                  <a:pt x="49" y="596"/>
                </a:lnTo>
                <a:lnTo>
                  <a:pt x="57" y="596"/>
                </a:lnTo>
                <a:lnTo>
                  <a:pt x="67" y="596"/>
                </a:lnTo>
                <a:lnTo>
                  <a:pt x="75" y="596"/>
                </a:lnTo>
                <a:lnTo>
                  <a:pt x="81" y="596"/>
                </a:lnTo>
                <a:lnTo>
                  <a:pt x="89" y="596"/>
                </a:lnTo>
                <a:lnTo>
                  <a:pt x="98" y="596"/>
                </a:lnTo>
                <a:lnTo>
                  <a:pt x="107" y="596"/>
                </a:lnTo>
                <a:lnTo>
                  <a:pt x="116" y="596"/>
                </a:lnTo>
                <a:lnTo>
                  <a:pt x="122" y="596"/>
                </a:lnTo>
                <a:lnTo>
                  <a:pt x="130" y="596"/>
                </a:lnTo>
                <a:lnTo>
                  <a:pt x="138" y="596"/>
                </a:lnTo>
                <a:lnTo>
                  <a:pt x="148" y="596"/>
                </a:lnTo>
                <a:lnTo>
                  <a:pt x="156" y="596"/>
                </a:lnTo>
                <a:lnTo>
                  <a:pt x="163" y="596"/>
                </a:lnTo>
                <a:lnTo>
                  <a:pt x="171" y="596"/>
                </a:lnTo>
                <a:lnTo>
                  <a:pt x="179" y="596"/>
                </a:lnTo>
                <a:lnTo>
                  <a:pt x="189" y="596"/>
                </a:lnTo>
                <a:lnTo>
                  <a:pt x="197" y="596"/>
                </a:lnTo>
                <a:lnTo>
                  <a:pt x="204" y="596"/>
                </a:lnTo>
                <a:lnTo>
                  <a:pt x="212" y="596"/>
                </a:lnTo>
                <a:lnTo>
                  <a:pt x="220" y="596"/>
                </a:lnTo>
                <a:lnTo>
                  <a:pt x="230" y="596"/>
                </a:lnTo>
                <a:lnTo>
                  <a:pt x="238" y="596"/>
                </a:lnTo>
                <a:lnTo>
                  <a:pt x="244" y="596"/>
                </a:lnTo>
                <a:lnTo>
                  <a:pt x="253" y="596"/>
                </a:lnTo>
                <a:lnTo>
                  <a:pt x="261" y="596"/>
                </a:lnTo>
                <a:lnTo>
                  <a:pt x="271" y="596"/>
                </a:lnTo>
                <a:lnTo>
                  <a:pt x="279" y="596"/>
                </a:lnTo>
                <a:lnTo>
                  <a:pt x="285" y="596"/>
                </a:lnTo>
                <a:lnTo>
                  <a:pt x="293" y="596"/>
                </a:lnTo>
                <a:lnTo>
                  <a:pt x="302" y="596"/>
                </a:lnTo>
                <a:lnTo>
                  <a:pt x="311" y="596"/>
                </a:lnTo>
                <a:lnTo>
                  <a:pt x="319" y="596"/>
                </a:lnTo>
                <a:lnTo>
                  <a:pt x="326" y="596"/>
                </a:lnTo>
                <a:lnTo>
                  <a:pt x="334" y="596"/>
                </a:lnTo>
                <a:lnTo>
                  <a:pt x="342" y="468"/>
                </a:lnTo>
                <a:lnTo>
                  <a:pt x="352" y="465"/>
                </a:lnTo>
                <a:lnTo>
                  <a:pt x="360" y="462"/>
                </a:lnTo>
                <a:lnTo>
                  <a:pt x="367" y="460"/>
                </a:lnTo>
                <a:lnTo>
                  <a:pt x="375" y="457"/>
                </a:lnTo>
                <a:lnTo>
                  <a:pt x="383" y="454"/>
                </a:lnTo>
                <a:lnTo>
                  <a:pt x="393" y="450"/>
                </a:lnTo>
                <a:lnTo>
                  <a:pt x="401" y="449"/>
                </a:lnTo>
                <a:lnTo>
                  <a:pt x="408" y="445"/>
                </a:lnTo>
                <a:lnTo>
                  <a:pt x="416" y="442"/>
                </a:lnTo>
                <a:lnTo>
                  <a:pt x="424" y="441"/>
                </a:lnTo>
                <a:lnTo>
                  <a:pt x="434" y="437"/>
                </a:lnTo>
                <a:lnTo>
                  <a:pt x="442" y="434"/>
                </a:lnTo>
                <a:lnTo>
                  <a:pt x="448" y="432"/>
                </a:lnTo>
                <a:lnTo>
                  <a:pt x="457" y="429"/>
                </a:lnTo>
                <a:lnTo>
                  <a:pt x="465" y="426"/>
                </a:lnTo>
                <a:lnTo>
                  <a:pt x="474" y="424"/>
                </a:lnTo>
                <a:lnTo>
                  <a:pt x="483" y="421"/>
                </a:lnTo>
                <a:lnTo>
                  <a:pt x="489" y="419"/>
                </a:lnTo>
                <a:lnTo>
                  <a:pt x="497" y="416"/>
                </a:lnTo>
                <a:lnTo>
                  <a:pt x="505" y="413"/>
                </a:lnTo>
                <a:lnTo>
                  <a:pt x="515" y="411"/>
                </a:lnTo>
                <a:lnTo>
                  <a:pt x="523" y="408"/>
                </a:lnTo>
                <a:lnTo>
                  <a:pt x="532" y="406"/>
                </a:lnTo>
                <a:lnTo>
                  <a:pt x="538" y="403"/>
                </a:lnTo>
                <a:lnTo>
                  <a:pt x="546" y="400"/>
                </a:lnTo>
                <a:lnTo>
                  <a:pt x="556" y="398"/>
                </a:lnTo>
                <a:lnTo>
                  <a:pt x="564" y="395"/>
                </a:lnTo>
                <a:lnTo>
                  <a:pt x="572" y="393"/>
                </a:lnTo>
                <a:lnTo>
                  <a:pt x="579" y="390"/>
                </a:lnTo>
                <a:lnTo>
                  <a:pt x="587" y="388"/>
                </a:lnTo>
                <a:lnTo>
                  <a:pt x="597" y="385"/>
                </a:lnTo>
                <a:lnTo>
                  <a:pt x="605" y="382"/>
                </a:lnTo>
                <a:lnTo>
                  <a:pt x="613" y="380"/>
                </a:lnTo>
                <a:lnTo>
                  <a:pt x="620" y="377"/>
                </a:lnTo>
                <a:lnTo>
                  <a:pt x="628" y="375"/>
                </a:lnTo>
                <a:lnTo>
                  <a:pt x="638" y="372"/>
                </a:lnTo>
                <a:lnTo>
                  <a:pt x="646" y="370"/>
                </a:lnTo>
                <a:lnTo>
                  <a:pt x="654" y="367"/>
                </a:lnTo>
                <a:lnTo>
                  <a:pt x="661" y="366"/>
                </a:lnTo>
                <a:lnTo>
                  <a:pt x="669" y="362"/>
                </a:lnTo>
                <a:lnTo>
                  <a:pt x="678" y="361"/>
                </a:lnTo>
                <a:lnTo>
                  <a:pt x="687" y="357"/>
                </a:lnTo>
                <a:lnTo>
                  <a:pt x="695" y="356"/>
                </a:lnTo>
                <a:lnTo>
                  <a:pt x="701" y="352"/>
                </a:lnTo>
                <a:lnTo>
                  <a:pt x="709" y="351"/>
                </a:lnTo>
                <a:lnTo>
                  <a:pt x="719" y="348"/>
                </a:lnTo>
                <a:lnTo>
                  <a:pt x="727" y="346"/>
                </a:lnTo>
                <a:lnTo>
                  <a:pt x="736" y="344"/>
                </a:lnTo>
                <a:lnTo>
                  <a:pt x="742" y="341"/>
                </a:lnTo>
                <a:lnTo>
                  <a:pt x="750" y="339"/>
                </a:lnTo>
                <a:lnTo>
                  <a:pt x="760" y="336"/>
                </a:lnTo>
                <a:lnTo>
                  <a:pt x="768" y="335"/>
                </a:lnTo>
                <a:lnTo>
                  <a:pt x="776" y="331"/>
                </a:lnTo>
                <a:lnTo>
                  <a:pt x="783" y="330"/>
                </a:lnTo>
                <a:lnTo>
                  <a:pt x="791" y="326"/>
                </a:lnTo>
                <a:lnTo>
                  <a:pt x="801" y="325"/>
                </a:lnTo>
                <a:lnTo>
                  <a:pt x="809" y="323"/>
                </a:lnTo>
                <a:lnTo>
                  <a:pt x="817" y="320"/>
                </a:lnTo>
                <a:lnTo>
                  <a:pt x="824" y="318"/>
                </a:lnTo>
                <a:lnTo>
                  <a:pt x="832" y="315"/>
                </a:lnTo>
                <a:lnTo>
                  <a:pt x="842" y="313"/>
                </a:lnTo>
                <a:lnTo>
                  <a:pt x="850" y="312"/>
                </a:lnTo>
                <a:lnTo>
                  <a:pt x="856" y="308"/>
                </a:lnTo>
                <a:lnTo>
                  <a:pt x="866" y="307"/>
                </a:lnTo>
                <a:lnTo>
                  <a:pt x="873" y="305"/>
                </a:lnTo>
                <a:lnTo>
                  <a:pt x="882" y="302"/>
                </a:lnTo>
                <a:lnTo>
                  <a:pt x="891" y="300"/>
                </a:lnTo>
                <a:lnTo>
                  <a:pt x="897" y="297"/>
                </a:lnTo>
                <a:lnTo>
                  <a:pt x="907" y="295"/>
                </a:lnTo>
                <a:lnTo>
                  <a:pt x="913" y="294"/>
                </a:lnTo>
                <a:lnTo>
                  <a:pt x="923" y="290"/>
                </a:lnTo>
                <a:lnTo>
                  <a:pt x="931" y="289"/>
                </a:lnTo>
                <a:lnTo>
                  <a:pt x="938" y="287"/>
                </a:lnTo>
                <a:lnTo>
                  <a:pt x="948" y="284"/>
                </a:lnTo>
                <a:lnTo>
                  <a:pt x="954" y="282"/>
                </a:lnTo>
                <a:lnTo>
                  <a:pt x="964" y="281"/>
                </a:lnTo>
                <a:lnTo>
                  <a:pt x="972" y="277"/>
                </a:lnTo>
                <a:lnTo>
                  <a:pt x="979" y="276"/>
                </a:lnTo>
                <a:lnTo>
                  <a:pt x="988" y="274"/>
                </a:lnTo>
                <a:lnTo>
                  <a:pt x="995" y="271"/>
                </a:lnTo>
                <a:lnTo>
                  <a:pt x="1005" y="269"/>
                </a:lnTo>
                <a:lnTo>
                  <a:pt x="1013" y="268"/>
                </a:lnTo>
                <a:lnTo>
                  <a:pt x="1019" y="266"/>
                </a:lnTo>
                <a:lnTo>
                  <a:pt x="1029" y="263"/>
                </a:lnTo>
                <a:lnTo>
                  <a:pt x="1036" y="261"/>
                </a:lnTo>
                <a:lnTo>
                  <a:pt x="1044" y="259"/>
                </a:lnTo>
                <a:lnTo>
                  <a:pt x="1054" y="256"/>
                </a:lnTo>
                <a:lnTo>
                  <a:pt x="1060" y="255"/>
                </a:lnTo>
                <a:lnTo>
                  <a:pt x="1070" y="253"/>
                </a:lnTo>
                <a:lnTo>
                  <a:pt x="1077" y="251"/>
                </a:lnTo>
                <a:lnTo>
                  <a:pt x="1085" y="248"/>
                </a:lnTo>
                <a:lnTo>
                  <a:pt x="1095" y="246"/>
                </a:lnTo>
                <a:lnTo>
                  <a:pt x="1101" y="245"/>
                </a:lnTo>
                <a:lnTo>
                  <a:pt x="1111" y="243"/>
                </a:lnTo>
                <a:lnTo>
                  <a:pt x="1117" y="240"/>
                </a:lnTo>
                <a:lnTo>
                  <a:pt x="1126" y="238"/>
                </a:lnTo>
                <a:lnTo>
                  <a:pt x="1135" y="237"/>
                </a:lnTo>
                <a:lnTo>
                  <a:pt x="1142" y="235"/>
                </a:lnTo>
                <a:lnTo>
                  <a:pt x="1152" y="233"/>
                </a:lnTo>
                <a:lnTo>
                  <a:pt x="1158" y="230"/>
                </a:lnTo>
                <a:lnTo>
                  <a:pt x="1166" y="228"/>
                </a:lnTo>
                <a:lnTo>
                  <a:pt x="1176" y="227"/>
                </a:lnTo>
                <a:lnTo>
                  <a:pt x="1183" y="225"/>
                </a:lnTo>
                <a:lnTo>
                  <a:pt x="1192" y="224"/>
                </a:lnTo>
                <a:lnTo>
                  <a:pt x="1199" y="220"/>
                </a:lnTo>
                <a:lnTo>
                  <a:pt x="1207" y="219"/>
                </a:lnTo>
                <a:lnTo>
                  <a:pt x="1217" y="217"/>
                </a:lnTo>
                <a:lnTo>
                  <a:pt x="1223" y="215"/>
                </a:lnTo>
                <a:lnTo>
                  <a:pt x="1233" y="214"/>
                </a:lnTo>
                <a:lnTo>
                  <a:pt x="1240" y="211"/>
                </a:lnTo>
                <a:lnTo>
                  <a:pt x="1248" y="209"/>
                </a:lnTo>
                <a:lnTo>
                  <a:pt x="1258" y="207"/>
                </a:lnTo>
                <a:lnTo>
                  <a:pt x="1264" y="206"/>
                </a:lnTo>
                <a:lnTo>
                  <a:pt x="1274" y="204"/>
                </a:lnTo>
                <a:lnTo>
                  <a:pt x="1281" y="202"/>
                </a:lnTo>
                <a:lnTo>
                  <a:pt x="1289" y="201"/>
                </a:lnTo>
                <a:lnTo>
                  <a:pt x="1299" y="197"/>
                </a:lnTo>
                <a:lnTo>
                  <a:pt x="1305" y="196"/>
                </a:lnTo>
                <a:lnTo>
                  <a:pt x="1315" y="194"/>
                </a:lnTo>
                <a:lnTo>
                  <a:pt x="1323" y="193"/>
                </a:lnTo>
                <a:lnTo>
                  <a:pt x="1330" y="191"/>
                </a:lnTo>
                <a:lnTo>
                  <a:pt x="1339" y="189"/>
                </a:lnTo>
                <a:lnTo>
                  <a:pt x="1346" y="188"/>
                </a:lnTo>
                <a:lnTo>
                  <a:pt x="1356" y="184"/>
                </a:lnTo>
                <a:lnTo>
                  <a:pt x="1364" y="183"/>
                </a:lnTo>
                <a:lnTo>
                  <a:pt x="1370" y="181"/>
                </a:lnTo>
                <a:lnTo>
                  <a:pt x="1380" y="180"/>
                </a:lnTo>
                <a:lnTo>
                  <a:pt x="1387" y="178"/>
                </a:lnTo>
                <a:lnTo>
                  <a:pt x="1396" y="176"/>
                </a:lnTo>
                <a:lnTo>
                  <a:pt x="1405" y="175"/>
                </a:lnTo>
                <a:lnTo>
                  <a:pt x="1411" y="173"/>
                </a:lnTo>
                <a:lnTo>
                  <a:pt x="1421" y="171"/>
                </a:lnTo>
                <a:lnTo>
                  <a:pt x="1427" y="170"/>
                </a:lnTo>
                <a:lnTo>
                  <a:pt x="1437" y="168"/>
                </a:lnTo>
                <a:lnTo>
                  <a:pt x="1445" y="165"/>
                </a:lnTo>
                <a:lnTo>
                  <a:pt x="1452" y="163"/>
                </a:lnTo>
                <a:lnTo>
                  <a:pt x="1462" y="162"/>
                </a:lnTo>
                <a:lnTo>
                  <a:pt x="1468" y="160"/>
                </a:lnTo>
                <a:lnTo>
                  <a:pt x="1478" y="158"/>
                </a:lnTo>
                <a:lnTo>
                  <a:pt x="1486" y="157"/>
                </a:lnTo>
                <a:lnTo>
                  <a:pt x="1493" y="155"/>
                </a:lnTo>
                <a:lnTo>
                  <a:pt x="1502" y="153"/>
                </a:lnTo>
                <a:lnTo>
                  <a:pt x="1509" y="152"/>
                </a:lnTo>
                <a:lnTo>
                  <a:pt x="1519" y="150"/>
                </a:lnTo>
                <a:lnTo>
                  <a:pt x="1527" y="149"/>
                </a:lnTo>
                <a:lnTo>
                  <a:pt x="1533" y="147"/>
                </a:lnTo>
                <a:lnTo>
                  <a:pt x="1543" y="145"/>
                </a:lnTo>
                <a:lnTo>
                  <a:pt x="1550" y="144"/>
                </a:lnTo>
                <a:lnTo>
                  <a:pt x="1560" y="142"/>
                </a:lnTo>
                <a:lnTo>
                  <a:pt x="1568" y="140"/>
                </a:lnTo>
                <a:lnTo>
                  <a:pt x="1574" y="139"/>
                </a:lnTo>
                <a:lnTo>
                  <a:pt x="1584" y="137"/>
                </a:lnTo>
                <a:lnTo>
                  <a:pt x="1591" y="136"/>
                </a:lnTo>
                <a:lnTo>
                  <a:pt x="1599" y="134"/>
                </a:lnTo>
                <a:lnTo>
                  <a:pt x="1609" y="132"/>
                </a:lnTo>
                <a:lnTo>
                  <a:pt x="1615" y="131"/>
                </a:lnTo>
                <a:lnTo>
                  <a:pt x="1625" y="129"/>
                </a:lnTo>
                <a:lnTo>
                  <a:pt x="1633" y="127"/>
                </a:lnTo>
                <a:lnTo>
                  <a:pt x="1640" y="126"/>
                </a:lnTo>
                <a:lnTo>
                  <a:pt x="1648" y="124"/>
                </a:lnTo>
                <a:lnTo>
                  <a:pt x="1656" y="122"/>
                </a:lnTo>
                <a:lnTo>
                  <a:pt x="1666" y="121"/>
                </a:lnTo>
                <a:lnTo>
                  <a:pt x="1674" y="119"/>
                </a:lnTo>
                <a:lnTo>
                  <a:pt x="1680" y="118"/>
                </a:lnTo>
                <a:lnTo>
                  <a:pt x="1688" y="116"/>
                </a:lnTo>
                <a:lnTo>
                  <a:pt x="1697" y="114"/>
                </a:lnTo>
                <a:lnTo>
                  <a:pt x="1706" y="113"/>
                </a:lnTo>
                <a:lnTo>
                  <a:pt x="1715" y="111"/>
                </a:lnTo>
                <a:lnTo>
                  <a:pt x="1721" y="109"/>
                </a:lnTo>
                <a:lnTo>
                  <a:pt x="1729" y="108"/>
                </a:lnTo>
                <a:lnTo>
                  <a:pt x="1739" y="106"/>
                </a:lnTo>
                <a:lnTo>
                  <a:pt x="1747" y="105"/>
                </a:lnTo>
                <a:lnTo>
                  <a:pt x="1755" y="103"/>
                </a:lnTo>
                <a:lnTo>
                  <a:pt x="1762" y="101"/>
                </a:lnTo>
                <a:lnTo>
                  <a:pt x="1770" y="101"/>
                </a:lnTo>
                <a:lnTo>
                  <a:pt x="1780" y="100"/>
                </a:lnTo>
                <a:lnTo>
                  <a:pt x="1788" y="98"/>
                </a:lnTo>
                <a:lnTo>
                  <a:pt x="1796" y="96"/>
                </a:lnTo>
                <a:lnTo>
                  <a:pt x="1803" y="95"/>
                </a:lnTo>
                <a:lnTo>
                  <a:pt x="1811" y="93"/>
                </a:lnTo>
                <a:lnTo>
                  <a:pt x="1821" y="91"/>
                </a:lnTo>
                <a:lnTo>
                  <a:pt x="1829" y="90"/>
                </a:lnTo>
                <a:lnTo>
                  <a:pt x="1835" y="88"/>
                </a:lnTo>
                <a:lnTo>
                  <a:pt x="1844" y="87"/>
                </a:lnTo>
                <a:lnTo>
                  <a:pt x="1852" y="85"/>
                </a:lnTo>
                <a:lnTo>
                  <a:pt x="1861" y="85"/>
                </a:lnTo>
                <a:lnTo>
                  <a:pt x="1870" y="83"/>
                </a:lnTo>
                <a:lnTo>
                  <a:pt x="1876" y="82"/>
                </a:lnTo>
                <a:lnTo>
                  <a:pt x="1884" y="80"/>
                </a:lnTo>
                <a:lnTo>
                  <a:pt x="1892" y="78"/>
                </a:lnTo>
                <a:lnTo>
                  <a:pt x="1902" y="77"/>
                </a:lnTo>
                <a:lnTo>
                  <a:pt x="1910" y="75"/>
                </a:lnTo>
                <a:lnTo>
                  <a:pt x="1917" y="74"/>
                </a:lnTo>
                <a:lnTo>
                  <a:pt x="1925" y="72"/>
                </a:lnTo>
                <a:lnTo>
                  <a:pt x="1933" y="72"/>
                </a:lnTo>
                <a:lnTo>
                  <a:pt x="1943" y="70"/>
                </a:lnTo>
                <a:lnTo>
                  <a:pt x="1951" y="69"/>
                </a:lnTo>
                <a:lnTo>
                  <a:pt x="1958" y="67"/>
                </a:lnTo>
                <a:lnTo>
                  <a:pt x="1966" y="65"/>
                </a:lnTo>
                <a:lnTo>
                  <a:pt x="1976" y="64"/>
                </a:lnTo>
                <a:lnTo>
                  <a:pt x="1984" y="62"/>
                </a:lnTo>
                <a:lnTo>
                  <a:pt x="1992" y="62"/>
                </a:lnTo>
                <a:lnTo>
                  <a:pt x="1999" y="60"/>
                </a:lnTo>
                <a:lnTo>
                  <a:pt x="2007" y="59"/>
                </a:lnTo>
                <a:lnTo>
                  <a:pt x="2015" y="57"/>
                </a:lnTo>
                <a:lnTo>
                  <a:pt x="2023" y="56"/>
                </a:lnTo>
                <a:lnTo>
                  <a:pt x="2033" y="54"/>
                </a:lnTo>
                <a:lnTo>
                  <a:pt x="2039" y="54"/>
                </a:lnTo>
                <a:lnTo>
                  <a:pt x="2049" y="52"/>
                </a:lnTo>
                <a:lnTo>
                  <a:pt x="2056" y="51"/>
                </a:lnTo>
                <a:lnTo>
                  <a:pt x="2065" y="49"/>
                </a:lnTo>
                <a:lnTo>
                  <a:pt x="2074" y="47"/>
                </a:lnTo>
                <a:lnTo>
                  <a:pt x="2080" y="46"/>
                </a:lnTo>
                <a:lnTo>
                  <a:pt x="2090" y="46"/>
                </a:lnTo>
                <a:lnTo>
                  <a:pt x="2096" y="44"/>
                </a:lnTo>
                <a:lnTo>
                  <a:pt x="2106" y="43"/>
                </a:lnTo>
                <a:lnTo>
                  <a:pt x="2113" y="41"/>
                </a:lnTo>
                <a:lnTo>
                  <a:pt x="2121" y="39"/>
                </a:lnTo>
                <a:lnTo>
                  <a:pt x="2131" y="39"/>
                </a:lnTo>
                <a:lnTo>
                  <a:pt x="2137" y="38"/>
                </a:lnTo>
                <a:lnTo>
                  <a:pt x="2147" y="36"/>
                </a:lnTo>
                <a:lnTo>
                  <a:pt x="2154" y="34"/>
                </a:lnTo>
                <a:lnTo>
                  <a:pt x="2163" y="34"/>
                </a:lnTo>
                <a:lnTo>
                  <a:pt x="2171" y="33"/>
                </a:lnTo>
                <a:lnTo>
                  <a:pt x="2178" y="31"/>
                </a:lnTo>
                <a:lnTo>
                  <a:pt x="2188" y="29"/>
                </a:lnTo>
                <a:lnTo>
                  <a:pt x="2194" y="28"/>
                </a:lnTo>
                <a:lnTo>
                  <a:pt x="2202" y="28"/>
                </a:lnTo>
                <a:lnTo>
                  <a:pt x="2212" y="26"/>
                </a:lnTo>
                <a:lnTo>
                  <a:pt x="2220" y="25"/>
                </a:lnTo>
                <a:lnTo>
                  <a:pt x="2229" y="23"/>
                </a:lnTo>
                <a:lnTo>
                  <a:pt x="2235" y="23"/>
                </a:lnTo>
                <a:lnTo>
                  <a:pt x="2243" y="21"/>
                </a:lnTo>
                <a:lnTo>
                  <a:pt x="2251" y="20"/>
                </a:lnTo>
                <a:lnTo>
                  <a:pt x="2261" y="18"/>
                </a:lnTo>
                <a:lnTo>
                  <a:pt x="2269" y="18"/>
                </a:lnTo>
                <a:lnTo>
                  <a:pt x="2278" y="16"/>
                </a:lnTo>
                <a:lnTo>
                  <a:pt x="2284" y="15"/>
                </a:lnTo>
                <a:lnTo>
                  <a:pt x="2292" y="13"/>
                </a:lnTo>
                <a:lnTo>
                  <a:pt x="2300" y="13"/>
                </a:lnTo>
                <a:lnTo>
                  <a:pt x="2310" y="12"/>
                </a:lnTo>
                <a:lnTo>
                  <a:pt x="2317" y="10"/>
                </a:lnTo>
                <a:lnTo>
                  <a:pt x="2326" y="8"/>
                </a:lnTo>
                <a:lnTo>
                  <a:pt x="2335" y="8"/>
                </a:lnTo>
                <a:lnTo>
                  <a:pt x="2341" y="7"/>
                </a:lnTo>
                <a:lnTo>
                  <a:pt x="2351" y="5"/>
                </a:lnTo>
                <a:lnTo>
                  <a:pt x="2357" y="3"/>
                </a:lnTo>
                <a:lnTo>
                  <a:pt x="2366" y="3"/>
                </a:lnTo>
                <a:lnTo>
                  <a:pt x="2375" y="2"/>
                </a:lnTo>
                <a:lnTo>
                  <a:pt x="2382" y="0"/>
                </a:lnTo>
                <a:lnTo>
                  <a:pt x="2390" y="127"/>
                </a:lnTo>
                <a:lnTo>
                  <a:pt x="2400" y="127"/>
                </a:lnTo>
                <a:lnTo>
                  <a:pt x="2408" y="127"/>
                </a:lnTo>
                <a:lnTo>
                  <a:pt x="2416" y="127"/>
                </a:lnTo>
                <a:lnTo>
                  <a:pt x="2424" y="127"/>
                </a:lnTo>
                <a:lnTo>
                  <a:pt x="2433" y="129"/>
                </a:lnTo>
                <a:lnTo>
                  <a:pt x="2439" y="129"/>
                </a:lnTo>
                <a:lnTo>
                  <a:pt x="2449" y="129"/>
                </a:lnTo>
                <a:lnTo>
                  <a:pt x="2455" y="129"/>
                </a:lnTo>
                <a:lnTo>
                  <a:pt x="2464" y="129"/>
                </a:lnTo>
                <a:lnTo>
                  <a:pt x="2473" y="129"/>
                </a:lnTo>
                <a:lnTo>
                  <a:pt x="2480" y="129"/>
                </a:lnTo>
                <a:lnTo>
                  <a:pt x="2490" y="129"/>
                </a:lnTo>
                <a:lnTo>
                  <a:pt x="2498" y="131"/>
                </a:lnTo>
                <a:lnTo>
                  <a:pt x="2506" y="131"/>
                </a:lnTo>
                <a:lnTo>
                  <a:pt x="2513" y="131"/>
                </a:lnTo>
                <a:lnTo>
                  <a:pt x="2521" y="131"/>
                </a:lnTo>
                <a:lnTo>
                  <a:pt x="2529" y="131"/>
                </a:lnTo>
                <a:lnTo>
                  <a:pt x="2539" y="131"/>
                </a:lnTo>
                <a:lnTo>
                  <a:pt x="2547" y="131"/>
                </a:lnTo>
                <a:lnTo>
                  <a:pt x="2555" y="131"/>
                </a:lnTo>
                <a:lnTo>
                  <a:pt x="2561" y="132"/>
                </a:lnTo>
                <a:lnTo>
                  <a:pt x="2570" y="132"/>
                </a:lnTo>
                <a:lnTo>
                  <a:pt x="2578" y="132"/>
                </a:lnTo>
                <a:lnTo>
                  <a:pt x="2588" y="132"/>
                </a:lnTo>
                <a:lnTo>
                  <a:pt x="2594" y="132"/>
                </a:lnTo>
                <a:lnTo>
                  <a:pt x="2604" y="132"/>
                </a:lnTo>
                <a:lnTo>
                  <a:pt x="2610" y="132"/>
                </a:lnTo>
                <a:lnTo>
                  <a:pt x="2620" y="132"/>
                </a:lnTo>
                <a:lnTo>
                  <a:pt x="2627" y="134"/>
                </a:lnTo>
                <a:lnTo>
                  <a:pt x="2635" y="134"/>
                </a:lnTo>
                <a:lnTo>
                  <a:pt x="2645" y="134"/>
                </a:lnTo>
                <a:lnTo>
                  <a:pt x="2651" y="134"/>
                </a:lnTo>
                <a:lnTo>
                  <a:pt x="2661" y="134"/>
                </a:lnTo>
                <a:lnTo>
                  <a:pt x="2668" y="134"/>
                </a:lnTo>
                <a:lnTo>
                  <a:pt x="2676" y="134"/>
                </a:lnTo>
                <a:lnTo>
                  <a:pt x="2685" y="134"/>
                </a:lnTo>
                <a:lnTo>
                  <a:pt x="2692" y="136"/>
                </a:lnTo>
                <a:lnTo>
                  <a:pt x="2702" y="136"/>
                </a:lnTo>
                <a:lnTo>
                  <a:pt x="2708" y="136"/>
                </a:lnTo>
                <a:lnTo>
                  <a:pt x="2718" y="136"/>
                </a:lnTo>
                <a:lnTo>
                  <a:pt x="2726" y="136"/>
                </a:lnTo>
                <a:lnTo>
                  <a:pt x="2733" y="136"/>
                </a:lnTo>
                <a:lnTo>
                  <a:pt x="2743" y="136"/>
                </a:lnTo>
                <a:lnTo>
                  <a:pt x="2749" y="136"/>
                </a:lnTo>
                <a:lnTo>
                  <a:pt x="2759" y="137"/>
                </a:lnTo>
                <a:lnTo>
                  <a:pt x="2765" y="137"/>
                </a:lnTo>
                <a:lnTo>
                  <a:pt x="2774" y="137"/>
                </a:lnTo>
                <a:lnTo>
                  <a:pt x="2783" y="137"/>
                </a:lnTo>
                <a:lnTo>
                  <a:pt x="2790" y="137"/>
                </a:lnTo>
                <a:lnTo>
                  <a:pt x="2798" y="137"/>
                </a:lnTo>
                <a:lnTo>
                  <a:pt x="2808" y="137"/>
                </a:lnTo>
                <a:lnTo>
                  <a:pt x="2816" y="137"/>
                </a:lnTo>
                <a:lnTo>
                  <a:pt x="2824" y="139"/>
                </a:lnTo>
                <a:lnTo>
                  <a:pt x="2831" y="139"/>
                </a:lnTo>
                <a:lnTo>
                  <a:pt x="2839" y="139"/>
                </a:lnTo>
                <a:lnTo>
                  <a:pt x="2849" y="139"/>
                </a:lnTo>
                <a:lnTo>
                  <a:pt x="2857" y="139"/>
                </a:lnTo>
                <a:lnTo>
                  <a:pt x="2865" y="139"/>
                </a:lnTo>
                <a:lnTo>
                  <a:pt x="2871" y="139"/>
                </a:lnTo>
                <a:lnTo>
                  <a:pt x="2880" y="139"/>
                </a:lnTo>
                <a:lnTo>
                  <a:pt x="2889" y="140"/>
                </a:lnTo>
                <a:lnTo>
                  <a:pt x="2898" y="140"/>
                </a:lnTo>
                <a:lnTo>
                  <a:pt x="2904" y="140"/>
                </a:lnTo>
                <a:lnTo>
                  <a:pt x="2912" y="140"/>
                </a:lnTo>
                <a:lnTo>
                  <a:pt x="2920" y="140"/>
                </a:lnTo>
                <a:lnTo>
                  <a:pt x="2930" y="140"/>
                </a:lnTo>
                <a:lnTo>
                  <a:pt x="2938" y="140"/>
                </a:lnTo>
                <a:lnTo>
                  <a:pt x="2945" y="140"/>
                </a:lnTo>
                <a:lnTo>
                  <a:pt x="2953" y="142"/>
                </a:lnTo>
                <a:lnTo>
                  <a:pt x="2961" y="142"/>
                </a:lnTo>
                <a:lnTo>
                  <a:pt x="2971" y="142"/>
                </a:lnTo>
                <a:lnTo>
                  <a:pt x="2979" y="142"/>
                </a:lnTo>
                <a:lnTo>
                  <a:pt x="2986" y="142"/>
                </a:lnTo>
                <a:lnTo>
                  <a:pt x="2994" y="142"/>
                </a:lnTo>
                <a:lnTo>
                  <a:pt x="3002" y="142"/>
                </a:lnTo>
                <a:lnTo>
                  <a:pt x="3012" y="142"/>
                </a:lnTo>
                <a:lnTo>
                  <a:pt x="3020" y="144"/>
                </a:lnTo>
                <a:lnTo>
                  <a:pt x="3027" y="144"/>
                </a:lnTo>
                <a:lnTo>
                  <a:pt x="3035" y="144"/>
                </a:lnTo>
                <a:lnTo>
                  <a:pt x="3044" y="144"/>
                </a:lnTo>
                <a:lnTo>
                  <a:pt x="3053" y="144"/>
                </a:lnTo>
                <a:lnTo>
                  <a:pt x="3061" y="144"/>
                </a:lnTo>
                <a:lnTo>
                  <a:pt x="3067" y="144"/>
                </a:lnTo>
                <a:lnTo>
                  <a:pt x="3075" y="144"/>
                </a:lnTo>
                <a:lnTo>
                  <a:pt x="3085" y="144"/>
                </a:lnTo>
                <a:lnTo>
                  <a:pt x="3093" y="145"/>
                </a:lnTo>
                <a:lnTo>
                  <a:pt x="3102" y="145"/>
                </a:lnTo>
                <a:lnTo>
                  <a:pt x="3108" y="145"/>
                </a:lnTo>
                <a:lnTo>
                  <a:pt x="3116" y="145"/>
                </a:lnTo>
                <a:lnTo>
                  <a:pt x="3126" y="145"/>
                </a:lnTo>
                <a:lnTo>
                  <a:pt x="3134" y="145"/>
                </a:lnTo>
                <a:lnTo>
                  <a:pt x="3142" y="145"/>
                </a:lnTo>
                <a:lnTo>
                  <a:pt x="3149" y="145"/>
                </a:lnTo>
                <a:lnTo>
                  <a:pt x="3157" y="147"/>
                </a:lnTo>
                <a:lnTo>
                  <a:pt x="3167" y="147"/>
                </a:lnTo>
                <a:lnTo>
                  <a:pt x="3173" y="147"/>
                </a:lnTo>
                <a:lnTo>
                  <a:pt x="3182" y="147"/>
                </a:lnTo>
                <a:lnTo>
                  <a:pt x="3191" y="147"/>
                </a:lnTo>
                <a:lnTo>
                  <a:pt x="3198" y="147"/>
                </a:lnTo>
                <a:lnTo>
                  <a:pt x="3208" y="147"/>
                </a:lnTo>
                <a:lnTo>
                  <a:pt x="3214" y="147"/>
                </a:lnTo>
                <a:lnTo>
                  <a:pt x="3222" y="149"/>
                </a:lnTo>
                <a:lnTo>
                  <a:pt x="3232" y="149"/>
                </a:lnTo>
                <a:lnTo>
                  <a:pt x="3239" y="149"/>
                </a:lnTo>
                <a:lnTo>
                  <a:pt x="3248" y="149"/>
                </a:lnTo>
                <a:lnTo>
                  <a:pt x="3255" y="149"/>
                </a:lnTo>
                <a:lnTo>
                  <a:pt x="3263" y="149"/>
                </a:lnTo>
                <a:lnTo>
                  <a:pt x="3273" y="149"/>
                </a:lnTo>
                <a:lnTo>
                  <a:pt x="3279" y="149"/>
                </a:lnTo>
                <a:lnTo>
                  <a:pt x="3289" y="149"/>
                </a:lnTo>
                <a:lnTo>
                  <a:pt x="3296" y="150"/>
                </a:lnTo>
                <a:lnTo>
                  <a:pt x="3304" y="150"/>
                </a:lnTo>
                <a:lnTo>
                  <a:pt x="3314" y="150"/>
                </a:lnTo>
                <a:lnTo>
                  <a:pt x="3320" y="150"/>
                </a:lnTo>
                <a:lnTo>
                  <a:pt x="3330" y="150"/>
                </a:lnTo>
                <a:lnTo>
                  <a:pt x="3337" y="150"/>
                </a:lnTo>
                <a:lnTo>
                  <a:pt x="3345" y="150"/>
                </a:lnTo>
                <a:lnTo>
                  <a:pt x="3354" y="150"/>
                </a:lnTo>
                <a:lnTo>
                  <a:pt x="3361" y="152"/>
                </a:lnTo>
                <a:lnTo>
                  <a:pt x="3371" y="152"/>
                </a:lnTo>
                <a:lnTo>
                  <a:pt x="3377" y="152"/>
                </a:lnTo>
                <a:lnTo>
                  <a:pt x="3385" y="152"/>
                </a:lnTo>
                <a:lnTo>
                  <a:pt x="3395" y="152"/>
                </a:lnTo>
                <a:lnTo>
                  <a:pt x="3402" y="152"/>
                </a:lnTo>
                <a:lnTo>
                  <a:pt x="3412" y="152"/>
                </a:lnTo>
                <a:lnTo>
                  <a:pt x="3418" y="152"/>
                </a:lnTo>
                <a:lnTo>
                  <a:pt x="3426" y="153"/>
                </a:lnTo>
                <a:lnTo>
                  <a:pt x="3436" y="153"/>
                </a:lnTo>
                <a:lnTo>
                  <a:pt x="3443" y="153"/>
                </a:lnTo>
                <a:lnTo>
                  <a:pt x="3452" y="153"/>
                </a:lnTo>
                <a:lnTo>
                  <a:pt x="3461" y="153"/>
                </a:lnTo>
                <a:lnTo>
                  <a:pt x="3467" y="153"/>
                </a:lnTo>
                <a:lnTo>
                  <a:pt x="3477" y="153"/>
                </a:lnTo>
                <a:lnTo>
                  <a:pt x="3483" y="153"/>
                </a:lnTo>
                <a:lnTo>
                  <a:pt x="3493" y="153"/>
                </a:lnTo>
                <a:lnTo>
                  <a:pt x="3501" y="155"/>
                </a:lnTo>
                <a:lnTo>
                  <a:pt x="3508" y="155"/>
                </a:lnTo>
                <a:lnTo>
                  <a:pt x="3518" y="155"/>
                </a:lnTo>
                <a:lnTo>
                  <a:pt x="3524" y="155"/>
                </a:lnTo>
                <a:lnTo>
                  <a:pt x="3534" y="155"/>
                </a:lnTo>
                <a:lnTo>
                  <a:pt x="3542" y="155"/>
                </a:lnTo>
                <a:lnTo>
                  <a:pt x="3549" y="155"/>
                </a:lnTo>
                <a:lnTo>
                  <a:pt x="3558" y="155"/>
                </a:lnTo>
                <a:lnTo>
                  <a:pt x="3565" y="157"/>
                </a:lnTo>
                <a:lnTo>
                  <a:pt x="3575" y="157"/>
                </a:lnTo>
                <a:lnTo>
                  <a:pt x="3583" y="157"/>
                </a:lnTo>
                <a:lnTo>
                  <a:pt x="3589" y="157"/>
                </a:lnTo>
                <a:lnTo>
                  <a:pt x="3599" y="157"/>
                </a:lnTo>
                <a:lnTo>
                  <a:pt x="3606" y="157"/>
                </a:lnTo>
                <a:lnTo>
                  <a:pt x="3616" y="157"/>
                </a:lnTo>
                <a:lnTo>
                  <a:pt x="3624" y="157"/>
                </a:lnTo>
                <a:lnTo>
                  <a:pt x="3630" y="157"/>
                </a:lnTo>
                <a:lnTo>
                  <a:pt x="3640" y="158"/>
                </a:lnTo>
                <a:lnTo>
                  <a:pt x="3647" y="158"/>
                </a:lnTo>
                <a:lnTo>
                  <a:pt x="3656" y="158"/>
                </a:lnTo>
                <a:lnTo>
                  <a:pt x="3665" y="158"/>
                </a:lnTo>
                <a:lnTo>
                  <a:pt x="3671" y="158"/>
                </a:lnTo>
                <a:lnTo>
                  <a:pt x="3681" y="158"/>
                </a:lnTo>
                <a:lnTo>
                  <a:pt x="3687" y="158"/>
                </a:lnTo>
                <a:lnTo>
                  <a:pt x="3696" y="158"/>
                </a:lnTo>
                <a:lnTo>
                  <a:pt x="3705" y="160"/>
                </a:lnTo>
                <a:lnTo>
                  <a:pt x="3712" y="160"/>
                </a:lnTo>
                <a:lnTo>
                  <a:pt x="3722" y="160"/>
                </a:lnTo>
                <a:lnTo>
                  <a:pt x="3728" y="160"/>
                </a:lnTo>
                <a:lnTo>
                  <a:pt x="3736" y="160"/>
                </a:lnTo>
                <a:lnTo>
                  <a:pt x="3746" y="160"/>
                </a:lnTo>
                <a:lnTo>
                  <a:pt x="3753" y="160"/>
                </a:lnTo>
                <a:lnTo>
                  <a:pt x="3762" y="160"/>
                </a:lnTo>
                <a:lnTo>
                  <a:pt x="3769" y="160"/>
                </a:lnTo>
                <a:lnTo>
                  <a:pt x="3777" y="162"/>
                </a:lnTo>
                <a:lnTo>
                  <a:pt x="3787" y="162"/>
                </a:lnTo>
                <a:lnTo>
                  <a:pt x="3793" y="162"/>
                </a:lnTo>
                <a:lnTo>
                  <a:pt x="3803" y="162"/>
                </a:lnTo>
                <a:lnTo>
                  <a:pt x="3810" y="162"/>
                </a:lnTo>
                <a:lnTo>
                  <a:pt x="3818" y="162"/>
                </a:lnTo>
                <a:lnTo>
                  <a:pt x="3828" y="162"/>
                </a:lnTo>
                <a:lnTo>
                  <a:pt x="3834" y="162"/>
                </a:lnTo>
                <a:lnTo>
                  <a:pt x="3844" y="163"/>
                </a:lnTo>
                <a:lnTo>
                  <a:pt x="3851" y="163"/>
                </a:lnTo>
                <a:lnTo>
                  <a:pt x="3859" y="163"/>
                </a:lnTo>
                <a:lnTo>
                  <a:pt x="3868" y="163"/>
                </a:lnTo>
                <a:lnTo>
                  <a:pt x="3875" y="163"/>
                </a:lnTo>
                <a:lnTo>
                  <a:pt x="3885" y="163"/>
                </a:lnTo>
                <a:lnTo>
                  <a:pt x="3891" y="163"/>
                </a:lnTo>
                <a:lnTo>
                  <a:pt x="3899" y="163"/>
                </a:lnTo>
                <a:lnTo>
                  <a:pt x="3909" y="163"/>
                </a:lnTo>
                <a:lnTo>
                  <a:pt x="3916" y="165"/>
                </a:lnTo>
                <a:lnTo>
                  <a:pt x="3926" y="165"/>
                </a:lnTo>
                <a:lnTo>
                  <a:pt x="3932" y="165"/>
                </a:lnTo>
                <a:lnTo>
                  <a:pt x="3940" y="165"/>
                </a:lnTo>
                <a:lnTo>
                  <a:pt x="3948" y="165"/>
                </a:lnTo>
                <a:lnTo>
                  <a:pt x="3957" y="165"/>
                </a:lnTo>
                <a:lnTo>
                  <a:pt x="3966" y="165"/>
                </a:lnTo>
                <a:lnTo>
                  <a:pt x="3975" y="165"/>
                </a:lnTo>
                <a:lnTo>
                  <a:pt x="3983" y="165"/>
                </a:lnTo>
                <a:lnTo>
                  <a:pt x="3989" y="167"/>
                </a:lnTo>
                <a:lnTo>
                  <a:pt x="3997" y="167"/>
                </a:lnTo>
                <a:lnTo>
                  <a:pt x="4007" y="167"/>
                </a:lnTo>
                <a:lnTo>
                  <a:pt x="4015" y="167"/>
                </a:lnTo>
                <a:lnTo>
                  <a:pt x="4023" y="167"/>
                </a:lnTo>
                <a:lnTo>
                  <a:pt x="4030" y="167"/>
                </a:lnTo>
                <a:lnTo>
                  <a:pt x="4038" y="167"/>
                </a:lnTo>
                <a:lnTo>
                  <a:pt x="4048" y="167"/>
                </a:lnTo>
                <a:lnTo>
                  <a:pt x="4056" y="168"/>
                </a:lnTo>
                <a:lnTo>
                  <a:pt x="4064" y="168"/>
                </a:lnTo>
                <a:lnTo>
                  <a:pt x="4071" y="168"/>
                </a:lnTo>
                <a:lnTo>
                  <a:pt x="4079" y="168"/>
                </a:lnTo>
                <a:lnTo>
                  <a:pt x="4089" y="168"/>
                </a:lnTo>
                <a:lnTo>
                  <a:pt x="4097" y="168"/>
                </a:lnTo>
                <a:lnTo>
                  <a:pt x="4105" y="168"/>
                </a:lnTo>
                <a:lnTo>
                  <a:pt x="4112" y="168"/>
                </a:lnTo>
                <a:lnTo>
                  <a:pt x="4120" y="168"/>
                </a:lnTo>
                <a:lnTo>
                  <a:pt x="4130" y="170"/>
                </a:lnTo>
                <a:lnTo>
                  <a:pt x="4138" y="170"/>
                </a:lnTo>
                <a:lnTo>
                  <a:pt x="4146" y="170"/>
                </a:lnTo>
                <a:lnTo>
                  <a:pt x="4152" y="170"/>
                </a:lnTo>
                <a:lnTo>
                  <a:pt x="4161" y="170"/>
                </a:lnTo>
                <a:lnTo>
                  <a:pt x="4170" y="170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02" name="Freeform 100"/>
          <p:cNvSpPr>
            <a:spLocks/>
          </p:cNvSpPr>
          <p:nvPr/>
        </p:nvSpPr>
        <p:spPr bwMode="auto">
          <a:xfrm>
            <a:off x="672307" y="4487864"/>
            <a:ext cx="6619876" cy="498475"/>
          </a:xfrm>
          <a:custGeom>
            <a:avLst/>
            <a:gdLst>
              <a:gd name="T0" fmla="*/ 67 w 4170"/>
              <a:gd name="T1" fmla="*/ 314 h 314"/>
              <a:gd name="T2" fmla="*/ 138 w 4170"/>
              <a:gd name="T3" fmla="*/ 314 h 314"/>
              <a:gd name="T4" fmla="*/ 212 w 4170"/>
              <a:gd name="T5" fmla="*/ 314 h 314"/>
              <a:gd name="T6" fmla="*/ 285 w 4170"/>
              <a:gd name="T7" fmla="*/ 314 h 314"/>
              <a:gd name="T8" fmla="*/ 360 w 4170"/>
              <a:gd name="T9" fmla="*/ 274 h 314"/>
              <a:gd name="T10" fmla="*/ 434 w 4170"/>
              <a:gd name="T11" fmla="*/ 263 h 314"/>
              <a:gd name="T12" fmla="*/ 505 w 4170"/>
              <a:gd name="T13" fmla="*/ 250 h 314"/>
              <a:gd name="T14" fmla="*/ 579 w 4170"/>
              <a:gd name="T15" fmla="*/ 238 h 314"/>
              <a:gd name="T16" fmla="*/ 654 w 4170"/>
              <a:gd name="T17" fmla="*/ 227 h 314"/>
              <a:gd name="T18" fmla="*/ 727 w 4170"/>
              <a:gd name="T19" fmla="*/ 214 h 314"/>
              <a:gd name="T20" fmla="*/ 801 w 4170"/>
              <a:gd name="T21" fmla="*/ 203 h 314"/>
              <a:gd name="T22" fmla="*/ 873 w 4170"/>
              <a:gd name="T23" fmla="*/ 193 h 314"/>
              <a:gd name="T24" fmla="*/ 948 w 4170"/>
              <a:gd name="T25" fmla="*/ 181 h 314"/>
              <a:gd name="T26" fmla="*/ 1019 w 4170"/>
              <a:gd name="T27" fmla="*/ 170 h 314"/>
              <a:gd name="T28" fmla="*/ 1095 w 4170"/>
              <a:gd name="T29" fmla="*/ 160 h 314"/>
              <a:gd name="T30" fmla="*/ 1166 w 4170"/>
              <a:gd name="T31" fmla="*/ 149 h 314"/>
              <a:gd name="T32" fmla="*/ 1240 w 4170"/>
              <a:gd name="T33" fmla="*/ 139 h 314"/>
              <a:gd name="T34" fmla="*/ 1315 w 4170"/>
              <a:gd name="T35" fmla="*/ 129 h 314"/>
              <a:gd name="T36" fmla="*/ 1387 w 4170"/>
              <a:gd name="T37" fmla="*/ 119 h 314"/>
              <a:gd name="T38" fmla="*/ 1462 w 4170"/>
              <a:gd name="T39" fmla="*/ 110 h 314"/>
              <a:gd name="T40" fmla="*/ 1533 w 4170"/>
              <a:gd name="T41" fmla="*/ 100 h 314"/>
              <a:gd name="T42" fmla="*/ 1609 w 4170"/>
              <a:gd name="T43" fmla="*/ 90 h 314"/>
              <a:gd name="T44" fmla="*/ 1680 w 4170"/>
              <a:gd name="T45" fmla="*/ 80 h 314"/>
              <a:gd name="T46" fmla="*/ 1755 w 4170"/>
              <a:gd name="T47" fmla="*/ 72 h 314"/>
              <a:gd name="T48" fmla="*/ 1829 w 4170"/>
              <a:gd name="T49" fmla="*/ 62 h 314"/>
              <a:gd name="T50" fmla="*/ 1902 w 4170"/>
              <a:gd name="T51" fmla="*/ 54 h 314"/>
              <a:gd name="T52" fmla="*/ 1976 w 4170"/>
              <a:gd name="T53" fmla="*/ 46 h 314"/>
              <a:gd name="T54" fmla="*/ 2049 w 4170"/>
              <a:gd name="T55" fmla="*/ 38 h 314"/>
              <a:gd name="T56" fmla="*/ 2121 w 4170"/>
              <a:gd name="T57" fmla="*/ 28 h 314"/>
              <a:gd name="T58" fmla="*/ 2194 w 4170"/>
              <a:gd name="T59" fmla="*/ 20 h 314"/>
              <a:gd name="T60" fmla="*/ 2269 w 4170"/>
              <a:gd name="T61" fmla="*/ 13 h 314"/>
              <a:gd name="T62" fmla="*/ 2341 w 4170"/>
              <a:gd name="T63" fmla="*/ 5 h 314"/>
              <a:gd name="T64" fmla="*/ 2416 w 4170"/>
              <a:gd name="T65" fmla="*/ 36 h 314"/>
              <a:gd name="T66" fmla="*/ 2490 w 4170"/>
              <a:gd name="T67" fmla="*/ 38 h 314"/>
              <a:gd name="T68" fmla="*/ 2561 w 4170"/>
              <a:gd name="T69" fmla="*/ 38 h 314"/>
              <a:gd name="T70" fmla="*/ 2635 w 4170"/>
              <a:gd name="T71" fmla="*/ 39 h 314"/>
              <a:gd name="T72" fmla="*/ 2708 w 4170"/>
              <a:gd name="T73" fmla="*/ 41 h 314"/>
              <a:gd name="T74" fmla="*/ 2783 w 4170"/>
              <a:gd name="T75" fmla="*/ 41 h 314"/>
              <a:gd name="T76" fmla="*/ 2857 w 4170"/>
              <a:gd name="T77" fmla="*/ 43 h 314"/>
              <a:gd name="T78" fmla="*/ 2930 w 4170"/>
              <a:gd name="T79" fmla="*/ 44 h 314"/>
              <a:gd name="T80" fmla="*/ 3002 w 4170"/>
              <a:gd name="T81" fmla="*/ 44 h 314"/>
              <a:gd name="T82" fmla="*/ 3075 w 4170"/>
              <a:gd name="T83" fmla="*/ 46 h 314"/>
              <a:gd name="T84" fmla="*/ 3149 w 4170"/>
              <a:gd name="T85" fmla="*/ 46 h 314"/>
              <a:gd name="T86" fmla="*/ 3222 w 4170"/>
              <a:gd name="T87" fmla="*/ 48 h 314"/>
              <a:gd name="T88" fmla="*/ 3296 w 4170"/>
              <a:gd name="T89" fmla="*/ 49 h 314"/>
              <a:gd name="T90" fmla="*/ 3371 w 4170"/>
              <a:gd name="T91" fmla="*/ 49 h 314"/>
              <a:gd name="T92" fmla="*/ 3443 w 4170"/>
              <a:gd name="T93" fmla="*/ 51 h 314"/>
              <a:gd name="T94" fmla="*/ 3518 w 4170"/>
              <a:gd name="T95" fmla="*/ 53 h 314"/>
              <a:gd name="T96" fmla="*/ 3589 w 4170"/>
              <a:gd name="T97" fmla="*/ 53 h 314"/>
              <a:gd name="T98" fmla="*/ 3665 w 4170"/>
              <a:gd name="T99" fmla="*/ 54 h 314"/>
              <a:gd name="T100" fmla="*/ 3736 w 4170"/>
              <a:gd name="T101" fmla="*/ 56 h 314"/>
              <a:gd name="T102" fmla="*/ 3810 w 4170"/>
              <a:gd name="T103" fmla="*/ 56 h 314"/>
              <a:gd name="T104" fmla="*/ 3885 w 4170"/>
              <a:gd name="T105" fmla="*/ 57 h 314"/>
              <a:gd name="T106" fmla="*/ 3957 w 4170"/>
              <a:gd name="T107" fmla="*/ 57 h 314"/>
              <a:gd name="T108" fmla="*/ 4030 w 4170"/>
              <a:gd name="T109" fmla="*/ 59 h 314"/>
              <a:gd name="T110" fmla="*/ 4105 w 4170"/>
              <a:gd name="T111" fmla="*/ 61 h 3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314">
                <a:moveTo>
                  <a:pt x="0" y="314"/>
                </a:moveTo>
                <a:lnTo>
                  <a:pt x="8" y="314"/>
                </a:lnTo>
                <a:lnTo>
                  <a:pt x="16" y="314"/>
                </a:lnTo>
                <a:lnTo>
                  <a:pt x="26" y="314"/>
                </a:lnTo>
                <a:lnTo>
                  <a:pt x="34" y="314"/>
                </a:lnTo>
                <a:lnTo>
                  <a:pt x="40" y="314"/>
                </a:lnTo>
                <a:lnTo>
                  <a:pt x="49" y="314"/>
                </a:lnTo>
                <a:lnTo>
                  <a:pt x="57" y="314"/>
                </a:lnTo>
                <a:lnTo>
                  <a:pt x="67" y="314"/>
                </a:lnTo>
                <a:lnTo>
                  <a:pt x="75" y="314"/>
                </a:lnTo>
                <a:lnTo>
                  <a:pt x="81" y="314"/>
                </a:lnTo>
                <a:lnTo>
                  <a:pt x="89" y="314"/>
                </a:lnTo>
                <a:lnTo>
                  <a:pt x="98" y="314"/>
                </a:lnTo>
                <a:lnTo>
                  <a:pt x="107" y="314"/>
                </a:lnTo>
                <a:lnTo>
                  <a:pt x="116" y="314"/>
                </a:lnTo>
                <a:lnTo>
                  <a:pt x="122" y="314"/>
                </a:lnTo>
                <a:lnTo>
                  <a:pt x="130" y="314"/>
                </a:lnTo>
                <a:lnTo>
                  <a:pt x="138" y="314"/>
                </a:lnTo>
                <a:lnTo>
                  <a:pt x="148" y="314"/>
                </a:lnTo>
                <a:lnTo>
                  <a:pt x="156" y="314"/>
                </a:lnTo>
                <a:lnTo>
                  <a:pt x="163" y="314"/>
                </a:lnTo>
                <a:lnTo>
                  <a:pt x="171" y="314"/>
                </a:lnTo>
                <a:lnTo>
                  <a:pt x="179" y="314"/>
                </a:lnTo>
                <a:lnTo>
                  <a:pt x="189" y="314"/>
                </a:lnTo>
                <a:lnTo>
                  <a:pt x="197" y="314"/>
                </a:lnTo>
                <a:lnTo>
                  <a:pt x="204" y="314"/>
                </a:lnTo>
                <a:lnTo>
                  <a:pt x="212" y="314"/>
                </a:lnTo>
                <a:lnTo>
                  <a:pt x="220" y="314"/>
                </a:lnTo>
                <a:lnTo>
                  <a:pt x="230" y="314"/>
                </a:lnTo>
                <a:lnTo>
                  <a:pt x="238" y="314"/>
                </a:lnTo>
                <a:lnTo>
                  <a:pt x="244" y="314"/>
                </a:lnTo>
                <a:lnTo>
                  <a:pt x="253" y="314"/>
                </a:lnTo>
                <a:lnTo>
                  <a:pt x="261" y="314"/>
                </a:lnTo>
                <a:lnTo>
                  <a:pt x="271" y="314"/>
                </a:lnTo>
                <a:lnTo>
                  <a:pt x="279" y="314"/>
                </a:lnTo>
                <a:lnTo>
                  <a:pt x="285" y="314"/>
                </a:lnTo>
                <a:lnTo>
                  <a:pt x="293" y="314"/>
                </a:lnTo>
                <a:lnTo>
                  <a:pt x="302" y="314"/>
                </a:lnTo>
                <a:lnTo>
                  <a:pt x="311" y="314"/>
                </a:lnTo>
                <a:lnTo>
                  <a:pt x="319" y="314"/>
                </a:lnTo>
                <a:lnTo>
                  <a:pt x="326" y="314"/>
                </a:lnTo>
                <a:lnTo>
                  <a:pt x="334" y="314"/>
                </a:lnTo>
                <a:lnTo>
                  <a:pt x="342" y="278"/>
                </a:lnTo>
                <a:lnTo>
                  <a:pt x="352" y="276"/>
                </a:lnTo>
                <a:lnTo>
                  <a:pt x="360" y="274"/>
                </a:lnTo>
                <a:lnTo>
                  <a:pt x="367" y="274"/>
                </a:lnTo>
                <a:lnTo>
                  <a:pt x="375" y="273"/>
                </a:lnTo>
                <a:lnTo>
                  <a:pt x="383" y="271"/>
                </a:lnTo>
                <a:lnTo>
                  <a:pt x="393" y="269"/>
                </a:lnTo>
                <a:lnTo>
                  <a:pt x="401" y="268"/>
                </a:lnTo>
                <a:lnTo>
                  <a:pt x="408" y="266"/>
                </a:lnTo>
                <a:lnTo>
                  <a:pt x="416" y="266"/>
                </a:lnTo>
                <a:lnTo>
                  <a:pt x="424" y="265"/>
                </a:lnTo>
                <a:lnTo>
                  <a:pt x="434" y="263"/>
                </a:lnTo>
                <a:lnTo>
                  <a:pt x="442" y="261"/>
                </a:lnTo>
                <a:lnTo>
                  <a:pt x="448" y="260"/>
                </a:lnTo>
                <a:lnTo>
                  <a:pt x="457" y="258"/>
                </a:lnTo>
                <a:lnTo>
                  <a:pt x="465" y="256"/>
                </a:lnTo>
                <a:lnTo>
                  <a:pt x="474" y="256"/>
                </a:lnTo>
                <a:lnTo>
                  <a:pt x="483" y="255"/>
                </a:lnTo>
                <a:lnTo>
                  <a:pt x="489" y="253"/>
                </a:lnTo>
                <a:lnTo>
                  <a:pt x="497" y="252"/>
                </a:lnTo>
                <a:lnTo>
                  <a:pt x="505" y="250"/>
                </a:lnTo>
                <a:lnTo>
                  <a:pt x="515" y="248"/>
                </a:lnTo>
                <a:lnTo>
                  <a:pt x="523" y="248"/>
                </a:lnTo>
                <a:lnTo>
                  <a:pt x="532" y="247"/>
                </a:lnTo>
                <a:lnTo>
                  <a:pt x="538" y="245"/>
                </a:lnTo>
                <a:lnTo>
                  <a:pt x="546" y="243"/>
                </a:lnTo>
                <a:lnTo>
                  <a:pt x="556" y="242"/>
                </a:lnTo>
                <a:lnTo>
                  <a:pt x="564" y="242"/>
                </a:lnTo>
                <a:lnTo>
                  <a:pt x="572" y="240"/>
                </a:lnTo>
                <a:lnTo>
                  <a:pt x="579" y="238"/>
                </a:lnTo>
                <a:lnTo>
                  <a:pt x="587" y="237"/>
                </a:lnTo>
                <a:lnTo>
                  <a:pt x="597" y="235"/>
                </a:lnTo>
                <a:lnTo>
                  <a:pt x="605" y="234"/>
                </a:lnTo>
                <a:lnTo>
                  <a:pt x="613" y="234"/>
                </a:lnTo>
                <a:lnTo>
                  <a:pt x="620" y="232"/>
                </a:lnTo>
                <a:lnTo>
                  <a:pt x="628" y="230"/>
                </a:lnTo>
                <a:lnTo>
                  <a:pt x="638" y="229"/>
                </a:lnTo>
                <a:lnTo>
                  <a:pt x="646" y="227"/>
                </a:lnTo>
                <a:lnTo>
                  <a:pt x="654" y="227"/>
                </a:lnTo>
                <a:lnTo>
                  <a:pt x="661" y="225"/>
                </a:lnTo>
                <a:lnTo>
                  <a:pt x="669" y="224"/>
                </a:lnTo>
                <a:lnTo>
                  <a:pt x="678" y="222"/>
                </a:lnTo>
                <a:lnTo>
                  <a:pt x="687" y="221"/>
                </a:lnTo>
                <a:lnTo>
                  <a:pt x="695" y="221"/>
                </a:lnTo>
                <a:lnTo>
                  <a:pt x="701" y="219"/>
                </a:lnTo>
                <a:lnTo>
                  <a:pt x="709" y="217"/>
                </a:lnTo>
                <a:lnTo>
                  <a:pt x="719" y="216"/>
                </a:lnTo>
                <a:lnTo>
                  <a:pt x="727" y="214"/>
                </a:lnTo>
                <a:lnTo>
                  <a:pt x="736" y="214"/>
                </a:lnTo>
                <a:lnTo>
                  <a:pt x="742" y="212"/>
                </a:lnTo>
                <a:lnTo>
                  <a:pt x="750" y="211"/>
                </a:lnTo>
                <a:lnTo>
                  <a:pt x="760" y="209"/>
                </a:lnTo>
                <a:lnTo>
                  <a:pt x="768" y="209"/>
                </a:lnTo>
                <a:lnTo>
                  <a:pt x="776" y="207"/>
                </a:lnTo>
                <a:lnTo>
                  <a:pt x="783" y="206"/>
                </a:lnTo>
                <a:lnTo>
                  <a:pt x="791" y="204"/>
                </a:lnTo>
                <a:lnTo>
                  <a:pt x="801" y="203"/>
                </a:lnTo>
                <a:lnTo>
                  <a:pt x="809" y="203"/>
                </a:lnTo>
                <a:lnTo>
                  <a:pt x="817" y="201"/>
                </a:lnTo>
                <a:lnTo>
                  <a:pt x="824" y="199"/>
                </a:lnTo>
                <a:lnTo>
                  <a:pt x="832" y="198"/>
                </a:lnTo>
                <a:lnTo>
                  <a:pt x="842" y="198"/>
                </a:lnTo>
                <a:lnTo>
                  <a:pt x="850" y="196"/>
                </a:lnTo>
                <a:lnTo>
                  <a:pt x="856" y="194"/>
                </a:lnTo>
                <a:lnTo>
                  <a:pt x="866" y="193"/>
                </a:lnTo>
                <a:lnTo>
                  <a:pt x="873" y="193"/>
                </a:lnTo>
                <a:lnTo>
                  <a:pt x="882" y="191"/>
                </a:lnTo>
                <a:lnTo>
                  <a:pt x="891" y="190"/>
                </a:lnTo>
                <a:lnTo>
                  <a:pt x="897" y="188"/>
                </a:lnTo>
                <a:lnTo>
                  <a:pt x="907" y="188"/>
                </a:lnTo>
                <a:lnTo>
                  <a:pt x="913" y="186"/>
                </a:lnTo>
                <a:lnTo>
                  <a:pt x="923" y="185"/>
                </a:lnTo>
                <a:lnTo>
                  <a:pt x="931" y="183"/>
                </a:lnTo>
                <a:lnTo>
                  <a:pt x="938" y="183"/>
                </a:lnTo>
                <a:lnTo>
                  <a:pt x="948" y="181"/>
                </a:lnTo>
                <a:lnTo>
                  <a:pt x="954" y="180"/>
                </a:lnTo>
                <a:lnTo>
                  <a:pt x="964" y="178"/>
                </a:lnTo>
                <a:lnTo>
                  <a:pt x="972" y="178"/>
                </a:lnTo>
                <a:lnTo>
                  <a:pt x="979" y="176"/>
                </a:lnTo>
                <a:lnTo>
                  <a:pt x="988" y="175"/>
                </a:lnTo>
                <a:lnTo>
                  <a:pt x="995" y="173"/>
                </a:lnTo>
                <a:lnTo>
                  <a:pt x="1005" y="173"/>
                </a:lnTo>
                <a:lnTo>
                  <a:pt x="1013" y="172"/>
                </a:lnTo>
                <a:lnTo>
                  <a:pt x="1019" y="170"/>
                </a:lnTo>
                <a:lnTo>
                  <a:pt x="1029" y="168"/>
                </a:lnTo>
                <a:lnTo>
                  <a:pt x="1036" y="168"/>
                </a:lnTo>
                <a:lnTo>
                  <a:pt x="1044" y="167"/>
                </a:lnTo>
                <a:lnTo>
                  <a:pt x="1054" y="165"/>
                </a:lnTo>
                <a:lnTo>
                  <a:pt x="1060" y="165"/>
                </a:lnTo>
                <a:lnTo>
                  <a:pt x="1070" y="163"/>
                </a:lnTo>
                <a:lnTo>
                  <a:pt x="1077" y="162"/>
                </a:lnTo>
                <a:lnTo>
                  <a:pt x="1085" y="160"/>
                </a:lnTo>
                <a:lnTo>
                  <a:pt x="1095" y="160"/>
                </a:lnTo>
                <a:lnTo>
                  <a:pt x="1101" y="159"/>
                </a:lnTo>
                <a:lnTo>
                  <a:pt x="1111" y="157"/>
                </a:lnTo>
                <a:lnTo>
                  <a:pt x="1117" y="155"/>
                </a:lnTo>
                <a:lnTo>
                  <a:pt x="1126" y="155"/>
                </a:lnTo>
                <a:lnTo>
                  <a:pt x="1135" y="154"/>
                </a:lnTo>
                <a:lnTo>
                  <a:pt x="1142" y="152"/>
                </a:lnTo>
                <a:lnTo>
                  <a:pt x="1152" y="152"/>
                </a:lnTo>
                <a:lnTo>
                  <a:pt x="1158" y="150"/>
                </a:lnTo>
                <a:lnTo>
                  <a:pt x="1166" y="149"/>
                </a:lnTo>
                <a:lnTo>
                  <a:pt x="1176" y="149"/>
                </a:lnTo>
                <a:lnTo>
                  <a:pt x="1183" y="147"/>
                </a:lnTo>
                <a:lnTo>
                  <a:pt x="1192" y="145"/>
                </a:lnTo>
                <a:lnTo>
                  <a:pt x="1199" y="144"/>
                </a:lnTo>
                <a:lnTo>
                  <a:pt x="1207" y="144"/>
                </a:lnTo>
                <a:lnTo>
                  <a:pt x="1217" y="142"/>
                </a:lnTo>
                <a:lnTo>
                  <a:pt x="1223" y="141"/>
                </a:lnTo>
                <a:lnTo>
                  <a:pt x="1233" y="141"/>
                </a:lnTo>
                <a:lnTo>
                  <a:pt x="1240" y="139"/>
                </a:lnTo>
                <a:lnTo>
                  <a:pt x="1248" y="137"/>
                </a:lnTo>
                <a:lnTo>
                  <a:pt x="1258" y="137"/>
                </a:lnTo>
                <a:lnTo>
                  <a:pt x="1264" y="136"/>
                </a:lnTo>
                <a:lnTo>
                  <a:pt x="1274" y="134"/>
                </a:lnTo>
                <a:lnTo>
                  <a:pt x="1281" y="132"/>
                </a:lnTo>
                <a:lnTo>
                  <a:pt x="1289" y="132"/>
                </a:lnTo>
                <a:lnTo>
                  <a:pt x="1299" y="131"/>
                </a:lnTo>
                <a:lnTo>
                  <a:pt x="1305" y="129"/>
                </a:lnTo>
                <a:lnTo>
                  <a:pt x="1315" y="129"/>
                </a:lnTo>
                <a:lnTo>
                  <a:pt x="1323" y="128"/>
                </a:lnTo>
                <a:lnTo>
                  <a:pt x="1330" y="126"/>
                </a:lnTo>
                <a:lnTo>
                  <a:pt x="1339" y="126"/>
                </a:lnTo>
                <a:lnTo>
                  <a:pt x="1346" y="124"/>
                </a:lnTo>
                <a:lnTo>
                  <a:pt x="1356" y="123"/>
                </a:lnTo>
                <a:lnTo>
                  <a:pt x="1364" y="123"/>
                </a:lnTo>
                <a:lnTo>
                  <a:pt x="1370" y="121"/>
                </a:lnTo>
                <a:lnTo>
                  <a:pt x="1380" y="119"/>
                </a:lnTo>
                <a:lnTo>
                  <a:pt x="1387" y="119"/>
                </a:lnTo>
                <a:lnTo>
                  <a:pt x="1396" y="118"/>
                </a:lnTo>
                <a:lnTo>
                  <a:pt x="1405" y="116"/>
                </a:lnTo>
                <a:lnTo>
                  <a:pt x="1411" y="116"/>
                </a:lnTo>
                <a:lnTo>
                  <a:pt x="1421" y="115"/>
                </a:lnTo>
                <a:lnTo>
                  <a:pt x="1427" y="113"/>
                </a:lnTo>
                <a:lnTo>
                  <a:pt x="1437" y="113"/>
                </a:lnTo>
                <a:lnTo>
                  <a:pt x="1445" y="111"/>
                </a:lnTo>
                <a:lnTo>
                  <a:pt x="1452" y="110"/>
                </a:lnTo>
                <a:lnTo>
                  <a:pt x="1462" y="110"/>
                </a:lnTo>
                <a:lnTo>
                  <a:pt x="1468" y="108"/>
                </a:lnTo>
                <a:lnTo>
                  <a:pt x="1478" y="106"/>
                </a:lnTo>
                <a:lnTo>
                  <a:pt x="1486" y="106"/>
                </a:lnTo>
                <a:lnTo>
                  <a:pt x="1493" y="105"/>
                </a:lnTo>
                <a:lnTo>
                  <a:pt x="1502" y="103"/>
                </a:lnTo>
                <a:lnTo>
                  <a:pt x="1509" y="103"/>
                </a:lnTo>
                <a:lnTo>
                  <a:pt x="1519" y="101"/>
                </a:lnTo>
                <a:lnTo>
                  <a:pt x="1527" y="100"/>
                </a:lnTo>
                <a:lnTo>
                  <a:pt x="1533" y="100"/>
                </a:lnTo>
                <a:lnTo>
                  <a:pt x="1543" y="98"/>
                </a:lnTo>
                <a:lnTo>
                  <a:pt x="1550" y="98"/>
                </a:lnTo>
                <a:lnTo>
                  <a:pt x="1560" y="97"/>
                </a:lnTo>
                <a:lnTo>
                  <a:pt x="1568" y="95"/>
                </a:lnTo>
                <a:lnTo>
                  <a:pt x="1574" y="95"/>
                </a:lnTo>
                <a:lnTo>
                  <a:pt x="1584" y="93"/>
                </a:lnTo>
                <a:lnTo>
                  <a:pt x="1591" y="92"/>
                </a:lnTo>
                <a:lnTo>
                  <a:pt x="1599" y="92"/>
                </a:lnTo>
                <a:lnTo>
                  <a:pt x="1609" y="90"/>
                </a:lnTo>
                <a:lnTo>
                  <a:pt x="1615" y="88"/>
                </a:lnTo>
                <a:lnTo>
                  <a:pt x="1625" y="88"/>
                </a:lnTo>
                <a:lnTo>
                  <a:pt x="1633" y="87"/>
                </a:lnTo>
                <a:lnTo>
                  <a:pt x="1640" y="87"/>
                </a:lnTo>
                <a:lnTo>
                  <a:pt x="1648" y="85"/>
                </a:lnTo>
                <a:lnTo>
                  <a:pt x="1656" y="84"/>
                </a:lnTo>
                <a:lnTo>
                  <a:pt x="1666" y="84"/>
                </a:lnTo>
                <a:lnTo>
                  <a:pt x="1674" y="82"/>
                </a:lnTo>
                <a:lnTo>
                  <a:pt x="1680" y="80"/>
                </a:lnTo>
                <a:lnTo>
                  <a:pt x="1688" y="80"/>
                </a:lnTo>
                <a:lnTo>
                  <a:pt x="1697" y="79"/>
                </a:lnTo>
                <a:lnTo>
                  <a:pt x="1706" y="79"/>
                </a:lnTo>
                <a:lnTo>
                  <a:pt x="1715" y="77"/>
                </a:lnTo>
                <a:lnTo>
                  <a:pt x="1721" y="75"/>
                </a:lnTo>
                <a:lnTo>
                  <a:pt x="1729" y="75"/>
                </a:lnTo>
                <a:lnTo>
                  <a:pt x="1739" y="74"/>
                </a:lnTo>
                <a:lnTo>
                  <a:pt x="1747" y="72"/>
                </a:lnTo>
                <a:lnTo>
                  <a:pt x="1755" y="72"/>
                </a:lnTo>
                <a:lnTo>
                  <a:pt x="1762" y="70"/>
                </a:lnTo>
                <a:lnTo>
                  <a:pt x="1770" y="70"/>
                </a:lnTo>
                <a:lnTo>
                  <a:pt x="1780" y="69"/>
                </a:lnTo>
                <a:lnTo>
                  <a:pt x="1788" y="67"/>
                </a:lnTo>
                <a:lnTo>
                  <a:pt x="1796" y="67"/>
                </a:lnTo>
                <a:lnTo>
                  <a:pt x="1803" y="66"/>
                </a:lnTo>
                <a:lnTo>
                  <a:pt x="1811" y="66"/>
                </a:lnTo>
                <a:lnTo>
                  <a:pt x="1821" y="64"/>
                </a:lnTo>
                <a:lnTo>
                  <a:pt x="1829" y="62"/>
                </a:lnTo>
                <a:lnTo>
                  <a:pt x="1835" y="62"/>
                </a:lnTo>
                <a:lnTo>
                  <a:pt x="1844" y="61"/>
                </a:lnTo>
                <a:lnTo>
                  <a:pt x="1852" y="61"/>
                </a:lnTo>
                <a:lnTo>
                  <a:pt x="1861" y="59"/>
                </a:lnTo>
                <a:lnTo>
                  <a:pt x="1870" y="57"/>
                </a:lnTo>
                <a:lnTo>
                  <a:pt x="1876" y="57"/>
                </a:lnTo>
                <a:lnTo>
                  <a:pt x="1884" y="56"/>
                </a:lnTo>
                <a:lnTo>
                  <a:pt x="1892" y="56"/>
                </a:lnTo>
                <a:lnTo>
                  <a:pt x="1902" y="54"/>
                </a:lnTo>
                <a:lnTo>
                  <a:pt x="1910" y="53"/>
                </a:lnTo>
                <a:lnTo>
                  <a:pt x="1917" y="53"/>
                </a:lnTo>
                <a:lnTo>
                  <a:pt x="1925" y="51"/>
                </a:lnTo>
                <a:lnTo>
                  <a:pt x="1933" y="51"/>
                </a:lnTo>
                <a:lnTo>
                  <a:pt x="1943" y="49"/>
                </a:lnTo>
                <a:lnTo>
                  <a:pt x="1951" y="48"/>
                </a:lnTo>
                <a:lnTo>
                  <a:pt x="1958" y="48"/>
                </a:lnTo>
                <a:lnTo>
                  <a:pt x="1966" y="46"/>
                </a:lnTo>
                <a:lnTo>
                  <a:pt x="1976" y="46"/>
                </a:lnTo>
                <a:lnTo>
                  <a:pt x="1984" y="44"/>
                </a:lnTo>
                <a:lnTo>
                  <a:pt x="1992" y="44"/>
                </a:lnTo>
                <a:lnTo>
                  <a:pt x="1999" y="43"/>
                </a:lnTo>
                <a:lnTo>
                  <a:pt x="2007" y="41"/>
                </a:lnTo>
                <a:lnTo>
                  <a:pt x="2015" y="41"/>
                </a:lnTo>
                <a:lnTo>
                  <a:pt x="2023" y="39"/>
                </a:lnTo>
                <a:lnTo>
                  <a:pt x="2033" y="39"/>
                </a:lnTo>
                <a:lnTo>
                  <a:pt x="2039" y="38"/>
                </a:lnTo>
                <a:lnTo>
                  <a:pt x="2049" y="38"/>
                </a:lnTo>
                <a:lnTo>
                  <a:pt x="2056" y="36"/>
                </a:lnTo>
                <a:lnTo>
                  <a:pt x="2065" y="35"/>
                </a:lnTo>
                <a:lnTo>
                  <a:pt x="2074" y="35"/>
                </a:lnTo>
                <a:lnTo>
                  <a:pt x="2080" y="33"/>
                </a:lnTo>
                <a:lnTo>
                  <a:pt x="2090" y="33"/>
                </a:lnTo>
                <a:lnTo>
                  <a:pt x="2096" y="31"/>
                </a:lnTo>
                <a:lnTo>
                  <a:pt x="2106" y="31"/>
                </a:lnTo>
                <a:lnTo>
                  <a:pt x="2113" y="30"/>
                </a:lnTo>
                <a:lnTo>
                  <a:pt x="2121" y="28"/>
                </a:lnTo>
                <a:lnTo>
                  <a:pt x="2131" y="28"/>
                </a:lnTo>
                <a:lnTo>
                  <a:pt x="2137" y="26"/>
                </a:lnTo>
                <a:lnTo>
                  <a:pt x="2147" y="26"/>
                </a:lnTo>
                <a:lnTo>
                  <a:pt x="2154" y="25"/>
                </a:lnTo>
                <a:lnTo>
                  <a:pt x="2163" y="25"/>
                </a:lnTo>
                <a:lnTo>
                  <a:pt x="2171" y="23"/>
                </a:lnTo>
                <a:lnTo>
                  <a:pt x="2178" y="23"/>
                </a:lnTo>
                <a:lnTo>
                  <a:pt x="2188" y="22"/>
                </a:lnTo>
                <a:lnTo>
                  <a:pt x="2194" y="20"/>
                </a:lnTo>
                <a:lnTo>
                  <a:pt x="2202" y="20"/>
                </a:lnTo>
                <a:lnTo>
                  <a:pt x="2212" y="18"/>
                </a:lnTo>
                <a:lnTo>
                  <a:pt x="2220" y="18"/>
                </a:lnTo>
                <a:lnTo>
                  <a:pt x="2229" y="17"/>
                </a:lnTo>
                <a:lnTo>
                  <a:pt x="2235" y="17"/>
                </a:lnTo>
                <a:lnTo>
                  <a:pt x="2243" y="15"/>
                </a:lnTo>
                <a:lnTo>
                  <a:pt x="2251" y="15"/>
                </a:lnTo>
                <a:lnTo>
                  <a:pt x="2261" y="13"/>
                </a:lnTo>
                <a:lnTo>
                  <a:pt x="2269" y="13"/>
                </a:lnTo>
                <a:lnTo>
                  <a:pt x="2278" y="12"/>
                </a:lnTo>
                <a:lnTo>
                  <a:pt x="2284" y="10"/>
                </a:lnTo>
                <a:lnTo>
                  <a:pt x="2292" y="10"/>
                </a:lnTo>
                <a:lnTo>
                  <a:pt x="2300" y="8"/>
                </a:lnTo>
                <a:lnTo>
                  <a:pt x="2310" y="8"/>
                </a:lnTo>
                <a:lnTo>
                  <a:pt x="2317" y="7"/>
                </a:lnTo>
                <a:lnTo>
                  <a:pt x="2326" y="7"/>
                </a:lnTo>
                <a:lnTo>
                  <a:pt x="2335" y="5"/>
                </a:lnTo>
                <a:lnTo>
                  <a:pt x="2341" y="5"/>
                </a:lnTo>
                <a:lnTo>
                  <a:pt x="2351" y="4"/>
                </a:lnTo>
                <a:lnTo>
                  <a:pt x="2357" y="4"/>
                </a:lnTo>
                <a:lnTo>
                  <a:pt x="2366" y="2"/>
                </a:lnTo>
                <a:lnTo>
                  <a:pt x="2375" y="2"/>
                </a:lnTo>
                <a:lnTo>
                  <a:pt x="2382" y="0"/>
                </a:lnTo>
                <a:lnTo>
                  <a:pt x="2390" y="36"/>
                </a:lnTo>
                <a:lnTo>
                  <a:pt x="2400" y="36"/>
                </a:lnTo>
                <a:lnTo>
                  <a:pt x="2408" y="36"/>
                </a:lnTo>
                <a:lnTo>
                  <a:pt x="2416" y="36"/>
                </a:lnTo>
                <a:lnTo>
                  <a:pt x="2424" y="36"/>
                </a:lnTo>
                <a:lnTo>
                  <a:pt x="2433" y="36"/>
                </a:lnTo>
                <a:lnTo>
                  <a:pt x="2439" y="36"/>
                </a:lnTo>
                <a:lnTo>
                  <a:pt x="2449" y="36"/>
                </a:lnTo>
                <a:lnTo>
                  <a:pt x="2455" y="36"/>
                </a:lnTo>
                <a:lnTo>
                  <a:pt x="2464" y="36"/>
                </a:lnTo>
                <a:lnTo>
                  <a:pt x="2473" y="36"/>
                </a:lnTo>
                <a:lnTo>
                  <a:pt x="2480" y="36"/>
                </a:lnTo>
                <a:lnTo>
                  <a:pt x="2490" y="38"/>
                </a:lnTo>
                <a:lnTo>
                  <a:pt x="2498" y="38"/>
                </a:lnTo>
                <a:lnTo>
                  <a:pt x="2506" y="38"/>
                </a:lnTo>
                <a:lnTo>
                  <a:pt x="2513" y="38"/>
                </a:lnTo>
                <a:lnTo>
                  <a:pt x="2521" y="38"/>
                </a:lnTo>
                <a:lnTo>
                  <a:pt x="2529" y="38"/>
                </a:lnTo>
                <a:lnTo>
                  <a:pt x="2539" y="38"/>
                </a:lnTo>
                <a:lnTo>
                  <a:pt x="2547" y="38"/>
                </a:lnTo>
                <a:lnTo>
                  <a:pt x="2555" y="38"/>
                </a:lnTo>
                <a:lnTo>
                  <a:pt x="2561" y="38"/>
                </a:lnTo>
                <a:lnTo>
                  <a:pt x="2570" y="38"/>
                </a:lnTo>
                <a:lnTo>
                  <a:pt x="2578" y="38"/>
                </a:lnTo>
                <a:lnTo>
                  <a:pt x="2588" y="38"/>
                </a:lnTo>
                <a:lnTo>
                  <a:pt x="2594" y="39"/>
                </a:lnTo>
                <a:lnTo>
                  <a:pt x="2604" y="39"/>
                </a:lnTo>
                <a:lnTo>
                  <a:pt x="2610" y="39"/>
                </a:lnTo>
                <a:lnTo>
                  <a:pt x="2620" y="39"/>
                </a:lnTo>
                <a:lnTo>
                  <a:pt x="2627" y="39"/>
                </a:lnTo>
                <a:lnTo>
                  <a:pt x="2635" y="39"/>
                </a:lnTo>
                <a:lnTo>
                  <a:pt x="2645" y="39"/>
                </a:lnTo>
                <a:lnTo>
                  <a:pt x="2651" y="39"/>
                </a:lnTo>
                <a:lnTo>
                  <a:pt x="2661" y="39"/>
                </a:lnTo>
                <a:lnTo>
                  <a:pt x="2668" y="39"/>
                </a:lnTo>
                <a:lnTo>
                  <a:pt x="2676" y="39"/>
                </a:lnTo>
                <a:lnTo>
                  <a:pt x="2685" y="39"/>
                </a:lnTo>
                <a:lnTo>
                  <a:pt x="2692" y="39"/>
                </a:lnTo>
                <a:lnTo>
                  <a:pt x="2702" y="39"/>
                </a:lnTo>
                <a:lnTo>
                  <a:pt x="2708" y="41"/>
                </a:lnTo>
                <a:lnTo>
                  <a:pt x="2718" y="41"/>
                </a:lnTo>
                <a:lnTo>
                  <a:pt x="2726" y="41"/>
                </a:lnTo>
                <a:lnTo>
                  <a:pt x="2733" y="41"/>
                </a:lnTo>
                <a:lnTo>
                  <a:pt x="2743" y="41"/>
                </a:lnTo>
                <a:lnTo>
                  <a:pt x="2749" y="41"/>
                </a:lnTo>
                <a:lnTo>
                  <a:pt x="2759" y="41"/>
                </a:lnTo>
                <a:lnTo>
                  <a:pt x="2765" y="41"/>
                </a:lnTo>
                <a:lnTo>
                  <a:pt x="2774" y="41"/>
                </a:lnTo>
                <a:lnTo>
                  <a:pt x="2783" y="41"/>
                </a:lnTo>
                <a:lnTo>
                  <a:pt x="2790" y="41"/>
                </a:lnTo>
                <a:lnTo>
                  <a:pt x="2798" y="41"/>
                </a:lnTo>
                <a:lnTo>
                  <a:pt x="2808" y="41"/>
                </a:lnTo>
                <a:lnTo>
                  <a:pt x="2816" y="43"/>
                </a:lnTo>
                <a:lnTo>
                  <a:pt x="2824" y="43"/>
                </a:lnTo>
                <a:lnTo>
                  <a:pt x="2831" y="43"/>
                </a:lnTo>
                <a:lnTo>
                  <a:pt x="2839" y="43"/>
                </a:lnTo>
                <a:lnTo>
                  <a:pt x="2849" y="43"/>
                </a:lnTo>
                <a:lnTo>
                  <a:pt x="2857" y="43"/>
                </a:lnTo>
                <a:lnTo>
                  <a:pt x="2865" y="43"/>
                </a:lnTo>
                <a:lnTo>
                  <a:pt x="2871" y="43"/>
                </a:lnTo>
                <a:lnTo>
                  <a:pt x="2880" y="43"/>
                </a:lnTo>
                <a:lnTo>
                  <a:pt x="2889" y="43"/>
                </a:lnTo>
                <a:lnTo>
                  <a:pt x="2898" y="43"/>
                </a:lnTo>
                <a:lnTo>
                  <a:pt x="2904" y="43"/>
                </a:lnTo>
                <a:lnTo>
                  <a:pt x="2912" y="43"/>
                </a:lnTo>
                <a:lnTo>
                  <a:pt x="2920" y="43"/>
                </a:lnTo>
                <a:lnTo>
                  <a:pt x="2930" y="44"/>
                </a:lnTo>
                <a:lnTo>
                  <a:pt x="2938" y="44"/>
                </a:lnTo>
                <a:lnTo>
                  <a:pt x="2945" y="44"/>
                </a:lnTo>
                <a:lnTo>
                  <a:pt x="2953" y="44"/>
                </a:lnTo>
                <a:lnTo>
                  <a:pt x="2961" y="44"/>
                </a:lnTo>
                <a:lnTo>
                  <a:pt x="2971" y="44"/>
                </a:lnTo>
                <a:lnTo>
                  <a:pt x="2979" y="44"/>
                </a:lnTo>
                <a:lnTo>
                  <a:pt x="2986" y="44"/>
                </a:lnTo>
                <a:lnTo>
                  <a:pt x="2994" y="44"/>
                </a:lnTo>
                <a:lnTo>
                  <a:pt x="3002" y="44"/>
                </a:lnTo>
                <a:lnTo>
                  <a:pt x="3012" y="44"/>
                </a:lnTo>
                <a:lnTo>
                  <a:pt x="3020" y="44"/>
                </a:lnTo>
                <a:lnTo>
                  <a:pt x="3027" y="44"/>
                </a:lnTo>
                <a:lnTo>
                  <a:pt x="3035" y="44"/>
                </a:lnTo>
                <a:lnTo>
                  <a:pt x="3044" y="46"/>
                </a:lnTo>
                <a:lnTo>
                  <a:pt x="3053" y="46"/>
                </a:lnTo>
                <a:lnTo>
                  <a:pt x="3061" y="46"/>
                </a:lnTo>
                <a:lnTo>
                  <a:pt x="3067" y="46"/>
                </a:lnTo>
                <a:lnTo>
                  <a:pt x="3075" y="46"/>
                </a:lnTo>
                <a:lnTo>
                  <a:pt x="3085" y="46"/>
                </a:lnTo>
                <a:lnTo>
                  <a:pt x="3093" y="46"/>
                </a:lnTo>
                <a:lnTo>
                  <a:pt x="3102" y="46"/>
                </a:lnTo>
                <a:lnTo>
                  <a:pt x="3108" y="46"/>
                </a:lnTo>
                <a:lnTo>
                  <a:pt x="3116" y="46"/>
                </a:lnTo>
                <a:lnTo>
                  <a:pt x="3126" y="46"/>
                </a:lnTo>
                <a:lnTo>
                  <a:pt x="3134" y="46"/>
                </a:lnTo>
                <a:lnTo>
                  <a:pt x="3142" y="46"/>
                </a:lnTo>
                <a:lnTo>
                  <a:pt x="3149" y="46"/>
                </a:lnTo>
                <a:lnTo>
                  <a:pt x="3157" y="48"/>
                </a:lnTo>
                <a:lnTo>
                  <a:pt x="3167" y="48"/>
                </a:lnTo>
                <a:lnTo>
                  <a:pt x="3173" y="48"/>
                </a:lnTo>
                <a:lnTo>
                  <a:pt x="3182" y="48"/>
                </a:lnTo>
                <a:lnTo>
                  <a:pt x="3191" y="48"/>
                </a:lnTo>
                <a:lnTo>
                  <a:pt x="3198" y="48"/>
                </a:lnTo>
                <a:lnTo>
                  <a:pt x="3208" y="48"/>
                </a:lnTo>
                <a:lnTo>
                  <a:pt x="3214" y="48"/>
                </a:lnTo>
                <a:lnTo>
                  <a:pt x="3222" y="48"/>
                </a:lnTo>
                <a:lnTo>
                  <a:pt x="3232" y="48"/>
                </a:lnTo>
                <a:lnTo>
                  <a:pt x="3239" y="48"/>
                </a:lnTo>
                <a:lnTo>
                  <a:pt x="3248" y="48"/>
                </a:lnTo>
                <a:lnTo>
                  <a:pt x="3255" y="48"/>
                </a:lnTo>
                <a:lnTo>
                  <a:pt x="3263" y="48"/>
                </a:lnTo>
                <a:lnTo>
                  <a:pt x="3273" y="49"/>
                </a:lnTo>
                <a:lnTo>
                  <a:pt x="3279" y="49"/>
                </a:lnTo>
                <a:lnTo>
                  <a:pt x="3289" y="49"/>
                </a:lnTo>
                <a:lnTo>
                  <a:pt x="3296" y="49"/>
                </a:lnTo>
                <a:lnTo>
                  <a:pt x="3304" y="49"/>
                </a:lnTo>
                <a:lnTo>
                  <a:pt x="3314" y="49"/>
                </a:lnTo>
                <a:lnTo>
                  <a:pt x="3320" y="49"/>
                </a:lnTo>
                <a:lnTo>
                  <a:pt x="3330" y="49"/>
                </a:lnTo>
                <a:lnTo>
                  <a:pt x="3337" y="49"/>
                </a:lnTo>
                <a:lnTo>
                  <a:pt x="3345" y="49"/>
                </a:lnTo>
                <a:lnTo>
                  <a:pt x="3354" y="49"/>
                </a:lnTo>
                <a:lnTo>
                  <a:pt x="3361" y="49"/>
                </a:lnTo>
                <a:lnTo>
                  <a:pt x="3371" y="49"/>
                </a:lnTo>
                <a:lnTo>
                  <a:pt x="3377" y="49"/>
                </a:lnTo>
                <a:lnTo>
                  <a:pt x="3385" y="51"/>
                </a:lnTo>
                <a:lnTo>
                  <a:pt x="3395" y="51"/>
                </a:lnTo>
                <a:lnTo>
                  <a:pt x="3402" y="51"/>
                </a:lnTo>
                <a:lnTo>
                  <a:pt x="3412" y="51"/>
                </a:lnTo>
                <a:lnTo>
                  <a:pt x="3418" y="51"/>
                </a:lnTo>
                <a:lnTo>
                  <a:pt x="3426" y="51"/>
                </a:lnTo>
                <a:lnTo>
                  <a:pt x="3436" y="51"/>
                </a:lnTo>
                <a:lnTo>
                  <a:pt x="3443" y="51"/>
                </a:lnTo>
                <a:lnTo>
                  <a:pt x="3452" y="51"/>
                </a:lnTo>
                <a:lnTo>
                  <a:pt x="3461" y="51"/>
                </a:lnTo>
                <a:lnTo>
                  <a:pt x="3467" y="51"/>
                </a:lnTo>
                <a:lnTo>
                  <a:pt x="3477" y="51"/>
                </a:lnTo>
                <a:lnTo>
                  <a:pt x="3483" y="51"/>
                </a:lnTo>
                <a:lnTo>
                  <a:pt x="3493" y="51"/>
                </a:lnTo>
                <a:lnTo>
                  <a:pt x="3501" y="53"/>
                </a:lnTo>
                <a:lnTo>
                  <a:pt x="3508" y="53"/>
                </a:lnTo>
                <a:lnTo>
                  <a:pt x="3518" y="53"/>
                </a:lnTo>
                <a:lnTo>
                  <a:pt x="3524" y="53"/>
                </a:lnTo>
                <a:lnTo>
                  <a:pt x="3534" y="53"/>
                </a:lnTo>
                <a:lnTo>
                  <a:pt x="3542" y="53"/>
                </a:lnTo>
                <a:lnTo>
                  <a:pt x="3549" y="53"/>
                </a:lnTo>
                <a:lnTo>
                  <a:pt x="3558" y="53"/>
                </a:lnTo>
                <a:lnTo>
                  <a:pt x="3565" y="53"/>
                </a:lnTo>
                <a:lnTo>
                  <a:pt x="3575" y="53"/>
                </a:lnTo>
                <a:lnTo>
                  <a:pt x="3583" y="53"/>
                </a:lnTo>
                <a:lnTo>
                  <a:pt x="3589" y="53"/>
                </a:lnTo>
                <a:lnTo>
                  <a:pt x="3599" y="53"/>
                </a:lnTo>
                <a:lnTo>
                  <a:pt x="3606" y="53"/>
                </a:lnTo>
                <a:lnTo>
                  <a:pt x="3616" y="54"/>
                </a:lnTo>
                <a:lnTo>
                  <a:pt x="3624" y="54"/>
                </a:lnTo>
                <a:lnTo>
                  <a:pt x="3630" y="54"/>
                </a:lnTo>
                <a:lnTo>
                  <a:pt x="3640" y="54"/>
                </a:lnTo>
                <a:lnTo>
                  <a:pt x="3647" y="54"/>
                </a:lnTo>
                <a:lnTo>
                  <a:pt x="3656" y="54"/>
                </a:lnTo>
                <a:lnTo>
                  <a:pt x="3665" y="54"/>
                </a:lnTo>
                <a:lnTo>
                  <a:pt x="3671" y="54"/>
                </a:lnTo>
                <a:lnTo>
                  <a:pt x="3681" y="54"/>
                </a:lnTo>
                <a:lnTo>
                  <a:pt x="3687" y="54"/>
                </a:lnTo>
                <a:lnTo>
                  <a:pt x="3696" y="54"/>
                </a:lnTo>
                <a:lnTo>
                  <a:pt x="3705" y="54"/>
                </a:lnTo>
                <a:lnTo>
                  <a:pt x="3712" y="54"/>
                </a:lnTo>
                <a:lnTo>
                  <a:pt x="3722" y="54"/>
                </a:lnTo>
                <a:lnTo>
                  <a:pt x="3728" y="54"/>
                </a:lnTo>
                <a:lnTo>
                  <a:pt x="3736" y="56"/>
                </a:lnTo>
                <a:lnTo>
                  <a:pt x="3746" y="56"/>
                </a:lnTo>
                <a:lnTo>
                  <a:pt x="3753" y="56"/>
                </a:lnTo>
                <a:lnTo>
                  <a:pt x="3762" y="56"/>
                </a:lnTo>
                <a:lnTo>
                  <a:pt x="3769" y="56"/>
                </a:lnTo>
                <a:lnTo>
                  <a:pt x="3777" y="56"/>
                </a:lnTo>
                <a:lnTo>
                  <a:pt x="3787" y="56"/>
                </a:lnTo>
                <a:lnTo>
                  <a:pt x="3793" y="56"/>
                </a:lnTo>
                <a:lnTo>
                  <a:pt x="3803" y="56"/>
                </a:lnTo>
                <a:lnTo>
                  <a:pt x="3810" y="56"/>
                </a:lnTo>
                <a:lnTo>
                  <a:pt x="3818" y="56"/>
                </a:lnTo>
                <a:lnTo>
                  <a:pt x="3828" y="56"/>
                </a:lnTo>
                <a:lnTo>
                  <a:pt x="3834" y="56"/>
                </a:lnTo>
                <a:lnTo>
                  <a:pt x="3844" y="56"/>
                </a:lnTo>
                <a:lnTo>
                  <a:pt x="3851" y="57"/>
                </a:lnTo>
                <a:lnTo>
                  <a:pt x="3859" y="57"/>
                </a:lnTo>
                <a:lnTo>
                  <a:pt x="3868" y="57"/>
                </a:lnTo>
                <a:lnTo>
                  <a:pt x="3875" y="57"/>
                </a:lnTo>
                <a:lnTo>
                  <a:pt x="3885" y="57"/>
                </a:lnTo>
                <a:lnTo>
                  <a:pt x="3891" y="57"/>
                </a:lnTo>
                <a:lnTo>
                  <a:pt x="3899" y="57"/>
                </a:lnTo>
                <a:lnTo>
                  <a:pt x="3909" y="57"/>
                </a:lnTo>
                <a:lnTo>
                  <a:pt x="3916" y="57"/>
                </a:lnTo>
                <a:lnTo>
                  <a:pt x="3926" y="57"/>
                </a:lnTo>
                <a:lnTo>
                  <a:pt x="3932" y="57"/>
                </a:lnTo>
                <a:lnTo>
                  <a:pt x="3940" y="57"/>
                </a:lnTo>
                <a:lnTo>
                  <a:pt x="3948" y="57"/>
                </a:lnTo>
                <a:lnTo>
                  <a:pt x="3957" y="57"/>
                </a:lnTo>
                <a:lnTo>
                  <a:pt x="3966" y="57"/>
                </a:lnTo>
                <a:lnTo>
                  <a:pt x="3975" y="59"/>
                </a:lnTo>
                <a:lnTo>
                  <a:pt x="3983" y="59"/>
                </a:lnTo>
                <a:lnTo>
                  <a:pt x="3989" y="59"/>
                </a:lnTo>
                <a:lnTo>
                  <a:pt x="3997" y="59"/>
                </a:lnTo>
                <a:lnTo>
                  <a:pt x="4007" y="59"/>
                </a:lnTo>
                <a:lnTo>
                  <a:pt x="4015" y="59"/>
                </a:lnTo>
                <a:lnTo>
                  <a:pt x="4023" y="59"/>
                </a:lnTo>
                <a:lnTo>
                  <a:pt x="4030" y="59"/>
                </a:lnTo>
                <a:lnTo>
                  <a:pt x="4038" y="59"/>
                </a:lnTo>
                <a:lnTo>
                  <a:pt x="4048" y="59"/>
                </a:lnTo>
                <a:lnTo>
                  <a:pt x="4056" y="59"/>
                </a:lnTo>
                <a:lnTo>
                  <a:pt x="4064" y="59"/>
                </a:lnTo>
                <a:lnTo>
                  <a:pt x="4071" y="59"/>
                </a:lnTo>
                <a:lnTo>
                  <a:pt x="4079" y="59"/>
                </a:lnTo>
                <a:lnTo>
                  <a:pt x="4089" y="61"/>
                </a:lnTo>
                <a:lnTo>
                  <a:pt x="4097" y="61"/>
                </a:lnTo>
                <a:lnTo>
                  <a:pt x="4105" y="61"/>
                </a:lnTo>
                <a:lnTo>
                  <a:pt x="4112" y="61"/>
                </a:lnTo>
                <a:lnTo>
                  <a:pt x="4120" y="61"/>
                </a:lnTo>
                <a:lnTo>
                  <a:pt x="4130" y="61"/>
                </a:lnTo>
                <a:lnTo>
                  <a:pt x="4138" y="61"/>
                </a:lnTo>
                <a:lnTo>
                  <a:pt x="4146" y="61"/>
                </a:lnTo>
                <a:lnTo>
                  <a:pt x="4152" y="61"/>
                </a:lnTo>
                <a:lnTo>
                  <a:pt x="4161" y="61"/>
                </a:lnTo>
                <a:lnTo>
                  <a:pt x="4170" y="61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03" name="Freeform 101"/>
          <p:cNvSpPr>
            <a:spLocks/>
          </p:cNvSpPr>
          <p:nvPr/>
        </p:nvSpPr>
        <p:spPr bwMode="auto">
          <a:xfrm>
            <a:off x="672307" y="4733927"/>
            <a:ext cx="6619876" cy="252413"/>
          </a:xfrm>
          <a:custGeom>
            <a:avLst/>
            <a:gdLst>
              <a:gd name="T0" fmla="*/ 67 w 4170"/>
              <a:gd name="T1" fmla="*/ 159 h 159"/>
              <a:gd name="T2" fmla="*/ 138 w 4170"/>
              <a:gd name="T3" fmla="*/ 159 h 159"/>
              <a:gd name="T4" fmla="*/ 212 w 4170"/>
              <a:gd name="T5" fmla="*/ 159 h 159"/>
              <a:gd name="T6" fmla="*/ 285 w 4170"/>
              <a:gd name="T7" fmla="*/ 159 h 159"/>
              <a:gd name="T8" fmla="*/ 360 w 4170"/>
              <a:gd name="T9" fmla="*/ 150 h 159"/>
              <a:gd name="T10" fmla="*/ 434 w 4170"/>
              <a:gd name="T11" fmla="*/ 144 h 159"/>
              <a:gd name="T12" fmla="*/ 505 w 4170"/>
              <a:gd name="T13" fmla="*/ 137 h 159"/>
              <a:gd name="T14" fmla="*/ 579 w 4170"/>
              <a:gd name="T15" fmla="*/ 132 h 159"/>
              <a:gd name="T16" fmla="*/ 654 w 4170"/>
              <a:gd name="T17" fmla="*/ 126 h 159"/>
              <a:gd name="T18" fmla="*/ 727 w 4170"/>
              <a:gd name="T19" fmla="*/ 119 h 159"/>
              <a:gd name="T20" fmla="*/ 801 w 4170"/>
              <a:gd name="T21" fmla="*/ 114 h 159"/>
              <a:gd name="T22" fmla="*/ 873 w 4170"/>
              <a:gd name="T23" fmla="*/ 108 h 159"/>
              <a:gd name="T24" fmla="*/ 948 w 4170"/>
              <a:gd name="T25" fmla="*/ 101 h 159"/>
              <a:gd name="T26" fmla="*/ 1019 w 4170"/>
              <a:gd name="T27" fmla="*/ 97 h 159"/>
              <a:gd name="T28" fmla="*/ 1095 w 4170"/>
              <a:gd name="T29" fmla="*/ 90 h 159"/>
              <a:gd name="T30" fmla="*/ 1166 w 4170"/>
              <a:gd name="T31" fmla="*/ 85 h 159"/>
              <a:gd name="T32" fmla="*/ 1240 w 4170"/>
              <a:gd name="T33" fmla="*/ 80 h 159"/>
              <a:gd name="T34" fmla="*/ 1315 w 4170"/>
              <a:gd name="T35" fmla="*/ 74 h 159"/>
              <a:gd name="T36" fmla="*/ 1387 w 4170"/>
              <a:gd name="T37" fmla="*/ 69 h 159"/>
              <a:gd name="T38" fmla="*/ 1462 w 4170"/>
              <a:gd name="T39" fmla="*/ 64 h 159"/>
              <a:gd name="T40" fmla="*/ 1533 w 4170"/>
              <a:gd name="T41" fmla="*/ 57 h 159"/>
              <a:gd name="T42" fmla="*/ 1609 w 4170"/>
              <a:gd name="T43" fmla="*/ 52 h 159"/>
              <a:gd name="T44" fmla="*/ 1680 w 4170"/>
              <a:gd name="T45" fmla="*/ 48 h 159"/>
              <a:gd name="T46" fmla="*/ 1755 w 4170"/>
              <a:gd name="T47" fmla="*/ 43 h 159"/>
              <a:gd name="T48" fmla="*/ 1829 w 4170"/>
              <a:gd name="T49" fmla="*/ 36 h 159"/>
              <a:gd name="T50" fmla="*/ 1902 w 4170"/>
              <a:gd name="T51" fmla="*/ 31 h 159"/>
              <a:gd name="T52" fmla="*/ 1976 w 4170"/>
              <a:gd name="T53" fmla="*/ 26 h 159"/>
              <a:gd name="T54" fmla="*/ 2049 w 4170"/>
              <a:gd name="T55" fmla="*/ 21 h 159"/>
              <a:gd name="T56" fmla="*/ 2121 w 4170"/>
              <a:gd name="T57" fmla="*/ 17 h 159"/>
              <a:gd name="T58" fmla="*/ 2194 w 4170"/>
              <a:gd name="T59" fmla="*/ 12 h 159"/>
              <a:gd name="T60" fmla="*/ 2269 w 4170"/>
              <a:gd name="T61" fmla="*/ 7 h 159"/>
              <a:gd name="T62" fmla="*/ 2341 w 4170"/>
              <a:gd name="T63" fmla="*/ 2 h 159"/>
              <a:gd name="T64" fmla="*/ 2416 w 4170"/>
              <a:gd name="T65" fmla="*/ 7 h 159"/>
              <a:gd name="T66" fmla="*/ 2490 w 4170"/>
              <a:gd name="T67" fmla="*/ 7 h 159"/>
              <a:gd name="T68" fmla="*/ 2561 w 4170"/>
              <a:gd name="T69" fmla="*/ 8 h 159"/>
              <a:gd name="T70" fmla="*/ 2635 w 4170"/>
              <a:gd name="T71" fmla="*/ 8 h 159"/>
              <a:gd name="T72" fmla="*/ 2708 w 4170"/>
              <a:gd name="T73" fmla="*/ 8 h 159"/>
              <a:gd name="T74" fmla="*/ 2783 w 4170"/>
              <a:gd name="T75" fmla="*/ 10 h 159"/>
              <a:gd name="T76" fmla="*/ 2857 w 4170"/>
              <a:gd name="T77" fmla="*/ 10 h 159"/>
              <a:gd name="T78" fmla="*/ 2930 w 4170"/>
              <a:gd name="T79" fmla="*/ 12 h 159"/>
              <a:gd name="T80" fmla="*/ 3002 w 4170"/>
              <a:gd name="T81" fmla="*/ 12 h 159"/>
              <a:gd name="T82" fmla="*/ 3075 w 4170"/>
              <a:gd name="T83" fmla="*/ 12 h 159"/>
              <a:gd name="T84" fmla="*/ 3149 w 4170"/>
              <a:gd name="T85" fmla="*/ 13 h 159"/>
              <a:gd name="T86" fmla="*/ 3222 w 4170"/>
              <a:gd name="T87" fmla="*/ 13 h 159"/>
              <a:gd name="T88" fmla="*/ 3296 w 4170"/>
              <a:gd name="T89" fmla="*/ 13 h 159"/>
              <a:gd name="T90" fmla="*/ 3371 w 4170"/>
              <a:gd name="T91" fmla="*/ 15 h 159"/>
              <a:gd name="T92" fmla="*/ 3443 w 4170"/>
              <a:gd name="T93" fmla="*/ 15 h 159"/>
              <a:gd name="T94" fmla="*/ 3518 w 4170"/>
              <a:gd name="T95" fmla="*/ 15 h 159"/>
              <a:gd name="T96" fmla="*/ 3589 w 4170"/>
              <a:gd name="T97" fmla="*/ 17 h 159"/>
              <a:gd name="T98" fmla="*/ 3665 w 4170"/>
              <a:gd name="T99" fmla="*/ 17 h 159"/>
              <a:gd name="T100" fmla="*/ 3736 w 4170"/>
              <a:gd name="T101" fmla="*/ 17 h 159"/>
              <a:gd name="T102" fmla="*/ 3810 w 4170"/>
              <a:gd name="T103" fmla="*/ 18 h 159"/>
              <a:gd name="T104" fmla="*/ 3885 w 4170"/>
              <a:gd name="T105" fmla="*/ 18 h 159"/>
              <a:gd name="T106" fmla="*/ 3957 w 4170"/>
              <a:gd name="T107" fmla="*/ 18 h 159"/>
              <a:gd name="T108" fmla="*/ 4030 w 4170"/>
              <a:gd name="T109" fmla="*/ 20 h 159"/>
              <a:gd name="T110" fmla="*/ 4105 w 4170"/>
              <a:gd name="T111" fmla="*/ 20 h 1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159">
                <a:moveTo>
                  <a:pt x="0" y="159"/>
                </a:moveTo>
                <a:lnTo>
                  <a:pt x="8" y="159"/>
                </a:lnTo>
                <a:lnTo>
                  <a:pt x="16" y="159"/>
                </a:lnTo>
                <a:lnTo>
                  <a:pt x="26" y="159"/>
                </a:lnTo>
                <a:lnTo>
                  <a:pt x="34" y="159"/>
                </a:lnTo>
                <a:lnTo>
                  <a:pt x="40" y="159"/>
                </a:lnTo>
                <a:lnTo>
                  <a:pt x="49" y="159"/>
                </a:lnTo>
                <a:lnTo>
                  <a:pt x="57" y="159"/>
                </a:lnTo>
                <a:lnTo>
                  <a:pt x="67" y="159"/>
                </a:lnTo>
                <a:lnTo>
                  <a:pt x="75" y="159"/>
                </a:lnTo>
                <a:lnTo>
                  <a:pt x="81" y="159"/>
                </a:lnTo>
                <a:lnTo>
                  <a:pt x="89" y="159"/>
                </a:lnTo>
                <a:lnTo>
                  <a:pt x="98" y="159"/>
                </a:lnTo>
                <a:lnTo>
                  <a:pt x="107" y="159"/>
                </a:lnTo>
                <a:lnTo>
                  <a:pt x="116" y="159"/>
                </a:lnTo>
                <a:lnTo>
                  <a:pt x="122" y="159"/>
                </a:lnTo>
                <a:lnTo>
                  <a:pt x="130" y="159"/>
                </a:lnTo>
                <a:lnTo>
                  <a:pt x="138" y="159"/>
                </a:lnTo>
                <a:lnTo>
                  <a:pt x="148" y="159"/>
                </a:lnTo>
                <a:lnTo>
                  <a:pt x="156" y="159"/>
                </a:lnTo>
                <a:lnTo>
                  <a:pt x="163" y="159"/>
                </a:lnTo>
                <a:lnTo>
                  <a:pt x="171" y="159"/>
                </a:lnTo>
                <a:lnTo>
                  <a:pt x="179" y="159"/>
                </a:lnTo>
                <a:lnTo>
                  <a:pt x="189" y="159"/>
                </a:lnTo>
                <a:lnTo>
                  <a:pt x="197" y="159"/>
                </a:lnTo>
                <a:lnTo>
                  <a:pt x="204" y="159"/>
                </a:lnTo>
                <a:lnTo>
                  <a:pt x="212" y="159"/>
                </a:lnTo>
                <a:lnTo>
                  <a:pt x="220" y="159"/>
                </a:lnTo>
                <a:lnTo>
                  <a:pt x="230" y="159"/>
                </a:lnTo>
                <a:lnTo>
                  <a:pt x="238" y="159"/>
                </a:lnTo>
                <a:lnTo>
                  <a:pt x="244" y="159"/>
                </a:lnTo>
                <a:lnTo>
                  <a:pt x="253" y="159"/>
                </a:lnTo>
                <a:lnTo>
                  <a:pt x="261" y="159"/>
                </a:lnTo>
                <a:lnTo>
                  <a:pt x="271" y="159"/>
                </a:lnTo>
                <a:lnTo>
                  <a:pt x="279" y="159"/>
                </a:lnTo>
                <a:lnTo>
                  <a:pt x="285" y="159"/>
                </a:lnTo>
                <a:lnTo>
                  <a:pt x="293" y="159"/>
                </a:lnTo>
                <a:lnTo>
                  <a:pt x="302" y="159"/>
                </a:lnTo>
                <a:lnTo>
                  <a:pt x="311" y="159"/>
                </a:lnTo>
                <a:lnTo>
                  <a:pt x="319" y="159"/>
                </a:lnTo>
                <a:lnTo>
                  <a:pt x="326" y="159"/>
                </a:lnTo>
                <a:lnTo>
                  <a:pt x="334" y="159"/>
                </a:lnTo>
                <a:lnTo>
                  <a:pt x="342" y="152"/>
                </a:lnTo>
                <a:lnTo>
                  <a:pt x="352" y="152"/>
                </a:lnTo>
                <a:lnTo>
                  <a:pt x="360" y="150"/>
                </a:lnTo>
                <a:lnTo>
                  <a:pt x="367" y="150"/>
                </a:lnTo>
                <a:lnTo>
                  <a:pt x="375" y="149"/>
                </a:lnTo>
                <a:lnTo>
                  <a:pt x="383" y="149"/>
                </a:lnTo>
                <a:lnTo>
                  <a:pt x="393" y="147"/>
                </a:lnTo>
                <a:lnTo>
                  <a:pt x="401" y="147"/>
                </a:lnTo>
                <a:lnTo>
                  <a:pt x="408" y="147"/>
                </a:lnTo>
                <a:lnTo>
                  <a:pt x="416" y="145"/>
                </a:lnTo>
                <a:lnTo>
                  <a:pt x="424" y="145"/>
                </a:lnTo>
                <a:lnTo>
                  <a:pt x="434" y="144"/>
                </a:lnTo>
                <a:lnTo>
                  <a:pt x="442" y="144"/>
                </a:lnTo>
                <a:lnTo>
                  <a:pt x="448" y="142"/>
                </a:lnTo>
                <a:lnTo>
                  <a:pt x="457" y="142"/>
                </a:lnTo>
                <a:lnTo>
                  <a:pt x="465" y="142"/>
                </a:lnTo>
                <a:lnTo>
                  <a:pt x="474" y="141"/>
                </a:lnTo>
                <a:lnTo>
                  <a:pt x="483" y="141"/>
                </a:lnTo>
                <a:lnTo>
                  <a:pt x="489" y="139"/>
                </a:lnTo>
                <a:lnTo>
                  <a:pt x="497" y="139"/>
                </a:lnTo>
                <a:lnTo>
                  <a:pt x="505" y="137"/>
                </a:lnTo>
                <a:lnTo>
                  <a:pt x="515" y="137"/>
                </a:lnTo>
                <a:lnTo>
                  <a:pt x="523" y="137"/>
                </a:lnTo>
                <a:lnTo>
                  <a:pt x="532" y="136"/>
                </a:lnTo>
                <a:lnTo>
                  <a:pt x="538" y="136"/>
                </a:lnTo>
                <a:lnTo>
                  <a:pt x="546" y="134"/>
                </a:lnTo>
                <a:lnTo>
                  <a:pt x="556" y="134"/>
                </a:lnTo>
                <a:lnTo>
                  <a:pt x="564" y="134"/>
                </a:lnTo>
                <a:lnTo>
                  <a:pt x="572" y="132"/>
                </a:lnTo>
                <a:lnTo>
                  <a:pt x="579" y="132"/>
                </a:lnTo>
                <a:lnTo>
                  <a:pt x="587" y="131"/>
                </a:lnTo>
                <a:lnTo>
                  <a:pt x="597" y="131"/>
                </a:lnTo>
                <a:lnTo>
                  <a:pt x="605" y="129"/>
                </a:lnTo>
                <a:lnTo>
                  <a:pt x="613" y="129"/>
                </a:lnTo>
                <a:lnTo>
                  <a:pt x="620" y="129"/>
                </a:lnTo>
                <a:lnTo>
                  <a:pt x="628" y="128"/>
                </a:lnTo>
                <a:lnTo>
                  <a:pt x="638" y="128"/>
                </a:lnTo>
                <a:lnTo>
                  <a:pt x="646" y="126"/>
                </a:lnTo>
                <a:lnTo>
                  <a:pt x="654" y="126"/>
                </a:lnTo>
                <a:lnTo>
                  <a:pt x="661" y="126"/>
                </a:lnTo>
                <a:lnTo>
                  <a:pt x="669" y="124"/>
                </a:lnTo>
                <a:lnTo>
                  <a:pt x="678" y="124"/>
                </a:lnTo>
                <a:lnTo>
                  <a:pt x="687" y="123"/>
                </a:lnTo>
                <a:lnTo>
                  <a:pt x="695" y="123"/>
                </a:lnTo>
                <a:lnTo>
                  <a:pt x="701" y="123"/>
                </a:lnTo>
                <a:lnTo>
                  <a:pt x="709" y="121"/>
                </a:lnTo>
                <a:lnTo>
                  <a:pt x="719" y="121"/>
                </a:lnTo>
                <a:lnTo>
                  <a:pt x="727" y="119"/>
                </a:lnTo>
                <a:lnTo>
                  <a:pt x="736" y="119"/>
                </a:lnTo>
                <a:lnTo>
                  <a:pt x="742" y="118"/>
                </a:lnTo>
                <a:lnTo>
                  <a:pt x="750" y="118"/>
                </a:lnTo>
                <a:lnTo>
                  <a:pt x="760" y="118"/>
                </a:lnTo>
                <a:lnTo>
                  <a:pt x="768" y="116"/>
                </a:lnTo>
                <a:lnTo>
                  <a:pt x="776" y="116"/>
                </a:lnTo>
                <a:lnTo>
                  <a:pt x="783" y="114"/>
                </a:lnTo>
                <a:lnTo>
                  <a:pt x="791" y="114"/>
                </a:lnTo>
                <a:lnTo>
                  <a:pt x="801" y="114"/>
                </a:lnTo>
                <a:lnTo>
                  <a:pt x="809" y="113"/>
                </a:lnTo>
                <a:lnTo>
                  <a:pt x="817" y="113"/>
                </a:lnTo>
                <a:lnTo>
                  <a:pt x="824" y="111"/>
                </a:lnTo>
                <a:lnTo>
                  <a:pt x="832" y="111"/>
                </a:lnTo>
                <a:lnTo>
                  <a:pt x="842" y="111"/>
                </a:lnTo>
                <a:lnTo>
                  <a:pt x="850" y="110"/>
                </a:lnTo>
                <a:lnTo>
                  <a:pt x="856" y="110"/>
                </a:lnTo>
                <a:lnTo>
                  <a:pt x="866" y="108"/>
                </a:lnTo>
                <a:lnTo>
                  <a:pt x="873" y="108"/>
                </a:lnTo>
                <a:lnTo>
                  <a:pt x="882" y="108"/>
                </a:lnTo>
                <a:lnTo>
                  <a:pt x="891" y="106"/>
                </a:lnTo>
                <a:lnTo>
                  <a:pt x="897" y="106"/>
                </a:lnTo>
                <a:lnTo>
                  <a:pt x="907" y="105"/>
                </a:lnTo>
                <a:lnTo>
                  <a:pt x="913" y="105"/>
                </a:lnTo>
                <a:lnTo>
                  <a:pt x="923" y="105"/>
                </a:lnTo>
                <a:lnTo>
                  <a:pt x="931" y="103"/>
                </a:lnTo>
                <a:lnTo>
                  <a:pt x="938" y="103"/>
                </a:lnTo>
                <a:lnTo>
                  <a:pt x="948" y="101"/>
                </a:lnTo>
                <a:lnTo>
                  <a:pt x="954" y="101"/>
                </a:lnTo>
                <a:lnTo>
                  <a:pt x="964" y="101"/>
                </a:lnTo>
                <a:lnTo>
                  <a:pt x="972" y="100"/>
                </a:lnTo>
                <a:lnTo>
                  <a:pt x="979" y="100"/>
                </a:lnTo>
                <a:lnTo>
                  <a:pt x="988" y="98"/>
                </a:lnTo>
                <a:lnTo>
                  <a:pt x="995" y="98"/>
                </a:lnTo>
                <a:lnTo>
                  <a:pt x="1005" y="98"/>
                </a:lnTo>
                <a:lnTo>
                  <a:pt x="1013" y="97"/>
                </a:lnTo>
                <a:lnTo>
                  <a:pt x="1019" y="97"/>
                </a:lnTo>
                <a:lnTo>
                  <a:pt x="1029" y="97"/>
                </a:lnTo>
                <a:lnTo>
                  <a:pt x="1036" y="95"/>
                </a:lnTo>
                <a:lnTo>
                  <a:pt x="1044" y="95"/>
                </a:lnTo>
                <a:lnTo>
                  <a:pt x="1054" y="93"/>
                </a:lnTo>
                <a:lnTo>
                  <a:pt x="1060" y="93"/>
                </a:lnTo>
                <a:lnTo>
                  <a:pt x="1070" y="93"/>
                </a:lnTo>
                <a:lnTo>
                  <a:pt x="1077" y="92"/>
                </a:lnTo>
                <a:lnTo>
                  <a:pt x="1085" y="92"/>
                </a:lnTo>
                <a:lnTo>
                  <a:pt x="1095" y="90"/>
                </a:lnTo>
                <a:lnTo>
                  <a:pt x="1101" y="90"/>
                </a:lnTo>
                <a:lnTo>
                  <a:pt x="1111" y="90"/>
                </a:lnTo>
                <a:lnTo>
                  <a:pt x="1117" y="88"/>
                </a:lnTo>
                <a:lnTo>
                  <a:pt x="1126" y="88"/>
                </a:lnTo>
                <a:lnTo>
                  <a:pt x="1135" y="87"/>
                </a:lnTo>
                <a:lnTo>
                  <a:pt x="1142" y="87"/>
                </a:lnTo>
                <a:lnTo>
                  <a:pt x="1152" y="87"/>
                </a:lnTo>
                <a:lnTo>
                  <a:pt x="1158" y="85"/>
                </a:lnTo>
                <a:lnTo>
                  <a:pt x="1166" y="85"/>
                </a:lnTo>
                <a:lnTo>
                  <a:pt x="1176" y="85"/>
                </a:lnTo>
                <a:lnTo>
                  <a:pt x="1183" y="83"/>
                </a:lnTo>
                <a:lnTo>
                  <a:pt x="1192" y="83"/>
                </a:lnTo>
                <a:lnTo>
                  <a:pt x="1199" y="82"/>
                </a:lnTo>
                <a:lnTo>
                  <a:pt x="1207" y="82"/>
                </a:lnTo>
                <a:lnTo>
                  <a:pt x="1217" y="82"/>
                </a:lnTo>
                <a:lnTo>
                  <a:pt x="1223" y="80"/>
                </a:lnTo>
                <a:lnTo>
                  <a:pt x="1233" y="80"/>
                </a:lnTo>
                <a:lnTo>
                  <a:pt x="1240" y="80"/>
                </a:lnTo>
                <a:lnTo>
                  <a:pt x="1248" y="79"/>
                </a:lnTo>
                <a:lnTo>
                  <a:pt x="1258" y="79"/>
                </a:lnTo>
                <a:lnTo>
                  <a:pt x="1264" y="77"/>
                </a:lnTo>
                <a:lnTo>
                  <a:pt x="1274" y="77"/>
                </a:lnTo>
                <a:lnTo>
                  <a:pt x="1281" y="77"/>
                </a:lnTo>
                <a:lnTo>
                  <a:pt x="1289" y="75"/>
                </a:lnTo>
                <a:lnTo>
                  <a:pt x="1299" y="75"/>
                </a:lnTo>
                <a:lnTo>
                  <a:pt x="1305" y="75"/>
                </a:lnTo>
                <a:lnTo>
                  <a:pt x="1315" y="74"/>
                </a:lnTo>
                <a:lnTo>
                  <a:pt x="1323" y="74"/>
                </a:lnTo>
                <a:lnTo>
                  <a:pt x="1330" y="72"/>
                </a:lnTo>
                <a:lnTo>
                  <a:pt x="1339" y="72"/>
                </a:lnTo>
                <a:lnTo>
                  <a:pt x="1346" y="72"/>
                </a:lnTo>
                <a:lnTo>
                  <a:pt x="1356" y="70"/>
                </a:lnTo>
                <a:lnTo>
                  <a:pt x="1364" y="70"/>
                </a:lnTo>
                <a:lnTo>
                  <a:pt x="1370" y="70"/>
                </a:lnTo>
                <a:lnTo>
                  <a:pt x="1380" y="69"/>
                </a:lnTo>
                <a:lnTo>
                  <a:pt x="1387" y="69"/>
                </a:lnTo>
                <a:lnTo>
                  <a:pt x="1396" y="67"/>
                </a:lnTo>
                <a:lnTo>
                  <a:pt x="1405" y="67"/>
                </a:lnTo>
                <a:lnTo>
                  <a:pt x="1411" y="67"/>
                </a:lnTo>
                <a:lnTo>
                  <a:pt x="1421" y="66"/>
                </a:lnTo>
                <a:lnTo>
                  <a:pt x="1427" y="66"/>
                </a:lnTo>
                <a:lnTo>
                  <a:pt x="1437" y="66"/>
                </a:lnTo>
                <a:lnTo>
                  <a:pt x="1445" y="64"/>
                </a:lnTo>
                <a:lnTo>
                  <a:pt x="1452" y="64"/>
                </a:lnTo>
                <a:lnTo>
                  <a:pt x="1462" y="64"/>
                </a:lnTo>
                <a:lnTo>
                  <a:pt x="1468" y="62"/>
                </a:lnTo>
                <a:lnTo>
                  <a:pt x="1478" y="62"/>
                </a:lnTo>
                <a:lnTo>
                  <a:pt x="1486" y="61"/>
                </a:lnTo>
                <a:lnTo>
                  <a:pt x="1493" y="61"/>
                </a:lnTo>
                <a:lnTo>
                  <a:pt x="1502" y="61"/>
                </a:lnTo>
                <a:lnTo>
                  <a:pt x="1509" y="59"/>
                </a:lnTo>
                <a:lnTo>
                  <a:pt x="1519" y="59"/>
                </a:lnTo>
                <a:lnTo>
                  <a:pt x="1527" y="59"/>
                </a:lnTo>
                <a:lnTo>
                  <a:pt x="1533" y="57"/>
                </a:lnTo>
                <a:lnTo>
                  <a:pt x="1543" y="57"/>
                </a:lnTo>
                <a:lnTo>
                  <a:pt x="1550" y="57"/>
                </a:lnTo>
                <a:lnTo>
                  <a:pt x="1560" y="56"/>
                </a:lnTo>
                <a:lnTo>
                  <a:pt x="1568" y="56"/>
                </a:lnTo>
                <a:lnTo>
                  <a:pt x="1574" y="54"/>
                </a:lnTo>
                <a:lnTo>
                  <a:pt x="1584" y="54"/>
                </a:lnTo>
                <a:lnTo>
                  <a:pt x="1591" y="54"/>
                </a:lnTo>
                <a:lnTo>
                  <a:pt x="1599" y="52"/>
                </a:lnTo>
                <a:lnTo>
                  <a:pt x="1609" y="52"/>
                </a:lnTo>
                <a:lnTo>
                  <a:pt x="1615" y="52"/>
                </a:lnTo>
                <a:lnTo>
                  <a:pt x="1625" y="51"/>
                </a:lnTo>
                <a:lnTo>
                  <a:pt x="1633" y="51"/>
                </a:lnTo>
                <a:lnTo>
                  <a:pt x="1640" y="51"/>
                </a:lnTo>
                <a:lnTo>
                  <a:pt x="1648" y="49"/>
                </a:lnTo>
                <a:lnTo>
                  <a:pt x="1656" y="49"/>
                </a:lnTo>
                <a:lnTo>
                  <a:pt x="1666" y="49"/>
                </a:lnTo>
                <a:lnTo>
                  <a:pt x="1674" y="48"/>
                </a:lnTo>
                <a:lnTo>
                  <a:pt x="1680" y="48"/>
                </a:lnTo>
                <a:lnTo>
                  <a:pt x="1688" y="46"/>
                </a:lnTo>
                <a:lnTo>
                  <a:pt x="1697" y="46"/>
                </a:lnTo>
                <a:lnTo>
                  <a:pt x="1706" y="46"/>
                </a:lnTo>
                <a:lnTo>
                  <a:pt x="1715" y="44"/>
                </a:lnTo>
                <a:lnTo>
                  <a:pt x="1721" y="44"/>
                </a:lnTo>
                <a:lnTo>
                  <a:pt x="1729" y="44"/>
                </a:lnTo>
                <a:lnTo>
                  <a:pt x="1739" y="43"/>
                </a:lnTo>
                <a:lnTo>
                  <a:pt x="1747" y="43"/>
                </a:lnTo>
                <a:lnTo>
                  <a:pt x="1755" y="43"/>
                </a:lnTo>
                <a:lnTo>
                  <a:pt x="1762" y="41"/>
                </a:lnTo>
                <a:lnTo>
                  <a:pt x="1770" y="41"/>
                </a:lnTo>
                <a:lnTo>
                  <a:pt x="1780" y="41"/>
                </a:lnTo>
                <a:lnTo>
                  <a:pt x="1788" y="39"/>
                </a:lnTo>
                <a:lnTo>
                  <a:pt x="1796" y="39"/>
                </a:lnTo>
                <a:lnTo>
                  <a:pt x="1803" y="39"/>
                </a:lnTo>
                <a:lnTo>
                  <a:pt x="1811" y="38"/>
                </a:lnTo>
                <a:lnTo>
                  <a:pt x="1821" y="38"/>
                </a:lnTo>
                <a:lnTo>
                  <a:pt x="1829" y="36"/>
                </a:lnTo>
                <a:lnTo>
                  <a:pt x="1835" y="36"/>
                </a:lnTo>
                <a:lnTo>
                  <a:pt x="1844" y="36"/>
                </a:lnTo>
                <a:lnTo>
                  <a:pt x="1852" y="35"/>
                </a:lnTo>
                <a:lnTo>
                  <a:pt x="1861" y="35"/>
                </a:lnTo>
                <a:lnTo>
                  <a:pt x="1870" y="35"/>
                </a:lnTo>
                <a:lnTo>
                  <a:pt x="1876" y="33"/>
                </a:lnTo>
                <a:lnTo>
                  <a:pt x="1884" y="33"/>
                </a:lnTo>
                <a:lnTo>
                  <a:pt x="1892" y="33"/>
                </a:lnTo>
                <a:lnTo>
                  <a:pt x="1902" y="31"/>
                </a:lnTo>
                <a:lnTo>
                  <a:pt x="1910" y="31"/>
                </a:lnTo>
                <a:lnTo>
                  <a:pt x="1917" y="31"/>
                </a:lnTo>
                <a:lnTo>
                  <a:pt x="1925" y="30"/>
                </a:lnTo>
                <a:lnTo>
                  <a:pt x="1933" y="30"/>
                </a:lnTo>
                <a:lnTo>
                  <a:pt x="1943" y="30"/>
                </a:lnTo>
                <a:lnTo>
                  <a:pt x="1951" y="28"/>
                </a:lnTo>
                <a:lnTo>
                  <a:pt x="1958" y="28"/>
                </a:lnTo>
                <a:lnTo>
                  <a:pt x="1966" y="28"/>
                </a:lnTo>
                <a:lnTo>
                  <a:pt x="1976" y="26"/>
                </a:lnTo>
                <a:lnTo>
                  <a:pt x="1984" y="26"/>
                </a:lnTo>
                <a:lnTo>
                  <a:pt x="1992" y="26"/>
                </a:lnTo>
                <a:lnTo>
                  <a:pt x="1999" y="25"/>
                </a:lnTo>
                <a:lnTo>
                  <a:pt x="2007" y="25"/>
                </a:lnTo>
                <a:lnTo>
                  <a:pt x="2015" y="25"/>
                </a:lnTo>
                <a:lnTo>
                  <a:pt x="2023" y="23"/>
                </a:lnTo>
                <a:lnTo>
                  <a:pt x="2033" y="23"/>
                </a:lnTo>
                <a:lnTo>
                  <a:pt x="2039" y="23"/>
                </a:lnTo>
                <a:lnTo>
                  <a:pt x="2049" y="21"/>
                </a:lnTo>
                <a:lnTo>
                  <a:pt x="2056" y="21"/>
                </a:lnTo>
                <a:lnTo>
                  <a:pt x="2065" y="21"/>
                </a:lnTo>
                <a:lnTo>
                  <a:pt x="2074" y="20"/>
                </a:lnTo>
                <a:lnTo>
                  <a:pt x="2080" y="20"/>
                </a:lnTo>
                <a:lnTo>
                  <a:pt x="2090" y="20"/>
                </a:lnTo>
                <a:lnTo>
                  <a:pt x="2096" y="18"/>
                </a:lnTo>
                <a:lnTo>
                  <a:pt x="2106" y="18"/>
                </a:lnTo>
                <a:lnTo>
                  <a:pt x="2113" y="18"/>
                </a:lnTo>
                <a:lnTo>
                  <a:pt x="2121" y="17"/>
                </a:lnTo>
                <a:lnTo>
                  <a:pt x="2131" y="17"/>
                </a:lnTo>
                <a:lnTo>
                  <a:pt x="2137" y="17"/>
                </a:lnTo>
                <a:lnTo>
                  <a:pt x="2147" y="15"/>
                </a:lnTo>
                <a:lnTo>
                  <a:pt x="2154" y="15"/>
                </a:lnTo>
                <a:lnTo>
                  <a:pt x="2163" y="15"/>
                </a:lnTo>
                <a:lnTo>
                  <a:pt x="2171" y="13"/>
                </a:lnTo>
                <a:lnTo>
                  <a:pt x="2178" y="13"/>
                </a:lnTo>
                <a:lnTo>
                  <a:pt x="2188" y="13"/>
                </a:lnTo>
                <a:lnTo>
                  <a:pt x="2194" y="12"/>
                </a:lnTo>
                <a:lnTo>
                  <a:pt x="2202" y="12"/>
                </a:lnTo>
                <a:lnTo>
                  <a:pt x="2212" y="12"/>
                </a:lnTo>
                <a:lnTo>
                  <a:pt x="2220" y="10"/>
                </a:lnTo>
                <a:lnTo>
                  <a:pt x="2229" y="10"/>
                </a:lnTo>
                <a:lnTo>
                  <a:pt x="2235" y="10"/>
                </a:lnTo>
                <a:lnTo>
                  <a:pt x="2243" y="8"/>
                </a:lnTo>
                <a:lnTo>
                  <a:pt x="2251" y="8"/>
                </a:lnTo>
                <a:lnTo>
                  <a:pt x="2261" y="8"/>
                </a:lnTo>
                <a:lnTo>
                  <a:pt x="2269" y="7"/>
                </a:lnTo>
                <a:lnTo>
                  <a:pt x="2278" y="7"/>
                </a:lnTo>
                <a:lnTo>
                  <a:pt x="2284" y="7"/>
                </a:lnTo>
                <a:lnTo>
                  <a:pt x="2292" y="5"/>
                </a:lnTo>
                <a:lnTo>
                  <a:pt x="2300" y="5"/>
                </a:lnTo>
                <a:lnTo>
                  <a:pt x="2310" y="5"/>
                </a:lnTo>
                <a:lnTo>
                  <a:pt x="2317" y="4"/>
                </a:lnTo>
                <a:lnTo>
                  <a:pt x="2326" y="4"/>
                </a:lnTo>
                <a:lnTo>
                  <a:pt x="2335" y="4"/>
                </a:lnTo>
                <a:lnTo>
                  <a:pt x="2341" y="2"/>
                </a:lnTo>
                <a:lnTo>
                  <a:pt x="2351" y="2"/>
                </a:lnTo>
                <a:lnTo>
                  <a:pt x="2357" y="2"/>
                </a:lnTo>
                <a:lnTo>
                  <a:pt x="2366" y="2"/>
                </a:lnTo>
                <a:lnTo>
                  <a:pt x="2375" y="0"/>
                </a:lnTo>
                <a:lnTo>
                  <a:pt x="2382" y="0"/>
                </a:lnTo>
                <a:lnTo>
                  <a:pt x="2390" y="7"/>
                </a:lnTo>
                <a:lnTo>
                  <a:pt x="2400" y="7"/>
                </a:lnTo>
                <a:lnTo>
                  <a:pt x="2408" y="7"/>
                </a:lnTo>
                <a:lnTo>
                  <a:pt x="2416" y="7"/>
                </a:lnTo>
                <a:lnTo>
                  <a:pt x="2424" y="7"/>
                </a:lnTo>
                <a:lnTo>
                  <a:pt x="2433" y="7"/>
                </a:lnTo>
                <a:lnTo>
                  <a:pt x="2439" y="7"/>
                </a:lnTo>
                <a:lnTo>
                  <a:pt x="2449" y="7"/>
                </a:lnTo>
                <a:lnTo>
                  <a:pt x="2455" y="7"/>
                </a:lnTo>
                <a:lnTo>
                  <a:pt x="2464" y="7"/>
                </a:lnTo>
                <a:lnTo>
                  <a:pt x="2473" y="7"/>
                </a:lnTo>
                <a:lnTo>
                  <a:pt x="2480" y="7"/>
                </a:lnTo>
                <a:lnTo>
                  <a:pt x="2490" y="7"/>
                </a:lnTo>
                <a:lnTo>
                  <a:pt x="2498" y="7"/>
                </a:lnTo>
                <a:lnTo>
                  <a:pt x="2506" y="7"/>
                </a:lnTo>
                <a:lnTo>
                  <a:pt x="2513" y="7"/>
                </a:lnTo>
                <a:lnTo>
                  <a:pt x="2521" y="7"/>
                </a:lnTo>
                <a:lnTo>
                  <a:pt x="2529" y="8"/>
                </a:lnTo>
                <a:lnTo>
                  <a:pt x="2539" y="8"/>
                </a:lnTo>
                <a:lnTo>
                  <a:pt x="2547" y="8"/>
                </a:lnTo>
                <a:lnTo>
                  <a:pt x="2555" y="8"/>
                </a:lnTo>
                <a:lnTo>
                  <a:pt x="2561" y="8"/>
                </a:lnTo>
                <a:lnTo>
                  <a:pt x="2570" y="8"/>
                </a:lnTo>
                <a:lnTo>
                  <a:pt x="2578" y="8"/>
                </a:lnTo>
                <a:lnTo>
                  <a:pt x="2588" y="8"/>
                </a:lnTo>
                <a:lnTo>
                  <a:pt x="2594" y="8"/>
                </a:lnTo>
                <a:lnTo>
                  <a:pt x="2604" y="8"/>
                </a:lnTo>
                <a:lnTo>
                  <a:pt x="2610" y="8"/>
                </a:lnTo>
                <a:lnTo>
                  <a:pt x="2620" y="8"/>
                </a:lnTo>
                <a:lnTo>
                  <a:pt x="2627" y="8"/>
                </a:lnTo>
                <a:lnTo>
                  <a:pt x="2635" y="8"/>
                </a:lnTo>
                <a:lnTo>
                  <a:pt x="2645" y="8"/>
                </a:lnTo>
                <a:lnTo>
                  <a:pt x="2651" y="8"/>
                </a:lnTo>
                <a:lnTo>
                  <a:pt x="2661" y="8"/>
                </a:lnTo>
                <a:lnTo>
                  <a:pt x="2668" y="8"/>
                </a:lnTo>
                <a:lnTo>
                  <a:pt x="2676" y="8"/>
                </a:lnTo>
                <a:lnTo>
                  <a:pt x="2685" y="8"/>
                </a:lnTo>
                <a:lnTo>
                  <a:pt x="2692" y="8"/>
                </a:lnTo>
                <a:lnTo>
                  <a:pt x="2702" y="8"/>
                </a:lnTo>
                <a:lnTo>
                  <a:pt x="2708" y="8"/>
                </a:lnTo>
                <a:lnTo>
                  <a:pt x="2718" y="8"/>
                </a:lnTo>
                <a:lnTo>
                  <a:pt x="2726" y="10"/>
                </a:lnTo>
                <a:lnTo>
                  <a:pt x="2733" y="10"/>
                </a:lnTo>
                <a:lnTo>
                  <a:pt x="2743" y="10"/>
                </a:lnTo>
                <a:lnTo>
                  <a:pt x="2749" y="10"/>
                </a:lnTo>
                <a:lnTo>
                  <a:pt x="2759" y="10"/>
                </a:lnTo>
                <a:lnTo>
                  <a:pt x="2765" y="10"/>
                </a:lnTo>
                <a:lnTo>
                  <a:pt x="2774" y="10"/>
                </a:lnTo>
                <a:lnTo>
                  <a:pt x="2783" y="10"/>
                </a:lnTo>
                <a:lnTo>
                  <a:pt x="2790" y="10"/>
                </a:lnTo>
                <a:lnTo>
                  <a:pt x="2798" y="10"/>
                </a:lnTo>
                <a:lnTo>
                  <a:pt x="2808" y="10"/>
                </a:lnTo>
                <a:lnTo>
                  <a:pt x="2816" y="10"/>
                </a:lnTo>
                <a:lnTo>
                  <a:pt x="2824" y="10"/>
                </a:lnTo>
                <a:lnTo>
                  <a:pt x="2831" y="10"/>
                </a:lnTo>
                <a:lnTo>
                  <a:pt x="2839" y="10"/>
                </a:lnTo>
                <a:lnTo>
                  <a:pt x="2849" y="10"/>
                </a:lnTo>
                <a:lnTo>
                  <a:pt x="2857" y="10"/>
                </a:lnTo>
                <a:lnTo>
                  <a:pt x="2865" y="10"/>
                </a:lnTo>
                <a:lnTo>
                  <a:pt x="2871" y="10"/>
                </a:lnTo>
                <a:lnTo>
                  <a:pt x="2880" y="10"/>
                </a:lnTo>
                <a:lnTo>
                  <a:pt x="2889" y="10"/>
                </a:lnTo>
                <a:lnTo>
                  <a:pt x="2898" y="10"/>
                </a:lnTo>
                <a:lnTo>
                  <a:pt x="2904" y="10"/>
                </a:lnTo>
                <a:lnTo>
                  <a:pt x="2912" y="10"/>
                </a:lnTo>
                <a:lnTo>
                  <a:pt x="2920" y="10"/>
                </a:lnTo>
                <a:lnTo>
                  <a:pt x="2930" y="12"/>
                </a:lnTo>
                <a:lnTo>
                  <a:pt x="2938" y="12"/>
                </a:lnTo>
                <a:lnTo>
                  <a:pt x="2945" y="12"/>
                </a:lnTo>
                <a:lnTo>
                  <a:pt x="2953" y="12"/>
                </a:lnTo>
                <a:lnTo>
                  <a:pt x="2961" y="12"/>
                </a:lnTo>
                <a:lnTo>
                  <a:pt x="2971" y="12"/>
                </a:lnTo>
                <a:lnTo>
                  <a:pt x="2979" y="12"/>
                </a:lnTo>
                <a:lnTo>
                  <a:pt x="2986" y="12"/>
                </a:lnTo>
                <a:lnTo>
                  <a:pt x="2994" y="12"/>
                </a:lnTo>
                <a:lnTo>
                  <a:pt x="3002" y="12"/>
                </a:lnTo>
                <a:lnTo>
                  <a:pt x="3012" y="12"/>
                </a:lnTo>
                <a:lnTo>
                  <a:pt x="3020" y="12"/>
                </a:lnTo>
                <a:lnTo>
                  <a:pt x="3027" y="12"/>
                </a:lnTo>
                <a:lnTo>
                  <a:pt x="3035" y="12"/>
                </a:lnTo>
                <a:lnTo>
                  <a:pt x="3044" y="12"/>
                </a:lnTo>
                <a:lnTo>
                  <a:pt x="3053" y="12"/>
                </a:lnTo>
                <a:lnTo>
                  <a:pt x="3061" y="12"/>
                </a:lnTo>
                <a:lnTo>
                  <a:pt x="3067" y="12"/>
                </a:lnTo>
                <a:lnTo>
                  <a:pt x="3075" y="12"/>
                </a:lnTo>
                <a:lnTo>
                  <a:pt x="3085" y="12"/>
                </a:lnTo>
                <a:lnTo>
                  <a:pt x="3093" y="12"/>
                </a:lnTo>
                <a:lnTo>
                  <a:pt x="3102" y="12"/>
                </a:lnTo>
                <a:lnTo>
                  <a:pt x="3108" y="12"/>
                </a:lnTo>
                <a:lnTo>
                  <a:pt x="3116" y="12"/>
                </a:lnTo>
                <a:lnTo>
                  <a:pt x="3126" y="12"/>
                </a:lnTo>
                <a:lnTo>
                  <a:pt x="3134" y="12"/>
                </a:lnTo>
                <a:lnTo>
                  <a:pt x="3142" y="13"/>
                </a:lnTo>
                <a:lnTo>
                  <a:pt x="3149" y="13"/>
                </a:lnTo>
                <a:lnTo>
                  <a:pt x="3157" y="13"/>
                </a:lnTo>
                <a:lnTo>
                  <a:pt x="3167" y="13"/>
                </a:lnTo>
                <a:lnTo>
                  <a:pt x="3173" y="13"/>
                </a:lnTo>
                <a:lnTo>
                  <a:pt x="3182" y="13"/>
                </a:lnTo>
                <a:lnTo>
                  <a:pt x="3191" y="13"/>
                </a:lnTo>
                <a:lnTo>
                  <a:pt x="3198" y="13"/>
                </a:lnTo>
                <a:lnTo>
                  <a:pt x="3208" y="13"/>
                </a:lnTo>
                <a:lnTo>
                  <a:pt x="3214" y="13"/>
                </a:lnTo>
                <a:lnTo>
                  <a:pt x="3222" y="13"/>
                </a:lnTo>
                <a:lnTo>
                  <a:pt x="3232" y="13"/>
                </a:lnTo>
                <a:lnTo>
                  <a:pt x="3239" y="13"/>
                </a:lnTo>
                <a:lnTo>
                  <a:pt x="3248" y="13"/>
                </a:lnTo>
                <a:lnTo>
                  <a:pt x="3255" y="13"/>
                </a:lnTo>
                <a:lnTo>
                  <a:pt x="3263" y="13"/>
                </a:lnTo>
                <a:lnTo>
                  <a:pt x="3273" y="13"/>
                </a:lnTo>
                <a:lnTo>
                  <a:pt x="3279" y="13"/>
                </a:lnTo>
                <a:lnTo>
                  <a:pt x="3289" y="13"/>
                </a:lnTo>
                <a:lnTo>
                  <a:pt x="3296" y="13"/>
                </a:lnTo>
                <a:lnTo>
                  <a:pt x="3304" y="13"/>
                </a:lnTo>
                <a:lnTo>
                  <a:pt x="3314" y="13"/>
                </a:lnTo>
                <a:lnTo>
                  <a:pt x="3320" y="13"/>
                </a:lnTo>
                <a:lnTo>
                  <a:pt x="3330" y="13"/>
                </a:lnTo>
                <a:lnTo>
                  <a:pt x="3337" y="13"/>
                </a:lnTo>
                <a:lnTo>
                  <a:pt x="3345" y="15"/>
                </a:lnTo>
                <a:lnTo>
                  <a:pt x="3354" y="15"/>
                </a:lnTo>
                <a:lnTo>
                  <a:pt x="3361" y="15"/>
                </a:lnTo>
                <a:lnTo>
                  <a:pt x="3371" y="15"/>
                </a:lnTo>
                <a:lnTo>
                  <a:pt x="3377" y="15"/>
                </a:lnTo>
                <a:lnTo>
                  <a:pt x="3385" y="15"/>
                </a:lnTo>
                <a:lnTo>
                  <a:pt x="3395" y="15"/>
                </a:lnTo>
                <a:lnTo>
                  <a:pt x="3402" y="15"/>
                </a:lnTo>
                <a:lnTo>
                  <a:pt x="3412" y="15"/>
                </a:lnTo>
                <a:lnTo>
                  <a:pt x="3418" y="15"/>
                </a:lnTo>
                <a:lnTo>
                  <a:pt x="3426" y="15"/>
                </a:lnTo>
                <a:lnTo>
                  <a:pt x="3436" y="15"/>
                </a:lnTo>
                <a:lnTo>
                  <a:pt x="3443" y="15"/>
                </a:lnTo>
                <a:lnTo>
                  <a:pt x="3452" y="15"/>
                </a:lnTo>
                <a:lnTo>
                  <a:pt x="3461" y="15"/>
                </a:lnTo>
                <a:lnTo>
                  <a:pt x="3467" y="15"/>
                </a:lnTo>
                <a:lnTo>
                  <a:pt x="3477" y="15"/>
                </a:lnTo>
                <a:lnTo>
                  <a:pt x="3483" y="15"/>
                </a:lnTo>
                <a:lnTo>
                  <a:pt x="3493" y="15"/>
                </a:lnTo>
                <a:lnTo>
                  <a:pt x="3501" y="15"/>
                </a:lnTo>
                <a:lnTo>
                  <a:pt x="3508" y="15"/>
                </a:lnTo>
                <a:lnTo>
                  <a:pt x="3518" y="15"/>
                </a:lnTo>
                <a:lnTo>
                  <a:pt x="3524" y="15"/>
                </a:lnTo>
                <a:lnTo>
                  <a:pt x="3534" y="15"/>
                </a:lnTo>
                <a:lnTo>
                  <a:pt x="3542" y="15"/>
                </a:lnTo>
                <a:lnTo>
                  <a:pt x="3549" y="15"/>
                </a:lnTo>
                <a:lnTo>
                  <a:pt x="3558" y="17"/>
                </a:lnTo>
                <a:lnTo>
                  <a:pt x="3565" y="17"/>
                </a:lnTo>
                <a:lnTo>
                  <a:pt x="3575" y="17"/>
                </a:lnTo>
                <a:lnTo>
                  <a:pt x="3583" y="17"/>
                </a:lnTo>
                <a:lnTo>
                  <a:pt x="3589" y="17"/>
                </a:lnTo>
                <a:lnTo>
                  <a:pt x="3599" y="17"/>
                </a:lnTo>
                <a:lnTo>
                  <a:pt x="3606" y="17"/>
                </a:lnTo>
                <a:lnTo>
                  <a:pt x="3616" y="17"/>
                </a:lnTo>
                <a:lnTo>
                  <a:pt x="3624" y="17"/>
                </a:lnTo>
                <a:lnTo>
                  <a:pt x="3630" y="17"/>
                </a:lnTo>
                <a:lnTo>
                  <a:pt x="3640" y="17"/>
                </a:lnTo>
                <a:lnTo>
                  <a:pt x="3647" y="17"/>
                </a:lnTo>
                <a:lnTo>
                  <a:pt x="3656" y="17"/>
                </a:lnTo>
                <a:lnTo>
                  <a:pt x="3665" y="17"/>
                </a:lnTo>
                <a:lnTo>
                  <a:pt x="3671" y="17"/>
                </a:lnTo>
                <a:lnTo>
                  <a:pt x="3681" y="17"/>
                </a:lnTo>
                <a:lnTo>
                  <a:pt x="3687" y="17"/>
                </a:lnTo>
                <a:lnTo>
                  <a:pt x="3696" y="17"/>
                </a:lnTo>
                <a:lnTo>
                  <a:pt x="3705" y="17"/>
                </a:lnTo>
                <a:lnTo>
                  <a:pt x="3712" y="17"/>
                </a:lnTo>
                <a:lnTo>
                  <a:pt x="3722" y="17"/>
                </a:lnTo>
                <a:lnTo>
                  <a:pt x="3728" y="17"/>
                </a:lnTo>
                <a:lnTo>
                  <a:pt x="3736" y="17"/>
                </a:lnTo>
                <a:lnTo>
                  <a:pt x="3746" y="17"/>
                </a:lnTo>
                <a:lnTo>
                  <a:pt x="3753" y="17"/>
                </a:lnTo>
                <a:lnTo>
                  <a:pt x="3762" y="17"/>
                </a:lnTo>
                <a:lnTo>
                  <a:pt x="3769" y="18"/>
                </a:lnTo>
                <a:lnTo>
                  <a:pt x="3777" y="18"/>
                </a:lnTo>
                <a:lnTo>
                  <a:pt x="3787" y="18"/>
                </a:lnTo>
                <a:lnTo>
                  <a:pt x="3793" y="18"/>
                </a:lnTo>
                <a:lnTo>
                  <a:pt x="3803" y="18"/>
                </a:lnTo>
                <a:lnTo>
                  <a:pt x="3810" y="18"/>
                </a:lnTo>
                <a:lnTo>
                  <a:pt x="3818" y="18"/>
                </a:lnTo>
                <a:lnTo>
                  <a:pt x="3828" y="18"/>
                </a:lnTo>
                <a:lnTo>
                  <a:pt x="3834" y="18"/>
                </a:lnTo>
                <a:lnTo>
                  <a:pt x="3844" y="18"/>
                </a:lnTo>
                <a:lnTo>
                  <a:pt x="3851" y="18"/>
                </a:lnTo>
                <a:lnTo>
                  <a:pt x="3859" y="18"/>
                </a:lnTo>
                <a:lnTo>
                  <a:pt x="3868" y="18"/>
                </a:lnTo>
                <a:lnTo>
                  <a:pt x="3875" y="18"/>
                </a:lnTo>
                <a:lnTo>
                  <a:pt x="3885" y="18"/>
                </a:lnTo>
                <a:lnTo>
                  <a:pt x="3891" y="18"/>
                </a:lnTo>
                <a:lnTo>
                  <a:pt x="3899" y="18"/>
                </a:lnTo>
                <a:lnTo>
                  <a:pt x="3909" y="18"/>
                </a:lnTo>
                <a:lnTo>
                  <a:pt x="3916" y="18"/>
                </a:lnTo>
                <a:lnTo>
                  <a:pt x="3926" y="18"/>
                </a:lnTo>
                <a:lnTo>
                  <a:pt x="3932" y="18"/>
                </a:lnTo>
                <a:lnTo>
                  <a:pt x="3940" y="18"/>
                </a:lnTo>
                <a:lnTo>
                  <a:pt x="3948" y="18"/>
                </a:lnTo>
                <a:lnTo>
                  <a:pt x="3957" y="18"/>
                </a:lnTo>
                <a:lnTo>
                  <a:pt x="3966" y="18"/>
                </a:lnTo>
                <a:lnTo>
                  <a:pt x="3975" y="18"/>
                </a:lnTo>
                <a:lnTo>
                  <a:pt x="3983" y="18"/>
                </a:lnTo>
                <a:lnTo>
                  <a:pt x="3989" y="20"/>
                </a:lnTo>
                <a:lnTo>
                  <a:pt x="3997" y="20"/>
                </a:lnTo>
                <a:lnTo>
                  <a:pt x="4007" y="20"/>
                </a:lnTo>
                <a:lnTo>
                  <a:pt x="4015" y="20"/>
                </a:lnTo>
                <a:lnTo>
                  <a:pt x="4023" y="20"/>
                </a:lnTo>
                <a:lnTo>
                  <a:pt x="4030" y="20"/>
                </a:lnTo>
                <a:lnTo>
                  <a:pt x="4038" y="20"/>
                </a:lnTo>
                <a:lnTo>
                  <a:pt x="4048" y="20"/>
                </a:lnTo>
                <a:lnTo>
                  <a:pt x="4056" y="20"/>
                </a:lnTo>
                <a:lnTo>
                  <a:pt x="4064" y="20"/>
                </a:lnTo>
                <a:lnTo>
                  <a:pt x="4071" y="20"/>
                </a:lnTo>
                <a:lnTo>
                  <a:pt x="4079" y="20"/>
                </a:lnTo>
                <a:lnTo>
                  <a:pt x="4089" y="20"/>
                </a:lnTo>
                <a:lnTo>
                  <a:pt x="4097" y="20"/>
                </a:lnTo>
                <a:lnTo>
                  <a:pt x="4105" y="20"/>
                </a:lnTo>
                <a:lnTo>
                  <a:pt x="4112" y="20"/>
                </a:lnTo>
                <a:lnTo>
                  <a:pt x="4120" y="20"/>
                </a:lnTo>
                <a:lnTo>
                  <a:pt x="4130" y="20"/>
                </a:lnTo>
                <a:lnTo>
                  <a:pt x="4138" y="20"/>
                </a:lnTo>
                <a:lnTo>
                  <a:pt x="4146" y="20"/>
                </a:lnTo>
                <a:lnTo>
                  <a:pt x="4152" y="20"/>
                </a:lnTo>
                <a:lnTo>
                  <a:pt x="4161" y="20"/>
                </a:lnTo>
                <a:lnTo>
                  <a:pt x="4170" y="20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104" name="Freeform 102"/>
          <p:cNvSpPr>
            <a:spLocks/>
          </p:cNvSpPr>
          <p:nvPr/>
        </p:nvSpPr>
        <p:spPr bwMode="auto">
          <a:xfrm>
            <a:off x="672307" y="4859339"/>
            <a:ext cx="6619876" cy="149225"/>
          </a:xfrm>
          <a:custGeom>
            <a:avLst/>
            <a:gdLst>
              <a:gd name="T0" fmla="*/ 67 w 4170"/>
              <a:gd name="T1" fmla="*/ 80 h 94"/>
              <a:gd name="T2" fmla="*/ 138 w 4170"/>
              <a:gd name="T3" fmla="*/ 80 h 94"/>
              <a:gd name="T4" fmla="*/ 212 w 4170"/>
              <a:gd name="T5" fmla="*/ 80 h 94"/>
              <a:gd name="T6" fmla="*/ 285 w 4170"/>
              <a:gd name="T7" fmla="*/ 80 h 94"/>
              <a:gd name="T8" fmla="*/ 360 w 4170"/>
              <a:gd name="T9" fmla="*/ 94 h 94"/>
              <a:gd name="T10" fmla="*/ 434 w 4170"/>
              <a:gd name="T11" fmla="*/ 91 h 94"/>
              <a:gd name="T12" fmla="*/ 505 w 4170"/>
              <a:gd name="T13" fmla="*/ 88 h 94"/>
              <a:gd name="T14" fmla="*/ 579 w 4170"/>
              <a:gd name="T15" fmla="*/ 84 h 94"/>
              <a:gd name="T16" fmla="*/ 654 w 4170"/>
              <a:gd name="T17" fmla="*/ 81 h 94"/>
              <a:gd name="T18" fmla="*/ 727 w 4170"/>
              <a:gd name="T19" fmla="*/ 78 h 94"/>
              <a:gd name="T20" fmla="*/ 801 w 4170"/>
              <a:gd name="T21" fmla="*/ 75 h 94"/>
              <a:gd name="T22" fmla="*/ 873 w 4170"/>
              <a:gd name="T23" fmla="*/ 71 h 94"/>
              <a:gd name="T24" fmla="*/ 948 w 4170"/>
              <a:gd name="T25" fmla="*/ 68 h 94"/>
              <a:gd name="T26" fmla="*/ 1019 w 4170"/>
              <a:gd name="T27" fmla="*/ 66 h 94"/>
              <a:gd name="T28" fmla="*/ 1095 w 4170"/>
              <a:gd name="T29" fmla="*/ 63 h 94"/>
              <a:gd name="T30" fmla="*/ 1166 w 4170"/>
              <a:gd name="T31" fmla="*/ 60 h 94"/>
              <a:gd name="T32" fmla="*/ 1240 w 4170"/>
              <a:gd name="T33" fmla="*/ 57 h 94"/>
              <a:gd name="T34" fmla="*/ 1315 w 4170"/>
              <a:gd name="T35" fmla="*/ 53 h 94"/>
              <a:gd name="T36" fmla="*/ 1387 w 4170"/>
              <a:gd name="T37" fmla="*/ 52 h 94"/>
              <a:gd name="T38" fmla="*/ 1462 w 4170"/>
              <a:gd name="T39" fmla="*/ 49 h 94"/>
              <a:gd name="T40" fmla="*/ 1533 w 4170"/>
              <a:gd name="T41" fmla="*/ 45 h 94"/>
              <a:gd name="T42" fmla="*/ 1609 w 4170"/>
              <a:gd name="T43" fmla="*/ 44 h 94"/>
              <a:gd name="T44" fmla="*/ 1680 w 4170"/>
              <a:gd name="T45" fmla="*/ 40 h 94"/>
              <a:gd name="T46" fmla="*/ 1755 w 4170"/>
              <a:gd name="T47" fmla="*/ 37 h 94"/>
              <a:gd name="T48" fmla="*/ 1829 w 4170"/>
              <a:gd name="T49" fmla="*/ 34 h 94"/>
              <a:gd name="T50" fmla="*/ 1902 w 4170"/>
              <a:gd name="T51" fmla="*/ 32 h 94"/>
              <a:gd name="T52" fmla="*/ 1976 w 4170"/>
              <a:gd name="T53" fmla="*/ 29 h 94"/>
              <a:gd name="T54" fmla="*/ 2049 w 4170"/>
              <a:gd name="T55" fmla="*/ 26 h 94"/>
              <a:gd name="T56" fmla="*/ 2121 w 4170"/>
              <a:gd name="T57" fmla="*/ 24 h 94"/>
              <a:gd name="T58" fmla="*/ 2194 w 4170"/>
              <a:gd name="T59" fmla="*/ 21 h 94"/>
              <a:gd name="T60" fmla="*/ 2269 w 4170"/>
              <a:gd name="T61" fmla="*/ 19 h 94"/>
              <a:gd name="T62" fmla="*/ 2341 w 4170"/>
              <a:gd name="T63" fmla="*/ 16 h 94"/>
              <a:gd name="T64" fmla="*/ 2416 w 4170"/>
              <a:gd name="T65" fmla="*/ 0 h 94"/>
              <a:gd name="T66" fmla="*/ 2490 w 4170"/>
              <a:gd name="T67" fmla="*/ 1 h 94"/>
              <a:gd name="T68" fmla="*/ 2561 w 4170"/>
              <a:gd name="T69" fmla="*/ 1 h 94"/>
              <a:gd name="T70" fmla="*/ 2635 w 4170"/>
              <a:gd name="T71" fmla="*/ 1 h 94"/>
              <a:gd name="T72" fmla="*/ 2708 w 4170"/>
              <a:gd name="T73" fmla="*/ 1 h 94"/>
              <a:gd name="T74" fmla="*/ 2783 w 4170"/>
              <a:gd name="T75" fmla="*/ 1 h 94"/>
              <a:gd name="T76" fmla="*/ 2857 w 4170"/>
              <a:gd name="T77" fmla="*/ 1 h 94"/>
              <a:gd name="T78" fmla="*/ 2930 w 4170"/>
              <a:gd name="T79" fmla="*/ 3 h 94"/>
              <a:gd name="T80" fmla="*/ 3002 w 4170"/>
              <a:gd name="T81" fmla="*/ 3 h 94"/>
              <a:gd name="T82" fmla="*/ 3075 w 4170"/>
              <a:gd name="T83" fmla="*/ 3 h 94"/>
              <a:gd name="T84" fmla="*/ 3149 w 4170"/>
              <a:gd name="T85" fmla="*/ 3 h 94"/>
              <a:gd name="T86" fmla="*/ 3222 w 4170"/>
              <a:gd name="T87" fmla="*/ 3 h 94"/>
              <a:gd name="T88" fmla="*/ 3296 w 4170"/>
              <a:gd name="T89" fmla="*/ 4 h 94"/>
              <a:gd name="T90" fmla="*/ 3371 w 4170"/>
              <a:gd name="T91" fmla="*/ 4 h 94"/>
              <a:gd name="T92" fmla="*/ 3443 w 4170"/>
              <a:gd name="T93" fmla="*/ 4 h 94"/>
              <a:gd name="T94" fmla="*/ 3518 w 4170"/>
              <a:gd name="T95" fmla="*/ 4 h 94"/>
              <a:gd name="T96" fmla="*/ 3589 w 4170"/>
              <a:gd name="T97" fmla="*/ 4 h 94"/>
              <a:gd name="T98" fmla="*/ 3665 w 4170"/>
              <a:gd name="T99" fmla="*/ 6 h 94"/>
              <a:gd name="T100" fmla="*/ 3736 w 4170"/>
              <a:gd name="T101" fmla="*/ 6 h 94"/>
              <a:gd name="T102" fmla="*/ 3810 w 4170"/>
              <a:gd name="T103" fmla="*/ 6 h 94"/>
              <a:gd name="T104" fmla="*/ 3885 w 4170"/>
              <a:gd name="T105" fmla="*/ 6 h 94"/>
              <a:gd name="T106" fmla="*/ 3957 w 4170"/>
              <a:gd name="T107" fmla="*/ 6 h 94"/>
              <a:gd name="T108" fmla="*/ 4030 w 4170"/>
              <a:gd name="T109" fmla="*/ 6 h 94"/>
              <a:gd name="T110" fmla="*/ 4105 w 4170"/>
              <a:gd name="T111" fmla="*/ 8 h 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170" h="94">
                <a:moveTo>
                  <a:pt x="0" y="80"/>
                </a:moveTo>
                <a:lnTo>
                  <a:pt x="8" y="80"/>
                </a:lnTo>
                <a:lnTo>
                  <a:pt x="16" y="80"/>
                </a:lnTo>
                <a:lnTo>
                  <a:pt x="26" y="80"/>
                </a:lnTo>
                <a:lnTo>
                  <a:pt x="34" y="80"/>
                </a:lnTo>
                <a:lnTo>
                  <a:pt x="40" y="80"/>
                </a:lnTo>
                <a:lnTo>
                  <a:pt x="49" y="80"/>
                </a:lnTo>
                <a:lnTo>
                  <a:pt x="57" y="80"/>
                </a:lnTo>
                <a:lnTo>
                  <a:pt x="67" y="80"/>
                </a:lnTo>
                <a:lnTo>
                  <a:pt x="75" y="80"/>
                </a:lnTo>
                <a:lnTo>
                  <a:pt x="81" y="80"/>
                </a:lnTo>
                <a:lnTo>
                  <a:pt x="89" y="80"/>
                </a:lnTo>
                <a:lnTo>
                  <a:pt x="98" y="80"/>
                </a:lnTo>
                <a:lnTo>
                  <a:pt x="107" y="80"/>
                </a:lnTo>
                <a:lnTo>
                  <a:pt x="116" y="80"/>
                </a:lnTo>
                <a:lnTo>
                  <a:pt x="122" y="80"/>
                </a:lnTo>
                <a:lnTo>
                  <a:pt x="130" y="80"/>
                </a:lnTo>
                <a:lnTo>
                  <a:pt x="138" y="80"/>
                </a:lnTo>
                <a:lnTo>
                  <a:pt x="148" y="80"/>
                </a:lnTo>
                <a:lnTo>
                  <a:pt x="156" y="80"/>
                </a:lnTo>
                <a:lnTo>
                  <a:pt x="163" y="80"/>
                </a:lnTo>
                <a:lnTo>
                  <a:pt x="171" y="80"/>
                </a:lnTo>
                <a:lnTo>
                  <a:pt x="179" y="80"/>
                </a:lnTo>
                <a:lnTo>
                  <a:pt x="189" y="80"/>
                </a:lnTo>
                <a:lnTo>
                  <a:pt x="197" y="80"/>
                </a:lnTo>
                <a:lnTo>
                  <a:pt x="204" y="80"/>
                </a:lnTo>
                <a:lnTo>
                  <a:pt x="212" y="80"/>
                </a:lnTo>
                <a:lnTo>
                  <a:pt x="220" y="80"/>
                </a:lnTo>
                <a:lnTo>
                  <a:pt x="230" y="80"/>
                </a:lnTo>
                <a:lnTo>
                  <a:pt x="238" y="80"/>
                </a:lnTo>
                <a:lnTo>
                  <a:pt x="244" y="80"/>
                </a:lnTo>
                <a:lnTo>
                  <a:pt x="253" y="80"/>
                </a:lnTo>
                <a:lnTo>
                  <a:pt x="261" y="80"/>
                </a:lnTo>
                <a:lnTo>
                  <a:pt x="271" y="80"/>
                </a:lnTo>
                <a:lnTo>
                  <a:pt x="279" y="80"/>
                </a:lnTo>
                <a:lnTo>
                  <a:pt x="285" y="80"/>
                </a:lnTo>
                <a:lnTo>
                  <a:pt x="293" y="80"/>
                </a:lnTo>
                <a:lnTo>
                  <a:pt x="302" y="80"/>
                </a:lnTo>
                <a:lnTo>
                  <a:pt x="311" y="80"/>
                </a:lnTo>
                <a:lnTo>
                  <a:pt x="319" y="80"/>
                </a:lnTo>
                <a:lnTo>
                  <a:pt x="326" y="80"/>
                </a:lnTo>
                <a:lnTo>
                  <a:pt x="334" y="80"/>
                </a:lnTo>
                <a:lnTo>
                  <a:pt x="342" y="94"/>
                </a:lnTo>
                <a:lnTo>
                  <a:pt x="352" y="94"/>
                </a:lnTo>
                <a:lnTo>
                  <a:pt x="360" y="94"/>
                </a:lnTo>
                <a:lnTo>
                  <a:pt x="367" y="93"/>
                </a:lnTo>
                <a:lnTo>
                  <a:pt x="375" y="93"/>
                </a:lnTo>
                <a:lnTo>
                  <a:pt x="383" y="93"/>
                </a:lnTo>
                <a:lnTo>
                  <a:pt x="393" y="93"/>
                </a:lnTo>
                <a:lnTo>
                  <a:pt x="401" y="91"/>
                </a:lnTo>
                <a:lnTo>
                  <a:pt x="408" y="91"/>
                </a:lnTo>
                <a:lnTo>
                  <a:pt x="416" y="91"/>
                </a:lnTo>
                <a:lnTo>
                  <a:pt x="424" y="91"/>
                </a:lnTo>
                <a:lnTo>
                  <a:pt x="434" y="91"/>
                </a:lnTo>
                <a:lnTo>
                  <a:pt x="442" y="89"/>
                </a:lnTo>
                <a:lnTo>
                  <a:pt x="448" y="89"/>
                </a:lnTo>
                <a:lnTo>
                  <a:pt x="457" y="89"/>
                </a:lnTo>
                <a:lnTo>
                  <a:pt x="465" y="89"/>
                </a:lnTo>
                <a:lnTo>
                  <a:pt x="474" y="89"/>
                </a:lnTo>
                <a:lnTo>
                  <a:pt x="483" y="88"/>
                </a:lnTo>
                <a:lnTo>
                  <a:pt x="489" y="88"/>
                </a:lnTo>
                <a:lnTo>
                  <a:pt x="497" y="88"/>
                </a:lnTo>
                <a:lnTo>
                  <a:pt x="505" y="88"/>
                </a:lnTo>
                <a:lnTo>
                  <a:pt x="515" y="86"/>
                </a:lnTo>
                <a:lnTo>
                  <a:pt x="523" y="86"/>
                </a:lnTo>
                <a:lnTo>
                  <a:pt x="532" y="86"/>
                </a:lnTo>
                <a:lnTo>
                  <a:pt x="538" y="86"/>
                </a:lnTo>
                <a:lnTo>
                  <a:pt x="546" y="86"/>
                </a:lnTo>
                <a:lnTo>
                  <a:pt x="556" y="84"/>
                </a:lnTo>
                <a:lnTo>
                  <a:pt x="564" y="84"/>
                </a:lnTo>
                <a:lnTo>
                  <a:pt x="572" y="84"/>
                </a:lnTo>
                <a:lnTo>
                  <a:pt x="579" y="84"/>
                </a:lnTo>
                <a:lnTo>
                  <a:pt x="587" y="84"/>
                </a:lnTo>
                <a:lnTo>
                  <a:pt x="597" y="83"/>
                </a:lnTo>
                <a:lnTo>
                  <a:pt x="605" y="83"/>
                </a:lnTo>
                <a:lnTo>
                  <a:pt x="613" y="83"/>
                </a:lnTo>
                <a:lnTo>
                  <a:pt x="620" y="83"/>
                </a:lnTo>
                <a:lnTo>
                  <a:pt x="628" y="81"/>
                </a:lnTo>
                <a:lnTo>
                  <a:pt x="638" y="81"/>
                </a:lnTo>
                <a:lnTo>
                  <a:pt x="646" y="81"/>
                </a:lnTo>
                <a:lnTo>
                  <a:pt x="654" y="81"/>
                </a:lnTo>
                <a:lnTo>
                  <a:pt x="661" y="81"/>
                </a:lnTo>
                <a:lnTo>
                  <a:pt x="669" y="80"/>
                </a:lnTo>
                <a:lnTo>
                  <a:pt x="678" y="80"/>
                </a:lnTo>
                <a:lnTo>
                  <a:pt x="687" y="80"/>
                </a:lnTo>
                <a:lnTo>
                  <a:pt x="695" y="80"/>
                </a:lnTo>
                <a:lnTo>
                  <a:pt x="701" y="80"/>
                </a:lnTo>
                <a:lnTo>
                  <a:pt x="709" y="78"/>
                </a:lnTo>
                <a:lnTo>
                  <a:pt x="719" y="78"/>
                </a:lnTo>
                <a:lnTo>
                  <a:pt x="727" y="78"/>
                </a:lnTo>
                <a:lnTo>
                  <a:pt x="736" y="78"/>
                </a:lnTo>
                <a:lnTo>
                  <a:pt x="742" y="78"/>
                </a:lnTo>
                <a:lnTo>
                  <a:pt x="750" y="76"/>
                </a:lnTo>
                <a:lnTo>
                  <a:pt x="760" y="76"/>
                </a:lnTo>
                <a:lnTo>
                  <a:pt x="768" y="76"/>
                </a:lnTo>
                <a:lnTo>
                  <a:pt x="776" y="76"/>
                </a:lnTo>
                <a:lnTo>
                  <a:pt x="783" y="76"/>
                </a:lnTo>
                <a:lnTo>
                  <a:pt x="791" y="75"/>
                </a:lnTo>
                <a:lnTo>
                  <a:pt x="801" y="75"/>
                </a:lnTo>
                <a:lnTo>
                  <a:pt x="809" y="75"/>
                </a:lnTo>
                <a:lnTo>
                  <a:pt x="817" y="75"/>
                </a:lnTo>
                <a:lnTo>
                  <a:pt x="824" y="75"/>
                </a:lnTo>
                <a:lnTo>
                  <a:pt x="832" y="73"/>
                </a:lnTo>
                <a:lnTo>
                  <a:pt x="842" y="73"/>
                </a:lnTo>
                <a:lnTo>
                  <a:pt x="850" y="73"/>
                </a:lnTo>
                <a:lnTo>
                  <a:pt x="856" y="73"/>
                </a:lnTo>
                <a:lnTo>
                  <a:pt x="866" y="71"/>
                </a:lnTo>
                <a:lnTo>
                  <a:pt x="873" y="71"/>
                </a:lnTo>
                <a:lnTo>
                  <a:pt x="882" y="71"/>
                </a:lnTo>
                <a:lnTo>
                  <a:pt x="891" y="71"/>
                </a:lnTo>
                <a:lnTo>
                  <a:pt x="897" y="71"/>
                </a:lnTo>
                <a:lnTo>
                  <a:pt x="907" y="70"/>
                </a:lnTo>
                <a:lnTo>
                  <a:pt x="913" y="70"/>
                </a:lnTo>
                <a:lnTo>
                  <a:pt x="923" y="70"/>
                </a:lnTo>
                <a:lnTo>
                  <a:pt x="931" y="70"/>
                </a:lnTo>
                <a:lnTo>
                  <a:pt x="938" y="70"/>
                </a:lnTo>
                <a:lnTo>
                  <a:pt x="948" y="68"/>
                </a:lnTo>
                <a:lnTo>
                  <a:pt x="954" y="68"/>
                </a:lnTo>
                <a:lnTo>
                  <a:pt x="964" y="68"/>
                </a:lnTo>
                <a:lnTo>
                  <a:pt x="972" y="68"/>
                </a:lnTo>
                <a:lnTo>
                  <a:pt x="979" y="68"/>
                </a:lnTo>
                <a:lnTo>
                  <a:pt x="988" y="66"/>
                </a:lnTo>
                <a:lnTo>
                  <a:pt x="995" y="66"/>
                </a:lnTo>
                <a:lnTo>
                  <a:pt x="1005" y="66"/>
                </a:lnTo>
                <a:lnTo>
                  <a:pt x="1013" y="66"/>
                </a:lnTo>
                <a:lnTo>
                  <a:pt x="1019" y="66"/>
                </a:lnTo>
                <a:lnTo>
                  <a:pt x="1029" y="65"/>
                </a:lnTo>
                <a:lnTo>
                  <a:pt x="1036" y="65"/>
                </a:lnTo>
                <a:lnTo>
                  <a:pt x="1044" y="65"/>
                </a:lnTo>
                <a:lnTo>
                  <a:pt x="1054" y="65"/>
                </a:lnTo>
                <a:lnTo>
                  <a:pt x="1060" y="65"/>
                </a:lnTo>
                <a:lnTo>
                  <a:pt x="1070" y="63"/>
                </a:lnTo>
                <a:lnTo>
                  <a:pt x="1077" y="63"/>
                </a:lnTo>
                <a:lnTo>
                  <a:pt x="1085" y="63"/>
                </a:lnTo>
                <a:lnTo>
                  <a:pt x="1095" y="63"/>
                </a:lnTo>
                <a:lnTo>
                  <a:pt x="1101" y="63"/>
                </a:lnTo>
                <a:lnTo>
                  <a:pt x="1111" y="62"/>
                </a:lnTo>
                <a:lnTo>
                  <a:pt x="1117" y="62"/>
                </a:lnTo>
                <a:lnTo>
                  <a:pt x="1126" y="62"/>
                </a:lnTo>
                <a:lnTo>
                  <a:pt x="1135" y="62"/>
                </a:lnTo>
                <a:lnTo>
                  <a:pt x="1142" y="62"/>
                </a:lnTo>
                <a:lnTo>
                  <a:pt x="1152" y="60"/>
                </a:lnTo>
                <a:lnTo>
                  <a:pt x="1158" y="60"/>
                </a:lnTo>
                <a:lnTo>
                  <a:pt x="1166" y="60"/>
                </a:lnTo>
                <a:lnTo>
                  <a:pt x="1176" y="60"/>
                </a:lnTo>
                <a:lnTo>
                  <a:pt x="1183" y="60"/>
                </a:lnTo>
                <a:lnTo>
                  <a:pt x="1192" y="58"/>
                </a:lnTo>
                <a:lnTo>
                  <a:pt x="1199" y="58"/>
                </a:lnTo>
                <a:lnTo>
                  <a:pt x="1207" y="58"/>
                </a:lnTo>
                <a:lnTo>
                  <a:pt x="1217" y="58"/>
                </a:lnTo>
                <a:lnTo>
                  <a:pt x="1223" y="58"/>
                </a:lnTo>
                <a:lnTo>
                  <a:pt x="1233" y="57"/>
                </a:lnTo>
                <a:lnTo>
                  <a:pt x="1240" y="57"/>
                </a:lnTo>
                <a:lnTo>
                  <a:pt x="1248" y="57"/>
                </a:lnTo>
                <a:lnTo>
                  <a:pt x="1258" y="57"/>
                </a:lnTo>
                <a:lnTo>
                  <a:pt x="1264" y="57"/>
                </a:lnTo>
                <a:lnTo>
                  <a:pt x="1274" y="55"/>
                </a:lnTo>
                <a:lnTo>
                  <a:pt x="1281" y="55"/>
                </a:lnTo>
                <a:lnTo>
                  <a:pt x="1289" y="55"/>
                </a:lnTo>
                <a:lnTo>
                  <a:pt x="1299" y="55"/>
                </a:lnTo>
                <a:lnTo>
                  <a:pt x="1305" y="55"/>
                </a:lnTo>
                <a:lnTo>
                  <a:pt x="1315" y="53"/>
                </a:lnTo>
                <a:lnTo>
                  <a:pt x="1323" y="53"/>
                </a:lnTo>
                <a:lnTo>
                  <a:pt x="1330" y="53"/>
                </a:lnTo>
                <a:lnTo>
                  <a:pt x="1339" y="53"/>
                </a:lnTo>
                <a:lnTo>
                  <a:pt x="1346" y="53"/>
                </a:lnTo>
                <a:lnTo>
                  <a:pt x="1356" y="52"/>
                </a:lnTo>
                <a:lnTo>
                  <a:pt x="1364" y="52"/>
                </a:lnTo>
                <a:lnTo>
                  <a:pt x="1370" y="52"/>
                </a:lnTo>
                <a:lnTo>
                  <a:pt x="1380" y="52"/>
                </a:lnTo>
                <a:lnTo>
                  <a:pt x="1387" y="52"/>
                </a:lnTo>
                <a:lnTo>
                  <a:pt x="1396" y="52"/>
                </a:lnTo>
                <a:lnTo>
                  <a:pt x="1405" y="50"/>
                </a:lnTo>
                <a:lnTo>
                  <a:pt x="1411" y="50"/>
                </a:lnTo>
                <a:lnTo>
                  <a:pt x="1421" y="50"/>
                </a:lnTo>
                <a:lnTo>
                  <a:pt x="1427" y="50"/>
                </a:lnTo>
                <a:lnTo>
                  <a:pt x="1437" y="50"/>
                </a:lnTo>
                <a:lnTo>
                  <a:pt x="1445" y="49"/>
                </a:lnTo>
                <a:lnTo>
                  <a:pt x="1452" y="49"/>
                </a:lnTo>
                <a:lnTo>
                  <a:pt x="1462" y="49"/>
                </a:lnTo>
                <a:lnTo>
                  <a:pt x="1468" y="49"/>
                </a:lnTo>
                <a:lnTo>
                  <a:pt x="1478" y="49"/>
                </a:lnTo>
                <a:lnTo>
                  <a:pt x="1486" y="47"/>
                </a:lnTo>
                <a:lnTo>
                  <a:pt x="1493" y="47"/>
                </a:lnTo>
                <a:lnTo>
                  <a:pt x="1502" y="47"/>
                </a:lnTo>
                <a:lnTo>
                  <a:pt x="1509" y="47"/>
                </a:lnTo>
                <a:lnTo>
                  <a:pt x="1519" y="47"/>
                </a:lnTo>
                <a:lnTo>
                  <a:pt x="1527" y="45"/>
                </a:lnTo>
                <a:lnTo>
                  <a:pt x="1533" y="45"/>
                </a:lnTo>
                <a:lnTo>
                  <a:pt x="1543" y="45"/>
                </a:lnTo>
                <a:lnTo>
                  <a:pt x="1550" y="45"/>
                </a:lnTo>
                <a:lnTo>
                  <a:pt x="1560" y="45"/>
                </a:lnTo>
                <a:lnTo>
                  <a:pt x="1568" y="44"/>
                </a:lnTo>
                <a:lnTo>
                  <a:pt x="1574" y="44"/>
                </a:lnTo>
                <a:lnTo>
                  <a:pt x="1584" y="44"/>
                </a:lnTo>
                <a:lnTo>
                  <a:pt x="1591" y="44"/>
                </a:lnTo>
                <a:lnTo>
                  <a:pt x="1599" y="44"/>
                </a:lnTo>
                <a:lnTo>
                  <a:pt x="1609" y="44"/>
                </a:lnTo>
                <a:lnTo>
                  <a:pt x="1615" y="42"/>
                </a:lnTo>
                <a:lnTo>
                  <a:pt x="1625" y="42"/>
                </a:lnTo>
                <a:lnTo>
                  <a:pt x="1633" y="42"/>
                </a:lnTo>
                <a:lnTo>
                  <a:pt x="1640" y="42"/>
                </a:lnTo>
                <a:lnTo>
                  <a:pt x="1648" y="42"/>
                </a:lnTo>
                <a:lnTo>
                  <a:pt x="1656" y="40"/>
                </a:lnTo>
                <a:lnTo>
                  <a:pt x="1666" y="40"/>
                </a:lnTo>
                <a:lnTo>
                  <a:pt x="1674" y="40"/>
                </a:lnTo>
                <a:lnTo>
                  <a:pt x="1680" y="40"/>
                </a:lnTo>
                <a:lnTo>
                  <a:pt x="1688" y="40"/>
                </a:lnTo>
                <a:lnTo>
                  <a:pt x="1697" y="39"/>
                </a:lnTo>
                <a:lnTo>
                  <a:pt x="1706" y="39"/>
                </a:lnTo>
                <a:lnTo>
                  <a:pt x="1715" y="39"/>
                </a:lnTo>
                <a:lnTo>
                  <a:pt x="1721" y="39"/>
                </a:lnTo>
                <a:lnTo>
                  <a:pt x="1729" y="39"/>
                </a:lnTo>
                <a:lnTo>
                  <a:pt x="1739" y="37"/>
                </a:lnTo>
                <a:lnTo>
                  <a:pt x="1747" y="37"/>
                </a:lnTo>
                <a:lnTo>
                  <a:pt x="1755" y="37"/>
                </a:lnTo>
                <a:lnTo>
                  <a:pt x="1762" y="37"/>
                </a:lnTo>
                <a:lnTo>
                  <a:pt x="1770" y="37"/>
                </a:lnTo>
                <a:lnTo>
                  <a:pt x="1780" y="37"/>
                </a:lnTo>
                <a:lnTo>
                  <a:pt x="1788" y="35"/>
                </a:lnTo>
                <a:lnTo>
                  <a:pt x="1796" y="35"/>
                </a:lnTo>
                <a:lnTo>
                  <a:pt x="1803" y="35"/>
                </a:lnTo>
                <a:lnTo>
                  <a:pt x="1811" y="35"/>
                </a:lnTo>
                <a:lnTo>
                  <a:pt x="1821" y="35"/>
                </a:lnTo>
                <a:lnTo>
                  <a:pt x="1829" y="34"/>
                </a:lnTo>
                <a:lnTo>
                  <a:pt x="1835" y="34"/>
                </a:lnTo>
                <a:lnTo>
                  <a:pt x="1844" y="34"/>
                </a:lnTo>
                <a:lnTo>
                  <a:pt x="1852" y="34"/>
                </a:lnTo>
                <a:lnTo>
                  <a:pt x="1861" y="34"/>
                </a:lnTo>
                <a:lnTo>
                  <a:pt x="1870" y="34"/>
                </a:lnTo>
                <a:lnTo>
                  <a:pt x="1876" y="32"/>
                </a:lnTo>
                <a:lnTo>
                  <a:pt x="1884" y="32"/>
                </a:lnTo>
                <a:lnTo>
                  <a:pt x="1892" y="32"/>
                </a:lnTo>
                <a:lnTo>
                  <a:pt x="1902" y="32"/>
                </a:lnTo>
                <a:lnTo>
                  <a:pt x="1910" y="32"/>
                </a:lnTo>
                <a:lnTo>
                  <a:pt x="1917" y="31"/>
                </a:lnTo>
                <a:lnTo>
                  <a:pt x="1925" y="31"/>
                </a:lnTo>
                <a:lnTo>
                  <a:pt x="1933" y="31"/>
                </a:lnTo>
                <a:lnTo>
                  <a:pt x="1943" y="31"/>
                </a:lnTo>
                <a:lnTo>
                  <a:pt x="1951" y="31"/>
                </a:lnTo>
                <a:lnTo>
                  <a:pt x="1958" y="29"/>
                </a:lnTo>
                <a:lnTo>
                  <a:pt x="1966" y="29"/>
                </a:lnTo>
                <a:lnTo>
                  <a:pt x="1976" y="29"/>
                </a:lnTo>
                <a:lnTo>
                  <a:pt x="1984" y="29"/>
                </a:lnTo>
                <a:lnTo>
                  <a:pt x="1992" y="29"/>
                </a:lnTo>
                <a:lnTo>
                  <a:pt x="1999" y="29"/>
                </a:lnTo>
                <a:lnTo>
                  <a:pt x="2007" y="27"/>
                </a:lnTo>
                <a:lnTo>
                  <a:pt x="2015" y="27"/>
                </a:lnTo>
                <a:lnTo>
                  <a:pt x="2023" y="27"/>
                </a:lnTo>
                <a:lnTo>
                  <a:pt x="2033" y="27"/>
                </a:lnTo>
                <a:lnTo>
                  <a:pt x="2039" y="27"/>
                </a:lnTo>
                <a:lnTo>
                  <a:pt x="2049" y="26"/>
                </a:lnTo>
                <a:lnTo>
                  <a:pt x="2056" y="26"/>
                </a:lnTo>
                <a:lnTo>
                  <a:pt x="2065" y="26"/>
                </a:lnTo>
                <a:lnTo>
                  <a:pt x="2074" y="26"/>
                </a:lnTo>
                <a:lnTo>
                  <a:pt x="2080" y="26"/>
                </a:lnTo>
                <a:lnTo>
                  <a:pt x="2090" y="26"/>
                </a:lnTo>
                <a:lnTo>
                  <a:pt x="2096" y="24"/>
                </a:lnTo>
                <a:lnTo>
                  <a:pt x="2106" y="24"/>
                </a:lnTo>
                <a:lnTo>
                  <a:pt x="2113" y="24"/>
                </a:lnTo>
                <a:lnTo>
                  <a:pt x="2121" y="24"/>
                </a:lnTo>
                <a:lnTo>
                  <a:pt x="2131" y="24"/>
                </a:lnTo>
                <a:lnTo>
                  <a:pt x="2137" y="22"/>
                </a:lnTo>
                <a:lnTo>
                  <a:pt x="2147" y="22"/>
                </a:lnTo>
                <a:lnTo>
                  <a:pt x="2154" y="22"/>
                </a:lnTo>
                <a:lnTo>
                  <a:pt x="2163" y="22"/>
                </a:lnTo>
                <a:lnTo>
                  <a:pt x="2171" y="22"/>
                </a:lnTo>
                <a:lnTo>
                  <a:pt x="2178" y="22"/>
                </a:lnTo>
                <a:lnTo>
                  <a:pt x="2188" y="21"/>
                </a:lnTo>
                <a:lnTo>
                  <a:pt x="2194" y="21"/>
                </a:lnTo>
                <a:lnTo>
                  <a:pt x="2202" y="21"/>
                </a:lnTo>
                <a:lnTo>
                  <a:pt x="2212" y="21"/>
                </a:lnTo>
                <a:lnTo>
                  <a:pt x="2220" y="21"/>
                </a:lnTo>
                <a:lnTo>
                  <a:pt x="2229" y="21"/>
                </a:lnTo>
                <a:lnTo>
                  <a:pt x="2235" y="19"/>
                </a:lnTo>
                <a:lnTo>
                  <a:pt x="2243" y="19"/>
                </a:lnTo>
                <a:lnTo>
                  <a:pt x="2251" y="19"/>
                </a:lnTo>
                <a:lnTo>
                  <a:pt x="2261" y="19"/>
                </a:lnTo>
                <a:lnTo>
                  <a:pt x="2269" y="19"/>
                </a:lnTo>
                <a:lnTo>
                  <a:pt x="2278" y="18"/>
                </a:lnTo>
                <a:lnTo>
                  <a:pt x="2284" y="18"/>
                </a:lnTo>
                <a:lnTo>
                  <a:pt x="2292" y="18"/>
                </a:lnTo>
                <a:lnTo>
                  <a:pt x="2300" y="18"/>
                </a:lnTo>
                <a:lnTo>
                  <a:pt x="2310" y="18"/>
                </a:lnTo>
                <a:lnTo>
                  <a:pt x="2317" y="18"/>
                </a:lnTo>
                <a:lnTo>
                  <a:pt x="2326" y="16"/>
                </a:lnTo>
                <a:lnTo>
                  <a:pt x="2335" y="16"/>
                </a:lnTo>
                <a:lnTo>
                  <a:pt x="2341" y="16"/>
                </a:lnTo>
                <a:lnTo>
                  <a:pt x="2351" y="16"/>
                </a:lnTo>
                <a:lnTo>
                  <a:pt x="2357" y="16"/>
                </a:lnTo>
                <a:lnTo>
                  <a:pt x="2366" y="16"/>
                </a:lnTo>
                <a:lnTo>
                  <a:pt x="2375" y="14"/>
                </a:lnTo>
                <a:lnTo>
                  <a:pt x="2382" y="14"/>
                </a:lnTo>
                <a:lnTo>
                  <a:pt x="2390" y="0"/>
                </a:lnTo>
                <a:lnTo>
                  <a:pt x="2400" y="0"/>
                </a:lnTo>
                <a:lnTo>
                  <a:pt x="2408" y="0"/>
                </a:lnTo>
                <a:lnTo>
                  <a:pt x="2416" y="0"/>
                </a:lnTo>
                <a:lnTo>
                  <a:pt x="2424" y="0"/>
                </a:lnTo>
                <a:lnTo>
                  <a:pt x="2433" y="0"/>
                </a:lnTo>
                <a:lnTo>
                  <a:pt x="2439" y="0"/>
                </a:lnTo>
                <a:lnTo>
                  <a:pt x="2449" y="0"/>
                </a:lnTo>
                <a:lnTo>
                  <a:pt x="2455" y="0"/>
                </a:lnTo>
                <a:lnTo>
                  <a:pt x="2464" y="0"/>
                </a:lnTo>
                <a:lnTo>
                  <a:pt x="2473" y="1"/>
                </a:lnTo>
                <a:lnTo>
                  <a:pt x="2480" y="1"/>
                </a:lnTo>
                <a:lnTo>
                  <a:pt x="2490" y="1"/>
                </a:lnTo>
                <a:lnTo>
                  <a:pt x="2498" y="1"/>
                </a:lnTo>
                <a:lnTo>
                  <a:pt x="2506" y="1"/>
                </a:lnTo>
                <a:lnTo>
                  <a:pt x="2513" y="1"/>
                </a:lnTo>
                <a:lnTo>
                  <a:pt x="2521" y="1"/>
                </a:lnTo>
                <a:lnTo>
                  <a:pt x="2529" y="1"/>
                </a:lnTo>
                <a:lnTo>
                  <a:pt x="2539" y="1"/>
                </a:lnTo>
                <a:lnTo>
                  <a:pt x="2547" y="1"/>
                </a:lnTo>
                <a:lnTo>
                  <a:pt x="2555" y="1"/>
                </a:lnTo>
                <a:lnTo>
                  <a:pt x="2561" y="1"/>
                </a:lnTo>
                <a:lnTo>
                  <a:pt x="2570" y="1"/>
                </a:lnTo>
                <a:lnTo>
                  <a:pt x="2578" y="1"/>
                </a:lnTo>
                <a:lnTo>
                  <a:pt x="2588" y="1"/>
                </a:lnTo>
                <a:lnTo>
                  <a:pt x="2594" y="1"/>
                </a:lnTo>
                <a:lnTo>
                  <a:pt x="2604" y="1"/>
                </a:lnTo>
                <a:lnTo>
                  <a:pt x="2610" y="1"/>
                </a:lnTo>
                <a:lnTo>
                  <a:pt x="2620" y="1"/>
                </a:lnTo>
                <a:lnTo>
                  <a:pt x="2627" y="1"/>
                </a:lnTo>
                <a:lnTo>
                  <a:pt x="2635" y="1"/>
                </a:lnTo>
                <a:lnTo>
                  <a:pt x="2645" y="1"/>
                </a:lnTo>
                <a:lnTo>
                  <a:pt x="2651" y="1"/>
                </a:lnTo>
                <a:lnTo>
                  <a:pt x="2661" y="1"/>
                </a:lnTo>
                <a:lnTo>
                  <a:pt x="2668" y="1"/>
                </a:lnTo>
                <a:lnTo>
                  <a:pt x="2676" y="1"/>
                </a:lnTo>
                <a:lnTo>
                  <a:pt x="2685" y="1"/>
                </a:lnTo>
                <a:lnTo>
                  <a:pt x="2692" y="1"/>
                </a:lnTo>
                <a:lnTo>
                  <a:pt x="2702" y="1"/>
                </a:lnTo>
                <a:lnTo>
                  <a:pt x="2708" y="1"/>
                </a:lnTo>
                <a:lnTo>
                  <a:pt x="2718" y="1"/>
                </a:lnTo>
                <a:lnTo>
                  <a:pt x="2726" y="1"/>
                </a:lnTo>
                <a:lnTo>
                  <a:pt x="2733" y="1"/>
                </a:lnTo>
                <a:lnTo>
                  <a:pt x="2743" y="1"/>
                </a:lnTo>
                <a:lnTo>
                  <a:pt x="2749" y="1"/>
                </a:lnTo>
                <a:lnTo>
                  <a:pt x="2759" y="1"/>
                </a:lnTo>
                <a:lnTo>
                  <a:pt x="2765" y="1"/>
                </a:lnTo>
                <a:lnTo>
                  <a:pt x="2774" y="1"/>
                </a:lnTo>
                <a:lnTo>
                  <a:pt x="2783" y="1"/>
                </a:lnTo>
                <a:lnTo>
                  <a:pt x="2790" y="1"/>
                </a:lnTo>
                <a:lnTo>
                  <a:pt x="2798" y="1"/>
                </a:lnTo>
                <a:lnTo>
                  <a:pt x="2808" y="1"/>
                </a:lnTo>
                <a:lnTo>
                  <a:pt x="2816" y="1"/>
                </a:lnTo>
                <a:lnTo>
                  <a:pt x="2824" y="1"/>
                </a:lnTo>
                <a:lnTo>
                  <a:pt x="2831" y="1"/>
                </a:lnTo>
                <a:lnTo>
                  <a:pt x="2839" y="1"/>
                </a:lnTo>
                <a:lnTo>
                  <a:pt x="2849" y="1"/>
                </a:lnTo>
                <a:lnTo>
                  <a:pt x="2857" y="1"/>
                </a:lnTo>
                <a:lnTo>
                  <a:pt x="2865" y="3"/>
                </a:lnTo>
                <a:lnTo>
                  <a:pt x="2871" y="3"/>
                </a:lnTo>
                <a:lnTo>
                  <a:pt x="2880" y="3"/>
                </a:lnTo>
                <a:lnTo>
                  <a:pt x="2889" y="3"/>
                </a:lnTo>
                <a:lnTo>
                  <a:pt x="2898" y="3"/>
                </a:lnTo>
                <a:lnTo>
                  <a:pt x="2904" y="3"/>
                </a:lnTo>
                <a:lnTo>
                  <a:pt x="2912" y="3"/>
                </a:lnTo>
                <a:lnTo>
                  <a:pt x="2920" y="3"/>
                </a:lnTo>
                <a:lnTo>
                  <a:pt x="2930" y="3"/>
                </a:lnTo>
                <a:lnTo>
                  <a:pt x="2938" y="3"/>
                </a:lnTo>
                <a:lnTo>
                  <a:pt x="2945" y="3"/>
                </a:lnTo>
                <a:lnTo>
                  <a:pt x="2953" y="3"/>
                </a:lnTo>
                <a:lnTo>
                  <a:pt x="2961" y="3"/>
                </a:lnTo>
                <a:lnTo>
                  <a:pt x="2971" y="3"/>
                </a:lnTo>
                <a:lnTo>
                  <a:pt x="2979" y="3"/>
                </a:lnTo>
                <a:lnTo>
                  <a:pt x="2986" y="3"/>
                </a:lnTo>
                <a:lnTo>
                  <a:pt x="2994" y="3"/>
                </a:lnTo>
                <a:lnTo>
                  <a:pt x="3002" y="3"/>
                </a:lnTo>
                <a:lnTo>
                  <a:pt x="3012" y="3"/>
                </a:lnTo>
                <a:lnTo>
                  <a:pt x="3020" y="3"/>
                </a:lnTo>
                <a:lnTo>
                  <a:pt x="3027" y="3"/>
                </a:lnTo>
                <a:lnTo>
                  <a:pt x="3035" y="3"/>
                </a:lnTo>
                <a:lnTo>
                  <a:pt x="3044" y="3"/>
                </a:lnTo>
                <a:lnTo>
                  <a:pt x="3053" y="3"/>
                </a:lnTo>
                <a:lnTo>
                  <a:pt x="3061" y="3"/>
                </a:lnTo>
                <a:lnTo>
                  <a:pt x="3067" y="3"/>
                </a:lnTo>
                <a:lnTo>
                  <a:pt x="3075" y="3"/>
                </a:lnTo>
                <a:lnTo>
                  <a:pt x="3085" y="3"/>
                </a:lnTo>
                <a:lnTo>
                  <a:pt x="3093" y="3"/>
                </a:lnTo>
                <a:lnTo>
                  <a:pt x="3102" y="3"/>
                </a:lnTo>
                <a:lnTo>
                  <a:pt x="3108" y="3"/>
                </a:lnTo>
                <a:lnTo>
                  <a:pt x="3116" y="3"/>
                </a:lnTo>
                <a:lnTo>
                  <a:pt x="3126" y="3"/>
                </a:lnTo>
                <a:lnTo>
                  <a:pt x="3134" y="3"/>
                </a:lnTo>
                <a:lnTo>
                  <a:pt x="3142" y="3"/>
                </a:lnTo>
                <a:lnTo>
                  <a:pt x="3149" y="3"/>
                </a:lnTo>
                <a:lnTo>
                  <a:pt x="3157" y="3"/>
                </a:lnTo>
                <a:lnTo>
                  <a:pt x="3167" y="3"/>
                </a:lnTo>
                <a:lnTo>
                  <a:pt x="3173" y="3"/>
                </a:lnTo>
                <a:lnTo>
                  <a:pt x="3182" y="3"/>
                </a:lnTo>
                <a:lnTo>
                  <a:pt x="3191" y="3"/>
                </a:lnTo>
                <a:lnTo>
                  <a:pt x="3198" y="3"/>
                </a:lnTo>
                <a:lnTo>
                  <a:pt x="3208" y="3"/>
                </a:lnTo>
                <a:lnTo>
                  <a:pt x="3214" y="3"/>
                </a:lnTo>
                <a:lnTo>
                  <a:pt x="3222" y="3"/>
                </a:lnTo>
                <a:lnTo>
                  <a:pt x="3232" y="3"/>
                </a:lnTo>
                <a:lnTo>
                  <a:pt x="3239" y="3"/>
                </a:lnTo>
                <a:lnTo>
                  <a:pt x="3248" y="3"/>
                </a:lnTo>
                <a:lnTo>
                  <a:pt x="3255" y="4"/>
                </a:lnTo>
                <a:lnTo>
                  <a:pt x="3263" y="4"/>
                </a:lnTo>
                <a:lnTo>
                  <a:pt x="3273" y="4"/>
                </a:lnTo>
                <a:lnTo>
                  <a:pt x="3279" y="4"/>
                </a:lnTo>
                <a:lnTo>
                  <a:pt x="3289" y="4"/>
                </a:lnTo>
                <a:lnTo>
                  <a:pt x="3296" y="4"/>
                </a:lnTo>
                <a:lnTo>
                  <a:pt x="3304" y="4"/>
                </a:lnTo>
                <a:lnTo>
                  <a:pt x="3314" y="4"/>
                </a:lnTo>
                <a:lnTo>
                  <a:pt x="3320" y="4"/>
                </a:lnTo>
                <a:lnTo>
                  <a:pt x="3330" y="4"/>
                </a:lnTo>
                <a:lnTo>
                  <a:pt x="3337" y="4"/>
                </a:lnTo>
                <a:lnTo>
                  <a:pt x="3345" y="4"/>
                </a:lnTo>
                <a:lnTo>
                  <a:pt x="3354" y="4"/>
                </a:lnTo>
                <a:lnTo>
                  <a:pt x="3361" y="4"/>
                </a:lnTo>
                <a:lnTo>
                  <a:pt x="3371" y="4"/>
                </a:lnTo>
                <a:lnTo>
                  <a:pt x="3377" y="4"/>
                </a:lnTo>
                <a:lnTo>
                  <a:pt x="3385" y="4"/>
                </a:lnTo>
                <a:lnTo>
                  <a:pt x="3395" y="4"/>
                </a:lnTo>
                <a:lnTo>
                  <a:pt x="3402" y="4"/>
                </a:lnTo>
                <a:lnTo>
                  <a:pt x="3412" y="4"/>
                </a:lnTo>
                <a:lnTo>
                  <a:pt x="3418" y="4"/>
                </a:lnTo>
                <a:lnTo>
                  <a:pt x="3426" y="4"/>
                </a:lnTo>
                <a:lnTo>
                  <a:pt x="3436" y="4"/>
                </a:lnTo>
                <a:lnTo>
                  <a:pt x="3443" y="4"/>
                </a:lnTo>
                <a:lnTo>
                  <a:pt x="3452" y="4"/>
                </a:lnTo>
                <a:lnTo>
                  <a:pt x="3461" y="4"/>
                </a:lnTo>
                <a:lnTo>
                  <a:pt x="3467" y="4"/>
                </a:lnTo>
                <a:lnTo>
                  <a:pt x="3477" y="4"/>
                </a:lnTo>
                <a:lnTo>
                  <a:pt x="3483" y="4"/>
                </a:lnTo>
                <a:lnTo>
                  <a:pt x="3493" y="4"/>
                </a:lnTo>
                <a:lnTo>
                  <a:pt x="3501" y="4"/>
                </a:lnTo>
                <a:lnTo>
                  <a:pt x="3508" y="4"/>
                </a:lnTo>
                <a:lnTo>
                  <a:pt x="3518" y="4"/>
                </a:lnTo>
                <a:lnTo>
                  <a:pt x="3524" y="4"/>
                </a:lnTo>
                <a:lnTo>
                  <a:pt x="3534" y="4"/>
                </a:lnTo>
                <a:lnTo>
                  <a:pt x="3542" y="4"/>
                </a:lnTo>
                <a:lnTo>
                  <a:pt x="3549" y="4"/>
                </a:lnTo>
                <a:lnTo>
                  <a:pt x="3558" y="4"/>
                </a:lnTo>
                <a:lnTo>
                  <a:pt x="3565" y="4"/>
                </a:lnTo>
                <a:lnTo>
                  <a:pt x="3575" y="4"/>
                </a:lnTo>
                <a:lnTo>
                  <a:pt x="3583" y="4"/>
                </a:lnTo>
                <a:lnTo>
                  <a:pt x="3589" y="4"/>
                </a:lnTo>
                <a:lnTo>
                  <a:pt x="3599" y="4"/>
                </a:lnTo>
                <a:lnTo>
                  <a:pt x="3606" y="4"/>
                </a:lnTo>
                <a:lnTo>
                  <a:pt x="3616" y="4"/>
                </a:lnTo>
                <a:lnTo>
                  <a:pt x="3624" y="4"/>
                </a:lnTo>
                <a:lnTo>
                  <a:pt x="3630" y="4"/>
                </a:lnTo>
                <a:lnTo>
                  <a:pt x="3640" y="4"/>
                </a:lnTo>
                <a:lnTo>
                  <a:pt x="3647" y="4"/>
                </a:lnTo>
                <a:lnTo>
                  <a:pt x="3656" y="4"/>
                </a:lnTo>
                <a:lnTo>
                  <a:pt x="3665" y="6"/>
                </a:lnTo>
                <a:lnTo>
                  <a:pt x="3671" y="6"/>
                </a:lnTo>
                <a:lnTo>
                  <a:pt x="3681" y="6"/>
                </a:lnTo>
                <a:lnTo>
                  <a:pt x="3687" y="6"/>
                </a:lnTo>
                <a:lnTo>
                  <a:pt x="3696" y="6"/>
                </a:lnTo>
                <a:lnTo>
                  <a:pt x="3705" y="6"/>
                </a:lnTo>
                <a:lnTo>
                  <a:pt x="3712" y="6"/>
                </a:lnTo>
                <a:lnTo>
                  <a:pt x="3722" y="6"/>
                </a:lnTo>
                <a:lnTo>
                  <a:pt x="3728" y="6"/>
                </a:lnTo>
                <a:lnTo>
                  <a:pt x="3736" y="6"/>
                </a:lnTo>
                <a:lnTo>
                  <a:pt x="3746" y="6"/>
                </a:lnTo>
                <a:lnTo>
                  <a:pt x="3753" y="6"/>
                </a:lnTo>
                <a:lnTo>
                  <a:pt x="3762" y="6"/>
                </a:lnTo>
                <a:lnTo>
                  <a:pt x="3769" y="6"/>
                </a:lnTo>
                <a:lnTo>
                  <a:pt x="3777" y="6"/>
                </a:lnTo>
                <a:lnTo>
                  <a:pt x="3787" y="6"/>
                </a:lnTo>
                <a:lnTo>
                  <a:pt x="3793" y="6"/>
                </a:lnTo>
                <a:lnTo>
                  <a:pt x="3803" y="6"/>
                </a:lnTo>
                <a:lnTo>
                  <a:pt x="3810" y="6"/>
                </a:lnTo>
                <a:lnTo>
                  <a:pt x="3818" y="6"/>
                </a:lnTo>
                <a:lnTo>
                  <a:pt x="3828" y="6"/>
                </a:lnTo>
                <a:lnTo>
                  <a:pt x="3834" y="6"/>
                </a:lnTo>
                <a:lnTo>
                  <a:pt x="3844" y="6"/>
                </a:lnTo>
                <a:lnTo>
                  <a:pt x="3851" y="6"/>
                </a:lnTo>
                <a:lnTo>
                  <a:pt x="3859" y="6"/>
                </a:lnTo>
                <a:lnTo>
                  <a:pt x="3868" y="6"/>
                </a:lnTo>
                <a:lnTo>
                  <a:pt x="3875" y="6"/>
                </a:lnTo>
                <a:lnTo>
                  <a:pt x="3885" y="6"/>
                </a:lnTo>
                <a:lnTo>
                  <a:pt x="3891" y="6"/>
                </a:lnTo>
                <a:lnTo>
                  <a:pt x="3899" y="6"/>
                </a:lnTo>
                <a:lnTo>
                  <a:pt x="3909" y="6"/>
                </a:lnTo>
                <a:lnTo>
                  <a:pt x="3916" y="6"/>
                </a:lnTo>
                <a:lnTo>
                  <a:pt x="3926" y="6"/>
                </a:lnTo>
                <a:lnTo>
                  <a:pt x="3932" y="6"/>
                </a:lnTo>
                <a:lnTo>
                  <a:pt x="3940" y="6"/>
                </a:lnTo>
                <a:lnTo>
                  <a:pt x="3948" y="6"/>
                </a:lnTo>
                <a:lnTo>
                  <a:pt x="3957" y="6"/>
                </a:lnTo>
                <a:lnTo>
                  <a:pt x="3966" y="6"/>
                </a:lnTo>
                <a:lnTo>
                  <a:pt x="3975" y="6"/>
                </a:lnTo>
                <a:lnTo>
                  <a:pt x="3983" y="6"/>
                </a:lnTo>
                <a:lnTo>
                  <a:pt x="3989" y="6"/>
                </a:lnTo>
                <a:lnTo>
                  <a:pt x="3997" y="6"/>
                </a:lnTo>
                <a:lnTo>
                  <a:pt x="4007" y="6"/>
                </a:lnTo>
                <a:lnTo>
                  <a:pt x="4015" y="6"/>
                </a:lnTo>
                <a:lnTo>
                  <a:pt x="4023" y="6"/>
                </a:lnTo>
                <a:lnTo>
                  <a:pt x="4030" y="6"/>
                </a:lnTo>
                <a:lnTo>
                  <a:pt x="4038" y="6"/>
                </a:lnTo>
                <a:lnTo>
                  <a:pt x="4048" y="6"/>
                </a:lnTo>
                <a:lnTo>
                  <a:pt x="4056" y="6"/>
                </a:lnTo>
                <a:lnTo>
                  <a:pt x="4064" y="6"/>
                </a:lnTo>
                <a:lnTo>
                  <a:pt x="4071" y="8"/>
                </a:lnTo>
                <a:lnTo>
                  <a:pt x="4079" y="8"/>
                </a:lnTo>
                <a:lnTo>
                  <a:pt x="4089" y="8"/>
                </a:lnTo>
                <a:lnTo>
                  <a:pt x="4097" y="8"/>
                </a:lnTo>
                <a:lnTo>
                  <a:pt x="4105" y="8"/>
                </a:lnTo>
                <a:lnTo>
                  <a:pt x="4112" y="8"/>
                </a:lnTo>
                <a:lnTo>
                  <a:pt x="4120" y="8"/>
                </a:lnTo>
                <a:lnTo>
                  <a:pt x="4130" y="8"/>
                </a:lnTo>
                <a:lnTo>
                  <a:pt x="4138" y="8"/>
                </a:lnTo>
                <a:lnTo>
                  <a:pt x="4146" y="8"/>
                </a:lnTo>
                <a:lnTo>
                  <a:pt x="4152" y="8"/>
                </a:lnTo>
                <a:lnTo>
                  <a:pt x="4161" y="8"/>
                </a:lnTo>
                <a:lnTo>
                  <a:pt x="4170" y="8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</p:spTree>
    <p:extLst>
      <p:ext uri="{BB962C8B-B14F-4D97-AF65-F5344CB8AC3E}">
        <p14:creationId xmlns:p14="http://schemas.microsoft.com/office/powerpoint/2010/main" val="19643382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dirty="0" smtClean="0"/>
              <a:t>Figure2B</a:t>
            </a:r>
            <a:endParaRPr lang="en-US" dirty="0"/>
          </a:p>
        </p:txBody>
      </p:sp>
      <p:grpSp>
        <p:nvGrpSpPr>
          <p:cNvPr id="163" name="Group 162"/>
          <p:cNvGrpSpPr/>
          <p:nvPr/>
        </p:nvGrpSpPr>
        <p:grpSpPr>
          <a:xfrm>
            <a:off x="527163" y="2730344"/>
            <a:ext cx="7957911" cy="3146584"/>
            <a:chOff x="343873" y="1035051"/>
            <a:chExt cx="7957911" cy="3146584"/>
          </a:xfrm>
        </p:grpSpPr>
        <p:sp>
          <p:nvSpPr>
            <p:cNvPr id="164" name="Line 12"/>
            <p:cNvSpPr>
              <a:spLocks noChangeShapeType="1"/>
            </p:cNvSpPr>
            <p:nvPr/>
          </p:nvSpPr>
          <p:spPr bwMode="auto">
            <a:xfrm flipV="1">
              <a:off x="1048544" y="1131888"/>
              <a:ext cx="15875" cy="24860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65" name="Line 13"/>
            <p:cNvSpPr>
              <a:spLocks noChangeShapeType="1"/>
            </p:cNvSpPr>
            <p:nvPr/>
          </p:nvSpPr>
          <p:spPr bwMode="auto">
            <a:xfrm flipH="1">
              <a:off x="1048544" y="3616326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66" name="Line 17"/>
            <p:cNvSpPr>
              <a:spLocks noChangeShapeType="1"/>
            </p:cNvSpPr>
            <p:nvPr/>
          </p:nvSpPr>
          <p:spPr bwMode="auto">
            <a:xfrm flipH="1">
              <a:off x="1048544" y="3625851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67" name="Line 18"/>
            <p:cNvSpPr>
              <a:spLocks noChangeShapeType="1"/>
            </p:cNvSpPr>
            <p:nvPr/>
          </p:nvSpPr>
          <p:spPr bwMode="auto">
            <a:xfrm flipH="1">
              <a:off x="1048544" y="3416301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68" name="Line 19"/>
            <p:cNvSpPr>
              <a:spLocks noChangeShapeType="1"/>
            </p:cNvSpPr>
            <p:nvPr/>
          </p:nvSpPr>
          <p:spPr bwMode="auto">
            <a:xfrm flipH="1">
              <a:off x="1048544" y="3208338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69" name="Line 20"/>
            <p:cNvSpPr>
              <a:spLocks noChangeShapeType="1"/>
            </p:cNvSpPr>
            <p:nvPr/>
          </p:nvSpPr>
          <p:spPr bwMode="auto">
            <a:xfrm flipH="1">
              <a:off x="1048544" y="3001963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0" name="Line 21"/>
            <p:cNvSpPr>
              <a:spLocks noChangeShapeType="1"/>
            </p:cNvSpPr>
            <p:nvPr/>
          </p:nvSpPr>
          <p:spPr bwMode="auto">
            <a:xfrm flipH="1">
              <a:off x="1048544" y="2794001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1" name="Line 22"/>
            <p:cNvSpPr>
              <a:spLocks noChangeShapeType="1"/>
            </p:cNvSpPr>
            <p:nvPr/>
          </p:nvSpPr>
          <p:spPr bwMode="auto">
            <a:xfrm flipH="1">
              <a:off x="1048544" y="2584451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2" name="Line 23"/>
            <p:cNvSpPr>
              <a:spLocks noChangeShapeType="1"/>
            </p:cNvSpPr>
            <p:nvPr/>
          </p:nvSpPr>
          <p:spPr bwMode="auto">
            <a:xfrm flipH="1">
              <a:off x="1048544" y="2378076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3" name="Line 24"/>
            <p:cNvSpPr>
              <a:spLocks noChangeShapeType="1"/>
            </p:cNvSpPr>
            <p:nvPr/>
          </p:nvSpPr>
          <p:spPr bwMode="auto">
            <a:xfrm flipH="1">
              <a:off x="1048544" y="2170113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4" name="Line 25"/>
            <p:cNvSpPr>
              <a:spLocks noChangeShapeType="1"/>
            </p:cNvSpPr>
            <p:nvPr/>
          </p:nvSpPr>
          <p:spPr bwMode="auto">
            <a:xfrm flipH="1">
              <a:off x="1048544" y="1963738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5" name="Line 26"/>
            <p:cNvSpPr>
              <a:spLocks noChangeShapeType="1"/>
            </p:cNvSpPr>
            <p:nvPr/>
          </p:nvSpPr>
          <p:spPr bwMode="auto">
            <a:xfrm flipH="1">
              <a:off x="1048544" y="1755776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6" name="Line 27"/>
            <p:cNvSpPr>
              <a:spLocks noChangeShapeType="1"/>
            </p:cNvSpPr>
            <p:nvPr/>
          </p:nvSpPr>
          <p:spPr bwMode="auto">
            <a:xfrm flipH="1">
              <a:off x="1048544" y="1546226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7" name="Line 28"/>
            <p:cNvSpPr>
              <a:spLocks noChangeShapeType="1"/>
            </p:cNvSpPr>
            <p:nvPr/>
          </p:nvSpPr>
          <p:spPr bwMode="auto">
            <a:xfrm flipH="1">
              <a:off x="1048544" y="1338263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8" name="Line 29"/>
            <p:cNvSpPr>
              <a:spLocks noChangeShapeType="1"/>
            </p:cNvSpPr>
            <p:nvPr/>
          </p:nvSpPr>
          <p:spPr bwMode="auto">
            <a:xfrm flipH="1">
              <a:off x="1048544" y="1131888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79" name="Line 32"/>
            <p:cNvSpPr>
              <a:spLocks noChangeShapeType="1"/>
            </p:cNvSpPr>
            <p:nvPr/>
          </p:nvSpPr>
          <p:spPr bwMode="auto">
            <a:xfrm flipH="1">
              <a:off x="1027907" y="3616326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0" name="Line 34"/>
            <p:cNvSpPr>
              <a:spLocks noChangeShapeType="1"/>
            </p:cNvSpPr>
            <p:nvPr/>
          </p:nvSpPr>
          <p:spPr bwMode="auto">
            <a:xfrm flipH="1">
              <a:off x="1027907" y="3625851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1" name="Line 35"/>
            <p:cNvSpPr>
              <a:spLocks noChangeShapeType="1"/>
            </p:cNvSpPr>
            <p:nvPr/>
          </p:nvSpPr>
          <p:spPr bwMode="auto">
            <a:xfrm flipH="1">
              <a:off x="1027907" y="3208338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2" name="Line 36"/>
            <p:cNvSpPr>
              <a:spLocks noChangeShapeType="1"/>
            </p:cNvSpPr>
            <p:nvPr/>
          </p:nvSpPr>
          <p:spPr bwMode="auto">
            <a:xfrm flipH="1">
              <a:off x="1027907" y="2794001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3" name="Line 37"/>
            <p:cNvSpPr>
              <a:spLocks noChangeShapeType="1"/>
            </p:cNvSpPr>
            <p:nvPr/>
          </p:nvSpPr>
          <p:spPr bwMode="auto">
            <a:xfrm flipH="1">
              <a:off x="1027907" y="2378076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4" name="Line 38"/>
            <p:cNvSpPr>
              <a:spLocks noChangeShapeType="1"/>
            </p:cNvSpPr>
            <p:nvPr/>
          </p:nvSpPr>
          <p:spPr bwMode="auto">
            <a:xfrm flipH="1">
              <a:off x="1027907" y="1963738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5" name="Line 39"/>
            <p:cNvSpPr>
              <a:spLocks noChangeShapeType="1"/>
            </p:cNvSpPr>
            <p:nvPr/>
          </p:nvSpPr>
          <p:spPr bwMode="auto">
            <a:xfrm flipH="1">
              <a:off x="1027907" y="1546226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6" name="Line 40"/>
            <p:cNvSpPr>
              <a:spLocks noChangeShapeType="1"/>
            </p:cNvSpPr>
            <p:nvPr/>
          </p:nvSpPr>
          <p:spPr bwMode="auto">
            <a:xfrm flipH="1">
              <a:off x="1027907" y="1131888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87" name="Rectangle 44"/>
            <p:cNvSpPr>
              <a:spLocks noChangeArrowheads="1"/>
            </p:cNvSpPr>
            <p:nvPr/>
          </p:nvSpPr>
          <p:spPr bwMode="auto">
            <a:xfrm>
              <a:off x="842169" y="3629026"/>
              <a:ext cx="25653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-5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88" name="Rectangle 45"/>
            <p:cNvSpPr>
              <a:spLocks noChangeArrowheads="1"/>
            </p:cNvSpPr>
            <p:nvPr/>
          </p:nvSpPr>
          <p:spPr bwMode="auto">
            <a:xfrm>
              <a:off x="886619" y="3117851"/>
              <a:ext cx="1026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89" name="Rectangle 46"/>
            <p:cNvSpPr>
              <a:spLocks noChangeArrowheads="1"/>
            </p:cNvSpPr>
            <p:nvPr/>
          </p:nvSpPr>
          <p:spPr bwMode="auto">
            <a:xfrm>
              <a:off x="812007" y="2697163"/>
              <a:ext cx="20528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5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90" name="Rectangle 47"/>
            <p:cNvSpPr>
              <a:spLocks noChangeArrowheads="1"/>
            </p:cNvSpPr>
            <p:nvPr/>
          </p:nvSpPr>
          <p:spPr bwMode="auto">
            <a:xfrm>
              <a:off x="707232" y="2279651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10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91" name="Rectangle 48"/>
            <p:cNvSpPr>
              <a:spLocks noChangeArrowheads="1"/>
            </p:cNvSpPr>
            <p:nvPr/>
          </p:nvSpPr>
          <p:spPr bwMode="auto">
            <a:xfrm>
              <a:off x="700882" y="1858963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15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92" name="Rectangle 49"/>
            <p:cNvSpPr>
              <a:spLocks noChangeArrowheads="1"/>
            </p:cNvSpPr>
            <p:nvPr/>
          </p:nvSpPr>
          <p:spPr bwMode="auto">
            <a:xfrm>
              <a:off x="713582" y="14430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20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93" name="Rectangle 50"/>
            <p:cNvSpPr>
              <a:spLocks noChangeArrowheads="1"/>
            </p:cNvSpPr>
            <p:nvPr/>
          </p:nvSpPr>
          <p:spPr bwMode="auto">
            <a:xfrm>
              <a:off x="700882" y="1035051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25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94" name="Line 52"/>
            <p:cNvSpPr>
              <a:spLocks noChangeShapeType="1"/>
            </p:cNvSpPr>
            <p:nvPr/>
          </p:nvSpPr>
          <p:spPr bwMode="auto">
            <a:xfrm>
              <a:off x="1064419" y="3616326"/>
              <a:ext cx="697230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95" name="Line 53"/>
            <p:cNvSpPr>
              <a:spLocks noChangeShapeType="1"/>
            </p:cNvSpPr>
            <p:nvPr/>
          </p:nvSpPr>
          <p:spPr bwMode="auto">
            <a:xfrm>
              <a:off x="106441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96" name="Line 54"/>
            <p:cNvSpPr>
              <a:spLocks noChangeShapeType="1"/>
            </p:cNvSpPr>
            <p:nvPr/>
          </p:nvSpPr>
          <p:spPr bwMode="auto">
            <a:xfrm>
              <a:off x="1499394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97" name="Line 55"/>
            <p:cNvSpPr>
              <a:spLocks noChangeShapeType="1"/>
            </p:cNvSpPr>
            <p:nvPr/>
          </p:nvSpPr>
          <p:spPr bwMode="auto">
            <a:xfrm>
              <a:off x="193436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98" name="Line 56"/>
            <p:cNvSpPr>
              <a:spLocks noChangeShapeType="1"/>
            </p:cNvSpPr>
            <p:nvPr/>
          </p:nvSpPr>
          <p:spPr bwMode="auto">
            <a:xfrm>
              <a:off x="2369344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99" name="Line 57"/>
            <p:cNvSpPr>
              <a:spLocks noChangeShapeType="1"/>
            </p:cNvSpPr>
            <p:nvPr/>
          </p:nvSpPr>
          <p:spPr bwMode="auto">
            <a:xfrm>
              <a:off x="2807494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0" name="Line 58"/>
            <p:cNvSpPr>
              <a:spLocks noChangeShapeType="1"/>
            </p:cNvSpPr>
            <p:nvPr/>
          </p:nvSpPr>
          <p:spPr bwMode="auto">
            <a:xfrm>
              <a:off x="324246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1" name="Line 59"/>
            <p:cNvSpPr>
              <a:spLocks noChangeShapeType="1"/>
            </p:cNvSpPr>
            <p:nvPr/>
          </p:nvSpPr>
          <p:spPr bwMode="auto">
            <a:xfrm>
              <a:off x="3677444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2" name="Line 60"/>
            <p:cNvSpPr>
              <a:spLocks noChangeShapeType="1"/>
            </p:cNvSpPr>
            <p:nvPr/>
          </p:nvSpPr>
          <p:spPr bwMode="auto">
            <a:xfrm>
              <a:off x="411241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3" name="Line 61"/>
            <p:cNvSpPr>
              <a:spLocks noChangeShapeType="1"/>
            </p:cNvSpPr>
            <p:nvPr/>
          </p:nvSpPr>
          <p:spPr bwMode="auto">
            <a:xfrm>
              <a:off x="455056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4" name="Line 62"/>
            <p:cNvSpPr>
              <a:spLocks noChangeShapeType="1"/>
            </p:cNvSpPr>
            <p:nvPr/>
          </p:nvSpPr>
          <p:spPr bwMode="auto">
            <a:xfrm>
              <a:off x="4985544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5" name="Line 63"/>
            <p:cNvSpPr>
              <a:spLocks noChangeShapeType="1"/>
            </p:cNvSpPr>
            <p:nvPr/>
          </p:nvSpPr>
          <p:spPr bwMode="auto">
            <a:xfrm>
              <a:off x="542051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6" name="Line 64"/>
            <p:cNvSpPr>
              <a:spLocks noChangeShapeType="1"/>
            </p:cNvSpPr>
            <p:nvPr/>
          </p:nvSpPr>
          <p:spPr bwMode="auto">
            <a:xfrm>
              <a:off x="585866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7" name="Line 65"/>
            <p:cNvSpPr>
              <a:spLocks noChangeShapeType="1"/>
            </p:cNvSpPr>
            <p:nvPr/>
          </p:nvSpPr>
          <p:spPr bwMode="auto">
            <a:xfrm>
              <a:off x="6293644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8" name="Line 66"/>
            <p:cNvSpPr>
              <a:spLocks noChangeShapeType="1"/>
            </p:cNvSpPr>
            <p:nvPr/>
          </p:nvSpPr>
          <p:spPr bwMode="auto">
            <a:xfrm>
              <a:off x="672861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09" name="Line 67"/>
            <p:cNvSpPr>
              <a:spLocks noChangeShapeType="1"/>
            </p:cNvSpPr>
            <p:nvPr/>
          </p:nvSpPr>
          <p:spPr bwMode="auto">
            <a:xfrm>
              <a:off x="7165182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0" name="Line 68"/>
            <p:cNvSpPr>
              <a:spLocks noChangeShapeType="1"/>
            </p:cNvSpPr>
            <p:nvPr/>
          </p:nvSpPr>
          <p:spPr bwMode="auto">
            <a:xfrm>
              <a:off x="7601744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1" name="Line 69"/>
            <p:cNvSpPr>
              <a:spLocks noChangeShapeType="1"/>
            </p:cNvSpPr>
            <p:nvPr/>
          </p:nvSpPr>
          <p:spPr bwMode="auto">
            <a:xfrm>
              <a:off x="8036719" y="3611563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2" name="Line 72"/>
            <p:cNvSpPr>
              <a:spLocks noChangeShapeType="1"/>
            </p:cNvSpPr>
            <p:nvPr/>
          </p:nvSpPr>
          <p:spPr bwMode="auto">
            <a:xfrm>
              <a:off x="1064419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3" name="Line 73"/>
            <p:cNvSpPr>
              <a:spLocks noChangeShapeType="1"/>
            </p:cNvSpPr>
            <p:nvPr/>
          </p:nvSpPr>
          <p:spPr bwMode="auto">
            <a:xfrm>
              <a:off x="1934369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4" name="Line 74"/>
            <p:cNvSpPr>
              <a:spLocks noChangeShapeType="1"/>
            </p:cNvSpPr>
            <p:nvPr/>
          </p:nvSpPr>
          <p:spPr bwMode="auto">
            <a:xfrm>
              <a:off x="2807494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5" name="Line 75"/>
            <p:cNvSpPr>
              <a:spLocks noChangeShapeType="1"/>
            </p:cNvSpPr>
            <p:nvPr/>
          </p:nvSpPr>
          <p:spPr bwMode="auto">
            <a:xfrm>
              <a:off x="3677444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6" name="Line 76"/>
            <p:cNvSpPr>
              <a:spLocks noChangeShapeType="1"/>
            </p:cNvSpPr>
            <p:nvPr/>
          </p:nvSpPr>
          <p:spPr bwMode="auto">
            <a:xfrm>
              <a:off x="4550569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7" name="Line 77"/>
            <p:cNvSpPr>
              <a:spLocks noChangeShapeType="1"/>
            </p:cNvSpPr>
            <p:nvPr/>
          </p:nvSpPr>
          <p:spPr bwMode="auto">
            <a:xfrm>
              <a:off x="5420519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8" name="Line 78"/>
            <p:cNvSpPr>
              <a:spLocks noChangeShapeType="1"/>
            </p:cNvSpPr>
            <p:nvPr/>
          </p:nvSpPr>
          <p:spPr bwMode="auto">
            <a:xfrm>
              <a:off x="6293644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19" name="Line 79"/>
            <p:cNvSpPr>
              <a:spLocks noChangeShapeType="1"/>
            </p:cNvSpPr>
            <p:nvPr/>
          </p:nvSpPr>
          <p:spPr bwMode="auto">
            <a:xfrm>
              <a:off x="7165182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20" name="Line 80"/>
            <p:cNvSpPr>
              <a:spLocks noChangeShapeType="1"/>
            </p:cNvSpPr>
            <p:nvPr/>
          </p:nvSpPr>
          <p:spPr bwMode="auto">
            <a:xfrm>
              <a:off x="8036719" y="3600451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21" name="Rectangle 83"/>
            <p:cNvSpPr>
              <a:spLocks noChangeArrowheads="1"/>
            </p:cNvSpPr>
            <p:nvPr/>
          </p:nvSpPr>
          <p:spPr bwMode="auto">
            <a:xfrm>
              <a:off x="1921669" y="3678238"/>
              <a:ext cx="1026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2" name="Rectangle 84"/>
            <p:cNvSpPr>
              <a:spLocks noChangeArrowheads="1"/>
            </p:cNvSpPr>
            <p:nvPr/>
          </p:nvSpPr>
          <p:spPr bwMode="auto">
            <a:xfrm>
              <a:off x="2778919" y="3678238"/>
              <a:ext cx="20528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5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3" name="Rectangle 85"/>
            <p:cNvSpPr>
              <a:spLocks noChangeArrowheads="1"/>
            </p:cNvSpPr>
            <p:nvPr/>
          </p:nvSpPr>
          <p:spPr bwMode="auto">
            <a:xfrm>
              <a:off x="3632994" y="36782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10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4" name="Rectangle 86"/>
            <p:cNvSpPr>
              <a:spLocks noChangeArrowheads="1"/>
            </p:cNvSpPr>
            <p:nvPr/>
          </p:nvSpPr>
          <p:spPr bwMode="auto">
            <a:xfrm>
              <a:off x="4506119" y="36782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15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5" name="Rectangle 87"/>
            <p:cNvSpPr>
              <a:spLocks noChangeArrowheads="1"/>
            </p:cNvSpPr>
            <p:nvPr/>
          </p:nvSpPr>
          <p:spPr bwMode="auto">
            <a:xfrm>
              <a:off x="5377657" y="36782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20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6" name="Rectangle 88"/>
            <p:cNvSpPr>
              <a:spLocks noChangeArrowheads="1"/>
            </p:cNvSpPr>
            <p:nvPr/>
          </p:nvSpPr>
          <p:spPr bwMode="auto">
            <a:xfrm>
              <a:off x="6250782" y="36782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25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7" name="Rectangle 89"/>
            <p:cNvSpPr>
              <a:spLocks noChangeArrowheads="1"/>
            </p:cNvSpPr>
            <p:nvPr/>
          </p:nvSpPr>
          <p:spPr bwMode="auto">
            <a:xfrm>
              <a:off x="7120732" y="36782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30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8" name="Rectangle 90"/>
            <p:cNvSpPr>
              <a:spLocks noChangeArrowheads="1"/>
            </p:cNvSpPr>
            <p:nvPr/>
          </p:nvSpPr>
          <p:spPr bwMode="auto">
            <a:xfrm>
              <a:off x="7993857" y="36782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35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229" name="Rectangle 94"/>
            <p:cNvSpPr>
              <a:spLocks noChangeArrowheads="1"/>
            </p:cNvSpPr>
            <p:nvPr/>
          </p:nvSpPr>
          <p:spPr bwMode="auto">
            <a:xfrm rot="16200000">
              <a:off x="-355307" y="2134465"/>
              <a:ext cx="164458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600" b="1" dirty="0" smtClean="0">
                  <a:solidFill>
                    <a:srgbClr val="000000"/>
                  </a:solidFill>
                  <a:latin typeface="Arial Black"/>
                  <a:cs typeface="Arial Black"/>
                </a:rPr>
                <a:t>Response (RU)</a:t>
              </a:r>
              <a:endParaRPr lang="es-ES" sz="1600" dirty="0">
                <a:latin typeface="Arial Black"/>
                <a:cs typeface="Arial Black"/>
              </a:endParaRPr>
            </a:p>
          </p:txBody>
        </p:sp>
        <p:sp>
          <p:nvSpPr>
            <p:cNvPr id="230" name="Rectangle 96"/>
            <p:cNvSpPr>
              <a:spLocks noChangeArrowheads="1"/>
            </p:cNvSpPr>
            <p:nvPr/>
          </p:nvSpPr>
          <p:spPr bwMode="auto">
            <a:xfrm>
              <a:off x="4285457" y="3935414"/>
              <a:ext cx="118572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600" b="1" dirty="0" smtClean="0">
                  <a:solidFill>
                    <a:srgbClr val="000000"/>
                  </a:solidFill>
                  <a:latin typeface="Arial Black"/>
                  <a:cs typeface="Arial Black"/>
                </a:rPr>
                <a:t>Time (</a:t>
              </a:r>
              <a:r>
                <a:rPr lang="es-ES" sz="1600" b="1" dirty="0" err="1" smtClean="0">
                  <a:solidFill>
                    <a:srgbClr val="000000"/>
                  </a:solidFill>
                  <a:latin typeface="Arial Black"/>
                  <a:cs typeface="Arial Black"/>
                </a:rPr>
                <a:t>sec</a:t>
              </a:r>
              <a:r>
                <a:rPr lang="es-ES" sz="1600" b="1" dirty="0" smtClean="0">
                  <a:solidFill>
                    <a:srgbClr val="000000"/>
                  </a:solidFill>
                  <a:latin typeface="Arial Black"/>
                  <a:cs typeface="Arial Black"/>
                </a:rPr>
                <a:t>)</a:t>
              </a:r>
              <a:endParaRPr lang="es-ES" sz="1600" dirty="0">
                <a:latin typeface="Arial Black"/>
                <a:cs typeface="Arial Black"/>
              </a:endParaRPr>
            </a:p>
          </p:txBody>
        </p:sp>
        <p:sp>
          <p:nvSpPr>
            <p:cNvPr id="231" name="Freeform 97"/>
            <p:cNvSpPr>
              <a:spLocks/>
            </p:cNvSpPr>
            <p:nvPr/>
          </p:nvSpPr>
          <p:spPr bwMode="auto">
            <a:xfrm>
              <a:off x="1447007" y="1763713"/>
              <a:ext cx="6715125" cy="1903413"/>
            </a:xfrm>
            <a:custGeom>
              <a:avLst/>
              <a:gdLst>
                <a:gd name="T0" fmla="*/ 66 w 4230"/>
                <a:gd name="T1" fmla="*/ 912 h 1199"/>
                <a:gd name="T2" fmla="*/ 142 w 4230"/>
                <a:gd name="T3" fmla="*/ 910 h 1199"/>
                <a:gd name="T4" fmla="*/ 219 w 4230"/>
                <a:gd name="T5" fmla="*/ 907 h 1199"/>
                <a:gd name="T6" fmla="*/ 296 w 4230"/>
                <a:gd name="T7" fmla="*/ 892 h 1199"/>
                <a:gd name="T8" fmla="*/ 374 w 4230"/>
                <a:gd name="T9" fmla="*/ 788 h 1199"/>
                <a:gd name="T10" fmla="*/ 451 w 4230"/>
                <a:gd name="T11" fmla="*/ 679 h 1199"/>
                <a:gd name="T12" fmla="*/ 527 w 4230"/>
                <a:gd name="T13" fmla="*/ 599 h 1199"/>
                <a:gd name="T14" fmla="*/ 604 w 4230"/>
                <a:gd name="T15" fmla="*/ 532 h 1199"/>
                <a:gd name="T16" fmla="*/ 681 w 4230"/>
                <a:gd name="T17" fmla="*/ 480 h 1199"/>
                <a:gd name="T18" fmla="*/ 757 w 4230"/>
                <a:gd name="T19" fmla="*/ 435 h 1199"/>
                <a:gd name="T20" fmla="*/ 834 w 4230"/>
                <a:gd name="T21" fmla="*/ 398 h 1199"/>
                <a:gd name="T22" fmla="*/ 912 w 4230"/>
                <a:gd name="T23" fmla="*/ 364 h 1199"/>
                <a:gd name="T24" fmla="*/ 989 w 4230"/>
                <a:gd name="T25" fmla="*/ 331 h 1199"/>
                <a:gd name="T26" fmla="*/ 1066 w 4230"/>
                <a:gd name="T27" fmla="*/ 305 h 1199"/>
                <a:gd name="T28" fmla="*/ 1143 w 4230"/>
                <a:gd name="T29" fmla="*/ 277 h 1199"/>
                <a:gd name="T30" fmla="*/ 1219 w 4230"/>
                <a:gd name="T31" fmla="*/ 251 h 1199"/>
                <a:gd name="T32" fmla="*/ 1296 w 4230"/>
                <a:gd name="T33" fmla="*/ 228 h 1199"/>
                <a:gd name="T34" fmla="*/ 1373 w 4230"/>
                <a:gd name="T35" fmla="*/ 202 h 1199"/>
                <a:gd name="T36" fmla="*/ 1449 w 4230"/>
                <a:gd name="T37" fmla="*/ 179 h 1199"/>
                <a:gd name="T38" fmla="*/ 1528 w 4230"/>
                <a:gd name="T39" fmla="*/ 160 h 1199"/>
                <a:gd name="T40" fmla="*/ 1604 w 4230"/>
                <a:gd name="T41" fmla="*/ 139 h 1199"/>
                <a:gd name="T42" fmla="*/ 1681 w 4230"/>
                <a:gd name="T43" fmla="*/ 119 h 1199"/>
                <a:gd name="T44" fmla="*/ 1758 w 4230"/>
                <a:gd name="T45" fmla="*/ 101 h 1199"/>
                <a:gd name="T46" fmla="*/ 1834 w 4230"/>
                <a:gd name="T47" fmla="*/ 80 h 1199"/>
                <a:gd name="T48" fmla="*/ 1911 w 4230"/>
                <a:gd name="T49" fmla="*/ 60 h 1199"/>
                <a:gd name="T50" fmla="*/ 1988 w 4230"/>
                <a:gd name="T51" fmla="*/ 44 h 1199"/>
                <a:gd name="T52" fmla="*/ 2066 w 4230"/>
                <a:gd name="T53" fmla="*/ 29 h 1199"/>
                <a:gd name="T54" fmla="*/ 2143 w 4230"/>
                <a:gd name="T55" fmla="*/ 13 h 1199"/>
                <a:gd name="T56" fmla="*/ 2219 w 4230"/>
                <a:gd name="T57" fmla="*/ 8 h 1199"/>
                <a:gd name="T58" fmla="*/ 2296 w 4230"/>
                <a:gd name="T59" fmla="*/ 28 h 1199"/>
                <a:gd name="T60" fmla="*/ 2373 w 4230"/>
                <a:gd name="T61" fmla="*/ 47 h 1199"/>
                <a:gd name="T62" fmla="*/ 2450 w 4230"/>
                <a:gd name="T63" fmla="*/ 59 h 1199"/>
                <a:gd name="T64" fmla="*/ 2526 w 4230"/>
                <a:gd name="T65" fmla="*/ 65 h 1199"/>
                <a:gd name="T66" fmla="*/ 2603 w 4230"/>
                <a:gd name="T67" fmla="*/ 75 h 1199"/>
                <a:gd name="T68" fmla="*/ 2681 w 4230"/>
                <a:gd name="T69" fmla="*/ 83 h 1199"/>
                <a:gd name="T70" fmla="*/ 2758 w 4230"/>
                <a:gd name="T71" fmla="*/ 83 h 1199"/>
                <a:gd name="T72" fmla="*/ 2835 w 4230"/>
                <a:gd name="T73" fmla="*/ 86 h 1199"/>
                <a:gd name="T74" fmla="*/ 2911 w 4230"/>
                <a:gd name="T75" fmla="*/ 86 h 1199"/>
                <a:gd name="T76" fmla="*/ 2988 w 4230"/>
                <a:gd name="T77" fmla="*/ 86 h 1199"/>
                <a:gd name="T78" fmla="*/ 3065 w 4230"/>
                <a:gd name="T79" fmla="*/ 88 h 1199"/>
                <a:gd name="T80" fmla="*/ 3141 w 4230"/>
                <a:gd name="T81" fmla="*/ 88 h 1199"/>
                <a:gd name="T82" fmla="*/ 3220 w 4230"/>
                <a:gd name="T83" fmla="*/ 88 h 1199"/>
                <a:gd name="T84" fmla="*/ 3296 w 4230"/>
                <a:gd name="T85" fmla="*/ 86 h 1199"/>
                <a:gd name="T86" fmla="*/ 3373 w 4230"/>
                <a:gd name="T87" fmla="*/ 83 h 1199"/>
                <a:gd name="T88" fmla="*/ 3450 w 4230"/>
                <a:gd name="T89" fmla="*/ 83 h 1199"/>
                <a:gd name="T90" fmla="*/ 3526 w 4230"/>
                <a:gd name="T91" fmla="*/ 80 h 1199"/>
                <a:gd name="T92" fmla="*/ 3603 w 4230"/>
                <a:gd name="T93" fmla="*/ 78 h 1199"/>
                <a:gd name="T94" fmla="*/ 3680 w 4230"/>
                <a:gd name="T95" fmla="*/ 77 h 1199"/>
                <a:gd name="T96" fmla="*/ 3757 w 4230"/>
                <a:gd name="T97" fmla="*/ 75 h 1199"/>
                <a:gd name="T98" fmla="*/ 3835 w 4230"/>
                <a:gd name="T99" fmla="*/ 77 h 1199"/>
                <a:gd name="T100" fmla="*/ 3912 w 4230"/>
                <a:gd name="T101" fmla="*/ 73 h 1199"/>
                <a:gd name="T102" fmla="*/ 3988 w 4230"/>
                <a:gd name="T103" fmla="*/ 83 h 1199"/>
                <a:gd name="T104" fmla="*/ 4065 w 4230"/>
                <a:gd name="T105" fmla="*/ 77 h 1199"/>
                <a:gd name="T106" fmla="*/ 4142 w 4230"/>
                <a:gd name="T107" fmla="*/ 75 h 1199"/>
                <a:gd name="T108" fmla="*/ 4218 w 4230"/>
                <a:gd name="T109" fmla="*/ 75 h 1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230" h="1199">
                  <a:moveTo>
                    <a:pt x="0" y="913"/>
                  </a:moveTo>
                  <a:lnTo>
                    <a:pt x="10" y="913"/>
                  </a:lnTo>
                  <a:lnTo>
                    <a:pt x="22" y="913"/>
                  </a:lnTo>
                  <a:lnTo>
                    <a:pt x="33" y="913"/>
                  </a:lnTo>
                  <a:lnTo>
                    <a:pt x="44" y="913"/>
                  </a:lnTo>
                  <a:lnTo>
                    <a:pt x="54" y="913"/>
                  </a:lnTo>
                  <a:lnTo>
                    <a:pt x="66" y="912"/>
                  </a:lnTo>
                  <a:lnTo>
                    <a:pt x="77" y="910"/>
                  </a:lnTo>
                  <a:lnTo>
                    <a:pt x="88" y="909"/>
                  </a:lnTo>
                  <a:lnTo>
                    <a:pt x="98" y="910"/>
                  </a:lnTo>
                  <a:lnTo>
                    <a:pt x="110" y="909"/>
                  </a:lnTo>
                  <a:lnTo>
                    <a:pt x="121" y="910"/>
                  </a:lnTo>
                  <a:lnTo>
                    <a:pt x="131" y="912"/>
                  </a:lnTo>
                  <a:lnTo>
                    <a:pt x="142" y="910"/>
                  </a:lnTo>
                  <a:lnTo>
                    <a:pt x="154" y="909"/>
                  </a:lnTo>
                  <a:lnTo>
                    <a:pt x="165" y="909"/>
                  </a:lnTo>
                  <a:lnTo>
                    <a:pt x="175" y="909"/>
                  </a:lnTo>
                  <a:lnTo>
                    <a:pt x="186" y="907"/>
                  </a:lnTo>
                  <a:lnTo>
                    <a:pt x="198" y="907"/>
                  </a:lnTo>
                  <a:lnTo>
                    <a:pt x="209" y="907"/>
                  </a:lnTo>
                  <a:lnTo>
                    <a:pt x="219" y="907"/>
                  </a:lnTo>
                  <a:lnTo>
                    <a:pt x="230" y="900"/>
                  </a:lnTo>
                  <a:lnTo>
                    <a:pt x="242" y="892"/>
                  </a:lnTo>
                  <a:lnTo>
                    <a:pt x="253" y="900"/>
                  </a:lnTo>
                  <a:lnTo>
                    <a:pt x="263" y="909"/>
                  </a:lnTo>
                  <a:lnTo>
                    <a:pt x="274" y="669"/>
                  </a:lnTo>
                  <a:lnTo>
                    <a:pt x="286" y="178"/>
                  </a:lnTo>
                  <a:lnTo>
                    <a:pt x="296" y="892"/>
                  </a:lnTo>
                  <a:lnTo>
                    <a:pt x="307" y="1199"/>
                  </a:lnTo>
                  <a:lnTo>
                    <a:pt x="318" y="1077"/>
                  </a:lnTo>
                  <a:lnTo>
                    <a:pt x="330" y="953"/>
                  </a:lnTo>
                  <a:lnTo>
                    <a:pt x="340" y="881"/>
                  </a:lnTo>
                  <a:lnTo>
                    <a:pt x="351" y="838"/>
                  </a:lnTo>
                  <a:lnTo>
                    <a:pt x="363" y="811"/>
                  </a:lnTo>
                  <a:lnTo>
                    <a:pt x="374" y="788"/>
                  </a:lnTo>
                  <a:lnTo>
                    <a:pt x="384" y="770"/>
                  </a:lnTo>
                  <a:lnTo>
                    <a:pt x="395" y="754"/>
                  </a:lnTo>
                  <a:lnTo>
                    <a:pt x="407" y="737"/>
                  </a:lnTo>
                  <a:lnTo>
                    <a:pt x="418" y="721"/>
                  </a:lnTo>
                  <a:lnTo>
                    <a:pt x="428" y="708"/>
                  </a:lnTo>
                  <a:lnTo>
                    <a:pt x="439" y="693"/>
                  </a:lnTo>
                  <a:lnTo>
                    <a:pt x="451" y="679"/>
                  </a:lnTo>
                  <a:lnTo>
                    <a:pt x="460" y="667"/>
                  </a:lnTo>
                  <a:lnTo>
                    <a:pt x="472" y="652"/>
                  </a:lnTo>
                  <a:lnTo>
                    <a:pt x="483" y="641"/>
                  </a:lnTo>
                  <a:lnTo>
                    <a:pt x="495" y="630"/>
                  </a:lnTo>
                  <a:lnTo>
                    <a:pt x="505" y="618"/>
                  </a:lnTo>
                  <a:lnTo>
                    <a:pt x="516" y="607"/>
                  </a:lnTo>
                  <a:lnTo>
                    <a:pt x="527" y="599"/>
                  </a:lnTo>
                  <a:lnTo>
                    <a:pt x="539" y="587"/>
                  </a:lnTo>
                  <a:lnTo>
                    <a:pt x="549" y="579"/>
                  </a:lnTo>
                  <a:lnTo>
                    <a:pt x="560" y="568"/>
                  </a:lnTo>
                  <a:lnTo>
                    <a:pt x="571" y="558"/>
                  </a:lnTo>
                  <a:lnTo>
                    <a:pt x="583" y="550"/>
                  </a:lnTo>
                  <a:lnTo>
                    <a:pt x="593" y="542"/>
                  </a:lnTo>
                  <a:lnTo>
                    <a:pt x="604" y="532"/>
                  </a:lnTo>
                  <a:lnTo>
                    <a:pt x="615" y="525"/>
                  </a:lnTo>
                  <a:lnTo>
                    <a:pt x="625" y="517"/>
                  </a:lnTo>
                  <a:lnTo>
                    <a:pt x="637" y="509"/>
                  </a:lnTo>
                  <a:lnTo>
                    <a:pt x="648" y="501"/>
                  </a:lnTo>
                  <a:lnTo>
                    <a:pt x="660" y="494"/>
                  </a:lnTo>
                  <a:lnTo>
                    <a:pt x="669" y="486"/>
                  </a:lnTo>
                  <a:lnTo>
                    <a:pt x="681" y="480"/>
                  </a:lnTo>
                  <a:lnTo>
                    <a:pt x="692" y="473"/>
                  </a:lnTo>
                  <a:lnTo>
                    <a:pt x="704" y="466"/>
                  </a:lnTo>
                  <a:lnTo>
                    <a:pt x="713" y="462"/>
                  </a:lnTo>
                  <a:lnTo>
                    <a:pt x="725" y="453"/>
                  </a:lnTo>
                  <a:lnTo>
                    <a:pt x="736" y="447"/>
                  </a:lnTo>
                  <a:lnTo>
                    <a:pt x="748" y="440"/>
                  </a:lnTo>
                  <a:lnTo>
                    <a:pt x="757" y="435"/>
                  </a:lnTo>
                  <a:lnTo>
                    <a:pt x="769" y="431"/>
                  </a:lnTo>
                  <a:lnTo>
                    <a:pt x="780" y="424"/>
                  </a:lnTo>
                  <a:lnTo>
                    <a:pt x="790" y="418"/>
                  </a:lnTo>
                  <a:lnTo>
                    <a:pt x="801" y="413"/>
                  </a:lnTo>
                  <a:lnTo>
                    <a:pt x="813" y="406"/>
                  </a:lnTo>
                  <a:lnTo>
                    <a:pt x="824" y="403"/>
                  </a:lnTo>
                  <a:lnTo>
                    <a:pt x="834" y="398"/>
                  </a:lnTo>
                  <a:lnTo>
                    <a:pt x="846" y="391"/>
                  </a:lnTo>
                  <a:lnTo>
                    <a:pt x="857" y="387"/>
                  </a:lnTo>
                  <a:lnTo>
                    <a:pt x="868" y="383"/>
                  </a:lnTo>
                  <a:lnTo>
                    <a:pt x="878" y="377"/>
                  </a:lnTo>
                  <a:lnTo>
                    <a:pt x="890" y="370"/>
                  </a:lnTo>
                  <a:lnTo>
                    <a:pt x="901" y="367"/>
                  </a:lnTo>
                  <a:lnTo>
                    <a:pt x="912" y="364"/>
                  </a:lnTo>
                  <a:lnTo>
                    <a:pt x="922" y="357"/>
                  </a:lnTo>
                  <a:lnTo>
                    <a:pt x="934" y="354"/>
                  </a:lnTo>
                  <a:lnTo>
                    <a:pt x="945" y="349"/>
                  </a:lnTo>
                  <a:lnTo>
                    <a:pt x="955" y="344"/>
                  </a:lnTo>
                  <a:lnTo>
                    <a:pt x="966" y="339"/>
                  </a:lnTo>
                  <a:lnTo>
                    <a:pt x="978" y="334"/>
                  </a:lnTo>
                  <a:lnTo>
                    <a:pt x="989" y="331"/>
                  </a:lnTo>
                  <a:lnTo>
                    <a:pt x="999" y="328"/>
                  </a:lnTo>
                  <a:lnTo>
                    <a:pt x="1010" y="325"/>
                  </a:lnTo>
                  <a:lnTo>
                    <a:pt x="1022" y="321"/>
                  </a:lnTo>
                  <a:lnTo>
                    <a:pt x="1033" y="316"/>
                  </a:lnTo>
                  <a:lnTo>
                    <a:pt x="1043" y="313"/>
                  </a:lnTo>
                  <a:lnTo>
                    <a:pt x="1054" y="310"/>
                  </a:lnTo>
                  <a:lnTo>
                    <a:pt x="1066" y="305"/>
                  </a:lnTo>
                  <a:lnTo>
                    <a:pt x="1077" y="300"/>
                  </a:lnTo>
                  <a:lnTo>
                    <a:pt x="1087" y="295"/>
                  </a:lnTo>
                  <a:lnTo>
                    <a:pt x="1098" y="292"/>
                  </a:lnTo>
                  <a:lnTo>
                    <a:pt x="1110" y="289"/>
                  </a:lnTo>
                  <a:lnTo>
                    <a:pt x="1120" y="285"/>
                  </a:lnTo>
                  <a:lnTo>
                    <a:pt x="1131" y="280"/>
                  </a:lnTo>
                  <a:lnTo>
                    <a:pt x="1143" y="277"/>
                  </a:lnTo>
                  <a:lnTo>
                    <a:pt x="1154" y="274"/>
                  </a:lnTo>
                  <a:lnTo>
                    <a:pt x="1164" y="271"/>
                  </a:lnTo>
                  <a:lnTo>
                    <a:pt x="1175" y="267"/>
                  </a:lnTo>
                  <a:lnTo>
                    <a:pt x="1187" y="261"/>
                  </a:lnTo>
                  <a:lnTo>
                    <a:pt x="1198" y="259"/>
                  </a:lnTo>
                  <a:lnTo>
                    <a:pt x="1208" y="254"/>
                  </a:lnTo>
                  <a:lnTo>
                    <a:pt x="1219" y="251"/>
                  </a:lnTo>
                  <a:lnTo>
                    <a:pt x="1231" y="248"/>
                  </a:lnTo>
                  <a:lnTo>
                    <a:pt x="1242" y="245"/>
                  </a:lnTo>
                  <a:lnTo>
                    <a:pt x="1252" y="241"/>
                  </a:lnTo>
                  <a:lnTo>
                    <a:pt x="1263" y="238"/>
                  </a:lnTo>
                  <a:lnTo>
                    <a:pt x="1275" y="235"/>
                  </a:lnTo>
                  <a:lnTo>
                    <a:pt x="1284" y="230"/>
                  </a:lnTo>
                  <a:lnTo>
                    <a:pt x="1296" y="228"/>
                  </a:lnTo>
                  <a:lnTo>
                    <a:pt x="1307" y="223"/>
                  </a:lnTo>
                  <a:lnTo>
                    <a:pt x="1319" y="219"/>
                  </a:lnTo>
                  <a:lnTo>
                    <a:pt x="1329" y="215"/>
                  </a:lnTo>
                  <a:lnTo>
                    <a:pt x="1340" y="212"/>
                  </a:lnTo>
                  <a:lnTo>
                    <a:pt x="1351" y="209"/>
                  </a:lnTo>
                  <a:lnTo>
                    <a:pt x="1363" y="207"/>
                  </a:lnTo>
                  <a:lnTo>
                    <a:pt x="1373" y="202"/>
                  </a:lnTo>
                  <a:lnTo>
                    <a:pt x="1384" y="199"/>
                  </a:lnTo>
                  <a:lnTo>
                    <a:pt x="1395" y="197"/>
                  </a:lnTo>
                  <a:lnTo>
                    <a:pt x="1407" y="194"/>
                  </a:lnTo>
                  <a:lnTo>
                    <a:pt x="1417" y="189"/>
                  </a:lnTo>
                  <a:lnTo>
                    <a:pt x="1428" y="186"/>
                  </a:lnTo>
                  <a:lnTo>
                    <a:pt x="1439" y="183"/>
                  </a:lnTo>
                  <a:lnTo>
                    <a:pt x="1449" y="179"/>
                  </a:lnTo>
                  <a:lnTo>
                    <a:pt x="1461" y="178"/>
                  </a:lnTo>
                  <a:lnTo>
                    <a:pt x="1472" y="174"/>
                  </a:lnTo>
                  <a:lnTo>
                    <a:pt x="1484" y="173"/>
                  </a:lnTo>
                  <a:lnTo>
                    <a:pt x="1493" y="170"/>
                  </a:lnTo>
                  <a:lnTo>
                    <a:pt x="1505" y="166"/>
                  </a:lnTo>
                  <a:lnTo>
                    <a:pt x="1516" y="163"/>
                  </a:lnTo>
                  <a:lnTo>
                    <a:pt x="1528" y="160"/>
                  </a:lnTo>
                  <a:lnTo>
                    <a:pt x="1537" y="155"/>
                  </a:lnTo>
                  <a:lnTo>
                    <a:pt x="1549" y="153"/>
                  </a:lnTo>
                  <a:lnTo>
                    <a:pt x="1560" y="150"/>
                  </a:lnTo>
                  <a:lnTo>
                    <a:pt x="1572" y="147"/>
                  </a:lnTo>
                  <a:lnTo>
                    <a:pt x="1581" y="145"/>
                  </a:lnTo>
                  <a:lnTo>
                    <a:pt x="1593" y="142"/>
                  </a:lnTo>
                  <a:lnTo>
                    <a:pt x="1604" y="139"/>
                  </a:lnTo>
                  <a:lnTo>
                    <a:pt x="1614" y="135"/>
                  </a:lnTo>
                  <a:lnTo>
                    <a:pt x="1626" y="132"/>
                  </a:lnTo>
                  <a:lnTo>
                    <a:pt x="1637" y="130"/>
                  </a:lnTo>
                  <a:lnTo>
                    <a:pt x="1648" y="127"/>
                  </a:lnTo>
                  <a:lnTo>
                    <a:pt x="1658" y="124"/>
                  </a:lnTo>
                  <a:lnTo>
                    <a:pt x="1670" y="122"/>
                  </a:lnTo>
                  <a:lnTo>
                    <a:pt x="1681" y="119"/>
                  </a:lnTo>
                  <a:lnTo>
                    <a:pt x="1692" y="117"/>
                  </a:lnTo>
                  <a:lnTo>
                    <a:pt x="1702" y="114"/>
                  </a:lnTo>
                  <a:lnTo>
                    <a:pt x="1714" y="111"/>
                  </a:lnTo>
                  <a:lnTo>
                    <a:pt x="1725" y="109"/>
                  </a:lnTo>
                  <a:lnTo>
                    <a:pt x="1736" y="106"/>
                  </a:lnTo>
                  <a:lnTo>
                    <a:pt x="1746" y="103"/>
                  </a:lnTo>
                  <a:lnTo>
                    <a:pt x="1758" y="101"/>
                  </a:lnTo>
                  <a:lnTo>
                    <a:pt x="1769" y="96"/>
                  </a:lnTo>
                  <a:lnTo>
                    <a:pt x="1779" y="95"/>
                  </a:lnTo>
                  <a:lnTo>
                    <a:pt x="1790" y="91"/>
                  </a:lnTo>
                  <a:lnTo>
                    <a:pt x="1802" y="88"/>
                  </a:lnTo>
                  <a:lnTo>
                    <a:pt x="1813" y="86"/>
                  </a:lnTo>
                  <a:lnTo>
                    <a:pt x="1823" y="83"/>
                  </a:lnTo>
                  <a:lnTo>
                    <a:pt x="1834" y="80"/>
                  </a:lnTo>
                  <a:lnTo>
                    <a:pt x="1846" y="80"/>
                  </a:lnTo>
                  <a:lnTo>
                    <a:pt x="1857" y="77"/>
                  </a:lnTo>
                  <a:lnTo>
                    <a:pt x="1867" y="75"/>
                  </a:lnTo>
                  <a:lnTo>
                    <a:pt x="1878" y="72"/>
                  </a:lnTo>
                  <a:lnTo>
                    <a:pt x="1890" y="68"/>
                  </a:lnTo>
                  <a:lnTo>
                    <a:pt x="1901" y="65"/>
                  </a:lnTo>
                  <a:lnTo>
                    <a:pt x="1911" y="60"/>
                  </a:lnTo>
                  <a:lnTo>
                    <a:pt x="1922" y="60"/>
                  </a:lnTo>
                  <a:lnTo>
                    <a:pt x="1934" y="59"/>
                  </a:lnTo>
                  <a:lnTo>
                    <a:pt x="1944" y="55"/>
                  </a:lnTo>
                  <a:lnTo>
                    <a:pt x="1955" y="52"/>
                  </a:lnTo>
                  <a:lnTo>
                    <a:pt x="1967" y="50"/>
                  </a:lnTo>
                  <a:lnTo>
                    <a:pt x="1978" y="47"/>
                  </a:lnTo>
                  <a:lnTo>
                    <a:pt x="1988" y="44"/>
                  </a:lnTo>
                  <a:lnTo>
                    <a:pt x="1999" y="42"/>
                  </a:lnTo>
                  <a:lnTo>
                    <a:pt x="2011" y="41"/>
                  </a:lnTo>
                  <a:lnTo>
                    <a:pt x="2022" y="37"/>
                  </a:lnTo>
                  <a:lnTo>
                    <a:pt x="2032" y="36"/>
                  </a:lnTo>
                  <a:lnTo>
                    <a:pt x="2043" y="34"/>
                  </a:lnTo>
                  <a:lnTo>
                    <a:pt x="2055" y="33"/>
                  </a:lnTo>
                  <a:lnTo>
                    <a:pt x="2066" y="29"/>
                  </a:lnTo>
                  <a:lnTo>
                    <a:pt x="2076" y="28"/>
                  </a:lnTo>
                  <a:lnTo>
                    <a:pt x="2087" y="23"/>
                  </a:lnTo>
                  <a:lnTo>
                    <a:pt x="2099" y="21"/>
                  </a:lnTo>
                  <a:lnTo>
                    <a:pt x="2108" y="19"/>
                  </a:lnTo>
                  <a:lnTo>
                    <a:pt x="2120" y="18"/>
                  </a:lnTo>
                  <a:lnTo>
                    <a:pt x="2131" y="15"/>
                  </a:lnTo>
                  <a:lnTo>
                    <a:pt x="2143" y="13"/>
                  </a:lnTo>
                  <a:lnTo>
                    <a:pt x="2153" y="10"/>
                  </a:lnTo>
                  <a:lnTo>
                    <a:pt x="2164" y="6"/>
                  </a:lnTo>
                  <a:lnTo>
                    <a:pt x="2175" y="5"/>
                  </a:lnTo>
                  <a:lnTo>
                    <a:pt x="2187" y="2"/>
                  </a:lnTo>
                  <a:lnTo>
                    <a:pt x="2197" y="0"/>
                  </a:lnTo>
                  <a:lnTo>
                    <a:pt x="2208" y="0"/>
                  </a:lnTo>
                  <a:lnTo>
                    <a:pt x="2219" y="8"/>
                  </a:lnTo>
                  <a:lnTo>
                    <a:pt x="2231" y="3"/>
                  </a:lnTo>
                  <a:lnTo>
                    <a:pt x="2241" y="57"/>
                  </a:lnTo>
                  <a:lnTo>
                    <a:pt x="2252" y="36"/>
                  </a:lnTo>
                  <a:lnTo>
                    <a:pt x="2264" y="16"/>
                  </a:lnTo>
                  <a:lnTo>
                    <a:pt x="2273" y="21"/>
                  </a:lnTo>
                  <a:lnTo>
                    <a:pt x="2285" y="24"/>
                  </a:lnTo>
                  <a:lnTo>
                    <a:pt x="2296" y="28"/>
                  </a:lnTo>
                  <a:lnTo>
                    <a:pt x="2308" y="31"/>
                  </a:lnTo>
                  <a:lnTo>
                    <a:pt x="2317" y="34"/>
                  </a:lnTo>
                  <a:lnTo>
                    <a:pt x="2329" y="37"/>
                  </a:lnTo>
                  <a:lnTo>
                    <a:pt x="2340" y="39"/>
                  </a:lnTo>
                  <a:lnTo>
                    <a:pt x="2352" y="42"/>
                  </a:lnTo>
                  <a:lnTo>
                    <a:pt x="2361" y="44"/>
                  </a:lnTo>
                  <a:lnTo>
                    <a:pt x="2373" y="47"/>
                  </a:lnTo>
                  <a:lnTo>
                    <a:pt x="2384" y="47"/>
                  </a:lnTo>
                  <a:lnTo>
                    <a:pt x="2396" y="50"/>
                  </a:lnTo>
                  <a:lnTo>
                    <a:pt x="2405" y="52"/>
                  </a:lnTo>
                  <a:lnTo>
                    <a:pt x="2417" y="55"/>
                  </a:lnTo>
                  <a:lnTo>
                    <a:pt x="2428" y="57"/>
                  </a:lnTo>
                  <a:lnTo>
                    <a:pt x="2438" y="59"/>
                  </a:lnTo>
                  <a:lnTo>
                    <a:pt x="2450" y="59"/>
                  </a:lnTo>
                  <a:lnTo>
                    <a:pt x="2461" y="60"/>
                  </a:lnTo>
                  <a:lnTo>
                    <a:pt x="2472" y="64"/>
                  </a:lnTo>
                  <a:lnTo>
                    <a:pt x="2482" y="64"/>
                  </a:lnTo>
                  <a:lnTo>
                    <a:pt x="2494" y="64"/>
                  </a:lnTo>
                  <a:lnTo>
                    <a:pt x="2505" y="65"/>
                  </a:lnTo>
                  <a:lnTo>
                    <a:pt x="2516" y="67"/>
                  </a:lnTo>
                  <a:lnTo>
                    <a:pt x="2526" y="65"/>
                  </a:lnTo>
                  <a:lnTo>
                    <a:pt x="2538" y="68"/>
                  </a:lnTo>
                  <a:lnTo>
                    <a:pt x="2549" y="68"/>
                  </a:lnTo>
                  <a:lnTo>
                    <a:pt x="2560" y="70"/>
                  </a:lnTo>
                  <a:lnTo>
                    <a:pt x="2570" y="72"/>
                  </a:lnTo>
                  <a:lnTo>
                    <a:pt x="2582" y="72"/>
                  </a:lnTo>
                  <a:lnTo>
                    <a:pt x="2593" y="73"/>
                  </a:lnTo>
                  <a:lnTo>
                    <a:pt x="2603" y="75"/>
                  </a:lnTo>
                  <a:lnTo>
                    <a:pt x="2614" y="77"/>
                  </a:lnTo>
                  <a:lnTo>
                    <a:pt x="2626" y="77"/>
                  </a:lnTo>
                  <a:lnTo>
                    <a:pt x="2637" y="78"/>
                  </a:lnTo>
                  <a:lnTo>
                    <a:pt x="2647" y="80"/>
                  </a:lnTo>
                  <a:lnTo>
                    <a:pt x="2658" y="80"/>
                  </a:lnTo>
                  <a:lnTo>
                    <a:pt x="2670" y="81"/>
                  </a:lnTo>
                  <a:lnTo>
                    <a:pt x="2681" y="83"/>
                  </a:lnTo>
                  <a:lnTo>
                    <a:pt x="2691" y="81"/>
                  </a:lnTo>
                  <a:lnTo>
                    <a:pt x="2702" y="81"/>
                  </a:lnTo>
                  <a:lnTo>
                    <a:pt x="2714" y="83"/>
                  </a:lnTo>
                  <a:lnTo>
                    <a:pt x="2725" y="85"/>
                  </a:lnTo>
                  <a:lnTo>
                    <a:pt x="2735" y="85"/>
                  </a:lnTo>
                  <a:lnTo>
                    <a:pt x="2747" y="83"/>
                  </a:lnTo>
                  <a:lnTo>
                    <a:pt x="2758" y="83"/>
                  </a:lnTo>
                  <a:lnTo>
                    <a:pt x="2768" y="85"/>
                  </a:lnTo>
                  <a:lnTo>
                    <a:pt x="2779" y="83"/>
                  </a:lnTo>
                  <a:lnTo>
                    <a:pt x="2791" y="85"/>
                  </a:lnTo>
                  <a:lnTo>
                    <a:pt x="2802" y="85"/>
                  </a:lnTo>
                  <a:lnTo>
                    <a:pt x="2812" y="85"/>
                  </a:lnTo>
                  <a:lnTo>
                    <a:pt x="2823" y="85"/>
                  </a:lnTo>
                  <a:lnTo>
                    <a:pt x="2835" y="86"/>
                  </a:lnTo>
                  <a:lnTo>
                    <a:pt x="2846" y="85"/>
                  </a:lnTo>
                  <a:lnTo>
                    <a:pt x="2856" y="86"/>
                  </a:lnTo>
                  <a:lnTo>
                    <a:pt x="2867" y="85"/>
                  </a:lnTo>
                  <a:lnTo>
                    <a:pt x="2879" y="85"/>
                  </a:lnTo>
                  <a:lnTo>
                    <a:pt x="2890" y="88"/>
                  </a:lnTo>
                  <a:lnTo>
                    <a:pt x="2900" y="86"/>
                  </a:lnTo>
                  <a:lnTo>
                    <a:pt x="2911" y="86"/>
                  </a:lnTo>
                  <a:lnTo>
                    <a:pt x="2923" y="86"/>
                  </a:lnTo>
                  <a:lnTo>
                    <a:pt x="2933" y="88"/>
                  </a:lnTo>
                  <a:lnTo>
                    <a:pt x="2944" y="88"/>
                  </a:lnTo>
                  <a:lnTo>
                    <a:pt x="2955" y="88"/>
                  </a:lnTo>
                  <a:lnTo>
                    <a:pt x="2967" y="86"/>
                  </a:lnTo>
                  <a:lnTo>
                    <a:pt x="2977" y="88"/>
                  </a:lnTo>
                  <a:lnTo>
                    <a:pt x="2988" y="86"/>
                  </a:lnTo>
                  <a:lnTo>
                    <a:pt x="2999" y="88"/>
                  </a:lnTo>
                  <a:lnTo>
                    <a:pt x="3011" y="88"/>
                  </a:lnTo>
                  <a:lnTo>
                    <a:pt x="3021" y="88"/>
                  </a:lnTo>
                  <a:lnTo>
                    <a:pt x="3032" y="88"/>
                  </a:lnTo>
                  <a:lnTo>
                    <a:pt x="3043" y="88"/>
                  </a:lnTo>
                  <a:lnTo>
                    <a:pt x="3055" y="90"/>
                  </a:lnTo>
                  <a:lnTo>
                    <a:pt x="3065" y="88"/>
                  </a:lnTo>
                  <a:lnTo>
                    <a:pt x="3076" y="90"/>
                  </a:lnTo>
                  <a:lnTo>
                    <a:pt x="3088" y="88"/>
                  </a:lnTo>
                  <a:lnTo>
                    <a:pt x="3097" y="88"/>
                  </a:lnTo>
                  <a:lnTo>
                    <a:pt x="3109" y="88"/>
                  </a:lnTo>
                  <a:lnTo>
                    <a:pt x="3120" y="86"/>
                  </a:lnTo>
                  <a:lnTo>
                    <a:pt x="3132" y="88"/>
                  </a:lnTo>
                  <a:lnTo>
                    <a:pt x="3141" y="88"/>
                  </a:lnTo>
                  <a:lnTo>
                    <a:pt x="3153" y="86"/>
                  </a:lnTo>
                  <a:lnTo>
                    <a:pt x="3164" y="88"/>
                  </a:lnTo>
                  <a:lnTo>
                    <a:pt x="3176" y="88"/>
                  </a:lnTo>
                  <a:lnTo>
                    <a:pt x="3185" y="88"/>
                  </a:lnTo>
                  <a:lnTo>
                    <a:pt x="3197" y="86"/>
                  </a:lnTo>
                  <a:lnTo>
                    <a:pt x="3208" y="86"/>
                  </a:lnTo>
                  <a:lnTo>
                    <a:pt x="3220" y="88"/>
                  </a:lnTo>
                  <a:lnTo>
                    <a:pt x="3229" y="86"/>
                  </a:lnTo>
                  <a:lnTo>
                    <a:pt x="3241" y="86"/>
                  </a:lnTo>
                  <a:lnTo>
                    <a:pt x="3252" y="86"/>
                  </a:lnTo>
                  <a:lnTo>
                    <a:pt x="3262" y="86"/>
                  </a:lnTo>
                  <a:lnTo>
                    <a:pt x="3274" y="86"/>
                  </a:lnTo>
                  <a:lnTo>
                    <a:pt x="3285" y="85"/>
                  </a:lnTo>
                  <a:lnTo>
                    <a:pt x="3296" y="86"/>
                  </a:lnTo>
                  <a:lnTo>
                    <a:pt x="3306" y="86"/>
                  </a:lnTo>
                  <a:lnTo>
                    <a:pt x="3318" y="85"/>
                  </a:lnTo>
                  <a:lnTo>
                    <a:pt x="3329" y="85"/>
                  </a:lnTo>
                  <a:lnTo>
                    <a:pt x="3340" y="85"/>
                  </a:lnTo>
                  <a:lnTo>
                    <a:pt x="3350" y="83"/>
                  </a:lnTo>
                  <a:lnTo>
                    <a:pt x="3362" y="83"/>
                  </a:lnTo>
                  <a:lnTo>
                    <a:pt x="3373" y="83"/>
                  </a:lnTo>
                  <a:lnTo>
                    <a:pt x="3385" y="85"/>
                  </a:lnTo>
                  <a:lnTo>
                    <a:pt x="3394" y="83"/>
                  </a:lnTo>
                  <a:lnTo>
                    <a:pt x="3406" y="83"/>
                  </a:lnTo>
                  <a:lnTo>
                    <a:pt x="3417" y="83"/>
                  </a:lnTo>
                  <a:lnTo>
                    <a:pt x="3427" y="83"/>
                  </a:lnTo>
                  <a:lnTo>
                    <a:pt x="3438" y="81"/>
                  </a:lnTo>
                  <a:lnTo>
                    <a:pt x="3450" y="83"/>
                  </a:lnTo>
                  <a:lnTo>
                    <a:pt x="3461" y="81"/>
                  </a:lnTo>
                  <a:lnTo>
                    <a:pt x="3471" y="80"/>
                  </a:lnTo>
                  <a:lnTo>
                    <a:pt x="3482" y="80"/>
                  </a:lnTo>
                  <a:lnTo>
                    <a:pt x="3494" y="80"/>
                  </a:lnTo>
                  <a:lnTo>
                    <a:pt x="3505" y="80"/>
                  </a:lnTo>
                  <a:lnTo>
                    <a:pt x="3515" y="80"/>
                  </a:lnTo>
                  <a:lnTo>
                    <a:pt x="3526" y="80"/>
                  </a:lnTo>
                  <a:lnTo>
                    <a:pt x="3538" y="80"/>
                  </a:lnTo>
                  <a:lnTo>
                    <a:pt x="3549" y="80"/>
                  </a:lnTo>
                  <a:lnTo>
                    <a:pt x="3559" y="78"/>
                  </a:lnTo>
                  <a:lnTo>
                    <a:pt x="3571" y="80"/>
                  </a:lnTo>
                  <a:lnTo>
                    <a:pt x="3582" y="80"/>
                  </a:lnTo>
                  <a:lnTo>
                    <a:pt x="3592" y="80"/>
                  </a:lnTo>
                  <a:lnTo>
                    <a:pt x="3603" y="78"/>
                  </a:lnTo>
                  <a:lnTo>
                    <a:pt x="3615" y="78"/>
                  </a:lnTo>
                  <a:lnTo>
                    <a:pt x="3626" y="78"/>
                  </a:lnTo>
                  <a:lnTo>
                    <a:pt x="3636" y="78"/>
                  </a:lnTo>
                  <a:lnTo>
                    <a:pt x="3647" y="80"/>
                  </a:lnTo>
                  <a:lnTo>
                    <a:pt x="3659" y="78"/>
                  </a:lnTo>
                  <a:lnTo>
                    <a:pt x="3670" y="77"/>
                  </a:lnTo>
                  <a:lnTo>
                    <a:pt x="3680" y="77"/>
                  </a:lnTo>
                  <a:lnTo>
                    <a:pt x="3691" y="78"/>
                  </a:lnTo>
                  <a:lnTo>
                    <a:pt x="3703" y="75"/>
                  </a:lnTo>
                  <a:lnTo>
                    <a:pt x="3714" y="75"/>
                  </a:lnTo>
                  <a:lnTo>
                    <a:pt x="3724" y="78"/>
                  </a:lnTo>
                  <a:lnTo>
                    <a:pt x="3735" y="75"/>
                  </a:lnTo>
                  <a:lnTo>
                    <a:pt x="3747" y="73"/>
                  </a:lnTo>
                  <a:lnTo>
                    <a:pt x="3757" y="75"/>
                  </a:lnTo>
                  <a:lnTo>
                    <a:pt x="3768" y="78"/>
                  </a:lnTo>
                  <a:lnTo>
                    <a:pt x="3779" y="77"/>
                  </a:lnTo>
                  <a:lnTo>
                    <a:pt x="3791" y="77"/>
                  </a:lnTo>
                  <a:lnTo>
                    <a:pt x="3801" y="75"/>
                  </a:lnTo>
                  <a:lnTo>
                    <a:pt x="3812" y="75"/>
                  </a:lnTo>
                  <a:lnTo>
                    <a:pt x="3823" y="77"/>
                  </a:lnTo>
                  <a:lnTo>
                    <a:pt x="3835" y="77"/>
                  </a:lnTo>
                  <a:lnTo>
                    <a:pt x="3845" y="77"/>
                  </a:lnTo>
                  <a:lnTo>
                    <a:pt x="3856" y="75"/>
                  </a:lnTo>
                  <a:lnTo>
                    <a:pt x="3867" y="77"/>
                  </a:lnTo>
                  <a:lnTo>
                    <a:pt x="3879" y="75"/>
                  </a:lnTo>
                  <a:lnTo>
                    <a:pt x="3889" y="78"/>
                  </a:lnTo>
                  <a:lnTo>
                    <a:pt x="3900" y="75"/>
                  </a:lnTo>
                  <a:lnTo>
                    <a:pt x="3912" y="73"/>
                  </a:lnTo>
                  <a:lnTo>
                    <a:pt x="3921" y="85"/>
                  </a:lnTo>
                  <a:lnTo>
                    <a:pt x="3933" y="86"/>
                  </a:lnTo>
                  <a:lnTo>
                    <a:pt x="3944" y="77"/>
                  </a:lnTo>
                  <a:lnTo>
                    <a:pt x="3956" y="77"/>
                  </a:lnTo>
                  <a:lnTo>
                    <a:pt x="3965" y="80"/>
                  </a:lnTo>
                  <a:lnTo>
                    <a:pt x="3977" y="90"/>
                  </a:lnTo>
                  <a:lnTo>
                    <a:pt x="3988" y="83"/>
                  </a:lnTo>
                  <a:lnTo>
                    <a:pt x="4000" y="68"/>
                  </a:lnTo>
                  <a:lnTo>
                    <a:pt x="4009" y="70"/>
                  </a:lnTo>
                  <a:lnTo>
                    <a:pt x="4021" y="73"/>
                  </a:lnTo>
                  <a:lnTo>
                    <a:pt x="4032" y="75"/>
                  </a:lnTo>
                  <a:lnTo>
                    <a:pt x="4044" y="75"/>
                  </a:lnTo>
                  <a:lnTo>
                    <a:pt x="4054" y="75"/>
                  </a:lnTo>
                  <a:lnTo>
                    <a:pt x="4065" y="77"/>
                  </a:lnTo>
                  <a:lnTo>
                    <a:pt x="4076" y="70"/>
                  </a:lnTo>
                  <a:lnTo>
                    <a:pt x="4086" y="67"/>
                  </a:lnTo>
                  <a:lnTo>
                    <a:pt x="4098" y="73"/>
                  </a:lnTo>
                  <a:lnTo>
                    <a:pt x="4109" y="81"/>
                  </a:lnTo>
                  <a:lnTo>
                    <a:pt x="4120" y="88"/>
                  </a:lnTo>
                  <a:lnTo>
                    <a:pt x="4130" y="81"/>
                  </a:lnTo>
                  <a:lnTo>
                    <a:pt x="4142" y="75"/>
                  </a:lnTo>
                  <a:lnTo>
                    <a:pt x="4153" y="75"/>
                  </a:lnTo>
                  <a:lnTo>
                    <a:pt x="4164" y="75"/>
                  </a:lnTo>
                  <a:lnTo>
                    <a:pt x="4174" y="75"/>
                  </a:lnTo>
                  <a:lnTo>
                    <a:pt x="4186" y="75"/>
                  </a:lnTo>
                  <a:lnTo>
                    <a:pt x="4197" y="77"/>
                  </a:lnTo>
                  <a:lnTo>
                    <a:pt x="4209" y="75"/>
                  </a:lnTo>
                  <a:lnTo>
                    <a:pt x="4218" y="75"/>
                  </a:lnTo>
                  <a:lnTo>
                    <a:pt x="4230" y="75"/>
                  </a:lnTo>
                </a:path>
              </a:pathLst>
            </a:custGeom>
            <a:noFill/>
            <a:ln w="19050" cmpd="sng">
              <a:solidFill>
                <a:schemeClr val="bg1">
                  <a:lumMod val="50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2" name="Freeform 98"/>
            <p:cNvSpPr>
              <a:spLocks/>
            </p:cNvSpPr>
            <p:nvPr/>
          </p:nvSpPr>
          <p:spPr bwMode="auto">
            <a:xfrm>
              <a:off x="1393032" y="2100263"/>
              <a:ext cx="6716713" cy="1592263"/>
            </a:xfrm>
            <a:custGeom>
              <a:avLst/>
              <a:gdLst>
                <a:gd name="T0" fmla="*/ 67 w 4231"/>
                <a:gd name="T1" fmla="*/ 700 h 1003"/>
                <a:gd name="T2" fmla="*/ 144 w 4231"/>
                <a:gd name="T3" fmla="*/ 697 h 1003"/>
                <a:gd name="T4" fmla="*/ 220 w 4231"/>
                <a:gd name="T5" fmla="*/ 695 h 1003"/>
                <a:gd name="T6" fmla="*/ 297 w 4231"/>
                <a:gd name="T7" fmla="*/ 597 h 1003"/>
                <a:gd name="T8" fmla="*/ 374 w 4231"/>
                <a:gd name="T9" fmla="*/ 713 h 1003"/>
                <a:gd name="T10" fmla="*/ 452 w 4231"/>
                <a:gd name="T11" fmla="*/ 615 h 1003"/>
                <a:gd name="T12" fmla="*/ 529 w 4231"/>
                <a:gd name="T13" fmla="*/ 566 h 1003"/>
                <a:gd name="T14" fmla="*/ 605 w 4231"/>
                <a:gd name="T15" fmla="*/ 524 h 1003"/>
                <a:gd name="T16" fmla="*/ 682 w 4231"/>
                <a:gd name="T17" fmla="*/ 488 h 1003"/>
                <a:gd name="T18" fmla="*/ 759 w 4231"/>
                <a:gd name="T19" fmla="*/ 457 h 1003"/>
                <a:gd name="T20" fmla="*/ 835 w 4231"/>
                <a:gd name="T21" fmla="*/ 429 h 1003"/>
                <a:gd name="T22" fmla="*/ 912 w 4231"/>
                <a:gd name="T23" fmla="*/ 403 h 1003"/>
                <a:gd name="T24" fmla="*/ 989 w 4231"/>
                <a:gd name="T25" fmla="*/ 380 h 1003"/>
                <a:gd name="T26" fmla="*/ 1067 w 4231"/>
                <a:gd name="T27" fmla="*/ 360 h 1003"/>
                <a:gd name="T28" fmla="*/ 1144 w 4231"/>
                <a:gd name="T29" fmla="*/ 341 h 1003"/>
                <a:gd name="T30" fmla="*/ 1221 w 4231"/>
                <a:gd name="T31" fmla="*/ 323 h 1003"/>
                <a:gd name="T32" fmla="*/ 1297 w 4231"/>
                <a:gd name="T33" fmla="*/ 308 h 1003"/>
                <a:gd name="T34" fmla="*/ 1374 w 4231"/>
                <a:gd name="T35" fmla="*/ 289 h 1003"/>
                <a:gd name="T36" fmla="*/ 1451 w 4231"/>
                <a:gd name="T37" fmla="*/ 272 h 1003"/>
                <a:gd name="T38" fmla="*/ 1527 w 4231"/>
                <a:gd name="T39" fmla="*/ 258 h 1003"/>
                <a:gd name="T40" fmla="*/ 1606 w 4231"/>
                <a:gd name="T41" fmla="*/ 243 h 1003"/>
                <a:gd name="T42" fmla="*/ 1682 w 4231"/>
                <a:gd name="T43" fmla="*/ 228 h 1003"/>
                <a:gd name="T44" fmla="*/ 1759 w 4231"/>
                <a:gd name="T45" fmla="*/ 214 h 1003"/>
                <a:gd name="T46" fmla="*/ 1836 w 4231"/>
                <a:gd name="T47" fmla="*/ 201 h 1003"/>
                <a:gd name="T48" fmla="*/ 1912 w 4231"/>
                <a:gd name="T49" fmla="*/ 188 h 1003"/>
                <a:gd name="T50" fmla="*/ 1989 w 4231"/>
                <a:gd name="T51" fmla="*/ 173 h 1003"/>
                <a:gd name="T52" fmla="*/ 2066 w 4231"/>
                <a:gd name="T53" fmla="*/ 160 h 1003"/>
                <a:gd name="T54" fmla="*/ 2142 w 4231"/>
                <a:gd name="T55" fmla="*/ 147 h 1003"/>
                <a:gd name="T56" fmla="*/ 2221 w 4231"/>
                <a:gd name="T57" fmla="*/ 134 h 1003"/>
                <a:gd name="T58" fmla="*/ 2298 w 4231"/>
                <a:gd name="T59" fmla="*/ 121 h 1003"/>
                <a:gd name="T60" fmla="*/ 2374 w 4231"/>
                <a:gd name="T61" fmla="*/ 147 h 1003"/>
                <a:gd name="T62" fmla="*/ 2451 w 4231"/>
                <a:gd name="T63" fmla="*/ 157 h 1003"/>
                <a:gd name="T64" fmla="*/ 2528 w 4231"/>
                <a:gd name="T65" fmla="*/ 158 h 1003"/>
                <a:gd name="T66" fmla="*/ 2604 w 4231"/>
                <a:gd name="T67" fmla="*/ 163 h 1003"/>
                <a:gd name="T68" fmla="*/ 2681 w 4231"/>
                <a:gd name="T69" fmla="*/ 165 h 1003"/>
                <a:gd name="T70" fmla="*/ 2759 w 4231"/>
                <a:gd name="T71" fmla="*/ 168 h 1003"/>
                <a:gd name="T72" fmla="*/ 2836 w 4231"/>
                <a:gd name="T73" fmla="*/ 166 h 1003"/>
                <a:gd name="T74" fmla="*/ 2913 w 4231"/>
                <a:gd name="T75" fmla="*/ 166 h 1003"/>
                <a:gd name="T76" fmla="*/ 2989 w 4231"/>
                <a:gd name="T77" fmla="*/ 168 h 1003"/>
                <a:gd name="T78" fmla="*/ 3066 w 4231"/>
                <a:gd name="T79" fmla="*/ 168 h 1003"/>
                <a:gd name="T80" fmla="*/ 3143 w 4231"/>
                <a:gd name="T81" fmla="*/ 168 h 1003"/>
                <a:gd name="T82" fmla="*/ 3219 w 4231"/>
                <a:gd name="T83" fmla="*/ 170 h 1003"/>
                <a:gd name="T84" fmla="*/ 3296 w 4231"/>
                <a:gd name="T85" fmla="*/ 171 h 1003"/>
                <a:gd name="T86" fmla="*/ 3374 w 4231"/>
                <a:gd name="T87" fmla="*/ 171 h 1003"/>
                <a:gd name="T88" fmla="*/ 3451 w 4231"/>
                <a:gd name="T89" fmla="*/ 171 h 1003"/>
                <a:gd name="T90" fmla="*/ 3528 w 4231"/>
                <a:gd name="T91" fmla="*/ 176 h 1003"/>
                <a:gd name="T92" fmla="*/ 3605 w 4231"/>
                <a:gd name="T93" fmla="*/ 178 h 1003"/>
                <a:gd name="T94" fmla="*/ 3681 w 4231"/>
                <a:gd name="T95" fmla="*/ 179 h 1003"/>
                <a:gd name="T96" fmla="*/ 3758 w 4231"/>
                <a:gd name="T97" fmla="*/ 183 h 1003"/>
                <a:gd name="T98" fmla="*/ 3835 w 4231"/>
                <a:gd name="T99" fmla="*/ 183 h 1003"/>
                <a:gd name="T100" fmla="*/ 3913 w 4231"/>
                <a:gd name="T101" fmla="*/ 184 h 1003"/>
                <a:gd name="T102" fmla="*/ 3990 w 4231"/>
                <a:gd name="T103" fmla="*/ 184 h 1003"/>
                <a:gd name="T104" fmla="*/ 4066 w 4231"/>
                <a:gd name="T105" fmla="*/ 189 h 1003"/>
                <a:gd name="T106" fmla="*/ 4143 w 4231"/>
                <a:gd name="T107" fmla="*/ 192 h 1003"/>
                <a:gd name="T108" fmla="*/ 4220 w 4231"/>
                <a:gd name="T109" fmla="*/ 194 h 10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231" h="1003">
                  <a:moveTo>
                    <a:pt x="0" y="701"/>
                  </a:moveTo>
                  <a:lnTo>
                    <a:pt x="11" y="701"/>
                  </a:lnTo>
                  <a:lnTo>
                    <a:pt x="23" y="701"/>
                  </a:lnTo>
                  <a:lnTo>
                    <a:pt x="34" y="701"/>
                  </a:lnTo>
                  <a:lnTo>
                    <a:pt x="44" y="701"/>
                  </a:lnTo>
                  <a:lnTo>
                    <a:pt x="56" y="700"/>
                  </a:lnTo>
                  <a:lnTo>
                    <a:pt x="67" y="700"/>
                  </a:lnTo>
                  <a:lnTo>
                    <a:pt x="78" y="698"/>
                  </a:lnTo>
                  <a:lnTo>
                    <a:pt x="88" y="698"/>
                  </a:lnTo>
                  <a:lnTo>
                    <a:pt x="100" y="698"/>
                  </a:lnTo>
                  <a:lnTo>
                    <a:pt x="111" y="698"/>
                  </a:lnTo>
                  <a:lnTo>
                    <a:pt x="122" y="698"/>
                  </a:lnTo>
                  <a:lnTo>
                    <a:pt x="132" y="698"/>
                  </a:lnTo>
                  <a:lnTo>
                    <a:pt x="144" y="697"/>
                  </a:lnTo>
                  <a:lnTo>
                    <a:pt x="155" y="697"/>
                  </a:lnTo>
                  <a:lnTo>
                    <a:pt x="165" y="697"/>
                  </a:lnTo>
                  <a:lnTo>
                    <a:pt x="176" y="695"/>
                  </a:lnTo>
                  <a:lnTo>
                    <a:pt x="188" y="695"/>
                  </a:lnTo>
                  <a:lnTo>
                    <a:pt x="199" y="697"/>
                  </a:lnTo>
                  <a:lnTo>
                    <a:pt x="209" y="698"/>
                  </a:lnTo>
                  <a:lnTo>
                    <a:pt x="220" y="695"/>
                  </a:lnTo>
                  <a:lnTo>
                    <a:pt x="232" y="695"/>
                  </a:lnTo>
                  <a:lnTo>
                    <a:pt x="243" y="695"/>
                  </a:lnTo>
                  <a:lnTo>
                    <a:pt x="253" y="692"/>
                  </a:lnTo>
                  <a:lnTo>
                    <a:pt x="264" y="690"/>
                  </a:lnTo>
                  <a:lnTo>
                    <a:pt x="276" y="682"/>
                  </a:lnTo>
                  <a:lnTo>
                    <a:pt x="287" y="688"/>
                  </a:lnTo>
                  <a:lnTo>
                    <a:pt x="297" y="597"/>
                  </a:lnTo>
                  <a:lnTo>
                    <a:pt x="308" y="279"/>
                  </a:lnTo>
                  <a:lnTo>
                    <a:pt x="320" y="0"/>
                  </a:lnTo>
                  <a:lnTo>
                    <a:pt x="330" y="894"/>
                  </a:lnTo>
                  <a:lnTo>
                    <a:pt x="341" y="1003"/>
                  </a:lnTo>
                  <a:lnTo>
                    <a:pt x="352" y="861"/>
                  </a:lnTo>
                  <a:lnTo>
                    <a:pt x="364" y="763"/>
                  </a:lnTo>
                  <a:lnTo>
                    <a:pt x="374" y="713"/>
                  </a:lnTo>
                  <a:lnTo>
                    <a:pt x="385" y="683"/>
                  </a:lnTo>
                  <a:lnTo>
                    <a:pt x="397" y="666"/>
                  </a:lnTo>
                  <a:lnTo>
                    <a:pt x="408" y="652"/>
                  </a:lnTo>
                  <a:lnTo>
                    <a:pt x="418" y="639"/>
                  </a:lnTo>
                  <a:lnTo>
                    <a:pt x="429" y="631"/>
                  </a:lnTo>
                  <a:lnTo>
                    <a:pt x="441" y="625"/>
                  </a:lnTo>
                  <a:lnTo>
                    <a:pt x="452" y="615"/>
                  </a:lnTo>
                  <a:lnTo>
                    <a:pt x="462" y="608"/>
                  </a:lnTo>
                  <a:lnTo>
                    <a:pt x="473" y="600"/>
                  </a:lnTo>
                  <a:lnTo>
                    <a:pt x="485" y="594"/>
                  </a:lnTo>
                  <a:lnTo>
                    <a:pt x="494" y="586"/>
                  </a:lnTo>
                  <a:lnTo>
                    <a:pt x="506" y="579"/>
                  </a:lnTo>
                  <a:lnTo>
                    <a:pt x="517" y="573"/>
                  </a:lnTo>
                  <a:lnTo>
                    <a:pt x="529" y="566"/>
                  </a:lnTo>
                  <a:lnTo>
                    <a:pt x="539" y="560"/>
                  </a:lnTo>
                  <a:lnTo>
                    <a:pt x="550" y="553"/>
                  </a:lnTo>
                  <a:lnTo>
                    <a:pt x="561" y="546"/>
                  </a:lnTo>
                  <a:lnTo>
                    <a:pt x="573" y="542"/>
                  </a:lnTo>
                  <a:lnTo>
                    <a:pt x="583" y="537"/>
                  </a:lnTo>
                  <a:lnTo>
                    <a:pt x="594" y="529"/>
                  </a:lnTo>
                  <a:lnTo>
                    <a:pt x="605" y="524"/>
                  </a:lnTo>
                  <a:lnTo>
                    <a:pt x="617" y="517"/>
                  </a:lnTo>
                  <a:lnTo>
                    <a:pt x="627" y="512"/>
                  </a:lnTo>
                  <a:lnTo>
                    <a:pt x="638" y="507"/>
                  </a:lnTo>
                  <a:lnTo>
                    <a:pt x="649" y="502"/>
                  </a:lnTo>
                  <a:lnTo>
                    <a:pt x="659" y="496"/>
                  </a:lnTo>
                  <a:lnTo>
                    <a:pt x="671" y="491"/>
                  </a:lnTo>
                  <a:lnTo>
                    <a:pt x="682" y="488"/>
                  </a:lnTo>
                  <a:lnTo>
                    <a:pt x="694" y="483"/>
                  </a:lnTo>
                  <a:lnTo>
                    <a:pt x="703" y="478"/>
                  </a:lnTo>
                  <a:lnTo>
                    <a:pt x="715" y="475"/>
                  </a:lnTo>
                  <a:lnTo>
                    <a:pt x="726" y="470"/>
                  </a:lnTo>
                  <a:lnTo>
                    <a:pt x="738" y="465"/>
                  </a:lnTo>
                  <a:lnTo>
                    <a:pt x="747" y="460"/>
                  </a:lnTo>
                  <a:lnTo>
                    <a:pt x="759" y="457"/>
                  </a:lnTo>
                  <a:lnTo>
                    <a:pt x="770" y="450"/>
                  </a:lnTo>
                  <a:lnTo>
                    <a:pt x="782" y="447"/>
                  </a:lnTo>
                  <a:lnTo>
                    <a:pt x="791" y="444"/>
                  </a:lnTo>
                  <a:lnTo>
                    <a:pt x="803" y="439"/>
                  </a:lnTo>
                  <a:lnTo>
                    <a:pt x="814" y="437"/>
                  </a:lnTo>
                  <a:lnTo>
                    <a:pt x="824" y="432"/>
                  </a:lnTo>
                  <a:lnTo>
                    <a:pt x="835" y="429"/>
                  </a:lnTo>
                  <a:lnTo>
                    <a:pt x="847" y="426"/>
                  </a:lnTo>
                  <a:lnTo>
                    <a:pt x="858" y="421"/>
                  </a:lnTo>
                  <a:lnTo>
                    <a:pt x="868" y="418"/>
                  </a:lnTo>
                  <a:lnTo>
                    <a:pt x="880" y="414"/>
                  </a:lnTo>
                  <a:lnTo>
                    <a:pt x="891" y="411"/>
                  </a:lnTo>
                  <a:lnTo>
                    <a:pt x="902" y="408"/>
                  </a:lnTo>
                  <a:lnTo>
                    <a:pt x="912" y="403"/>
                  </a:lnTo>
                  <a:lnTo>
                    <a:pt x="924" y="401"/>
                  </a:lnTo>
                  <a:lnTo>
                    <a:pt x="935" y="396"/>
                  </a:lnTo>
                  <a:lnTo>
                    <a:pt x="946" y="393"/>
                  </a:lnTo>
                  <a:lnTo>
                    <a:pt x="956" y="390"/>
                  </a:lnTo>
                  <a:lnTo>
                    <a:pt x="968" y="387"/>
                  </a:lnTo>
                  <a:lnTo>
                    <a:pt x="979" y="383"/>
                  </a:lnTo>
                  <a:lnTo>
                    <a:pt x="989" y="380"/>
                  </a:lnTo>
                  <a:lnTo>
                    <a:pt x="1000" y="377"/>
                  </a:lnTo>
                  <a:lnTo>
                    <a:pt x="1012" y="375"/>
                  </a:lnTo>
                  <a:lnTo>
                    <a:pt x="1023" y="374"/>
                  </a:lnTo>
                  <a:lnTo>
                    <a:pt x="1033" y="370"/>
                  </a:lnTo>
                  <a:lnTo>
                    <a:pt x="1044" y="367"/>
                  </a:lnTo>
                  <a:lnTo>
                    <a:pt x="1056" y="362"/>
                  </a:lnTo>
                  <a:lnTo>
                    <a:pt x="1067" y="360"/>
                  </a:lnTo>
                  <a:lnTo>
                    <a:pt x="1077" y="359"/>
                  </a:lnTo>
                  <a:lnTo>
                    <a:pt x="1088" y="354"/>
                  </a:lnTo>
                  <a:lnTo>
                    <a:pt x="1100" y="351"/>
                  </a:lnTo>
                  <a:lnTo>
                    <a:pt x="1111" y="347"/>
                  </a:lnTo>
                  <a:lnTo>
                    <a:pt x="1121" y="346"/>
                  </a:lnTo>
                  <a:lnTo>
                    <a:pt x="1132" y="344"/>
                  </a:lnTo>
                  <a:lnTo>
                    <a:pt x="1144" y="341"/>
                  </a:lnTo>
                  <a:lnTo>
                    <a:pt x="1154" y="339"/>
                  </a:lnTo>
                  <a:lnTo>
                    <a:pt x="1165" y="338"/>
                  </a:lnTo>
                  <a:lnTo>
                    <a:pt x="1177" y="334"/>
                  </a:lnTo>
                  <a:lnTo>
                    <a:pt x="1188" y="331"/>
                  </a:lnTo>
                  <a:lnTo>
                    <a:pt x="1198" y="330"/>
                  </a:lnTo>
                  <a:lnTo>
                    <a:pt x="1209" y="326"/>
                  </a:lnTo>
                  <a:lnTo>
                    <a:pt x="1221" y="323"/>
                  </a:lnTo>
                  <a:lnTo>
                    <a:pt x="1232" y="321"/>
                  </a:lnTo>
                  <a:lnTo>
                    <a:pt x="1242" y="318"/>
                  </a:lnTo>
                  <a:lnTo>
                    <a:pt x="1253" y="315"/>
                  </a:lnTo>
                  <a:lnTo>
                    <a:pt x="1265" y="313"/>
                  </a:lnTo>
                  <a:lnTo>
                    <a:pt x="1276" y="312"/>
                  </a:lnTo>
                  <a:lnTo>
                    <a:pt x="1286" y="310"/>
                  </a:lnTo>
                  <a:lnTo>
                    <a:pt x="1297" y="308"/>
                  </a:lnTo>
                  <a:lnTo>
                    <a:pt x="1309" y="303"/>
                  </a:lnTo>
                  <a:lnTo>
                    <a:pt x="1318" y="302"/>
                  </a:lnTo>
                  <a:lnTo>
                    <a:pt x="1330" y="300"/>
                  </a:lnTo>
                  <a:lnTo>
                    <a:pt x="1341" y="297"/>
                  </a:lnTo>
                  <a:lnTo>
                    <a:pt x="1353" y="294"/>
                  </a:lnTo>
                  <a:lnTo>
                    <a:pt x="1363" y="292"/>
                  </a:lnTo>
                  <a:lnTo>
                    <a:pt x="1374" y="289"/>
                  </a:lnTo>
                  <a:lnTo>
                    <a:pt x="1385" y="287"/>
                  </a:lnTo>
                  <a:lnTo>
                    <a:pt x="1397" y="285"/>
                  </a:lnTo>
                  <a:lnTo>
                    <a:pt x="1407" y="284"/>
                  </a:lnTo>
                  <a:lnTo>
                    <a:pt x="1418" y="281"/>
                  </a:lnTo>
                  <a:lnTo>
                    <a:pt x="1429" y="279"/>
                  </a:lnTo>
                  <a:lnTo>
                    <a:pt x="1441" y="276"/>
                  </a:lnTo>
                  <a:lnTo>
                    <a:pt x="1451" y="272"/>
                  </a:lnTo>
                  <a:lnTo>
                    <a:pt x="1462" y="271"/>
                  </a:lnTo>
                  <a:lnTo>
                    <a:pt x="1473" y="269"/>
                  </a:lnTo>
                  <a:lnTo>
                    <a:pt x="1483" y="266"/>
                  </a:lnTo>
                  <a:lnTo>
                    <a:pt x="1495" y="263"/>
                  </a:lnTo>
                  <a:lnTo>
                    <a:pt x="1506" y="263"/>
                  </a:lnTo>
                  <a:lnTo>
                    <a:pt x="1518" y="261"/>
                  </a:lnTo>
                  <a:lnTo>
                    <a:pt x="1527" y="258"/>
                  </a:lnTo>
                  <a:lnTo>
                    <a:pt x="1539" y="254"/>
                  </a:lnTo>
                  <a:lnTo>
                    <a:pt x="1550" y="254"/>
                  </a:lnTo>
                  <a:lnTo>
                    <a:pt x="1562" y="253"/>
                  </a:lnTo>
                  <a:lnTo>
                    <a:pt x="1571" y="250"/>
                  </a:lnTo>
                  <a:lnTo>
                    <a:pt x="1583" y="246"/>
                  </a:lnTo>
                  <a:lnTo>
                    <a:pt x="1594" y="246"/>
                  </a:lnTo>
                  <a:lnTo>
                    <a:pt x="1606" y="243"/>
                  </a:lnTo>
                  <a:lnTo>
                    <a:pt x="1615" y="241"/>
                  </a:lnTo>
                  <a:lnTo>
                    <a:pt x="1627" y="237"/>
                  </a:lnTo>
                  <a:lnTo>
                    <a:pt x="1638" y="235"/>
                  </a:lnTo>
                  <a:lnTo>
                    <a:pt x="1648" y="235"/>
                  </a:lnTo>
                  <a:lnTo>
                    <a:pt x="1660" y="232"/>
                  </a:lnTo>
                  <a:lnTo>
                    <a:pt x="1671" y="232"/>
                  </a:lnTo>
                  <a:lnTo>
                    <a:pt x="1682" y="228"/>
                  </a:lnTo>
                  <a:lnTo>
                    <a:pt x="1692" y="225"/>
                  </a:lnTo>
                  <a:lnTo>
                    <a:pt x="1704" y="225"/>
                  </a:lnTo>
                  <a:lnTo>
                    <a:pt x="1715" y="223"/>
                  </a:lnTo>
                  <a:lnTo>
                    <a:pt x="1726" y="220"/>
                  </a:lnTo>
                  <a:lnTo>
                    <a:pt x="1736" y="217"/>
                  </a:lnTo>
                  <a:lnTo>
                    <a:pt x="1748" y="217"/>
                  </a:lnTo>
                  <a:lnTo>
                    <a:pt x="1759" y="214"/>
                  </a:lnTo>
                  <a:lnTo>
                    <a:pt x="1770" y="212"/>
                  </a:lnTo>
                  <a:lnTo>
                    <a:pt x="1780" y="210"/>
                  </a:lnTo>
                  <a:lnTo>
                    <a:pt x="1792" y="209"/>
                  </a:lnTo>
                  <a:lnTo>
                    <a:pt x="1803" y="207"/>
                  </a:lnTo>
                  <a:lnTo>
                    <a:pt x="1813" y="206"/>
                  </a:lnTo>
                  <a:lnTo>
                    <a:pt x="1824" y="202"/>
                  </a:lnTo>
                  <a:lnTo>
                    <a:pt x="1836" y="201"/>
                  </a:lnTo>
                  <a:lnTo>
                    <a:pt x="1847" y="199"/>
                  </a:lnTo>
                  <a:lnTo>
                    <a:pt x="1857" y="197"/>
                  </a:lnTo>
                  <a:lnTo>
                    <a:pt x="1868" y="194"/>
                  </a:lnTo>
                  <a:lnTo>
                    <a:pt x="1880" y="194"/>
                  </a:lnTo>
                  <a:lnTo>
                    <a:pt x="1891" y="191"/>
                  </a:lnTo>
                  <a:lnTo>
                    <a:pt x="1901" y="189"/>
                  </a:lnTo>
                  <a:lnTo>
                    <a:pt x="1912" y="188"/>
                  </a:lnTo>
                  <a:lnTo>
                    <a:pt x="1924" y="186"/>
                  </a:lnTo>
                  <a:lnTo>
                    <a:pt x="1935" y="184"/>
                  </a:lnTo>
                  <a:lnTo>
                    <a:pt x="1945" y="181"/>
                  </a:lnTo>
                  <a:lnTo>
                    <a:pt x="1956" y="179"/>
                  </a:lnTo>
                  <a:lnTo>
                    <a:pt x="1968" y="178"/>
                  </a:lnTo>
                  <a:lnTo>
                    <a:pt x="1978" y="175"/>
                  </a:lnTo>
                  <a:lnTo>
                    <a:pt x="1989" y="173"/>
                  </a:lnTo>
                  <a:lnTo>
                    <a:pt x="2001" y="171"/>
                  </a:lnTo>
                  <a:lnTo>
                    <a:pt x="2012" y="170"/>
                  </a:lnTo>
                  <a:lnTo>
                    <a:pt x="2022" y="168"/>
                  </a:lnTo>
                  <a:lnTo>
                    <a:pt x="2033" y="166"/>
                  </a:lnTo>
                  <a:lnTo>
                    <a:pt x="2045" y="165"/>
                  </a:lnTo>
                  <a:lnTo>
                    <a:pt x="2056" y="163"/>
                  </a:lnTo>
                  <a:lnTo>
                    <a:pt x="2066" y="160"/>
                  </a:lnTo>
                  <a:lnTo>
                    <a:pt x="2077" y="158"/>
                  </a:lnTo>
                  <a:lnTo>
                    <a:pt x="2089" y="155"/>
                  </a:lnTo>
                  <a:lnTo>
                    <a:pt x="2100" y="155"/>
                  </a:lnTo>
                  <a:lnTo>
                    <a:pt x="2110" y="153"/>
                  </a:lnTo>
                  <a:lnTo>
                    <a:pt x="2121" y="152"/>
                  </a:lnTo>
                  <a:lnTo>
                    <a:pt x="2133" y="148"/>
                  </a:lnTo>
                  <a:lnTo>
                    <a:pt x="2142" y="147"/>
                  </a:lnTo>
                  <a:lnTo>
                    <a:pt x="2154" y="145"/>
                  </a:lnTo>
                  <a:lnTo>
                    <a:pt x="2165" y="145"/>
                  </a:lnTo>
                  <a:lnTo>
                    <a:pt x="2177" y="142"/>
                  </a:lnTo>
                  <a:lnTo>
                    <a:pt x="2187" y="140"/>
                  </a:lnTo>
                  <a:lnTo>
                    <a:pt x="2198" y="139"/>
                  </a:lnTo>
                  <a:lnTo>
                    <a:pt x="2209" y="135"/>
                  </a:lnTo>
                  <a:lnTo>
                    <a:pt x="2221" y="134"/>
                  </a:lnTo>
                  <a:lnTo>
                    <a:pt x="2231" y="132"/>
                  </a:lnTo>
                  <a:lnTo>
                    <a:pt x="2242" y="135"/>
                  </a:lnTo>
                  <a:lnTo>
                    <a:pt x="2253" y="145"/>
                  </a:lnTo>
                  <a:lnTo>
                    <a:pt x="2265" y="139"/>
                  </a:lnTo>
                  <a:lnTo>
                    <a:pt x="2275" y="183"/>
                  </a:lnTo>
                  <a:lnTo>
                    <a:pt x="2286" y="117"/>
                  </a:lnTo>
                  <a:lnTo>
                    <a:pt x="2298" y="121"/>
                  </a:lnTo>
                  <a:lnTo>
                    <a:pt x="2307" y="130"/>
                  </a:lnTo>
                  <a:lnTo>
                    <a:pt x="2319" y="135"/>
                  </a:lnTo>
                  <a:lnTo>
                    <a:pt x="2330" y="140"/>
                  </a:lnTo>
                  <a:lnTo>
                    <a:pt x="2342" y="142"/>
                  </a:lnTo>
                  <a:lnTo>
                    <a:pt x="2351" y="144"/>
                  </a:lnTo>
                  <a:lnTo>
                    <a:pt x="2363" y="147"/>
                  </a:lnTo>
                  <a:lnTo>
                    <a:pt x="2374" y="147"/>
                  </a:lnTo>
                  <a:lnTo>
                    <a:pt x="2386" y="150"/>
                  </a:lnTo>
                  <a:lnTo>
                    <a:pt x="2395" y="150"/>
                  </a:lnTo>
                  <a:lnTo>
                    <a:pt x="2407" y="150"/>
                  </a:lnTo>
                  <a:lnTo>
                    <a:pt x="2418" y="153"/>
                  </a:lnTo>
                  <a:lnTo>
                    <a:pt x="2430" y="155"/>
                  </a:lnTo>
                  <a:lnTo>
                    <a:pt x="2439" y="155"/>
                  </a:lnTo>
                  <a:lnTo>
                    <a:pt x="2451" y="157"/>
                  </a:lnTo>
                  <a:lnTo>
                    <a:pt x="2462" y="157"/>
                  </a:lnTo>
                  <a:lnTo>
                    <a:pt x="2472" y="155"/>
                  </a:lnTo>
                  <a:lnTo>
                    <a:pt x="2484" y="157"/>
                  </a:lnTo>
                  <a:lnTo>
                    <a:pt x="2495" y="157"/>
                  </a:lnTo>
                  <a:lnTo>
                    <a:pt x="2506" y="158"/>
                  </a:lnTo>
                  <a:lnTo>
                    <a:pt x="2516" y="158"/>
                  </a:lnTo>
                  <a:lnTo>
                    <a:pt x="2528" y="158"/>
                  </a:lnTo>
                  <a:lnTo>
                    <a:pt x="2539" y="160"/>
                  </a:lnTo>
                  <a:lnTo>
                    <a:pt x="2550" y="160"/>
                  </a:lnTo>
                  <a:lnTo>
                    <a:pt x="2560" y="160"/>
                  </a:lnTo>
                  <a:lnTo>
                    <a:pt x="2572" y="161"/>
                  </a:lnTo>
                  <a:lnTo>
                    <a:pt x="2583" y="161"/>
                  </a:lnTo>
                  <a:lnTo>
                    <a:pt x="2594" y="161"/>
                  </a:lnTo>
                  <a:lnTo>
                    <a:pt x="2604" y="163"/>
                  </a:lnTo>
                  <a:lnTo>
                    <a:pt x="2616" y="163"/>
                  </a:lnTo>
                  <a:lnTo>
                    <a:pt x="2627" y="163"/>
                  </a:lnTo>
                  <a:lnTo>
                    <a:pt x="2637" y="163"/>
                  </a:lnTo>
                  <a:lnTo>
                    <a:pt x="2648" y="163"/>
                  </a:lnTo>
                  <a:lnTo>
                    <a:pt x="2660" y="163"/>
                  </a:lnTo>
                  <a:lnTo>
                    <a:pt x="2671" y="163"/>
                  </a:lnTo>
                  <a:lnTo>
                    <a:pt x="2681" y="165"/>
                  </a:lnTo>
                  <a:lnTo>
                    <a:pt x="2692" y="165"/>
                  </a:lnTo>
                  <a:lnTo>
                    <a:pt x="2704" y="165"/>
                  </a:lnTo>
                  <a:lnTo>
                    <a:pt x="2715" y="166"/>
                  </a:lnTo>
                  <a:lnTo>
                    <a:pt x="2725" y="165"/>
                  </a:lnTo>
                  <a:lnTo>
                    <a:pt x="2736" y="168"/>
                  </a:lnTo>
                  <a:lnTo>
                    <a:pt x="2748" y="168"/>
                  </a:lnTo>
                  <a:lnTo>
                    <a:pt x="2759" y="168"/>
                  </a:lnTo>
                  <a:lnTo>
                    <a:pt x="2769" y="166"/>
                  </a:lnTo>
                  <a:lnTo>
                    <a:pt x="2781" y="166"/>
                  </a:lnTo>
                  <a:lnTo>
                    <a:pt x="2792" y="166"/>
                  </a:lnTo>
                  <a:lnTo>
                    <a:pt x="2802" y="166"/>
                  </a:lnTo>
                  <a:lnTo>
                    <a:pt x="2813" y="166"/>
                  </a:lnTo>
                  <a:lnTo>
                    <a:pt x="2825" y="166"/>
                  </a:lnTo>
                  <a:lnTo>
                    <a:pt x="2836" y="166"/>
                  </a:lnTo>
                  <a:lnTo>
                    <a:pt x="2846" y="165"/>
                  </a:lnTo>
                  <a:lnTo>
                    <a:pt x="2857" y="168"/>
                  </a:lnTo>
                  <a:lnTo>
                    <a:pt x="2869" y="168"/>
                  </a:lnTo>
                  <a:lnTo>
                    <a:pt x="2880" y="168"/>
                  </a:lnTo>
                  <a:lnTo>
                    <a:pt x="2890" y="168"/>
                  </a:lnTo>
                  <a:lnTo>
                    <a:pt x="2901" y="168"/>
                  </a:lnTo>
                  <a:lnTo>
                    <a:pt x="2913" y="166"/>
                  </a:lnTo>
                  <a:lnTo>
                    <a:pt x="2924" y="165"/>
                  </a:lnTo>
                  <a:lnTo>
                    <a:pt x="2934" y="165"/>
                  </a:lnTo>
                  <a:lnTo>
                    <a:pt x="2945" y="166"/>
                  </a:lnTo>
                  <a:lnTo>
                    <a:pt x="2957" y="166"/>
                  </a:lnTo>
                  <a:lnTo>
                    <a:pt x="2967" y="168"/>
                  </a:lnTo>
                  <a:lnTo>
                    <a:pt x="2978" y="168"/>
                  </a:lnTo>
                  <a:lnTo>
                    <a:pt x="2989" y="168"/>
                  </a:lnTo>
                  <a:lnTo>
                    <a:pt x="3001" y="168"/>
                  </a:lnTo>
                  <a:lnTo>
                    <a:pt x="3011" y="168"/>
                  </a:lnTo>
                  <a:lnTo>
                    <a:pt x="3022" y="168"/>
                  </a:lnTo>
                  <a:lnTo>
                    <a:pt x="3033" y="168"/>
                  </a:lnTo>
                  <a:lnTo>
                    <a:pt x="3045" y="166"/>
                  </a:lnTo>
                  <a:lnTo>
                    <a:pt x="3055" y="168"/>
                  </a:lnTo>
                  <a:lnTo>
                    <a:pt x="3066" y="168"/>
                  </a:lnTo>
                  <a:lnTo>
                    <a:pt x="3077" y="168"/>
                  </a:lnTo>
                  <a:lnTo>
                    <a:pt x="3089" y="168"/>
                  </a:lnTo>
                  <a:lnTo>
                    <a:pt x="3099" y="166"/>
                  </a:lnTo>
                  <a:lnTo>
                    <a:pt x="3110" y="166"/>
                  </a:lnTo>
                  <a:lnTo>
                    <a:pt x="3122" y="166"/>
                  </a:lnTo>
                  <a:lnTo>
                    <a:pt x="3131" y="168"/>
                  </a:lnTo>
                  <a:lnTo>
                    <a:pt x="3143" y="168"/>
                  </a:lnTo>
                  <a:lnTo>
                    <a:pt x="3154" y="168"/>
                  </a:lnTo>
                  <a:lnTo>
                    <a:pt x="3166" y="168"/>
                  </a:lnTo>
                  <a:lnTo>
                    <a:pt x="3175" y="168"/>
                  </a:lnTo>
                  <a:lnTo>
                    <a:pt x="3187" y="170"/>
                  </a:lnTo>
                  <a:lnTo>
                    <a:pt x="3198" y="170"/>
                  </a:lnTo>
                  <a:lnTo>
                    <a:pt x="3210" y="170"/>
                  </a:lnTo>
                  <a:lnTo>
                    <a:pt x="3219" y="170"/>
                  </a:lnTo>
                  <a:lnTo>
                    <a:pt x="3231" y="170"/>
                  </a:lnTo>
                  <a:lnTo>
                    <a:pt x="3242" y="170"/>
                  </a:lnTo>
                  <a:lnTo>
                    <a:pt x="3254" y="170"/>
                  </a:lnTo>
                  <a:lnTo>
                    <a:pt x="3263" y="171"/>
                  </a:lnTo>
                  <a:lnTo>
                    <a:pt x="3275" y="170"/>
                  </a:lnTo>
                  <a:lnTo>
                    <a:pt x="3286" y="171"/>
                  </a:lnTo>
                  <a:lnTo>
                    <a:pt x="3296" y="171"/>
                  </a:lnTo>
                  <a:lnTo>
                    <a:pt x="3308" y="171"/>
                  </a:lnTo>
                  <a:lnTo>
                    <a:pt x="3319" y="171"/>
                  </a:lnTo>
                  <a:lnTo>
                    <a:pt x="3330" y="170"/>
                  </a:lnTo>
                  <a:lnTo>
                    <a:pt x="3340" y="171"/>
                  </a:lnTo>
                  <a:lnTo>
                    <a:pt x="3352" y="171"/>
                  </a:lnTo>
                  <a:lnTo>
                    <a:pt x="3363" y="171"/>
                  </a:lnTo>
                  <a:lnTo>
                    <a:pt x="3374" y="171"/>
                  </a:lnTo>
                  <a:lnTo>
                    <a:pt x="3384" y="171"/>
                  </a:lnTo>
                  <a:lnTo>
                    <a:pt x="3396" y="171"/>
                  </a:lnTo>
                  <a:lnTo>
                    <a:pt x="3407" y="171"/>
                  </a:lnTo>
                  <a:lnTo>
                    <a:pt x="3419" y="173"/>
                  </a:lnTo>
                  <a:lnTo>
                    <a:pt x="3428" y="173"/>
                  </a:lnTo>
                  <a:lnTo>
                    <a:pt x="3440" y="173"/>
                  </a:lnTo>
                  <a:lnTo>
                    <a:pt x="3451" y="171"/>
                  </a:lnTo>
                  <a:lnTo>
                    <a:pt x="3461" y="171"/>
                  </a:lnTo>
                  <a:lnTo>
                    <a:pt x="3472" y="173"/>
                  </a:lnTo>
                  <a:lnTo>
                    <a:pt x="3484" y="175"/>
                  </a:lnTo>
                  <a:lnTo>
                    <a:pt x="3495" y="176"/>
                  </a:lnTo>
                  <a:lnTo>
                    <a:pt x="3505" y="176"/>
                  </a:lnTo>
                  <a:lnTo>
                    <a:pt x="3516" y="175"/>
                  </a:lnTo>
                  <a:lnTo>
                    <a:pt x="3528" y="176"/>
                  </a:lnTo>
                  <a:lnTo>
                    <a:pt x="3539" y="175"/>
                  </a:lnTo>
                  <a:lnTo>
                    <a:pt x="3549" y="176"/>
                  </a:lnTo>
                  <a:lnTo>
                    <a:pt x="3560" y="178"/>
                  </a:lnTo>
                  <a:lnTo>
                    <a:pt x="3572" y="178"/>
                  </a:lnTo>
                  <a:lnTo>
                    <a:pt x="3583" y="178"/>
                  </a:lnTo>
                  <a:lnTo>
                    <a:pt x="3593" y="178"/>
                  </a:lnTo>
                  <a:lnTo>
                    <a:pt x="3605" y="178"/>
                  </a:lnTo>
                  <a:lnTo>
                    <a:pt x="3616" y="178"/>
                  </a:lnTo>
                  <a:lnTo>
                    <a:pt x="3626" y="179"/>
                  </a:lnTo>
                  <a:lnTo>
                    <a:pt x="3637" y="179"/>
                  </a:lnTo>
                  <a:lnTo>
                    <a:pt x="3649" y="179"/>
                  </a:lnTo>
                  <a:lnTo>
                    <a:pt x="3660" y="179"/>
                  </a:lnTo>
                  <a:lnTo>
                    <a:pt x="3670" y="179"/>
                  </a:lnTo>
                  <a:lnTo>
                    <a:pt x="3681" y="179"/>
                  </a:lnTo>
                  <a:lnTo>
                    <a:pt x="3693" y="181"/>
                  </a:lnTo>
                  <a:lnTo>
                    <a:pt x="3704" y="181"/>
                  </a:lnTo>
                  <a:lnTo>
                    <a:pt x="3714" y="179"/>
                  </a:lnTo>
                  <a:lnTo>
                    <a:pt x="3725" y="179"/>
                  </a:lnTo>
                  <a:lnTo>
                    <a:pt x="3737" y="179"/>
                  </a:lnTo>
                  <a:lnTo>
                    <a:pt x="3748" y="181"/>
                  </a:lnTo>
                  <a:lnTo>
                    <a:pt x="3758" y="183"/>
                  </a:lnTo>
                  <a:lnTo>
                    <a:pt x="3769" y="179"/>
                  </a:lnTo>
                  <a:lnTo>
                    <a:pt x="3781" y="178"/>
                  </a:lnTo>
                  <a:lnTo>
                    <a:pt x="3791" y="181"/>
                  </a:lnTo>
                  <a:lnTo>
                    <a:pt x="3802" y="183"/>
                  </a:lnTo>
                  <a:lnTo>
                    <a:pt x="3813" y="181"/>
                  </a:lnTo>
                  <a:lnTo>
                    <a:pt x="3825" y="181"/>
                  </a:lnTo>
                  <a:lnTo>
                    <a:pt x="3835" y="183"/>
                  </a:lnTo>
                  <a:lnTo>
                    <a:pt x="3846" y="183"/>
                  </a:lnTo>
                  <a:lnTo>
                    <a:pt x="3857" y="183"/>
                  </a:lnTo>
                  <a:lnTo>
                    <a:pt x="3869" y="183"/>
                  </a:lnTo>
                  <a:lnTo>
                    <a:pt x="3879" y="184"/>
                  </a:lnTo>
                  <a:lnTo>
                    <a:pt x="3890" y="184"/>
                  </a:lnTo>
                  <a:lnTo>
                    <a:pt x="3901" y="184"/>
                  </a:lnTo>
                  <a:lnTo>
                    <a:pt x="3913" y="184"/>
                  </a:lnTo>
                  <a:lnTo>
                    <a:pt x="3923" y="188"/>
                  </a:lnTo>
                  <a:lnTo>
                    <a:pt x="3934" y="184"/>
                  </a:lnTo>
                  <a:lnTo>
                    <a:pt x="3946" y="186"/>
                  </a:lnTo>
                  <a:lnTo>
                    <a:pt x="3955" y="197"/>
                  </a:lnTo>
                  <a:lnTo>
                    <a:pt x="3967" y="196"/>
                  </a:lnTo>
                  <a:lnTo>
                    <a:pt x="3978" y="186"/>
                  </a:lnTo>
                  <a:lnTo>
                    <a:pt x="3990" y="184"/>
                  </a:lnTo>
                  <a:lnTo>
                    <a:pt x="3999" y="188"/>
                  </a:lnTo>
                  <a:lnTo>
                    <a:pt x="4011" y="197"/>
                  </a:lnTo>
                  <a:lnTo>
                    <a:pt x="4022" y="194"/>
                  </a:lnTo>
                  <a:lnTo>
                    <a:pt x="4034" y="179"/>
                  </a:lnTo>
                  <a:lnTo>
                    <a:pt x="4043" y="183"/>
                  </a:lnTo>
                  <a:lnTo>
                    <a:pt x="4055" y="186"/>
                  </a:lnTo>
                  <a:lnTo>
                    <a:pt x="4066" y="189"/>
                  </a:lnTo>
                  <a:lnTo>
                    <a:pt x="4078" y="189"/>
                  </a:lnTo>
                  <a:lnTo>
                    <a:pt x="4088" y="189"/>
                  </a:lnTo>
                  <a:lnTo>
                    <a:pt x="4099" y="189"/>
                  </a:lnTo>
                  <a:lnTo>
                    <a:pt x="4110" y="183"/>
                  </a:lnTo>
                  <a:lnTo>
                    <a:pt x="4120" y="181"/>
                  </a:lnTo>
                  <a:lnTo>
                    <a:pt x="4132" y="189"/>
                  </a:lnTo>
                  <a:lnTo>
                    <a:pt x="4143" y="192"/>
                  </a:lnTo>
                  <a:lnTo>
                    <a:pt x="4154" y="204"/>
                  </a:lnTo>
                  <a:lnTo>
                    <a:pt x="4164" y="201"/>
                  </a:lnTo>
                  <a:lnTo>
                    <a:pt x="4176" y="192"/>
                  </a:lnTo>
                  <a:lnTo>
                    <a:pt x="4187" y="191"/>
                  </a:lnTo>
                  <a:lnTo>
                    <a:pt x="4198" y="191"/>
                  </a:lnTo>
                  <a:lnTo>
                    <a:pt x="4208" y="192"/>
                  </a:lnTo>
                  <a:lnTo>
                    <a:pt x="4220" y="194"/>
                  </a:lnTo>
                  <a:lnTo>
                    <a:pt x="4231" y="192"/>
                  </a:lnTo>
                </a:path>
              </a:pathLst>
            </a:custGeom>
            <a:noFill/>
            <a:ln w="19050" cmpd="sng">
              <a:solidFill>
                <a:schemeClr val="bg1">
                  <a:lumMod val="50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3" name="Freeform 99"/>
            <p:cNvSpPr>
              <a:spLocks/>
            </p:cNvSpPr>
            <p:nvPr/>
          </p:nvSpPr>
          <p:spPr bwMode="auto">
            <a:xfrm>
              <a:off x="1429544" y="2190751"/>
              <a:ext cx="6713538" cy="1517650"/>
            </a:xfrm>
            <a:custGeom>
              <a:avLst/>
              <a:gdLst>
                <a:gd name="T0" fmla="*/ 65 w 4229"/>
                <a:gd name="T1" fmla="*/ 643 h 956"/>
                <a:gd name="T2" fmla="*/ 142 w 4229"/>
                <a:gd name="T3" fmla="*/ 640 h 956"/>
                <a:gd name="T4" fmla="*/ 220 w 4229"/>
                <a:gd name="T5" fmla="*/ 640 h 956"/>
                <a:gd name="T6" fmla="*/ 297 w 4229"/>
                <a:gd name="T7" fmla="*/ 26 h 956"/>
                <a:gd name="T8" fmla="*/ 374 w 4229"/>
                <a:gd name="T9" fmla="*/ 636 h 956"/>
                <a:gd name="T10" fmla="*/ 450 w 4229"/>
                <a:gd name="T11" fmla="*/ 599 h 956"/>
                <a:gd name="T12" fmla="*/ 527 w 4229"/>
                <a:gd name="T13" fmla="*/ 576 h 956"/>
                <a:gd name="T14" fmla="*/ 604 w 4229"/>
                <a:gd name="T15" fmla="*/ 553 h 956"/>
                <a:gd name="T16" fmla="*/ 680 w 4229"/>
                <a:gd name="T17" fmla="*/ 537 h 956"/>
                <a:gd name="T18" fmla="*/ 759 w 4229"/>
                <a:gd name="T19" fmla="*/ 519 h 956"/>
                <a:gd name="T20" fmla="*/ 835 w 4229"/>
                <a:gd name="T21" fmla="*/ 506 h 956"/>
                <a:gd name="T22" fmla="*/ 912 w 4229"/>
                <a:gd name="T23" fmla="*/ 491 h 956"/>
                <a:gd name="T24" fmla="*/ 989 w 4229"/>
                <a:gd name="T25" fmla="*/ 478 h 956"/>
                <a:gd name="T26" fmla="*/ 1065 w 4229"/>
                <a:gd name="T27" fmla="*/ 468 h 956"/>
                <a:gd name="T28" fmla="*/ 1142 w 4229"/>
                <a:gd name="T29" fmla="*/ 457 h 956"/>
                <a:gd name="T30" fmla="*/ 1219 w 4229"/>
                <a:gd name="T31" fmla="*/ 447 h 956"/>
                <a:gd name="T32" fmla="*/ 1295 w 4229"/>
                <a:gd name="T33" fmla="*/ 434 h 956"/>
                <a:gd name="T34" fmla="*/ 1374 w 4229"/>
                <a:gd name="T35" fmla="*/ 426 h 956"/>
                <a:gd name="T36" fmla="*/ 1450 w 4229"/>
                <a:gd name="T37" fmla="*/ 414 h 956"/>
                <a:gd name="T38" fmla="*/ 1527 w 4229"/>
                <a:gd name="T39" fmla="*/ 408 h 956"/>
                <a:gd name="T40" fmla="*/ 1604 w 4229"/>
                <a:gd name="T41" fmla="*/ 398 h 956"/>
                <a:gd name="T42" fmla="*/ 1681 w 4229"/>
                <a:gd name="T43" fmla="*/ 388 h 956"/>
                <a:gd name="T44" fmla="*/ 1757 w 4229"/>
                <a:gd name="T45" fmla="*/ 380 h 956"/>
                <a:gd name="T46" fmla="*/ 1834 w 4229"/>
                <a:gd name="T47" fmla="*/ 372 h 956"/>
                <a:gd name="T48" fmla="*/ 1912 w 4229"/>
                <a:gd name="T49" fmla="*/ 364 h 956"/>
                <a:gd name="T50" fmla="*/ 1989 w 4229"/>
                <a:gd name="T51" fmla="*/ 356 h 956"/>
                <a:gd name="T52" fmla="*/ 2066 w 4229"/>
                <a:gd name="T53" fmla="*/ 346 h 956"/>
                <a:gd name="T54" fmla="*/ 2142 w 4229"/>
                <a:gd name="T55" fmla="*/ 339 h 956"/>
                <a:gd name="T56" fmla="*/ 2219 w 4229"/>
                <a:gd name="T57" fmla="*/ 339 h 956"/>
                <a:gd name="T58" fmla="*/ 2296 w 4229"/>
                <a:gd name="T59" fmla="*/ 331 h 956"/>
                <a:gd name="T60" fmla="*/ 2372 w 4229"/>
                <a:gd name="T61" fmla="*/ 341 h 956"/>
                <a:gd name="T62" fmla="*/ 2449 w 4229"/>
                <a:gd name="T63" fmla="*/ 346 h 956"/>
                <a:gd name="T64" fmla="*/ 2527 w 4229"/>
                <a:gd name="T65" fmla="*/ 348 h 956"/>
                <a:gd name="T66" fmla="*/ 2604 w 4229"/>
                <a:gd name="T67" fmla="*/ 349 h 956"/>
                <a:gd name="T68" fmla="*/ 2681 w 4229"/>
                <a:gd name="T69" fmla="*/ 352 h 956"/>
                <a:gd name="T70" fmla="*/ 2758 w 4229"/>
                <a:gd name="T71" fmla="*/ 349 h 956"/>
                <a:gd name="T72" fmla="*/ 2834 w 4229"/>
                <a:gd name="T73" fmla="*/ 352 h 956"/>
                <a:gd name="T74" fmla="*/ 2911 w 4229"/>
                <a:gd name="T75" fmla="*/ 352 h 956"/>
                <a:gd name="T76" fmla="*/ 2988 w 4229"/>
                <a:gd name="T77" fmla="*/ 356 h 956"/>
                <a:gd name="T78" fmla="*/ 3066 w 4229"/>
                <a:gd name="T79" fmla="*/ 356 h 956"/>
                <a:gd name="T80" fmla="*/ 3143 w 4229"/>
                <a:gd name="T81" fmla="*/ 357 h 956"/>
                <a:gd name="T82" fmla="*/ 3219 w 4229"/>
                <a:gd name="T83" fmla="*/ 359 h 956"/>
                <a:gd name="T84" fmla="*/ 3296 w 4229"/>
                <a:gd name="T85" fmla="*/ 359 h 956"/>
                <a:gd name="T86" fmla="*/ 3373 w 4229"/>
                <a:gd name="T87" fmla="*/ 359 h 956"/>
                <a:gd name="T88" fmla="*/ 3449 w 4229"/>
                <a:gd name="T89" fmla="*/ 361 h 956"/>
                <a:gd name="T90" fmla="*/ 3526 w 4229"/>
                <a:gd name="T91" fmla="*/ 361 h 956"/>
                <a:gd name="T92" fmla="*/ 3603 w 4229"/>
                <a:gd name="T93" fmla="*/ 362 h 956"/>
                <a:gd name="T94" fmla="*/ 3681 w 4229"/>
                <a:gd name="T95" fmla="*/ 361 h 956"/>
                <a:gd name="T96" fmla="*/ 3758 w 4229"/>
                <a:gd name="T97" fmla="*/ 359 h 956"/>
                <a:gd name="T98" fmla="*/ 3834 w 4229"/>
                <a:gd name="T99" fmla="*/ 362 h 956"/>
                <a:gd name="T100" fmla="*/ 3911 w 4229"/>
                <a:gd name="T101" fmla="*/ 362 h 956"/>
                <a:gd name="T102" fmla="*/ 3988 w 4229"/>
                <a:gd name="T103" fmla="*/ 375 h 956"/>
                <a:gd name="T104" fmla="*/ 4065 w 4229"/>
                <a:gd name="T105" fmla="*/ 364 h 956"/>
                <a:gd name="T106" fmla="*/ 4141 w 4229"/>
                <a:gd name="T107" fmla="*/ 369 h 956"/>
                <a:gd name="T108" fmla="*/ 4220 w 4229"/>
                <a:gd name="T109" fmla="*/ 367 h 9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229" h="956">
                  <a:moveTo>
                    <a:pt x="0" y="646"/>
                  </a:moveTo>
                  <a:lnTo>
                    <a:pt x="11" y="646"/>
                  </a:lnTo>
                  <a:lnTo>
                    <a:pt x="21" y="643"/>
                  </a:lnTo>
                  <a:lnTo>
                    <a:pt x="33" y="643"/>
                  </a:lnTo>
                  <a:lnTo>
                    <a:pt x="44" y="641"/>
                  </a:lnTo>
                  <a:lnTo>
                    <a:pt x="55" y="644"/>
                  </a:lnTo>
                  <a:lnTo>
                    <a:pt x="65" y="643"/>
                  </a:lnTo>
                  <a:lnTo>
                    <a:pt x="77" y="641"/>
                  </a:lnTo>
                  <a:lnTo>
                    <a:pt x="88" y="643"/>
                  </a:lnTo>
                  <a:lnTo>
                    <a:pt x="99" y="643"/>
                  </a:lnTo>
                  <a:lnTo>
                    <a:pt x="109" y="641"/>
                  </a:lnTo>
                  <a:lnTo>
                    <a:pt x="121" y="641"/>
                  </a:lnTo>
                  <a:lnTo>
                    <a:pt x="132" y="641"/>
                  </a:lnTo>
                  <a:lnTo>
                    <a:pt x="142" y="640"/>
                  </a:lnTo>
                  <a:lnTo>
                    <a:pt x="153" y="640"/>
                  </a:lnTo>
                  <a:lnTo>
                    <a:pt x="165" y="640"/>
                  </a:lnTo>
                  <a:lnTo>
                    <a:pt x="176" y="638"/>
                  </a:lnTo>
                  <a:lnTo>
                    <a:pt x="186" y="640"/>
                  </a:lnTo>
                  <a:lnTo>
                    <a:pt x="197" y="638"/>
                  </a:lnTo>
                  <a:lnTo>
                    <a:pt x="209" y="638"/>
                  </a:lnTo>
                  <a:lnTo>
                    <a:pt x="220" y="640"/>
                  </a:lnTo>
                  <a:lnTo>
                    <a:pt x="230" y="636"/>
                  </a:lnTo>
                  <a:lnTo>
                    <a:pt x="241" y="633"/>
                  </a:lnTo>
                  <a:lnTo>
                    <a:pt x="253" y="625"/>
                  </a:lnTo>
                  <a:lnTo>
                    <a:pt x="264" y="633"/>
                  </a:lnTo>
                  <a:lnTo>
                    <a:pt x="274" y="460"/>
                  </a:lnTo>
                  <a:lnTo>
                    <a:pt x="285" y="0"/>
                  </a:lnTo>
                  <a:lnTo>
                    <a:pt x="297" y="26"/>
                  </a:lnTo>
                  <a:lnTo>
                    <a:pt x="307" y="887"/>
                  </a:lnTo>
                  <a:lnTo>
                    <a:pt x="318" y="956"/>
                  </a:lnTo>
                  <a:lnTo>
                    <a:pt x="329" y="814"/>
                  </a:lnTo>
                  <a:lnTo>
                    <a:pt x="341" y="721"/>
                  </a:lnTo>
                  <a:lnTo>
                    <a:pt x="351" y="674"/>
                  </a:lnTo>
                  <a:lnTo>
                    <a:pt x="362" y="651"/>
                  </a:lnTo>
                  <a:lnTo>
                    <a:pt x="374" y="636"/>
                  </a:lnTo>
                  <a:lnTo>
                    <a:pt x="385" y="626"/>
                  </a:lnTo>
                  <a:lnTo>
                    <a:pt x="395" y="622"/>
                  </a:lnTo>
                  <a:lnTo>
                    <a:pt x="406" y="615"/>
                  </a:lnTo>
                  <a:lnTo>
                    <a:pt x="418" y="610"/>
                  </a:lnTo>
                  <a:lnTo>
                    <a:pt x="429" y="607"/>
                  </a:lnTo>
                  <a:lnTo>
                    <a:pt x="439" y="600"/>
                  </a:lnTo>
                  <a:lnTo>
                    <a:pt x="450" y="599"/>
                  </a:lnTo>
                  <a:lnTo>
                    <a:pt x="462" y="595"/>
                  </a:lnTo>
                  <a:lnTo>
                    <a:pt x="471" y="592"/>
                  </a:lnTo>
                  <a:lnTo>
                    <a:pt x="483" y="587"/>
                  </a:lnTo>
                  <a:lnTo>
                    <a:pt x="494" y="586"/>
                  </a:lnTo>
                  <a:lnTo>
                    <a:pt x="506" y="581"/>
                  </a:lnTo>
                  <a:lnTo>
                    <a:pt x="516" y="578"/>
                  </a:lnTo>
                  <a:lnTo>
                    <a:pt x="527" y="576"/>
                  </a:lnTo>
                  <a:lnTo>
                    <a:pt x="538" y="571"/>
                  </a:lnTo>
                  <a:lnTo>
                    <a:pt x="550" y="568"/>
                  </a:lnTo>
                  <a:lnTo>
                    <a:pt x="560" y="565"/>
                  </a:lnTo>
                  <a:lnTo>
                    <a:pt x="571" y="563"/>
                  </a:lnTo>
                  <a:lnTo>
                    <a:pt x="582" y="558"/>
                  </a:lnTo>
                  <a:lnTo>
                    <a:pt x="594" y="555"/>
                  </a:lnTo>
                  <a:lnTo>
                    <a:pt x="604" y="553"/>
                  </a:lnTo>
                  <a:lnTo>
                    <a:pt x="615" y="550"/>
                  </a:lnTo>
                  <a:lnTo>
                    <a:pt x="626" y="548"/>
                  </a:lnTo>
                  <a:lnTo>
                    <a:pt x="636" y="545"/>
                  </a:lnTo>
                  <a:lnTo>
                    <a:pt x="648" y="543"/>
                  </a:lnTo>
                  <a:lnTo>
                    <a:pt x="659" y="542"/>
                  </a:lnTo>
                  <a:lnTo>
                    <a:pt x="671" y="540"/>
                  </a:lnTo>
                  <a:lnTo>
                    <a:pt x="680" y="537"/>
                  </a:lnTo>
                  <a:lnTo>
                    <a:pt x="692" y="535"/>
                  </a:lnTo>
                  <a:lnTo>
                    <a:pt x="703" y="532"/>
                  </a:lnTo>
                  <a:lnTo>
                    <a:pt x="715" y="530"/>
                  </a:lnTo>
                  <a:lnTo>
                    <a:pt x="724" y="527"/>
                  </a:lnTo>
                  <a:lnTo>
                    <a:pt x="736" y="525"/>
                  </a:lnTo>
                  <a:lnTo>
                    <a:pt x="747" y="522"/>
                  </a:lnTo>
                  <a:lnTo>
                    <a:pt x="759" y="519"/>
                  </a:lnTo>
                  <a:lnTo>
                    <a:pt x="768" y="516"/>
                  </a:lnTo>
                  <a:lnTo>
                    <a:pt x="780" y="516"/>
                  </a:lnTo>
                  <a:lnTo>
                    <a:pt x="791" y="514"/>
                  </a:lnTo>
                  <a:lnTo>
                    <a:pt x="801" y="512"/>
                  </a:lnTo>
                  <a:lnTo>
                    <a:pt x="812" y="511"/>
                  </a:lnTo>
                  <a:lnTo>
                    <a:pt x="824" y="507"/>
                  </a:lnTo>
                  <a:lnTo>
                    <a:pt x="835" y="506"/>
                  </a:lnTo>
                  <a:lnTo>
                    <a:pt x="845" y="504"/>
                  </a:lnTo>
                  <a:lnTo>
                    <a:pt x="857" y="503"/>
                  </a:lnTo>
                  <a:lnTo>
                    <a:pt x="868" y="499"/>
                  </a:lnTo>
                  <a:lnTo>
                    <a:pt x="879" y="498"/>
                  </a:lnTo>
                  <a:lnTo>
                    <a:pt x="889" y="494"/>
                  </a:lnTo>
                  <a:lnTo>
                    <a:pt x="901" y="493"/>
                  </a:lnTo>
                  <a:lnTo>
                    <a:pt x="912" y="491"/>
                  </a:lnTo>
                  <a:lnTo>
                    <a:pt x="923" y="489"/>
                  </a:lnTo>
                  <a:lnTo>
                    <a:pt x="933" y="486"/>
                  </a:lnTo>
                  <a:lnTo>
                    <a:pt x="945" y="485"/>
                  </a:lnTo>
                  <a:lnTo>
                    <a:pt x="956" y="483"/>
                  </a:lnTo>
                  <a:lnTo>
                    <a:pt x="966" y="483"/>
                  </a:lnTo>
                  <a:lnTo>
                    <a:pt x="977" y="480"/>
                  </a:lnTo>
                  <a:lnTo>
                    <a:pt x="989" y="478"/>
                  </a:lnTo>
                  <a:lnTo>
                    <a:pt x="1000" y="476"/>
                  </a:lnTo>
                  <a:lnTo>
                    <a:pt x="1010" y="475"/>
                  </a:lnTo>
                  <a:lnTo>
                    <a:pt x="1021" y="473"/>
                  </a:lnTo>
                  <a:lnTo>
                    <a:pt x="1033" y="472"/>
                  </a:lnTo>
                  <a:lnTo>
                    <a:pt x="1044" y="470"/>
                  </a:lnTo>
                  <a:lnTo>
                    <a:pt x="1054" y="468"/>
                  </a:lnTo>
                  <a:lnTo>
                    <a:pt x="1065" y="468"/>
                  </a:lnTo>
                  <a:lnTo>
                    <a:pt x="1077" y="467"/>
                  </a:lnTo>
                  <a:lnTo>
                    <a:pt x="1088" y="463"/>
                  </a:lnTo>
                  <a:lnTo>
                    <a:pt x="1098" y="462"/>
                  </a:lnTo>
                  <a:lnTo>
                    <a:pt x="1109" y="460"/>
                  </a:lnTo>
                  <a:lnTo>
                    <a:pt x="1121" y="460"/>
                  </a:lnTo>
                  <a:lnTo>
                    <a:pt x="1131" y="458"/>
                  </a:lnTo>
                  <a:lnTo>
                    <a:pt x="1142" y="457"/>
                  </a:lnTo>
                  <a:lnTo>
                    <a:pt x="1154" y="455"/>
                  </a:lnTo>
                  <a:lnTo>
                    <a:pt x="1165" y="455"/>
                  </a:lnTo>
                  <a:lnTo>
                    <a:pt x="1175" y="452"/>
                  </a:lnTo>
                  <a:lnTo>
                    <a:pt x="1186" y="450"/>
                  </a:lnTo>
                  <a:lnTo>
                    <a:pt x="1198" y="449"/>
                  </a:lnTo>
                  <a:lnTo>
                    <a:pt x="1209" y="447"/>
                  </a:lnTo>
                  <a:lnTo>
                    <a:pt x="1219" y="447"/>
                  </a:lnTo>
                  <a:lnTo>
                    <a:pt x="1230" y="444"/>
                  </a:lnTo>
                  <a:lnTo>
                    <a:pt x="1242" y="444"/>
                  </a:lnTo>
                  <a:lnTo>
                    <a:pt x="1253" y="442"/>
                  </a:lnTo>
                  <a:lnTo>
                    <a:pt x="1263" y="441"/>
                  </a:lnTo>
                  <a:lnTo>
                    <a:pt x="1274" y="437"/>
                  </a:lnTo>
                  <a:lnTo>
                    <a:pt x="1286" y="436"/>
                  </a:lnTo>
                  <a:lnTo>
                    <a:pt x="1295" y="434"/>
                  </a:lnTo>
                  <a:lnTo>
                    <a:pt x="1307" y="434"/>
                  </a:lnTo>
                  <a:lnTo>
                    <a:pt x="1318" y="432"/>
                  </a:lnTo>
                  <a:lnTo>
                    <a:pt x="1330" y="431"/>
                  </a:lnTo>
                  <a:lnTo>
                    <a:pt x="1340" y="429"/>
                  </a:lnTo>
                  <a:lnTo>
                    <a:pt x="1351" y="427"/>
                  </a:lnTo>
                  <a:lnTo>
                    <a:pt x="1362" y="426"/>
                  </a:lnTo>
                  <a:lnTo>
                    <a:pt x="1374" y="426"/>
                  </a:lnTo>
                  <a:lnTo>
                    <a:pt x="1384" y="426"/>
                  </a:lnTo>
                  <a:lnTo>
                    <a:pt x="1395" y="424"/>
                  </a:lnTo>
                  <a:lnTo>
                    <a:pt x="1406" y="421"/>
                  </a:lnTo>
                  <a:lnTo>
                    <a:pt x="1418" y="421"/>
                  </a:lnTo>
                  <a:lnTo>
                    <a:pt x="1428" y="419"/>
                  </a:lnTo>
                  <a:lnTo>
                    <a:pt x="1439" y="416"/>
                  </a:lnTo>
                  <a:lnTo>
                    <a:pt x="1450" y="414"/>
                  </a:lnTo>
                  <a:lnTo>
                    <a:pt x="1460" y="414"/>
                  </a:lnTo>
                  <a:lnTo>
                    <a:pt x="1472" y="414"/>
                  </a:lnTo>
                  <a:lnTo>
                    <a:pt x="1483" y="413"/>
                  </a:lnTo>
                  <a:lnTo>
                    <a:pt x="1495" y="411"/>
                  </a:lnTo>
                  <a:lnTo>
                    <a:pt x="1504" y="410"/>
                  </a:lnTo>
                  <a:lnTo>
                    <a:pt x="1516" y="408"/>
                  </a:lnTo>
                  <a:lnTo>
                    <a:pt x="1527" y="408"/>
                  </a:lnTo>
                  <a:lnTo>
                    <a:pt x="1539" y="406"/>
                  </a:lnTo>
                  <a:lnTo>
                    <a:pt x="1548" y="403"/>
                  </a:lnTo>
                  <a:lnTo>
                    <a:pt x="1560" y="401"/>
                  </a:lnTo>
                  <a:lnTo>
                    <a:pt x="1571" y="401"/>
                  </a:lnTo>
                  <a:lnTo>
                    <a:pt x="1583" y="401"/>
                  </a:lnTo>
                  <a:lnTo>
                    <a:pt x="1592" y="398"/>
                  </a:lnTo>
                  <a:lnTo>
                    <a:pt x="1604" y="398"/>
                  </a:lnTo>
                  <a:lnTo>
                    <a:pt x="1615" y="396"/>
                  </a:lnTo>
                  <a:lnTo>
                    <a:pt x="1625" y="395"/>
                  </a:lnTo>
                  <a:lnTo>
                    <a:pt x="1637" y="393"/>
                  </a:lnTo>
                  <a:lnTo>
                    <a:pt x="1648" y="392"/>
                  </a:lnTo>
                  <a:lnTo>
                    <a:pt x="1659" y="390"/>
                  </a:lnTo>
                  <a:lnTo>
                    <a:pt x="1669" y="390"/>
                  </a:lnTo>
                  <a:lnTo>
                    <a:pt x="1681" y="388"/>
                  </a:lnTo>
                  <a:lnTo>
                    <a:pt x="1692" y="388"/>
                  </a:lnTo>
                  <a:lnTo>
                    <a:pt x="1703" y="387"/>
                  </a:lnTo>
                  <a:lnTo>
                    <a:pt x="1713" y="385"/>
                  </a:lnTo>
                  <a:lnTo>
                    <a:pt x="1725" y="383"/>
                  </a:lnTo>
                  <a:lnTo>
                    <a:pt x="1736" y="383"/>
                  </a:lnTo>
                  <a:lnTo>
                    <a:pt x="1747" y="382"/>
                  </a:lnTo>
                  <a:lnTo>
                    <a:pt x="1757" y="380"/>
                  </a:lnTo>
                  <a:lnTo>
                    <a:pt x="1769" y="380"/>
                  </a:lnTo>
                  <a:lnTo>
                    <a:pt x="1780" y="377"/>
                  </a:lnTo>
                  <a:lnTo>
                    <a:pt x="1790" y="377"/>
                  </a:lnTo>
                  <a:lnTo>
                    <a:pt x="1801" y="375"/>
                  </a:lnTo>
                  <a:lnTo>
                    <a:pt x="1813" y="374"/>
                  </a:lnTo>
                  <a:lnTo>
                    <a:pt x="1824" y="372"/>
                  </a:lnTo>
                  <a:lnTo>
                    <a:pt x="1834" y="372"/>
                  </a:lnTo>
                  <a:lnTo>
                    <a:pt x="1845" y="370"/>
                  </a:lnTo>
                  <a:lnTo>
                    <a:pt x="1857" y="370"/>
                  </a:lnTo>
                  <a:lnTo>
                    <a:pt x="1868" y="369"/>
                  </a:lnTo>
                  <a:lnTo>
                    <a:pt x="1878" y="367"/>
                  </a:lnTo>
                  <a:lnTo>
                    <a:pt x="1889" y="365"/>
                  </a:lnTo>
                  <a:lnTo>
                    <a:pt x="1901" y="364"/>
                  </a:lnTo>
                  <a:lnTo>
                    <a:pt x="1912" y="364"/>
                  </a:lnTo>
                  <a:lnTo>
                    <a:pt x="1922" y="362"/>
                  </a:lnTo>
                  <a:lnTo>
                    <a:pt x="1933" y="361"/>
                  </a:lnTo>
                  <a:lnTo>
                    <a:pt x="1945" y="361"/>
                  </a:lnTo>
                  <a:lnTo>
                    <a:pt x="1955" y="359"/>
                  </a:lnTo>
                  <a:lnTo>
                    <a:pt x="1966" y="357"/>
                  </a:lnTo>
                  <a:lnTo>
                    <a:pt x="1978" y="356"/>
                  </a:lnTo>
                  <a:lnTo>
                    <a:pt x="1989" y="356"/>
                  </a:lnTo>
                  <a:lnTo>
                    <a:pt x="1999" y="354"/>
                  </a:lnTo>
                  <a:lnTo>
                    <a:pt x="2010" y="351"/>
                  </a:lnTo>
                  <a:lnTo>
                    <a:pt x="2022" y="351"/>
                  </a:lnTo>
                  <a:lnTo>
                    <a:pt x="2033" y="349"/>
                  </a:lnTo>
                  <a:lnTo>
                    <a:pt x="2043" y="349"/>
                  </a:lnTo>
                  <a:lnTo>
                    <a:pt x="2054" y="349"/>
                  </a:lnTo>
                  <a:lnTo>
                    <a:pt x="2066" y="346"/>
                  </a:lnTo>
                  <a:lnTo>
                    <a:pt x="2077" y="346"/>
                  </a:lnTo>
                  <a:lnTo>
                    <a:pt x="2087" y="344"/>
                  </a:lnTo>
                  <a:lnTo>
                    <a:pt x="2098" y="344"/>
                  </a:lnTo>
                  <a:lnTo>
                    <a:pt x="2110" y="343"/>
                  </a:lnTo>
                  <a:lnTo>
                    <a:pt x="2119" y="341"/>
                  </a:lnTo>
                  <a:lnTo>
                    <a:pt x="2131" y="339"/>
                  </a:lnTo>
                  <a:lnTo>
                    <a:pt x="2142" y="339"/>
                  </a:lnTo>
                  <a:lnTo>
                    <a:pt x="2154" y="338"/>
                  </a:lnTo>
                  <a:lnTo>
                    <a:pt x="2164" y="336"/>
                  </a:lnTo>
                  <a:lnTo>
                    <a:pt x="2175" y="336"/>
                  </a:lnTo>
                  <a:lnTo>
                    <a:pt x="2186" y="334"/>
                  </a:lnTo>
                  <a:lnTo>
                    <a:pt x="2198" y="333"/>
                  </a:lnTo>
                  <a:lnTo>
                    <a:pt x="2208" y="333"/>
                  </a:lnTo>
                  <a:lnTo>
                    <a:pt x="2219" y="339"/>
                  </a:lnTo>
                  <a:lnTo>
                    <a:pt x="2230" y="344"/>
                  </a:lnTo>
                  <a:lnTo>
                    <a:pt x="2242" y="341"/>
                  </a:lnTo>
                  <a:lnTo>
                    <a:pt x="2252" y="374"/>
                  </a:lnTo>
                  <a:lnTo>
                    <a:pt x="2263" y="305"/>
                  </a:lnTo>
                  <a:lnTo>
                    <a:pt x="2275" y="313"/>
                  </a:lnTo>
                  <a:lnTo>
                    <a:pt x="2284" y="325"/>
                  </a:lnTo>
                  <a:lnTo>
                    <a:pt x="2296" y="331"/>
                  </a:lnTo>
                  <a:lnTo>
                    <a:pt x="2307" y="333"/>
                  </a:lnTo>
                  <a:lnTo>
                    <a:pt x="2319" y="336"/>
                  </a:lnTo>
                  <a:lnTo>
                    <a:pt x="2328" y="338"/>
                  </a:lnTo>
                  <a:lnTo>
                    <a:pt x="2340" y="339"/>
                  </a:lnTo>
                  <a:lnTo>
                    <a:pt x="2351" y="339"/>
                  </a:lnTo>
                  <a:lnTo>
                    <a:pt x="2363" y="341"/>
                  </a:lnTo>
                  <a:lnTo>
                    <a:pt x="2372" y="341"/>
                  </a:lnTo>
                  <a:lnTo>
                    <a:pt x="2384" y="343"/>
                  </a:lnTo>
                  <a:lnTo>
                    <a:pt x="2395" y="344"/>
                  </a:lnTo>
                  <a:lnTo>
                    <a:pt x="2407" y="344"/>
                  </a:lnTo>
                  <a:lnTo>
                    <a:pt x="2416" y="344"/>
                  </a:lnTo>
                  <a:lnTo>
                    <a:pt x="2428" y="344"/>
                  </a:lnTo>
                  <a:lnTo>
                    <a:pt x="2439" y="346"/>
                  </a:lnTo>
                  <a:lnTo>
                    <a:pt x="2449" y="346"/>
                  </a:lnTo>
                  <a:lnTo>
                    <a:pt x="2461" y="348"/>
                  </a:lnTo>
                  <a:lnTo>
                    <a:pt x="2472" y="348"/>
                  </a:lnTo>
                  <a:lnTo>
                    <a:pt x="2483" y="346"/>
                  </a:lnTo>
                  <a:lnTo>
                    <a:pt x="2493" y="348"/>
                  </a:lnTo>
                  <a:lnTo>
                    <a:pt x="2505" y="348"/>
                  </a:lnTo>
                  <a:lnTo>
                    <a:pt x="2516" y="348"/>
                  </a:lnTo>
                  <a:lnTo>
                    <a:pt x="2527" y="348"/>
                  </a:lnTo>
                  <a:lnTo>
                    <a:pt x="2537" y="348"/>
                  </a:lnTo>
                  <a:lnTo>
                    <a:pt x="2549" y="348"/>
                  </a:lnTo>
                  <a:lnTo>
                    <a:pt x="2560" y="348"/>
                  </a:lnTo>
                  <a:lnTo>
                    <a:pt x="2571" y="348"/>
                  </a:lnTo>
                  <a:lnTo>
                    <a:pt x="2581" y="349"/>
                  </a:lnTo>
                  <a:lnTo>
                    <a:pt x="2593" y="349"/>
                  </a:lnTo>
                  <a:lnTo>
                    <a:pt x="2604" y="349"/>
                  </a:lnTo>
                  <a:lnTo>
                    <a:pt x="2614" y="349"/>
                  </a:lnTo>
                  <a:lnTo>
                    <a:pt x="2625" y="349"/>
                  </a:lnTo>
                  <a:lnTo>
                    <a:pt x="2637" y="351"/>
                  </a:lnTo>
                  <a:lnTo>
                    <a:pt x="2648" y="352"/>
                  </a:lnTo>
                  <a:lnTo>
                    <a:pt x="2658" y="351"/>
                  </a:lnTo>
                  <a:lnTo>
                    <a:pt x="2669" y="351"/>
                  </a:lnTo>
                  <a:lnTo>
                    <a:pt x="2681" y="352"/>
                  </a:lnTo>
                  <a:lnTo>
                    <a:pt x="2692" y="349"/>
                  </a:lnTo>
                  <a:lnTo>
                    <a:pt x="2702" y="351"/>
                  </a:lnTo>
                  <a:lnTo>
                    <a:pt x="2713" y="351"/>
                  </a:lnTo>
                  <a:lnTo>
                    <a:pt x="2725" y="352"/>
                  </a:lnTo>
                  <a:lnTo>
                    <a:pt x="2736" y="351"/>
                  </a:lnTo>
                  <a:lnTo>
                    <a:pt x="2746" y="352"/>
                  </a:lnTo>
                  <a:lnTo>
                    <a:pt x="2758" y="349"/>
                  </a:lnTo>
                  <a:lnTo>
                    <a:pt x="2769" y="351"/>
                  </a:lnTo>
                  <a:lnTo>
                    <a:pt x="2779" y="352"/>
                  </a:lnTo>
                  <a:lnTo>
                    <a:pt x="2790" y="352"/>
                  </a:lnTo>
                  <a:lnTo>
                    <a:pt x="2802" y="351"/>
                  </a:lnTo>
                  <a:lnTo>
                    <a:pt x="2813" y="352"/>
                  </a:lnTo>
                  <a:lnTo>
                    <a:pt x="2823" y="352"/>
                  </a:lnTo>
                  <a:lnTo>
                    <a:pt x="2834" y="352"/>
                  </a:lnTo>
                  <a:lnTo>
                    <a:pt x="2846" y="354"/>
                  </a:lnTo>
                  <a:lnTo>
                    <a:pt x="2857" y="354"/>
                  </a:lnTo>
                  <a:lnTo>
                    <a:pt x="2867" y="354"/>
                  </a:lnTo>
                  <a:lnTo>
                    <a:pt x="2878" y="354"/>
                  </a:lnTo>
                  <a:lnTo>
                    <a:pt x="2890" y="352"/>
                  </a:lnTo>
                  <a:lnTo>
                    <a:pt x="2901" y="352"/>
                  </a:lnTo>
                  <a:lnTo>
                    <a:pt x="2911" y="352"/>
                  </a:lnTo>
                  <a:lnTo>
                    <a:pt x="2922" y="354"/>
                  </a:lnTo>
                  <a:lnTo>
                    <a:pt x="2934" y="354"/>
                  </a:lnTo>
                  <a:lnTo>
                    <a:pt x="2944" y="352"/>
                  </a:lnTo>
                  <a:lnTo>
                    <a:pt x="2955" y="352"/>
                  </a:lnTo>
                  <a:lnTo>
                    <a:pt x="2966" y="352"/>
                  </a:lnTo>
                  <a:lnTo>
                    <a:pt x="2978" y="356"/>
                  </a:lnTo>
                  <a:lnTo>
                    <a:pt x="2988" y="356"/>
                  </a:lnTo>
                  <a:lnTo>
                    <a:pt x="2999" y="357"/>
                  </a:lnTo>
                  <a:lnTo>
                    <a:pt x="3010" y="356"/>
                  </a:lnTo>
                  <a:lnTo>
                    <a:pt x="3022" y="356"/>
                  </a:lnTo>
                  <a:lnTo>
                    <a:pt x="3032" y="356"/>
                  </a:lnTo>
                  <a:lnTo>
                    <a:pt x="3043" y="356"/>
                  </a:lnTo>
                  <a:lnTo>
                    <a:pt x="3054" y="356"/>
                  </a:lnTo>
                  <a:lnTo>
                    <a:pt x="3066" y="356"/>
                  </a:lnTo>
                  <a:lnTo>
                    <a:pt x="3076" y="356"/>
                  </a:lnTo>
                  <a:lnTo>
                    <a:pt x="3087" y="356"/>
                  </a:lnTo>
                  <a:lnTo>
                    <a:pt x="3099" y="357"/>
                  </a:lnTo>
                  <a:lnTo>
                    <a:pt x="3108" y="357"/>
                  </a:lnTo>
                  <a:lnTo>
                    <a:pt x="3120" y="359"/>
                  </a:lnTo>
                  <a:lnTo>
                    <a:pt x="3131" y="356"/>
                  </a:lnTo>
                  <a:lnTo>
                    <a:pt x="3143" y="357"/>
                  </a:lnTo>
                  <a:lnTo>
                    <a:pt x="3152" y="357"/>
                  </a:lnTo>
                  <a:lnTo>
                    <a:pt x="3164" y="357"/>
                  </a:lnTo>
                  <a:lnTo>
                    <a:pt x="3175" y="356"/>
                  </a:lnTo>
                  <a:lnTo>
                    <a:pt x="3187" y="356"/>
                  </a:lnTo>
                  <a:lnTo>
                    <a:pt x="3196" y="357"/>
                  </a:lnTo>
                  <a:lnTo>
                    <a:pt x="3208" y="357"/>
                  </a:lnTo>
                  <a:lnTo>
                    <a:pt x="3219" y="359"/>
                  </a:lnTo>
                  <a:lnTo>
                    <a:pt x="3231" y="359"/>
                  </a:lnTo>
                  <a:lnTo>
                    <a:pt x="3240" y="357"/>
                  </a:lnTo>
                  <a:lnTo>
                    <a:pt x="3252" y="359"/>
                  </a:lnTo>
                  <a:lnTo>
                    <a:pt x="3263" y="359"/>
                  </a:lnTo>
                  <a:lnTo>
                    <a:pt x="3273" y="359"/>
                  </a:lnTo>
                  <a:lnTo>
                    <a:pt x="3285" y="359"/>
                  </a:lnTo>
                  <a:lnTo>
                    <a:pt x="3296" y="359"/>
                  </a:lnTo>
                  <a:lnTo>
                    <a:pt x="3307" y="357"/>
                  </a:lnTo>
                  <a:lnTo>
                    <a:pt x="3317" y="357"/>
                  </a:lnTo>
                  <a:lnTo>
                    <a:pt x="3329" y="359"/>
                  </a:lnTo>
                  <a:lnTo>
                    <a:pt x="3340" y="359"/>
                  </a:lnTo>
                  <a:lnTo>
                    <a:pt x="3351" y="359"/>
                  </a:lnTo>
                  <a:lnTo>
                    <a:pt x="3361" y="359"/>
                  </a:lnTo>
                  <a:lnTo>
                    <a:pt x="3373" y="359"/>
                  </a:lnTo>
                  <a:lnTo>
                    <a:pt x="3384" y="361"/>
                  </a:lnTo>
                  <a:lnTo>
                    <a:pt x="3396" y="361"/>
                  </a:lnTo>
                  <a:lnTo>
                    <a:pt x="3405" y="359"/>
                  </a:lnTo>
                  <a:lnTo>
                    <a:pt x="3417" y="361"/>
                  </a:lnTo>
                  <a:lnTo>
                    <a:pt x="3428" y="361"/>
                  </a:lnTo>
                  <a:lnTo>
                    <a:pt x="3438" y="361"/>
                  </a:lnTo>
                  <a:lnTo>
                    <a:pt x="3449" y="361"/>
                  </a:lnTo>
                  <a:lnTo>
                    <a:pt x="3461" y="361"/>
                  </a:lnTo>
                  <a:lnTo>
                    <a:pt x="3472" y="361"/>
                  </a:lnTo>
                  <a:lnTo>
                    <a:pt x="3482" y="361"/>
                  </a:lnTo>
                  <a:lnTo>
                    <a:pt x="3493" y="361"/>
                  </a:lnTo>
                  <a:lnTo>
                    <a:pt x="3505" y="361"/>
                  </a:lnTo>
                  <a:lnTo>
                    <a:pt x="3516" y="361"/>
                  </a:lnTo>
                  <a:lnTo>
                    <a:pt x="3526" y="361"/>
                  </a:lnTo>
                  <a:lnTo>
                    <a:pt x="3537" y="361"/>
                  </a:lnTo>
                  <a:lnTo>
                    <a:pt x="3549" y="361"/>
                  </a:lnTo>
                  <a:lnTo>
                    <a:pt x="3560" y="362"/>
                  </a:lnTo>
                  <a:lnTo>
                    <a:pt x="3570" y="362"/>
                  </a:lnTo>
                  <a:lnTo>
                    <a:pt x="3582" y="361"/>
                  </a:lnTo>
                  <a:lnTo>
                    <a:pt x="3593" y="362"/>
                  </a:lnTo>
                  <a:lnTo>
                    <a:pt x="3603" y="362"/>
                  </a:lnTo>
                  <a:lnTo>
                    <a:pt x="3614" y="361"/>
                  </a:lnTo>
                  <a:lnTo>
                    <a:pt x="3626" y="361"/>
                  </a:lnTo>
                  <a:lnTo>
                    <a:pt x="3637" y="361"/>
                  </a:lnTo>
                  <a:lnTo>
                    <a:pt x="3647" y="362"/>
                  </a:lnTo>
                  <a:lnTo>
                    <a:pt x="3658" y="361"/>
                  </a:lnTo>
                  <a:lnTo>
                    <a:pt x="3670" y="361"/>
                  </a:lnTo>
                  <a:lnTo>
                    <a:pt x="3681" y="361"/>
                  </a:lnTo>
                  <a:lnTo>
                    <a:pt x="3691" y="362"/>
                  </a:lnTo>
                  <a:lnTo>
                    <a:pt x="3702" y="361"/>
                  </a:lnTo>
                  <a:lnTo>
                    <a:pt x="3714" y="361"/>
                  </a:lnTo>
                  <a:lnTo>
                    <a:pt x="3725" y="361"/>
                  </a:lnTo>
                  <a:lnTo>
                    <a:pt x="3735" y="362"/>
                  </a:lnTo>
                  <a:lnTo>
                    <a:pt x="3746" y="359"/>
                  </a:lnTo>
                  <a:lnTo>
                    <a:pt x="3758" y="359"/>
                  </a:lnTo>
                  <a:lnTo>
                    <a:pt x="3768" y="362"/>
                  </a:lnTo>
                  <a:lnTo>
                    <a:pt x="3779" y="362"/>
                  </a:lnTo>
                  <a:lnTo>
                    <a:pt x="3790" y="361"/>
                  </a:lnTo>
                  <a:lnTo>
                    <a:pt x="3802" y="361"/>
                  </a:lnTo>
                  <a:lnTo>
                    <a:pt x="3812" y="361"/>
                  </a:lnTo>
                  <a:lnTo>
                    <a:pt x="3823" y="361"/>
                  </a:lnTo>
                  <a:lnTo>
                    <a:pt x="3834" y="362"/>
                  </a:lnTo>
                  <a:lnTo>
                    <a:pt x="3846" y="361"/>
                  </a:lnTo>
                  <a:lnTo>
                    <a:pt x="3856" y="362"/>
                  </a:lnTo>
                  <a:lnTo>
                    <a:pt x="3867" y="362"/>
                  </a:lnTo>
                  <a:lnTo>
                    <a:pt x="3878" y="362"/>
                  </a:lnTo>
                  <a:lnTo>
                    <a:pt x="3890" y="364"/>
                  </a:lnTo>
                  <a:lnTo>
                    <a:pt x="3900" y="367"/>
                  </a:lnTo>
                  <a:lnTo>
                    <a:pt x="3911" y="362"/>
                  </a:lnTo>
                  <a:lnTo>
                    <a:pt x="3923" y="362"/>
                  </a:lnTo>
                  <a:lnTo>
                    <a:pt x="3932" y="374"/>
                  </a:lnTo>
                  <a:lnTo>
                    <a:pt x="3944" y="374"/>
                  </a:lnTo>
                  <a:lnTo>
                    <a:pt x="3955" y="365"/>
                  </a:lnTo>
                  <a:lnTo>
                    <a:pt x="3967" y="362"/>
                  </a:lnTo>
                  <a:lnTo>
                    <a:pt x="3976" y="365"/>
                  </a:lnTo>
                  <a:lnTo>
                    <a:pt x="3988" y="375"/>
                  </a:lnTo>
                  <a:lnTo>
                    <a:pt x="3999" y="369"/>
                  </a:lnTo>
                  <a:lnTo>
                    <a:pt x="4011" y="354"/>
                  </a:lnTo>
                  <a:lnTo>
                    <a:pt x="4020" y="359"/>
                  </a:lnTo>
                  <a:lnTo>
                    <a:pt x="4032" y="362"/>
                  </a:lnTo>
                  <a:lnTo>
                    <a:pt x="4043" y="364"/>
                  </a:lnTo>
                  <a:lnTo>
                    <a:pt x="4055" y="364"/>
                  </a:lnTo>
                  <a:lnTo>
                    <a:pt x="4065" y="364"/>
                  </a:lnTo>
                  <a:lnTo>
                    <a:pt x="4076" y="364"/>
                  </a:lnTo>
                  <a:lnTo>
                    <a:pt x="4087" y="356"/>
                  </a:lnTo>
                  <a:lnTo>
                    <a:pt x="4097" y="357"/>
                  </a:lnTo>
                  <a:lnTo>
                    <a:pt x="4109" y="367"/>
                  </a:lnTo>
                  <a:lnTo>
                    <a:pt x="4120" y="379"/>
                  </a:lnTo>
                  <a:lnTo>
                    <a:pt x="4131" y="379"/>
                  </a:lnTo>
                  <a:lnTo>
                    <a:pt x="4141" y="369"/>
                  </a:lnTo>
                  <a:lnTo>
                    <a:pt x="4153" y="367"/>
                  </a:lnTo>
                  <a:lnTo>
                    <a:pt x="4164" y="367"/>
                  </a:lnTo>
                  <a:lnTo>
                    <a:pt x="4175" y="369"/>
                  </a:lnTo>
                  <a:lnTo>
                    <a:pt x="4185" y="367"/>
                  </a:lnTo>
                  <a:lnTo>
                    <a:pt x="4197" y="367"/>
                  </a:lnTo>
                  <a:lnTo>
                    <a:pt x="4208" y="365"/>
                  </a:lnTo>
                  <a:lnTo>
                    <a:pt x="4220" y="367"/>
                  </a:lnTo>
                  <a:lnTo>
                    <a:pt x="4229" y="367"/>
                  </a:lnTo>
                </a:path>
              </a:pathLst>
            </a:custGeom>
            <a:noFill/>
            <a:ln w="19050" cmpd="sng">
              <a:solidFill>
                <a:schemeClr val="bg1">
                  <a:lumMod val="50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4" name="Freeform 100"/>
            <p:cNvSpPr>
              <a:spLocks/>
            </p:cNvSpPr>
            <p:nvPr/>
          </p:nvSpPr>
          <p:spPr bwMode="auto">
            <a:xfrm>
              <a:off x="1410494" y="1246188"/>
              <a:ext cx="6718300" cy="2679700"/>
            </a:xfrm>
            <a:custGeom>
              <a:avLst/>
              <a:gdLst>
                <a:gd name="T0" fmla="*/ 67 w 4232"/>
                <a:gd name="T1" fmla="*/ 1236 h 1688"/>
                <a:gd name="T2" fmla="*/ 144 w 4232"/>
                <a:gd name="T3" fmla="*/ 1236 h 1688"/>
                <a:gd name="T4" fmla="*/ 221 w 4232"/>
                <a:gd name="T5" fmla="*/ 1235 h 1688"/>
                <a:gd name="T6" fmla="*/ 297 w 4232"/>
                <a:gd name="T7" fmla="*/ 750 h 1688"/>
                <a:gd name="T8" fmla="*/ 374 w 4232"/>
                <a:gd name="T9" fmla="*/ 1272 h 1688"/>
                <a:gd name="T10" fmla="*/ 451 w 4232"/>
                <a:gd name="T11" fmla="*/ 1231 h 1688"/>
                <a:gd name="T12" fmla="*/ 528 w 4232"/>
                <a:gd name="T13" fmla="*/ 1223 h 1688"/>
                <a:gd name="T14" fmla="*/ 606 w 4232"/>
                <a:gd name="T15" fmla="*/ 1218 h 1688"/>
                <a:gd name="T16" fmla="*/ 683 w 4232"/>
                <a:gd name="T17" fmla="*/ 1212 h 1688"/>
                <a:gd name="T18" fmla="*/ 759 w 4232"/>
                <a:gd name="T19" fmla="*/ 1208 h 1688"/>
                <a:gd name="T20" fmla="*/ 836 w 4232"/>
                <a:gd name="T21" fmla="*/ 1204 h 1688"/>
                <a:gd name="T22" fmla="*/ 913 w 4232"/>
                <a:gd name="T23" fmla="*/ 1197 h 1688"/>
                <a:gd name="T24" fmla="*/ 989 w 4232"/>
                <a:gd name="T25" fmla="*/ 1194 h 1688"/>
                <a:gd name="T26" fmla="*/ 1066 w 4232"/>
                <a:gd name="T27" fmla="*/ 1189 h 1688"/>
                <a:gd name="T28" fmla="*/ 1143 w 4232"/>
                <a:gd name="T29" fmla="*/ 1182 h 1688"/>
                <a:gd name="T30" fmla="*/ 1221 w 4232"/>
                <a:gd name="T31" fmla="*/ 1179 h 1688"/>
                <a:gd name="T32" fmla="*/ 1298 w 4232"/>
                <a:gd name="T33" fmla="*/ 1173 h 1688"/>
                <a:gd name="T34" fmla="*/ 1374 w 4232"/>
                <a:gd name="T35" fmla="*/ 1169 h 1688"/>
                <a:gd name="T36" fmla="*/ 1451 w 4232"/>
                <a:gd name="T37" fmla="*/ 1163 h 1688"/>
                <a:gd name="T38" fmla="*/ 1528 w 4232"/>
                <a:gd name="T39" fmla="*/ 1160 h 1688"/>
                <a:gd name="T40" fmla="*/ 1604 w 4232"/>
                <a:gd name="T41" fmla="*/ 1156 h 1688"/>
                <a:gd name="T42" fmla="*/ 1681 w 4232"/>
                <a:gd name="T43" fmla="*/ 1151 h 1688"/>
                <a:gd name="T44" fmla="*/ 1759 w 4232"/>
                <a:gd name="T45" fmla="*/ 1145 h 1688"/>
                <a:gd name="T46" fmla="*/ 1836 w 4232"/>
                <a:gd name="T47" fmla="*/ 1142 h 1688"/>
                <a:gd name="T48" fmla="*/ 1913 w 4232"/>
                <a:gd name="T49" fmla="*/ 1137 h 1688"/>
                <a:gd name="T50" fmla="*/ 1990 w 4232"/>
                <a:gd name="T51" fmla="*/ 1133 h 1688"/>
                <a:gd name="T52" fmla="*/ 2066 w 4232"/>
                <a:gd name="T53" fmla="*/ 1130 h 1688"/>
                <a:gd name="T54" fmla="*/ 2143 w 4232"/>
                <a:gd name="T55" fmla="*/ 1125 h 1688"/>
                <a:gd name="T56" fmla="*/ 2220 w 4232"/>
                <a:gd name="T57" fmla="*/ 1122 h 1688"/>
                <a:gd name="T58" fmla="*/ 2296 w 4232"/>
                <a:gd name="T59" fmla="*/ 1112 h 1688"/>
                <a:gd name="T60" fmla="*/ 2375 w 4232"/>
                <a:gd name="T61" fmla="*/ 1129 h 1688"/>
                <a:gd name="T62" fmla="*/ 2451 w 4232"/>
                <a:gd name="T63" fmla="*/ 1137 h 1688"/>
                <a:gd name="T64" fmla="*/ 2528 w 4232"/>
                <a:gd name="T65" fmla="*/ 1135 h 1688"/>
                <a:gd name="T66" fmla="*/ 2605 w 4232"/>
                <a:gd name="T67" fmla="*/ 1138 h 1688"/>
                <a:gd name="T68" fmla="*/ 2681 w 4232"/>
                <a:gd name="T69" fmla="*/ 1138 h 1688"/>
                <a:gd name="T70" fmla="*/ 2758 w 4232"/>
                <a:gd name="T71" fmla="*/ 1138 h 1688"/>
                <a:gd name="T72" fmla="*/ 2835 w 4232"/>
                <a:gd name="T73" fmla="*/ 1140 h 1688"/>
                <a:gd name="T74" fmla="*/ 2913 w 4232"/>
                <a:gd name="T75" fmla="*/ 1138 h 1688"/>
                <a:gd name="T76" fmla="*/ 2990 w 4232"/>
                <a:gd name="T77" fmla="*/ 1140 h 1688"/>
                <a:gd name="T78" fmla="*/ 3066 w 4232"/>
                <a:gd name="T79" fmla="*/ 1140 h 1688"/>
                <a:gd name="T80" fmla="*/ 3143 w 4232"/>
                <a:gd name="T81" fmla="*/ 1140 h 1688"/>
                <a:gd name="T82" fmla="*/ 3220 w 4232"/>
                <a:gd name="T83" fmla="*/ 1140 h 1688"/>
                <a:gd name="T84" fmla="*/ 3297 w 4232"/>
                <a:gd name="T85" fmla="*/ 1140 h 1688"/>
                <a:gd name="T86" fmla="*/ 3373 w 4232"/>
                <a:gd name="T87" fmla="*/ 1140 h 1688"/>
                <a:gd name="T88" fmla="*/ 3450 w 4232"/>
                <a:gd name="T89" fmla="*/ 1142 h 1688"/>
                <a:gd name="T90" fmla="*/ 3528 w 4232"/>
                <a:gd name="T91" fmla="*/ 1142 h 1688"/>
                <a:gd name="T92" fmla="*/ 3605 w 4232"/>
                <a:gd name="T93" fmla="*/ 1142 h 1688"/>
                <a:gd name="T94" fmla="*/ 3682 w 4232"/>
                <a:gd name="T95" fmla="*/ 1143 h 1688"/>
                <a:gd name="T96" fmla="*/ 3758 w 4232"/>
                <a:gd name="T97" fmla="*/ 1138 h 1688"/>
                <a:gd name="T98" fmla="*/ 3835 w 4232"/>
                <a:gd name="T99" fmla="*/ 1142 h 1688"/>
                <a:gd name="T100" fmla="*/ 3912 w 4232"/>
                <a:gd name="T101" fmla="*/ 1146 h 1688"/>
                <a:gd name="T102" fmla="*/ 3988 w 4232"/>
                <a:gd name="T103" fmla="*/ 1148 h 1688"/>
                <a:gd name="T104" fmla="*/ 4067 w 4232"/>
                <a:gd name="T105" fmla="*/ 1143 h 1688"/>
                <a:gd name="T106" fmla="*/ 4143 w 4232"/>
                <a:gd name="T107" fmla="*/ 1155 h 1688"/>
                <a:gd name="T108" fmla="*/ 4220 w 4232"/>
                <a:gd name="T109" fmla="*/ 1145 h 16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232" h="1688">
                  <a:moveTo>
                    <a:pt x="0" y="1236"/>
                  </a:moveTo>
                  <a:lnTo>
                    <a:pt x="12" y="1236"/>
                  </a:lnTo>
                  <a:lnTo>
                    <a:pt x="23" y="1236"/>
                  </a:lnTo>
                  <a:lnTo>
                    <a:pt x="33" y="1238"/>
                  </a:lnTo>
                  <a:lnTo>
                    <a:pt x="45" y="1238"/>
                  </a:lnTo>
                  <a:lnTo>
                    <a:pt x="56" y="1236"/>
                  </a:lnTo>
                  <a:lnTo>
                    <a:pt x="67" y="1236"/>
                  </a:lnTo>
                  <a:lnTo>
                    <a:pt x="77" y="1236"/>
                  </a:lnTo>
                  <a:lnTo>
                    <a:pt x="89" y="1235"/>
                  </a:lnTo>
                  <a:lnTo>
                    <a:pt x="100" y="1236"/>
                  </a:lnTo>
                  <a:lnTo>
                    <a:pt x="111" y="1236"/>
                  </a:lnTo>
                  <a:lnTo>
                    <a:pt x="121" y="1236"/>
                  </a:lnTo>
                  <a:lnTo>
                    <a:pt x="133" y="1236"/>
                  </a:lnTo>
                  <a:lnTo>
                    <a:pt x="144" y="1236"/>
                  </a:lnTo>
                  <a:lnTo>
                    <a:pt x="154" y="1238"/>
                  </a:lnTo>
                  <a:lnTo>
                    <a:pt x="165" y="1236"/>
                  </a:lnTo>
                  <a:lnTo>
                    <a:pt x="177" y="1236"/>
                  </a:lnTo>
                  <a:lnTo>
                    <a:pt x="188" y="1236"/>
                  </a:lnTo>
                  <a:lnTo>
                    <a:pt x="198" y="1236"/>
                  </a:lnTo>
                  <a:lnTo>
                    <a:pt x="209" y="1235"/>
                  </a:lnTo>
                  <a:lnTo>
                    <a:pt x="221" y="1235"/>
                  </a:lnTo>
                  <a:lnTo>
                    <a:pt x="232" y="1235"/>
                  </a:lnTo>
                  <a:lnTo>
                    <a:pt x="242" y="1231"/>
                  </a:lnTo>
                  <a:lnTo>
                    <a:pt x="253" y="1230"/>
                  </a:lnTo>
                  <a:lnTo>
                    <a:pt x="265" y="1221"/>
                  </a:lnTo>
                  <a:lnTo>
                    <a:pt x="276" y="1230"/>
                  </a:lnTo>
                  <a:lnTo>
                    <a:pt x="286" y="1218"/>
                  </a:lnTo>
                  <a:lnTo>
                    <a:pt x="297" y="750"/>
                  </a:lnTo>
                  <a:lnTo>
                    <a:pt x="309" y="0"/>
                  </a:lnTo>
                  <a:lnTo>
                    <a:pt x="319" y="1251"/>
                  </a:lnTo>
                  <a:lnTo>
                    <a:pt x="330" y="1688"/>
                  </a:lnTo>
                  <a:lnTo>
                    <a:pt x="341" y="1535"/>
                  </a:lnTo>
                  <a:lnTo>
                    <a:pt x="353" y="1385"/>
                  </a:lnTo>
                  <a:lnTo>
                    <a:pt x="363" y="1308"/>
                  </a:lnTo>
                  <a:lnTo>
                    <a:pt x="374" y="1272"/>
                  </a:lnTo>
                  <a:lnTo>
                    <a:pt x="386" y="1254"/>
                  </a:lnTo>
                  <a:lnTo>
                    <a:pt x="397" y="1246"/>
                  </a:lnTo>
                  <a:lnTo>
                    <a:pt x="407" y="1239"/>
                  </a:lnTo>
                  <a:lnTo>
                    <a:pt x="418" y="1236"/>
                  </a:lnTo>
                  <a:lnTo>
                    <a:pt x="430" y="1235"/>
                  </a:lnTo>
                  <a:lnTo>
                    <a:pt x="441" y="1231"/>
                  </a:lnTo>
                  <a:lnTo>
                    <a:pt x="451" y="1231"/>
                  </a:lnTo>
                  <a:lnTo>
                    <a:pt x="462" y="1230"/>
                  </a:lnTo>
                  <a:lnTo>
                    <a:pt x="474" y="1230"/>
                  </a:lnTo>
                  <a:lnTo>
                    <a:pt x="483" y="1228"/>
                  </a:lnTo>
                  <a:lnTo>
                    <a:pt x="495" y="1226"/>
                  </a:lnTo>
                  <a:lnTo>
                    <a:pt x="506" y="1226"/>
                  </a:lnTo>
                  <a:lnTo>
                    <a:pt x="518" y="1223"/>
                  </a:lnTo>
                  <a:lnTo>
                    <a:pt x="528" y="1223"/>
                  </a:lnTo>
                  <a:lnTo>
                    <a:pt x="539" y="1221"/>
                  </a:lnTo>
                  <a:lnTo>
                    <a:pt x="550" y="1221"/>
                  </a:lnTo>
                  <a:lnTo>
                    <a:pt x="562" y="1221"/>
                  </a:lnTo>
                  <a:lnTo>
                    <a:pt x="572" y="1220"/>
                  </a:lnTo>
                  <a:lnTo>
                    <a:pt x="583" y="1218"/>
                  </a:lnTo>
                  <a:lnTo>
                    <a:pt x="594" y="1218"/>
                  </a:lnTo>
                  <a:lnTo>
                    <a:pt x="606" y="1218"/>
                  </a:lnTo>
                  <a:lnTo>
                    <a:pt x="616" y="1217"/>
                  </a:lnTo>
                  <a:lnTo>
                    <a:pt x="627" y="1217"/>
                  </a:lnTo>
                  <a:lnTo>
                    <a:pt x="638" y="1217"/>
                  </a:lnTo>
                  <a:lnTo>
                    <a:pt x="648" y="1215"/>
                  </a:lnTo>
                  <a:lnTo>
                    <a:pt x="660" y="1213"/>
                  </a:lnTo>
                  <a:lnTo>
                    <a:pt x="671" y="1213"/>
                  </a:lnTo>
                  <a:lnTo>
                    <a:pt x="683" y="1212"/>
                  </a:lnTo>
                  <a:lnTo>
                    <a:pt x="692" y="1210"/>
                  </a:lnTo>
                  <a:lnTo>
                    <a:pt x="704" y="1212"/>
                  </a:lnTo>
                  <a:lnTo>
                    <a:pt x="715" y="1210"/>
                  </a:lnTo>
                  <a:lnTo>
                    <a:pt x="727" y="1210"/>
                  </a:lnTo>
                  <a:lnTo>
                    <a:pt x="736" y="1208"/>
                  </a:lnTo>
                  <a:lnTo>
                    <a:pt x="748" y="1208"/>
                  </a:lnTo>
                  <a:lnTo>
                    <a:pt x="759" y="1208"/>
                  </a:lnTo>
                  <a:lnTo>
                    <a:pt x="771" y="1208"/>
                  </a:lnTo>
                  <a:lnTo>
                    <a:pt x="780" y="1207"/>
                  </a:lnTo>
                  <a:lnTo>
                    <a:pt x="792" y="1205"/>
                  </a:lnTo>
                  <a:lnTo>
                    <a:pt x="803" y="1205"/>
                  </a:lnTo>
                  <a:lnTo>
                    <a:pt x="813" y="1204"/>
                  </a:lnTo>
                  <a:lnTo>
                    <a:pt x="824" y="1204"/>
                  </a:lnTo>
                  <a:lnTo>
                    <a:pt x="836" y="1204"/>
                  </a:lnTo>
                  <a:lnTo>
                    <a:pt x="847" y="1202"/>
                  </a:lnTo>
                  <a:lnTo>
                    <a:pt x="857" y="1202"/>
                  </a:lnTo>
                  <a:lnTo>
                    <a:pt x="869" y="1202"/>
                  </a:lnTo>
                  <a:lnTo>
                    <a:pt x="880" y="1200"/>
                  </a:lnTo>
                  <a:lnTo>
                    <a:pt x="891" y="1199"/>
                  </a:lnTo>
                  <a:lnTo>
                    <a:pt x="901" y="1197"/>
                  </a:lnTo>
                  <a:lnTo>
                    <a:pt x="913" y="1197"/>
                  </a:lnTo>
                  <a:lnTo>
                    <a:pt x="924" y="1195"/>
                  </a:lnTo>
                  <a:lnTo>
                    <a:pt x="935" y="1197"/>
                  </a:lnTo>
                  <a:lnTo>
                    <a:pt x="945" y="1197"/>
                  </a:lnTo>
                  <a:lnTo>
                    <a:pt x="957" y="1195"/>
                  </a:lnTo>
                  <a:lnTo>
                    <a:pt x="968" y="1195"/>
                  </a:lnTo>
                  <a:lnTo>
                    <a:pt x="978" y="1194"/>
                  </a:lnTo>
                  <a:lnTo>
                    <a:pt x="989" y="1194"/>
                  </a:lnTo>
                  <a:lnTo>
                    <a:pt x="1001" y="1194"/>
                  </a:lnTo>
                  <a:lnTo>
                    <a:pt x="1012" y="1192"/>
                  </a:lnTo>
                  <a:lnTo>
                    <a:pt x="1022" y="1192"/>
                  </a:lnTo>
                  <a:lnTo>
                    <a:pt x="1033" y="1192"/>
                  </a:lnTo>
                  <a:lnTo>
                    <a:pt x="1045" y="1189"/>
                  </a:lnTo>
                  <a:lnTo>
                    <a:pt x="1056" y="1189"/>
                  </a:lnTo>
                  <a:lnTo>
                    <a:pt x="1066" y="1189"/>
                  </a:lnTo>
                  <a:lnTo>
                    <a:pt x="1077" y="1187"/>
                  </a:lnTo>
                  <a:lnTo>
                    <a:pt x="1089" y="1187"/>
                  </a:lnTo>
                  <a:lnTo>
                    <a:pt x="1100" y="1186"/>
                  </a:lnTo>
                  <a:lnTo>
                    <a:pt x="1110" y="1186"/>
                  </a:lnTo>
                  <a:lnTo>
                    <a:pt x="1121" y="1186"/>
                  </a:lnTo>
                  <a:lnTo>
                    <a:pt x="1133" y="1184"/>
                  </a:lnTo>
                  <a:lnTo>
                    <a:pt x="1143" y="1182"/>
                  </a:lnTo>
                  <a:lnTo>
                    <a:pt x="1154" y="1182"/>
                  </a:lnTo>
                  <a:lnTo>
                    <a:pt x="1166" y="1181"/>
                  </a:lnTo>
                  <a:lnTo>
                    <a:pt x="1177" y="1181"/>
                  </a:lnTo>
                  <a:lnTo>
                    <a:pt x="1187" y="1181"/>
                  </a:lnTo>
                  <a:lnTo>
                    <a:pt x="1198" y="1179"/>
                  </a:lnTo>
                  <a:lnTo>
                    <a:pt x="1210" y="1177"/>
                  </a:lnTo>
                  <a:lnTo>
                    <a:pt x="1221" y="1179"/>
                  </a:lnTo>
                  <a:lnTo>
                    <a:pt x="1231" y="1177"/>
                  </a:lnTo>
                  <a:lnTo>
                    <a:pt x="1242" y="1176"/>
                  </a:lnTo>
                  <a:lnTo>
                    <a:pt x="1254" y="1176"/>
                  </a:lnTo>
                  <a:lnTo>
                    <a:pt x="1265" y="1176"/>
                  </a:lnTo>
                  <a:lnTo>
                    <a:pt x="1275" y="1174"/>
                  </a:lnTo>
                  <a:lnTo>
                    <a:pt x="1286" y="1173"/>
                  </a:lnTo>
                  <a:lnTo>
                    <a:pt x="1298" y="1173"/>
                  </a:lnTo>
                  <a:lnTo>
                    <a:pt x="1307" y="1173"/>
                  </a:lnTo>
                  <a:lnTo>
                    <a:pt x="1319" y="1171"/>
                  </a:lnTo>
                  <a:lnTo>
                    <a:pt x="1330" y="1171"/>
                  </a:lnTo>
                  <a:lnTo>
                    <a:pt x="1342" y="1171"/>
                  </a:lnTo>
                  <a:lnTo>
                    <a:pt x="1352" y="1171"/>
                  </a:lnTo>
                  <a:lnTo>
                    <a:pt x="1363" y="1169"/>
                  </a:lnTo>
                  <a:lnTo>
                    <a:pt x="1374" y="1169"/>
                  </a:lnTo>
                  <a:lnTo>
                    <a:pt x="1386" y="1169"/>
                  </a:lnTo>
                  <a:lnTo>
                    <a:pt x="1396" y="1168"/>
                  </a:lnTo>
                  <a:lnTo>
                    <a:pt x="1407" y="1166"/>
                  </a:lnTo>
                  <a:lnTo>
                    <a:pt x="1418" y="1164"/>
                  </a:lnTo>
                  <a:lnTo>
                    <a:pt x="1430" y="1164"/>
                  </a:lnTo>
                  <a:lnTo>
                    <a:pt x="1440" y="1164"/>
                  </a:lnTo>
                  <a:lnTo>
                    <a:pt x="1451" y="1163"/>
                  </a:lnTo>
                  <a:lnTo>
                    <a:pt x="1462" y="1163"/>
                  </a:lnTo>
                  <a:lnTo>
                    <a:pt x="1472" y="1163"/>
                  </a:lnTo>
                  <a:lnTo>
                    <a:pt x="1484" y="1163"/>
                  </a:lnTo>
                  <a:lnTo>
                    <a:pt x="1495" y="1163"/>
                  </a:lnTo>
                  <a:lnTo>
                    <a:pt x="1507" y="1161"/>
                  </a:lnTo>
                  <a:lnTo>
                    <a:pt x="1516" y="1161"/>
                  </a:lnTo>
                  <a:lnTo>
                    <a:pt x="1528" y="1160"/>
                  </a:lnTo>
                  <a:lnTo>
                    <a:pt x="1539" y="1158"/>
                  </a:lnTo>
                  <a:lnTo>
                    <a:pt x="1551" y="1160"/>
                  </a:lnTo>
                  <a:lnTo>
                    <a:pt x="1560" y="1158"/>
                  </a:lnTo>
                  <a:lnTo>
                    <a:pt x="1572" y="1158"/>
                  </a:lnTo>
                  <a:lnTo>
                    <a:pt x="1583" y="1158"/>
                  </a:lnTo>
                  <a:lnTo>
                    <a:pt x="1595" y="1160"/>
                  </a:lnTo>
                  <a:lnTo>
                    <a:pt x="1604" y="1156"/>
                  </a:lnTo>
                  <a:lnTo>
                    <a:pt x="1616" y="1155"/>
                  </a:lnTo>
                  <a:lnTo>
                    <a:pt x="1627" y="1155"/>
                  </a:lnTo>
                  <a:lnTo>
                    <a:pt x="1637" y="1155"/>
                  </a:lnTo>
                  <a:lnTo>
                    <a:pt x="1649" y="1153"/>
                  </a:lnTo>
                  <a:lnTo>
                    <a:pt x="1660" y="1153"/>
                  </a:lnTo>
                  <a:lnTo>
                    <a:pt x="1671" y="1153"/>
                  </a:lnTo>
                  <a:lnTo>
                    <a:pt x="1681" y="1151"/>
                  </a:lnTo>
                  <a:lnTo>
                    <a:pt x="1693" y="1151"/>
                  </a:lnTo>
                  <a:lnTo>
                    <a:pt x="1704" y="1150"/>
                  </a:lnTo>
                  <a:lnTo>
                    <a:pt x="1715" y="1150"/>
                  </a:lnTo>
                  <a:lnTo>
                    <a:pt x="1725" y="1148"/>
                  </a:lnTo>
                  <a:lnTo>
                    <a:pt x="1737" y="1146"/>
                  </a:lnTo>
                  <a:lnTo>
                    <a:pt x="1748" y="1146"/>
                  </a:lnTo>
                  <a:lnTo>
                    <a:pt x="1759" y="1145"/>
                  </a:lnTo>
                  <a:lnTo>
                    <a:pt x="1769" y="1143"/>
                  </a:lnTo>
                  <a:lnTo>
                    <a:pt x="1781" y="1145"/>
                  </a:lnTo>
                  <a:lnTo>
                    <a:pt x="1792" y="1143"/>
                  </a:lnTo>
                  <a:lnTo>
                    <a:pt x="1802" y="1143"/>
                  </a:lnTo>
                  <a:lnTo>
                    <a:pt x="1813" y="1142"/>
                  </a:lnTo>
                  <a:lnTo>
                    <a:pt x="1825" y="1142"/>
                  </a:lnTo>
                  <a:lnTo>
                    <a:pt x="1836" y="1142"/>
                  </a:lnTo>
                  <a:lnTo>
                    <a:pt x="1846" y="1142"/>
                  </a:lnTo>
                  <a:lnTo>
                    <a:pt x="1857" y="1142"/>
                  </a:lnTo>
                  <a:lnTo>
                    <a:pt x="1869" y="1142"/>
                  </a:lnTo>
                  <a:lnTo>
                    <a:pt x="1880" y="1142"/>
                  </a:lnTo>
                  <a:lnTo>
                    <a:pt x="1890" y="1140"/>
                  </a:lnTo>
                  <a:lnTo>
                    <a:pt x="1901" y="1138"/>
                  </a:lnTo>
                  <a:lnTo>
                    <a:pt x="1913" y="1137"/>
                  </a:lnTo>
                  <a:lnTo>
                    <a:pt x="1924" y="1135"/>
                  </a:lnTo>
                  <a:lnTo>
                    <a:pt x="1934" y="1137"/>
                  </a:lnTo>
                  <a:lnTo>
                    <a:pt x="1945" y="1137"/>
                  </a:lnTo>
                  <a:lnTo>
                    <a:pt x="1957" y="1135"/>
                  </a:lnTo>
                  <a:lnTo>
                    <a:pt x="1967" y="1133"/>
                  </a:lnTo>
                  <a:lnTo>
                    <a:pt x="1978" y="1133"/>
                  </a:lnTo>
                  <a:lnTo>
                    <a:pt x="1990" y="1133"/>
                  </a:lnTo>
                  <a:lnTo>
                    <a:pt x="2001" y="1132"/>
                  </a:lnTo>
                  <a:lnTo>
                    <a:pt x="2011" y="1132"/>
                  </a:lnTo>
                  <a:lnTo>
                    <a:pt x="2022" y="1132"/>
                  </a:lnTo>
                  <a:lnTo>
                    <a:pt x="2034" y="1130"/>
                  </a:lnTo>
                  <a:lnTo>
                    <a:pt x="2045" y="1130"/>
                  </a:lnTo>
                  <a:lnTo>
                    <a:pt x="2055" y="1132"/>
                  </a:lnTo>
                  <a:lnTo>
                    <a:pt x="2066" y="1130"/>
                  </a:lnTo>
                  <a:lnTo>
                    <a:pt x="2078" y="1129"/>
                  </a:lnTo>
                  <a:lnTo>
                    <a:pt x="2089" y="1129"/>
                  </a:lnTo>
                  <a:lnTo>
                    <a:pt x="2099" y="1129"/>
                  </a:lnTo>
                  <a:lnTo>
                    <a:pt x="2110" y="1127"/>
                  </a:lnTo>
                  <a:lnTo>
                    <a:pt x="2122" y="1125"/>
                  </a:lnTo>
                  <a:lnTo>
                    <a:pt x="2131" y="1125"/>
                  </a:lnTo>
                  <a:lnTo>
                    <a:pt x="2143" y="1125"/>
                  </a:lnTo>
                  <a:lnTo>
                    <a:pt x="2154" y="1125"/>
                  </a:lnTo>
                  <a:lnTo>
                    <a:pt x="2166" y="1124"/>
                  </a:lnTo>
                  <a:lnTo>
                    <a:pt x="2176" y="1124"/>
                  </a:lnTo>
                  <a:lnTo>
                    <a:pt x="2187" y="1124"/>
                  </a:lnTo>
                  <a:lnTo>
                    <a:pt x="2198" y="1122"/>
                  </a:lnTo>
                  <a:lnTo>
                    <a:pt x="2210" y="1122"/>
                  </a:lnTo>
                  <a:lnTo>
                    <a:pt x="2220" y="1122"/>
                  </a:lnTo>
                  <a:lnTo>
                    <a:pt x="2231" y="1130"/>
                  </a:lnTo>
                  <a:lnTo>
                    <a:pt x="2242" y="1135"/>
                  </a:lnTo>
                  <a:lnTo>
                    <a:pt x="2254" y="1140"/>
                  </a:lnTo>
                  <a:lnTo>
                    <a:pt x="2264" y="1161"/>
                  </a:lnTo>
                  <a:lnTo>
                    <a:pt x="2275" y="1088"/>
                  </a:lnTo>
                  <a:lnTo>
                    <a:pt x="2287" y="1099"/>
                  </a:lnTo>
                  <a:lnTo>
                    <a:pt x="2296" y="1112"/>
                  </a:lnTo>
                  <a:lnTo>
                    <a:pt x="2308" y="1117"/>
                  </a:lnTo>
                  <a:lnTo>
                    <a:pt x="2319" y="1122"/>
                  </a:lnTo>
                  <a:lnTo>
                    <a:pt x="2331" y="1125"/>
                  </a:lnTo>
                  <a:lnTo>
                    <a:pt x="2340" y="1127"/>
                  </a:lnTo>
                  <a:lnTo>
                    <a:pt x="2352" y="1127"/>
                  </a:lnTo>
                  <a:lnTo>
                    <a:pt x="2363" y="1129"/>
                  </a:lnTo>
                  <a:lnTo>
                    <a:pt x="2375" y="1129"/>
                  </a:lnTo>
                  <a:lnTo>
                    <a:pt x="2384" y="1132"/>
                  </a:lnTo>
                  <a:lnTo>
                    <a:pt x="2396" y="1132"/>
                  </a:lnTo>
                  <a:lnTo>
                    <a:pt x="2407" y="1132"/>
                  </a:lnTo>
                  <a:lnTo>
                    <a:pt x="2419" y="1132"/>
                  </a:lnTo>
                  <a:lnTo>
                    <a:pt x="2428" y="1132"/>
                  </a:lnTo>
                  <a:lnTo>
                    <a:pt x="2440" y="1135"/>
                  </a:lnTo>
                  <a:lnTo>
                    <a:pt x="2451" y="1137"/>
                  </a:lnTo>
                  <a:lnTo>
                    <a:pt x="2461" y="1137"/>
                  </a:lnTo>
                  <a:lnTo>
                    <a:pt x="2473" y="1135"/>
                  </a:lnTo>
                  <a:lnTo>
                    <a:pt x="2484" y="1135"/>
                  </a:lnTo>
                  <a:lnTo>
                    <a:pt x="2495" y="1135"/>
                  </a:lnTo>
                  <a:lnTo>
                    <a:pt x="2505" y="1135"/>
                  </a:lnTo>
                  <a:lnTo>
                    <a:pt x="2517" y="1137"/>
                  </a:lnTo>
                  <a:lnTo>
                    <a:pt x="2528" y="1135"/>
                  </a:lnTo>
                  <a:lnTo>
                    <a:pt x="2539" y="1135"/>
                  </a:lnTo>
                  <a:lnTo>
                    <a:pt x="2549" y="1137"/>
                  </a:lnTo>
                  <a:lnTo>
                    <a:pt x="2561" y="1138"/>
                  </a:lnTo>
                  <a:lnTo>
                    <a:pt x="2572" y="1138"/>
                  </a:lnTo>
                  <a:lnTo>
                    <a:pt x="2583" y="1138"/>
                  </a:lnTo>
                  <a:lnTo>
                    <a:pt x="2593" y="1138"/>
                  </a:lnTo>
                  <a:lnTo>
                    <a:pt x="2605" y="1138"/>
                  </a:lnTo>
                  <a:lnTo>
                    <a:pt x="2616" y="1138"/>
                  </a:lnTo>
                  <a:lnTo>
                    <a:pt x="2626" y="1138"/>
                  </a:lnTo>
                  <a:lnTo>
                    <a:pt x="2637" y="1138"/>
                  </a:lnTo>
                  <a:lnTo>
                    <a:pt x="2649" y="1137"/>
                  </a:lnTo>
                  <a:lnTo>
                    <a:pt x="2660" y="1138"/>
                  </a:lnTo>
                  <a:lnTo>
                    <a:pt x="2670" y="1138"/>
                  </a:lnTo>
                  <a:lnTo>
                    <a:pt x="2681" y="1138"/>
                  </a:lnTo>
                  <a:lnTo>
                    <a:pt x="2693" y="1140"/>
                  </a:lnTo>
                  <a:lnTo>
                    <a:pt x="2704" y="1140"/>
                  </a:lnTo>
                  <a:lnTo>
                    <a:pt x="2714" y="1140"/>
                  </a:lnTo>
                  <a:lnTo>
                    <a:pt x="2725" y="1138"/>
                  </a:lnTo>
                  <a:lnTo>
                    <a:pt x="2737" y="1138"/>
                  </a:lnTo>
                  <a:lnTo>
                    <a:pt x="2748" y="1138"/>
                  </a:lnTo>
                  <a:lnTo>
                    <a:pt x="2758" y="1138"/>
                  </a:lnTo>
                  <a:lnTo>
                    <a:pt x="2770" y="1138"/>
                  </a:lnTo>
                  <a:lnTo>
                    <a:pt x="2781" y="1138"/>
                  </a:lnTo>
                  <a:lnTo>
                    <a:pt x="2791" y="1140"/>
                  </a:lnTo>
                  <a:lnTo>
                    <a:pt x="2802" y="1138"/>
                  </a:lnTo>
                  <a:lnTo>
                    <a:pt x="2814" y="1138"/>
                  </a:lnTo>
                  <a:lnTo>
                    <a:pt x="2825" y="1138"/>
                  </a:lnTo>
                  <a:lnTo>
                    <a:pt x="2835" y="1140"/>
                  </a:lnTo>
                  <a:lnTo>
                    <a:pt x="2846" y="1140"/>
                  </a:lnTo>
                  <a:lnTo>
                    <a:pt x="2858" y="1140"/>
                  </a:lnTo>
                  <a:lnTo>
                    <a:pt x="2869" y="1138"/>
                  </a:lnTo>
                  <a:lnTo>
                    <a:pt x="2879" y="1138"/>
                  </a:lnTo>
                  <a:lnTo>
                    <a:pt x="2890" y="1138"/>
                  </a:lnTo>
                  <a:lnTo>
                    <a:pt x="2902" y="1138"/>
                  </a:lnTo>
                  <a:lnTo>
                    <a:pt x="2913" y="1138"/>
                  </a:lnTo>
                  <a:lnTo>
                    <a:pt x="2923" y="1138"/>
                  </a:lnTo>
                  <a:lnTo>
                    <a:pt x="2934" y="1138"/>
                  </a:lnTo>
                  <a:lnTo>
                    <a:pt x="2946" y="1138"/>
                  </a:lnTo>
                  <a:lnTo>
                    <a:pt x="2956" y="1138"/>
                  </a:lnTo>
                  <a:lnTo>
                    <a:pt x="2967" y="1140"/>
                  </a:lnTo>
                  <a:lnTo>
                    <a:pt x="2978" y="1140"/>
                  </a:lnTo>
                  <a:lnTo>
                    <a:pt x="2990" y="1140"/>
                  </a:lnTo>
                  <a:lnTo>
                    <a:pt x="3000" y="1140"/>
                  </a:lnTo>
                  <a:lnTo>
                    <a:pt x="3011" y="1138"/>
                  </a:lnTo>
                  <a:lnTo>
                    <a:pt x="3022" y="1138"/>
                  </a:lnTo>
                  <a:lnTo>
                    <a:pt x="3034" y="1140"/>
                  </a:lnTo>
                  <a:lnTo>
                    <a:pt x="3044" y="1140"/>
                  </a:lnTo>
                  <a:lnTo>
                    <a:pt x="3055" y="1140"/>
                  </a:lnTo>
                  <a:lnTo>
                    <a:pt x="3066" y="1140"/>
                  </a:lnTo>
                  <a:lnTo>
                    <a:pt x="3078" y="1140"/>
                  </a:lnTo>
                  <a:lnTo>
                    <a:pt x="3088" y="1142"/>
                  </a:lnTo>
                  <a:lnTo>
                    <a:pt x="3099" y="1140"/>
                  </a:lnTo>
                  <a:lnTo>
                    <a:pt x="3111" y="1140"/>
                  </a:lnTo>
                  <a:lnTo>
                    <a:pt x="3120" y="1140"/>
                  </a:lnTo>
                  <a:lnTo>
                    <a:pt x="3132" y="1140"/>
                  </a:lnTo>
                  <a:lnTo>
                    <a:pt x="3143" y="1140"/>
                  </a:lnTo>
                  <a:lnTo>
                    <a:pt x="3155" y="1140"/>
                  </a:lnTo>
                  <a:lnTo>
                    <a:pt x="3164" y="1138"/>
                  </a:lnTo>
                  <a:lnTo>
                    <a:pt x="3176" y="1140"/>
                  </a:lnTo>
                  <a:lnTo>
                    <a:pt x="3187" y="1138"/>
                  </a:lnTo>
                  <a:lnTo>
                    <a:pt x="3199" y="1138"/>
                  </a:lnTo>
                  <a:lnTo>
                    <a:pt x="3208" y="1140"/>
                  </a:lnTo>
                  <a:lnTo>
                    <a:pt x="3220" y="1140"/>
                  </a:lnTo>
                  <a:lnTo>
                    <a:pt x="3231" y="1138"/>
                  </a:lnTo>
                  <a:lnTo>
                    <a:pt x="3243" y="1140"/>
                  </a:lnTo>
                  <a:lnTo>
                    <a:pt x="3252" y="1140"/>
                  </a:lnTo>
                  <a:lnTo>
                    <a:pt x="3264" y="1138"/>
                  </a:lnTo>
                  <a:lnTo>
                    <a:pt x="3275" y="1140"/>
                  </a:lnTo>
                  <a:lnTo>
                    <a:pt x="3285" y="1140"/>
                  </a:lnTo>
                  <a:lnTo>
                    <a:pt x="3297" y="1140"/>
                  </a:lnTo>
                  <a:lnTo>
                    <a:pt x="3308" y="1140"/>
                  </a:lnTo>
                  <a:lnTo>
                    <a:pt x="3319" y="1140"/>
                  </a:lnTo>
                  <a:lnTo>
                    <a:pt x="3329" y="1140"/>
                  </a:lnTo>
                  <a:lnTo>
                    <a:pt x="3341" y="1138"/>
                  </a:lnTo>
                  <a:lnTo>
                    <a:pt x="3352" y="1140"/>
                  </a:lnTo>
                  <a:lnTo>
                    <a:pt x="3363" y="1140"/>
                  </a:lnTo>
                  <a:lnTo>
                    <a:pt x="3373" y="1140"/>
                  </a:lnTo>
                  <a:lnTo>
                    <a:pt x="3385" y="1140"/>
                  </a:lnTo>
                  <a:lnTo>
                    <a:pt x="3396" y="1140"/>
                  </a:lnTo>
                  <a:lnTo>
                    <a:pt x="3408" y="1142"/>
                  </a:lnTo>
                  <a:lnTo>
                    <a:pt x="3417" y="1142"/>
                  </a:lnTo>
                  <a:lnTo>
                    <a:pt x="3429" y="1142"/>
                  </a:lnTo>
                  <a:lnTo>
                    <a:pt x="3440" y="1140"/>
                  </a:lnTo>
                  <a:lnTo>
                    <a:pt x="3450" y="1142"/>
                  </a:lnTo>
                  <a:lnTo>
                    <a:pt x="3461" y="1140"/>
                  </a:lnTo>
                  <a:lnTo>
                    <a:pt x="3473" y="1142"/>
                  </a:lnTo>
                  <a:lnTo>
                    <a:pt x="3484" y="1142"/>
                  </a:lnTo>
                  <a:lnTo>
                    <a:pt x="3494" y="1142"/>
                  </a:lnTo>
                  <a:lnTo>
                    <a:pt x="3505" y="1142"/>
                  </a:lnTo>
                  <a:lnTo>
                    <a:pt x="3517" y="1142"/>
                  </a:lnTo>
                  <a:lnTo>
                    <a:pt x="3528" y="1142"/>
                  </a:lnTo>
                  <a:lnTo>
                    <a:pt x="3538" y="1142"/>
                  </a:lnTo>
                  <a:lnTo>
                    <a:pt x="3549" y="1142"/>
                  </a:lnTo>
                  <a:lnTo>
                    <a:pt x="3561" y="1142"/>
                  </a:lnTo>
                  <a:lnTo>
                    <a:pt x="3572" y="1142"/>
                  </a:lnTo>
                  <a:lnTo>
                    <a:pt x="3582" y="1143"/>
                  </a:lnTo>
                  <a:lnTo>
                    <a:pt x="3594" y="1142"/>
                  </a:lnTo>
                  <a:lnTo>
                    <a:pt x="3605" y="1142"/>
                  </a:lnTo>
                  <a:lnTo>
                    <a:pt x="3615" y="1142"/>
                  </a:lnTo>
                  <a:lnTo>
                    <a:pt x="3626" y="1143"/>
                  </a:lnTo>
                  <a:lnTo>
                    <a:pt x="3638" y="1143"/>
                  </a:lnTo>
                  <a:lnTo>
                    <a:pt x="3649" y="1143"/>
                  </a:lnTo>
                  <a:lnTo>
                    <a:pt x="3659" y="1143"/>
                  </a:lnTo>
                  <a:lnTo>
                    <a:pt x="3670" y="1143"/>
                  </a:lnTo>
                  <a:lnTo>
                    <a:pt x="3682" y="1143"/>
                  </a:lnTo>
                  <a:lnTo>
                    <a:pt x="3693" y="1143"/>
                  </a:lnTo>
                  <a:lnTo>
                    <a:pt x="3703" y="1145"/>
                  </a:lnTo>
                  <a:lnTo>
                    <a:pt x="3714" y="1143"/>
                  </a:lnTo>
                  <a:lnTo>
                    <a:pt x="3726" y="1142"/>
                  </a:lnTo>
                  <a:lnTo>
                    <a:pt x="3737" y="1143"/>
                  </a:lnTo>
                  <a:lnTo>
                    <a:pt x="3747" y="1142"/>
                  </a:lnTo>
                  <a:lnTo>
                    <a:pt x="3758" y="1138"/>
                  </a:lnTo>
                  <a:lnTo>
                    <a:pt x="3770" y="1142"/>
                  </a:lnTo>
                  <a:lnTo>
                    <a:pt x="3780" y="1145"/>
                  </a:lnTo>
                  <a:lnTo>
                    <a:pt x="3791" y="1143"/>
                  </a:lnTo>
                  <a:lnTo>
                    <a:pt x="3802" y="1143"/>
                  </a:lnTo>
                  <a:lnTo>
                    <a:pt x="3814" y="1143"/>
                  </a:lnTo>
                  <a:lnTo>
                    <a:pt x="3824" y="1142"/>
                  </a:lnTo>
                  <a:lnTo>
                    <a:pt x="3835" y="1142"/>
                  </a:lnTo>
                  <a:lnTo>
                    <a:pt x="3846" y="1142"/>
                  </a:lnTo>
                  <a:lnTo>
                    <a:pt x="3858" y="1143"/>
                  </a:lnTo>
                  <a:lnTo>
                    <a:pt x="3868" y="1142"/>
                  </a:lnTo>
                  <a:lnTo>
                    <a:pt x="3879" y="1142"/>
                  </a:lnTo>
                  <a:lnTo>
                    <a:pt x="3890" y="1142"/>
                  </a:lnTo>
                  <a:lnTo>
                    <a:pt x="3902" y="1143"/>
                  </a:lnTo>
                  <a:lnTo>
                    <a:pt x="3912" y="1146"/>
                  </a:lnTo>
                  <a:lnTo>
                    <a:pt x="3923" y="1142"/>
                  </a:lnTo>
                  <a:lnTo>
                    <a:pt x="3935" y="1145"/>
                  </a:lnTo>
                  <a:lnTo>
                    <a:pt x="3944" y="1155"/>
                  </a:lnTo>
                  <a:lnTo>
                    <a:pt x="3956" y="1151"/>
                  </a:lnTo>
                  <a:lnTo>
                    <a:pt x="3967" y="1145"/>
                  </a:lnTo>
                  <a:lnTo>
                    <a:pt x="3979" y="1145"/>
                  </a:lnTo>
                  <a:lnTo>
                    <a:pt x="3988" y="1148"/>
                  </a:lnTo>
                  <a:lnTo>
                    <a:pt x="4000" y="1153"/>
                  </a:lnTo>
                  <a:lnTo>
                    <a:pt x="4011" y="1146"/>
                  </a:lnTo>
                  <a:lnTo>
                    <a:pt x="4023" y="1137"/>
                  </a:lnTo>
                  <a:lnTo>
                    <a:pt x="4032" y="1138"/>
                  </a:lnTo>
                  <a:lnTo>
                    <a:pt x="4044" y="1142"/>
                  </a:lnTo>
                  <a:lnTo>
                    <a:pt x="4055" y="1143"/>
                  </a:lnTo>
                  <a:lnTo>
                    <a:pt x="4067" y="1143"/>
                  </a:lnTo>
                  <a:lnTo>
                    <a:pt x="4077" y="1145"/>
                  </a:lnTo>
                  <a:lnTo>
                    <a:pt x="4088" y="1142"/>
                  </a:lnTo>
                  <a:lnTo>
                    <a:pt x="4099" y="1132"/>
                  </a:lnTo>
                  <a:lnTo>
                    <a:pt x="4109" y="1135"/>
                  </a:lnTo>
                  <a:lnTo>
                    <a:pt x="4121" y="1146"/>
                  </a:lnTo>
                  <a:lnTo>
                    <a:pt x="4132" y="1153"/>
                  </a:lnTo>
                  <a:lnTo>
                    <a:pt x="4143" y="1155"/>
                  </a:lnTo>
                  <a:lnTo>
                    <a:pt x="4153" y="1146"/>
                  </a:lnTo>
                  <a:lnTo>
                    <a:pt x="4165" y="1143"/>
                  </a:lnTo>
                  <a:lnTo>
                    <a:pt x="4176" y="1143"/>
                  </a:lnTo>
                  <a:lnTo>
                    <a:pt x="4187" y="1145"/>
                  </a:lnTo>
                  <a:lnTo>
                    <a:pt x="4197" y="1143"/>
                  </a:lnTo>
                  <a:lnTo>
                    <a:pt x="4209" y="1143"/>
                  </a:lnTo>
                  <a:lnTo>
                    <a:pt x="4220" y="1145"/>
                  </a:lnTo>
                  <a:lnTo>
                    <a:pt x="4232" y="1145"/>
                  </a:lnTo>
                </a:path>
              </a:pathLst>
            </a:custGeom>
            <a:noFill/>
            <a:ln w="19050" cmpd="sng">
              <a:solidFill>
                <a:schemeClr val="bg1">
                  <a:lumMod val="50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5" name="Freeform 101"/>
            <p:cNvSpPr>
              <a:spLocks/>
            </p:cNvSpPr>
            <p:nvPr/>
          </p:nvSpPr>
          <p:spPr bwMode="auto">
            <a:xfrm>
              <a:off x="1429544" y="1698626"/>
              <a:ext cx="6713538" cy="1968500"/>
            </a:xfrm>
            <a:custGeom>
              <a:avLst/>
              <a:gdLst>
                <a:gd name="T0" fmla="*/ 65 w 4229"/>
                <a:gd name="T1" fmla="*/ 951 h 1240"/>
                <a:gd name="T2" fmla="*/ 142 w 4229"/>
                <a:gd name="T3" fmla="*/ 951 h 1240"/>
                <a:gd name="T4" fmla="*/ 220 w 4229"/>
                <a:gd name="T5" fmla="*/ 951 h 1240"/>
                <a:gd name="T6" fmla="*/ 297 w 4229"/>
                <a:gd name="T7" fmla="*/ 0 h 1240"/>
                <a:gd name="T8" fmla="*/ 374 w 4229"/>
                <a:gd name="T9" fmla="*/ 958 h 1240"/>
                <a:gd name="T10" fmla="*/ 450 w 4229"/>
                <a:gd name="T11" fmla="*/ 940 h 1240"/>
                <a:gd name="T12" fmla="*/ 527 w 4229"/>
                <a:gd name="T13" fmla="*/ 936 h 1240"/>
                <a:gd name="T14" fmla="*/ 604 w 4229"/>
                <a:gd name="T15" fmla="*/ 928 h 1240"/>
                <a:gd name="T16" fmla="*/ 680 w 4229"/>
                <a:gd name="T17" fmla="*/ 925 h 1240"/>
                <a:gd name="T18" fmla="*/ 759 w 4229"/>
                <a:gd name="T19" fmla="*/ 923 h 1240"/>
                <a:gd name="T20" fmla="*/ 835 w 4229"/>
                <a:gd name="T21" fmla="*/ 919 h 1240"/>
                <a:gd name="T22" fmla="*/ 912 w 4229"/>
                <a:gd name="T23" fmla="*/ 915 h 1240"/>
                <a:gd name="T24" fmla="*/ 989 w 4229"/>
                <a:gd name="T25" fmla="*/ 912 h 1240"/>
                <a:gd name="T26" fmla="*/ 1065 w 4229"/>
                <a:gd name="T27" fmla="*/ 912 h 1240"/>
                <a:gd name="T28" fmla="*/ 1142 w 4229"/>
                <a:gd name="T29" fmla="*/ 907 h 1240"/>
                <a:gd name="T30" fmla="*/ 1219 w 4229"/>
                <a:gd name="T31" fmla="*/ 905 h 1240"/>
                <a:gd name="T32" fmla="*/ 1295 w 4229"/>
                <a:gd name="T33" fmla="*/ 902 h 1240"/>
                <a:gd name="T34" fmla="*/ 1374 w 4229"/>
                <a:gd name="T35" fmla="*/ 899 h 1240"/>
                <a:gd name="T36" fmla="*/ 1450 w 4229"/>
                <a:gd name="T37" fmla="*/ 896 h 1240"/>
                <a:gd name="T38" fmla="*/ 1527 w 4229"/>
                <a:gd name="T39" fmla="*/ 892 h 1240"/>
                <a:gd name="T40" fmla="*/ 1604 w 4229"/>
                <a:gd name="T41" fmla="*/ 891 h 1240"/>
                <a:gd name="T42" fmla="*/ 1681 w 4229"/>
                <a:gd name="T43" fmla="*/ 889 h 1240"/>
                <a:gd name="T44" fmla="*/ 1757 w 4229"/>
                <a:gd name="T45" fmla="*/ 888 h 1240"/>
                <a:gd name="T46" fmla="*/ 1834 w 4229"/>
                <a:gd name="T47" fmla="*/ 886 h 1240"/>
                <a:gd name="T48" fmla="*/ 1912 w 4229"/>
                <a:gd name="T49" fmla="*/ 883 h 1240"/>
                <a:gd name="T50" fmla="*/ 1989 w 4229"/>
                <a:gd name="T51" fmla="*/ 881 h 1240"/>
                <a:gd name="T52" fmla="*/ 2066 w 4229"/>
                <a:gd name="T53" fmla="*/ 879 h 1240"/>
                <a:gd name="T54" fmla="*/ 2142 w 4229"/>
                <a:gd name="T55" fmla="*/ 878 h 1240"/>
                <a:gd name="T56" fmla="*/ 2219 w 4229"/>
                <a:gd name="T57" fmla="*/ 876 h 1240"/>
                <a:gd name="T58" fmla="*/ 2296 w 4229"/>
                <a:gd name="T59" fmla="*/ 865 h 1240"/>
                <a:gd name="T60" fmla="*/ 2372 w 4229"/>
                <a:gd name="T61" fmla="*/ 881 h 1240"/>
                <a:gd name="T62" fmla="*/ 2449 w 4229"/>
                <a:gd name="T63" fmla="*/ 884 h 1240"/>
                <a:gd name="T64" fmla="*/ 2527 w 4229"/>
                <a:gd name="T65" fmla="*/ 886 h 1240"/>
                <a:gd name="T66" fmla="*/ 2604 w 4229"/>
                <a:gd name="T67" fmla="*/ 886 h 1240"/>
                <a:gd name="T68" fmla="*/ 2681 w 4229"/>
                <a:gd name="T69" fmla="*/ 886 h 1240"/>
                <a:gd name="T70" fmla="*/ 2758 w 4229"/>
                <a:gd name="T71" fmla="*/ 888 h 1240"/>
                <a:gd name="T72" fmla="*/ 2834 w 4229"/>
                <a:gd name="T73" fmla="*/ 888 h 1240"/>
                <a:gd name="T74" fmla="*/ 2911 w 4229"/>
                <a:gd name="T75" fmla="*/ 888 h 1240"/>
                <a:gd name="T76" fmla="*/ 2988 w 4229"/>
                <a:gd name="T77" fmla="*/ 888 h 1240"/>
                <a:gd name="T78" fmla="*/ 3066 w 4229"/>
                <a:gd name="T79" fmla="*/ 888 h 1240"/>
                <a:gd name="T80" fmla="*/ 3143 w 4229"/>
                <a:gd name="T81" fmla="*/ 886 h 1240"/>
                <a:gd name="T82" fmla="*/ 3219 w 4229"/>
                <a:gd name="T83" fmla="*/ 886 h 1240"/>
                <a:gd name="T84" fmla="*/ 3296 w 4229"/>
                <a:gd name="T85" fmla="*/ 888 h 1240"/>
                <a:gd name="T86" fmla="*/ 3373 w 4229"/>
                <a:gd name="T87" fmla="*/ 888 h 1240"/>
                <a:gd name="T88" fmla="*/ 3449 w 4229"/>
                <a:gd name="T89" fmla="*/ 888 h 1240"/>
                <a:gd name="T90" fmla="*/ 3526 w 4229"/>
                <a:gd name="T91" fmla="*/ 886 h 1240"/>
                <a:gd name="T92" fmla="*/ 3603 w 4229"/>
                <a:gd name="T93" fmla="*/ 886 h 1240"/>
                <a:gd name="T94" fmla="*/ 3681 w 4229"/>
                <a:gd name="T95" fmla="*/ 886 h 1240"/>
                <a:gd name="T96" fmla="*/ 3758 w 4229"/>
                <a:gd name="T97" fmla="*/ 884 h 1240"/>
                <a:gd name="T98" fmla="*/ 3834 w 4229"/>
                <a:gd name="T99" fmla="*/ 886 h 1240"/>
                <a:gd name="T100" fmla="*/ 3911 w 4229"/>
                <a:gd name="T101" fmla="*/ 886 h 1240"/>
                <a:gd name="T102" fmla="*/ 3988 w 4229"/>
                <a:gd name="T103" fmla="*/ 889 h 1240"/>
                <a:gd name="T104" fmla="*/ 4065 w 4229"/>
                <a:gd name="T105" fmla="*/ 883 h 1240"/>
                <a:gd name="T106" fmla="*/ 4141 w 4229"/>
                <a:gd name="T107" fmla="*/ 894 h 1240"/>
                <a:gd name="T108" fmla="*/ 4220 w 4229"/>
                <a:gd name="T109" fmla="*/ 881 h 1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229" h="1240">
                  <a:moveTo>
                    <a:pt x="0" y="953"/>
                  </a:moveTo>
                  <a:lnTo>
                    <a:pt x="11" y="953"/>
                  </a:lnTo>
                  <a:lnTo>
                    <a:pt x="21" y="953"/>
                  </a:lnTo>
                  <a:lnTo>
                    <a:pt x="33" y="954"/>
                  </a:lnTo>
                  <a:lnTo>
                    <a:pt x="44" y="953"/>
                  </a:lnTo>
                  <a:lnTo>
                    <a:pt x="55" y="953"/>
                  </a:lnTo>
                  <a:lnTo>
                    <a:pt x="65" y="951"/>
                  </a:lnTo>
                  <a:lnTo>
                    <a:pt x="77" y="951"/>
                  </a:lnTo>
                  <a:lnTo>
                    <a:pt x="88" y="953"/>
                  </a:lnTo>
                  <a:lnTo>
                    <a:pt x="99" y="951"/>
                  </a:lnTo>
                  <a:lnTo>
                    <a:pt x="109" y="951"/>
                  </a:lnTo>
                  <a:lnTo>
                    <a:pt x="121" y="951"/>
                  </a:lnTo>
                  <a:lnTo>
                    <a:pt x="132" y="950"/>
                  </a:lnTo>
                  <a:lnTo>
                    <a:pt x="142" y="951"/>
                  </a:lnTo>
                  <a:lnTo>
                    <a:pt x="153" y="951"/>
                  </a:lnTo>
                  <a:lnTo>
                    <a:pt x="165" y="950"/>
                  </a:lnTo>
                  <a:lnTo>
                    <a:pt x="176" y="950"/>
                  </a:lnTo>
                  <a:lnTo>
                    <a:pt x="186" y="950"/>
                  </a:lnTo>
                  <a:lnTo>
                    <a:pt x="197" y="950"/>
                  </a:lnTo>
                  <a:lnTo>
                    <a:pt x="209" y="950"/>
                  </a:lnTo>
                  <a:lnTo>
                    <a:pt x="220" y="951"/>
                  </a:lnTo>
                  <a:lnTo>
                    <a:pt x="230" y="951"/>
                  </a:lnTo>
                  <a:lnTo>
                    <a:pt x="241" y="946"/>
                  </a:lnTo>
                  <a:lnTo>
                    <a:pt x="253" y="938"/>
                  </a:lnTo>
                  <a:lnTo>
                    <a:pt x="264" y="945"/>
                  </a:lnTo>
                  <a:lnTo>
                    <a:pt x="274" y="953"/>
                  </a:lnTo>
                  <a:lnTo>
                    <a:pt x="285" y="700"/>
                  </a:lnTo>
                  <a:lnTo>
                    <a:pt x="297" y="0"/>
                  </a:lnTo>
                  <a:lnTo>
                    <a:pt x="307" y="910"/>
                  </a:lnTo>
                  <a:lnTo>
                    <a:pt x="318" y="1240"/>
                  </a:lnTo>
                  <a:lnTo>
                    <a:pt x="329" y="1142"/>
                  </a:lnTo>
                  <a:lnTo>
                    <a:pt x="341" y="1044"/>
                  </a:lnTo>
                  <a:lnTo>
                    <a:pt x="351" y="994"/>
                  </a:lnTo>
                  <a:lnTo>
                    <a:pt x="362" y="971"/>
                  </a:lnTo>
                  <a:lnTo>
                    <a:pt x="374" y="958"/>
                  </a:lnTo>
                  <a:lnTo>
                    <a:pt x="385" y="951"/>
                  </a:lnTo>
                  <a:lnTo>
                    <a:pt x="395" y="948"/>
                  </a:lnTo>
                  <a:lnTo>
                    <a:pt x="406" y="945"/>
                  </a:lnTo>
                  <a:lnTo>
                    <a:pt x="418" y="943"/>
                  </a:lnTo>
                  <a:lnTo>
                    <a:pt x="429" y="941"/>
                  </a:lnTo>
                  <a:lnTo>
                    <a:pt x="439" y="941"/>
                  </a:lnTo>
                  <a:lnTo>
                    <a:pt x="450" y="940"/>
                  </a:lnTo>
                  <a:lnTo>
                    <a:pt x="462" y="940"/>
                  </a:lnTo>
                  <a:lnTo>
                    <a:pt x="471" y="938"/>
                  </a:lnTo>
                  <a:lnTo>
                    <a:pt x="483" y="936"/>
                  </a:lnTo>
                  <a:lnTo>
                    <a:pt x="494" y="936"/>
                  </a:lnTo>
                  <a:lnTo>
                    <a:pt x="506" y="938"/>
                  </a:lnTo>
                  <a:lnTo>
                    <a:pt x="516" y="936"/>
                  </a:lnTo>
                  <a:lnTo>
                    <a:pt x="527" y="936"/>
                  </a:lnTo>
                  <a:lnTo>
                    <a:pt x="538" y="935"/>
                  </a:lnTo>
                  <a:lnTo>
                    <a:pt x="550" y="933"/>
                  </a:lnTo>
                  <a:lnTo>
                    <a:pt x="560" y="932"/>
                  </a:lnTo>
                  <a:lnTo>
                    <a:pt x="571" y="932"/>
                  </a:lnTo>
                  <a:lnTo>
                    <a:pt x="582" y="932"/>
                  </a:lnTo>
                  <a:lnTo>
                    <a:pt x="594" y="930"/>
                  </a:lnTo>
                  <a:lnTo>
                    <a:pt x="604" y="928"/>
                  </a:lnTo>
                  <a:lnTo>
                    <a:pt x="615" y="928"/>
                  </a:lnTo>
                  <a:lnTo>
                    <a:pt x="626" y="930"/>
                  </a:lnTo>
                  <a:lnTo>
                    <a:pt x="636" y="928"/>
                  </a:lnTo>
                  <a:lnTo>
                    <a:pt x="648" y="928"/>
                  </a:lnTo>
                  <a:lnTo>
                    <a:pt x="659" y="928"/>
                  </a:lnTo>
                  <a:lnTo>
                    <a:pt x="671" y="927"/>
                  </a:lnTo>
                  <a:lnTo>
                    <a:pt x="680" y="925"/>
                  </a:lnTo>
                  <a:lnTo>
                    <a:pt x="692" y="927"/>
                  </a:lnTo>
                  <a:lnTo>
                    <a:pt x="703" y="923"/>
                  </a:lnTo>
                  <a:lnTo>
                    <a:pt x="715" y="925"/>
                  </a:lnTo>
                  <a:lnTo>
                    <a:pt x="724" y="925"/>
                  </a:lnTo>
                  <a:lnTo>
                    <a:pt x="736" y="923"/>
                  </a:lnTo>
                  <a:lnTo>
                    <a:pt x="747" y="923"/>
                  </a:lnTo>
                  <a:lnTo>
                    <a:pt x="759" y="923"/>
                  </a:lnTo>
                  <a:lnTo>
                    <a:pt x="768" y="922"/>
                  </a:lnTo>
                  <a:lnTo>
                    <a:pt x="780" y="922"/>
                  </a:lnTo>
                  <a:lnTo>
                    <a:pt x="791" y="920"/>
                  </a:lnTo>
                  <a:lnTo>
                    <a:pt x="801" y="920"/>
                  </a:lnTo>
                  <a:lnTo>
                    <a:pt x="812" y="920"/>
                  </a:lnTo>
                  <a:lnTo>
                    <a:pt x="824" y="919"/>
                  </a:lnTo>
                  <a:lnTo>
                    <a:pt x="835" y="919"/>
                  </a:lnTo>
                  <a:lnTo>
                    <a:pt x="845" y="919"/>
                  </a:lnTo>
                  <a:lnTo>
                    <a:pt x="857" y="919"/>
                  </a:lnTo>
                  <a:lnTo>
                    <a:pt x="868" y="917"/>
                  </a:lnTo>
                  <a:lnTo>
                    <a:pt x="879" y="919"/>
                  </a:lnTo>
                  <a:lnTo>
                    <a:pt x="889" y="917"/>
                  </a:lnTo>
                  <a:lnTo>
                    <a:pt x="901" y="915"/>
                  </a:lnTo>
                  <a:lnTo>
                    <a:pt x="912" y="915"/>
                  </a:lnTo>
                  <a:lnTo>
                    <a:pt x="923" y="917"/>
                  </a:lnTo>
                  <a:lnTo>
                    <a:pt x="933" y="915"/>
                  </a:lnTo>
                  <a:lnTo>
                    <a:pt x="945" y="915"/>
                  </a:lnTo>
                  <a:lnTo>
                    <a:pt x="956" y="914"/>
                  </a:lnTo>
                  <a:lnTo>
                    <a:pt x="966" y="912"/>
                  </a:lnTo>
                  <a:lnTo>
                    <a:pt x="977" y="912"/>
                  </a:lnTo>
                  <a:lnTo>
                    <a:pt x="989" y="912"/>
                  </a:lnTo>
                  <a:lnTo>
                    <a:pt x="1000" y="912"/>
                  </a:lnTo>
                  <a:lnTo>
                    <a:pt x="1010" y="912"/>
                  </a:lnTo>
                  <a:lnTo>
                    <a:pt x="1021" y="912"/>
                  </a:lnTo>
                  <a:lnTo>
                    <a:pt x="1033" y="910"/>
                  </a:lnTo>
                  <a:lnTo>
                    <a:pt x="1044" y="910"/>
                  </a:lnTo>
                  <a:lnTo>
                    <a:pt x="1054" y="910"/>
                  </a:lnTo>
                  <a:lnTo>
                    <a:pt x="1065" y="912"/>
                  </a:lnTo>
                  <a:lnTo>
                    <a:pt x="1077" y="910"/>
                  </a:lnTo>
                  <a:lnTo>
                    <a:pt x="1088" y="909"/>
                  </a:lnTo>
                  <a:lnTo>
                    <a:pt x="1098" y="907"/>
                  </a:lnTo>
                  <a:lnTo>
                    <a:pt x="1109" y="905"/>
                  </a:lnTo>
                  <a:lnTo>
                    <a:pt x="1121" y="907"/>
                  </a:lnTo>
                  <a:lnTo>
                    <a:pt x="1131" y="907"/>
                  </a:lnTo>
                  <a:lnTo>
                    <a:pt x="1142" y="907"/>
                  </a:lnTo>
                  <a:lnTo>
                    <a:pt x="1154" y="907"/>
                  </a:lnTo>
                  <a:lnTo>
                    <a:pt x="1165" y="905"/>
                  </a:lnTo>
                  <a:lnTo>
                    <a:pt x="1175" y="905"/>
                  </a:lnTo>
                  <a:lnTo>
                    <a:pt x="1186" y="905"/>
                  </a:lnTo>
                  <a:lnTo>
                    <a:pt x="1198" y="905"/>
                  </a:lnTo>
                  <a:lnTo>
                    <a:pt x="1209" y="905"/>
                  </a:lnTo>
                  <a:lnTo>
                    <a:pt x="1219" y="905"/>
                  </a:lnTo>
                  <a:lnTo>
                    <a:pt x="1230" y="905"/>
                  </a:lnTo>
                  <a:lnTo>
                    <a:pt x="1242" y="905"/>
                  </a:lnTo>
                  <a:lnTo>
                    <a:pt x="1253" y="905"/>
                  </a:lnTo>
                  <a:lnTo>
                    <a:pt x="1263" y="904"/>
                  </a:lnTo>
                  <a:lnTo>
                    <a:pt x="1274" y="904"/>
                  </a:lnTo>
                  <a:lnTo>
                    <a:pt x="1286" y="902"/>
                  </a:lnTo>
                  <a:lnTo>
                    <a:pt x="1295" y="902"/>
                  </a:lnTo>
                  <a:lnTo>
                    <a:pt x="1307" y="902"/>
                  </a:lnTo>
                  <a:lnTo>
                    <a:pt x="1318" y="901"/>
                  </a:lnTo>
                  <a:lnTo>
                    <a:pt x="1330" y="899"/>
                  </a:lnTo>
                  <a:lnTo>
                    <a:pt x="1340" y="899"/>
                  </a:lnTo>
                  <a:lnTo>
                    <a:pt x="1351" y="899"/>
                  </a:lnTo>
                  <a:lnTo>
                    <a:pt x="1362" y="901"/>
                  </a:lnTo>
                  <a:lnTo>
                    <a:pt x="1374" y="899"/>
                  </a:lnTo>
                  <a:lnTo>
                    <a:pt x="1384" y="899"/>
                  </a:lnTo>
                  <a:lnTo>
                    <a:pt x="1395" y="899"/>
                  </a:lnTo>
                  <a:lnTo>
                    <a:pt x="1406" y="896"/>
                  </a:lnTo>
                  <a:lnTo>
                    <a:pt x="1418" y="897"/>
                  </a:lnTo>
                  <a:lnTo>
                    <a:pt x="1428" y="897"/>
                  </a:lnTo>
                  <a:lnTo>
                    <a:pt x="1439" y="897"/>
                  </a:lnTo>
                  <a:lnTo>
                    <a:pt x="1450" y="896"/>
                  </a:lnTo>
                  <a:lnTo>
                    <a:pt x="1460" y="896"/>
                  </a:lnTo>
                  <a:lnTo>
                    <a:pt x="1472" y="896"/>
                  </a:lnTo>
                  <a:lnTo>
                    <a:pt x="1483" y="896"/>
                  </a:lnTo>
                  <a:lnTo>
                    <a:pt x="1495" y="896"/>
                  </a:lnTo>
                  <a:lnTo>
                    <a:pt x="1504" y="896"/>
                  </a:lnTo>
                  <a:lnTo>
                    <a:pt x="1516" y="894"/>
                  </a:lnTo>
                  <a:lnTo>
                    <a:pt x="1527" y="892"/>
                  </a:lnTo>
                  <a:lnTo>
                    <a:pt x="1539" y="896"/>
                  </a:lnTo>
                  <a:lnTo>
                    <a:pt x="1548" y="894"/>
                  </a:lnTo>
                  <a:lnTo>
                    <a:pt x="1560" y="892"/>
                  </a:lnTo>
                  <a:lnTo>
                    <a:pt x="1571" y="892"/>
                  </a:lnTo>
                  <a:lnTo>
                    <a:pt x="1583" y="894"/>
                  </a:lnTo>
                  <a:lnTo>
                    <a:pt x="1592" y="892"/>
                  </a:lnTo>
                  <a:lnTo>
                    <a:pt x="1604" y="891"/>
                  </a:lnTo>
                  <a:lnTo>
                    <a:pt x="1615" y="891"/>
                  </a:lnTo>
                  <a:lnTo>
                    <a:pt x="1625" y="891"/>
                  </a:lnTo>
                  <a:lnTo>
                    <a:pt x="1637" y="891"/>
                  </a:lnTo>
                  <a:lnTo>
                    <a:pt x="1648" y="889"/>
                  </a:lnTo>
                  <a:lnTo>
                    <a:pt x="1659" y="889"/>
                  </a:lnTo>
                  <a:lnTo>
                    <a:pt x="1669" y="889"/>
                  </a:lnTo>
                  <a:lnTo>
                    <a:pt x="1681" y="889"/>
                  </a:lnTo>
                  <a:lnTo>
                    <a:pt x="1692" y="891"/>
                  </a:lnTo>
                  <a:lnTo>
                    <a:pt x="1703" y="889"/>
                  </a:lnTo>
                  <a:lnTo>
                    <a:pt x="1713" y="889"/>
                  </a:lnTo>
                  <a:lnTo>
                    <a:pt x="1725" y="888"/>
                  </a:lnTo>
                  <a:lnTo>
                    <a:pt x="1736" y="888"/>
                  </a:lnTo>
                  <a:lnTo>
                    <a:pt x="1747" y="889"/>
                  </a:lnTo>
                  <a:lnTo>
                    <a:pt x="1757" y="888"/>
                  </a:lnTo>
                  <a:lnTo>
                    <a:pt x="1769" y="888"/>
                  </a:lnTo>
                  <a:lnTo>
                    <a:pt x="1780" y="886"/>
                  </a:lnTo>
                  <a:lnTo>
                    <a:pt x="1790" y="888"/>
                  </a:lnTo>
                  <a:lnTo>
                    <a:pt x="1801" y="886"/>
                  </a:lnTo>
                  <a:lnTo>
                    <a:pt x="1813" y="886"/>
                  </a:lnTo>
                  <a:lnTo>
                    <a:pt x="1824" y="886"/>
                  </a:lnTo>
                  <a:lnTo>
                    <a:pt x="1834" y="886"/>
                  </a:lnTo>
                  <a:lnTo>
                    <a:pt x="1845" y="886"/>
                  </a:lnTo>
                  <a:lnTo>
                    <a:pt x="1857" y="884"/>
                  </a:lnTo>
                  <a:lnTo>
                    <a:pt x="1868" y="884"/>
                  </a:lnTo>
                  <a:lnTo>
                    <a:pt x="1878" y="883"/>
                  </a:lnTo>
                  <a:lnTo>
                    <a:pt x="1889" y="884"/>
                  </a:lnTo>
                  <a:lnTo>
                    <a:pt x="1901" y="884"/>
                  </a:lnTo>
                  <a:lnTo>
                    <a:pt x="1912" y="883"/>
                  </a:lnTo>
                  <a:lnTo>
                    <a:pt x="1922" y="883"/>
                  </a:lnTo>
                  <a:lnTo>
                    <a:pt x="1933" y="883"/>
                  </a:lnTo>
                  <a:lnTo>
                    <a:pt x="1945" y="883"/>
                  </a:lnTo>
                  <a:lnTo>
                    <a:pt x="1955" y="883"/>
                  </a:lnTo>
                  <a:lnTo>
                    <a:pt x="1966" y="881"/>
                  </a:lnTo>
                  <a:lnTo>
                    <a:pt x="1978" y="883"/>
                  </a:lnTo>
                  <a:lnTo>
                    <a:pt x="1989" y="881"/>
                  </a:lnTo>
                  <a:lnTo>
                    <a:pt x="1999" y="881"/>
                  </a:lnTo>
                  <a:lnTo>
                    <a:pt x="2010" y="881"/>
                  </a:lnTo>
                  <a:lnTo>
                    <a:pt x="2022" y="881"/>
                  </a:lnTo>
                  <a:lnTo>
                    <a:pt x="2033" y="881"/>
                  </a:lnTo>
                  <a:lnTo>
                    <a:pt x="2043" y="881"/>
                  </a:lnTo>
                  <a:lnTo>
                    <a:pt x="2054" y="879"/>
                  </a:lnTo>
                  <a:lnTo>
                    <a:pt x="2066" y="879"/>
                  </a:lnTo>
                  <a:lnTo>
                    <a:pt x="2077" y="879"/>
                  </a:lnTo>
                  <a:lnTo>
                    <a:pt x="2087" y="879"/>
                  </a:lnTo>
                  <a:lnTo>
                    <a:pt x="2098" y="879"/>
                  </a:lnTo>
                  <a:lnTo>
                    <a:pt x="2110" y="878"/>
                  </a:lnTo>
                  <a:lnTo>
                    <a:pt x="2119" y="878"/>
                  </a:lnTo>
                  <a:lnTo>
                    <a:pt x="2131" y="878"/>
                  </a:lnTo>
                  <a:lnTo>
                    <a:pt x="2142" y="878"/>
                  </a:lnTo>
                  <a:lnTo>
                    <a:pt x="2154" y="878"/>
                  </a:lnTo>
                  <a:lnTo>
                    <a:pt x="2164" y="876"/>
                  </a:lnTo>
                  <a:lnTo>
                    <a:pt x="2175" y="876"/>
                  </a:lnTo>
                  <a:lnTo>
                    <a:pt x="2186" y="876"/>
                  </a:lnTo>
                  <a:lnTo>
                    <a:pt x="2198" y="876"/>
                  </a:lnTo>
                  <a:lnTo>
                    <a:pt x="2208" y="875"/>
                  </a:lnTo>
                  <a:lnTo>
                    <a:pt x="2219" y="876"/>
                  </a:lnTo>
                  <a:lnTo>
                    <a:pt x="2230" y="889"/>
                  </a:lnTo>
                  <a:lnTo>
                    <a:pt x="2242" y="888"/>
                  </a:lnTo>
                  <a:lnTo>
                    <a:pt x="2252" y="902"/>
                  </a:lnTo>
                  <a:lnTo>
                    <a:pt x="2263" y="868"/>
                  </a:lnTo>
                  <a:lnTo>
                    <a:pt x="2275" y="842"/>
                  </a:lnTo>
                  <a:lnTo>
                    <a:pt x="2284" y="855"/>
                  </a:lnTo>
                  <a:lnTo>
                    <a:pt x="2296" y="865"/>
                  </a:lnTo>
                  <a:lnTo>
                    <a:pt x="2307" y="871"/>
                  </a:lnTo>
                  <a:lnTo>
                    <a:pt x="2319" y="875"/>
                  </a:lnTo>
                  <a:lnTo>
                    <a:pt x="2328" y="875"/>
                  </a:lnTo>
                  <a:lnTo>
                    <a:pt x="2340" y="878"/>
                  </a:lnTo>
                  <a:lnTo>
                    <a:pt x="2351" y="878"/>
                  </a:lnTo>
                  <a:lnTo>
                    <a:pt x="2363" y="879"/>
                  </a:lnTo>
                  <a:lnTo>
                    <a:pt x="2372" y="881"/>
                  </a:lnTo>
                  <a:lnTo>
                    <a:pt x="2384" y="881"/>
                  </a:lnTo>
                  <a:lnTo>
                    <a:pt x="2395" y="883"/>
                  </a:lnTo>
                  <a:lnTo>
                    <a:pt x="2407" y="883"/>
                  </a:lnTo>
                  <a:lnTo>
                    <a:pt x="2416" y="883"/>
                  </a:lnTo>
                  <a:lnTo>
                    <a:pt x="2428" y="883"/>
                  </a:lnTo>
                  <a:lnTo>
                    <a:pt x="2439" y="884"/>
                  </a:lnTo>
                  <a:lnTo>
                    <a:pt x="2449" y="884"/>
                  </a:lnTo>
                  <a:lnTo>
                    <a:pt x="2461" y="886"/>
                  </a:lnTo>
                  <a:lnTo>
                    <a:pt x="2472" y="886"/>
                  </a:lnTo>
                  <a:lnTo>
                    <a:pt x="2483" y="886"/>
                  </a:lnTo>
                  <a:lnTo>
                    <a:pt x="2493" y="888"/>
                  </a:lnTo>
                  <a:lnTo>
                    <a:pt x="2505" y="888"/>
                  </a:lnTo>
                  <a:lnTo>
                    <a:pt x="2516" y="886"/>
                  </a:lnTo>
                  <a:lnTo>
                    <a:pt x="2527" y="886"/>
                  </a:lnTo>
                  <a:lnTo>
                    <a:pt x="2537" y="886"/>
                  </a:lnTo>
                  <a:lnTo>
                    <a:pt x="2549" y="888"/>
                  </a:lnTo>
                  <a:lnTo>
                    <a:pt x="2560" y="888"/>
                  </a:lnTo>
                  <a:lnTo>
                    <a:pt x="2571" y="886"/>
                  </a:lnTo>
                  <a:lnTo>
                    <a:pt x="2581" y="888"/>
                  </a:lnTo>
                  <a:lnTo>
                    <a:pt x="2593" y="888"/>
                  </a:lnTo>
                  <a:lnTo>
                    <a:pt x="2604" y="886"/>
                  </a:lnTo>
                  <a:lnTo>
                    <a:pt x="2614" y="886"/>
                  </a:lnTo>
                  <a:lnTo>
                    <a:pt x="2625" y="886"/>
                  </a:lnTo>
                  <a:lnTo>
                    <a:pt x="2637" y="886"/>
                  </a:lnTo>
                  <a:lnTo>
                    <a:pt x="2648" y="886"/>
                  </a:lnTo>
                  <a:lnTo>
                    <a:pt x="2658" y="888"/>
                  </a:lnTo>
                  <a:lnTo>
                    <a:pt x="2669" y="886"/>
                  </a:lnTo>
                  <a:lnTo>
                    <a:pt x="2681" y="886"/>
                  </a:lnTo>
                  <a:lnTo>
                    <a:pt x="2692" y="886"/>
                  </a:lnTo>
                  <a:lnTo>
                    <a:pt x="2702" y="888"/>
                  </a:lnTo>
                  <a:lnTo>
                    <a:pt x="2713" y="886"/>
                  </a:lnTo>
                  <a:lnTo>
                    <a:pt x="2725" y="886"/>
                  </a:lnTo>
                  <a:lnTo>
                    <a:pt x="2736" y="886"/>
                  </a:lnTo>
                  <a:lnTo>
                    <a:pt x="2746" y="888"/>
                  </a:lnTo>
                  <a:lnTo>
                    <a:pt x="2758" y="888"/>
                  </a:lnTo>
                  <a:lnTo>
                    <a:pt x="2769" y="889"/>
                  </a:lnTo>
                  <a:lnTo>
                    <a:pt x="2779" y="888"/>
                  </a:lnTo>
                  <a:lnTo>
                    <a:pt x="2790" y="888"/>
                  </a:lnTo>
                  <a:lnTo>
                    <a:pt x="2802" y="888"/>
                  </a:lnTo>
                  <a:lnTo>
                    <a:pt x="2813" y="888"/>
                  </a:lnTo>
                  <a:lnTo>
                    <a:pt x="2823" y="888"/>
                  </a:lnTo>
                  <a:lnTo>
                    <a:pt x="2834" y="888"/>
                  </a:lnTo>
                  <a:lnTo>
                    <a:pt x="2846" y="886"/>
                  </a:lnTo>
                  <a:lnTo>
                    <a:pt x="2857" y="886"/>
                  </a:lnTo>
                  <a:lnTo>
                    <a:pt x="2867" y="889"/>
                  </a:lnTo>
                  <a:lnTo>
                    <a:pt x="2878" y="889"/>
                  </a:lnTo>
                  <a:lnTo>
                    <a:pt x="2890" y="886"/>
                  </a:lnTo>
                  <a:lnTo>
                    <a:pt x="2901" y="888"/>
                  </a:lnTo>
                  <a:lnTo>
                    <a:pt x="2911" y="888"/>
                  </a:lnTo>
                  <a:lnTo>
                    <a:pt x="2922" y="886"/>
                  </a:lnTo>
                  <a:lnTo>
                    <a:pt x="2934" y="888"/>
                  </a:lnTo>
                  <a:lnTo>
                    <a:pt x="2944" y="888"/>
                  </a:lnTo>
                  <a:lnTo>
                    <a:pt x="2955" y="888"/>
                  </a:lnTo>
                  <a:lnTo>
                    <a:pt x="2966" y="888"/>
                  </a:lnTo>
                  <a:lnTo>
                    <a:pt x="2978" y="888"/>
                  </a:lnTo>
                  <a:lnTo>
                    <a:pt x="2988" y="888"/>
                  </a:lnTo>
                  <a:lnTo>
                    <a:pt x="2999" y="886"/>
                  </a:lnTo>
                  <a:lnTo>
                    <a:pt x="3010" y="886"/>
                  </a:lnTo>
                  <a:lnTo>
                    <a:pt x="3022" y="888"/>
                  </a:lnTo>
                  <a:lnTo>
                    <a:pt x="3032" y="888"/>
                  </a:lnTo>
                  <a:lnTo>
                    <a:pt x="3043" y="888"/>
                  </a:lnTo>
                  <a:lnTo>
                    <a:pt x="3054" y="888"/>
                  </a:lnTo>
                  <a:lnTo>
                    <a:pt x="3066" y="888"/>
                  </a:lnTo>
                  <a:lnTo>
                    <a:pt x="3076" y="888"/>
                  </a:lnTo>
                  <a:lnTo>
                    <a:pt x="3087" y="886"/>
                  </a:lnTo>
                  <a:lnTo>
                    <a:pt x="3099" y="888"/>
                  </a:lnTo>
                  <a:lnTo>
                    <a:pt x="3108" y="888"/>
                  </a:lnTo>
                  <a:lnTo>
                    <a:pt x="3120" y="888"/>
                  </a:lnTo>
                  <a:lnTo>
                    <a:pt x="3131" y="888"/>
                  </a:lnTo>
                  <a:lnTo>
                    <a:pt x="3143" y="886"/>
                  </a:lnTo>
                  <a:lnTo>
                    <a:pt x="3152" y="886"/>
                  </a:lnTo>
                  <a:lnTo>
                    <a:pt x="3164" y="886"/>
                  </a:lnTo>
                  <a:lnTo>
                    <a:pt x="3175" y="888"/>
                  </a:lnTo>
                  <a:lnTo>
                    <a:pt x="3187" y="888"/>
                  </a:lnTo>
                  <a:lnTo>
                    <a:pt x="3196" y="886"/>
                  </a:lnTo>
                  <a:lnTo>
                    <a:pt x="3208" y="888"/>
                  </a:lnTo>
                  <a:lnTo>
                    <a:pt x="3219" y="886"/>
                  </a:lnTo>
                  <a:lnTo>
                    <a:pt x="3231" y="886"/>
                  </a:lnTo>
                  <a:lnTo>
                    <a:pt x="3240" y="888"/>
                  </a:lnTo>
                  <a:lnTo>
                    <a:pt x="3252" y="888"/>
                  </a:lnTo>
                  <a:lnTo>
                    <a:pt x="3263" y="888"/>
                  </a:lnTo>
                  <a:lnTo>
                    <a:pt x="3273" y="888"/>
                  </a:lnTo>
                  <a:lnTo>
                    <a:pt x="3285" y="888"/>
                  </a:lnTo>
                  <a:lnTo>
                    <a:pt x="3296" y="888"/>
                  </a:lnTo>
                  <a:lnTo>
                    <a:pt x="3307" y="889"/>
                  </a:lnTo>
                  <a:lnTo>
                    <a:pt x="3317" y="888"/>
                  </a:lnTo>
                  <a:lnTo>
                    <a:pt x="3329" y="888"/>
                  </a:lnTo>
                  <a:lnTo>
                    <a:pt x="3340" y="888"/>
                  </a:lnTo>
                  <a:lnTo>
                    <a:pt x="3351" y="888"/>
                  </a:lnTo>
                  <a:lnTo>
                    <a:pt x="3361" y="888"/>
                  </a:lnTo>
                  <a:lnTo>
                    <a:pt x="3373" y="888"/>
                  </a:lnTo>
                  <a:lnTo>
                    <a:pt x="3384" y="889"/>
                  </a:lnTo>
                  <a:lnTo>
                    <a:pt x="3396" y="889"/>
                  </a:lnTo>
                  <a:lnTo>
                    <a:pt x="3405" y="888"/>
                  </a:lnTo>
                  <a:lnTo>
                    <a:pt x="3417" y="886"/>
                  </a:lnTo>
                  <a:lnTo>
                    <a:pt x="3428" y="888"/>
                  </a:lnTo>
                  <a:lnTo>
                    <a:pt x="3438" y="889"/>
                  </a:lnTo>
                  <a:lnTo>
                    <a:pt x="3449" y="888"/>
                  </a:lnTo>
                  <a:lnTo>
                    <a:pt x="3461" y="886"/>
                  </a:lnTo>
                  <a:lnTo>
                    <a:pt x="3472" y="886"/>
                  </a:lnTo>
                  <a:lnTo>
                    <a:pt x="3482" y="888"/>
                  </a:lnTo>
                  <a:lnTo>
                    <a:pt x="3493" y="888"/>
                  </a:lnTo>
                  <a:lnTo>
                    <a:pt x="3505" y="886"/>
                  </a:lnTo>
                  <a:lnTo>
                    <a:pt x="3516" y="886"/>
                  </a:lnTo>
                  <a:lnTo>
                    <a:pt x="3526" y="886"/>
                  </a:lnTo>
                  <a:lnTo>
                    <a:pt x="3537" y="886"/>
                  </a:lnTo>
                  <a:lnTo>
                    <a:pt x="3549" y="884"/>
                  </a:lnTo>
                  <a:lnTo>
                    <a:pt x="3560" y="886"/>
                  </a:lnTo>
                  <a:lnTo>
                    <a:pt x="3570" y="884"/>
                  </a:lnTo>
                  <a:lnTo>
                    <a:pt x="3582" y="886"/>
                  </a:lnTo>
                  <a:lnTo>
                    <a:pt x="3593" y="886"/>
                  </a:lnTo>
                  <a:lnTo>
                    <a:pt x="3603" y="886"/>
                  </a:lnTo>
                  <a:lnTo>
                    <a:pt x="3614" y="884"/>
                  </a:lnTo>
                  <a:lnTo>
                    <a:pt x="3626" y="886"/>
                  </a:lnTo>
                  <a:lnTo>
                    <a:pt x="3637" y="888"/>
                  </a:lnTo>
                  <a:lnTo>
                    <a:pt x="3647" y="886"/>
                  </a:lnTo>
                  <a:lnTo>
                    <a:pt x="3658" y="888"/>
                  </a:lnTo>
                  <a:lnTo>
                    <a:pt x="3670" y="886"/>
                  </a:lnTo>
                  <a:lnTo>
                    <a:pt x="3681" y="886"/>
                  </a:lnTo>
                  <a:lnTo>
                    <a:pt x="3691" y="886"/>
                  </a:lnTo>
                  <a:lnTo>
                    <a:pt x="3702" y="888"/>
                  </a:lnTo>
                  <a:lnTo>
                    <a:pt x="3714" y="884"/>
                  </a:lnTo>
                  <a:lnTo>
                    <a:pt x="3725" y="886"/>
                  </a:lnTo>
                  <a:lnTo>
                    <a:pt x="3735" y="888"/>
                  </a:lnTo>
                  <a:lnTo>
                    <a:pt x="3746" y="884"/>
                  </a:lnTo>
                  <a:lnTo>
                    <a:pt x="3758" y="884"/>
                  </a:lnTo>
                  <a:lnTo>
                    <a:pt x="3768" y="886"/>
                  </a:lnTo>
                  <a:lnTo>
                    <a:pt x="3779" y="888"/>
                  </a:lnTo>
                  <a:lnTo>
                    <a:pt x="3790" y="886"/>
                  </a:lnTo>
                  <a:lnTo>
                    <a:pt x="3802" y="886"/>
                  </a:lnTo>
                  <a:lnTo>
                    <a:pt x="3812" y="886"/>
                  </a:lnTo>
                  <a:lnTo>
                    <a:pt x="3823" y="886"/>
                  </a:lnTo>
                  <a:lnTo>
                    <a:pt x="3834" y="886"/>
                  </a:lnTo>
                  <a:lnTo>
                    <a:pt x="3846" y="886"/>
                  </a:lnTo>
                  <a:lnTo>
                    <a:pt x="3856" y="884"/>
                  </a:lnTo>
                  <a:lnTo>
                    <a:pt x="3867" y="884"/>
                  </a:lnTo>
                  <a:lnTo>
                    <a:pt x="3878" y="884"/>
                  </a:lnTo>
                  <a:lnTo>
                    <a:pt x="3890" y="884"/>
                  </a:lnTo>
                  <a:lnTo>
                    <a:pt x="3900" y="884"/>
                  </a:lnTo>
                  <a:lnTo>
                    <a:pt x="3911" y="886"/>
                  </a:lnTo>
                  <a:lnTo>
                    <a:pt x="3923" y="884"/>
                  </a:lnTo>
                  <a:lnTo>
                    <a:pt x="3932" y="889"/>
                  </a:lnTo>
                  <a:lnTo>
                    <a:pt x="3944" y="894"/>
                  </a:lnTo>
                  <a:lnTo>
                    <a:pt x="3955" y="889"/>
                  </a:lnTo>
                  <a:lnTo>
                    <a:pt x="3967" y="884"/>
                  </a:lnTo>
                  <a:lnTo>
                    <a:pt x="3976" y="883"/>
                  </a:lnTo>
                  <a:lnTo>
                    <a:pt x="3988" y="889"/>
                  </a:lnTo>
                  <a:lnTo>
                    <a:pt x="3999" y="891"/>
                  </a:lnTo>
                  <a:lnTo>
                    <a:pt x="4011" y="881"/>
                  </a:lnTo>
                  <a:lnTo>
                    <a:pt x="4020" y="878"/>
                  </a:lnTo>
                  <a:lnTo>
                    <a:pt x="4032" y="881"/>
                  </a:lnTo>
                  <a:lnTo>
                    <a:pt x="4043" y="883"/>
                  </a:lnTo>
                  <a:lnTo>
                    <a:pt x="4055" y="884"/>
                  </a:lnTo>
                  <a:lnTo>
                    <a:pt x="4065" y="883"/>
                  </a:lnTo>
                  <a:lnTo>
                    <a:pt x="4076" y="884"/>
                  </a:lnTo>
                  <a:lnTo>
                    <a:pt x="4087" y="879"/>
                  </a:lnTo>
                  <a:lnTo>
                    <a:pt x="4097" y="873"/>
                  </a:lnTo>
                  <a:lnTo>
                    <a:pt x="4109" y="876"/>
                  </a:lnTo>
                  <a:lnTo>
                    <a:pt x="4120" y="883"/>
                  </a:lnTo>
                  <a:lnTo>
                    <a:pt x="4131" y="889"/>
                  </a:lnTo>
                  <a:lnTo>
                    <a:pt x="4141" y="894"/>
                  </a:lnTo>
                  <a:lnTo>
                    <a:pt x="4153" y="888"/>
                  </a:lnTo>
                  <a:lnTo>
                    <a:pt x="4164" y="883"/>
                  </a:lnTo>
                  <a:lnTo>
                    <a:pt x="4175" y="883"/>
                  </a:lnTo>
                  <a:lnTo>
                    <a:pt x="4185" y="883"/>
                  </a:lnTo>
                  <a:lnTo>
                    <a:pt x="4197" y="881"/>
                  </a:lnTo>
                  <a:lnTo>
                    <a:pt x="4208" y="883"/>
                  </a:lnTo>
                  <a:lnTo>
                    <a:pt x="4220" y="881"/>
                  </a:lnTo>
                  <a:lnTo>
                    <a:pt x="4229" y="883"/>
                  </a:lnTo>
                </a:path>
              </a:pathLst>
            </a:custGeom>
            <a:noFill/>
            <a:ln w="19050" cmpd="sng">
              <a:solidFill>
                <a:schemeClr val="bg1">
                  <a:lumMod val="50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6" name="Freeform 102"/>
            <p:cNvSpPr>
              <a:spLocks/>
            </p:cNvSpPr>
            <p:nvPr/>
          </p:nvSpPr>
          <p:spPr bwMode="auto">
            <a:xfrm>
              <a:off x="1450182" y="1554163"/>
              <a:ext cx="6708775" cy="1654175"/>
            </a:xfrm>
            <a:custGeom>
              <a:avLst/>
              <a:gdLst>
                <a:gd name="T0" fmla="*/ 67 w 4226"/>
                <a:gd name="T1" fmla="*/ 1042 h 1042"/>
                <a:gd name="T2" fmla="*/ 139 w 4226"/>
                <a:gd name="T3" fmla="*/ 1042 h 1042"/>
                <a:gd name="T4" fmla="*/ 214 w 4226"/>
                <a:gd name="T5" fmla="*/ 1042 h 1042"/>
                <a:gd name="T6" fmla="*/ 285 w 4226"/>
                <a:gd name="T7" fmla="*/ 1042 h 1042"/>
                <a:gd name="T8" fmla="*/ 359 w 4226"/>
                <a:gd name="T9" fmla="*/ 830 h 1042"/>
                <a:gd name="T10" fmla="*/ 432 w 4226"/>
                <a:gd name="T11" fmla="*/ 778 h 1042"/>
                <a:gd name="T12" fmla="*/ 506 w 4226"/>
                <a:gd name="T13" fmla="*/ 729 h 1042"/>
                <a:gd name="T14" fmla="*/ 579 w 4226"/>
                <a:gd name="T15" fmla="*/ 682 h 1042"/>
                <a:gd name="T16" fmla="*/ 653 w 4226"/>
                <a:gd name="T17" fmla="*/ 636 h 1042"/>
                <a:gd name="T18" fmla="*/ 726 w 4226"/>
                <a:gd name="T19" fmla="*/ 592 h 1042"/>
                <a:gd name="T20" fmla="*/ 799 w 4226"/>
                <a:gd name="T21" fmla="*/ 550 h 1042"/>
                <a:gd name="T22" fmla="*/ 873 w 4226"/>
                <a:gd name="T23" fmla="*/ 510 h 1042"/>
                <a:gd name="T24" fmla="*/ 946 w 4226"/>
                <a:gd name="T25" fmla="*/ 471 h 1042"/>
                <a:gd name="T26" fmla="*/ 1021 w 4226"/>
                <a:gd name="T27" fmla="*/ 434 h 1042"/>
                <a:gd name="T28" fmla="*/ 1095 w 4226"/>
                <a:gd name="T29" fmla="*/ 398 h 1042"/>
                <a:gd name="T30" fmla="*/ 1168 w 4226"/>
                <a:gd name="T31" fmla="*/ 362 h 1042"/>
                <a:gd name="T32" fmla="*/ 1242 w 4226"/>
                <a:gd name="T33" fmla="*/ 329 h 1042"/>
                <a:gd name="T34" fmla="*/ 1315 w 4226"/>
                <a:gd name="T35" fmla="*/ 297 h 1042"/>
                <a:gd name="T36" fmla="*/ 1389 w 4226"/>
                <a:gd name="T37" fmla="*/ 266 h 1042"/>
                <a:gd name="T38" fmla="*/ 1462 w 4226"/>
                <a:gd name="T39" fmla="*/ 236 h 1042"/>
                <a:gd name="T40" fmla="*/ 1535 w 4226"/>
                <a:gd name="T41" fmla="*/ 209 h 1042"/>
                <a:gd name="T42" fmla="*/ 1609 w 4226"/>
                <a:gd name="T43" fmla="*/ 181 h 1042"/>
                <a:gd name="T44" fmla="*/ 1682 w 4226"/>
                <a:gd name="T45" fmla="*/ 155 h 1042"/>
                <a:gd name="T46" fmla="*/ 1754 w 4226"/>
                <a:gd name="T47" fmla="*/ 130 h 1042"/>
                <a:gd name="T48" fmla="*/ 1827 w 4226"/>
                <a:gd name="T49" fmla="*/ 106 h 1042"/>
                <a:gd name="T50" fmla="*/ 1901 w 4226"/>
                <a:gd name="T51" fmla="*/ 81 h 1042"/>
                <a:gd name="T52" fmla="*/ 1974 w 4226"/>
                <a:gd name="T53" fmla="*/ 60 h 1042"/>
                <a:gd name="T54" fmla="*/ 2048 w 4226"/>
                <a:gd name="T55" fmla="*/ 37 h 1042"/>
                <a:gd name="T56" fmla="*/ 2121 w 4226"/>
                <a:gd name="T57" fmla="*/ 18 h 1042"/>
                <a:gd name="T58" fmla="*/ 2195 w 4226"/>
                <a:gd name="T59" fmla="*/ 171 h 1042"/>
                <a:gd name="T60" fmla="*/ 2268 w 4226"/>
                <a:gd name="T61" fmla="*/ 176 h 1042"/>
                <a:gd name="T62" fmla="*/ 2341 w 4226"/>
                <a:gd name="T63" fmla="*/ 179 h 1042"/>
                <a:gd name="T64" fmla="*/ 2415 w 4226"/>
                <a:gd name="T65" fmla="*/ 184 h 1042"/>
                <a:gd name="T66" fmla="*/ 2488 w 4226"/>
                <a:gd name="T67" fmla="*/ 187 h 1042"/>
                <a:gd name="T68" fmla="*/ 2562 w 4226"/>
                <a:gd name="T69" fmla="*/ 191 h 1042"/>
                <a:gd name="T70" fmla="*/ 2635 w 4226"/>
                <a:gd name="T71" fmla="*/ 196 h 1042"/>
                <a:gd name="T72" fmla="*/ 2709 w 4226"/>
                <a:gd name="T73" fmla="*/ 199 h 1042"/>
                <a:gd name="T74" fmla="*/ 2782 w 4226"/>
                <a:gd name="T75" fmla="*/ 202 h 1042"/>
                <a:gd name="T76" fmla="*/ 2855 w 4226"/>
                <a:gd name="T77" fmla="*/ 207 h 1042"/>
                <a:gd name="T78" fmla="*/ 2929 w 4226"/>
                <a:gd name="T79" fmla="*/ 210 h 1042"/>
                <a:gd name="T80" fmla="*/ 3002 w 4226"/>
                <a:gd name="T81" fmla="*/ 213 h 1042"/>
                <a:gd name="T82" fmla="*/ 3076 w 4226"/>
                <a:gd name="T83" fmla="*/ 218 h 1042"/>
                <a:gd name="T84" fmla="*/ 3151 w 4226"/>
                <a:gd name="T85" fmla="*/ 222 h 1042"/>
                <a:gd name="T86" fmla="*/ 3223 w 4226"/>
                <a:gd name="T87" fmla="*/ 225 h 1042"/>
                <a:gd name="T88" fmla="*/ 3298 w 4226"/>
                <a:gd name="T89" fmla="*/ 230 h 1042"/>
                <a:gd name="T90" fmla="*/ 3369 w 4226"/>
                <a:gd name="T91" fmla="*/ 233 h 1042"/>
                <a:gd name="T92" fmla="*/ 3445 w 4226"/>
                <a:gd name="T93" fmla="*/ 236 h 1042"/>
                <a:gd name="T94" fmla="*/ 3516 w 4226"/>
                <a:gd name="T95" fmla="*/ 240 h 1042"/>
                <a:gd name="T96" fmla="*/ 3591 w 4226"/>
                <a:gd name="T97" fmla="*/ 244 h 1042"/>
                <a:gd name="T98" fmla="*/ 3663 w 4226"/>
                <a:gd name="T99" fmla="*/ 248 h 1042"/>
                <a:gd name="T100" fmla="*/ 3738 w 4226"/>
                <a:gd name="T101" fmla="*/ 251 h 1042"/>
                <a:gd name="T102" fmla="*/ 3810 w 4226"/>
                <a:gd name="T103" fmla="*/ 254 h 1042"/>
                <a:gd name="T104" fmla="*/ 3885 w 4226"/>
                <a:gd name="T105" fmla="*/ 259 h 1042"/>
                <a:gd name="T106" fmla="*/ 3957 w 4226"/>
                <a:gd name="T107" fmla="*/ 262 h 1042"/>
                <a:gd name="T108" fmla="*/ 4032 w 4226"/>
                <a:gd name="T109" fmla="*/ 266 h 1042"/>
                <a:gd name="T110" fmla="*/ 4104 w 4226"/>
                <a:gd name="T111" fmla="*/ 269 h 1042"/>
                <a:gd name="T112" fmla="*/ 4179 w 4226"/>
                <a:gd name="T113" fmla="*/ 272 h 10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226" h="1042">
                  <a:moveTo>
                    <a:pt x="0" y="1042"/>
                  </a:moveTo>
                  <a:lnTo>
                    <a:pt x="10" y="1042"/>
                  </a:lnTo>
                  <a:lnTo>
                    <a:pt x="16" y="1042"/>
                  </a:lnTo>
                  <a:lnTo>
                    <a:pt x="26" y="1042"/>
                  </a:lnTo>
                  <a:lnTo>
                    <a:pt x="33" y="1042"/>
                  </a:lnTo>
                  <a:lnTo>
                    <a:pt x="42" y="1042"/>
                  </a:lnTo>
                  <a:lnTo>
                    <a:pt x="49" y="1042"/>
                  </a:lnTo>
                  <a:lnTo>
                    <a:pt x="57" y="1042"/>
                  </a:lnTo>
                  <a:lnTo>
                    <a:pt x="67" y="1042"/>
                  </a:lnTo>
                  <a:lnTo>
                    <a:pt x="73" y="1042"/>
                  </a:lnTo>
                  <a:lnTo>
                    <a:pt x="83" y="1042"/>
                  </a:lnTo>
                  <a:lnTo>
                    <a:pt x="90" y="1042"/>
                  </a:lnTo>
                  <a:lnTo>
                    <a:pt x="99" y="1042"/>
                  </a:lnTo>
                  <a:lnTo>
                    <a:pt x="106" y="1042"/>
                  </a:lnTo>
                  <a:lnTo>
                    <a:pt x="116" y="1042"/>
                  </a:lnTo>
                  <a:lnTo>
                    <a:pt x="124" y="1042"/>
                  </a:lnTo>
                  <a:lnTo>
                    <a:pt x="130" y="1042"/>
                  </a:lnTo>
                  <a:lnTo>
                    <a:pt x="139" y="1042"/>
                  </a:lnTo>
                  <a:lnTo>
                    <a:pt x="147" y="1042"/>
                  </a:lnTo>
                  <a:lnTo>
                    <a:pt x="157" y="1042"/>
                  </a:lnTo>
                  <a:lnTo>
                    <a:pt x="165" y="1042"/>
                  </a:lnTo>
                  <a:lnTo>
                    <a:pt x="173" y="1042"/>
                  </a:lnTo>
                  <a:lnTo>
                    <a:pt x="179" y="1042"/>
                  </a:lnTo>
                  <a:lnTo>
                    <a:pt x="188" y="1042"/>
                  </a:lnTo>
                  <a:lnTo>
                    <a:pt x="196" y="1042"/>
                  </a:lnTo>
                  <a:lnTo>
                    <a:pt x="204" y="1042"/>
                  </a:lnTo>
                  <a:lnTo>
                    <a:pt x="214" y="1042"/>
                  </a:lnTo>
                  <a:lnTo>
                    <a:pt x="220" y="1042"/>
                  </a:lnTo>
                  <a:lnTo>
                    <a:pt x="230" y="1042"/>
                  </a:lnTo>
                  <a:lnTo>
                    <a:pt x="238" y="1042"/>
                  </a:lnTo>
                  <a:lnTo>
                    <a:pt x="245" y="1042"/>
                  </a:lnTo>
                  <a:lnTo>
                    <a:pt x="254" y="1042"/>
                  </a:lnTo>
                  <a:lnTo>
                    <a:pt x="263" y="1042"/>
                  </a:lnTo>
                  <a:lnTo>
                    <a:pt x="269" y="1042"/>
                  </a:lnTo>
                  <a:lnTo>
                    <a:pt x="279" y="1042"/>
                  </a:lnTo>
                  <a:lnTo>
                    <a:pt x="285" y="1042"/>
                  </a:lnTo>
                  <a:lnTo>
                    <a:pt x="295" y="1042"/>
                  </a:lnTo>
                  <a:lnTo>
                    <a:pt x="302" y="1042"/>
                  </a:lnTo>
                  <a:lnTo>
                    <a:pt x="310" y="866"/>
                  </a:lnTo>
                  <a:lnTo>
                    <a:pt x="320" y="859"/>
                  </a:lnTo>
                  <a:lnTo>
                    <a:pt x="328" y="853"/>
                  </a:lnTo>
                  <a:lnTo>
                    <a:pt x="334" y="848"/>
                  </a:lnTo>
                  <a:lnTo>
                    <a:pt x="344" y="842"/>
                  </a:lnTo>
                  <a:lnTo>
                    <a:pt x="352" y="835"/>
                  </a:lnTo>
                  <a:lnTo>
                    <a:pt x="359" y="830"/>
                  </a:lnTo>
                  <a:lnTo>
                    <a:pt x="367" y="824"/>
                  </a:lnTo>
                  <a:lnTo>
                    <a:pt x="377" y="819"/>
                  </a:lnTo>
                  <a:lnTo>
                    <a:pt x="385" y="812"/>
                  </a:lnTo>
                  <a:lnTo>
                    <a:pt x="392" y="807"/>
                  </a:lnTo>
                  <a:lnTo>
                    <a:pt x="401" y="801"/>
                  </a:lnTo>
                  <a:lnTo>
                    <a:pt x="409" y="796"/>
                  </a:lnTo>
                  <a:lnTo>
                    <a:pt x="418" y="789"/>
                  </a:lnTo>
                  <a:lnTo>
                    <a:pt x="424" y="784"/>
                  </a:lnTo>
                  <a:lnTo>
                    <a:pt x="432" y="778"/>
                  </a:lnTo>
                  <a:lnTo>
                    <a:pt x="441" y="773"/>
                  </a:lnTo>
                  <a:lnTo>
                    <a:pt x="449" y="768"/>
                  </a:lnTo>
                  <a:lnTo>
                    <a:pt x="458" y="762"/>
                  </a:lnTo>
                  <a:lnTo>
                    <a:pt x="467" y="757"/>
                  </a:lnTo>
                  <a:lnTo>
                    <a:pt x="475" y="750"/>
                  </a:lnTo>
                  <a:lnTo>
                    <a:pt x="483" y="745"/>
                  </a:lnTo>
                  <a:lnTo>
                    <a:pt x="489" y="740"/>
                  </a:lnTo>
                  <a:lnTo>
                    <a:pt x="499" y="734"/>
                  </a:lnTo>
                  <a:lnTo>
                    <a:pt x="506" y="729"/>
                  </a:lnTo>
                  <a:lnTo>
                    <a:pt x="516" y="724"/>
                  </a:lnTo>
                  <a:lnTo>
                    <a:pt x="522" y="719"/>
                  </a:lnTo>
                  <a:lnTo>
                    <a:pt x="532" y="713"/>
                  </a:lnTo>
                  <a:lnTo>
                    <a:pt x="538" y="708"/>
                  </a:lnTo>
                  <a:lnTo>
                    <a:pt x="547" y="703"/>
                  </a:lnTo>
                  <a:lnTo>
                    <a:pt x="556" y="698"/>
                  </a:lnTo>
                  <a:lnTo>
                    <a:pt x="563" y="691"/>
                  </a:lnTo>
                  <a:lnTo>
                    <a:pt x="573" y="687"/>
                  </a:lnTo>
                  <a:lnTo>
                    <a:pt x="579" y="682"/>
                  </a:lnTo>
                  <a:lnTo>
                    <a:pt x="589" y="677"/>
                  </a:lnTo>
                  <a:lnTo>
                    <a:pt x="596" y="672"/>
                  </a:lnTo>
                  <a:lnTo>
                    <a:pt x="604" y="667"/>
                  </a:lnTo>
                  <a:lnTo>
                    <a:pt x="613" y="660"/>
                  </a:lnTo>
                  <a:lnTo>
                    <a:pt x="620" y="656"/>
                  </a:lnTo>
                  <a:lnTo>
                    <a:pt x="630" y="651"/>
                  </a:lnTo>
                  <a:lnTo>
                    <a:pt x="636" y="646"/>
                  </a:lnTo>
                  <a:lnTo>
                    <a:pt x="646" y="641"/>
                  </a:lnTo>
                  <a:lnTo>
                    <a:pt x="653" y="636"/>
                  </a:lnTo>
                  <a:lnTo>
                    <a:pt x="661" y="631"/>
                  </a:lnTo>
                  <a:lnTo>
                    <a:pt x="671" y="626"/>
                  </a:lnTo>
                  <a:lnTo>
                    <a:pt x="679" y="621"/>
                  </a:lnTo>
                  <a:lnTo>
                    <a:pt x="685" y="616"/>
                  </a:lnTo>
                  <a:lnTo>
                    <a:pt x="693" y="612"/>
                  </a:lnTo>
                  <a:lnTo>
                    <a:pt x="703" y="607"/>
                  </a:lnTo>
                  <a:lnTo>
                    <a:pt x="711" y="602"/>
                  </a:lnTo>
                  <a:lnTo>
                    <a:pt x="718" y="597"/>
                  </a:lnTo>
                  <a:lnTo>
                    <a:pt x="726" y="592"/>
                  </a:lnTo>
                  <a:lnTo>
                    <a:pt x="734" y="587"/>
                  </a:lnTo>
                  <a:lnTo>
                    <a:pt x="744" y="582"/>
                  </a:lnTo>
                  <a:lnTo>
                    <a:pt x="752" y="577"/>
                  </a:lnTo>
                  <a:lnTo>
                    <a:pt x="759" y="574"/>
                  </a:lnTo>
                  <a:lnTo>
                    <a:pt x="767" y="569"/>
                  </a:lnTo>
                  <a:lnTo>
                    <a:pt x="777" y="564"/>
                  </a:lnTo>
                  <a:lnTo>
                    <a:pt x="785" y="559"/>
                  </a:lnTo>
                  <a:lnTo>
                    <a:pt x="793" y="554"/>
                  </a:lnTo>
                  <a:lnTo>
                    <a:pt x="799" y="550"/>
                  </a:lnTo>
                  <a:lnTo>
                    <a:pt x="808" y="546"/>
                  </a:lnTo>
                  <a:lnTo>
                    <a:pt x="817" y="541"/>
                  </a:lnTo>
                  <a:lnTo>
                    <a:pt x="826" y="536"/>
                  </a:lnTo>
                  <a:lnTo>
                    <a:pt x="832" y="532"/>
                  </a:lnTo>
                  <a:lnTo>
                    <a:pt x="840" y="527"/>
                  </a:lnTo>
                  <a:lnTo>
                    <a:pt x="848" y="523"/>
                  </a:lnTo>
                  <a:lnTo>
                    <a:pt x="858" y="519"/>
                  </a:lnTo>
                  <a:lnTo>
                    <a:pt x="866" y="514"/>
                  </a:lnTo>
                  <a:lnTo>
                    <a:pt x="873" y="510"/>
                  </a:lnTo>
                  <a:lnTo>
                    <a:pt x="881" y="505"/>
                  </a:lnTo>
                  <a:lnTo>
                    <a:pt x="891" y="501"/>
                  </a:lnTo>
                  <a:lnTo>
                    <a:pt x="899" y="496"/>
                  </a:lnTo>
                  <a:lnTo>
                    <a:pt x="907" y="492"/>
                  </a:lnTo>
                  <a:lnTo>
                    <a:pt x="914" y="488"/>
                  </a:lnTo>
                  <a:lnTo>
                    <a:pt x="922" y="483"/>
                  </a:lnTo>
                  <a:lnTo>
                    <a:pt x="932" y="479"/>
                  </a:lnTo>
                  <a:lnTo>
                    <a:pt x="940" y="474"/>
                  </a:lnTo>
                  <a:lnTo>
                    <a:pt x="946" y="471"/>
                  </a:lnTo>
                  <a:lnTo>
                    <a:pt x="954" y="466"/>
                  </a:lnTo>
                  <a:lnTo>
                    <a:pt x="963" y="461"/>
                  </a:lnTo>
                  <a:lnTo>
                    <a:pt x="972" y="458"/>
                  </a:lnTo>
                  <a:lnTo>
                    <a:pt x="981" y="453"/>
                  </a:lnTo>
                  <a:lnTo>
                    <a:pt x="987" y="450"/>
                  </a:lnTo>
                  <a:lnTo>
                    <a:pt x="995" y="445"/>
                  </a:lnTo>
                  <a:lnTo>
                    <a:pt x="1005" y="442"/>
                  </a:lnTo>
                  <a:lnTo>
                    <a:pt x="1013" y="437"/>
                  </a:lnTo>
                  <a:lnTo>
                    <a:pt x="1021" y="434"/>
                  </a:lnTo>
                  <a:lnTo>
                    <a:pt x="1030" y="429"/>
                  </a:lnTo>
                  <a:lnTo>
                    <a:pt x="1038" y="426"/>
                  </a:lnTo>
                  <a:lnTo>
                    <a:pt x="1044" y="421"/>
                  </a:lnTo>
                  <a:lnTo>
                    <a:pt x="1052" y="417"/>
                  </a:lnTo>
                  <a:lnTo>
                    <a:pt x="1061" y="412"/>
                  </a:lnTo>
                  <a:lnTo>
                    <a:pt x="1069" y="409"/>
                  </a:lnTo>
                  <a:lnTo>
                    <a:pt x="1079" y="404"/>
                  </a:lnTo>
                  <a:lnTo>
                    <a:pt x="1087" y="401"/>
                  </a:lnTo>
                  <a:lnTo>
                    <a:pt x="1095" y="398"/>
                  </a:lnTo>
                  <a:lnTo>
                    <a:pt x="1103" y="393"/>
                  </a:lnTo>
                  <a:lnTo>
                    <a:pt x="1111" y="390"/>
                  </a:lnTo>
                  <a:lnTo>
                    <a:pt x="1118" y="385"/>
                  </a:lnTo>
                  <a:lnTo>
                    <a:pt x="1126" y="381"/>
                  </a:lnTo>
                  <a:lnTo>
                    <a:pt x="1134" y="378"/>
                  </a:lnTo>
                  <a:lnTo>
                    <a:pt x="1142" y="373"/>
                  </a:lnTo>
                  <a:lnTo>
                    <a:pt x="1150" y="370"/>
                  </a:lnTo>
                  <a:lnTo>
                    <a:pt x="1160" y="367"/>
                  </a:lnTo>
                  <a:lnTo>
                    <a:pt x="1168" y="362"/>
                  </a:lnTo>
                  <a:lnTo>
                    <a:pt x="1176" y="359"/>
                  </a:lnTo>
                  <a:lnTo>
                    <a:pt x="1185" y="355"/>
                  </a:lnTo>
                  <a:lnTo>
                    <a:pt x="1191" y="351"/>
                  </a:lnTo>
                  <a:lnTo>
                    <a:pt x="1199" y="347"/>
                  </a:lnTo>
                  <a:lnTo>
                    <a:pt x="1207" y="344"/>
                  </a:lnTo>
                  <a:lnTo>
                    <a:pt x="1216" y="341"/>
                  </a:lnTo>
                  <a:lnTo>
                    <a:pt x="1224" y="336"/>
                  </a:lnTo>
                  <a:lnTo>
                    <a:pt x="1234" y="333"/>
                  </a:lnTo>
                  <a:lnTo>
                    <a:pt x="1242" y="329"/>
                  </a:lnTo>
                  <a:lnTo>
                    <a:pt x="1250" y="326"/>
                  </a:lnTo>
                  <a:lnTo>
                    <a:pt x="1258" y="323"/>
                  </a:lnTo>
                  <a:lnTo>
                    <a:pt x="1266" y="318"/>
                  </a:lnTo>
                  <a:lnTo>
                    <a:pt x="1273" y="315"/>
                  </a:lnTo>
                  <a:lnTo>
                    <a:pt x="1281" y="311"/>
                  </a:lnTo>
                  <a:lnTo>
                    <a:pt x="1289" y="308"/>
                  </a:lnTo>
                  <a:lnTo>
                    <a:pt x="1297" y="305"/>
                  </a:lnTo>
                  <a:lnTo>
                    <a:pt x="1307" y="300"/>
                  </a:lnTo>
                  <a:lnTo>
                    <a:pt x="1315" y="297"/>
                  </a:lnTo>
                  <a:lnTo>
                    <a:pt x="1323" y="293"/>
                  </a:lnTo>
                  <a:lnTo>
                    <a:pt x="1331" y="290"/>
                  </a:lnTo>
                  <a:lnTo>
                    <a:pt x="1340" y="287"/>
                  </a:lnTo>
                  <a:lnTo>
                    <a:pt x="1346" y="284"/>
                  </a:lnTo>
                  <a:lnTo>
                    <a:pt x="1354" y="280"/>
                  </a:lnTo>
                  <a:lnTo>
                    <a:pt x="1362" y="277"/>
                  </a:lnTo>
                  <a:lnTo>
                    <a:pt x="1371" y="274"/>
                  </a:lnTo>
                  <a:lnTo>
                    <a:pt x="1380" y="271"/>
                  </a:lnTo>
                  <a:lnTo>
                    <a:pt x="1389" y="266"/>
                  </a:lnTo>
                  <a:lnTo>
                    <a:pt x="1397" y="262"/>
                  </a:lnTo>
                  <a:lnTo>
                    <a:pt x="1405" y="259"/>
                  </a:lnTo>
                  <a:lnTo>
                    <a:pt x="1413" y="256"/>
                  </a:lnTo>
                  <a:lnTo>
                    <a:pt x="1420" y="253"/>
                  </a:lnTo>
                  <a:lnTo>
                    <a:pt x="1428" y="249"/>
                  </a:lnTo>
                  <a:lnTo>
                    <a:pt x="1436" y="246"/>
                  </a:lnTo>
                  <a:lnTo>
                    <a:pt x="1444" y="243"/>
                  </a:lnTo>
                  <a:lnTo>
                    <a:pt x="1452" y="240"/>
                  </a:lnTo>
                  <a:lnTo>
                    <a:pt x="1462" y="236"/>
                  </a:lnTo>
                  <a:lnTo>
                    <a:pt x="1470" y="233"/>
                  </a:lnTo>
                  <a:lnTo>
                    <a:pt x="1478" y="230"/>
                  </a:lnTo>
                  <a:lnTo>
                    <a:pt x="1486" y="227"/>
                  </a:lnTo>
                  <a:lnTo>
                    <a:pt x="1493" y="225"/>
                  </a:lnTo>
                  <a:lnTo>
                    <a:pt x="1501" y="222"/>
                  </a:lnTo>
                  <a:lnTo>
                    <a:pt x="1509" y="218"/>
                  </a:lnTo>
                  <a:lnTo>
                    <a:pt x="1517" y="215"/>
                  </a:lnTo>
                  <a:lnTo>
                    <a:pt x="1526" y="212"/>
                  </a:lnTo>
                  <a:lnTo>
                    <a:pt x="1535" y="209"/>
                  </a:lnTo>
                  <a:lnTo>
                    <a:pt x="1544" y="205"/>
                  </a:lnTo>
                  <a:lnTo>
                    <a:pt x="1552" y="202"/>
                  </a:lnTo>
                  <a:lnTo>
                    <a:pt x="1560" y="199"/>
                  </a:lnTo>
                  <a:lnTo>
                    <a:pt x="1568" y="196"/>
                  </a:lnTo>
                  <a:lnTo>
                    <a:pt x="1575" y="194"/>
                  </a:lnTo>
                  <a:lnTo>
                    <a:pt x="1583" y="191"/>
                  </a:lnTo>
                  <a:lnTo>
                    <a:pt x="1591" y="187"/>
                  </a:lnTo>
                  <a:lnTo>
                    <a:pt x="1599" y="184"/>
                  </a:lnTo>
                  <a:lnTo>
                    <a:pt x="1609" y="181"/>
                  </a:lnTo>
                  <a:lnTo>
                    <a:pt x="1617" y="178"/>
                  </a:lnTo>
                  <a:lnTo>
                    <a:pt x="1625" y="176"/>
                  </a:lnTo>
                  <a:lnTo>
                    <a:pt x="1633" y="173"/>
                  </a:lnTo>
                  <a:lnTo>
                    <a:pt x="1641" y="169"/>
                  </a:lnTo>
                  <a:lnTo>
                    <a:pt x="1648" y="166"/>
                  </a:lnTo>
                  <a:lnTo>
                    <a:pt x="1656" y="163"/>
                  </a:lnTo>
                  <a:lnTo>
                    <a:pt x="1664" y="161"/>
                  </a:lnTo>
                  <a:lnTo>
                    <a:pt x="1672" y="158"/>
                  </a:lnTo>
                  <a:lnTo>
                    <a:pt x="1682" y="155"/>
                  </a:lnTo>
                  <a:lnTo>
                    <a:pt x="1690" y="151"/>
                  </a:lnTo>
                  <a:lnTo>
                    <a:pt x="1699" y="150"/>
                  </a:lnTo>
                  <a:lnTo>
                    <a:pt x="1707" y="147"/>
                  </a:lnTo>
                  <a:lnTo>
                    <a:pt x="1715" y="143"/>
                  </a:lnTo>
                  <a:lnTo>
                    <a:pt x="1721" y="140"/>
                  </a:lnTo>
                  <a:lnTo>
                    <a:pt x="1731" y="138"/>
                  </a:lnTo>
                  <a:lnTo>
                    <a:pt x="1738" y="135"/>
                  </a:lnTo>
                  <a:lnTo>
                    <a:pt x="1748" y="132"/>
                  </a:lnTo>
                  <a:lnTo>
                    <a:pt x="1754" y="130"/>
                  </a:lnTo>
                  <a:lnTo>
                    <a:pt x="1762" y="127"/>
                  </a:lnTo>
                  <a:lnTo>
                    <a:pt x="1772" y="124"/>
                  </a:lnTo>
                  <a:lnTo>
                    <a:pt x="1779" y="122"/>
                  </a:lnTo>
                  <a:lnTo>
                    <a:pt x="1788" y="119"/>
                  </a:lnTo>
                  <a:lnTo>
                    <a:pt x="1795" y="116"/>
                  </a:lnTo>
                  <a:lnTo>
                    <a:pt x="1805" y="114"/>
                  </a:lnTo>
                  <a:lnTo>
                    <a:pt x="1811" y="111"/>
                  </a:lnTo>
                  <a:lnTo>
                    <a:pt x="1821" y="107"/>
                  </a:lnTo>
                  <a:lnTo>
                    <a:pt x="1827" y="106"/>
                  </a:lnTo>
                  <a:lnTo>
                    <a:pt x="1836" y="103"/>
                  </a:lnTo>
                  <a:lnTo>
                    <a:pt x="1845" y="99"/>
                  </a:lnTo>
                  <a:lnTo>
                    <a:pt x="1852" y="98"/>
                  </a:lnTo>
                  <a:lnTo>
                    <a:pt x="1862" y="94"/>
                  </a:lnTo>
                  <a:lnTo>
                    <a:pt x="1868" y="93"/>
                  </a:lnTo>
                  <a:lnTo>
                    <a:pt x="1878" y="89"/>
                  </a:lnTo>
                  <a:lnTo>
                    <a:pt x="1885" y="86"/>
                  </a:lnTo>
                  <a:lnTo>
                    <a:pt x="1894" y="85"/>
                  </a:lnTo>
                  <a:lnTo>
                    <a:pt x="1901" y="81"/>
                  </a:lnTo>
                  <a:lnTo>
                    <a:pt x="1909" y="80"/>
                  </a:lnTo>
                  <a:lnTo>
                    <a:pt x="1919" y="76"/>
                  </a:lnTo>
                  <a:lnTo>
                    <a:pt x="1925" y="75"/>
                  </a:lnTo>
                  <a:lnTo>
                    <a:pt x="1935" y="72"/>
                  </a:lnTo>
                  <a:lnTo>
                    <a:pt x="1942" y="70"/>
                  </a:lnTo>
                  <a:lnTo>
                    <a:pt x="1951" y="67"/>
                  </a:lnTo>
                  <a:lnTo>
                    <a:pt x="1958" y="65"/>
                  </a:lnTo>
                  <a:lnTo>
                    <a:pt x="1968" y="62"/>
                  </a:lnTo>
                  <a:lnTo>
                    <a:pt x="1974" y="60"/>
                  </a:lnTo>
                  <a:lnTo>
                    <a:pt x="1982" y="57"/>
                  </a:lnTo>
                  <a:lnTo>
                    <a:pt x="1992" y="55"/>
                  </a:lnTo>
                  <a:lnTo>
                    <a:pt x="1999" y="52"/>
                  </a:lnTo>
                  <a:lnTo>
                    <a:pt x="2009" y="50"/>
                  </a:lnTo>
                  <a:lnTo>
                    <a:pt x="2015" y="47"/>
                  </a:lnTo>
                  <a:lnTo>
                    <a:pt x="2025" y="45"/>
                  </a:lnTo>
                  <a:lnTo>
                    <a:pt x="2031" y="42"/>
                  </a:lnTo>
                  <a:lnTo>
                    <a:pt x="2041" y="41"/>
                  </a:lnTo>
                  <a:lnTo>
                    <a:pt x="2048" y="37"/>
                  </a:lnTo>
                  <a:lnTo>
                    <a:pt x="2058" y="36"/>
                  </a:lnTo>
                  <a:lnTo>
                    <a:pt x="2066" y="32"/>
                  </a:lnTo>
                  <a:lnTo>
                    <a:pt x="2072" y="31"/>
                  </a:lnTo>
                  <a:lnTo>
                    <a:pt x="2082" y="29"/>
                  </a:lnTo>
                  <a:lnTo>
                    <a:pt x="2089" y="26"/>
                  </a:lnTo>
                  <a:lnTo>
                    <a:pt x="2098" y="24"/>
                  </a:lnTo>
                  <a:lnTo>
                    <a:pt x="2105" y="21"/>
                  </a:lnTo>
                  <a:lnTo>
                    <a:pt x="2115" y="19"/>
                  </a:lnTo>
                  <a:lnTo>
                    <a:pt x="2121" y="18"/>
                  </a:lnTo>
                  <a:lnTo>
                    <a:pt x="2131" y="14"/>
                  </a:lnTo>
                  <a:lnTo>
                    <a:pt x="2139" y="13"/>
                  </a:lnTo>
                  <a:lnTo>
                    <a:pt x="2146" y="10"/>
                  </a:lnTo>
                  <a:lnTo>
                    <a:pt x="2155" y="8"/>
                  </a:lnTo>
                  <a:lnTo>
                    <a:pt x="2162" y="6"/>
                  </a:lnTo>
                  <a:lnTo>
                    <a:pt x="2172" y="3"/>
                  </a:lnTo>
                  <a:lnTo>
                    <a:pt x="2178" y="1"/>
                  </a:lnTo>
                  <a:lnTo>
                    <a:pt x="2188" y="0"/>
                  </a:lnTo>
                  <a:lnTo>
                    <a:pt x="2195" y="171"/>
                  </a:lnTo>
                  <a:lnTo>
                    <a:pt x="2204" y="173"/>
                  </a:lnTo>
                  <a:lnTo>
                    <a:pt x="2213" y="173"/>
                  </a:lnTo>
                  <a:lnTo>
                    <a:pt x="2219" y="173"/>
                  </a:lnTo>
                  <a:lnTo>
                    <a:pt x="2229" y="173"/>
                  </a:lnTo>
                  <a:lnTo>
                    <a:pt x="2235" y="174"/>
                  </a:lnTo>
                  <a:lnTo>
                    <a:pt x="2245" y="174"/>
                  </a:lnTo>
                  <a:lnTo>
                    <a:pt x="2252" y="174"/>
                  </a:lnTo>
                  <a:lnTo>
                    <a:pt x="2262" y="174"/>
                  </a:lnTo>
                  <a:lnTo>
                    <a:pt x="2268" y="176"/>
                  </a:lnTo>
                  <a:lnTo>
                    <a:pt x="2278" y="176"/>
                  </a:lnTo>
                  <a:lnTo>
                    <a:pt x="2286" y="176"/>
                  </a:lnTo>
                  <a:lnTo>
                    <a:pt x="2293" y="176"/>
                  </a:lnTo>
                  <a:lnTo>
                    <a:pt x="2302" y="178"/>
                  </a:lnTo>
                  <a:lnTo>
                    <a:pt x="2309" y="178"/>
                  </a:lnTo>
                  <a:lnTo>
                    <a:pt x="2319" y="178"/>
                  </a:lnTo>
                  <a:lnTo>
                    <a:pt x="2325" y="179"/>
                  </a:lnTo>
                  <a:lnTo>
                    <a:pt x="2335" y="179"/>
                  </a:lnTo>
                  <a:lnTo>
                    <a:pt x="2341" y="179"/>
                  </a:lnTo>
                  <a:lnTo>
                    <a:pt x="2351" y="179"/>
                  </a:lnTo>
                  <a:lnTo>
                    <a:pt x="2358" y="181"/>
                  </a:lnTo>
                  <a:lnTo>
                    <a:pt x="2366" y="181"/>
                  </a:lnTo>
                  <a:lnTo>
                    <a:pt x="2376" y="181"/>
                  </a:lnTo>
                  <a:lnTo>
                    <a:pt x="2382" y="181"/>
                  </a:lnTo>
                  <a:lnTo>
                    <a:pt x="2392" y="182"/>
                  </a:lnTo>
                  <a:lnTo>
                    <a:pt x="2399" y="182"/>
                  </a:lnTo>
                  <a:lnTo>
                    <a:pt x="2408" y="182"/>
                  </a:lnTo>
                  <a:lnTo>
                    <a:pt x="2415" y="184"/>
                  </a:lnTo>
                  <a:lnTo>
                    <a:pt x="2425" y="184"/>
                  </a:lnTo>
                  <a:lnTo>
                    <a:pt x="2431" y="184"/>
                  </a:lnTo>
                  <a:lnTo>
                    <a:pt x="2439" y="184"/>
                  </a:lnTo>
                  <a:lnTo>
                    <a:pt x="2449" y="186"/>
                  </a:lnTo>
                  <a:lnTo>
                    <a:pt x="2456" y="186"/>
                  </a:lnTo>
                  <a:lnTo>
                    <a:pt x="2465" y="186"/>
                  </a:lnTo>
                  <a:lnTo>
                    <a:pt x="2472" y="186"/>
                  </a:lnTo>
                  <a:lnTo>
                    <a:pt x="2482" y="187"/>
                  </a:lnTo>
                  <a:lnTo>
                    <a:pt x="2488" y="187"/>
                  </a:lnTo>
                  <a:lnTo>
                    <a:pt x="2498" y="187"/>
                  </a:lnTo>
                  <a:lnTo>
                    <a:pt x="2505" y="187"/>
                  </a:lnTo>
                  <a:lnTo>
                    <a:pt x="2513" y="189"/>
                  </a:lnTo>
                  <a:lnTo>
                    <a:pt x="2523" y="189"/>
                  </a:lnTo>
                  <a:lnTo>
                    <a:pt x="2529" y="189"/>
                  </a:lnTo>
                  <a:lnTo>
                    <a:pt x="2539" y="191"/>
                  </a:lnTo>
                  <a:lnTo>
                    <a:pt x="2545" y="191"/>
                  </a:lnTo>
                  <a:lnTo>
                    <a:pt x="2555" y="191"/>
                  </a:lnTo>
                  <a:lnTo>
                    <a:pt x="2562" y="191"/>
                  </a:lnTo>
                  <a:lnTo>
                    <a:pt x="2572" y="192"/>
                  </a:lnTo>
                  <a:lnTo>
                    <a:pt x="2578" y="192"/>
                  </a:lnTo>
                  <a:lnTo>
                    <a:pt x="2586" y="192"/>
                  </a:lnTo>
                  <a:lnTo>
                    <a:pt x="2596" y="192"/>
                  </a:lnTo>
                  <a:lnTo>
                    <a:pt x="2603" y="194"/>
                  </a:lnTo>
                  <a:lnTo>
                    <a:pt x="2612" y="194"/>
                  </a:lnTo>
                  <a:lnTo>
                    <a:pt x="2619" y="194"/>
                  </a:lnTo>
                  <a:lnTo>
                    <a:pt x="2629" y="194"/>
                  </a:lnTo>
                  <a:lnTo>
                    <a:pt x="2635" y="196"/>
                  </a:lnTo>
                  <a:lnTo>
                    <a:pt x="2645" y="196"/>
                  </a:lnTo>
                  <a:lnTo>
                    <a:pt x="2651" y="196"/>
                  </a:lnTo>
                  <a:lnTo>
                    <a:pt x="2661" y="197"/>
                  </a:lnTo>
                  <a:lnTo>
                    <a:pt x="2669" y="197"/>
                  </a:lnTo>
                  <a:lnTo>
                    <a:pt x="2676" y="197"/>
                  </a:lnTo>
                  <a:lnTo>
                    <a:pt x="2686" y="197"/>
                  </a:lnTo>
                  <a:lnTo>
                    <a:pt x="2692" y="199"/>
                  </a:lnTo>
                  <a:lnTo>
                    <a:pt x="2702" y="199"/>
                  </a:lnTo>
                  <a:lnTo>
                    <a:pt x="2709" y="199"/>
                  </a:lnTo>
                  <a:lnTo>
                    <a:pt x="2718" y="199"/>
                  </a:lnTo>
                  <a:lnTo>
                    <a:pt x="2725" y="200"/>
                  </a:lnTo>
                  <a:lnTo>
                    <a:pt x="2735" y="200"/>
                  </a:lnTo>
                  <a:lnTo>
                    <a:pt x="2743" y="200"/>
                  </a:lnTo>
                  <a:lnTo>
                    <a:pt x="2749" y="200"/>
                  </a:lnTo>
                  <a:lnTo>
                    <a:pt x="2759" y="202"/>
                  </a:lnTo>
                  <a:lnTo>
                    <a:pt x="2766" y="202"/>
                  </a:lnTo>
                  <a:lnTo>
                    <a:pt x="2776" y="202"/>
                  </a:lnTo>
                  <a:lnTo>
                    <a:pt x="2782" y="202"/>
                  </a:lnTo>
                  <a:lnTo>
                    <a:pt x="2792" y="204"/>
                  </a:lnTo>
                  <a:lnTo>
                    <a:pt x="2798" y="204"/>
                  </a:lnTo>
                  <a:lnTo>
                    <a:pt x="2808" y="204"/>
                  </a:lnTo>
                  <a:lnTo>
                    <a:pt x="2816" y="205"/>
                  </a:lnTo>
                  <a:lnTo>
                    <a:pt x="2823" y="205"/>
                  </a:lnTo>
                  <a:lnTo>
                    <a:pt x="2833" y="205"/>
                  </a:lnTo>
                  <a:lnTo>
                    <a:pt x="2839" y="205"/>
                  </a:lnTo>
                  <a:lnTo>
                    <a:pt x="2849" y="207"/>
                  </a:lnTo>
                  <a:lnTo>
                    <a:pt x="2855" y="207"/>
                  </a:lnTo>
                  <a:lnTo>
                    <a:pt x="2865" y="207"/>
                  </a:lnTo>
                  <a:lnTo>
                    <a:pt x="2872" y="207"/>
                  </a:lnTo>
                  <a:lnTo>
                    <a:pt x="2882" y="209"/>
                  </a:lnTo>
                  <a:lnTo>
                    <a:pt x="2890" y="209"/>
                  </a:lnTo>
                  <a:lnTo>
                    <a:pt x="2896" y="209"/>
                  </a:lnTo>
                  <a:lnTo>
                    <a:pt x="2906" y="209"/>
                  </a:lnTo>
                  <a:lnTo>
                    <a:pt x="2913" y="210"/>
                  </a:lnTo>
                  <a:lnTo>
                    <a:pt x="2922" y="210"/>
                  </a:lnTo>
                  <a:lnTo>
                    <a:pt x="2929" y="210"/>
                  </a:lnTo>
                  <a:lnTo>
                    <a:pt x="2939" y="210"/>
                  </a:lnTo>
                  <a:lnTo>
                    <a:pt x="2945" y="212"/>
                  </a:lnTo>
                  <a:lnTo>
                    <a:pt x="2955" y="212"/>
                  </a:lnTo>
                  <a:lnTo>
                    <a:pt x="2962" y="212"/>
                  </a:lnTo>
                  <a:lnTo>
                    <a:pt x="2970" y="212"/>
                  </a:lnTo>
                  <a:lnTo>
                    <a:pt x="2979" y="213"/>
                  </a:lnTo>
                  <a:lnTo>
                    <a:pt x="2986" y="213"/>
                  </a:lnTo>
                  <a:lnTo>
                    <a:pt x="2996" y="213"/>
                  </a:lnTo>
                  <a:lnTo>
                    <a:pt x="3002" y="213"/>
                  </a:lnTo>
                  <a:lnTo>
                    <a:pt x="3012" y="215"/>
                  </a:lnTo>
                  <a:lnTo>
                    <a:pt x="3019" y="215"/>
                  </a:lnTo>
                  <a:lnTo>
                    <a:pt x="3028" y="215"/>
                  </a:lnTo>
                  <a:lnTo>
                    <a:pt x="3035" y="217"/>
                  </a:lnTo>
                  <a:lnTo>
                    <a:pt x="3043" y="217"/>
                  </a:lnTo>
                  <a:lnTo>
                    <a:pt x="3053" y="217"/>
                  </a:lnTo>
                  <a:lnTo>
                    <a:pt x="3059" y="217"/>
                  </a:lnTo>
                  <a:lnTo>
                    <a:pt x="3069" y="218"/>
                  </a:lnTo>
                  <a:lnTo>
                    <a:pt x="3076" y="218"/>
                  </a:lnTo>
                  <a:lnTo>
                    <a:pt x="3086" y="218"/>
                  </a:lnTo>
                  <a:lnTo>
                    <a:pt x="3092" y="218"/>
                  </a:lnTo>
                  <a:lnTo>
                    <a:pt x="3102" y="220"/>
                  </a:lnTo>
                  <a:lnTo>
                    <a:pt x="3108" y="220"/>
                  </a:lnTo>
                  <a:lnTo>
                    <a:pt x="3117" y="220"/>
                  </a:lnTo>
                  <a:lnTo>
                    <a:pt x="3125" y="220"/>
                  </a:lnTo>
                  <a:lnTo>
                    <a:pt x="3133" y="222"/>
                  </a:lnTo>
                  <a:lnTo>
                    <a:pt x="3143" y="222"/>
                  </a:lnTo>
                  <a:lnTo>
                    <a:pt x="3151" y="222"/>
                  </a:lnTo>
                  <a:lnTo>
                    <a:pt x="3157" y="222"/>
                  </a:lnTo>
                  <a:lnTo>
                    <a:pt x="3165" y="223"/>
                  </a:lnTo>
                  <a:lnTo>
                    <a:pt x="3175" y="223"/>
                  </a:lnTo>
                  <a:lnTo>
                    <a:pt x="3183" y="223"/>
                  </a:lnTo>
                  <a:lnTo>
                    <a:pt x="3190" y="223"/>
                  </a:lnTo>
                  <a:lnTo>
                    <a:pt x="3200" y="225"/>
                  </a:lnTo>
                  <a:lnTo>
                    <a:pt x="3208" y="225"/>
                  </a:lnTo>
                  <a:lnTo>
                    <a:pt x="3214" y="225"/>
                  </a:lnTo>
                  <a:lnTo>
                    <a:pt x="3223" y="225"/>
                  </a:lnTo>
                  <a:lnTo>
                    <a:pt x="3232" y="227"/>
                  </a:lnTo>
                  <a:lnTo>
                    <a:pt x="3241" y="227"/>
                  </a:lnTo>
                  <a:lnTo>
                    <a:pt x="3247" y="227"/>
                  </a:lnTo>
                  <a:lnTo>
                    <a:pt x="3255" y="227"/>
                  </a:lnTo>
                  <a:lnTo>
                    <a:pt x="3265" y="228"/>
                  </a:lnTo>
                  <a:lnTo>
                    <a:pt x="3272" y="228"/>
                  </a:lnTo>
                  <a:lnTo>
                    <a:pt x="3280" y="228"/>
                  </a:lnTo>
                  <a:lnTo>
                    <a:pt x="3289" y="228"/>
                  </a:lnTo>
                  <a:lnTo>
                    <a:pt x="3298" y="230"/>
                  </a:lnTo>
                  <a:lnTo>
                    <a:pt x="3304" y="230"/>
                  </a:lnTo>
                  <a:lnTo>
                    <a:pt x="3312" y="230"/>
                  </a:lnTo>
                  <a:lnTo>
                    <a:pt x="3322" y="230"/>
                  </a:lnTo>
                  <a:lnTo>
                    <a:pt x="3330" y="231"/>
                  </a:lnTo>
                  <a:lnTo>
                    <a:pt x="3337" y="231"/>
                  </a:lnTo>
                  <a:lnTo>
                    <a:pt x="3347" y="231"/>
                  </a:lnTo>
                  <a:lnTo>
                    <a:pt x="3355" y="231"/>
                  </a:lnTo>
                  <a:lnTo>
                    <a:pt x="3361" y="233"/>
                  </a:lnTo>
                  <a:lnTo>
                    <a:pt x="3369" y="233"/>
                  </a:lnTo>
                  <a:lnTo>
                    <a:pt x="3379" y="233"/>
                  </a:lnTo>
                  <a:lnTo>
                    <a:pt x="3387" y="233"/>
                  </a:lnTo>
                  <a:lnTo>
                    <a:pt x="3394" y="235"/>
                  </a:lnTo>
                  <a:lnTo>
                    <a:pt x="3402" y="235"/>
                  </a:lnTo>
                  <a:lnTo>
                    <a:pt x="3412" y="235"/>
                  </a:lnTo>
                  <a:lnTo>
                    <a:pt x="3418" y="235"/>
                  </a:lnTo>
                  <a:lnTo>
                    <a:pt x="3427" y="236"/>
                  </a:lnTo>
                  <a:lnTo>
                    <a:pt x="3436" y="236"/>
                  </a:lnTo>
                  <a:lnTo>
                    <a:pt x="3445" y="236"/>
                  </a:lnTo>
                  <a:lnTo>
                    <a:pt x="3451" y="236"/>
                  </a:lnTo>
                  <a:lnTo>
                    <a:pt x="3459" y="238"/>
                  </a:lnTo>
                  <a:lnTo>
                    <a:pt x="3469" y="238"/>
                  </a:lnTo>
                  <a:lnTo>
                    <a:pt x="3477" y="238"/>
                  </a:lnTo>
                  <a:lnTo>
                    <a:pt x="3484" y="238"/>
                  </a:lnTo>
                  <a:lnTo>
                    <a:pt x="3493" y="240"/>
                  </a:lnTo>
                  <a:lnTo>
                    <a:pt x="3502" y="240"/>
                  </a:lnTo>
                  <a:lnTo>
                    <a:pt x="3508" y="240"/>
                  </a:lnTo>
                  <a:lnTo>
                    <a:pt x="3516" y="240"/>
                  </a:lnTo>
                  <a:lnTo>
                    <a:pt x="3526" y="241"/>
                  </a:lnTo>
                  <a:lnTo>
                    <a:pt x="3534" y="241"/>
                  </a:lnTo>
                  <a:lnTo>
                    <a:pt x="3541" y="241"/>
                  </a:lnTo>
                  <a:lnTo>
                    <a:pt x="3549" y="241"/>
                  </a:lnTo>
                  <a:lnTo>
                    <a:pt x="3559" y="243"/>
                  </a:lnTo>
                  <a:lnTo>
                    <a:pt x="3567" y="243"/>
                  </a:lnTo>
                  <a:lnTo>
                    <a:pt x="3573" y="243"/>
                  </a:lnTo>
                  <a:lnTo>
                    <a:pt x="3583" y="243"/>
                  </a:lnTo>
                  <a:lnTo>
                    <a:pt x="3591" y="244"/>
                  </a:lnTo>
                  <a:lnTo>
                    <a:pt x="3598" y="244"/>
                  </a:lnTo>
                  <a:lnTo>
                    <a:pt x="3606" y="244"/>
                  </a:lnTo>
                  <a:lnTo>
                    <a:pt x="3616" y="244"/>
                  </a:lnTo>
                  <a:lnTo>
                    <a:pt x="3624" y="246"/>
                  </a:lnTo>
                  <a:lnTo>
                    <a:pt x="3631" y="246"/>
                  </a:lnTo>
                  <a:lnTo>
                    <a:pt x="3639" y="246"/>
                  </a:lnTo>
                  <a:lnTo>
                    <a:pt x="3648" y="246"/>
                  </a:lnTo>
                  <a:lnTo>
                    <a:pt x="3655" y="248"/>
                  </a:lnTo>
                  <a:lnTo>
                    <a:pt x="3663" y="248"/>
                  </a:lnTo>
                  <a:lnTo>
                    <a:pt x="3673" y="248"/>
                  </a:lnTo>
                  <a:lnTo>
                    <a:pt x="3681" y="248"/>
                  </a:lnTo>
                  <a:lnTo>
                    <a:pt x="3688" y="249"/>
                  </a:lnTo>
                  <a:lnTo>
                    <a:pt x="3696" y="249"/>
                  </a:lnTo>
                  <a:lnTo>
                    <a:pt x="3706" y="249"/>
                  </a:lnTo>
                  <a:lnTo>
                    <a:pt x="3714" y="249"/>
                  </a:lnTo>
                  <a:lnTo>
                    <a:pt x="3720" y="251"/>
                  </a:lnTo>
                  <a:lnTo>
                    <a:pt x="3730" y="251"/>
                  </a:lnTo>
                  <a:lnTo>
                    <a:pt x="3738" y="251"/>
                  </a:lnTo>
                  <a:lnTo>
                    <a:pt x="3745" y="251"/>
                  </a:lnTo>
                  <a:lnTo>
                    <a:pt x="3753" y="253"/>
                  </a:lnTo>
                  <a:lnTo>
                    <a:pt x="3763" y="253"/>
                  </a:lnTo>
                  <a:lnTo>
                    <a:pt x="3771" y="253"/>
                  </a:lnTo>
                  <a:lnTo>
                    <a:pt x="3777" y="253"/>
                  </a:lnTo>
                  <a:lnTo>
                    <a:pt x="3786" y="254"/>
                  </a:lnTo>
                  <a:lnTo>
                    <a:pt x="3795" y="254"/>
                  </a:lnTo>
                  <a:lnTo>
                    <a:pt x="3802" y="254"/>
                  </a:lnTo>
                  <a:lnTo>
                    <a:pt x="3810" y="254"/>
                  </a:lnTo>
                  <a:lnTo>
                    <a:pt x="3820" y="256"/>
                  </a:lnTo>
                  <a:lnTo>
                    <a:pt x="3828" y="256"/>
                  </a:lnTo>
                  <a:lnTo>
                    <a:pt x="3834" y="256"/>
                  </a:lnTo>
                  <a:lnTo>
                    <a:pt x="3843" y="256"/>
                  </a:lnTo>
                  <a:lnTo>
                    <a:pt x="3852" y="258"/>
                  </a:lnTo>
                  <a:lnTo>
                    <a:pt x="3861" y="258"/>
                  </a:lnTo>
                  <a:lnTo>
                    <a:pt x="3867" y="258"/>
                  </a:lnTo>
                  <a:lnTo>
                    <a:pt x="3877" y="258"/>
                  </a:lnTo>
                  <a:lnTo>
                    <a:pt x="3885" y="259"/>
                  </a:lnTo>
                  <a:lnTo>
                    <a:pt x="3892" y="259"/>
                  </a:lnTo>
                  <a:lnTo>
                    <a:pt x="3900" y="259"/>
                  </a:lnTo>
                  <a:lnTo>
                    <a:pt x="3910" y="259"/>
                  </a:lnTo>
                  <a:lnTo>
                    <a:pt x="3918" y="261"/>
                  </a:lnTo>
                  <a:lnTo>
                    <a:pt x="3924" y="261"/>
                  </a:lnTo>
                  <a:lnTo>
                    <a:pt x="3932" y="261"/>
                  </a:lnTo>
                  <a:lnTo>
                    <a:pt x="3942" y="261"/>
                  </a:lnTo>
                  <a:lnTo>
                    <a:pt x="3949" y="262"/>
                  </a:lnTo>
                  <a:lnTo>
                    <a:pt x="3957" y="262"/>
                  </a:lnTo>
                  <a:lnTo>
                    <a:pt x="3967" y="262"/>
                  </a:lnTo>
                  <a:lnTo>
                    <a:pt x="3975" y="262"/>
                  </a:lnTo>
                  <a:lnTo>
                    <a:pt x="3981" y="264"/>
                  </a:lnTo>
                  <a:lnTo>
                    <a:pt x="3990" y="264"/>
                  </a:lnTo>
                  <a:lnTo>
                    <a:pt x="3999" y="264"/>
                  </a:lnTo>
                  <a:lnTo>
                    <a:pt x="4007" y="264"/>
                  </a:lnTo>
                  <a:lnTo>
                    <a:pt x="4014" y="266"/>
                  </a:lnTo>
                  <a:lnTo>
                    <a:pt x="4024" y="266"/>
                  </a:lnTo>
                  <a:lnTo>
                    <a:pt x="4032" y="266"/>
                  </a:lnTo>
                  <a:lnTo>
                    <a:pt x="4038" y="266"/>
                  </a:lnTo>
                  <a:lnTo>
                    <a:pt x="4047" y="266"/>
                  </a:lnTo>
                  <a:lnTo>
                    <a:pt x="4056" y="267"/>
                  </a:lnTo>
                  <a:lnTo>
                    <a:pt x="4065" y="267"/>
                  </a:lnTo>
                  <a:lnTo>
                    <a:pt x="4071" y="267"/>
                  </a:lnTo>
                  <a:lnTo>
                    <a:pt x="4079" y="267"/>
                  </a:lnTo>
                  <a:lnTo>
                    <a:pt x="4089" y="269"/>
                  </a:lnTo>
                  <a:lnTo>
                    <a:pt x="4096" y="269"/>
                  </a:lnTo>
                  <a:lnTo>
                    <a:pt x="4104" y="269"/>
                  </a:lnTo>
                  <a:lnTo>
                    <a:pt x="4114" y="269"/>
                  </a:lnTo>
                  <a:lnTo>
                    <a:pt x="4122" y="271"/>
                  </a:lnTo>
                  <a:lnTo>
                    <a:pt x="4128" y="271"/>
                  </a:lnTo>
                  <a:lnTo>
                    <a:pt x="4136" y="271"/>
                  </a:lnTo>
                  <a:lnTo>
                    <a:pt x="4146" y="271"/>
                  </a:lnTo>
                  <a:lnTo>
                    <a:pt x="4154" y="272"/>
                  </a:lnTo>
                  <a:lnTo>
                    <a:pt x="4161" y="272"/>
                  </a:lnTo>
                  <a:lnTo>
                    <a:pt x="4169" y="272"/>
                  </a:lnTo>
                  <a:lnTo>
                    <a:pt x="4179" y="272"/>
                  </a:lnTo>
                  <a:lnTo>
                    <a:pt x="4185" y="274"/>
                  </a:lnTo>
                  <a:lnTo>
                    <a:pt x="4193" y="274"/>
                  </a:lnTo>
                  <a:lnTo>
                    <a:pt x="4203" y="274"/>
                  </a:lnTo>
                  <a:lnTo>
                    <a:pt x="4211" y="274"/>
                  </a:lnTo>
                  <a:lnTo>
                    <a:pt x="4218" y="275"/>
                  </a:lnTo>
                  <a:lnTo>
                    <a:pt x="4226" y="275"/>
                  </a:lnTo>
                </a:path>
              </a:pathLst>
            </a:custGeom>
            <a:noFill/>
            <a:ln w="19050" cmpd="sng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7" name="Freeform 103"/>
            <p:cNvSpPr>
              <a:spLocks/>
            </p:cNvSpPr>
            <p:nvPr/>
          </p:nvSpPr>
          <p:spPr bwMode="auto">
            <a:xfrm>
              <a:off x="1400969" y="2224088"/>
              <a:ext cx="6705600" cy="984250"/>
            </a:xfrm>
            <a:custGeom>
              <a:avLst/>
              <a:gdLst>
                <a:gd name="T0" fmla="*/ 64 w 4224"/>
                <a:gd name="T1" fmla="*/ 620 h 620"/>
                <a:gd name="T2" fmla="*/ 137 w 4224"/>
                <a:gd name="T3" fmla="*/ 620 h 620"/>
                <a:gd name="T4" fmla="*/ 210 w 4224"/>
                <a:gd name="T5" fmla="*/ 620 h 620"/>
                <a:gd name="T6" fmla="*/ 285 w 4224"/>
                <a:gd name="T7" fmla="*/ 620 h 620"/>
                <a:gd name="T8" fmla="*/ 359 w 4224"/>
                <a:gd name="T9" fmla="*/ 519 h 620"/>
                <a:gd name="T10" fmla="*/ 432 w 4224"/>
                <a:gd name="T11" fmla="*/ 493 h 620"/>
                <a:gd name="T12" fmla="*/ 506 w 4224"/>
                <a:gd name="T13" fmla="*/ 467 h 620"/>
                <a:gd name="T14" fmla="*/ 578 w 4224"/>
                <a:gd name="T15" fmla="*/ 442 h 620"/>
                <a:gd name="T16" fmla="*/ 651 w 4224"/>
                <a:gd name="T17" fmla="*/ 418 h 620"/>
                <a:gd name="T18" fmla="*/ 724 w 4224"/>
                <a:gd name="T19" fmla="*/ 393 h 620"/>
                <a:gd name="T20" fmla="*/ 798 w 4224"/>
                <a:gd name="T21" fmla="*/ 369 h 620"/>
                <a:gd name="T22" fmla="*/ 871 w 4224"/>
                <a:gd name="T23" fmla="*/ 346 h 620"/>
                <a:gd name="T24" fmla="*/ 945 w 4224"/>
                <a:gd name="T25" fmla="*/ 323 h 620"/>
                <a:gd name="T26" fmla="*/ 1018 w 4224"/>
                <a:gd name="T27" fmla="*/ 300 h 620"/>
                <a:gd name="T28" fmla="*/ 1092 w 4224"/>
                <a:gd name="T29" fmla="*/ 279 h 620"/>
                <a:gd name="T30" fmla="*/ 1165 w 4224"/>
                <a:gd name="T31" fmla="*/ 258 h 620"/>
                <a:gd name="T32" fmla="*/ 1238 w 4224"/>
                <a:gd name="T33" fmla="*/ 237 h 620"/>
                <a:gd name="T34" fmla="*/ 1312 w 4224"/>
                <a:gd name="T35" fmla="*/ 217 h 620"/>
                <a:gd name="T36" fmla="*/ 1385 w 4224"/>
                <a:gd name="T37" fmla="*/ 198 h 620"/>
                <a:gd name="T38" fmla="*/ 1459 w 4224"/>
                <a:gd name="T39" fmla="*/ 178 h 620"/>
                <a:gd name="T40" fmla="*/ 1532 w 4224"/>
                <a:gd name="T41" fmla="*/ 159 h 620"/>
                <a:gd name="T42" fmla="*/ 1606 w 4224"/>
                <a:gd name="T43" fmla="*/ 141 h 620"/>
                <a:gd name="T44" fmla="*/ 1679 w 4224"/>
                <a:gd name="T45" fmla="*/ 123 h 620"/>
                <a:gd name="T46" fmla="*/ 1752 w 4224"/>
                <a:gd name="T47" fmla="*/ 105 h 620"/>
                <a:gd name="T48" fmla="*/ 1826 w 4224"/>
                <a:gd name="T49" fmla="*/ 87 h 620"/>
                <a:gd name="T50" fmla="*/ 1899 w 4224"/>
                <a:gd name="T51" fmla="*/ 69 h 620"/>
                <a:gd name="T52" fmla="*/ 1973 w 4224"/>
                <a:gd name="T53" fmla="*/ 52 h 620"/>
                <a:gd name="T54" fmla="*/ 2046 w 4224"/>
                <a:gd name="T55" fmla="*/ 36 h 620"/>
                <a:gd name="T56" fmla="*/ 2120 w 4224"/>
                <a:gd name="T57" fmla="*/ 20 h 620"/>
                <a:gd name="T58" fmla="*/ 2193 w 4224"/>
                <a:gd name="T59" fmla="*/ 5 h 620"/>
                <a:gd name="T60" fmla="*/ 2266 w 4224"/>
                <a:gd name="T61" fmla="*/ 93 h 620"/>
                <a:gd name="T62" fmla="*/ 2340 w 4224"/>
                <a:gd name="T63" fmla="*/ 95 h 620"/>
                <a:gd name="T64" fmla="*/ 2413 w 4224"/>
                <a:gd name="T65" fmla="*/ 98 h 620"/>
                <a:gd name="T66" fmla="*/ 2487 w 4224"/>
                <a:gd name="T67" fmla="*/ 100 h 620"/>
                <a:gd name="T68" fmla="*/ 2560 w 4224"/>
                <a:gd name="T69" fmla="*/ 103 h 620"/>
                <a:gd name="T70" fmla="*/ 2634 w 4224"/>
                <a:gd name="T71" fmla="*/ 105 h 620"/>
                <a:gd name="T72" fmla="*/ 2707 w 4224"/>
                <a:gd name="T73" fmla="*/ 106 h 620"/>
                <a:gd name="T74" fmla="*/ 2780 w 4224"/>
                <a:gd name="T75" fmla="*/ 110 h 620"/>
                <a:gd name="T76" fmla="*/ 2854 w 4224"/>
                <a:gd name="T77" fmla="*/ 111 h 620"/>
                <a:gd name="T78" fmla="*/ 2927 w 4224"/>
                <a:gd name="T79" fmla="*/ 114 h 620"/>
                <a:gd name="T80" fmla="*/ 3001 w 4224"/>
                <a:gd name="T81" fmla="*/ 116 h 620"/>
                <a:gd name="T82" fmla="*/ 3074 w 4224"/>
                <a:gd name="T83" fmla="*/ 119 h 620"/>
                <a:gd name="T84" fmla="*/ 3148 w 4224"/>
                <a:gd name="T85" fmla="*/ 121 h 620"/>
                <a:gd name="T86" fmla="*/ 3221 w 4224"/>
                <a:gd name="T87" fmla="*/ 123 h 620"/>
                <a:gd name="T88" fmla="*/ 3296 w 4224"/>
                <a:gd name="T89" fmla="*/ 126 h 620"/>
                <a:gd name="T90" fmla="*/ 3368 w 4224"/>
                <a:gd name="T91" fmla="*/ 128 h 620"/>
                <a:gd name="T92" fmla="*/ 3443 w 4224"/>
                <a:gd name="T93" fmla="*/ 131 h 620"/>
                <a:gd name="T94" fmla="*/ 3515 w 4224"/>
                <a:gd name="T95" fmla="*/ 132 h 620"/>
                <a:gd name="T96" fmla="*/ 3590 w 4224"/>
                <a:gd name="T97" fmla="*/ 134 h 620"/>
                <a:gd name="T98" fmla="*/ 3662 w 4224"/>
                <a:gd name="T99" fmla="*/ 137 h 620"/>
                <a:gd name="T100" fmla="*/ 3737 w 4224"/>
                <a:gd name="T101" fmla="*/ 139 h 620"/>
                <a:gd name="T102" fmla="*/ 3808 w 4224"/>
                <a:gd name="T103" fmla="*/ 141 h 620"/>
                <a:gd name="T104" fmla="*/ 3883 w 4224"/>
                <a:gd name="T105" fmla="*/ 144 h 620"/>
                <a:gd name="T106" fmla="*/ 3955 w 4224"/>
                <a:gd name="T107" fmla="*/ 145 h 620"/>
                <a:gd name="T108" fmla="*/ 4030 w 4224"/>
                <a:gd name="T109" fmla="*/ 147 h 620"/>
                <a:gd name="T110" fmla="*/ 4102 w 4224"/>
                <a:gd name="T111" fmla="*/ 150 h 620"/>
                <a:gd name="T112" fmla="*/ 4177 w 4224"/>
                <a:gd name="T113" fmla="*/ 152 h 6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224" h="620">
                  <a:moveTo>
                    <a:pt x="0" y="620"/>
                  </a:moveTo>
                  <a:lnTo>
                    <a:pt x="6" y="620"/>
                  </a:lnTo>
                  <a:lnTo>
                    <a:pt x="16" y="620"/>
                  </a:lnTo>
                  <a:lnTo>
                    <a:pt x="23" y="620"/>
                  </a:lnTo>
                  <a:lnTo>
                    <a:pt x="31" y="620"/>
                  </a:lnTo>
                  <a:lnTo>
                    <a:pt x="41" y="620"/>
                  </a:lnTo>
                  <a:lnTo>
                    <a:pt x="47" y="620"/>
                  </a:lnTo>
                  <a:lnTo>
                    <a:pt x="57" y="620"/>
                  </a:lnTo>
                  <a:lnTo>
                    <a:pt x="64" y="620"/>
                  </a:lnTo>
                  <a:lnTo>
                    <a:pt x="73" y="620"/>
                  </a:lnTo>
                  <a:lnTo>
                    <a:pt x="80" y="620"/>
                  </a:lnTo>
                  <a:lnTo>
                    <a:pt x="88" y="620"/>
                  </a:lnTo>
                  <a:lnTo>
                    <a:pt x="98" y="620"/>
                  </a:lnTo>
                  <a:lnTo>
                    <a:pt x="104" y="620"/>
                  </a:lnTo>
                  <a:lnTo>
                    <a:pt x="114" y="620"/>
                  </a:lnTo>
                  <a:lnTo>
                    <a:pt x="121" y="620"/>
                  </a:lnTo>
                  <a:lnTo>
                    <a:pt x="130" y="620"/>
                  </a:lnTo>
                  <a:lnTo>
                    <a:pt x="137" y="620"/>
                  </a:lnTo>
                  <a:lnTo>
                    <a:pt x="147" y="620"/>
                  </a:lnTo>
                  <a:lnTo>
                    <a:pt x="155" y="620"/>
                  </a:lnTo>
                  <a:lnTo>
                    <a:pt x="161" y="620"/>
                  </a:lnTo>
                  <a:lnTo>
                    <a:pt x="170" y="620"/>
                  </a:lnTo>
                  <a:lnTo>
                    <a:pt x="178" y="620"/>
                  </a:lnTo>
                  <a:lnTo>
                    <a:pt x="188" y="620"/>
                  </a:lnTo>
                  <a:lnTo>
                    <a:pt x="196" y="620"/>
                  </a:lnTo>
                  <a:lnTo>
                    <a:pt x="204" y="620"/>
                  </a:lnTo>
                  <a:lnTo>
                    <a:pt x="210" y="620"/>
                  </a:lnTo>
                  <a:lnTo>
                    <a:pt x="219" y="620"/>
                  </a:lnTo>
                  <a:lnTo>
                    <a:pt x="227" y="620"/>
                  </a:lnTo>
                  <a:lnTo>
                    <a:pt x="235" y="620"/>
                  </a:lnTo>
                  <a:lnTo>
                    <a:pt x="245" y="620"/>
                  </a:lnTo>
                  <a:lnTo>
                    <a:pt x="251" y="620"/>
                  </a:lnTo>
                  <a:lnTo>
                    <a:pt x="261" y="620"/>
                  </a:lnTo>
                  <a:lnTo>
                    <a:pt x="269" y="620"/>
                  </a:lnTo>
                  <a:lnTo>
                    <a:pt x="276" y="620"/>
                  </a:lnTo>
                  <a:lnTo>
                    <a:pt x="285" y="620"/>
                  </a:lnTo>
                  <a:lnTo>
                    <a:pt x="294" y="620"/>
                  </a:lnTo>
                  <a:lnTo>
                    <a:pt x="300" y="620"/>
                  </a:lnTo>
                  <a:lnTo>
                    <a:pt x="310" y="620"/>
                  </a:lnTo>
                  <a:lnTo>
                    <a:pt x="316" y="620"/>
                  </a:lnTo>
                  <a:lnTo>
                    <a:pt x="326" y="620"/>
                  </a:lnTo>
                  <a:lnTo>
                    <a:pt x="333" y="620"/>
                  </a:lnTo>
                  <a:lnTo>
                    <a:pt x="341" y="526"/>
                  </a:lnTo>
                  <a:lnTo>
                    <a:pt x="351" y="522"/>
                  </a:lnTo>
                  <a:lnTo>
                    <a:pt x="359" y="519"/>
                  </a:lnTo>
                  <a:lnTo>
                    <a:pt x="365" y="517"/>
                  </a:lnTo>
                  <a:lnTo>
                    <a:pt x="375" y="514"/>
                  </a:lnTo>
                  <a:lnTo>
                    <a:pt x="383" y="511"/>
                  </a:lnTo>
                  <a:lnTo>
                    <a:pt x="390" y="508"/>
                  </a:lnTo>
                  <a:lnTo>
                    <a:pt x="398" y="504"/>
                  </a:lnTo>
                  <a:lnTo>
                    <a:pt x="408" y="503"/>
                  </a:lnTo>
                  <a:lnTo>
                    <a:pt x="416" y="499"/>
                  </a:lnTo>
                  <a:lnTo>
                    <a:pt x="423" y="496"/>
                  </a:lnTo>
                  <a:lnTo>
                    <a:pt x="432" y="493"/>
                  </a:lnTo>
                  <a:lnTo>
                    <a:pt x="440" y="490"/>
                  </a:lnTo>
                  <a:lnTo>
                    <a:pt x="449" y="488"/>
                  </a:lnTo>
                  <a:lnTo>
                    <a:pt x="455" y="485"/>
                  </a:lnTo>
                  <a:lnTo>
                    <a:pt x="463" y="482"/>
                  </a:lnTo>
                  <a:lnTo>
                    <a:pt x="472" y="478"/>
                  </a:lnTo>
                  <a:lnTo>
                    <a:pt x="480" y="477"/>
                  </a:lnTo>
                  <a:lnTo>
                    <a:pt x="489" y="473"/>
                  </a:lnTo>
                  <a:lnTo>
                    <a:pt x="498" y="470"/>
                  </a:lnTo>
                  <a:lnTo>
                    <a:pt x="506" y="467"/>
                  </a:lnTo>
                  <a:lnTo>
                    <a:pt x="514" y="465"/>
                  </a:lnTo>
                  <a:lnTo>
                    <a:pt x="520" y="462"/>
                  </a:lnTo>
                  <a:lnTo>
                    <a:pt x="530" y="459"/>
                  </a:lnTo>
                  <a:lnTo>
                    <a:pt x="537" y="455"/>
                  </a:lnTo>
                  <a:lnTo>
                    <a:pt x="547" y="454"/>
                  </a:lnTo>
                  <a:lnTo>
                    <a:pt x="553" y="451"/>
                  </a:lnTo>
                  <a:lnTo>
                    <a:pt x="563" y="447"/>
                  </a:lnTo>
                  <a:lnTo>
                    <a:pt x="569" y="446"/>
                  </a:lnTo>
                  <a:lnTo>
                    <a:pt x="578" y="442"/>
                  </a:lnTo>
                  <a:lnTo>
                    <a:pt x="587" y="439"/>
                  </a:lnTo>
                  <a:lnTo>
                    <a:pt x="594" y="436"/>
                  </a:lnTo>
                  <a:lnTo>
                    <a:pt x="604" y="434"/>
                  </a:lnTo>
                  <a:lnTo>
                    <a:pt x="610" y="431"/>
                  </a:lnTo>
                  <a:lnTo>
                    <a:pt x="620" y="428"/>
                  </a:lnTo>
                  <a:lnTo>
                    <a:pt x="627" y="426"/>
                  </a:lnTo>
                  <a:lnTo>
                    <a:pt x="635" y="423"/>
                  </a:lnTo>
                  <a:lnTo>
                    <a:pt x="644" y="420"/>
                  </a:lnTo>
                  <a:lnTo>
                    <a:pt x="651" y="418"/>
                  </a:lnTo>
                  <a:lnTo>
                    <a:pt x="661" y="415"/>
                  </a:lnTo>
                  <a:lnTo>
                    <a:pt x="667" y="411"/>
                  </a:lnTo>
                  <a:lnTo>
                    <a:pt x="677" y="410"/>
                  </a:lnTo>
                  <a:lnTo>
                    <a:pt x="684" y="406"/>
                  </a:lnTo>
                  <a:lnTo>
                    <a:pt x="692" y="403"/>
                  </a:lnTo>
                  <a:lnTo>
                    <a:pt x="702" y="402"/>
                  </a:lnTo>
                  <a:lnTo>
                    <a:pt x="710" y="398"/>
                  </a:lnTo>
                  <a:lnTo>
                    <a:pt x="716" y="395"/>
                  </a:lnTo>
                  <a:lnTo>
                    <a:pt x="724" y="393"/>
                  </a:lnTo>
                  <a:lnTo>
                    <a:pt x="734" y="390"/>
                  </a:lnTo>
                  <a:lnTo>
                    <a:pt x="742" y="387"/>
                  </a:lnTo>
                  <a:lnTo>
                    <a:pt x="749" y="385"/>
                  </a:lnTo>
                  <a:lnTo>
                    <a:pt x="757" y="382"/>
                  </a:lnTo>
                  <a:lnTo>
                    <a:pt x="765" y="380"/>
                  </a:lnTo>
                  <a:lnTo>
                    <a:pt x="775" y="377"/>
                  </a:lnTo>
                  <a:lnTo>
                    <a:pt x="783" y="374"/>
                  </a:lnTo>
                  <a:lnTo>
                    <a:pt x="790" y="372"/>
                  </a:lnTo>
                  <a:lnTo>
                    <a:pt x="798" y="369"/>
                  </a:lnTo>
                  <a:lnTo>
                    <a:pt x="808" y="367"/>
                  </a:lnTo>
                  <a:lnTo>
                    <a:pt x="816" y="364"/>
                  </a:lnTo>
                  <a:lnTo>
                    <a:pt x="824" y="361"/>
                  </a:lnTo>
                  <a:lnTo>
                    <a:pt x="830" y="359"/>
                  </a:lnTo>
                  <a:lnTo>
                    <a:pt x="839" y="356"/>
                  </a:lnTo>
                  <a:lnTo>
                    <a:pt x="848" y="354"/>
                  </a:lnTo>
                  <a:lnTo>
                    <a:pt x="857" y="351"/>
                  </a:lnTo>
                  <a:lnTo>
                    <a:pt x="863" y="349"/>
                  </a:lnTo>
                  <a:lnTo>
                    <a:pt x="871" y="346"/>
                  </a:lnTo>
                  <a:lnTo>
                    <a:pt x="879" y="343"/>
                  </a:lnTo>
                  <a:lnTo>
                    <a:pt x="889" y="341"/>
                  </a:lnTo>
                  <a:lnTo>
                    <a:pt x="897" y="338"/>
                  </a:lnTo>
                  <a:lnTo>
                    <a:pt x="904" y="336"/>
                  </a:lnTo>
                  <a:lnTo>
                    <a:pt x="912" y="333"/>
                  </a:lnTo>
                  <a:lnTo>
                    <a:pt x="922" y="331"/>
                  </a:lnTo>
                  <a:lnTo>
                    <a:pt x="930" y="328"/>
                  </a:lnTo>
                  <a:lnTo>
                    <a:pt x="938" y="327"/>
                  </a:lnTo>
                  <a:lnTo>
                    <a:pt x="945" y="323"/>
                  </a:lnTo>
                  <a:lnTo>
                    <a:pt x="953" y="322"/>
                  </a:lnTo>
                  <a:lnTo>
                    <a:pt x="963" y="318"/>
                  </a:lnTo>
                  <a:lnTo>
                    <a:pt x="971" y="315"/>
                  </a:lnTo>
                  <a:lnTo>
                    <a:pt x="977" y="313"/>
                  </a:lnTo>
                  <a:lnTo>
                    <a:pt x="985" y="310"/>
                  </a:lnTo>
                  <a:lnTo>
                    <a:pt x="994" y="309"/>
                  </a:lnTo>
                  <a:lnTo>
                    <a:pt x="1003" y="305"/>
                  </a:lnTo>
                  <a:lnTo>
                    <a:pt x="1012" y="304"/>
                  </a:lnTo>
                  <a:lnTo>
                    <a:pt x="1018" y="300"/>
                  </a:lnTo>
                  <a:lnTo>
                    <a:pt x="1026" y="299"/>
                  </a:lnTo>
                  <a:lnTo>
                    <a:pt x="1036" y="296"/>
                  </a:lnTo>
                  <a:lnTo>
                    <a:pt x="1044" y="294"/>
                  </a:lnTo>
                  <a:lnTo>
                    <a:pt x="1052" y="291"/>
                  </a:lnTo>
                  <a:lnTo>
                    <a:pt x="1061" y="289"/>
                  </a:lnTo>
                  <a:lnTo>
                    <a:pt x="1069" y="287"/>
                  </a:lnTo>
                  <a:lnTo>
                    <a:pt x="1075" y="284"/>
                  </a:lnTo>
                  <a:lnTo>
                    <a:pt x="1083" y="282"/>
                  </a:lnTo>
                  <a:lnTo>
                    <a:pt x="1092" y="279"/>
                  </a:lnTo>
                  <a:lnTo>
                    <a:pt x="1100" y="278"/>
                  </a:lnTo>
                  <a:lnTo>
                    <a:pt x="1110" y="274"/>
                  </a:lnTo>
                  <a:lnTo>
                    <a:pt x="1118" y="273"/>
                  </a:lnTo>
                  <a:lnTo>
                    <a:pt x="1126" y="269"/>
                  </a:lnTo>
                  <a:lnTo>
                    <a:pt x="1134" y="268"/>
                  </a:lnTo>
                  <a:lnTo>
                    <a:pt x="1142" y="265"/>
                  </a:lnTo>
                  <a:lnTo>
                    <a:pt x="1149" y="263"/>
                  </a:lnTo>
                  <a:lnTo>
                    <a:pt x="1157" y="261"/>
                  </a:lnTo>
                  <a:lnTo>
                    <a:pt x="1165" y="258"/>
                  </a:lnTo>
                  <a:lnTo>
                    <a:pt x="1173" y="256"/>
                  </a:lnTo>
                  <a:lnTo>
                    <a:pt x="1181" y="253"/>
                  </a:lnTo>
                  <a:lnTo>
                    <a:pt x="1191" y="252"/>
                  </a:lnTo>
                  <a:lnTo>
                    <a:pt x="1199" y="248"/>
                  </a:lnTo>
                  <a:lnTo>
                    <a:pt x="1207" y="247"/>
                  </a:lnTo>
                  <a:lnTo>
                    <a:pt x="1216" y="245"/>
                  </a:lnTo>
                  <a:lnTo>
                    <a:pt x="1222" y="242"/>
                  </a:lnTo>
                  <a:lnTo>
                    <a:pt x="1230" y="240"/>
                  </a:lnTo>
                  <a:lnTo>
                    <a:pt x="1238" y="237"/>
                  </a:lnTo>
                  <a:lnTo>
                    <a:pt x="1247" y="235"/>
                  </a:lnTo>
                  <a:lnTo>
                    <a:pt x="1255" y="234"/>
                  </a:lnTo>
                  <a:lnTo>
                    <a:pt x="1265" y="230"/>
                  </a:lnTo>
                  <a:lnTo>
                    <a:pt x="1273" y="229"/>
                  </a:lnTo>
                  <a:lnTo>
                    <a:pt x="1281" y="225"/>
                  </a:lnTo>
                  <a:lnTo>
                    <a:pt x="1289" y="224"/>
                  </a:lnTo>
                  <a:lnTo>
                    <a:pt x="1297" y="222"/>
                  </a:lnTo>
                  <a:lnTo>
                    <a:pt x="1304" y="219"/>
                  </a:lnTo>
                  <a:lnTo>
                    <a:pt x="1312" y="217"/>
                  </a:lnTo>
                  <a:lnTo>
                    <a:pt x="1320" y="216"/>
                  </a:lnTo>
                  <a:lnTo>
                    <a:pt x="1328" y="212"/>
                  </a:lnTo>
                  <a:lnTo>
                    <a:pt x="1338" y="211"/>
                  </a:lnTo>
                  <a:lnTo>
                    <a:pt x="1346" y="207"/>
                  </a:lnTo>
                  <a:lnTo>
                    <a:pt x="1354" y="206"/>
                  </a:lnTo>
                  <a:lnTo>
                    <a:pt x="1362" y="204"/>
                  </a:lnTo>
                  <a:lnTo>
                    <a:pt x="1371" y="201"/>
                  </a:lnTo>
                  <a:lnTo>
                    <a:pt x="1377" y="199"/>
                  </a:lnTo>
                  <a:lnTo>
                    <a:pt x="1385" y="198"/>
                  </a:lnTo>
                  <a:lnTo>
                    <a:pt x="1393" y="194"/>
                  </a:lnTo>
                  <a:lnTo>
                    <a:pt x="1402" y="193"/>
                  </a:lnTo>
                  <a:lnTo>
                    <a:pt x="1411" y="191"/>
                  </a:lnTo>
                  <a:lnTo>
                    <a:pt x="1420" y="188"/>
                  </a:lnTo>
                  <a:lnTo>
                    <a:pt x="1428" y="186"/>
                  </a:lnTo>
                  <a:lnTo>
                    <a:pt x="1436" y="185"/>
                  </a:lnTo>
                  <a:lnTo>
                    <a:pt x="1444" y="181"/>
                  </a:lnTo>
                  <a:lnTo>
                    <a:pt x="1451" y="180"/>
                  </a:lnTo>
                  <a:lnTo>
                    <a:pt x="1459" y="178"/>
                  </a:lnTo>
                  <a:lnTo>
                    <a:pt x="1467" y="175"/>
                  </a:lnTo>
                  <a:lnTo>
                    <a:pt x="1475" y="173"/>
                  </a:lnTo>
                  <a:lnTo>
                    <a:pt x="1483" y="172"/>
                  </a:lnTo>
                  <a:lnTo>
                    <a:pt x="1493" y="170"/>
                  </a:lnTo>
                  <a:lnTo>
                    <a:pt x="1501" y="167"/>
                  </a:lnTo>
                  <a:lnTo>
                    <a:pt x="1509" y="165"/>
                  </a:lnTo>
                  <a:lnTo>
                    <a:pt x="1517" y="163"/>
                  </a:lnTo>
                  <a:lnTo>
                    <a:pt x="1524" y="160"/>
                  </a:lnTo>
                  <a:lnTo>
                    <a:pt x="1532" y="159"/>
                  </a:lnTo>
                  <a:lnTo>
                    <a:pt x="1540" y="157"/>
                  </a:lnTo>
                  <a:lnTo>
                    <a:pt x="1548" y="155"/>
                  </a:lnTo>
                  <a:lnTo>
                    <a:pt x="1557" y="152"/>
                  </a:lnTo>
                  <a:lnTo>
                    <a:pt x="1566" y="150"/>
                  </a:lnTo>
                  <a:lnTo>
                    <a:pt x="1575" y="149"/>
                  </a:lnTo>
                  <a:lnTo>
                    <a:pt x="1583" y="145"/>
                  </a:lnTo>
                  <a:lnTo>
                    <a:pt x="1591" y="144"/>
                  </a:lnTo>
                  <a:lnTo>
                    <a:pt x="1599" y="142"/>
                  </a:lnTo>
                  <a:lnTo>
                    <a:pt x="1606" y="141"/>
                  </a:lnTo>
                  <a:lnTo>
                    <a:pt x="1614" y="137"/>
                  </a:lnTo>
                  <a:lnTo>
                    <a:pt x="1622" y="136"/>
                  </a:lnTo>
                  <a:lnTo>
                    <a:pt x="1630" y="134"/>
                  </a:lnTo>
                  <a:lnTo>
                    <a:pt x="1640" y="132"/>
                  </a:lnTo>
                  <a:lnTo>
                    <a:pt x="1648" y="129"/>
                  </a:lnTo>
                  <a:lnTo>
                    <a:pt x="1656" y="128"/>
                  </a:lnTo>
                  <a:lnTo>
                    <a:pt x="1664" y="126"/>
                  </a:lnTo>
                  <a:lnTo>
                    <a:pt x="1672" y="124"/>
                  </a:lnTo>
                  <a:lnTo>
                    <a:pt x="1679" y="123"/>
                  </a:lnTo>
                  <a:lnTo>
                    <a:pt x="1687" y="119"/>
                  </a:lnTo>
                  <a:lnTo>
                    <a:pt x="1695" y="118"/>
                  </a:lnTo>
                  <a:lnTo>
                    <a:pt x="1703" y="116"/>
                  </a:lnTo>
                  <a:lnTo>
                    <a:pt x="1713" y="114"/>
                  </a:lnTo>
                  <a:lnTo>
                    <a:pt x="1721" y="111"/>
                  </a:lnTo>
                  <a:lnTo>
                    <a:pt x="1730" y="110"/>
                  </a:lnTo>
                  <a:lnTo>
                    <a:pt x="1738" y="108"/>
                  </a:lnTo>
                  <a:lnTo>
                    <a:pt x="1746" y="106"/>
                  </a:lnTo>
                  <a:lnTo>
                    <a:pt x="1752" y="105"/>
                  </a:lnTo>
                  <a:lnTo>
                    <a:pt x="1762" y="101"/>
                  </a:lnTo>
                  <a:lnTo>
                    <a:pt x="1769" y="100"/>
                  </a:lnTo>
                  <a:lnTo>
                    <a:pt x="1779" y="98"/>
                  </a:lnTo>
                  <a:lnTo>
                    <a:pt x="1785" y="97"/>
                  </a:lnTo>
                  <a:lnTo>
                    <a:pt x="1793" y="95"/>
                  </a:lnTo>
                  <a:lnTo>
                    <a:pt x="1803" y="92"/>
                  </a:lnTo>
                  <a:lnTo>
                    <a:pt x="1810" y="90"/>
                  </a:lnTo>
                  <a:lnTo>
                    <a:pt x="1819" y="88"/>
                  </a:lnTo>
                  <a:lnTo>
                    <a:pt x="1826" y="87"/>
                  </a:lnTo>
                  <a:lnTo>
                    <a:pt x="1836" y="85"/>
                  </a:lnTo>
                  <a:lnTo>
                    <a:pt x="1842" y="83"/>
                  </a:lnTo>
                  <a:lnTo>
                    <a:pt x="1852" y="80"/>
                  </a:lnTo>
                  <a:lnTo>
                    <a:pt x="1858" y="79"/>
                  </a:lnTo>
                  <a:lnTo>
                    <a:pt x="1867" y="77"/>
                  </a:lnTo>
                  <a:lnTo>
                    <a:pt x="1876" y="75"/>
                  </a:lnTo>
                  <a:lnTo>
                    <a:pt x="1883" y="74"/>
                  </a:lnTo>
                  <a:lnTo>
                    <a:pt x="1893" y="72"/>
                  </a:lnTo>
                  <a:lnTo>
                    <a:pt x="1899" y="69"/>
                  </a:lnTo>
                  <a:lnTo>
                    <a:pt x="1909" y="67"/>
                  </a:lnTo>
                  <a:lnTo>
                    <a:pt x="1916" y="66"/>
                  </a:lnTo>
                  <a:lnTo>
                    <a:pt x="1925" y="64"/>
                  </a:lnTo>
                  <a:lnTo>
                    <a:pt x="1932" y="62"/>
                  </a:lnTo>
                  <a:lnTo>
                    <a:pt x="1940" y="61"/>
                  </a:lnTo>
                  <a:lnTo>
                    <a:pt x="1950" y="59"/>
                  </a:lnTo>
                  <a:lnTo>
                    <a:pt x="1956" y="56"/>
                  </a:lnTo>
                  <a:lnTo>
                    <a:pt x="1966" y="54"/>
                  </a:lnTo>
                  <a:lnTo>
                    <a:pt x="1973" y="52"/>
                  </a:lnTo>
                  <a:lnTo>
                    <a:pt x="1982" y="51"/>
                  </a:lnTo>
                  <a:lnTo>
                    <a:pt x="1989" y="49"/>
                  </a:lnTo>
                  <a:lnTo>
                    <a:pt x="1999" y="48"/>
                  </a:lnTo>
                  <a:lnTo>
                    <a:pt x="2005" y="46"/>
                  </a:lnTo>
                  <a:lnTo>
                    <a:pt x="2013" y="44"/>
                  </a:lnTo>
                  <a:lnTo>
                    <a:pt x="2023" y="43"/>
                  </a:lnTo>
                  <a:lnTo>
                    <a:pt x="2030" y="39"/>
                  </a:lnTo>
                  <a:lnTo>
                    <a:pt x="2040" y="38"/>
                  </a:lnTo>
                  <a:lnTo>
                    <a:pt x="2046" y="36"/>
                  </a:lnTo>
                  <a:lnTo>
                    <a:pt x="2056" y="35"/>
                  </a:lnTo>
                  <a:lnTo>
                    <a:pt x="2062" y="33"/>
                  </a:lnTo>
                  <a:lnTo>
                    <a:pt x="2072" y="31"/>
                  </a:lnTo>
                  <a:lnTo>
                    <a:pt x="2079" y="30"/>
                  </a:lnTo>
                  <a:lnTo>
                    <a:pt x="2089" y="28"/>
                  </a:lnTo>
                  <a:lnTo>
                    <a:pt x="2097" y="26"/>
                  </a:lnTo>
                  <a:lnTo>
                    <a:pt x="2103" y="25"/>
                  </a:lnTo>
                  <a:lnTo>
                    <a:pt x="2113" y="21"/>
                  </a:lnTo>
                  <a:lnTo>
                    <a:pt x="2120" y="20"/>
                  </a:lnTo>
                  <a:lnTo>
                    <a:pt x="2129" y="18"/>
                  </a:lnTo>
                  <a:lnTo>
                    <a:pt x="2136" y="17"/>
                  </a:lnTo>
                  <a:lnTo>
                    <a:pt x="2146" y="15"/>
                  </a:lnTo>
                  <a:lnTo>
                    <a:pt x="2152" y="13"/>
                  </a:lnTo>
                  <a:lnTo>
                    <a:pt x="2162" y="12"/>
                  </a:lnTo>
                  <a:lnTo>
                    <a:pt x="2170" y="10"/>
                  </a:lnTo>
                  <a:lnTo>
                    <a:pt x="2177" y="8"/>
                  </a:lnTo>
                  <a:lnTo>
                    <a:pt x="2186" y="7"/>
                  </a:lnTo>
                  <a:lnTo>
                    <a:pt x="2193" y="5"/>
                  </a:lnTo>
                  <a:lnTo>
                    <a:pt x="2203" y="4"/>
                  </a:lnTo>
                  <a:lnTo>
                    <a:pt x="2209" y="2"/>
                  </a:lnTo>
                  <a:lnTo>
                    <a:pt x="2219" y="0"/>
                  </a:lnTo>
                  <a:lnTo>
                    <a:pt x="2226" y="92"/>
                  </a:lnTo>
                  <a:lnTo>
                    <a:pt x="2235" y="92"/>
                  </a:lnTo>
                  <a:lnTo>
                    <a:pt x="2244" y="92"/>
                  </a:lnTo>
                  <a:lnTo>
                    <a:pt x="2250" y="92"/>
                  </a:lnTo>
                  <a:lnTo>
                    <a:pt x="2260" y="93"/>
                  </a:lnTo>
                  <a:lnTo>
                    <a:pt x="2266" y="93"/>
                  </a:lnTo>
                  <a:lnTo>
                    <a:pt x="2276" y="93"/>
                  </a:lnTo>
                  <a:lnTo>
                    <a:pt x="2283" y="93"/>
                  </a:lnTo>
                  <a:lnTo>
                    <a:pt x="2293" y="93"/>
                  </a:lnTo>
                  <a:lnTo>
                    <a:pt x="2299" y="93"/>
                  </a:lnTo>
                  <a:lnTo>
                    <a:pt x="2309" y="95"/>
                  </a:lnTo>
                  <a:lnTo>
                    <a:pt x="2317" y="95"/>
                  </a:lnTo>
                  <a:lnTo>
                    <a:pt x="2324" y="95"/>
                  </a:lnTo>
                  <a:lnTo>
                    <a:pt x="2333" y="95"/>
                  </a:lnTo>
                  <a:lnTo>
                    <a:pt x="2340" y="95"/>
                  </a:lnTo>
                  <a:lnTo>
                    <a:pt x="2350" y="95"/>
                  </a:lnTo>
                  <a:lnTo>
                    <a:pt x="2356" y="97"/>
                  </a:lnTo>
                  <a:lnTo>
                    <a:pt x="2366" y="97"/>
                  </a:lnTo>
                  <a:lnTo>
                    <a:pt x="2372" y="97"/>
                  </a:lnTo>
                  <a:lnTo>
                    <a:pt x="2382" y="97"/>
                  </a:lnTo>
                  <a:lnTo>
                    <a:pt x="2389" y="97"/>
                  </a:lnTo>
                  <a:lnTo>
                    <a:pt x="2397" y="97"/>
                  </a:lnTo>
                  <a:lnTo>
                    <a:pt x="2407" y="97"/>
                  </a:lnTo>
                  <a:lnTo>
                    <a:pt x="2413" y="98"/>
                  </a:lnTo>
                  <a:lnTo>
                    <a:pt x="2423" y="98"/>
                  </a:lnTo>
                  <a:lnTo>
                    <a:pt x="2430" y="98"/>
                  </a:lnTo>
                  <a:lnTo>
                    <a:pt x="2439" y="98"/>
                  </a:lnTo>
                  <a:lnTo>
                    <a:pt x="2446" y="98"/>
                  </a:lnTo>
                  <a:lnTo>
                    <a:pt x="2456" y="98"/>
                  </a:lnTo>
                  <a:lnTo>
                    <a:pt x="2462" y="100"/>
                  </a:lnTo>
                  <a:lnTo>
                    <a:pt x="2470" y="100"/>
                  </a:lnTo>
                  <a:lnTo>
                    <a:pt x="2480" y="100"/>
                  </a:lnTo>
                  <a:lnTo>
                    <a:pt x="2487" y="100"/>
                  </a:lnTo>
                  <a:lnTo>
                    <a:pt x="2496" y="100"/>
                  </a:lnTo>
                  <a:lnTo>
                    <a:pt x="2503" y="100"/>
                  </a:lnTo>
                  <a:lnTo>
                    <a:pt x="2513" y="101"/>
                  </a:lnTo>
                  <a:lnTo>
                    <a:pt x="2519" y="101"/>
                  </a:lnTo>
                  <a:lnTo>
                    <a:pt x="2529" y="101"/>
                  </a:lnTo>
                  <a:lnTo>
                    <a:pt x="2536" y="101"/>
                  </a:lnTo>
                  <a:lnTo>
                    <a:pt x="2544" y="101"/>
                  </a:lnTo>
                  <a:lnTo>
                    <a:pt x="2554" y="101"/>
                  </a:lnTo>
                  <a:lnTo>
                    <a:pt x="2560" y="103"/>
                  </a:lnTo>
                  <a:lnTo>
                    <a:pt x="2570" y="103"/>
                  </a:lnTo>
                  <a:lnTo>
                    <a:pt x="2576" y="103"/>
                  </a:lnTo>
                  <a:lnTo>
                    <a:pt x="2586" y="103"/>
                  </a:lnTo>
                  <a:lnTo>
                    <a:pt x="2593" y="103"/>
                  </a:lnTo>
                  <a:lnTo>
                    <a:pt x="2603" y="103"/>
                  </a:lnTo>
                  <a:lnTo>
                    <a:pt x="2609" y="105"/>
                  </a:lnTo>
                  <a:lnTo>
                    <a:pt x="2617" y="105"/>
                  </a:lnTo>
                  <a:lnTo>
                    <a:pt x="2627" y="105"/>
                  </a:lnTo>
                  <a:lnTo>
                    <a:pt x="2634" y="105"/>
                  </a:lnTo>
                  <a:lnTo>
                    <a:pt x="2643" y="105"/>
                  </a:lnTo>
                  <a:lnTo>
                    <a:pt x="2650" y="105"/>
                  </a:lnTo>
                  <a:lnTo>
                    <a:pt x="2660" y="106"/>
                  </a:lnTo>
                  <a:lnTo>
                    <a:pt x="2666" y="106"/>
                  </a:lnTo>
                  <a:lnTo>
                    <a:pt x="2676" y="106"/>
                  </a:lnTo>
                  <a:lnTo>
                    <a:pt x="2682" y="106"/>
                  </a:lnTo>
                  <a:lnTo>
                    <a:pt x="2692" y="106"/>
                  </a:lnTo>
                  <a:lnTo>
                    <a:pt x="2700" y="106"/>
                  </a:lnTo>
                  <a:lnTo>
                    <a:pt x="2707" y="106"/>
                  </a:lnTo>
                  <a:lnTo>
                    <a:pt x="2717" y="108"/>
                  </a:lnTo>
                  <a:lnTo>
                    <a:pt x="2723" y="108"/>
                  </a:lnTo>
                  <a:lnTo>
                    <a:pt x="2733" y="108"/>
                  </a:lnTo>
                  <a:lnTo>
                    <a:pt x="2740" y="108"/>
                  </a:lnTo>
                  <a:lnTo>
                    <a:pt x="2749" y="108"/>
                  </a:lnTo>
                  <a:lnTo>
                    <a:pt x="2756" y="108"/>
                  </a:lnTo>
                  <a:lnTo>
                    <a:pt x="2766" y="110"/>
                  </a:lnTo>
                  <a:lnTo>
                    <a:pt x="2774" y="110"/>
                  </a:lnTo>
                  <a:lnTo>
                    <a:pt x="2780" y="110"/>
                  </a:lnTo>
                  <a:lnTo>
                    <a:pt x="2790" y="110"/>
                  </a:lnTo>
                  <a:lnTo>
                    <a:pt x="2797" y="110"/>
                  </a:lnTo>
                  <a:lnTo>
                    <a:pt x="2807" y="110"/>
                  </a:lnTo>
                  <a:lnTo>
                    <a:pt x="2813" y="111"/>
                  </a:lnTo>
                  <a:lnTo>
                    <a:pt x="2823" y="111"/>
                  </a:lnTo>
                  <a:lnTo>
                    <a:pt x="2829" y="111"/>
                  </a:lnTo>
                  <a:lnTo>
                    <a:pt x="2839" y="111"/>
                  </a:lnTo>
                  <a:lnTo>
                    <a:pt x="2847" y="111"/>
                  </a:lnTo>
                  <a:lnTo>
                    <a:pt x="2854" y="111"/>
                  </a:lnTo>
                  <a:lnTo>
                    <a:pt x="2864" y="113"/>
                  </a:lnTo>
                  <a:lnTo>
                    <a:pt x="2870" y="113"/>
                  </a:lnTo>
                  <a:lnTo>
                    <a:pt x="2880" y="113"/>
                  </a:lnTo>
                  <a:lnTo>
                    <a:pt x="2886" y="113"/>
                  </a:lnTo>
                  <a:lnTo>
                    <a:pt x="2896" y="113"/>
                  </a:lnTo>
                  <a:lnTo>
                    <a:pt x="2903" y="113"/>
                  </a:lnTo>
                  <a:lnTo>
                    <a:pt x="2913" y="113"/>
                  </a:lnTo>
                  <a:lnTo>
                    <a:pt x="2921" y="114"/>
                  </a:lnTo>
                  <a:lnTo>
                    <a:pt x="2927" y="114"/>
                  </a:lnTo>
                  <a:lnTo>
                    <a:pt x="2937" y="114"/>
                  </a:lnTo>
                  <a:lnTo>
                    <a:pt x="2944" y="114"/>
                  </a:lnTo>
                  <a:lnTo>
                    <a:pt x="2953" y="114"/>
                  </a:lnTo>
                  <a:lnTo>
                    <a:pt x="2960" y="114"/>
                  </a:lnTo>
                  <a:lnTo>
                    <a:pt x="2970" y="116"/>
                  </a:lnTo>
                  <a:lnTo>
                    <a:pt x="2976" y="116"/>
                  </a:lnTo>
                  <a:lnTo>
                    <a:pt x="2986" y="116"/>
                  </a:lnTo>
                  <a:lnTo>
                    <a:pt x="2993" y="116"/>
                  </a:lnTo>
                  <a:lnTo>
                    <a:pt x="3001" y="116"/>
                  </a:lnTo>
                  <a:lnTo>
                    <a:pt x="3010" y="116"/>
                  </a:lnTo>
                  <a:lnTo>
                    <a:pt x="3017" y="118"/>
                  </a:lnTo>
                  <a:lnTo>
                    <a:pt x="3027" y="118"/>
                  </a:lnTo>
                  <a:lnTo>
                    <a:pt x="3033" y="118"/>
                  </a:lnTo>
                  <a:lnTo>
                    <a:pt x="3043" y="118"/>
                  </a:lnTo>
                  <a:lnTo>
                    <a:pt x="3050" y="118"/>
                  </a:lnTo>
                  <a:lnTo>
                    <a:pt x="3059" y="118"/>
                  </a:lnTo>
                  <a:lnTo>
                    <a:pt x="3066" y="118"/>
                  </a:lnTo>
                  <a:lnTo>
                    <a:pt x="3074" y="119"/>
                  </a:lnTo>
                  <a:lnTo>
                    <a:pt x="3084" y="119"/>
                  </a:lnTo>
                  <a:lnTo>
                    <a:pt x="3090" y="119"/>
                  </a:lnTo>
                  <a:lnTo>
                    <a:pt x="3100" y="119"/>
                  </a:lnTo>
                  <a:lnTo>
                    <a:pt x="3107" y="119"/>
                  </a:lnTo>
                  <a:lnTo>
                    <a:pt x="3117" y="119"/>
                  </a:lnTo>
                  <a:lnTo>
                    <a:pt x="3123" y="121"/>
                  </a:lnTo>
                  <a:lnTo>
                    <a:pt x="3133" y="121"/>
                  </a:lnTo>
                  <a:lnTo>
                    <a:pt x="3139" y="121"/>
                  </a:lnTo>
                  <a:lnTo>
                    <a:pt x="3148" y="121"/>
                  </a:lnTo>
                  <a:lnTo>
                    <a:pt x="3156" y="121"/>
                  </a:lnTo>
                  <a:lnTo>
                    <a:pt x="3164" y="121"/>
                  </a:lnTo>
                  <a:lnTo>
                    <a:pt x="3174" y="121"/>
                  </a:lnTo>
                  <a:lnTo>
                    <a:pt x="3182" y="123"/>
                  </a:lnTo>
                  <a:lnTo>
                    <a:pt x="3188" y="123"/>
                  </a:lnTo>
                  <a:lnTo>
                    <a:pt x="3196" y="123"/>
                  </a:lnTo>
                  <a:lnTo>
                    <a:pt x="3206" y="123"/>
                  </a:lnTo>
                  <a:lnTo>
                    <a:pt x="3214" y="123"/>
                  </a:lnTo>
                  <a:lnTo>
                    <a:pt x="3221" y="123"/>
                  </a:lnTo>
                  <a:lnTo>
                    <a:pt x="3231" y="124"/>
                  </a:lnTo>
                  <a:lnTo>
                    <a:pt x="3239" y="124"/>
                  </a:lnTo>
                  <a:lnTo>
                    <a:pt x="3245" y="124"/>
                  </a:lnTo>
                  <a:lnTo>
                    <a:pt x="3254" y="124"/>
                  </a:lnTo>
                  <a:lnTo>
                    <a:pt x="3263" y="124"/>
                  </a:lnTo>
                  <a:lnTo>
                    <a:pt x="3272" y="124"/>
                  </a:lnTo>
                  <a:lnTo>
                    <a:pt x="3278" y="124"/>
                  </a:lnTo>
                  <a:lnTo>
                    <a:pt x="3286" y="126"/>
                  </a:lnTo>
                  <a:lnTo>
                    <a:pt x="3296" y="126"/>
                  </a:lnTo>
                  <a:lnTo>
                    <a:pt x="3303" y="126"/>
                  </a:lnTo>
                  <a:lnTo>
                    <a:pt x="3311" y="126"/>
                  </a:lnTo>
                  <a:lnTo>
                    <a:pt x="3320" y="126"/>
                  </a:lnTo>
                  <a:lnTo>
                    <a:pt x="3329" y="126"/>
                  </a:lnTo>
                  <a:lnTo>
                    <a:pt x="3335" y="128"/>
                  </a:lnTo>
                  <a:lnTo>
                    <a:pt x="3343" y="128"/>
                  </a:lnTo>
                  <a:lnTo>
                    <a:pt x="3353" y="128"/>
                  </a:lnTo>
                  <a:lnTo>
                    <a:pt x="3361" y="128"/>
                  </a:lnTo>
                  <a:lnTo>
                    <a:pt x="3368" y="128"/>
                  </a:lnTo>
                  <a:lnTo>
                    <a:pt x="3378" y="128"/>
                  </a:lnTo>
                  <a:lnTo>
                    <a:pt x="3386" y="128"/>
                  </a:lnTo>
                  <a:lnTo>
                    <a:pt x="3392" y="129"/>
                  </a:lnTo>
                  <a:lnTo>
                    <a:pt x="3400" y="129"/>
                  </a:lnTo>
                  <a:lnTo>
                    <a:pt x="3410" y="129"/>
                  </a:lnTo>
                  <a:lnTo>
                    <a:pt x="3418" y="129"/>
                  </a:lnTo>
                  <a:lnTo>
                    <a:pt x="3425" y="129"/>
                  </a:lnTo>
                  <a:lnTo>
                    <a:pt x="3433" y="129"/>
                  </a:lnTo>
                  <a:lnTo>
                    <a:pt x="3443" y="131"/>
                  </a:lnTo>
                  <a:lnTo>
                    <a:pt x="3449" y="131"/>
                  </a:lnTo>
                  <a:lnTo>
                    <a:pt x="3458" y="131"/>
                  </a:lnTo>
                  <a:lnTo>
                    <a:pt x="3467" y="131"/>
                  </a:lnTo>
                  <a:lnTo>
                    <a:pt x="3476" y="131"/>
                  </a:lnTo>
                  <a:lnTo>
                    <a:pt x="3482" y="131"/>
                  </a:lnTo>
                  <a:lnTo>
                    <a:pt x="3490" y="131"/>
                  </a:lnTo>
                  <a:lnTo>
                    <a:pt x="3500" y="132"/>
                  </a:lnTo>
                  <a:lnTo>
                    <a:pt x="3508" y="132"/>
                  </a:lnTo>
                  <a:lnTo>
                    <a:pt x="3515" y="132"/>
                  </a:lnTo>
                  <a:lnTo>
                    <a:pt x="3524" y="132"/>
                  </a:lnTo>
                  <a:lnTo>
                    <a:pt x="3533" y="132"/>
                  </a:lnTo>
                  <a:lnTo>
                    <a:pt x="3539" y="132"/>
                  </a:lnTo>
                  <a:lnTo>
                    <a:pt x="3547" y="134"/>
                  </a:lnTo>
                  <a:lnTo>
                    <a:pt x="3557" y="134"/>
                  </a:lnTo>
                  <a:lnTo>
                    <a:pt x="3565" y="134"/>
                  </a:lnTo>
                  <a:lnTo>
                    <a:pt x="3572" y="134"/>
                  </a:lnTo>
                  <a:lnTo>
                    <a:pt x="3580" y="134"/>
                  </a:lnTo>
                  <a:lnTo>
                    <a:pt x="3590" y="134"/>
                  </a:lnTo>
                  <a:lnTo>
                    <a:pt x="3598" y="134"/>
                  </a:lnTo>
                  <a:lnTo>
                    <a:pt x="3604" y="136"/>
                  </a:lnTo>
                  <a:lnTo>
                    <a:pt x="3614" y="136"/>
                  </a:lnTo>
                  <a:lnTo>
                    <a:pt x="3622" y="136"/>
                  </a:lnTo>
                  <a:lnTo>
                    <a:pt x="3629" y="136"/>
                  </a:lnTo>
                  <a:lnTo>
                    <a:pt x="3637" y="136"/>
                  </a:lnTo>
                  <a:lnTo>
                    <a:pt x="3647" y="136"/>
                  </a:lnTo>
                  <a:lnTo>
                    <a:pt x="3655" y="137"/>
                  </a:lnTo>
                  <a:lnTo>
                    <a:pt x="3662" y="137"/>
                  </a:lnTo>
                  <a:lnTo>
                    <a:pt x="3670" y="137"/>
                  </a:lnTo>
                  <a:lnTo>
                    <a:pt x="3679" y="137"/>
                  </a:lnTo>
                  <a:lnTo>
                    <a:pt x="3686" y="137"/>
                  </a:lnTo>
                  <a:lnTo>
                    <a:pt x="3694" y="137"/>
                  </a:lnTo>
                  <a:lnTo>
                    <a:pt x="3704" y="137"/>
                  </a:lnTo>
                  <a:lnTo>
                    <a:pt x="3712" y="139"/>
                  </a:lnTo>
                  <a:lnTo>
                    <a:pt x="3719" y="139"/>
                  </a:lnTo>
                  <a:lnTo>
                    <a:pt x="3727" y="139"/>
                  </a:lnTo>
                  <a:lnTo>
                    <a:pt x="3737" y="139"/>
                  </a:lnTo>
                  <a:lnTo>
                    <a:pt x="3745" y="139"/>
                  </a:lnTo>
                  <a:lnTo>
                    <a:pt x="3751" y="139"/>
                  </a:lnTo>
                  <a:lnTo>
                    <a:pt x="3761" y="139"/>
                  </a:lnTo>
                  <a:lnTo>
                    <a:pt x="3769" y="141"/>
                  </a:lnTo>
                  <a:lnTo>
                    <a:pt x="3776" y="141"/>
                  </a:lnTo>
                  <a:lnTo>
                    <a:pt x="3784" y="141"/>
                  </a:lnTo>
                  <a:lnTo>
                    <a:pt x="3794" y="141"/>
                  </a:lnTo>
                  <a:lnTo>
                    <a:pt x="3802" y="141"/>
                  </a:lnTo>
                  <a:lnTo>
                    <a:pt x="3808" y="141"/>
                  </a:lnTo>
                  <a:lnTo>
                    <a:pt x="3817" y="142"/>
                  </a:lnTo>
                  <a:lnTo>
                    <a:pt x="3826" y="142"/>
                  </a:lnTo>
                  <a:lnTo>
                    <a:pt x="3833" y="142"/>
                  </a:lnTo>
                  <a:lnTo>
                    <a:pt x="3841" y="142"/>
                  </a:lnTo>
                  <a:lnTo>
                    <a:pt x="3851" y="142"/>
                  </a:lnTo>
                  <a:lnTo>
                    <a:pt x="3859" y="142"/>
                  </a:lnTo>
                  <a:lnTo>
                    <a:pt x="3865" y="142"/>
                  </a:lnTo>
                  <a:lnTo>
                    <a:pt x="3874" y="144"/>
                  </a:lnTo>
                  <a:lnTo>
                    <a:pt x="3883" y="144"/>
                  </a:lnTo>
                  <a:lnTo>
                    <a:pt x="3892" y="144"/>
                  </a:lnTo>
                  <a:lnTo>
                    <a:pt x="3898" y="144"/>
                  </a:lnTo>
                  <a:lnTo>
                    <a:pt x="3908" y="144"/>
                  </a:lnTo>
                  <a:lnTo>
                    <a:pt x="3916" y="144"/>
                  </a:lnTo>
                  <a:lnTo>
                    <a:pt x="3923" y="144"/>
                  </a:lnTo>
                  <a:lnTo>
                    <a:pt x="3931" y="145"/>
                  </a:lnTo>
                  <a:lnTo>
                    <a:pt x="3941" y="145"/>
                  </a:lnTo>
                  <a:lnTo>
                    <a:pt x="3949" y="145"/>
                  </a:lnTo>
                  <a:lnTo>
                    <a:pt x="3955" y="145"/>
                  </a:lnTo>
                  <a:lnTo>
                    <a:pt x="3963" y="145"/>
                  </a:lnTo>
                  <a:lnTo>
                    <a:pt x="3973" y="145"/>
                  </a:lnTo>
                  <a:lnTo>
                    <a:pt x="3980" y="145"/>
                  </a:lnTo>
                  <a:lnTo>
                    <a:pt x="3988" y="147"/>
                  </a:lnTo>
                  <a:lnTo>
                    <a:pt x="3998" y="147"/>
                  </a:lnTo>
                  <a:lnTo>
                    <a:pt x="4006" y="147"/>
                  </a:lnTo>
                  <a:lnTo>
                    <a:pt x="4012" y="147"/>
                  </a:lnTo>
                  <a:lnTo>
                    <a:pt x="4021" y="147"/>
                  </a:lnTo>
                  <a:lnTo>
                    <a:pt x="4030" y="147"/>
                  </a:lnTo>
                  <a:lnTo>
                    <a:pt x="4038" y="149"/>
                  </a:lnTo>
                  <a:lnTo>
                    <a:pt x="4045" y="149"/>
                  </a:lnTo>
                  <a:lnTo>
                    <a:pt x="4055" y="149"/>
                  </a:lnTo>
                  <a:lnTo>
                    <a:pt x="4063" y="149"/>
                  </a:lnTo>
                  <a:lnTo>
                    <a:pt x="4069" y="149"/>
                  </a:lnTo>
                  <a:lnTo>
                    <a:pt x="4078" y="149"/>
                  </a:lnTo>
                  <a:lnTo>
                    <a:pt x="4087" y="149"/>
                  </a:lnTo>
                  <a:lnTo>
                    <a:pt x="4096" y="150"/>
                  </a:lnTo>
                  <a:lnTo>
                    <a:pt x="4102" y="150"/>
                  </a:lnTo>
                  <a:lnTo>
                    <a:pt x="4110" y="150"/>
                  </a:lnTo>
                  <a:lnTo>
                    <a:pt x="4120" y="150"/>
                  </a:lnTo>
                  <a:lnTo>
                    <a:pt x="4127" y="150"/>
                  </a:lnTo>
                  <a:lnTo>
                    <a:pt x="4135" y="150"/>
                  </a:lnTo>
                  <a:lnTo>
                    <a:pt x="4145" y="150"/>
                  </a:lnTo>
                  <a:lnTo>
                    <a:pt x="4153" y="152"/>
                  </a:lnTo>
                  <a:lnTo>
                    <a:pt x="4159" y="152"/>
                  </a:lnTo>
                  <a:lnTo>
                    <a:pt x="4167" y="152"/>
                  </a:lnTo>
                  <a:lnTo>
                    <a:pt x="4177" y="152"/>
                  </a:lnTo>
                  <a:lnTo>
                    <a:pt x="4185" y="152"/>
                  </a:lnTo>
                  <a:lnTo>
                    <a:pt x="4192" y="152"/>
                  </a:lnTo>
                  <a:lnTo>
                    <a:pt x="4200" y="152"/>
                  </a:lnTo>
                  <a:lnTo>
                    <a:pt x="4210" y="154"/>
                  </a:lnTo>
                  <a:lnTo>
                    <a:pt x="4216" y="154"/>
                  </a:lnTo>
                  <a:lnTo>
                    <a:pt x="4224" y="154"/>
                  </a:lnTo>
                </a:path>
              </a:pathLst>
            </a:custGeom>
            <a:noFill/>
            <a:ln w="19050" cmpd="sng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8" name="Freeform 104"/>
            <p:cNvSpPr>
              <a:spLocks/>
            </p:cNvSpPr>
            <p:nvPr/>
          </p:nvSpPr>
          <p:spPr bwMode="auto">
            <a:xfrm>
              <a:off x="1437482" y="2679701"/>
              <a:ext cx="6697663" cy="528638"/>
            </a:xfrm>
            <a:custGeom>
              <a:avLst/>
              <a:gdLst>
                <a:gd name="T0" fmla="*/ 65 w 4219"/>
                <a:gd name="T1" fmla="*/ 333 h 333"/>
                <a:gd name="T2" fmla="*/ 138 w 4219"/>
                <a:gd name="T3" fmla="*/ 333 h 333"/>
                <a:gd name="T4" fmla="*/ 212 w 4219"/>
                <a:gd name="T5" fmla="*/ 333 h 333"/>
                <a:gd name="T6" fmla="*/ 287 w 4219"/>
                <a:gd name="T7" fmla="*/ 333 h 333"/>
                <a:gd name="T8" fmla="*/ 360 w 4219"/>
                <a:gd name="T9" fmla="*/ 284 h 333"/>
                <a:gd name="T10" fmla="*/ 432 w 4219"/>
                <a:gd name="T11" fmla="*/ 271 h 333"/>
                <a:gd name="T12" fmla="*/ 507 w 4219"/>
                <a:gd name="T13" fmla="*/ 258 h 333"/>
                <a:gd name="T14" fmla="*/ 581 w 4219"/>
                <a:gd name="T15" fmla="*/ 245 h 333"/>
                <a:gd name="T16" fmla="*/ 654 w 4219"/>
                <a:gd name="T17" fmla="*/ 232 h 333"/>
                <a:gd name="T18" fmla="*/ 726 w 4219"/>
                <a:gd name="T19" fmla="*/ 219 h 333"/>
                <a:gd name="T20" fmla="*/ 801 w 4219"/>
                <a:gd name="T21" fmla="*/ 208 h 333"/>
                <a:gd name="T22" fmla="*/ 874 w 4219"/>
                <a:gd name="T23" fmla="*/ 195 h 333"/>
                <a:gd name="T24" fmla="*/ 948 w 4219"/>
                <a:gd name="T25" fmla="*/ 183 h 333"/>
                <a:gd name="T26" fmla="*/ 1021 w 4219"/>
                <a:gd name="T27" fmla="*/ 172 h 333"/>
                <a:gd name="T28" fmla="*/ 1095 w 4219"/>
                <a:gd name="T29" fmla="*/ 159 h 333"/>
                <a:gd name="T30" fmla="*/ 1168 w 4219"/>
                <a:gd name="T31" fmla="*/ 147 h 333"/>
                <a:gd name="T32" fmla="*/ 1242 w 4219"/>
                <a:gd name="T33" fmla="*/ 136 h 333"/>
                <a:gd name="T34" fmla="*/ 1315 w 4219"/>
                <a:gd name="T35" fmla="*/ 124 h 333"/>
                <a:gd name="T36" fmla="*/ 1388 w 4219"/>
                <a:gd name="T37" fmla="*/ 113 h 333"/>
                <a:gd name="T38" fmla="*/ 1460 w 4219"/>
                <a:gd name="T39" fmla="*/ 103 h 333"/>
                <a:gd name="T40" fmla="*/ 1534 w 4219"/>
                <a:gd name="T41" fmla="*/ 92 h 333"/>
                <a:gd name="T42" fmla="*/ 1607 w 4219"/>
                <a:gd name="T43" fmla="*/ 80 h 333"/>
                <a:gd name="T44" fmla="*/ 1680 w 4219"/>
                <a:gd name="T45" fmla="*/ 71 h 333"/>
                <a:gd name="T46" fmla="*/ 1756 w 4219"/>
                <a:gd name="T47" fmla="*/ 59 h 333"/>
                <a:gd name="T48" fmla="*/ 1829 w 4219"/>
                <a:gd name="T49" fmla="*/ 49 h 333"/>
                <a:gd name="T50" fmla="*/ 1902 w 4219"/>
                <a:gd name="T51" fmla="*/ 40 h 333"/>
                <a:gd name="T52" fmla="*/ 1976 w 4219"/>
                <a:gd name="T53" fmla="*/ 30 h 333"/>
                <a:gd name="T54" fmla="*/ 2049 w 4219"/>
                <a:gd name="T55" fmla="*/ 20 h 333"/>
                <a:gd name="T56" fmla="*/ 2123 w 4219"/>
                <a:gd name="T57" fmla="*/ 10 h 333"/>
                <a:gd name="T58" fmla="*/ 2196 w 4219"/>
                <a:gd name="T59" fmla="*/ 0 h 333"/>
                <a:gd name="T60" fmla="*/ 2270 w 4219"/>
                <a:gd name="T61" fmla="*/ 41 h 333"/>
                <a:gd name="T62" fmla="*/ 2343 w 4219"/>
                <a:gd name="T63" fmla="*/ 43 h 333"/>
                <a:gd name="T64" fmla="*/ 2416 w 4219"/>
                <a:gd name="T65" fmla="*/ 44 h 333"/>
                <a:gd name="T66" fmla="*/ 2490 w 4219"/>
                <a:gd name="T67" fmla="*/ 46 h 333"/>
                <a:gd name="T68" fmla="*/ 2563 w 4219"/>
                <a:gd name="T69" fmla="*/ 46 h 333"/>
                <a:gd name="T70" fmla="*/ 2637 w 4219"/>
                <a:gd name="T71" fmla="*/ 48 h 333"/>
                <a:gd name="T72" fmla="*/ 2710 w 4219"/>
                <a:gd name="T73" fmla="*/ 49 h 333"/>
                <a:gd name="T74" fmla="*/ 2784 w 4219"/>
                <a:gd name="T75" fmla="*/ 51 h 333"/>
                <a:gd name="T76" fmla="*/ 2857 w 4219"/>
                <a:gd name="T77" fmla="*/ 53 h 333"/>
                <a:gd name="T78" fmla="*/ 2930 w 4219"/>
                <a:gd name="T79" fmla="*/ 53 h 333"/>
                <a:gd name="T80" fmla="*/ 3004 w 4219"/>
                <a:gd name="T81" fmla="*/ 54 h 333"/>
                <a:gd name="T82" fmla="*/ 3077 w 4219"/>
                <a:gd name="T83" fmla="*/ 56 h 333"/>
                <a:gd name="T84" fmla="*/ 3151 w 4219"/>
                <a:gd name="T85" fmla="*/ 57 h 333"/>
                <a:gd name="T86" fmla="*/ 3222 w 4219"/>
                <a:gd name="T87" fmla="*/ 57 h 333"/>
                <a:gd name="T88" fmla="*/ 3297 w 4219"/>
                <a:gd name="T89" fmla="*/ 59 h 333"/>
                <a:gd name="T90" fmla="*/ 3369 w 4219"/>
                <a:gd name="T91" fmla="*/ 61 h 333"/>
                <a:gd name="T92" fmla="*/ 3444 w 4219"/>
                <a:gd name="T93" fmla="*/ 62 h 333"/>
                <a:gd name="T94" fmla="*/ 3516 w 4219"/>
                <a:gd name="T95" fmla="*/ 64 h 333"/>
                <a:gd name="T96" fmla="*/ 3591 w 4219"/>
                <a:gd name="T97" fmla="*/ 64 h 333"/>
                <a:gd name="T98" fmla="*/ 3663 w 4219"/>
                <a:gd name="T99" fmla="*/ 66 h 333"/>
                <a:gd name="T100" fmla="*/ 3738 w 4219"/>
                <a:gd name="T101" fmla="*/ 67 h 333"/>
                <a:gd name="T102" fmla="*/ 3810 w 4219"/>
                <a:gd name="T103" fmla="*/ 69 h 333"/>
                <a:gd name="T104" fmla="*/ 3885 w 4219"/>
                <a:gd name="T105" fmla="*/ 69 h 333"/>
                <a:gd name="T106" fmla="*/ 3957 w 4219"/>
                <a:gd name="T107" fmla="*/ 71 h 333"/>
                <a:gd name="T108" fmla="*/ 4032 w 4219"/>
                <a:gd name="T109" fmla="*/ 72 h 333"/>
                <a:gd name="T110" fmla="*/ 4104 w 4219"/>
                <a:gd name="T111" fmla="*/ 72 h 333"/>
                <a:gd name="T112" fmla="*/ 4177 w 4219"/>
                <a:gd name="T113" fmla="*/ 74 h 3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219" h="333">
                  <a:moveTo>
                    <a:pt x="0" y="333"/>
                  </a:moveTo>
                  <a:lnTo>
                    <a:pt x="8" y="333"/>
                  </a:lnTo>
                  <a:lnTo>
                    <a:pt x="18" y="333"/>
                  </a:lnTo>
                  <a:lnTo>
                    <a:pt x="24" y="333"/>
                  </a:lnTo>
                  <a:lnTo>
                    <a:pt x="34" y="333"/>
                  </a:lnTo>
                  <a:lnTo>
                    <a:pt x="41" y="333"/>
                  </a:lnTo>
                  <a:lnTo>
                    <a:pt x="50" y="333"/>
                  </a:lnTo>
                  <a:lnTo>
                    <a:pt x="57" y="333"/>
                  </a:lnTo>
                  <a:lnTo>
                    <a:pt x="65" y="333"/>
                  </a:lnTo>
                  <a:lnTo>
                    <a:pt x="75" y="333"/>
                  </a:lnTo>
                  <a:lnTo>
                    <a:pt x="81" y="333"/>
                  </a:lnTo>
                  <a:lnTo>
                    <a:pt x="91" y="333"/>
                  </a:lnTo>
                  <a:lnTo>
                    <a:pt x="98" y="333"/>
                  </a:lnTo>
                  <a:lnTo>
                    <a:pt x="107" y="333"/>
                  </a:lnTo>
                  <a:lnTo>
                    <a:pt x="114" y="333"/>
                  </a:lnTo>
                  <a:lnTo>
                    <a:pt x="124" y="333"/>
                  </a:lnTo>
                  <a:lnTo>
                    <a:pt x="132" y="333"/>
                  </a:lnTo>
                  <a:lnTo>
                    <a:pt x="138" y="333"/>
                  </a:lnTo>
                  <a:lnTo>
                    <a:pt x="147" y="333"/>
                  </a:lnTo>
                  <a:lnTo>
                    <a:pt x="155" y="333"/>
                  </a:lnTo>
                  <a:lnTo>
                    <a:pt x="165" y="333"/>
                  </a:lnTo>
                  <a:lnTo>
                    <a:pt x="173" y="333"/>
                  </a:lnTo>
                  <a:lnTo>
                    <a:pt x="181" y="333"/>
                  </a:lnTo>
                  <a:lnTo>
                    <a:pt x="187" y="333"/>
                  </a:lnTo>
                  <a:lnTo>
                    <a:pt x="196" y="333"/>
                  </a:lnTo>
                  <a:lnTo>
                    <a:pt x="204" y="333"/>
                  </a:lnTo>
                  <a:lnTo>
                    <a:pt x="212" y="333"/>
                  </a:lnTo>
                  <a:lnTo>
                    <a:pt x="222" y="333"/>
                  </a:lnTo>
                  <a:lnTo>
                    <a:pt x="228" y="333"/>
                  </a:lnTo>
                  <a:lnTo>
                    <a:pt x="238" y="333"/>
                  </a:lnTo>
                  <a:lnTo>
                    <a:pt x="246" y="333"/>
                  </a:lnTo>
                  <a:lnTo>
                    <a:pt x="253" y="333"/>
                  </a:lnTo>
                  <a:lnTo>
                    <a:pt x="262" y="333"/>
                  </a:lnTo>
                  <a:lnTo>
                    <a:pt x="271" y="333"/>
                  </a:lnTo>
                  <a:lnTo>
                    <a:pt x="277" y="333"/>
                  </a:lnTo>
                  <a:lnTo>
                    <a:pt x="287" y="333"/>
                  </a:lnTo>
                  <a:lnTo>
                    <a:pt x="293" y="333"/>
                  </a:lnTo>
                  <a:lnTo>
                    <a:pt x="303" y="333"/>
                  </a:lnTo>
                  <a:lnTo>
                    <a:pt x="310" y="333"/>
                  </a:lnTo>
                  <a:lnTo>
                    <a:pt x="318" y="292"/>
                  </a:lnTo>
                  <a:lnTo>
                    <a:pt x="328" y="291"/>
                  </a:lnTo>
                  <a:lnTo>
                    <a:pt x="336" y="289"/>
                  </a:lnTo>
                  <a:lnTo>
                    <a:pt x="342" y="287"/>
                  </a:lnTo>
                  <a:lnTo>
                    <a:pt x="352" y="286"/>
                  </a:lnTo>
                  <a:lnTo>
                    <a:pt x="360" y="284"/>
                  </a:lnTo>
                  <a:lnTo>
                    <a:pt x="367" y="283"/>
                  </a:lnTo>
                  <a:lnTo>
                    <a:pt x="375" y="281"/>
                  </a:lnTo>
                  <a:lnTo>
                    <a:pt x="385" y="279"/>
                  </a:lnTo>
                  <a:lnTo>
                    <a:pt x="393" y="278"/>
                  </a:lnTo>
                  <a:lnTo>
                    <a:pt x="400" y="276"/>
                  </a:lnTo>
                  <a:lnTo>
                    <a:pt x="409" y="276"/>
                  </a:lnTo>
                  <a:lnTo>
                    <a:pt x="417" y="274"/>
                  </a:lnTo>
                  <a:lnTo>
                    <a:pt x="426" y="273"/>
                  </a:lnTo>
                  <a:lnTo>
                    <a:pt x="432" y="271"/>
                  </a:lnTo>
                  <a:lnTo>
                    <a:pt x="440" y="270"/>
                  </a:lnTo>
                  <a:lnTo>
                    <a:pt x="449" y="268"/>
                  </a:lnTo>
                  <a:lnTo>
                    <a:pt x="457" y="266"/>
                  </a:lnTo>
                  <a:lnTo>
                    <a:pt x="466" y="265"/>
                  </a:lnTo>
                  <a:lnTo>
                    <a:pt x="475" y="263"/>
                  </a:lnTo>
                  <a:lnTo>
                    <a:pt x="483" y="261"/>
                  </a:lnTo>
                  <a:lnTo>
                    <a:pt x="491" y="261"/>
                  </a:lnTo>
                  <a:lnTo>
                    <a:pt x="497" y="260"/>
                  </a:lnTo>
                  <a:lnTo>
                    <a:pt x="507" y="258"/>
                  </a:lnTo>
                  <a:lnTo>
                    <a:pt x="514" y="257"/>
                  </a:lnTo>
                  <a:lnTo>
                    <a:pt x="524" y="255"/>
                  </a:lnTo>
                  <a:lnTo>
                    <a:pt x="530" y="253"/>
                  </a:lnTo>
                  <a:lnTo>
                    <a:pt x="540" y="252"/>
                  </a:lnTo>
                  <a:lnTo>
                    <a:pt x="546" y="250"/>
                  </a:lnTo>
                  <a:lnTo>
                    <a:pt x="555" y="250"/>
                  </a:lnTo>
                  <a:lnTo>
                    <a:pt x="564" y="248"/>
                  </a:lnTo>
                  <a:lnTo>
                    <a:pt x="571" y="247"/>
                  </a:lnTo>
                  <a:lnTo>
                    <a:pt x="581" y="245"/>
                  </a:lnTo>
                  <a:lnTo>
                    <a:pt x="587" y="243"/>
                  </a:lnTo>
                  <a:lnTo>
                    <a:pt x="597" y="242"/>
                  </a:lnTo>
                  <a:lnTo>
                    <a:pt x="604" y="240"/>
                  </a:lnTo>
                  <a:lnTo>
                    <a:pt x="612" y="239"/>
                  </a:lnTo>
                  <a:lnTo>
                    <a:pt x="621" y="239"/>
                  </a:lnTo>
                  <a:lnTo>
                    <a:pt x="628" y="237"/>
                  </a:lnTo>
                  <a:lnTo>
                    <a:pt x="638" y="235"/>
                  </a:lnTo>
                  <a:lnTo>
                    <a:pt x="644" y="234"/>
                  </a:lnTo>
                  <a:lnTo>
                    <a:pt x="654" y="232"/>
                  </a:lnTo>
                  <a:lnTo>
                    <a:pt x="661" y="230"/>
                  </a:lnTo>
                  <a:lnTo>
                    <a:pt x="669" y="229"/>
                  </a:lnTo>
                  <a:lnTo>
                    <a:pt x="679" y="229"/>
                  </a:lnTo>
                  <a:lnTo>
                    <a:pt x="687" y="227"/>
                  </a:lnTo>
                  <a:lnTo>
                    <a:pt x="693" y="226"/>
                  </a:lnTo>
                  <a:lnTo>
                    <a:pt x="701" y="224"/>
                  </a:lnTo>
                  <a:lnTo>
                    <a:pt x="711" y="222"/>
                  </a:lnTo>
                  <a:lnTo>
                    <a:pt x="719" y="221"/>
                  </a:lnTo>
                  <a:lnTo>
                    <a:pt x="726" y="219"/>
                  </a:lnTo>
                  <a:lnTo>
                    <a:pt x="734" y="219"/>
                  </a:lnTo>
                  <a:lnTo>
                    <a:pt x="742" y="217"/>
                  </a:lnTo>
                  <a:lnTo>
                    <a:pt x="752" y="216"/>
                  </a:lnTo>
                  <a:lnTo>
                    <a:pt x="760" y="214"/>
                  </a:lnTo>
                  <a:lnTo>
                    <a:pt x="767" y="212"/>
                  </a:lnTo>
                  <a:lnTo>
                    <a:pt x="775" y="211"/>
                  </a:lnTo>
                  <a:lnTo>
                    <a:pt x="785" y="209"/>
                  </a:lnTo>
                  <a:lnTo>
                    <a:pt x="793" y="209"/>
                  </a:lnTo>
                  <a:lnTo>
                    <a:pt x="801" y="208"/>
                  </a:lnTo>
                  <a:lnTo>
                    <a:pt x="807" y="206"/>
                  </a:lnTo>
                  <a:lnTo>
                    <a:pt x="816" y="204"/>
                  </a:lnTo>
                  <a:lnTo>
                    <a:pt x="825" y="203"/>
                  </a:lnTo>
                  <a:lnTo>
                    <a:pt x="834" y="201"/>
                  </a:lnTo>
                  <a:lnTo>
                    <a:pt x="840" y="201"/>
                  </a:lnTo>
                  <a:lnTo>
                    <a:pt x="848" y="199"/>
                  </a:lnTo>
                  <a:lnTo>
                    <a:pt x="856" y="198"/>
                  </a:lnTo>
                  <a:lnTo>
                    <a:pt x="866" y="196"/>
                  </a:lnTo>
                  <a:lnTo>
                    <a:pt x="874" y="195"/>
                  </a:lnTo>
                  <a:lnTo>
                    <a:pt x="881" y="193"/>
                  </a:lnTo>
                  <a:lnTo>
                    <a:pt x="889" y="193"/>
                  </a:lnTo>
                  <a:lnTo>
                    <a:pt x="899" y="191"/>
                  </a:lnTo>
                  <a:lnTo>
                    <a:pt x="907" y="190"/>
                  </a:lnTo>
                  <a:lnTo>
                    <a:pt x="915" y="188"/>
                  </a:lnTo>
                  <a:lnTo>
                    <a:pt x="922" y="186"/>
                  </a:lnTo>
                  <a:lnTo>
                    <a:pt x="930" y="185"/>
                  </a:lnTo>
                  <a:lnTo>
                    <a:pt x="940" y="185"/>
                  </a:lnTo>
                  <a:lnTo>
                    <a:pt x="948" y="183"/>
                  </a:lnTo>
                  <a:lnTo>
                    <a:pt x="954" y="181"/>
                  </a:lnTo>
                  <a:lnTo>
                    <a:pt x="962" y="180"/>
                  </a:lnTo>
                  <a:lnTo>
                    <a:pt x="971" y="178"/>
                  </a:lnTo>
                  <a:lnTo>
                    <a:pt x="980" y="178"/>
                  </a:lnTo>
                  <a:lnTo>
                    <a:pt x="989" y="177"/>
                  </a:lnTo>
                  <a:lnTo>
                    <a:pt x="995" y="175"/>
                  </a:lnTo>
                  <a:lnTo>
                    <a:pt x="1003" y="173"/>
                  </a:lnTo>
                  <a:lnTo>
                    <a:pt x="1013" y="172"/>
                  </a:lnTo>
                  <a:lnTo>
                    <a:pt x="1021" y="172"/>
                  </a:lnTo>
                  <a:lnTo>
                    <a:pt x="1029" y="170"/>
                  </a:lnTo>
                  <a:lnTo>
                    <a:pt x="1038" y="168"/>
                  </a:lnTo>
                  <a:lnTo>
                    <a:pt x="1046" y="167"/>
                  </a:lnTo>
                  <a:lnTo>
                    <a:pt x="1052" y="165"/>
                  </a:lnTo>
                  <a:lnTo>
                    <a:pt x="1060" y="165"/>
                  </a:lnTo>
                  <a:lnTo>
                    <a:pt x="1069" y="164"/>
                  </a:lnTo>
                  <a:lnTo>
                    <a:pt x="1077" y="162"/>
                  </a:lnTo>
                  <a:lnTo>
                    <a:pt x="1087" y="160"/>
                  </a:lnTo>
                  <a:lnTo>
                    <a:pt x="1095" y="159"/>
                  </a:lnTo>
                  <a:lnTo>
                    <a:pt x="1103" y="159"/>
                  </a:lnTo>
                  <a:lnTo>
                    <a:pt x="1111" y="157"/>
                  </a:lnTo>
                  <a:lnTo>
                    <a:pt x="1119" y="155"/>
                  </a:lnTo>
                  <a:lnTo>
                    <a:pt x="1126" y="154"/>
                  </a:lnTo>
                  <a:lnTo>
                    <a:pt x="1134" y="152"/>
                  </a:lnTo>
                  <a:lnTo>
                    <a:pt x="1142" y="152"/>
                  </a:lnTo>
                  <a:lnTo>
                    <a:pt x="1150" y="150"/>
                  </a:lnTo>
                  <a:lnTo>
                    <a:pt x="1158" y="149"/>
                  </a:lnTo>
                  <a:lnTo>
                    <a:pt x="1168" y="147"/>
                  </a:lnTo>
                  <a:lnTo>
                    <a:pt x="1176" y="146"/>
                  </a:lnTo>
                  <a:lnTo>
                    <a:pt x="1184" y="146"/>
                  </a:lnTo>
                  <a:lnTo>
                    <a:pt x="1193" y="144"/>
                  </a:lnTo>
                  <a:lnTo>
                    <a:pt x="1199" y="142"/>
                  </a:lnTo>
                  <a:lnTo>
                    <a:pt x="1207" y="141"/>
                  </a:lnTo>
                  <a:lnTo>
                    <a:pt x="1215" y="139"/>
                  </a:lnTo>
                  <a:lnTo>
                    <a:pt x="1224" y="139"/>
                  </a:lnTo>
                  <a:lnTo>
                    <a:pt x="1232" y="137"/>
                  </a:lnTo>
                  <a:lnTo>
                    <a:pt x="1242" y="136"/>
                  </a:lnTo>
                  <a:lnTo>
                    <a:pt x="1250" y="134"/>
                  </a:lnTo>
                  <a:lnTo>
                    <a:pt x="1258" y="134"/>
                  </a:lnTo>
                  <a:lnTo>
                    <a:pt x="1266" y="133"/>
                  </a:lnTo>
                  <a:lnTo>
                    <a:pt x="1274" y="131"/>
                  </a:lnTo>
                  <a:lnTo>
                    <a:pt x="1281" y="129"/>
                  </a:lnTo>
                  <a:lnTo>
                    <a:pt x="1289" y="129"/>
                  </a:lnTo>
                  <a:lnTo>
                    <a:pt x="1297" y="128"/>
                  </a:lnTo>
                  <a:lnTo>
                    <a:pt x="1305" y="126"/>
                  </a:lnTo>
                  <a:lnTo>
                    <a:pt x="1315" y="124"/>
                  </a:lnTo>
                  <a:lnTo>
                    <a:pt x="1323" y="123"/>
                  </a:lnTo>
                  <a:lnTo>
                    <a:pt x="1331" y="123"/>
                  </a:lnTo>
                  <a:lnTo>
                    <a:pt x="1339" y="121"/>
                  </a:lnTo>
                  <a:lnTo>
                    <a:pt x="1348" y="119"/>
                  </a:lnTo>
                  <a:lnTo>
                    <a:pt x="1354" y="118"/>
                  </a:lnTo>
                  <a:lnTo>
                    <a:pt x="1362" y="118"/>
                  </a:lnTo>
                  <a:lnTo>
                    <a:pt x="1370" y="116"/>
                  </a:lnTo>
                  <a:lnTo>
                    <a:pt x="1379" y="115"/>
                  </a:lnTo>
                  <a:lnTo>
                    <a:pt x="1388" y="113"/>
                  </a:lnTo>
                  <a:lnTo>
                    <a:pt x="1397" y="113"/>
                  </a:lnTo>
                  <a:lnTo>
                    <a:pt x="1405" y="111"/>
                  </a:lnTo>
                  <a:lnTo>
                    <a:pt x="1413" y="110"/>
                  </a:lnTo>
                  <a:lnTo>
                    <a:pt x="1421" y="108"/>
                  </a:lnTo>
                  <a:lnTo>
                    <a:pt x="1428" y="108"/>
                  </a:lnTo>
                  <a:lnTo>
                    <a:pt x="1436" y="106"/>
                  </a:lnTo>
                  <a:lnTo>
                    <a:pt x="1444" y="105"/>
                  </a:lnTo>
                  <a:lnTo>
                    <a:pt x="1452" y="103"/>
                  </a:lnTo>
                  <a:lnTo>
                    <a:pt x="1460" y="103"/>
                  </a:lnTo>
                  <a:lnTo>
                    <a:pt x="1470" y="102"/>
                  </a:lnTo>
                  <a:lnTo>
                    <a:pt x="1478" y="100"/>
                  </a:lnTo>
                  <a:lnTo>
                    <a:pt x="1486" y="98"/>
                  </a:lnTo>
                  <a:lnTo>
                    <a:pt x="1494" y="98"/>
                  </a:lnTo>
                  <a:lnTo>
                    <a:pt x="1501" y="97"/>
                  </a:lnTo>
                  <a:lnTo>
                    <a:pt x="1509" y="95"/>
                  </a:lnTo>
                  <a:lnTo>
                    <a:pt x="1517" y="93"/>
                  </a:lnTo>
                  <a:lnTo>
                    <a:pt x="1525" y="93"/>
                  </a:lnTo>
                  <a:lnTo>
                    <a:pt x="1534" y="92"/>
                  </a:lnTo>
                  <a:lnTo>
                    <a:pt x="1543" y="90"/>
                  </a:lnTo>
                  <a:lnTo>
                    <a:pt x="1552" y="88"/>
                  </a:lnTo>
                  <a:lnTo>
                    <a:pt x="1560" y="88"/>
                  </a:lnTo>
                  <a:lnTo>
                    <a:pt x="1568" y="87"/>
                  </a:lnTo>
                  <a:lnTo>
                    <a:pt x="1576" y="85"/>
                  </a:lnTo>
                  <a:lnTo>
                    <a:pt x="1583" y="85"/>
                  </a:lnTo>
                  <a:lnTo>
                    <a:pt x="1591" y="84"/>
                  </a:lnTo>
                  <a:lnTo>
                    <a:pt x="1599" y="82"/>
                  </a:lnTo>
                  <a:lnTo>
                    <a:pt x="1607" y="80"/>
                  </a:lnTo>
                  <a:lnTo>
                    <a:pt x="1617" y="80"/>
                  </a:lnTo>
                  <a:lnTo>
                    <a:pt x="1625" y="79"/>
                  </a:lnTo>
                  <a:lnTo>
                    <a:pt x="1633" y="77"/>
                  </a:lnTo>
                  <a:lnTo>
                    <a:pt x="1641" y="75"/>
                  </a:lnTo>
                  <a:lnTo>
                    <a:pt x="1649" y="75"/>
                  </a:lnTo>
                  <a:lnTo>
                    <a:pt x="1656" y="74"/>
                  </a:lnTo>
                  <a:lnTo>
                    <a:pt x="1664" y="72"/>
                  </a:lnTo>
                  <a:lnTo>
                    <a:pt x="1672" y="72"/>
                  </a:lnTo>
                  <a:lnTo>
                    <a:pt x="1680" y="71"/>
                  </a:lnTo>
                  <a:lnTo>
                    <a:pt x="1690" y="69"/>
                  </a:lnTo>
                  <a:lnTo>
                    <a:pt x="1698" y="67"/>
                  </a:lnTo>
                  <a:lnTo>
                    <a:pt x="1707" y="67"/>
                  </a:lnTo>
                  <a:lnTo>
                    <a:pt x="1715" y="66"/>
                  </a:lnTo>
                  <a:lnTo>
                    <a:pt x="1723" y="64"/>
                  </a:lnTo>
                  <a:lnTo>
                    <a:pt x="1729" y="64"/>
                  </a:lnTo>
                  <a:lnTo>
                    <a:pt x="1739" y="62"/>
                  </a:lnTo>
                  <a:lnTo>
                    <a:pt x="1746" y="61"/>
                  </a:lnTo>
                  <a:lnTo>
                    <a:pt x="1756" y="59"/>
                  </a:lnTo>
                  <a:lnTo>
                    <a:pt x="1762" y="59"/>
                  </a:lnTo>
                  <a:lnTo>
                    <a:pt x="1770" y="57"/>
                  </a:lnTo>
                  <a:lnTo>
                    <a:pt x="1780" y="56"/>
                  </a:lnTo>
                  <a:lnTo>
                    <a:pt x="1787" y="56"/>
                  </a:lnTo>
                  <a:lnTo>
                    <a:pt x="1796" y="54"/>
                  </a:lnTo>
                  <a:lnTo>
                    <a:pt x="1803" y="53"/>
                  </a:lnTo>
                  <a:lnTo>
                    <a:pt x="1813" y="53"/>
                  </a:lnTo>
                  <a:lnTo>
                    <a:pt x="1819" y="51"/>
                  </a:lnTo>
                  <a:lnTo>
                    <a:pt x="1829" y="49"/>
                  </a:lnTo>
                  <a:lnTo>
                    <a:pt x="1835" y="48"/>
                  </a:lnTo>
                  <a:lnTo>
                    <a:pt x="1844" y="48"/>
                  </a:lnTo>
                  <a:lnTo>
                    <a:pt x="1853" y="46"/>
                  </a:lnTo>
                  <a:lnTo>
                    <a:pt x="1860" y="44"/>
                  </a:lnTo>
                  <a:lnTo>
                    <a:pt x="1870" y="44"/>
                  </a:lnTo>
                  <a:lnTo>
                    <a:pt x="1876" y="43"/>
                  </a:lnTo>
                  <a:lnTo>
                    <a:pt x="1886" y="41"/>
                  </a:lnTo>
                  <a:lnTo>
                    <a:pt x="1893" y="41"/>
                  </a:lnTo>
                  <a:lnTo>
                    <a:pt x="1902" y="40"/>
                  </a:lnTo>
                  <a:lnTo>
                    <a:pt x="1909" y="38"/>
                  </a:lnTo>
                  <a:lnTo>
                    <a:pt x="1917" y="38"/>
                  </a:lnTo>
                  <a:lnTo>
                    <a:pt x="1927" y="36"/>
                  </a:lnTo>
                  <a:lnTo>
                    <a:pt x="1933" y="35"/>
                  </a:lnTo>
                  <a:lnTo>
                    <a:pt x="1943" y="35"/>
                  </a:lnTo>
                  <a:lnTo>
                    <a:pt x="1950" y="33"/>
                  </a:lnTo>
                  <a:lnTo>
                    <a:pt x="1959" y="31"/>
                  </a:lnTo>
                  <a:lnTo>
                    <a:pt x="1966" y="30"/>
                  </a:lnTo>
                  <a:lnTo>
                    <a:pt x="1976" y="30"/>
                  </a:lnTo>
                  <a:lnTo>
                    <a:pt x="1982" y="28"/>
                  </a:lnTo>
                  <a:lnTo>
                    <a:pt x="1990" y="26"/>
                  </a:lnTo>
                  <a:lnTo>
                    <a:pt x="2000" y="26"/>
                  </a:lnTo>
                  <a:lnTo>
                    <a:pt x="2007" y="25"/>
                  </a:lnTo>
                  <a:lnTo>
                    <a:pt x="2017" y="23"/>
                  </a:lnTo>
                  <a:lnTo>
                    <a:pt x="2023" y="23"/>
                  </a:lnTo>
                  <a:lnTo>
                    <a:pt x="2033" y="22"/>
                  </a:lnTo>
                  <a:lnTo>
                    <a:pt x="2039" y="20"/>
                  </a:lnTo>
                  <a:lnTo>
                    <a:pt x="2049" y="20"/>
                  </a:lnTo>
                  <a:lnTo>
                    <a:pt x="2056" y="18"/>
                  </a:lnTo>
                  <a:lnTo>
                    <a:pt x="2066" y="17"/>
                  </a:lnTo>
                  <a:lnTo>
                    <a:pt x="2074" y="17"/>
                  </a:lnTo>
                  <a:lnTo>
                    <a:pt x="2080" y="15"/>
                  </a:lnTo>
                  <a:lnTo>
                    <a:pt x="2090" y="13"/>
                  </a:lnTo>
                  <a:lnTo>
                    <a:pt x="2097" y="13"/>
                  </a:lnTo>
                  <a:lnTo>
                    <a:pt x="2106" y="12"/>
                  </a:lnTo>
                  <a:lnTo>
                    <a:pt x="2113" y="10"/>
                  </a:lnTo>
                  <a:lnTo>
                    <a:pt x="2123" y="10"/>
                  </a:lnTo>
                  <a:lnTo>
                    <a:pt x="2129" y="9"/>
                  </a:lnTo>
                  <a:lnTo>
                    <a:pt x="2139" y="7"/>
                  </a:lnTo>
                  <a:lnTo>
                    <a:pt x="2147" y="7"/>
                  </a:lnTo>
                  <a:lnTo>
                    <a:pt x="2154" y="5"/>
                  </a:lnTo>
                  <a:lnTo>
                    <a:pt x="2163" y="4"/>
                  </a:lnTo>
                  <a:lnTo>
                    <a:pt x="2170" y="4"/>
                  </a:lnTo>
                  <a:lnTo>
                    <a:pt x="2180" y="2"/>
                  </a:lnTo>
                  <a:lnTo>
                    <a:pt x="2186" y="0"/>
                  </a:lnTo>
                  <a:lnTo>
                    <a:pt x="2196" y="0"/>
                  </a:lnTo>
                  <a:lnTo>
                    <a:pt x="2203" y="40"/>
                  </a:lnTo>
                  <a:lnTo>
                    <a:pt x="2212" y="40"/>
                  </a:lnTo>
                  <a:lnTo>
                    <a:pt x="2221" y="41"/>
                  </a:lnTo>
                  <a:lnTo>
                    <a:pt x="2227" y="41"/>
                  </a:lnTo>
                  <a:lnTo>
                    <a:pt x="2237" y="41"/>
                  </a:lnTo>
                  <a:lnTo>
                    <a:pt x="2243" y="41"/>
                  </a:lnTo>
                  <a:lnTo>
                    <a:pt x="2253" y="41"/>
                  </a:lnTo>
                  <a:lnTo>
                    <a:pt x="2260" y="41"/>
                  </a:lnTo>
                  <a:lnTo>
                    <a:pt x="2270" y="41"/>
                  </a:lnTo>
                  <a:lnTo>
                    <a:pt x="2276" y="41"/>
                  </a:lnTo>
                  <a:lnTo>
                    <a:pt x="2286" y="41"/>
                  </a:lnTo>
                  <a:lnTo>
                    <a:pt x="2294" y="41"/>
                  </a:lnTo>
                  <a:lnTo>
                    <a:pt x="2301" y="41"/>
                  </a:lnTo>
                  <a:lnTo>
                    <a:pt x="2310" y="43"/>
                  </a:lnTo>
                  <a:lnTo>
                    <a:pt x="2317" y="43"/>
                  </a:lnTo>
                  <a:lnTo>
                    <a:pt x="2327" y="43"/>
                  </a:lnTo>
                  <a:lnTo>
                    <a:pt x="2333" y="43"/>
                  </a:lnTo>
                  <a:lnTo>
                    <a:pt x="2343" y="43"/>
                  </a:lnTo>
                  <a:lnTo>
                    <a:pt x="2349" y="43"/>
                  </a:lnTo>
                  <a:lnTo>
                    <a:pt x="2359" y="43"/>
                  </a:lnTo>
                  <a:lnTo>
                    <a:pt x="2366" y="43"/>
                  </a:lnTo>
                  <a:lnTo>
                    <a:pt x="2374" y="43"/>
                  </a:lnTo>
                  <a:lnTo>
                    <a:pt x="2384" y="43"/>
                  </a:lnTo>
                  <a:lnTo>
                    <a:pt x="2390" y="43"/>
                  </a:lnTo>
                  <a:lnTo>
                    <a:pt x="2400" y="44"/>
                  </a:lnTo>
                  <a:lnTo>
                    <a:pt x="2407" y="44"/>
                  </a:lnTo>
                  <a:lnTo>
                    <a:pt x="2416" y="44"/>
                  </a:lnTo>
                  <a:lnTo>
                    <a:pt x="2423" y="44"/>
                  </a:lnTo>
                  <a:lnTo>
                    <a:pt x="2433" y="44"/>
                  </a:lnTo>
                  <a:lnTo>
                    <a:pt x="2439" y="44"/>
                  </a:lnTo>
                  <a:lnTo>
                    <a:pt x="2447" y="44"/>
                  </a:lnTo>
                  <a:lnTo>
                    <a:pt x="2457" y="44"/>
                  </a:lnTo>
                  <a:lnTo>
                    <a:pt x="2464" y="44"/>
                  </a:lnTo>
                  <a:lnTo>
                    <a:pt x="2473" y="44"/>
                  </a:lnTo>
                  <a:lnTo>
                    <a:pt x="2480" y="44"/>
                  </a:lnTo>
                  <a:lnTo>
                    <a:pt x="2490" y="46"/>
                  </a:lnTo>
                  <a:lnTo>
                    <a:pt x="2496" y="46"/>
                  </a:lnTo>
                  <a:lnTo>
                    <a:pt x="2506" y="46"/>
                  </a:lnTo>
                  <a:lnTo>
                    <a:pt x="2513" y="46"/>
                  </a:lnTo>
                  <a:lnTo>
                    <a:pt x="2521" y="46"/>
                  </a:lnTo>
                  <a:lnTo>
                    <a:pt x="2531" y="46"/>
                  </a:lnTo>
                  <a:lnTo>
                    <a:pt x="2537" y="46"/>
                  </a:lnTo>
                  <a:lnTo>
                    <a:pt x="2547" y="46"/>
                  </a:lnTo>
                  <a:lnTo>
                    <a:pt x="2553" y="46"/>
                  </a:lnTo>
                  <a:lnTo>
                    <a:pt x="2563" y="46"/>
                  </a:lnTo>
                  <a:lnTo>
                    <a:pt x="2570" y="46"/>
                  </a:lnTo>
                  <a:lnTo>
                    <a:pt x="2580" y="48"/>
                  </a:lnTo>
                  <a:lnTo>
                    <a:pt x="2586" y="48"/>
                  </a:lnTo>
                  <a:lnTo>
                    <a:pt x="2594" y="48"/>
                  </a:lnTo>
                  <a:lnTo>
                    <a:pt x="2604" y="48"/>
                  </a:lnTo>
                  <a:lnTo>
                    <a:pt x="2611" y="48"/>
                  </a:lnTo>
                  <a:lnTo>
                    <a:pt x="2620" y="48"/>
                  </a:lnTo>
                  <a:lnTo>
                    <a:pt x="2627" y="48"/>
                  </a:lnTo>
                  <a:lnTo>
                    <a:pt x="2637" y="48"/>
                  </a:lnTo>
                  <a:lnTo>
                    <a:pt x="2643" y="48"/>
                  </a:lnTo>
                  <a:lnTo>
                    <a:pt x="2653" y="48"/>
                  </a:lnTo>
                  <a:lnTo>
                    <a:pt x="2659" y="48"/>
                  </a:lnTo>
                  <a:lnTo>
                    <a:pt x="2669" y="49"/>
                  </a:lnTo>
                  <a:lnTo>
                    <a:pt x="2677" y="49"/>
                  </a:lnTo>
                  <a:lnTo>
                    <a:pt x="2684" y="49"/>
                  </a:lnTo>
                  <a:lnTo>
                    <a:pt x="2694" y="49"/>
                  </a:lnTo>
                  <a:lnTo>
                    <a:pt x="2700" y="49"/>
                  </a:lnTo>
                  <a:lnTo>
                    <a:pt x="2710" y="49"/>
                  </a:lnTo>
                  <a:lnTo>
                    <a:pt x="2717" y="49"/>
                  </a:lnTo>
                  <a:lnTo>
                    <a:pt x="2726" y="49"/>
                  </a:lnTo>
                  <a:lnTo>
                    <a:pt x="2733" y="49"/>
                  </a:lnTo>
                  <a:lnTo>
                    <a:pt x="2743" y="49"/>
                  </a:lnTo>
                  <a:lnTo>
                    <a:pt x="2751" y="49"/>
                  </a:lnTo>
                  <a:lnTo>
                    <a:pt x="2757" y="49"/>
                  </a:lnTo>
                  <a:lnTo>
                    <a:pt x="2767" y="51"/>
                  </a:lnTo>
                  <a:lnTo>
                    <a:pt x="2774" y="51"/>
                  </a:lnTo>
                  <a:lnTo>
                    <a:pt x="2784" y="51"/>
                  </a:lnTo>
                  <a:lnTo>
                    <a:pt x="2790" y="51"/>
                  </a:lnTo>
                  <a:lnTo>
                    <a:pt x="2800" y="51"/>
                  </a:lnTo>
                  <a:lnTo>
                    <a:pt x="2806" y="51"/>
                  </a:lnTo>
                  <a:lnTo>
                    <a:pt x="2816" y="51"/>
                  </a:lnTo>
                  <a:lnTo>
                    <a:pt x="2824" y="51"/>
                  </a:lnTo>
                  <a:lnTo>
                    <a:pt x="2831" y="51"/>
                  </a:lnTo>
                  <a:lnTo>
                    <a:pt x="2841" y="51"/>
                  </a:lnTo>
                  <a:lnTo>
                    <a:pt x="2847" y="51"/>
                  </a:lnTo>
                  <a:lnTo>
                    <a:pt x="2857" y="53"/>
                  </a:lnTo>
                  <a:lnTo>
                    <a:pt x="2863" y="53"/>
                  </a:lnTo>
                  <a:lnTo>
                    <a:pt x="2873" y="53"/>
                  </a:lnTo>
                  <a:lnTo>
                    <a:pt x="2880" y="53"/>
                  </a:lnTo>
                  <a:lnTo>
                    <a:pt x="2890" y="53"/>
                  </a:lnTo>
                  <a:lnTo>
                    <a:pt x="2898" y="53"/>
                  </a:lnTo>
                  <a:lnTo>
                    <a:pt x="2904" y="53"/>
                  </a:lnTo>
                  <a:lnTo>
                    <a:pt x="2914" y="53"/>
                  </a:lnTo>
                  <a:lnTo>
                    <a:pt x="2921" y="53"/>
                  </a:lnTo>
                  <a:lnTo>
                    <a:pt x="2930" y="53"/>
                  </a:lnTo>
                  <a:lnTo>
                    <a:pt x="2937" y="53"/>
                  </a:lnTo>
                  <a:lnTo>
                    <a:pt x="2947" y="54"/>
                  </a:lnTo>
                  <a:lnTo>
                    <a:pt x="2953" y="54"/>
                  </a:lnTo>
                  <a:lnTo>
                    <a:pt x="2963" y="54"/>
                  </a:lnTo>
                  <a:lnTo>
                    <a:pt x="2970" y="54"/>
                  </a:lnTo>
                  <a:lnTo>
                    <a:pt x="2978" y="54"/>
                  </a:lnTo>
                  <a:lnTo>
                    <a:pt x="2987" y="54"/>
                  </a:lnTo>
                  <a:lnTo>
                    <a:pt x="2994" y="54"/>
                  </a:lnTo>
                  <a:lnTo>
                    <a:pt x="3004" y="54"/>
                  </a:lnTo>
                  <a:lnTo>
                    <a:pt x="3010" y="54"/>
                  </a:lnTo>
                  <a:lnTo>
                    <a:pt x="3020" y="54"/>
                  </a:lnTo>
                  <a:lnTo>
                    <a:pt x="3027" y="54"/>
                  </a:lnTo>
                  <a:lnTo>
                    <a:pt x="3036" y="54"/>
                  </a:lnTo>
                  <a:lnTo>
                    <a:pt x="3043" y="56"/>
                  </a:lnTo>
                  <a:lnTo>
                    <a:pt x="3051" y="56"/>
                  </a:lnTo>
                  <a:lnTo>
                    <a:pt x="3061" y="56"/>
                  </a:lnTo>
                  <a:lnTo>
                    <a:pt x="3067" y="56"/>
                  </a:lnTo>
                  <a:lnTo>
                    <a:pt x="3077" y="56"/>
                  </a:lnTo>
                  <a:lnTo>
                    <a:pt x="3084" y="56"/>
                  </a:lnTo>
                  <a:lnTo>
                    <a:pt x="3094" y="56"/>
                  </a:lnTo>
                  <a:lnTo>
                    <a:pt x="3100" y="56"/>
                  </a:lnTo>
                  <a:lnTo>
                    <a:pt x="3110" y="56"/>
                  </a:lnTo>
                  <a:lnTo>
                    <a:pt x="3116" y="56"/>
                  </a:lnTo>
                  <a:lnTo>
                    <a:pt x="3125" y="56"/>
                  </a:lnTo>
                  <a:lnTo>
                    <a:pt x="3133" y="56"/>
                  </a:lnTo>
                  <a:lnTo>
                    <a:pt x="3141" y="57"/>
                  </a:lnTo>
                  <a:lnTo>
                    <a:pt x="3151" y="57"/>
                  </a:lnTo>
                  <a:lnTo>
                    <a:pt x="3159" y="57"/>
                  </a:lnTo>
                  <a:lnTo>
                    <a:pt x="3165" y="57"/>
                  </a:lnTo>
                  <a:lnTo>
                    <a:pt x="3173" y="57"/>
                  </a:lnTo>
                  <a:lnTo>
                    <a:pt x="3183" y="57"/>
                  </a:lnTo>
                  <a:lnTo>
                    <a:pt x="3191" y="57"/>
                  </a:lnTo>
                  <a:lnTo>
                    <a:pt x="3198" y="57"/>
                  </a:lnTo>
                  <a:lnTo>
                    <a:pt x="3208" y="57"/>
                  </a:lnTo>
                  <a:lnTo>
                    <a:pt x="3216" y="57"/>
                  </a:lnTo>
                  <a:lnTo>
                    <a:pt x="3222" y="57"/>
                  </a:lnTo>
                  <a:lnTo>
                    <a:pt x="3231" y="59"/>
                  </a:lnTo>
                  <a:lnTo>
                    <a:pt x="3240" y="59"/>
                  </a:lnTo>
                  <a:lnTo>
                    <a:pt x="3249" y="59"/>
                  </a:lnTo>
                  <a:lnTo>
                    <a:pt x="3255" y="59"/>
                  </a:lnTo>
                  <a:lnTo>
                    <a:pt x="3263" y="59"/>
                  </a:lnTo>
                  <a:lnTo>
                    <a:pt x="3273" y="59"/>
                  </a:lnTo>
                  <a:lnTo>
                    <a:pt x="3280" y="59"/>
                  </a:lnTo>
                  <a:lnTo>
                    <a:pt x="3288" y="59"/>
                  </a:lnTo>
                  <a:lnTo>
                    <a:pt x="3297" y="59"/>
                  </a:lnTo>
                  <a:lnTo>
                    <a:pt x="3306" y="59"/>
                  </a:lnTo>
                  <a:lnTo>
                    <a:pt x="3312" y="59"/>
                  </a:lnTo>
                  <a:lnTo>
                    <a:pt x="3320" y="59"/>
                  </a:lnTo>
                  <a:lnTo>
                    <a:pt x="3330" y="61"/>
                  </a:lnTo>
                  <a:lnTo>
                    <a:pt x="3338" y="61"/>
                  </a:lnTo>
                  <a:lnTo>
                    <a:pt x="3345" y="61"/>
                  </a:lnTo>
                  <a:lnTo>
                    <a:pt x="3355" y="61"/>
                  </a:lnTo>
                  <a:lnTo>
                    <a:pt x="3363" y="61"/>
                  </a:lnTo>
                  <a:lnTo>
                    <a:pt x="3369" y="61"/>
                  </a:lnTo>
                  <a:lnTo>
                    <a:pt x="3377" y="61"/>
                  </a:lnTo>
                  <a:lnTo>
                    <a:pt x="3387" y="61"/>
                  </a:lnTo>
                  <a:lnTo>
                    <a:pt x="3395" y="61"/>
                  </a:lnTo>
                  <a:lnTo>
                    <a:pt x="3402" y="61"/>
                  </a:lnTo>
                  <a:lnTo>
                    <a:pt x="3410" y="61"/>
                  </a:lnTo>
                  <a:lnTo>
                    <a:pt x="3420" y="61"/>
                  </a:lnTo>
                  <a:lnTo>
                    <a:pt x="3426" y="62"/>
                  </a:lnTo>
                  <a:lnTo>
                    <a:pt x="3435" y="62"/>
                  </a:lnTo>
                  <a:lnTo>
                    <a:pt x="3444" y="62"/>
                  </a:lnTo>
                  <a:lnTo>
                    <a:pt x="3453" y="62"/>
                  </a:lnTo>
                  <a:lnTo>
                    <a:pt x="3459" y="62"/>
                  </a:lnTo>
                  <a:lnTo>
                    <a:pt x="3467" y="62"/>
                  </a:lnTo>
                  <a:lnTo>
                    <a:pt x="3477" y="62"/>
                  </a:lnTo>
                  <a:lnTo>
                    <a:pt x="3485" y="62"/>
                  </a:lnTo>
                  <a:lnTo>
                    <a:pt x="3492" y="62"/>
                  </a:lnTo>
                  <a:lnTo>
                    <a:pt x="3501" y="62"/>
                  </a:lnTo>
                  <a:lnTo>
                    <a:pt x="3510" y="62"/>
                  </a:lnTo>
                  <a:lnTo>
                    <a:pt x="3516" y="64"/>
                  </a:lnTo>
                  <a:lnTo>
                    <a:pt x="3524" y="64"/>
                  </a:lnTo>
                  <a:lnTo>
                    <a:pt x="3534" y="64"/>
                  </a:lnTo>
                  <a:lnTo>
                    <a:pt x="3542" y="64"/>
                  </a:lnTo>
                  <a:lnTo>
                    <a:pt x="3549" y="64"/>
                  </a:lnTo>
                  <a:lnTo>
                    <a:pt x="3557" y="64"/>
                  </a:lnTo>
                  <a:lnTo>
                    <a:pt x="3567" y="64"/>
                  </a:lnTo>
                  <a:lnTo>
                    <a:pt x="3575" y="64"/>
                  </a:lnTo>
                  <a:lnTo>
                    <a:pt x="3581" y="64"/>
                  </a:lnTo>
                  <a:lnTo>
                    <a:pt x="3591" y="64"/>
                  </a:lnTo>
                  <a:lnTo>
                    <a:pt x="3599" y="64"/>
                  </a:lnTo>
                  <a:lnTo>
                    <a:pt x="3606" y="64"/>
                  </a:lnTo>
                  <a:lnTo>
                    <a:pt x="3614" y="66"/>
                  </a:lnTo>
                  <a:lnTo>
                    <a:pt x="3624" y="66"/>
                  </a:lnTo>
                  <a:lnTo>
                    <a:pt x="3632" y="66"/>
                  </a:lnTo>
                  <a:lnTo>
                    <a:pt x="3639" y="66"/>
                  </a:lnTo>
                  <a:lnTo>
                    <a:pt x="3647" y="66"/>
                  </a:lnTo>
                  <a:lnTo>
                    <a:pt x="3656" y="66"/>
                  </a:lnTo>
                  <a:lnTo>
                    <a:pt x="3663" y="66"/>
                  </a:lnTo>
                  <a:lnTo>
                    <a:pt x="3671" y="66"/>
                  </a:lnTo>
                  <a:lnTo>
                    <a:pt x="3681" y="66"/>
                  </a:lnTo>
                  <a:lnTo>
                    <a:pt x="3689" y="66"/>
                  </a:lnTo>
                  <a:lnTo>
                    <a:pt x="3696" y="66"/>
                  </a:lnTo>
                  <a:lnTo>
                    <a:pt x="3704" y="66"/>
                  </a:lnTo>
                  <a:lnTo>
                    <a:pt x="3714" y="67"/>
                  </a:lnTo>
                  <a:lnTo>
                    <a:pt x="3722" y="67"/>
                  </a:lnTo>
                  <a:lnTo>
                    <a:pt x="3728" y="67"/>
                  </a:lnTo>
                  <a:lnTo>
                    <a:pt x="3738" y="67"/>
                  </a:lnTo>
                  <a:lnTo>
                    <a:pt x="3746" y="67"/>
                  </a:lnTo>
                  <a:lnTo>
                    <a:pt x="3753" y="67"/>
                  </a:lnTo>
                  <a:lnTo>
                    <a:pt x="3761" y="67"/>
                  </a:lnTo>
                  <a:lnTo>
                    <a:pt x="3771" y="67"/>
                  </a:lnTo>
                  <a:lnTo>
                    <a:pt x="3779" y="67"/>
                  </a:lnTo>
                  <a:lnTo>
                    <a:pt x="3785" y="67"/>
                  </a:lnTo>
                  <a:lnTo>
                    <a:pt x="3794" y="67"/>
                  </a:lnTo>
                  <a:lnTo>
                    <a:pt x="3803" y="67"/>
                  </a:lnTo>
                  <a:lnTo>
                    <a:pt x="3810" y="69"/>
                  </a:lnTo>
                  <a:lnTo>
                    <a:pt x="3818" y="69"/>
                  </a:lnTo>
                  <a:lnTo>
                    <a:pt x="3828" y="69"/>
                  </a:lnTo>
                  <a:lnTo>
                    <a:pt x="3836" y="69"/>
                  </a:lnTo>
                  <a:lnTo>
                    <a:pt x="3842" y="69"/>
                  </a:lnTo>
                  <a:lnTo>
                    <a:pt x="3851" y="69"/>
                  </a:lnTo>
                  <a:lnTo>
                    <a:pt x="3860" y="69"/>
                  </a:lnTo>
                  <a:lnTo>
                    <a:pt x="3869" y="69"/>
                  </a:lnTo>
                  <a:lnTo>
                    <a:pt x="3875" y="69"/>
                  </a:lnTo>
                  <a:lnTo>
                    <a:pt x="3885" y="69"/>
                  </a:lnTo>
                  <a:lnTo>
                    <a:pt x="3893" y="69"/>
                  </a:lnTo>
                  <a:lnTo>
                    <a:pt x="3900" y="69"/>
                  </a:lnTo>
                  <a:lnTo>
                    <a:pt x="3908" y="71"/>
                  </a:lnTo>
                  <a:lnTo>
                    <a:pt x="3918" y="71"/>
                  </a:lnTo>
                  <a:lnTo>
                    <a:pt x="3926" y="71"/>
                  </a:lnTo>
                  <a:lnTo>
                    <a:pt x="3932" y="71"/>
                  </a:lnTo>
                  <a:lnTo>
                    <a:pt x="3940" y="71"/>
                  </a:lnTo>
                  <a:lnTo>
                    <a:pt x="3950" y="71"/>
                  </a:lnTo>
                  <a:lnTo>
                    <a:pt x="3957" y="71"/>
                  </a:lnTo>
                  <a:lnTo>
                    <a:pt x="3965" y="71"/>
                  </a:lnTo>
                  <a:lnTo>
                    <a:pt x="3975" y="71"/>
                  </a:lnTo>
                  <a:lnTo>
                    <a:pt x="3983" y="71"/>
                  </a:lnTo>
                  <a:lnTo>
                    <a:pt x="3989" y="71"/>
                  </a:lnTo>
                  <a:lnTo>
                    <a:pt x="3998" y="71"/>
                  </a:lnTo>
                  <a:lnTo>
                    <a:pt x="4007" y="71"/>
                  </a:lnTo>
                  <a:lnTo>
                    <a:pt x="4015" y="72"/>
                  </a:lnTo>
                  <a:lnTo>
                    <a:pt x="4022" y="72"/>
                  </a:lnTo>
                  <a:lnTo>
                    <a:pt x="4032" y="72"/>
                  </a:lnTo>
                  <a:lnTo>
                    <a:pt x="4040" y="72"/>
                  </a:lnTo>
                  <a:lnTo>
                    <a:pt x="4046" y="72"/>
                  </a:lnTo>
                  <a:lnTo>
                    <a:pt x="4055" y="72"/>
                  </a:lnTo>
                  <a:lnTo>
                    <a:pt x="4064" y="72"/>
                  </a:lnTo>
                  <a:lnTo>
                    <a:pt x="4073" y="72"/>
                  </a:lnTo>
                  <a:lnTo>
                    <a:pt x="4079" y="72"/>
                  </a:lnTo>
                  <a:lnTo>
                    <a:pt x="4087" y="72"/>
                  </a:lnTo>
                  <a:lnTo>
                    <a:pt x="4097" y="72"/>
                  </a:lnTo>
                  <a:lnTo>
                    <a:pt x="4104" y="72"/>
                  </a:lnTo>
                  <a:lnTo>
                    <a:pt x="4112" y="74"/>
                  </a:lnTo>
                  <a:lnTo>
                    <a:pt x="4122" y="74"/>
                  </a:lnTo>
                  <a:lnTo>
                    <a:pt x="4130" y="74"/>
                  </a:lnTo>
                  <a:lnTo>
                    <a:pt x="4136" y="74"/>
                  </a:lnTo>
                  <a:lnTo>
                    <a:pt x="4144" y="74"/>
                  </a:lnTo>
                  <a:lnTo>
                    <a:pt x="4154" y="74"/>
                  </a:lnTo>
                  <a:lnTo>
                    <a:pt x="4162" y="74"/>
                  </a:lnTo>
                  <a:lnTo>
                    <a:pt x="4169" y="74"/>
                  </a:lnTo>
                  <a:lnTo>
                    <a:pt x="4177" y="74"/>
                  </a:lnTo>
                  <a:lnTo>
                    <a:pt x="4187" y="74"/>
                  </a:lnTo>
                  <a:lnTo>
                    <a:pt x="4193" y="74"/>
                  </a:lnTo>
                  <a:lnTo>
                    <a:pt x="4201" y="74"/>
                  </a:lnTo>
                  <a:lnTo>
                    <a:pt x="4211" y="75"/>
                  </a:lnTo>
                  <a:lnTo>
                    <a:pt x="4219" y="75"/>
                  </a:lnTo>
                </a:path>
              </a:pathLst>
            </a:custGeom>
            <a:noFill/>
            <a:ln w="19050" cmpd="sng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39" name="Freeform 105"/>
            <p:cNvSpPr>
              <a:spLocks/>
            </p:cNvSpPr>
            <p:nvPr/>
          </p:nvSpPr>
          <p:spPr bwMode="auto">
            <a:xfrm>
              <a:off x="1410494" y="2962276"/>
              <a:ext cx="6711950" cy="261938"/>
            </a:xfrm>
            <a:custGeom>
              <a:avLst/>
              <a:gdLst>
                <a:gd name="T0" fmla="*/ 67 w 4228"/>
                <a:gd name="T1" fmla="*/ 155 h 165"/>
                <a:gd name="T2" fmla="*/ 141 w 4228"/>
                <a:gd name="T3" fmla="*/ 155 h 165"/>
                <a:gd name="T4" fmla="*/ 213 w 4228"/>
                <a:gd name="T5" fmla="*/ 155 h 165"/>
                <a:gd name="T6" fmla="*/ 288 w 4228"/>
                <a:gd name="T7" fmla="*/ 155 h 165"/>
                <a:gd name="T8" fmla="*/ 359 w 4228"/>
                <a:gd name="T9" fmla="*/ 162 h 165"/>
                <a:gd name="T10" fmla="*/ 434 w 4228"/>
                <a:gd name="T11" fmla="*/ 155 h 165"/>
                <a:gd name="T12" fmla="*/ 508 w 4228"/>
                <a:gd name="T13" fmla="*/ 149 h 165"/>
                <a:gd name="T14" fmla="*/ 581 w 4228"/>
                <a:gd name="T15" fmla="*/ 142 h 165"/>
                <a:gd name="T16" fmla="*/ 655 w 4228"/>
                <a:gd name="T17" fmla="*/ 136 h 165"/>
                <a:gd name="T18" fmla="*/ 728 w 4228"/>
                <a:gd name="T19" fmla="*/ 129 h 165"/>
                <a:gd name="T20" fmla="*/ 802 w 4228"/>
                <a:gd name="T21" fmla="*/ 123 h 165"/>
                <a:gd name="T22" fmla="*/ 873 w 4228"/>
                <a:gd name="T23" fmla="*/ 116 h 165"/>
                <a:gd name="T24" fmla="*/ 947 w 4228"/>
                <a:gd name="T25" fmla="*/ 109 h 165"/>
                <a:gd name="T26" fmla="*/ 1020 w 4228"/>
                <a:gd name="T27" fmla="*/ 105 h 165"/>
                <a:gd name="T28" fmla="*/ 1094 w 4228"/>
                <a:gd name="T29" fmla="*/ 98 h 165"/>
                <a:gd name="T30" fmla="*/ 1167 w 4228"/>
                <a:gd name="T31" fmla="*/ 92 h 165"/>
                <a:gd name="T32" fmla="*/ 1241 w 4228"/>
                <a:gd name="T33" fmla="*/ 85 h 165"/>
                <a:gd name="T34" fmla="*/ 1314 w 4228"/>
                <a:gd name="T35" fmla="*/ 80 h 165"/>
                <a:gd name="T36" fmla="*/ 1387 w 4228"/>
                <a:gd name="T37" fmla="*/ 74 h 165"/>
                <a:gd name="T38" fmla="*/ 1461 w 4228"/>
                <a:gd name="T39" fmla="*/ 67 h 165"/>
                <a:gd name="T40" fmla="*/ 1534 w 4228"/>
                <a:gd name="T41" fmla="*/ 62 h 165"/>
                <a:gd name="T42" fmla="*/ 1608 w 4228"/>
                <a:gd name="T43" fmla="*/ 56 h 165"/>
                <a:gd name="T44" fmla="*/ 1681 w 4228"/>
                <a:gd name="T45" fmla="*/ 51 h 165"/>
                <a:gd name="T46" fmla="*/ 1756 w 4228"/>
                <a:gd name="T47" fmla="*/ 44 h 165"/>
                <a:gd name="T48" fmla="*/ 1830 w 4228"/>
                <a:gd name="T49" fmla="*/ 39 h 165"/>
                <a:gd name="T50" fmla="*/ 1903 w 4228"/>
                <a:gd name="T51" fmla="*/ 33 h 165"/>
                <a:gd name="T52" fmla="*/ 1976 w 4228"/>
                <a:gd name="T53" fmla="*/ 28 h 165"/>
                <a:gd name="T54" fmla="*/ 2050 w 4228"/>
                <a:gd name="T55" fmla="*/ 23 h 165"/>
                <a:gd name="T56" fmla="*/ 2123 w 4228"/>
                <a:gd name="T57" fmla="*/ 17 h 165"/>
                <a:gd name="T58" fmla="*/ 2197 w 4228"/>
                <a:gd name="T59" fmla="*/ 12 h 165"/>
                <a:gd name="T60" fmla="*/ 2270 w 4228"/>
                <a:gd name="T61" fmla="*/ 2 h 165"/>
                <a:gd name="T62" fmla="*/ 2344 w 4228"/>
                <a:gd name="T63" fmla="*/ 2 h 165"/>
                <a:gd name="T64" fmla="*/ 2417 w 4228"/>
                <a:gd name="T65" fmla="*/ 2 h 165"/>
                <a:gd name="T66" fmla="*/ 2490 w 4228"/>
                <a:gd name="T67" fmla="*/ 3 h 165"/>
                <a:gd name="T68" fmla="*/ 2564 w 4228"/>
                <a:gd name="T69" fmla="*/ 3 h 165"/>
                <a:gd name="T70" fmla="*/ 2637 w 4228"/>
                <a:gd name="T71" fmla="*/ 5 h 165"/>
                <a:gd name="T72" fmla="*/ 2711 w 4228"/>
                <a:gd name="T73" fmla="*/ 5 h 165"/>
                <a:gd name="T74" fmla="*/ 2784 w 4228"/>
                <a:gd name="T75" fmla="*/ 7 h 165"/>
                <a:gd name="T76" fmla="*/ 2858 w 4228"/>
                <a:gd name="T77" fmla="*/ 7 h 165"/>
                <a:gd name="T78" fmla="*/ 2931 w 4228"/>
                <a:gd name="T79" fmla="*/ 7 h 165"/>
                <a:gd name="T80" fmla="*/ 3004 w 4228"/>
                <a:gd name="T81" fmla="*/ 8 h 165"/>
                <a:gd name="T82" fmla="*/ 3078 w 4228"/>
                <a:gd name="T83" fmla="*/ 8 h 165"/>
                <a:gd name="T84" fmla="*/ 3150 w 4228"/>
                <a:gd name="T85" fmla="*/ 10 h 165"/>
                <a:gd name="T86" fmla="*/ 3225 w 4228"/>
                <a:gd name="T87" fmla="*/ 10 h 165"/>
                <a:gd name="T88" fmla="*/ 3297 w 4228"/>
                <a:gd name="T89" fmla="*/ 12 h 165"/>
                <a:gd name="T90" fmla="*/ 3372 w 4228"/>
                <a:gd name="T91" fmla="*/ 12 h 165"/>
                <a:gd name="T92" fmla="*/ 3443 w 4228"/>
                <a:gd name="T93" fmla="*/ 12 h 165"/>
                <a:gd name="T94" fmla="*/ 3518 w 4228"/>
                <a:gd name="T95" fmla="*/ 13 h 165"/>
                <a:gd name="T96" fmla="*/ 3592 w 4228"/>
                <a:gd name="T97" fmla="*/ 13 h 165"/>
                <a:gd name="T98" fmla="*/ 3664 w 4228"/>
                <a:gd name="T99" fmla="*/ 15 h 165"/>
                <a:gd name="T100" fmla="*/ 3739 w 4228"/>
                <a:gd name="T101" fmla="*/ 15 h 165"/>
                <a:gd name="T102" fmla="*/ 3811 w 4228"/>
                <a:gd name="T103" fmla="*/ 15 h 165"/>
                <a:gd name="T104" fmla="*/ 3886 w 4228"/>
                <a:gd name="T105" fmla="*/ 17 h 165"/>
                <a:gd name="T106" fmla="*/ 3957 w 4228"/>
                <a:gd name="T107" fmla="*/ 17 h 165"/>
                <a:gd name="T108" fmla="*/ 4032 w 4228"/>
                <a:gd name="T109" fmla="*/ 17 h 165"/>
                <a:gd name="T110" fmla="*/ 4104 w 4228"/>
                <a:gd name="T111" fmla="*/ 18 h 165"/>
                <a:gd name="T112" fmla="*/ 4179 w 4228"/>
                <a:gd name="T113" fmla="*/ 18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228" h="165">
                  <a:moveTo>
                    <a:pt x="0" y="155"/>
                  </a:moveTo>
                  <a:lnTo>
                    <a:pt x="10" y="155"/>
                  </a:lnTo>
                  <a:lnTo>
                    <a:pt x="17" y="155"/>
                  </a:lnTo>
                  <a:lnTo>
                    <a:pt x="25" y="155"/>
                  </a:lnTo>
                  <a:lnTo>
                    <a:pt x="35" y="155"/>
                  </a:lnTo>
                  <a:lnTo>
                    <a:pt x="41" y="155"/>
                  </a:lnTo>
                  <a:lnTo>
                    <a:pt x="51" y="155"/>
                  </a:lnTo>
                  <a:lnTo>
                    <a:pt x="58" y="155"/>
                  </a:lnTo>
                  <a:lnTo>
                    <a:pt x="67" y="155"/>
                  </a:lnTo>
                  <a:lnTo>
                    <a:pt x="74" y="155"/>
                  </a:lnTo>
                  <a:lnTo>
                    <a:pt x="82" y="155"/>
                  </a:lnTo>
                  <a:lnTo>
                    <a:pt x="92" y="155"/>
                  </a:lnTo>
                  <a:lnTo>
                    <a:pt x="98" y="155"/>
                  </a:lnTo>
                  <a:lnTo>
                    <a:pt x="108" y="155"/>
                  </a:lnTo>
                  <a:lnTo>
                    <a:pt x="115" y="155"/>
                  </a:lnTo>
                  <a:lnTo>
                    <a:pt x="124" y="155"/>
                  </a:lnTo>
                  <a:lnTo>
                    <a:pt x="131" y="155"/>
                  </a:lnTo>
                  <a:lnTo>
                    <a:pt x="141" y="155"/>
                  </a:lnTo>
                  <a:lnTo>
                    <a:pt x="149" y="155"/>
                  </a:lnTo>
                  <a:lnTo>
                    <a:pt x="155" y="155"/>
                  </a:lnTo>
                  <a:lnTo>
                    <a:pt x="164" y="155"/>
                  </a:lnTo>
                  <a:lnTo>
                    <a:pt x="172" y="155"/>
                  </a:lnTo>
                  <a:lnTo>
                    <a:pt x="182" y="155"/>
                  </a:lnTo>
                  <a:lnTo>
                    <a:pt x="190" y="155"/>
                  </a:lnTo>
                  <a:lnTo>
                    <a:pt x="198" y="155"/>
                  </a:lnTo>
                  <a:lnTo>
                    <a:pt x="204" y="155"/>
                  </a:lnTo>
                  <a:lnTo>
                    <a:pt x="213" y="155"/>
                  </a:lnTo>
                  <a:lnTo>
                    <a:pt x="221" y="155"/>
                  </a:lnTo>
                  <a:lnTo>
                    <a:pt x="229" y="155"/>
                  </a:lnTo>
                  <a:lnTo>
                    <a:pt x="239" y="155"/>
                  </a:lnTo>
                  <a:lnTo>
                    <a:pt x="245" y="155"/>
                  </a:lnTo>
                  <a:lnTo>
                    <a:pt x="255" y="155"/>
                  </a:lnTo>
                  <a:lnTo>
                    <a:pt x="263" y="155"/>
                  </a:lnTo>
                  <a:lnTo>
                    <a:pt x="270" y="155"/>
                  </a:lnTo>
                  <a:lnTo>
                    <a:pt x="279" y="155"/>
                  </a:lnTo>
                  <a:lnTo>
                    <a:pt x="288" y="155"/>
                  </a:lnTo>
                  <a:lnTo>
                    <a:pt x="294" y="155"/>
                  </a:lnTo>
                  <a:lnTo>
                    <a:pt x="304" y="155"/>
                  </a:lnTo>
                  <a:lnTo>
                    <a:pt x="310" y="155"/>
                  </a:lnTo>
                  <a:lnTo>
                    <a:pt x="320" y="155"/>
                  </a:lnTo>
                  <a:lnTo>
                    <a:pt x="327" y="155"/>
                  </a:lnTo>
                  <a:lnTo>
                    <a:pt x="335" y="165"/>
                  </a:lnTo>
                  <a:lnTo>
                    <a:pt x="345" y="163"/>
                  </a:lnTo>
                  <a:lnTo>
                    <a:pt x="353" y="163"/>
                  </a:lnTo>
                  <a:lnTo>
                    <a:pt x="359" y="162"/>
                  </a:lnTo>
                  <a:lnTo>
                    <a:pt x="369" y="162"/>
                  </a:lnTo>
                  <a:lnTo>
                    <a:pt x="377" y="160"/>
                  </a:lnTo>
                  <a:lnTo>
                    <a:pt x="384" y="160"/>
                  </a:lnTo>
                  <a:lnTo>
                    <a:pt x="392" y="158"/>
                  </a:lnTo>
                  <a:lnTo>
                    <a:pt x="402" y="158"/>
                  </a:lnTo>
                  <a:lnTo>
                    <a:pt x="410" y="157"/>
                  </a:lnTo>
                  <a:lnTo>
                    <a:pt x="417" y="157"/>
                  </a:lnTo>
                  <a:lnTo>
                    <a:pt x="426" y="157"/>
                  </a:lnTo>
                  <a:lnTo>
                    <a:pt x="434" y="155"/>
                  </a:lnTo>
                  <a:lnTo>
                    <a:pt x="443" y="155"/>
                  </a:lnTo>
                  <a:lnTo>
                    <a:pt x="449" y="154"/>
                  </a:lnTo>
                  <a:lnTo>
                    <a:pt x="457" y="154"/>
                  </a:lnTo>
                  <a:lnTo>
                    <a:pt x="466" y="152"/>
                  </a:lnTo>
                  <a:lnTo>
                    <a:pt x="474" y="152"/>
                  </a:lnTo>
                  <a:lnTo>
                    <a:pt x="483" y="150"/>
                  </a:lnTo>
                  <a:lnTo>
                    <a:pt x="492" y="150"/>
                  </a:lnTo>
                  <a:lnTo>
                    <a:pt x="500" y="149"/>
                  </a:lnTo>
                  <a:lnTo>
                    <a:pt x="508" y="149"/>
                  </a:lnTo>
                  <a:lnTo>
                    <a:pt x="514" y="149"/>
                  </a:lnTo>
                  <a:lnTo>
                    <a:pt x="524" y="147"/>
                  </a:lnTo>
                  <a:lnTo>
                    <a:pt x="531" y="147"/>
                  </a:lnTo>
                  <a:lnTo>
                    <a:pt x="541" y="145"/>
                  </a:lnTo>
                  <a:lnTo>
                    <a:pt x="547" y="145"/>
                  </a:lnTo>
                  <a:lnTo>
                    <a:pt x="557" y="144"/>
                  </a:lnTo>
                  <a:lnTo>
                    <a:pt x="563" y="144"/>
                  </a:lnTo>
                  <a:lnTo>
                    <a:pt x="572" y="142"/>
                  </a:lnTo>
                  <a:lnTo>
                    <a:pt x="581" y="142"/>
                  </a:lnTo>
                  <a:lnTo>
                    <a:pt x="588" y="142"/>
                  </a:lnTo>
                  <a:lnTo>
                    <a:pt x="598" y="140"/>
                  </a:lnTo>
                  <a:lnTo>
                    <a:pt x="604" y="140"/>
                  </a:lnTo>
                  <a:lnTo>
                    <a:pt x="614" y="139"/>
                  </a:lnTo>
                  <a:lnTo>
                    <a:pt x="621" y="139"/>
                  </a:lnTo>
                  <a:lnTo>
                    <a:pt x="629" y="137"/>
                  </a:lnTo>
                  <a:lnTo>
                    <a:pt x="638" y="137"/>
                  </a:lnTo>
                  <a:lnTo>
                    <a:pt x="645" y="136"/>
                  </a:lnTo>
                  <a:lnTo>
                    <a:pt x="655" y="136"/>
                  </a:lnTo>
                  <a:lnTo>
                    <a:pt x="661" y="136"/>
                  </a:lnTo>
                  <a:lnTo>
                    <a:pt x="671" y="134"/>
                  </a:lnTo>
                  <a:lnTo>
                    <a:pt x="678" y="134"/>
                  </a:lnTo>
                  <a:lnTo>
                    <a:pt x="686" y="132"/>
                  </a:lnTo>
                  <a:lnTo>
                    <a:pt x="696" y="132"/>
                  </a:lnTo>
                  <a:lnTo>
                    <a:pt x="704" y="131"/>
                  </a:lnTo>
                  <a:lnTo>
                    <a:pt x="710" y="131"/>
                  </a:lnTo>
                  <a:lnTo>
                    <a:pt x="718" y="131"/>
                  </a:lnTo>
                  <a:lnTo>
                    <a:pt x="728" y="129"/>
                  </a:lnTo>
                  <a:lnTo>
                    <a:pt x="736" y="129"/>
                  </a:lnTo>
                  <a:lnTo>
                    <a:pt x="743" y="127"/>
                  </a:lnTo>
                  <a:lnTo>
                    <a:pt x="751" y="127"/>
                  </a:lnTo>
                  <a:lnTo>
                    <a:pt x="759" y="126"/>
                  </a:lnTo>
                  <a:lnTo>
                    <a:pt x="769" y="126"/>
                  </a:lnTo>
                  <a:lnTo>
                    <a:pt x="777" y="124"/>
                  </a:lnTo>
                  <a:lnTo>
                    <a:pt x="784" y="124"/>
                  </a:lnTo>
                  <a:lnTo>
                    <a:pt x="792" y="124"/>
                  </a:lnTo>
                  <a:lnTo>
                    <a:pt x="802" y="123"/>
                  </a:lnTo>
                  <a:lnTo>
                    <a:pt x="810" y="123"/>
                  </a:lnTo>
                  <a:lnTo>
                    <a:pt x="818" y="121"/>
                  </a:lnTo>
                  <a:lnTo>
                    <a:pt x="824" y="121"/>
                  </a:lnTo>
                  <a:lnTo>
                    <a:pt x="833" y="119"/>
                  </a:lnTo>
                  <a:lnTo>
                    <a:pt x="842" y="119"/>
                  </a:lnTo>
                  <a:lnTo>
                    <a:pt x="851" y="119"/>
                  </a:lnTo>
                  <a:lnTo>
                    <a:pt x="857" y="118"/>
                  </a:lnTo>
                  <a:lnTo>
                    <a:pt x="865" y="118"/>
                  </a:lnTo>
                  <a:lnTo>
                    <a:pt x="873" y="116"/>
                  </a:lnTo>
                  <a:lnTo>
                    <a:pt x="883" y="116"/>
                  </a:lnTo>
                  <a:lnTo>
                    <a:pt x="891" y="114"/>
                  </a:lnTo>
                  <a:lnTo>
                    <a:pt x="898" y="114"/>
                  </a:lnTo>
                  <a:lnTo>
                    <a:pt x="906" y="114"/>
                  </a:lnTo>
                  <a:lnTo>
                    <a:pt x="916" y="113"/>
                  </a:lnTo>
                  <a:lnTo>
                    <a:pt x="924" y="113"/>
                  </a:lnTo>
                  <a:lnTo>
                    <a:pt x="932" y="111"/>
                  </a:lnTo>
                  <a:lnTo>
                    <a:pt x="939" y="111"/>
                  </a:lnTo>
                  <a:lnTo>
                    <a:pt x="947" y="109"/>
                  </a:lnTo>
                  <a:lnTo>
                    <a:pt x="957" y="109"/>
                  </a:lnTo>
                  <a:lnTo>
                    <a:pt x="965" y="109"/>
                  </a:lnTo>
                  <a:lnTo>
                    <a:pt x="971" y="108"/>
                  </a:lnTo>
                  <a:lnTo>
                    <a:pt x="979" y="108"/>
                  </a:lnTo>
                  <a:lnTo>
                    <a:pt x="988" y="106"/>
                  </a:lnTo>
                  <a:lnTo>
                    <a:pt x="997" y="106"/>
                  </a:lnTo>
                  <a:lnTo>
                    <a:pt x="1006" y="105"/>
                  </a:lnTo>
                  <a:lnTo>
                    <a:pt x="1012" y="105"/>
                  </a:lnTo>
                  <a:lnTo>
                    <a:pt x="1020" y="105"/>
                  </a:lnTo>
                  <a:lnTo>
                    <a:pt x="1030" y="103"/>
                  </a:lnTo>
                  <a:lnTo>
                    <a:pt x="1038" y="103"/>
                  </a:lnTo>
                  <a:lnTo>
                    <a:pt x="1046" y="101"/>
                  </a:lnTo>
                  <a:lnTo>
                    <a:pt x="1055" y="101"/>
                  </a:lnTo>
                  <a:lnTo>
                    <a:pt x="1063" y="101"/>
                  </a:lnTo>
                  <a:lnTo>
                    <a:pt x="1069" y="100"/>
                  </a:lnTo>
                  <a:lnTo>
                    <a:pt x="1077" y="100"/>
                  </a:lnTo>
                  <a:lnTo>
                    <a:pt x="1086" y="98"/>
                  </a:lnTo>
                  <a:lnTo>
                    <a:pt x="1094" y="98"/>
                  </a:lnTo>
                  <a:lnTo>
                    <a:pt x="1104" y="96"/>
                  </a:lnTo>
                  <a:lnTo>
                    <a:pt x="1112" y="96"/>
                  </a:lnTo>
                  <a:lnTo>
                    <a:pt x="1120" y="96"/>
                  </a:lnTo>
                  <a:lnTo>
                    <a:pt x="1128" y="95"/>
                  </a:lnTo>
                  <a:lnTo>
                    <a:pt x="1136" y="95"/>
                  </a:lnTo>
                  <a:lnTo>
                    <a:pt x="1143" y="93"/>
                  </a:lnTo>
                  <a:lnTo>
                    <a:pt x="1151" y="93"/>
                  </a:lnTo>
                  <a:lnTo>
                    <a:pt x="1159" y="93"/>
                  </a:lnTo>
                  <a:lnTo>
                    <a:pt x="1167" y="92"/>
                  </a:lnTo>
                  <a:lnTo>
                    <a:pt x="1175" y="92"/>
                  </a:lnTo>
                  <a:lnTo>
                    <a:pt x="1185" y="90"/>
                  </a:lnTo>
                  <a:lnTo>
                    <a:pt x="1193" y="90"/>
                  </a:lnTo>
                  <a:lnTo>
                    <a:pt x="1201" y="88"/>
                  </a:lnTo>
                  <a:lnTo>
                    <a:pt x="1210" y="88"/>
                  </a:lnTo>
                  <a:lnTo>
                    <a:pt x="1216" y="88"/>
                  </a:lnTo>
                  <a:lnTo>
                    <a:pt x="1224" y="87"/>
                  </a:lnTo>
                  <a:lnTo>
                    <a:pt x="1232" y="87"/>
                  </a:lnTo>
                  <a:lnTo>
                    <a:pt x="1241" y="85"/>
                  </a:lnTo>
                  <a:lnTo>
                    <a:pt x="1249" y="85"/>
                  </a:lnTo>
                  <a:lnTo>
                    <a:pt x="1259" y="85"/>
                  </a:lnTo>
                  <a:lnTo>
                    <a:pt x="1267" y="83"/>
                  </a:lnTo>
                  <a:lnTo>
                    <a:pt x="1275" y="83"/>
                  </a:lnTo>
                  <a:lnTo>
                    <a:pt x="1283" y="82"/>
                  </a:lnTo>
                  <a:lnTo>
                    <a:pt x="1291" y="82"/>
                  </a:lnTo>
                  <a:lnTo>
                    <a:pt x="1298" y="82"/>
                  </a:lnTo>
                  <a:lnTo>
                    <a:pt x="1306" y="80"/>
                  </a:lnTo>
                  <a:lnTo>
                    <a:pt x="1314" y="80"/>
                  </a:lnTo>
                  <a:lnTo>
                    <a:pt x="1322" y="79"/>
                  </a:lnTo>
                  <a:lnTo>
                    <a:pt x="1332" y="79"/>
                  </a:lnTo>
                  <a:lnTo>
                    <a:pt x="1340" y="77"/>
                  </a:lnTo>
                  <a:lnTo>
                    <a:pt x="1348" y="77"/>
                  </a:lnTo>
                  <a:lnTo>
                    <a:pt x="1356" y="77"/>
                  </a:lnTo>
                  <a:lnTo>
                    <a:pt x="1365" y="75"/>
                  </a:lnTo>
                  <a:lnTo>
                    <a:pt x="1371" y="75"/>
                  </a:lnTo>
                  <a:lnTo>
                    <a:pt x="1379" y="74"/>
                  </a:lnTo>
                  <a:lnTo>
                    <a:pt x="1387" y="74"/>
                  </a:lnTo>
                  <a:lnTo>
                    <a:pt x="1396" y="74"/>
                  </a:lnTo>
                  <a:lnTo>
                    <a:pt x="1405" y="72"/>
                  </a:lnTo>
                  <a:lnTo>
                    <a:pt x="1414" y="72"/>
                  </a:lnTo>
                  <a:lnTo>
                    <a:pt x="1422" y="70"/>
                  </a:lnTo>
                  <a:lnTo>
                    <a:pt x="1430" y="70"/>
                  </a:lnTo>
                  <a:lnTo>
                    <a:pt x="1438" y="70"/>
                  </a:lnTo>
                  <a:lnTo>
                    <a:pt x="1445" y="69"/>
                  </a:lnTo>
                  <a:lnTo>
                    <a:pt x="1453" y="69"/>
                  </a:lnTo>
                  <a:lnTo>
                    <a:pt x="1461" y="67"/>
                  </a:lnTo>
                  <a:lnTo>
                    <a:pt x="1469" y="67"/>
                  </a:lnTo>
                  <a:lnTo>
                    <a:pt x="1477" y="67"/>
                  </a:lnTo>
                  <a:lnTo>
                    <a:pt x="1487" y="65"/>
                  </a:lnTo>
                  <a:lnTo>
                    <a:pt x="1495" y="65"/>
                  </a:lnTo>
                  <a:lnTo>
                    <a:pt x="1503" y="64"/>
                  </a:lnTo>
                  <a:lnTo>
                    <a:pt x="1511" y="64"/>
                  </a:lnTo>
                  <a:lnTo>
                    <a:pt x="1518" y="64"/>
                  </a:lnTo>
                  <a:lnTo>
                    <a:pt x="1526" y="62"/>
                  </a:lnTo>
                  <a:lnTo>
                    <a:pt x="1534" y="62"/>
                  </a:lnTo>
                  <a:lnTo>
                    <a:pt x="1542" y="61"/>
                  </a:lnTo>
                  <a:lnTo>
                    <a:pt x="1551" y="61"/>
                  </a:lnTo>
                  <a:lnTo>
                    <a:pt x="1560" y="61"/>
                  </a:lnTo>
                  <a:lnTo>
                    <a:pt x="1569" y="59"/>
                  </a:lnTo>
                  <a:lnTo>
                    <a:pt x="1577" y="59"/>
                  </a:lnTo>
                  <a:lnTo>
                    <a:pt x="1585" y="57"/>
                  </a:lnTo>
                  <a:lnTo>
                    <a:pt x="1593" y="57"/>
                  </a:lnTo>
                  <a:lnTo>
                    <a:pt x="1600" y="57"/>
                  </a:lnTo>
                  <a:lnTo>
                    <a:pt x="1608" y="56"/>
                  </a:lnTo>
                  <a:lnTo>
                    <a:pt x="1616" y="56"/>
                  </a:lnTo>
                  <a:lnTo>
                    <a:pt x="1624" y="56"/>
                  </a:lnTo>
                  <a:lnTo>
                    <a:pt x="1634" y="54"/>
                  </a:lnTo>
                  <a:lnTo>
                    <a:pt x="1642" y="54"/>
                  </a:lnTo>
                  <a:lnTo>
                    <a:pt x="1650" y="52"/>
                  </a:lnTo>
                  <a:lnTo>
                    <a:pt x="1658" y="52"/>
                  </a:lnTo>
                  <a:lnTo>
                    <a:pt x="1666" y="52"/>
                  </a:lnTo>
                  <a:lnTo>
                    <a:pt x="1673" y="51"/>
                  </a:lnTo>
                  <a:lnTo>
                    <a:pt x="1681" y="51"/>
                  </a:lnTo>
                  <a:lnTo>
                    <a:pt x="1689" y="49"/>
                  </a:lnTo>
                  <a:lnTo>
                    <a:pt x="1697" y="49"/>
                  </a:lnTo>
                  <a:lnTo>
                    <a:pt x="1707" y="49"/>
                  </a:lnTo>
                  <a:lnTo>
                    <a:pt x="1715" y="48"/>
                  </a:lnTo>
                  <a:lnTo>
                    <a:pt x="1724" y="48"/>
                  </a:lnTo>
                  <a:lnTo>
                    <a:pt x="1732" y="46"/>
                  </a:lnTo>
                  <a:lnTo>
                    <a:pt x="1740" y="46"/>
                  </a:lnTo>
                  <a:lnTo>
                    <a:pt x="1746" y="46"/>
                  </a:lnTo>
                  <a:lnTo>
                    <a:pt x="1756" y="44"/>
                  </a:lnTo>
                  <a:lnTo>
                    <a:pt x="1763" y="44"/>
                  </a:lnTo>
                  <a:lnTo>
                    <a:pt x="1773" y="44"/>
                  </a:lnTo>
                  <a:lnTo>
                    <a:pt x="1779" y="43"/>
                  </a:lnTo>
                  <a:lnTo>
                    <a:pt x="1787" y="43"/>
                  </a:lnTo>
                  <a:lnTo>
                    <a:pt x="1797" y="41"/>
                  </a:lnTo>
                  <a:lnTo>
                    <a:pt x="1804" y="41"/>
                  </a:lnTo>
                  <a:lnTo>
                    <a:pt x="1813" y="41"/>
                  </a:lnTo>
                  <a:lnTo>
                    <a:pt x="1820" y="39"/>
                  </a:lnTo>
                  <a:lnTo>
                    <a:pt x="1830" y="39"/>
                  </a:lnTo>
                  <a:lnTo>
                    <a:pt x="1836" y="38"/>
                  </a:lnTo>
                  <a:lnTo>
                    <a:pt x="1846" y="38"/>
                  </a:lnTo>
                  <a:lnTo>
                    <a:pt x="1852" y="38"/>
                  </a:lnTo>
                  <a:lnTo>
                    <a:pt x="1861" y="36"/>
                  </a:lnTo>
                  <a:lnTo>
                    <a:pt x="1870" y="36"/>
                  </a:lnTo>
                  <a:lnTo>
                    <a:pt x="1877" y="36"/>
                  </a:lnTo>
                  <a:lnTo>
                    <a:pt x="1887" y="34"/>
                  </a:lnTo>
                  <a:lnTo>
                    <a:pt x="1893" y="34"/>
                  </a:lnTo>
                  <a:lnTo>
                    <a:pt x="1903" y="33"/>
                  </a:lnTo>
                  <a:lnTo>
                    <a:pt x="1910" y="33"/>
                  </a:lnTo>
                  <a:lnTo>
                    <a:pt x="1919" y="33"/>
                  </a:lnTo>
                  <a:lnTo>
                    <a:pt x="1926" y="31"/>
                  </a:lnTo>
                  <a:lnTo>
                    <a:pt x="1934" y="31"/>
                  </a:lnTo>
                  <a:lnTo>
                    <a:pt x="1944" y="31"/>
                  </a:lnTo>
                  <a:lnTo>
                    <a:pt x="1950" y="30"/>
                  </a:lnTo>
                  <a:lnTo>
                    <a:pt x="1960" y="30"/>
                  </a:lnTo>
                  <a:lnTo>
                    <a:pt x="1967" y="28"/>
                  </a:lnTo>
                  <a:lnTo>
                    <a:pt x="1976" y="28"/>
                  </a:lnTo>
                  <a:lnTo>
                    <a:pt x="1983" y="28"/>
                  </a:lnTo>
                  <a:lnTo>
                    <a:pt x="1993" y="26"/>
                  </a:lnTo>
                  <a:lnTo>
                    <a:pt x="1999" y="26"/>
                  </a:lnTo>
                  <a:lnTo>
                    <a:pt x="2007" y="26"/>
                  </a:lnTo>
                  <a:lnTo>
                    <a:pt x="2017" y="25"/>
                  </a:lnTo>
                  <a:lnTo>
                    <a:pt x="2024" y="25"/>
                  </a:lnTo>
                  <a:lnTo>
                    <a:pt x="2034" y="23"/>
                  </a:lnTo>
                  <a:lnTo>
                    <a:pt x="2040" y="23"/>
                  </a:lnTo>
                  <a:lnTo>
                    <a:pt x="2050" y="23"/>
                  </a:lnTo>
                  <a:lnTo>
                    <a:pt x="2056" y="21"/>
                  </a:lnTo>
                  <a:lnTo>
                    <a:pt x="2066" y="21"/>
                  </a:lnTo>
                  <a:lnTo>
                    <a:pt x="2073" y="21"/>
                  </a:lnTo>
                  <a:lnTo>
                    <a:pt x="2083" y="20"/>
                  </a:lnTo>
                  <a:lnTo>
                    <a:pt x="2091" y="20"/>
                  </a:lnTo>
                  <a:lnTo>
                    <a:pt x="2097" y="18"/>
                  </a:lnTo>
                  <a:lnTo>
                    <a:pt x="2107" y="18"/>
                  </a:lnTo>
                  <a:lnTo>
                    <a:pt x="2114" y="18"/>
                  </a:lnTo>
                  <a:lnTo>
                    <a:pt x="2123" y="17"/>
                  </a:lnTo>
                  <a:lnTo>
                    <a:pt x="2130" y="17"/>
                  </a:lnTo>
                  <a:lnTo>
                    <a:pt x="2140" y="17"/>
                  </a:lnTo>
                  <a:lnTo>
                    <a:pt x="2146" y="15"/>
                  </a:lnTo>
                  <a:lnTo>
                    <a:pt x="2156" y="15"/>
                  </a:lnTo>
                  <a:lnTo>
                    <a:pt x="2164" y="13"/>
                  </a:lnTo>
                  <a:lnTo>
                    <a:pt x="2171" y="13"/>
                  </a:lnTo>
                  <a:lnTo>
                    <a:pt x="2180" y="13"/>
                  </a:lnTo>
                  <a:lnTo>
                    <a:pt x="2187" y="12"/>
                  </a:lnTo>
                  <a:lnTo>
                    <a:pt x="2197" y="12"/>
                  </a:lnTo>
                  <a:lnTo>
                    <a:pt x="2203" y="12"/>
                  </a:lnTo>
                  <a:lnTo>
                    <a:pt x="2213" y="10"/>
                  </a:lnTo>
                  <a:lnTo>
                    <a:pt x="2220" y="0"/>
                  </a:lnTo>
                  <a:lnTo>
                    <a:pt x="2229" y="0"/>
                  </a:lnTo>
                  <a:lnTo>
                    <a:pt x="2238" y="0"/>
                  </a:lnTo>
                  <a:lnTo>
                    <a:pt x="2244" y="0"/>
                  </a:lnTo>
                  <a:lnTo>
                    <a:pt x="2254" y="2"/>
                  </a:lnTo>
                  <a:lnTo>
                    <a:pt x="2260" y="2"/>
                  </a:lnTo>
                  <a:lnTo>
                    <a:pt x="2270" y="2"/>
                  </a:lnTo>
                  <a:lnTo>
                    <a:pt x="2277" y="2"/>
                  </a:lnTo>
                  <a:lnTo>
                    <a:pt x="2287" y="2"/>
                  </a:lnTo>
                  <a:lnTo>
                    <a:pt x="2293" y="2"/>
                  </a:lnTo>
                  <a:lnTo>
                    <a:pt x="2303" y="2"/>
                  </a:lnTo>
                  <a:lnTo>
                    <a:pt x="2311" y="2"/>
                  </a:lnTo>
                  <a:lnTo>
                    <a:pt x="2318" y="2"/>
                  </a:lnTo>
                  <a:lnTo>
                    <a:pt x="2327" y="2"/>
                  </a:lnTo>
                  <a:lnTo>
                    <a:pt x="2334" y="2"/>
                  </a:lnTo>
                  <a:lnTo>
                    <a:pt x="2344" y="2"/>
                  </a:lnTo>
                  <a:lnTo>
                    <a:pt x="2350" y="2"/>
                  </a:lnTo>
                  <a:lnTo>
                    <a:pt x="2360" y="2"/>
                  </a:lnTo>
                  <a:lnTo>
                    <a:pt x="2366" y="2"/>
                  </a:lnTo>
                  <a:lnTo>
                    <a:pt x="2376" y="2"/>
                  </a:lnTo>
                  <a:lnTo>
                    <a:pt x="2383" y="2"/>
                  </a:lnTo>
                  <a:lnTo>
                    <a:pt x="2391" y="2"/>
                  </a:lnTo>
                  <a:lnTo>
                    <a:pt x="2401" y="2"/>
                  </a:lnTo>
                  <a:lnTo>
                    <a:pt x="2407" y="2"/>
                  </a:lnTo>
                  <a:lnTo>
                    <a:pt x="2417" y="2"/>
                  </a:lnTo>
                  <a:lnTo>
                    <a:pt x="2424" y="3"/>
                  </a:lnTo>
                  <a:lnTo>
                    <a:pt x="2433" y="3"/>
                  </a:lnTo>
                  <a:lnTo>
                    <a:pt x="2440" y="3"/>
                  </a:lnTo>
                  <a:lnTo>
                    <a:pt x="2450" y="3"/>
                  </a:lnTo>
                  <a:lnTo>
                    <a:pt x="2456" y="3"/>
                  </a:lnTo>
                  <a:lnTo>
                    <a:pt x="2464" y="3"/>
                  </a:lnTo>
                  <a:lnTo>
                    <a:pt x="2474" y="3"/>
                  </a:lnTo>
                  <a:lnTo>
                    <a:pt x="2481" y="3"/>
                  </a:lnTo>
                  <a:lnTo>
                    <a:pt x="2490" y="3"/>
                  </a:lnTo>
                  <a:lnTo>
                    <a:pt x="2497" y="3"/>
                  </a:lnTo>
                  <a:lnTo>
                    <a:pt x="2507" y="3"/>
                  </a:lnTo>
                  <a:lnTo>
                    <a:pt x="2513" y="3"/>
                  </a:lnTo>
                  <a:lnTo>
                    <a:pt x="2523" y="3"/>
                  </a:lnTo>
                  <a:lnTo>
                    <a:pt x="2530" y="3"/>
                  </a:lnTo>
                  <a:lnTo>
                    <a:pt x="2538" y="3"/>
                  </a:lnTo>
                  <a:lnTo>
                    <a:pt x="2548" y="3"/>
                  </a:lnTo>
                  <a:lnTo>
                    <a:pt x="2554" y="3"/>
                  </a:lnTo>
                  <a:lnTo>
                    <a:pt x="2564" y="3"/>
                  </a:lnTo>
                  <a:lnTo>
                    <a:pt x="2570" y="3"/>
                  </a:lnTo>
                  <a:lnTo>
                    <a:pt x="2580" y="3"/>
                  </a:lnTo>
                  <a:lnTo>
                    <a:pt x="2587" y="3"/>
                  </a:lnTo>
                  <a:lnTo>
                    <a:pt x="2597" y="5"/>
                  </a:lnTo>
                  <a:lnTo>
                    <a:pt x="2603" y="5"/>
                  </a:lnTo>
                  <a:lnTo>
                    <a:pt x="2611" y="5"/>
                  </a:lnTo>
                  <a:lnTo>
                    <a:pt x="2621" y="5"/>
                  </a:lnTo>
                  <a:lnTo>
                    <a:pt x="2628" y="5"/>
                  </a:lnTo>
                  <a:lnTo>
                    <a:pt x="2637" y="5"/>
                  </a:lnTo>
                  <a:lnTo>
                    <a:pt x="2644" y="5"/>
                  </a:lnTo>
                  <a:lnTo>
                    <a:pt x="2654" y="5"/>
                  </a:lnTo>
                  <a:lnTo>
                    <a:pt x="2660" y="5"/>
                  </a:lnTo>
                  <a:lnTo>
                    <a:pt x="2670" y="5"/>
                  </a:lnTo>
                  <a:lnTo>
                    <a:pt x="2676" y="5"/>
                  </a:lnTo>
                  <a:lnTo>
                    <a:pt x="2686" y="5"/>
                  </a:lnTo>
                  <a:lnTo>
                    <a:pt x="2694" y="5"/>
                  </a:lnTo>
                  <a:lnTo>
                    <a:pt x="2701" y="5"/>
                  </a:lnTo>
                  <a:lnTo>
                    <a:pt x="2711" y="5"/>
                  </a:lnTo>
                  <a:lnTo>
                    <a:pt x="2717" y="5"/>
                  </a:lnTo>
                  <a:lnTo>
                    <a:pt x="2727" y="5"/>
                  </a:lnTo>
                  <a:lnTo>
                    <a:pt x="2734" y="5"/>
                  </a:lnTo>
                  <a:lnTo>
                    <a:pt x="2743" y="5"/>
                  </a:lnTo>
                  <a:lnTo>
                    <a:pt x="2750" y="5"/>
                  </a:lnTo>
                  <a:lnTo>
                    <a:pt x="2760" y="5"/>
                  </a:lnTo>
                  <a:lnTo>
                    <a:pt x="2768" y="7"/>
                  </a:lnTo>
                  <a:lnTo>
                    <a:pt x="2774" y="7"/>
                  </a:lnTo>
                  <a:lnTo>
                    <a:pt x="2784" y="7"/>
                  </a:lnTo>
                  <a:lnTo>
                    <a:pt x="2791" y="7"/>
                  </a:lnTo>
                  <a:lnTo>
                    <a:pt x="2801" y="7"/>
                  </a:lnTo>
                  <a:lnTo>
                    <a:pt x="2807" y="7"/>
                  </a:lnTo>
                  <a:lnTo>
                    <a:pt x="2817" y="7"/>
                  </a:lnTo>
                  <a:lnTo>
                    <a:pt x="2823" y="7"/>
                  </a:lnTo>
                  <a:lnTo>
                    <a:pt x="2833" y="7"/>
                  </a:lnTo>
                  <a:lnTo>
                    <a:pt x="2841" y="7"/>
                  </a:lnTo>
                  <a:lnTo>
                    <a:pt x="2848" y="7"/>
                  </a:lnTo>
                  <a:lnTo>
                    <a:pt x="2858" y="7"/>
                  </a:lnTo>
                  <a:lnTo>
                    <a:pt x="2864" y="7"/>
                  </a:lnTo>
                  <a:lnTo>
                    <a:pt x="2874" y="7"/>
                  </a:lnTo>
                  <a:lnTo>
                    <a:pt x="2880" y="7"/>
                  </a:lnTo>
                  <a:lnTo>
                    <a:pt x="2890" y="7"/>
                  </a:lnTo>
                  <a:lnTo>
                    <a:pt x="2897" y="7"/>
                  </a:lnTo>
                  <a:lnTo>
                    <a:pt x="2907" y="7"/>
                  </a:lnTo>
                  <a:lnTo>
                    <a:pt x="2915" y="7"/>
                  </a:lnTo>
                  <a:lnTo>
                    <a:pt x="2921" y="7"/>
                  </a:lnTo>
                  <a:lnTo>
                    <a:pt x="2931" y="7"/>
                  </a:lnTo>
                  <a:lnTo>
                    <a:pt x="2938" y="8"/>
                  </a:lnTo>
                  <a:lnTo>
                    <a:pt x="2947" y="8"/>
                  </a:lnTo>
                  <a:lnTo>
                    <a:pt x="2954" y="8"/>
                  </a:lnTo>
                  <a:lnTo>
                    <a:pt x="2964" y="8"/>
                  </a:lnTo>
                  <a:lnTo>
                    <a:pt x="2970" y="8"/>
                  </a:lnTo>
                  <a:lnTo>
                    <a:pt x="2980" y="8"/>
                  </a:lnTo>
                  <a:lnTo>
                    <a:pt x="2987" y="8"/>
                  </a:lnTo>
                  <a:lnTo>
                    <a:pt x="2995" y="8"/>
                  </a:lnTo>
                  <a:lnTo>
                    <a:pt x="3004" y="8"/>
                  </a:lnTo>
                  <a:lnTo>
                    <a:pt x="3011" y="8"/>
                  </a:lnTo>
                  <a:lnTo>
                    <a:pt x="3021" y="8"/>
                  </a:lnTo>
                  <a:lnTo>
                    <a:pt x="3027" y="8"/>
                  </a:lnTo>
                  <a:lnTo>
                    <a:pt x="3037" y="8"/>
                  </a:lnTo>
                  <a:lnTo>
                    <a:pt x="3044" y="8"/>
                  </a:lnTo>
                  <a:lnTo>
                    <a:pt x="3053" y="8"/>
                  </a:lnTo>
                  <a:lnTo>
                    <a:pt x="3060" y="8"/>
                  </a:lnTo>
                  <a:lnTo>
                    <a:pt x="3068" y="8"/>
                  </a:lnTo>
                  <a:lnTo>
                    <a:pt x="3078" y="8"/>
                  </a:lnTo>
                  <a:lnTo>
                    <a:pt x="3084" y="8"/>
                  </a:lnTo>
                  <a:lnTo>
                    <a:pt x="3094" y="8"/>
                  </a:lnTo>
                  <a:lnTo>
                    <a:pt x="3101" y="8"/>
                  </a:lnTo>
                  <a:lnTo>
                    <a:pt x="3111" y="8"/>
                  </a:lnTo>
                  <a:lnTo>
                    <a:pt x="3117" y="10"/>
                  </a:lnTo>
                  <a:lnTo>
                    <a:pt x="3127" y="10"/>
                  </a:lnTo>
                  <a:lnTo>
                    <a:pt x="3133" y="10"/>
                  </a:lnTo>
                  <a:lnTo>
                    <a:pt x="3142" y="10"/>
                  </a:lnTo>
                  <a:lnTo>
                    <a:pt x="3150" y="10"/>
                  </a:lnTo>
                  <a:lnTo>
                    <a:pt x="3158" y="10"/>
                  </a:lnTo>
                  <a:lnTo>
                    <a:pt x="3168" y="10"/>
                  </a:lnTo>
                  <a:lnTo>
                    <a:pt x="3176" y="10"/>
                  </a:lnTo>
                  <a:lnTo>
                    <a:pt x="3182" y="10"/>
                  </a:lnTo>
                  <a:lnTo>
                    <a:pt x="3190" y="10"/>
                  </a:lnTo>
                  <a:lnTo>
                    <a:pt x="3200" y="10"/>
                  </a:lnTo>
                  <a:lnTo>
                    <a:pt x="3208" y="10"/>
                  </a:lnTo>
                  <a:lnTo>
                    <a:pt x="3215" y="10"/>
                  </a:lnTo>
                  <a:lnTo>
                    <a:pt x="3225" y="10"/>
                  </a:lnTo>
                  <a:lnTo>
                    <a:pt x="3233" y="10"/>
                  </a:lnTo>
                  <a:lnTo>
                    <a:pt x="3239" y="10"/>
                  </a:lnTo>
                  <a:lnTo>
                    <a:pt x="3248" y="10"/>
                  </a:lnTo>
                  <a:lnTo>
                    <a:pt x="3257" y="10"/>
                  </a:lnTo>
                  <a:lnTo>
                    <a:pt x="3266" y="10"/>
                  </a:lnTo>
                  <a:lnTo>
                    <a:pt x="3272" y="10"/>
                  </a:lnTo>
                  <a:lnTo>
                    <a:pt x="3280" y="10"/>
                  </a:lnTo>
                  <a:lnTo>
                    <a:pt x="3290" y="10"/>
                  </a:lnTo>
                  <a:lnTo>
                    <a:pt x="3297" y="12"/>
                  </a:lnTo>
                  <a:lnTo>
                    <a:pt x="3305" y="12"/>
                  </a:lnTo>
                  <a:lnTo>
                    <a:pt x="3314" y="12"/>
                  </a:lnTo>
                  <a:lnTo>
                    <a:pt x="3323" y="12"/>
                  </a:lnTo>
                  <a:lnTo>
                    <a:pt x="3329" y="12"/>
                  </a:lnTo>
                  <a:lnTo>
                    <a:pt x="3337" y="12"/>
                  </a:lnTo>
                  <a:lnTo>
                    <a:pt x="3347" y="12"/>
                  </a:lnTo>
                  <a:lnTo>
                    <a:pt x="3355" y="12"/>
                  </a:lnTo>
                  <a:lnTo>
                    <a:pt x="3362" y="12"/>
                  </a:lnTo>
                  <a:lnTo>
                    <a:pt x="3372" y="12"/>
                  </a:lnTo>
                  <a:lnTo>
                    <a:pt x="3380" y="12"/>
                  </a:lnTo>
                  <a:lnTo>
                    <a:pt x="3386" y="12"/>
                  </a:lnTo>
                  <a:lnTo>
                    <a:pt x="3394" y="12"/>
                  </a:lnTo>
                  <a:lnTo>
                    <a:pt x="3404" y="12"/>
                  </a:lnTo>
                  <a:lnTo>
                    <a:pt x="3412" y="12"/>
                  </a:lnTo>
                  <a:lnTo>
                    <a:pt x="3419" y="12"/>
                  </a:lnTo>
                  <a:lnTo>
                    <a:pt x="3427" y="12"/>
                  </a:lnTo>
                  <a:lnTo>
                    <a:pt x="3437" y="12"/>
                  </a:lnTo>
                  <a:lnTo>
                    <a:pt x="3443" y="12"/>
                  </a:lnTo>
                  <a:lnTo>
                    <a:pt x="3452" y="12"/>
                  </a:lnTo>
                  <a:lnTo>
                    <a:pt x="3461" y="12"/>
                  </a:lnTo>
                  <a:lnTo>
                    <a:pt x="3470" y="12"/>
                  </a:lnTo>
                  <a:lnTo>
                    <a:pt x="3476" y="12"/>
                  </a:lnTo>
                  <a:lnTo>
                    <a:pt x="3484" y="13"/>
                  </a:lnTo>
                  <a:lnTo>
                    <a:pt x="3494" y="13"/>
                  </a:lnTo>
                  <a:lnTo>
                    <a:pt x="3502" y="13"/>
                  </a:lnTo>
                  <a:lnTo>
                    <a:pt x="3509" y="13"/>
                  </a:lnTo>
                  <a:lnTo>
                    <a:pt x="3518" y="13"/>
                  </a:lnTo>
                  <a:lnTo>
                    <a:pt x="3527" y="13"/>
                  </a:lnTo>
                  <a:lnTo>
                    <a:pt x="3533" y="13"/>
                  </a:lnTo>
                  <a:lnTo>
                    <a:pt x="3541" y="13"/>
                  </a:lnTo>
                  <a:lnTo>
                    <a:pt x="3551" y="13"/>
                  </a:lnTo>
                  <a:lnTo>
                    <a:pt x="3559" y="13"/>
                  </a:lnTo>
                  <a:lnTo>
                    <a:pt x="3566" y="13"/>
                  </a:lnTo>
                  <a:lnTo>
                    <a:pt x="3574" y="13"/>
                  </a:lnTo>
                  <a:lnTo>
                    <a:pt x="3584" y="13"/>
                  </a:lnTo>
                  <a:lnTo>
                    <a:pt x="3592" y="13"/>
                  </a:lnTo>
                  <a:lnTo>
                    <a:pt x="3598" y="13"/>
                  </a:lnTo>
                  <a:lnTo>
                    <a:pt x="3608" y="13"/>
                  </a:lnTo>
                  <a:lnTo>
                    <a:pt x="3616" y="13"/>
                  </a:lnTo>
                  <a:lnTo>
                    <a:pt x="3623" y="13"/>
                  </a:lnTo>
                  <a:lnTo>
                    <a:pt x="3631" y="13"/>
                  </a:lnTo>
                  <a:lnTo>
                    <a:pt x="3641" y="13"/>
                  </a:lnTo>
                  <a:lnTo>
                    <a:pt x="3649" y="13"/>
                  </a:lnTo>
                  <a:lnTo>
                    <a:pt x="3656" y="13"/>
                  </a:lnTo>
                  <a:lnTo>
                    <a:pt x="3664" y="15"/>
                  </a:lnTo>
                  <a:lnTo>
                    <a:pt x="3673" y="15"/>
                  </a:lnTo>
                  <a:lnTo>
                    <a:pt x="3680" y="15"/>
                  </a:lnTo>
                  <a:lnTo>
                    <a:pt x="3688" y="15"/>
                  </a:lnTo>
                  <a:lnTo>
                    <a:pt x="3698" y="15"/>
                  </a:lnTo>
                  <a:lnTo>
                    <a:pt x="3706" y="15"/>
                  </a:lnTo>
                  <a:lnTo>
                    <a:pt x="3713" y="15"/>
                  </a:lnTo>
                  <a:lnTo>
                    <a:pt x="3721" y="15"/>
                  </a:lnTo>
                  <a:lnTo>
                    <a:pt x="3731" y="15"/>
                  </a:lnTo>
                  <a:lnTo>
                    <a:pt x="3739" y="15"/>
                  </a:lnTo>
                  <a:lnTo>
                    <a:pt x="3745" y="15"/>
                  </a:lnTo>
                  <a:lnTo>
                    <a:pt x="3755" y="15"/>
                  </a:lnTo>
                  <a:lnTo>
                    <a:pt x="3763" y="15"/>
                  </a:lnTo>
                  <a:lnTo>
                    <a:pt x="3770" y="15"/>
                  </a:lnTo>
                  <a:lnTo>
                    <a:pt x="3778" y="15"/>
                  </a:lnTo>
                  <a:lnTo>
                    <a:pt x="3788" y="15"/>
                  </a:lnTo>
                  <a:lnTo>
                    <a:pt x="3796" y="15"/>
                  </a:lnTo>
                  <a:lnTo>
                    <a:pt x="3802" y="15"/>
                  </a:lnTo>
                  <a:lnTo>
                    <a:pt x="3811" y="15"/>
                  </a:lnTo>
                  <a:lnTo>
                    <a:pt x="3820" y="15"/>
                  </a:lnTo>
                  <a:lnTo>
                    <a:pt x="3827" y="15"/>
                  </a:lnTo>
                  <a:lnTo>
                    <a:pt x="3835" y="15"/>
                  </a:lnTo>
                  <a:lnTo>
                    <a:pt x="3845" y="15"/>
                  </a:lnTo>
                  <a:lnTo>
                    <a:pt x="3853" y="17"/>
                  </a:lnTo>
                  <a:lnTo>
                    <a:pt x="3859" y="17"/>
                  </a:lnTo>
                  <a:lnTo>
                    <a:pt x="3868" y="17"/>
                  </a:lnTo>
                  <a:lnTo>
                    <a:pt x="3877" y="17"/>
                  </a:lnTo>
                  <a:lnTo>
                    <a:pt x="3886" y="17"/>
                  </a:lnTo>
                  <a:lnTo>
                    <a:pt x="3892" y="17"/>
                  </a:lnTo>
                  <a:lnTo>
                    <a:pt x="3902" y="17"/>
                  </a:lnTo>
                  <a:lnTo>
                    <a:pt x="3910" y="17"/>
                  </a:lnTo>
                  <a:lnTo>
                    <a:pt x="3917" y="17"/>
                  </a:lnTo>
                  <a:lnTo>
                    <a:pt x="3925" y="17"/>
                  </a:lnTo>
                  <a:lnTo>
                    <a:pt x="3935" y="17"/>
                  </a:lnTo>
                  <a:lnTo>
                    <a:pt x="3943" y="17"/>
                  </a:lnTo>
                  <a:lnTo>
                    <a:pt x="3949" y="17"/>
                  </a:lnTo>
                  <a:lnTo>
                    <a:pt x="3957" y="17"/>
                  </a:lnTo>
                  <a:lnTo>
                    <a:pt x="3967" y="17"/>
                  </a:lnTo>
                  <a:lnTo>
                    <a:pt x="3974" y="17"/>
                  </a:lnTo>
                  <a:lnTo>
                    <a:pt x="3982" y="17"/>
                  </a:lnTo>
                  <a:lnTo>
                    <a:pt x="3992" y="17"/>
                  </a:lnTo>
                  <a:lnTo>
                    <a:pt x="4000" y="17"/>
                  </a:lnTo>
                  <a:lnTo>
                    <a:pt x="4006" y="17"/>
                  </a:lnTo>
                  <a:lnTo>
                    <a:pt x="4015" y="17"/>
                  </a:lnTo>
                  <a:lnTo>
                    <a:pt x="4024" y="17"/>
                  </a:lnTo>
                  <a:lnTo>
                    <a:pt x="4032" y="17"/>
                  </a:lnTo>
                  <a:lnTo>
                    <a:pt x="4039" y="18"/>
                  </a:lnTo>
                  <a:lnTo>
                    <a:pt x="4049" y="18"/>
                  </a:lnTo>
                  <a:lnTo>
                    <a:pt x="4057" y="18"/>
                  </a:lnTo>
                  <a:lnTo>
                    <a:pt x="4063" y="18"/>
                  </a:lnTo>
                  <a:lnTo>
                    <a:pt x="4072" y="18"/>
                  </a:lnTo>
                  <a:lnTo>
                    <a:pt x="4081" y="18"/>
                  </a:lnTo>
                  <a:lnTo>
                    <a:pt x="4090" y="18"/>
                  </a:lnTo>
                  <a:lnTo>
                    <a:pt x="4096" y="18"/>
                  </a:lnTo>
                  <a:lnTo>
                    <a:pt x="4104" y="18"/>
                  </a:lnTo>
                  <a:lnTo>
                    <a:pt x="4114" y="18"/>
                  </a:lnTo>
                  <a:lnTo>
                    <a:pt x="4121" y="18"/>
                  </a:lnTo>
                  <a:lnTo>
                    <a:pt x="4129" y="18"/>
                  </a:lnTo>
                  <a:lnTo>
                    <a:pt x="4139" y="18"/>
                  </a:lnTo>
                  <a:lnTo>
                    <a:pt x="4147" y="18"/>
                  </a:lnTo>
                  <a:lnTo>
                    <a:pt x="4153" y="18"/>
                  </a:lnTo>
                  <a:lnTo>
                    <a:pt x="4161" y="18"/>
                  </a:lnTo>
                  <a:lnTo>
                    <a:pt x="4171" y="18"/>
                  </a:lnTo>
                  <a:lnTo>
                    <a:pt x="4179" y="18"/>
                  </a:lnTo>
                  <a:lnTo>
                    <a:pt x="4186" y="18"/>
                  </a:lnTo>
                  <a:lnTo>
                    <a:pt x="4194" y="18"/>
                  </a:lnTo>
                  <a:lnTo>
                    <a:pt x="4204" y="18"/>
                  </a:lnTo>
                  <a:lnTo>
                    <a:pt x="4210" y="18"/>
                  </a:lnTo>
                  <a:lnTo>
                    <a:pt x="4218" y="18"/>
                  </a:lnTo>
                  <a:lnTo>
                    <a:pt x="4228" y="20"/>
                  </a:lnTo>
                </a:path>
              </a:pathLst>
            </a:custGeom>
            <a:noFill/>
            <a:ln w="19050" cmpd="sng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240" name="Freeform 106"/>
            <p:cNvSpPr>
              <a:spLocks/>
            </p:cNvSpPr>
            <p:nvPr/>
          </p:nvSpPr>
          <p:spPr bwMode="auto">
            <a:xfrm>
              <a:off x="1437482" y="3068638"/>
              <a:ext cx="6697663" cy="139700"/>
            </a:xfrm>
            <a:custGeom>
              <a:avLst/>
              <a:gdLst>
                <a:gd name="T0" fmla="*/ 65 w 4219"/>
                <a:gd name="T1" fmla="*/ 88 h 88"/>
                <a:gd name="T2" fmla="*/ 138 w 4219"/>
                <a:gd name="T3" fmla="*/ 88 h 88"/>
                <a:gd name="T4" fmla="*/ 212 w 4219"/>
                <a:gd name="T5" fmla="*/ 88 h 88"/>
                <a:gd name="T6" fmla="*/ 287 w 4219"/>
                <a:gd name="T7" fmla="*/ 88 h 88"/>
                <a:gd name="T8" fmla="*/ 360 w 4219"/>
                <a:gd name="T9" fmla="*/ 78 h 88"/>
                <a:gd name="T10" fmla="*/ 432 w 4219"/>
                <a:gd name="T11" fmla="*/ 75 h 88"/>
                <a:gd name="T12" fmla="*/ 507 w 4219"/>
                <a:gd name="T13" fmla="*/ 72 h 88"/>
                <a:gd name="T14" fmla="*/ 581 w 4219"/>
                <a:gd name="T15" fmla="*/ 67 h 88"/>
                <a:gd name="T16" fmla="*/ 654 w 4219"/>
                <a:gd name="T17" fmla="*/ 64 h 88"/>
                <a:gd name="T18" fmla="*/ 726 w 4219"/>
                <a:gd name="T19" fmla="*/ 60 h 88"/>
                <a:gd name="T20" fmla="*/ 801 w 4219"/>
                <a:gd name="T21" fmla="*/ 59 h 88"/>
                <a:gd name="T22" fmla="*/ 874 w 4219"/>
                <a:gd name="T23" fmla="*/ 56 h 88"/>
                <a:gd name="T24" fmla="*/ 948 w 4219"/>
                <a:gd name="T25" fmla="*/ 52 h 88"/>
                <a:gd name="T26" fmla="*/ 1021 w 4219"/>
                <a:gd name="T27" fmla="*/ 49 h 88"/>
                <a:gd name="T28" fmla="*/ 1095 w 4219"/>
                <a:gd name="T29" fmla="*/ 46 h 88"/>
                <a:gd name="T30" fmla="*/ 1168 w 4219"/>
                <a:gd name="T31" fmla="*/ 42 h 88"/>
                <a:gd name="T32" fmla="*/ 1242 w 4219"/>
                <a:gd name="T33" fmla="*/ 39 h 88"/>
                <a:gd name="T34" fmla="*/ 1315 w 4219"/>
                <a:gd name="T35" fmla="*/ 36 h 88"/>
                <a:gd name="T36" fmla="*/ 1388 w 4219"/>
                <a:gd name="T37" fmla="*/ 33 h 88"/>
                <a:gd name="T38" fmla="*/ 1460 w 4219"/>
                <a:gd name="T39" fmla="*/ 29 h 88"/>
                <a:gd name="T40" fmla="*/ 1534 w 4219"/>
                <a:gd name="T41" fmla="*/ 26 h 88"/>
                <a:gd name="T42" fmla="*/ 1607 w 4219"/>
                <a:gd name="T43" fmla="*/ 25 h 88"/>
                <a:gd name="T44" fmla="*/ 1680 w 4219"/>
                <a:gd name="T45" fmla="*/ 21 h 88"/>
                <a:gd name="T46" fmla="*/ 1756 w 4219"/>
                <a:gd name="T47" fmla="*/ 18 h 88"/>
                <a:gd name="T48" fmla="*/ 1829 w 4219"/>
                <a:gd name="T49" fmla="*/ 15 h 88"/>
                <a:gd name="T50" fmla="*/ 1902 w 4219"/>
                <a:gd name="T51" fmla="*/ 12 h 88"/>
                <a:gd name="T52" fmla="*/ 1976 w 4219"/>
                <a:gd name="T53" fmla="*/ 10 h 88"/>
                <a:gd name="T54" fmla="*/ 2049 w 4219"/>
                <a:gd name="T55" fmla="*/ 7 h 88"/>
                <a:gd name="T56" fmla="*/ 2123 w 4219"/>
                <a:gd name="T57" fmla="*/ 3 h 88"/>
                <a:gd name="T58" fmla="*/ 2196 w 4219"/>
                <a:gd name="T59" fmla="*/ 0 h 88"/>
                <a:gd name="T60" fmla="*/ 2270 w 4219"/>
                <a:gd name="T61" fmla="*/ 10 h 88"/>
                <a:gd name="T62" fmla="*/ 2343 w 4219"/>
                <a:gd name="T63" fmla="*/ 10 h 88"/>
                <a:gd name="T64" fmla="*/ 2416 w 4219"/>
                <a:gd name="T65" fmla="*/ 10 h 88"/>
                <a:gd name="T66" fmla="*/ 2490 w 4219"/>
                <a:gd name="T67" fmla="*/ 10 h 88"/>
                <a:gd name="T68" fmla="*/ 2563 w 4219"/>
                <a:gd name="T69" fmla="*/ 12 h 88"/>
                <a:gd name="T70" fmla="*/ 2637 w 4219"/>
                <a:gd name="T71" fmla="*/ 12 h 88"/>
                <a:gd name="T72" fmla="*/ 2710 w 4219"/>
                <a:gd name="T73" fmla="*/ 12 h 88"/>
                <a:gd name="T74" fmla="*/ 2784 w 4219"/>
                <a:gd name="T75" fmla="*/ 12 h 88"/>
                <a:gd name="T76" fmla="*/ 2857 w 4219"/>
                <a:gd name="T77" fmla="*/ 12 h 88"/>
                <a:gd name="T78" fmla="*/ 2930 w 4219"/>
                <a:gd name="T79" fmla="*/ 13 h 88"/>
                <a:gd name="T80" fmla="*/ 3004 w 4219"/>
                <a:gd name="T81" fmla="*/ 13 h 88"/>
                <a:gd name="T82" fmla="*/ 3077 w 4219"/>
                <a:gd name="T83" fmla="*/ 13 h 88"/>
                <a:gd name="T84" fmla="*/ 3151 w 4219"/>
                <a:gd name="T85" fmla="*/ 13 h 88"/>
                <a:gd name="T86" fmla="*/ 3222 w 4219"/>
                <a:gd name="T87" fmla="*/ 13 h 88"/>
                <a:gd name="T88" fmla="*/ 3297 w 4219"/>
                <a:gd name="T89" fmla="*/ 15 h 88"/>
                <a:gd name="T90" fmla="*/ 3369 w 4219"/>
                <a:gd name="T91" fmla="*/ 15 h 88"/>
                <a:gd name="T92" fmla="*/ 3444 w 4219"/>
                <a:gd name="T93" fmla="*/ 15 h 88"/>
                <a:gd name="T94" fmla="*/ 3516 w 4219"/>
                <a:gd name="T95" fmla="*/ 15 h 88"/>
                <a:gd name="T96" fmla="*/ 3591 w 4219"/>
                <a:gd name="T97" fmla="*/ 15 h 88"/>
                <a:gd name="T98" fmla="*/ 3663 w 4219"/>
                <a:gd name="T99" fmla="*/ 16 h 88"/>
                <a:gd name="T100" fmla="*/ 3738 w 4219"/>
                <a:gd name="T101" fmla="*/ 16 h 88"/>
                <a:gd name="T102" fmla="*/ 3810 w 4219"/>
                <a:gd name="T103" fmla="*/ 16 h 88"/>
                <a:gd name="T104" fmla="*/ 3885 w 4219"/>
                <a:gd name="T105" fmla="*/ 16 h 88"/>
                <a:gd name="T106" fmla="*/ 3957 w 4219"/>
                <a:gd name="T107" fmla="*/ 18 h 88"/>
                <a:gd name="T108" fmla="*/ 4032 w 4219"/>
                <a:gd name="T109" fmla="*/ 18 h 88"/>
                <a:gd name="T110" fmla="*/ 4104 w 4219"/>
                <a:gd name="T111" fmla="*/ 18 h 88"/>
                <a:gd name="T112" fmla="*/ 4177 w 4219"/>
                <a:gd name="T113" fmla="*/ 1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219" h="88">
                  <a:moveTo>
                    <a:pt x="0" y="88"/>
                  </a:moveTo>
                  <a:lnTo>
                    <a:pt x="8" y="88"/>
                  </a:lnTo>
                  <a:lnTo>
                    <a:pt x="18" y="88"/>
                  </a:lnTo>
                  <a:lnTo>
                    <a:pt x="24" y="88"/>
                  </a:lnTo>
                  <a:lnTo>
                    <a:pt x="34" y="88"/>
                  </a:lnTo>
                  <a:lnTo>
                    <a:pt x="41" y="88"/>
                  </a:lnTo>
                  <a:lnTo>
                    <a:pt x="50" y="88"/>
                  </a:lnTo>
                  <a:lnTo>
                    <a:pt x="57" y="88"/>
                  </a:lnTo>
                  <a:lnTo>
                    <a:pt x="65" y="88"/>
                  </a:lnTo>
                  <a:lnTo>
                    <a:pt x="75" y="88"/>
                  </a:lnTo>
                  <a:lnTo>
                    <a:pt x="81" y="88"/>
                  </a:lnTo>
                  <a:lnTo>
                    <a:pt x="91" y="88"/>
                  </a:lnTo>
                  <a:lnTo>
                    <a:pt x="98" y="88"/>
                  </a:lnTo>
                  <a:lnTo>
                    <a:pt x="107" y="88"/>
                  </a:lnTo>
                  <a:lnTo>
                    <a:pt x="114" y="88"/>
                  </a:lnTo>
                  <a:lnTo>
                    <a:pt x="124" y="88"/>
                  </a:lnTo>
                  <a:lnTo>
                    <a:pt x="132" y="88"/>
                  </a:lnTo>
                  <a:lnTo>
                    <a:pt x="138" y="88"/>
                  </a:lnTo>
                  <a:lnTo>
                    <a:pt x="147" y="88"/>
                  </a:lnTo>
                  <a:lnTo>
                    <a:pt x="155" y="88"/>
                  </a:lnTo>
                  <a:lnTo>
                    <a:pt x="165" y="88"/>
                  </a:lnTo>
                  <a:lnTo>
                    <a:pt x="173" y="88"/>
                  </a:lnTo>
                  <a:lnTo>
                    <a:pt x="181" y="88"/>
                  </a:lnTo>
                  <a:lnTo>
                    <a:pt x="187" y="88"/>
                  </a:lnTo>
                  <a:lnTo>
                    <a:pt x="196" y="88"/>
                  </a:lnTo>
                  <a:lnTo>
                    <a:pt x="204" y="88"/>
                  </a:lnTo>
                  <a:lnTo>
                    <a:pt x="212" y="88"/>
                  </a:lnTo>
                  <a:lnTo>
                    <a:pt x="222" y="88"/>
                  </a:lnTo>
                  <a:lnTo>
                    <a:pt x="228" y="88"/>
                  </a:lnTo>
                  <a:lnTo>
                    <a:pt x="238" y="88"/>
                  </a:lnTo>
                  <a:lnTo>
                    <a:pt x="246" y="88"/>
                  </a:lnTo>
                  <a:lnTo>
                    <a:pt x="253" y="88"/>
                  </a:lnTo>
                  <a:lnTo>
                    <a:pt x="262" y="88"/>
                  </a:lnTo>
                  <a:lnTo>
                    <a:pt x="271" y="88"/>
                  </a:lnTo>
                  <a:lnTo>
                    <a:pt x="277" y="88"/>
                  </a:lnTo>
                  <a:lnTo>
                    <a:pt x="287" y="88"/>
                  </a:lnTo>
                  <a:lnTo>
                    <a:pt x="293" y="88"/>
                  </a:lnTo>
                  <a:lnTo>
                    <a:pt x="303" y="88"/>
                  </a:lnTo>
                  <a:lnTo>
                    <a:pt x="310" y="88"/>
                  </a:lnTo>
                  <a:lnTo>
                    <a:pt x="318" y="80"/>
                  </a:lnTo>
                  <a:lnTo>
                    <a:pt x="328" y="78"/>
                  </a:lnTo>
                  <a:lnTo>
                    <a:pt x="336" y="78"/>
                  </a:lnTo>
                  <a:lnTo>
                    <a:pt x="342" y="78"/>
                  </a:lnTo>
                  <a:lnTo>
                    <a:pt x="352" y="78"/>
                  </a:lnTo>
                  <a:lnTo>
                    <a:pt x="360" y="78"/>
                  </a:lnTo>
                  <a:lnTo>
                    <a:pt x="367" y="77"/>
                  </a:lnTo>
                  <a:lnTo>
                    <a:pt x="375" y="77"/>
                  </a:lnTo>
                  <a:lnTo>
                    <a:pt x="385" y="77"/>
                  </a:lnTo>
                  <a:lnTo>
                    <a:pt x="393" y="77"/>
                  </a:lnTo>
                  <a:lnTo>
                    <a:pt x="400" y="75"/>
                  </a:lnTo>
                  <a:lnTo>
                    <a:pt x="409" y="75"/>
                  </a:lnTo>
                  <a:lnTo>
                    <a:pt x="417" y="75"/>
                  </a:lnTo>
                  <a:lnTo>
                    <a:pt x="426" y="75"/>
                  </a:lnTo>
                  <a:lnTo>
                    <a:pt x="432" y="75"/>
                  </a:lnTo>
                  <a:lnTo>
                    <a:pt x="440" y="73"/>
                  </a:lnTo>
                  <a:lnTo>
                    <a:pt x="449" y="73"/>
                  </a:lnTo>
                  <a:lnTo>
                    <a:pt x="457" y="73"/>
                  </a:lnTo>
                  <a:lnTo>
                    <a:pt x="466" y="73"/>
                  </a:lnTo>
                  <a:lnTo>
                    <a:pt x="475" y="72"/>
                  </a:lnTo>
                  <a:lnTo>
                    <a:pt x="483" y="72"/>
                  </a:lnTo>
                  <a:lnTo>
                    <a:pt x="491" y="72"/>
                  </a:lnTo>
                  <a:lnTo>
                    <a:pt x="497" y="72"/>
                  </a:lnTo>
                  <a:lnTo>
                    <a:pt x="507" y="72"/>
                  </a:lnTo>
                  <a:lnTo>
                    <a:pt x="514" y="70"/>
                  </a:lnTo>
                  <a:lnTo>
                    <a:pt x="524" y="70"/>
                  </a:lnTo>
                  <a:lnTo>
                    <a:pt x="530" y="70"/>
                  </a:lnTo>
                  <a:lnTo>
                    <a:pt x="540" y="70"/>
                  </a:lnTo>
                  <a:lnTo>
                    <a:pt x="546" y="69"/>
                  </a:lnTo>
                  <a:lnTo>
                    <a:pt x="555" y="69"/>
                  </a:lnTo>
                  <a:lnTo>
                    <a:pt x="564" y="69"/>
                  </a:lnTo>
                  <a:lnTo>
                    <a:pt x="571" y="69"/>
                  </a:lnTo>
                  <a:lnTo>
                    <a:pt x="581" y="67"/>
                  </a:lnTo>
                  <a:lnTo>
                    <a:pt x="587" y="67"/>
                  </a:lnTo>
                  <a:lnTo>
                    <a:pt x="597" y="67"/>
                  </a:lnTo>
                  <a:lnTo>
                    <a:pt x="604" y="67"/>
                  </a:lnTo>
                  <a:lnTo>
                    <a:pt x="612" y="67"/>
                  </a:lnTo>
                  <a:lnTo>
                    <a:pt x="621" y="65"/>
                  </a:lnTo>
                  <a:lnTo>
                    <a:pt x="628" y="65"/>
                  </a:lnTo>
                  <a:lnTo>
                    <a:pt x="638" y="65"/>
                  </a:lnTo>
                  <a:lnTo>
                    <a:pt x="644" y="65"/>
                  </a:lnTo>
                  <a:lnTo>
                    <a:pt x="654" y="64"/>
                  </a:lnTo>
                  <a:lnTo>
                    <a:pt x="661" y="64"/>
                  </a:lnTo>
                  <a:lnTo>
                    <a:pt x="669" y="64"/>
                  </a:lnTo>
                  <a:lnTo>
                    <a:pt x="679" y="64"/>
                  </a:lnTo>
                  <a:lnTo>
                    <a:pt x="687" y="64"/>
                  </a:lnTo>
                  <a:lnTo>
                    <a:pt x="693" y="62"/>
                  </a:lnTo>
                  <a:lnTo>
                    <a:pt x="701" y="62"/>
                  </a:lnTo>
                  <a:lnTo>
                    <a:pt x="711" y="62"/>
                  </a:lnTo>
                  <a:lnTo>
                    <a:pt x="719" y="62"/>
                  </a:lnTo>
                  <a:lnTo>
                    <a:pt x="726" y="60"/>
                  </a:lnTo>
                  <a:lnTo>
                    <a:pt x="734" y="60"/>
                  </a:lnTo>
                  <a:lnTo>
                    <a:pt x="742" y="60"/>
                  </a:lnTo>
                  <a:lnTo>
                    <a:pt x="752" y="60"/>
                  </a:lnTo>
                  <a:lnTo>
                    <a:pt x="760" y="60"/>
                  </a:lnTo>
                  <a:lnTo>
                    <a:pt x="767" y="59"/>
                  </a:lnTo>
                  <a:lnTo>
                    <a:pt x="775" y="59"/>
                  </a:lnTo>
                  <a:lnTo>
                    <a:pt x="785" y="59"/>
                  </a:lnTo>
                  <a:lnTo>
                    <a:pt x="793" y="59"/>
                  </a:lnTo>
                  <a:lnTo>
                    <a:pt x="801" y="59"/>
                  </a:lnTo>
                  <a:lnTo>
                    <a:pt x="807" y="57"/>
                  </a:lnTo>
                  <a:lnTo>
                    <a:pt x="816" y="57"/>
                  </a:lnTo>
                  <a:lnTo>
                    <a:pt x="825" y="57"/>
                  </a:lnTo>
                  <a:lnTo>
                    <a:pt x="834" y="57"/>
                  </a:lnTo>
                  <a:lnTo>
                    <a:pt x="840" y="56"/>
                  </a:lnTo>
                  <a:lnTo>
                    <a:pt x="848" y="56"/>
                  </a:lnTo>
                  <a:lnTo>
                    <a:pt x="856" y="56"/>
                  </a:lnTo>
                  <a:lnTo>
                    <a:pt x="866" y="56"/>
                  </a:lnTo>
                  <a:lnTo>
                    <a:pt x="874" y="56"/>
                  </a:lnTo>
                  <a:lnTo>
                    <a:pt x="881" y="54"/>
                  </a:lnTo>
                  <a:lnTo>
                    <a:pt x="889" y="54"/>
                  </a:lnTo>
                  <a:lnTo>
                    <a:pt x="899" y="54"/>
                  </a:lnTo>
                  <a:lnTo>
                    <a:pt x="907" y="54"/>
                  </a:lnTo>
                  <a:lnTo>
                    <a:pt x="915" y="52"/>
                  </a:lnTo>
                  <a:lnTo>
                    <a:pt x="922" y="52"/>
                  </a:lnTo>
                  <a:lnTo>
                    <a:pt x="930" y="52"/>
                  </a:lnTo>
                  <a:lnTo>
                    <a:pt x="940" y="52"/>
                  </a:lnTo>
                  <a:lnTo>
                    <a:pt x="948" y="52"/>
                  </a:lnTo>
                  <a:lnTo>
                    <a:pt x="954" y="51"/>
                  </a:lnTo>
                  <a:lnTo>
                    <a:pt x="962" y="51"/>
                  </a:lnTo>
                  <a:lnTo>
                    <a:pt x="971" y="51"/>
                  </a:lnTo>
                  <a:lnTo>
                    <a:pt x="980" y="51"/>
                  </a:lnTo>
                  <a:lnTo>
                    <a:pt x="989" y="51"/>
                  </a:lnTo>
                  <a:lnTo>
                    <a:pt x="995" y="49"/>
                  </a:lnTo>
                  <a:lnTo>
                    <a:pt x="1003" y="49"/>
                  </a:lnTo>
                  <a:lnTo>
                    <a:pt x="1013" y="49"/>
                  </a:lnTo>
                  <a:lnTo>
                    <a:pt x="1021" y="49"/>
                  </a:lnTo>
                  <a:lnTo>
                    <a:pt x="1029" y="47"/>
                  </a:lnTo>
                  <a:lnTo>
                    <a:pt x="1038" y="47"/>
                  </a:lnTo>
                  <a:lnTo>
                    <a:pt x="1046" y="47"/>
                  </a:lnTo>
                  <a:lnTo>
                    <a:pt x="1052" y="47"/>
                  </a:lnTo>
                  <a:lnTo>
                    <a:pt x="1060" y="47"/>
                  </a:lnTo>
                  <a:lnTo>
                    <a:pt x="1069" y="46"/>
                  </a:lnTo>
                  <a:lnTo>
                    <a:pt x="1077" y="46"/>
                  </a:lnTo>
                  <a:lnTo>
                    <a:pt x="1087" y="46"/>
                  </a:lnTo>
                  <a:lnTo>
                    <a:pt x="1095" y="46"/>
                  </a:lnTo>
                  <a:lnTo>
                    <a:pt x="1103" y="46"/>
                  </a:lnTo>
                  <a:lnTo>
                    <a:pt x="1111" y="44"/>
                  </a:lnTo>
                  <a:lnTo>
                    <a:pt x="1119" y="44"/>
                  </a:lnTo>
                  <a:lnTo>
                    <a:pt x="1126" y="44"/>
                  </a:lnTo>
                  <a:lnTo>
                    <a:pt x="1134" y="44"/>
                  </a:lnTo>
                  <a:lnTo>
                    <a:pt x="1142" y="42"/>
                  </a:lnTo>
                  <a:lnTo>
                    <a:pt x="1150" y="42"/>
                  </a:lnTo>
                  <a:lnTo>
                    <a:pt x="1158" y="42"/>
                  </a:lnTo>
                  <a:lnTo>
                    <a:pt x="1168" y="42"/>
                  </a:lnTo>
                  <a:lnTo>
                    <a:pt x="1176" y="42"/>
                  </a:lnTo>
                  <a:lnTo>
                    <a:pt x="1184" y="41"/>
                  </a:lnTo>
                  <a:lnTo>
                    <a:pt x="1193" y="41"/>
                  </a:lnTo>
                  <a:lnTo>
                    <a:pt x="1199" y="41"/>
                  </a:lnTo>
                  <a:lnTo>
                    <a:pt x="1207" y="41"/>
                  </a:lnTo>
                  <a:lnTo>
                    <a:pt x="1215" y="41"/>
                  </a:lnTo>
                  <a:lnTo>
                    <a:pt x="1224" y="39"/>
                  </a:lnTo>
                  <a:lnTo>
                    <a:pt x="1232" y="39"/>
                  </a:lnTo>
                  <a:lnTo>
                    <a:pt x="1242" y="39"/>
                  </a:lnTo>
                  <a:lnTo>
                    <a:pt x="1250" y="39"/>
                  </a:lnTo>
                  <a:lnTo>
                    <a:pt x="1258" y="38"/>
                  </a:lnTo>
                  <a:lnTo>
                    <a:pt x="1266" y="38"/>
                  </a:lnTo>
                  <a:lnTo>
                    <a:pt x="1274" y="38"/>
                  </a:lnTo>
                  <a:lnTo>
                    <a:pt x="1281" y="38"/>
                  </a:lnTo>
                  <a:lnTo>
                    <a:pt x="1289" y="38"/>
                  </a:lnTo>
                  <a:lnTo>
                    <a:pt x="1297" y="36"/>
                  </a:lnTo>
                  <a:lnTo>
                    <a:pt x="1305" y="36"/>
                  </a:lnTo>
                  <a:lnTo>
                    <a:pt x="1315" y="36"/>
                  </a:lnTo>
                  <a:lnTo>
                    <a:pt x="1323" y="36"/>
                  </a:lnTo>
                  <a:lnTo>
                    <a:pt x="1331" y="36"/>
                  </a:lnTo>
                  <a:lnTo>
                    <a:pt x="1339" y="34"/>
                  </a:lnTo>
                  <a:lnTo>
                    <a:pt x="1348" y="34"/>
                  </a:lnTo>
                  <a:lnTo>
                    <a:pt x="1354" y="34"/>
                  </a:lnTo>
                  <a:lnTo>
                    <a:pt x="1362" y="34"/>
                  </a:lnTo>
                  <a:lnTo>
                    <a:pt x="1370" y="34"/>
                  </a:lnTo>
                  <a:lnTo>
                    <a:pt x="1379" y="33"/>
                  </a:lnTo>
                  <a:lnTo>
                    <a:pt x="1388" y="33"/>
                  </a:lnTo>
                  <a:lnTo>
                    <a:pt x="1397" y="33"/>
                  </a:lnTo>
                  <a:lnTo>
                    <a:pt x="1405" y="33"/>
                  </a:lnTo>
                  <a:lnTo>
                    <a:pt x="1413" y="33"/>
                  </a:lnTo>
                  <a:lnTo>
                    <a:pt x="1421" y="31"/>
                  </a:lnTo>
                  <a:lnTo>
                    <a:pt x="1428" y="31"/>
                  </a:lnTo>
                  <a:lnTo>
                    <a:pt x="1436" y="31"/>
                  </a:lnTo>
                  <a:lnTo>
                    <a:pt x="1444" y="31"/>
                  </a:lnTo>
                  <a:lnTo>
                    <a:pt x="1452" y="29"/>
                  </a:lnTo>
                  <a:lnTo>
                    <a:pt x="1460" y="29"/>
                  </a:lnTo>
                  <a:lnTo>
                    <a:pt x="1470" y="29"/>
                  </a:lnTo>
                  <a:lnTo>
                    <a:pt x="1478" y="29"/>
                  </a:lnTo>
                  <a:lnTo>
                    <a:pt x="1486" y="29"/>
                  </a:lnTo>
                  <a:lnTo>
                    <a:pt x="1494" y="28"/>
                  </a:lnTo>
                  <a:lnTo>
                    <a:pt x="1501" y="28"/>
                  </a:lnTo>
                  <a:lnTo>
                    <a:pt x="1509" y="28"/>
                  </a:lnTo>
                  <a:lnTo>
                    <a:pt x="1517" y="28"/>
                  </a:lnTo>
                  <a:lnTo>
                    <a:pt x="1525" y="28"/>
                  </a:lnTo>
                  <a:lnTo>
                    <a:pt x="1534" y="26"/>
                  </a:lnTo>
                  <a:lnTo>
                    <a:pt x="1543" y="26"/>
                  </a:lnTo>
                  <a:lnTo>
                    <a:pt x="1552" y="26"/>
                  </a:lnTo>
                  <a:lnTo>
                    <a:pt x="1560" y="26"/>
                  </a:lnTo>
                  <a:lnTo>
                    <a:pt x="1568" y="26"/>
                  </a:lnTo>
                  <a:lnTo>
                    <a:pt x="1576" y="25"/>
                  </a:lnTo>
                  <a:lnTo>
                    <a:pt x="1583" y="25"/>
                  </a:lnTo>
                  <a:lnTo>
                    <a:pt x="1591" y="25"/>
                  </a:lnTo>
                  <a:lnTo>
                    <a:pt x="1599" y="25"/>
                  </a:lnTo>
                  <a:lnTo>
                    <a:pt x="1607" y="25"/>
                  </a:lnTo>
                  <a:lnTo>
                    <a:pt x="1617" y="23"/>
                  </a:lnTo>
                  <a:lnTo>
                    <a:pt x="1625" y="23"/>
                  </a:lnTo>
                  <a:lnTo>
                    <a:pt x="1633" y="23"/>
                  </a:lnTo>
                  <a:lnTo>
                    <a:pt x="1641" y="23"/>
                  </a:lnTo>
                  <a:lnTo>
                    <a:pt x="1649" y="23"/>
                  </a:lnTo>
                  <a:lnTo>
                    <a:pt x="1656" y="21"/>
                  </a:lnTo>
                  <a:lnTo>
                    <a:pt x="1664" y="21"/>
                  </a:lnTo>
                  <a:lnTo>
                    <a:pt x="1672" y="21"/>
                  </a:lnTo>
                  <a:lnTo>
                    <a:pt x="1680" y="21"/>
                  </a:lnTo>
                  <a:lnTo>
                    <a:pt x="1690" y="21"/>
                  </a:lnTo>
                  <a:lnTo>
                    <a:pt x="1698" y="20"/>
                  </a:lnTo>
                  <a:lnTo>
                    <a:pt x="1707" y="20"/>
                  </a:lnTo>
                  <a:lnTo>
                    <a:pt x="1715" y="20"/>
                  </a:lnTo>
                  <a:lnTo>
                    <a:pt x="1723" y="20"/>
                  </a:lnTo>
                  <a:lnTo>
                    <a:pt x="1729" y="20"/>
                  </a:lnTo>
                  <a:lnTo>
                    <a:pt x="1739" y="18"/>
                  </a:lnTo>
                  <a:lnTo>
                    <a:pt x="1746" y="18"/>
                  </a:lnTo>
                  <a:lnTo>
                    <a:pt x="1756" y="18"/>
                  </a:lnTo>
                  <a:lnTo>
                    <a:pt x="1762" y="18"/>
                  </a:lnTo>
                  <a:lnTo>
                    <a:pt x="1770" y="18"/>
                  </a:lnTo>
                  <a:lnTo>
                    <a:pt x="1780" y="16"/>
                  </a:lnTo>
                  <a:lnTo>
                    <a:pt x="1787" y="16"/>
                  </a:lnTo>
                  <a:lnTo>
                    <a:pt x="1796" y="16"/>
                  </a:lnTo>
                  <a:lnTo>
                    <a:pt x="1803" y="16"/>
                  </a:lnTo>
                  <a:lnTo>
                    <a:pt x="1813" y="16"/>
                  </a:lnTo>
                  <a:lnTo>
                    <a:pt x="1819" y="15"/>
                  </a:lnTo>
                  <a:lnTo>
                    <a:pt x="1829" y="15"/>
                  </a:lnTo>
                  <a:lnTo>
                    <a:pt x="1835" y="15"/>
                  </a:lnTo>
                  <a:lnTo>
                    <a:pt x="1844" y="15"/>
                  </a:lnTo>
                  <a:lnTo>
                    <a:pt x="1853" y="15"/>
                  </a:lnTo>
                  <a:lnTo>
                    <a:pt x="1860" y="13"/>
                  </a:lnTo>
                  <a:lnTo>
                    <a:pt x="1870" y="13"/>
                  </a:lnTo>
                  <a:lnTo>
                    <a:pt x="1876" y="13"/>
                  </a:lnTo>
                  <a:lnTo>
                    <a:pt x="1886" y="13"/>
                  </a:lnTo>
                  <a:lnTo>
                    <a:pt x="1893" y="13"/>
                  </a:lnTo>
                  <a:lnTo>
                    <a:pt x="1902" y="12"/>
                  </a:lnTo>
                  <a:lnTo>
                    <a:pt x="1909" y="12"/>
                  </a:lnTo>
                  <a:lnTo>
                    <a:pt x="1917" y="12"/>
                  </a:lnTo>
                  <a:lnTo>
                    <a:pt x="1927" y="12"/>
                  </a:lnTo>
                  <a:lnTo>
                    <a:pt x="1933" y="12"/>
                  </a:lnTo>
                  <a:lnTo>
                    <a:pt x="1943" y="10"/>
                  </a:lnTo>
                  <a:lnTo>
                    <a:pt x="1950" y="10"/>
                  </a:lnTo>
                  <a:lnTo>
                    <a:pt x="1959" y="10"/>
                  </a:lnTo>
                  <a:lnTo>
                    <a:pt x="1966" y="10"/>
                  </a:lnTo>
                  <a:lnTo>
                    <a:pt x="1976" y="10"/>
                  </a:lnTo>
                  <a:lnTo>
                    <a:pt x="1982" y="8"/>
                  </a:lnTo>
                  <a:lnTo>
                    <a:pt x="1990" y="8"/>
                  </a:lnTo>
                  <a:lnTo>
                    <a:pt x="2000" y="8"/>
                  </a:lnTo>
                  <a:lnTo>
                    <a:pt x="2007" y="8"/>
                  </a:lnTo>
                  <a:lnTo>
                    <a:pt x="2017" y="8"/>
                  </a:lnTo>
                  <a:lnTo>
                    <a:pt x="2023" y="7"/>
                  </a:lnTo>
                  <a:lnTo>
                    <a:pt x="2033" y="7"/>
                  </a:lnTo>
                  <a:lnTo>
                    <a:pt x="2039" y="7"/>
                  </a:lnTo>
                  <a:lnTo>
                    <a:pt x="2049" y="7"/>
                  </a:lnTo>
                  <a:lnTo>
                    <a:pt x="2056" y="7"/>
                  </a:lnTo>
                  <a:lnTo>
                    <a:pt x="2066" y="5"/>
                  </a:lnTo>
                  <a:lnTo>
                    <a:pt x="2074" y="5"/>
                  </a:lnTo>
                  <a:lnTo>
                    <a:pt x="2080" y="5"/>
                  </a:lnTo>
                  <a:lnTo>
                    <a:pt x="2090" y="5"/>
                  </a:lnTo>
                  <a:lnTo>
                    <a:pt x="2097" y="5"/>
                  </a:lnTo>
                  <a:lnTo>
                    <a:pt x="2106" y="3"/>
                  </a:lnTo>
                  <a:lnTo>
                    <a:pt x="2113" y="3"/>
                  </a:lnTo>
                  <a:lnTo>
                    <a:pt x="2123" y="3"/>
                  </a:lnTo>
                  <a:lnTo>
                    <a:pt x="2129" y="3"/>
                  </a:lnTo>
                  <a:lnTo>
                    <a:pt x="2139" y="3"/>
                  </a:lnTo>
                  <a:lnTo>
                    <a:pt x="2147" y="2"/>
                  </a:lnTo>
                  <a:lnTo>
                    <a:pt x="2154" y="2"/>
                  </a:lnTo>
                  <a:lnTo>
                    <a:pt x="2163" y="2"/>
                  </a:lnTo>
                  <a:lnTo>
                    <a:pt x="2170" y="2"/>
                  </a:lnTo>
                  <a:lnTo>
                    <a:pt x="2180" y="2"/>
                  </a:lnTo>
                  <a:lnTo>
                    <a:pt x="2186" y="2"/>
                  </a:lnTo>
                  <a:lnTo>
                    <a:pt x="2196" y="0"/>
                  </a:lnTo>
                  <a:lnTo>
                    <a:pt x="2203" y="8"/>
                  </a:lnTo>
                  <a:lnTo>
                    <a:pt x="2212" y="8"/>
                  </a:lnTo>
                  <a:lnTo>
                    <a:pt x="2221" y="10"/>
                  </a:lnTo>
                  <a:lnTo>
                    <a:pt x="2227" y="10"/>
                  </a:lnTo>
                  <a:lnTo>
                    <a:pt x="2237" y="10"/>
                  </a:lnTo>
                  <a:lnTo>
                    <a:pt x="2243" y="10"/>
                  </a:lnTo>
                  <a:lnTo>
                    <a:pt x="2253" y="10"/>
                  </a:lnTo>
                  <a:lnTo>
                    <a:pt x="2260" y="10"/>
                  </a:lnTo>
                  <a:lnTo>
                    <a:pt x="2270" y="10"/>
                  </a:lnTo>
                  <a:lnTo>
                    <a:pt x="2276" y="10"/>
                  </a:lnTo>
                  <a:lnTo>
                    <a:pt x="2286" y="10"/>
                  </a:lnTo>
                  <a:lnTo>
                    <a:pt x="2294" y="10"/>
                  </a:lnTo>
                  <a:lnTo>
                    <a:pt x="2301" y="10"/>
                  </a:lnTo>
                  <a:lnTo>
                    <a:pt x="2310" y="10"/>
                  </a:lnTo>
                  <a:lnTo>
                    <a:pt x="2317" y="10"/>
                  </a:lnTo>
                  <a:lnTo>
                    <a:pt x="2327" y="10"/>
                  </a:lnTo>
                  <a:lnTo>
                    <a:pt x="2333" y="10"/>
                  </a:lnTo>
                  <a:lnTo>
                    <a:pt x="2343" y="10"/>
                  </a:lnTo>
                  <a:lnTo>
                    <a:pt x="2349" y="10"/>
                  </a:lnTo>
                  <a:lnTo>
                    <a:pt x="2359" y="10"/>
                  </a:lnTo>
                  <a:lnTo>
                    <a:pt x="2366" y="10"/>
                  </a:lnTo>
                  <a:lnTo>
                    <a:pt x="2374" y="10"/>
                  </a:lnTo>
                  <a:lnTo>
                    <a:pt x="2384" y="10"/>
                  </a:lnTo>
                  <a:lnTo>
                    <a:pt x="2390" y="10"/>
                  </a:lnTo>
                  <a:lnTo>
                    <a:pt x="2400" y="10"/>
                  </a:lnTo>
                  <a:lnTo>
                    <a:pt x="2407" y="10"/>
                  </a:lnTo>
                  <a:lnTo>
                    <a:pt x="2416" y="10"/>
                  </a:lnTo>
                  <a:lnTo>
                    <a:pt x="2423" y="10"/>
                  </a:lnTo>
                  <a:lnTo>
                    <a:pt x="2433" y="10"/>
                  </a:lnTo>
                  <a:lnTo>
                    <a:pt x="2439" y="10"/>
                  </a:lnTo>
                  <a:lnTo>
                    <a:pt x="2447" y="10"/>
                  </a:lnTo>
                  <a:lnTo>
                    <a:pt x="2457" y="10"/>
                  </a:lnTo>
                  <a:lnTo>
                    <a:pt x="2464" y="10"/>
                  </a:lnTo>
                  <a:lnTo>
                    <a:pt x="2473" y="10"/>
                  </a:lnTo>
                  <a:lnTo>
                    <a:pt x="2480" y="10"/>
                  </a:lnTo>
                  <a:lnTo>
                    <a:pt x="2490" y="10"/>
                  </a:lnTo>
                  <a:lnTo>
                    <a:pt x="2496" y="10"/>
                  </a:lnTo>
                  <a:lnTo>
                    <a:pt x="2506" y="10"/>
                  </a:lnTo>
                  <a:lnTo>
                    <a:pt x="2513" y="10"/>
                  </a:lnTo>
                  <a:lnTo>
                    <a:pt x="2521" y="10"/>
                  </a:lnTo>
                  <a:lnTo>
                    <a:pt x="2531" y="10"/>
                  </a:lnTo>
                  <a:lnTo>
                    <a:pt x="2537" y="10"/>
                  </a:lnTo>
                  <a:lnTo>
                    <a:pt x="2547" y="10"/>
                  </a:lnTo>
                  <a:lnTo>
                    <a:pt x="2553" y="12"/>
                  </a:lnTo>
                  <a:lnTo>
                    <a:pt x="2563" y="12"/>
                  </a:lnTo>
                  <a:lnTo>
                    <a:pt x="2570" y="12"/>
                  </a:lnTo>
                  <a:lnTo>
                    <a:pt x="2580" y="12"/>
                  </a:lnTo>
                  <a:lnTo>
                    <a:pt x="2586" y="12"/>
                  </a:lnTo>
                  <a:lnTo>
                    <a:pt x="2594" y="12"/>
                  </a:lnTo>
                  <a:lnTo>
                    <a:pt x="2604" y="12"/>
                  </a:lnTo>
                  <a:lnTo>
                    <a:pt x="2611" y="12"/>
                  </a:lnTo>
                  <a:lnTo>
                    <a:pt x="2620" y="12"/>
                  </a:lnTo>
                  <a:lnTo>
                    <a:pt x="2627" y="12"/>
                  </a:lnTo>
                  <a:lnTo>
                    <a:pt x="2637" y="12"/>
                  </a:lnTo>
                  <a:lnTo>
                    <a:pt x="2643" y="12"/>
                  </a:lnTo>
                  <a:lnTo>
                    <a:pt x="2653" y="12"/>
                  </a:lnTo>
                  <a:lnTo>
                    <a:pt x="2659" y="12"/>
                  </a:lnTo>
                  <a:lnTo>
                    <a:pt x="2669" y="12"/>
                  </a:lnTo>
                  <a:lnTo>
                    <a:pt x="2677" y="12"/>
                  </a:lnTo>
                  <a:lnTo>
                    <a:pt x="2684" y="12"/>
                  </a:lnTo>
                  <a:lnTo>
                    <a:pt x="2694" y="12"/>
                  </a:lnTo>
                  <a:lnTo>
                    <a:pt x="2700" y="12"/>
                  </a:lnTo>
                  <a:lnTo>
                    <a:pt x="2710" y="12"/>
                  </a:lnTo>
                  <a:lnTo>
                    <a:pt x="2717" y="12"/>
                  </a:lnTo>
                  <a:lnTo>
                    <a:pt x="2726" y="12"/>
                  </a:lnTo>
                  <a:lnTo>
                    <a:pt x="2733" y="12"/>
                  </a:lnTo>
                  <a:lnTo>
                    <a:pt x="2743" y="12"/>
                  </a:lnTo>
                  <a:lnTo>
                    <a:pt x="2751" y="12"/>
                  </a:lnTo>
                  <a:lnTo>
                    <a:pt x="2757" y="12"/>
                  </a:lnTo>
                  <a:lnTo>
                    <a:pt x="2767" y="12"/>
                  </a:lnTo>
                  <a:lnTo>
                    <a:pt x="2774" y="12"/>
                  </a:lnTo>
                  <a:lnTo>
                    <a:pt x="2784" y="12"/>
                  </a:lnTo>
                  <a:lnTo>
                    <a:pt x="2790" y="12"/>
                  </a:lnTo>
                  <a:lnTo>
                    <a:pt x="2800" y="12"/>
                  </a:lnTo>
                  <a:lnTo>
                    <a:pt x="2806" y="12"/>
                  </a:lnTo>
                  <a:lnTo>
                    <a:pt x="2816" y="12"/>
                  </a:lnTo>
                  <a:lnTo>
                    <a:pt x="2824" y="12"/>
                  </a:lnTo>
                  <a:lnTo>
                    <a:pt x="2831" y="12"/>
                  </a:lnTo>
                  <a:lnTo>
                    <a:pt x="2841" y="12"/>
                  </a:lnTo>
                  <a:lnTo>
                    <a:pt x="2847" y="12"/>
                  </a:lnTo>
                  <a:lnTo>
                    <a:pt x="2857" y="12"/>
                  </a:lnTo>
                  <a:lnTo>
                    <a:pt x="2863" y="12"/>
                  </a:lnTo>
                  <a:lnTo>
                    <a:pt x="2873" y="12"/>
                  </a:lnTo>
                  <a:lnTo>
                    <a:pt x="2880" y="12"/>
                  </a:lnTo>
                  <a:lnTo>
                    <a:pt x="2890" y="12"/>
                  </a:lnTo>
                  <a:lnTo>
                    <a:pt x="2898" y="13"/>
                  </a:lnTo>
                  <a:lnTo>
                    <a:pt x="2904" y="13"/>
                  </a:lnTo>
                  <a:lnTo>
                    <a:pt x="2914" y="13"/>
                  </a:lnTo>
                  <a:lnTo>
                    <a:pt x="2921" y="13"/>
                  </a:lnTo>
                  <a:lnTo>
                    <a:pt x="2930" y="13"/>
                  </a:lnTo>
                  <a:lnTo>
                    <a:pt x="2937" y="13"/>
                  </a:lnTo>
                  <a:lnTo>
                    <a:pt x="2947" y="13"/>
                  </a:lnTo>
                  <a:lnTo>
                    <a:pt x="2953" y="13"/>
                  </a:lnTo>
                  <a:lnTo>
                    <a:pt x="2963" y="13"/>
                  </a:lnTo>
                  <a:lnTo>
                    <a:pt x="2970" y="13"/>
                  </a:lnTo>
                  <a:lnTo>
                    <a:pt x="2978" y="13"/>
                  </a:lnTo>
                  <a:lnTo>
                    <a:pt x="2987" y="13"/>
                  </a:lnTo>
                  <a:lnTo>
                    <a:pt x="2994" y="13"/>
                  </a:lnTo>
                  <a:lnTo>
                    <a:pt x="3004" y="13"/>
                  </a:lnTo>
                  <a:lnTo>
                    <a:pt x="3010" y="13"/>
                  </a:lnTo>
                  <a:lnTo>
                    <a:pt x="3020" y="13"/>
                  </a:lnTo>
                  <a:lnTo>
                    <a:pt x="3027" y="13"/>
                  </a:lnTo>
                  <a:lnTo>
                    <a:pt x="3036" y="13"/>
                  </a:lnTo>
                  <a:lnTo>
                    <a:pt x="3043" y="13"/>
                  </a:lnTo>
                  <a:lnTo>
                    <a:pt x="3051" y="13"/>
                  </a:lnTo>
                  <a:lnTo>
                    <a:pt x="3061" y="13"/>
                  </a:lnTo>
                  <a:lnTo>
                    <a:pt x="3067" y="13"/>
                  </a:lnTo>
                  <a:lnTo>
                    <a:pt x="3077" y="13"/>
                  </a:lnTo>
                  <a:lnTo>
                    <a:pt x="3084" y="13"/>
                  </a:lnTo>
                  <a:lnTo>
                    <a:pt x="3094" y="13"/>
                  </a:lnTo>
                  <a:lnTo>
                    <a:pt x="3100" y="13"/>
                  </a:lnTo>
                  <a:lnTo>
                    <a:pt x="3110" y="13"/>
                  </a:lnTo>
                  <a:lnTo>
                    <a:pt x="3116" y="13"/>
                  </a:lnTo>
                  <a:lnTo>
                    <a:pt x="3125" y="13"/>
                  </a:lnTo>
                  <a:lnTo>
                    <a:pt x="3133" y="13"/>
                  </a:lnTo>
                  <a:lnTo>
                    <a:pt x="3141" y="13"/>
                  </a:lnTo>
                  <a:lnTo>
                    <a:pt x="3151" y="13"/>
                  </a:lnTo>
                  <a:lnTo>
                    <a:pt x="3159" y="13"/>
                  </a:lnTo>
                  <a:lnTo>
                    <a:pt x="3165" y="13"/>
                  </a:lnTo>
                  <a:lnTo>
                    <a:pt x="3173" y="13"/>
                  </a:lnTo>
                  <a:lnTo>
                    <a:pt x="3183" y="13"/>
                  </a:lnTo>
                  <a:lnTo>
                    <a:pt x="3191" y="13"/>
                  </a:lnTo>
                  <a:lnTo>
                    <a:pt x="3198" y="13"/>
                  </a:lnTo>
                  <a:lnTo>
                    <a:pt x="3208" y="13"/>
                  </a:lnTo>
                  <a:lnTo>
                    <a:pt x="3216" y="13"/>
                  </a:lnTo>
                  <a:lnTo>
                    <a:pt x="3222" y="13"/>
                  </a:lnTo>
                  <a:lnTo>
                    <a:pt x="3231" y="13"/>
                  </a:lnTo>
                  <a:lnTo>
                    <a:pt x="3240" y="15"/>
                  </a:lnTo>
                  <a:lnTo>
                    <a:pt x="3249" y="15"/>
                  </a:lnTo>
                  <a:lnTo>
                    <a:pt x="3255" y="15"/>
                  </a:lnTo>
                  <a:lnTo>
                    <a:pt x="3263" y="15"/>
                  </a:lnTo>
                  <a:lnTo>
                    <a:pt x="3273" y="15"/>
                  </a:lnTo>
                  <a:lnTo>
                    <a:pt x="3280" y="15"/>
                  </a:lnTo>
                  <a:lnTo>
                    <a:pt x="3288" y="15"/>
                  </a:lnTo>
                  <a:lnTo>
                    <a:pt x="3297" y="15"/>
                  </a:lnTo>
                  <a:lnTo>
                    <a:pt x="3306" y="15"/>
                  </a:lnTo>
                  <a:lnTo>
                    <a:pt x="3312" y="15"/>
                  </a:lnTo>
                  <a:lnTo>
                    <a:pt x="3320" y="15"/>
                  </a:lnTo>
                  <a:lnTo>
                    <a:pt x="3330" y="15"/>
                  </a:lnTo>
                  <a:lnTo>
                    <a:pt x="3338" y="15"/>
                  </a:lnTo>
                  <a:lnTo>
                    <a:pt x="3345" y="15"/>
                  </a:lnTo>
                  <a:lnTo>
                    <a:pt x="3355" y="15"/>
                  </a:lnTo>
                  <a:lnTo>
                    <a:pt x="3363" y="15"/>
                  </a:lnTo>
                  <a:lnTo>
                    <a:pt x="3369" y="15"/>
                  </a:lnTo>
                  <a:lnTo>
                    <a:pt x="3377" y="15"/>
                  </a:lnTo>
                  <a:lnTo>
                    <a:pt x="3387" y="15"/>
                  </a:lnTo>
                  <a:lnTo>
                    <a:pt x="3395" y="15"/>
                  </a:lnTo>
                  <a:lnTo>
                    <a:pt x="3402" y="15"/>
                  </a:lnTo>
                  <a:lnTo>
                    <a:pt x="3410" y="15"/>
                  </a:lnTo>
                  <a:lnTo>
                    <a:pt x="3420" y="15"/>
                  </a:lnTo>
                  <a:lnTo>
                    <a:pt x="3426" y="15"/>
                  </a:lnTo>
                  <a:lnTo>
                    <a:pt x="3435" y="15"/>
                  </a:lnTo>
                  <a:lnTo>
                    <a:pt x="3444" y="15"/>
                  </a:lnTo>
                  <a:lnTo>
                    <a:pt x="3453" y="15"/>
                  </a:lnTo>
                  <a:lnTo>
                    <a:pt x="3459" y="15"/>
                  </a:lnTo>
                  <a:lnTo>
                    <a:pt x="3467" y="15"/>
                  </a:lnTo>
                  <a:lnTo>
                    <a:pt x="3477" y="15"/>
                  </a:lnTo>
                  <a:lnTo>
                    <a:pt x="3485" y="15"/>
                  </a:lnTo>
                  <a:lnTo>
                    <a:pt x="3492" y="15"/>
                  </a:lnTo>
                  <a:lnTo>
                    <a:pt x="3501" y="15"/>
                  </a:lnTo>
                  <a:lnTo>
                    <a:pt x="3510" y="15"/>
                  </a:lnTo>
                  <a:lnTo>
                    <a:pt x="3516" y="15"/>
                  </a:lnTo>
                  <a:lnTo>
                    <a:pt x="3524" y="15"/>
                  </a:lnTo>
                  <a:lnTo>
                    <a:pt x="3534" y="15"/>
                  </a:lnTo>
                  <a:lnTo>
                    <a:pt x="3542" y="15"/>
                  </a:lnTo>
                  <a:lnTo>
                    <a:pt x="3549" y="15"/>
                  </a:lnTo>
                  <a:lnTo>
                    <a:pt x="3557" y="15"/>
                  </a:lnTo>
                  <a:lnTo>
                    <a:pt x="3567" y="15"/>
                  </a:lnTo>
                  <a:lnTo>
                    <a:pt x="3575" y="15"/>
                  </a:lnTo>
                  <a:lnTo>
                    <a:pt x="3581" y="15"/>
                  </a:lnTo>
                  <a:lnTo>
                    <a:pt x="3591" y="15"/>
                  </a:lnTo>
                  <a:lnTo>
                    <a:pt x="3599" y="16"/>
                  </a:lnTo>
                  <a:lnTo>
                    <a:pt x="3606" y="16"/>
                  </a:lnTo>
                  <a:lnTo>
                    <a:pt x="3614" y="16"/>
                  </a:lnTo>
                  <a:lnTo>
                    <a:pt x="3624" y="16"/>
                  </a:lnTo>
                  <a:lnTo>
                    <a:pt x="3632" y="16"/>
                  </a:lnTo>
                  <a:lnTo>
                    <a:pt x="3639" y="16"/>
                  </a:lnTo>
                  <a:lnTo>
                    <a:pt x="3647" y="16"/>
                  </a:lnTo>
                  <a:lnTo>
                    <a:pt x="3656" y="16"/>
                  </a:lnTo>
                  <a:lnTo>
                    <a:pt x="3663" y="16"/>
                  </a:lnTo>
                  <a:lnTo>
                    <a:pt x="3671" y="16"/>
                  </a:lnTo>
                  <a:lnTo>
                    <a:pt x="3681" y="16"/>
                  </a:lnTo>
                  <a:lnTo>
                    <a:pt x="3689" y="16"/>
                  </a:lnTo>
                  <a:lnTo>
                    <a:pt x="3696" y="16"/>
                  </a:lnTo>
                  <a:lnTo>
                    <a:pt x="3704" y="16"/>
                  </a:lnTo>
                  <a:lnTo>
                    <a:pt x="3714" y="16"/>
                  </a:lnTo>
                  <a:lnTo>
                    <a:pt x="3722" y="16"/>
                  </a:lnTo>
                  <a:lnTo>
                    <a:pt x="3728" y="16"/>
                  </a:lnTo>
                  <a:lnTo>
                    <a:pt x="3738" y="16"/>
                  </a:lnTo>
                  <a:lnTo>
                    <a:pt x="3746" y="16"/>
                  </a:lnTo>
                  <a:lnTo>
                    <a:pt x="3753" y="16"/>
                  </a:lnTo>
                  <a:lnTo>
                    <a:pt x="3761" y="16"/>
                  </a:lnTo>
                  <a:lnTo>
                    <a:pt x="3771" y="16"/>
                  </a:lnTo>
                  <a:lnTo>
                    <a:pt x="3779" y="16"/>
                  </a:lnTo>
                  <a:lnTo>
                    <a:pt x="3785" y="16"/>
                  </a:lnTo>
                  <a:lnTo>
                    <a:pt x="3794" y="16"/>
                  </a:lnTo>
                  <a:lnTo>
                    <a:pt x="3803" y="16"/>
                  </a:lnTo>
                  <a:lnTo>
                    <a:pt x="3810" y="16"/>
                  </a:lnTo>
                  <a:lnTo>
                    <a:pt x="3818" y="16"/>
                  </a:lnTo>
                  <a:lnTo>
                    <a:pt x="3828" y="16"/>
                  </a:lnTo>
                  <a:lnTo>
                    <a:pt x="3836" y="16"/>
                  </a:lnTo>
                  <a:lnTo>
                    <a:pt x="3842" y="16"/>
                  </a:lnTo>
                  <a:lnTo>
                    <a:pt x="3851" y="16"/>
                  </a:lnTo>
                  <a:lnTo>
                    <a:pt x="3860" y="16"/>
                  </a:lnTo>
                  <a:lnTo>
                    <a:pt x="3869" y="16"/>
                  </a:lnTo>
                  <a:lnTo>
                    <a:pt x="3875" y="16"/>
                  </a:lnTo>
                  <a:lnTo>
                    <a:pt x="3885" y="16"/>
                  </a:lnTo>
                  <a:lnTo>
                    <a:pt x="3893" y="16"/>
                  </a:lnTo>
                  <a:lnTo>
                    <a:pt x="3900" y="16"/>
                  </a:lnTo>
                  <a:lnTo>
                    <a:pt x="3908" y="16"/>
                  </a:lnTo>
                  <a:lnTo>
                    <a:pt x="3918" y="16"/>
                  </a:lnTo>
                  <a:lnTo>
                    <a:pt x="3926" y="16"/>
                  </a:lnTo>
                  <a:lnTo>
                    <a:pt x="3932" y="16"/>
                  </a:lnTo>
                  <a:lnTo>
                    <a:pt x="3940" y="16"/>
                  </a:lnTo>
                  <a:lnTo>
                    <a:pt x="3950" y="16"/>
                  </a:lnTo>
                  <a:lnTo>
                    <a:pt x="3957" y="18"/>
                  </a:lnTo>
                  <a:lnTo>
                    <a:pt x="3965" y="18"/>
                  </a:lnTo>
                  <a:lnTo>
                    <a:pt x="3975" y="18"/>
                  </a:lnTo>
                  <a:lnTo>
                    <a:pt x="3983" y="18"/>
                  </a:lnTo>
                  <a:lnTo>
                    <a:pt x="3989" y="18"/>
                  </a:lnTo>
                  <a:lnTo>
                    <a:pt x="3998" y="18"/>
                  </a:lnTo>
                  <a:lnTo>
                    <a:pt x="4007" y="18"/>
                  </a:lnTo>
                  <a:lnTo>
                    <a:pt x="4015" y="18"/>
                  </a:lnTo>
                  <a:lnTo>
                    <a:pt x="4022" y="18"/>
                  </a:lnTo>
                  <a:lnTo>
                    <a:pt x="4032" y="18"/>
                  </a:lnTo>
                  <a:lnTo>
                    <a:pt x="4040" y="18"/>
                  </a:lnTo>
                  <a:lnTo>
                    <a:pt x="4046" y="18"/>
                  </a:lnTo>
                  <a:lnTo>
                    <a:pt x="4055" y="18"/>
                  </a:lnTo>
                  <a:lnTo>
                    <a:pt x="4064" y="18"/>
                  </a:lnTo>
                  <a:lnTo>
                    <a:pt x="4073" y="18"/>
                  </a:lnTo>
                  <a:lnTo>
                    <a:pt x="4079" y="18"/>
                  </a:lnTo>
                  <a:lnTo>
                    <a:pt x="4087" y="18"/>
                  </a:lnTo>
                  <a:lnTo>
                    <a:pt x="4097" y="18"/>
                  </a:lnTo>
                  <a:lnTo>
                    <a:pt x="4104" y="18"/>
                  </a:lnTo>
                  <a:lnTo>
                    <a:pt x="4112" y="18"/>
                  </a:lnTo>
                  <a:lnTo>
                    <a:pt x="4122" y="18"/>
                  </a:lnTo>
                  <a:lnTo>
                    <a:pt x="4130" y="18"/>
                  </a:lnTo>
                  <a:lnTo>
                    <a:pt x="4136" y="18"/>
                  </a:lnTo>
                  <a:lnTo>
                    <a:pt x="4144" y="18"/>
                  </a:lnTo>
                  <a:lnTo>
                    <a:pt x="4154" y="18"/>
                  </a:lnTo>
                  <a:lnTo>
                    <a:pt x="4162" y="18"/>
                  </a:lnTo>
                  <a:lnTo>
                    <a:pt x="4169" y="18"/>
                  </a:lnTo>
                  <a:lnTo>
                    <a:pt x="4177" y="18"/>
                  </a:lnTo>
                  <a:lnTo>
                    <a:pt x="4187" y="18"/>
                  </a:lnTo>
                  <a:lnTo>
                    <a:pt x="4193" y="18"/>
                  </a:lnTo>
                  <a:lnTo>
                    <a:pt x="4201" y="18"/>
                  </a:lnTo>
                  <a:lnTo>
                    <a:pt x="4211" y="18"/>
                  </a:lnTo>
                  <a:lnTo>
                    <a:pt x="4219" y="18"/>
                  </a:lnTo>
                </a:path>
              </a:pathLst>
            </a:custGeom>
            <a:noFill/>
            <a:ln w="19050" cmpd="sng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547982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dirty="0" smtClean="0"/>
              <a:t>Figure2B</a:t>
            </a:r>
            <a:endParaRPr lang="en-US" dirty="0"/>
          </a:p>
        </p:txBody>
      </p:sp>
      <p:grpSp>
        <p:nvGrpSpPr>
          <p:cNvPr id="81" name="Group 11"/>
          <p:cNvGrpSpPr>
            <a:grpSpLocks noChangeAspect="1"/>
          </p:cNvGrpSpPr>
          <p:nvPr/>
        </p:nvGrpSpPr>
        <p:grpSpPr bwMode="auto">
          <a:xfrm>
            <a:off x="431801" y="1600200"/>
            <a:ext cx="8261351" cy="4616451"/>
            <a:chOff x="272" y="1008"/>
            <a:chExt cx="5204" cy="2908"/>
          </a:xfrm>
        </p:grpSpPr>
        <p:sp>
          <p:nvSpPr>
            <p:cNvPr id="82" name="AutoShape 10"/>
            <p:cNvSpPr>
              <a:spLocks noChangeAspect="1" noChangeArrowheads="1" noTextEdit="1"/>
            </p:cNvSpPr>
            <p:nvPr/>
          </p:nvSpPr>
          <p:spPr bwMode="auto">
            <a:xfrm>
              <a:off x="359" y="1008"/>
              <a:ext cx="5041" cy="2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83" name="Rectangle 12"/>
            <p:cNvSpPr>
              <a:spLocks noChangeArrowheads="1"/>
            </p:cNvSpPr>
            <p:nvPr/>
          </p:nvSpPr>
          <p:spPr bwMode="auto">
            <a:xfrm>
              <a:off x="359" y="1008"/>
              <a:ext cx="5041" cy="285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84" name="Line 13"/>
            <p:cNvSpPr>
              <a:spLocks noChangeShapeType="1"/>
            </p:cNvSpPr>
            <p:nvPr/>
          </p:nvSpPr>
          <p:spPr bwMode="auto">
            <a:xfrm flipV="1">
              <a:off x="550" y="1132"/>
              <a:ext cx="1" cy="25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85" name="Line 14"/>
            <p:cNvSpPr>
              <a:spLocks noChangeShapeType="1"/>
            </p:cNvSpPr>
            <p:nvPr/>
          </p:nvSpPr>
          <p:spPr bwMode="auto">
            <a:xfrm flipH="1">
              <a:off x="540" y="3687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86" name="Line 15"/>
            <p:cNvSpPr>
              <a:spLocks noChangeShapeType="1"/>
            </p:cNvSpPr>
            <p:nvPr/>
          </p:nvSpPr>
          <p:spPr bwMode="auto">
            <a:xfrm flipH="1">
              <a:off x="540" y="3546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87" name="Line 16"/>
            <p:cNvSpPr>
              <a:spLocks noChangeShapeType="1"/>
            </p:cNvSpPr>
            <p:nvPr/>
          </p:nvSpPr>
          <p:spPr bwMode="auto">
            <a:xfrm flipH="1">
              <a:off x="540" y="3405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88" name="Line 17"/>
            <p:cNvSpPr>
              <a:spLocks noChangeShapeType="1"/>
            </p:cNvSpPr>
            <p:nvPr/>
          </p:nvSpPr>
          <p:spPr bwMode="auto">
            <a:xfrm flipH="1">
              <a:off x="540" y="3262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89" name="Line 18"/>
            <p:cNvSpPr>
              <a:spLocks noChangeShapeType="1"/>
            </p:cNvSpPr>
            <p:nvPr/>
          </p:nvSpPr>
          <p:spPr bwMode="auto">
            <a:xfrm flipH="1">
              <a:off x="540" y="3120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0" name="Line 19"/>
            <p:cNvSpPr>
              <a:spLocks noChangeShapeType="1"/>
            </p:cNvSpPr>
            <p:nvPr/>
          </p:nvSpPr>
          <p:spPr bwMode="auto">
            <a:xfrm flipH="1">
              <a:off x="540" y="2979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1" name="Line 20"/>
            <p:cNvSpPr>
              <a:spLocks noChangeShapeType="1"/>
            </p:cNvSpPr>
            <p:nvPr/>
          </p:nvSpPr>
          <p:spPr bwMode="auto">
            <a:xfrm flipH="1">
              <a:off x="540" y="2836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2" name="Line 21"/>
            <p:cNvSpPr>
              <a:spLocks noChangeShapeType="1"/>
            </p:cNvSpPr>
            <p:nvPr/>
          </p:nvSpPr>
          <p:spPr bwMode="auto">
            <a:xfrm flipH="1">
              <a:off x="540" y="2695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3" name="Line 22"/>
            <p:cNvSpPr>
              <a:spLocks noChangeShapeType="1"/>
            </p:cNvSpPr>
            <p:nvPr/>
          </p:nvSpPr>
          <p:spPr bwMode="auto">
            <a:xfrm flipH="1">
              <a:off x="540" y="2552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4" name="Line 23"/>
            <p:cNvSpPr>
              <a:spLocks noChangeShapeType="1"/>
            </p:cNvSpPr>
            <p:nvPr/>
          </p:nvSpPr>
          <p:spPr bwMode="auto">
            <a:xfrm flipH="1">
              <a:off x="540" y="2410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5" name="Line 24"/>
            <p:cNvSpPr>
              <a:spLocks noChangeShapeType="1"/>
            </p:cNvSpPr>
            <p:nvPr/>
          </p:nvSpPr>
          <p:spPr bwMode="auto">
            <a:xfrm flipH="1">
              <a:off x="540" y="2269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6" name="Line 25"/>
            <p:cNvSpPr>
              <a:spLocks noChangeShapeType="1"/>
            </p:cNvSpPr>
            <p:nvPr/>
          </p:nvSpPr>
          <p:spPr bwMode="auto">
            <a:xfrm flipH="1">
              <a:off x="540" y="2126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7" name="Line 26"/>
            <p:cNvSpPr>
              <a:spLocks noChangeShapeType="1"/>
            </p:cNvSpPr>
            <p:nvPr/>
          </p:nvSpPr>
          <p:spPr bwMode="auto">
            <a:xfrm flipH="1">
              <a:off x="540" y="1985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8" name="Line 27"/>
            <p:cNvSpPr>
              <a:spLocks noChangeShapeType="1"/>
            </p:cNvSpPr>
            <p:nvPr/>
          </p:nvSpPr>
          <p:spPr bwMode="auto">
            <a:xfrm flipH="1">
              <a:off x="540" y="1842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99" name="Line 28"/>
            <p:cNvSpPr>
              <a:spLocks noChangeShapeType="1"/>
            </p:cNvSpPr>
            <p:nvPr/>
          </p:nvSpPr>
          <p:spPr bwMode="auto">
            <a:xfrm flipH="1">
              <a:off x="540" y="1700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0" name="Line 29"/>
            <p:cNvSpPr>
              <a:spLocks noChangeShapeType="1"/>
            </p:cNvSpPr>
            <p:nvPr/>
          </p:nvSpPr>
          <p:spPr bwMode="auto">
            <a:xfrm flipH="1">
              <a:off x="540" y="1559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1" name="Line 30"/>
            <p:cNvSpPr>
              <a:spLocks noChangeShapeType="1"/>
            </p:cNvSpPr>
            <p:nvPr/>
          </p:nvSpPr>
          <p:spPr bwMode="auto">
            <a:xfrm flipH="1">
              <a:off x="540" y="1416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3" name="Line 31"/>
            <p:cNvSpPr>
              <a:spLocks noChangeShapeType="1"/>
            </p:cNvSpPr>
            <p:nvPr/>
          </p:nvSpPr>
          <p:spPr bwMode="auto">
            <a:xfrm flipH="1">
              <a:off x="540" y="1275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4" name="Line 32"/>
            <p:cNvSpPr>
              <a:spLocks noChangeShapeType="1"/>
            </p:cNvSpPr>
            <p:nvPr/>
          </p:nvSpPr>
          <p:spPr bwMode="auto">
            <a:xfrm flipH="1">
              <a:off x="540" y="1132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5" name="Line 33"/>
            <p:cNvSpPr>
              <a:spLocks noChangeShapeType="1"/>
            </p:cNvSpPr>
            <p:nvPr/>
          </p:nvSpPr>
          <p:spPr bwMode="auto">
            <a:xfrm flipH="1">
              <a:off x="527" y="3687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6" name="Line 34"/>
            <p:cNvSpPr>
              <a:spLocks noChangeShapeType="1"/>
            </p:cNvSpPr>
            <p:nvPr/>
          </p:nvSpPr>
          <p:spPr bwMode="auto">
            <a:xfrm flipH="1">
              <a:off x="527" y="3405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7" name="Line 35"/>
            <p:cNvSpPr>
              <a:spLocks noChangeShapeType="1"/>
            </p:cNvSpPr>
            <p:nvPr/>
          </p:nvSpPr>
          <p:spPr bwMode="auto">
            <a:xfrm flipH="1">
              <a:off x="527" y="3120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8" name="Line 36"/>
            <p:cNvSpPr>
              <a:spLocks noChangeShapeType="1"/>
            </p:cNvSpPr>
            <p:nvPr/>
          </p:nvSpPr>
          <p:spPr bwMode="auto">
            <a:xfrm flipH="1">
              <a:off x="527" y="2836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9" name="Line 37"/>
            <p:cNvSpPr>
              <a:spLocks noChangeShapeType="1"/>
            </p:cNvSpPr>
            <p:nvPr/>
          </p:nvSpPr>
          <p:spPr bwMode="auto">
            <a:xfrm flipH="1">
              <a:off x="527" y="2552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10" name="Line 38"/>
            <p:cNvSpPr>
              <a:spLocks noChangeShapeType="1"/>
            </p:cNvSpPr>
            <p:nvPr/>
          </p:nvSpPr>
          <p:spPr bwMode="auto">
            <a:xfrm flipH="1">
              <a:off x="527" y="2269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11" name="Line 39"/>
            <p:cNvSpPr>
              <a:spLocks noChangeShapeType="1"/>
            </p:cNvSpPr>
            <p:nvPr/>
          </p:nvSpPr>
          <p:spPr bwMode="auto">
            <a:xfrm flipH="1">
              <a:off x="527" y="1985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12" name="Line 40"/>
            <p:cNvSpPr>
              <a:spLocks noChangeShapeType="1"/>
            </p:cNvSpPr>
            <p:nvPr/>
          </p:nvSpPr>
          <p:spPr bwMode="auto">
            <a:xfrm flipH="1">
              <a:off x="527" y="1700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13" name="Line 41"/>
            <p:cNvSpPr>
              <a:spLocks noChangeShapeType="1"/>
            </p:cNvSpPr>
            <p:nvPr/>
          </p:nvSpPr>
          <p:spPr bwMode="auto">
            <a:xfrm flipH="1">
              <a:off x="527" y="1416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14" name="Line 42"/>
            <p:cNvSpPr>
              <a:spLocks noChangeShapeType="1"/>
            </p:cNvSpPr>
            <p:nvPr/>
          </p:nvSpPr>
          <p:spPr bwMode="auto">
            <a:xfrm flipH="1">
              <a:off x="527" y="1132"/>
              <a:ext cx="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15" name="Rectangle 43"/>
            <p:cNvSpPr>
              <a:spLocks noChangeArrowheads="1"/>
            </p:cNvSpPr>
            <p:nvPr/>
          </p:nvSpPr>
          <p:spPr bwMode="auto">
            <a:xfrm>
              <a:off x="415" y="3659"/>
              <a:ext cx="17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-150</a:t>
              </a:r>
              <a:endParaRPr lang="es-ES" sz="1200"/>
            </a:p>
          </p:txBody>
        </p:sp>
        <p:sp>
          <p:nvSpPr>
            <p:cNvPr id="116" name="Rectangle 44"/>
            <p:cNvSpPr>
              <a:spLocks noChangeArrowheads="1"/>
            </p:cNvSpPr>
            <p:nvPr/>
          </p:nvSpPr>
          <p:spPr bwMode="auto">
            <a:xfrm>
              <a:off x="415" y="3376"/>
              <a:ext cx="17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-100</a:t>
              </a:r>
              <a:endParaRPr lang="es-ES" sz="1200"/>
            </a:p>
          </p:txBody>
        </p:sp>
        <p:sp>
          <p:nvSpPr>
            <p:cNvPr id="117" name="Rectangle 45"/>
            <p:cNvSpPr>
              <a:spLocks noChangeArrowheads="1"/>
            </p:cNvSpPr>
            <p:nvPr/>
          </p:nvSpPr>
          <p:spPr bwMode="auto">
            <a:xfrm>
              <a:off x="437" y="3092"/>
              <a:ext cx="12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-50</a:t>
              </a:r>
              <a:endParaRPr lang="es-ES" sz="1200"/>
            </a:p>
          </p:txBody>
        </p:sp>
        <p:sp>
          <p:nvSpPr>
            <p:cNvPr id="118" name="Rectangle 46"/>
            <p:cNvSpPr>
              <a:spLocks noChangeArrowheads="1"/>
            </p:cNvSpPr>
            <p:nvPr/>
          </p:nvSpPr>
          <p:spPr bwMode="auto">
            <a:xfrm>
              <a:off x="472" y="2808"/>
              <a:ext cx="4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0</a:t>
              </a:r>
              <a:endParaRPr lang="es-ES" sz="1200"/>
            </a:p>
          </p:txBody>
        </p:sp>
        <p:sp>
          <p:nvSpPr>
            <p:cNvPr id="119" name="Rectangle 47"/>
            <p:cNvSpPr>
              <a:spLocks noChangeArrowheads="1"/>
            </p:cNvSpPr>
            <p:nvPr/>
          </p:nvSpPr>
          <p:spPr bwMode="auto">
            <a:xfrm>
              <a:off x="450" y="2523"/>
              <a:ext cx="9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50</a:t>
              </a:r>
              <a:endParaRPr lang="es-ES" sz="1200"/>
            </a:p>
          </p:txBody>
        </p:sp>
        <p:sp>
          <p:nvSpPr>
            <p:cNvPr id="120" name="Rectangle 48"/>
            <p:cNvSpPr>
              <a:spLocks noChangeArrowheads="1"/>
            </p:cNvSpPr>
            <p:nvPr/>
          </p:nvSpPr>
          <p:spPr bwMode="auto">
            <a:xfrm>
              <a:off x="428" y="2241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00</a:t>
              </a:r>
              <a:endParaRPr lang="es-ES" sz="1200"/>
            </a:p>
          </p:txBody>
        </p:sp>
        <p:sp>
          <p:nvSpPr>
            <p:cNvPr id="121" name="Rectangle 49"/>
            <p:cNvSpPr>
              <a:spLocks noChangeArrowheads="1"/>
            </p:cNvSpPr>
            <p:nvPr/>
          </p:nvSpPr>
          <p:spPr bwMode="auto">
            <a:xfrm>
              <a:off x="428" y="195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50</a:t>
              </a:r>
              <a:endParaRPr lang="es-ES" sz="1200"/>
            </a:p>
          </p:txBody>
        </p:sp>
        <p:sp>
          <p:nvSpPr>
            <p:cNvPr id="122" name="Rectangle 50"/>
            <p:cNvSpPr>
              <a:spLocks noChangeArrowheads="1"/>
            </p:cNvSpPr>
            <p:nvPr/>
          </p:nvSpPr>
          <p:spPr bwMode="auto">
            <a:xfrm>
              <a:off x="428" y="1672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200</a:t>
              </a:r>
              <a:endParaRPr lang="es-ES" sz="1200"/>
            </a:p>
          </p:txBody>
        </p:sp>
        <p:sp>
          <p:nvSpPr>
            <p:cNvPr id="123" name="Rectangle 51"/>
            <p:cNvSpPr>
              <a:spLocks noChangeArrowheads="1"/>
            </p:cNvSpPr>
            <p:nvPr/>
          </p:nvSpPr>
          <p:spPr bwMode="auto">
            <a:xfrm>
              <a:off x="428" y="1388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250</a:t>
              </a:r>
              <a:endParaRPr lang="es-ES" sz="1200"/>
            </a:p>
          </p:txBody>
        </p:sp>
        <p:sp>
          <p:nvSpPr>
            <p:cNvPr id="124" name="Rectangle 52"/>
            <p:cNvSpPr>
              <a:spLocks noChangeArrowheads="1"/>
            </p:cNvSpPr>
            <p:nvPr/>
          </p:nvSpPr>
          <p:spPr bwMode="auto">
            <a:xfrm>
              <a:off x="428" y="1103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300</a:t>
              </a:r>
              <a:endParaRPr lang="es-ES" sz="1200"/>
            </a:p>
          </p:txBody>
        </p:sp>
        <p:sp>
          <p:nvSpPr>
            <p:cNvPr id="125" name="Line 53"/>
            <p:cNvSpPr>
              <a:spLocks noChangeShapeType="1"/>
            </p:cNvSpPr>
            <p:nvPr/>
          </p:nvSpPr>
          <p:spPr bwMode="auto">
            <a:xfrm>
              <a:off x="550" y="3687"/>
              <a:ext cx="4807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26" name="Line 54"/>
            <p:cNvSpPr>
              <a:spLocks noChangeShapeType="1"/>
            </p:cNvSpPr>
            <p:nvPr/>
          </p:nvSpPr>
          <p:spPr bwMode="auto">
            <a:xfrm>
              <a:off x="550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27" name="Line 55"/>
            <p:cNvSpPr>
              <a:spLocks noChangeShapeType="1"/>
            </p:cNvSpPr>
            <p:nvPr/>
          </p:nvSpPr>
          <p:spPr bwMode="auto">
            <a:xfrm>
              <a:off x="817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28" name="Line 56"/>
            <p:cNvSpPr>
              <a:spLocks noChangeShapeType="1"/>
            </p:cNvSpPr>
            <p:nvPr/>
          </p:nvSpPr>
          <p:spPr bwMode="auto">
            <a:xfrm>
              <a:off x="1083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29" name="Line 57"/>
            <p:cNvSpPr>
              <a:spLocks noChangeShapeType="1"/>
            </p:cNvSpPr>
            <p:nvPr/>
          </p:nvSpPr>
          <p:spPr bwMode="auto">
            <a:xfrm>
              <a:off x="1350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0" name="Line 58"/>
            <p:cNvSpPr>
              <a:spLocks noChangeShapeType="1"/>
            </p:cNvSpPr>
            <p:nvPr/>
          </p:nvSpPr>
          <p:spPr bwMode="auto">
            <a:xfrm>
              <a:off x="1617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1" name="Line 59"/>
            <p:cNvSpPr>
              <a:spLocks noChangeShapeType="1"/>
            </p:cNvSpPr>
            <p:nvPr/>
          </p:nvSpPr>
          <p:spPr bwMode="auto">
            <a:xfrm>
              <a:off x="1884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2" name="Line 60"/>
            <p:cNvSpPr>
              <a:spLocks noChangeShapeType="1"/>
            </p:cNvSpPr>
            <p:nvPr/>
          </p:nvSpPr>
          <p:spPr bwMode="auto">
            <a:xfrm>
              <a:off x="2151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3" name="Line 61"/>
            <p:cNvSpPr>
              <a:spLocks noChangeShapeType="1"/>
            </p:cNvSpPr>
            <p:nvPr/>
          </p:nvSpPr>
          <p:spPr bwMode="auto">
            <a:xfrm>
              <a:off x="2418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4" name="Line 62"/>
            <p:cNvSpPr>
              <a:spLocks noChangeShapeType="1"/>
            </p:cNvSpPr>
            <p:nvPr/>
          </p:nvSpPr>
          <p:spPr bwMode="auto">
            <a:xfrm>
              <a:off x="2685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5" name="Line 63"/>
            <p:cNvSpPr>
              <a:spLocks noChangeShapeType="1"/>
            </p:cNvSpPr>
            <p:nvPr/>
          </p:nvSpPr>
          <p:spPr bwMode="auto">
            <a:xfrm>
              <a:off x="2952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6" name="Line 64"/>
            <p:cNvSpPr>
              <a:spLocks noChangeShapeType="1"/>
            </p:cNvSpPr>
            <p:nvPr/>
          </p:nvSpPr>
          <p:spPr bwMode="auto">
            <a:xfrm>
              <a:off x="3219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7" name="Line 65"/>
            <p:cNvSpPr>
              <a:spLocks noChangeShapeType="1"/>
            </p:cNvSpPr>
            <p:nvPr/>
          </p:nvSpPr>
          <p:spPr bwMode="auto">
            <a:xfrm>
              <a:off x="3486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8" name="Line 66"/>
            <p:cNvSpPr>
              <a:spLocks noChangeShapeType="1"/>
            </p:cNvSpPr>
            <p:nvPr/>
          </p:nvSpPr>
          <p:spPr bwMode="auto">
            <a:xfrm>
              <a:off x="3753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39" name="Line 67"/>
            <p:cNvSpPr>
              <a:spLocks noChangeShapeType="1"/>
            </p:cNvSpPr>
            <p:nvPr/>
          </p:nvSpPr>
          <p:spPr bwMode="auto">
            <a:xfrm>
              <a:off x="4019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0" name="Line 68"/>
            <p:cNvSpPr>
              <a:spLocks noChangeShapeType="1"/>
            </p:cNvSpPr>
            <p:nvPr/>
          </p:nvSpPr>
          <p:spPr bwMode="auto">
            <a:xfrm>
              <a:off x="4286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1" name="Line 69"/>
            <p:cNvSpPr>
              <a:spLocks noChangeShapeType="1"/>
            </p:cNvSpPr>
            <p:nvPr/>
          </p:nvSpPr>
          <p:spPr bwMode="auto">
            <a:xfrm>
              <a:off x="4553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2" name="Line 70"/>
            <p:cNvSpPr>
              <a:spLocks noChangeShapeType="1"/>
            </p:cNvSpPr>
            <p:nvPr/>
          </p:nvSpPr>
          <p:spPr bwMode="auto">
            <a:xfrm>
              <a:off x="4820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3" name="Line 71"/>
            <p:cNvSpPr>
              <a:spLocks noChangeShapeType="1"/>
            </p:cNvSpPr>
            <p:nvPr/>
          </p:nvSpPr>
          <p:spPr bwMode="auto">
            <a:xfrm>
              <a:off x="5087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4" name="Line 72"/>
            <p:cNvSpPr>
              <a:spLocks noChangeShapeType="1"/>
            </p:cNvSpPr>
            <p:nvPr/>
          </p:nvSpPr>
          <p:spPr bwMode="auto">
            <a:xfrm>
              <a:off x="5356" y="3684"/>
              <a:ext cx="1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5" name="Line 73"/>
            <p:cNvSpPr>
              <a:spLocks noChangeShapeType="1"/>
            </p:cNvSpPr>
            <p:nvPr/>
          </p:nvSpPr>
          <p:spPr bwMode="auto">
            <a:xfrm>
              <a:off x="550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6" name="Line 74"/>
            <p:cNvSpPr>
              <a:spLocks noChangeShapeType="1"/>
            </p:cNvSpPr>
            <p:nvPr/>
          </p:nvSpPr>
          <p:spPr bwMode="auto">
            <a:xfrm>
              <a:off x="1083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7" name="Line 75"/>
            <p:cNvSpPr>
              <a:spLocks noChangeShapeType="1"/>
            </p:cNvSpPr>
            <p:nvPr/>
          </p:nvSpPr>
          <p:spPr bwMode="auto">
            <a:xfrm>
              <a:off x="1617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8" name="Line 76"/>
            <p:cNvSpPr>
              <a:spLocks noChangeShapeType="1"/>
            </p:cNvSpPr>
            <p:nvPr/>
          </p:nvSpPr>
          <p:spPr bwMode="auto">
            <a:xfrm>
              <a:off x="2151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49" name="Line 77"/>
            <p:cNvSpPr>
              <a:spLocks noChangeShapeType="1"/>
            </p:cNvSpPr>
            <p:nvPr/>
          </p:nvSpPr>
          <p:spPr bwMode="auto">
            <a:xfrm>
              <a:off x="2685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50" name="Line 78"/>
            <p:cNvSpPr>
              <a:spLocks noChangeShapeType="1"/>
            </p:cNvSpPr>
            <p:nvPr/>
          </p:nvSpPr>
          <p:spPr bwMode="auto">
            <a:xfrm>
              <a:off x="3219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51" name="Line 79"/>
            <p:cNvSpPr>
              <a:spLocks noChangeShapeType="1"/>
            </p:cNvSpPr>
            <p:nvPr/>
          </p:nvSpPr>
          <p:spPr bwMode="auto">
            <a:xfrm>
              <a:off x="3753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52" name="Line 80"/>
            <p:cNvSpPr>
              <a:spLocks noChangeShapeType="1"/>
            </p:cNvSpPr>
            <p:nvPr/>
          </p:nvSpPr>
          <p:spPr bwMode="auto">
            <a:xfrm>
              <a:off x="4286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53" name="Line 81"/>
            <p:cNvSpPr>
              <a:spLocks noChangeShapeType="1"/>
            </p:cNvSpPr>
            <p:nvPr/>
          </p:nvSpPr>
          <p:spPr bwMode="auto">
            <a:xfrm>
              <a:off x="4820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54" name="Line 82"/>
            <p:cNvSpPr>
              <a:spLocks noChangeShapeType="1"/>
            </p:cNvSpPr>
            <p:nvPr/>
          </p:nvSpPr>
          <p:spPr bwMode="auto">
            <a:xfrm>
              <a:off x="5356" y="3678"/>
              <a:ext cx="1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55" name="Rectangle 83"/>
            <p:cNvSpPr>
              <a:spLocks noChangeArrowheads="1"/>
            </p:cNvSpPr>
            <p:nvPr/>
          </p:nvSpPr>
          <p:spPr bwMode="auto">
            <a:xfrm>
              <a:off x="526" y="3726"/>
              <a:ext cx="12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-50</a:t>
              </a:r>
              <a:endParaRPr lang="es-ES" sz="1200"/>
            </a:p>
          </p:txBody>
        </p:sp>
        <p:sp>
          <p:nvSpPr>
            <p:cNvPr id="156" name="Rectangle 84"/>
            <p:cNvSpPr>
              <a:spLocks noChangeArrowheads="1"/>
            </p:cNvSpPr>
            <p:nvPr/>
          </p:nvSpPr>
          <p:spPr bwMode="auto">
            <a:xfrm>
              <a:off x="1076" y="3726"/>
              <a:ext cx="4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0</a:t>
              </a:r>
              <a:endParaRPr lang="es-ES" sz="1200"/>
            </a:p>
          </p:txBody>
        </p:sp>
        <p:sp>
          <p:nvSpPr>
            <p:cNvPr id="157" name="Rectangle 85"/>
            <p:cNvSpPr>
              <a:spLocks noChangeArrowheads="1"/>
            </p:cNvSpPr>
            <p:nvPr/>
          </p:nvSpPr>
          <p:spPr bwMode="auto">
            <a:xfrm>
              <a:off x="1600" y="3726"/>
              <a:ext cx="9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50</a:t>
              </a:r>
              <a:endParaRPr lang="es-ES" sz="1200"/>
            </a:p>
          </p:txBody>
        </p:sp>
        <p:sp>
          <p:nvSpPr>
            <p:cNvPr id="158" name="Rectangle 86"/>
            <p:cNvSpPr>
              <a:spLocks noChangeArrowheads="1"/>
            </p:cNvSpPr>
            <p:nvPr/>
          </p:nvSpPr>
          <p:spPr bwMode="auto">
            <a:xfrm>
              <a:off x="2124" y="372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00</a:t>
              </a:r>
              <a:endParaRPr lang="es-ES" sz="1200"/>
            </a:p>
          </p:txBody>
        </p:sp>
        <p:sp>
          <p:nvSpPr>
            <p:cNvPr id="159" name="Rectangle 87"/>
            <p:cNvSpPr>
              <a:spLocks noChangeArrowheads="1"/>
            </p:cNvSpPr>
            <p:nvPr/>
          </p:nvSpPr>
          <p:spPr bwMode="auto">
            <a:xfrm>
              <a:off x="2658" y="372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50</a:t>
              </a:r>
              <a:endParaRPr lang="es-ES" sz="1200"/>
            </a:p>
          </p:txBody>
        </p:sp>
        <p:sp>
          <p:nvSpPr>
            <p:cNvPr id="160" name="Rectangle 88"/>
            <p:cNvSpPr>
              <a:spLocks noChangeArrowheads="1"/>
            </p:cNvSpPr>
            <p:nvPr/>
          </p:nvSpPr>
          <p:spPr bwMode="auto">
            <a:xfrm>
              <a:off x="3192" y="372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200</a:t>
              </a:r>
              <a:endParaRPr lang="es-ES" sz="1200"/>
            </a:p>
          </p:txBody>
        </p:sp>
        <p:sp>
          <p:nvSpPr>
            <p:cNvPr id="161" name="Rectangle 89"/>
            <p:cNvSpPr>
              <a:spLocks noChangeArrowheads="1"/>
            </p:cNvSpPr>
            <p:nvPr/>
          </p:nvSpPr>
          <p:spPr bwMode="auto">
            <a:xfrm>
              <a:off x="3725" y="372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250</a:t>
              </a:r>
              <a:endParaRPr lang="es-ES" sz="1200"/>
            </a:p>
          </p:txBody>
        </p:sp>
        <p:sp>
          <p:nvSpPr>
            <p:cNvPr id="162" name="Rectangle 90"/>
            <p:cNvSpPr>
              <a:spLocks noChangeArrowheads="1"/>
            </p:cNvSpPr>
            <p:nvPr/>
          </p:nvSpPr>
          <p:spPr bwMode="auto">
            <a:xfrm>
              <a:off x="4259" y="372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300</a:t>
              </a:r>
              <a:endParaRPr lang="es-ES" sz="1200"/>
            </a:p>
          </p:txBody>
        </p:sp>
        <p:sp>
          <p:nvSpPr>
            <p:cNvPr id="241" name="Rectangle 91"/>
            <p:cNvSpPr>
              <a:spLocks noChangeArrowheads="1"/>
            </p:cNvSpPr>
            <p:nvPr/>
          </p:nvSpPr>
          <p:spPr bwMode="auto">
            <a:xfrm>
              <a:off x="4793" y="372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350</a:t>
              </a:r>
              <a:endParaRPr lang="es-ES" sz="1200"/>
            </a:p>
          </p:txBody>
        </p:sp>
        <p:sp>
          <p:nvSpPr>
            <p:cNvPr id="242" name="Rectangle 92"/>
            <p:cNvSpPr>
              <a:spLocks noChangeArrowheads="1"/>
            </p:cNvSpPr>
            <p:nvPr/>
          </p:nvSpPr>
          <p:spPr bwMode="auto">
            <a:xfrm>
              <a:off x="5329" y="3726"/>
              <a:ext cx="1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400</a:t>
              </a:r>
              <a:endParaRPr lang="es-ES" sz="1200"/>
            </a:p>
          </p:txBody>
        </p:sp>
        <p:sp>
          <p:nvSpPr>
            <p:cNvPr id="244" name="Rectangle 94"/>
            <p:cNvSpPr>
              <a:spLocks noChangeArrowheads="1"/>
            </p:cNvSpPr>
            <p:nvPr/>
          </p:nvSpPr>
          <p:spPr bwMode="auto">
            <a:xfrm>
              <a:off x="413" y="1029"/>
              <a:ext cx="11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RU</a:t>
              </a:r>
              <a:endParaRPr lang="es-ES" sz="1200"/>
            </a:p>
          </p:txBody>
        </p:sp>
        <p:sp>
          <p:nvSpPr>
            <p:cNvPr id="245" name="Rectangle 95"/>
            <p:cNvSpPr>
              <a:spLocks noChangeArrowheads="1"/>
            </p:cNvSpPr>
            <p:nvPr/>
          </p:nvSpPr>
          <p:spPr bwMode="auto">
            <a:xfrm rot="5400000">
              <a:off x="124" y="2565"/>
              <a:ext cx="41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b="1">
                  <a:solidFill>
                    <a:srgbClr val="000000"/>
                  </a:solidFill>
                </a:rPr>
                <a:t>Resp. Diff.</a:t>
              </a:r>
              <a:endParaRPr lang="es-ES" sz="1200"/>
            </a:p>
          </p:txBody>
        </p:sp>
        <p:sp>
          <p:nvSpPr>
            <p:cNvPr id="246" name="Rectangle 96"/>
            <p:cNvSpPr>
              <a:spLocks noChangeArrowheads="1"/>
            </p:cNvSpPr>
            <p:nvPr/>
          </p:nvSpPr>
          <p:spPr bwMode="auto">
            <a:xfrm>
              <a:off x="5383" y="3800"/>
              <a:ext cx="4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s</a:t>
              </a:r>
              <a:endParaRPr lang="es-ES" sz="1200"/>
            </a:p>
          </p:txBody>
        </p:sp>
        <p:sp>
          <p:nvSpPr>
            <p:cNvPr id="247" name="Rectangle 97"/>
            <p:cNvSpPr>
              <a:spLocks noChangeArrowheads="1"/>
            </p:cNvSpPr>
            <p:nvPr/>
          </p:nvSpPr>
          <p:spPr bwMode="auto">
            <a:xfrm>
              <a:off x="2837" y="3800"/>
              <a:ext cx="19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b="1">
                  <a:solidFill>
                    <a:srgbClr val="000000"/>
                  </a:solidFill>
                </a:rPr>
                <a:t>Time</a:t>
              </a:r>
              <a:endParaRPr lang="es-ES" sz="1200"/>
            </a:p>
          </p:txBody>
        </p:sp>
        <p:sp>
          <p:nvSpPr>
            <p:cNvPr id="248" name="Freeform 98"/>
            <p:cNvSpPr>
              <a:spLocks/>
            </p:cNvSpPr>
            <p:nvPr/>
          </p:nvSpPr>
          <p:spPr bwMode="auto">
            <a:xfrm>
              <a:off x="783" y="1848"/>
              <a:ext cx="4113" cy="1303"/>
            </a:xfrm>
            <a:custGeom>
              <a:avLst/>
              <a:gdLst>
                <a:gd name="T0" fmla="*/ 65 w 4113"/>
                <a:gd name="T1" fmla="*/ 990 h 1303"/>
                <a:gd name="T2" fmla="*/ 140 w 4113"/>
                <a:gd name="T3" fmla="*/ 987 h 1303"/>
                <a:gd name="T4" fmla="*/ 215 w 4113"/>
                <a:gd name="T5" fmla="*/ 985 h 1303"/>
                <a:gd name="T6" fmla="*/ 289 w 4113"/>
                <a:gd name="T7" fmla="*/ 967 h 1303"/>
                <a:gd name="T8" fmla="*/ 364 w 4113"/>
                <a:gd name="T9" fmla="*/ 856 h 1303"/>
                <a:gd name="T10" fmla="*/ 439 w 4113"/>
                <a:gd name="T11" fmla="*/ 737 h 1303"/>
                <a:gd name="T12" fmla="*/ 513 w 4113"/>
                <a:gd name="T13" fmla="*/ 650 h 1303"/>
                <a:gd name="T14" fmla="*/ 588 w 4113"/>
                <a:gd name="T15" fmla="*/ 578 h 1303"/>
                <a:gd name="T16" fmla="*/ 663 w 4113"/>
                <a:gd name="T17" fmla="*/ 521 h 1303"/>
                <a:gd name="T18" fmla="*/ 737 w 4113"/>
                <a:gd name="T19" fmla="*/ 474 h 1303"/>
                <a:gd name="T20" fmla="*/ 812 w 4113"/>
                <a:gd name="T21" fmla="*/ 432 h 1303"/>
                <a:gd name="T22" fmla="*/ 888 w 4113"/>
                <a:gd name="T23" fmla="*/ 396 h 1303"/>
                <a:gd name="T24" fmla="*/ 963 w 4113"/>
                <a:gd name="T25" fmla="*/ 359 h 1303"/>
                <a:gd name="T26" fmla="*/ 1038 w 4113"/>
                <a:gd name="T27" fmla="*/ 332 h 1303"/>
                <a:gd name="T28" fmla="*/ 1112 w 4113"/>
                <a:gd name="T29" fmla="*/ 300 h 1303"/>
                <a:gd name="T30" fmla="*/ 1187 w 4113"/>
                <a:gd name="T31" fmla="*/ 273 h 1303"/>
                <a:gd name="T32" fmla="*/ 1262 w 4113"/>
                <a:gd name="T33" fmla="*/ 248 h 1303"/>
                <a:gd name="T34" fmla="*/ 1336 w 4113"/>
                <a:gd name="T35" fmla="*/ 221 h 1303"/>
                <a:gd name="T36" fmla="*/ 1411 w 4113"/>
                <a:gd name="T37" fmla="*/ 196 h 1303"/>
                <a:gd name="T38" fmla="*/ 1486 w 4113"/>
                <a:gd name="T39" fmla="*/ 173 h 1303"/>
                <a:gd name="T40" fmla="*/ 1560 w 4113"/>
                <a:gd name="T41" fmla="*/ 150 h 1303"/>
                <a:gd name="T42" fmla="*/ 1635 w 4113"/>
                <a:gd name="T43" fmla="*/ 130 h 1303"/>
                <a:gd name="T44" fmla="*/ 1710 w 4113"/>
                <a:gd name="T45" fmla="*/ 110 h 1303"/>
                <a:gd name="T46" fmla="*/ 1784 w 4113"/>
                <a:gd name="T47" fmla="*/ 88 h 1303"/>
                <a:gd name="T48" fmla="*/ 1859 w 4113"/>
                <a:gd name="T49" fmla="*/ 67 h 1303"/>
                <a:gd name="T50" fmla="*/ 1935 w 4113"/>
                <a:gd name="T51" fmla="*/ 49 h 1303"/>
                <a:gd name="T52" fmla="*/ 2010 w 4113"/>
                <a:gd name="T53" fmla="*/ 32 h 1303"/>
                <a:gd name="T54" fmla="*/ 2085 w 4113"/>
                <a:gd name="T55" fmla="*/ 15 h 1303"/>
                <a:gd name="T56" fmla="*/ 2159 w 4113"/>
                <a:gd name="T57" fmla="*/ 10 h 1303"/>
                <a:gd name="T58" fmla="*/ 2234 w 4113"/>
                <a:gd name="T59" fmla="*/ 30 h 1303"/>
                <a:gd name="T60" fmla="*/ 2309 w 4113"/>
                <a:gd name="T61" fmla="*/ 51 h 1303"/>
                <a:gd name="T62" fmla="*/ 2383 w 4113"/>
                <a:gd name="T63" fmla="*/ 65 h 1303"/>
                <a:gd name="T64" fmla="*/ 2458 w 4113"/>
                <a:gd name="T65" fmla="*/ 72 h 1303"/>
                <a:gd name="T66" fmla="*/ 2533 w 4113"/>
                <a:gd name="T67" fmla="*/ 81 h 1303"/>
                <a:gd name="T68" fmla="*/ 2607 w 4113"/>
                <a:gd name="T69" fmla="*/ 91 h 1303"/>
                <a:gd name="T70" fmla="*/ 2682 w 4113"/>
                <a:gd name="T71" fmla="*/ 91 h 1303"/>
                <a:gd name="T72" fmla="*/ 2757 w 4113"/>
                <a:gd name="T73" fmla="*/ 94 h 1303"/>
                <a:gd name="T74" fmla="*/ 2831 w 4113"/>
                <a:gd name="T75" fmla="*/ 96 h 1303"/>
                <a:gd name="T76" fmla="*/ 2906 w 4113"/>
                <a:gd name="T77" fmla="*/ 96 h 1303"/>
                <a:gd name="T78" fmla="*/ 2982 w 4113"/>
                <a:gd name="T79" fmla="*/ 97 h 1303"/>
                <a:gd name="T80" fmla="*/ 3057 w 4113"/>
                <a:gd name="T81" fmla="*/ 97 h 1303"/>
                <a:gd name="T82" fmla="*/ 3132 w 4113"/>
                <a:gd name="T83" fmla="*/ 96 h 1303"/>
                <a:gd name="T84" fmla="*/ 3206 w 4113"/>
                <a:gd name="T85" fmla="*/ 94 h 1303"/>
                <a:gd name="T86" fmla="*/ 3281 w 4113"/>
                <a:gd name="T87" fmla="*/ 91 h 1303"/>
                <a:gd name="T88" fmla="*/ 3356 w 4113"/>
                <a:gd name="T89" fmla="*/ 91 h 1303"/>
                <a:gd name="T90" fmla="*/ 3430 w 4113"/>
                <a:gd name="T91" fmla="*/ 88 h 1303"/>
                <a:gd name="T92" fmla="*/ 3505 w 4113"/>
                <a:gd name="T93" fmla="*/ 86 h 1303"/>
                <a:gd name="T94" fmla="*/ 3580 w 4113"/>
                <a:gd name="T95" fmla="*/ 84 h 1303"/>
                <a:gd name="T96" fmla="*/ 3654 w 4113"/>
                <a:gd name="T97" fmla="*/ 81 h 1303"/>
                <a:gd name="T98" fmla="*/ 3729 w 4113"/>
                <a:gd name="T99" fmla="*/ 84 h 1303"/>
                <a:gd name="T100" fmla="*/ 3804 w 4113"/>
                <a:gd name="T101" fmla="*/ 81 h 1303"/>
                <a:gd name="T102" fmla="*/ 3878 w 4113"/>
                <a:gd name="T103" fmla="*/ 91 h 1303"/>
                <a:gd name="T104" fmla="*/ 3953 w 4113"/>
                <a:gd name="T105" fmla="*/ 84 h 1303"/>
                <a:gd name="T106" fmla="*/ 4029 w 4113"/>
                <a:gd name="T107" fmla="*/ 81 h 1303"/>
                <a:gd name="T108" fmla="*/ 4104 w 4113"/>
                <a:gd name="T109" fmla="*/ 83 h 13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113" h="1303">
                  <a:moveTo>
                    <a:pt x="0" y="991"/>
                  </a:moveTo>
                  <a:lnTo>
                    <a:pt x="11" y="991"/>
                  </a:lnTo>
                  <a:lnTo>
                    <a:pt x="22" y="993"/>
                  </a:lnTo>
                  <a:lnTo>
                    <a:pt x="34" y="991"/>
                  </a:lnTo>
                  <a:lnTo>
                    <a:pt x="43" y="991"/>
                  </a:lnTo>
                  <a:lnTo>
                    <a:pt x="54" y="991"/>
                  </a:lnTo>
                  <a:lnTo>
                    <a:pt x="65" y="990"/>
                  </a:lnTo>
                  <a:lnTo>
                    <a:pt x="76" y="988"/>
                  </a:lnTo>
                  <a:lnTo>
                    <a:pt x="86" y="987"/>
                  </a:lnTo>
                  <a:lnTo>
                    <a:pt x="97" y="988"/>
                  </a:lnTo>
                  <a:lnTo>
                    <a:pt x="108" y="987"/>
                  </a:lnTo>
                  <a:lnTo>
                    <a:pt x="118" y="988"/>
                  </a:lnTo>
                  <a:lnTo>
                    <a:pt x="129" y="990"/>
                  </a:lnTo>
                  <a:lnTo>
                    <a:pt x="140" y="987"/>
                  </a:lnTo>
                  <a:lnTo>
                    <a:pt x="151" y="987"/>
                  </a:lnTo>
                  <a:lnTo>
                    <a:pt x="161" y="987"/>
                  </a:lnTo>
                  <a:lnTo>
                    <a:pt x="172" y="987"/>
                  </a:lnTo>
                  <a:lnTo>
                    <a:pt x="183" y="985"/>
                  </a:lnTo>
                  <a:lnTo>
                    <a:pt x="192" y="985"/>
                  </a:lnTo>
                  <a:lnTo>
                    <a:pt x="204" y="985"/>
                  </a:lnTo>
                  <a:lnTo>
                    <a:pt x="215" y="985"/>
                  </a:lnTo>
                  <a:lnTo>
                    <a:pt x="226" y="977"/>
                  </a:lnTo>
                  <a:lnTo>
                    <a:pt x="235" y="969"/>
                  </a:lnTo>
                  <a:lnTo>
                    <a:pt x="246" y="979"/>
                  </a:lnTo>
                  <a:lnTo>
                    <a:pt x="258" y="987"/>
                  </a:lnTo>
                  <a:lnTo>
                    <a:pt x="269" y="726"/>
                  </a:lnTo>
                  <a:lnTo>
                    <a:pt x="278" y="194"/>
                  </a:lnTo>
                  <a:lnTo>
                    <a:pt x="289" y="967"/>
                  </a:lnTo>
                  <a:lnTo>
                    <a:pt x="300" y="1303"/>
                  </a:lnTo>
                  <a:lnTo>
                    <a:pt x="310" y="1168"/>
                  </a:lnTo>
                  <a:lnTo>
                    <a:pt x="321" y="1034"/>
                  </a:lnTo>
                  <a:lnTo>
                    <a:pt x="332" y="956"/>
                  </a:lnTo>
                  <a:lnTo>
                    <a:pt x="343" y="912"/>
                  </a:lnTo>
                  <a:lnTo>
                    <a:pt x="353" y="880"/>
                  </a:lnTo>
                  <a:lnTo>
                    <a:pt x="364" y="856"/>
                  </a:lnTo>
                  <a:lnTo>
                    <a:pt x="375" y="836"/>
                  </a:lnTo>
                  <a:lnTo>
                    <a:pt x="386" y="818"/>
                  </a:lnTo>
                  <a:lnTo>
                    <a:pt x="396" y="801"/>
                  </a:lnTo>
                  <a:lnTo>
                    <a:pt x="407" y="783"/>
                  </a:lnTo>
                  <a:lnTo>
                    <a:pt x="418" y="769"/>
                  </a:lnTo>
                  <a:lnTo>
                    <a:pt x="428" y="753"/>
                  </a:lnTo>
                  <a:lnTo>
                    <a:pt x="439" y="737"/>
                  </a:lnTo>
                  <a:lnTo>
                    <a:pt x="450" y="724"/>
                  </a:lnTo>
                  <a:lnTo>
                    <a:pt x="461" y="709"/>
                  </a:lnTo>
                  <a:lnTo>
                    <a:pt x="470" y="696"/>
                  </a:lnTo>
                  <a:lnTo>
                    <a:pt x="482" y="683"/>
                  </a:lnTo>
                  <a:lnTo>
                    <a:pt x="493" y="670"/>
                  </a:lnTo>
                  <a:lnTo>
                    <a:pt x="502" y="659"/>
                  </a:lnTo>
                  <a:lnTo>
                    <a:pt x="513" y="650"/>
                  </a:lnTo>
                  <a:lnTo>
                    <a:pt x="524" y="639"/>
                  </a:lnTo>
                  <a:lnTo>
                    <a:pt x="536" y="629"/>
                  </a:lnTo>
                  <a:lnTo>
                    <a:pt x="545" y="618"/>
                  </a:lnTo>
                  <a:lnTo>
                    <a:pt x="556" y="607"/>
                  </a:lnTo>
                  <a:lnTo>
                    <a:pt x="567" y="596"/>
                  </a:lnTo>
                  <a:lnTo>
                    <a:pt x="578" y="588"/>
                  </a:lnTo>
                  <a:lnTo>
                    <a:pt x="588" y="578"/>
                  </a:lnTo>
                  <a:lnTo>
                    <a:pt x="599" y="570"/>
                  </a:lnTo>
                  <a:lnTo>
                    <a:pt x="610" y="561"/>
                  </a:lnTo>
                  <a:lnTo>
                    <a:pt x="620" y="553"/>
                  </a:lnTo>
                  <a:lnTo>
                    <a:pt x="631" y="543"/>
                  </a:lnTo>
                  <a:lnTo>
                    <a:pt x="642" y="537"/>
                  </a:lnTo>
                  <a:lnTo>
                    <a:pt x="653" y="528"/>
                  </a:lnTo>
                  <a:lnTo>
                    <a:pt x="663" y="521"/>
                  </a:lnTo>
                  <a:lnTo>
                    <a:pt x="674" y="515"/>
                  </a:lnTo>
                  <a:lnTo>
                    <a:pt x="685" y="507"/>
                  </a:lnTo>
                  <a:lnTo>
                    <a:pt x="696" y="501"/>
                  </a:lnTo>
                  <a:lnTo>
                    <a:pt x="706" y="493"/>
                  </a:lnTo>
                  <a:lnTo>
                    <a:pt x="717" y="486"/>
                  </a:lnTo>
                  <a:lnTo>
                    <a:pt x="728" y="480"/>
                  </a:lnTo>
                  <a:lnTo>
                    <a:pt x="737" y="474"/>
                  </a:lnTo>
                  <a:lnTo>
                    <a:pt x="748" y="467"/>
                  </a:lnTo>
                  <a:lnTo>
                    <a:pt x="760" y="461"/>
                  </a:lnTo>
                  <a:lnTo>
                    <a:pt x="771" y="454"/>
                  </a:lnTo>
                  <a:lnTo>
                    <a:pt x="780" y="448"/>
                  </a:lnTo>
                  <a:lnTo>
                    <a:pt x="791" y="442"/>
                  </a:lnTo>
                  <a:lnTo>
                    <a:pt x="802" y="437"/>
                  </a:lnTo>
                  <a:lnTo>
                    <a:pt x="812" y="432"/>
                  </a:lnTo>
                  <a:lnTo>
                    <a:pt x="823" y="426"/>
                  </a:lnTo>
                  <a:lnTo>
                    <a:pt x="834" y="420"/>
                  </a:lnTo>
                  <a:lnTo>
                    <a:pt x="845" y="416"/>
                  </a:lnTo>
                  <a:lnTo>
                    <a:pt x="855" y="410"/>
                  </a:lnTo>
                  <a:lnTo>
                    <a:pt x="866" y="402"/>
                  </a:lnTo>
                  <a:lnTo>
                    <a:pt x="877" y="399"/>
                  </a:lnTo>
                  <a:lnTo>
                    <a:pt x="888" y="396"/>
                  </a:lnTo>
                  <a:lnTo>
                    <a:pt x="898" y="389"/>
                  </a:lnTo>
                  <a:lnTo>
                    <a:pt x="909" y="385"/>
                  </a:lnTo>
                  <a:lnTo>
                    <a:pt x="920" y="378"/>
                  </a:lnTo>
                  <a:lnTo>
                    <a:pt x="930" y="373"/>
                  </a:lnTo>
                  <a:lnTo>
                    <a:pt x="941" y="369"/>
                  </a:lnTo>
                  <a:lnTo>
                    <a:pt x="952" y="364"/>
                  </a:lnTo>
                  <a:lnTo>
                    <a:pt x="963" y="359"/>
                  </a:lnTo>
                  <a:lnTo>
                    <a:pt x="972" y="358"/>
                  </a:lnTo>
                  <a:lnTo>
                    <a:pt x="984" y="353"/>
                  </a:lnTo>
                  <a:lnTo>
                    <a:pt x="995" y="350"/>
                  </a:lnTo>
                  <a:lnTo>
                    <a:pt x="1006" y="343"/>
                  </a:lnTo>
                  <a:lnTo>
                    <a:pt x="1015" y="340"/>
                  </a:lnTo>
                  <a:lnTo>
                    <a:pt x="1026" y="335"/>
                  </a:lnTo>
                  <a:lnTo>
                    <a:pt x="1038" y="332"/>
                  </a:lnTo>
                  <a:lnTo>
                    <a:pt x="1047" y="326"/>
                  </a:lnTo>
                  <a:lnTo>
                    <a:pt x="1058" y="321"/>
                  </a:lnTo>
                  <a:lnTo>
                    <a:pt x="1069" y="318"/>
                  </a:lnTo>
                  <a:lnTo>
                    <a:pt x="1081" y="313"/>
                  </a:lnTo>
                  <a:lnTo>
                    <a:pt x="1090" y="310"/>
                  </a:lnTo>
                  <a:lnTo>
                    <a:pt x="1101" y="305"/>
                  </a:lnTo>
                  <a:lnTo>
                    <a:pt x="1112" y="300"/>
                  </a:lnTo>
                  <a:lnTo>
                    <a:pt x="1123" y="297"/>
                  </a:lnTo>
                  <a:lnTo>
                    <a:pt x="1133" y="294"/>
                  </a:lnTo>
                  <a:lnTo>
                    <a:pt x="1144" y="291"/>
                  </a:lnTo>
                  <a:lnTo>
                    <a:pt x="1155" y="285"/>
                  </a:lnTo>
                  <a:lnTo>
                    <a:pt x="1165" y="281"/>
                  </a:lnTo>
                  <a:lnTo>
                    <a:pt x="1176" y="278"/>
                  </a:lnTo>
                  <a:lnTo>
                    <a:pt x="1187" y="273"/>
                  </a:lnTo>
                  <a:lnTo>
                    <a:pt x="1198" y="269"/>
                  </a:lnTo>
                  <a:lnTo>
                    <a:pt x="1208" y="265"/>
                  </a:lnTo>
                  <a:lnTo>
                    <a:pt x="1219" y="262"/>
                  </a:lnTo>
                  <a:lnTo>
                    <a:pt x="1230" y="258"/>
                  </a:lnTo>
                  <a:lnTo>
                    <a:pt x="1239" y="256"/>
                  </a:lnTo>
                  <a:lnTo>
                    <a:pt x="1251" y="251"/>
                  </a:lnTo>
                  <a:lnTo>
                    <a:pt x="1262" y="248"/>
                  </a:lnTo>
                  <a:lnTo>
                    <a:pt x="1273" y="243"/>
                  </a:lnTo>
                  <a:lnTo>
                    <a:pt x="1282" y="238"/>
                  </a:lnTo>
                  <a:lnTo>
                    <a:pt x="1293" y="235"/>
                  </a:lnTo>
                  <a:lnTo>
                    <a:pt x="1305" y="231"/>
                  </a:lnTo>
                  <a:lnTo>
                    <a:pt x="1316" y="227"/>
                  </a:lnTo>
                  <a:lnTo>
                    <a:pt x="1325" y="224"/>
                  </a:lnTo>
                  <a:lnTo>
                    <a:pt x="1336" y="221"/>
                  </a:lnTo>
                  <a:lnTo>
                    <a:pt x="1347" y="218"/>
                  </a:lnTo>
                  <a:lnTo>
                    <a:pt x="1357" y="215"/>
                  </a:lnTo>
                  <a:lnTo>
                    <a:pt x="1368" y="210"/>
                  </a:lnTo>
                  <a:lnTo>
                    <a:pt x="1379" y="207"/>
                  </a:lnTo>
                  <a:lnTo>
                    <a:pt x="1390" y="204"/>
                  </a:lnTo>
                  <a:lnTo>
                    <a:pt x="1400" y="200"/>
                  </a:lnTo>
                  <a:lnTo>
                    <a:pt x="1411" y="196"/>
                  </a:lnTo>
                  <a:lnTo>
                    <a:pt x="1422" y="194"/>
                  </a:lnTo>
                  <a:lnTo>
                    <a:pt x="1433" y="189"/>
                  </a:lnTo>
                  <a:lnTo>
                    <a:pt x="1443" y="188"/>
                  </a:lnTo>
                  <a:lnTo>
                    <a:pt x="1454" y="184"/>
                  </a:lnTo>
                  <a:lnTo>
                    <a:pt x="1465" y="181"/>
                  </a:lnTo>
                  <a:lnTo>
                    <a:pt x="1475" y="178"/>
                  </a:lnTo>
                  <a:lnTo>
                    <a:pt x="1486" y="173"/>
                  </a:lnTo>
                  <a:lnTo>
                    <a:pt x="1497" y="169"/>
                  </a:lnTo>
                  <a:lnTo>
                    <a:pt x="1508" y="167"/>
                  </a:lnTo>
                  <a:lnTo>
                    <a:pt x="1517" y="164"/>
                  </a:lnTo>
                  <a:lnTo>
                    <a:pt x="1529" y="161"/>
                  </a:lnTo>
                  <a:lnTo>
                    <a:pt x="1540" y="157"/>
                  </a:lnTo>
                  <a:lnTo>
                    <a:pt x="1549" y="154"/>
                  </a:lnTo>
                  <a:lnTo>
                    <a:pt x="1560" y="150"/>
                  </a:lnTo>
                  <a:lnTo>
                    <a:pt x="1571" y="146"/>
                  </a:lnTo>
                  <a:lnTo>
                    <a:pt x="1583" y="143"/>
                  </a:lnTo>
                  <a:lnTo>
                    <a:pt x="1592" y="142"/>
                  </a:lnTo>
                  <a:lnTo>
                    <a:pt x="1603" y="138"/>
                  </a:lnTo>
                  <a:lnTo>
                    <a:pt x="1614" y="135"/>
                  </a:lnTo>
                  <a:lnTo>
                    <a:pt x="1625" y="132"/>
                  </a:lnTo>
                  <a:lnTo>
                    <a:pt x="1635" y="130"/>
                  </a:lnTo>
                  <a:lnTo>
                    <a:pt x="1646" y="127"/>
                  </a:lnTo>
                  <a:lnTo>
                    <a:pt x="1657" y="124"/>
                  </a:lnTo>
                  <a:lnTo>
                    <a:pt x="1667" y="121"/>
                  </a:lnTo>
                  <a:lnTo>
                    <a:pt x="1678" y="119"/>
                  </a:lnTo>
                  <a:lnTo>
                    <a:pt x="1689" y="116"/>
                  </a:lnTo>
                  <a:lnTo>
                    <a:pt x="1700" y="113"/>
                  </a:lnTo>
                  <a:lnTo>
                    <a:pt x="1710" y="110"/>
                  </a:lnTo>
                  <a:lnTo>
                    <a:pt x="1721" y="105"/>
                  </a:lnTo>
                  <a:lnTo>
                    <a:pt x="1732" y="103"/>
                  </a:lnTo>
                  <a:lnTo>
                    <a:pt x="1743" y="100"/>
                  </a:lnTo>
                  <a:lnTo>
                    <a:pt x="1753" y="97"/>
                  </a:lnTo>
                  <a:lnTo>
                    <a:pt x="1764" y="94"/>
                  </a:lnTo>
                  <a:lnTo>
                    <a:pt x="1775" y="91"/>
                  </a:lnTo>
                  <a:lnTo>
                    <a:pt x="1784" y="88"/>
                  </a:lnTo>
                  <a:lnTo>
                    <a:pt x="1795" y="86"/>
                  </a:lnTo>
                  <a:lnTo>
                    <a:pt x="1807" y="84"/>
                  </a:lnTo>
                  <a:lnTo>
                    <a:pt x="1818" y="81"/>
                  </a:lnTo>
                  <a:lnTo>
                    <a:pt x="1827" y="78"/>
                  </a:lnTo>
                  <a:lnTo>
                    <a:pt x="1838" y="75"/>
                  </a:lnTo>
                  <a:lnTo>
                    <a:pt x="1849" y="72"/>
                  </a:lnTo>
                  <a:lnTo>
                    <a:pt x="1859" y="67"/>
                  </a:lnTo>
                  <a:lnTo>
                    <a:pt x="1870" y="65"/>
                  </a:lnTo>
                  <a:lnTo>
                    <a:pt x="1881" y="64"/>
                  </a:lnTo>
                  <a:lnTo>
                    <a:pt x="1892" y="61"/>
                  </a:lnTo>
                  <a:lnTo>
                    <a:pt x="1902" y="57"/>
                  </a:lnTo>
                  <a:lnTo>
                    <a:pt x="1913" y="54"/>
                  </a:lnTo>
                  <a:lnTo>
                    <a:pt x="1924" y="53"/>
                  </a:lnTo>
                  <a:lnTo>
                    <a:pt x="1935" y="49"/>
                  </a:lnTo>
                  <a:lnTo>
                    <a:pt x="1945" y="46"/>
                  </a:lnTo>
                  <a:lnTo>
                    <a:pt x="1956" y="45"/>
                  </a:lnTo>
                  <a:lnTo>
                    <a:pt x="1967" y="42"/>
                  </a:lnTo>
                  <a:lnTo>
                    <a:pt x="1977" y="40"/>
                  </a:lnTo>
                  <a:lnTo>
                    <a:pt x="1988" y="37"/>
                  </a:lnTo>
                  <a:lnTo>
                    <a:pt x="1999" y="35"/>
                  </a:lnTo>
                  <a:lnTo>
                    <a:pt x="2010" y="32"/>
                  </a:lnTo>
                  <a:lnTo>
                    <a:pt x="2019" y="30"/>
                  </a:lnTo>
                  <a:lnTo>
                    <a:pt x="2031" y="26"/>
                  </a:lnTo>
                  <a:lnTo>
                    <a:pt x="2042" y="24"/>
                  </a:lnTo>
                  <a:lnTo>
                    <a:pt x="2053" y="21"/>
                  </a:lnTo>
                  <a:lnTo>
                    <a:pt x="2062" y="19"/>
                  </a:lnTo>
                  <a:lnTo>
                    <a:pt x="2073" y="18"/>
                  </a:lnTo>
                  <a:lnTo>
                    <a:pt x="2085" y="15"/>
                  </a:lnTo>
                  <a:lnTo>
                    <a:pt x="2094" y="11"/>
                  </a:lnTo>
                  <a:lnTo>
                    <a:pt x="2105" y="8"/>
                  </a:lnTo>
                  <a:lnTo>
                    <a:pt x="2116" y="5"/>
                  </a:lnTo>
                  <a:lnTo>
                    <a:pt x="2127" y="3"/>
                  </a:lnTo>
                  <a:lnTo>
                    <a:pt x="2137" y="0"/>
                  </a:lnTo>
                  <a:lnTo>
                    <a:pt x="2148" y="0"/>
                  </a:lnTo>
                  <a:lnTo>
                    <a:pt x="2159" y="10"/>
                  </a:lnTo>
                  <a:lnTo>
                    <a:pt x="2170" y="5"/>
                  </a:lnTo>
                  <a:lnTo>
                    <a:pt x="2180" y="62"/>
                  </a:lnTo>
                  <a:lnTo>
                    <a:pt x="2191" y="40"/>
                  </a:lnTo>
                  <a:lnTo>
                    <a:pt x="2202" y="18"/>
                  </a:lnTo>
                  <a:lnTo>
                    <a:pt x="2212" y="24"/>
                  </a:lnTo>
                  <a:lnTo>
                    <a:pt x="2223" y="27"/>
                  </a:lnTo>
                  <a:lnTo>
                    <a:pt x="2234" y="30"/>
                  </a:lnTo>
                  <a:lnTo>
                    <a:pt x="2245" y="34"/>
                  </a:lnTo>
                  <a:lnTo>
                    <a:pt x="2255" y="37"/>
                  </a:lnTo>
                  <a:lnTo>
                    <a:pt x="2266" y="42"/>
                  </a:lnTo>
                  <a:lnTo>
                    <a:pt x="2277" y="43"/>
                  </a:lnTo>
                  <a:lnTo>
                    <a:pt x="2286" y="46"/>
                  </a:lnTo>
                  <a:lnTo>
                    <a:pt x="2297" y="49"/>
                  </a:lnTo>
                  <a:lnTo>
                    <a:pt x="2309" y="51"/>
                  </a:lnTo>
                  <a:lnTo>
                    <a:pt x="2320" y="51"/>
                  </a:lnTo>
                  <a:lnTo>
                    <a:pt x="2329" y="56"/>
                  </a:lnTo>
                  <a:lnTo>
                    <a:pt x="2340" y="57"/>
                  </a:lnTo>
                  <a:lnTo>
                    <a:pt x="2351" y="61"/>
                  </a:lnTo>
                  <a:lnTo>
                    <a:pt x="2363" y="64"/>
                  </a:lnTo>
                  <a:lnTo>
                    <a:pt x="2372" y="64"/>
                  </a:lnTo>
                  <a:lnTo>
                    <a:pt x="2383" y="65"/>
                  </a:lnTo>
                  <a:lnTo>
                    <a:pt x="2394" y="67"/>
                  </a:lnTo>
                  <a:lnTo>
                    <a:pt x="2404" y="69"/>
                  </a:lnTo>
                  <a:lnTo>
                    <a:pt x="2415" y="70"/>
                  </a:lnTo>
                  <a:lnTo>
                    <a:pt x="2426" y="69"/>
                  </a:lnTo>
                  <a:lnTo>
                    <a:pt x="2437" y="72"/>
                  </a:lnTo>
                  <a:lnTo>
                    <a:pt x="2447" y="72"/>
                  </a:lnTo>
                  <a:lnTo>
                    <a:pt x="2458" y="72"/>
                  </a:lnTo>
                  <a:lnTo>
                    <a:pt x="2469" y="75"/>
                  </a:lnTo>
                  <a:lnTo>
                    <a:pt x="2480" y="76"/>
                  </a:lnTo>
                  <a:lnTo>
                    <a:pt x="2490" y="78"/>
                  </a:lnTo>
                  <a:lnTo>
                    <a:pt x="2501" y="78"/>
                  </a:lnTo>
                  <a:lnTo>
                    <a:pt x="2512" y="80"/>
                  </a:lnTo>
                  <a:lnTo>
                    <a:pt x="2521" y="81"/>
                  </a:lnTo>
                  <a:lnTo>
                    <a:pt x="2533" y="81"/>
                  </a:lnTo>
                  <a:lnTo>
                    <a:pt x="2544" y="83"/>
                  </a:lnTo>
                  <a:lnTo>
                    <a:pt x="2555" y="84"/>
                  </a:lnTo>
                  <a:lnTo>
                    <a:pt x="2564" y="84"/>
                  </a:lnTo>
                  <a:lnTo>
                    <a:pt x="2575" y="86"/>
                  </a:lnTo>
                  <a:lnTo>
                    <a:pt x="2587" y="88"/>
                  </a:lnTo>
                  <a:lnTo>
                    <a:pt x="2596" y="89"/>
                  </a:lnTo>
                  <a:lnTo>
                    <a:pt x="2607" y="91"/>
                  </a:lnTo>
                  <a:lnTo>
                    <a:pt x="2618" y="89"/>
                  </a:lnTo>
                  <a:lnTo>
                    <a:pt x="2630" y="89"/>
                  </a:lnTo>
                  <a:lnTo>
                    <a:pt x="2639" y="91"/>
                  </a:lnTo>
                  <a:lnTo>
                    <a:pt x="2650" y="92"/>
                  </a:lnTo>
                  <a:lnTo>
                    <a:pt x="2661" y="92"/>
                  </a:lnTo>
                  <a:lnTo>
                    <a:pt x="2672" y="92"/>
                  </a:lnTo>
                  <a:lnTo>
                    <a:pt x="2682" y="91"/>
                  </a:lnTo>
                  <a:lnTo>
                    <a:pt x="2693" y="92"/>
                  </a:lnTo>
                  <a:lnTo>
                    <a:pt x="2704" y="91"/>
                  </a:lnTo>
                  <a:lnTo>
                    <a:pt x="2714" y="92"/>
                  </a:lnTo>
                  <a:lnTo>
                    <a:pt x="2725" y="92"/>
                  </a:lnTo>
                  <a:lnTo>
                    <a:pt x="2736" y="92"/>
                  </a:lnTo>
                  <a:lnTo>
                    <a:pt x="2747" y="94"/>
                  </a:lnTo>
                  <a:lnTo>
                    <a:pt x="2757" y="94"/>
                  </a:lnTo>
                  <a:lnTo>
                    <a:pt x="2768" y="94"/>
                  </a:lnTo>
                  <a:lnTo>
                    <a:pt x="2779" y="94"/>
                  </a:lnTo>
                  <a:lnTo>
                    <a:pt x="2790" y="94"/>
                  </a:lnTo>
                  <a:lnTo>
                    <a:pt x="2800" y="94"/>
                  </a:lnTo>
                  <a:lnTo>
                    <a:pt x="2811" y="96"/>
                  </a:lnTo>
                  <a:lnTo>
                    <a:pt x="2822" y="94"/>
                  </a:lnTo>
                  <a:lnTo>
                    <a:pt x="2831" y="96"/>
                  </a:lnTo>
                  <a:lnTo>
                    <a:pt x="2842" y="96"/>
                  </a:lnTo>
                  <a:lnTo>
                    <a:pt x="2854" y="96"/>
                  </a:lnTo>
                  <a:lnTo>
                    <a:pt x="2865" y="96"/>
                  </a:lnTo>
                  <a:lnTo>
                    <a:pt x="2874" y="96"/>
                  </a:lnTo>
                  <a:lnTo>
                    <a:pt x="2885" y="96"/>
                  </a:lnTo>
                  <a:lnTo>
                    <a:pt x="2896" y="97"/>
                  </a:lnTo>
                  <a:lnTo>
                    <a:pt x="2906" y="96"/>
                  </a:lnTo>
                  <a:lnTo>
                    <a:pt x="2917" y="96"/>
                  </a:lnTo>
                  <a:lnTo>
                    <a:pt x="2928" y="97"/>
                  </a:lnTo>
                  <a:lnTo>
                    <a:pt x="2939" y="96"/>
                  </a:lnTo>
                  <a:lnTo>
                    <a:pt x="2949" y="96"/>
                  </a:lnTo>
                  <a:lnTo>
                    <a:pt x="2960" y="97"/>
                  </a:lnTo>
                  <a:lnTo>
                    <a:pt x="2971" y="97"/>
                  </a:lnTo>
                  <a:lnTo>
                    <a:pt x="2982" y="97"/>
                  </a:lnTo>
                  <a:lnTo>
                    <a:pt x="2992" y="97"/>
                  </a:lnTo>
                  <a:lnTo>
                    <a:pt x="3003" y="96"/>
                  </a:lnTo>
                  <a:lnTo>
                    <a:pt x="3014" y="97"/>
                  </a:lnTo>
                  <a:lnTo>
                    <a:pt x="3024" y="97"/>
                  </a:lnTo>
                  <a:lnTo>
                    <a:pt x="3035" y="96"/>
                  </a:lnTo>
                  <a:lnTo>
                    <a:pt x="3046" y="97"/>
                  </a:lnTo>
                  <a:lnTo>
                    <a:pt x="3057" y="97"/>
                  </a:lnTo>
                  <a:lnTo>
                    <a:pt x="3066" y="96"/>
                  </a:lnTo>
                  <a:lnTo>
                    <a:pt x="3078" y="96"/>
                  </a:lnTo>
                  <a:lnTo>
                    <a:pt x="3089" y="96"/>
                  </a:lnTo>
                  <a:lnTo>
                    <a:pt x="3100" y="96"/>
                  </a:lnTo>
                  <a:lnTo>
                    <a:pt x="3109" y="96"/>
                  </a:lnTo>
                  <a:lnTo>
                    <a:pt x="3120" y="96"/>
                  </a:lnTo>
                  <a:lnTo>
                    <a:pt x="3132" y="96"/>
                  </a:lnTo>
                  <a:lnTo>
                    <a:pt x="3141" y="94"/>
                  </a:lnTo>
                  <a:lnTo>
                    <a:pt x="3152" y="94"/>
                  </a:lnTo>
                  <a:lnTo>
                    <a:pt x="3163" y="94"/>
                  </a:lnTo>
                  <a:lnTo>
                    <a:pt x="3174" y="94"/>
                  </a:lnTo>
                  <a:lnTo>
                    <a:pt x="3184" y="94"/>
                  </a:lnTo>
                  <a:lnTo>
                    <a:pt x="3195" y="92"/>
                  </a:lnTo>
                  <a:lnTo>
                    <a:pt x="3206" y="94"/>
                  </a:lnTo>
                  <a:lnTo>
                    <a:pt x="3216" y="94"/>
                  </a:lnTo>
                  <a:lnTo>
                    <a:pt x="3227" y="92"/>
                  </a:lnTo>
                  <a:lnTo>
                    <a:pt x="3238" y="92"/>
                  </a:lnTo>
                  <a:lnTo>
                    <a:pt x="3249" y="92"/>
                  </a:lnTo>
                  <a:lnTo>
                    <a:pt x="3259" y="92"/>
                  </a:lnTo>
                  <a:lnTo>
                    <a:pt x="3270" y="91"/>
                  </a:lnTo>
                  <a:lnTo>
                    <a:pt x="3281" y="91"/>
                  </a:lnTo>
                  <a:lnTo>
                    <a:pt x="3292" y="92"/>
                  </a:lnTo>
                  <a:lnTo>
                    <a:pt x="3302" y="91"/>
                  </a:lnTo>
                  <a:lnTo>
                    <a:pt x="3313" y="91"/>
                  </a:lnTo>
                  <a:lnTo>
                    <a:pt x="3324" y="91"/>
                  </a:lnTo>
                  <a:lnTo>
                    <a:pt x="3333" y="91"/>
                  </a:lnTo>
                  <a:lnTo>
                    <a:pt x="3344" y="89"/>
                  </a:lnTo>
                  <a:lnTo>
                    <a:pt x="3356" y="91"/>
                  </a:lnTo>
                  <a:lnTo>
                    <a:pt x="3367" y="89"/>
                  </a:lnTo>
                  <a:lnTo>
                    <a:pt x="3376" y="88"/>
                  </a:lnTo>
                  <a:lnTo>
                    <a:pt x="3387" y="88"/>
                  </a:lnTo>
                  <a:lnTo>
                    <a:pt x="3398" y="88"/>
                  </a:lnTo>
                  <a:lnTo>
                    <a:pt x="3410" y="88"/>
                  </a:lnTo>
                  <a:lnTo>
                    <a:pt x="3419" y="88"/>
                  </a:lnTo>
                  <a:lnTo>
                    <a:pt x="3430" y="88"/>
                  </a:lnTo>
                  <a:lnTo>
                    <a:pt x="3441" y="88"/>
                  </a:lnTo>
                  <a:lnTo>
                    <a:pt x="3451" y="88"/>
                  </a:lnTo>
                  <a:lnTo>
                    <a:pt x="3462" y="86"/>
                  </a:lnTo>
                  <a:lnTo>
                    <a:pt x="3473" y="86"/>
                  </a:lnTo>
                  <a:lnTo>
                    <a:pt x="3484" y="88"/>
                  </a:lnTo>
                  <a:lnTo>
                    <a:pt x="3494" y="88"/>
                  </a:lnTo>
                  <a:lnTo>
                    <a:pt x="3505" y="86"/>
                  </a:lnTo>
                  <a:lnTo>
                    <a:pt x="3516" y="86"/>
                  </a:lnTo>
                  <a:lnTo>
                    <a:pt x="3527" y="86"/>
                  </a:lnTo>
                  <a:lnTo>
                    <a:pt x="3537" y="86"/>
                  </a:lnTo>
                  <a:lnTo>
                    <a:pt x="3548" y="88"/>
                  </a:lnTo>
                  <a:lnTo>
                    <a:pt x="3559" y="86"/>
                  </a:lnTo>
                  <a:lnTo>
                    <a:pt x="3568" y="84"/>
                  </a:lnTo>
                  <a:lnTo>
                    <a:pt x="3580" y="84"/>
                  </a:lnTo>
                  <a:lnTo>
                    <a:pt x="3591" y="84"/>
                  </a:lnTo>
                  <a:lnTo>
                    <a:pt x="3602" y="83"/>
                  </a:lnTo>
                  <a:lnTo>
                    <a:pt x="3611" y="83"/>
                  </a:lnTo>
                  <a:lnTo>
                    <a:pt x="3622" y="84"/>
                  </a:lnTo>
                  <a:lnTo>
                    <a:pt x="3634" y="81"/>
                  </a:lnTo>
                  <a:lnTo>
                    <a:pt x="3643" y="81"/>
                  </a:lnTo>
                  <a:lnTo>
                    <a:pt x="3654" y="81"/>
                  </a:lnTo>
                  <a:lnTo>
                    <a:pt x="3665" y="84"/>
                  </a:lnTo>
                  <a:lnTo>
                    <a:pt x="3676" y="84"/>
                  </a:lnTo>
                  <a:lnTo>
                    <a:pt x="3686" y="83"/>
                  </a:lnTo>
                  <a:lnTo>
                    <a:pt x="3697" y="83"/>
                  </a:lnTo>
                  <a:lnTo>
                    <a:pt x="3708" y="81"/>
                  </a:lnTo>
                  <a:lnTo>
                    <a:pt x="3719" y="84"/>
                  </a:lnTo>
                  <a:lnTo>
                    <a:pt x="3729" y="84"/>
                  </a:lnTo>
                  <a:lnTo>
                    <a:pt x="3740" y="83"/>
                  </a:lnTo>
                  <a:lnTo>
                    <a:pt x="3751" y="81"/>
                  </a:lnTo>
                  <a:lnTo>
                    <a:pt x="3761" y="83"/>
                  </a:lnTo>
                  <a:lnTo>
                    <a:pt x="3772" y="81"/>
                  </a:lnTo>
                  <a:lnTo>
                    <a:pt x="3783" y="86"/>
                  </a:lnTo>
                  <a:lnTo>
                    <a:pt x="3794" y="81"/>
                  </a:lnTo>
                  <a:lnTo>
                    <a:pt x="3804" y="81"/>
                  </a:lnTo>
                  <a:lnTo>
                    <a:pt x="3815" y="92"/>
                  </a:lnTo>
                  <a:lnTo>
                    <a:pt x="3826" y="94"/>
                  </a:lnTo>
                  <a:lnTo>
                    <a:pt x="3837" y="84"/>
                  </a:lnTo>
                  <a:lnTo>
                    <a:pt x="3846" y="83"/>
                  </a:lnTo>
                  <a:lnTo>
                    <a:pt x="3858" y="86"/>
                  </a:lnTo>
                  <a:lnTo>
                    <a:pt x="3869" y="97"/>
                  </a:lnTo>
                  <a:lnTo>
                    <a:pt x="3878" y="91"/>
                  </a:lnTo>
                  <a:lnTo>
                    <a:pt x="3889" y="75"/>
                  </a:lnTo>
                  <a:lnTo>
                    <a:pt x="3900" y="76"/>
                  </a:lnTo>
                  <a:lnTo>
                    <a:pt x="3912" y="80"/>
                  </a:lnTo>
                  <a:lnTo>
                    <a:pt x="3921" y="83"/>
                  </a:lnTo>
                  <a:lnTo>
                    <a:pt x="3932" y="83"/>
                  </a:lnTo>
                  <a:lnTo>
                    <a:pt x="3943" y="83"/>
                  </a:lnTo>
                  <a:lnTo>
                    <a:pt x="3953" y="84"/>
                  </a:lnTo>
                  <a:lnTo>
                    <a:pt x="3964" y="76"/>
                  </a:lnTo>
                  <a:lnTo>
                    <a:pt x="3975" y="73"/>
                  </a:lnTo>
                  <a:lnTo>
                    <a:pt x="3986" y="81"/>
                  </a:lnTo>
                  <a:lnTo>
                    <a:pt x="3996" y="89"/>
                  </a:lnTo>
                  <a:lnTo>
                    <a:pt x="4007" y="97"/>
                  </a:lnTo>
                  <a:lnTo>
                    <a:pt x="4018" y="89"/>
                  </a:lnTo>
                  <a:lnTo>
                    <a:pt x="4029" y="81"/>
                  </a:lnTo>
                  <a:lnTo>
                    <a:pt x="4039" y="83"/>
                  </a:lnTo>
                  <a:lnTo>
                    <a:pt x="4050" y="83"/>
                  </a:lnTo>
                  <a:lnTo>
                    <a:pt x="4061" y="81"/>
                  </a:lnTo>
                  <a:lnTo>
                    <a:pt x="4070" y="81"/>
                  </a:lnTo>
                  <a:lnTo>
                    <a:pt x="4082" y="83"/>
                  </a:lnTo>
                  <a:lnTo>
                    <a:pt x="4093" y="83"/>
                  </a:lnTo>
                  <a:lnTo>
                    <a:pt x="4104" y="83"/>
                  </a:lnTo>
                  <a:lnTo>
                    <a:pt x="4113" y="83"/>
                  </a:lnTo>
                </a:path>
              </a:pathLst>
            </a:custGeom>
            <a:noFill/>
            <a:ln w="0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49" name="Freeform 99"/>
            <p:cNvSpPr>
              <a:spLocks/>
            </p:cNvSpPr>
            <p:nvPr/>
          </p:nvSpPr>
          <p:spPr bwMode="auto">
            <a:xfrm>
              <a:off x="751" y="2080"/>
              <a:ext cx="4114" cy="1087"/>
            </a:xfrm>
            <a:custGeom>
              <a:avLst/>
              <a:gdLst>
                <a:gd name="T0" fmla="*/ 66 w 4114"/>
                <a:gd name="T1" fmla="*/ 758 h 1087"/>
                <a:gd name="T2" fmla="*/ 140 w 4114"/>
                <a:gd name="T3" fmla="*/ 755 h 1087"/>
                <a:gd name="T4" fmla="*/ 215 w 4114"/>
                <a:gd name="T5" fmla="*/ 753 h 1087"/>
                <a:gd name="T6" fmla="*/ 290 w 4114"/>
                <a:gd name="T7" fmla="*/ 647 h 1087"/>
                <a:gd name="T8" fmla="*/ 364 w 4114"/>
                <a:gd name="T9" fmla="*/ 772 h 1087"/>
                <a:gd name="T10" fmla="*/ 439 w 4114"/>
                <a:gd name="T11" fmla="*/ 666 h 1087"/>
                <a:gd name="T12" fmla="*/ 514 w 4114"/>
                <a:gd name="T13" fmla="*/ 613 h 1087"/>
                <a:gd name="T14" fmla="*/ 588 w 4114"/>
                <a:gd name="T15" fmla="*/ 566 h 1087"/>
                <a:gd name="T16" fmla="*/ 663 w 4114"/>
                <a:gd name="T17" fmla="*/ 527 h 1087"/>
                <a:gd name="T18" fmla="*/ 738 w 4114"/>
                <a:gd name="T19" fmla="*/ 494 h 1087"/>
                <a:gd name="T20" fmla="*/ 812 w 4114"/>
                <a:gd name="T21" fmla="*/ 464 h 1087"/>
                <a:gd name="T22" fmla="*/ 887 w 4114"/>
                <a:gd name="T23" fmla="*/ 435 h 1087"/>
                <a:gd name="T24" fmla="*/ 962 w 4114"/>
                <a:gd name="T25" fmla="*/ 411 h 1087"/>
                <a:gd name="T26" fmla="*/ 1038 w 4114"/>
                <a:gd name="T27" fmla="*/ 391 h 1087"/>
                <a:gd name="T28" fmla="*/ 1113 w 4114"/>
                <a:gd name="T29" fmla="*/ 369 h 1087"/>
                <a:gd name="T30" fmla="*/ 1187 w 4114"/>
                <a:gd name="T31" fmla="*/ 350 h 1087"/>
                <a:gd name="T32" fmla="*/ 1262 w 4114"/>
                <a:gd name="T33" fmla="*/ 332 h 1087"/>
                <a:gd name="T34" fmla="*/ 1337 w 4114"/>
                <a:gd name="T35" fmla="*/ 313 h 1087"/>
                <a:gd name="T36" fmla="*/ 1411 w 4114"/>
                <a:gd name="T37" fmla="*/ 294 h 1087"/>
                <a:gd name="T38" fmla="*/ 1486 w 4114"/>
                <a:gd name="T39" fmla="*/ 278 h 1087"/>
                <a:gd name="T40" fmla="*/ 1561 w 4114"/>
                <a:gd name="T41" fmla="*/ 262 h 1087"/>
                <a:gd name="T42" fmla="*/ 1635 w 4114"/>
                <a:gd name="T43" fmla="*/ 246 h 1087"/>
                <a:gd name="T44" fmla="*/ 1710 w 4114"/>
                <a:gd name="T45" fmla="*/ 230 h 1087"/>
                <a:gd name="T46" fmla="*/ 1785 w 4114"/>
                <a:gd name="T47" fmla="*/ 216 h 1087"/>
                <a:gd name="T48" fmla="*/ 1859 w 4114"/>
                <a:gd name="T49" fmla="*/ 202 h 1087"/>
                <a:gd name="T50" fmla="*/ 1934 w 4114"/>
                <a:gd name="T51" fmla="*/ 186 h 1087"/>
                <a:gd name="T52" fmla="*/ 2009 w 4114"/>
                <a:gd name="T53" fmla="*/ 172 h 1087"/>
                <a:gd name="T54" fmla="*/ 2085 w 4114"/>
                <a:gd name="T55" fmla="*/ 159 h 1087"/>
                <a:gd name="T56" fmla="*/ 2159 w 4114"/>
                <a:gd name="T57" fmla="*/ 145 h 1087"/>
                <a:gd name="T58" fmla="*/ 2234 w 4114"/>
                <a:gd name="T59" fmla="*/ 130 h 1087"/>
                <a:gd name="T60" fmla="*/ 2309 w 4114"/>
                <a:gd name="T61" fmla="*/ 159 h 1087"/>
                <a:gd name="T62" fmla="*/ 2383 w 4114"/>
                <a:gd name="T63" fmla="*/ 168 h 1087"/>
                <a:gd name="T64" fmla="*/ 2458 w 4114"/>
                <a:gd name="T65" fmla="*/ 170 h 1087"/>
                <a:gd name="T66" fmla="*/ 2533 w 4114"/>
                <a:gd name="T67" fmla="*/ 176 h 1087"/>
                <a:gd name="T68" fmla="*/ 2607 w 4114"/>
                <a:gd name="T69" fmla="*/ 178 h 1087"/>
                <a:gd name="T70" fmla="*/ 2682 w 4114"/>
                <a:gd name="T71" fmla="*/ 181 h 1087"/>
                <a:gd name="T72" fmla="*/ 2757 w 4114"/>
                <a:gd name="T73" fmla="*/ 178 h 1087"/>
                <a:gd name="T74" fmla="*/ 2832 w 4114"/>
                <a:gd name="T75" fmla="*/ 178 h 1087"/>
                <a:gd name="T76" fmla="*/ 2906 w 4114"/>
                <a:gd name="T77" fmla="*/ 181 h 1087"/>
                <a:gd name="T78" fmla="*/ 2981 w 4114"/>
                <a:gd name="T79" fmla="*/ 181 h 1087"/>
                <a:gd name="T80" fmla="*/ 3056 w 4114"/>
                <a:gd name="T81" fmla="*/ 181 h 1087"/>
                <a:gd name="T82" fmla="*/ 3132 w 4114"/>
                <a:gd name="T83" fmla="*/ 183 h 1087"/>
                <a:gd name="T84" fmla="*/ 3206 w 4114"/>
                <a:gd name="T85" fmla="*/ 184 h 1087"/>
                <a:gd name="T86" fmla="*/ 3281 w 4114"/>
                <a:gd name="T87" fmla="*/ 184 h 1087"/>
                <a:gd name="T88" fmla="*/ 3356 w 4114"/>
                <a:gd name="T89" fmla="*/ 184 h 1087"/>
                <a:gd name="T90" fmla="*/ 3430 w 4114"/>
                <a:gd name="T91" fmla="*/ 189 h 1087"/>
                <a:gd name="T92" fmla="*/ 3505 w 4114"/>
                <a:gd name="T93" fmla="*/ 191 h 1087"/>
                <a:gd name="T94" fmla="*/ 3580 w 4114"/>
                <a:gd name="T95" fmla="*/ 194 h 1087"/>
                <a:gd name="T96" fmla="*/ 3654 w 4114"/>
                <a:gd name="T97" fmla="*/ 197 h 1087"/>
                <a:gd name="T98" fmla="*/ 3729 w 4114"/>
                <a:gd name="T99" fmla="*/ 197 h 1087"/>
                <a:gd name="T100" fmla="*/ 3804 w 4114"/>
                <a:gd name="T101" fmla="*/ 199 h 1087"/>
                <a:gd name="T102" fmla="*/ 3878 w 4114"/>
                <a:gd name="T103" fmla="*/ 199 h 1087"/>
                <a:gd name="T104" fmla="*/ 3953 w 4114"/>
                <a:gd name="T105" fmla="*/ 203 h 1087"/>
                <a:gd name="T106" fmla="*/ 4028 w 4114"/>
                <a:gd name="T107" fmla="*/ 207 h 1087"/>
                <a:gd name="T108" fmla="*/ 4102 w 4114"/>
                <a:gd name="T109" fmla="*/ 208 h 10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114" h="1087">
                  <a:moveTo>
                    <a:pt x="0" y="761"/>
                  </a:moveTo>
                  <a:lnTo>
                    <a:pt x="12" y="759"/>
                  </a:lnTo>
                  <a:lnTo>
                    <a:pt x="23" y="759"/>
                  </a:lnTo>
                  <a:lnTo>
                    <a:pt x="32" y="759"/>
                  </a:lnTo>
                  <a:lnTo>
                    <a:pt x="43" y="759"/>
                  </a:lnTo>
                  <a:lnTo>
                    <a:pt x="54" y="759"/>
                  </a:lnTo>
                  <a:lnTo>
                    <a:pt x="66" y="758"/>
                  </a:lnTo>
                  <a:lnTo>
                    <a:pt x="75" y="756"/>
                  </a:lnTo>
                  <a:lnTo>
                    <a:pt x="86" y="756"/>
                  </a:lnTo>
                  <a:lnTo>
                    <a:pt x="97" y="756"/>
                  </a:lnTo>
                  <a:lnTo>
                    <a:pt x="108" y="756"/>
                  </a:lnTo>
                  <a:lnTo>
                    <a:pt x="118" y="756"/>
                  </a:lnTo>
                  <a:lnTo>
                    <a:pt x="129" y="756"/>
                  </a:lnTo>
                  <a:lnTo>
                    <a:pt x="140" y="755"/>
                  </a:lnTo>
                  <a:lnTo>
                    <a:pt x="150" y="755"/>
                  </a:lnTo>
                  <a:lnTo>
                    <a:pt x="161" y="755"/>
                  </a:lnTo>
                  <a:lnTo>
                    <a:pt x="172" y="753"/>
                  </a:lnTo>
                  <a:lnTo>
                    <a:pt x="183" y="753"/>
                  </a:lnTo>
                  <a:lnTo>
                    <a:pt x="193" y="755"/>
                  </a:lnTo>
                  <a:lnTo>
                    <a:pt x="204" y="755"/>
                  </a:lnTo>
                  <a:lnTo>
                    <a:pt x="215" y="753"/>
                  </a:lnTo>
                  <a:lnTo>
                    <a:pt x="224" y="753"/>
                  </a:lnTo>
                  <a:lnTo>
                    <a:pt x="236" y="753"/>
                  </a:lnTo>
                  <a:lnTo>
                    <a:pt x="247" y="750"/>
                  </a:lnTo>
                  <a:lnTo>
                    <a:pt x="258" y="747"/>
                  </a:lnTo>
                  <a:lnTo>
                    <a:pt x="267" y="739"/>
                  </a:lnTo>
                  <a:lnTo>
                    <a:pt x="278" y="747"/>
                  </a:lnTo>
                  <a:lnTo>
                    <a:pt x="290" y="647"/>
                  </a:lnTo>
                  <a:lnTo>
                    <a:pt x="301" y="300"/>
                  </a:lnTo>
                  <a:lnTo>
                    <a:pt x="310" y="0"/>
                  </a:lnTo>
                  <a:lnTo>
                    <a:pt x="321" y="969"/>
                  </a:lnTo>
                  <a:lnTo>
                    <a:pt x="332" y="1087"/>
                  </a:lnTo>
                  <a:lnTo>
                    <a:pt x="342" y="932"/>
                  </a:lnTo>
                  <a:lnTo>
                    <a:pt x="353" y="826"/>
                  </a:lnTo>
                  <a:lnTo>
                    <a:pt x="364" y="772"/>
                  </a:lnTo>
                  <a:lnTo>
                    <a:pt x="375" y="742"/>
                  </a:lnTo>
                  <a:lnTo>
                    <a:pt x="385" y="721"/>
                  </a:lnTo>
                  <a:lnTo>
                    <a:pt x="396" y="705"/>
                  </a:lnTo>
                  <a:lnTo>
                    <a:pt x="407" y="693"/>
                  </a:lnTo>
                  <a:lnTo>
                    <a:pt x="418" y="683"/>
                  </a:lnTo>
                  <a:lnTo>
                    <a:pt x="428" y="675"/>
                  </a:lnTo>
                  <a:lnTo>
                    <a:pt x="439" y="666"/>
                  </a:lnTo>
                  <a:lnTo>
                    <a:pt x="450" y="658"/>
                  </a:lnTo>
                  <a:lnTo>
                    <a:pt x="460" y="650"/>
                  </a:lnTo>
                  <a:lnTo>
                    <a:pt x="471" y="642"/>
                  </a:lnTo>
                  <a:lnTo>
                    <a:pt x="482" y="635"/>
                  </a:lnTo>
                  <a:lnTo>
                    <a:pt x="493" y="627"/>
                  </a:lnTo>
                  <a:lnTo>
                    <a:pt x="502" y="620"/>
                  </a:lnTo>
                  <a:lnTo>
                    <a:pt x="514" y="613"/>
                  </a:lnTo>
                  <a:lnTo>
                    <a:pt x="525" y="605"/>
                  </a:lnTo>
                  <a:lnTo>
                    <a:pt x="534" y="597"/>
                  </a:lnTo>
                  <a:lnTo>
                    <a:pt x="545" y="591"/>
                  </a:lnTo>
                  <a:lnTo>
                    <a:pt x="556" y="586"/>
                  </a:lnTo>
                  <a:lnTo>
                    <a:pt x="568" y="581"/>
                  </a:lnTo>
                  <a:lnTo>
                    <a:pt x="577" y="573"/>
                  </a:lnTo>
                  <a:lnTo>
                    <a:pt x="588" y="566"/>
                  </a:lnTo>
                  <a:lnTo>
                    <a:pt x="599" y="559"/>
                  </a:lnTo>
                  <a:lnTo>
                    <a:pt x="610" y="554"/>
                  </a:lnTo>
                  <a:lnTo>
                    <a:pt x="620" y="548"/>
                  </a:lnTo>
                  <a:lnTo>
                    <a:pt x="631" y="543"/>
                  </a:lnTo>
                  <a:lnTo>
                    <a:pt x="642" y="537"/>
                  </a:lnTo>
                  <a:lnTo>
                    <a:pt x="652" y="531"/>
                  </a:lnTo>
                  <a:lnTo>
                    <a:pt x="663" y="527"/>
                  </a:lnTo>
                  <a:lnTo>
                    <a:pt x="674" y="523"/>
                  </a:lnTo>
                  <a:lnTo>
                    <a:pt x="685" y="518"/>
                  </a:lnTo>
                  <a:lnTo>
                    <a:pt x="695" y="515"/>
                  </a:lnTo>
                  <a:lnTo>
                    <a:pt x="706" y="508"/>
                  </a:lnTo>
                  <a:lnTo>
                    <a:pt x="717" y="504"/>
                  </a:lnTo>
                  <a:lnTo>
                    <a:pt x="728" y="497"/>
                  </a:lnTo>
                  <a:lnTo>
                    <a:pt x="738" y="494"/>
                  </a:lnTo>
                  <a:lnTo>
                    <a:pt x="749" y="488"/>
                  </a:lnTo>
                  <a:lnTo>
                    <a:pt x="760" y="483"/>
                  </a:lnTo>
                  <a:lnTo>
                    <a:pt x="769" y="480"/>
                  </a:lnTo>
                  <a:lnTo>
                    <a:pt x="780" y="473"/>
                  </a:lnTo>
                  <a:lnTo>
                    <a:pt x="792" y="472"/>
                  </a:lnTo>
                  <a:lnTo>
                    <a:pt x="803" y="467"/>
                  </a:lnTo>
                  <a:lnTo>
                    <a:pt x="812" y="464"/>
                  </a:lnTo>
                  <a:lnTo>
                    <a:pt x="823" y="461"/>
                  </a:lnTo>
                  <a:lnTo>
                    <a:pt x="834" y="456"/>
                  </a:lnTo>
                  <a:lnTo>
                    <a:pt x="844" y="453"/>
                  </a:lnTo>
                  <a:lnTo>
                    <a:pt x="855" y="448"/>
                  </a:lnTo>
                  <a:lnTo>
                    <a:pt x="866" y="445"/>
                  </a:lnTo>
                  <a:lnTo>
                    <a:pt x="877" y="440"/>
                  </a:lnTo>
                  <a:lnTo>
                    <a:pt x="887" y="435"/>
                  </a:lnTo>
                  <a:lnTo>
                    <a:pt x="898" y="434"/>
                  </a:lnTo>
                  <a:lnTo>
                    <a:pt x="909" y="429"/>
                  </a:lnTo>
                  <a:lnTo>
                    <a:pt x="920" y="426"/>
                  </a:lnTo>
                  <a:lnTo>
                    <a:pt x="930" y="421"/>
                  </a:lnTo>
                  <a:lnTo>
                    <a:pt x="941" y="418"/>
                  </a:lnTo>
                  <a:lnTo>
                    <a:pt x="952" y="415"/>
                  </a:lnTo>
                  <a:lnTo>
                    <a:pt x="962" y="411"/>
                  </a:lnTo>
                  <a:lnTo>
                    <a:pt x="973" y="408"/>
                  </a:lnTo>
                  <a:lnTo>
                    <a:pt x="984" y="405"/>
                  </a:lnTo>
                  <a:lnTo>
                    <a:pt x="995" y="404"/>
                  </a:lnTo>
                  <a:lnTo>
                    <a:pt x="1004" y="400"/>
                  </a:lnTo>
                  <a:lnTo>
                    <a:pt x="1016" y="396"/>
                  </a:lnTo>
                  <a:lnTo>
                    <a:pt x="1027" y="392"/>
                  </a:lnTo>
                  <a:lnTo>
                    <a:pt x="1038" y="391"/>
                  </a:lnTo>
                  <a:lnTo>
                    <a:pt x="1047" y="388"/>
                  </a:lnTo>
                  <a:lnTo>
                    <a:pt x="1058" y="383"/>
                  </a:lnTo>
                  <a:lnTo>
                    <a:pt x="1070" y="380"/>
                  </a:lnTo>
                  <a:lnTo>
                    <a:pt x="1079" y="377"/>
                  </a:lnTo>
                  <a:lnTo>
                    <a:pt x="1090" y="373"/>
                  </a:lnTo>
                  <a:lnTo>
                    <a:pt x="1101" y="372"/>
                  </a:lnTo>
                  <a:lnTo>
                    <a:pt x="1113" y="369"/>
                  </a:lnTo>
                  <a:lnTo>
                    <a:pt x="1122" y="367"/>
                  </a:lnTo>
                  <a:lnTo>
                    <a:pt x="1133" y="364"/>
                  </a:lnTo>
                  <a:lnTo>
                    <a:pt x="1144" y="361"/>
                  </a:lnTo>
                  <a:lnTo>
                    <a:pt x="1155" y="357"/>
                  </a:lnTo>
                  <a:lnTo>
                    <a:pt x="1165" y="356"/>
                  </a:lnTo>
                  <a:lnTo>
                    <a:pt x="1176" y="353"/>
                  </a:lnTo>
                  <a:lnTo>
                    <a:pt x="1187" y="350"/>
                  </a:lnTo>
                  <a:lnTo>
                    <a:pt x="1197" y="348"/>
                  </a:lnTo>
                  <a:lnTo>
                    <a:pt x="1208" y="343"/>
                  </a:lnTo>
                  <a:lnTo>
                    <a:pt x="1219" y="340"/>
                  </a:lnTo>
                  <a:lnTo>
                    <a:pt x="1230" y="338"/>
                  </a:lnTo>
                  <a:lnTo>
                    <a:pt x="1240" y="335"/>
                  </a:lnTo>
                  <a:lnTo>
                    <a:pt x="1251" y="334"/>
                  </a:lnTo>
                  <a:lnTo>
                    <a:pt x="1262" y="332"/>
                  </a:lnTo>
                  <a:lnTo>
                    <a:pt x="1271" y="329"/>
                  </a:lnTo>
                  <a:lnTo>
                    <a:pt x="1283" y="326"/>
                  </a:lnTo>
                  <a:lnTo>
                    <a:pt x="1294" y="324"/>
                  </a:lnTo>
                  <a:lnTo>
                    <a:pt x="1305" y="319"/>
                  </a:lnTo>
                  <a:lnTo>
                    <a:pt x="1314" y="316"/>
                  </a:lnTo>
                  <a:lnTo>
                    <a:pt x="1325" y="316"/>
                  </a:lnTo>
                  <a:lnTo>
                    <a:pt x="1337" y="313"/>
                  </a:lnTo>
                  <a:lnTo>
                    <a:pt x="1348" y="310"/>
                  </a:lnTo>
                  <a:lnTo>
                    <a:pt x="1357" y="308"/>
                  </a:lnTo>
                  <a:lnTo>
                    <a:pt x="1368" y="307"/>
                  </a:lnTo>
                  <a:lnTo>
                    <a:pt x="1379" y="303"/>
                  </a:lnTo>
                  <a:lnTo>
                    <a:pt x="1389" y="300"/>
                  </a:lnTo>
                  <a:lnTo>
                    <a:pt x="1400" y="297"/>
                  </a:lnTo>
                  <a:lnTo>
                    <a:pt x="1411" y="294"/>
                  </a:lnTo>
                  <a:lnTo>
                    <a:pt x="1422" y="292"/>
                  </a:lnTo>
                  <a:lnTo>
                    <a:pt x="1432" y="289"/>
                  </a:lnTo>
                  <a:lnTo>
                    <a:pt x="1443" y="288"/>
                  </a:lnTo>
                  <a:lnTo>
                    <a:pt x="1454" y="284"/>
                  </a:lnTo>
                  <a:lnTo>
                    <a:pt x="1465" y="283"/>
                  </a:lnTo>
                  <a:lnTo>
                    <a:pt x="1475" y="281"/>
                  </a:lnTo>
                  <a:lnTo>
                    <a:pt x="1486" y="278"/>
                  </a:lnTo>
                  <a:lnTo>
                    <a:pt x="1497" y="275"/>
                  </a:lnTo>
                  <a:lnTo>
                    <a:pt x="1507" y="273"/>
                  </a:lnTo>
                  <a:lnTo>
                    <a:pt x="1518" y="272"/>
                  </a:lnTo>
                  <a:lnTo>
                    <a:pt x="1529" y="269"/>
                  </a:lnTo>
                  <a:lnTo>
                    <a:pt x="1540" y="267"/>
                  </a:lnTo>
                  <a:lnTo>
                    <a:pt x="1549" y="265"/>
                  </a:lnTo>
                  <a:lnTo>
                    <a:pt x="1561" y="262"/>
                  </a:lnTo>
                  <a:lnTo>
                    <a:pt x="1572" y="261"/>
                  </a:lnTo>
                  <a:lnTo>
                    <a:pt x="1581" y="256"/>
                  </a:lnTo>
                  <a:lnTo>
                    <a:pt x="1592" y="254"/>
                  </a:lnTo>
                  <a:lnTo>
                    <a:pt x="1603" y="253"/>
                  </a:lnTo>
                  <a:lnTo>
                    <a:pt x="1615" y="249"/>
                  </a:lnTo>
                  <a:lnTo>
                    <a:pt x="1624" y="249"/>
                  </a:lnTo>
                  <a:lnTo>
                    <a:pt x="1635" y="246"/>
                  </a:lnTo>
                  <a:lnTo>
                    <a:pt x="1646" y="243"/>
                  </a:lnTo>
                  <a:lnTo>
                    <a:pt x="1657" y="242"/>
                  </a:lnTo>
                  <a:lnTo>
                    <a:pt x="1667" y="240"/>
                  </a:lnTo>
                  <a:lnTo>
                    <a:pt x="1678" y="237"/>
                  </a:lnTo>
                  <a:lnTo>
                    <a:pt x="1689" y="234"/>
                  </a:lnTo>
                  <a:lnTo>
                    <a:pt x="1699" y="234"/>
                  </a:lnTo>
                  <a:lnTo>
                    <a:pt x="1710" y="230"/>
                  </a:lnTo>
                  <a:lnTo>
                    <a:pt x="1721" y="227"/>
                  </a:lnTo>
                  <a:lnTo>
                    <a:pt x="1732" y="226"/>
                  </a:lnTo>
                  <a:lnTo>
                    <a:pt x="1742" y="226"/>
                  </a:lnTo>
                  <a:lnTo>
                    <a:pt x="1753" y="222"/>
                  </a:lnTo>
                  <a:lnTo>
                    <a:pt x="1764" y="221"/>
                  </a:lnTo>
                  <a:lnTo>
                    <a:pt x="1775" y="218"/>
                  </a:lnTo>
                  <a:lnTo>
                    <a:pt x="1785" y="216"/>
                  </a:lnTo>
                  <a:lnTo>
                    <a:pt x="1796" y="215"/>
                  </a:lnTo>
                  <a:lnTo>
                    <a:pt x="1807" y="213"/>
                  </a:lnTo>
                  <a:lnTo>
                    <a:pt x="1816" y="210"/>
                  </a:lnTo>
                  <a:lnTo>
                    <a:pt x="1827" y="208"/>
                  </a:lnTo>
                  <a:lnTo>
                    <a:pt x="1839" y="207"/>
                  </a:lnTo>
                  <a:lnTo>
                    <a:pt x="1850" y="205"/>
                  </a:lnTo>
                  <a:lnTo>
                    <a:pt x="1859" y="202"/>
                  </a:lnTo>
                  <a:lnTo>
                    <a:pt x="1870" y="200"/>
                  </a:lnTo>
                  <a:lnTo>
                    <a:pt x="1881" y="199"/>
                  </a:lnTo>
                  <a:lnTo>
                    <a:pt x="1891" y="195"/>
                  </a:lnTo>
                  <a:lnTo>
                    <a:pt x="1902" y="194"/>
                  </a:lnTo>
                  <a:lnTo>
                    <a:pt x="1913" y="191"/>
                  </a:lnTo>
                  <a:lnTo>
                    <a:pt x="1924" y="189"/>
                  </a:lnTo>
                  <a:lnTo>
                    <a:pt x="1934" y="186"/>
                  </a:lnTo>
                  <a:lnTo>
                    <a:pt x="1945" y="184"/>
                  </a:lnTo>
                  <a:lnTo>
                    <a:pt x="1956" y="183"/>
                  </a:lnTo>
                  <a:lnTo>
                    <a:pt x="1967" y="180"/>
                  </a:lnTo>
                  <a:lnTo>
                    <a:pt x="1977" y="180"/>
                  </a:lnTo>
                  <a:lnTo>
                    <a:pt x="1988" y="176"/>
                  </a:lnTo>
                  <a:lnTo>
                    <a:pt x="1999" y="175"/>
                  </a:lnTo>
                  <a:lnTo>
                    <a:pt x="2009" y="172"/>
                  </a:lnTo>
                  <a:lnTo>
                    <a:pt x="2020" y="170"/>
                  </a:lnTo>
                  <a:lnTo>
                    <a:pt x="2031" y="167"/>
                  </a:lnTo>
                  <a:lnTo>
                    <a:pt x="2042" y="165"/>
                  </a:lnTo>
                  <a:lnTo>
                    <a:pt x="2051" y="164"/>
                  </a:lnTo>
                  <a:lnTo>
                    <a:pt x="2063" y="162"/>
                  </a:lnTo>
                  <a:lnTo>
                    <a:pt x="2074" y="161"/>
                  </a:lnTo>
                  <a:lnTo>
                    <a:pt x="2085" y="159"/>
                  </a:lnTo>
                  <a:lnTo>
                    <a:pt x="2094" y="157"/>
                  </a:lnTo>
                  <a:lnTo>
                    <a:pt x="2105" y="156"/>
                  </a:lnTo>
                  <a:lnTo>
                    <a:pt x="2117" y="153"/>
                  </a:lnTo>
                  <a:lnTo>
                    <a:pt x="2126" y="151"/>
                  </a:lnTo>
                  <a:lnTo>
                    <a:pt x="2137" y="149"/>
                  </a:lnTo>
                  <a:lnTo>
                    <a:pt x="2148" y="146"/>
                  </a:lnTo>
                  <a:lnTo>
                    <a:pt x="2159" y="145"/>
                  </a:lnTo>
                  <a:lnTo>
                    <a:pt x="2169" y="141"/>
                  </a:lnTo>
                  <a:lnTo>
                    <a:pt x="2180" y="145"/>
                  </a:lnTo>
                  <a:lnTo>
                    <a:pt x="2191" y="156"/>
                  </a:lnTo>
                  <a:lnTo>
                    <a:pt x="2202" y="149"/>
                  </a:lnTo>
                  <a:lnTo>
                    <a:pt x="2212" y="197"/>
                  </a:lnTo>
                  <a:lnTo>
                    <a:pt x="2223" y="127"/>
                  </a:lnTo>
                  <a:lnTo>
                    <a:pt x="2234" y="130"/>
                  </a:lnTo>
                  <a:lnTo>
                    <a:pt x="2244" y="140"/>
                  </a:lnTo>
                  <a:lnTo>
                    <a:pt x="2255" y="146"/>
                  </a:lnTo>
                  <a:lnTo>
                    <a:pt x="2266" y="151"/>
                  </a:lnTo>
                  <a:lnTo>
                    <a:pt x="2277" y="153"/>
                  </a:lnTo>
                  <a:lnTo>
                    <a:pt x="2287" y="156"/>
                  </a:lnTo>
                  <a:lnTo>
                    <a:pt x="2298" y="157"/>
                  </a:lnTo>
                  <a:lnTo>
                    <a:pt x="2309" y="159"/>
                  </a:lnTo>
                  <a:lnTo>
                    <a:pt x="2318" y="162"/>
                  </a:lnTo>
                  <a:lnTo>
                    <a:pt x="2329" y="162"/>
                  </a:lnTo>
                  <a:lnTo>
                    <a:pt x="2341" y="162"/>
                  </a:lnTo>
                  <a:lnTo>
                    <a:pt x="2352" y="165"/>
                  </a:lnTo>
                  <a:lnTo>
                    <a:pt x="2361" y="167"/>
                  </a:lnTo>
                  <a:lnTo>
                    <a:pt x="2372" y="167"/>
                  </a:lnTo>
                  <a:lnTo>
                    <a:pt x="2383" y="168"/>
                  </a:lnTo>
                  <a:lnTo>
                    <a:pt x="2395" y="170"/>
                  </a:lnTo>
                  <a:lnTo>
                    <a:pt x="2404" y="167"/>
                  </a:lnTo>
                  <a:lnTo>
                    <a:pt x="2415" y="168"/>
                  </a:lnTo>
                  <a:lnTo>
                    <a:pt x="2426" y="168"/>
                  </a:lnTo>
                  <a:lnTo>
                    <a:pt x="2436" y="170"/>
                  </a:lnTo>
                  <a:lnTo>
                    <a:pt x="2447" y="170"/>
                  </a:lnTo>
                  <a:lnTo>
                    <a:pt x="2458" y="170"/>
                  </a:lnTo>
                  <a:lnTo>
                    <a:pt x="2469" y="172"/>
                  </a:lnTo>
                  <a:lnTo>
                    <a:pt x="2479" y="172"/>
                  </a:lnTo>
                  <a:lnTo>
                    <a:pt x="2490" y="172"/>
                  </a:lnTo>
                  <a:lnTo>
                    <a:pt x="2501" y="175"/>
                  </a:lnTo>
                  <a:lnTo>
                    <a:pt x="2512" y="175"/>
                  </a:lnTo>
                  <a:lnTo>
                    <a:pt x="2522" y="175"/>
                  </a:lnTo>
                  <a:lnTo>
                    <a:pt x="2533" y="176"/>
                  </a:lnTo>
                  <a:lnTo>
                    <a:pt x="2544" y="176"/>
                  </a:lnTo>
                  <a:lnTo>
                    <a:pt x="2553" y="175"/>
                  </a:lnTo>
                  <a:lnTo>
                    <a:pt x="2565" y="175"/>
                  </a:lnTo>
                  <a:lnTo>
                    <a:pt x="2576" y="176"/>
                  </a:lnTo>
                  <a:lnTo>
                    <a:pt x="2587" y="176"/>
                  </a:lnTo>
                  <a:lnTo>
                    <a:pt x="2596" y="176"/>
                  </a:lnTo>
                  <a:lnTo>
                    <a:pt x="2607" y="178"/>
                  </a:lnTo>
                  <a:lnTo>
                    <a:pt x="2619" y="178"/>
                  </a:lnTo>
                  <a:lnTo>
                    <a:pt x="2628" y="178"/>
                  </a:lnTo>
                  <a:lnTo>
                    <a:pt x="2639" y="178"/>
                  </a:lnTo>
                  <a:lnTo>
                    <a:pt x="2650" y="178"/>
                  </a:lnTo>
                  <a:lnTo>
                    <a:pt x="2662" y="180"/>
                  </a:lnTo>
                  <a:lnTo>
                    <a:pt x="2671" y="180"/>
                  </a:lnTo>
                  <a:lnTo>
                    <a:pt x="2682" y="181"/>
                  </a:lnTo>
                  <a:lnTo>
                    <a:pt x="2693" y="180"/>
                  </a:lnTo>
                  <a:lnTo>
                    <a:pt x="2704" y="180"/>
                  </a:lnTo>
                  <a:lnTo>
                    <a:pt x="2714" y="178"/>
                  </a:lnTo>
                  <a:lnTo>
                    <a:pt x="2725" y="180"/>
                  </a:lnTo>
                  <a:lnTo>
                    <a:pt x="2736" y="178"/>
                  </a:lnTo>
                  <a:lnTo>
                    <a:pt x="2746" y="180"/>
                  </a:lnTo>
                  <a:lnTo>
                    <a:pt x="2757" y="178"/>
                  </a:lnTo>
                  <a:lnTo>
                    <a:pt x="2768" y="178"/>
                  </a:lnTo>
                  <a:lnTo>
                    <a:pt x="2779" y="180"/>
                  </a:lnTo>
                  <a:lnTo>
                    <a:pt x="2789" y="181"/>
                  </a:lnTo>
                  <a:lnTo>
                    <a:pt x="2800" y="181"/>
                  </a:lnTo>
                  <a:lnTo>
                    <a:pt x="2811" y="180"/>
                  </a:lnTo>
                  <a:lnTo>
                    <a:pt x="2822" y="181"/>
                  </a:lnTo>
                  <a:lnTo>
                    <a:pt x="2832" y="178"/>
                  </a:lnTo>
                  <a:lnTo>
                    <a:pt x="2843" y="178"/>
                  </a:lnTo>
                  <a:lnTo>
                    <a:pt x="2854" y="178"/>
                  </a:lnTo>
                  <a:lnTo>
                    <a:pt x="2863" y="178"/>
                  </a:lnTo>
                  <a:lnTo>
                    <a:pt x="2874" y="178"/>
                  </a:lnTo>
                  <a:lnTo>
                    <a:pt x="2886" y="181"/>
                  </a:lnTo>
                  <a:lnTo>
                    <a:pt x="2897" y="181"/>
                  </a:lnTo>
                  <a:lnTo>
                    <a:pt x="2906" y="181"/>
                  </a:lnTo>
                  <a:lnTo>
                    <a:pt x="2917" y="180"/>
                  </a:lnTo>
                  <a:lnTo>
                    <a:pt x="2928" y="180"/>
                  </a:lnTo>
                  <a:lnTo>
                    <a:pt x="2938" y="180"/>
                  </a:lnTo>
                  <a:lnTo>
                    <a:pt x="2949" y="180"/>
                  </a:lnTo>
                  <a:lnTo>
                    <a:pt x="2960" y="180"/>
                  </a:lnTo>
                  <a:lnTo>
                    <a:pt x="2971" y="180"/>
                  </a:lnTo>
                  <a:lnTo>
                    <a:pt x="2981" y="181"/>
                  </a:lnTo>
                  <a:lnTo>
                    <a:pt x="2992" y="180"/>
                  </a:lnTo>
                  <a:lnTo>
                    <a:pt x="3003" y="181"/>
                  </a:lnTo>
                  <a:lnTo>
                    <a:pt x="3014" y="180"/>
                  </a:lnTo>
                  <a:lnTo>
                    <a:pt x="3024" y="180"/>
                  </a:lnTo>
                  <a:lnTo>
                    <a:pt x="3035" y="180"/>
                  </a:lnTo>
                  <a:lnTo>
                    <a:pt x="3046" y="181"/>
                  </a:lnTo>
                  <a:lnTo>
                    <a:pt x="3056" y="181"/>
                  </a:lnTo>
                  <a:lnTo>
                    <a:pt x="3067" y="181"/>
                  </a:lnTo>
                  <a:lnTo>
                    <a:pt x="3078" y="181"/>
                  </a:lnTo>
                  <a:lnTo>
                    <a:pt x="3089" y="181"/>
                  </a:lnTo>
                  <a:lnTo>
                    <a:pt x="3098" y="183"/>
                  </a:lnTo>
                  <a:lnTo>
                    <a:pt x="3110" y="183"/>
                  </a:lnTo>
                  <a:lnTo>
                    <a:pt x="3121" y="183"/>
                  </a:lnTo>
                  <a:lnTo>
                    <a:pt x="3132" y="183"/>
                  </a:lnTo>
                  <a:lnTo>
                    <a:pt x="3141" y="183"/>
                  </a:lnTo>
                  <a:lnTo>
                    <a:pt x="3152" y="183"/>
                  </a:lnTo>
                  <a:lnTo>
                    <a:pt x="3164" y="183"/>
                  </a:lnTo>
                  <a:lnTo>
                    <a:pt x="3173" y="184"/>
                  </a:lnTo>
                  <a:lnTo>
                    <a:pt x="3184" y="183"/>
                  </a:lnTo>
                  <a:lnTo>
                    <a:pt x="3195" y="184"/>
                  </a:lnTo>
                  <a:lnTo>
                    <a:pt x="3206" y="184"/>
                  </a:lnTo>
                  <a:lnTo>
                    <a:pt x="3216" y="184"/>
                  </a:lnTo>
                  <a:lnTo>
                    <a:pt x="3227" y="184"/>
                  </a:lnTo>
                  <a:lnTo>
                    <a:pt x="3238" y="183"/>
                  </a:lnTo>
                  <a:lnTo>
                    <a:pt x="3248" y="184"/>
                  </a:lnTo>
                  <a:lnTo>
                    <a:pt x="3259" y="184"/>
                  </a:lnTo>
                  <a:lnTo>
                    <a:pt x="3270" y="184"/>
                  </a:lnTo>
                  <a:lnTo>
                    <a:pt x="3281" y="184"/>
                  </a:lnTo>
                  <a:lnTo>
                    <a:pt x="3291" y="186"/>
                  </a:lnTo>
                  <a:lnTo>
                    <a:pt x="3302" y="184"/>
                  </a:lnTo>
                  <a:lnTo>
                    <a:pt x="3313" y="184"/>
                  </a:lnTo>
                  <a:lnTo>
                    <a:pt x="3324" y="186"/>
                  </a:lnTo>
                  <a:lnTo>
                    <a:pt x="3334" y="186"/>
                  </a:lnTo>
                  <a:lnTo>
                    <a:pt x="3345" y="186"/>
                  </a:lnTo>
                  <a:lnTo>
                    <a:pt x="3356" y="184"/>
                  </a:lnTo>
                  <a:lnTo>
                    <a:pt x="3365" y="184"/>
                  </a:lnTo>
                  <a:lnTo>
                    <a:pt x="3376" y="188"/>
                  </a:lnTo>
                  <a:lnTo>
                    <a:pt x="3388" y="189"/>
                  </a:lnTo>
                  <a:lnTo>
                    <a:pt x="3399" y="189"/>
                  </a:lnTo>
                  <a:lnTo>
                    <a:pt x="3408" y="189"/>
                  </a:lnTo>
                  <a:lnTo>
                    <a:pt x="3419" y="189"/>
                  </a:lnTo>
                  <a:lnTo>
                    <a:pt x="3430" y="189"/>
                  </a:lnTo>
                  <a:lnTo>
                    <a:pt x="3442" y="189"/>
                  </a:lnTo>
                  <a:lnTo>
                    <a:pt x="3451" y="191"/>
                  </a:lnTo>
                  <a:lnTo>
                    <a:pt x="3462" y="191"/>
                  </a:lnTo>
                  <a:lnTo>
                    <a:pt x="3473" y="191"/>
                  </a:lnTo>
                  <a:lnTo>
                    <a:pt x="3483" y="191"/>
                  </a:lnTo>
                  <a:lnTo>
                    <a:pt x="3494" y="192"/>
                  </a:lnTo>
                  <a:lnTo>
                    <a:pt x="3505" y="191"/>
                  </a:lnTo>
                  <a:lnTo>
                    <a:pt x="3516" y="191"/>
                  </a:lnTo>
                  <a:lnTo>
                    <a:pt x="3526" y="192"/>
                  </a:lnTo>
                  <a:lnTo>
                    <a:pt x="3537" y="192"/>
                  </a:lnTo>
                  <a:lnTo>
                    <a:pt x="3548" y="194"/>
                  </a:lnTo>
                  <a:lnTo>
                    <a:pt x="3559" y="194"/>
                  </a:lnTo>
                  <a:lnTo>
                    <a:pt x="3569" y="194"/>
                  </a:lnTo>
                  <a:lnTo>
                    <a:pt x="3580" y="194"/>
                  </a:lnTo>
                  <a:lnTo>
                    <a:pt x="3591" y="195"/>
                  </a:lnTo>
                  <a:lnTo>
                    <a:pt x="3600" y="195"/>
                  </a:lnTo>
                  <a:lnTo>
                    <a:pt x="3612" y="194"/>
                  </a:lnTo>
                  <a:lnTo>
                    <a:pt x="3623" y="194"/>
                  </a:lnTo>
                  <a:lnTo>
                    <a:pt x="3634" y="194"/>
                  </a:lnTo>
                  <a:lnTo>
                    <a:pt x="3643" y="195"/>
                  </a:lnTo>
                  <a:lnTo>
                    <a:pt x="3654" y="197"/>
                  </a:lnTo>
                  <a:lnTo>
                    <a:pt x="3666" y="192"/>
                  </a:lnTo>
                  <a:lnTo>
                    <a:pt x="3675" y="192"/>
                  </a:lnTo>
                  <a:lnTo>
                    <a:pt x="3686" y="195"/>
                  </a:lnTo>
                  <a:lnTo>
                    <a:pt x="3697" y="197"/>
                  </a:lnTo>
                  <a:lnTo>
                    <a:pt x="3708" y="195"/>
                  </a:lnTo>
                  <a:lnTo>
                    <a:pt x="3718" y="195"/>
                  </a:lnTo>
                  <a:lnTo>
                    <a:pt x="3729" y="197"/>
                  </a:lnTo>
                  <a:lnTo>
                    <a:pt x="3740" y="197"/>
                  </a:lnTo>
                  <a:lnTo>
                    <a:pt x="3751" y="197"/>
                  </a:lnTo>
                  <a:lnTo>
                    <a:pt x="3761" y="197"/>
                  </a:lnTo>
                  <a:lnTo>
                    <a:pt x="3772" y="197"/>
                  </a:lnTo>
                  <a:lnTo>
                    <a:pt x="3783" y="199"/>
                  </a:lnTo>
                  <a:lnTo>
                    <a:pt x="3793" y="199"/>
                  </a:lnTo>
                  <a:lnTo>
                    <a:pt x="3804" y="199"/>
                  </a:lnTo>
                  <a:lnTo>
                    <a:pt x="3815" y="203"/>
                  </a:lnTo>
                  <a:lnTo>
                    <a:pt x="3826" y="199"/>
                  </a:lnTo>
                  <a:lnTo>
                    <a:pt x="3836" y="200"/>
                  </a:lnTo>
                  <a:lnTo>
                    <a:pt x="3847" y="211"/>
                  </a:lnTo>
                  <a:lnTo>
                    <a:pt x="3858" y="211"/>
                  </a:lnTo>
                  <a:lnTo>
                    <a:pt x="3869" y="202"/>
                  </a:lnTo>
                  <a:lnTo>
                    <a:pt x="3878" y="199"/>
                  </a:lnTo>
                  <a:lnTo>
                    <a:pt x="3890" y="202"/>
                  </a:lnTo>
                  <a:lnTo>
                    <a:pt x="3901" y="213"/>
                  </a:lnTo>
                  <a:lnTo>
                    <a:pt x="3910" y="208"/>
                  </a:lnTo>
                  <a:lnTo>
                    <a:pt x="3921" y="194"/>
                  </a:lnTo>
                  <a:lnTo>
                    <a:pt x="3932" y="197"/>
                  </a:lnTo>
                  <a:lnTo>
                    <a:pt x="3944" y="200"/>
                  </a:lnTo>
                  <a:lnTo>
                    <a:pt x="3953" y="203"/>
                  </a:lnTo>
                  <a:lnTo>
                    <a:pt x="3964" y="203"/>
                  </a:lnTo>
                  <a:lnTo>
                    <a:pt x="3975" y="205"/>
                  </a:lnTo>
                  <a:lnTo>
                    <a:pt x="3985" y="203"/>
                  </a:lnTo>
                  <a:lnTo>
                    <a:pt x="3996" y="195"/>
                  </a:lnTo>
                  <a:lnTo>
                    <a:pt x="4007" y="195"/>
                  </a:lnTo>
                  <a:lnTo>
                    <a:pt x="4018" y="203"/>
                  </a:lnTo>
                  <a:lnTo>
                    <a:pt x="4028" y="207"/>
                  </a:lnTo>
                  <a:lnTo>
                    <a:pt x="4039" y="219"/>
                  </a:lnTo>
                  <a:lnTo>
                    <a:pt x="4050" y="216"/>
                  </a:lnTo>
                  <a:lnTo>
                    <a:pt x="4061" y="207"/>
                  </a:lnTo>
                  <a:lnTo>
                    <a:pt x="4071" y="205"/>
                  </a:lnTo>
                  <a:lnTo>
                    <a:pt x="4082" y="205"/>
                  </a:lnTo>
                  <a:lnTo>
                    <a:pt x="4093" y="208"/>
                  </a:lnTo>
                  <a:lnTo>
                    <a:pt x="4102" y="208"/>
                  </a:lnTo>
                  <a:lnTo>
                    <a:pt x="4114" y="208"/>
                  </a:lnTo>
                </a:path>
              </a:pathLst>
            </a:custGeom>
            <a:noFill/>
            <a:ln w="0">
              <a:solidFill>
                <a:srgbClr val="808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0" name="Freeform 100"/>
            <p:cNvSpPr>
              <a:spLocks/>
            </p:cNvSpPr>
            <p:nvPr/>
          </p:nvSpPr>
          <p:spPr bwMode="auto">
            <a:xfrm>
              <a:off x="774" y="2140"/>
              <a:ext cx="4113" cy="1038"/>
            </a:xfrm>
            <a:custGeom>
              <a:avLst/>
              <a:gdLst>
                <a:gd name="T0" fmla="*/ 63 w 4113"/>
                <a:gd name="T1" fmla="*/ 698 h 1038"/>
                <a:gd name="T2" fmla="*/ 138 w 4113"/>
                <a:gd name="T3" fmla="*/ 695 h 1038"/>
                <a:gd name="T4" fmla="*/ 213 w 4113"/>
                <a:gd name="T5" fmla="*/ 693 h 1038"/>
                <a:gd name="T6" fmla="*/ 287 w 4113"/>
                <a:gd name="T7" fmla="*/ 29 h 1038"/>
                <a:gd name="T8" fmla="*/ 362 w 4113"/>
                <a:gd name="T9" fmla="*/ 691 h 1038"/>
                <a:gd name="T10" fmla="*/ 437 w 4113"/>
                <a:gd name="T11" fmla="*/ 648 h 1038"/>
                <a:gd name="T12" fmla="*/ 511 w 4113"/>
                <a:gd name="T13" fmla="*/ 625 h 1038"/>
                <a:gd name="T14" fmla="*/ 587 w 4113"/>
                <a:gd name="T15" fmla="*/ 601 h 1038"/>
                <a:gd name="T16" fmla="*/ 662 w 4113"/>
                <a:gd name="T17" fmla="*/ 582 h 1038"/>
                <a:gd name="T18" fmla="*/ 737 w 4113"/>
                <a:gd name="T19" fmla="*/ 564 h 1038"/>
                <a:gd name="T20" fmla="*/ 811 w 4113"/>
                <a:gd name="T21" fmla="*/ 550 h 1038"/>
                <a:gd name="T22" fmla="*/ 886 w 4113"/>
                <a:gd name="T23" fmla="*/ 533 h 1038"/>
                <a:gd name="T24" fmla="*/ 961 w 4113"/>
                <a:gd name="T25" fmla="*/ 520 h 1038"/>
                <a:gd name="T26" fmla="*/ 1035 w 4113"/>
                <a:gd name="T27" fmla="*/ 509 h 1038"/>
                <a:gd name="T28" fmla="*/ 1110 w 4113"/>
                <a:gd name="T29" fmla="*/ 496 h 1038"/>
                <a:gd name="T30" fmla="*/ 1185 w 4113"/>
                <a:gd name="T31" fmla="*/ 486 h 1038"/>
                <a:gd name="T32" fmla="*/ 1260 w 4113"/>
                <a:gd name="T33" fmla="*/ 471 h 1038"/>
                <a:gd name="T34" fmla="*/ 1334 w 4113"/>
                <a:gd name="T35" fmla="*/ 463 h 1038"/>
                <a:gd name="T36" fmla="*/ 1409 w 4113"/>
                <a:gd name="T37" fmla="*/ 450 h 1038"/>
                <a:gd name="T38" fmla="*/ 1484 w 4113"/>
                <a:gd name="T39" fmla="*/ 444 h 1038"/>
                <a:gd name="T40" fmla="*/ 1558 w 4113"/>
                <a:gd name="T41" fmla="*/ 432 h 1038"/>
                <a:gd name="T42" fmla="*/ 1634 w 4113"/>
                <a:gd name="T43" fmla="*/ 423 h 1038"/>
                <a:gd name="T44" fmla="*/ 1709 w 4113"/>
                <a:gd name="T45" fmla="*/ 413 h 1038"/>
                <a:gd name="T46" fmla="*/ 1784 w 4113"/>
                <a:gd name="T47" fmla="*/ 404 h 1038"/>
                <a:gd name="T48" fmla="*/ 1858 w 4113"/>
                <a:gd name="T49" fmla="*/ 396 h 1038"/>
                <a:gd name="T50" fmla="*/ 1933 w 4113"/>
                <a:gd name="T51" fmla="*/ 386 h 1038"/>
                <a:gd name="T52" fmla="*/ 2008 w 4113"/>
                <a:gd name="T53" fmla="*/ 377 h 1038"/>
                <a:gd name="T54" fmla="*/ 2082 w 4113"/>
                <a:gd name="T55" fmla="*/ 369 h 1038"/>
                <a:gd name="T56" fmla="*/ 2157 w 4113"/>
                <a:gd name="T57" fmla="*/ 369 h 1038"/>
                <a:gd name="T58" fmla="*/ 2232 w 4113"/>
                <a:gd name="T59" fmla="*/ 359 h 1038"/>
                <a:gd name="T60" fmla="*/ 2306 w 4113"/>
                <a:gd name="T61" fmla="*/ 371 h 1038"/>
                <a:gd name="T62" fmla="*/ 2381 w 4113"/>
                <a:gd name="T63" fmla="*/ 375 h 1038"/>
                <a:gd name="T64" fmla="*/ 2456 w 4113"/>
                <a:gd name="T65" fmla="*/ 377 h 1038"/>
                <a:gd name="T66" fmla="*/ 2530 w 4113"/>
                <a:gd name="T67" fmla="*/ 380 h 1038"/>
                <a:gd name="T68" fmla="*/ 2605 w 4113"/>
                <a:gd name="T69" fmla="*/ 382 h 1038"/>
                <a:gd name="T70" fmla="*/ 2681 w 4113"/>
                <a:gd name="T71" fmla="*/ 380 h 1038"/>
                <a:gd name="T72" fmla="*/ 2756 w 4113"/>
                <a:gd name="T73" fmla="*/ 382 h 1038"/>
                <a:gd name="T74" fmla="*/ 2831 w 4113"/>
                <a:gd name="T75" fmla="*/ 383 h 1038"/>
                <a:gd name="T76" fmla="*/ 2905 w 4113"/>
                <a:gd name="T77" fmla="*/ 386 h 1038"/>
                <a:gd name="T78" fmla="*/ 2980 w 4113"/>
                <a:gd name="T79" fmla="*/ 386 h 1038"/>
                <a:gd name="T80" fmla="*/ 3055 w 4113"/>
                <a:gd name="T81" fmla="*/ 388 h 1038"/>
                <a:gd name="T82" fmla="*/ 3129 w 4113"/>
                <a:gd name="T83" fmla="*/ 390 h 1038"/>
                <a:gd name="T84" fmla="*/ 3204 w 4113"/>
                <a:gd name="T85" fmla="*/ 390 h 1038"/>
                <a:gd name="T86" fmla="*/ 3279 w 4113"/>
                <a:gd name="T87" fmla="*/ 390 h 1038"/>
                <a:gd name="T88" fmla="*/ 3353 w 4113"/>
                <a:gd name="T89" fmla="*/ 391 h 1038"/>
                <a:gd name="T90" fmla="*/ 3428 w 4113"/>
                <a:gd name="T91" fmla="*/ 393 h 1038"/>
                <a:gd name="T92" fmla="*/ 3503 w 4113"/>
                <a:gd name="T93" fmla="*/ 393 h 1038"/>
                <a:gd name="T94" fmla="*/ 3577 w 4113"/>
                <a:gd name="T95" fmla="*/ 391 h 1038"/>
                <a:gd name="T96" fmla="*/ 3652 w 4113"/>
                <a:gd name="T97" fmla="*/ 391 h 1038"/>
                <a:gd name="T98" fmla="*/ 3728 w 4113"/>
                <a:gd name="T99" fmla="*/ 393 h 1038"/>
                <a:gd name="T100" fmla="*/ 3803 w 4113"/>
                <a:gd name="T101" fmla="*/ 394 h 1038"/>
                <a:gd name="T102" fmla="*/ 3878 w 4113"/>
                <a:gd name="T103" fmla="*/ 407 h 1038"/>
                <a:gd name="T104" fmla="*/ 3952 w 4113"/>
                <a:gd name="T105" fmla="*/ 396 h 1038"/>
                <a:gd name="T106" fmla="*/ 4027 w 4113"/>
                <a:gd name="T107" fmla="*/ 401 h 1038"/>
                <a:gd name="T108" fmla="*/ 4102 w 4113"/>
                <a:gd name="T109" fmla="*/ 399 h 10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113" h="1038">
                  <a:moveTo>
                    <a:pt x="0" y="701"/>
                  </a:moveTo>
                  <a:lnTo>
                    <a:pt x="9" y="701"/>
                  </a:lnTo>
                  <a:lnTo>
                    <a:pt x="20" y="699"/>
                  </a:lnTo>
                  <a:lnTo>
                    <a:pt x="31" y="698"/>
                  </a:lnTo>
                  <a:lnTo>
                    <a:pt x="43" y="696"/>
                  </a:lnTo>
                  <a:lnTo>
                    <a:pt x="52" y="699"/>
                  </a:lnTo>
                  <a:lnTo>
                    <a:pt x="63" y="698"/>
                  </a:lnTo>
                  <a:lnTo>
                    <a:pt x="74" y="696"/>
                  </a:lnTo>
                  <a:lnTo>
                    <a:pt x="85" y="698"/>
                  </a:lnTo>
                  <a:lnTo>
                    <a:pt x="95" y="698"/>
                  </a:lnTo>
                  <a:lnTo>
                    <a:pt x="106" y="696"/>
                  </a:lnTo>
                  <a:lnTo>
                    <a:pt x="117" y="696"/>
                  </a:lnTo>
                  <a:lnTo>
                    <a:pt x="127" y="696"/>
                  </a:lnTo>
                  <a:lnTo>
                    <a:pt x="138" y="695"/>
                  </a:lnTo>
                  <a:lnTo>
                    <a:pt x="149" y="695"/>
                  </a:lnTo>
                  <a:lnTo>
                    <a:pt x="160" y="695"/>
                  </a:lnTo>
                  <a:lnTo>
                    <a:pt x="170" y="693"/>
                  </a:lnTo>
                  <a:lnTo>
                    <a:pt x="181" y="693"/>
                  </a:lnTo>
                  <a:lnTo>
                    <a:pt x="192" y="693"/>
                  </a:lnTo>
                  <a:lnTo>
                    <a:pt x="201" y="691"/>
                  </a:lnTo>
                  <a:lnTo>
                    <a:pt x="213" y="693"/>
                  </a:lnTo>
                  <a:lnTo>
                    <a:pt x="224" y="690"/>
                  </a:lnTo>
                  <a:lnTo>
                    <a:pt x="235" y="688"/>
                  </a:lnTo>
                  <a:lnTo>
                    <a:pt x="244" y="679"/>
                  </a:lnTo>
                  <a:lnTo>
                    <a:pt x="255" y="687"/>
                  </a:lnTo>
                  <a:lnTo>
                    <a:pt x="267" y="499"/>
                  </a:lnTo>
                  <a:lnTo>
                    <a:pt x="278" y="0"/>
                  </a:lnTo>
                  <a:lnTo>
                    <a:pt x="287" y="29"/>
                  </a:lnTo>
                  <a:lnTo>
                    <a:pt x="298" y="965"/>
                  </a:lnTo>
                  <a:lnTo>
                    <a:pt x="309" y="1038"/>
                  </a:lnTo>
                  <a:lnTo>
                    <a:pt x="319" y="884"/>
                  </a:lnTo>
                  <a:lnTo>
                    <a:pt x="330" y="783"/>
                  </a:lnTo>
                  <a:lnTo>
                    <a:pt x="341" y="733"/>
                  </a:lnTo>
                  <a:lnTo>
                    <a:pt x="352" y="707"/>
                  </a:lnTo>
                  <a:lnTo>
                    <a:pt x="362" y="691"/>
                  </a:lnTo>
                  <a:lnTo>
                    <a:pt x="373" y="680"/>
                  </a:lnTo>
                  <a:lnTo>
                    <a:pt x="384" y="675"/>
                  </a:lnTo>
                  <a:lnTo>
                    <a:pt x="395" y="668"/>
                  </a:lnTo>
                  <a:lnTo>
                    <a:pt x="405" y="663"/>
                  </a:lnTo>
                  <a:lnTo>
                    <a:pt x="416" y="658"/>
                  </a:lnTo>
                  <a:lnTo>
                    <a:pt x="427" y="653"/>
                  </a:lnTo>
                  <a:lnTo>
                    <a:pt x="437" y="648"/>
                  </a:lnTo>
                  <a:lnTo>
                    <a:pt x="448" y="645"/>
                  </a:lnTo>
                  <a:lnTo>
                    <a:pt x="459" y="644"/>
                  </a:lnTo>
                  <a:lnTo>
                    <a:pt x="470" y="639"/>
                  </a:lnTo>
                  <a:lnTo>
                    <a:pt x="479" y="636"/>
                  </a:lnTo>
                  <a:lnTo>
                    <a:pt x="491" y="631"/>
                  </a:lnTo>
                  <a:lnTo>
                    <a:pt x="502" y="628"/>
                  </a:lnTo>
                  <a:lnTo>
                    <a:pt x="511" y="625"/>
                  </a:lnTo>
                  <a:lnTo>
                    <a:pt x="522" y="620"/>
                  </a:lnTo>
                  <a:lnTo>
                    <a:pt x="533" y="617"/>
                  </a:lnTo>
                  <a:lnTo>
                    <a:pt x="545" y="614"/>
                  </a:lnTo>
                  <a:lnTo>
                    <a:pt x="554" y="610"/>
                  </a:lnTo>
                  <a:lnTo>
                    <a:pt x="565" y="607"/>
                  </a:lnTo>
                  <a:lnTo>
                    <a:pt x="576" y="602"/>
                  </a:lnTo>
                  <a:lnTo>
                    <a:pt x="587" y="601"/>
                  </a:lnTo>
                  <a:lnTo>
                    <a:pt x="597" y="596"/>
                  </a:lnTo>
                  <a:lnTo>
                    <a:pt x="608" y="596"/>
                  </a:lnTo>
                  <a:lnTo>
                    <a:pt x="619" y="593"/>
                  </a:lnTo>
                  <a:lnTo>
                    <a:pt x="629" y="590"/>
                  </a:lnTo>
                  <a:lnTo>
                    <a:pt x="640" y="588"/>
                  </a:lnTo>
                  <a:lnTo>
                    <a:pt x="651" y="585"/>
                  </a:lnTo>
                  <a:lnTo>
                    <a:pt x="662" y="582"/>
                  </a:lnTo>
                  <a:lnTo>
                    <a:pt x="672" y="580"/>
                  </a:lnTo>
                  <a:lnTo>
                    <a:pt x="683" y="577"/>
                  </a:lnTo>
                  <a:lnTo>
                    <a:pt x="694" y="575"/>
                  </a:lnTo>
                  <a:lnTo>
                    <a:pt x="705" y="571"/>
                  </a:lnTo>
                  <a:lnTo>
                    <a:pt x="715" y="571"/>
                  </a:lnTo>
                  <a:lnTo>
                    <a:pt x="726" y="567"/>
                  </a:lnTo>
                  <a:lnTo>
                    <a:pt x="737" y="564"/>
                  </a:lnTo>
                  <a:lnTo>
                    <a:pt x="746" y="561"/>
                  </a:lnTo>
                  <a:lnTo>
                    <a:pt x="757" y="561"/>
                  </a:lnTo>
                  <a:lnTo>
                    <a:pt x="769" y="558"/>
                  </a:lnTo>
                  <a:lnTo>
                    <a:pt x="780" y="555"/>
                  </a:lnTo>
                  <a:lnTo>
                    <a:pt x="789" y="555"/>
                  </a:lnTo>
                  <a:lnTo>
                    <a:pt x="800" y="552"/>
                  </a:lnTo>
                  <a:lnTo>
                    <a:pt x="811" y="550"/>
                  </a:lnTo>
                  <a:lnTo>
                    <a:pt x="821" y="548"/>
                  </a:lnTo>
                  <a:lnTo>
                    <a:pt x="832" y="545"/>
                  </a:lnTo>
                  <a:lnTo>
                    <a:pt x="843" y="542"/>
                  </a:lnTo>
                  <a:lnTo>
                    <a:pt x="854" y="540"/>
                  </a:lnTo>
                  <a:lnTo>
                    <a:pt x="864" y="537"/>
                  </a:lnTo>
                  <a:lnTo>
                    <a:pt x="875" y="536"/>
                  </a:lnTo>
                  <a:lnTo>
                    <a:pt x="886" y="533"/>
                  </a:lnTo>
                  <a:lnTo>
                    <a:pt x="897" y="531"/>
                  </a:lnTo>
                  <a:lnTo>
                    <a:pt x="907" y="528"/>
                  </a:lnTo>
                  <a:lnTo>
                    <a:pt x="918" y="526"/>
                  </a:lnTo>
                  <a:lnTo>
                    <a:pt x="929" y="525"/>
                  </a:lnTo>
                  <a:lnTo>
                    <a:pt x="939" y="523"/>
                  </a:lnTo>
                  <a:lnTo>
                    <a:pt x="950" y="521"/>
                  </a:lnTo>
                  <a:lnTo>
                    <a:pt x="961" y="520"/>
                  </a:lnTo>
                  <a:lnTo>
                    <a:pt x="972" y="518"/>
                  </a:lnTo>
                  <a:lnTo>
                    <a:pt x="981" y="515"/>
                  </a:lnTo>
                  <a:lnTo>
                    <a:pt x="993" y="513"/>
                  </a:lnTo>
                  <a:lnTo>
                    <a:pt x="1004" y="512"/>
                  </a:lnTo>
                  <a:lnTo>
                    <a:pt x="1015" y="510"/>
                  </a:lnTo>
                  <a:lnTo>
                    <a:pt x="1024" y="509"/>
                  </a:lnTo>
                  <a:lnTo>
                    <a:pt x="1035" y="509"/>
                  </a:lnTo>
                  <a:lnTo>
                    <a:pt x="1047" y="507"/>
                  </a:lnTo>
                  <a:lnTo>
                    <a:pt x="1056" y="504"/>
                  </a:lnTo>
                  <a:lnTo>
                    <a:pt x="1067" y="501"/>
                  </a:lnTo>
                  <a:lnTo>
                    <a:pt x="1078" y="499"/>
                  </a:lnTo>
                  <a:lnTo>
                    <a:pt x="1090" y="499"/>
                  </a:lnTo>
                  <a:lnTo>
                    <a:pt x="1099" y="498"/>
                  </a:lnTo>
                  <a:lnTo>
                    <a:pt x="1110" y="496"/>
                  </a:lnTo>
                  <a:lnTo>
                    <a:pt x="1121" y="494"/>
                  </a:lnTo>
                  <a:lnTo>
                    <a:pt x="1132" y="494"/>
                  </a:lnTo>
                  <a:lnTo>
                    <a:pt x="1142" y="491"/>
                  </a:lnTo>
                  <a:lnTo>
                    <a:pt x="1153" y="488"/>
                  </a:lnTo>
                  <a:lnTo>
                    <a:pt x="1164" y="488"/>
                  </a:lnTo>
                  <a:lnTo>
                    <a:pt x="1174" y="486"/>
                  </a:lnTo>
                  <a:lnTo>
                    <a:pt x="1185" y="486"/>
                  </a:lnTo>
                  <a:lnTo>
                    <a:pt x="1196" y="482"/>
                  </a:lnTo>
                  <a:lnTo>
                    <a:pt x="1207" y="482"/>
                  </a:lnTo>
                  <a:lnTo>
                    <a:pt x="1217" y="480"/>
                  </a:lnTo>
                  <a:lnTo>
                    <a:pt x="1228" y="479"/>
                  </a:lnTo>
                  <a:lnTo>
                    <a:pt x="1239" y="475"/>
                  </a:lnTo>
                  <a:lnTo>
                    <a:pt x="1248" y="474"/>
                  </a:lnTo>
                  <a:lnTo>
                    <a:pt x="1260" y="471"/>
                  </a:lnTo>
                  <a:lnTo>
                    <a:pt x="1271" y="471"/>
                  </a:lnTo>
                  <a:lnTo>
                    <a:pt x="1282" y="469"/>
                  </a:lnTo>
                  <a:lnTo>
                    <a:pt x="1291" y="467"/>
                  </a:lnTo>
                  <a:lnTo>
                    <a:pt x="1302" y="467"/>
                  </a:lnTo>
                  <a:lnTo>
                    <a:pt x="1314" y="464"/>
                  </a:lnTo>
                  <a:lnTo>
                    <a:pt x="1325" y="463"/>
                  </a:lnTo>
                  <a:lnTo>
                    <a:pt x="1334" y="463"/>
                  </a:lnTo>
                  <a:lnTo>
                    <a:pt x="1345" y="463"/>
                  </a:lnTo>
                  <a:lnTo>
                    <a:pt x="1356" y="461"/>
                  </a:lnTo>
                  <a:lnTo>
                    <a:pt x="1366" y="458"/>
                  </a:lnTo>
                  <a:lnTo>
                    <a:pt x="1377" y="456"/>
                  </a:lnTo>
                  <a:lnTo>
                    <a:pt x="1388" y="455"/>
                  </a:lnTo>
                  <a:lnTo>
                    <a:pt x="1399" y="452"/>
                  </a:lnTo>
                  <a:lnTo>
                    <a:pt x="1409" y="450"/>
                  </a:lnTo>
                  <a:lnTo>
                    <a:pt x="1420" y="450"/>
                  </a:lnTo>
                  <a:lnTo>
                    <a:pt x="1431" y="450"/>
                  </a:lnTo>
                  <a:lnTo>
                    <a:pt x="1442" y="448"/>
                  </a:lnTo>
                  <a:lnTo>
                    <a:pt x="1452" y="447"/>
                  </a:lnTo>
                  <a:lnTo>
                    <a:pt x="1463" y="445"/>
                  </a:lnTo>
                  <a:lnTo>
                    <a:pt x="1474" y="444"/>
                  </a:lnTo>
                  <a:lnTo>
                    <a:pt x="1484" y="444"/>
                  </a:lnTo>
                  <a:lnTo>
                    <a:pt x="1495" y="442"/>
                  </a:lnTo>
                  <a:lnTo>
                    <a:pt x="1506" y="439"/>
                  </a:lnTo>
                  <a:lnTo>
                    <a:pt x="1517" y="436"/>
                  </a:lnTo>
                  <a:lnTo>
                    <a:pt x="1526" y="437"/>
                  </a:lnTo>
                  <a:lnTo>
                    <a:pt x="1538" y="436"/>
                  </a:lnTo>
                  <a:lnTo>
                    <a:pt x="1549" y="432"/>
                  </a:lnTo>
                  <a:lnTo>
                    <a:pt x="1558" y="432"/>
                  </a:lnTo>
                  <a:lnTo>
                    <a:pt x="1569" y="429"/>
                  </a:lnTo>
                  <a:lnTo>
                    <a:pt x="1580" y="429"/>
                  </a:lnTo>
                  <a:lnTo>
                    <a:pt x="1592" y="428"/>
                  </a:lnTo>
                  <a:lnTo>
                    <a:pt x="1601" y="426"/>
                  </a:lnTo>
                  <a:lnTo>
                    <a:pt x="1612" y="425"/>
                  </a:lnTo>
                  <a:lnTo>
                    <a:pt x="1623" y="423"/>
                  </a:lnTo>
                  <a:lnTo>
                    <a:pt x="1634" y="423"/>
                  </a:lnTo>
                  <a:lnTo>
                    <a:pt x="1644" y="421"/>
                  </a:lnTo>
                  <a:lnTo>
                    <a:pt x="1655" y="420"/>
                  </a:lnTo>
                  <a:lnTo>
                    <a:pt x="1666" y="418"/>
                  </a:lnTo>
                  <a:lnTo>
                    <a:pt x="1676" y="417"/>
                  </a:lnTo>
                  <a:lnTo>
                    <a:pt x="1687" y="417"/>
                  </a:lnTo>
                  <a:lnTo>
                    <a:pt x="1698" y="415"/>
                  </a:lnTo>
                  <a:lnTo>
                    <a:pt x="1709" y="413"/>
                  </a:lnTo>
                  <a:lnTo>
                    <a:pt x="1719" y="412"/>
                  </a:lnTo>
                  <a:lnTo>
                    <a:pt x="1730" y="410"/>
                  </a:lnTo>
                  <a:lnTo>
                    <a:pt x="1741" y="409"/>
                  </a:lnTo>
                  <a:lnTo>
                    <a:pt x="1752" y="407"/>
                  </a:lnTo>
                  <a:lnTo>
                    <a:pt x="1762" y="405"/>
                  </a:lnTo>
                  <a:lnTo>
                    <a:pt x="1773" y="404"/>
                  </a:lnTo>
                  <a:lnTo>
                    <a:pt x="1784" y="404"/>
                  </a:lnTo>
                  <a:lnTo>
                    <a:pt x="1793" y="402"/>
                  </a:lnTo>
                  <a:lnTo>
                    <a:pt x="1804" y="402"/>
                  </a:lnTo>
                  <a:lnTo>
                    <a:pt x="1816" y="401"/>
                  </a:lnTo>
                  <a:lnTo>
                    <a:pt x="1827" y="399"/>
                  </a:lnTo>
                  <a:lnTo>
                    <a:pt x="1836" y="398"/>
                  </a:lnTo>
                  <a:lnTo>
                    <a:pt x="1847" y="396"/>
                  </a:lnTo>
                  <a:lnTo>
                    <a:pt x="1858" y="396"/>
                  </a:lnTo>
                  <a:lnTo>
                    <a:pt x="1868" y="393"/>
                  </a:lnTo>
                  <a:lnTo>
                    <a:pt x="1879" y="391"/>
                  </a:lnTo>
                  <a:lnTo>
                    <a:pt x="1890" y="391"/>
                  </a:lnTo>
                  <a:lnTo>
                    <a:pt x="1901" y="390"/>
                  </a:lnTo>
                  <a:lnTo>
                    <a:pt x="1911" y="388"/>
                  </a:lnTo>
                  <a:lnTo>
                    <a:pt x="1922" y="386"/>
                  </a:lnTo>
                  <a:lnTo>
                    <a:pt x="1933" y="386"/>
                  </a:lnTo>
                  <a:lnTo>
                    <a:pt x="1944" y="383"/>
                  </a:lnTo>
                  <a:lnTo>
                    <a:pt x="1954" y="382"/>
                  </a:lnTo>
                  <a:lnTo>
                    <a:pt x="1965" y="382"/>
                  </a:lnTo>
                  <a:lnTo>
                    <a:pt x="1976" y="378"/>
                  </a:lnTo>
                  <a:lnTo>
                    <a:pt x="1986" y="378"/>
                  </a:lnTo>
                  <a:lnTo>
                    <a:pt x="1997" y="378"/>
                  </a:lnTo>
                  <a:lnTo>
                    <a:pt x="2008" y="377"/>
                  </a:lnTo>
                  <a:lnTo>
                    <a:pt x="2019" y="377"/>
                  </a:lnTo>
                  <a:lnTo>
                    <a:pt x="2028" y="375"/>
                  </a:lnTo>
                  <a:lnTo>
                    <a:pt x="2040" y="374"/>
                  </a:lnTo>
                  <a:lnTo>
                    <a:pt x="2051" y="372"/>
                  </a:lnTo>
                  <a:lnTo>
                    <a:pt x="2062" y="371"/>
                  </a:lnTo>
                  <a:lnTo>
                    <a:pt x="2071" y="367"/>
                  </a:lnTo>
                  <a:lnTo>
                    <a:pt x="2082" y="369"/>
                  </a:lnTo>
                  <a:lnTo>
                    <a:pt x="2094" y="367"/>
                  </a:lnTo>
                  <a:lnTo>
                    <a:pt x="2103" y="366"/>
                  </a:lnTo>
                  <a:lnTo>
                    <a:pt x="2114" y="364"/>
                  </a:lnTo>
                  <a:lnTo>
                    <a:pt x="2125" y="364"/>
                  </a:lnTo>
                  <a:lnTo>
                    <a:pt x="2136" y="361"/>
                  </a:lnTo>
                  <a:lnTo>
                    <a:pt x="2146" y="361"/>
                  </a:lnTo>
                  <a:lnTo>
                    <a:pt x="2157" y="369"/>
                  </a:lnTo>
                  <a:lnTo>
                    <a:pt x="2168" y="374"/>
                  </a:lnTo>
                  <a:lnTo>
                    <a:pt x="2179" y="371"/>
                  </a:lnTo>
                  <a:lnTo>
                    <a:pt x="2189" y="405"/>
                  </a:lnTo>
                  <a:lnTo>
                    <a:pt x="2200" y="331"/>
                  </a:lnTo>
                  <a:lnTo>
                    <a:pt x="2211" y="340"/>
                  </a:lnTo>
                  <a:lnTo>
                    <a:pt x="2221" y="353"/>
                  </a:lnTo>
                  <a:lnTo>
                    <a:pt x="2232" y="359"/>
                  </a:lnTo>
                  <a:lnTo>
                    <a:pt x="2243" y="363"/>
                  </a:lnTo>
                  <a:lnTo>
                    <a:pt x="2254" y="366"/>
                  </a:lnTo>
                  <a:lnTo>
                    <a:pt x="2264" y="367"/>
                  </a:lnTo>
                  <a:lnTo>
                    <a:pt x="2275" y="367"/>
                  </a:lnTo>
                  <a:lnTo>
                    <a:pt x="2286" y="369"/>
                  </a:lnTo>
                  <a:lnTo>
                    <a:pt x="2295" y="371"/>
                  </a:lnTo>
                  <a:lnTo>
                    <a:pt x="2306" y="371"/>
                  </a:lnTo>
                  <a:lnTo>
                    <a:pt x="2318" y="372"/>
                  </a:lnTo>
                  <a:lnTo>
                    <a:pt x="2329" y="374"/>
                  </a:lnTo>
                  <a:lnTo>
                    <a:pt x="2338" y="374"/>
                  </a:lnTo>
                  <a:lnTo>
                    <a:pt x="2349" y="374"/>
                  </a:lnTo>
                  <a:lnTo>
                    <a:pt x="2360" y="375"/>
                  </a:lnTo>
                  <a:lnTo>
                    <a:pt x="2372" y="375"/>
                  </a:lnTo>
                  <a:lnTo>
                    <a:pt x="2381" y="375"/>
                  </a:lnTo>
                  <a:lnTo>
                    <a:pt x="2392" y="377"/>
                  </a:lnTo>
                  <a:lnTo>
                    <a:pt x="2403" y="377"/>
                  </a:lnTo>
                  <a:lnTo>
                    <a:pt x="2413" y="377"/>
                  </a:lnTo>
                  <a:lnTo>
                    <a:pt x="2424" y="377"/>
                  </a:lnTo>
                  <a:lnTo>
                    <a:pt x="2435" y="377"/>
                  </a:lnTo>
                  <a:lnTo>
                    <a:pt x="2446" y="377"/>
                  </a:lnTo>
                  <a:lnTo>
                    <a:pt x="2456" y="377"/>
                  </a:lnTo>
                  <a:lnTo>
                    <a:pt x="2467" y="377"/>
                  </a:lnTo>
                  <a:lnTo>
                    <a:pt x="2478" y="377"/>
                  </a:lnTo>
                  <a:lnTo>
                    <a:pt x="2489" y="377"/>
                  </a:lnTo>
                  <a:lnTo>
                    <a:pt x="2499" y="378"/>
                  </a:lnTo>
                  <a:lnTo>
                    <a:pt x="2510" y="380"/>
                  </a:lnTo>
                  <a:lnTo>
                    <a:pt x="2521" y="380"/>
                  </a:lnTo>
                  <a:lnTo>
                    <a:pt x="2530" y="380"/>
                  </a:lnTo>
                  <a:lnTo>
                    <a:pt x="2542" y="380"/>
                  </a:lnTo>
                  <a:lnTo>
                    <a:pt x="2553" y="380"/>
                  </a:lnTo>
                  <a:lnTo>
                    <a:pt x="2564" y="380"/>
                  </a:lnTo>
                  <a:lnTo>
                    <a:pt x="2573" y="382"/>
                  </a:lnTo>
                  <a:lnTo>
                    <a:pt x="2584" y="382"/>
                  </a:lnTo>
                  <a:lnTo>
                    <a:pt x="2596" y="382"/>
                  </a:lnTo>
                  <a:lnTo>
                    <a:pt x="2605" y="382"/>
                  </a:lnTo>
                  <a:lnTo>
                    <a:pt x="2616" y="380"/>
                  </a:lnTo>
                  <a:lnTo>
                    <a:pt x="2627" y="380"/>
                  </a:lnTo>
                  <a:lnTo>
                    <a:pt x="2639" y="382"/>
                  </a:lnTo>
                  <a:lnTo>
                    <a:pt x="2648" y="382"/>
                  </a:lnTo>
                  <a:lnTo>
                    <a:pt x="2659" y="382"/>
                  </a:lnTo>
                  <a:lnTo>
                    <a:pt x="2670" y="382"/>
                  </a:lnTo>
                  <a:lnTo>
                    <a:pt x="2681" y="380"/>
                  </a:lnTo>
                  <a:lnTo>
                    <a:pt x="2691" y="382"/>
                  </a:lnTo>
                  <a:lnTo>
                    <a:pt x="2702" y="383"/>
                  </a:lnTo>
                  <a:lnTo>
                    <a:pt x="2713" y="383"/>
                  </a:lnTo>
                  <a:lnTo>
                    <a:pt x="2723" y="382"/>
                  </a:lnTo>
                  <a:lnTo>
                    <a:pt x="2734" y="382"/>
                  </a:lnTo>
                  <a:lnTo>
                    <a:pt x="2745" y="383"/>
                  </a:lnTo>
                  <a:lnTo>
                    <a:pt x="2756" y="382"/>
                  </a:lnTo>
                  <a:lnTo>
                    <a:pt x="2766" y="385"/>
                  </a:lnTo>
                  <a:lnTo>
                    <a:pt x="2777" y="385"/>
                  </a:lnTo>
                  <a:lnTo>
                    <a:pt x="2788" y="385"/>
                  </a:lnTo>
                  <a:lnTo>
                    <a:pt x="2799" y="385"/>
                  </a:lnTo>
                  <a:lnTo>
                    <a:pt x="2809" y="383"/>
                  </a:lnTo>
                  <a:lnTo>
                    <a:pt x="2820" y="382"/>
                  </a:lnTo>
                  <a:lnTo>
                    <a:pt x="2831" y="383"/>
                  </a:lnTo>
                  <a:lnTo>
                    <a:pt x="2840" y="385"/>
                  </a:lnTo>
                  <a:lnTo>
                    <a:pt x="2851" y="385"/>
                  </a:lnTo>
                  <a:lnTo>
                    <a:pt x="2863" y="383"/>
                  </a:lnTo>
                  <a:lnTo>
                    <a:pt x="2874" y="382"/>
                  </a:lnTo>
                  <a:lnTo>
                    <a:pt x="2883" y="383"/>
                  </a:lnTo>
                  <a:lnTo>
                    <a:pt x="2894" y="386"/>
                  </a:lnTo>
                  <a:lnTo>
                    <a:pt x="2905" y="386"/>
                  </a:lnTo>
                  <a:lnTo>
                    <a:pt x="2915" y="388"/>
                  </a:lnTo>
                  <a:lnTo>
                    <a:pt x="2926" y="386"/>
                  </a:lnTo>
                  <a:lnTo>
                    <a:pt x="2937" y="386"/>
                  </a:lnTo>
                  <a:lnTo>
                    <a:pt x="2948" y="386"/>
                  </a:lnTo>
                  <a:lnTo>
                    <a:pt x="2958" y="386"/>
                  </a:lnTo>
                  <a:lnTo>
                    <a:pt x="2969" y="386"/>
                  </a:lnTo>
                  <a:lnTo>
                    <a:pt x="2980" y="386"/>
                  </a:lnTo>
                  <a:lnTo>
                    <a:pt x="2991" y="386"/>
                  </a:lnTo>
                  <a:lnTo>
                    <a:pt x="3001" y="386"/>
                  </a:lnTo>
                  <a:lnTo>
                    <a:pt x="3012" y="388"/>
                  </a:lnTo>
                  <a:lnTo>
                    <a:pt x="3023" y="388"/>
                  </a:lnTo>
                  <a:lnTo>
                    <a:pt x="3033" y="390"/>
                  </a:lnTo>
                  <a:lnTo>
                    <a:pt x="3044" y="386"/>
                  </a:lnTo>
                  <a:lnTo>
                    <a:pt x="3055" y="388"/>
                  </a:lnTo>
                  <a:lnTo>
                    <a:pt x="3066" y="388"/>
                  </a:lnTo>
                  <a:lnTo>
                    <a:pt x="3075" y="388"/>
                  </a:lnTo>
                  <a:lnTo>
                    <a:pt x="3087" y="386"/>
                  </a:lnTo>
                  <a:lnTo>
                    <a:pt x="3098" y="386"/>
                  </a:lnTo>
                  <a:lnTo>
                    <a:pt x="3109" y="388"/>
                  </a:lnTo>
                  <a:lnTo>
                    <a:pt x="3118" y="388"/>
                  </a:lnTo>
                  <a:lnTo>
                    <a:pt x="3129" y="390"/>
                  </a:lnTo>
                  <a:lnTo>
                    <a:pt x="3141" y="390"/>
                  </a:lnTo>
                  <a:lnTo>
                    <a:pt x="3150" y="390"/>
                  </a:lnTo>
                  <a:lnTo>
                    <a:pt x="3161" y="390"/>
                  </a:lnTo>
                  <a:lnTo>
                    <a:pt x="3172" y="391"/>
                  </a:lnTo>
                  <a:lnTo>
                    <a:pt x="3183" y="390"/>
                  </a:lnTo>
                  <a:lnTo>
                    <a:pt x="3193" y="390"/>
                  </a:lnTo>
                  <a:lnTo>
                    <a:pt x="3204" y="390"/>
                  </a:lnTo>
                  <a:lnTo>
                    <a:pt x="3215" y="388"/>
                  </a:lnTo>
                  <a:lnTo>
                    <a:pt x="3225" y="388"/>
                  </a:lnTo>
                  <a:lnTo>
                    <a:pt x="3236" y="390"/>
                  </a:lnTo>
                  <a:lnTo>
                    <a:pt x="3247" y="390"/>
                  </a:lnTo>
                  <a:lnTo>
                    <a:pt x="3258" y="391"/>
                  </a:lnTo>
                  <a:lnTo>
                    <a:pt x="3268" y="390"/>
                  </a:lnTo>
                  <a:lnTo>
                    <a:pt x="3279" y="390"/>
                  </a:lnTo>
                  <a:lnTo>
                    <a:pt x="3290" y="391"/>
                  </a:lnTo>
                  <a:lnTo>
                    <a:pt x="3301" y="391"/>
                  </a:lnTo>
                  <a:lnTo>
                    <a:pt x="3311" y="390"/>
                  </a:lnTo>
                  <a:lnTo>
                    <a:pt x="3322" y="391"/>
                  </a:lnTo>
                  <a:lnTo>
                    <a:pt x="3333" y="391"/>
                  </a:lnTo>
                  <a:lnTo>
                    <a:pt x="3342" y="391"/>
                  </a:lnTo>
                  <a:lnTo>
                    <a:pt x="3353" y="391"/>
                  </a:lnTo>
                  <a:lnTo>
                    <a:pt x="3365" y="391"/>
                  </a:lnTo>
                  <a:lnTo>
                    <a:pt x="3376" y="391"/>
                  </a:lnTo>
                  <a:lnTo>
                    <a:pt x="3385" y="391"/>
                  </a:lnTo>
                  <a:lnTo>
                    <a:pt x="3396" y="391"/>
                  </a:lnTo>
                  <a:lnTo>
                    <a:pt x="3407" y="391"/>
                  </a:lnTo>
                  <a:lnTo>
                    <a:pt x="3419" y="391"/>
                  </a:lnTo>
                  <a:lnTo>
                    <a:pt x="3428" y="393"/>
                  </a:lnTo>
                  <a:lnTo>
                    <a:pt x="3439" y="393"/>
                  </a:lnTo>
                  <a:lnTo>
                    <a:pt x="3450" y="391"/>
                  </a:lnTo>
                  <a:lnTo>
                    <a:pt x="3460" y="393"/>
                  </a:lnTo>
                  <a:lnTo>
                    <a:pt x="3471" y="393"/>
                  </a:lnTo>
                  <a:lnTo>
                    <a:pt x="3482" y="393"/>
                  </a:lnTo>
                  <a:lnTo>
                    <a:pt x="3493" y="393"/>
                  </a:lnTo>
                  <a:lnTo>
                    <a:pt x="3503" y="393"/>
                  </a:lnTo>
                  <a:lnTo>
                    <a:pt x="3514" y="393"/>
                  </a:lnTo>
                  <a:lnTo>
                    <a:pt x="3525" y="391"/>
                  </a:lnTo>
                  <a:lnTo>
                    <a:pt x="3536" y="393"/>
                  </a:lnTo>
                  <a:lnTo>
                    <a:pt x="3546" y="393"/>
                  </a:lnTo>
                  <a:lnTo>
                    <a:pt x="3557" y="391"/>
                  </a:lnTo>
                  <a:lnTo>
                    <a:pt x="3568" y="391"/>
                  </a:lnTo>
                  <a:lnTo>
                    <a:pt x="3577" y="391"/>
                  </a:lnTo>
                  <a:lnTo>
                    <a:pt x="3589" y="393"/>
                  </a:lnTo>
                  <a:lnTo>
                    <a:pt x="3600" y="393"/>
                  </a:lnTo>
                  <a:lnTo>
                    <a:pt x="3611" y="391"/>
                  </a:lnTo>
                  <a:lnTo>
                    <a:pt x="3620" y="393"/>
                  </a:lnTo>
                  <a:lnTo>
                    <a:pt x="3631" y="394"/>
                  </a:lnTo>
                  <a:lnTo>
                    <a:pt x="3643" y="390"/>
                  </a:lnTo>
                  <a:lnTo>
                    <a:pt x="3652" y="391"/>
                  </a:lnTo>
                  <a:lnTo>
                    <a:pt x="3663" y="393"/>
                  </a:lnTo>
                  <a:lnTo>
                    <a:pt x="3674" y="393"/>
                  </a:lnTo>
                  <a:lnTo>
                    <a:pt x="3685" y="391"/>
                  </a:lnTo>
                  <a:lnTo>
                    <a:pt x="3695" y="391"/>
                  </a:lnTo>
                  <a:lnTo>
                    <a:pt x="3706" y="393"/>
                  </a:lnTo>
                  <a:lnTo>
                    <a:pt x="3717" y="393"/>
                  </a:lnTo>
                  <a:lnTo>
                    <a:pt x="3728" y="393"/>
                  </a:lnTo>
                  <a:lnTo>
                    <a:pt x="3738" y="393"/>
                  </a:lnTo>
                  <a:lnTo>
                    <a:pt x="3749" y="393"/>
                  </a:lnTo>
                  <a:lnTo>
                    <a:pt x="3760" y="393"/>
                  </a:lnTo>
                  <a:lnTo>
                    <a:pt x="3770" y="393"/>
                  </a:lnTo>
                  <a:lnTo>
                    <a:pt x="3781" y="394"/>
                  </a:lnTo>
                  <a:lnTo>
                    <a:pt x="3792" y="399"/>
                  </a:lnTo>
                  <a:lnTo>
                    <a:pt x="3803" y="394"/>
                  </a:lnTo>
                  <a:lnTo>
                    <a:pt x="3813" y="394"/>
                  </a:lnTo>
                  <a:lnTo>
                    <a:pt x="3824" y="407"/>
                  </a:lnTo>
                  <a:lnTo>
                    <a:pt x="3835" y="405"/>
                  </a:lnTo>
                  <a:lnTo>
                    <a:pt x="3846" y="396"/>
                  </a:lnTo>
                  <a:lnTo>
                    <a:pt x="3855" y="394"/>
                  </a:lnTo>
                  <a:lnTo>
                    <a:pt x="3867" y="398"/>
                  </a:lnTo>
                  <a:lnTo>
                    <a:pt x="3878" y="407"/>
                  </a:lnTo>
                  <a:lnTo>
                    <a:pt x="3887" y="399"/>
                  </a:lnTo>
                  <a:lnTo>
                    <a:pt x="3898" y="385"/>
                  </a:lnTo>
                  <a:lnTo>
                    <a:pt x="3909" y="391"/>
                  </a:lnTo>
                  <a:lnTo>
                    <a:pt x="3921" y="394"/>
                  </a:lnTo>
                  <a:lnTo>
                    <a:pt x="3930" y="396"/>
                  </a:lnTo>
                  <a:lnTo>
                    <a:pt x="3941" y="396"/>
                  </a:lnTo>
                  <a:lnTo>
                    <a:pt x="3952" y="396"/>
                  </a:lnTo>
                  <a:lnTo>
                    <a:pt x="3962" y="396"/>
                  </a:lnTo>
                  <a:lnTo>
                    <a:pt x="3973" y="386"/>
                  </a:lnTo>
                  <a:lnTo>
                    <a:pt x="3984" y="388"/>
                  </a:lnTo>
                  <a:lnTo>
                    <a:pt x="3995" y="398"/>
                  </a:lnTo>
                  <a:lnTo>
                    <a:pt x="4005" y="412"/>
                  </a:lnTo>
                  <a:lnTo>
                    <a:pt x="4016" y="412"/>
                  </a:lnTo>
                  <a:lnTo>
                    <a:pt x="4027" y="401"/>
                  </a:lnTo>
                  <a:lnTo>
                    <a:pt x="4038" y="399"/>
                  </a:lnTo>
                  <a:lnTo>
                    <a:pt x="4048" y="399"/>
                  </a:lnTo>
                  <a:lnTo>
                    <a:pt x="4059" y="399"/>
                  </a:lnTo>
                  <a:lnTo>
                    <a:pt x="4070" y="399"/>
                  </a:lnTo>
                  <a:lnTo>
                    <a:pt x="4079" y="399"/>
                  </a:lnTo>
                  <a:lnTo>
                    <a:pt x="4091" y="398"/>
                  </a:lnTo>
                  <a:lnTo>
                    <a:pt x="4102" y="399"/>
                  </a:lnTo>
                  <a:lnTo>
                    <a:pt x="4113" y="399"/>
                  </a:lnTo>
                </a:path>
              </a:pathLst>
            </a:custGeom>
            <a:noFill/>
            <a:ln w="0">
              <a:solidFill>
                <a:srgbClr val="FF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1" name="Freeform 101"/>
            <p:cNvSpPr>
              <a:spLocks/>
            </p:cNvSpPr>
            <p:nvPr/>
          </p:nvSpPr>
          <p:spPr bwMode="auto">
            <a:xfrm>
              <a:off x="763" y="1494"/>
              <a:ext cx="4113" cy="1831"/>
            </a:xfrm>
            <a:custGeom>
              <a:avLst/>
              <a:gdLst>
                <a:gd name="T0" fmla="*/ 63 w 4113"/>
                <a:gd name="T1" fmla="*/ 1342 h 1831"/>
                <a:gd name="T2" fmla="*/ 138 w 4113"/>
                <a:gd name="T3" fmla="*/ 1342 h 1831"/>
                <a:gd name="T4" fmla="*/ 212 w 4113"/>
                <a:gd name="T5" fmla="*/ 1341 h 1831"/>
                <a:gd name="T6" fmla="*/ 289 w 4113"/>
                <a:gd name="T7" fmla="*/ 815 h 1831"/>
                <a:gd name="T8" fmla="*/ 363 w 4113"/>
                <a:gd name="T9" fmla="*/ 1382 h 1831"/>
                <a:gd name="T10" fmla="*/ 438 w 4113"/>
                <a:gd name="T11" fmla="*/ 1336 h 1831"/>
                <a:gd name="T12" fmla="*/ 513 w 4113"/>
                <a:gd name="T13" fmla="*/ 1328 h 1831"/>
                <a:gd name="T14" fmla="*/ 587 w 4113"/>
                <a:gd name="T15" fmla="*/ 1323 h 1831"/>
                <a:gd name="T16" fmla="*/ 662 w 4113"/>
                <a:gd name="T17" fmla="*/ 1315 h 1831"/>
                <a:gd name="T18" fmla="*/ 737 w 4113"/>
                <a:gd name="T19" fmla="*/ 1312 h 1831"/>
                <a:gd name="T20" fmla="*/ 811 w 4113"/>
                <a:gd name="T21" fmla="*/ 1306 h 1831"/>
                <a:gd name="T22" fmla="*/ 886 w 4113"/>
                <a:gd name="T23" fmla="*/ 1299 h 1831"/>
                <a:gd name="T24" fmla="*/ 961 w 4113"/>
                <a:gd name="T25" fmla="*/ 1296 h 1831"/>
                <a:gd name="T26" fmla="*/ 1035 w 4113"/>
                <a:gd name="T27" fmla="*/ 1290 h 1831"/>
                <a:gd name="T28" fmla="*/ 1110 w 4113"/>
                <a:gd name="T29" fmla="*/ 1285 h 1831"/>
                <a:gd name="T30" fmla="*/ 1185 w 4113"/>
                <a:gd name="T31" fmla="*/ 1280 h 1831"/>
                <a:gd name="T32" fmla="*/ 1259 w 4113"/>
                <a:gd name="T33" fmla="*/ 1274 h 1831"/>
                <a:gd name="T34" fmla="*/ 1336 w 4113"/>
                <a:gd name="T35" fmla="*/ 1269 h 1831"/>
                <a:gd name="T36" fmla="*/ 1410 w 4113"/>
                <a:gd name="T37" fmla="*/ 1263 h 1831"/>
                <a:gd name="T38" fmla="*/ 1485 w 4113"/>
                <a:gd name="T39" fmla="*/ 1260 h 1831"/>
                <a:gd name="T40" fmla="*/ 1560 w 4113"/>
                <a:gd name="T41" fmla="*/ 1256 h 1831"/>
                <a:gd name="T42" fmla="*/ 1634 w 4113"/>
                <a:gd name="T43" fmla="*/ 1250 h 1831"/>
                <a:gd name="T44" fmla="*/ 1709 w 4113"/>
                <a:gd name="T45" fmla="*/ 1244 h 1831"/>
                <a:gd name="T46" fmla="*/ 1784 w 4113"/>
                <a:gd name="T47" fmla="*/ 1239 h 1831"/>
                <a:gd name="T48" fmla="*/ 1858 w 4113"/>
                <a:gd name="T49" fmla="*/ 1234 h 1831"/>
                <a:gd name="T50" fmla="*/ 1933 w 4113"/>
                <a:gd name="T51" fmla="*/ 1231 h 1831"/>
                <a:gd name="T52" fmla="*/ 2008 w 4113"/>
                <a:gd name="T53" fmla="*/ 1226 h 1831"/>
                <a:gd name="T54" fmla="*/ 2082 w 4113"/>
                <a:gd name="T55" fmla="*/ 1223 h 1831"/>
                <a:gd name="T56" fmla="*/ 2157 w 4113"/>
                <a:gd name="T57" fmla="*/ 1218 h 1831"/>
                <a:gd name="T58" fmla="*/ 2232 w 4113"/>
                <a:gd name="T59" fmla="*/ 1207 h 1831"/>
                <a:gd name="T60" fmla="*/ 2306 w 4113"/>
                <a:gd name="T61" fmla="*/ 1226 h 1831"/>
                <a:gd name="T62" fmla="*/ 2383 w 4113"/>
                <a:gd name="T63" fmla="*/ 1234 h 1831"/>
                <a:gd name="T64" fmla="*/ 2457 w 4113"/>
                <a:gd name="T65" fmla="*/ 1233 h 1831"/>
                <a:gd name="T66" fmla="*/ 2532 w 4113"/>
                <a:gd name="T67" fmla="*/ 1236 h 1831"/>
                <a:gd name="T68" fmla="*/ 2607 w 4113"/>
                <a:gd name="T69" fmla="*/ 1236 h 1831"/>
                <a:gd name="T70" fmla="*/ 2681 w 4113"/>
                <a:gd name="T71" fmla="*/ 1236 h 1831"/>
                <a:gd name="T72" fmla="*/ 2756 w 4113"/>
                <a:gd name="T73" fmla="*/ 1237 h 1831"/>
                <a:gd name="T74" fmla="*/ 2831 w 4113"/>
                <a:gd name="T75" fmla="*/ 1236 h 1831"/>
                <a:gd name="T76" fmla="*/ 2905 w 4113"/>
                <a:gd name="T77" fmla="*/ 1237 h 1831"/>
                <a:gd name="T78" fmla="*/ 2980 w 4113"/>
                <a:gd name="T79" fmla="*/ 1239 h 1831"/>
                <a:gd name="T80" fmla="*/ 3055 w 4113"/>
                <a:gd name="T81" fmla="*/ 1237 h 1831"/>
                <a:gd name="T82" fmla="*/ 3129 w 4113"/>
                <a:gd name="T83" fmla="*/ 1237 h 1831"/>
                <a:gd name="T84" fmla="*/ 3204 w 4113"/>
                <a:gd name="T85" fmla="*/ 1239 h 1831"/>
                <a:gd name="T86" fmla="*/ 3279 w 4113"/>
                <a:gd name="T87" fmla="*/ 1237 h 1831"/>
                <a:gd name="T88" fmla="*/ 3353 w 4113"/>
                <a:gd name="T89" fmla="*/ 1239 h 1831"/>
                <a:gd name="T90" fmla="*/ 3430 w 4113"/>
                <a:gd name="T91" fmla="*/ 1240 h 1831"/>
                <a:gd name="T92" fmla="*/ 3504 w 4113"/>
                <a:gd name="T93" fmla="*/ 1240 h 1831"/>
                <a:gd name="T94" fmla="*/ 3579 w 4113"/>
                <a:gd name="T95" fmla="*/ 1240 h 1831"/>
                <a:gd name="T96" fmla="*/ 3654 w 4113"/>
                <a:gd name="T97" fmla="*/ 1236 h 1831"/>
                <a:gd name="T98" fmla="*/ 3728 w 4113"/>
                <a:gd name="T99" fmla="*/ 1239 h 1831"/>
                <a:gd name="T100" fmla="*/ 3803 w 4113"/>
                <a:gd name="T101" fmla="*/ 1245 h 1831"/>
                <a:gd name="T102" fmla="*/ 3878 w 4113"/>
                <a:gd name="T103" fmla="*/ 1245 h 1831"/>
                <a:gd name="T104" fmla="*/ 3952 w 4113"/>
                <a:gd name="T105" fmla="*/ 1240 h 1831"/>
                <a:gd name="T106" fmla="*/ 4027 w 4113"/>
                <a:gd name="T107" fmla="*/ 1255 h 1831"/>
                <a:gd name="T108" fmla="*/ 4102 w 4113"/>
                <a:gd name="T109" fmla="*/ 1242 h 18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113" h="1831">
                  <a:moveTo>
                    <a:pt x="0" y="1342"/>
                  </a:moveTo>
                  <a:lnTo>
                    <a:pt x="11" y="1344"/>
                  </a:lnTo>
                  <a:lnTo>
                    <a:pt x="20" y="1342"/>
                  </a:lnTo>
                  <a:lnTo>
                    <a:pt x="31" y="1344"/>
                  </a:lnTo>
                  <a:lnTo>
                    <a:pt x="42" y="1344"/>
                  </a:lnTo>
                  <a:lnTo>
                    <a:pt x="54" y="1342"/>
                  </a:lnTo>
                  <a:lnTo>
                    <a:pt x="63" y="1342"/>
                  </a:lnTo>
                  <a:lnTo>
                    <a:pt x="74" y="1342"/>
                  </a:lnTo>
                  <a:lnTo>
                    <a:pt x="85" y="1341"/>
                  </a:lnTo>
                  <a:lnTo>
                    <a:pt x="96" y="1342"/>
                  </a:lnTo>
                  <a:lnTo>
                    <a:pt x="106" y="1342"/>
                  </a:lnTo>
                  <a:lnTo>
                    <a:pt x="117" y="1342"/>
                  </a:lnTo>
                  <a:lnTo>
                    <a:pt x="128" y="1342"/>
                  </a:lnTo>
                  <a:lnTo>
                    <a:pt x="138" y="1342"/>
                  </a:lnTo>
                  <a:lnTo>
                    <a:pt x="149" y="1344"/>
                  </a:lnTo>
                  <a:lnTo>
                    <a:pt x="160" y="1342"/>
                  </a:lnTo>
                  <a:lnTo>
                    <a:pt x="171" y="1341"/>
                  </a:lnTo>
                  <a:lnTo>
                    <a:pt x="181" y="1342"/>
                  </a:lnTo>
                  <a:lnTo>
                    <a:pt x="192" y="1342"/>
                  </a:lnTo>
                  <a:lnTo>
                    <a:pt x="203" y="1341"/>
                  </a:lnTo>
                  <a:lnTo>
                    <a:pt x="212" y="1341"/>
                  </a:lnTo>
                  <a:lnTo>
                    <a:pt x="224" y="1341"/>
                  </a:lnTo>
                  <a:lnTo>
                    <a:pt x="235" y="1336"/>
                  </a:lnTo>
                  <a:lnTo>
                    <a:pt x="246" y="1336"/>
                  </a:lnTo>
                  <a:lnTo>
                    <a:pt x="255" y="1326"/>
                  </a:lnTo>
                  <a:lnTo>
                    <a:pt x="266" y="1334"/>
                  </a:lnTo>
                  <a:lnTo>
                    <a:pt x="278" y="1321"/>
                  </a:lnTo>
                  <a:lnTo>
                    <a:pt x="289" y="815"/>
                  </a:lnTo>
                  <a:lnTo>
                    <a:pt x="298" y="0"/>
                  </a:lnTo>
                  <a:lnTo>
                    <a:pt x="309" y="1358"/>
                  </a:lnTo>
                  <a:lnTo>
                    <a:pt x="320" y="1831"/>
                  </a:lnTo>
                  <a:lnTo>
                    <a:pt x="330" y="1666"/>
                  </a:lnTo>
                  <a:lnTo>
                    <a:pt x="341" y="1503"/>
                  </a:lnTo>
                  <a:lnTo>
                    <a:pt x="352" y="1420"/>
                  </a:lnTo>
                  <a:lnTo>
                    <a:pt x="363" y="1382"/>
                  </a:lnTo>
                  <a:lnTo>
                    <a:pt x="373" y="1361"/>
                  </a:lnTo>
                  <a:lnTo>
                    <a:pt x="384" y="1352"/>
                  </a:lnTo>
                  <a:lnTo>
                    <a:pt x="395" y="1345"/>
                  </a:lnTo>
                  <a:lnTo>
                    <a:pt x="406" y="1342"/>
                  </a:lnTo>
                  <a:lnTo>
                    <a:pt x="416" y="1341"/>
                  </a:lnTo>
                  <a:lnTo>
                    <a:pt x="427" y="1337"/>
                  </a:lnTo>
                  <a:lnTo>
                    <a:pt x="438" y="1336"/>
                  </a:lnTo>
                  <a:lnTo>
                    <a:pt x="448" y="1336"/>
                  </a:lnTo>
                  <a:lnTo>
                    <a:pt x="459" y="1334"/>
                  </a:lnTo>
                  <a:lnTo>
                    <a:pt x="470" y="1333"/>
                  </a:lnTo>
                  <a:lnTo>
                    <a:pt x="481" y="1333"/>
                  </a:lnTo>
                  <a:lnTo>
                    <a:pt x="490" y="1331"/>
                  </a:lnTo>
                  <a:lnTo>
                    <a:pt x="502" y="1328"/>
                  </a:lnTo>
                  <a:lnTo>
                    <a:pt x="513" y="1328"/>
                  </a:lnTo>
                  <a:lnTo>
                    <a:pt x="522" y="1326"/>
                  </a:lnTo>
                  <a:lnTo>
                    <a:pt x="533" y="1326"/>
                  </a:lnTo>
                  <a:lnTo>
                    <a:pt x="544" y="1326"/>
                  </a:lnTo>
                  <a:lnTo>
                    <a:pt x="556" y="1325"/>
                  </a:lnTo>
                  <a:lnTo>
                    <a:pt x="565" y="1323"/>
                  </a:lnTo>
                  <a:lnTo>
                    <a:pt x="576" y="1323"/>
                  </a:lnTo>
                  <a:lnTo>
                    <a:pt x="587" y="1323"/>
                  </a:lnTo>
                  <a:lnTo>
                    <a:pt x="598" y="1321"/>
                  </a:lnTo>
                  <a:lnTo>
                    <a:pt x="608" y="1321"/>
                  </a:lnTo>
                  <a:lnTo>
                    <a:pt x="619" y="1321"/>
                  </a:lnTo>
                  <a:lnTo>
                    <a:pt x="630" y="1318"/>
                  </a:lnTo>
                  <a:lnTo>
                    <a:pt x="640" y="1317"/>
                  </a:lnTo>
                  <a:lnTo>
                    <a:pt x="651" y="1317"/>
                  </a:lnTo>
                  <a:lnTo>
                    <a:pt x="662" y="1315"/>
                  </a:lnTo>
                  <a:lnTo>
                    <a:pt x="673" y="1315"/>
                  </a:lnTo>
                  <a:lnTo>
                    <a:pt x="683" y="1315"/>
                  </a:lnTo>
                  <a:lnTo>
                    <a:pt x="694" y="1314"/>
                  </a:lnTo>
                  <a:lnTo>
                    <a:pt x="705" y="1314"/>
                  </a:lnTo>
                  <a:lnTo>
                    <a:pt x="716" y="1312"/>
                  </a:lnTo>
                  <a:lnTo>
                    <a:pt x="726" y="1312"/>
                  </a:lnTo>
                  <a:lnTo>
                    <a:pt x="737" y="1312"/>
                  </a:lnTo>
                  <a:lnTo>
                    <a:pt x="748" y="1312"/>
                  </a:lnTo>
                  <a:lnTo>
                    <a:pt x="757" y="1310"/>
                  </a:lnTo>
                  <a:lnTo>
                    <a:pt x="768" y="1309"/>
                  </a:lnTo>
                  <a:lnTo>
                    <a:pt x="780" y="1309"/>
                  </a:lnTo>
                  <a:lnTo>
                    <a:pt x="791" y="1307"/>
                  </a:lnTo>
                  <a:lnTo>
                    <a:pt x="800" y="1307"/>
                  </a:lnTo>
                  <a:lnTo>
                    <a:pt x="811" y="1306"/>
                  </a:lnTo>
                  <a:lnTo>
                    <a:pt x="822" y="1306"/>
                  </a:lnTo>
                  <a:lnTo>
                    <a:pt x="832" y="1306"/>
                  </a:lnTo>
                  <a:lnTo>
                    <a:pt x="843" y="1304"/>
                  </a:lnTo>
                  <a:lnTo>
                    <a:pt x="854" y="1304"/>
                  </a:lnTo>
                  <a:lnTo>
                    <a:pt x="865" y="1301"/>
                  </a:lnTo>
                  <a:lnTo>
                    <a:pt x="875" y="1299"/>
                  </a:lnTo>
                  <a:lnTo>
                    <a:pt x="886" y="1299"/>
                  </a:lnTo>
                  <a:lnTo>
                    <a:pt x="897" y="1298"/>
                  </a:lnTo>
                  <a:lnTo>
                    <a:pt x="908" y="1299"/>
                  </a:lnTo>
                  <a:lnTo>
                    <a:pt x="918" y="1299"/>
                  </a:lnTo>
                  <a:lnTo>
                    <a:pt x="929" y="1298"/>
                  </a:lnTo>
                  <a:lnTo>
                    <a:pt x="940" y="1298"/>
                  </a:lnTo>
                  <a:lnTo>
                    <a:pt x="950" y="1296"/>
                  </a:lnTo>
                  <a:lnTo>
                    <a:pt x="961" y="1296"/>
                  </a:lnTo>
                  <a:lnTo>
                    <a:pt x="972" y="1296"/>
                  </a:lnTo>
                  <a:lnTo>
                    <a:pt x="983" y="1294"/>
                  </a:lnTo>
                  <a:lnTo>
                    <a:pt x="992" y="1293"/>
                  </a:lnTo>
                  <a:lnTo>
                    <a:pt x="1004" y="1293"/>
                  </a:lnTo>
                  <a:lnTo>
                    <a:pt x="1015" y="1291"/>
                  </a:lnTo>
                  <a:lnTo>
                    <a:pt x="1026" y="1290"/>
                  </a:lnTo>
                  <a:lnTo>
                    <a:pt x="1035" y="1290"/>
                  </a:lnTo>
                  <a:lnTo>
                    <a:pt x="1046" y="1290"/>
                  </a:lnTo>
                  <a:lnTo>
                    <a:pt x="1058" y="1290"/>
                  </a:lnTo>
                  <a:lnTo>
                    <a:pt x="1067" y="1288"/>
                  </a:lnTo>
                  <a:lnTo>
                    <a:pt x="1078" y="1288"/>
                  </a:lnTo>
                  <a:lnTo>
                    <a:pt x="1089" y="1287"/>
                  </a:lnTo>
                  <a:lnTo>
                    <a:pt x="1101" y="1285"/>
                  </a:lnTo>
                  <a:lnTo>
                    <a:pt x="1110" y="1285"/>
                  </a:lnTo>
                  <a:lnTo>
                    <a:pt x="1121" y="1283"/>
                  </a:lnTo>
                  <a:lnTo>
                    <a:pt x="1132" y="1282"/>
                  </a:lnTo>
                  <a:lnTo>
                    <a:pt x="1143" y="1282"/>
                  </a:lnTo>
                  <a:lnTo>
                    <a:pt x="1153" y="1282"/>
                  </a:lnTo>
                  <a:lnTo>
                    <a:pt x="1164" y="1280"/>
                  </a:lnTo>
                  <a:lnTo>
                    <a:pt x="1175" y="1279"/>
                  </a:lnTo>
                  <a:lnTo>
                    <a:pt x="1185" y="1280"/>
                  </a:lnTo>
                  <a:lnTo>
                    <a:pt x="1196" y="1279"/>
                  </a:lnTo>
                  <a:lnTo>
                    <a:pt x="1207" y="1277"/>
                  </a:lnTo>
                  <a:lnTo>
                    <a:pt x="1218" y="1277"/>
                  </a:lnTo>
                  <a:lnTo>
                    <a:pt x="1228" y="1275"/>
                  </a:lnTo>
                  <a:lnTo>
                    <a:pt x="1239" y="1274"/>
                  </a:lnTo>
                  <a:lnTo>
                    <a:pt x="1250" y="1274"/>
                  </a:lnTo>
                  <a:lnTo>
                    <a:pt x="1259" y="1274"/>
                  </a:lnTo>
                  <a:lnTo>
                    <a:pt x="1271" y="1272"/>
                  </a:lnTo>
                  <a:lnTo>
                    <a:pt x="1282" y="1271"/>
                  </a:lnTo>
                  <a:lnTo>
                    <a:pt x="1293" y="1272"/>
                  </a:lnTo>
                  <a:lnTo>
                    <a:pt x="1302" y="1272"/>
                  </a:lnTo>
                  <a:lnTo>
                    <a:pt x="1313" y="1272"/>
                  </a:lnTo>
                  <a:lnTo>
                    <a:pt x="1325" y="1269"/>
                  </a:lnTo>
                  <a:lnTo>
                    <a:pt x="1336" y="1269"/>
                  </a:lnTo>
                  <a:lnTo>
                    <a:pt x="1345" y="1269"/>
                  </a:lnTo>
                  <a:lnTo>
                    <a:pt x="1356" y="1267"/>
                  </a:lnTo>
                  <a:lnTo>
                    <a:pt x="1367" y="1266"/>
                  </a:lnTo>
                  <a:lnTo>
                    <a:pt x="1377" y="1264"/>
                  </a:lnTo>
                  <a:lnTo>
                    <a:pt x="1388" y="1264"/>
                  </a:lnTo>
                  <a:lnTo>
                    <a:pt x="1399" y="1264"/>
                  </a:lnTo>
                  <a:lnTo>
                    <a:pt x="1410" y="1263"/>
                  </a:lnTo>
                  <a:lnTo>
                    <a:pt x="1420" y="1263"/>
                  </a:lnTo>
                  <a:lnTo>
                    <a:pt x="1431" y="1263"/>
                  </a:lnTo>
                  <a:lnTo>
                    <a:pt x="1442" y="1263"/>
                  </a:lnTo>
                  <a:lnTo>
                    <a:pt x="1453" y="1263"/>
                  </a:lnTo>
                  <a:lnTo>
                    <a:pt x="1463" y="1261"/>
                  </a:lnTo>
                  <a:lnTo>
                    <a:pt x="1474" y="1261"/>
                  </a:lnTo>
                  <a:lnTo>
                    <a:pt x="1485" y="1260"/>
                  </a:lnTo>
                  <a:lnTo>
                    <a:pt x="1495" y="1258"/>
                  </a:lnTo>
                  <a:lnTo>
                    <a:pt x="1506" y="1258"/>
                  </a:lnTo>
                  <a:lnTo>
                    <a:pt x="1517" y="1258"/>
                  </a:lnTo>
                  <a:lnTo>
                    <a:pt x="1528" y="1256"/>
                  </a:lnTo>
                  <a:lnTo>
                    <a:pt x="1537" y="1256"/>
                  </a:lnTo>
                  <a:lnTo>
                    <a:pt x="1549" y="1258"/>
                  </a:lnTo>
                  <a:lnTo>
                    <a:pt x="1560" y="1256"/>
                  </a:lnTo>
                  <a:lnTo>
                    <a:pt x="1569" y="1253"/>
                  </a:lnTo>
                  <a:lnTo>
                    <a:pt x="1580" y="1253"/>
                  </a:lnTo>
                  <a:lnTo>
                    <a:pt x="1591" y="1253"/>
                  </a:lnTo>
                  <a:lnTo>
                    <a:pt x="1603" y="1252"/>
                  </a:lnTo>
                  <a:lnTo>
                    <a:pt x="1612" y="1252"/>
                  </a:lnTo>
                  <a:lnTo>
                    <a:pt x="1623" y="1252"/>
                  </a:lnTo>
                  <a:lnTo>
                    <a:pt x="1634" y="1250"/>
                  </a:lnTo>
                  <a:lnTo>
                    <a:pt x="1645" y="1250"/>
                  </a:lnTo>
                  <a:lnTo>
                    <a:pt x="1655" y="1248"/>
                  </a:lnTo>
                  <a:lnTo>
                    <a:pt x="1666" y="1248"/>
                  </a:lnTo>
                  <a:lnTo>
                    <a:pt x="1677" y="1247"/>
                  </a:lnTo>
                  <a:lnTo>
                    <a:pt x="1687" y="1245"/>
                  </a:lnTo>
                  <a:lnTo>
                    <a:pt x="1698" y="1245"/>
                  </a:lnTo>
                  <a:lnTo>
                    <a:pt x="1709" y="1244"/>
                  </a:lnTo>
                  <a:lnTo>
                    <a:pt x="1720" y="1242"/>
                  </a:lnTo>
                  <a:lnTo>
                    <a:pt x="1730" y="1242"/>
                  </a:lnTo>
                  <a:lnTo>
                    <a:pt x="1741" y="1240"/>
                  </a:lnTo>
                  <a:lnTo>
                    <a:pt x="1752" y="1240"/>
                  </a:lnTo>
                  <a:lnTo>
                    <a:pt x="1763" y="1240"/>
                  </a:lnTo>
                  <a:lnTo>
                    <a:pt x="1773" y="1239"/>
                  </a:lnTo>
                  <a:lnTo>
                    <a:pt x="1784" y="1239"/>
                  </a:lnTo>
                  <a:lnTo>
                    <a:pt x="1795" y="1239"/>
                  </a:lnTo>
                  <a:lnTo>
                    <a:pt x="1804" y="1239"/>
                  </a:lnTo>
                  <a:lnTo>
                    <a:pt x="1815" y="1239"/>
                  </a:lnTo>
                  <a:lnTo>
                    <a:pt x="1827" y="1239"/>
                  </a:lnTo>
                  <a:lnTo>
                    <a:pt x="1838" y="1237"/>
                  </a:lnTo>
                  <a:lnTo>
                    <a:pt x="1847" y="1236"/>
                  </a:lnTo>
                  <a:lnTo>
                    <a:pt x="1858" y="1234"/>
                  </a:lnTo>
                  <a:lnTo>
                    <a:pt x="1869" y="1233"/>
                  </a:lnTo>
                  <a:lnTo>
                    <a:pt x="1879" y="1234"/>
                  </a:lnTo>
                  <a:lnTo>
                    <a:pt x="1890" y="1234"/>
                  </a:lnTo>
                  <a:lnTo>
                    <a:pt x="1901" y="1233"/>
                  </a:lnTo>
                  <a:lnTo>
                    <a:pt x="1912" y="1231"/>
                  </a:lnTo>
                  <a:lnTo>
                    <a:pt x="1922" y="1231"/>
                  </a:lnTo>
                  <a:lnTo>
                    <a:pt x="1933" y="1231"/>
                  </a:lnTo>
                  <a:lnTo>
                    <a:pt x="1944" y="1229"/>
                  </a:lnTo>
                  <a:lnTo>
                    <a:pt x="1955" y="1229"/>
                  </a:lnTo>
                  <a:lnTo>
                    <a:pt x="1965" y="1229"/>
                  </a:lnTo>
                  <a:lnTo>
                    <a:pt x="1976" y="1226"/>
                  </a:lnTo>
                  <a:lnTo>
                    <a:pt x="1987" y="1228"/>
                  </a:lnTo>
                  <a:lnTo>
                    <a:pt x="1997" y="1228"/>
                  </a:lnTo>
                  <a:lnTo>
                    <a:pt x="2008" y="1226"/>
                  </a:lnTo>
                  <a:lnTo>
                    <a:pt x="2019" y="1226"/>
                  </a:lnTo>
                  <a:lnTo>
                    <a:pt x="2030" y="1226"/>
                  </a:lnTo>
                  <a:lnTo>
                    <a:pt x="2039" y="1225"/>
                  </a:lnTo>
                  <a:lnTo>
                    <a:pt x="2051" y="1223"/>
                  </a:lnTo>
                  <a:lnTo>
                    <a:pt x="2062" y="1221"/>
                  </a:lnTo>
                  <a:lnTo>
                    <a:pt x="2073" y="1223"/>
                  </a:lnTo>
                  <a:lnTo>
                    <a:pt x="2082" y="1223"/>
                  </a:lnTo>
                  <a:lnTo>
                    <a:pt x="2093" y="1223"/>
                  </a:lnTo>
                  <a:lnTo>
                    <a:pt x="2105" y="1220"/>
                  </a:lnTo>
                  <a:lnTo>
                    <a:pt x="2114" y="1220"/>
                  </a:lnTo>
                  <a:lnTo>
                    <a:pt x="2125" y="1220"/>
                  </a:lnTo>
                  <a:lnTo>
                    <a:pt x="2136" y="1220"/>
                  </a:lnTo>
                  <a:lnTo>
                    <a:pt x="2147" y="1218"/>
                  </a:lnTo>
                  <a:lnTo>
                    <a:pt x="2157" y="1218"/>
                  </a:lnTo>
                  <a:lnTo>
                    <a:pt x="2168" y="1228"/>
                  </a:lnTo>
                  <a:lnTo>
                    <a:pt x="2179" y="1233"/>
                  </a:lnTo>
                  <a:lnTo>
                    <a:pt x="2190" y="1237"/>
                  </a:lnTo>
                  <a:lnTo>
                    <a:pt x="2200" y="1261"/>
                  </a:lnTo>
                  <a:lnTo>
                    <a:pt x="2211" y="1182"/>
                  </a:lnTo>
                  <a:lnTo>
                    <a:pt x="2222" y="1194"/>
                  </a:lnTo>
                  <a:lnTo>
                    <a:pt x="2232" y="1207"/>
                  </a:lnTo>
                  <a:lnTo>
                    <a:pt x="2243" y="1213"/>
                  </a:lnTo>
                  <a:lnTo>
                    <a:pt x="2254" y="1218"/>
                  </a:lnTo>
                  <a:lnTo>
                    <a:pt x="2265" y="1221"/>
                  </a:lnTo>
                  <a:lnTo>
                    <a:pt x="2275" y="1223"/>
                  </a:lnTo>
                  <a:lnTo>
                    <a:pt x="2286" y="1223"/>
                  </a:lnTo>
                  <a:lnTo>
                    <a:pt x="2297" y="1225"/>
                  </a:lnTo>
                  <a:lnTo>
                    <a:pt x="2306" y="1226"/>
                  </a:lnTo>
                  <a:lnTo>
                    <a:pt x="2317" y="1228"/>
                  </a:lnTo>
                  <a:lnTo>
                    <a:pt x="2329" y="1229"/>
                  </a:lnTo>
                  <a:lnTo>
                    <a:pt x="2340" y="1229"/>
                  </a:lnTo>
                  <a:lnTo>
                    <a:pt x="2349" y="1229"/>
                  </a:lnTo>
                  <a:lnTo>
                    <a:pt x="2360" y="1229"/>
                  </a:lnTo>
                  <a:lnTo>
                    <a:pt x="2371" y="1231"/>
                  </a:lnTo>
                  <a:lnTo>
                    <a:pt x="2383" y="1234"/>
                  </a:lnTo>
                  <a:lnTo>
                    <a:pt x="2392" y="1234"/>
                  </a:lnTo>
                  <a:lnTo>
                    <a:pt x="2403" y="1233"/>
                  </a:lnTo>
                  <a:lnTo>
                    <a:pt x="2414" y="1233"/>
                  </a:lnTo>
                  <a:lnTo>
                    <a:pt x="2424" y="1233"/>
                  </a:lnTo>
                  <a:lnTo>
                    <a:pt x="2435" y="1233"/>
                  </a:lnTo>
                  <a:lnTo>
                    <a:pt x="2446" y="1233"/>
                  </a:lnTo>
                  <a:lnTo>
                    <a:pt x="2457" y="1233"/>
                  </a:lnTo>
                  <a:lnTo>
                    <a:pt x="2467" y="1233"/>
                  </a:lnTo>
                  <a:lnTo>
                    <a:pt x="2478" y="1234"/>
                  </a:lnTo>
                  <a:lnTo>
                    <a:pt x="2489" y="1236"/>
                  </a:lnTo>
                  <a:lnTo>
                    <a:pt x="2500" y="1236"/>
                  </a:lnTo>
                  <a:lnTo>
                    <a:pt x="2510" y="1236"/>
                  </a:lnTo>
                  <a:lnTo>
                    <a:pt x="2521" y="1236"/>
                  </a:lnTo>
                  <a:lnTo>
                    <a:pt x="2532" y="1236"/>
                  </a:lnTo>
                  <a:lnTo>
                    <a:pt x="2541" y="1236"/>
                  </a:lnTo>
                  <a:lnTo>
                    <a:pt x="2553" y="1236"/>
                  </a:lnTo>
                  <a:lnTo>
                    <a:pt x="2564" y="1236"/>
                  </a:lnTo>
                  <a:lnTo>
                    <a:pt x="2575" y="1236"/>
                  </a:lnTo>
                  <a:lnTo>
                    <a:pt x="2584" y="1236"/>
                  </a:lnTo>
                  <a:lnTo>
                    <a:pt x="2595" y="1236"/>
                  </a:lnTo>
                  <a:lnTo>
                    <a:pt x="2607" y="1236"/>
                  </a:lnTo>
                  <a:lnTo>
                    <a:pt x="2616" y="1237"/>
                  </a:lnTo>
                  <a:lnTo>
                    <a:pt x="2627" y="1237"/>
                  </a:lnTo>
                  <a:lnTo>
                    <a:pt x="2638" y="1237"/>
                  </a:lnTo>
                  <a:lnTo>
                    <a:pt x="2650" y="1237"/>
                  </a:lnTo>
                  <a:lnTo>
                    <a:pt x="2659" y="1236"/>
                  </a:lnTo>
                  <a:lnTo>
                    <a:pt x="2670" y="1236"/>
                  </a:lnTo>
                  <a:lnTo>
                    <a:pt x="2681" y="1236"/>
                  </a:lnTo>
                  <a:lnTo>
                    <a:pt x="2692" y="1236"/>
                  </a:lnTo>
                  <a:lnTo>
                    <a:pt x="2702" y="1236"/>
                  </a:lnTo>
                  <a:lnTo>
                    <a:pt x="2713" y="1237"/>
                  </a:lnTo>
                  <a:lnTo>
                    <a:pt x="2724" y="1236"/>
                  </a:lnTo>
                  <a:lnTo>
                    <a:pt x="2734" y="1236"/>
                  </a:lnTo>
                  <a:lnTo>
                    <a:pt x="2745" y="1236"/>
                  </a:lnTo>
                  <a:lnTo>
                    <a:pt x="2756" y="1237"/>
                  </a:lnTo>
                  <a:lnTo>
                    <a:pt x="2767" y="1237"/>
                  </a:lnTo>
                  <a:lnTo>
                    <a:pt x="2777" y="1237"/>
                  </a:lnTo>
                  <a:lnTo>
                    <a:pt x="2788" y="1236"/>
                  </a:lnTo>
                  <a:lnTo>
                    <a:pt x="2799" y="1236"/>
                  </a:lnTo>
                  <a:lnTo>
                    <a:pt x="2810" y="1236"/>
                  </a:lnTo>
                  <a:lnTo>
                    <a:pt x="2820" y="1236"/>
                  </a:lnTo>
                  <a:lnTo>
                    <a:pt x="2831" y="1236"/>
                  </a:lnTo>
                  <a:lnTo>
                    <a:pt x="2842" y="1236"/>
                  </a:lnTo>
                  <a:lnTo>
                    <a:pt x="2851" y="1236"/>
                  </a:lnTo>
                  <a:lnTo>
                    <a:pt x="2862" y="1236"/>
                  </a:lnTo>
                  <a:lnTo>
                    <a:pt x="2874" y="1236"/>
                  </a:lnTo>
                  <a:lnTo>
                    <a:pt x="2885" y="1237"/>
                  </a:lnTo>
                  <a:lnTo>
                    <a:pt x="2894" y="1237"/>
                  </a:lnTo>
                  <a:lnTo>
                    <a:pt x="2905" y="1237"/>
                  </a:lnTo>
                  <a:lnTo>
                    <a:pt x="2916" y="1237"/>
                  </a:lnTo>
                  <a:lnTo>
                    <a:pt x="2926" y="1237"/>
                  </a:lnTo>
                  <a:lnTo>
                    <a:pt x="2937" y="1236"/>
                  </a:lnTo>
                  <a:lnTo>
                    <a:pt x="2948" y="1237"/>
                  </a:lnTo>
                  <a:lnTo>
                    <a:pt x="2959" y="1237"/>
                  </a:lnTo>
                  <a:lnTo>
                    <a:pt x="2969" y="1237"/>
                  </a:lnTo>
                  <a:lnTo>
                    <a:pt x="2980" y="1239"/>
                  </a:lnTo>
                  <a:lnTo>
                    <a:pt x="2991" y="1237"/>
                  </a:lnTo>
                  <a:lnTo>
                    <a:pt x="3002" y="1239"/>
                  </a:lnTo>
                  <a:lnTo>
                    <a:pt x="3012" y="1237"/>
                  </a:lnTo>
                  <a:lnTo>
                    <a:pt x="3023" y="1237"/>
                  </a:lnTo>
                  <a:lnTo>
                    <a:pt x="3034" y="1237"/>
                  </a:lnTo>
                  <a:lnTo>
                    <a:pt x="3044" y="1237"/>
                  </a:lnTo>
                  <a:lnTo>
                    <a:pt x="3055" y="1237"/>
                  </a:lnTo>
                  <a:lnTo>
                    <a:pt x="3066" y="1237"/>
                  </a:lnTo>
                  <a:lnTo>
                    <a:pt x="3077" y="1236"/>
                  </a:lnTo>
                  <a:lnTo>
                    <a:pt x="3086" y="1237"/>
                  </a:lnTo>
                  <a:lnTo>
                    <a:pt x="3098" y="1236"/>
                  </a:lnTo>
                  <a:lnTo>
                    <a:pt x="3109" y="1236"/>
                  </a:lnTo>
                  <a:lnTo>
                    <a:pt x="3120" y="1237"/>
                  </a:lnTo>
                  <a:lnTo>
                    <a:pt x="3129" y="1237"/>
                  </a:lnTo>
                  <a:lnTo>
                    <a:pt x="3140" y="1236"/>
                  </a:lnTo>
                  <a:lnTo>
                    <a:pt x="3152" y="1237"/>
                  </a:lnTo>
                  <a:lnTo>
                    <a:pt x="3161" y="1239"/>
                  </a:lnTo>
                  <a:lnTo>
                    <a:pt x="3172" y="1236"/>
                  </a:lnTo>
                  <a:lnTo>
                    <a:pt x="3183" y="1237"/>
                  </a:lnTo>
                  <a:lnTo>
                    <a:pt x="3194" y="1239"/>
                  </a:lnTo>
                  <a:lnTo>
                    <a:pt x="3204" y="1239"/>
                  </a:lnTo>
                  <a:lnTo>
                    <a:pt x="3215" y="1237"/>
                  </a:lnTo>
                  <a:lnTo>
                    <a:pt x="3226" y="1237"/>
                  </a:lnTo>
                  <a:lnTo>
                    <a:pt x="3236" y="1237"/>
                  </a:lnTo>
                  <a:lnTo>
                    <a:pt x="3247" y="1237"/>
                  </a:lnTo>
                  <a:lnTo>
                    <a:pt x="3258" y="1237"/>
                  </a:lnTo>
                  <a:lnTo>
                    <a:pt x="3269" y="1237"/>
                  </a:lnTo>
                  <a:lnTo>
                    <a:pt x="3279" y="1237"/>
                  </a:lnTo>
                  <a:lnTo>
                    <a:pt x="3290" y="1239"/>
                  </a:lnTo>
                  <a:lnTo>
                    <a:pt x="3301" y="1237"/>
                  </a:lnTo>
                  <a:lnTo>
                    <a:pt x="3312" y="1239"/>
                  </a:lnTo>
                  <a:lnTo>
                    <a:pt x="3322" y="1239"/>
                  </a:lnTo>
                  <a:lnTo>
                    <a:pt x="3333" y="1239"/>
                  </a:lnTo>
                  <a:lnTo>
                    <a:pt x="3344" y="1239"/>
                  </a:lnTo>
                  <a:lnTo>
                    <a:pt x="3353" y="1239"/>
                  </a:lnTo>
                  <a:lnTo>
                    <a:pt x="3364" y="1239"/>
                  </a:lnTo>
                  <a:lnTo>
                    <a:pt x="3376" y="1239"/>
                  </a:lnTo>
                  <a:lnTo>
                    <a:pt x="3387" y="1239"/>
                  </a:lnTo>
                  <a:lnTo>
                    <a:pt x="3396" y="1239"/>
                  </a:lnTo>
                  <a:lnTo>
                    <a:pt x="3407" y="1240"/>
                  </a:lnTo>
                  <a:lnTo>
                    <a:pt x="3418" y="1240"/>
                  </a:lnTo>
                  <a:lnTo>
                    <a:pt x="3430" y="1240"/>
                  </a:lnTo>
                  <a:lnTo>
                    <a:pt x="3439" y="1240"/>
                  </a:lnTo>
                  <a:lnTo>
                    <a:pt x="3450" y="1239"/>
                  </a:lnTo>
                  <a:lnTo>
                    <a:pt x="3461" y="1240"/>
                  </a:lnTo>
                  <a:lnTo>
                    <a:pt x="3471" y="1240"/>
                  </a:lnTo>
                  <a:lnTo>
                    <a:pt x="3482" y="1242"/>
                  </a:lnTo>
                  <a:lnTo>
                    <a:pt x="3493" y="1240"/>
                  </a:lnTo>
                  <a:lnTo>
                    <a:pt x="3504" y="1240"/>
                  </a:lnTo>
                  <a:lnTo>
                    <a:pt x="3514" y="1240"/>
                  </a:lnTo>
                  <a:lnTo>
                    <a:pt x="3525" y="1240"/>
                  </a:lnTo>
                  <a:lnTo>
                    <a:pt x="3536" y="1242"/>
                  </a:lnTo>
                  <a:lnTo>
                    <a:pt x="3547" y="1240"/>
                  </a:lnTo>
                  <a:lnTo>
                    <a:pt x="3557" y="1242"/>
                  </a:lnTo>
                  <a:lnTo>
                    <a:pt x="3568" y="1240"/>
                  </a:lnTo>
                  <a:lnTo>
                    <a:pt x="3579" y="1240"/>
                  </a:lnTo>
                  <a:lnTo>
                    <a:pt x="3588" y="1240"/>
                  </a:lnTo>
                  <a:lnTo>
                    <a:pt x="3600" y="1242"/>
                  </a:lnTo>
                  <a:lnTo>
                    <a:pt x="3611" y="1242"/>
                  </a:lnTo>
                  <a:lnTo>
                    <a:pt x="3622" y="1240"/>
                  </a:lnTo>
                  <a:lnTo>
                    <a:pt x="3631" y="1242"/>
                  </a:lnTo>
                  <a:lnTo>
                    <a:pt x="3642" y="1239"/>
                  </a:lnTo>
                  <a:lnTo>
                    <a:pt x="3654" y="1236"/>
                  </a:lnTo>
                  <a:lnTo>
                    <a:pt x="3663" y="1239"/>
                  </a:lnTo>
                  <a:lnTo>
                    <a:pt x="3674" y="1242"/>
                  </a:lnTo>
                  <a:lnTo>
                    <a:pt x="3685" y="1242"/>
                  </a:lnTo>
                  <a:lnTo>
                    <a:pt x="3696" y="1240"/>
                  </a:lnTo>
                  <a:lnTo>
                    <a:pt x="3706" y="1240"/>
                  </a:lnTo>
                  <a:lnTo>
                    <a:pt x="3717" y="1240"/>
                  </a:lnTo>
                  <a:lnTo>
                    <a:pt x="3728" y="1239"/>
                  </a:lnTo>
                  <a:lnTo>
                    <a:pt x="3739" y="1240"/>
                  </a:lnTo>
                  <a:lnTo>
                    <a:pt x="3749" y="1240"/>
                  </a:lnTo>
                  <a:lnTo>
                    <a:pt x="3760" y="1240"/>
                  </a:lnTo>
                  <a:lnTo>
                    <a:pt x="3771" y="1240"/>
                  </a:lnTo>
                  <a:lnTo>
                    <a:pt x="3781" y="1240"/>
                  </a:lnTo>
                  <a:lnTo>
                    <a:pt x="3792" y="1242"/>
                  </a:lnTo>
                  <a:lnTo>
                    <a:pt x="3803" y="1245"/>
                  </a:lnTo>
                  <a:lnTo>
                    <a:pt x="3814" y="1240"/>
                  </a:lnTo>
                  <a:lnTo>
                    <a:pt x="3824" y="1244"/>
                  </a:lnTo>
                  <a:lnTo>
                    <a:pt x="3835" y="1253"/>
                  </a:lnTo>
                  <a:lnTo>
                    <a:pt x="3846" y="1250"/>
                  </a:lnTo>
                  <a:lnTo>
                    <a:pt x="3857" y="1242"/>
                  </a:lnTo>
                  <a:lnTo>
                    <a:pt x="3866" y="1242"/>
                  </a:lnTo>
                  <a:lnTo>
                    <a:pt x="3878" y="1245"/>
                  </a:lnTo>
                  <a:lnTo>
                    <a:pt x="3889" y="1253"/>
                  </a:lnTo>
                  <a:lnTo>
                    <a:pt x="3898" y="1245"/>
                  </a:lnTo>
                  <a:lnTo>
                    <a:pt x="3909" y="1234"/>
                  </a:lnTo>
                  <a:lnTo>
                    <a:pt x="3920" y="1237"/>
                  </a:lnTo>
                  <a:lnTo>
                    <a:pt x="3932" y="1239"/>
                  </a:lnTo>
                  <a:lnTo>
                    <a:pt x="3941" y="1240"/>
                  </a:lnTo>
                  <a:lnTo>
                    <a:pt x="3952" y="1240"/>
                  </a:lnTo>
                  <a:lnTo>
                    <a:pt x="3963" y="1242"/>
                  </a:lnTo>
                  <a:lnTo>
                    <a:pt x="3973" y="1239"/>
                  </a:lnTo>
                  <a:lnTo>
                    <a:pt x="3984" y="1228"/>
                  </a:lnTo>
                  <a:lnTo>
                    <a:pt x="3995" y="1233"/>
                  </a:lnTo>
                  <a:lnTo>
                    <a:pt x="4006" y="1245"/>
                  </a:lnTo>
                  <a:lnTo>
                    <a:pt x="4016" y="1252"/>
                  </a:lnTo>
                  <a:lnTo>
                    <a:pt x="4027" y="1255"/>
                  </a:lnTo>
                  <a:lnTo>
                    <a:pt x="4038" y="1245"/>
                  </a:lnTo>
                  <a:lnTo>
                    <a:pt x="4049" y="1242"/>
                  </a:lnTo>
                  <a:lnTo>
                    <a:pt x="4059" y="1242"/>
                  </a:lnTo>
                  <a:lnTo>
                    <a:pt x="4070" y="1242"/>
                  </a:lnTo>
                  <a:lnTo>
                    <a:pt x="4081" y="1240"/>
                  </a:lnTo>
                  <a:lnTo>
                    <a:pt x="4090" y="1242"/>
                  </a:lnTo>
                  <a:lnTo>
                    <a:pt x="4102" y="1242"/>
                  </a:lnTo>
                  <a:lnTo>
                    <a:pt x="4113" y="1242"/>
                  </a:lnTo>
                </a:path>
              </a:pathLst>
            </a:custGeom>
            <a:noFill/>
            <a:ln w="0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2" name="Freeform 102"/>
            <p:cNvSpPr>
              <a:spLocks/>
            </p:cNvSpPr>
            <p:nvPr/>
          </p:nvSpPr>
          <p:spPr bwMode="auto">
            <a:xfrm>
              <a:off x="774" y="1804"/>
              <a:ext cx="4113" cy="1345"/>
            </a:xfrm>
            <a:custGeom>
              <a:avLst/>
              <a:gdLst>
                <a:gd name="T0" fmla="*/ 63 w 4113"/>
                <a:gd name="T1" fmla="*/ 1032 h 1345"/>
                <a:gd name="T2" fmla="*/ 138 w 4113"/>
                <a:gd name="T3" fmla="*/ 1032 h 1345"/>
                <a:gd name="T4" fmla="*/ 213 w 4113"/>
                <a:gd name="T5" fmla="*/ 1032 h 1345"/>
                <a:gd name="T6" fmla="*/ 287 w 4113"/>
                <a:gd name="T7" fmla="*/ 0 h 1345"/>
                <a:gd name="T8" fmla="*/ 362 w 4113"/>
                <a:gd name="T9" fmla="*/ 1040 h 1345"/>
                <a:gd name="T10" fmla="*/ 437 w 4113"/>
                <a:gd name="T11" fmla="*/ 1019 h 1345"/>
                <a:gd name="T12" fmla="*/ 511 w 4113"/>
                <a:gd name="T13" fmla="*/ 1015 h 1345"/>
                <a:gd name="T14" fmla="*/ 587 w 4113"/>
                <a:gd name="T15" fmla="*/ 1007 h 1345"/>
                <a:gd name="T16" fmla="*/ 662 w 4113"/>
                <a:gd name="T17" fmla="*/ 1005 h 1345"/>
                <a:gd name="T18" fmla="*/ 737 w 4113"/>
                <a:gd name="T19" fmla="*/ 1002 h 1345"/>
                <a:gd name="T20" fmla="*/ 811 w 4113"/>
                <a:gd name="T21" fmla="*/ 997 h 1345"/>
                <a:gd name="T22" fmla="*/ 886 w 4113"/>
                <a:gd name="T23" fmla="*/ 994 h 1345"/>
                <a:gd name="T24" fmla="*/ 961 w 4113"/>
                <a:gd name="T25" fmla="*/ 991 h 1345"/>
                <a:gd name="T26" fmla="*/ 1035 w 4113"/>
                <a:gd name="T27" fmla="*/ 989 h 1345"/>
                <a:gd name="T28" fmla="*/ 1110 w 4113"/>
                <a:gd name="T29" fmla="*/ 984 h 1345"/>
                <a:gd name="T30" fmla="*/ 1185 w 4113"/>
                <a:gd name="T31" fmla="*/ 981 h 1345"/>
                <a:gd name="T32" fmla="*/ 1260 w 4113"/>
                <a:gd name="T33" fmla="*/ 980 h 1345"/>
                <a:gd name="T34" fmla="*/ 1334 w 4113"/>
                <a:gd name="T35" fmla="*/ 977 h 1345"/>
                <a:gd name="T36" fmla="*/ 1409 w 4113"/>
                <a:gd name="T37" fmla="*/ 972 h 1345"/>
                <a:gd name="T38" fmla="*/ 1484 w 4113"/>
                <a:gd name="T39" fmla="*/ 969 h 1345"/>
                <a:gd name="T40" fmla="*/ 1558 w 4113"/>
                <a:gd name="T41" fmla="*/ 967 h 1345"/>
                <a:gd name="T42" fmla="*/ 1634 w 4113"/>
                <a:gd name="T43" fmla="*/ 965 h 1345"/>
                <a:gd name="T44" fmla="*/ 1709 w 4113"/>
                <a:gd name="T45" fmla="*/ 964 h 1345"/>
                <a:gd name="T46" fmla="*/ 1784 w 4113"/>
                <a:gd name="T47" fmla="*/ 961 h 1345"/>
                <a:gd name="T48" fmla="*/ 1858 w 4113"/>
                <a:gd name="T49" fmla="*/ 959 h 1345"/>
                <a:gd name="T50" fmla="*/ 1933 w 4113"/>
                <a:gd name="T51" fmla="*/ 956 h 1345"/>
                <a:gd name="T52" fmla="*/ 2008 w 4113"/>
                <a:gd name="T53" fmla="*/ 954 h 1345"/>
                <a:gd name="T54" fmla="*/ 2082 w 4113"/>
                <a:gd name="T55" fmla="*/ 951 h 1345"/>
                <a:gd name="T56" fmla="*/ 2157 w 4113"/>
                <a:gd name="T57" fmla="*/ 951 h 1345"/>
                <a:gd name="T58" fmla="*/ 2232 w 4113"/>
                <a:gd name="T59" fmla="*/ 938 h 1345"/>
                <a:gd name="T60" fmla="*/ 2306 w 4113"/>
                <a:gd name="T61" fmla="*/ 956 h 1345"/>
                <a:gd name="T62" fmla="*/ 2381 w 4113"/>
                <a:gd name="T63" fmla="*/ 959 h 1345"/>
                <a:gd name="T64" fmla="*/ 2456 w 4113"/>
                <a:gd name="T65" fmla="*/ 962 h 1345"/>
                <a:gd name="T66" fmla="*/ 2530 w 4113"/>
                <a:gd name="T67" fmla="*/ 962 h 1345"/>
                <a:gd name="T68" fmla="*/ 2605 w 4113"/>
                <a:gd name="T69" fmla="*/ 961 h 1345"/>
                <a:gd name="T70" fmla="*/ 2681 w 4113"/>
                <a:gd name="T71" fmla="*/ 964 h 1345"/>
                <a:gd name="T72" fmla="*/ 2756 w 4113"/>
                <a:gd name="T73" fmla="*/ 962 h 1345"/>
                <a:gd name="T74" fmla="*/ 2831 w 4113"/>
                <a:gd name="T75" fmla="*/ 964 h 1345"/>
                <a:gd name="T76" fmla="*/ 2905 w 4113"/>
                <a:gd name="T77" fmla="*/ 962 h 1345"/>
                <a:gd name="T78" fmla="*/ 2980 w 4113"/>
                <a:gd name="T79" fmla="*/ 962 h 1345"/>
                <a:gd name="T80" fmla="*/ 3055 w 4113"/>
                <a:gd name="T81" fmla="*/ 962 h 1345"/>
                <a:gd name="T82" fmla="*/ 3129 w 4113"/>
                <a:gd name="T83" fmla="*/ 962 h 1345"/>
                <a:gd name="T84" fmla="*/ 3204 w 4113"/>
                <a:gd name="T85" fmla="*/ 964 h 1345"/>
                <a:gd name="T86" fmla="*/ 3279 w 4113"/>
                <a:gd name="T87" fmla="*/ 962 h 1345"/>
                <a:gd name="T88" fmla="*/ 3353 w 4113"/>
                <a:gd name="T89" fmla="*/ 964 h 1345"/>
                <a:gd name="T90" fmla="*/ 3428 w 4113"/>
                <a:gd name="T91" fmla="*/ 961 h 1345"/>
                <a:gd name="T92" fmla="*/ 3503 w 4113"/>
                <a:gd name="T93" fmla="*/ 961 h 1345"/>
                <a:gd name="T94" fmla="*/ 3577 w 4113"/>
                <a:gd name="T95" fmla="*/ 961 h 1345"/>
                <a:gd name="T96" fmla="*/ 3652 w 4113"/>
                <a:gd name="T97" fmla="*/ 959 h 1345"/>
                <a:gd name="T98" fmla="*/ 3728 w 4113"/>
                <a:gd name="T99" fmla="*/ 961 h 1345"/>
                <a:gd name="T100" fmla="*/ 3803 w 4113"/>
                <a:gd name="T101" fmla="*/ 961 h 1345"/>
                <a:gd name="T102" fmla="*/ 3878 w 4113"/>
                <a:gd name="T103" fmla="*/ 965 h 1345"/>
                <a:gd name="T104" fmla="*/ 3952 w 4113"/>
                <a:gd name="T105" fmla="*/ 957 h 1345"/>
                <a:gd name="T106" fmla="*/ 4027 w 4113"/>
                <a:gd name="T107" fmla="*/ 970 h 1345"/>
                <a:gd name="T108" fmla="*/ 4102 w 4113"/>
                <a:gd name="T109" fmla="*/ 956 h 13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113" h="1345">
                  <a:moveTo>
                    <a:pt x="0" y="1034"/>
                  </a:moveTo>
                  <a:lnTo>
                    <a:pt x="9" y="1034"/>
                  </a:lnTo>
                  <a:lnTo>
                    <a:pt x="20" y="1034"/>
                  </a:lnTo>
                  <a:lnTo>
                    <a:pt x="31" y="1035"/>
                  </a:lnTo>
                  <a:lnTo>
                    <a:pt x="43" y="1034"/>
                  </a:lnTo>
                  <a:lnTo>
                    <a:pt x="52" y="1034"/>
                  </a:lnTo>
                  <a:lnTo>
                    <a:pt x="63" y="1032"/>
                  </a:lnTo>
                  <a:lnTo>
                    <a:pt x="74" y="1032"/>
                  </a:lnTo>
                  <a:lnTo>
                    <a:pt x="85" y="1034"/>
                  </a:lnTo>
                  <a:lnTo>
                    <a:pt x="95" y="1032"/>
                  </a:lnTo>
                  <a:lnTo>
                    <a:pt x="106" y="1032"/>
                  </a:lnTo>
                  <a:lnTo>
                    <a:pt x="117" y="1032"/>
                  </a:lnTo>
                  <a:lnTo>
                    <a:pt x="127" y="1031"/>
                  </a:lnTo>
                  <a:lnTo>
                    <a:pt x="138" y="1032"/>
                  </a:lnTo>
                  <a:lnTo>
                    <a:pt x="149" y="1032"/>
                  </a:lnTo>
                  <a:lnTo>
                    <a:pt x="160" y="1031"/>
                  </a:lnTo>
                  <a:lnTo>
                    <a:pt x="170" y="1031"/>
                  </a:lnTo>
                  <a:lnTo>
                    <a:pt x="181" y="1031"/>
                  </a:lnTo>
                  <a:lnTo>
                    <a:pt x="192" y="1031"/>
                  </a:lnTo>
                  <a:lnTo>
                    <a:pt x="201" y="1031"/>
                  </a:lnTo>
                  <a:lnTo>
                    <a:pt x="213" y="1032"/>
                  </a:lnTo>
                  <a:lnTo>
                    <a:pt x="224" y="1032"/>
                  </a:lnTo>
                  <a:lnTo>
                    <a:pt x="235" y="1027"/>
                  </a:lnTo>
                  <a:lnTo>
                    <a:pt x="244" y="1018"/>
                  </a:lnTo>
                  <a:lnTo>
                    <a:pt x="255" y="1026"/>
                  </a:lnTo>
                  <a:lnTo>
                    <a:pt x="267" y="1034"/>
                  </a:lnTo>
                  <a:lnTo>
                    <a:pt x="278" y="759"/>
                  </a:lnTo>
                  <a:lnTo>
                    <a:pt x="287" y="0"/>
                  </a:lnTo>
                  <a:lnTo>
                    <a:pt x="298" y="988"/>
                  </a:lnTo>
                  <a:lnTo>
                    <a:pt x="309" y="1345"/>
                  </a:lnTo>
                  <a:lnTo>
                    <a:pt x="319" y="1239"/>
                  </a:lnTo>
                  <a:lnTo>
                    <a:pt x="330" y="1134"/>
                  </a:lnTo>
                  <a:lnTo>
                    <a:pt x="341" y="1078"/>
                  </a:lnTo>
                  <a:lnTo>
                    <a:pt x="352" y="1054"/>
                  </a:lnTo>
                  <a:lnTo>
                    <a:pt x="362" y="1040"/>
                  </a:lnTo>
                  <a:lnTo>
                    <a:pt x="373" y="1032"/>
                  </a:lnTo>
                  <a:lnTo>
                    <a:pt x="384" y="1029"/>
                  </a:lnTo>
                  <a:lnTo>
                    <a:pt x="395" y="1026"/>
                  </a:lnTo>
                  <a:lnTo>
                    <a:pt x="405" y="1024"/>
                  </a:lnTo>
                  <a:lnTo>
                    <a:pt x="416" y="1021"/>
                  </a:lnTo>
                  <a:lnTo>
                    <a:pt x="427" y="1021"/>
                  </a:lnTo>
                  <a:lnTo>
                    <a:pt x="437" y="1019"/>
                  </a:lnTo>
                  <a:lnTo>
                    <a:pt x="448" y="1019"/>
                  </a:lnTo>
                  <a:lnTo>
                    <a:pt x="459" y="1018"/>
                  </a:lnTo>
                  <a:lnTo>
                    <a:pt x="470" y="1016"/>
                  </a:lnTo>
                  <a:lnTo>
                    <a:pt x="479" y="1016"/>
                  </a:lnTo>
                  <a:lnTo>
                    <a:pt x="491" y="1018"/>
                  </a:lnTo>
                  <a:lnTo>
                    <a:pt x="502" y="1016"/>
                  </a:lnTo>
                  <a:lnTo>
                    <a:pt x="511" y="1015"/>
                  </a:lnTo>
                  <a:lnTo>
                    <a:pt x="522" y="1015"/>
                  </a:lnTo>
                  <a:lnTo>
                    <a:pt x="533" y="1013"/>
                  </a:lnTo>
                  <a:lnTo>
                    <a:pt x="545" y="1011"/>
                  </a:lnTo>
                  <a:lnTo>
                    <a:pt x="554" y="1010"/>
                  </a:lnTo>
                  <a:lnTo>
                    <a:pt x="565" y="1010"/>
                  </a:lnTo>
                  <a:lnTo>
                    <a:pt x="576" y="1010"/>
                  </a:lnTo>
                  <a:lnTo>
                    <a:pt x="587" y="1007"/>
                  </a:lnTo>
                  <a:lnTo>
                    <a:pt x="597" y="1007"/>
                  </a:lnTo>
                  <a:lnTo>
                    <a:pt x="608" y="1008"/>
                  </a:lnTo>
                  <a:lnTo>
                    <a:pt x="619" y="1008"/>
                  </a:lnTo>
                  <a:lnTo>
                    <a:pt x="629" y="1008"/>
                  </a:lnTo>
                  <a:lnTo>
                    <a:pt x="640" y="1007"/>
                  </a:lnTo>
                  <a:lnTo>
                    <a:pt x="651" y="1005"/>
                  </a:lnTo>
                  <a:lnTo>
                    <a:pt x="662" y="1005"/>
                  </a:lnTo>
                  <a:lnTo>
                    <a:pt x="672" y="1005"/>
                  </a:lnTo>
                  <a:lnTo>
                    <a:pt x="683" y="1002"/>
                  </a:lnTo>
                  <a:lnTo>
                    <a:pt x="694" y="1004"/>
                  </a:lnTo>
                  <a:lnTo>
                    <a:pt x="705" y="1004"/>
                  </a:lnTo>
                  <a:lnTo>
                    <a:pt x="715" y="1002"/>
                  </a:lnTo>
                  <a:lnTo>
                    <a:pt x="726" y="1002"/>
                  </a:lnTo>
                  <a:lnTo>
                    <a:pt x="737" y="1002"/>
                  </a:lnTo>
                  <a:lnTo>
                    <a:pt x="746" y="1000"/>
                  </a:lnTo>
                  <a:lnTo>
                    <a:pt x="757" y="1000"/>
                  </a:lnTo>
                  <a:lnTo>
                    <a:pt x="769" y="999"/>
                  </a:lnTo>
                  <a:lnTo>
                    <a:pt x="780" y="999"/>
                  </a:lnTo>
                  <a:lnTo>
                    <a:pt x="789" y="999"/>
                  </a:lnTo>
                  <a:lnTo>
                    <a:pt x="800" y="997"/>
                  </a:lnTo>
                  <a:lnTo>
                    <a:pt x="811" y="997"/>
                  </a:lnTo>
                  <a:lnTo>
                    <a:pt x="821" y="997"/>
                  </a:lnTo>
                  <a:lnTo>
                    <a:pt x="832" y="996"/>
                  </a:lnTo>
                  <a:lnTo>
                    <a:pt x="843" y="994"/>
                  </a:lnTo>
                  <a:lnTo>
                    <a:pt x="854" y="996"/>
                  </a:lnTo>
                  <a:lnTo>
                    <a:pt x="864" y="994"/>
                  </a:lnTo>
                  <a:lnTo>
                    <a:pt x="875" y="994"/>
                  </a:lnTo>
                  <a:lnTo>
                    <a:pt x="886" y="994"/>
                  </a:lnTo>
                  <a:lnTo>
                    <a:pt x="897" y="994"/>
                  </a:lnTo>
                  <a:lnTo>
                    <a:pt x="907" y="994"/>
                  </a:lnTo>
                  <a:lnTo>
                    <a:pt x="918" y="992"/>
                  </a:lnTo>
                  <a:lnTo>
                    <a:pt x="929" y="991"/>
                  </a:lnTo>
                  <a:lnTo>
                    <a:pt x="939" y="989"/>
                  </a:lnTo>
                  <a:lnTo>
                    <a:pt x="950" y="991"/>
                  </a:lnTo>
                  <a:lnTo>
                    <a:pt x="961" y="991"/>
                  </a:lnTo>
                  <a:lnTo>
                    <a:pt x="972" y="991"/>
                  </a:lnTo>
                  <a:lnTo>
                    <a:pt x="981" y="989"/>
                  </a:lnTo>
                  <a:lnTo>
                    <a:pt x="993" y="989"/>
                  </a:lnTo>
                  <a:lnTo>
                    <a:pt x="1004" y="988"/>
                  </a:lnTo>
                  <a:lnTo>
                    <a:pt x="1015" y="988"/>
                  </a:lnTo>
                  <a:lnTo>
                    <a:pt x="1024" y="988"/>
                  </a:lnTo>
                  <a:lnTo>
                    <a:pt x="1035" y="989"/>
                  </a:lnTo>
                  <a:lnTo>
                    <a:pt x="1047" y="988"/>
                  </a:lnTo>
                  <a:lnTo>
                    <a:pt x="1056" y="986"/>
                  </a:lnTo>
                  <a:lnTo>
                    <a:pt x="1067" y="984"/>
                  </a:lnTo>
                  <a:lnTo>
                    <a:pt x="1078" y="983"/>
                  </a:lnTo>
                  <a:lnTo>
                    <a:pt x="1090" y="984"/>
                  </a:lnTo>
                  <a:lnTo>
                    <a:pt x="1099" y="984"/>
                  </a:lnTo>
                  <a:lnTo>
                    <a:pt x="1110" y="984"/>
                  </a:lnTo>
                  <a:lnTo>
                    <a:pt x="1121" y="984"/>
                  </a:lnTo>
                  <a:lnTo>
                    <a:pt x="1132" y="983"/>
                  </a:lnTo>
                  <a:lnTo>
                    <a:pt x="1142" y="981"/>
                  </a:lnTo>
                  <a:lnTo>
                    <a:pt x="1153" y="983"/>
                  </a:lnTo>
                  <a:lnTo>
                    <a:pt x="1164" y="983"/>
                  </a:lnTo>
                  <a:lnTo>
                    <a:pt x="1174" y="983"/>
                  </a:lnTo>
                  <a:lnTo>
                    <a:pt x="1185" y="981"/>
                  </a:lnTo>
                  <a:lnTo>
                    <a:pt x="1196" y="981"/>
                  </a:lnTo>
                  <a:lnTo>
                    <a:pt x="1207" y="983"/>
                  </a:lnTo>
                  <a:lnTo>
                    <a:pt x="1217" y="981"/>
                  </a:lnTo>
                  <a:lnTo>
                    <a:pt x="1228" y="981"/>
                  </a:lnTo>
                  <a:lnTo>
                    <a:pt x="1239" y="980"/>
                  </a:lnTo>
                  <a:lnTo>
                    <a:pt x="1248" y="980"/>
                  </a:lnTo>
                  <a:lnTo>
                    <a:pt x="1260" y="980"/>
                  </a:lnTo>
                  <a:lnTo>
                    <a:pt x="1271" y="978"/>
                  </a:lnTo>
                  <a:lnTo>
                    <a:pt x="1282" y="977"/>
                  </a:lnTo>
                  <a:lnTo>
                    <a:pt x="1291" y="977"/>
                  </a:lnTo>
                  <a:lnTo>
                    <a:pt x="1302" y="977"/>
                  </a:lnTo>
                  <a:lnTo>
                    <a:pt x="1314" y="977"/>
                  </a:lnTo>
                  <a:lnTo>
                    <a:pt x="1325" y="977"/>
                  </a:lnTo>
                  <a:lnTo>
                    <a:pt x="1334" y="977"/>
                  </a:lnTo>
                  <a:lnTo>
                    <a:pt x="1345" y="975"/>
                  </a:lnTo>
                  <a:lnTo>
                    <a:pt x="1356" y="975"/>
                  </a:lnTo>
                  <a:lnTo>
                    <a:pt x="1366" y="973"/>
                  </a:lnTo>
                  <a:lnTo>
                    <a:pt x="1377" y="973"/>
                  </a:lnTo>
                  <a:lnTo>
                    <a:pt x="1388" y="973"/>
                  </a:lnTo>
                  <a:lnTo>
                    <a:pt x="1399" y="973"/>
                  </a:lnTo>
                  <a:lnTo>
                    <a:pt x="1409" y="972"/>
                  </a:lnTo>
                  <a:lnTo>
                    <a:pt x="1420" y="972"/>
                  </a:lnTo>
                  <a:lnTo>
                    <a:pt x="1431" y="972"/>
                  </a:lnTo>
                  <a:lnTo>
                    <a:pt x="1442" y="972"/>
                  </a:lnTo>
                  <a:lnTo>
                    <a:pt x="1452" y="972"/>
                  </a:lnTo>
                  <a:lnTo>
                    <a:pt x="1463" y="972"/>
                  </a:lnTo>
                  <a:lnTo>
                    <a:pt x="1474" y="970"/>
                  </a:lnTo>
                  <a:lnTo>
                    <a:pt x="1484" y="969"/>
                  </a:lnTo>
                  <a:lnTo>
                    <a:pt x="1495" y="972"/>
                  </a:lnTo>
                  <a:lnTo>
                    <a:pt x="1506" y="969"/>
                  </a:lnTo>
                  <a:lnTo>
                    <a:pt x="1517" y="969"/>
                  </a:lnTo>
                  <a:lnTo>
                    <a:pt x="1526" y="969"/>
                  </a:lnTo>
                  <a:lnTo>
                    <a:pt x="1538" y="970"/>
                  </a:lnTo>
                  <a:lnTo>
                    <a:pt x="1549" y="969"/>
                  </a:lnTo>
                  <a:lnTo>
                    <a:pt x="1558" y="967"/>
                  </a:lnTo>
                  <a:lnTo>
                    <a:pt x="1569" y="965"/>
                  </a:lnTo>
                  <a:lnTo>
                    <a:pt x="1580" y="967"/>
                  </a:lnTo>
                  <a:lnTo>
                    <a:pt x="1592" y="967"/>
                  </a:lnTo>
                  <a:lnTo>
                    <a:pt x="1601" y="965"/>
                  </a:lnTo>
                  <a:lnTo>
                    <a:pt x="1612" y="965"/>
                  </a:lnTo>
                  <a:lnTo>
                    <a:pt x="1623" y="965"/>
                  </a:lnTo>
                  <a:lnTo>
                    <a:pt x="1634" y="965"/>
                  </a:lnTo>
                  <a:lnTo>
                    <a:pt x="1644" y="965"/>
                  </a:lnTo>
                  <a:lnTo>
                    <a:pt x="1655" y="965"/>
                  </a:lnTo>
                  <a:lnTo>
                    <a:pt x="1666" y="965"/>
                  </a:lnTo>
                  <a:lnTo>
                    <a:pt x="1676" y="964"/>
                  </a:lnTo>
                  <a:lnTo>
                    <a:pt x="1687" y="964"/>
                  </a:lnTo>
                  <a:lnTo>
                    <a:pt x="1698" y="965"/>
                  </a:lnTo>
                  <a:lnTo>
                    <a:pt x="1709" y="964"/>
                  </a:lnTo>
                  <a:lnTo>
                    <a:pt x="1719" y="962"/>
                  </a:lnTo>
                  <a:lnTo>
                    <a:pt x="1730" y="962"/>
                  </a:lnTo>
                  <a:lnTo>
                    <a:pt x="1741" y="962"/>
                  </a:lnTo>
                  <a:lnTo>
                    <a:pt x="1752" y="962"/>
                  </a:lnTo>
                  <a:lnTo>
                    <a:pt x="1762" y="962"/>
                  </a:lnTo>
                  <a:lnTo>
                    <a:pt x="1773" y="961"/>
                  </a:lnTo>
                  <a:lnTo>
                    <a:pt x="1784" y="961"/>
                  </a:lnTo>
                  <a:lnTo>
                    <a:pt x="1793" y="961"/>
                  </a:lnTo>
                  <a:lnTo>
                    <a:pt x="1804" y="959"/>
                  </a:lnTo>
                  <a:lnTo>
                    <a:pt x="1816" y="961"/>
                  </a:lnTo>
                  <a:lnTo>
                    <a:pt x="1827" y="959"/>
                  </a:lnTo>
                  <a:lnTo>
                    <a:pt x="1836" y="959"/>
                  </a:lnTo>
                  <a:lnTo>
                    <a:pt x="1847" y="959"/>
                  </a:lnTo>
                  <a:lnTo>
                    <a:pt x="1858" y="959"/>
                  </a:lnTo>
                  <a:lnTo>
                    <a:pt x="1868" y="957"/>
                  </a:lnTo>
                  <a:lnTo>
                    <a:pt x="1879" y="957"/>
                  </a:lnTo>
                  <a:lnTo>
                    <a:pt x="1890" y="957"/>
                  </a:lnTo>
                  <a:lnTo>
                    <a:pt x="1901" y="957"/>
                  </a:lnTo>
                  <a:lnTo>
                    <a:pt x="1911" y="956"/>
                  </a:lnTo>
                  <a:lnTo>
                    <a:pt x="1922" y="957"/>
                  </a:lnTo>
                  <a:lnTo>
                    <a:pt x="1933" y="956"/>
                  </a:lnTo>
                  <a:lnTo>
                    <a:pt x="1944" y="956"/>
                  </a:lnTo>
                  <a:lnTo>
                    <a:pt x="1954" y="956"/>
                  </a:lnTo>
                  <a:lnTo>
                    <a:pt x="1965" y="956"/>
                  </a:lnTo>
                  <a:lnTo>
                    <a:pt x="1976" y="956"/>
                  </a:lnTo>
                  <a:lnTo>
                    <a:pt x="1986" y="956"/>
                  </a:lnTo>
                  <a:lnTo>
                    <a:pt x="1997" y="954"/>
                  </a:lnTo>
                  <a:lnTo>
                    <a:pt x="2008" y="954"/>
                  </a:lnTo>
                  <a:lnTo>
                    <a:pt x="2019" y="954"/>
                  </a:lnTo>
                  <a:lnTo>
                    <a:pt x="2028" y="953"/>
                  </a:lnTo>
                  <a:lnTo>
                    <a:pt x="2040" y="954"/>
                  </a:lnTo>
                  <a:lnTo>
                    <a:pt x="2051" y="953"/>
                  </a:lnTo>
                  <a:lnTo>
                    <a:pt x="2062" y="953"/>
                  </a:lnTo>
                  <a:lnTo>
                    <a:pt x="2071" y="951"/>
                  </a:lnTo>
                  <a:lnTo>
                    <a:pt x="2082" y="951"/>
                  </a:lnTo>
                  <a:lnTo>
                    <a:pt x="2094" y="953"/>
                  </a:lnTo>
                  <a:lnTo>
                    <a:pt x="2103" y="951"/>
                  </a:lnTo>
                  <a:lnTo>
                    <a:pt x="2114" y="951"/>
                  </a:lnTo>
                  <a:lnTo>
                    <a:pt x="2125" y="951"/>
                  </a:lnTo>
                  <a:lnTo>
                    <a:pt x="2136" y="950"/>
                  </a:lnTo>
                  <a:lnTo>
                    <a:pt x="2146" y="950"/>
                  </a:lnTo>
                  <a:lnTo>
                    <a:pt x="2157" y="951"/>
                  </a:lnTo>
                  <a:lnTo>
                    <a:pt x="2168" y="964"/>
                  </a:lnTo>
                  <a:lnTo>
                    <a:pt x="2179" y="962"/>
                  </a:lnTo>
                  <a:lnTo>
                    <a:pt x="2189" y="978"/>
                  </a:lnTo>
                  <a:lnTo>
                    <a:pt x="2200" y="942"/>
                  </a:lnTo>
                  <a:lnTo>
                    <a:pt x="2211" y="913"/>
                  </a:lnTo>
                  <a:lnTo>
                    <a:pt x="2221" y="929"/>
                  </a:lnTo>
                  <a:lnTo>
                    <a:pt x="2232" y="938"/>
                  </a:lnTo>
                  <a:lnTo>
                    <a:pt x="2243" y="945"/>
                  </a:lnTo>
                  <a:lnTo>
                    <a:pt x="2254" y="950"/>
                  </a:lnTo>
                  <a:lnTo>
                    <a:pt x="2264" y="950"/>
                  </a:lnTo>
                  <a:lnTo>
                    <a:pt x="2275" y="953"/>
                  </a:lnTo>
                  <a:lnTo>
                    <a:pt x="2286" y="953"/>
                  </a:lnTo>
                  <a:lnTo>
                    <a:pt x="2295" y="954"/>
                  </a:lnTo>
                  <a:lnTo>
                    <a:pt x="2306" y="956"/>
                  </a:lnTo>
                  <a:lnTo>
                    <a:pt x="2318" y="957"/>
                  </a:lnTo>
                  <a:lnTo>
                    <a:pt x="2329" y="959"/>
                  </a:lnTo>
                  <a:lnTo>
                    <a:pt x="2338" y="957"/>
                  </a:lnTo>
                  <a:lnTo>
                    <a:pt x="2349" y="957"/>
                  </a:lnTo>
                  <a:lnTo>
                    <a:pt x="2360" y="957"/>
                  </a:lnTo>
                  <a:lnTo>
                    <a:pt x="2372" y="959"/>
                  </a:lnTo>
                  <a:lnTo>
                    <a:pt x="2381" y="959"/>
                  </a:lnTo>
                  <a:lnTo>
                    <a:pt x="2392" y="961"/>
                  </a:lnTo>
                  <a:lnTo>
                    <a:pt x="2403" y="962"/>
                  </a:lnTo>
                  <a:lnTo>
                    <a:pt x="2413" y="961"/>
                  </a:lnTo>
                  <a:lnTo>
                    <a:pt x="2424" y="962"/>
                  </a:lnTo>
                  <a:lnTo>
                    <a:pt x="2435" y="962"/>
                  </a:lnTo>
                  <a:lnTo>
                    <a:pt x="2446" y="962"/>
                  </a:lnTo>
                  <a:lnTo>
                    <a:pt x="2456" y="962"/>
                  </a:lnTo>
                  <a:lnTo>
                    <a:pt x="2467" y="962"/>
                  </a:lnTo>
                  <a:lnTo>
                    <a:pt x="2478" y="962"/>
                  </a:lnTo>
                  <a:lnTo>
                    <a:pt x="2489" y="962"/>
                  </a:lnTo>
                  <a:lnTo>
                    <a:pt x="2499" y="962"/>
                  </a:lnTo>
                  <a:lnTo>
                    <a:pt x="2510" y="962"/>
                  </a:lnTo>
                  <a:lnTo>
                    <a:pt x="2521" y="964"/>
                  </a:lnTo>
                  <a:lnTo>
                    <a:pt x="2530" y="962"/>
                  </a:lnTo>
                  <a:lnTo>
                    <a:pt x="2542" y="961"/>
                  </a:lnTo>
                  <a:lnTo>
                    <a:pt x="2553" y="962"/>
                  </a:lnTo>
                  <a:lnTo>
                    <a:pt x="2564" y="962"/>
                  </a:lnTo>
                  <a:lnTo>
                    <a:pt x="2573" y="961"/>
                  </a:lnTo>
                  <a:lnTo>
                    <a:pt x="2584" y="962"/>
                  </a:lnTo>
                  <a:lnTo>
                    <a:pt x="2596" y="961"/>
                  </a:lnTo>
                  <a:lnTo>
                    <a:pt x="2605" y="961"/>
                  </a:lnTo>
                  <a:lnTo>
                    <a:pt x="2616" y="962"/>
                  </a:lnTo>
                  <a:lnTo>
                    <a:pt x="2627" y="962"/>
                  </a:lnTo>
                  <a:lnTo>
                    <a:pt x="2639" y="961"/>
                  </a:lnTo>
                  <a:lnTo>
                    <a:pt x="2648" y="961"/>
                  </a:lnTo>
                  <a:lnTo>
                    <a:pt x="2659" y="962"/>
                  </a:lnTo>
                  <a:lnTo>
                    <a:pt x="2670" y="962"/>
                  </a:lnTo>
                  <a:lnTo>
                    <a:pt x="2681" y="964"/>
                  </a:lnTo>
                  <a:lnTo>
                    <a:pt x="2691" y="964"/>
                  </a:lnTo>
                  <a:lnTo>
                    <a:pt x="2702" y="964"/>
                  </a:lnTo>
                  <a:lnTo>
                    <a:pt x="2713" y="962"/>
                  </a:lnTo>
                  <a:lnTo>
                    <a:pt x="2723" y="964"/>
                  </a:lnTo>
                  <a:lnTo>
                    <a:pt x="2734" y="962"/>
                  </a:lnTo>
                  <a:lnTo>
                    <a:pt x="2745" y="962"/>
                  </a:lnTo>
                  <a:lnTo>
                    <a:pt x="2756" y="962"/>
                  </a:lnTo>
                  <a:lnTo>
                    <a:pt x="2766" y="962"/>
                  </a:lnTo>
                  <a:lnTo>
                    <a:pt x="2777" y="962"/>
                  </a:lnTo>
                  <a:lnTo>
                    <a:pt x="2788" y="965"/>
                  </a:lnTo>
                  <a:lnTo>
                    <a:pt x="2799" y="964"/>
                  </a:lnTo>
                  <a:lnTo>
                    <a:pt x="2809" y="962"/>
                  </a:lnTo>
                  <a:lnTo>
                    <a:pt x="2820" y="962"/>
                  </a:lnTo>
                  <a:lnTo>
                    <a:pt x="2831" y="964"/>
                  </a:lnTo>
                  <a:lnTo>
                    <a:pt x="2840" y="962"/>
                  </a:lnTo>
                  <a:lnTo>
                    <a:pt x="2851" y="962"/>
                  </a:lnTo>
                  <a:lnTo>
                    <a:pt x="2863" y="964"/>
                  </a:lnTo>
                  <a:lnTo>
                    <a:pt x="2874" y="962"/>
                  </a:lnTo>
                  <a:lnTo>
                    <a:pt x="2883" y="962"/>
                  </a:lnTo>
                  <a:lnTo>
                    <a:pt x="2894" y="964"/>
                  </a:lnTo>
                  <a:lnTo>
                    <a:pt x="2905" y="962"/>
                  </a:lnTo>
                  <a:lnTo>
                    <a:pt x="2915" y="962"/>
                  </a:lnTo>
                  <a:lnTo>
                    <a:pt x="2926" y="961"/>
                  </a:lnTo>
                  <a:lnTo>
                    <a:pt x="2937" y="962"/>
                  </a:lnTo>
                  <a:lnTo>
                    <a:pt x="2948" y="962"/>
                  </a:lnTo>
                  <a:lnTo>
                    <a:pt x="2958" y="964"/>
                  </a:lnTo>
                  <a:lnTo>
                    <a:pt x="2969" y="964"/>
                  </a:lnTo>
                  <a:lnTo>
                    <a:pt x="2980" y="962"/>
                  </a:lnTo>
                  <a:lnTo>
                    <a:pt x="2991" y="964"/>
                  </a:lnTo>
                  <a:lnTo>
                    <a:pt x="3001" y="962"/>
                  </a:lnTo>
                  <a:lnTo>
                    <a:pt x="3012" y="962"/>
                  </a:lnTo>
                  <a:lnTo>
                    <a:pt x="3023" y="964"/>
                  </a:lnTo>
                  <a:lnTo>
                    <a:pt x="3033" y="962"/>
                  </a:lnTo>
                  <a:lnTo>
                    <a:pt x="3044" y="962"/>
                  </a:lnTo>
                  <a:lnTo>
                    <a:pt x="3055" y="962"/>
                  </a:lnTo>
                  <a:lnTo>
                    <a:pt x="3066" y="962"/>
                  </a:lnTo>
                  <a:lnTo>
                    <a:pt x="3075" y="961"/>
                  </a:lnTo>
                  <a:lnTo>
                    <a:pt x="3087" y="962"/>
                  </a:lnTo>
                  <a:lnTo>
                    <a:pt x="3098" y="962"/>
                  </a:lnTo>
                  <a:lnTo>
                    <a:pt x="3109" y="961"/>
                  </a:lnTo>
                  <a:lnTo>
                    <a:pt x="3118" y="962"/>
                  </a:lnTo>
                  <a:lnTo>
                    <a:pt x="3129" y="962"/>
                  </a:lnTo>
                  <a:lnTo>
                    <a:pt x="3141" y="962"/>
                  </a:lnTo>
                  <a:lnTo>
                    <a:pt x="3150" y="964"/>
                  </a:lnTo>
                  <a:lnTo>
                    <a:pt x="3161" y="964"/>
                  </a:lnTo>
                  <a:lnTo>
                    <a:pt x="3172" y="962"/>
                  </a:lnTo>
                  <a:lnTo>
                    <a:pt x="3183" y="964"/>
                  </a:lnTo>
                  <a:lnTo>
                    <a:pt x="3193" y="964"/>
                  </a:lnTo>
                  <a:lnTo>
                    <a:pt x="3204" y="964"/>
                  </a:lnTo>
                  <a:lnTo>
                    <a:pt x="3215" y="964"/>
                  </a:lnTo>
                  <a:lnTo>
                    <a:pt x="3225" y="964"/>
                  </a:lnTo>
                  <a:lnTo>
                    <a:pt x="3236" y="962"/>
                  </a:lnTo>
                  <a:lnTo>
                    <a:pt x="3247" y="962"/>
                  </a:lnTo>
                  <a:lnTo>
                    <a:pt x="3258" y="964"/>
                  </a:lnTo>
                  <a:lnTo>
                    <a:pt x="3268" y="964"/>
                  </a:lnTo>
                  <a:lnTo>
                    <a:pt x="3279" y="962"/>
                  </a:lnTo>
                  <a:lnTo>
                    <a:pt x="3290" y="964"/>
                  </a:lnTo>
                  <a:lnTo>
                    <a:pt x="3301" y="965"/>
                  </a:lnTo>
                  <a:lnTo>
                    <a:pt x="3311" y="962"/>
                  </a:lnTo>
                  <a:lnTo>
                    <a:pt x="3322" y="962"/>
                  </a:lnTo>
                  <a:lnTo>
                    <a:pt x="3333" y="962"/>
                  </a:lnTo>
                  <a:lnTo>
                    <a:pt x="3342" y="964"/>
                  </a:lnTo>
                  <a:lnTo>
                    <a:pt x="3353" y="964"/>
                  </a:lnTo>
                  <a:lnTo>
                    <a:pt x="3365" y="961"/>
                  </a:lnTo>
                  <a:lnTo>
                    <a:pt x="3376" y="961"/>
                  </a:lnTo>
                  <a:lnTo>
                    <a:pt x="3385" y="962"/>
                  </a:lnTo>
                  <a:lnTo>
                    <a:pt x="3396" y="962"/>
                  </a:lnTo>
                  <a:lnTo>
                    <a:pt x="3407" y="962"/>
                  </a:lnTo>
                  <a:lnTo>
                    <a:pt x="3419" y="962"/>
                  </a:lnTo>
                  <a:lnTo>
                    <a:pt x="3428" y="961"/>
                  </a:lnTo>
                  <a:lnTo>
                    <a:pt x="3439" y="961"/>
                  </a:lnTo>
                  <a:lnTo>
                    <a:pt x="3450" y="961"/>
                  </a:lnTo>
                  <a:lnTo>
                    <a:pt x="3460" y="961"/>
                  </a:lnTo>
                  <a:lnTo>
                    <a:pt x="3471" y="961"/>
                  </a:lnTo>
                  <a:lnTo>
                    <a:pt x="3482" y="961"/>
                  </a:lnTo>
                  <a:lnTo>
                    <a:pt x="3493" y="962"/>
                  </a:lnTo>
                  <a:lnTo>
                    <a:pt x="3503" y="961"/>
                  </a:lnTo>
                  <a:lnTo>
                    <a:pt x="3514" y="961"/>
                  </a:lnTo>
                  <a:lnTo>
                    <a:pt x="3525" y="962"/>
                  </a:lnTo>
                  <a:lnTo>
                    <a:pt x="3536" y="962"/>
                  </a:lnTo>
                  <a:lnTo>
                    <a:pt x="3546" y="962"/>
                  </a:lnTo>
                  <a:lnTo>
                    <a:pt x="3557" y="962"/>
                  </a:lnTo>
                  <a:lnTo>
                    <a:pt x="3568" y="962"/>
                  </a:lnTo>
                  <a:lnTo>
                    <a:pt x="3577" y="961"/>
                  </a:lnTo>
                  <a:lnTo>
                    <a:pt x="3589" y="961"/>
                  </a:lnTo>
                  <a:lnTo>
                    <a:pt x="3600" y="962"/>
                  </a:lnTo>
                  <a:lnTo>
                    <a:pt x="3611" y="959"/>
                  </a:lnTo>
                  <a:lnTo>
                    <a:pt x="3620" y="962"/>
                  </a:lnTo>
                  <a:lnTo>
                    <a:pt x="3631" y="962"/>
                  </a:lnTo>
                  <a:lnTo>
                    <a:pt x="3643" y="961"/>
                  </a:lnTo>
                  <a:lnTo>
                    <a:pt x="3652" y="959"/>
                  </a:lnTo>
                  <a:lnTo>
                    <a:pt x="3663" y="961"/>
                  </a:lnTo>
                  <a:lnTo>
                    <a:pt x="3674" y="964"/>
                  </a:lnTo>
                  <a:lnTo>
                    <a:pt x="3685" y="962"/>
                  </a:lnTo>
                  <a:lnTo>
                    <a:pt x="3695" y="961"/>
                  </a:lnTo>
                  <a:lnTo>
                    <a:pt x="3706" y="961"/>
                  </a:lnTo>
                  <a:lnTo>
                    <a:pt x="3717" y="961"/>
                  </a:lnTo>
                  <a:lnTo>
                    <a:pt x="3728" y="961"/>
                  </a:lnTo>
                  <a:lnTo>
                    <a:pt x="3738" y="961"/>
                  </a:lnTo>
                  <a:lnTo>
                    <a:pt x="3749" y="961"/>
                  </a:lnTo>
                  <a:lnTo>
                    <a:pt x="3760" y="959"/>
                  </a:lnTo>
                  <a:lnTo>
                    <a:pt x="3770" y="959"/>
                  </a:lnTo>
                  <a:lnTo>
                    <a:pt x="3781" y="959"/>
                  </a:lnTo>
                  <a:lnTo>
                    <a:pt x="3792" y="961"/>
                  </a:lnTo>
                  <a:lnTo>
                    <a:pt x="3803" y="961"/>
                  </a:lnTo>
                  <a:lnTo>
                    <a:pt x="3813" y="959"/>
                  </a:lnTo>
                  <a:lnTo>
                    <a:pt x="3824" y="965"/>
                  </a:lnTo>
                  <a:lnTo>
                    <a:pt x="3835" y="970"/>
                  </a:lnTo>
                  <a:lnTo>
                    <a:pt x="3846" y="964"/>
                  </a:lnTo>
                  <a:lnTo>
                    <a:pt x="3855" y="961"/>
                  </a:lnTo>
                  <a:lnTo>
                    <a:pt x="3867" y="959"/>
                  </a:lnTo>
                  <a:lnTo>
                    <a:pt x="3878" y="965"/>
                  </a:lnTo>
                  <a:lnTo>
                    <a:pt x="3887" y="967"/>
                  </a:lnTo>
                  <a:lnTo>
                    <a:pt x="3898" y="956"/>
                  </a:lnTo>
                  <a:lnTo>
                    <a:pt x="3909" y="953"/>
                  </a:lnTo>
                  <a:lnTo>
                    <a:pt x="3921" y="956"/>
                  </a:lnTo>
                  <a:lnTo>
                    <a:pt x="3930" y="959"/>
                  </a:lnTo>
                  <a:lnTo>
                    <a:pt x="3941" y="959"/>
                  </a:lnTo>
                  <a:lnTo>
                    <a:pt x="3952" y="957"/>
                  </a:lnTo>
                  <a:lnTo>
                    <a:pt x="3962" y="959"/>
                  </a:lnTo>
                  <a:lnTo>
                    <a:pt x="3973" y="954"/>
                  </a:lnTo>
                  <a:lnTo>
                    <a:pt x="3984" y="948"/>
                  </a:lnTo>
                  <a:lnTo>
                    <a:pt x="3995" y="950"/>
                  </a:lnTo>
                  <a:lnTo>
                    <a:pt x="4005" y="957"/>
                  </a:lnTo>
                  <a:lnTo>
                    <a:pt x="4016" y="964"/>
                  </a:lnTo>
                  <a:lnTo>
                    <a:pt x="4027" y="970"/>
                  </a:lnTo>
                  <a:lnTo>
                    <a:pt x="4038" y="962"/>
                  </a:lnTo>
                  <a:lnTo>
                    <a:pt x="4048" y="957"/>
                  </a:lnTo>
                  <a:lnTo>
                    <a:pt x="4059" y="959"/>
                  </a:lnTo>
                  <a:lnTo>
                    <a:pt x="4070" y="957"/>
                  </a:lnTo>
                  <a:lnTo>
                    <a:pt x="4079" y="957"/>
                  </a:lnTo>
                  <a:lnTo>
                    <a:pt x="4091" y="957"/>
                  </a:lnTo>
                  <a:lnTo>
                    <a:pt x="4102" y="956"/>
                  </a:lnTo>
                  <a:lnTo>
                    <a:pt x="4113" y="957"/>
                  </a:lnTo>
                </a:path>
              </a:pathLst>
            </a:custGeom>
            <a:noFill/>
            <a:ln w="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3" name="Freeform 103"/>
            <p:cNvSpPr>
              <a:spLocks/>
            </p:cNvSpPr>
            <p:nvPr/>
          </p:nvSpPr>
          <p:spPr bwMode="auto">
            <a:xfrm>
              <a:off x="788" y="1724"/>
              <a:ext cx="4107" cy="1112"/>
            </a:xfrm>
            <a:custGeom>
              <a:avLst/>
              <a:gdLst>
                <a:gd name="T0" fmla="*/ 64 w 4107"/>
                <a:gd name="T1" fmla="*/ 1112 h 1112"/>
                <a:gd name="T2" fmla="*/ 135 w 4107"/>
                <a:gd name="T3" fmla="*/ 1112 h 1112"/>
                <a:gd name="T4" fmla="*/ 206 w 4107"/>
                <a:gd name="T5" fmla="*/ 1112 h 1112"/>
                <a:gd name="T6" fmla="*/ 278 w 4107"/>
                <a:gd name="T7" fmla="*/ 1112 h 1112"/>
                <a:gd name="T8" fmla="*/ 349 w 4107"/>
                <a:gd name="T9" fmla="*/ 899 h 1112"/>
                <a:gd name="T10" fmla="*/ 419 w 4107"/>
                <a:gd name="T11" fmla="*/ 844 h 1112"/>
                <a:gd name="T12" fmla="*/ 492 w 4107"/>
                <a:gd name="T13" fmla="*/ 790 h 1112"/>
                <a:gd name="T14" fmla="*/ 562 w 4107"/>
                <a:gd name="T15" fmla="*/ 737 h 1112"/>
                <a:gd name="T16" fmla="*/ 635 w 4107"/>
                <a:gd name="T17" fmla="*/ 688 h 1112"/>
                <a:gd name="T18" fmla="*/ 705 w 4107"/>
                <a:gd name="T19" fmla="*/ 640 h 1112"/>
                <a:gd name="T20" fmla="*/ 777 w 4107"/>
                <a:gd name="T21" fmla="*/ 594 h 1112"/>
                <a:gd name="T22" fmla="*/ 848 w 4107"/>
                <a:gd name="T23" fmla="*/ 550 h 1112"/>
                <a:gd name="T24" fmla="*/ 921 w 4107"/>
                <a:gd name="T25" fmla="*/ 509 h 1112"/>
                <a:gd name="T26" fmla="*/ 993 w 4107"/>
                <a:gd name="T27" fmla="*/ 467 h 1112"/>
                <a:gd name="T28" fmla="*/ 1064 w 4107"/>
                <a:gd name="T29" fmla="*/ 428 h 1112"/>
                <a:gd name="T30" fmla="*/ 1134 w 4107"/>
                <a:gd name="T31" fmla="*/ 391 h 1112"/>
                <a:gd name="T32" fmla="*/ 1207 w 4107"/>
                <a:gd name="T33" fmla="*/ 355 h 1112"/>
                <a:gd name="T34" fmla="*/ 1277 w 4107"/>
                <a:gd name="T35" fmla="*/ 320 h 1112"/>
                <a:gd name="T36" fmla="*/ 1350 w 4107"/>
                <a:gd name="T37" fmla="*/ 286 h 1112"/>
                <a:gd name="T38" fmla="*/ 1422 w 4107"/>
                <a:gd name="T39" fmla="*/ 254 h 1112"/>
                <a:gd name="T40" fmla="*/ 1492 w 4107"/>
                <a:gd name="T41" fmla="*/ 224 h 1112"/>
                <a:gd name="T42" fmla="*/ 1565 w 4107"/>
                <a:gd name="T43" fmla="*/ 194 h 1112"/>
                <a:gd name="T44" fmla="*/ 1635 w 4107"/>
                <a:gd name="T45" fmla="*/ 167 h 1112"/>
                <a:gd name="T46" fmla="*/ 1708 w 4107"/>
                <a:gd name="T47" fmla="*/ 140 h 1112"/>
                <a:gd name="T48" fmla="*/ 1779 w 4107"/>
                <a:gd name="T49" fmla="*/ 113 h 1112"/>
                <a:gd name="T50" fmla="*/ 1851 w 4107"/>
                <a:gd name="T51" fmla="*/ 88 h 1112"/>
                <a:gd name="T52" fmla="*/ 1921 w 4107"/>
                <a:gd name="T53" fmla="*/ 64 h 1112"/>
                <a:gd name="T54" fmla="*/ 1992 w 4107"/>
                <a:gd name="T55" fmla="*/ 42 h 1112"/>
                <a:gd name="T56" fmla="*/ 2065 w 4107"/>
                <a:gd name="T57" fmla="*/ 19 h 1112"/>
                <a:gd name="T58" fmla="*/ 2137 w 4107"/>
                <a:gd name="T59" fmla="*/ 167 h 1112"/>
                <a:gd name="T60" fmla="*/ 2208 w 4107"/>
                <a:gd name="T61" fmla="*/ 172 h 1112"/>
                <a:gd name="T62" fmla="*/ 2278 w 4107"/>
                <a:gd name="T63" fmla="*/ 177 h 1112"/>
                <a:gd name="T64" fmla="*/ 2350 w 4107"/>
                <a:gd name="T65" fmla="*/ 181 h 1112"/>
                <a:gd name="T66" fmla="*/ 2423 w 4107"/>
                <a:gd name="T67" fmla="*/ 186 h 1112"/>
                <a:gd name="T68" fmla="*/ 2494 w 4107"/>
                <a:gd name="T69" fmla="*/ 189 h 1112"/>
                <a:gd name="T70" fmla="*/ 2566 w 4107"/>
                <a:gd name="T71" fmla="*/ 194 h 1112"/>
                <a:gd name="T72" fmla="*/ 2636 w 4107"/>
                <a:gd name="T73" fmla="*/ 199 h 1112"/>
                <a:gd name="T74" fmla="*/ 2707 w 4107"/>
                <a:gd name="T75" fmla="*/ 204 h 1112"/>
                <a:gd name="T76" fmla="*/ 2780 w 4107"/>
                <a:gd name="T77" fmla="*/ 207 h 1112"/>
                <a:gd name="T78" fmla="*/ 2852 w 4107"/>
                <a:gd name="T79" fmla="*/ 212 h 1112"/>
                <a:gd name="T80" fmla="*/ 2923 w 4107"/>
                <a:gd name="T81" fmla="*/ 216 h 1112"/>
                <a:gd name="T82" fmla="*/ 2993 w 4107"/>
                <a:gd name="T83" fmla="*/ 220 h 1112"/>
                <a:gd name="T84" fmla="*/ 3066 w 4107"/>
                <a:gd name="T85" fmla="*/ 224 h 1112"/>
                <a:gd name="T86" fmla="*/ 3138 w 4107"/>
                <a:gd name="T87" fmla="*/ 229 h 1112"/>
                <a:gd name="T88" fmla="*/ 3208 w 4107"/>
                <a:gd name="T89" fmla="*/ 232 h 1112"/>
                <a:gd name="T90" fmla="*/ 3281 w 4107"/>
                <a:gd name="T91" fmla="*/ 237 h 1112"/>
                <a:gd name="T92" fmla="*/ 3351 w 4107"/>
                <a:gd name="T93" fmla="*/ 240 h 1112"/>
                <a:gd name="T94" fmla="*/ 3424 w 4107"/>
                <a:gd name="T95" fmla="*/ 245 h 1112"/>
                <a:gd name="T96" fmla="*/ 3495 w 4107"/>
                <a:gd name="T97" fmla="*/ 250 h 1112"/>
                <a:gd name="T98" fmla="*/ 3565 w 4107"/>
                <a:gd name="T99" fmla="*/ 253 h 1112"/>
                <a:gd name="T100" fmla="*/ 3638 w 4107"/>
                <a:gd name="T101" fmla="*/ 258 h 1112"/>
                <a:gd name="T102" fmla="*/ 3708 w 4107"/>
                <a:gd name="T103" fmla="*/ 261 h 1112"/>
                <a:gd name="T104" fmla="*/ 3781 w 4107"/>
                <a:gd name="T105" fmla="*/ 266 h 1112"/>
                <a:gd name="T106" fmla="*/ 3853 w 4107"/>
                <a:gd name="T107" fmla="*/ 269 h 1112"/>
                <a:gd name="T108" fmla="*/ 3922 w 4107"/>
                <a:gd name="T109" fmla="*/ 274 h 1112"/>
                <a:gd name="T110" fmla="*/ 3996 w 4107"/>
                <a:gd name="T111" fmla="*/ 277 h 1112"/>
                <a:gd name="T112" fmla="*/ 4065 w 4107"/>
                <a:gd name="T113" fmla="*/ 281 h 1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107" h="1112">
                  <a:moveTo>
                    <a:pt x="0" y="1112"/>
                  </a:moveTo>
                  <a:lnTo>
                    <a:pt x="6" y="1112"/>
                  </a:lnTo>
                  <a:lnTo>
                    <a:pt x="16" y="1112"/>
                  </a:lnTo>
                  <a:lnTo>
                    <a:pt x="22" y="1112"/>
                  </a:lnTo>
                  <a:lnTo>
                    <a:pt x="32" y="1112"/>
                  </a:lnTo>
                  <a:lnTo>
                    <a:pt x="38" y="1112"/>
                  </a:lnTo>
                  <a:lnTo>
                    <a:pt x="48" y="1112"/>
                  </a:lnTo>
                  <a:lnTo>
                    <a:pt x="54" y="1112"/>
                  </a:lnTo>
                  <a:lnTo>
                    <a:pt x="64" y="1112"/>
                  </a:lnTo>
                  <a:lnTo>
                    <a:pt x="70" y="1112"/>
                  </a:lnTo>
                  <a:lnTo>
                    <a:pt x="79" y="1112"/>
                  </a:lnTo>
                  <a:lnTo>
                    <a:pt x="86" y="1112"/>
                  </a:lnTo>
                  <a:lnTo>
                    <a:pt x="95" y="1112"/>
                  </a:lnTo>
                  <a:lnTo>
                    <a:pt x="102" y="1112"/>
                  </a:lnTo>
                  <a:lnTo>
                    <a:pt x="110" y="1112"/>
                  </a:lnTo>
                  <a:lnTo>
                    <a:pt x="119" y="1112"/>
                  </a:lnTo>
                  <a:lnTo>
                    <a:pt x="127" y="1112"/>
                  </a:lnTo>
                  <a:lnTo>
                    <a:pt x="135" y="1112"/>
                  </a:lnTo>
                  <a:lnTo>
                    <a:pt x="143" y="1112"/>
                  </a:lnTo>
                  <a:lnTo>
                    <a:pt x="151" y="1112"/>
                  </a:lnTo>
                  <a:lnTo>
                    <a:pt x="159" y="1112"/>
                  </a:lnTo>
                  <a:lnTo>
                    <a:pt x="167" y="1112"/>
                  </a:lnTo>
                  <a:lnTo>
                    <a:pt x="175" y="1112"/>
                  </a:lnTo>
                  <a:lnTo>
                    <a:pt x="183" y="1112"/>
                  </a:lnTo>
                  <a:lnTo>
                    <a:pt x="191" y="1112"/>
                  </a:lnTo>
                  <a:lnTo>
                    <a:pt x="199" y="1112"/>
                  </a:lnTo>
                  <a:lnTo>
                    <a:pt x="206" y="1112"/>
                  </a:lnTo>
                  <a:lnTo>
                    <a:pt x="213" y="1112"/>
                  </a:lnTo>
                  <a:lnTo>
                    <a:pt x="221" y="1112"/>
                  </a:lnTo>
                  <a:lnTo>
                    <a:pt x="229" y="1112"/>
                  </a:lnTo>
                  <a:lnTo>
                    <a:pt x="237" y="1112"/>
                  </a:lnTo>
                  <a:lnTo>
                    <a:pt x="245" y="1112"/>
                  </a:lnTo>
                  <a:lnTo>
                    <a:pt x="253" y="1112"/>
                  </a:lnTo>
                  <a:lnTo>
                    <a:pt x="261" y="1112"/>
                  </a:lnTo>
                  <a:lnTo>
                    <a:pt x="268" y="1112"/>
                  </a:lnTo>
                  <a:lnTo>
                    <a:pt x="278" y="1112"/>
                  </a:lnTo>
                  <a:lnTo>
                    <a:pt x="286" y="1112"/>
                  </a:lnTo>
                  <a:lnTo>
                    <a:pt x="294" y="1112"/>
                  </a:lnTo>
                  <a:lnTo>
                    <a:pt x="302" y="937"/>
                  </a:lnTo>
                  <a:lnTo>
                    <a:pt x="308" y="931"/>
                  </a:lnTo>
                  <a:lnTo>
                    <a:pt x="318" y="925"/>
                  </a:lnTo>
                  <a:lnTo>
                    <a:pt x="324" y="918"/>
                  </a:lnTo>
                  <a:lnTo>
                    <a:pt x="332" y="912"/>
                  </a:lnTo>
                  <a:lnTo>
                    <a:pt x="342" y="906"/>
                  </a:lnTo>
                  <a:lnTo>
                    <a:pt x="349" y="899"/>
                  </a:lnTo>
                  <a:lnTo>
                    <a:pt x="357" y="893"/>
                  </a:lnTo>
                  <a:lnTo>
                    <a:pt x="364" y="887"/>
                  </a:lnTo>
                  <a:lnTo>
                    <a:pt x="372" y="880"/>
                  </a:lnTo>
                  <a:lnTo>
                    <a:pt x="380" y="874"/>
                  </a:lnTo>
                  <a:lnTo>
                    <a:pt x="388" y="868"/>
                  </a:lnTo>
                  <a:lnTo>
                    <a:pt x="396" y="861"/>
                  </a:lnTo>
                  <a:lnTo>
                    <a:pt x="403" y="856"/>
                  </a:lnTo>
                  <a:lnTo>
                    <a:pt x="411" y="850"/>
                  </a:lnTo>
                  <a:lnTo>
                    <a:pt x="419" y="844"/>
                  </a:lnTo>
                  <a:lnTo>
                    <a:pt x="427" y="837"/>
                  </a:lnTo>
                  <a:lnTo>
                    <a:pt x="435" y="831"/>
                  </a:lnTo>
                  <a:lnTo>
                    <a:pt x="443" y="825"/>
                  </a:lnTo>
                  <a:lnTo>
                    <a:pt x="453" y="820"/>
                  </a:lnTo>
                  <a:lnTo>
                    <a:pt x="461" y="814"/>
                  </a:lnTo>
                  <a:lnTo>
                    <a:pt x="467" y="807"/>
                  </a:lnTo>
                  <a:lnTo>
                    <a:pt x="477" y="801"/>
                  </a:lnTo>
                  <a:lnTo>
                    <a:pt x="483" y="796"/>
                  </a:lnTo>
                  <a:lnTo>
                    <a:pt x="492" y="790"/>
                  </a:lnTo>
                  <a:lnTo>
                    <a:pt x="499" y="783"/>
                  </a:lnTo>
                  <a:lnTo>
                    <a:pt x="508" y="779"/>
                  </a:lnTo>
                  <a:lnTo>
                    <a:pt x="515" y="772"/>
                  </a:lnTo>
                  <a:lnTo>
                    <a:pt x="524" y="766"/>
                  </a:lnTo>
                  <a:lnTo>
                    <a:pt x="531" y="761"/>
                  </a:lnTo>
                  <a:lnTo>
                    <a:pt x="540" y="755"/>
                  </a:lnTo>
                  <a:lnTo>
                    <a:pt x="546" y="748"/>
                  </a:lnTo>
                  <a:lnTo>
                    <a:pt x="556" y="744"/>
                  </a:lnTo>
                  <a:lnTo>
                    <a:pt x="562" y="737"/>
                  </a:lnTo>
                  <a:lnTo>
                    <a:pt x="572" y="733"/>
                  </a:lnTo>
                  <a:lnTo>
                    <a:pt x="578" y="726"/>
                  </a:lnTo>
                  <a:lnTo>
                    <a:pt x="588" y="721"/>
                  </a:lnTo>
                  <a:lnTo>
                    <a:pt x="594" y="715"/>
                  </a:lnTo>
                  <a:lnTo>
                    <a:pt x="604" y="710"/>
                  </a:lnTo>
                  <a:lnTo>
                    <a:pt x="610" y="704"/>
                  </a:lnTo>
                  <a:lnTo>
                    <a:pt x="620" y="699"/>
                  </a:lnTo>
                  <a:lnTo>
                    <a:pt x="626" y="693"/>
                  </a:lnTo>
                  <a:lnTo>
                    <a:pt x="635" y="688"/>
                  </a:lnTo>
                  <a:lnTo>
                    <a:pt x="642" y="683"/>
                  </a:lnTo>
                  <a:lnTo>
                    <a:pt x="650" y="677"/>
                  </a:lnTo>
                  <a:lnTo>
                    <a:pt x="659" y="672"/>
                  </a:lnTo>
                  <a:lnTo>
                    <a:pt x="667" y="666"/>
                  </a:lnTo>
                  <a:lnTo>
                    <a:pt x="674" y="661"/>
                  </a:lnTo>
                  <a:lnTo>
                    <a:pt x="682" y="656"/>
                  </a:lnTo>
                  <a:lnTo>
                    <a:pt x="691" y="652"/>
                  </a:lnTo>
                  <a:lnTo>
                    <a:pt x="699" y="645"/>
                  </a:lnTo>
                  <a:lnTo>
                    <a:pt x="705" y="640"/>
                  </a:lnTo>
                  <a:lnTo>
                    <a:pt x="713" y="636"/>
                  </a:lnTo>
                  <a:lnTo>
                    <a:pt x="723" y="629"/>
                  </a:lnTo>
                  <a:lnTo>
                    <a:pt x="731" y="625"/>
                  </a:lnTo>
                  <a:lnTo>
                    <a:pt x="737" y="620"/>
                  </a:lnTo>
                  <a:lnTo>
                    <a:pt x="745" y="615"/>
                  </a:lnTo>
                  <a:lnTo>
                    <a:pt x="755" y="610"/>
                  </a:lnTo>
                  <a:lnTo>
                    <a:pt x="763" y="604"/>
                  </a:lnTo>
                  <a:lnTo>
                    <a:pt x="769" y="599"/>
                  </a:lnTo>
                  <a:lnTo>
                    <a:pt x="777" y="594"/>
                  </a:lnTo>
                  <a:lnTo>
                    <a:pt x="786" y="590"/>
                  </a:lnTo>
                  <a:lnTo>
                    <a:pt x="794" y="585"/>
                  </a:lnTo>
                  <a:lnTo>
                    <a:pt x="802" y="580"/>
                  </a:lnTo>
                  <a:lnTo>
                    <a:pt x="809" y="575"/>
                  </a:lnTo>
                  <a:lnTo>
                    <a:pt x="817" y="571"/>
                  </a:lnTo>
                  <a:lnTo>
                    <a:pt x="826" y="564"/>
                  </a:lnTo>
                  <a:lnTo>
                    <a:pt x="834" y="559"/>
                  </a:lnTo>
                  <a:lnTo>
                    <a:pt x="840" y="555"/>
                  </a:lnTo>
                  <a:lnTo>
                    <a:pt x="848" y="550"/>
                  </a:lnTo>
                  <a:lnTo>
                    <a:pt x="858" y="545"/>
                  </a:lnTo>
                  <a:lnTo>
                    <a:pt x="866" y="540"/>
                  </a:lnTo>
                  <a:lnTo>
                    <a:pt x="872" y="536"/>
                  </a:lnTo>
                  <a:lnTo>
                    <a:pt x="880" y="531"/>
                  </a:lnTo>
                  <a:lnTo>
                    <a:pt x="890" y="526"/>
                  </a:lnTo>
                  <a:lnTo>
                    <a:pt x="898" y="521"/>
                  </a:lnTo>
                  <a:lnTo>
                    <a:pt x="904" y="517"/>
                  </a:lnTo>
                  <a:lnTo>
                    <a:pt x="912" y="513"/>
                  </a:lnTo>
                  <a:lnTo>
                    <a:pt x="921" y="509"/>
                  </a:lnTo>
                  <a:lnTo>
                    <a:pt x="929" y="504"/>
                  </a:lnTo>
                  <a:lnTo>
                    <a:pt x="936" y="499"/>
                  </a:lnTo>
                  <a:lnTo>
                    <a:pt x="944" y="494"/>
                  </a:lnTo>
                  <a:lnTo>
                    <a:pt x="953" y="490"/>
                  </a:lnTo>
                  <a:lnTo>
                    <a:pt x="961" y="485"/>
                  </a:lnTo>
                  <a:lnTo>
                    <a:pt x="967" y="480"/>
                  </a:lnTo>
                  <a:lnTo>
                    <a:pt x="975" y="477"/>
                  </a:lnTo>
                  <a:lnTo>
                    <a:pt x="983" y="472"/>
                  </a:lnTo>
                  <a:lnTo>
                    <a:pt x="993" y="467"/>
                  </a:lnTo>
                  <a:lnTo>
                    <a:pt x="1001" y="463"/>
                  </a:lnTo>
                  <a:lnTo>
                    <a:pt x="1007" y="459"/>
                  </a:lnTo>
                  <a:lnTo>
                    <a:pt x="1017" y="455"/>
                  </a:lnTo>
                  <a:lnTo>
                    <a:pt x="1023" y="450"/>
                  </a:lnTo>
                  <a:lnTo>
                    <a:pt x="1031" y="445"/>
                  </a:lnTo>
                  <a:lnTo>
                    <a:pt x="1041" y="442"/>
                  </a:lnTo>
                  <a:lnTo>
                    <a:pt x="1047" y="437"/>
                  </a:lnTo>
                  <a:lnTo>
                    <a:pt x="1056" y="432"/>
                  </a:lnTo>
                  <a:lnTo>
                    <a:pt x="1064" y="428"/>
                  </a:lnTo>
                  <a:lnTo>
                    <a:pt x="1071" y="424"/>
                  </a:lnTo>
                  <a:lnTo>
                    <a:pt x="1080" y="420"/>
                  </a:lnTo>
                  <a:lnTo>
                    <a:pt x="1087" y="416"/>
                  </a:lnTo>
                  <a:lnTo>
                    <a:pt x="1095" y="412"/>
                  </a:lnTo>
                  <a:lnTo>
                    <a:pt x="1104" y="407"/>
                  </a:lnTo>
                  <a:lnTo>
                    <a:pt x="1110" y="404"/>
                  </a:lnTo>
                  <a:lnTo>
                    <a:pt x="1120" y="399"/>
                  </a:lnTo>
                  <a:lnTo>
                    <a:pt x="1128" y="394"/>
                  </a:lnTo>
                  <a:lnTo>
                    <a:pt x="1134" y="391"/>
                  </a:lnTo>
                  <a:lnTo>
                    <a:pt x="1144" y="386"/>
                  </a:lnTo>
                  <a:lnTo>
                    <a:pt x="1150" y="383"/>
                  </a:lnTo>
                  <a:lnTo>
                    <a:pt x="1160" y="378"/>
                  </a:lnTo>
                  <a:lnTo>
                    <a:pt x="1168" y="375"/>
                  </a:lnTo>
                  <a:lnTo>
                    <a:pt x="1174" y="370"/>
                  </a:lnTo>
                  <a:lnTo>
                    <a:pt x="1184" y="367"/>
                  </a:lnTo>
                  <a:lnTo>
                    <a:pt x="1190" y="362"/>
                  </a:lnTo>
                  <a:lnTo>
                    <a:pt x="1198" y="359"/>
                  </a:lnTo>
                  <a:lnTo>
                    <a:pt x="1207" y="355"/>
                  </a:lnTo>
                  <a:lnTo>
                    <a:pt x="1214" y="351"/>
                  </a:lnTo>
                  <a:lnTo>
                    <a:pt x="1223" y="347"/>
                  </a:lnTo>
                  <a:lnTo>
                    <a:pt x="1231" y="343"/>
                  </a:lnTo>
                  <a:lnTo>
                    <a:pt x="1238" y="339"/>
                  </a:lnTo>
                  <a:lnTo>
                    <a:pt x="1247" y="335"/>
                  </a:lnTo>
                  <a:lnTo>
                    <a:pt x="1253" y="332"/>
                  </a:lnTo>
                  <a:lnTo>
                    <a:pt x="1261" y="328"/>
                  </a:lnTo>
                  <a:lnTo>
                    <a:pt x="1271" y="324"/>
                  </a:lnTo>
                  <a:lnTo>
                    <a:pt x="1277" y="320"/>
                  </a:lnTo>
                  <a:lnTo>
                    <a:pt x="1287" y="316"/>
                  </a:lnTo>
                  <a:lnTo>
                    <a:pt x="1295" y="313"/>
                  </a:lnTo>
                  <a:lnTo>
                    <a:pt x="1301" y="308"/>
                  </a:lnTo>
                  <a:lnTo>
                    <a:pt x="1311" y="305"/>
                  </a:lnTo>
                  <a:lnTo>
                    <a:pt x="1317" y="302"/>
                  </a:lnTo>
                  <a:lnTo>
                    <a:pt x="1325" y="297"/>
                  </a:lnTo>
                  <a:lnTo>
                    <a:pt x="1334" y="294"/>
                  </a:lnTo>
                  <a:lnTo>
                    <a:pt x="1341" y="291"/>
                  </a:lnTo>
                  <a:lnTo>
                    <a:pt x="1350" y="286"/>
                  </a:lnTo>
                  <a:lnTo>
                    <a:pt x="1358" y="283"/>
                  </a:lnTo>
                  <a:lnTo>
                    <a:pt x="1365" y="280"/>
                  </a:lnTo>
                  <a:lnTo>
                    <a:pt x="1374" y="277"/>
                  </a:lnTo>
                  <a:lnTo>
                    <a:pt x="1381" y="272"/>
                  </a:lnTo>
                  <a:lnTo>
                    <a:pt x="1388" y="269"/>
                  </a:lnTo>
                  <a:lnTo>
                    <a:pt x="1398" y="266"/>
                  </a:lnTo>
                  <a:lnTo>
                    <a:pt x="1404" y="262"/>
                  </a:lnTo>
                  <a:lnTo>
                    <a:pt x="1414" y="259"/>
                  </a:lnTo>
                  <a:lnTo>
                    <a:pt x="1422" y="254"/>
                  </a:lnTo>
                  <a:lnTo>
                    <a:pt x="1428" y="251"/>
                  </a:lnTo>
                  <a:lnTo>
                    <a:pt x="1438" y="248"/>
                  </a:lnTo>
                  <a:lnTo>
                    <a:pt x="1444" y="245"/>
                  </a:lnTo>
                  <a:lnTo>
                    <a:pt x="1452" y="242"/>
                  </a:lnTo>
                  <a:lnTo>
                    <a:pt x="1462" y="239"/>
                  </a:lnTo>
                  <a:lnTo>
                    <a:pt x="1468" y="234"/>
                  </a:lnTo>
                  <a:lnTo>
                    <a:pt x="1477" y="231"/>
                  </a:lnTo>
                  <a:lnTo>
                    <a:pt x="1484" y="227"/>
                  </a:lnTo>
                  <a:lnTo>
                    <a:pt x="1492" y="224"/>
                  </a:lnTo>
                  <a:lnTo>
                    <a:pt x="1501" y="221"/>
                  </a:lnTo>
                  <a:lnTo>
                    <a:pt x="1508" y="218"/>
                  </a:lnTo>
                  <a:lnTo>
                    <a:pt x="1517" y="215"/>
                  </a:lnTo>
                  <a:lnTo>
                    <a:pt x="1525" y="212"/>
                  </a:lnTo>
                  <a:lnTo>
                    <a:pt x="1531" y="208"/>
                  </a:lnTo>
                  <a:lnTo>
                    <a:pt x="1541" y="205"/>
                  </a:lnTo>
                  <a:lnTo>
                    <a:pt x="1547" y="202"/>
                  </a:lnTo>
                  <a:lnTo>
                    <a:pt x="1555" y="199"/>
                  </a:lnTo>
                  <a:lnTo>
                    <a:pt x="1565" y="194"/>
                  </a:lnTo>
                  <a:lnTo>
                    <a:pt x="1571" y="191"/>
                  </a:lnTo>
                  <a:lnTo>
                    <a:pt x="1581" y="188"/>
                  </a:lnTo>
                  <a:lnTo>
                    <a:pt x="1589" y="185"/>
                  </a:lnTo>
                  <a:lnTo>
                    <a:pt x="1595" y="181"/>
                  </a:lnTo>
                  <a:lnTo>
                    <a:pt x="1605" y="178"/>
                  </a:lnTo>
                  <a:lnTo>
                    <a:pt x="1611" y="177"/>
                  </a:lnTo>
                  <a:lnTo>
                    <a:pt x="1619" y="173"/>
                  </a:lnTo>
                  <a:lnTo>
                    <a:pt x="1628" y="170"/>
                  </a:lnTo>
                  <a:lnTo>
                    <a:pt x="1635" y="167"/>
                  </a:lnTo>
                  <a:lnTo>
                    <a:pt x="1644" y="164"/>
                  </a:lnTo>
                  <a:lnTo>
                    <a:pt x="1652" y="161"/>
                  </a:lnTo>
                  <a:lnTo>
                    <a:pt x="1659" y="158"/>
                  </a:lnTo>
                  <a:lnTo>
                    <a:pt x="1667" y="154"/>
                  </a:lnTo>
                  <a:lnTo>
                    <a:pt x="1676" y="151"/>
                  </a:lnTo>
                  <a:lnTo>
                    <a:pt x="1682" y="148"/>
                  </a:lnTo>
                  <a:lnTo>
                    <a:pt x="1690" y="145"/>
                  </a:lnTo>
                  <a:lnTo>
                    <a:pt x="1700" y="142"/>
                  </a:lnTo>
                  <a:lnTo>
                    <a:pt x="1708" y="140"/>
                  </a:lnTo>
                  <a:lnTo>
                    <a:pt x="1714" y="137"/>
                  </a:lnTo>
                  <a:lnTo>
                    <a:pt x="1724" y="134"/>
                  </a:lnTo>
                  <a:lnTo>
                    <a:pt x="1732" y="131"/>
                  </a:lnTo>
                  <a:lnTo>
                    <a:pt x="1738" y="127"/>
                  </a:lnTo>
                  <a:lnTo>
                    <a:pt x="1748" y="124"/>
                  </a:lnTo>
                  <a:lnTo>
                    <a:pt x="1755" y="123"/>
                  </a:lnTo>
                  <a:lnTo>
                    <a:pt x="1762" y="119"/>
                  </a:lnTo>
                  <a:lnTo>
                    <a:pt x="1770" y="116"/>
                  </a:lnTo>
                  <a:lnTo>
                    <a:pt x="1779" y="113"/>
                  </a:lnTo>
                  <a:lnTo>
                    <a:pt x="1786" y="110"/>
                  </a:lnTo>
                  <a:lnTo>
                    <a:pt x="1794" y="108"/>
                  </a:lnTo>
                  <a:lnTo>
                    <a:pt x="1803" y="105"/>
                  </a:lnTo>
                  <a:lnTo>
                    <a:pt x="1810" y="102"/>
                  </a:lnTo>
                  <a:lnTo>
                    <a:pt x="1817" y="99"/>
                  </a:lnTo>
                  <a:lnTo>
                    <a:pt x="1827" y="96"/>
                  </a:lnTo>
                  <a:lnTo>
                    <a:pt x="1835" y="94"/>
                  </a:lnTo>
                  <a:lnTo>
                    <a:pt x="1841" y="91"/>
                  </a:lnTo>
                  <a:lnTo>
                    <a:pt x="1851" y="88"/>
                  </a:lnTo>
                  <a:lnTo>
                    <a:pt x="1859" y="86"/>
                  </a:lnTo>
                  <a:lnTo>
                    <a:pt x="1865" y="83"/>
                  </a:lnTo>
                  <a:lnTo>
                    <a:pt x="1873" y="80"/>
                  </a:lnTo>
                  <a:lnTo>
                    <a:pt x="1883" y="77"/>
                  </a:lnTo>
                  <a:lnTo>
                    <a:pt x="1889" y="75"/>
                  </a:lnTo>
                  <a:lnTo>
                    <a:pt x="1897" y="72"/>
                  </a:lnTo>
                  <a:lnTo>
                    <a:pt x="1906" y="69"/>
                  </a:lnTo>
                  <a:lnTo>
                    <a:pt x="1913" y="67"/>
                  </a:lnTo>
                  <a:lnTo>
                    <a:pt x="1921" y="64"/>
                  </a:lnTo>
                  <a:lnTo>
                    <a:pt x="1930" y="61"/>
                  </a:lnTo>
                  <a:lnTo>
                    <a:pt x="1938" y="59"/>
                  </a:lnTo>
                  <a:lnTo>
                    <a:pt x="1945" y="56"/>
                  </a:lnTo>
                  <a:lnTo>
                    <a:pt x="1954" y="54"/>
                  </a:lnTo>
                  <a:lnTo>
                    <a:pt x="1962" y="51"/>
                  </a:lnTo>
                  <a:lnTo>
                    <a:pt x="1968" y="48"/>
                  </a:lnTo>
                  <a:lnTo>
                    <a:pt x="1978" y="46"/>
                  </a:lnTo>
                  <a:lnTo>
                    <a:pt x="1986" y="43"/>
                  </a:lnTo>
                  <a:lnTo>
                    <a:pt x="1992" y="42"/>
                  </a:lnTo>
                  <a:lnTo>
                    <a:pt x="2000" y="38"/>
                  </a:lnTo>
                  <a:lnTo>
                    <a:pt x="2010" y="35"/>
                  </a:lnTo>
                  <a:lnTo>
                    <a:pt x="2016" y="34"/>
                  </a:lnTo>
                  <a:lnTo>
                    <a:pt x="2024" y="31"/>
                  </a:lnTo>
                  <a:lnTo>
                    <a:pt x="2034" y="29"/>
                  </a:lnTo>
                  <a:lnTo>
                    <a:pt x="2040" y="26"/>
                  </a:lnTo>
                  <a:lnTo>
                    <a:pt x="2048" y="24"/>
                  </a:lnTo>
                  <a:lnTo>
                    <a:pt x="2057" y="21"/>
                  </a:lnTo>
                  <a:lnTo>
                    <a:pt x="2065" y="19"/>
                  </a:lnTo>
                  <a:lnTo>
                    <a:pt x="2072" y="16"/>
                  </a:lnTo>
                  <a:lnTo>
                    <a:pt x="2081" y="15"/>
                  </a:lnTo>
                  <a:lnTo>
                    <a:pt x="2089" y="11"/>
                  </a:lnTo>
                  <a:lnTo>
                    <a:pt x="2095" y="10"/>
                  </a:lnTo>
                  <a:lnTo>
                    <a:pt x="2105" y="7"/>
                  </a:lnTo>
                  <a:lnTo>
                    <a:pt x="2113" y="5"/>
                  </a:lnTo>
                  <a:lnTo>
                    <a:pt x="2119" y="2"/>
                  </a:lnTo>
                  <a:lnTo>
                    <a:pt x="2127" y="0"/>
                  </a:lnTo>
                  <a:lnTo>
                    <a:pt x="2137" y="167"/>
                  </a:lnTo>
                  <a:lnTo>
                    <a:pt x="2143" y="169"/>
                  </a:lnTo>
                  <a:lnTo>
                    <a:pt x="2151" y="169"/>
                  </a:lnTo>
                  <a:lnTo>
                    <a:pt x="2161" y="169"/>
                  </a:lnTo>
                  <a:lnTo>
                    <a:pt x="2169" y="170"/>
                  </a:lnTo>
                  <a:lnTo>
                    <a:pt x="2175" y="170"/>
                  </a:lnTo>
                  <a:lnTo>
                    <a:pt x="2184" y="170"/>
                  </a:lnTo>
                  <a:lnTo>
                    <a:pt x="2192" y="172"/>
                  </a:lnTo>
                  <a:lnTo>
                    <a:pt x="2199" y="172"/>
                  </a:lnTo>
                  <a:lnTo>
                    <a:pt x="2208" y="172"/>
                  </a:lnTo>
                  <a:lnTo>
                    <a:pt x="2216" y="172"/>
                  </a:lnTo>
                  <a:lnTo>
                    <a:pt x="2223" y="173"/>
                  </a:lnTo>
                  <a:lnTo>
                    <a:pt x="2231" y="173"/>
                  </a:lnTo>
                  <a:lnTo>
                    <a:pt x="2240" y="173"/>
                  </a:lnTo>
                  <a:lnTo>
                    <a:pt x="2246" y="175"/>
                  </a:lnTo>
                  <a:lnTo>
                    <a:pt x="2254" y="175"/>
                  </a:lnTo>
                  <a:lnTo>
                    <a:pt x="2264" y="175"/>
                  </a:lnTo>
                  <a:lnTo>
                    <a:pt x="2270" y="177"/>
                  </a:lnTo>
                  <a:lnTo>
                    <a:pt x="2278" y="177"/>
                  </a:lnTo>
                  <a:lnTo>
                    <a:pt x="2288" y="177"/>
                  </a:lnTo>
                  <a:lnTo>
                    <a:pt x="2296" y="178"/>
                  </a:lnTo>
                  <a:lnTo>
                    <a:pt x="2302" y="178"/>
                  </a:lnTo>
                  <a:lnTo>
                    <a:pt x="2312" y="178"/>
                  </a:lnTo>
                  <a:lnTo>
                    <a:pt x="2319" y="180"/>
                  </a:lnTo>
                  <a:lnTo>
                    <a:pt x="2326" y="180"/>
                  </a:lnTo>
                  <a:lnTo>
                    <a:pt x="2335" y="180"/>
                  </a:lnTo>
                  <a:lnTo>
                    <a:pt x="2343" y="180"/>
                  </a:lnTo>
                  <a:lnTo>
                    <a:pt x="2350" y="181"/>
                  </a:lnTo>
                  <a:lnTo>
                    <a:pt x="2358" y="181"/>
                  </a:lnTo>
                  <a:lnTo>
                    <a:pt x="2367" y="181"/>
                  </a:lnTo>
                  <a:lnTo>
                    <a:pt x="2373" y="183"/>
                  </a:lnTo>
                  <a:lnTo>
                    <a:pt x="2381" y="183"/>
                  </a:lnTo>
                  <a:lnTo>
                    <a:pt x="2391" y="183"/>
                  </a:lnTo>
                  <a:lnTo>
                    <a:pt x="2397" y="185"/>
                  </a:lnTo>
                  <a:lnTo>
                    <a:pt x="2405" y="185"/>
                  </a:lnTo>
                  <a:lnTo>
                    <a:pt x="2415" y="185"/>
                  </a:lnTo>
                  <a:lnTo>
                    <a:pt x="2423" y="186"/>
                  </a:lnTo>
                  <a:lnTo>
                    <a:pt x="2429" y="186"/>
                  </a:lnTo>
                  <a:lnTo>
                    <a:pt x="2439" y="186"/>
                  </a:lnTo>
                  <a:lnTo>
                    <a:pt x="2447" y="186"/>
                  </a:lnTo>
                  <a:lnTo>
                    <a:pt x="2453" y="188"/>
                  </a:lnTo>
                  <a:lnTo>
                    <a:pt x="2462" y="188"/>
                  </a:lnTo>
                  <a:lnTo>
                    <a:pt x="2470" y="188"/>
                  </a:lnTo>
                  <a:lnTo>
                    <a:pt x="2477" y="189"/>
                  </a:lnTo>
                  <a:lnTo>
                    <a:pt x="2485" y="189"/>
                  </a:lnTo>
                  <a:lnTo>
                    <a:pt x="2494" y="189"/>
                  </a:lnTo>
                  <a:lnTo>
                    <a:pt x="2501" y="191"/>
                  </a:lnTo>
                  <a:lnTo>
                    <a:pt x="2509" y="191"/>
                  </a:lnTo>
                  <a:lnTo>
                    <a:pt x="2518" y="191"/>
                  </a:lnTo>
                  <a:lnTo>
                    <a:pt x="2526" y="193"/>
                  </a:lnTo>
                  <a:lnTo>
                    <a:pt x="2532" y="193"/>
                  </a:lnTo>
                  <a:lnTo>
                    <a:pt x="2542" y="193"/>
                  </a:lnTo>
                  <a:lnTo>
                    <a:pt x="2550" y="193"/>
                  </a:lnTo>
                  <a:lnTo>
                    <a:pt x="2556" y="194"/>
                  </a:lnTo>
                  <a:lnTo>
                    <a:pt x="2566" y="194"/>
                  </a:lnTo>
                  <a:lnTo>
                    <a:pt x="2574" y="194"/>
                  </a:lnTo>
                  <a:lnTo>
                    <a:pt x="2580" y="196"/>
                  </a:lnTo>
                  <a:lnTo>
                    <a:pt x="2588" y="196"/>
                  </a:lnTo>
                  <a:lnTo>
                    <a:pt x="2598" y="196"/>
                  </a:lnTo>
                  <a:lnTo>
                    <a:pt x="2604" y="197"/>
                  </a:lnTo>
                  <a:lnTo>
                    <a:pt x="2612" y="197"/>
                  </a:lnTo>
                  <a:lnTo>
                    <a:pt x="2621" y="197"/>
                  </a:lnTo>
                  <a:lnTo>
                    <a:pt x="2628" y="197"/>
                  </a:lnTo>
                  <a:lnTo>
                    <a:pt x="2636" y="199"/>
                  </a:lnTo>
                  <a:lnTo>
                    <a:pt x="2645" y="199"/>
                  </a:lnTo>
                  <a:lnTo>
                    <a:pt x="2653" y="199"/>
                  </a:lnTo>
                  <a:lnTo>
                    <a:pt x="2659" y="200"/>
                  </a:lnTo>
                  <a:lnTo>
                    <a:pt x="2669" y="200"/>
                  </a:lnTo>
                  <a:lnTo>
                    <a:pt x="2677" y="200"/>
                  </a:lnTo>
                  <a:lnTo>
                    <a:pt x="2683" y="202"/>
                  </a:lnTo>
                  <a:lnTo>
                    <a:pt x="2693" y="202"/>
                  </a:lnTo>
                  <a:lnTo>
                    <a:pt x="2701" y="202"/>
                  </a:lnTo>
                  <a:lnTo>
                    <a:pt x="2707" y="204"/>
                  </a:lnTo>
                  <a:lnTo>
                    <a:pt x="2715" y="204"/>
                  </a:lnTo>
                  <a:lnTo>
                    <a:pt x="2725" y="204"/>
                  </a:lnTo>
                  <a:lnTo>
                    <a:pt x="2731" y="204"/>
                  </a:lnTo>
                  <a:lnTo>
                    <a:pt x="2739" y="205"/>
                  </a:lnTo>
                  <a:lnTo>
                    <a:pt x="2748" y="205"/>
                  </a:lnTo>
                  <a:lnTo>
                    <a:pt x="2755" y="205"/>
                  </a:lnTo>
                  <a:lnTo>
                    <a:pt x="2763" y="207"/>
                  </a:lnTo>
                  <a:lnTo>
                    <a:pt x="2772" y="207"/>
                  </a:lnTo>
                  <a:lnTo>
                    <a:pt x="2780" y="207"/>
                  </a:lnTo>
                  <a:lnTo>
                    <a:pt x="2787" y="208"/>
                  </a:lnTo>
                  <a:lnTo>
                    <a:pt x="2796" y="208"/>
                  </a:lnTo>
                  <a:lnTo>
                    <a:pt x="2804" y="208"/>
                  </a:lnTo>
                  <a:lnTo>
                    <a:pt x="2810" y="208"/>
                  </a:lnTo>
                  <a:lnTo>
                    <a:pt x="2820" y="210"/>
                  </a:lnTo>
                  <a:lnTo>
                    <a:pt x="2828" y="210"/>
                  </a:lnTo>
                  <a:lnTo>
                    <a:pt x="2834" y="210"/>
                  </a:lnTo>
                  <a:lnTo>
                    <a:pt x="2842" y="212"/>
                  </a:lnTo>
                  <a:lnTo>
                    <a:pt x="2852" y="212"/>
                  </a:lnTo>
                  <a:lnTo>
                    <a:pt x="2858" y="212"/>
                  </a:lnTo>
                  <a:lnTo>
                    <a:pt x="2866" y="213"/>
                  </a:lnTo>
                  <a:lnTo>
                    <a:pt x="2876" y="213"/>
                  </a:lnTo>
                  <a:lnTo>
                    <a:pt x="2883" y="213"/>
                  </a:lnTo>
                  <a:lnTo>
                    <a:pt x="2890" y="213"/>
                  </a:lnTo>
                  <a:lnTo>
                    <a:pt x="2899" y="215"/>
                  </a:lnTo>
                  <a:lnTo>
                    <a:pt x="2907" y="215"/>
                  </a:lnTo>
                  <a:lnTo>
                    <a:pt x="2914" y="215"/>
                  </a:lnTo>
                  <a:lnTo>
                    <a:pt x="2923" y="216"/>
                  </a:lnTo>
                  <a:lnTo>
                    <a:pt x="2931" y="216"/>
                  </a:lnTo>
                  <a:lnTo>
                    <a:pt x="2937" y="216"/>
                  </a:lnTo>
                  <a:lnTo>
                    <a:pt x="2945" y="218"/>
                  </a:lnTo>
                  <a:lnTo>
                    <a:pt x="2955" y="218"/>
                  </a:lnTo>
                  <a:lnTo>
                    <a:pt x="2961" y="218"/>
                  </a:lnTo>
                  <a:lnTo>
                    <a:pt x="2969" y="218"/>
                  </a:lnTo>
                  <a:lnTo>
                    <a:pt x="2979" y="220"/>
                  </a:lnTo>
                  <a:lnTo>
                    <a:pt x="2985" y="220"/>
                  </a:lnTo>
                  <a:lnTo>
                    <a:pt x="2993" y="220"/>
                  </a:lnTo>
                  <a:lnTo>
                    <a:pt x="3003" y="221"/>
                  </a:lnTo>
                  <a:lnTo>
                    <a:pt x="3011" y="221"/>
                  </a:lnTo>
                  <a:lnTo>
                    <a:pt x="3017" y="221"/>
                  </a:lnTo>
                  <a:lnTo>
                    <a:pt x="3026" y="221"/>
                  </a:lnTo>
                  <a:lnTo>
                    <a:pt x="3034" y="223"/>
                  </a:lnTo>
                  <a:lnTo>
                    <a:pt x="3041" y="223"/>
                  </a:lnTo>
                  <a:lnTo>
                    <a:pt x="3049" y="223"/>
                  </a:lnTo>
                  <a:lnTo>
                    <a:pt x="3057" y="224"/>
                  </a:lnTo>
                  <a:lnTo>
                    <a:pt x="3066" y="224"/>
                  </a:lnTo>
                  <a:lnTo>
                    <a:pt x="3074" y="224"/>
                  </a:lnTo>
                  <a:lnTo>
                    <a:pt x="3082" y="226"/>
                  </a:lnTo>
                  <a:lnTo>
                    <a:pt x="3088" y="226"/>
                  </a:lnTo>
                  <a:lnTo>
                    <a:pt x="3096" y="226"/>
                  </a:lnTo>
                  <a:lnTo>
                    <a:pt x="3104" y="226"/>
                  </a:lnTo>
                  <a:lnTo>
                    <a:pt x="3114" y="227"/>
                  </a:lnTo>
                  <a:lnTo>
                    <a:pt x="3122" y="227"/>
                  </a:lnTo>
                  <a:lnTo>
                    <a:pt x="3130" y="227"/>
                  </a:lnTo>
                  <a:lnTo>
                    <a:pt x="3138" y="229"/>
                  </a:lnTo>
                  <a:lnTo>
                    <a:pt x="3144" y="229"/>
                  </a:lnTo>
                  <a:lnTo>
                    <a:pt x="3152" y="229"/>
                  </a:lnTo>
                  <a:lnTo>
                    <a:pt x="3160" y="229"/>
                  </a:lnTo>
                  <a:lnTo>
                    <a:pt x="3169" y="231"/>
                  </a:lnTo>
                  <a:lnTo>
                    <a:pt x="3177" y="231"/>
                  </a:lnTo>
                  <a:lnTo>
                    <a:pt x="3185" y="231"/>
                  </a:lnTo>
                  <a:lnTo>
                    <a:pt x="3192" y="232"/>
                  </a:lnTo>
                  <a:lnTo>
                    <a:pt x="3200" y="232"/>
                  </a:lnTo>
                  <a:lnTo>
                    <a:pt x="3208" y="232"/>
                  </a:lnTo>
                  <a:lnTo>
                    <a:pt x="3217" y="234"/>
                  </a:lnTo>
                  <a:lnTo>
                    <a:pt x="3225" y="234"/>
                  </a:lnTo>
                  <a:lnTo>
                    <a:pt x="3233" y="234"/>
                  </a:lnTo>
                  <a:lnTo>
                    <a:pt x="3241" y="234"/>
                  </a:lnTo>
                  <a:lnTo>
                    <a:pt x="3247" y="235"/>
                  </a:lnTo>
                  <a:lnTo>
                    <a:pt x="3255" y="235"/>
                  </a:lnTo>
                  <a:lnTo>
                    <a:pt x="3263" y="235"/>
                  </a:lnTo>
                  <a:lnTo>
                    <a:pt x="3273" y="237"/>
                  </a:lnTo>
                  <a:lnTo>
                    <a:pt x="3281" y="237"/>
                  </a:lnTo>
                  <a:lnTo>
                    <a:pt x="3289" y="237"/>
                  </a:lnTo>
                  <a:lnTo>
                    <a:pt x="3295" y="237"/>
                  </a:lnTo>
                  <a:lnTo>
                    <a:pt x="3303" y="239"/>
                  </a:lnTo>
                  <a:lnTo>
                    <a:pt x="3311" y="239"/>
                  </a:lnTo>
                  <a:lnTo>
                    <a:pt x="3320" y="239"/>
                  </a:lnTo>
                  <a:lnTo>
                    <a:pt x="3328" y="240"/>
                  </a:lnTo>
                  <a:lnTo>
                    <a:pt x="3336" y="240"/>
                  </a:lnTo>
                  <a:lnTo>
                    <a:pt x="3343" y="240"/>
                  </a:lnTo>
                  <a:lnTo>
                    <a:pt x="3351" y="240"/>
                  </a:lnTo>
                  <a:lnTo>
                    <a:pt x="3359" y="242"/>
                  </a:lnTo>
                  <a:lnTo>
                    <a:pt x="3366" y="242"/>
                  </a:lnTo>
                  <a:lnTo>
                    <a:pt x="3376" y="242"/>
                  </a:lnTo>
                  <a:lnTo>
                    <a:pt x="3384" y="243"/>
                  </a:lnTo>
                  <a:lnTo>
                    <a:pt x="3392" y="243"/>
                  </a:lnTo>
                  <a:lnTo>
                    <a:pt x="3398" y="243"/>
                  </a:lnTo>
                  <a:lnTo>
                    <a:pt x="3406" y="245"/>
                  </a:lnTo>
                  <a:lnTo>
                    <a:pt x="3414" y="245"/>
                  </a:lnTo>
                  <a:lnTo>
                    <a:pt x="3424" y="245"/>
                  </a:lnTo>
                  <a:lnTo>
                    <a:pt x="3432" y="245"/>
                  </a:lnTo>
                  <a:lnTo>
                    <a:pt x="3440" y="247"/>
                  </a:lnTo>
                  <a:lnTo>
                    <a:pt x="3446" y="247"/>
                  </a:lnTo>
                  <a:lnTo>
                    <a:pt x="3454" y="247"/>
                  </a:lnTo>
                  <a:lnTo>
                    <a:pt x="3462" y="248"/>
                  </a:lnTo>
                  <a:lnTo>
                    <a:pt x="3471" y="248"/>
                  </a:lnTo>
                  <a:lnTo>
                    <a:pt x="3479" y="248"/>
                  </a:lnTo>
                  <a:lnTo>
                    <a:pt x="3487" y="248"/>
                  </a:lnTo>
                  <a:lnTo>
                    <a:pt x="3495" y="250"/>
                  </a:lnTo>
                  <a:lnTo>
                    <a:pt x="3501" y="250"/>
                  </a:lnTo>
                  <a:lnTo>
                    <a:pt x="3509" y="250"/>
                  </a:lnTo>
                  <a:lnTo>
                    <a:pt x="3517" y="251"/>
                  </a:lnTo>
                  <a:lnTo>
                    <a:pt x="3527" y="251"/>
                  </a:lnTo>
                  <a:lnTo>
                    <a:pt x="3535" y="251"/>
                  </a:lnTo>
                  <a:lnTo>
                    <a:pt x="3543" y="251"/>
                  </a:lnTo>
                  <a:lnTo>
                    <a:pt x="3549" y="253"/>
                  </a:lnTo>
                  <a:lnTo>
                    <a:pt x="3557" y="253"/>
                  </a:lnTo>
                  <a:lnTo>
                    <a:pt x="3565" y="253"/>
                  </a:lnTo>
                  <a:lnTo>
                    <a:pt x="3575" y="254"/>
                  </a:lnTo>
                  <a:lnTo>
                    <a:pt x="3583" y="254"/>
                  </a:lnTo>
                  <a:lnTo>
                    <a:pt x="3590" y="254"/>
                  </a:lnTo>
                  <a:lnTo>
                    <a:pt x="3598" y="254"/>
                  </a:lnTo>
                  <a:lnTo>
                    <a:pt x="3605" y="256"/>
                  </a:lnTo>
                  <a:lnTo>
                    <a:pt x="3613" y="256"/>
                  </a:lnTo>
                  <a:lnTo>
                    <a:pt x="3621" y="256"/>
                  </a:lnTo>
                  <a:lnTo>
                    <a:pt x="3630" y="258"/>
                  </a:lnTo>
                  <a:lnTo>
                    <a:pt x="3638" y="258"/>
                  </a:lnTo>
                  <a:lnTo>
                    <a:pt x="3646" y="258"/>
                  </a:lnTo>
                  <a:lnTo>
                    <a:pt x="3652" y="258"/>
                  </a:lnTo>
                  <a:lnTo>
                    <a:pt x="3660" y="259"/>
                  </a:lnTo>
                  <a:lnTo>
                    <a:pt x="3668" y="259"/>
                  </a:lnTo>
                  <a:lnTo>
                    <a:pt x="3678" y="259"/>
                  </a:lnTo>
                  <a:lnTo>
                    <a:pt x="3686" y="261"/>
                  </a:lnTo>
                  <a:lnTo>
                    <a:pt x="3694" y="261"/>
                  </a:lnTo>
                  <a:lnTo>
                    <a:pt x="3700" y="261"/>
                  </a:lnTo>
                  <a:lnTo>
                    <a:pt x="3708" y="261"/>
                  </a:lnTo>
                  <a:lnTo>
                    <a:pt x="3716" y="262"/>
                  </a:lnTo>
                  <a:lnTo>
                    <a:pt x="3724" y="262"/>
                  </a:lnTo>
                  <a:lnTo>
                    <a:pt x="3733" y="262"/>
                  </a:lnTo>
                  <a:lnTo>
                    <a:pt x="3741" y="262"/>
                  </a:lnTo>
                  <a:lnTo>
                    <a:pt x="3749" y="264"/>
                  </a:lnTo>
                  <a:lnTo>
                    <a:pt x="3756" y="264"/>
                  </a:lnTo>
                  <a:lnTo>
                    <a:pt x="3764" y="264"/>
                  </a:lnTo>
                  <a:lnTo>
                    <a:pt x="3772" y="266"/>
                  </a:lnTo>
                  <a:lnTo>
                    <a:pt x="3781" y="266"/>
                  </a:lnTo>
                  <a:lnTo>
                    <a:pt x="3789" y="266"/>
                  </a:lnTo>
                  <a:lnTo>
                    <a:pt x="3797" y="266"/>
                  </a:lnTo>
                  <a:lnTo>
                    <a:pt x="3803" y="267"/>
                  </a:lnTo>
                  <a:lnTo>
                    <a:pt x="3811" y="267"/>
                  </a:lnTo>
                  <a:lnTo>
                    <a:pt x="3819" y="267"/>
                  </a:lnTo>
                  <a:lnTo>
                    <a:pt x="3829" y="269"/>
                  </a:lnTo>
                  <a:lnTo>
                    <a:pt x="3837" y="269"/>
                  </a:lnTo>
                  <a:lnTo>
                    <a:pt x="3845" y="269"/>
                  </a:lnTo>
                  <a:lnTo>
                    <a:pt x="3853" y="269"/>
                  </a:lnTo>
                  <a:lnTo>
                    <a:pt x="3859" y="270"/>
                  </a:lnTo>
                  <a:lnTo>
                    <a:pt x="3867" y="270"/>
                  </a:lnTo>
                  <a:lnTo>
                    <a:pt x="3875" y="270"/>
                  </a:lnTo>
                  <a:lnTo>
                    <a:pt x="3884" y="272"/>
                  </a:lnTo>
                  <a:lnTo>
                    <a:pt x="3892" y="272"/>
                  </a:lnTo>
                  <a:lnTo>
                    <a:pt x="3900" y="272"/>
                  </a:lnTo>
                  <a:lnTo>
                    <a:pt x="3907" y="272"/>
                  </a:lnTo>
                  <a:lnTo>
                    <a:pt x="3915" y="274"/>
                  </a:lnTo>
                  <a:lnTo>
                    <a:pt x="3922" y="274"/>
                  </a:lnTo>
                  <a:lnTo>
                    <a:pt x="3932" y="274"/>
                  </a:lnTo>
                  <a:lnTo>
                    <a:pt x="3940" y="274"/>
                  </a:lnTo>
                  <a:lnTo>
                    <a:pt x="3948" y="275"/>
                  </a:lnTo>
                  <a:lnTo>
                    <a:pt x="3956" y="275"/>
                  </a:lnTo>
                  <a:lnTo>
                    <a:pt x="3962" y="275"/>
                  </a:lnTo>
                  <a:lnTo>
                    <a:pt x="3970" y="277"/>
                  </a:lnTo>
                  <a:lnTo>
                    <a:pt x="3978" y="277"/>
                  </a:lnTo>
                  <a:lnTo>
                    <a:pt x="3988" y="277"/>
                  </a:lnTo>
                  <a:lnTo>
                    <a:pt x="3996" y="277"/>
                  </a:lnTo>
                  <a:lnTo>
                    <a:pt x="4004" y="278"/>
                  </a:lnTo>
                  <a:lnTo>
                    <a:pt x="4010" y="278"/>
                  </a:lnTo>
                  <a:lnTo>
                    <a:pt x="4018" y="278"/>
                  </a:lnTo>
                  <a:lnTo>
                    <a:pt x="4026" y="280"/>
                  </a:lnTo>
                  <a:lnTo>
                    <a:pt x="4035" y="280"/>
                  </a:lnTo>
                  <a:lnTo>
                    <a:pt x="4043" y="280"/>
                  </a:lnTo>
                  <a:lnTo>
                    <a:pt x="4051" y="280"/>
                  </a:lnTo>
                  <a:lnTo>
                    <a:pt x="4058" y="281"/>
                  </a:lnTo>
                  <a:lnTo>
                    <a:pt x="4065" y="281"/>
                  </a:lnTo>
                  <a:lnTo>
                    <a:pt x="4073" y="281"/>
                  </a:lnTo>
                  <a:lnTo>
                    <a:pt x="4081" y="281"/>
                  </a:lnTo>
                  <a:lnTo>
                    <a:pt x="4091" y="283"/>
                  </a:lnTo>
                  <a:lnTo>
                    <a:pt x="4099" y="283"/>
                  </a:lnTo>
                  <a:lnTo>
                    <a:pt x="4107" y="28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4" name="Freeform 104"/>
            <p:cNvSpPr>
              <a:spLocks/>
            </p:cNvSpPr>
            <p:nvPr/>
          </p:nvSpPr>
          <p:spPr bwMode="auto">
            <a:xfrm>
              <a:off x="756" y="2166"/>
              <a:ext cx="4105" cy="670"/>
            </a:xfrm>
            <a:custGeom>
              <a:avLst/>
              <a:gdLst>
                <a:gd name="T0" fmla="*/ 64 w 4105"/>
                <a:gd name="T1" fmla="*/ 670 h 670"/>
                <a:gd name="T2" fmla="*/ 134 w 4105"/>
                <a:gd name="T3" fmla="*/ 670 h 670"/>
                <a:gd name="T4" fmla="*/ 207 w 4105"/>
                <a:gd name="T5" fmla="*/ 670 h 670"/>
                <a:gd name="T6" fmla="*/ 277 w 4105"/>
                <a:gd name="T7" fmla="*/ 670 h 670"/>
                <a:gd name="T8" fmla="*/ 350 w 4105"/>
                <a:gd name="T9" fmla="*/ 565 h 670"/>
                <a:gd name="T10" fmla="*/ 420 w 4105"/>
                <a:gd name="T11" fmla="*/ 537 h 670"/>
                <a:gd name="T12" fmla="*/ 493 w 4105"/>
                <a:gd name="T13" fmla="*/ 508 h 670"/>
                <a:gd name="T14" fmla="*/ 563 w 4105"/>
                <a:gd name="T15" fmla="*/ 480 h 670"/>
                <a:gd name="T16" fmla="*/ 636 w 4105"/>
                <a:gd name="T17" fmla="*/ 453 h 670"/>
                <a:gd name="T18" fmla="*/ 706 w 4105"/>
                <a:gd name="T19" fmla="*/ 427 h 670"/>
                <a:gd name="T20" fmla="*/ 777 w 4105"/>
                <a:gd name="T21" fmla="*/ 400 h 670"/>
                <a:gd name="T22" fmla="*/ 849 w 4105"/>
                <a:gd name="T23" fmla="*/ 375 h 670"/>
                <a:gd name="T24" fmla="*/ 922 w 4105"/>
                <a:gd name="T25" fmla="*/ 351 h 670"/>
                <a:gd name="T26" fmla="*/ 993 w 4105"/>
                <a:gd name="T27" fmla="*/ 327 h 670"/>
                <a:gd name="T28" fmla="*/ 1063 w 4105"/>
                <a:gd name="T29" fmla="*/ 303 h 670"/>
                <a:gd name="T30" fmla="*/ 1136 w 4105"/>
                <a:gd name="T31" fmla="*/ 279 h 670"/>
                <a:gd name="T32" fmla="*/ 1206 w 4105"/>
                <a:gd name="T33" fmla="*/ 257 h 670"/>
                <a:gd name="T34" fmla="*/ 1279 w 4105"/>
                <a:gd name="T35" fmla="*/ 235 h 670"/>
                <a:gd name="T36" fmla="*/ 1349 w 4105"/>
                <a:gd name="T37" fmla="*/ 213 h 670"/>
                <a:gd name="T38" fmla="*/ 1420 w 4105"/>
                <a:gd name="T39" fmla="*/ 192 h 670"/>
                <a:gd name="T40" fmla="*/ 1494 w 4105"/>
                <a:gd name="T41" fmla="*/ 171 h 670"/>
                <a:gd name="T42" fmla="*/ 1563 w 4105"/>
                <a:gd name="T43" fmla="*/ 151 h 670"/>
                <a:gd name="T44" fmla="*/ 1637 w 4105"/>
                <a:gd name="T45" fmla="*/ 132 h 670"/>
                <a:gd name="T46" fmla="*/ 1708 w 4105"/>
                <a:gd name="T47" fmla="*/ 113 h 670"/>
                <a:gd name="T48" fmla="*/ 1780 w 4105"/>
                <a:gd name="T49" fmla="*/ 94 h 670"/>
                <a:gd name="T50" fmla="*/ 1849 w 4105"/>
                <a:gd name="T51" fmla="*/ 75 h 670"/>
                <a:gd name="T52" fmla="*/ 1921 w 4105"/>
                <a:gd name="T53" fmla="*/ 57 h 670"/>
                <a:gd name="T54" fmla="*/ 1994 w 4105"/>
                <a:gd name="T55" fmla="*/ 40 h 670"/>
                <a:gd name="T56" fmla="*/ 2066 w 4105"/>
                <a:gd name="T57" fmla="*/ 22 h 670"/>
                <a:gd name="T58" fmla="*/ 2137 w 4105"/>
                <a:gd name="T59" fmla="*/ 5 h 670"/>
                <a:gd name="T60" fmla="*/ 2207 w 4105"/>
                <a:gd name="T61" fmla="*/ 97 h 670"/>
                <a:gd name="T62" fmla="*/ 2278 w 4105"/>
                <a:gd name="T63" fmla="*/ 98 h 670"/>
                <a:gd name="T64" fmla="*/ 2351 w 4105"/>
                <a:gd name="T65" fmla="*/ 102 h 670"/>
                <a:gd name="T66" fmla="*/ 2423 w 4105"/>
                <a:gd name="T67" fmla="*/ 105 h 670"/>
                <a:gd name="T68" fmla="*/ 2494 w 4105"/>
                <a:gd name="T69" fmla="*/ 108 h 670"/>
                <a:gd name="T70" fmla="*/ 2564 w 4105"/>
                <a:gd name="T71" fmla="*/ 109 h 670"/>
                <a:gd name="T72" fmla="*/ 2636 w 4105"/>
                <a:gd name="T73" fmla="*/ 113 h 670"/>
                <a:gd name="T74" fmla="*/ 2709 w 4105"/>
                <a:gd name="T75" fmla="*/ 116 h 670"/>
                <a:gd name="T76" fmla="*/ 2780 w 4105"/>
                <a:gd name="T77" fmla="*/ 117 h 670"/>
                <a:gd name="T78" fmla="*/ 2852 w 4105"/>
                <a:gd name="T79" fmla="*/ 121 h 670"/>
                <a:gd name="T80" fmla="*/ 2922 w 4105"/>
                <a:gd name="T81" fmla="*/ 122 h 670"/>
                <a:gd name="T82" fmla="*/ 2993 w 4105"/>
                <a:gd name="T83" fmla="*/ 125 h 670"/>
                <a:gd name="T84" fmla="*/ 3066 w 4105"/>
                <a:gd name="T85" fmla="*/ 129 h 670"/>
                <a:gd name="T86" fmla="*/ 3136 w 4105"/>
                <a:gd name="T87" fmla="*/ 130 h 670"/>
                <a:gd name="T88" fmla="*/ 3209 w 4105"/>
                <a:gd name="T89" fmla="*/ 133 h 670"/>
                <a:gd name="T90" fmla="*/ 3279 w 4105"/>
                <a:gd name="T91" fmla="*/ 136 h 670"/>
                <a:gd name="T92" fmla="*/ 3352 w 4105"/>
                <a:gd name="T93" fmla="*/ 138 h 670"/>
                <a:gd name="T94" fmla="*/ 3424 w 4105"/>
                <a:gd name="T95" fmla="*/ 141 h 670"/>
                <a:gd name="T96" fmla="*/ 3494 w 4105"/>
                <a:gd name="T97" fmla="*/ 143 h 670"/>
                <a:gd name="T98" fmla="*/ 3567 w 4105"/>
                <a:gd name="T99" fmla="*/ 146 h 670"/>
                <a:gd name="T100" fmla="*/ 3637 w 4105"/>
                <a:gd name="T101" fmla="*/ 148 h 670"/>
                <a:gd name="T102" fmla="*/ 3710 w 4105"/>
                <a:gd name="T103" fmla="*/ 151 h 670"/>
                <a:gd name="T104" fmla="*/ 3781 w 4105"/>
                <a:gd name="T105" fmla="*/ 154 h 670"/>
                <a:gd name="T106" fmla="*/ 3851 w 4105"/>
                <a:gd name="T107" fmla="*/ 156 h 670"/>
                <a:gd name="T108" fmla="*/ 3924 w 4105"/>
                <a:gd name="T109" fmla="*/ 159 h 670"/>
                <a:gd name="T110" fmla="*/ 3994 w 4105"/>
                <a:gd name="T111" fmla="*/ 160 h 670"/>
                <a:gd name="T112" fmla="*/ 4067 w 4105"/>
                <a:gd name="T113" fmla="*/ 163 h 6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105" h="670">
                  <a:moveTo>
                    <a:pt x="0" y="670"/>
                  </a:moveTo>
                  <a:lnTo>
                    <a:pt x="7" y="670"/>
                  </a:lnTo>
                  <a:lnTo>
                    <a:pt x="16" y="670"/>
                  </a:lnTo>
                  <a:lnTo>
                    <a:pt x="22" y="670"/>
                  </a:lnTo>
                  <a:lnTo>
                    <a:pt x="32" y="670"/>
                  </a:lnTo>
                  <a:lnTo>
                    <a:pt x="38" y="670"/>
                  </a:lnTo>
                  <a:lnTo>
                    <a:pt x="48" y="670"/>
                  </a:lnTo>
                  <a:lnTo>
                    <a:pt x="54" y="670"/>
                  </a:lnTo>
                  <a:lnTo>
                    <a:pt x="64" y="670"/>
                  </a:lnTo>
                  <a:lnTo>
                    <a:pt x="70" y="670"/>
                  </a:lnTo>
                  <a:lnTo>
                    <a:pt x="80" y="670"/>
                  </a:lnTo>
                  <a:lnTo>
                    <a:pt x="86" y="670"/>
                  </a:lnTo>
                  <a:lnTo>
                    <a:pt x="96" y="670"/>
                  </a:lnTo>
                  <a:lnTo>
                    <a:pt x="102" y="670"/>
                  </a:lnTo>
                  <a:lnTo>
                    <a:pt x="111" y="670"/>
                  </a:lnTo>
                  <a:lnTo>
                    <a:pt x="118" y="670"/>
                  </a:lnTo>
                  <a:lnTo>
                    <a:pt x="127" y="670"/>
                  </a:lnTo>
                  <a:lnTo>
                    <a:pt x="134" y="670"/>
                  </a:lnTo>
                  <a:lnTo>
                    <a:pt x="142" y="670"/>
                  </a:lnTo>
                  <a:lnTo>
                    <a:pt x="151" y="670"/>
                  </a:lnTo>
                  <a:lnTo>
                    <a:pt x="159" y="670"/>
                  </a:lnTo>
                  <a:lnTo>
                    <a:pt x="167" y="670"/>
                  </a:lnTo>
                  <a:lnTo>
                    <a:pt x="175" y="670"/>
                  </a:lnTo>
                  <a:lnTo>
                    <a:pt x="183" y="670"/>
                  </a:lnTo>
                  <a:lnTo>
                    <a:pt x="191" y="670"/>
                  </a:lnTo>
                  <a:lnTo>
                    <a:pt x="199" y="670"/>
                  </a:lnTo>
                  <a:lnTo>
                    <a:pt x="207" y="670"/>
                  </a:lnTo>
                  <a:lnTo>
                    <a:pt x="215" y="670"/>
                  </a:lnTo>
                  <a:lnTo>
                    <a:pt x="223" y="670"/>
                  </a:lnTo>
                  <a:lnTo>
                    <a:pt x="231" y="670"/>
                  </a:lnTo>
                  <a:lnTo>
                    <a:pt x="238" y="670"/>
                  </a:lnTo>
                  <a:lnTo>
                    <a:pt x="245" y="670"/>
                  </a:lnTo>
                  <a:lnTo>
                    <a:pt x="253" y="670"/>
                  </a:lnTo>
                  <a:lnTo>
                    <a:pt x="261" y="670"/>
                  </a:lnTo>
                  <a:lnTo>
                    <a:pt x="269" y="670"/>
                  </a:lnTo>
                  <a:lnTo>
                    <a:pt x="277" y="670"/>
                  </a:lnTo>
                  <a:lnTo>
                    <a:pt x="285" y="670"/>
                  </a:lnTo>
                  <a:lnTo>
                    <a:pt x="293" y="670"/>
                  </a:lnTo>
                  <a:lnTo>
                    <a:pt x="300" y="670"/>
                  </a:lnTo>
                  <a:lnTo>
                    <a:pt x="310" y="670"/>
                  </a:lnTo>
                  <a:lnTo>
                    <a:pt x="318" y="670"/>
                  </a:lnTo>
                  <a:lnTo>
                    <a:pt x="326" y="670"/>
                  </a:lnTo>
                  <a:lnTo>
                    <a:pt x="334" y="572"/>
                  </a:lnTo>
                  <a:lnTo>
                    <a:pt x="340" y="568"/>
                  </a:lnTo>
                  <a:lnTo>
                    <a:pt x="350" y="565"/>
                  </a:lnTo>
                  <a:lnTo>
                    <a:pt x="356" y="562"/>
                  </a:lnTo>
                  <a:lnTo>
                    <a:pt x="364" y="559"/>
                  </a:lnTo>
                  <a:lnTo>
                    <a:pt x="374" y="556"/>
                  </a:lnTo>
                  <a:lnTo>
                    <a:pt x="381" y="553"/>
                  </a:lnTo>
                  <a:lnTo>
                    <a:pt x="389" y="549"/>
                  </a:lnTo>
                  <a:lnTo>
                    <a:pt x="396" y="546"/>
                  </a:lnTo>
                  <a:lnTo>
                    <a:pt x="404" y="543"/>
                  </a:lnTo>
                  <a:lnTo>
                    <a:pt x="412" y="540"/>
                  </a:lnTo>
                  <a:lnTo>
                    <a:pt x="420" y="537"/>
                  </a:lnTo>
                  <a:lnTo>
                    <a:pt x="428" y="534"/>
                  </a:lnTo>
                  <a:lnTo>
                    <a:pt x="435" y="530"/>
                  </a:lnTo>
                  <a:lnTo>
                    <a:pt x="443" y="527"/>
                  </a:lnTo>
                  <a:lnTo>
                    <a:pt x="451" y="524"/>
                  </a:lnTo>
                  <a:lnTo>
                    <a:pt x="459" y="521"/>
                  </a:lnTo>
                  <a:lnTo>
                    <a:pt x="467" y="518"/>
                  </a:lnTo>
                  <a:lnTo>
                    <a:pt x="475" y="514"/>
                  </a:lnTo>
                  <a:lnTo>
                    <a:pt x="485" y="511"/>
                  </a:lnTo>
                  <a:lnTo>
                    <a:pt x="493" y="508"/>
                  </a:lnTo>
                  <a:lnTo>
                    <a:pt x="499" y="505"/>
                  </a:lnTo>
                  <a:lnTo>
                    <a:pt x="509" y="502"/>
                  </a:lnTo>
                  <a:lnTo>
                    <a:pt x="515" y="499"/>
                  </a:lnTo>
                  <a:lnTo>
                    <a:pt x="524" y="495"/>
                  </a:lnTo>
                  <a:lnTo>
                    <a:pt x="531" y="492"/>
                  </a:lnTo>
                  <a:lnTo>
                    <a:pt x="540" y="489"/>
                  </a:lnTo>
                  <a:lnTo>
                    <a:pt x="547" y="486"/>
                  </a:lnTo>
                  <a:lnTo>
                    <a:pt x="556" y="483"/>
                  </a:lnTo>
                  <a:lnTo>
                    <a:pt x="563" y="480"/>
                  </a:lnTo>
                  <a:lnTo>
                    <a:pt x="572" y="476"/>
                  </a:lnTo>
                  <a:lnTo>
                    <a:pt x="578" y="475"/>
                  </a:lnTo>
                  <a:lnTo>
                    <a:pt x="588" y="472"/>
                  </a:lnTo>
                  <a:lnTo>
                    <a:pt x="594" y="468"/>
                  </a:lnTo>
                  <a:lnTo>
                    <a:pt x="604" y="465"/>
                  </a:lnTo>
                  <a:lnTo>
                    <a:pt x="610" y="462"/>
                  </a:lnTo>
                  <a:lnTo>
                    <a:pt x="620" y="459"/>
                  </a:lnTo>
                  <a:lnTo>
                    <a:pt x="626" y="456"/>
                  </a:lnTo>
                  <a:lnTo>
                    <a:pt x="636" y="453"/>
                  </a:lnTo>
                  <a:lnTo>
                    <a:pt x="642" y="449"/>
                  </a:lnTo>
                  <a:lnTo>
                    <a:pt x="652" y="448"/>
                  </a:lnTo>
                  <a:lnTo>
                    <a:pt x="658" y="445"/>
                  </a:lnTo>
                  <a:lnTo>
                    <a:pt x="667" y="441"/>
                  </a:lnTo>
                  <a:lnTo>
                    <a:pt x="674" y="438"/>
                  </a:lnTo>
                  <a:lnTo>
                    <a:pt x="682" y="435"/>
                  </a:lnTo>
                  <a:lnTo>
                    <a:pt x="691" y="432"/>
                  </a:lnTo>
                  <a:lnTo>
                    <a:pt x="699" y="430"/>
                  </a:lnTo>
                  <a:lnTo>
                    <a:pt x="706" y="427"/>
                  </a:lnTo>
                  <a:lnTo>
                    <a:pt x="714" y="424"/>
                  </a:lnTo>
                  <a:lnTo>
                    <a:pt x="723" y="421"/>
                  </a:lnTo>
                  <a:lnTo>
                    <a:pt x="731" y="418"/>
                  </a:lnTo>
                  <a:lnTo>
                    <a:pt x="737" y="414"/>
                  </a:lnTo>
                  <a:lnTo>
                    <a:pt x="745" y="413"/>
                  </a:lnTo>
                  <a:lnTo>
                    <a:pt x="755" y="410"/>
                  </a:lnTo>
                  <a:lnTo>
                    <a:pt x="763" y="406"/>
                  </a:lnTo>
                  <a:lnTo>
                    <a:pt x="769" y="403"/>
                  </a:lnTo>
                  <a:lnTo>
                    <a:pt x="777" y="400"/>
                  </a:lnTo>
                  <a:lnTo>
                    <a:pt x="787" y="399"/>
                  </a:lnTo>
                  <a:lnTo>
                    <a:pt x="795" y="395"/>
                  </a:lnTo>
                  <a:lnTo>
                    <a:pt x="801" y="392"/>
                  </a:lnTo>
                  <a:lnTo>
                    <a:pt x="809" y="389"/>
                  </a:lnTo>
                  <a:lnTo>
                    <a:pt x="818" y="386"/>
                  </a:lnTo>
                  <a:lnTo>
                    <a:pt x="826" y="384"/>
                  </a:lnTo>
                  <a:lnTo>
                    <a:pt x="834" y="381"/>
                  </a:lnTo>
                  <a:lnTo>
                    <a:pt x="841" y="378"/>
                  </a:lnTo>
                  <a:lnTo>
                    <a:pt x="849" y="375"/>
                  </a:lnTo>
                  <a:lnTo>
                    <a:pt x="858" y="373"/>
                  </a:lnTo>
                  <a:lnTo>
                    <a:pt x="866" y="370"/>
                  </a:lnTo>
                  <a:lnTo>
                    <a:pt x="872" y="367"/>
                  </a:lnTo>
                  <a:lnTo>
                    <a:pt x="880" y="364"/>
                  </a:lnTo>
                  <a:lnTo>
                    <a:pt x="890" y="362"/>
                  </a:lnTo>
                  <a:lnTo>
                    <a:pt x="898" y="359"/>
                  </a:lnTo>
                  <a:lnTo>
                    <a:pt x="904" y="356"/>
                  </a:lnTo>
                  <a:lnTo>
                    <a:pt x="912" y="354"/>
                  </a:lnTo>
                  <a:lnTo>
                    <a:pt x="922" y="351"/>
                  </a:lnTo>
                  <a:lnTo>
                    <a:pt x="930" y="348"/>
                  </a:lnTo>
                  <a:lnTo>
                    <a:pt x="936" y="345"/>
                  </a:lnTo>
                  <a:lnTo>
                    <a:pt x="944" y="343"/>
                  </a:lnTo>
                  <a:lnTo>
                    <a:pt x="953" y="340"/>
                  </a:lnTo>
                  <a:lnTo>
                    <a:pt x="961" y="337"/>
                  </a:lnTo>
                  <a:lnTo>
                    <a:pt x="968" y="335"/>
                  </a:lnTo>
                  <a:lnTo>
                    <a:pt x="976" y="332"/>
                  </a:lnTo>
                  <a:lnTo>
                    <a:pt x="985" y="329"/>
                  </a:lnTo>
                  <a:lnTo>
                    <a:pt x="993" y="327"/>
                  </a:lnTo>
                  <a:lnTo>
                    <a:pt x="999" y="324"/>
                  </a:lnTo>
                  <a:lnTo>
                    <a:pt x="1007" y="321"/>
                  </a:lnTo>
                  <a:lnTo>
                    <a:pt x="1015" y="319"/>
                  </a:lnTo>
                  <a:lnTo>
                    <a:pt x="1025" y="316"/>
                  </a:lnTo>
                  <a:lnTo>
                    <a:pt x="1033" y="313"/>
                  </a:lnTo>
                  <a:lnTo>
                    <a:pt x="1039" y="311"/>
                  </a:lnTo>
                  <a:lnTo>
                    <a:pt x="1049" y="308"/>
                  </a:lnTo>
                  <a:lnTo>
                    <a:pt x="1055" y="305"/>
                  </a:lnTo>
                  <a:lnTo>
                    <a:pt x="1063" y="303"/>
                  </a:lnTo>
                  <a:lnTo>
                    <a:pt x="1073" y="300"/>
                  </a:lnTo>
                  <a:lnTo>
                    <a:pt x="1079" y="297"/>
                  </a:lnTo>
                  <a:lnTo>
                    <a:pt x="1088" y="295"/>
                  </a:lnTo>
                  <a:lnTo>
                    <a:pt x="1096" y="292"/>
                  </a:lnTo>
                  <a:lnTo>
                    <a:pt x="1103" y="291"/>
                  </a:lnTo>
                  <a:lnTo>
                    <a:pt x="1112" y="287"/>
                  </a:lnTo>
                  <a:lnTo>
                    <a:pt x="1119" y="284"/>
                  </a:lnTo>
                  <a:lnTo>
                    <a:pt x="1127" y="283"/>
                  </a:lnTo>
                  <a:lnTo>
                    <a:pt x="1136" y="279"/>
                  </a:lnTo>
                  <a:lnTo>
                    <a:pt x="1142" y="278"/>
                  </a:lnTo>
                  <a:lnTo>
                    <a:pt x="1152" y="275"/>
                  </a:lnTo>
                  <a:lnTo>
                    <a:pt x="1160" y="271"/>
                  </a:lnTo>
                  <a:lnTo>
                    <a:pt x="1166" y="270"/>
                  </a:lnTo>
                  <a:lnTo>
                    <a:pt x="1176" y="267"/>
                  </a:lnTo>
                  <a:lnTo>
                    <a:pt x="1182" y="265"/>
                  </a:lnTo>
                  <a:lnTo>
                    <a:pt x="1192" y="262"/>
                  </a:lnTo>
                  <a:lnTo>
                    <a:pt x="1200" y="259"/>
                  </a:lnTo>
                  <a:lnTo>
                    <a:pt x="1206" y="257"/>
                  </a:lnTo>
                  <a:lnTo>
                    <a:pt x="1216" y="254"/>
                  </a:lnTo>
                  <a:lnTo>
                    <a:pt x="1222" y="252"/>
                  </a:lnTo>
                  <a:lnTo>
                    <a:pt x="1230" y="249"/>
                  </a:lnTo>
                  <a:lnTo>
                    <a:pt x="1239" y="248"/>
                  </a:lnTo>
                  <a:lnTo>
                    <a:pt x="1246" y="244"/>
                  </a:lnTo>
                  <a:lnTo>
                    <a:pt x="1255" y="243"/>
                  </a:lnTo>
                  <a:lnTo>
                    <a:pt x="1263" y="240"/>
                  </a:lnTo>
                  <a:lnTo>
                    <a:pt x="1270" y="238"/>
                  </a:lnTo>
                  <a:lnTo>
                    <a:pt x="1279" y="235"/>
                  </a:lnTo>
                  <a:lnTo>
                    <a:pt x="1285" y="232"/>
                  </a:lnTo>
                  <a:lnTo>
                    <a:pt x="1293" y="230"/>
                  </a:lnTo>
                  <a:lnTo>
                    <a:pt x="1303" y="227"/>
                  </a:lnTo>
                  <a:lnTo>
                    <a:pt x="1309" y="225"/>
                  </a:lnTo>
                  <a:lnTo>
                    <a:pt x="1319" y="222"/>
                  </a:lnTo>
                  <a:lnTo>
                    <a:pt x="1327" y="221"/>
                  </a:lnTo>
                  <a:lnTo>
                    <a:pt x="1333" y="217"/>
                  </a:lnTo>
                  <a:lnTo>
                    <a:pt x="1343" y="216"/>
                  </a:lnTo>
                  <a:lnTo>
                    <a:pt x="1349" y="213"/>
                  </a:lnTo>
                  <a:lnTo>
                    <a:pt x="1357" y="211"/>
                  </a:lnTo>
                  <a:lnTo>
                    <a:pt x="1366" y="208"/>
                  </a:lnTo>
                  <a:lnTo>
                    <a:pt x="1373" y="206"/>
                  </a:lnTo>
                  <a:lnTo>
                    <a:pt x="1382" y="203"/>
                  </a:lnTo>
                  <a:lnTo>
                    <a:pt x="1390" y="202"/>
                  </a:lnTo>
                  <a:lnTo>
                    <a:pt x="1397" y="198"/>
                  </a:lnTo>
                  <a:lnTo>
                    <a:pt x="1406" y="197"/>
                  </a:lnTo>
                  <a:lnTo>
                    <a:pt x="1413" y="195"/>
                  </a:lnTo>
                  <a:lnTo>
                    <a:pt x="1420" y="192"/>
                  </a:lnTo>
                  <a:lnTo>
                    <a:pt x="1430" y="190"/>
                  </a:lnTo>
                  <a:lnTo>
                    <a:pt x="1436" y="187"/>
                  </a:lnTo>
                  <a:lnTo>
                    <a:pt x="1446" y="186"/>
                  </a:lnTo>
                  <a:lnTo>
                    <a:pt x="1454" y="183"/>
                  </a:lnTo>
                  <a:lnTo>
                    <a:pt x="1460" y="181"/>
                  </a:lnTo>
                  <a:lnTo>
                    <a:pt x="1470" y="178"/>
                  </a:lnTo>
                  <a:lnTo>
                    <a:pt x="1476" y="176"/>
                  </a:lnTo>
                  <a:lnTo>
                    <a:pt x="1484" y="175"/>
                  </a:lnTo>
                  <a:lnTo>
                    <a:pt x="1494" y="171"/>
                  </a:lnTo>
                  <a:lnTo>
                    <a:pt x="1500" y="170"/>
                  </a:lnTo>
                  <a:lnTo>
                    <a:pt x="1509" y="167"/>
                  </a:lnTo>
                  <a:lnTo>
                    <a:pt x="1516" y="165"/>
                  </a:lnTo>
                  <a:lnTo>
                    <a:pt x="1524" y="162"/>
                  </a:lnTo>
                  <a:lnTo>
                    <a:pt x="1533" y="160"/>
                  </a:lnTo>
                  <a:lnTo>
                    <a:pt x="1540" y="159"/>
                  </a:lnTo>
                  <a:lnTo>
                    <a:pt x="1549" y="156"/>
                  </a:lnTo>
                  <a:lnTo>
                    <a:pt x="1557" y="154"/>
                  </a:lnTo>
                  <a:lnTo>
                    <a:pt x="1563" y="151"/>
                  </a:lnTo>
                  <a:lnTo>
                    <a:pt x="1573" y="149"/>
                  </a:lnTo>
                  <a:lnTo>
                    <a:pt x="1579" y="148"/>
                  </a:lnTo>
                  <a:lnTo>
                    <a:pt x="1587" y="144"/>
                  </a:lnTo>
                  <a:lnTo>
                    <a:pt x="1597" y="143"/>
                  </a:lnTo>
                  <a:lnTo>
                    <a:pt x="1603" y="140"/>
                  </a:lnTo>
                  <a:lnTo>
                    <a:pt x="1613" y="138"/>
                  </a:lnTo>
                  <a:lnTo>
                    <a:pt x="1621" y="136"/>
                  </a:lnTo>
                  <a:lnTo>
                    <a:pt x="1627" y="133"/>
                  </a:lnTo>
                  <a:lnTo>
                    <a:pt x="1637" y="132"/>
                  </a:lnTo>
                  <a:lnTo>
                    <a:pt x="1643" y="130"/>
                  </a:lnTo>
                  <a:lnTo>
                    <a:pt x="1651" y="127"/>
                  </a:lnTo>
                  <a:lnTo>
                    <a:pt x="1660" y="125"/>
                  </a:lnTo>
                  <a:lnTo>
                    <a:pt x="1667" y="122"/>
                  </a:lnTo>
                  <a:lnTo>
                    <a:pt x="1676" y="121"/>
                  </a:lnTo>
                  <a:lnTo>
                    <a:pt x="1684" y="119"/>
                  </a:lnTo>
                  <a:lnTo>
                    <a:pt x="1691" y="116"/>
                  </a:lnTo>
                  <a:lnTo>
                    <a:pt x="1699" y="114"/>
                  </a:lnTo>
                  <a:lnTo>
                    <a:pt x="1708" y="113"/>
                  </a:lnTo>
                  <a:lnTo>
                    <a:pt x="1714" y="109"/>
                  </a:lnTo>
                  <a:lnTo>
                    <a:pt x="1722" y="108"/>
                  </a:lnTo>
                  <a:lnTo>
                    <a:pt x="1732" y="106"/>
                  </a:lnTo>
                  <a:lnTo>
                    <a:pt x="1740" y="103"/>
                  </a:lnTo>
                  <a:lnTo>
                    <a:pt x="1746" y="102"/>
                  </a:lnTo>
                  <a:lnTo>
                    <a:pt x="1756" y="100"/>
                  </a:lnTo>
                  <a:lnTo>
                    <a:pt x="1764" y="97"/>
                  </a:lnTo>
                  <a:lnTo>
                    <a:pt x="1770" y="95"/>
                  </a:lnTo>
                  <a:lnTo>
                    <a:pt x="1780" y="94"/>
                  </a:lnTo>
                  <a:lnTo>
                    <a:pt x="1787" y="92"/>
                  </a:lnTo>
                  <a:lnTo>
                    <a:pt x="1794" y="89"/>
                  </a:lnTo>
                  <a:lnTo>
                    <a:pt x="1802" y="87"/>
                  </a:lnTo>
                  <a:lnTo>
                    <a:pt x="1811" y="86"/>
                  </a:lnTo>
                  <a:lnTo>
                    <a:pt x="1818" y="82"/>
                  </a:lnTo>
                  <a:lnTo>
                    <a:pt x="1826" y="81"/>
                  </a:lnTo>
                  <a:lnTo>
                    <a:pt x="1835" y="79"/>
                  </a:lnTo>
                  <a:lnTo>
                    <a:pt x="1842" y="76"/>
                  </a:lnTo>
                  <a:lnTo>
                    <a:pt x="1849" y="75"/>
                  </a:lnTo>
                  <a:lnTo>
                    <a:pt x="1859" y="73"/>
                  </a:lnTo>
                  <a:lnTo>
                    <a:pt x="1867" y="71"/>
                  </a:lnTo>
                  <a:lnTo>
                    <a:pt x="1873" y="68"/>
                  </a:lnTo>
                  <a:lnTo>
                    <a:pt x="1883" y="67"/>
                  </a:lnTo>
                  <a:lnTo>
                    <a:pt x="1891" y="65"/>
                  </a:lnTo>
                  <a:lnTo>
                    <a:pt x="1897" y="63"/>
                  </a:lnTo>
                  <a:lnTo>
                    <a:pt x="1905" y="60"/>
                  </a:lnTo>
                  <a:lnTo>
                    <a:pt x="1915" y="59"/>
                  </a:lnTo>
                  <a:lnTo>
                    <a:pt x="1921" y="57"/>
                  </a:lnTo>
                  <a:lnTo>
                    <a:pt x="1929" y="55"/>
                  </a:lnTo>
                  <a:lnTo>
                    <a:pt x="1938" y="52"/>
                  </a:lnTo>
                  <a:lnTo>
                    <a:pt x="1945" y="51"/>
                  </a:lnTo>
                  <a:lnTo>
                    <a:pt x="1953" y="49"/>
                  </a:lnTo>
                  <a:lnTo>
                    <a:pt x="1962" y="48"/>
                  </a:lnTo>
                  <a:lnTo>
                    <a:pt x="1970" y="44"/>
                  </a:lnTo>
                  <a:lnTo>
                    <a:pt x="1977" y="43"/>
                  </a:lnTo>
                  <a:lnTo>
                    <a:pt x="1986" y="41"/>
                  </a:lnTo>
                  <a:lnTo>
                    <a:pt x="1994" y="40"/>
                  </a:lnTo>
                  <a:lnTo>
                    <a:pt x="2000" y="38"/>
                  </a:lnTo>
                  <a:lnTo>
                    <a:pt x="2010" y="35"/>
                  </a:lnTo>
                  <a:lnTo>
                    <a:pt x="2018" y="33"/>
                  </a:lnTo>
                  <a:lnTo>
                    <a:pt x="2024" y="32"/>
                  </a:lnTo>
                  <a:lnTo>
                    <a:pt x="2032" y="30"/>
                  </a:lnTo>
                  <a:lnTo>
                    <a:pt x="2042" y="27"/>
                  </a:lnTo>
                  <a:lnTo>
                    <a:pt x="2048" y="25"/>
                  </a:lnTo>
                  <a:lnTo>
                    <a:pt x="2056" y="24"/>
                  </a:lnTo>
                  <a:lnTo>
                    <a:pt x="2066" y="22"/>
                  </a:lnTo>
                  <a:lnTo>
                    <a:pt x="2072" y="21"/>
                  </a:lnTo>
                  <a:lnTo>
                    <a:pt x="2080" y="17"/>
                  </a:lnTo>
                  <a:lnTo>
                    <a:pt x="2089" y="16"/>
                  </a:lnTo>
                  <a:lnTo>
                    <a:pt x="2097" y="14"/>
                  </a:lnTo>
                  <a:lnTo>
                    <a:pt x="2104" y="13"/>
                  </a:lnTo>
                  <a:lnTo>
                    <a:pt x="2113" y="11"/>
                  </a:lnTo>
                  <a:lnTo>
                    <a:pt x="2121" y="9"/>
                  </a:lnTo>
                  <a:lnTo>
                    <a:pt x="2127" y="6"/>
                  </a:lnTo>
                  <a:lnTo>
                    <a:pt x="2137" y="5"/>
                  </a:lnTo>
                  <a:lnTo>
                    <a:pt x="2145" y="3"/>
                  </a:lnTo>
                  <a:lnTo>
                    <a:pt x="2151" y="1"/>
                  </a:lnTo>
                  <a:lnTo>
                    <a:pt x="2159" y="0"/>
                  </a:lnTo>
                  <a:lnTo>
                    <a:pt x="2169" y="95"/>
                  </a:lnTo>
                  <a:lnTo>
                    <a:pt x="2175" y="95"/>
                  </a:lnTo>
                  <a:lnTo>
                    <a:pt x="2183" y="95"/>
                  </a:lnTo>
                  <a:lnTo>
                    <a:pt x="2193" y="95"/>
                  </a:lnTo>
                  <a:lnTo>
                    <a:pt x="2201" y="97"/>
                  </a:lnTo>
                  <a:lnTo>
                    <a:pt x="2207" y="97"/>
                  </a:lnTo>
                  <a:lnTo>
                    <a:pt x="2216" y="97"/>
                  </a:lnTo>
                  <a:lnTo>
                    <a:pt x="2224" y="97"/>
                  </a:lnTo>
                  <a:lnTo>
                    <a:pt x="2231" y="97"/>
                  </a:lnTo>
                  <a:lnTo>
                    <a:pt x="2240" y="97"/>
                  </a:lnTo>
                  <a:lnTo>
                    <a:pt x="2248" y="98"/>
                  </a:lnTo>
                  <a:lnTo>
                    <a:pt x="2255" y="98"/>
                  </a:lnTo>
                  <a:lnTo>
                    <a:pt x="2263" y="98"/>
                  </a:lnTo>
                  <a:lnTo>
                    <a:pt x="2272" y="98"/>
                  </a:lnTo>
                  <a:lnTo>
                    <a:pt x="2278" y="98"/>
                  </a:lnTo>
                  <a:lnTo>
                    <a:pt x="2286" y="100"/>
                  </a:lnTo>
                  <a:lnTo>
                    <a:pt x="2296" y="100"/>
                  </a:lnTo>
                  <a:lnTo>
                    <a:pt x="2302" y="100"/>
                  </a:lnTo>
                  <a:lnTo>
                    <a:pt x="2310" y="100"/>
                  </a:lnTo>
                  <a:lnTo>
                    <a:pt x="2320" y="100"/>
                  </a:lnTo>
                  <a:lnTo>
                    <a:pt x="2328" y="102"/>
                  </a:lnTo>
                  <a:lnTo>
                    <a:pt x="2334" y="102"/>
                  </a:lnTo>
                  <a:lnTo>
                    <a:pt x="2344" y="102"/>
                  </a:lnTo>
                  <a:lnTo>
                    <a:pt x="2351" y="102"/>
                  </a:lnTo>
                  <a:lnTo>
                    <a:pt x="2358" y="102"/>
                  </a:lnTo>
                  <a:lnTo>
                    <a:pt x="2367" y="102"/>
                  </a:lnTo>
                  <a:lnTo>
                    <a:pt x="2375" y="103"/>
                  </a:lnTo>
                  <a:lnTo>
                    <a:pt x="2382" y="103"/>
                  </a:lnTo>
                  <a:lnTo>
                    <a:pt x="2390" y="103"/>
                  </a:lnTo>
                  <a:lnTo>
                    <a:pt x="2399" y="103"/>
                  </a:lnTo>
                  <a:lnTo>
                    <a:pt x="2405" y="103"/>
                  </a:lnTo>
                  <a:lnTo>
                    <a:pt x="2413" y="105"/>
                  </a:lnTo>
                  <a:lnTo>
                    <a:pt x="2423" y="105"/>
                  </a:lnTo>
                  <a:lnTo>
                    <a:pt x="2429" y="105"/>
                  </a:lnTo>
                  <a:lnTo>
                    <a:pt x="2437" y="105"/>
                  </a:lnTo>
                  <a:lnTo>
                    <a:pt x="2447" y="105"/>
                  </a:lnTo>
                  <a:lnTo>
                    <a:pt x="2455" y="106"/>
                  </a:lnTo>
                  <a:lnTo>
                    <a:pt x="2461" y="106"/>
                  </a:lnTo>
                  <a:lnTo>
                    <a:pt x="2471" y="106"/>
                  </a:lnTo>
                  <a:lnTo>
                    <a:pt x="2479" y="106"/>
                  </a:lnTo>
                  <a:lnTo>
                    <a:pt x="2485" y="106"/>
                  </a:lnTo>
                  <a:lnTo>
                    <a:pt x="2494" y="108"/>
                  </a:lnTo>
                  <a:lnTo>
                    <a:pt x="2502" y="108"/>
                  </a:lnTo>
                  <a:lnTo>
                    <a:pt x="2509" y="108"/>
                  </a:lnTo>
                  <a:lnTo>
                    <a:pt x="2517" y="108"/>
                  </a:lnTo>
                  <a:lnTo>
                    <a:pt x="2526" y="108"/>
                  </a:lnTo>
                  <a:lnTo>
                    <a:pt x="2533" y="108"/>
                  </a:lnTo>
                  <a:lnTo>
                    <a:pt x="2541" y="109"/>
                  </a:lnTo>
                  <a:lnTo>
                    <a:pt x="2550" y="109"/>
                  </a:lnTo>
                  <a:lnTo>
                    <a:pt x="2558" y="109"/>
                  </a:lnTo>
                  <a:lnTo>
                    <a:pt x="2564" y="109"/>
                  </a:lnTo>
                  <a:lnTo>
                    <a:pt x="2574" y="109"/>
                  </a:lnTo>
                  <a:lnTo>
                    <a:pt x="2582" y="111"/>
                  </a:lnTo>
                  <a:lnTo>
                    <a:pt x="2588" y="111"/>
                  </a:lnTo>
                  <a:lnTo>
                    <a:pt x="2598" y="111"/>
                  </a:lnTo>
                  <a:lnTo>
                    <a:pt x="2606" y="111"/>
                  </a:lnTo>
                  <a:lnTo>
                    <a:pt x="2612" y="111"/>
                  </a:lnTo>
                  <a:lnTo>
                    <a:pt x="2620" y="111"/>
                  </a:lnTo>
                  <a:lnTo>
                    <a:pt x="2630" y="113"/>
                  </a:lnTo>
                  <a:lnTo>
                    <a:pt x="2636" y="113"/>
                  </a:lnTo>
                  <a:lnTo>
                    <a:pt x="2644" y="113"/>
                  </a:lnTo>
                  <a:lnTo>
                    <a:pt x="2653" y="113"/>
                  </a:lnTo>
                  <a:lnTo>
                    <a:pt x="2660" y="113"/>
                  </a:lnTo>
                  <a:lnTo>
                    <a:pt x="2668" y="114"/>
                  </a:lnTo>
                  <a:lnTo>
                    <a:pt x="2677" y="114"/>
                  </a:lnTo>
                  <a:lnTo>
                    <a:pt x="2685" y="114"/>
                  </a:lnTo>
                  <a:lnTo>
                    <a:pt x="2691" y="114"/>
                  </a:lnTo>
                  <a:lnTo>
                    <a:pt x="2701" y="114"/>
                  </a:lnTo>
                  <a:lnTo>
                    <a:pt x="2709" y="116"/>
                  </a:lnTo>
                  <a:lnTo>
                    <a:pt x="2715" y="116"/>
                  </a:lnTo>
                  <a:lnTo>
                    <a:pt x="2725" y="116"/>
                  </a:lnTo>
                  <a:lnTo>
                    <a:pt x="2733" y="116"/>
                  </a:lnTo>
                  <a:lnTo>
                    <a:pt x="2739" y="116"/>
                  </a:lnTo>
                  <a:lnTo>
                    <a:pt x="2747" y="116"/>
                  </a:lnTo>
                  <a:lnTo>
                    <a:pt x="2757" y="117"/>
                  </a:lnTo>
                  <a:lnTo>
                    <a:pt x="2763" y="117"/>
                  </a:lnTo>
                  <a:lnTo>
                    <a:pt x="2771" y="117"/>
                  </a:lnTo>
                  <a:lnTo>
                    <a:pt x="2780" y="117"/>
                  </a:lnTo>
                  <a:lnTo>
                    <a:pt x="2787" y="117"/>
                  </a:lnTo>
                  <a:lnTo>
                    <a:pt x="2795" y="119"/>
                  </a:lnTo>
                  <a:lnTo>
                    <a:pt x="2804" y="119"/>
                  </a:lnTo>
                  <a:lnTo>
                    <a:pt x="2812" y="119"/>
                  </a:lnTo>
                  <a:lnTo>
                    <a:pt x="2819" y="119"/>
                  </a:lnTo>
                  <a:lnTo>
                    <a:pt x="2828" y="119"/>
                  </a:lnTo>
                  <a:lnTo>
                    <a:pt x="2836" y="119"/>
                  </a:lnTo>
                  <a:lnTo>
                    <a:pt x="2842" y="121"/>
                  </a:lnTo>
                  <a:lnTo>
                    <a:pt x="2852" y="121"/>
                  </a:lnTo>
                  <a:lnTo>
                    <a:pt x="2860" y="121"/>
                  </a:lnTo>
                  <a:lnTo>
                    <a:pt x="2866" y="121"/>
                  </a:lnTo>
                  <a:lnTo>
                    <a:pt x="2874" y="121"/>
                  </a:lnTo>
                  <a:lnTo>
                    <a:pt x="2884" y="122"/>
                  </a:lnTo>
                  <a:lnTo>
                    <a:pt x="2890" y="122"/>
                  </a:lnTo>
                  <a:lnTo>
                    <a:pt x="2898" y="122"/>
                  </a:lnTo>
                  <a:lnTo>
                    <a:pt x="2908" y="122"/>
                  </a:lnTo>
                  <a:lnTo>
                    <a:pt x="2915" y="122"/>
                  </a:lnTo>
                  <a:lnTo>
                    <a:pt x="2922" y="122"/>
                  </a:lnTo>
                  <a:lnTo>
                    <a:pt x="2931" y="124"/>
                  </a:lnTo>
                  <a:lnTo>
                    <a:pt x="2939" y="124"/>
                  </a:lnTo>
                  <a:lnTo>
                    <a:pt x="2946" y="124"/>
                  </a:lnTo>
                  <a:lnTo>
                    <a:pt x="2955" y="124"/>
                  </a:lnTo>
                  <a:lnTo>
                    <a:pt x="2963" y="124"/>
                  </a:lnTo>
                  <a:lnTo>
                    <a:pt x="2969" y="125"/>
                  </a:lnTo>
                  <a:lnTo>
                    <a:pt x="2977" y="125"/>
                  </a:lnTo>
                  <a:lnTo>
                    <a:pt x="2987" y="125"/>
                  </a:lnTo>
                  <a:lnTo>
                    <a:pt x="2993" y="125"/>
                  </a:lnTo>
                  <a:lnTo>
                    <a:pt x="3001" y="125"/>
                  </a:lnTo>
                  <a:lnTo>
                    <a:pt x="3011" y="125"/>
                  </a:lnTo>
                  <a:lnTo>
                    <a:pt x="3017" y="127"/>
                  </a:lnTo>
                  <a:lnTo>
                    <a:pt x="3025" y="127"/>
                  </a:lnTo>
                  <a:lnTo>
                    <a:pt x="3035" y="127"/>
                  </a:lnTo>
                  <a:lnTo>
                    <a:pt x="3043" y="127"/>
                  </a:lnTo>
                  <a:lnTo>
                    <a:pt x="3049" y="127"/>
                  </a:lnTo>
                  <a:lnTo>
                    <a:pt x="3058" y="129"/>
                  </a:lnTo>
                  <a:lnTo>
                    <a:pt x="3066" y="129"/>
                  </a:lnTo>
                  <a:lnTo>
                    <a:pt x="3073" y="129"/>
                  </a:lnTo>
                  <a:lnTo>
                    <a:pt x="3081" y="129"/>
                  </a:lnTo>
                  <a:lnTo>
                    <a:pt x="3089" y="129"/>
                  </a:lnTo>
                  <a:lnTo>
                    <a:pt x="3098" y="129"/>
                  </a:lnTo>
                  <a:lnTo>
                    <a:pt x="3106" y="130"/>
                  </a:lnTo>
                  <a:lnTo>
                    <a:pt x="3114" y="130"/>
                  </a:lnTo>
                  <a:lnTo>
                    <a:pt x="3120" y="130"/>
                  </a:lnTo>
                  <a:lnTo>
                    <a:pt x="3128" y="130"/>
                  </a:lnTo>
                  <a:lnTo>
                    <a:pt x="3136" y="130"/>
                  </a:lnTo>
                  <a:lnTo>
                    <a:pt x="3146" y="132"/>
                  </a:lnTo>
                  <a:lnTo>
                    <a:pt x="3154" y="132"/>
                  </a:lnTo>
                  <a:lnTo>
                    <a:pt x="3162" y="132"/>
                  </a:lnTo>
                  <a:lnTo>
                    <a:pt x="3170" y="132"/>
                  </a:lnTo>
                  <a:lnTo>
                    <a:pt x="3176" y="132"/>
                  </a:lnTo>
                  <a:lnTo>
                    <a:pt x="3184" y="132"/>
                  </a:lnTo>
                  <a:lnTo>
                    <a:pt x="3192" y="133"/>
                  </a:lnTo>
                  <a:lnTo>
                    <a:pt x="3201" y="133"/>
                  </a:lnTo>
                  <a:lnTo>
                    <a:pt x="3209" y="133"/>
                  </a:lnTo>
                  <a:lnTo>
                    <a:pt x="3217" y="133"/>
                  </a:lnTo>
                  <a:lnTo>
                    <a:pt x="3224" y="133"/>
                  </a:lnTo>
                  <a:lnTo>
                    <a:pt x="3232" y="133"/>
                  </a:lnTo>
                  <a:lnTo>
                    <a:pt x="3240" y="135"/>
                  </a:lnTo>
                  <a:lnTo>
                    <a:pt x="3249" y="135"/>
                  </a:lnTo>
                  <a:lnTo>
                    <a:pt x="3257" y="135"/>
                  </a:lnTo>
                  <a:lnTo>
                    <a:pt x="3265" y="135"/>
                  </a:lnTo>
                  <a:lnTo>
                    <a:pt x="3273" y="135"/>
                  </a:lnTo>
                  <a:lnTo>
                    <a:pt x="3279" y="136"/>
                  </a:lnTo>
                  <a:lnTo>
                    <a:pt x="3287" y="136"/>
                  </a:lnTo>
                  <a:lnTo>
                    <a:pt x="3295" y="136"/>
                  </a:lnTo>
                  <a:lnTo>
                    <a:pt x="3305" y="136"/>
                  </a:lnTo>
                  <a:lnTo>
                    <a:pt x="3313" y="136"/>
                  </a:lnTo>
                  <a:lnTo>
                    <a:pt x="3321" y="136"/>
                  </a:lnTo>
                  <a:lnTo>
                    <a:pt x="3327" y="138"/>
                  </a:lnTo>
                  <a:lnTo>
                    <a:pt x="3335" y="138"/>
                  </a:lnTo>
                  <a:lnTo>
                    <a:pt x="3343" y="138"/>
                  </a:lnTo>
                  <a:lnTo>
                    <a:pt x="3352" y="138"/>
                  </a:lnTo>
                  <a:lnTo>
                    <a:pt x="3360" y="138"/>
                  </a:lnTo>
                  <a:lnTo>
                    <a:pt x="3368" y="140"/>
                  </a:lnTo>
                  <a:lnTo>
                    <a:pt x="3375" y="140"/>
                  </a:lnTo>
                  <a:lnTo>
                    <a:pt x="3383" y="140"/>
                  </a:lnTo>
                  <a:lnTo>
                    <a:pt x="3391" y="140"/>
                  </a:lnTo>
                  <a:lnTo>
                    <a:pt x="3398" y="140"/>
                  </a:lnTo>
                  <a:lnTo>
                    <a:pt x="3408" y="140"/>
                  </a:lnTo>
                  <a:lnTo>
                    <a:pt x="3416" y="141"/>
                  </a:lnTo>
                  <a:lnTo>
                    <a:pt x="3424" y="141"/>
                  </a:lnTo>
                  <a:lnTo>
                    <a:pt x="3430" y="141"/>
                  </a:lnTo>
                  <a:lnTo>
                    <a:pt x="3438" y="141"/>
                  </a:lnTo>
                  <a:lnTo>
                    <a:pt x="3446" y="141"/>
                  </a:lnTo>
                  <a:lnTo>
                    <a:pt x="3456" y="141"/>
                  </a:lnTo>
                  <a:lnTo>
                    <a:pt x="3464" y="143"/>
                  </a:lnTo>
                  <a:lnTo>
                    <a:pt x="3472" y="143"/>
                  </a:lnTo>
                  <a:lnTo>
                    <a:pt x="3478" y="143"/>
                  </a:lnTo>
                  <a:lnTo>
                    <a:pt x="3486" y="143"/>
                  </a:lnTo>
                  <a:lnTo>
                    <a:pt x="3494" y="143"/>
                  </a:lnTo>
                  <a:lnTo>
                    <a:pt x="3503" y="143"/>
                  </a:lnTo>
                  <a:lnTo>
                    <a:pt x="3511" y="144"/>
                  </a:lnTo>
                  <a:lnTo>
                    <a:pt x="3519" y="144"/>
                  </a:lnTo>
                  <a:lnTo>
                    <a:pt x="3527" y="144"/>
                  </a:lnTo>
                  <a:lnTo>
                    <a:pt x="3533" y="144"/>
                  </a:lnTo>
                  <a:lnTo>
                    <a:pt x="3541" y="144"/>
                  </a:lnTo>
                  <a:lnTo>
                    <a:pt x="3549" y="146"/>
                  </a:lnTo>
                  <a:lnTo>
                    <a:pt x="3559" y="146"/>
                  </a:lnTo>
                  <a:lnTo>
                    <a:pt x="3567" y="146"/>
                  </a:lnTo>
                  <a:lnTo>
                    <a:pt x="3575" y="146"/>
                  </a:lnTo>
                  <a:lnTo>
                    <a:pt x="3581" y="146"/>
                  </a:lnTo>
                  <a:lnTo>
                    <a:pt x="3589" y="146"/>
                  </a:lnTo>
                  <a:lnTo>
                    <a:pt x="3597" y="148"/>
                  </a:lnTo>
                  <a:lnTo>
                    <a:pt x="3607" y="148"/>
                  </a:lnTo>
                  <a:lnTo>
                    <a:pt x="3615" y="148"/>
                  </a:lnTo>
                  <a:lnTo>
                    <a:pt x="3622" y="148"/>
                  </a:lnTo>
                  <a:lnTo>
                    <a:pt x="3630" y="148"/>
                  </a:lnTo>
                  <a:lnTo>
                    <a:pt x="3637" y="148"/>
                  </a:lnTo>
                  <a:lnTo>
                    <a:pt x="3645" y="149"/>
                  </a:lnTo>
                  <a:lnTo>
                    <a:pt x="3653" y="149"/>
                  </a:lnTo>
                  <a:lnTo>
                    <a:pt x="3662" y="149"/>
                  </a:lnTo>
                  <a:lnTo>
                    <a:pt x="3670" y="149"/>
                  </a:lnTo>
                  <a:lnTo>
                    <a:pt x="3678" y="149"/>
                  </a:lnTo>
                  <a:lnTo>
                    <a:pt x="3684" y="149"/>
                  </a:lnTo>
                  <a:lnTo>
                    <a:pt x="3692" y="151"/>
                  </a:lnTo>
                  <a:lnTo>
                    <a:pt x="3700" y="151"/>
                  </a:lnTo>
                  <a:lnTo>
                    <a:pt x="3710" y="151"/>
                  </a:lnTo>
                  <a:lnTo>
                    <a:pt x="3718" y="151"/>
                  </a:lnTo>
                  <a:lnTo>
                    <a:pt x="3726" y="151"/>
                  </a:lnTo>
                  <a:lnTo>
                    <a:pt x="3732" y="152"/>
                  </a:lnTo>
                  <a:lnTo>
                    <a:pt x="3740" y="152"/>
                  </a:lnTo>
                  <a:lnTo>
                    <a:pt x="3748" y="152"/>
                  </a:lnTo>
                  <a:lnTo>
                    <a:pt x="3756" y="152"/>
                  </a:lnTo>
                  <a:lnTo>
                    <a:pt x="3765" y="152"/>
                  </a:lnTo>
                  <a:lnTo>
                    <a:pt x="3773" y="152"/>
                  </a:lnTo>
                  <a:lnTo>
                    <a:pt x="3781" y="154"/>
                  </a:lnTo>
                  <a:lnTo>
                    <a:pt x="3788" y="154"/>
                  </a:lnTo>
                  <a:lnTo>
                    <a:pt x="3796" y="154"/>
                  </a:lnTo>
                  <a:lnTo>
                    <a:pt x="3804" y="154"/>
                  </a:lnTo>
                  <a:lnTo>
                    <a:pt x="3813" y="154"/>
                  </a:lnTo>
                  <a:lnTo>
                    <a:pt x="3821" y="154"/>
                  </a:lnTo>
                  <a:lnTo>
                    <a:pt x="3829" y="156"/>
                  </a:lnTo>
                  <a:lnTo>
                    <a:pt x="3835" y="156"/>
                  </a:lnTo>
                  <a:lnTo>
                    <a:pt x="3843" y="156"/>
                  </a:lnTo>
                  <a:lnTo>
                    <a:pt x="3851" y="156"/>
                  </a:lnTo>
                  <a:lnTo>
                    <a:pt x="3861" y="156"/>
                  </a:lnTo>
                  <a:lnTo>
                    <a:pt x="3869" y="156"/>
                  </a:lnTo>
                  <a:lnTo>
                    <a:pt x="3877" y="157"/>
                  </a:lnTo>
                  <a:lnTo>
                    <a:pt x="3885" y="157"/>
                  </a:lnTo>
                  <a:lnTo>
                    <a:pt x="3891" y="157"/>
                  </a:lnTo>
                  <a:lnTo>
                    <a:pt x="3899" y="157"/>
                  </a:lnTo>
                  <a:lnTo>
                    <a:pt x="3907" y="157"/>
                  </a:lnTo>
                  <a:lnTo>
                    <a:pt x="3916" y="157"/>
                  </a:lnTo>
                  <a:lnTo>
                    <a:pt x="3924" y="159"/>
                  </a:lnTo>
                  <a:lnTo>
                    <a:pt x="3932" y="159"/>
                  </a:lnTo>
                  <a:lnTo>
                    <a:pt x="3939" y="159"/>
                  </a:lnTo>
                  <a:lnTo>
                    <a:pt x="3947" y="159"/>
                  </a:lnTo>
                  <a:lnTo>
                    <a:pt x="3954" y="159"/>
                  </a:lnTo>
                  <a:lnTo>
                    <a:pt x="3964" y="159"/>
                  </a:lnTo>
                  <a:lnTo>
                    <a:pt x="3972" y="160"/>
                  </a:lnTo>
                  <a:lnTo>
                    <a:pt x="3980" y="160"/>
                  </a:lnTo>
                  <a:lnTo>
                    <a:pt x="3988" y="160"/>
                  </a:lnTo>
                  <a:lnTo>
                    <a:pt x="3994" y="160"/>
                  </a:lnTo>
                  <a:lnTo>
                    <a:pt x="4002" y="160"/>
                  </a:lnTo>
                  <a:lnTo>
                    <a:pt x="4010" y="162"/>
                  </a:lnTo>
                  <a:lnTo>
                    <a:pt x="4020" y="162"/>
                  </a:lnTo>
                  <a:lnTo>
                    <a:pt x="4028" y="162"/>
                  </a:lnTo>
                  <a:lnTo>
                    <a:pt x="4036" y="162"/>
                  </a:lnTo>
                  <a:lnTo>
                    <a:pt x="4042" y="162"/>
                  </a:lnTo>
                  <a:lnTo>
                    <a:pt x="4050" y="162"/>
                  </a:lnTo>
                  <a:lnTo>
                    <a:pt x="4058" y="163"/>
                  </a:lnTo>
                  <a:lnTo>
                    <a:pt x="4067" y="163"/>
                  </a:lnTo>
                  <a:lnTo>
                    <a:pt x="4075" y="163"/>
                  </a:lnTo>
                  <a:lnTo>
                    <a:pt x="4083" y="163"/>
                  </a:lnTo>
                  <a:lnTo>
                    <a:pt x="4090" y="163"/>
                  </a:lnTo>
                  <a:lnTo>
                    <a:pt x="4097" y="163"/>
                  </a:lnTo>
                  <a:lnTo>
                    <a:pt x="4105" y="16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5" name="Freeform 105"/>
            <p:cNvSpPr>
              <a:spLocks/>
            </p:cNvSpPr>
            <p:nvPr/>
          </p:nvSpPr>
          <p:spPr bwMode="auto">
            <a:xfrm>
              <a:off x="778" y="2474"/>
              <a:ext cx="4109" cy="362"/>
            </a:xfrm>
            <a:custGeom>
              <a:avLst/>
              <a:gdLst>
                <a:gd name="T0" fmla="*/ 64 w 4109"/>
                <a:gd name="T1" fmla="*/ 362 h 362"/>
                <a:gd name="T2" fmla="*/ 137 w 4109"/>
                <a:gd name="T3" fmla="*/ 362 h 362"/>
                <a:gd name="T4" fmla="*/ 209 w 4109"/>
                <a:gd name="T5" fmla="*/ 362 h 362"/>
                <a:gd name="T6" fmla="*/ 278 w 4109"/>
                <a:gd name="T7" fmla="*/ 362 h 362"/>
                <a:gd name="T8" fmla="*/ 352 w 4109"/>
                <a:gd name="T9" fmla="*/ 310 h 362"/>
                <a:gd name="T10" fmla="*/ 421 w 4109"/>
                <a:gd name="T11" fmla="*/ 295 h 362"/>
                <a:gd name="T12" fmla="*/ 493 w 4109"/>
                <a:gd name="T13" fmla="*/ 281 h 362"/>
                <a:gd name="T14" fmla="*/ 566 w 4109"/>
                <a:gd name="T15" fmla="*/ 267 h 362"/>
                <a:gd name="T16" fmla="*/ 636 w 4109"/>
                <a:gd name="T17" fmla="*/ 253 h 362"/>
                <a:gd name="T18" fmla="*/ 709 w 4109"/>
                <a:gd name="T19" fmla="*/ 240 h 362"/>
                <a:gd name="T20" fmla="*/ 779 w 4109"/>
                <a:gd name="T21" fmla="*/ 226 h 362"/>
                <a:gd name="T22" fmla="*/ 850 w 4109"/>
                <a:gd name="T23" fmla="*/ 213 h 362"/>
                <a:gd name="T24" fmla="*/ 922 w 4109"/>
                <a:gd name="T25" fmla="*/ 199 h 362"/>
                <a:gd name="T26" fmla="*/ 993 w 4109"/>
                <a:gd name="T27" fmla="*/ 186 h 362"/>
                <a:gd name="T28" fmla="*/ 1066 w 4109"/>
                <a:gd name="T29" fmla="*/ 173 h 362"/>
                <a:gd name="T30" fmla="*/ 1138 w 4109"/>
                <a:gd name="T31" fmla="*/ 160 h 362"/>
                <a:gd name="T32" fmla="*/ 1208 w 4109"/>
                <a:gd name="T33" fmla="*/ 148 h 362"/>
                <a:gd name="T34" fmla="*/ 1281 w 4109"/>
                <a:gd name="T35" fmla="*/ 135 h 362"/>
                <a:gd name="T36" fmla="*/ 1351 w 4109"/>
                <a:gd name="T37" fmla="*/ 124 h 362"/>
                <a:gd name="T38" fmla="*/ 1424 w 4109"/>
                <a:gd name="T39" fmla="*/ 111 h 362"/>
                <a:gd name="T40" fmla="*/ 1494 w 4109"/>
                <a:gd name="T41" fmla="*/ 100 h 362"/>
                <a:gd name="T42" fmla="*/ 1565 w 4109"/>
                <a:gd name="T43" fmla="*/ 87 h 362"/>
                <a:gd name="T44" fmla="*/ 1638 w 4109"/>
                <a:gd name="T45" fmla="*/ 76 h 362"/>
                <a:gd name="T46" fmla="*/ 1710 w 4109"/>
                <a:gd name="T47" fmla="*/ 65 h 362"/>
                <a:gd name="T48" fmla="*/ 1780 w 4109"/>
                <a:gd name="T49" fmla="*/ 54 h 362"/>
                <a:gd name="T50" fmla="*/ 1851 w 4109"/>
                <a:gd name="T51" fmla="*/ 43 h 362"/>
                <a:gd name="T52" fmla="*/ 1923 w 4109"/>
                <a:gd name="T53" fmla="*/ 32 h 362"/>
                <a:gd name="T54" fmla="*/ 1996 w 4109"/>
                <a:gd name="T55" fmla="*/ 21 h 362"/>
                <a:gd name="T56" fmla="*/ 2067 w 4109"/>
                <a:gd name="T57" fmla="*/ 11 h 362"/>
                <a:gd name="T58" fmla="*/ 2137 w 4109"/>
                <a:gd name="T59" fmla="*/ 0 h 362"/>
                <a:gd name="T60" fmla="*/ 2209 w 4109"/>
                <a:gd name="T61" fmla="*/ 44 h 362"/>
                <a:gd name="T62" fmla="*/ 2280 w 4109"/>
                <a:gd name="T63" fmla="*/ 46 h 362"/>
                <a:gd name="T64" fmla="*/ 2353 w 4109"/>
                <a:gd name="T65" fmla="*/ 48 h 362"/>
                <a:gd name="T66" fmla="*/ 2425 w 4109"/>
                <a:gd name="T67" fmla="*/ 49 h 362"/>
                <a:gd name="T68" fmla="*/ 2495 w 4109"/>
                <a:gd name="T69" fmla="*/ 49 h 362"/>
                <a:gd name="T70" fmla="*/ 2566 w 4109"/>
                <a:gd name="T71" fmla="*/ 51 h 362"/>
                <a:gd name="T72" fmla="*/ 2638 w 4109"/>
                <a:gd name="T73" fmla="*/ 52 h 362"/>
                <a:gd name="T74" fmla="*/ 2711 w 4109"/>
                <a:gd name="T75" fmla="*/ 54 h 362"/>
                <a:gd name="T76" fmla="*/ 2782 w 4109"/>
                <a:gd name="T77" fmla="*/ 56 h 362"/>
                <a:gd name="T78" fmla="*/ 2852 w 4109"/>
                <a:gd name="T79" fmla="*/ 57 h 362"/>
                <a:gd name="T80" fmla="*/ 2924 w 4109"/>
                <a:gd name="T81" fmla="*/ 59 h 362"/>
                <a:gd name="T82" fmla="*/ 2995 w 4109"/>
                <a:gd name="T83" fmla="*/ 60 h 362"/>
                <a:gd name="T84" fmla="*/ 3067 w 4109"/>
                <a:gd name="T85" fmla="*/ 62 h 362"/>
                <a:gd name="T86" fmla="*/ 3140 w 4109"/>
                <a:gd name="T87" fmla="*/ 64 h 362"/>
                <a:gd name="T88" fmla="*/ 3210 w 4109"/>
                <a:gd name="T89" fmla="*/ 65 h 362"/>
                <a:gd name="T90" fmla="*/ 3283 w 4109"/>
                <a:gd name="T91" fmla="*/ 65 h 362"/>
                <a:gd name="T92" fmla="*/ 3353 w 4109"/>
                <a:gd name="T93" fmla="*/ 67 h 362"/>
                <a:gd name="T94" fmla="*/ 3424 w 4109"/>
                <a:gd name="T95" fmla="*/ 68 h 362"/>
                <a:gd name="T96" fmla="*/ 3497 w 4109"/>
                <a:gd name="T97" fmla="*/ 70 h 362"/>
                <a:gd name="T98" fmla="*/ 3567 w 4109"/>
                <a:gd name="T99" fmla="*/ 71 h 362"/>
                <a:gd name="T100" fmla="*/ 3640 w 4109"/>
                <a:gd name="T101" fmla="*/ 73 h 362"/>
                <a:gd name="T102" fmla="*/ 3710 w 4109"/>
                <a:gd name="T103" fmla="*/ 75 h 362"/>
                <a:gd name="T104" fmla="*/ 3782 w 4109"/>
                <a:gd name="T105" fmla="*/ 76 h 362"/>
                <a:gd name="T106" fmla="*/ 3855 w 4109"/>
                <a:gd name="T107" fmla="*/ 76 h 362"/>
                <a:gd name="T108" fmla="*/ 3925 w 4109"/>
                <a:gd name="T109" fmla="*/ 78 h 362"/>
                <a:gd name="T110" fmla="*/ 3998 w 4109"/>
                <a:gd name="T111" fmla="*/ 79 h 362"/>
                <a:gd name="T112" fmla="*/ 4068 w 4109"/>
                <a:gd name="T113" fmla="*/ 81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109" h="362">
                  <a:moveTo>
                    <a:pt x="0" y="362"/>
                  </a:moveTo>
                  <a:lnTo>
                    <a:pt x="10" y="362"/>
                  </a:lnTo>
                  <a:lnTo>
                    <a:pt x="16" y="362"/>
                  </a:lnTo>
                  <a:lnTo>
                    <a:pt x="26" y="362"/>
                  </a:lnTo>
                  <a:lnTo>
                    <a:pt x="32" y="362"/>
                  </a:lnTo>
                  <a:lnTo>
                    <a:pt x="42" y="362"/>
                  </a:lnTo>
                  <a:lnTo>
                    <a:pt x="48" y="362"/>
                  </a:lnTo>
                  <a:lnTo>
                    <a:pt x="58" y="362"/>
                  </a:lnTo>
                  <a:lnTo>
                    <a:pt x="64" y="362"/>
                  </a:lnTo>
                  <a:lnTo>
                    <a:pt x="74" y="362"/>
                  </a:lnTo>
                  <a:lnTo>
                    <a:pt x="80" y="362"/>
                  </a:lnTo>
                  <a:lnTo>
                    <a:pt x="89" y="362"/>
                  </a:lnTo>
                  <a:lnTo>
                    <a:pt x="96" y="362"/>
                  </a:lnTo>
                  <a:lnTo>
                    <a:pt x="105" y="362"/>
                  </a:lnTo>
                  <a:lnTo>
                    <a:pt x="112" y="362"/>
                  </a:lnTo>
                  <a:lnTo>
                    <a:pt x="120" y="362"/>
                  </a:lnTo>
                  <a:lnTo>
                    <a:pt x="129" y="362"/>
                  </a:lnTo>
                  <a:lnTo>
                    <a:pt x="137" y="362"/>
                  </a:lnTo>
                  <a:lnTo>
                    <a:pt x="145" y="362"/>
                  </a:lnTo>
                  <a:lnTo>
                    <a:pt x="153" y="362"/>
                  </a:lnTo>
                  <a:lnTo>
                    <a:pt x="161" y="362"/>
                  </a:lnTo>
                  <a:lnTo>
                    <a:pt x="169" y="362"/>
                  </a:lnTo>
                  <a:lnTo>
                    <a:pt x="177" y="362"/>
                  </a:lnTo>
                  <a:lnTo>
                    <a:pt x="185" y="362"/>
                  </a:lnTo>
                  <a:lnTo>
                    <a:pt x="193" y="362"/>
                  </a:lnTo>
                  <a:lnTo>
                    <a:pt x="201" y="362"/>
                  </a:lnTo>
                  <a:lnTo>
                    <a:pt x="209" y="362"/>
                  </a:lnTo>
                  <a:lnTo>
                    <a:pt x="216" y="362"/>
                  </a:lnTo>
                  <a:lnTo>
                    <a:pt x="223" y="362"/>
                  </a:lnTo>
                  <a:lnTo>
                    <a:pt x="231" y="362"/>
                  </a:lnTo>
                  <a:lnTo>
                    <a:pt x="239" y="362"/>
                  </a:lnTo>
                  <a:lnTo>
                    <a:pt x="247" y="362"/>
                  </a:lnTo>
                  <a:lnTo>
                    <a:pt x="255" y="362"/>
                  </a:lnTo>
                  <a:lnTo>
                    <a:pt x="263" y="362"/>
                  </a:lnTo>
                  <a:lnTo>
                    <a:pt x="271" y="362"/>
                  </a:lnTo>
                  <a:lnTo>
                    <a:pt x="278" y="362"/>
                  </a:lnTo>
                  <a:lnTo>
                    <a:pt x="288" y="362"/>
                  </a:lnTo>
                  <a:lnTo>
                    <a:pt x="296" y="362"/>
                  </a:lnTo>
                  <a:lnTo>
                    <a:pt x="304" y="362"/>
                  </a:lnTo>
                  <a:lnTo>
                    <a:pt x="312" y="318"/>
                  </a:lnTo>
                  <a:lnTo>
                    <a:pt x="318" y="316"/>
                  </a:lnTo>
                  <a:lnTo>
                    <a:pt x="328" y="314"/>
                  </a:lnTo>
                  <a:lnTo>
                    <a:pt x="334" y="313"/>
                  </a:lnTo>
                  <a:lnTo>
                    <a:pt x="342" y="311"/>
                  </a:lnTo>
                  <a:lnTo>
                    <a:pt x="352" y="310"/>
                  </a:lnTo>
                  <a:lnTo>
                    <a:pt x="359" y="308"/>
                  </a:lnTo>
                  <a:lnTo>
                    <a:pt x="367" y="307"/>
                  </a:lnTo>
                  <a:lnTo>
                    <a:pt x="374" y="305"/>
                  </a:lnTo>
                  <a:lnTo>
                    <a:pt x="382" y="303"/>
                  </a:lnTo>
                  <a:lnTo>
                    <a:pt x="390" y="302"/>
                  </a:lnTo>
                  <a:lnTo>
                    <a:pt x="398" y="300"/>
                  </a:lnTo>
                  <a:lnTo>
                    <a:pt x="406" y="299"/>
                  </a:lnTo>
                  <a:lnTo>
                    <a:pt x="413" y="297"/>
                  </a:lnTo>
                  <a:lnTo>
                    <a:pt x="421" y="295"/>
                  </a:lnTo>
                  <a:lnTo>
                    <a:pt x="429" y="294"/>
                  </a:lnTo>
                  <a:lnTo>
                    <a:pt x="437" y="292"/>
                  </a:lnTo>
                  <a:lnTo>
                    <a:pt x="445" y="291"/>
                  </a:lnTo>
                  <a:lnTo>
                    <a:pt x="453" y="289"/>
                  </a:lnTo>
                  <a:lnTo>
                    <a:pt x="463" y="287"/>
                  </a:lnTo>
                  <a:lnTo>
                    <a:pt x="471" y="286"/>
                  </a:lnTo>
                  <a:lnTo>
                    <a:pt x="477" y="284"/>
                  </a:lnTo>
                  <a:lnTo>
                    <a:pt x="487" y="283"/>
                  </a:lnTo>
                  <a:lnTo>
                    <a:pt x="493" y="281"/>
                  </a:lnTo>
                  <a:lnTo>
                    <a:pt x="502" y="280"/>
                  </a:lnTo>
                  <a:lnTo>
                    <a:pt x="509" y="278"/>
                  </a:lnTo>
                  <a:lnTo>
                    <a:pt x="518" y="276"/>
                  </a:lnTo>
                  <a:lnTo>
                    <a:pt x="525" y="275"/>
                  </a:lnTo>
                  <a:lnTo>
                    <a:pt x="534" y="273"/>
                  </a:lnTo>
                  <a:lnTo>
                    <a:pt x="541" y="272"/>
                  </a:lnTo>
                  <a:lnTo>
                    <a:pt x="550" y="270"/>
                  </a:lnTo>
                  <a:lnTo>
                    <a:pt x="556" y="268"/>
                  </a:lnTo>
                  <a:lnTo>
                    <a:pt x="566" y="267"/>
                  </a:lnTo>
                  <a:lnTo>
                    <a:pt x="572" y="265"/>
                  </a:lnTo>
                  <a:lnTo>
                    <a:pt x="582" y="264"/>
                  </a:lnTo>
                  <a:lnTo>
                    <a:pt x="588" y="262"/>
                  </a:lnTo>
                  <a:lnTo>
                    <a:pt x="598" y="260"/>
                  </a:lnTo>
                  <a:lnTo>
                    <a:pt x="604" y="259"/>
                  </a:lnTo>
                  <a:lnTo>
                    <a:pt x="614" y="257"/>
                  </a:lnTo>
                  <a:lnTo>
                    <a:pt x="620" y="256"/>
                  </a:lnTo>
                  <a:lnTo>
                    <a:pt x="630" y="254"/>
                  </a:lnTo>
                  <a:lnTo>
                    <a:pt x="636" y="253"/>
                  </a:lnTo>
                  <a:lnTo>
                    <a:pt x="645" y="251"/>
                  </a:lnTo>
                  <a:lnTo>
                    <a:pt x="652" y="249"/>
                  </a:lnTo>
                  <a:lnTo>
                    <a:pt x="660" y="248"/>
                  </a:lnTo>
                  <a:lnTo>
                    <a:pt x="669" y="246"/>
                  </a:lnTo>
                  <a:lnTo>
                    <a:pt x="677" y="245"/>
                  </a:lnTo>
                  <a:lnTo>
                    <a:pt x="684" y="243"/>
                  </a:lnTo>
                  <a:lnTo>
                    <a:pt x="692" y="243"/>
                  </a:lnTo>
                  <a:lnTo>
                    <a:pt x="701" y="241"/>
                  </a:lnTo>
                  <a:lnTo>
                    <a:pt x="709" y="240"/>
                  </a:lnTo>
                  <a:lnTo>
                    <a:pt x="715" y="238"/>
                  </a:lnTo>
                  <a:lnTo>
                    <a:pt x="723" y="237"/>
                  </a:lnTo>
                  <a:lnTo>
                    <a:pt x="733" y="235"/>
                  </a:lnTo>
                  <a:lnTo>
                    <a:pt x="741" y="233"/>
                  </a:lnTo>
                  <a:lnTo>
                    <a:pt x="747" y="232"/>
                  </a:lnTo>
                  <a:lnTo>
                    <a:pt x="755" y="230"/>
                  </a:lnTo>
                  <a:lnTo>
                    <a:pt x="765" y="229"/>
                  </a:lnTo>
                  <a:lnTo>
                    <a:pt x="773" y="227"/>
                  </a:lnTo>
                  <a:lnTo>
                    <a:pt x="779" y="226"/>
                  </a:lnTo>
                  <a:lnTo>
                    <a:pt x="787" y="224"/>
                  </a:lnTo>
                  <a:lnTo>
                    <a:pt x="796" y="222"/>
                  </a:lnTo>
                  <a:lnTo>
                    <a:pt x="804" y="221"/>
                  </a:lnTo>
                  <a:lnTo>
                    <a:pt x="812" y="219"/>
                  </a:lnTo>
                  <a:lnTo>
                    <a:pt x="819" y="218"/>
                  </a:lnTo>
                  <a:lnTo>
                    <a:pt x="827" y="216"/>
                  </a:lnTo>
                  <a:lnTo>
                    <a:pt x="836" y="214"/>
                  </a:lnTo>
                  <a:lnTo>
                    <a:pt x="844" y="214"/>
                  </a:lnTo>
                  <a:lnTo>
                    <a:pt x="850" y="213"/>
                  </a:lnTo>
                  <a:lnTo>
                    <a:pt x="858" y="211"/>
                  </a:lnTo>
                  <a:lnTo>
                    <a:pt x="868" y="210"/>
                  </a:lnTo>
                  <a:lnTo>
                    <a:pt x="876" y="208"/>
                  </a:lnTo>
                  <a:lnTo>
                    <a:pt x="882" y="206"/>
                  </a:lnTo>
                  <a:lnTo>
                    <a:pt x="890" y="205"/>
                  </a:lnTo>
                  <a:lnTo>
                    <a:pt x="900" y="203"/>
                  </a:lnTo>
                  <a:lnTo>
                    <a:pt x="908" y="202"/>
                  </a:lnTo>
                  <a:lnTo>
                    <a:pt x="914" y="200"/>
                  </a:lnTo>
                  <a:lnTo>
                    <a:pt x="922" y="199"/>
                  </a:lnTo>
                  <a:lnTo>
                    <a:pt x="931" y="197"/>
                  </a:lnTo>
                  <a:lnTo>
                    <a:pt x="939" y="195"/>
                  </a:lnTo>
                  <a:lnTo>
                    <a:pt x="946" y="195"/>
                  </a:lnTo>
                  <a:lnTo>
                    <a:pt x="954" y="194"/>
                  </a:lnTo>
                  <a:lnTo>
                    <a:pt x="963" y="192"/>
                  </a:lnTo>
                  <a:lnTo>
                    <a:pt x="971" y="191"/>
                  </a:lnTo>
                  <a:lnTo>
                    <a:pt x="977" y="189"/>
                  </a:lnTo>
                  <a:lnTo>
                    <a:pt x="985" y="187"/>
                  </a:lnTo>
                  <a:lnTo>
                    <a:pt x="993" y="186"/>
                  </a:lnTo>
                  <a:lnTo>
                    <a:pt x="1003" y="184"/>
                  </a:lnTo>
                  <a:lnTo>
                    <a:pt x="1011" y="183"/>
                  </a:lnTo>
                  <a:lnTo>
                    <a:pt x="1017" y="181"/>
                  </a:lnTo>
                  <a:lnTo>
                    <a:pt x="1027" y="181"/>
                  </a:lnTo>
                  <a:lnTo>
                    <a:pt x="1033" y="179"/>
                  </a:lnTo>
                  <a:lnTo>
                    <a:pt x="1041" y="178"/>
                  </a:lnTo>
                  <a:lnTo>
                    <a:pt x="1051" y="176"/>
                  </a:lnTo>
                  <a:lnTo>
                    <a:pt x="1057" y="175"/>
                  </a:lnTo>
                  <a:lnTo>
                    <a:pt x="1066" y="173"/>
                  </a:lnTo>
                  <a:lnTo>
                    <a:pt x="1074" y="172"/>
                  </a:lnTo>
                  <a:lnTo>
                    <a:pt x="1081" y="170"/>
                  </a:lnTo>
                  <a:lnTo>
                    <a:pt x="1090" y="168"/>
                  </a:lnTo>
                  <a:lnTo>
                    <a:pt x="1097" y="167"/>
                  </a:lnTo>
                  <a:lnTo>
                    <a:pt x="1105" y="167"/>
                  </a:lnTo>
                  <a:lnTo>
                    <a:pt x="1114" y="165"/>
                  </a:lnTo>
                  <a:lnTo>
                    <a:pt x="1120" y="164"/>
                  </a:lnTo>
                  <a:lnTo>
                    <a:pt x="1130" y="162"/>
                  </a:lnTo>
                  <a:lnTo>
                    <a:pt x="1138" y="160"/>
                  </a:lnTo>
                  <a:lnTo>
                    <a:pt x="1144" y="159"/>
                  </a:lnTo>
                  <a:lnTo>
                    <a:pt x="1154" y="157"/>
                  </a:lnTo>
                  <a:lnTo>
                    <a:pt x="1160" y="156"/>
                  </a:lnTo>
                  <a:lnTo>
                    <a:pt x="1170" y="156"/>
                  </a:lnTo>
                  <a:lnTo>
                    <a:pt x="1178" y="154"/>
                  </a:lnTo>
                  <a:lnTo>
                    <a:pt x="1184" y="152"/>
                  </a:lnTo>
                  <a:lnTo>
                    <a:pt x="1194" y="151"/>
                  </a:lnTo>
                  <a:lnTo>
                    <a:pt x="1200" y="149"/>
                  </a:lnTo>
                  <a:lnTo>
                    <a:pt x="1208" y="148"/>
                  </a:lnTo>
                  <a:lnTo>
                    <a:pt x="1217" y="146"/>
                  </a:lnTo>
                  <a:lnTo>
                    <a:pt x="1224" y="145"/>
                  </a:lnTo>
                  <a:lnTo>
                    <a:pt x="1233" y="145"/>
                  </a:lnTo>
                  <a:lnTo>
                    <a:pt x="1241" y="143"/>
                  </a:lnTo>
                  <a:lnTo>
                    <a:pt x="1248" y="141"/>
                  </a:lnTo>
                  <a:lnTo>
                    <a:pt x="1257" y="140"/>
                  </a:lnTo>
                  <a:lnTo>
                    <a:pt x="1263" y="138"/>
                  </a:lnTo>
                  <a:lnTo>
                    <a:pt x="1271" y="137"/>
                  </a:lnTo>
                  <a:lnTo>
                    <a:pt x="1281" y="135"/>
                  </a:lnTo>
                  <a:lnTo>
                    <a:pt x="1287" y="135"/>
                  </a:lnTo>
                  <a:lnTo>
                    <a:pt x="1297" y="133"/>
                  </a:lnTo>
                  <a:lnTo>
                    <a:pt x="1305" y="132"/>
                  </a:lnTo>
                  <a:lnTo>
                    <a:pt x="1311" y="130"/>
                  </a:lnTo>
                  <a:lnTo>
                    <a:pt x="1321" y="129"/>
                  </a:lnTo>
                  <a:lnTo>
                    <a:pt x="1327" y="127"/>
                  </a:lnTo>
                  <a:lnTo>
                    <a:pt x="1335" y="125"/>
                  </a:lnTo>
                  <a:lnTo>
                    <a:pt x="1344" y="125"/>
                  </a:lnTo>
                  <a:lnTo>
                    <a:pt x="1351" y="124"/>
                  </a:lnTo>
                  <a:lnTo>
                    <a:pt x="1360" y="122"/>
                  </a:lnTo>
                  <a:lnTo>
                    <a:pt x="1368" y="121"/>
                  </a:lnTo>
                  <a:lnTo>
                    <a:pt x="1375" y="119"/>
                  </a:lnTo>
                  <a:lnTo>
                    <a:pt x="1384" y="118"/>
                  </a:lnTo>
                  <a:lnTo>
                    <a:pt x="1391" y="118"/>
                  </a:lnTo>
                  <a:lnTo>
                    <a:pt x="1398" y="116"/>
                  </a:lnTo>
                  <a:lnTo>
                    <a:pt x="1408" y="114"/>
                  </a:lnTo>
                  <a:lnTo>
                    <a:pt x="1414" y="113"/>
                  </a:lnTo>
                  <a:lnTo>
                    <a:pt x="1424" y="111"/>
                  </a:lnTo>
                  <a:lnTo>
                    <a:pt x="1432" y="110"/>
                  </a:lnTo>
                  <a:lnTo>
                    <a:pt x="1438" y="110"/>
                  </a:lnTo>
                  <a:lnTo>
                    <a:pt x="1448" y="108"/>
                  </a:lnTo>
                  <a:lnTo>
                    <a:pt x="1454" y="106"/>
                  </a:lnTo>
                  <a:lnTo>
                    <a:pt x="1462" y="105"/>
                  </a:lnTo>
                  <a:lnTo>
                    <a:pt x="1472" y="103"/>
                  </a:lnTo>
                  <a:lnTo>
                    <a:pt x="1478" y="102"/>
                  </a:lnTo>
                  <a:lnTo>
                    <a:pt x="1487" y="102"/>
                  </a:lnTo>
                  <a:lnTo>
                    <a:pt x="1494" y="100"/>
                  </a:lnTo>
                  <a:lnTo>
                    <a:pt x="1502" y="98"/>
                  </a:lnTo>
                  <a:lnTo>
                    <a:pt x="1511" y="97"/>
                  </a:lnTo>
                  <a:lnTo>
                    <a:pt x="1518" y="95"/>
                  </a:lnTo>
                  <a:lnTo>
                    <a:pt x="1527" y="94"/>
                  </a:lnTo>
                  <a:lnTo>
                    <a:pt x="1535" y="94"/>
                  </a:lnTo>
                  <a:lnTo>
                    <a:pt x="1541" y="92"/>
                  </a:lnTo>
                  <a:lnTo>
                    <a:pt x="1551" y="91"/>
                  </a:lnTo>
                  <a:lnTo>
                    <a:pt x="1557" y="89"/>
                  </a:lnTo>
                  <a:lnTo>
                    <a:pt x="1565" y="87"/>
                  </a:lnTo>
                  <a:lnTo>
                    <a:pt x="1575" y="87"/>
                  </a:lnTo>
                  <a:lnTo>
                    <a:pt x="1581" y="86"/>
                  </a:lnTo>
                  <a:lnTo>
                    <a:pt x="1591" y="84"/>
                  </a:lnTo>
                  <a:lnTo>
                    <a:pt x="1599" y="83"/>
                  </a:lnTo>
                  <a:lnTo>
                    <a:pt x="1605" y="81"/>
                  </a:lnTo>
                  <a:lnTo>
                    <a:pt x="1615" y="81"/>
                  </a:lnTo>
                  <a:lnTo>
                    <a:pt x="1621" y="79"/>
                  </a:lnTo>
                  <a:lnTo>
                    <a:pt x="1629" y="78"/>
                  </a:lnTo>
                  <a:lnTo>
                    <a:pt x="1638" y="76"/>
                  </a:lnTo>
                  <a:lnTo>
                    <a:pt x="1645" y="75"/>
                  </a:lnTo>
                  <a:lnTo>
                    <a:pt x="1654" y="75"/>
                  </a:lnTo>
                  <a:lnTo>
                    <a:pt x="1662" y="73"/>
                  </a:lnTo>
                  <a:lnTo>
                    <a:pt x="1669" y="71"/>
                  </a:lnTo>
                  <a:lnTo>
                    <a:pt x="1677" y="70"/>
                  </a:lnTo>
                  <a:lnTo>
                    <a:pt x="1686" y="68"/>
                  </a:lnTo>
                  <a:lnTo>
                    <a:pt x="1692" y="68"/>
                  </a:lnTo>
                  <a:lnTo>
                    <a:pt x="1700" y="67"/>
                  </a:lnTo>
                  <a:lnTo>
                    <a:pt x="1710" y="65"/>
                  </a:lnTo>
                  <a:lnTo>
                    <a:pt x="1718" y="64"/>
                  </a:lnTo>
                  <a:lnTo>
                    <a:pt x="1724" y="62"/>
                  </a:lnTo>
                  <a:lnTo>
                    <a:pt x="1734" y="62"/>
                  </a:lnTo>
                  <a:lnTo>
                    <a:pt x="1742" y="60"/>
                  </a:lnTo>
                  <a:lnTo>
                    <a:pt x="1748" y="59"/>
                  </a:lnTo>
                  <a:lnTo>
                    <a:pt x="1758" y="57"/>
                  </a:lnTo>
                  <a:lnTo>
                    <a:pt x="1765" y="56"/>
                  </a:lnTo>
                  <a:lnTo>
                    <a:pt x="1772" y="56"/>
                  </a:lnTo>
                  <a:lnTo>
                    <a:pt x="1780" y="54"/>
                  </a:lnTo>
                  <a:lnTo>
                    <a:pt x="1789" y="52"/>
                  </a:lnTo>
                  <a:lnTo>
                    <a:pt x="1796" y="51"/>
                  </a:lnTo>
                  <a:lnTo>
                    <a:pt x="1804" y="51"/>
                  </a:lnTo>
                  <a:lnTo>
                    <a:pt x="1813" y="49"/>
                  </a:lnTo>
                  <a:lnTo>
                    <a:pt x="1820" y="48"/>
                  </a:lnTo>
                  <a:lnTo>
                    <a:pt x="1827" y="46"/>
                  </a:lnTo>
                  <a:lnTo>
                    <a:pt x="1837" y="46"/>
                  </a:lnTo>
                  <a:lnTo>
                    <a:pt x="1845" y="44"/>
                  </a:lnTo>
                  <a:lnTo>
                    <a:pt x="1851" y="43"/>
                  </a:lnTo>
                  <a:lnTo>
                    <a:pt x="1861" y="41"/>
                  </a:lnTo>
                  <a:lnTo>
                    <a:pt x="1869" y="40"/>
                  </a:lnTo>
                  <a:lnTo>
                    <a:pt x="1875" y="40"/>
                  </a:lnTo>
                  <a:lnTo>
                    <a:pt x="1883" y="38"/>
                  </a:lnTo>
                  <a:lnTo>
                    <a:pt x="1893" y="37"/>
                  </a:lnTo>
                  <a:lnTo>
                    <a:pt x="1899" y="35"/>
                  </a:lnTo>
                  <a:lnTo>
                    <a:pt x="1907" y="35"/>
                  </a:lnTo>
                  <a:lnTo>
                    <a:pt x="1916" y="33"/>
                  </a:lnTo>
                  <a:lnTo>
                    <a:pt x="1923" y="32"/>
                  </a:lnTo>
                  <a:lnTo>
                    <a:pt x="1931" y="30"/>
                  </a:lnTo>
                  <a:lnTo>
                    <a:pt x="1940" y="30"/>
                  </a:lnTo>
                  <a:lnTo>
                    <a:pt x="1948" y="29"/>
                  </a:lnTo>
                  <a:lnTo>
                    <a:pt x="1955" y="27"/>
                  </a:lnTo>
                  <a:lnTo>
                    <a:pt x="1964" y="25"/>
                  </a:lnTo>
                  <a:lnTo>
                    <a:pt x="1972" y="25"/>
                  </a:lnTo>
                  <a:lnTo>
                    <a:pt x="1978" y="24"/>
                  </a:lnTo>
                  <a:lnTo>
                    <a:pt x="1988" y="22"/>
                  </a:lnTo>
                  <a:lnTo>
                    <a:pt x="1996" y="21"/>
                  </a:lnTo>
                  <a:lnTo>
                    <a:pt x="2002" y="21"/>
                  </a:lnTo>
                  <a:lnTo>
                    <a:pt x="2010" y="19"/>
                  </a:lnTo>
                  <a:lnTo>
                    <a:pt x="2020" y="17"/>
                  </a:lnTo>
                  <a:lnTo>
                    <a:pt x="2026" y="16"/>
                  </a:lnTo>
                  <a:lnTo>
                    <a:pt x="2034" y="16"/>
                  </a:lnTo>
                  <a:lnTo>
                    <a:pt x="2044" y="14"/>
                  </a:lnTo>
                  <a:lnTo>
                    <a:pt x="2050" y="13"/>
                  </a:lnTo>
                  <a:lnTo>
                    <a:pt x="2058" y="11"/>
                  </a:lnTo>
                  <a:lnTo>
                    <a:pt x="2067" y="11"/>
                  </a:lnTo>
                  <a:lnTo>
                    <a:pt x="2075" y="10"/>
                  </a:lnTo>
                  <a:lnTo>
                    <a:pt x="2082" y="8"/>
                  </a:lnTo>
                  <a:lnTo>
                    <a:pt x="2091" y="6"/>
                  </a:lnTo>
                  <a:lnTo>
                    <a:pt x="2099" y="6"/>
                  </a:lnTo>
                  <a:lnTo>
                    <a:pt x="2105" y="5"/>
                  </a:lnTo>
                  <a:lnTo>
                    <a:pt x="2115" y="3"/>
                  </a:lnTo>
                  <a:lnTo>
                    <a:pt x="2123" y="3"/>
                  </a:lnTo>
                  <a:lnTo>
                    <a:pt x="2129" y="2"/>
                  </a:lnTo>
                  <a:lnTo>
                    <a:pt x="2137" y="0"/>
                  </a:lnTo>
                  <a:lnTo>
                    <a:pt x="2147" y="43"/>
                  </a:lnTo>
                  <a:lnTo>
                    <a:pt x="2153" y="43"/>
                  </a:lnTo>
                  <a:lnTo>
                    <a:pt x="2161" y="43"/>
                  </a:lnTo>
                  <a:lnTo>
                    <a:pt x="2171" y="43"/>
                  </a:lnTo>
                  <a:lnTo>
                    <a:pt x="2179" y="43"/>
                  </a:lnTo>
                  <a:lnTo>
                    <a:pt x="2185" y="43"/>
                  </a:lnTo>
                  <a:lnTo>
                    <a:pt x="2194" y="44"/>
                  </a:lnTo>
                  <a:lnTo>
                    <a:pt x="2202" y="44"/>
                  </a:lnTo>
                  <a:lnTo>
                    <a:pt x="2209" y="44"/>
                  </a:lnTo>
                  <a:lnTo>
                    <a:pt x="2218" y="44"/>
                  </a:lnTo>
                  <a:lnTo>
                    <a:pt x="2226" y="44"/>
                  </a:lnTo>
                  <a:lnTo>
                    <a:pt x="2233" y="44"/>
                  </a:lnTo>
                  <a:lnTo>
                    <a:pt x="2241" y="44"/>
                  </a:lnTo>
                  <a:lnTo>
                    <a:pt x="2250" y="44"/>
                  </a:lnTo>
                  <a:lnTo>
                    <a:pt x="2256" y="44"/>
                  </a:lnTo>
                  <a:lnTo>
                    <a:pt x="2264" y="44"/>
                  </a:lnTo>
                  <a:lnTo>
                    <a:pt x="2274" y="46"/>
                  </a:lnTo>
                  <a:lnTo>
                    <a:pt x="2280" y="46"/>
                  </a:lnTo>
                  <a:lnTo>
                    <a:pt x="2288" y="46"/>
                  </a:lnTo>
                  <a:lnTo>
                    <a:pt x="2298" y="46"/>
                  </a:lnTo>
                  <a:lnTo>
                    <a:pt x="2306" y="46"/>
                  </a:lnTo>
                  <a:lnTo>
                    <a:pt x="2312" y="46"/>
                  </a:lnTo>
                  <a:lnTo>
                    <a:pt x="2322" y="46"/>
                  </a:lnTo>
                  <a:lnTo>
                    <a:pt x="2329" y="46"/>
                  </a:lnTo>
                  <a:lnTo>
                    <a:pt x="2336" y="46"/>
                  </a:lnTo>
                  <a:lnTo>
                    <a:pt x="2345" y="48"/>
                  </a:lnTo>
                  <a:lnTo>
                    <a:pt x="2353" y="48"/>
                  </a:lnTo>
                  <a:lnTo>
                    <a:pt x="2360" y="48"/>
                  </a:lnTo>
                  <a:lnTo>
                    <a:pt x="2368" y="48"/>
                  </a:lnTo>
                  <a:lnTo>
                    <a:pt x="2377" y="48"/>
                  </a:lnTo>
                  <a:lnTo>
                    <a:pt x="2383" y="48"/>
                  </a:lnTo>
                  <a:lnTo>
                    <a:pt x="2391" y="48"/>
                  </a:lnTo>
                  <a:lnTo>
                    <a:pt x="2401" y="48"/>
                  </a:lnTo>
                  <a:lnTo>
                    <a:pt x="2407" y="48"/>
                  </a:lnTo>
                  <a:lnTo>
                    <a:pt x="2415" y="48"/>
                  </a:lnTo>
                  <a:lnTo>
                    <a:pt x="2425" y="49"/>
                  </a:lnTo>
                  <a:lnTo>
                    <a:pt x="2433" y="49"/>
                  </a:lnTo>
                  <a:lnTo>
                    <a:pt x="2439" y="49"/>
                  </a:lnTo>
                  <a:lnTo>
                    <a:pt x="2449" y="49"/>
                  </a:lnTo>
                  <a:lnTo>
                    <a:pt x="2457" y="49"/>
                  </a:lnTo>
                  <a:lnTo>
                    <a:pt x="2463" y="49"/>
                  </a:lnTo>
                  <a:lnTo>
                    <a:pt x="2472" y="49"/>
                  </a:lnTo>
                  <a:lnTo>
                    <a:pt x="2480" y="49"/>
                  </a:lnTo>
                  <a:lnTo>
                    <a:pt x="2487" y="49"/>
                  </a:lnTo>
                  <a:lnTo>
                    <a:pt x="2495" y="49"/>
                  </a:lnTo>
                  <a:lnTo>
                    <a:pt x="2504" y="51"/>
                  </a:lnTo>
                  <a:lnTo>
                    <a:pt x="2511" y="51"/>
                  </a:lnTo>
                  <a:lnTo>
                    <a:pt x="2519" y="51"/>
                  </a:lnTo>
                  <a:lnTo>
                    <a:pt x="2528" y="51"/>
                  </a:lnTo>
                  <a:lnTo>
                    <a:pt x="2536" y="51"/>
                  </a:lnTo>
                  <a:lnTo>
                    <a:pt x="2542" y="51"/>
                  </a:lnTo>
                  <a:lnTo>
                    <a:pt x="2552" y="51"/>
                  </a:lnTo>
                  <a:lnTo>
                    <a:pt x="2560" y="51"/>
                  </a:lnTo>
                  <a:lnTo>
                    <a:pt x="2566" y="51"/>
                  </a:lnTo>
                  <a:lnTo>
                    <a:pt x="2576" y="52"/>
                  </a:lnTo>
                  <a:lnTo>
                    <a:pt x="2584" y="52"/>
                  </a:lnTo>
                  <a:lnTo>
                    <a:pt x="2590" y="52"/>
                  </a:lnTo>
                  <a:lnTo>
                    <a:pt x="2598" y="52"/>
                  </a:lnTo>
                  <a:lnTo>
                    <a:pt x="2608" y="52"/>
                  </a:lnTo>
                  <a:lnTo>
                    <a:pt x="2614" y="52"/>
                  </a:lnTo>
                  <a:lnTo>
                    <a:pt x="2622" y="52"/>
                  </a:lnTo>
                  <a:lnTo>
                    <a:pt x="2631" y="52"/>
                  </a:lnTo>
                  <a:lnTo>
                    <a:pt x="2638" y="52"/>
                  </a:lnTo>
                  <a:lnTo>
                    <a:pt x="2646" y="52"/>
                  </a:lnTo>
                  <a:lnTo>
                    <a:pt x="2655" y="54"/>
                  </a:lnTo>
                  <a:lnTo>
                    <a:pt x="2663" y="54"/>
                  </a:lnTo>
                  <a:lnTo>
                    <a:pt x="2669" y="54"/>
                  </a:lnTo>
                  <a:lnTo>
                    <a:pt x="2679" y="54"/>
                  </a:lnTo>
                  <a:lnTo>
                    <a:pt x="2687" y="54"/>
                  </a:lnTo>
                  <a:lnTo>
                    <a:pt x="2693" y="54"/>
                  </a:lnTo>
                  <a:lnTo>
                    <a:pt x="2703" y="54"/>
                  </a:lnTo>
                  <a:lnTo>
                    <a:pt x="2711" y="54"/>
                  </a:lnTo>
                  <a:lnTo>
                    <a:pt x="2717" y="54"/>
                  </a:lnTo>
                  <a:lnTo>
                    <a:pt x="2725" y="54"/>
                  </a:lnTo>
                  <a:lnTo>
                    <a:pt x="2735" y="56"/>
                  </a:lnTo>
                  <a:lnTo>
                    <a:pt x="2741" y="56"/>
                  </a:lnTo>
                  <a:lnTo>
                    <a:pt x="2749" y="56"/>
                  </a:lnTo>
                  <a:lnTo>
                    <a:pt x="2758" y="56"/>
                  </a:lnTo>
                  <a:lnTo>
                    <a:pt x="2765" y="56"/>
                  </a:lnTo>
                  <a:lnTo>
                    <a:pt x="2773" y="56"/>
                  </a:lnTo>
                  <a:lnTo>
                    <a:pt x="2782" y="56"/>
                  </a:lnTo>
                  <a:lnTo>
                    <a:pt x="2790" y="56"/>
                  </a:lnTo>
                  <a:lnTo>
                    <a:pt x="2797" y="56"/>
                  </a:lnTo>
                  <a:lnTo>
                    <a:pt x="2806" y="56"/>
                  </a:lnTo>
                  <a:lnTo>
                    <a:pt x="2814" y="57"/>
                  </a:lnTo>
                  <a:lnTo>
                    <a:pt x="2820" y="57"/>
                  </a:lnTo>
                  <a:lnTo>
                    <a:pt x="2830" y="57"/>
                  </a:lnTo>
                  <a:lnTo>
                    <a:pt x="2838" y="57"/>
                  </a:lnTo>
                  <a:lnTo>
                    <a:pt x="2844" y="57"/>
                  </a:lnTo>
                  <a:lnTo>
                    <a:pt x="2852" y="57"/>
                  </a:lnTo>
                  <a:lnTo>
                    <a:pt x="2862" y="57"/>
                  </a:lnTo>
                  <a:lnTo>
                    <a:pt x="2868" y="57"/>
                  </a:lnTo>
                  <a:lnTo>
                    <a:pt x="2876" y="57"/>
                  </a:lnTo>
                  <a:lnTo>
                    <a:pt x="2886" y="59"/>
                  </a:lnTo>
                  <a:lnTo>
                    <a:pt x="2893" y="59"/>
                  </a:lnTo>
                  <a:lnTo>
                    <a:pt x="2900" y="59"/>
                  </a:lnTo>
                  <a:lnTo>
                    <a:pt x="2909" y="59"/>
                  </a:lnTo>
                  <a:lnTo>
                    <a:pt x="2917" y="59"/>
                  </a:lnTo>
                  <a:lnTo>
                    <a:pt x="2924" y="59"/>
                  </a:lnTo>
                  <a:lnTo>
                    <a:pt x="2933" y="59"/>
                  </a:lnTo>
                  <a:lnTo>
                    <a:pt x="2941" y="59"/>
                  </a:lnTo>
                  <a:lnTo>
                    <a:pt x="2947" y="59"/>
                  </a:lnTo>
                  <a:lnTo>
                    <a:pt x="2955" y="59"/>
                  </a:lnTo>
                  <a:lnTo>
                    <a:pt x="2965" y="60"/>
                  </a:lnTo>
                  <a:lnTo>
                    <a:pt x="2971" y="60"/>
                  </a:lnTo>
                  <a:lnTo>
                    <a:pt x="2979" y="60"/>
                  </a:lnTo>
                  <a:lnTo>
                    <a:pt x="2989" y="60"/>
                  </a:lnTo>
                  <a:lnTo>
                    <a:pt x="2995" y="60"/>
                  </a:lnTo>
                  <a:lnTo>
                    <a:pt x="3003" y="60"/>
                  </a:lnTo>
                  <a:lnTo>
                    <a:pt x="3013" y="60"/>
                  </a:lnTo>
                  <a:lnTo>
                    <a:pt x="3021" y="60"/>
                  </a:lnTo>
                  <a:lnTo>
                    <a:pt x="3027" y="60"/>
                  </a:lnTo>
                  <a:lnTo>
                    <a:pt x="3036" y="60"/>
                  </a:lnTo>
                  <a:lnTo>
                    <a:pt x="3044" y="62"/>
                  </a:lnTo>
                  <a:lnTo>
                    <a:pt x="3051" y="62"/>
                  </a:lnTo>
                  <a:lnTo>
                    <a:pt x="3059" y="62"/>
                  </a:lnTo>
                  <a:lnTo>
                    <a:pt x="3067" y="62"/>
                  </a:lnTo>
                  <a:lnTo>
                    <a:pt x="3076" y="62"/>
                  </a:lnTo>
                  <a:lnTo>
                    <a:pt x="3084" y="62"/>
                  </a:lnTo>
                  <a:lnTo>
                    <a:pt x="3092" y="62"/>
                  </a:lnTo>
                  <a:lnTo>
                    <a:pt x="3098" y="62"/>
                  </a:lnTo>
                  <a:lnTo>
                    <a:pt x="3106" y="62"/>
                  </a:lnTo>
                  <a:lnTo>
                    <a:pt x="3114" y="62"/>
                  </a:lnTo>
                  <a:lnTo>
                    <a:pt x="3124" y="64"/>
                  </a:lnTo>
                  <a:lnTo>
                    <a:pt x="3132" y="64"/>
                  </a:lnTo>
                  <a:lnTo>
                    <a:pt x="3140" y="64"/>
                  </a:lnTo>
                  <a:lnTo>
                    <a:pt x="3148" y="64"/>
                  </a:lnTo>
                  <a:lnTo>
                    <a:pt x="3154" y="64"/>
                  </a:lnTo>
                  <a:lnTo>
                    <a:pt x="3162" y="64"/>
                  </a:lnTo>
                  <a:lnTo>
                    <a:pt x="3170" y="64"/>
                  </a:lnTo>
                  <a:lnTo>
                    <a:pt x="3179" y="64"/>
                  </a:lnTo>
                  <a:lnTo>
                    <a:pt x="3187" y="64"/>
                  </a:lnTo>
                  <a:lnTo>
                    <a:pt x="3195" y="64"/>
                  </a:lnTo>
                  <a:lnTo>
                    <a:pt x="3202" y="65"/>
                  </a:lnTo>
                  <a:lnTo>
                    <a:pt x="3210" y="65"/>
                  </a:lnTo>
                  <a:lnTo>
                    <a:pt x="3218" y="65"/>
                  </a:lnTo>
                  <a:lnTo>
                    <a:pt x="3227" y="65"/>
                  </a:lnTo>
                  <a:lnTo>
                    <a:pt x="3235" y="65"/>
                  </a:lnTo>
                  <a:lnTo>
                    <a:pt x="3243" y="65"/>
                  </a:lnTo>
                  <a:lnTo>
                    <a:pt x="3251" y="65"/>
                  </a:lnTo>
                  <a:lnTo>
                    <a:pt x="3257" y="65"/>
                  </a:lnTo>
                  <a:lnTo>
                    <a:pt x="3265" y="65"/>
                  </a:lnTo>
                  <a:lnTo>
                    <a:pt x="3273" y="65"/>
                  </a:lnTo>
                  <a:lnTo>
                    <a:pt x="3283" y="65"/>
                  </a:lnTo>
                  <a:lnTo>
                    <a:pt x="3291" y="67"/>
                  </a:lnTo>
                  <a:lnTo>
                    <a:pt x="3299" y="67"/>
                  </a:lnTo>
                  <a:lnTo>
                    <a:pt x="3305" y="67"/>
                  </a:lnTo>
                  <a:lnTo>
                    <a:pt x="3313" y="67"/>
                  </a:lnTo>
                  <a:lnTo>
                    <a:pt x="3321" y="67"/>
                  </a:lnTo>
                  <a:lnTo>
                    <a:pt x="3330" y="67"/>
                  </a:lnTo>
                  <a:lnTo>
                    <a:pt x="3338" y="67"/>
                  </a:lnTo>
                  <a:lnTo>
                    <a:pt x="3346" y="67"/>
                  </a:lnTo>
                  <a:lnTo>
                    <a:pt x="3353" y="67"/>
                  </a:lnTo>
                  <a:lnTo>
                    <a:pt x="3361" y="67"/>
                  </a:lnTo>
                  <a:lnTo>
                    <a:pt x="3369" y="68"/>
                  </a:lnTo>
                  <a:lnTo>
                    <a:pt x="3376" y="68"/>
                  </a:lnTo>
                  <a:lnTo>
                    <a:pt x="3386" y="68"/>
                  </a:lnTo>
                  <a:lnTo>
                    <a:pt x="3394" y="68"/>
                  </a:lnTo>
                  <a:lnTo>
                    <a:pt x="3402" y="68"/>
                  </a:lnTo>
                  <a:lnTo>
                    <a:pt x="3408" y="68"/>
                  </a:lnTo>
                  <a:lnTo>
                    <a:pt x="3416" y="68"/>
                  </a:lnTo>
                  <a:lnTo>
                    <a:pt x="3424" y="68"/>
                  </a:lnTo>
                  <a:lnTo>
                    <a:pt x="3434" y="68"/>
                  </a:lnTo>
                  <a:lnTo>
                    <a:pt x="3442" y="68"/>
                  </a:lnTo>
                  <a:lnTo>
                    <a:pt x="3450" y="70"/>
                  </a:lnTo>
                  <a:lnTo>
                    <a:pt x="3456" y="70"/>
                  </a:lnTo>
                  <a:lnTo>
                    <a:pt x="3464" y="70"/>
                  </a:lnTo>
                  <a:lnTo>
                    <a:pt x="3472" y="70"/>
                  </a:lnTo>
                  <a:lnTo>
                    <a:pt x="3481" y="70"/>
                  </a:lnTo>
                  <a:lnTo>
                    <a:pt x="3489" y="70"/>
                  </a:lnTo>
                  <a:lnTo>
                    <a:pt x="3497" y="70"/>
                  </a:lnTo>
                  <a:lnTo>
                    <a:pt x="3505" y="70"/>
                  </a:lnTo>
                  <a:lnTo>
                    <a:pt x="3511" y="70"/>
                  </a:lnTo>
                  <a:lnTo>
                    <a:pt x="3519" y="70"/>
                  </a:lnTo>
                  <a:lnTo>
                    <a:pt x="3527" y="71"/>
                  </a:lnTo>
                  <a:lnTo>
                    <a:pt x="3537" y="71"/>
                  </a:lnTo>
                  <a:lnTo>
                    <a:pt x="3545" y="71"/>
                  </a:lnTo>
                  <a:lnTo>
                    <a:pt x="3553" y="71"/>
                  </a:lnTo>
                  <a:lnTo>
                    <a:pt x="3559" y="71"/>
                  </a:lnTo>
                  <a:lnTo>
                    <a:pt x="3567" y="71"/>
                  </a:lnTo>
                  <a:lnTo>
                    <a:pt x="3575" y="71"/>
                  </a:lnTo>
                  <a:lnTo>
                    <a:pt x="3585" y="71"/>
                  </a:lnTo>
                  <a:lnTo>
                    <a:pt x="3593" y="71"/>
                  </a:lnTo>
                  <a:lnTo>
                    <a:pt x="3600" y="71"/>
                  </a:lnTo>
                  <a:lnTo>
                    <a:pt x="3608" y="71"/>
                  </a:lnTo>
                  <a:lnTo>
                    <a:pt x="3615" y="73"/>
                  </a:lnTo>
                  <a:lnTo>
                    <a:pt x="3623" y="73"/>
                  </a:lnTo>
                  <a:lnTo>
                    <a:pt x="3631" y="73"/>
                  </a:lnTo>
                  <a:lnTo>
                    <a:pt x="3640" y="73"/>
                  </a:lnTo>
                  <a:lnTo>
                    <a:pt x="3648" y="73"/>
                  </a:lnTo>
                  <a:lnTo>
                    <a:pt x="3656" y="73"/>
                  </a:lnTo>
                  <a:lnTo>
                    <a:pt x="3662" y="73"/>
                  </a:lnTo>
                  <a:lnTo>
                    <a:pt x="3670" y="73"/>
                  </a:lnTo>
                  <a:lnTo>
                    <a:pt x="3678" y="73"/>
                  </a:lnTo>
                  <a:lnTo>
                    <a:pt x="3688" y="73"/>
                  </a:lnTo>
                  <a:lnTo>
                    <a:pt x="3696" y="75"/>
                  </a:lnTo>
                  <a:lnTo>
                    <a:pt x="3704" y="75"/>
                  </a:lnTo>
                  <a:lnTo>
                    <a:pt x="3710" y="75"/>
                  </a:lnTo>
                  <a:lnTo>
                    <a:pt x="3718" y="75"/>
                  </a:lnTo>
                  <a:lnTo>
                    <a:pt x="3726" y="75"/>
                  </a:lnTo>
                  <a:lnTo>
                    <a:pt x="3734" y="75"/>
                  </a:lnTo>
                  <a:lnTo>
                    <a:pt x="3743" y="75"/>
                  </a:lnTo>
                  <a:lnTo>
                    <a:pt x="3751" y="75"/>
                  </a:lnTo>
                  <a:lnTo>
                    <a:pt x="3759" y="75"/>
                  </a:lnTo>
                  <a:lnTo>
                    <a:pt x="3766" y="75"/>
                  </a:lnTo>
                  <a:lnTo>
                    <a:pt x="3774" y="76"/>
                  </a:lnTo>
                  <a:lnTo>
                    <a:pt x="3782" y="76"/>
                  </a:lnTo>
                  <a:lnTo>
                    <a:pt x="3791" y="76"/>
                  </a:lnTo>
                  <a:lnTo>
                    <a:pt x="3799" y="76"/>
                  </a:lnTo>
                  <a:lnTo>
                    <a:pt x="3807" y="76"/>
                  </a:lnTo>
                  <a:lnTo>
                    <a:pt x="3813" y="76"/>
                  </a:lnTo>
                  <a:lnTo>
                    <a:pt x="3821" y="76"/>
                  </a:lnTo>
                  <a:lnTo>
                    <a:pt x="3829" y="76"/>
                  </a:lnTo>
                  <a:lnTo>
                    <a:pt x="3839" y="76"/>
                  </a:lnTo>
                  <a:lnTo>
                    <a:pt x="3847" y="76"/>
                  </a:lnTo>
                  <a:lnTo>
                    <a:pt x="3855" y="76"/>
                  </a:lnTo>
                  <a:lnTo>
                    <a:pt x="3863" y="78"/>
                  </a:lnTo>
                  <a:lnTo>
                    <a:pt x="3869" y="78"/>
                  </a:lnTo>
                  <a:lnTo>
                    <a:pt x="3877" y="78"/>
                  </a:lnTo>
                  <a:lnTo>
                    <a:pt x="3885" y="78"/>
                  </a:lnTo>
                  <a:lnTo>
                    <a:pt x="3894" y="78"/>
                  </a:lnTo>
                  <a:lnTo>
                    <a:pt x="3902" y="78"/>
                  </a:lnTo>
                  <a:lnTo>
                    <a:pt x="3910" y="78"/>
                  </a:lnTo>
                  <a:lnTo>
                    <a:pt x="3917" y="78"/>
                  </a:lnTo>
                  <a:lnTo>
                    <a:pt x="3925" y="78"/>
                  </a:lnTo>
                  <a:lnTo>
                    <a:pt x="3932" y="78"/>
                  </a:lnTo>
                  <a:lnTo>
                    <a:pt x="3942" y="78"/>
                  </a:lnTo>
                  <a:lnTo>
                    <a:pt x="3950" y="79"/>
                  </a:lnTo>
                  <a:lnTo>
                    <a:pt x="3958" y="79"/>
                  </a:lnTo>
                  <a:lnTo>
                    <a:pt x="3966" y="79"/>
                  </a:lnTo>
                  <a:lnTo>
                    <a:pt x="3972" y="79"/>
                  </a:lnTo>
                  <a:lnTo>
                    <a:pt x="3980" y="79"/>
                  </a:lnTo>
                  <a:lnTo>
                    <a:pt x="3988" y="79"/>
                  </a:lnTo>
                  <a:lnTo>
                    <a:pt x="3998" y="79"/>
                  </a:lnTo>
                  <a:lnTo>
                    <a:pt x="4006" y="79"/>
                  </a:lnTo>
                  <a:lnTo>
                    <a:pt x="4014" y="79"/>
                  </a:lnTo>
                  <a:lnTo>
                    <a:pt x="4020" y="79"/>
                  </a:lnTo>
                  <a:lnTo>
                    <a:pt x="4028" y="81"/>
                  </a:lnTo>
                  <a:lnTo>
                    <a:pt x="4036" y="81"/>
                  </a:lnTo>
                  <a:lnTo>
                    <a:pt x="4045" y="81"/>
                  </a:lnTo>
                  <a:lnTo>
                    <a:pt x="4053" y="81"/>
                  </a:lnTo>
                  <a:lnTo>
                    <a:pt x="4061" y="81"/>
                  </a:lnTo>
                  <a:lnTo>
                    <a:pt x="4068" y="81"/>
                  </a:lnTo>
                  <a:lnTo>
                    <a:pt x="4075" y="81"/>
                  </a:lnTo>
                  <a:lnTo>
                    <a:pt x="4083" y="81"/>
                  </a:lnTo>
                  <a:lnTo>
                    <a:pt x="4091" y="81"/>
                  </a:lnTo>
                  <a:lnTo>
                    <a:pt x="4101" y="81"/>
                  </a:lnTo>
                  <a:lnTo>
                    <a:pt x="4109" y="8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6" name="Freeform 106"/>
            <p:cNvSpPr>
              <a:spLocks/>
            </p:cNvSpPr>
            <p:nvPr/>
          </p:nvSpPr>
          <p:spPr bwMode="auto">
            <a:xfrm>
              <a:off x="763" y="2668"/>
              <a:ext cx="4106" cy="181"/>
            </a:xfrm>
            <a:custGeom>
              <a:avLst/>
              <a:gdLst>
                <a:gd name="T0" fmla="*/ 63 w 4106"/>
                <a:gd name="T1" fmla="*/ 168 h 181"/>
                <a:gd name="T2" fmla="*/ 135 w 4106"/>
                <a:gd name="T3" fmla="*/ 168 h 181"/>
                <a:gd name="T4" fmla="*/ 208 w 4106"/>
                <a:gd name="T5" fmla="*/ 168 h 181"/>
                <a:gd name="T6" fmla="*/ 278 w 4106"/>
                <a:gd name="T7" fmla="*/ 168 h 181"/>
                <a:gd name="T8" fmla="*/ 349 w 4106"/>
                <a:gd name="T9" fmla="*/ 179 h 181"/>
                <a:gd name="T10" fmla="*/ 421 w 4106"/>
                <a:gd name="T11" fmla="*/ 171 h 181"/>
                <a:gd name="T12" fmla="*/ 492 w 4106"/>
                <a:gd name="T13" fmla="*/ 165 h 181"/>
                <a:gd name="T14" fmla="*/ 565 w 4106"/>
                <a:gd name="T15" fmla="*/ 157 h 181"/>
                <a:gd name="T16" fmla="*/ 635 w 4106"/>
                <a:gd name="T17" fmla="*/ 151 h 181"/>
                <a:gd name="T18" fmla="*/ 707 w 4106"/>
                <a:gd name="T19" fmla="*/ 143 h 181"/>
                <a:gd name="T20" fmla="*/ 780 w 4106"/>
                <a:gd name="T21" fmla="*/ 136 h 181"/>
                <a:gd name="T22" fmla="*/ 851 w 4106"/>
                <a:gd name="T23" fmla="*/ 128 h 181"/>
                <a:gd name="T24" fmla="*/ 923 w 4106"/>
                <a:gd name="T25" fmla="*/ 122 h 181"/>
                <a:gd name="T26" fmla="*/ 992 w 4106"/>
                <a:gd name="T27" fmla="*/ 116 h 181"/>
                <a:gd name="T28" fmla="*/ 1066 w 4106"/>
                <a:gd name="T29" fmla="*/ 108 h 181"/>
                <a:gd name="T30" fmla="*/ 1135 w 4106"/>
                <a:gd name="T31" fmla="*/ 101 h 181"/>
                <a:gd name="T32" fmla="*/ 1209 w 4106"/>
                <a:gd name="T33" fmla="*/ 95 h 181"/>
                <a:gd name="T34" fmla="*/ 1278 w 4106"/>
                <a:gd name="T35" fmla="*/ 89 h 181"/>
                <a:gd name="T36" fmla="*/ 1350 w 4106"/>
                <a:gd name="T37" fmla="*/ 82 h 181"/>
                <a:gd name="T38" fmla="*/ 1423 w 4106"/>
                <a:gd name="T39" fmla="*/ 76 h 181"/>
                <a:gd name="T40" fmla="*/ 1493 w 4106"/>
                <a:gd name="T41" fmla="*/ 70 h 181"/>
                <a:gd name="T42" fmla="*/ 1566 w 4106"/>
                <a:gd name="T43" fmla="*/ 63 h 181"/>
                <a:gd name="T44" fmla="*/ 1636 w 4106"/>
                <a:gd name="T45" fmla="*/ 57 h 181"/>
                <a:gd name="T46" fmla="*/ 1707 w 4106"/>
                <a:gd name="T47" fmla="*/ 51 h 181"/>
                <a:gd name="T48" fmla="*/ 1780 w 4106"/>
                <a:gd name="T49" fmla="*/ 44 h 181"/>
                <a:gd name="T50" fmla="*/ 1852 w 4106"/>
                <a:gd name="T51" fmla="*/ 38 h 181"/>
                <a:gd name="T52" fmla="*/ 1922 w 4106"/>
                <a:gd name="T53" fmla="*/ 33 h 181"/>
                <a:gd name="T54" fmla="*/ 1993 w 4106"/>
                <a:gd name="T55" fmla="*/ 27 h 181"/>
                <a:gd name="T56" fmla="*/ 2065 w 4106"/>
                <a:gd name="T57" fmla="*/ 20 h 181"/>
                <a:gd name="T58" fmla="*/ 2138 w 4106"/>
                <a:gd name="T59" fmla="*/ 14 h 181"/>
                <a:gd name="T60" fmla="*/ 2209 w 4106"/>
                <a:gd name="T61" fmla="*/ 0 h 181"/>
                <a:gd name="T62" fmla="*/ 2279 w 4106"/>
                <a:gd name="T63" fmla="*/ 1 h 181"/>
                <a:gd name="T64" fmla="*/ 2351 w 4106"/>
                <a:gd name="T65" fmla="*/ 1 h 181"/>
                <a:gd name="T66" fmla="*/ 2422 w 4106"/>
                <a:gd name="T67" fmla="*/ 3 h 181"/>
                <a:gd name="T68" fmla="*/ 2495 w 4106"/>
                <a:gd name="T69" fmla="*/ 3 h 181"/>
                <a:gd name="T70" fmla="*/ 2567 w 4106"/>
                <a:gd name="T71" fmla="*/ 5 h 181"/>
                <a:gd name="T72" fmla="*/ 2637 w 4106"/>
                <a:gd name="T73" fmla="*/ 5 h 181"/>
                <a:gd name="T74" fmla="*/ 2708 w 4106"/>
                <a:gd name="T75" fmla="*/ 6 h 181"/>
                <a:gd name="T76" fmla="*/ 2780 w 4106"/>
                <a:gd name="T77" fmla="*/ 6 h 181"/>
                <a:gd name="T78" fmla="*/ 2853 w 4106"/>
                <a:gd name="T79" fmla="*/ 8 h 181"/>
                <a:gd name="T80" fmla="*/ 2924 w 4106"/>
                <a:gd name="T81" fmla="*/ 8 h 181"/>
                <a:gd name="T82" fmla="*/ 2994 w 4106"/>
                <a:gd name="T83" fmla="*/ 9 h 181"/>
                <a:gd name="T84" fmla="*/ 3066 w 4106"/>
                <a:gd name="T85" fmla="*/ 9 h 181"/>
                <a:gd name="T86" fmla="*/ 3139 w 4106"/>
                <a:gd name="T87" fmla="*/ 11 h 181"/>
                <a:gd name="T88" fmla="*/ 3210 w 4106"/>
                <a:gd name="T89" fmla="*/ 11 h 181"/>
                <a:gd name="T90" fmla="*/ 3280 w 4106"/>
                <a:gd name="T91" fmla="*/ 12 h 181"/>
                <a:gd name="T92" fmla="*/ 3353 w 4106"/>
                <a:gd name="T93" fmla="*/ 12 h 181"/>
                <a:gd name="T94" fmla="*/ 3423 w 4106"/>
                <a:gd name="T95" fmla="*/ 12 h 181"/>
                <a:gd name="T96" fmla="*/ 3496 w 4106"/>
                <a:gd name="T97" fmla="*/ 14 h 181"/>
                <a:gd name="T98" fmla="*/ 3568 w 4106"/>
                <a:gd name="T99" fmla="*/ 14 h 181"/>
                <a:gd name="T100" fmla="*/ 3638 w 4106"/>
                <a:gd name="T101" fmla="*/ 16 h 181"/>
                <a:gd name="T102" fmla="*/ 3711 w 4106"/>
                <a:gd name="T103" fmla="*/ 16 h 181"/>
                <a:gd name="T104" fmla="*/ 3781 w 4106"/>
                <a:gd name="T105" fmla="*/ 17 h 181"/>
                <a:gd name="T106" fmla="*/ 3854 w 4106"/>
                <a:gd name="T107" fmla="*/ 17 h 181"/>
                <a:gd name="T108" fmla="*/ 3925 w 4106"/>
                <a:gd name="T109" fmla="*/ 19 h 181"/>
                <a:gd name="T110" fmla="*/ 3995 w 4106"/>
                <a:gd name="T111" fmla="*/ 19 h 181"/>
                <a:gd name="T112" fmla="*/ 4068 w 4106"/>
                <a:gd name="T113" fmla="*/ 20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106" h="181">
                  <a:moveTo>
                    <a:pt x="0" y="168"/>
                  </a:moveTo>
                  <a:lnTo>
                    <a:pt x="9" y="168"/>
                  </a:lnTo>
                  <a:lnTo>
                    <a:pt x="15" y="168"/>
                  </a:lnTo>
                  <a:lnTo>
                    <a:pt x="25" y="168"/>
                  </a:lnTo>
                  <a:lnTo>
                    <a:pt x="31" y="168"/>
                  </a:lnTo>
                  <a:lnTo>
                    <a:pt x="41" y="168"/>
                  </a:lnTo>
                  <a:lnTo>
                    <a:pt x="47" y="168"/>
                  </a:lnTo>
                  <a:lnTo>
                    <a:pt x="57" y="168"/>
                  </a:lnTo>
                  <a:lnTo>
                    <a:pt x="63" y="168"/>
                  </a:lnTo>
                  <a:lnTo>
                    <a:pt x="73" y="168"/>
                  </a:lnTo>
                  <a:lnTo>
                    <a:pt x="79" y="168"/>
                  </a:lnTo>
                  <a:lnTo>
                    <a:pt x="89" y="168"/>
                  </a:lnTo>
                  <a:lnTo>
                    <a:pt x="95" y="168"/>
                  </a:lnTo>
                  <a:lnTo>
                    <a:pt x="104" y="168"/>
                  </a:lnTo>
                  <a:lnTo>
                    <a:pt x="111" y="168"/>
                  </a:lnTo>
                  <a:lnTo>
                    <a:pt x="120" y="168"/>
                  </a:lnTo>
                  <a:lnTo>
                    <a:pt x="127" y="168"/>
                  </a:lnTo>
                  <a:lnTo>
                    <a:pt x="135" y="168"/>
                  </a:lnTo>
                  <a:lnTo>
                    <a:pt x="144" y="168"/>
                  </a:lnTo>
                  <a:lnTo>
                    <a:pt x="152" y="168"/>
                  </a:lnTo>
                  <a:lnTo>
                    <a:pt x="160" y="168"/>
                  </a:lnTo>
                  <a:lnTo>
                    <a:pt x="168" y="168"/>
                  </a:lnTo>
                  <a:lnTo>
                    <a:pt x="176" y="168"/>
                  </a:lnTo>
                  <a:lnTo>
                    <a:pt x="184" y="168"/>
                  </a:lnTo>
                  <a:lnTo>
                    <a:pt x="192" y="168"/>
                  </a:lnTo>
                  <a:lnTo>
                    <a:pt x="200" y="168"/>
                  </a:lnTo>
                  <a:lnTo>
                    <a:pt x="208" y="168"/>
                  </a:lnTo>
                  <a:lnTo>
                    <a:pt x="216" y="168"/>
                  </a:lnTo>
                  <a:lnTo>
                    <a:pt x="224" y="168"/>
                  </a:lnTo>
                  <a:lnTo>
                    <a:pt x="231" y="168"/>
                  </a:lnTo>
                  <a:lnTo>
                    <a:pt x="238" y="168"/>
                  </a:lnTo>
                  <a:lnTo>
                    <a:pt x="246" y="168"/>
                  </a:lnTo>
                  <a:lnTo>
                    <a:pt x="254" y="168"/>
                  </a:lnTo>
                  <a:lnTo>
                    <a:pt x="262" y="168"/>
                  </a:lnTo>
                  <a:lnTo>
                    <a:pt x="270" y="168"/>
                  </a:lnTo>
                  <a:lnTo>
                    <a:pt x="278" y="168"/>
                  </a:lnTo>
                  <a:lnTo>
                    <a:pt x="286" y="168"/>
                  </a:lnTo>
                  <a:lnTo>
                    <a:pt x="293" y="168"/>
                  </a:lnTo>
                  <a:lnTo>
                    <a:pt x="303" y="168"/>
                  </a:lnTo>
                  <a:lnTo>
                    <a:pt x="311" y="168"/>
                  </a:lnTo>
                  <a:lnTo>
                    <a:pt x="319" y="168"/>
                  </a:lnTo>
                  <a:lnTo>
                    <a:pt x="327" y="181"/>
                  </a:lnTo>
                  <a:lnTo>
                    <a:pt x="333" y="181"/>
                  </a:lnTo>
                  <a:lnTo>
                    <a:pt x="343" y="179"/>
                  </a:lnTo>
                  <a:lnTo>
                    <a:pt x="349" y="179"/>
                  </a:lnTo>
                  <a:lnTo>
                    <a:pt x="357" y="178"/>
                  </a:lnTo>
                  <a:lnTo>
                    <a:pt x="367" y="178"/>
                  </a:lnTo>
                  <a:lnTo>
                    <a:pt x="374" y="176"/>
                  </a:lnTo>
                  <a:lnTo>
                    <a:pt x="382" y="176"/>
                  </a:lnTo>
                  <a:lnTo>
                    <a:pt x="389" y="174"/>
                  </a:lnTo>
                  <a:lnTo>
                    <a:pt x="397" y="174"/>
                  </a:lnTo>
                  <a:lnTo>
                    <a:pt x="405" y="173"/>
                  </a:lnTo>
                  <a:lnTo>
                    <a:pt x="413" y="173"/>
                  </a:lnTo>
                  <a:lnTo>
                    <a:pt x="421" y="171"/>
                  </a:lnTo>
                  <a:lnTo>
                    <a:pt x="428" y="171"/>
                  </a:lnTo>
                  <a:lnTo>
                    <a:pt x="436" y="170"/>
                  </a:lnTo>
                  <a:lnTo>
                    <a:pt x="444" y="170"/>
                  </a:lnTo>
                  <a:lnTo>
                    <a:pt x="452" y="168"/>
                  </a:lnTo>
                  <a:lnTo>
                    <a:pt x="460" y="168"/>
                  </a:lnTo>
                  <a:lnTo>
                    <a:pt x="468" y="167"/>
                  </a:lnTo>
                  <a:lnTo>
                    <a:pt x="478" y="167"/>
                  </a:lnTo>
                  <a:lnTo>
                    <a:pt x="486" y="165"/>
                  </a:lnTo>
                  <a:lnTo>
                    <a:pt x="492" y="165"/>
                  </a:lnTo>
                  <a:lnTo>
                    <a:pt x="502" y="163"/>
                  </a:lnTo>
                  <a:lnTo>
                    <a:pt x="508" y="163"/>
                  </a:lnTo>
                  <a:lnTo>
                    <a:pt x="517" y="162"/>
                  </a:lnTo>
                  <a:lnTo>
                    <a:pt x="524" y="160"/>
                  </a:lnTo>
                  <a:lnTo>
                    <a:pt x="533" y="160"/>
                  </a:lnTo>
                  <a:lnTo>
                    <a:pt x="540" y="159"/>
                  </a:lnTo>
                  <a:lnTo>
                    <a:pt x="549" y="159"/>
                  </a:lnTo>
                  <a:lnTo>
                    <a:pt x="556" y="157"/>
                  </a:lnTo>
                  <a:lnTo>
                    <a:pt x="565" y="157"/>
                  </a:lnTo>
                  <a:lnTo>
                    <a:pt x="571" y="155"/>
                  </a:lnTo>
                  <a:lnTo>
                    <a:pt x="581" y="155"/>
                  </a:lnTo>
                  <a:lnTo>
                    <a:pt x="587" y="154"/>
                  </a:lnTo>
                  <a:lnTo>
                    <a:pt x="597" y="154"/>
                  </a:lnTo>
                  <a:lnTo>
                    <a:pt x="603" y="152"/>
                  </a:lnTo>
                  <a:lnTo>
                    <a:pt x="613" y="152"/>
                  </a:lnTo>
                  <a:lnTo>
                    <a:pt x="619" y="152"/>
                  </a:lnTo>
                  <a:lnTo>
                    <a:pt x="629" y="151"/>
                  </a:lnTo>
                  <a:lnTo>
                    <a:pt x="635" y="151"/>
                  </a:lnTo>
                  <a:lnTo>
                    <a:pt x="645" y="149"/>
                  </a:lnTo>
                  <a:lnTo>
                    <a:pt x="651" y="149"/>
                  </a:lnTo>
                  <a:lnTo>
                    <a:pt x="660" y="147"/>
                  </a:lnTo>
                  <a:lnTo>
                    <a:pt x="667" y="147"/>
                  </a:lnTo>
                  <a:lnTo>
                    <a:pt x="675" y="146"/>
                  </a:lnTo>
                  <a:lnTo>
                    <a:pt x="684" y="146"/>
                  </a:lnTo>
                  <a:lnTo>
                    <a:pt x="692" y="144"/>
                  </a:lnTo>
                  <a:lnTo>
                    <a:pt x="699" y="144"/>
                  </a:lnTo>
                  <a:lnTo>
                    <a:pt x="707" y="143"/>
                  </a:lnTo>
                  <a:lnTo>
                    <a:pt x="716" y="143"/>
                  </a:lnTo>
                  <a:lnTo>
                    <a:pt x="724" y="141"/>
                  </a:lnTo>
                  <a:lnTo>
                    <a:pt x="730" y="141"/>
                  </a:lnTo>
                  <a:lnTo>
                    <a:pt x="738" y="140"/>
                  </a:lnTo>
                  <a:lnTo>
                    <a:pt x="748" y="140"/>
                  </a:lnTo>
                  <a:lnTo>
                    <a:pt x="756" y="138"/>
                  </a:lnTo>
                  <a:lnTo>
                    <a:pt x="762" y="138"/>
                  </a:lnTo>
                  <a:lnTo>
                    <a:pt x="770" y="136"/>
                  </a:lnTo>
                  <a:lnTo>
                    <a:pt x="780" y="136"/>
                  </a:lnTo>
                  <a:lnTo>
                    <a:pt x="788" y="135"/>
                  </a:lnTo>
                  <a:lnTo>
                    <a:pt x="794" y="135"/>
                  </a:lnTo>
                  <a:lnTo>
                    <a:pt x="802" y="133"/>
                  </a:lnTo>
                  <a:lnTo>
                    <a:pt x="811" y="133"/>
                  </a:lnTo>
                  <a:lnTo>
                    <a:pt x="819" y="132"/>
                  </a:lnTo>
                  <a:lnTo>
                    <a:pt x="827" y="132"/>
                  </a:lnTo>
                  <a:lnTo>
                    <a:pt x="834" y="130"/>
                  </a:lnTo>
                  <a:lnTo>
                    <a:pt x="842" y="130"/>
                  </a:lnTo>
                  <a:lnTo>
                    <a:pt x="851" y="128"/>
                  </a:lnTo>
                  <a:lnTo>
                    <a:pt x="859" y="128"/>
                  </a:lnTo>
                  <a:lnTo>
                    <a:pt x="865" y="127"/>
                  </a:lnTo>
                  <a:lnTo>
                    <a:pt x="873" y="127"/>
                  </a:lnTo>
                  <a:lnTo>
                    <a:pt x="883" y="125"/>
                  </a:lnTo>
                  <a:lnTo>
                    <a:pt x="891" y="125"/>
                  </a:lnTo>
                  <a:lnTo>
                    <a:pt x="897" y="124"/>
                  </a:lnTo>
                  <a:lnTo>
                    <a:pt x="905" y="124"/>
                  </a:lnTo>
                  <a:lnTo>
                    <a:pt x="915" y="122"/>
                  </a:lnTo>
                  <a:lnTo>
                    <a:pt x="923" y="122"/>
                  </a:lnTo>
                  <a:lnTo>
                    <a:pt x="929" y="122"/>
                  </a:lnTo>
                  <a:lnTo>
                    <a:pt x="937" y="120"/>
                  </a:lnTo>
                  <a:lnTo>
                    <a:pt x="946" y="120"/>
                  </a:lnTo>
                  <a:lnTo>
                    <a:pt x="954" y="119"/>
                  </a:lnTo>
                  <a:lnTo>
                    <a:pt x="961" y="119"/>
                  </a:lnTo>
                  <a:lnTo>
                    <a:pt x="969" y="117"/>
                  </a:lnTo>
                  <a:lnTo>
                    <a:pt x="978" y="117"/>
                  </a:lnTo>
                  <a:lnTo>
                    <a:pt x="986" y="116"/>
                  </a:lnTo>
                  <a:lnTo>
                    <a:pt x="992" y="116"/>
                  </a:lnTo>
                  <a:lnTo>
                    <a:pt x="1000" y="114"/>
                  </a:lnTo>
                  <a:lnTo>
                    <a:pt x="1008" y="114"/>
                  </a:lnTo>
                  <a:lnTo>
                    <a:pt x="1018" y="113"/>
                  </a:lnTo>
                  <a:lnTo>
                    <a:pt x="1026" y="113"/>
                  </a:lnTo>
                  <a:lnTo>
                    <a:pt x="1032" y="111"/>
                  </a:lnTo>
                  <a:lnTo>
                    <a:pt x="1042" y="111"/>
                  </a:lnTo>
                  <a:lnTo>
                    <a:pt x="1048" y="109"/>
                  </a:lnTo>
                  <a:lnTo>
                    <a:pt x="1056" y="109"/>
                  </a:lnTo>
                  <a:lnTo>
                    <a:pt x="1066" y="108"/>
                  </a:lnTo>
                  <a:lnTo>
                    <a:pt x="1072" y="108"/>
                  </a:lnTo>
                  <a:lnTo>
                    <a:pt x="1081" y="108"/>
                  </a:lnTo>
                  <a:lnTo>
                    <a:pt x="1089" y="106"/>
                  </a:lnTo>
                  <a:lnTo>
                    <a:pt x="1096" y="106"/>
                  </a:lnTo>
                  <a:lnTo>
                    <a:pt x="1105" y="105"/>
                  </a:lnTo>
                  <a:lnTo>
                    <a:pt x="1112" y="105"/>
                  </a:lnTo>
                  <a:lnTo>
                    <a:pt x="1120" y="103"/>
                  </a:lnTo>
                  <a:lnTo>
                    <a:pt x="1129" y="103"/>
                  </a:lnTo>
                  <a:lnTo>
                    <a:pt x="1135" y="101"/>
                  </a:lnTo>
                  <a:lnTo>
                    <a:pt x="1145" y="101"/>
                  </a:lnTo>
                  <a:lnTo>
                    <a:pt x="1153" y="100"/>
                  </a:lnTo>
                  <a:lnTo>
                    <a:pt x="1159" y="100"/>
                  </a:lnTo>
                  <a:lnTo>
                    <a:pt x="1169" y="98"/>
                  </a:lnTo>
                  <a:lnTo>
                    <a:pt x="1175" y="98"/>
                  </a:lnTo>
                  <a:lnTo>
                    <a:pt x="1185" y="98"/>
                  </a:lnTo>
                  <a:lnTo>
                    <a:pt x="1193" y="97"/>
                  </a:lnTo>
                  <a:lnTo>
                    <a:pt x="1199" y="97"/>
                  </a:lnTo>
                  <a:lnTo>
                    <a:pt x="1209" y="95"/>
                  </a:lnTo>
                  <a:lnTo>
                    <a:pt x="1215" y="95"/>
                  </a:lnTo>
                  <a:lnTo>
                    <a:pt x="1223" y="93"/>
                  </a:lnTo>
                  <a:lnTo>
                    <a:pt x="1232" y="93"/>
                  </a:lnTo>
                  <a:lnTo>
                    <a:pt x="1239" y="92"/>
                  </a:lnTo>
                  <a:lnTo>
                    <a:pt x="1248" y="92"/>
                  </a:lnTo>
                  <a:lnTo>
                    <a:pt x="1256" y="90"/>
                  </a:lnTo>
                  <a:lnTo>
                    <a:pt x="1263" y="90"/>
                  </a:lnTo>
                  <a:lnTo>
                    <a:pt x="1272" y="89"/>
                  </a:lnTo>
                  <a:lnTo>
                    <a:pt x="1278" y="89"/>
                  </a:lnTo>
                  <a:lnTo>
                    <a:pt x="1286" y="89"/>
                  </a:lnTo>
                  <a:lnTo>
                    <a:pt x="1296" y="87"/>
                  </a:lnTo>
                  <a:lnTo>
                    <a:pt x="1302" y="87"/>
                  </a:lnTo>
                  <a:lnTo>
                    <a:pt x="1312" y="86"/>
                  </a:lnTo>
                  <a:lnTo>
                    <a:pt x="1320" y="86"/>
                  </a:lnTo>
                  <a:lnTo>
                    <a:pt x="1326" y="84"/>
                  </a:lnTo>
                  <a:lnTo>
                    <a:pt x="1336" y="84"/>
                  </a:lnTo>
                  <a:lnTo>
                    <a:pt x="1342" y="82"/>
                  </a:lnTo>
                  <a:lnTo>
                    <a:pt x="1350" y="82"/>
                  </a:lnTo>
                  <a:lnTo>
                    <a:pt x="1359" y="81"/>
                  </a:lnTo>
                  <a:lnTo>
                    <a:pt x="1366" y="81"/>
                  </a:lnTo>
                  <a:lnTo>
                    <a:pt x="1375" y="81"/>
                  </a:lnTo>
                  <a:lnTo>
                    <a:pt x="1383" y="79"/>
                  </a:lnTo>
                  <a:lnTo>
                    <a:pt x="1390" y="79"/>
                  </a:lnTo>
                  <a:lnTo>
                    <a:pt x="1399" y="78"/>
                  </a:lnTo>
                  <a:lnTo>
                    <a:pt x="1406" y="78"/>
                  </a:lnTo>
                  <a:lnTo>
                    <a:pt x="1413" y="76"/>
                  </a:lnTo>
                  <a:lnTo>
                    <a:pt x="1423" y="76"/>
                  </a:lnTo>
                  <a:lnTo>
                    <a:pt x="1429" y="74"/>
                  </a:lnTo>
                  <a:lnTo>
                    <a:pt x="1439" y="74"/>
                  </a:lnTo>
                  <a:lnTo>
                    <a:pt x="1447" y="74"/>
                  </a:lnTo>
                  <a:lnTo>
                    <a:pt x="1453" y="73"/>
                  </a:lnTo>
                  <a:lnTo>
                    <a:pt x="1463" y="73"/>
                  </a:lnTo>
                  <a:lnTo>
                    <a:pt x="1469" y="71"/>
                  </a:lnTo>
                  <a:lnTo>
                    <a:pt x="1477" y="71"/>
                  </a:lnTo>
                  <a:lnTo>
                    <a:pt x="1487" y="70"/>
                  </a:lnTo>
                  <a:lnTo>
                    <a:pt x="1493" y="70"/>
                  </a:lnTo>
                  <a:lnTo>
                    <a:pt x="1502" y="68"/>
                  </a:lnTo>
                  <a:lnTo>
                    <a:pt x="1509" y="68"/>
                  </a:lnTo>
                  <a:lnTo>
                    <a:pt x="1517" y="68"/>
                  </a:lnTo>
                  <a:lnTo>
                    <a:pt x="1526" y="66"/>
                  </a:lnTo>
                  <a:lnTo>
                    <a:pt x="1533" y="66"/>
                  </a:lnTo>
                  <a:lnTo>
                    <a:pt x="1542" y="65"/>
                  </a:lnTo>
                  <a:lnTo>
                    <a:pt x="1550" y="65"/>
                  </a:lnTo>
                  <a:lnTo>
                    <a:pt x="1556" y="63"/>
                  </a:lnTo>
                  <a:lnTo>
                    <a:pt x="1566" y="63"/>
                  </a:lnTo>
                  <a:lnTo>
                    <a:pt x="1572" y="62"/>
                  </a:lnTo>
                  <a:lnTo>
                    <a:pt x="1580" y="62"/>
                  </a:lnTo>
                  <a:lnTo>
                    <a:pt x="1590" y="62"/>
                  </a:lnTo>
                  <a:lnTo>
                    <a:pt x="1596" y="60"/>
                  </a:lnTo>
                  <a:lnTo>
                    <a:pt x="1606" y="60"/>
                  </a:lnTo>
                  <a:lnTo>
                    <a:pt x="1614" y="59"/>
                  </a:lnTo>
                  <a:lnTo>
                    <a:pt x="1620" y="59"/>
                  </a:lnTo>
                  <a:lnTo>
                    <a:pt x="1630" y="57"/>
                  </a:lnTo>
                  <a:lnTo>
                    <a:pt x="1636" y="57"/>
                  </a:lnTo>
                  <a:lnTo>
                    <a:pt x="1644" y="57"/>
                  </a:lnTo>
                  <a:lnTo>
                    <a:pt x="1653" y="55"/>
                  </a:lnTo>
                  <a:lnTo>
                    <a:pt x="1660" y="55"/>
                  </a:lnTo>
                  <a:lnTo>
                    <a:pt x="1669" y="54"/>
                  </a:lnTo>
                  <a:lnTo>
                    <a:pt x="1677" y="54"/>
                  </a:lnTo>
                  <a:lnTo>
                    <a:pt x="1684" y="52"/>
                  </a:lnTo>
                  <a:lnTo>
                    <a:pt x="1692" y="52"/>
                  </a:lnTo>
                  <a:lnTo>
                    <a:pt x="1701" y="51"/>
                  </a:lnTo>
                  <a:lnTo>
                    <a:pt x="1707" y="51"/>
                  </a:lnTo>
                  <a:lnTo>
                    <a:pt x="1715" y="51"/>
                  </a:lnTo>
                  <a:lnTo>
                    <a:pt x="1725" y="49"/>
                  </a:lnTo>
                  <a:lnTo>
                    <a:pt x="1733" y="49"/>
                  </a:lnTo>
                  <a:lnTo>
                    <a:pt x="1739" y="47"/>
                  </a:lnTo>
                  <a:lnTo>
                    <a:pt x="1749" y="47"/>
                  </a:lnTo>
                  <a:lnTo>
                    <a:pt x="1757" y="46"/>
                  </a:lnTo>
                  <a:lnTo>
                    <a:pt x="1763" y="46"/>
                  </a:lnTo>
                  <a:lnTo>
                    <a:pt x="1773" y="46"/>
                  </a:lnTo>
                  <a:lnTo>
                    <a:pt x="1780" y="44"/>
                  </a:lnTo>
                  <a:lnTo>
                    <a:pt x="1787" y="44"/>
                  </a:lnTo>
                  <a:lnTo>
                    <a:pt x="1795" y="43"/>
                  </a:lnTo>
                  <a:lnTo>
                    <a:pt x="1804" y="43"/>
                  </a:lnTo>
                  <a:lnTo>
                    <a:pt x="1811" y="41"/>
                  </a:lnTo>
                  <a:lnTo>
                    <a:pt x="1819" y="41"/>
                  </a:lnTo>
                  <a:lnTo>
                    <a:pt x="1828" y="41"/>
                  </a:lnTo>
                  <a:lnTo>
                    <a:pt x="1835" y="39"/>
                  </a:lnTo>
                  <a:lnTo>
                    <a:pt x="1842" y="39"/>
                  </a:lnTo>
                  <a:lnTo>
                    <a:pt x="1852" y="38"/>
                  </a:lnTo>
                  <a:lnTo>
                    <a:pt x="1860" y="38"/>
                  </a:lnTo>
                  <a:lnTo>
                    <a:pt x="1866" y="36"/>
                  </a:lnTo>
                  <a:lnTo>
                    <a:pt x="1876" y="36"/>
                  </a:lnTo>
                  <a:lnTo>
                    <a:pt x="1884" y="36"/>
                  </a:lnTo>
                  <a:lnTo>
                    <a:pt x="1890" y="35"/>
                  </a:lnTo>
                  <a:lnTo>
                    <a:pt x="1898" y="35"/>
                  </a:lnTo>
                  <a:lnTo>
                    <a:pt x="1908" y="33"/>
                  </a:lnTo>
                  <a:lnTo>
                    <a:pt x="1914" y="33"/>
                  </a:lnTo>
                  <a:lnTo>
                    <a:pt x="1922" y="33"/>
                  </a:lnTo>
                  <a:lnTo>
                    <a:pt x="1931" y="32"/>
                  </a:lnTo>
                  <a:lnTo>
                    <a:pt x="1938" y="32"/>
                  </a:lnTo>
                  <a:lnTo>
                    <a:pt x="1946" y="30"/>
                  </a:lnTo>
                  <a:lnTo>
                    <a:pt x="1955" y="30"/>
                  </a:lnTo>
                  <a:lnTo>
                    <a:pt x="1963" y="28"/>
                  </a:lnTo>
                  <a:lnTo>
                    <a:pt x="1970" y="28"/>
                  </a:lnTo>
                  <a:lnTo>
                    <a:pt x="1979" y="28"/>
                  </a:lnTo>
                  <a:lnTo>
                    <a:pt x="1987" y="27"/>
                  </a:lnTo>
                  <a:lnTo>
                    <a:pt x="1993" y="27"/>
                  </a:lnTo>
                  <a:lnTo>
                    <a:pt x="2003" y="25"/>
                  </a:lnTo>
                  <a:lnTo>
                    <a:pt x="2011" y="25"/>
                  </a:lnTo>
                  <a:lnTo>
                    <a:pt x="2017" y="25"/>
                  </a:lnTo>
                  <a:lnTo>
                    <a:pt x="2025" y="24"/>
                  </a:lnTo>
                  <a:lnTo>
                    <a:pt x="2035" y="24"/>
                  </a:lnTo>
                  <a:lnTo>
                    <a:pt x="2041" y="22"/>
                  </a:lnTo>
                  <a:lnTo>
                    <a:pt x="2049" y="22"/>
                  </a:lnTo>
                  <a:lnTo>
                    <a:pt x="2059" y="20"/>
                  </a:lnTo>
                  <a:lnTo>
                    <a:pt x="2065" y="20"/>
                  </a:lnTo>
                  <a:lnTo>
                    <a:pt x="2073" y="20"/>
                  </a:lnTo>
                  <a:lnTo>
                    <a:pt x="2082" y="19"/>
                  </a:lnTo>
                  <a:lnTo>
                    <a:pt x="2090" y="19"/>
                  </a:lnTo>
                  <a:lnTo>
                    <a:pt x="2097" y="17"/>
                  </a:lnTo>
                  <a:lnTo>
                    <a:pt x="2106" y="17"/>
                  </a:lnTo>
                  <a:lnTo>
                    <a:pt x="2114" y="17"/>
                  </a:lnTo>
                  <a:lnTo>
                    <a:pt x="2120" y="16"/>
                  </a:lnTo>
                  <a:lnTo>
                    <a:pt x="2130" y="16"/>
                  </a:lnTo>
                  <a:lnTo>
                    <a:pt x="2138" y="14"/>
                  </a:lnTo>
                  <a:lnTo>
                    <a:pt x="2144" y="14"/>
                  </a:lnTo>
                  <a:lnTo>
                    <a:pt x="2152" y="14"/>
                  </a:lnTo>
                  <a:lnTo>
                    <a:pt x="2162" y="0"/>
                  </a:lnTo>
                  <a:lnTo>
                    <a:pt x="2168" y="0"/>
                  </a:lnTo>
                  <a:lnTo>
                    <a:pt x="2176" y="0"/>
                  </a:lnTo>
                  <a:lnTo>
                    <a:pt x="2186" y="0"/>
                  </a:lnTo>
                  <a:lnTo>
                    <a:pt x="2194" y="0"/>
                  </a:lnTo>
                  <a:lnTo>
                    <a:pt x="2200" y="0"/>
                  </a:lnTo>
                  <a:lnTo>
                    <a:pt x="2209" y="0"/>
                  </a:lnTo>
                  <a:lnTo>
                    <a:pt x="2217" y="0"/>
                  </a:lnTo>
                  <a:lnTo>
                    <a:pt x="2224" y="0"/>
                  </a:lnTo>
                  <a:lnTo>
                    <a:pt x="2233" y="0"/>
                  </a:lnTo>
                  <a:lnTo>
                    <a:pt x="2241" y="0"/>
                  </a:lnTo>
                  <a:lnTo>
                    <a:pt x="2248" y="1"/>
                  </a:lnTo>
                  <a:lnTo>
                    <a:pt x="2256" y="1"/>
                  </a:lnTo>
                  <a:lnTo>
                    <a:pt x="2265" y="1"/>
                  </a:lnTo>
                  <a:lnTo>
                    <a:pt x="2271" y="1"/>
                  </a:lnTo>
                  <a:lnTo>
                    <a:pt x="2279" y="1"/>
                  </a:lnTo>
                  <a:lnTo>
                    <a:pt x="2289" y="1"/>
                  </a:lnTo>
                  <a:lnTo>
                    <a:pt x="2295" y="1"/>
                  </a:lnTo>
                  <a:lnTo>
                    <a:pt x="2303" y="1"/>
                  </a:lnTo>
                  <a:lnTo>
                    <a:pt x="2313" y="1"/>
                  </a:lnTo>
                  <a:lnTo>
                    <a:pt x="2321" y="1"/>
                  </a:lnTo>
                  <a:lnTo>
                    <a:pt x="2327" y="1"/>
                  </a:lnTo>
                  <a:lnTo>
                    <a:pt x="2337" y="1"/>
                  </a:lnTo>
                  <a:lnTo>
                    <a:pt x="2344" y="1"/>
                  </a:lnTo>
                  <a:lnTo>
                    <a:pt x="2351" y="1"/>
                  </a:lnTo>
                  <a:lnTo>
                    <a:pt x="2360" y="1"/>
                  </a:lnTo>
                  <a:lnTo>
                    <a:pt x="2368" y="1"/>
                  </a:lnTo>
                  <a:lnTo>
                    <a:pt x="2375" y="1"/>
                  </a:lnTo>
                  <a:lnTo>
                    <a:pt x="2383" y="1"/>
                  </a:lnTo>
                  <a:lnTo>
                    <a:pt x="2392" y="3"/>
                  </a:lnTo>
                  <a:lnTo>
                    <a:pt x="2398" y="3"/>
                  </a:lnTo>
                  <a:lnTo>
                    <a:pt x="2406" y="3"/>
                  </a:lnTo>
                  <a:lnTo>
                    <a:pt x="2416" y="3"/>
                  </a:lnTo>
                  <a:lnTo>
                    <a:pt x="2422" y="3"/>
                  </a:lnTo>
                  <a:lnTo>
                    <a:pt x="2430" y="3"/>
                  </a:lnTo>
                  <a:lnTo>
                    <a:pt x="2440" y="3"/>
                  </a:lnTo>
                  <a:lnTo>
                    <a:pt x="2448" y="3"/>
                  </a:lnTo>
                  <a:lnTo>
                    <a:pt x="2454" y="3"/>
                  </a:lnTo>
                  <a:lnTo>
                    <a:pt x="2464" y="3"/>
                  </a:lnTo>
                  <a:lnTo>
                    <a:pt x="2472" y="3"/>
                  </a:lnTo>
                  <a:lnTo>
                    <a:pt x="2478" y="3"/>
                  </a:lnTo>
                  <a:lnTo>
                    <a:pt x="2487" y="3"/>
                  </a:lnTo>
                  <a:lnTo>
                    <a:pt x="2495" y="3"/>
                  </a:lnTo>
                  <a:lnTo>
                    <a:pt x="2502" y="3"/>
                  </a:lnTo>
                  <a:lnTo>
                    <a:pt x="2510" y="3"/>
                  </a:lnTo>
                  <a:lnTo>
                    <a:pt x="2519" y="3"/>
                  </a:lnTo>
                  <a:lnTo>
                    <a:pt x="2526" y="3"/>
                  </a:lnTo>
                  <a:lnTo>
                    <a:pt x="2534" y="5"/>
                  </a:lnTo>
                  <a:lnTo>
                    <a:pt x="2543" y="5"/>
                  </a:lnTo>
                  <a:lnTo>
                    <a:pt x="2551" y="5"/>
                  </a:lnTo>
                  <a:lnTo>
                    <a:pt x="2557" y="5"/>
                  </a:lnTo>
                  <a:lnTo>
                    <a:pt x="2567" y="5"/>
                  </a:lnTo>
                  <a:lnTo>
                    <a:pt x="2575" y="5"/>
                  </a:lnTo>
                  <a:lnTo>
                    <a:pt x="2581" y="5"/>
                  </a:lnTo>
                  <a:lnTo>
                    <a:pt x="2591" y="5"/>
                  </a:lnTo>
                  <a:lnTo>
                    <a:pt x="2599" y="5"/>
                  </a:lnTo>
                  <a:lnTo>
                    <a:pt x="2605" y="5"/>
                  </a:lnTo>
                  <a:lnTo>
                    <a:pt x="2613" y="5"/>
                  </a:lnTo>
                  <a:lnTo>
                    <a:pt x="2623" y="5"/>
                  </a:lnTo>
                  <a:lnTo>
                    <a:pt x="2629" y="5"/>
                  </a:lnTo>
                  <a:lnTo>
                    <a:pt x="2637" y="5"/>
                  </a:lnTo>
                  <a:lnTo>
                    <a:pt x="2646" y="5"/>
                  </a:lnTo>
                  <a:lnTo>
                    <a:pt x="2653" y="5"/>
                  </a:lnTo>
                  <a:lnTo>
                    <a:pt x="2661" y="5"/>
                  </a:lnTo>
                  <a:lnTo>
                    <a:pt x="2670" y="5"/>
                  </a:lnTo>
                  <a:lnTo>
                    <a:pt x="2678" y="5"/>
                  </a:lnTo>
                  <a:lnTo>
                    <a:pt x="2684" y="6"/>
                  </a:lnTo>
                  <a:lnTo>
                    <a:pt x="2694" y="6"/>
                  </a:lnTo>
                  <a:lnTo>
                    <a:pt x="2702" y="6"/>
                  </a:lnTo>
                  <a:lnTo>
                    <a:pt x="2708" y="6"/>
                  </a:lnTo>
                  <a:lnTo>
                    <a:pt x="2718" y="6"/>
                  </a:lnTo>
                  <a:lnTo>
                    <a:pt x="2726" y="6"/>
                  </a:lnTo>
                  <a:lnTo>
                    <a:pt x="2732" y="6"/>
                  </a:lnTo>
                  <a:lnTo>
                    <a:pt x="2740" y="6"/>
                  </a:lnTo>
                  <a:lnTo>
                    <a:pt x="2750" y="6"/>
                  </a:lnTo>
                  <a:lnTo>
                    <a:pt x="2756" y="6"/>
                  </a:lnTo>
                  <a:lnTo>
                    <a:pt x="2764" y="6"/>
                  </a:lnTo>
                  <a:lnTo>
                    <a:pt x="2773" y="6"/>
                  </a:lnTo>
                  <a:lnTo>
                    <a:pt x="2780" y="6"/>
                  </a:lnTo>
                  <a:lnTo>
                    <a:pt x="2788" y="6"/>
                  </a:lnTo>
                  <a:lnTo>
                    <a:pt x="2797" y="6"/>
                  </a:lnTo>
                  <a:lnTo>
                    <a:pt x="2805" y="6"/>
                  </a:lnTo>
                  <a:lnTo>
                    <a:pt x="2812" y="6"/>
                  </a:lnTo>
                  <a:lnTo>
                    <a:pt x="2821" y="6"/>
                  </a:lnTo>
                  <a:lnTo>
                    <a:pt x="2829" y="8"/>
                  </a:lnTo>
                  <a:lnTo>
                    <a:pt x="2835" y="8"/>
                  </a:lnTo>
                  <a:lnTo>
                    <a:pt x="2845" y="8"/>
                  </a:lnTo>
                  <a:lnTo>
                    <a:pt x="2853" y="8"/>
                  </a:lnTo>
                  <a:lnTo>
                    <a:pt x="2859" y="8"/>
                  </a:lnTo>
                  <a:lnTo>
                    <a:pt x="2867" y="8"/>
                  </a:lnTo>
                  <a:lnTo>
                    <a:pt x="2877" y="8"/>
                  </a:lnTo>
                  <a:lnTo>
                    <a:pt x="2883" y="8"/>
                  </a:lnTo>
                  <a:lnTo>
                    <a:pt x="2891" y="8"/>
                  </a:lnTo>
                  <a:lnTo>
                    <a:pt x="2901" y="8"/>
                  </a:lnTo>
                  <a:lnTo>
                    <a:pt x="2908" y="8"/>
                  </a:lnTo>
                  <a:lnTo>
                    <a:pt x="2915" y="8"/>
                  </a:lnTo>
                  <a:lnTo>
                    <a:pt x="2924" y="8"/>
                  </a:lnTo>
                  <a:lnTo>
                    <a:pt x="2932" y="8"/>
                  </a:lnTo>
                  <a:lnTo>
                    <a:pt x="2939" y="8"/>
                  </a:lnTo>
                  <a:lnTo>
                    <a:pt x="2948" y="8"/>
                  </a:lnTo>
                  <a:lnTo>
                    <a:pt x="2956" y="8"/>
                  </a:lnTo>
                  <a:lnTo>
                    <a:pt x="2962" y="8"/>
                  </a:lnTo>
                  <a:lnTo>
                    <a:pt x="2970" y="8"/>
                  </a:lnTo>
                  <a:lnTo>
                    <a:pt x="2980" y="9"/>
                  </a:lnTo>
                  <a:lnTo>
                    <a:pt x="2986" y="9"/>
                  </a:lnTo>
                  <a:lnTo>
                    <a:pt x="2994" y="9"/>
                  </a:lnTo>
                  <a:lnTo>
                    <a:pt x="3004" y="9"/>
                  </a:lnTo>
                  <a:lnTo>
                    <a:pt x="3010" y="9"/>
                  </a:lnTo>
                  <a:lnTo>
                    <a:pt x="3018" y="9"/>
                  </a:lnTo>
                  <a:lnTo>
                    <a:pt x="3028" y="9"/>
                  </a:lnTo>
                  <a:lnTo>
                    <a:pt x="3036" y="9"/>
                  </a:lnTo>
                  <a:lnTo>
                    <a:pt x="3042" y="9"/>
                  </a:lnTo>
                  <a:lnTo>
                    <a:pt x="3051" y="9"/>
                  </a:lnTo>
                  <a:lnTo>
                    <a:pt x="3059" y="9"/>
                  </a:lnTo>
                  <a:lnTo>
                    <a:pt x="3066" y="9"/>
                  </a:lnTo>
                  <a:lnTo>
                    <a:pt x="3074" y="9"/>
                  </a:lnTo>
                  <a:lnTo>
                    <a:pt x="3082" y="9"/>
                  </a:lnTo>
                  <a:lnTo>
                    <a:pt x="3091" y="9"/>
                  </a:lnTo>
                  <a:lnTo>
                    <a:pt x="3099" y="9"/>
                  </a:lnTo>
                  <a:lnTo>
                    <a:pt x="3107" y="9"/>
                  </a:lnTo>
                  <a:lnTo>
                    <a:pt x="3113" y="9"/>
                  </a:lnTo>
                  <a:lnTo>
                    <a:pt x="3121" y="9"/>
                  </a:lnTo>
                  <a:lnTo>
                    <a:pt x="3129" y="11"/>
                  </a:lnTo>
                  <a:lnTo>
                    <a:pt x="3139" y="11"/>
                  </a:lnTo>
                  <a:lnTo>
                    <a:pt x="3147" y="11"/>
                  </a:lnTo>
                  <a:lnTo>
                    <a:pt x="3155" y="11"/>
                  </a:lnTo>
                  <a:lnTo>
                    <a:pt x="3163" y="11"/>
                  </a:lnTo>
                  <a:lnTo>
                    <a:pt x="3169" y="11"/>
                  </a:lnTo>
                  <a:lnTo>
                    <a:pt x="3177" y="11"/>
                  </a:lnTo>
                  <a:lnTo>
                    <a:pt x="3185" y="11"/>
                  </a:lnTo>
                  <a:lnTo>
                    <a:pt x="3194" y="11"/>
                  </a:lnTo>
                  <a:lnTo>
                    <a:pt x="3202" y="11"/>
                  </a:lnTo>
                  <a:lnTo>
                    <a:pt x="3210" y="11"/>
                  </a:lnTo>
                  <a:lnTo>
                    <a:pt x="3217" y="11"/>
                  </a:lnTo>
                  <a:lnTo>
                    <a:pt x="3225" y="11"/>
                  </a:lnTo>
                  <a:lnTo>
                    <a:pt x="3233" y="11"/>
                  </a:lnTo>
                  <a:lnTo>
                    <a:pt x="3242" y="11"/>
                  </a:lnTo>
                  <a:lnTo>
                    <a:pt x="3250" y="11"/>
                  </a:lnTo>
                  <a:lnTo>
                    <a:pt x="3258" y="11"/>
                  </a:lnTo>
                  <a:lnTo>
                    <a:pt x="3266" y="11"/>
                  </a:lnTo>
                  <a:lnTo>
                    <a:pt x="3272" y="11"/>
                  </a:lnTo>
                  <a:lnTo>
                    <a:pt x="3280" y="12"/>
                  </a:lnTo>
                  <a:lnTo>
                    <a:pt x="3288" y="12"/>
                  </a:lnTo>
                  <a:lnTo>
                    <a:pt x="3298" y="12"/>
                  </a:lnTo>
                  <a:lnTo>
                    <a:pt x="3306" y="12"/>
                  </a:lnTo>
                  <a:lnTo>
                    <a:pt x="3314" y="12"/>
                  </a:lnTo>
                  <a:lnTo>
                    <a:pt x="3320" y="12"/>
                  </a:lnTo>
                  <a:lnTo>
                    <a:pt x="3328" y="12"/>
                  </a:lnTo>
                  <a:lnTo>
                    <a:pt x="3336" y="12"/>
                  </a:lnTo>
                  <a:lnTo>
                    <a:pt x="3345" y="12"/>
                  </a:lnTo>
                  <a:lnTo>
                    <a:pt x="3353" y="12"/>
                  </a:lnTo>
                  <a:lnTo>
                    <a:pt x="3361" y="12"/>
                  </a:lnTo>
                  <a:lnTo>
                    <a:pt x="3368" y="12"/>
                  </a:lnTo>
                  <a:lnTo>
                    <a:pt x="3376" y="12"/>
                  </a:lnTo>
                  <a:lnTo>
                    <a:pt x="3384" y="12"/>
                  </a:lnTo>
                  <a:lnTo>
                    <a:pt x="3391" y="12"/>
                  </a:lnTo>
                  <a:lnTo>
                    <a:pt x="3401" y="12"/>
                  </a:lnTo>
                  <a:lnTo>
                    <a:pt x="3409" y="12"/>
                  </a:lnTo>
                  <a:lnTo>
                    <a:pt x="3417" y="12"/>
                  </a:lnTo>
                  <a:lnTo>
                    <a:pt x="3423" y="12"/>
                  </a:lnTo>
                  <a:lnTo>
                    <a:pt x="3431" y="14"/>
                  </a:lnTo>
                  <a:lnTo>
                    <a:pt x="3439" y="14"/>
                  </a:lnTo>
                  <a:lnTo>
                    <a:pt x="3449" y="14"/>
                  </a:lnTo>
                  <a:lnTo>
                    <a:pt x="3457" y="14"/>
                  </a:lnTo>
                  <a:lnTo>
                    <a:pt x="3465" y="14"/>
                  </a:lnTo>
                  <a:lnTo>
                    <a:pt x="3471" y="14"/>
                  </a:lnTo>
                  <a:lnTo>
                    <a:pt x="3479" y="14"/>
                  </a:lnTo>
                  <a:lnTo>
                    <a:pt x="3487" y="14"/>
                  </a:lnTo>
                  <a:lnTo>
                    <a:pt x="3496" y="14"/>
                  </a:lnTo>
                  <a:lnTo>
                    <a:pt x="3504" y="14"/>
                  </a:lnTo>
                  <a:lnTo>
                    <a:pt x="3512" y="14"/>
                  </a:lnTo>
                  <a:lnTo>
                    <a:pt x="3520" y="14"/>
                  </a:lnTo>
                  <a:lnTo>
                    <a:pt x="3526" y="14"/>
                  </a:lnTo>
                  <a:lnTo>
                    <a:pt x="3534" y="14"/>
                  </a:lnTo>
                  <a:lnTo>
                    <a:pt x="3542" y="14"/>
                  </a:lnTo>
                  <a:lnTo>
                    <a:pt x="3552" y="14"/>
                  </a:lnTo>
                  <a:lnTo>
                    <a:pt x="3560" y="14"/>
                  </a:lnTo>
                  <a:lnTo>
                    <a:pt x="3568" y="14"/>
                  </a:lnTo>
                  <a:lnTo>
                    <a:pt x="3574" y="14"/>
                  </a:lnTo>
                  <a:lnTo>
                    <a:pt x="3582" y="14"/>
                  </a:lnTo>
                  <a:lnTo>
                    <a:pt x="3590" y="16"/>
                  </a:lnTo>
                  <a:lnTo>
                    <a:pt x="3600" y="16"/>
                  </a:lnTo>
                  <a:lnTo>
                    <a:pt x="3608" y="16"/>
                  </a:lnTo>
                  <a:lnTo>
                    <a:pt x="3615" y="16"/>
                  </a:lnTo>
                  <a:lnTo>
                    <a:pt x="3623" y="16"/>
                  </a:lnTo>
                  <a:lnTo>
                    <a:pt x="3630" y="16"/>
                  </a:lnTo>
                  <a:lnTo>
                    <a:pt x="3638" y="16"/>
                  </a:lnTo>
                  <a:lnTo>
                    <a:pt x="3646" y="16"/>
                  </a:lnTo>
                  <a:lnTo>
                    <a:pt x="3655" y="16"/>
                  </a:lnTo>
                  <a:lnTo>
                    <a:pt x="3663" y="16"/>
                  </a:lnTo>
                  <a:lnTo>
                    <a:pt x="3671" y="16"/>
                  </a:lnTo>
                  <a:lnTo>
                    <a:pt x="3677" y="16"/>
                  </a:lnTo>
                  <a:lnTo>
                    <a:pt x="3685" y="16"/>
                  </a:lnTo>
                  <a:lnTo>
                    <a:pt x="3693" y="16"/>
                  </a:lnTo>
                  <a:lnTo>
                    <a:pt x="3703" y="16"/>
                  </a:lnTo>
                  <a:lnTo>
                    <a:pt x="3711" y="16"/>
                  </a:lnTo>
                  <a:lnTo>
                    <a:pt x="3719" y="16"/>
                  </a:lnTo>
                  <a:lnTo>
                    <a:pt x="3725" y="16"/>
                  </a:lnTo>
                  <a:lnTo>
                    <a:pt x="3733" y="16"/>
                  </a:lnTo>
                  <a:lnTo>
                    <a:pt x="3741" y="17"/>
                  </a:lnTo>
                  <a:lnTo>
                    <a:pt x="3749" y="17"/>
                  </a:lnTo>
                  <a:lnTo>
                    <a:pt x="3758" y="17"/>
                  </a:lnTo>
                  <a:lnTo>
                    <a:pt x="3766" y="17"/>
                  </a:lnTo>
                  <a:lnTo>
                    <a:pt x="3774" y="17"/>
                  </a:lnTo>
                  <a:lnTo>
                    <a:pt x="3781" y="17"/>
                  </a:lnTo>
                  <a:lnTo>
                    <a:pt x="3789" y="17"/>
                  </a:lnTo>
                  <a:lnTo>
                    <a:pt x="3797" y="17"/>
                  </a:lnTo>
                  <a:lnTo>
                    <a:pt x="3806" y="17"/>
                  </a:lnTo>
                  <a:lnTo>
                    <a:pt x="3814" y="17"/>
                  </a:lnTo>
                  <a:lnTo>
                    <a:pt x="3822" y="17"/>
                  </a:lnTo>
                  <a:lnTo>
                    <a:pt x="3828" y="17"/>
                  </a:lnTo>
                  <a:lnTo>
                    <a:pt x="3836" y="17"/>
                  </a:lnTo>
                  <a:lnTo>
                    <a:pt x="3844" y="17"/>
                  </a:lnTo>
                  <a:lnTo>
                    <a:pt x="3854" y="17"/>
                  </a:lnTo>
                  <a:lnTo>
                    <a:pt x="3862" y="17"/>
                  </a:lnTo>
                  <a:lnTo>
                    <a:pt x="3870" y="17"/>
                  </a:lnTo>
                  <a:lnTo>
                    <a:pt x="3878" y="17"/>
                  </a:lnTo>
                  <a:lnTo>
                    <a:pt x="3884" y="17"/>
                  </a:lnTo>
                  <a:lnTo>
                    <a:pt x="3892" y="17"/>
                  </a:lnTo>
                  <a:lnTo>
                    <a:pt x="3900" y="19"/>
                  </a:lnTo>
                  <a:lnTo>
                    <a:pt x="3909" y="19"/>
                  </a:lnTo>
                  <a:lnTo>
                    <a:pt x="3917" y="19"/>
                  </a:lnTo>
                  <a:lnTo>
                    <a:pt x="3925" y="19"/>
                  </a:lnTo>
                  <a:lnTo>
                    <a:pt x="3932" y="19"/>
                  </a:lnTo>
                  <a:lnTo>
                    <a:pt x="3940" y="19"/>
                  </a:lnTo>
                  <a:lnTo>
                    <a:pt x="3947" y="19"/>
                  </a:lnTo>
                  <a:lnTo>
                    <a:pt x="3957" y="19"/>
                  </a:lnTo>
                  <a:lnTo>
                    <a:pt x="3965" y="19"/>
                  </a:lnTo>
                  <a:lnTo>
                    <a:pt x="3973" y="19"/>
                  </a:lnTo>
                  <a:lnTo>
                    <a:pt x="3981" y="19"/>
                  </a:lnTo>
                  <a:lnTo>
                    <a:pt x="3987" y="19"/>
                  </a:lnTo>
                  <a:lnTo>
                    <a:pt x="3995" y="19"/>
                  </a:lnTo>
                  <a:lnTo>
                    <a:pt x="4003" y="19"/>
                  </a:lnTo>
                  <a:lnTo>
                    <a:pt x="4013" y="19"/>
                  </a:lnTo>
                  <a:lnTo>
                    <a:pt x="4021" y="19"/>
                  </a:lnTo>
                  <a:lnTo>
                    <a:pt x="4029" y="19"/>
                  </a:lnTo>
                  <a:lnTo>
                    <a:pt x="4035" y="19"/>
                  </a:lnTo>
                  <a:lnTo>
                    <a:pt x="4043" y="19"/>
                  </a:lnTo>
                  <a:lnTo>
                    <a:pt x="4051" y="19"/>
                  </a:lnTo>
                  <a:lnTo>
                    <a:pt x="4060" y="20"/>
                  </a:lnTo>
                  <a:lnTo>
                    <a:pt x="4068" y="20"/>
                  </a:lnTo>
                  <a:lnTo>
                    <a:pt x="4076" y="20"/>
                  </a:lnTo>
                  <a:lnTo>
                    <a:pt x="4083" y="20"/>
                  </a:lnTo>
                  <a:lnTo>
                    <a:pt x="4090" y="20"/>
                  </a:lnTo>
                  <a:lnTo>
                    <a:pt x="4098" y="20"/>
                  </a:lnTo>
                  <a:lnTo>
                    <a:pt x="4106" y="2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57" name="Freeform 107"/>
            <p:cNvSpPr>
              <a:spLocks/>
            </p:cNvSpPr>
            <p:nvPr/>
          </p:nvSpPr>
          <p:spPr bwMode="auto">
            <a:xfrm>
              <a:off x="778" y="2741"/>
              <a:ext cx="4109" cy="95"/>
            </a:xfrm>
            <a:custGeom>
              <a:avLst/>
              <a:gdLst>
                <a:gd name="T0" fmla="*/ 64 w 4109"/>
                <a:gd name="T1" fmla="*/ 95 h 95"/>
                <a:gd name="T2" fmla="*/ 137 w 4109"/>
                <a:gd name="T3" fmla="*/ 95 h 95"/>
                <a:gd name="T4" fmla="*/ 209 w 4109"/>
                <a:gd name="T5" fmla="*/ 95 h 95"/>
                <a:gd name="T6" fmla="*/ 278 w 4109"/>
                <a:gd name="T7" fmla="*/ 95 h 95"/>
                <a:gd name="T8" fmla="*/ 352 w 4109"/>
                <a:gd name="T9" fmla="*/ 84 h 95"/>
                <a:gd name="T10" fmla="*/ 421 w 4109"/>
                <a:gd name="T11" fmla="*/ 81 h 95"/>
                <a:gd name="T12" fmla="*/ 493 w 4109"/>
                <a:gd name="T13" fmla="*/ 78 h 95"/>
                <a:gd name="T14" fmla="*/ 566 w 4109"/>
                <a:gd name="T15" fmla="*/ 73 h 95"/>
                <a:gd name="T16" fmla="*/ 636 w 4109"/>
                <a:gd name="T17" fmla="*/ 70 h 95"/>
                <a:gd name="T18" fmla="*/ 709 w 4109"/>
                <a:gd name="T19" fmla="*/ 67 h 95"/>
                <a:gd name="T20" fmla="*/ 779 w 4109"/>
                <a:gd name="T21" fmla="*/ 63 h 95"/>
                <a:gd name="T22" fmla="*/ 850 w 4109"/>
                <a:gd name="T23" fmla="*/ 59 h 95"/>
                <a:gd name="T24" fmla="*/ 922 w 4109"/>
                <a:gd name="T25" fmla="*/ 55 h 95"/>
                <a:gd name="T26" fmla="*/ 993 w 4109"/>
                <a:gd name="T27" fmla="*/ 52 h 95"/>
                <a:gd name="T28" fmla="*/ 1066 w 4109"/>
                <a:gd name="T29" fmla="*/ 49 h 95"/>
                <a:gd name="T30" fmla="*/ 1138 w 4109"/>
                <a:gd name="T31" fmla="*/ 46 h 95"/>
                <a:gd name="T32" fmla="*/ 1208 w 4109"/>
                <a:gd name="T33" fmla="*/ 43 h 95"/>
                <a:gd name="T34" fmla="*/ 1281 w 4109"/>
                <a:gd name="T35" fmla="*/ 40 h 95"/>
                <a:gd name="T36" fmla="*/ 1351 w 4109"/>
                <a:gd name="T37" fmla="*/ 35 h 95"/>
                <a:gd name="T38" fmla="*/ 1424 w 4109"/>
                <a:gd name="T39" fmla="*/ 32 h 95"/>
                <a:gd name="T40" fmla="*/ 1494 w 4109"/>
                <a:gd name="T41" fmla="*/ 28 h 95"/>
                <a:gd name="T42" fmla="*/ 1565 w 4109"/>
                <a:gd name="T43" fmla="*/ 25 h 95"/>
                <a:gd name="T44" fmla="*/ 1638 w 4109"/>
                <a:gd name="T45" fmla="*/ 22 h 95"/>
                <a:gd name="T46" fmla="*/ 1710 w 4109"/>
                <a:gd name="T47" fmla="*/ 19 h 95"/>
                <a:gd name="T48" fmla="*/ 1780 w 4109"/>
                <a:gd name="T49" fmla="*/ 16 h 95"/>
                <a:gd name="T50" fmla="*/ 1851 w 4109"/>
                <a:gd name="T51" fmla="*/ 13 h 95"/>
                <a:gd name="T52" fmla="*/ 1923 w 4109"/>
                <a:gd name="T53" fmla="*/ 9 h 95"/>
                <a:gd name="T54" fmla="*/ 1996 w 4109"/>
                <a:gd name="T55" fmla="*/ 6 h 95"/>
                <a:gd name="T56" fmla="*/ 2067 w 4109"/>
                <a:gd name="T57" fmla="*/ 3 h 95"/>
                <a:gd name="T58" fmla="*/ 2137 w 4109"/>
                <a:gd name="T59" fmla="*/ 0 h 95"/>
                <a:gd name="T60" fmla="*/ 2209 w 4109"/>
                <a:gd name="T61" fmla="*/ 9 h 95"/>
                <a:gd name="T62" fmla="*/ 2280 w 4109"/>
                <a:gd name="T63" fmla="*/ 9 h 95"/>
                <a:gd name="T64" fmla="*/ 2353 w 4109"/>
                <a:gd name="T65" fmla="*/ 9 h 95"/>
                <a:gd name="T66" fmla="*/ 2425 w 4109"/>
                <a:gd name="T67" fmla="*/ 11 h 95"/>
                <a:gd name="T68" fmla="*/ 2495 w 4109"/>
                <a:gd name="T69" fmla="*/ 11 h 95"/>
                <a:gd name="T70" fmla="*/ 2566 w 4109"/>
                <a:gd name="T71" fmla="*/ 11 h 95"/>
                <a:gd name="T72" fmla="*/ 2638 w 4109"/>
                <a:gd name="T73" fmla="*/ 11 h 95"/>
                <a:gd name="T74" fmla="*/ 2711 w 4109"/>
                <a:gd name="T75" fmla="*/ 13 h 95"/>
                <a:gd name="T76" fmla="*/ 2782 w 4109"/>
                <a:gd name="T77" fmla="*/ 13 h 95"/>
                <a:gd name="T78" fmla="*/ 2852 w 4109"/>
                <a:gd name="T79" fmla="*/ 13 h 95"/>
                <a:gd name="T80" fmla="*/ 2924 w 4109"/>
                <a:gd name="T81" fmla="*/ 13 h 95"/>
                <a:gd name="T82" fmla="*/ 2995 w 4109"/>
                <a:gd name="T83" fmla="*/ 14 h 95"/>
                <a:gd name="T84" fmla="*/ 3067 w 4109"/>
                <a:gd name="T85" fmla="*/ 14 h 95"/>
                <a:gd name="T86" fmla="*/ 3140 w 4109"/>
                <a:gd name="T87" fmla="*/ 14 h 95"/>
                <a:gd name="T88" fmla="*/ 3210 w 4109"/>
                <a:gd name="T89" fmla="*/ 14 h 95"/>
                <a:gd name="T90" fmla="*/ 3283 w 4109"/>
                <a:gd name="T91" fmla="*/ 16 h 95"/>
                <a:gd name="T92" fmla="*/ 3353 w 4109"/>
                <a:gd name="T93" fmla="*/ 16 h 95"/>
                <a:gd name="T94" fmla="*/ 3424 w 4109"/>
                <a:gd name="T95" fmla="*/ 16 h 95"/>
                <a:gd name="T96" fmla="*/ 3497 w 4109"/>
                <a:gd name="T97" fmla="*/ 16 h 95"/>
                <a:gd name="T98" fmla="*/ 3567 w 4109"/>
                <a:gd name="T99" fmla="*/ 16 h 95"/>
                <a:gd name="T100" fmla="*/ 3640 w 4109"/>
                <a:gd name="T101" fmla="*/ 17 h 95"/>
                <a:gd name="T102" fmla="*/ 3710 w 4109"/>
                <a:gd name="T103" fmla="*/ 17 h 95"/>
                <a:gd name="T104" fmla="*/ 3782 w 4109"/>
                <a:gd name="T105" fmla="*/ 17 h 95"/>
                <a:gd name="T106" fmla="*/ 3855 w 4109"/>
                <a:gd name="T107" fmla="*/ 17 h 95"/>
                <a:gd name="T108" fmla="*/ 3925 w 4109"/>
                <a:gd name="T109" fmla="*/ 19 h 95"/>
                <a:gd name="T110" fmla="*/ 3998 w 4109"/>
                <a:gd name="T111" fmla="*/ 19 h 95"/>
                <a:gd name="T112" fmla="*/ 4068 w 4109"/>
                <a:gd name="T113" fmla="*/ 19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109" h="95">
                  <a:moveTo>
                    <a:pt x="0" y="95"/>
                  </a:moveTo>
                  <a:lnTo>
                    <a:pt x="10" y="95"/>
                  </a:lnTo>
                  <a:lnTo>
                    <a:pt x="16" y="95"/>
                  </a:lnTo>
                  <a:lnTo>
                    <a:pt x="26" y="95"/>
                  </a:lnTo>
                  <a:lnTo>
                    <a:pt x="32" y="95"/>
                  </a:lnTo>
                  <a:lnTo>
                    <a:pt x="42" y="95"/>
                  </a:lnTo>
                  <a:lnTo>
                    <a:pt x="48" y="95"/>
                  </a:lnTo>
                  <a:lnTo>
                    <a:pt x="58" y="95"/>
                  </a:lnTo>
                  <a:lnTo>
                    <a:pt x="64" y="95"/>
                  </a:lnTo>
                  <a:lnTo>
                    <a:pt x="74" y="95"/>
                  </a:lnTo>
                  <a:lnTo>
                    <a:pt x="80" y="95"/>
                  </a:lnTo>
                  <a:lnTo>
                    <a:pt x="89" y="95"/>
                  </a:lnTo>
                  <a:lnTo>
                    <a:pt x="96" y="95"/>
                  </a:lnTo>
                  <a:lnTo>
                    <a:pt x="105" y="95"/>
                  </a:lnTo>
                  <a:lnTo>
                    <a:pt x="112" y="95"/>
                  </a:lnTo>
                  <a:lnTo>
                    <a:pt x="120" y="95"/>
                  </a:lnTo>
                  <a:lnTo>
                    <a:pt x="129" y="95"/>
                  </a:lnTo>
                  <a:lnTo>
                    <a:pt x="137" y="95"/>
                  </a:lnTo>
                  <a:lnTo>
                    <a:pt x="145" y="95"/>
                  </a:lnTo>
                  <a:lnTo>
                    <a:pt x="153" y="95"/>
                  </a:lnTo>
                  <a:lnTo>
                    <a:pt x="161" y="95"/>
                  </a:lnTo>
                  <a:lnTo>
                    <a:pt x="169" y="95"/>
                  </a:lnTo>
                  <a:lnTo>
                    <a:pt x="177" y="95"/>
                  </a:lnTo>
                  <a:lnTo>
                    <a:pt x="185" y="95"/>
                  </a:lnTo>
                  <a:lnTo>
                    <a:pt x="193" y="95"/>
                  </a:lnTo>
                  <a:lnTo>
                    <a:pt x="201" y="95"/>
                  </a:lnTo>
                  <a:lnTo>
                    <a:pt x="209" y="95"/>
                  </a:lnTo>
                  <a:lnTo>
                    <a:pt x="216" y="95"/>
                  </a:lnTo>
                  <a:lnTo>
                    <a:pt x="223" y="95"/>
                  </a:lnTo>
                  <a:lnTo>
                    <a:pt x="231" y="95"/>
                  </a:lnTo>
                  <a:lnTo>
                    <a:pt x="239" y="95"/>
                  </a:lnTo>
                  <a:lnTo>
                    <a:pt x="247" y="95"/>
                  </a:lnTo>
                  <a:lnTo>
                    <a:pt x="255" y="95"/>
                  </a:lnTo>
                  <a:lnTo>
                    <a:pt x="263" y="95"/>
                  </a:lnTo>
                  <a:lnTo>
                    <a:pt x="271" y="95"/>
                  </a:lnTo>
                  <a:lnTo>
                    <a:pt x="278" y="95"/>
                  </a:lnTo>
                  <a:lnTo>
                    <a:pt x="288" y="95"/>
                  </a:lnTo>
                  <a:lnTo>
                    <a:pt x="296" y="95"/>
                  </a:lnTo>
                  <a:lnTo>
                    <a:pt x="304" y="95"/>
                  </a:lnTo>
                  <a:lnTo>
                    <a:pt x="312" y="87"/>
                  </a:lnTo>
                  <a:lnTo>
                    <a:pt x="318" y="86"/>
                  </a:lnTo>
                  <a:lnTo>
                    <a:pt x="328" y="86"/>
                  </a:lnTo>
                  <a:lnTo>
                    <a:pt x="334" y="86"/>
                  </a:lnTo>
                  <a:lnTo>
                    <a:pt x="342" y="86"/>
                  </a:lnTo>
                  <a:lnTo>
                    <a:pt x="352" y="84"/>
                  </a:lnTo>
                  <a:lnTo>
                    <a:pt x="359" y="84"/>
                  </a:lnTo>
                  <a:lnTo>
                    <a:pt x="367" y="84"/>
                  </a:lnTo>
                  <a:lnTo>
                    <a:pt x="374" y="82"/>
                  </a:lnTo>
                  <a:lnTo>
                    <a:pt x="382" y="82"/>
                  </a:lnTo>
                  <a:lnTo>
                    <a:pt x="390" y="82"/>
                  </a:lnTo>
                  <a:lnTo>
                    <a:pt x="398" y="82"/>
                  </a:lnTo>
                  <a:lnTo>
                    <a:pt x="406" y="81"/>
                  </a:lnTo>
                  <a:lnTo>
                    <a:pt x="413" y="81"/>
                  </a:lnTo>
                  <a:lnTo>
                    <a:pt x="421" y="81"/>
                  </a:lnTo>
                  <a:lnTo>
                    <a:pt x="429" y="81"/>
                  </a:lnTo>
                  <a:lnTo>
                    <a:pt x="437" y="79"/>
                  </a:lnTo>
                  <a:lnTo>
                    <a:pt x="445" y="79"/>
                  </a:lnTo>
                  <a:lnTo>
                    <a:pt x="453" y="79"/>
                  </a:lnTo>
                  <a:lnTo>
                    <a:pt x="463" y="79"/>
                  </a:lnTo>
                  <a:lnTo>
                    <a:pt x="471" y="78"/>
                  </a:lnTo>
                  <a:lnTo>
                    <a:pt x="477" y="78"/>
                  </a:lnTo>
                  <a:lnTo>
                    <a:pt x="487" y="78"/>
                  </a:lnTo>
                  <a:lnTo>
                    <a:pt x="493" y="78"/>
                  </a:lnTo>
                  <a:lnTo>
                    <a:pt x="502" y="76"/>
                  </a:lnTo>
                  <a:lnTo>
                    <a:pt x="509" y="76"/>
                  </a:lnTo>
                  <a:lnTo>
                    <a:pt x="518" y="76"/>
                  </a:lnTo>
                  <a:lnTo>
                    <a:pt x="525" y="76"/>
                  </a:lnTo>
                  <a:lnTo>
                    <a:pt x="534" y="74"/>
                  </a:lnTo>
                  <a:lnTo>
                    <a:pt x="541" y="74"/>
                  </a:lnTo>
                  <a:lnTo>
                    <a:pt x="550" y="74"/>
                  </a:lnTo>
                  <a:lnTo>
                    <a:pt x="556" y="74"/>
                  </a:lnTo>
                  <a:lnTo>
                    <a:pt x="566" y="73"/>
                  </a:lnTo>
                  <a:lnTo>
                    <a:pt x="572" y="73"/>
                  </a:lnTo>
                  <a:lnTo>
                    <a:pt x="582" y="73"/>
                  </a:lnTo>
                  <a:lnTo>
                    <a:pt x="588" y="73"/>
                  </a:lnTo>
                  <a:lnTo>
                    <a:pt x="598" y="71"/>
                  </a:lnTo>
                  <a:lnTo>
                    <a:pt x="604" y="71"/>
                  </a:lnTo>
                  <a:lnTo>
                    <a:pt x="614" y="71"/>
                  </a:lnTo>
                  <a:lnTo>
                    <a:pt x="620" y="71"/>
                  </a:lnTo>
                  <a:lnTo>
                    <a:pt x="630" y="70"/>
                  </a:lnTo>
                  <a:lnTo>
                    <a:pt x="636" y="70"/>
                  </a:lnTo>
                  <a:lnTo>
                    <a:pt x="645" y="70"/>
                  </a:lnTo>
                  <a:lnTo>
                    <a:pt x="652" y="70"/>
                  </a:lnTo>
                  <a:lnTo>
                    <a:pt x="660" y="68"/>
                  </a:lnTo>
                  <a:lnTo>
                    <a:pt x="669" y="68"/>
                  </a:lnTo>
                  <a:lnTo>
                    <a:pt x="677" y="68"/>
                  </a:lnTo>
                  <a:lnTo>
                    <a:pt x="684" y="68"/>
                  </a:lnTo>
                  <a:lnTo>
                    <a:pt x="692" y="67"/>
                  </a:lnTo>
                  <a:lnTo>
                    <a:pt x="701" y="67"/>
                  </a:lnTo>
                  <a:lnTo>
                    <a:pt x="709" y="67"/>
                  </a:lnTo>
                  <a:lnTo>
                    <a:pt x="715" y="67"/>
                  </a:lnTo>
                  <a:lnTo>
                    <a:pt x="723" y="65"/>
                  </a:lnTo>
                  <a:lnTo>
                    <a:pt x="733" y="65"/>
                  </a:lnTo>
                  <a:lnTo>
                    <a:pt x="741" y="65"/>
                  </a:lnTo>
                  <a:lnTo>
                    <a:pt x="747" y="65"/>
                  </a:lnTo>
                  <a:lnTo>
                    <a:pt x="755" y="63"/>
                  </a:lnTo>
                  <a:lnTo>
                    <a:pt x="765" y="63"/>
                  </a:lnTo>
                  <a:lnTo>
                    <a:pt x="773" y="63"/>
                  </a:lnTo>
                  <a:lnTo>
                    <a:pt x="779" y="63"/>
                  </a:lnTo>
                  <a:lnTo>
                    <a:pt x="787" y="62"/>
                  </a:lnTo>
                  <a:lnTo>
                    <a:pt x="796" y="62"/>
                  </a:lnTo>
                  <a:lnTo>
                    <a:pt x="804" y="62"/>
                  </a:lnTo>
                  <a:lnTo>
                    <a:pt x="812" y="62"/>
                  </a:lnTo>
                  <a:lnTo>
                    <a:pt x="819" y="60"/>
                  </a:lnTo>
                  <a:lnTo>
                    <a:pt x="827" y="60"/>
                  </a:lnTo>
                  <a:lnTo>
                    <a:pt x="836" y="60"/>
                  </a:lnTo>
                  <a:lnTo>
                    <a:pt x="844" y="60"/>
                  </a:lnTo>
                  <a:lnTo>
                    <a:pt x="850" y="59"/>
                  </a:lnTo>
                  <a:lnTo>
                    <a:pt x="858" y="59"/>
                  </a:lnTo>
                  <a:lnTo>
                    <a:pt x="868" y="59"/>
                  </a:lnTo>
                  <a:lnTo>
                    <a:pt x="876" y="59"/>
                  </a:lnTo>
                  <a:lnTo>
                    <a:pt x="882" y="59"/>
                  </a:lnTo>
                  <a:lnTo>
                    <a:pt x="890" y="57"/>
                  </a:lnTo>
                  <a:lnTo>
                    <a:pt x="900" y="57"/>
                  </a:lnTo>
                  <a:lnTo>
                    <a:pt x="908" y="57"/>
                  </a:lnTo>
                  <a:lnTo>
                    <a:pt x="914" y="57"/>
                  </a:lnTo>
                  <a:lnTo>
                    <a:pt x="922" y="55"/>
                  </a:lnTo>
                  <a:lnTo>
                    <a:pt x="931" y="55"/>
                  </a:lnTo>
                  <a:lnTo>
                    <a:pt x="939" y="55"/>
                  </a:lnTo>
                  <a:lnTo>
                    <a:pt x="946" y="55"/>
                  </a:lnTo>
                  <a:lnTo>
                    <a:pt x="954" y="54"/>
                  </a:lnTo>
                  <a:lnTo>
                    <a:pt x="963" y="54"/>
                  </a:lnTo>
                  <a:lnTo>
                    <a:pt x="971" y="54"/>
                  </a:lnTo>
                  <a:lnTo>
                    <a:pt x="977" y="54"/>
                  </a:lnTo>
                  <a:lnTo>
                    <a:pt x="985" y="52"/>
                  </a:lnTo>
                  <a:lnTo>
                    <a:pt x="993" y="52"/>
                  </a:lnTo>
                  <a:lnTo>
                    <a:pt x="1003" y="52"/>
                  </a:lnTo>
                  <a:lnTo>
                    <a:pt x="1011" y="52"/>
                  </a:lnTo>
                  <a:lnTo>
                    <a:pt x="1017" y="51"/>
                  </a:lnTo>
                  <a:lnTo>
                    <a:pt x="1027" y="51"/>
                  </a:lnTo>
                  <a:lnTo>
                    <a:pt x="1033" y="51"/>
                  </a:lnTo>
                  <a:lnTo>
                    <a:pt x="1041" y="51"/>
                  </a:lnTo>
                  <a:lnTo>
                    <a:pt x="1051" y="49"/>
                  </a:lnTo>
                  <a:lnTo>
                    <a:pt x="1057" y="49"/>
                  </a:lnTo>
                  <a:lnTo>
                    <a:pt x="1066" y="49"/>
                  </a:lnTo>
                  <a:lnTo>
                    <a:pt x="1074" y="49"/>
                  </a:lnTo>
                  <a:lnTo>
                    <a:pt x="1081" y="47"/>
                  </a:lnTo>
                  <a:lnTo>
                    <a:pt x="1090" y="47"/>
                  </a:lnTo>
                  <a:lnTo>
                    <a:pt x="1097" y="47"/>
                  </a:lnTo>
                  <a:lnTo>
                    <a:pt x="1105" y="47"/>
                  </a:lnTo>
                  <a:lnTo>
                    <a:pt x="1114" y="47"/>
                  </a:lnTo>
                  <a:lnTo>
                    <a:pt x="1120" y="46"/>
                  </a:lnTo>
                  <a:lnTo>
                    <a:pt x="1130" y="46"/>
                  </a:lnTo>
                  <a:lnTo>
                    <a:pt x="1138" y="46"/>
                  </a:lnTo>
                  <a:lnTo>
                    <a:pt x="1144" y="46"/>
                  </a:lnTo>
                  <a:lnTo>
                    <a:pt x="1154" y="44"/>
                  </a:lnTo>
                  <a:lnTo>
                    <a:pt x="1160" y="44"/>
                  </a:lnTo>
                  <a:lnTo>
                    <a:pt x="1170" y="44"/>
                  </a:lnTo>
                  <a:lnTo>
                    <a:pt x="1178" y="44"/>
                  </a:lnTo>
                  <a:lnTo>
                    <a:pt x="1184" y="43"/>
                  </a:lnTo>
                  <a:lnTo>
                    <a:pt x="1194" y="43"/>
                  </a:lnTo>
                  <a:lnTo>
                    <a:pt x="1200" y="43"/>
                  </a:lnTo>
                  <a:lnTo>
                    <a:pt x="1208" y="43"/>
                  </a:lnTo>
                  <a:lnTo>
                    <a:pt x="1217" y="41"/>
                  </a:lnTo>
                  <a:lnTo>
                    <a:pt x="1224" y="41"/>
                  </a:lnTo>
                  <a:lnTo>
                    <a:pt x="1233" y="41"/>
                  </a:lnTo>
                  <a:lnTo>
                    <a:pt x="1241" y="41"/>
                  </a:lnTo>
                  <a:lnTo>
                    <a:pt x="1248" y="40"/>
                  </a:lnTo>
                  <a:lnTo>
                    <a:pt x="1257" y="40"/>
                  </a:lnTo>
                  <a:lnTo>
                    <a:pt x="1263" y="40"/>
                  </a:lnTo>
                  <a:lnTo>
                    <a:pt x="1271" y="40"/>
                  </a:lnTo>
                  <a:lnTo>
                    <a:pt x="1281" y="40"/>
                  </a:lnTo>
                  <a:lnTo>
                    <a:pt x="1287" y="38"/>
                  </a:lnTo>
                  <a:lnTo>
                    <a:pt x="1297" y="38"/>
                  </a:lnTo>
                  <a:lnTo>
                    <a:pt x="1305" y="38"/>
                  </a:lnTo>
                  <a:lnTo>
                    <a:pt x="1311" y="38"/>
                  </a:lnTo>
                  <a:lnTo>
                    <a:pt x="1321" y="36"/>
                  </a:lnTo>
                  <a:lnTo>
                    <a:pt x="1327" y="36"/>
                  </a:lnTo>
                  <a:lnTo>
                    <a:pt x="1335" y="36"/>
                  </a:lnTo>
                  <a:lnTo>
                    <a:pt x="1344" y="36"/>
                  </a:lnTo>
                  <a:lnTo>
                    <a:pt x="1351" y="35"/>
                  </a:lnTo>
                  <a:lnTo>
                    <a:pt x="1360" y="35"/>
                  </a:lnTo>
                  <a:lnTo>
                    <a:pt x="1368" y="35"/>
                  </a:lnTo>
                  <a:lnTo>
                    <a:pt x="1375" y="35"/>
                  </a:lnTo>
                  <a:lnTo>
                    <a:pt x="1384" y="35"/>
                  </a:lnTo>
                  <a:lnTo>
                    <a:pt x="1391" y="33"/>
                  </a:lnTo>
                  <a:lnTo>
                    <a:pt x="1398" y="33"/>
                  </a:lnTo>
                  <a:lnTo>
                    <a:pt x="1408" y="33"/>
                  </a:lnTo>
                  <a:lnTo>
                    <a:pt x="1414" y="33"/>
                  </a:lnTo>
                  <a:lnTo>
                    <a:pt x="1424" y="32"/>
                  </a:lnTo>
                  <a:lnTo>
                    <a:pt x="1432" y="32"/>
                  </a:lnTo>
                  <a:lnTo>
                    <a:pt x="1438" y="32"/>
                  </a:lnTo>
                  <a:lnTo>
                    <a:pt x="1448" y="32"/>
                  </a:lnTo>
                  <a:lnTo>
                    <a:pt x="1454" y="30"/>
                  </a:lnTo>
                  <a:lnTo>
                    <a:pt x="1462" y="30"/>
                  </a:lnTo>
                  <a:lnTo>
                    <a:pt x="1472" y="30"/>
                  </a:lnTo>
                  <a:lnTo>
                    <a:pt x="1478" y="30"/>
                  </a:lnTo>
                  <a:lnTo>
                    <a:pt x="1487" y="30"/>
                  </a:lnTo>
                  <a:lnTo>
                    <a:pt x="1494" y="28"/>
                  </a:lnTo>
                  <a:lnTo>
                    <a:pt x="1502" y="28"/>
                  </a:lnTo>
                  <a:lnTo>
                    <a:pt x="1511" y="28"/>
                  </a:lnTo>
                  <a:lnTo>
                    <a:pt x="1518" y="28"/>
                  </a:lnTo>
                  <a:lnTo>
                    <a:pt x="1527" y="27"/>
                  </a:lnTo>
                  <a:lnTo>
                    <a:pt x="1535" y="27"/>
                  </a:lnTo>
                  <a:lnTo>
                    <a:pt x="1541" y="27"/>
                  </a:lnTo>
                  <a:lnTo>
                    <a:pt x="1551" y="27"/>
                  </a:lnTo>
                  <a:lnTo>
                    <a:pt x="1557" y="25"/>
                  </a:lnTo>
                  <a:lnTo>
                    <a:pt x="1565" y="25"/>
                  </a:lnTo>
                  <a:lnTo>
                    <a:pt x="1575" y="25"/>
                  </a:lnTo>
                  <a:lnTo>
                    <a:pt x="1581" y="25"/>
                  </a:lnTo>
                  <a:lnTo>
                    <a:pt x="1591" y="25"/>
                  </a:lnTo>
                  <a:lnTo>
                    <a:pt x="1599" y="24"/>
                  </a:lnTo>
                  <a:lnTo>
                    <a:pt x="1605" y="24"/>
                  </a:lnTo>
                  <a:lnTo>
                    <a:pt x="1615" y="24"/>
                  </a:lnTo>
                  <a:lnTo>
                    <a:pt x="1621" y="24"/>
                  </a:lnTo>
                  <a:lnTo>
                    <a:pt x="1629" y="22"/>
                  </a:lnTo>
                  <a:lnTo>
                    <a:pt x="1638" y="22"/>
                  </a:lnTo>
                  <a:lnTo>
                    <a:pt x="1645" y="22"/>
                  </a:lnTo>
                  <a:lnTo>
                    <a:pt x="1654" y="22"/>
                  </a:lnTo>
                  <a:lnTo>
                    <a:pt x="1662" y="20"/>
                  </a:lnTo>
                  <a:lnTo>
                    <a:pt x="1669" y="20"/>
                  </a:lnTo>
                  <a:lnTo>
                    <a:pt x="1677" y="20"/>
                  </a:lnTo>
                  <a:lnTo>
                    <a:pt x="1686" y="20"/>
                  </a:lnTo>
                  <a:lnTo>
                    <a:pt x="1692" y="20"/>
                  </a:lnTo>
                  <a:lnTo>
                    <a:pt x="1700" y="19"/>
                  </a:lnTo>
                  <a:lnTo>
                    <a:pt x="1710" y="19"/>
                  </a:lnTo>
                  <a:lnTo>
                    <a:pt x="1718" y="19"/>
                  </a:lnTo>
                  <a:lnTo>
                    <a:pt x="1724" y="19"/>
                  </a:lnTo>
                  <a:lnTo>
                    <a:pt x="1734" y="17"/>
                  </a:lnTo>
                  <a:lnTo>
                    <a:pt x="1742" y="17"/>
                  </a:lnTo>
                  <a:lnTo>
                    <a:pt x="1748" y="17"/>
                  </a:lnTo>
                  <a:lnTo>
                    <a:pt x="1758" y="17"/>
                  </a:lnTo>
                  <a:lnTo>
                    <a:pt x="1765" y="17"/>
                  </a:lnTo>
                  <a:lnTo>
                    <a:pt x="1772" y="16"/>
                  </a:lnTo>
                  <a:lnTo>
                    <a:pt x="1780" y="16"/>
                  </a:lnTo>
                  <a:lnTo>
                    <a:pt x="1789" y="16"/>
                  </a:lnTo>
                  <a:lnTo>
                    <a:pt x="1796" y="16"/>
                  </a:lnTo>
                  <a:lnTo>
                    <a:pt x="1804" y="14"/>
                  </a:lnTo>
                  <a:lnTo>
                    <a:pt x="1813" y="14"/>
                  </a:lnTo>
                  <a:lnTo>
                    <a:pt x="1820" y="14"/>
                  </a:lnTo>
                  <a:lnTo>
                    <a:pt x="1827" y="14"/>
                  </a:lnTo>
                  <a:lnTo>
                    <a:pt x="1837" y="14"/>
                  </a:lnTo>
                  <a:lnTo>
                    <a:pt x="1845" y="13"/>
                  </a:lnTo>
                  <a:lnTo>
                    <a:pt x="1851" y="13"/>
                  </a:lnTo>
                  <a:lnTo>
                    <a:pt x="1861" y="13"/>
                  </a:lnTo>
                  <a:lnTo>
                    <a:pt x="1869" y="13"/>
                  </a:lnTo>
                  <a:lnTo>
                    <a:pt x="1875" y="11"/>
                  </a:lnTo>
                  <a:lnTo>
                    <a:pt x="1883" y="11"/>
                  </a:lnTo>
                  <a:lnTo>
                    <a:pt x="1893" y="11"/>
                  </a:lnTo>
                  <a:lnTo>
                    <a:pt x="1899" y="11"/>
                  </a:lnTo>
                  <a:lnTo>
                    <a:pt x="1907" y="11"/>
                  </a:lnTo>
                  <a:lnTo>
                    <a:pt x="1916" y="9"/>
                  </a:lnTo>
                  <a:lnTo>
                    <a:pt x="1923" y="9"/>
                  </a:lnTo>
                  <a:lnTo>
                    <a:pt x="1931" y="9"/>
                  </a:lnTo>
                  <a:lnTo>
                    <a:pt x="1940" y="9"/>
                  </a:lnTo>
                  <a:lnTo>
                    <a:pt x="1948" y="8"/>
                  </a:lnTo>
                  <a:lnTo>
                    <a:pt x="1955" y="8"/>
                  </a:lnTo>
                  <a:lnTo>
                    <a:pt x="1964" y="8"/>
                  </a:lnTo>
                  <a:lnTo>
                    <a:pt x="1972" y="8"/>
                  </a:lnTo>
                  <a:lnTo>
                    <a:pt x="1978" y="8"/>
                  </a:lnTo>
                  <a:lnTo>
                    <a:pt x="1988" y="6"/>
                  </a:lnTo>
                  <a:lnTo>
                    <a:pt x="1996" y="6"/>
                  </a:lnTo>
                  <a:lnTo>
                    <a:pt x="2002" y="6"/>
                  </a:lnTo>
                  <a:lnTo>
                    <a:pt x="2010" y="6"/>
                  </a:lnTo>
                  <a:lnTo>
                    <a:pt x="2020" y="6"/>
                  </a:lnTo>
                  <a:lnTo>
                    <a:pt x="2026" y="5"/>
                  </a:lnTo>
                  <a:lnTo>
                    <a:pt x="2034" y="5"/>
                  </a:lnTo>
                  <a:lnTo>
                    <a:pt x="2044" y="5"/>
                  </a:lnTo>
                  <a:lnTo>
                    <a:pt x="2050" y="5"/>
                  </a:lnTo>
                  <a:lnTo>
                    <a:pt x="2058" y="3"/>
                  </a:lnTo>
                  <a:lnTo>
                    <a:pt x="2067" y="3"/>
                  </a:lnTo>
                  <a:lnTo>
                    <a:pt x="2075" y="3"/>
                  </a:lnTo>
                  <a:lnTo>
                    <a:pt x="2082" y="3"/>
                  </a:lnTo>
                  <a:lnTo>
                    <a:pt x="2091" y="3"/>
                  </a:lnTo>
                  <a:lnTo>
                    <a:pt x="2099" y="1"/>
                  </a:lnTo>
                  <a:lnTo>
                    <a:pt x="2105" y="1"/>
                  </a:lnTo>
                  <a:lnTo>
                    <a:pt x="2115" y="1"/>
                  </a:lnTo>
                  <a:lnTo>
                    <a:pt x="2123" y="1"/>
                  </a:lnTo>
                  <a:lnTo>
                    <a:pt x="2129" y="0"/>
                  </a:lnTo>
                  <a:lnTo>
                    <a:pt x="2137" y="0"/>
                  </a:lnTo>
                  <a:lnTo>
                    <a:pt x="2147" y="9"/>
                  </a:lnTo>
                  <a:lnTo>
                    <a:pt x="2153" y="9"/>
                  </a:lnTo>
                  <a:lnTo>
                    <a:pt x="2161" y="9"/>
                  </a:lnTo>
                  <a:lnTo>
                    <a:pt x="2171" y="9"/>
                  </a:lnTo>
                  <a:lnTo>
                    <a:pt x="2179" y="9"/>
                  </a:lnTo>
                  <a:lnTo>
                    <a:pt x="2185" y="9"/>
                  </a:lnTo>
                  <a:lnTo>
                    <a:pt x="2194" y="9"/>
                  </a:lnTo>
                  <a:lnTo>
                    <a:pt x="2202" y="9"/>
                  </a:lnTo>
                  <a:lnTo>
                    <a:pt x="2209" y="9"/>
                  </a:lnTo>
                  <a:lnTo>
                    <a:pt x="2218" y="9"/>
                  </a:lnTo>
                  <a:lnTo>
                    <a:pt x="2226" y="9"/>
                  </a:lnTo>
                  <a:lnTo>
                    <a:pt x="2233" y="9"/>
                  </a:lnTo>
                  <a:lnTo>
                    <a:pt x="2241" y="9"/>
                  </a:lnTo>
                  <a:lnTo>
                    <a:pt x="2250" y="9"/>
                  </a:lnTo>
                  <a:lnTo>
                    <a:pt x="2256" y="9"/>
                  </a:lnTo>
                  <a:lnTo>
                    <a:pt x="2264" y="9"/>
                  </a:lnTo>
                  <a:lnTo>
                    <a:pt x="2274" y="9"/>
                  </a:lnTo>
                  <a:lnTo>
                    <a:pt x="2280" y="9"/>
                  </a:lnTo>
                  <a:lnTo>
                    <a:pt x="2288" y="9"/>
                  </a:lnTo>
                  <a:lnTo>
                    <a:pt x="2298" y="9"/>
                  </a:lnTo>
                  <a:lnTo>
                    <a:pt x="2306" y="9"/>
                  </a:lnTo>
                  <a:lnTo>
                    <a:pt x="2312" y="9"/>
                  </a:lnTo>
                  <a:lnTo>
                    <a:pt x="2322" y="9"/>
                  </a:lnTo>
                  <a:lnTo>
                    <a:pt x="2329" y="9"/>
                  </a:lnTo>
                  <a:lnTo>
                    <a:pt x="2336" y="9"/>
                  </a:lnTo>
                  <a:lnTo>
                    <a:pt x="2345" y="9"/>
                  </a:lnTo>
                  <a:lnTo>
                    <a:pt x="2353" y="9"/>
                  </a:lnTo>
                  <a:lnTo>
                    <a:pt x="2360" y="9"/>
                  </a:lnTo>
                  <a:lnTo>
                    <a:pt x="2368" y="9"/>
                  </a:lnTo>
                  <a:lnTo>
                    <a:pt x="2377" y="9"/>
                  </a:lnTo>
                  <a:lnTo>
                    <a:pt x="2383" y="9"/>
                  </a:lnTo>
                  <a:lnTo>
                    <a:pt x="2391" y="9"/>
                  </a:lnTo>
                  <a:lnTo>
                    <a:pt x="2401" y="9"/>
                  </a:lnTo>
                  <a:lnTo>
                    <a:pt x="2407" y="11"/>
                  </a:lnTo>
                  <a:lnTo>
                    <a:pt x="2415" y="11"/>
                  </a:lnTo>
                  <a:lnTo>
                    <a:pt x="2425" y="11"/>
                  </a:lnTo>
                  <a:lnTo>
                    <a:pt x="2433" y="11"/>
                  </a:lnTo>
                  <a:lnTo>
                    <a:pt x="2439" y="11"/>
                  </a:lnTo>
                  <a:lnTo>
                    <a:pt x="2449" y="11"/>
                  </a:lnTo>
                  <a:lnTo>
                    <a:pt x="2457" y="11"/>
                  </a:lnTo>
                  <a:lnTo>
                    <a:pt x="2463" y="11"/>
                  </a:lnTo>
                  <a:lnTo>
                    <a:pt x="2472" y="11"/>
                  </a:lnTo>
                  <a:lnTo>
                    <a:pt x="2480" y="11"/>
                  </a:lnTo>
                  <a:lnTo>
                    <a:pt x="2487" y="11"/>
                  </a:lnTo>
                  <a:lnTo>
                    <a:pt x="2495" y="11"/>
                  </a:lnTo>
                  <a:lnTo>
                    <a:pt x="2504" y="11"/>
                  </a:lnTo>
                  <a:lnTo>
                    <a:pt x="2511" y="11"/>
                  </a:lnTo>
                  <a:lnTo>
                    <a:pt x="2519" y="11"/>
                  </a:lnTo>
                  <a:lnTo>
                    <a:pt x="2528" y="11"/>
                  </a:lnTo>
                  <a:lnTo>
                    <a:pt x="2536" y="11"/>
                  </a:lnTo>
                  <a:lnTo>
                    <a:pt x="2542" y="11"/>
                  </a:lnTo>
                  <a:lnTo>
                    <a:pt x="2552" y="11"/>
                  </a:lnTo>
                  <a:lnTo>
                    <a:pt x="2560" y="11"/>
                  </a:lnTo>
                  <a:lnTo>
                    <a:pt x="2566" y="11"/>
                  </a:lnTo>
                  <a:lnTo>
                    <a:pt x="2576" y="11"/>
                  </a:lnTo>
                  <a:lnTo>
                    <a:pt x="2584" y="11"/>
                  </a:lnTo>
                  <a:lnTo>
                    <a:pt x="2590" y="11"/>
                  </a:lnTo>
                  <a:lnTo>
                    <a:pt x="2598" y="11"/>
                  </a:lnTo>
                  <a:lnTo>
                    <a:pt x="2608" y="11"/>
                  </a:lnTo>
                  <a:lnTo>
                    <a:pt x="2614" y="11"/>
                  </a:lnTo>
                  <a:lnTo>
                    <a:pt x="2622" y="11"/>
                  </a:lnTo>
                  <a:lnTo>
                    <a:pt x="2631" y="11"/>
                  </a:lnTo>
                  <a:lnTo>
                    <a:pt x="2638" y="11"/>
                  </a:lnTo>
                  <a:lnTo>
                    <a:pt x="2646" y="11"/>
                  </a:lnTo>
                  <a:lnTo>
                    <a:pt x="2655" y="11"/>
                  </a:lnTo>
                  <a:lnTo>
                    <a:pt x="2663" y="11"/>
                  </a:lnTo>
                  <a:lnTo>
                    <a:pt x="2669" y="11"/>
                  </a:lnTo>
                  <a:lnTo>
                    <a:pt x="2679" y="11"/>
                  </a:lnTo>
                  <a:lnTo>
                    <a:pt x="2687" y="11"/>
                  </a:lnTo>
                  <a:lnTo>
                    <a:pt x="2693" y="13"/>
                  </a:lnTo>
                  <a:lnTo>
                    <a:pt x="2703" y="13"/>
                  </a:lnTo>
                  <a:lnTo>
                    <a:pt x="2711" y="13"/>
                  </a:lnTo>
                  <a:lnTo>
                    <a:pt x="2717" y="13"/>
                  </a:lnTo>
                  <a:lnTo>
                    <a:pt x="2725" y="13"/>
                  </a:lnTo>
                  <a:lnTo>
                    <a:pt x="2735" y="13"/>
                  </a:lnTo>
                  <a:lnTo>
                    <a:pt x="2741" y="13"/>
                  </a:lnTo>
                  <a:lnTo>
                    <a:pt x="2749" y="13"/>
                  </a:lnTo>
                  <a:lnTo>
                    <a:pt x="2758" y="13"/>
                  </a:lnTo>
                  <a:lnTo>
                    <a:pt x="2765" y="13"/>
                  </a:lnTo>
                  <a:lnTo>
                    <a:pt x="2773" y="13"/>
                  </a:lnTo>
                  <a:lnTo>
                    <a:pt x="2782" y="13"/>
                  </a:lnTo>
                  <a:lnTo>
                    <a:pt x="2790" y="13"/>
                  </a:lnTo>
                  <a:lnTo>
                    <a:pt x="2797" y="13"/>
                  </a:lnTo>
                  <a:lnTo>
                    <a:pt x="2806" y="13"/>
                  </a:lnTo>
                  <a:lnTo>
                    <a:pt x="2814" y="13"/>
                  </a:lnTo>
                  <a:lnTo>
                    <a:pt x="2820" y="13"/>
                  </a:lnTo>
                  <a:lnTo>
                    <a:pt x="2830" y="13"/>
                  </a:lnTo>
                  <a:lnTo>
                    <a:pt x="2838" y="13"/>
                  </a:lnTo>
                  <a:lnTo>
                    <a:pt x="2844" y="13"/>
                  </a:lnTo>
                  <a:lnTo>
                    <a:pt x="2852" y="13"/>
                  </a:lnTo>
                  <a:lnTo>
                    <a:pt x="2862" y="13"/>
                  </a:lnTo>
                  <a:lnTo>
                    <a:pt x="2868" y="13"/>
                  </a:lnTo>
                  <a:lnTo>
                    <a:pt x="2876" y="13"/>
                  </a:lnTo>
                  <a:lnTo>
                    <a:pt x="2886" y="13"/>
                  </a:lnTo>
                  <a:lnTo>
                    <a:pt x="2893" y="13"/>
                  </a:lnTo>
                  <a:lnTo>
                    <a:pt x="2900" y="13"/>
                  </a:lnTo>
                  <a:lnTo>
                    <a:pt x="2909" y="13"/>
                  </a:lnTo>
                  <a:lnTo>
                    <a:pt x="2917" y="13"/>
                  </a:lnTo>
                  <a:lnTo>
                    <a:pt x="2924" y="13"/>
                  </a:lnTo>
                  <a:lnTo>
                    <a:pt x="2933" y="13"/>
                  </a:lnTo>
                  <a:lnTo>
                    <a:pt x="2941" y="13"/>
                  </a:lnTo>
                  <a:lnTo>
                    <a:pt x="2947" y="13"/>
                  </a:lnTo>
                  <a:lnTo>
                    <a:pt x="2955" y="13"/>
                  </a:lnTo>
                  <a:lnTo>
                    <a:pt x="2965" y="13"/>
                  </a:lnTo>
                  <a:lnTo>
                    <a:pt x="2971" y="13"/>
                  </a:lnTo>
                  <a:lnTo>
                    <a:pt x="2979" y="14"/>
                  </a:lnTo>
                  <a:lnTo>
                    <a:pt x="2989" y="14"/>
                  </a:lnTo>
                  <a:lnTo>
                    <a:pt x="2995" y="14"/>
                  </a:lnTo>
                  <a:lnTo>
                    <a:pt x="3003" y="14"/>
                  </a:lnTo>
                  <a:lnTo>
                    <a:pt x="3013" y="14"/>
                  </a:lnTo>
                  <a:lnTo>
                    <a:pt x="3021" y="14"/>
                  </a:lnTo>
                  <a:lnTo>
                    <a:pt x="3027" y="14"/>
                  </a:lnTo>
                  <a:lnTo>
                    <a:pt x="3036" y="14"/>
                  </a:lnTo>
                  <a:lnTo>
                    <a:pt x="3044" y="14"/>
                  </a:lnTo>
                  <a:lnTo>
                    <a:pt x="3051" y="14"/>
                  </a:lnTo>
                  <a:lnTo>
                    <a:pt x="3059" y="14"/>
                  </a:lnTo>
                  <a:lnTo>
                    <a:pt x="3067" y="14"/>
                  </a:lnTo>
                  <a:lnTo>
                    <a:pt x="3076" y="14"/>
                  </a:lnTo>
                  <a:lnTo>
                    <a:pt x="3084" y="14"/>
                  </a:lnTo>
                  <a:lnTo>
                    <a:pt x="3092" y="14"/>
                  </a:lnTo>
                  <a:lnTo>
                    <a:pt x="3098" y="14"/>
                  </a:lnTo>
                  <a:lnTo>
                    <a:pt x="3106" y="14"/>
                  </a:lnTo>
                  <a:lnTo>
                    <a:pt x="3114" y="14"/>
                  </a:lnTo>
                  <a:lnTo>
                    <a:pt x="3124" y="14"/>
                  </a:lnTo>
                  <a:lnTo>
                    <a:pt x="3132" y="14"/>
                  </a:lnTo>
                  <a:lnTo>
                    <a:pt x="3140" y="14"/>
                  </a:lnTo>
                  <a:lnTo>
                    <a:pt x="3148" y="14"/>
                  </a:lnTo>
                  <a:lnTo>
                    <a:pt x="3154" y="14"/>
                  </a:lnTo>
                  <a:lnTo>
                    <a:pt x="3162" y="14"/>
                  </a:lnTo>
                  <a:lnTo>
                    <a:pt x="3170" y="14"/>
                  </a:lnTo>
                  <a:lnTo>
                    <a:pt x="3179" y="14"/>
                  </a:lnTo>
                  <a:lnTo>
                    <a:pt x="3187" y="14"/>
                  </a:lnTo>
                  <a:lnTo>
                    <a:pt x="3195" y="14"/>
                  </a:lnTo>
                  <a:lnTo>
                    <a:pt x="3202" y="14"/>
                  </a:lnTo>
                  <a:lnTo>
                    <a:pt x="3210" y="14"/>
                  </a:lnTo>
                  <a:lnTo>
                    <a:pt x="3218" y="14"/>
                  </a:lnTo>
                  <a:lnTo>
                    <a:pt x="3227" y="14"/>
                  </a:lnTo>
                  <a:lnTo>
                    <a:pt x="3235" y="14"/>
                  </a:lnTo>
                  <a:lnTo>
                    <a:pt x="3243" y="14"/>
                  </a:lnTo>
                  <a:lnTo>
                    <a:pt x="3251" y="14"/>
                  </a:lnTo>
                  <a:lnTo>
                    <a:pt x="3257" y="14"/>
                  </a:lnTo>
                  <a:lnTo>
                    <a:pt x="3265" y="14"/>
                  </a:lnTo>
                  <a:lnTo>
                    <a:pt x="3273" y="14"/>
                  </a:lnTo>
                  <a:lnTo>
                    <a:pt x="3283" y="16"/>
                  </a:lnTo>
                  <a:lnTo>
                    <a:pt x="3291" y="16"/>
                  </a:lnTo>
                  <a:lnTo>
                    <a:pt x="3299" y="16"/>
                  </a:lnTo>
                  <a:lnTo>
                    <a:pt x="3305" y="16"/>
                  </a:lnTo>
                  <a:lnTo>
                    <a:pt x="3313" y="16"/>
                  </a:lnTo>
                  <a:lnTo>
                    <a:pt x="3321" y="16"/>
                  </a:lnTo>
                  <a:lnTo>
                    <a:pt x="3330" y="16"/>
                  </a:lnTo>
                  <a:lnTo>
                    <a:pt x="3338" y="16"/>
                  </a:lnTo>
                  <a:lnTo>
                    <a:pt x="3346" y="16"/>
                  </a:lnTo>
                  <a:lnTo>
                    <a:pt x="3353" y="16"/>
                  </a:lnTo>
                  <a:lnTo>
                    <a:pt x="3361" y="16"/>
                  </a:lnTo>
                  <a:lnTo>
                    <a:pt x="3369" y="16"/>
                  </a:lnTo>
                  <a:lnTo>
                    <a:pt x="3376" y="16"/>
                  </a:lnTo>
                  <a:lnTo>
                    <a:pt x="3386" y="16"/>
                  </a:lnTo>
                  <a:lnTo>
                    <a:pt x="3394" y="16"/>
                  </a:lnTo>
                  <a:lnTo>
                    <a:pt x="3402" y="16"/>
                  </a:lnTo>
                  <a:lnTo>
                    <a:pt x="3408" y="16"/>
                  </a:lnTo>
                  <a:lnTo>
                    <a:pt x="3416" y="16"/>
                  </a:lnTo>
                  <a:lnTo>
                    <a:pt x="3424" y="16"/>
                  </a:lnTo>
                  <a:lnTo>
                    <a:pt x="3434" y="16"/>
                  </a:lnTo>
                  <a:lnTo>
                    <a:pt x="3442" y="16"/>
                  </a:lnTo>
                  <a:lnTo>
                    <a:pt x="3450" y="16"/>
                  </a:lnTo>
                  <a:lnTo>
                    <a:pt x="3456" y="16"/>
                  </a:lnTo>
                  <a:lnTo>
                    <a:pt x="3464" y="16"/>
                  </a:lnTo>
                  <a:lnTo>
                    <a:pt x="3472" y="16"/>
                  </a:lnTo>
                  <a:lnTo>
                    <a:pt x="3481" y="16"/>
                  </a:lnTo>
                  <a:lnTo>
                    <a:pt x="3489" y="16"/>
                  </a:lnTo>
                  <a:lnTo>
                    <a:pt x="3497" y="16"/>
                  </a:lnTo>
                  <a:lnTo>
                    <a:pt x="3505" y="16"/>
                  </a:lnTo>
                  <a:lnTo>
                    <a:pt x="3511" y="16"/>
                  </a:lnTo>
                  <a:lnTo>
                    <a:pt x="3519" y="16"/>
                  </a:lnTo>
                  <a:lnTo>
                    <a:pt x="3527" y="16"/>
                  </a:lnTo>
                  <a:lnTo>
                    <a:pt x="3537" y="16"/>
                  </a:lnTo>
                  <a:lnTo>
                    <a:pt x="3545" y="16"/>
                  </a:lnTo>
                  <a:lnTo>
                    <a:pt x="3553" y="16"/>
                  </a:lnTo>
                  <a:lnTo>
                    <a:pt x="3559" y="16"/>
                  </a:lnTo>
                  <a:lnTo>
                    <a:pt x="3567" y="16"/>
                  </a:lnTo>
                  <a:lnTo>
                    <a:pt x="3575" y="17"/>
                  </a:lnTo>
                  <a:lnTo>
                    <a:pt x="3585" y="17"/>
                  </a:lnTo>
                  <a:lnTo>
                    <a:pt x="3593" y="17"/>
                  </a:lnTo>
                  <a:lnTo>
                    <a:pt x="3600" y="17"/>
                  </a:lnTo>
                  <a:lnTo>
                    <a:pt x="3608" y="17"/>
                  </a:lnTo>
                  <a:lnTo>
                    <a:pt x="3615" y="17"/>
                  </a:lnTo>
                  <a:lnTo>
                    <a:pt x="3623" y="17"/>
                  </a:lnTo>
                  <a:lnTo>
                    <a:pt x="3631" y="17"/>
                  </a:lnTo>
                  <a:lnTo>
                    <a:pt x="3640" y="17"/>
                  </a:lnTo>
                  <a:lnTo>
                    <a:pt x="3648" y="17"/>
                  </a:lnTo>
                  <a:lnTo>
                    <a:pt x="3656" y="17"/>
                  </a:lnTo>
                  <a:lnTo>
                    <a:pt x="3662" y="17"/>
                  </a:lnTo>
                  <a:lnTo>
                    <a:pt x="3670" y="17"/>
                  </a:lnTo>
                  <a:lnTo>
                    <a:pt x="3678" y="17"/>
                  </a:lnTo>
                  <a:lnTo>
                    <a:pt x="3688" y="17"/>
                  </a:lnTo>
                  <a:lnTo>
                    <a:pt x="3696" y="17"/>
                  </a:lnTo>
                  <a:lnTo>
                    <a:pt x="3704" y="17"/>
                  </a:lnTo>
                  <a:lnTo>
                    <a:pt x="3710" y="17"/>
                  </a:lnTo>
                  <a:lnTo>
                    <a:pt x="3718" y="17"/>
                  </a:lnTo>
                  <a:lnTo>
                    <a:pt x="3726" y="17"/>
                  </a:lnTo>
                  <a:lnTo>
                    <a:pt x="3734" y="17"/>
                  </a:lnTo>
                  <a:lnTo>
                    <a:pt x="3743" y="17"/>
                  </a:lnTo>
                  <a:lnTo>
                    <a:pt x="3751" y="17"/>
                  </a:lnTo>
                  <a:lnTo>
                    <a:pt x="3759" y="17"/>
                  </a:lnTo>
                  <a:lnTo>
                    <a:pt x="3766" y="17"/>
                  </a:lnTo>
                  <a:lnTo>
                    <a:pt x="3774" y="17"/>
                  </a:lnTo>
                  <a:lnTo>
                    <a:pt x="3782" y="17"/>
                  </a:lnTo>
                  <a:lnTo>
                    <a:pt x="3791" y="17"/>
                  </a:lnTo>
                  <a:lnTo>
                    <a:pt x="3799" y="17"/>
                  </a:lnTo>
                  <a:lnTo>
                    <a:pt x="3807" y="17"/>
                  </a:lnTo>
                  <a:lnTo>
                    <a:pt x="3813" y="17"/>
                  </a:lnTo>
                  <a:lnTo>
                    <a:pt x="3821" y="17"/>
                  </a:lnTo>
                  <a:lnTo>
                    <a:pt x="3829" y="17"/>
                  </a:lnTo>
                  <a:lnTo>
                    <a:pt x="3839" y="17"/>
                  </a:lnTo>
                  <a:lnTo>
                    <a:pt x="3847" y="17"/>
                  </a:lnTo>
                  <a:lnTo>
                    <a:pt x="3855" y="17"/>
                  </a:lnTo>
                  <a:lnTo>
                    <a:pt x="3863" y="17"/>
                  </a:lnTo>
                  <a:lnTo>
                    <a:pt x="3869" y="17"/>
                  </a:lnTo>
                  <a:lnTo>
                    <a:pt x="3877" y="17"/>
                  </a:lnTo>
                  <a:lnTo>
                    <a:pt x="3885" y="19"/>
                  </a:lnTo>
                  <a:lnTo>
                    <a:pt x="3894" y="19"/>
                  </a:lnTo>
                  <a:lnTo>
                    <a:pt x="3902" y="19"/>
                  </a:lnTo>
                  <a:lnTo>
                    <a:pt x="3910" y="19"/>
                  </a:lnTo>
                  <a:lnTo>
                    <a:pt x="3917" y="19"/>
                  </a:lnTo>
                  <a:lnTo>
                    <a:pt x="3925" y="19"/>
                  </a:lnTo>
                  <a:lnTo>
                    <a:pt x="3932" y="19"/>
                  </a:lnTo>
                  <a:lnTo>
                    <a:pt x="3942" y="19"/>
                  </a:lnTo>
                  <a:lnTo>
                    <a:pt x="3950" y="19"/>
                  </a:lnTo>
                  <a:lnTo>
                    <a:pt x="3958" y="19"/>
                  </a:lnTo>
                  <a:lnTo>
                    <a:pt x="3966" y="19"/>
                  </a:lnTo>
                  <a:lnTo>
                    <a:pt x="3972" y="19"/>
                  </a:lnTo>
                  <a:lnTo>
                    <a:pt x="3980" y="19"/>
                  </a:lnTo>
                  <a:lnTo>
                    <a:pt x="3988" y="19"/>
                  </a:lnTo>
                  <a:lnTo>
                    <a:pt x="3998" y="19"/>
                  </a:lnTo>
                  <a:lnTo>
                    <a:pt x="4006" y="19"/>
                  </a:lnTo>
                  <a:lnTo>
                    <a:pt x="4014" y="19"/>
                  </a:lnTo>
                  <a:lnTo>
                    <a:pt x="4020" y="19"/>
                  </a:lnTo>
                  <a:lnTo>
                    <a:pt x="4028" y="19"/>
                  </a:lnTo>
                  <a:lnTo>
                    <a:pt x="4036" y="19"/>
                  </a:lnTo>
                  <a:lnTo>
                    <a:pt x="4045" y="19"/>
                  </a:lnTo>
                  <a:lnTo>
                    <a:pt x="4053" y="19"/>
                  </a:lnTo>
                  <a:lnTo>
                    <a:pt x="4061" y="19"/>
                  </a:lnTo>
                  <a:lnTo>
                    <a:pt x="4068" y="19"/>
                  </a:lnTo>
                  <a:lnTo>
                    <a:pt x="4075" y="19"/>
                  </a:lnTo>
                  <a:lnTo>
                    <a:pt x="4083" y="19"/>
                  </a:lnTo>
                  <a:lnTo>
                    <a:pt x="4091" y="19"/>
                  </a:lnTo>
                  <a:lnTo>
                    <a:pt x="4101" y="19"/>
                  </a:lnTo>
                  <a:lnTo>
                    <a:pt x="4109" y="1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/>
            </a:p>
          </p:txBody>
        </p:sp>
      </p:grpSp>
    </p:spTree>
    <p:extLst>
      <p:ext uri="{BB962C8B-B14F-4D97-AF65-F5344CB8AC3E}">
        <p14:creationId xmlns:p14="http://schemas.microsoft.com/office/powerpoint/2010/main" val="653655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dirty="0" smtClean="0"/>
              <a:t>Figure2C</a:t>
            </a:r>
            <a:endParaRPr lang="en-US" dirty="0"/>
          </a:p>
        </p:txBody>
      </p:sp>
      <p:grpSp>
        <p:nvGrpSpPr>
          <p:cNvPr id="5" name="Group 7"/>
          <p:cNvGrpSpPr>
            <a:grpSpLocks noChangeAspect="1"/>
          </p:cNvGrpSpPr>
          <p:nvPr/>
        </p:nvGrpSpPr>
        <p:grpSpPr bwMode="auto">
          <a:xfrm>
            <a:off x="179388" y="1417638"/>
            <a:ext cx="9486900" cy="2605088"/>
            <a:chOff x="172" y="376"/>
            <a:chExt cx="5976" cy="2457"/>
          </a:xfrm>
        </p:grpSpPr>
        <p:sp>
          <p:nvSpPr>
            <p:cNvPr id="6" name="AutoShape 6"/>
            <p:cNvSpPr>
              <a:spLocks noChangeAspect="1" noChangeArrowheads="1" noTextEdit="1"/>
            </p:cNvSpPr>
            <p:nvPr/>
          </p:nvSpPr>
          <p:spPr bwMode="auto">
            <a:xfrm>
              <a:off x="288" y="376"/>
              <a:ext cx="5184" cy="23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288" y="376"/>
              <a:ext cx="5184" cy="232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" name="Line 9"/>
            <p:cNvSpPr>
              <a:spLocks noChangeShapeType="1"/>
            </p:cNvSpPr>
            <p:nvPr/>
          </p:nvSpPr>
          <p:spPr bwMode="auto">
            <a:xfrm flipV="1">
              <a:off x="471" y="466"/>
              <a:ext cx="1" cy="21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" name="Line 10"/>
            <p:cNvSpPr>
              <a:spLocks noChangeShapeType="1"/>
            </p:cNvSpPr>
            <p:nvPr/>
          </p:nvSpPr>
          <p:spPr bwMode="auto">
            <a:xfrm flipH="1">
              <a:off x="461" y="2579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" name="Line 11"/>
            <p:cNvSpPr>
              <a:spLocks noChangeShapeType="1"/>
            </p:cNvSpPr>
            <p:nvPr/>
          </p:nvSpPr>
          <p:spPr bwMode="auto">
            <a:xfrm flipH="1">
              <a:off x="461" y="2447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" name="Line 12"/>
            <p:cNvSpPr>
              <a:spLocks noChangeShapeType="1"/>
            </p:cNvSpPr>
            <p:nvPr/>
          </p:nvSpPr>
          <p:spPr bwMode="auto">
            <a:xfrm flipH="1">
              <a:off x="461" y="2315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" name="Line 13"/>
            <p:cNvSpPr>
              <a:spLocks noChangeShapeType="1"/>
            </p:cNvSpPr>
            <p:nvPr/>
          </p:nvSpPr>
          <p:spPr bwMode="auto">
            <a:xfrm flipH="1">
              <a:off x="461" y="2183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" name="Line 14"/>
            <p:cNvSpPr>
              <a:spLocks noChangeShapeType="1"/>
            </p:cNvSpPr>
            <p:nvPr/>
          </p:nvSpPr>
          <p:spPr bwMode="auto">
            <a:xfrm flipH="1">
              <a:off x="461" y="2051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" name="Line 15"/>
            <p:cNvSpPr>
              <a:spLocks noChangeShapeType="1"/>
            </p:cNvSpPr>
            <p:nvPr/>
          </p:nvSpPr>
          <p:spPr bwMode="auto">
            <a:xfrm flipH="1">
              <a:off x="461" y="1919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" name="Line 16"/>
            <p:cNvSpPr>
              <a:spLocks noChangeShapeType="1"/>
            </p:cNvSpPr>
            <p:nvPr/>
          </p:nvSpPr>
          <p:spPr bwMode="auto">
            <a:xfrm flipH="1">
              <a:off x="461" y="1787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" name="Line 17"/>
            <p:cNvSpPr>
              <a:spLocks noChangeShapeType="1"/>
            </p:cNvSpPr>
            <p:nvPr/>
          </p:nvSpPr>
          <p:spPr bwMode="auto">
            <a:xfrm flipH="1">
              <a:off x="461" y="1655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" name="Line 18"/>
            <p:cNvSpPr>
              <a:spLocks noChangeShapeType="1"/>
            </p:cNvSpPr>
            <p:nvPr/>
          </p:nvSpPr>
          <p:spPr bwMode="auto">
            <a:xfrm flipH="1">
              <a:off x="461" y="1523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" name="Line 19"/>
            <p:cNvSpPr>
              <a:spLocks noChangeShapeType="1"/>
            </p:cNvSpPr>
            <p:nvPr/>
          </p:nvSpPr>
          <p:spPr bwMode="auto">
            <a:xfrm flipH="1">
              <a:off x="461" y="1391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" name="Line 20"/>
            <p:cNvSpPr>
              <a:spLocks noChangeShapeType="1"/>
            </p:cNvSpPr>
            <p:nvPr/>
          </p:nvSpPr>
          <p:spPr bwMode="auto">
            <a:xfrm flipH="1">
              <a:off x="461" y="1259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" name="Line 21"/>
            <p:cNvSpPr>
              <a:spLocks noChangeShapeType="1"/>
            </p:cNvSpPr>
            <p:nvPr/>
          </p:nvSpPr>
          <p:spPr bwMode="auto">
            <a:xfrm flipH="1">
              <a:off x="461" y="1127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" name="Line 22"/>
            <p:cNvSpPr>
              <a:spLocks noChangeShapeType="1"/>
            </p:cNvSpPr>
            <p:nvPr/>
          </p:nvSpPr>
          <p:spPr bwMode="auto">
            <a:xfrm flipH="1">
              <a:off x="461" y="994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" name="Line 23"/>
            <p:cNvSpPr>
              <a:spLocks noChangeShapeType="1"/>
            </p:cNvSpPr>
            <p:nvPr/>
          </p:nvSpPr>
          <p:spPr bwMode="auto">
            <a:xfrm flipH="1">
              <a:off x="461" y="862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" name="Line 24"/>
            <p:cNvSpPr>
              <a:spLocks noChangeShapeType="1"/>
            </p:cNvSpPr>
            <p:nvPr/>
          </p:nvSpPr>
          <p:spPr bwMode="auto">
            <a:xfrm flipH="1">
              <a:off x="461" y="730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" name="Line 25"/>
            <p:cNvSpPr>
              <a:spLocks noChangeShapeType="1"/>
            </p:cNvSpPr>
            <p:nvPr/>
          </p:nvSpPr>
          <p:spPr bwMode="auto">
            <a:xfrm flipH="1">
              <a:off x="461" y="598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" name="Line 26"/>
            <p:cNvSpPr>
              <a:spLocks noChangeShapeType="1"/>
            </p:cNvSpPr>
            <p:nvPr/>
          </p:nvSpPr>
          <p:spPr bwMode="auto">
            <a:xfrm flipH="1">
              <a:off x="461" y="466"/>
              <a:ext cx="1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" name="Line 27"/>
            <p:cNvSpPr>
              <a:spLocks noChangeShapeType="1"/>
            </p:cNvSpPr>
            <p:nvPr/>
          </p:nvSpPr>
          <p:spPr bwMode="auto">
            <a:xfrm flipH="1">
              <a:off x="448" y="2579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7" name="Line 28"/>
            <p:cNvSpPr>
              <a:spLocks noChangeShapeType="1"/>
            </p:cNvSpPr>
            <p:nvPr/>
          </p:nvSpPr>
          <p:spPr bwMode="auto">
            <a:xfrm flipH="1">
              <a:off x="448" y="2315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8" name="Line 29"/>
            <p:cNvSpPr>
              <a:spLocks noChangeShapeType="1"/>
            </p:cNvSpPr>
            <p:nvPr/>
          </p:nvSpPr>
          <p:spPr bwMode="auto">
            <a:xfrm flipH="1">
              <a:off x="448" y="2051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9" name="Line 30"/>
            <p:cNvSpPr>
              <a:spLocks noChangeShapeType="1"/>
            </p:cNvSpPr>
            <p:nvPr/>
          </p:nvSpPr>
          <p:spPr bwMode="auto">
            <a:xfrm flipH="1">
              <a:off x="448" y="1787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0" name="Line 31"/>
            <p:cNvSpPr>
              <a:spLocks noChangeShapeType="1"/>
            </p:cNvSpPr>
            <p:nvPr/>
          </p:nvSpPr>
          <p:spPr bwMode="auto">
            <a:xfrm flipH="1">
              <a:off x="448" y="1523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1" name="Line 32"/>
            <p:cNvSpPr>
              <a:spLocks noChangeShapeType="1"/>
            </p:cNvSpPr>
            <p:nvPr/>
          </p:nvSpPr>
          <p:spPr bwMode="auto">
            <a:xfrm flipH="1">
              <a:off x="448" y="1259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2" name="Line 33"/>
            <p:cNvSpPr>
              <a:spLocks noChangeShapeType="1"/>
            </p:cNvSpPr>
            <p:nvPr/>
          </p:nvSpPr>
          <p:spPr bwMode="auto">
            <a:xfrm flipH="1">
              <a:off x="448" y="994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3" name="Line 34"/>
            <p:cNvSpPr>
              <a:spLocks noChangeShapeType="1"/>
            </p:cNvSpPr>
            <p:nvPr/>
          </p:nvSpPr>
          <p:spPr bwMode="auto">
            <a:xfrm flipH="1">
              <a:off x="448" y="730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4" name="Line 35"/>
            <p:cNvSpPr>
              <a:spLocks noChangeShapeType="1"/>
            </p:cNvSpPr>
            <p:nvPr/>
          </p:nvSpPr>
          <p:spPr bwMode="auto">
            <a:xfrm flipH="1">
              <a:off x="448" y="466"/>
              <a:ext cx="3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5" name="Rectangle 36"/>
            <p:cNvSpPr>
              <a:spLocks noChangeArrowheads="1"/>
            </p:cNvSpPr>
            <p:nvPr/>
          </p:nvSpPr>
          <p:spPr bwMode="auto">
            <a:xfrm>
              <a:off x="355" y="2558"/>
              <a:ext cx="138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-20</a:t>
              </a:r>
              <a:endParaRPr lang="es-ES" sz="1200"/>
            </a:p>
          </p:txBody>
        </p:sp>
        <p:sp>
          <p:nvSpPr>
            <p:cNvPr id="36" name="Rectangle 37"/>
            <p:cNvSpPr>
              <a:spLocks noChangeArrowheads="1"/>
            </p:cNvSpPr>
            <p:nvPr/>
          </p:nvSpPr>
          <p:spPr bwMode="auto">
            <a:xfrm>
              <a:off x="391" y="2294"/>
              <a:ext cx="53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0</a:t>
              </a:r>
              <a:endParaRPr lang="es-ES" sz="1200"/>
            </a:p>
          </p:txBody>
        </p:sp>
        <p:sp>
          <p:nvSpPr>
            <p:cNvPr id="37" name="Rectangle 38"/>
            <p:cNvSpPr>
              <a:spLocks noChangeArrowheads="1"/>
            </p:cNvSpPr>
            <p:nvPr/>
          </p:nvSpPr>
          <p:spPr bwMode="auto">
            <a:xfrm>
              <a:off x="368" y="2030"/>
              <a:ext cx="106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20</a:t>
              </a:r>
              <a:endParaRPr lang="es-ES" sz="1200"/>
            </a:p>
          </p:txBody>
        </p:sp>
        <p:sp>
          <p:nvSpPr>
            <p:cNvPr id="38" name="Rectangle 39"/>
            <p:cNvSpPr>
              <a:spLocks noChangeArrowheads="1"/>
            </p:cNvSpPr>
            <p:nvPr/>
          </p:nvSpPr>
          <p:spPr bwMode="auto">
            <a:xfrm>
              <a:off x="368" y="1765"/>
              <a:ext cx="106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40</a:t>
              </a:r>
              <a:endParaRPr lang="es-ES" sz="1200"/>
            </a:p>
          </p:txBody>
        </p:sp>
        <p:sp>
          <p:nvSpPr>
            <p:cNvPr id="39" name="Rectangle 40"/>
            <p:cNvSpPr>
              <a:spLocks noChangeArrowheads="1"/>
            </p:cNvSpPr>
            <p:nvPr/>
          </p:nvSpPr>
          <p:spPr bwMode="auto">
            <a:xfrm>
              <a:off x="368" y="1502"/>
              <a:ext cx="106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60</a:t>
              </a:r>
              <a:endParaRPr lang="es-ES" sz="1200"/>
            </a:p>
          </p:txBody>
        </p:sp>
        <p:sp>
          <p:nvSpPr>
            <p:cNvPr id="40" name="Rectangle 41"/>
            <p:cNvSpPr>
              <a:spLocks noChangeArrowheads="1"/>
            </p:cNvSpPr>
            <p:nvPr/>
          </p:nvSpPr>
          <p:spPr bwMode="auto">
            <a:xfrm>
              <a:off x="368" y="1238"/>
              <a:ext cx="106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80</a:t>
              </a:r>
              <a:endParaRPr lang="es-ES" sz="1200"/>
            </a:p>
          </p:txBody>
        </p:sp>
        <p:sp>
          <p:nvSpPr>
            <p:cNvPr id="41" name="Rectangle 42"/>
            <p:cNvSpPr>
              <a:spLocks noChangeArrowheads="1"/>
            </p:cNvSpPr>
            <p:nvPr/>
          </p:nvSpPr>
          <p:spPr bwMode="auto">
            <a:xfrm>
              <a:off x="346" y="973"/>
              <a:ext cx="159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00</a:t>
              </a:r>
              <a:endParaRPr lang="es-ES" sz="1200"/>
            </a:p>
          </p:txBody>
        </p:sp>
        <p:sp>
          <p:nvSpPr>
            <p:cNvPr id="42" name="Rectangle 43"/>
            <p:cNvSpPr>
              <a:spLocks noChangeArrowheads="1"/>
            </p:cNvSpPr>
            <p:nvPr/>
          </p:nvSpPr>
          <p:spPr bwMode="auto">
            <a:xfrm>
              <a:off x="346" y="710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20</a:t>
              </a:r>
              <a:endParaRPr lang="es-ES" sz="1200"/>
            </a:p>
          </p:txBody>
        </p:sp>
        <p:sp>
          <p:nvSpPr>
            <p:cNvPr id="43" name="Rectangle 44"/>
            <p:cNvSpPr>
              <a:spLocks noChangeArrowheads="1"/>
            </p:cNvSpPr>
            <p:nvPr/>
          </p:nvSpPr>
          <p:spPr bwMode="auto">
            <a:xfrm>
              <a:off x="346" y="445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40</a:t>
              </a:r>
              <a:endParaRPr lang="es-ES" sz="1200"/>
            </a:p>
          </p:txBody>
        </p:sp>
        <p:sp>
          <p:nvSpPr>
            <p:cNvPr id="44" name="Line 45"/>
            <p:cNvSpPr>
              <a:spLocks noChangeShapeType="1"/>
            </p:cNvSpPr>
            <p:nvPr/>
          </p:nvSpPr>
          <p:spPr bwMode="auto">
            <a:xfrm>
              <a:off x="471" y="2579"/>
              <a:ext cx="433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5" name="Line 46"/>
            <p:cNvSpPr>
              <a:spLocks noChangeShapeType="1"/>
            </p:cNvSpPr>
            <p:nvPr/>
          </p:nvSpPr>
          <p:spPr bwMode="auto">
            <a:xfrm>
              <a:off x="471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6" name="Line 47"/>
            <p:cNvSpPr>
              <a:spLocks noChangeShapeType="1"/>
            </p:cNvSpPr>
            <p:nvPr/>
          </p:nvSpPr>
          <p:spPr bwMode="auto">
            <a:xfrm>
              <a:off x="686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7" name="Line 48"/>
            <p:cNvSpPr>
              <a:spLocks noChangeShapeType="1"/>
            </p:cNvSpPr>
            <p:nvPr/>
          </p:nvSpPr>
          <p:spPr bwMode="auto">
            <a:xfrm>
              <a:off x="903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8" name="Line 49"/>
            <p:cNvSpPr>
              <a:spLocks noChangeShapeType="1"/>
            </p:cNvSpPr>
            <p:nvPr/>
          </p:nvSpPr>
          <p:spPr bwMode="auto">
            <a:xfrm>
              <a:off x="1120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9" name="Line 50"/>
            <p:cNvSpPr>
              <a:spLocks noChangeShapeType="1"/>
            </p:cNvSpPr>
            <p:nvPr/>
          </p:nvSpPr>
          <p:spPr bwMode="auto">
            <a:xfrm>
              <a:off x="1336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0" name="Line 51"/>
            <p:cNvSpPr>
              <a:spLocks noChangeShapeType="1"/>
            </p:cNvSpPr>
            <p:nvPr/>
          </p:nvSpPr>
          <p:spPr bwMode="auto">
            <a:xfrm>
              <a:off x="1553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1" name="Line 52"/>
            <p:cNvSpPr>
              <a:spLocks noChangeShapeType="1"/>
            </p:cNvSpPr>
            <p:nvPr/>
          </p:nvSpPr>
          <p:spPr bwMode="auto">
            <a:xfrm>
              <a:off x="1770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2" name="Line 53"/>
            <p:cNvSpPr>
              <a:spLocks noChangeShapeType="1"/>
            </p:cNvSpPr>
            <p:nvPr/>
          </p:nvSpPr>
          <p:spPr bwMode="auto">
            <a:xfrm>
              <a:off x="1985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3" name="Line 54"/>
            <p:cNvSpPr>
              <a:spLocks noChangeShapeType="1"/>
            </p:cNvSpPr>
            <p:nvPr/>
          </p:nvSpPr>
          <p:spPr bwMode="auto">
            <a:xfrm>
              <a:off x="2202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4" name="Line 55"/>
            <p:cNvSpPr>
              <a:spLocks noChangeShapeType="1"/>
            </p:cNvSpPr>
            <p:nvPr/>
          </p:nvSpPr>
          <p:spPr bwMode="auto">
            <a:xfrm>
              <a:off x="2419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5" name="Line 56"/>
            <p:cNvSpPr>
              <a:spLocks noChangeShapeType="1"/>
            </p:cNvSpPr>
            <p:nvPr/>
          </p:nvSpPr>
          <p:spPr bwMode="auto">
            <a:xfrm>
              <a:off x="2636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6" name="Line 57"/>
            <p:cNvSpPr>
              <a:spLocks noChangeShapeType="1"/>
            </p:cNvSpPr>
            <p:nvPr/>
          </p:nvSpPr>
          <p:spPr bwMode="auto">
            <a:xfrm>
              <a:off x="2851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7" name="Line 58"/>
            <p:cNvSpPr>
              <a:spLocks noChangeShapeType="1"/>
            </p:cNvSpPr>
            <p:nvPr/>
          </p:nvSpPr>
          <p:spPr bwMode="auto">
            <a:xfrm>
              <a:off x="3068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8" name="Line 59"/>
            <p:cNvSpPr>
              <a:spLocks noChangeShapeType="1"/>
            </p:cNvSpPr>
            <p:nvPr/>
          </p:nvSpPr>
          <p:spPr bwMode="auto">
            <a:xfrm>
              <a:off x="3285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9" name="Line 60"/>
            <p:cNvSpPr>
              <a:spLocks noChangeShapeType="1"/>
            </p:cNvSpPr>
            <p:nvPr/>
          </p:nvSpPr>
          <p:spPr bwMode="auto">
            <a:xfrm>
              <a:off x="3501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0" name="Line 61"/>
            <p:cNvSpPr>
              <a:spLocks noChangeShapeType="1"/>
            </p:cNvSpPr>
            <p:nvPr/>
          </p:nvSpPr>
          <p:spPr bwMode="auto">
            <a:xfrm>
              <a:off x="3718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1" name="Line 62"/>
            <p:cNvSpPr>
              <a:spLocks noChangeShapeType="1"/>
            </p:cNvSpPr>
            <p:nvPr/>
          </p:nvSpPr>
          <p:spPr bwMode="auto">
            <a:xfrm>
              <a:off x="3935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2" name="Line 63"/>
            <p:cNvSpPr>
              <a:spLocks noChangeShapeType="1"/>
            </p:cNvSpPr>
            <p:nvPr/>
          </p:nvSpPr>
          <p:spPr bwMode="auto">
            <a:xfrm>
              <a:off x="4150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3" name="Line 64"/>
            <p:cNvSpPr>
              <a:spLocks noChangeShapeType="1"/>
            </p:cNvSpPr>
            <p:nvPr/>
          </p:nvSpPr>
          <p:spPr bwMode="auto">
            <a:xfrm>
              <a:off x="4367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4" name="Line 65"/>
            <p:cNvSpPr>
              <a:spLocks noChangeShapeType="1"/>
            </p:cNvSpPr>
            <p:nvPr/>
          </p:nvSpPr>
          <p:spPr bwMode="auto">
            <a:xfrm>
              <a:off x="4584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5" name="Line 66"/>
            <p:cNvSpPr>
              <a:spLocks noChangeShapeType="1"/>
            </p:cNvSpPr>
            <p:nvPr/>
          </p:nvSpPr>
          <p:spPr bwMode="auto">
            <a:xfrm>
              <a:off x="4801" y="2577"/>
              <a:ext cx="1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6" name="Line 67"/>
            <p:cNvSpPr>
              <a:spLocks noChangeShapeType="1"/>
            </p:cNvSpPr>
            <p:nvPr/>
          </p:nvSpPr>
          <p:spPr bwMode="auto">
            <a:xfrm>
              <a:off x="471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7" name="Line 68"/>
            <p:cNvSpPr>
              <a:spLocks noChangeShapeType="1"/>
            </p:cNvSpPr>
            <p:nvPr/>
          </p:nvSpPr>
          <p:spPr bwMode="auto">
            <a:xfrm>
              <a:off x="903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8" name="Line 69"/>
            <p:cNvSpPr>
              <a:spLocks noChangeShapeType="1"/>
            </p:cNvSpPr>
            <p:nvPr/>
          </p:nvSpPr>
          <p:spPr bwMode="auto">
            <a:xfrm>
              <a:off x="1336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9" name="Line 70"/>
            <p:cNvSpPr>
              <a:spLocks noChangeShapeType="1"/>
            </p:cNvSpPr>
            <p:nvPr/>
          </p:nvSpPr>
          <p:spPr bwMode="auto">
            <a:xfrm>
              <a:off x="1770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0" name="Line 71"/>
            <p:cNvSpPr>
              <a:spLocks noChangeShapeType="1"/>
            </p:cNvSpPr>
            <p:nvPr/>
          </p:nvSpPr>
          <p:spPr bwMode="auto">
            <a:xfrm>
              <a:off x="2202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1" name="Line 72"/>
            <p:cNvSpPr>
              <a:spLocks noChangeShapeType="1"/>
            </p:cNvSpPr>
            <p:nvPr/>
          </p:nvSpPr>
          <p:spPr bwMode="auto">
            <a:xfrm>
              <a:off x="2636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2" name="Line 73"/>
            <p:cNvSpPr>
              <a:spLocks noChangeShapeType="1"/>
            </p:cNvSpPr>
            <p:nvPr/>
          </p:nvSpPr>
          <p:spPr bwMode="auto">
            <a:xfrm>
              <a:off x="3068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Line 74"/>
            <p:cNvSpPr>
              <a:spLocks noChangeShapeType="1"/>
            </p:cNvSpPr>
            <p:nvPr/>
          </p:nvSpPr>
          <p:spPr bwMode="auto">
            <a:xfrm>
              <a:off x="3501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4" name="Line 75"/>
            <p:cNvSpPr>
              <a:spLocks noChangeShapeType="1"/>
            </p:cNvSpPr>
            <p:nvPr/>
          </p:nvSpPr>
          <p:spPr bwMode="auto">
            <a:xfrm>
              <a:off x="3935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5" name="Line 76"/>
            <p:cNvSpPr>
              <a:spLocks noChangeShapeType="1"/>
            </p:cNvSpPr>
            <p:nvPr/>
          </p:nvSpPr>
          <p:spPr bwMode="auto">
            <a:xfrm>
              <a:off x="4367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6" name="Line 77"/>
            <p:cNvSpPr>
              <a:spLocks noChangeShapeType="1"/>
            </p:cNvSpPr>
            <p:nvPr/>
          </p:nvSpPr>
          <p:spPr bwMode="auto">
            <a:xfrm>
              <a:off x="4801" y="2572"/>
              <a:ext cx="1" cy="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7" name="Rectangle 78"/>
            <p:cNvSpPr>
              <a:spLocks noChangeArrowheads="1"/>
            </p:cNvSpPr>
            <p:nvPr/>
          </p:nvSpPr>
          <p:spPr bwMode="auto">
            <a:xfrm>
              <a:off x="446" y="2607"/>
              <a:ext cx="138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-50</a:t>
              </a:r>
              <a:endParaRPr lang="es-ES" sz="1200"/>
            </a:p>
          </p:txBody>
        </p:sp>
        <p:sp>
          <p:nvSpPr>
            <p:cNvPr id="78" name="Rectangle 79"/>
            <p:cNvSpPr>
              <a:spLocks noChangeArrowheads="1"/>
            </p:cNvSpPr>
            <p:nvPr/>
          </p:nvSpPr>
          <p:spPr bwMode="auto">
            <a:xfrm>
              <a:off x="879" y="2607"/>
              <a:ext cx="138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-10</a:t>
              </a:r>
              <a:endParaRPr lang="es-ES" sz="1200"/>
            </a:p>
          </p:txBody>
        </p:sp>
        <p:sp>
          <p:nvSpPr>
            <p:cNvPr id="79" name="Rectangle 80"/>
            <p:cNvSpPr>
              <a:spLocks noChangeArrowheads="1"/>
            </p:cNvSpPr>
            <p:nvPr/>
          </p:nvSpPr>
          <p:spPr bwMode="auto">
            <a:xfrm>
              <a:off x="1318" y="2607"/>
              <a:ext cx="106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30</a:t>
              </a:r>
              <a:endParaRPr lang="es-ES" sz="1200"/>
            </a:p>
          </p:txBody>
        </p:sp>
        <p:sp>
          <p:nvSpPr>
            <p:cNvPr id="80" name="Rectangle 81"/>
            <p:cNvSpPr>
              <a:spLocks noChangeArrowheads="1"/>
            </p:cNvSpPr>
            <p:nvPr/>
          </p:nvSpPr>
          <p:spPr bwMode="auto">
            <a:xfrm>
              <a:off x="1752" y="2607"/>
              <a:ext cx="106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70</a:t>
              </a:r>
              <a:endParaRPr lang="es-ES" sz="1200"/>
            </a:p>
          </p:txBody>
        </p:sp>
        <p:sp>
          <p:nvSpPr>
            <p:cNvPr id="81" name="Rectangle 82"/>
            <p:cNvSpPr>
              <a:spLocks noChangeArrowheads="1"/>
            </p:cNvSpPr>
            <p:nvPr/>
          </p:nvSpPr>
          <p:spPr bwMode="auto">
            <a:xfrm>
              <a:off x="2174" y="2607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10</a:t>
              </a:r>
              <a:endParaRPr lang="es-ES" sz="1200"/>
            </a:p>
          </p:txBody>
        </p:sp>
        <p:sp>
          <p:nvSpPr>
            <p:cNvPr id="82" name="Rectangle 83"/>
            <p:cNvSpPr>
              <a:spLocks noChangeArrowheads="1"/>
            </p:cNvSpPr>
            <p:nvPr/>
          </p:nvSpPr>
          <p:spPr bwMode="auto">
            <a:xfrm>
              <a:off x="2608" y="2607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50</a:t>
              </a:r>
              <a:endParaRPr lang="es-ES" sz="1200"/>
            </a:p>
          </p:txBody>
        </p:sp>
        <p:sp>
          <p:nvSpPr>
            <p:cNvPr id="83" name="Rectangle 84"/>
            <p:cNvSpPr>
              <a:spLocks noChangeArrowheads="1"/>
            </p:cNvSpPr>
            <p:nvPr/>
          </p:nvSpPr>
          <p:spPr bwMode="auto">
            <a:xfrm>
              <a:off x="3041" y="2607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190</a:t>
              </a:r>
              <a:endParaRPr lang="es-ES" sz="1200"/>
            </a:p>
          </p:txBody>
        </p:sp>
        <p:sp>
          <p:nvSpPr>
            <p:cNvPr id="84" name="Rectangle 85"/>
            <p:cNvSpPr>
              <a:spLocks noChangeArrowheads="1"/>
            </p:cNvSpPr>
            <p:nvPr/>
          </p:nvSpPr>
          <p:spPr bwMode="auto">
            <a:xfrm>
              <a:off x="3473" y="2607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230</a:t>
              </a:r>
              <a:endParaRPr lang="es-ES" sz="1200"/>
            </a:p>
          </p:txBody>
        </p:sp>
        <p:sp>
          <p:nvSpPr>
            <p:cNvPr id="85" name="Rectangle 86"/>
            <p:cNvSpPr>
              <a:spLocks noChangeArrowheads="1"/>
            </p:cNvSpPr>
            <p:nvPr/>
          </p:nvSpPr>
          <p:spPr bwMode="auto">
            <a:xfrm>
              <a:off x="3907" y="2607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270</a:t>
              </a:r>
              <a:endParaRPr lang="es-ES" sz="1200"/>
            </a:p>
          </p:txBody>
        </p:sp>
        <p:sp>
          <p:nvSpPr>
            <p:cNvPr id="86" name="Rectangle 87"/>
            <p:cNvSpPr>
              <a:spLocks noChangeArrowheads="1"/>
            </p:cNvSpPr>
            <p:nvPr/>
          </p:nvSpPr>
          <p:spPr bwMode="auto">
            <a:xfrm>
              <a:off x="4340" y="2607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310</a:t>
              </a:r>
              <a:endParaRPr lang="es-ES" sz="1200"/>
            </a:p>
          </p:txBody>
        </p:sp>
        <p:sp>
          <p:nvSpPr>
            <p:cNvPr id="87" name="Rectangle 88"/>
            <p:cNvSpPr>
              <a:spLocks noChangeArrowheads="1"/>
            </p:cNvSpPr>
            <p:nvPr/>
          </p:nvSpPr>
          <p:spPr bwMode="auto">
            <a:xfrm>
              <a:off x="4774" y="2607"/>
              <a:ext cx="159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350</a:t>
              </a:r>
              <a:endParaRPr lang="es-ES" sz="1200"/>
            </a:p>
          </p:txBody>
        </p:sp>
        <p:sp>
          <p:nvSpPr>
            <p:cNvPr id="89" name="Rectangle 90"/>
            <p:cNvSpPr>
              <a:spLocks noChangeArrowheads="1"/>
            </p:cNvSpPr>
            <p:nvPr/>
          </p:nvSpPr>
          <p:spPr bwMode="auto">
            <a:xfrm>
              <a:off x="4829" y="2661"/>
              <a:ext cx="48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s</a:t>
              </a:r>
              <a:endParaRPr lang="es-ES" sz="1200"/>
            </a:p>
          </p:txBody>
        </p:sp>
        <p:sp>
          <p:nvSpPr>
            <p:cNvPr id="90" name="Rectangle 91"/>
            <p:cNvSpPr>
              <a:spLocks noChangeArrowheads="1"/>
            </p:cNvSpPr>
            <p:nvPr/>
          </p:nvSpPr>
          <p:spPr bwMode="auto">
            <a:xfrm>
              <a:off x="2525" y="2661"/>
              <a:ext cx="224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b="1">
                  <a:solidFill>
                    <a:srgbClr val="000000"/>
                  </a:solidFill>
                </a:rPr>
                <a:t>Time</a:t>
              </a:r>
              <a:endParaRPr lang="es-ES" sz="1200"/>
            </a:p>
          </p:txBody>
        </p:sp>
        <p:sp>
          <p:nvSpPr>
            <p:cNvPr id="91" name="Rectangle 92"/>
            <p:cNvSpPr>
              <a:spLocks noChangeArrowheads="1"/>
            </p:cNvSpPr>
            <p:nvPr/>
          </p:nvSpPr>
          <p:spPr bwMode="auto">
            <a:xfrm>
              <a:off x="343" y="391"/>
              <a:ext cx="138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RU</a:t>
              </a:r>
              <a:endParaRPr lang="es-ES" sz="1200"/>
            </a:p>
          </p:txBody>
        </p:sp>
        <p:sp>
          <p:nvSpPr>
            <p:cNvPr id="92" name="Rectangle 93"/>
            <p:cNvSpPr>
              <a:spLocks noChangeArrowheads="1"/>
            </p:cNvSpPr>
            <p:nvPr/>
          </p:nvSpPr>
          <p:spPr bwMode="auto">
            <a:xfrm rot="5400000">
              <a:off x="-126" y="1900"/>
              <a:ext cx="71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b="1">
                  <a:solidFill>
                    <a:srgbClr val="000000"/>
                  </a:solidFill>
                </a:rPr>
                <a:t>Resp. Diff.</a:t>
              </a:r>
              <a:endParaRPr lang="es-ES" sz="1200"/>
            </a:p>
          </p:txBody>
        </p:sp>
        <p:sp>
          <p:nvSpPr>
            <p:cNvPr id="93" name="Rectangle 94"/>
            <p:cNvSpPr>
              <a:spLocks noChangeArrowheads="1"/>
            </p:cNvSpPr>
            <p:nvPr/>
          </p:nvSpPr>
          <p:spPr bwMode="auto">
            <a:xfrm>
              <a:off x="4880" y="1406"/>
              <a:ext cx="584" cy="267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4" name="Rectangle 95"/>
            <p:cNvSpPr>
              <a:spLocks noChangeArrowheads="1"/>
            </p:cNvSpPr>
            <p:nvPr/>
          </p:nvSpPr>
          <p:spPr bwMode="auto">
            <a:xfrm>
              <a:off x="5027" y="1441"/>
              <a:ext cx="773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PS9'Fc Fc=2-1 - 1</a:t>
              </a:r>
              <a:endParaRPr lang="es-ES" sz="1200"/>
            </a:p>
          </p:txBody>
        </p:sp>
        <p:sp>
          <p:nvSpPr>
            <p:cNvPr id="95" name="Line 96"/>
            <p:cNvSpPr>
              <a:spLocks noChangeShapeType="1"/>
            </p:cNvSpPr>
            <p:nvPr/>
          </p:nvSpPr>
          <p:spPr bwMode="auto">
            <a:xfrm>
              <a:off x="4929" y="1461"/>
              <a:ext cx="81" cy="1"/>
            </a:xfrm>
            <a:prstGeom prst="line">
              <a:avLst/>
            </a:prstGeom>
            <a:noFill/>
            <a:ln w="0">
              <a:solidFill>
                <a:srgbClr val="FF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6" name="Rectangle 97"/>
            <p:cNvSpPr>
              <a:spLocks noChangeArrowheads="1"/>
            </p:cNvSpPr>
            <p:nvPr/>
          </p:nvSpPr>
          <p:spPr bwMode="auto">
            <a:xfrm>
              <a:off x="5027" y="1518"/>
              <a:ext cx="1121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</a:rPr>
                <a:t>PSG9-peptide2 Fc=2-1 - 1</a:t>
              </a:r>
              <a:endParaRPr lang="es-ES" sz="1200"/>
            </a:p>
          </p:txBody>
        </p:sp>
        <p:sp>
          <p:nvSpPr>
            <p:cNvPr id="97" name="Line 98"/>
            <p:cNvSpPr>
              <a:spLocks noChangeShapeType="1"/>
            </p:cNvSpPr>
            <p:nvPr/>
          </p:nvSpPr>
          <p:spPr bwMode="auto">
            <a:xfrm>
              <a:off x="4929" y="1539"/>
              <a:ext cx="81" cy="1"/>
            </a:xfrm>
            <a:prstGeom prst="line">
              <a:avLst/>
            </a:prstGeom>
            <a:noFill/>
            <a:ln w="0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8" name="Rectangle 99"/>
            <p:cNvSpPr>
              <a:spLocks noChangeArrowheads="1"/>
            </p:cNvSpPr>
            <p:nvPr/>
          </p:nvSpPr>
          <p:spPr bwMode="auto">
            <a:xfrm>
              <a:off x="5027" y="1596"/>
              <a:ext cx="1121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</a:rPr>
                <a:t>PSG9-peptide1 </a:t>
              </a:r>
              <a:r>
                <a:rPr lang="es-ES" sz="1200" dirty="0" err="1">
                  <a:solidFill>
                    <a:srgbClr val="000000"/>
                  </a:solidFill>
                </a:rPr>
                <a:t>Fc</a:t>
              </a:r>
              <a:r>
                <a:rPr lang="es-ES" sz="1200" dirty="0">
                  <a:solidFill>
                    <a:srgbClr val="000000"/>
                  </a:solidFill>
                </a:rPr>
                <a:t>=2-1 - 1</a:t>
              </a:r>
              <a:endParaRPr lang="es-ES" sz="1200" dirty="0"/>
            </a:p>
          </p:txBody>
        </p:sp>
        <p:sp>
          <p:nvSpPr>
            <p:cNvPr id="99" name="Line 100"/>
            <p:cNvSpPr>
              <a:spLocks noChangeShapeType="1"/>
            </p:cNvSpPr>
            <p:nvPr/>
          </p:nvSpPr>
          <p:spPr bwMode="auto">
            <a:xfrm>
              <a:off x="4929" y="1616"/>
              <a:ext cx="81" cy="1"/>
            </a:xfrm>
            <a:prstGeom prst="line">
              <a:avLst/>
            </a:prstGeom>
            <a:noFill/>
            <a:ln w="0">
              <a:solidFill>
                <a:srgbClr val="008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0" name="Freeform 101"/>
            <p:cNvSpPr>
              <a:spLocks/>
            </p:cNvSpPr>
            <p:nvPr/>
          </p:nvSpPr>
          <p:spPr bwMode="auto">
            <a:xfrm>
              <a:off x="795" y="1022"/>
              <a:ext cx="3758" cy="1299"/>
            </a:xfrm>
            <a:custGeom>
              <a:avLst/>
              <a:gdLst>
                <a:gd name="T0" fmla="*/ 54 w 3758"/>
                <a:gd name="T1" fmla="*/ 1294 h 1299"/>
                <a:gd name="T2" fmla="*/ 120 w 3758"/>
                <a:gd name="T3" fmla="*/ 1293 h 1299"/>
                <a:gd name="T4" fmla="*/ 183 w 3758"/>
                <a:gd name="T5" fmla="*/ 1296 h 1299"/>
                <a:gd name="T6" fmla="*/ 248 w 3758"/>
                <a:gd name="T7" fmla="*/ 1230 h 1299"/>
                <a:gd name="T8" fmla="*/ 314 w 3758"/>
                <a:gd name="T9" fmla="*/ 1207 h 1299"/>
                <a:gd name="T10" fmla="*/ 379 w 3758"/>
                <a:gd name="T11" fmla="*/ 1121 h 1299"/>
                <a:gd name="T12" fmla="*/ 444 w 3758"/>
                <a:gd name="T13" fmla="*/ 1051 h 1299"/>
                <a:gd name="T14" fmla="*/ 510 w 3758"/>
                <a:gd name="T15" fmla="*/ 980 h 1299"/>
                <a:gd name="T16" fmla="*/ 573 w 3758"/>
                <a:gd name="T17" fmla="*/ 918 h 1299"/>
                <a:gd name="T18" fmla="*/ 638 w 3758"/>
                <a:gd name="T19" fmla="*/ 859 h 1299"/>
                <a:gd name="T20" fmla="*/ 704 w 3758"/>
                <a:gd name="T21" fmla="*/ 804 h 1299"/>
                <a:gd name="T22" fmla="*/ 769 w 3758"/>
                <a:gd name="T23" fmla="*/ 754 h 1299"/>
                <a:gd name="T24" fmla="*/ 834 w 3758"/>
                <a:gd name="T25" fmla="*/ 708 h 1299"/>
                <a:gd name="T26" fmla="*/ 900 w 3758"/>
                <a:gd name="T27" fmla="*/ 666 h 1299"/>
                <a:gd name="T28" fmla="*/ 963 w 3758"/>
                <a:gd name="T29" fmla="*/ 622 h 1299"/>
                <a:gd name="T30" fmla="*/ 1028 w 3758"/>
                <a:gd name="T31" fmla="*/ 576 h 1299"/>
                <a:gd name="T32" fmla="*/ 1094 w 3758"/>
                <a:gd name="T33" fmla="*/ 541 h 1299"/>
                <a:gd name="T34" fmla="*/ 1159 w 3758"/>
                <a:gd name="T35" fmla="*/ 501 h 1299"/>
                <a:gd name="T36" fmla="*/ 1224 w 3758"/>
                <a:gd name="T37" fmla="*/ 462 h 1299"/>
                <a:gd name="T38" fmla="*/ 1288 w 3758"/>
                <a:gd name="T39" fmla="*/ 423 h 1299"/>
                <a:gd name="T40" fmla="*/ 1353 w 3758"/>
                <a:gd name="T41" fmla="*/ 392 h 1299"/>
                <a:gd name="T42" fmla="*/ 1418 w 3758"/>
                <a:gd name="T43" fmla="*/ 357 h 1299"/>
                <a:gd name="T44" fmla="*/ 1484 w 3758"/>
                <a:gd name="T45" fmla="*/ 319 h 1299"/>
                <a:gd name="T46" fmla="*/ 1549 w 3758"/>
                <a:gd name="T47" fmla="*/ 284 h 1299"/>
                <a:gd name="T48" fmla="*/ 1614 w 3758"/>
                <a:gd name="T49" fmla="*/ 249 h 1299"/>
                <a:gd name="T50" fmla="*/ 1678 w 3758"/>
                <a:gd name="T51" fmla="*/ 205 h 1299"/>
                <a:gd name="T52" fmla="*/ 1743 w 3758"/>
                <a:gd name="T53" fmla="*/ 180 h 1299"/>
                <a:gd name="T54" fmla="*/ 1808 w 3758"/>
                <a:gd name="T55" fmla="*/ 146 h 1299"/>
                <a:gd name="T56" fmla="*/ 1874 w 3758"/>
                <a:gd name="T57" fmla="*/ 122 h 1299"/>
                <a:gd name="T58" fmla="*/ 1939 w 3758"/>
                <a:gd name="T59" fmla="*/ 86 h 1299"/>
                <a:gd name="T60" fmla="*/ 2004 w 3758"/>
                <a:gd name="T61" fmla="*/ 61 h 1299"/>
                <a:gd name="T62" fmla="*/ 2068 w 3758"/>
                <a:gd name="T63" fmla="*/ 23 h 1299"/>
                <a:gd name="T64" fmla="*/ 2133 w 3758"/>
                <a:gd name="T65" fmla="*/ 3 h 1299"/>
                <a:gd name="T66" fmla="*/ 2198 w 3758"/>
                <a:gd name="T67" fmla="*/ 29 h 1299"/>
                <a:gd name="T68" fmla="*/ 2264 w 3758"/>
                <a:gd name="T69" fmla="*/ 51 h 1299"/>
                <a:gd name="T70" fmla="*/ 2329 w 3758"/>
                <a:gd name="T71" fmla="*/ 64 h 1299"/>
                <a:gd name="T72" fmla="*/ 2394 w 3758"/>
                <a:gd name="T73" fmla="*/ 76 h 1299"/>
                <a:gd name="T74" fmla="*/ 2458 w 3758"/>
                <a:gd name="T75" fmla="*/ 83 h 1299"/>
                <a:gd name="T76" fmla="*/ 2523 w 3758"/>
                <a:gd name="T77" fmla="*/ 85 h 1299"/>
                <a:gd name="T78" fmla="*/ 2588 w 3758"/>
                <a:gd name="T79" fmla="*/ 95 h 1299"/>
                <a:gd name="T80" fmla="*/ 2654 w 3758"/>
                <a:gd name="T81" fmla="*/ 106 h 1299"/>
                <a:gd name="T82" fmla="*/ 2719 w 3758"/>
                <a:gd name="T83" fmla="*/ 102 h 1299"/>
                <a:gd name="T84" fmla="*/ 2783 w 3758"/>
                <a:gd name="T85" fmla="*/ 116 h 1299"/>
                <a:gd name="T86" fmla="*/ 2848 w 3758"/>
                <a:gd name="T87" fmla="*/ 113 h 1299"/>
                <a:gd name="T88" fmla="*/ 2913 w 3758"/>
                <a:gd name="T89" fmla="*/ 121 h 1299"/>
                <a:gd name="T90" fmla="*/ 2978 w 3758"/>
                <a:gd name="T91" fmla="*/ 127 h 1299"/>
                <a:gd name="T92" fmla="*/ 3044 w 3758"/>
                <a:gd name="T93" fmla="*/ 125 h 1299"/>
                <a:gd name="T94" fmla="*/ 3109 w 3758"/>
                <a:gd name="T95" fmla="*/ 136 h 1299"/>
                <a:gd name="T96" fmla="*/ 3173 w 3758"/>
                <a:gd name="T97" fmla="*/ 139 h 1299"/>
                <a:gd name="T98" fmla="*/ 3238 w 3758"/>
                <a:gd name="T99" fmla="*/ 144 h 1299"/>
                <a:gd name="T100" fmla="*/ 3303 w 3758"/>
                <a:gd name="T101" fmla="*/ 155 h 1299"/>
                <a:gd name="T102" fmla="*/ 3368 w 3758"/>
                <a:gd name="T103" fmla="*/ 154 h 1299"/>
                <a:gd name="T104" fmla="*/ 3434 w 3758"/>
                <a:gd name="T105" fmla="*/ 159 h 1299"/>
                <a:gd name="T106" fmla="*/ 3499 w 3758"/>
                <a:gd name="T107" fmla="*/ 166 h 1299"/>
                <a:gd name="T108" fmla="*/ 3563 w 3758"/>
                <a:gd name="T109" fmla="*/ 172 h 1299"/>
                <a:gd name="T110" fmla="*/ 3628 w 3758"/>
                <a:gd name="T111" fmla="*/ 167 h 1299"/>
                <a:gd name="T112" fmla="*/ 3693 w 3758"/>
                <a:gd name="T113" fmla="*/ 169 h 1299"/>
                <a:gd name="T114" fmla="*/ 3758 w 3758"/>
                <a:gd name="T115" fmla="*/ 183 h 12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3758" h="1299">
                  <a:moveTo>
                    <a:pt x="0" y="1293"/>
                  </a:moveTo>
                  <a:lnTo>
                    <a:pt x="10" y="1295"/>
                  </a:lnTo>
                  <a:lnTo>
                    <a:pt x="22" y="1294"/>
                  </a:lnTo>
                  <a:lnTo>
                    <a:pt x="33" y="1293"/>
                  </a:lnTo>
                  <a:lnTo>
                    <a:pt x="43" y="1294"/>
                  </a:lnTo>
                  <a:lnTo>
                    <a:pt x="54" y="1294"/>
                  </a:lnTo>
                  <a:lnTo>
                    <a:pt x="64" y="1293"/>
                  </a:lnTo>
                  <a:lnTo>
                    <a:pt x="76" y="1294"/>
                  </a:lnTo>
                  <a:lnTo>
                    <a:pt x="87" y="1293"/>
                  </a:lnTo>
                  <a:lnTo>
                    <a:pt x="97" y="1293"/>
                  </a:lnTo>
                  <a:lnTo>
                    <a:pt x="108" y="1291"/>
                  </a:lnTo>
                  <a:lnTo>
                    <a:pt x="120" y="1293"/>
                  </a:lnTo>
                  <a:lnTo>
                    <a:pt x="129" y="1293"/>
                  </a:lnTo>
                  <a:lnTo>
                    <a:pt x="141" y="1295"/>
                  </a:lnTo>
                  <a:lnTo>
                    <a:pt x="152" y="1296"/>
                  </a:lnTo>
                  <a:lnTo>
                    <a:pt x="162" y="1294"/>
                  </a:lnTo>
                  <a:lnTo>
                    <a:pt x="173" y="1294"/>
                  </a:lnTo>
                  <a:lnTo>
                    <a:pt x="183" y="1296"/>
                  </a:lnTo>
                  <a:lnTo>
                    <a:pt x="195" y="1289"/>
                  </a:lnTo>
                  <a:lnTo>
                    <a:pt x="206" y="1284"/>
                  </a:lnTo>
                  <a:lnTo>
                    <a:pt x="216" y="1262"/>
                  </a:lnTo>
                  <a:lnTo>
                    <a:pt x="227" y="1281"/>
                  </a:lnTo>
                  <a:lnTo>
                    <a:pt x="239" y="1299"/>
                  </a:lnTo>
                  <a:lnTo>
                    <a:pt x="248" y="1230"/>
                  </a:lnTo>
                  <a:lnTo>
                    <a:pt x="260" y="1234"/>
                  </a:lnTo>
                  <a:lnTo>
                    <a:pt x="271" y="1230"/>
                  </a:lnTo>
                  <a:lnTo>
                    <a:pt x="281" y="1230"/>
                  </a:lnTo>
                  <a:lnTo>
                    <a:pt x="293" y="1226"/>
                  </a:lnTo>
                  <a:lnTo>
                    <a:pt x="302" y="1221"/>
                  </a:lnTo>
                  <a:lnTo>
                    <a:pt x="314" y="1207"/>
                  </a:lnTo>
                  <a:lnTo>
                    <a:pt x="325" y="1194"/>
                  </a:lnTo>
                  <a:lnTo>
                    <a:pt x="335" y="1179"/>
                  </a:lnTo>
                  <a:lnTo>
                    <a:pt x="346" y="1164"/>
                  </a:lnTo>
                  <a:lnTo>
                    <a:pt x="358" y="1154"/>
                  </a:lnTo>
                  <a:lnTo>
                    <a:pt x="368" y="1136"/>
                  </a:lnTo>
                  <a:lnTo>
                    <a:pt x="379" y="1121"/>
                  </a:lnTo>
                  <a:lnTo>
                    <a:pt x="390" y="1109"/>
                  </a:lnTo>
                  <a:lnTo>
                    <a:pt x="400" y="1096"/>
                  </a:lnTo>
                  <a:lnTo>
                    <a:pt x="412" y="1084"/>
                  </a:lnTo>
                  <a:lnTo>
                    <a:pt x="421" y="1073"/>
                  </a:lnTo>
                  <a:lnTo>
                    <a:pt x="433" y="1062"/>
                  </a:lnTo>
                  <a:lnTo>
                    <a:pt x="444" y="1051"/>
                  </a:lnTo>
                  <a:lnTo>
                    <a:pt x="454" y="1039"/>
                  </a:lnTo>
                  <a:lnTo>
                    <a:pt x="466" y="1026"/>
                  </a:lnTo>
                  <a:lnTo>
                    <a:pt x="477" y="1014"/>
                  </a:lnTo>
                  <a:lnTo>
                    <a:pt x="487" y="1006"/>
                  </a:lnTo>
                  <a:lnTo>
                    <a:pt x="498" y="995"/>
                  </a:lnTo>
                  <a:lnTo>
                    <a:pt x="510" y="980"/>
                  </a:lnTo>
                  <a:lnTo>
                    <a:pt x="519" y="969"/>
                  </a:lnTo>
                  <a:lnTo>
                    <a:pt x="531" y="958"/>
                  </a:lnTo>
                  <a:lnTo>
                    <a:pt x="542" y="949"/>
                  </a:lnTo>
                  <a:lnTo>
                    <a:pt x="552" y="937"/>
                  </a:lnTo>
                  <a:lnTo>
                    <a:pt x="563" y="928"/>
                  </a:lnTo>
                  <a:lnTo>
                    <a:pt x="573" y="918"/>
                  </a:lnTo>
                  <a:lnTo>
                    <a:pt x="585" y="904"/>
                  </a:lnTo>
                  <a:lnTo>
                    <a:pt x="596" y="897"/>
                  </a:lnTo>
                  <a:lnTo>
                    <a:pt x="606" y="885"/>
                  </a:lnTo>
                  <a:lnTo>
                    <a:pt x="617" y="877"/>
                  </a:lnTo>
                  <a:lnTo>
                    <a:pt x="629" y="864"/>
                  </a:lnTo>
                  <a:lnTo>
                    <a:pt x="638" y="859"/>
                  </a:lnTo>
                  <a:lnTo>
                    <a:pt x="650" y="850"/>
                  </a:lnTo>
                  <a:lnTo>
                    <a:pt x="661" y="841"/>
                  </a:lnTo>
                  <a:lnTo>
                    <a:pt x="671" y="835"/>
                  </a:lnTo>
                  <a:lnTo>
                    <a:pt x="683" y="824"/>
                  </a:lnTo>
                  <a:lnTo>
                    <a:pt x="692" y="815"/>
                  </a:lnTo>
                  <a:lnTo>
                    <a:pt x="704" y="804"/>
                  </a:lnTo>
                  <a:lnTo>
                    <a:pt x="715" y="796"/>
                  </a:lnTo>
                  <a:lnTo>
                    <a:pt x="725" y="789"/>
                  </a:lnTo>
                  <a:lnTo>
                    <a:pt x="736" y="780"/>
                  </a:lnTo>
                  <a:lnTo>
                    <a:pt x="748" y="774"/>
                  </a:lnTo>
                  <a:lnTo>
                    <a:pt x="758" y="765"/>
                  </a:lnTo>
                  <a:lnTo>
                    <a:pt x="769" y="754"/>
                  </a:lnTo>
                  <a:lnTo>
                    <a:pt x="780" y="750"/>
                  </a:lnTo>
                  <a:lnTo>
                    <a:pt x="790" y="743"/>
                  </a:lnTo>
                  <a:lnTo>
                    <a:pt x="802" y="730"/>
                  </a:lnTo>
                  <a:lnTo>
                    <a:pt x="811" y="726"/>
                  </a:lnTo>
                  <a:lnTo>
                    <a:pt x="823" y="714"/>
                  </a:lnTo>
                  <a:lnTo>
                    <a:pt x="834" y="708"/>
                  </a:lnTo>
                  <a:lnTo>
                    <a:pt x="844" y="700"/>
                  </a:lnTo>
                  <a:lnTo>
                    <a:pt x="855" y="696"/>
                  </a:lnTo>
                  <a:lnTo>
                    <a:pt x="867" y="689"/>
                  </a:lnTo>
                  <a:lnTo>
                    <a:pt x="877" y="677"/>
                  </a:lnTo>
                  <a:lnTo>
                    <a:pt x="888" y="672"/>
                  </a:lnTo>
                  <a:lnTo>
                    <a:pt x="900" y="666"/>
                  </a:lnTo>
                  <a:lnTo>
                    <a:pt x="909" y="656"/>
                  </a:lnTo>
                  <a:lnTo>
                    <a:pt x="921" y="650"/>
                  </a:lnTo>
                  <a:lnTo>
                    <a:pt x="931" y="645"/>
                  </a:lnTo>
                  <a:lnTo>
                    <a:pt x="942" y="636"/>
                  </a:lnTo>
                  <a:lnTo>
                    <a:pt x="953" y="627"/>
                  </a:lnTo>
                  <a:lnTo>
                    <a:pt x="963" y="622"/>
                  </a:lnTo>
                  <a:lnTo>
                    <a:pt x="975" y="612"/>
                  </a:lnTo>
                  <a:lnTo>
                    <a:pt x="986" y="607"/>
                  </a:lnTo>
                  <a:lnTo>
                    <a:pt x="996" y="600"/>
                  </a:lnTo>
                  <a:lnTo>
                    <a:pt x="1007" y="593"/>
                  </a:lnTo>
                  <a:lnTo>
                    <a:pt x="1019" y="586"/>
                  </a:lnTo>
                  <a:lnTo>
                    <a:pt x="1028" y="576"/>
                  </a:lnTo>
                  <a:lnTo>
                    <a:pt x="1040" y="572"/>
                  </a:lnTo>
                  <a:lnTo>
                    <a:pt x="1050" y="568"/>
                  </a:lnTo>
                  <a:lnTo>
                    <a:pt x="1061" y="561"/>
                  </a:lnTo>
                  <a:lnTo>
                    <a:pt x="1073" y="556"/>
                  </a:lnTo>
                  <a:lnTo>
                    <a:pt x="1082" y="548"/>
                  </a:lnTo>
                  <a:lnTo>
                    <a:pt x="1094" y="541"/>
                  </a:lnTo>
                  <a:lnTo>
                    <a:pt x="1105" y="535"/>
                  </a:lnTo>
                  <a:lnTo>
                    <a:pt x="1115" y="530"/>
                  </a:lnTo>
                  <a:lnTo>
                    <a:pt x="1126" y="518"/>
                  </a:lnTo>
                  <a:lnTo>
                    <a:pt x="1138" y="510"/>
                  </a:lnTo>
                  <a:lnTo>
                    <a:pt x="1148" y="505"/>
                  </a:lnTo>
                  <a:lnTo>
                    <a:pt x="1159" y="501"/>
                  </a:lnTo>
                  <a:lnTo>
                    <a:pt x="1169" y="497"/>
                  </a:lnTo>
                  <a:lnTo>
                    <a:pt x="1180" y="488"/>
                  </a:lnTo>
                  <a:lnTo>
                    <a:pt x="1192" y="482"/>
                  </a:lnTo>
                  <a:lnTo>
                    <a:pt x="1201" y="480"/>
                  </a:lnTo>
                  <a:lnTo>
                    <a:pt x="1213" y="474"/>
                  </a:lnTo>
                  <a:lnTo>
                    <a:pt x="1224" y="462"/>
                  </a:lnTo>
                  <a:lnTo>
                    <a:pt x="1234" y="459"/>
                  </a:lnTo>
                  <a:lnTo>
                    <a:pt x="1245" y="454"/>
                  </a:lnTo>
                  <a:lnTo>
                    <a:pt x="1257" y="443"/>
                  </a:lnTo>
                  <a:lnTo>
                    <a:pt x="1267" y="439"/>
                  </a:lnTo>
                  <a:lnTo>
                    <a:pt x="1278" y="435"/>
                  </a:lnTo>
                  <a:lnTo>
                    <a:pt x="1288" y="423"/>
                  </a:lnTo>
                  <a:lnTo>
                    <a:pt x="1299" y="417"/>
                  </a:lnTo>
                  <a:lnTo>
                    <a:pt x="1311" y="413"/>
                  </a:lnTo>
                  <a:lnTo>
                    <a:pt x="1321" y="404"/>
                  </a:lnTo>
                  <a:lnTo>
                    <a:pt x="1332" y="399"/>
                  </a:lnTo>
                  <a:lnTo>
                    <a:pt x="1343" y="395"/>
                  </a:lnTo>
                  <a:lnTo>
                    <a:pt x="1353" y="392"/>
                  </a:lnTo>
                  <a:lnTo>
                    <a:pt x="1365" y="385"/>
                  </a:lnTo>
                  <a:lnTo>
                    <a:pt x="1376" y="378"/>
                  </a:lnTo>
                  <a:lnTo>
                    <a:pt x="1386" y="372"/>
                  </a:lnTo>
                  <a:lnTo>
                    <a:pt x="1397" y="367"/>
                  </a:lnTo>
                  <a:lnTo>
                    <a:pt x="1409" y="359"/>
                  </a:lnTo>
                  <a:lnTo>
                    <a:pt x="1418" y="357"/>
                  </a:lnTo>
                  <a:lnTo>
                    <a:pt x="1430" y="347"/>
                  </a:lnTo>
                  <a:lnTo>
                    <a:pt x="1440" y="343"/>
                  </a:lnTo>
                  <a:lnTo>
                    <a:pt x="1451" y="335"/>
                  </a:lnTo>
                  <a:lnTo>
                    <a:pt x="1462" y="328"/>
                  </a:lnTo>
                  <a:lnTo>
                    <a:pt x="1472" y="325"/>
                  </a:lnTo>
                  <a:lnTo>
                    <a:pt x="1484" y="319"/>
                  </a:lnTo>
                  <a:lnTo>
                    <a:pt x="1495" y="308"/>
                  </a:lnTo>
                  <a:lnTo>
                    <a:pt x="1505" y="303"/>
                  </a:lnTo>
                  <a:lnTo>
                    <a:pt x="1516" y="297"/>
                  </a:lnTo>
                  <a:lnTo>
                    <a:pt x="1528" y="291"/>
                  </a:lnTo>
                  <a:lnTo>
                    <a:pt x="1538" y="290"/>
                  </a:lnTo>
                  <a:lnTo>
                    <a:pt x="1549" y="284"/>
                  </a:lnTo>
                  <a:lnTo>
                    <a:pt x="1559" y="279"/>
                  </a:lnTo>
                  <a:lnTo>
                    <a:pt x="1570" y="270"/>
                  </a:lnTo>
                  <a:lnTo>
                    <a:pt x="1582" y="264"/>
                  </a:lnTo>
                  <a:lnTo>
                    <a:pt x="1591" y="261"/>
                  </a:lnTo>
                  <a:lnTo>
                    <a:pt x="1603" y="254"/>
                  </a:lnTo>
                  <a:lnTo>
                    <a:pt x="1614" y="249"/>
                  </a:lnTo>
                  <a:lnTo>
                    <a:pt x="1624" y="244"/>
                  </a:lnTo>
                  <a:lnTo>
                    <a:pt x="1635" y="235"/>
                  </a:lnTo>
                  <a:lnTo>
                    <a:pt x="1647" y="232"/>
                  </a:lnTo>
                  <a:lnTo>
                    <a:pt x="1657" y="226"/>
                  </a:lnTo>
                  <a:lnTo>
                    <a:pt x="1668" y="218"/>
                  </a:lnTo>
                  <a:lnTo>
                    <a:pt x="1678" y="205"/>
                  </a:lnTo>
                  <a:lnTo>
                    <a:pt x="1689" y="204"/>
                  </a:lnTo>
                  <a:lnTo>
                    <a:pt x="1701" y="204"/>
                  </a:lnTo>
                  <a:lnTo>
                    <a:pt x="1711" y="196"/>
                  </a:lnTo>
                  <a:lnTo>
                    <a:pt x="1722" y="191"/>
                  </a:lnTo>
                  <a:lnTo>
                    <a:pt x="1733" y="184"/>
                  </a:lnTo>
                  <a:lnTo>
                    <a:pt x="1743" y="180"/>
                  </a:lnTo>
                  <a:lnTo>
                    <a:pt x="1755" y="174"/>
                  </a:lnTo>
                  <a:lnTo>
                    <a:pt x="1766" y="167"/>
                  </a:lnTo>
                  <a:lnTo>
                    <a:pt x="1776" y="161"/>
                  </a:lnTo>
                  <a:lnTo>
                    <a:pt x="1787" y="153"/>
                  </a:lnTo>
                  <a:lnTo>
                    <a:pt x="1797" y="147"/>
                  </a:lnTo>
                  <a:lnTo>
                    <a:pt x="1808" y="146"/>
                  </a:lnTo>
                  <a:lnTo>
                    <a:pt x="1820" y="140"/>
                  </a:lnTo>
                  <a:lnTo>
                    <a:pt x="1830" y="137"/>
                  </a:lnTo>
                  <a:lnTo>
                    <a:pt x="1841" y="131"/>
                  </a:lnTo>
                  <a:lnTo>
                    <a:pt x="1852" y="128"/>
                  </a:lnTo>
                  <a:lnTo>
                    <a:pt x="1862" y="125"/>
                  </a:lnTo>
                  <a:lnTo>
                    <a:pt x="1874" y="122"/>
                  </a:lnTo>
                  <a:lnTo>
                    <a:pt x="1885" y="113"/>
                  </a:lnTo>
                  <a:lnTo>
                    <a:pt x="1895" y="108"/>
                  </a:lnTo>
                  <a:lnTo>
                    <a:pt x="1906" y="105"/>
                  </a:lnTo>
                  <a:lnTo>
                    <a:pt x="1916" y="101"/>
                  </a:lnTo>
                  <a:lnTo>
                    <a:pt x="1928" y="89"/>
                  </a:lnTo>
                  <a:lnTo>
                    <a:pt x="1939" y="86"/>
                  </a:lnTo>
                  <a:lnTo>
                    <a:pt x="1949" y="83"/>
                  </a:lnTo>
                  <a:lnTo>
                    <a:pt x="1960" y="78"/>
                  </a:lnTo>
                  <a:lnTo>
                    <a:pt x="1972" y="72"/>
                  </a:lnTo>
                  <a:lnTo>
                    <a:pt x="1981" y="70"/>
                  </a:lnTo>
                  <a:lnTo>
                    <a:pt x="1993" y="64"/>
                  </a:lnTo>
                  <a:lnTo>
                    <a:pt x="2004" y="61"/>
                  </a:lnTo>
                  <a:lnTo>
                    <a:pt x="2014" y="54"/>
                  </a:lnTo>
                  <a:lnTo>
                    <a:pt x="2025" y="47"/>
                  </a:lnTo>
                  <a:lnTo>
                    <a:pt x="2035" y="44"/>
                  </a:lnTo>
                  <a:lnTo>
                    <a:pt x="2047" y="37"/>
                  </a:lnTo>
                  <a:lnTo>
                    <a:pt x="2058" y="32"/>
                  </a:lnTo>
                  <a:lnTo>
                    <a:pt x="2068" y="23"/>
                  </a:lnTo>
                  <a:lnTo>
                    <a:pt x="2079" y="21"/>
                  </a:lnTo>
                  <a:lnTo>
                    <a:pt x="2091" y="18"/>
                  </a:lnTo>
                  <a:lnTo>
                    <a:pt x="2101" y="11"/>
                  </a:lnTo>
                  <a:lnTo>
                    <a:pt x="2112" y="10"/>
                  </a:lnTo>
                  <a:lnTo>
                    <a:pt x="2123" y="6"/>
                  </a:lnTo>
                  <a:lnTo>
                    <a:pt x="2133" y="3"/>
                  </a:lnTo>
                  <a:lnTo>
                    <a:pt x="2145" y="0"/>
                  </a:lnTo>
                  <a:lnTo>
                    <a:pt x="2154" y="19"/>
                  </a:lnTo>
                  <a:lnTo>
                    <a:pt x="2166" y="27"/>
                  </a:lnTo>
                  <a:lnTo>
                    <a:pt x="2177" y="28"/>
                  </a:lnTo>
                  <a:lnTo>
                    <a:pt x="2187" y="25"/>
                  </a:lnTo>
                  <a:lnTo>
                    <a:pt x="2198" y="29"/>
                  </a:lnTo>
                  <a:lnTo>
                    <a:pt x="2210" y="42"/>
                  </a:lnTo>
                  <a:lnTo>
                    <a:pt x="2220" y="43"/>
                  </a:lnTo>
                  <a:lnTo>
                    <a:pt x="2231" y="44"/>
                  </a:lnTo>
                  <a:lnTo>
                    <a:pt x="2242" y="45"/>
                  </a:lnTo>
                  <a:lnTo>
                    <a:pt x="2252" y="48"/>
                  </a:lnTo>
                  <a:lnTo>
                    <a:pt x="2264" y="51"/>
                  </a:lnTo>
                  <a:lnTo>
                    <a:pt x="2275" y="49"/>
                  </a:lnTo>
                  <a:lnTo>
                    <a:pt x="2285" y="52"/>
                  </a:lnTo>
                  <a:lnTo>
                    <a:pt x="2296" y="51"/>
                  </a:lnTo>
                  <a:lnTo>
                    <a:pt x="2306" y="57"/>
                  </a:lnTo>
                  <a:lnTo>
                    <a:pt x="2318" y="59"/>
                  </a:lnTo>
                  <a:lnTo>
                    <a:pt x="2329" y="64"/>
                  </a:lnTo>
                  <a:lnTo>
                    <a:pt x="2339" y="62"/>
                  </a:lnTo>
                  <a:lnTo>
                    <a:pt x="2350" y="66"/>
                  </a:lnTo>
                  <a:lnTo>
                    <a:pt x="2362" y="69"/>
                  </a:lnTo>
                  <a:lnTo>
                    <a:pt x="2371" y="72"/>
                  </a:lnTo>
                  <a:lnTo>
                    <a:pt x="2383" y="76"/>
                  </a:lnTo>
                  <a:lnTo>
                    <a:pt x="2394" y="76"/>
                  </a:lnTo>
                  <a:lnTo>
                    <a:pt x="2404" y="72"/>
                  </a:lnTo>
                  <a:lnTo>
                    <a:pt x="2415" y="74"/>
                  </a:lnTo>
                  <a:lnTo>
                    <a:pt x="2425" y="77"/>
                  </a:lnTo>
                  <a:lnTo>
                    <a:pt x="2437" y="77"/>
                  </a:lnTo>
                  <a:lnTo>
                    <a:pt x="2448" y="80"/>
                  </a:lnTo>
                  <a:lnTo>
                    <a:pt x="2458" y="83"/>
                  </a:lnTo>
                  <a:lnTo>
                    <a:pt x="2469" y="85"/>
                  </a:lnTo>
                  <a:lnTo>
                    <a:pt x="2481" y="88"/>
                  </a:lnTo>
                  <a:lnTo>
                    <a:pt x="2490" y="89"/>
                  </a:lnTo>
                  <a:lnTo>
                    <a:pt x="2502" y="87"/>
                  </a:lnTo>
                  <a:lnTo>
                    <a:pt x="2513" y="85"/>
                  </a:lnTo>
                  <a:lnTo>
                    <a:pt x="2523" y="85"/>
                  </a:lnTo>
                  <a:lnTo>
                    <a:pt x="2535" y="89"/>
                  </a:lnTo>
                  <a:lnTo>
                    <a:pt x="2544" y="87"/>
                  </a:lnTo>
                  <a:lnTo>
                    <a:pt x="2556" y="92"/>
                  </a:lnTo>
                  <a:lnTo>
                    <a:pt x="2567" y="95"/>
                  </a:lnTo>
                  <a:lnTo>
                    <a:pt x="2577" y="98"/>
                  </a:lnTo>
                  <a:lnTo>
                    <a:pt x="2588" y="95"/>
                  </a:lnTo>
                  <a:lnTo>
                    <a:pt x="2600" y="95"/>
                  </a:lnTo>
                  <a:lnTo>
                    <a:pt x="2610" y="94"/>
                  </a:lnTo>
                  <a:lnTo>
                    <a:pt x="2621" y="94"/>
                  </a:lnTo>
                  <a:lnTo>
                    <a:pt x="2632" y="92"/>
                  </a:lnTo>
                  <a:lnTo>
                    <a:pt x="2642" y="101"/>
                  </a:lnTo>
                  <a:lnTo>
                    <a:pt x="2654" y="106"/>
                  </a:lnTo>
                  <a:lnTo>
                    <a:pt x="2663" y="101"/>
                  </a:lnTo>
                  <a:lnTo>
                    <a:pt x="2675" y="102"/>
                  </a:lnTo>
                  <a:lnTo>
                    <a:pt x="2686" y="105"/>
                  </a:lnTo>
                  <a:lnTo>
                    <a:pt x="2696" y="103"/>
                  </a:lnTo>
                  <a:lnTo>
                    <a:pt x="2708" y="102"/>
                  </a:lnTo>
                  <a:lnTo>
                    <a:pt x="2719" y="102"/>
                  </a:lnTo>
                  <a:lnTo>
                    <a:pt x="2729" y="103"/>
                  </a:lnTo>
                  <a:lnTo>
                    <a:pt x="2740" y="111"/>
                  </a:lnTo>
                  <a:lnTo>
                    <a:pt x="2752" y="109"/>
                  </a:lnTo>
                  <a:lnTo>
                    <a:pt x="2761" y="115"/>
                  </a:lnTo>
                  <a:lnTo>
                    <a:pt x="2773" y="113"/>
                  </a:lnTo>
                  <a:lnTo>
                    <a:pt x="2783" y="116"/>
                  </a:lnTo>
                  <a:lnTo>
                    <a:pt x="2794" y="117"/>
                  </a:lnTo>
                  <a:lnTo>
                    <a:pt x="2805" y="114"/>
                  </a:lnTo>
                  <a:lnTo>
                    <a:pt x="2815" y="113"/>
                  </a:lnTo>
                  <a:lnTo>
                    <a:pt x="2827" y="115"/>
                  </a:lnTo>
                  <a:lnTo>
                    <a:pt x="2838" y="115"/>
                  </a:lnTo>
                  <a:lnTo>
                    <a:pt x="2848" y="113"/>
                  </a:lnTo>
                  <a:lnTo>
                    <a:pt x="2859" y="117"/>
                  </a:lnTo>
                  <a:lnTo>
                    <a:pt x="2871" y="116"/>
                  </a:lnTo>
                  <a:lnTo>
                    <a:pt x="2880" y="120"/>
                  </a:lnTo>
                  <a:lnTo>
                    <a:pt x="2892" y="120"/>
                  </a:lnTo>
                  <a:lnTo>
                    <a:pt x="2902" y="121"/>
                  </a:lnTo>
                  <a:lnTo>
                    <a:pt x="2913" y="121"/>
                  </a:lnTo>
                  <a:lnTo>
                    <a:pt x="2925" y="122"/>
                  </a:lnTo>
                  <a:lnTo>
                    <a:pt x="2934" y="118"/>
                  </a:lnTo>
                  <a:lnTo>
                    <a:pt x="2946" y="120"/>
                  </a:lnTo>
                  <a:lnTo>
                    <a:pt x="2957" y="123"/>
                  </a:lnTo>
                  <a:lnTo>
                    <a:pt x="2967" y="124"/>
                  </a:lnTo>
                  <a:lnTo>
                    <a:pt x="2978" y="127"/>
                  </a:lnTo>
                  <a:lnTo>
                    <a:pt x="2990" y="129"/>
                  </a:lnTo>
                  <a:lnTo>
                    <a:pt x="3000" y="125"/>
                  </a:lnTo>
                  <a:lnTo>
                    <a:pt x="3011" y="130"/>
                  </a:lnTo>
                  <a:lnTo>
                    <a:pt x="3021" y="127"/>
                  </a:lnTo>
                  <a:lnTo>
                    <a:pt x="3032" y="129"/>
                  </a:lnTo>
                  <a:lnTo>
                    <a:pt x="3044" y="125"/>
                  </a:lnTo>
                  <a:lnTo>
                    <a:pt x="3053" y="128"/>
                  </a:lnTo>
                  <a:lnTo>
                    <a:pt x="3065" y="128"/>
                  </a:lnTo>
                  <a:lnTo>
                    <a:pt x="3076" y="133"/>
                  </a:lnTo>
                  <a:lnTo>
                    <a:pt x="3086" y="135"/>
                  </a:lnTo>
                  <a:lnTo>
                    <a:pt x="3097" y="137"/>
                  </a:lnTo>
                  <a:lnTo>
                    <a:pt x="3109" y="136"/>
                  </a:lnTo>
                  <a:lnTo>
                    <a:pt x="3119" y="135"/>
                  </a:lnTo>
                  <a:lnTo>
                    <a:pt x="3130" y="136"/>
                  </a:lnTo>
                  <a:lnTo>
                    <a:pt x="3142" y="137"/>
                  </a:lnTo>
                  <a:lnTo>
                    <a:pt x="3151" y="131"/>
                  </a:lnTo>
                  <a:lnTo>
                    <a:pt x="3163" y="133"/>
                  </a:lnTo>
                  <a:lnTo>
                    <a:pt x="3173" y="139"/>
                  </a:lnTo>
                  <a:lnTo>
                    <a:pt x="3184" y="144"/>
                  </a:lnTo>
                  <a:lnTo>
                    <a:pt x="3195" y="147"/>
                  </a:lnTo>
                  <a:lnTo>
                    <a:pt x="3205" y="145"/>
                  </a:lnTo>
                  <a:lnTo>
                    <a:pt x="3217" y="143"/>
                  </a:lnTo>
                  <a:lnTo>
                    <a:pt x="3228" y="144"/>
                  </a:lnTo>
                  <a:lnTo>
                    <a:pt x="3238" y="144"/>
                  </a:lnTo>
                  <a:lnTo>
                    <a:pt x="3249" y="145"/>
                  </a:lnTo>
                  <a:lnTo>
                    <a:pt x="3261" y="145"/>
                  </a:lnTo>
                  <a:lnTo>
                    <a:pt x="3270" y="149"/>
                  </a:lnTo>
                  <a:lnTo>
                    <a:pt x="3282" y="153"/>
                  </a:lnTo>
                  <a:lnTo>
                    <a:pt x="3292" y="153"/>
                  </a:lnTo>
                  <a:lnTo>
                    <a:pt x="3303" y="155"/>
                  </a:lnTo>
                  <a:lnTo>
                    <a:pt x="3315" y="152"/>
                  </a:lnTo>
                  <a:lnTo>
                    <a:pt x="3324" y="152"/>
                  </a:lnTo>
                  <a:lnTo>
                    <a:pt x="3336" y="150"/>
                  </a:lnTo>
                  <a:lnTo>
                    <a:pt x="3347" y="147"/>
                  </a:lnTo>
                  <a:lnTo>
                    <a:pt x="3357" y="151"/>
                  </a:lnTo>
                  <a:lnTo>
                    <a:pt x="3368" y="154"/>
                  </a:lnTo>
                  <a:lnTo>
                    <a:pt x="3380" y="158"/>
                  </a:lnTo>
                  <a:lnTo>
                    <a:pt x="3390" y="162"/>
                  </a:lnTo>
                  <a:lnTo>
                    <a:pt x="3401" y="162"/>
                  </a:lnTo>
                  <a:lnTo>
                    <a:pt x="3411" y="159"/>
                  </a:lnTo>
                  <a:lnTo>
                    <a:pt x="3422" y="159"/>
                  </a:lnTo>
                  <a:lnTo>
                    <a:pt x="3434" y="159"/>
                  </a:lnTo>
                  <a:lnTo>
                    <a:pt x="3443" y="157"/>
                  </a:lnTo>
                  <a:lnTo>
                    <a:pt x="3455" y="160"/>
                  </a:lnTo>
                  <a:lnTo>
                    <a:pt x="3466" y="164"/>
                  </a:lnTo>
                  <a:lnTo>
                    <a:pt x="3476" y="165"/>
                  </a:lnTo>
                  <a:lnTo>
                    <a:pt x="3487" y="165"/>
                  </a:lnTo>
                  <a:lnTo>
                    <a:pt x="3499" y="166"/>
                  </a:lnTo>
                  <a:lnTo>
                    <a:pt x="3509" y="165"/>
                  </a:lnTo>
                  <a:lnTo>
                    <a:pt x="3520" y="167"/>
                  </a:lnTo>
                  <a:lnTo>
                    <a:pt x="3530" y="164"/>
                  </a:lnTo>
                  <a:lnTo>
                    <a:pt x="3541" y="167"/>
                  </a:lnTo>
                  <a:lnTo>
                    <a:pt x="3553" y="167"/>
                  </a:lnTo>
                  <a:lnTo>
                    <a:pt x="3563" y="172"/>
                  </a:lnTo>
                  <a:lnTo>
                    <a:pt x="3574" y="172"/>
                  </a:lnTo>
                  <a:lnTo>
                    <a:pt x="3585" y="173"/>
                  </a:lnTo>
                  <a:lnTo>
                    <a:pt x="3595" y="171"/>
                  </a:lnTo>
                  <a:lnTo>
                    <a:pt x="3607" y="173"/>
                  </a:lnTo>
                  <a:lnTo>
                    <a:pt x="3618" y="167"/>
                  </a:lnTo>
                  <a:lnTo>
                    <a:pt x="3628" y="167"/>
                  </a:lnTo>
                  <a:lnTo>
                    <a:pt x="3639" y="172"/>
                  </a:lnTo>
                  <a:lnTo>
                    <a:pt x="3649" y="173"/>
                  </a:lnTo>
                  <a:lnTo>
                    <a:pt x="3660" y="159"/>
                  </a:lnTo>
                  <a:lnTo>
                    <a:pt x="3672" y="162"/>
                  </a:lnTo>
                  <a:lnTo>
                    <a:pt x="3682" y="171"/>
                  </a:lnTo>
                  <a:lnTo>
                    <a:pt x="3693" y="169"/>
                  </a:lnTo>
                  <a:lnTo>
                    <a:pt x="3704" y="169"/>
                  </a:lnTo>
                  <a:lnTo>
                    <a:pt x="3714" y="169"/>
                  </a:lnTo>
                  <a:lnTo>
                    <a:pt x="3726" y="165"/>
                  </a:lnTo>
                  <a:lnTo>
                    <a:pt x="3737" y="172"/>
                  </a:lnTo>
                  <a:lnTo>
                    <a:pt x="3747" y="174"/>
                  </a:lnTo>
                  <a:lnTo>
                    <a:pt x="3758" y="183"/>
                  </a:lnTo>
                </a:path>
              </a:pathLst>
            </a:custGeom>
            <a:noFill/>
            <a:ln w="0">
              <a:solidFill>
                <a:srgbClr val="FF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Freeform 102"/>
            <p:cNvSpPr>
              <a:spLocks/>
            </p:cNvSpPr>
            <p:nvPr/>
          </p:nvSpPr>
          <p:spPr bwMode="auto">
            <a:xfrm>
              <a:off x="665" y="799"/>
              <a:ext cx="3888" cy="1523"/>
            </a:xfrm>
            <a:custGeom>
              <a:avLst/>
              <a:gdLst>
                <a:gd name="T0" fmla="*/ 54 w 3888"/>
                <a:gd name="T1" fmla="*/ 1520 h 1523"/>
                <a:gd name="T2" fmla="*/ 119 w 3888"/>
                <a:gd name="T3" fmla="*/ 1518 h 1523"/>
                <a:gd name="T4" fmla="*/ 184 w 3888"/>
                <a:gd name="T5" fmla="*/ 1515 h 1523"/>
                <a:gd name="T6" fmla="*/ 250 w 3888"/>
                <a:gd name="T7" fmla="*/ 1515 h 1523"/>
                <a:gd name="T8" fmla="*/ 313 w 3888"/>
                <a:gd name="T9" fmla="*/ 1522 h 1523"/>
                <a:gd name="T10" fmla="*/ 378 w 3888"/>
                <a:gd name="T11" fmla="*/ 1186 h 1523"/>
                <a:gd name="T12" fmla="*/ 444 w 3888"/>
                <a:gd name="T13" fmla="*/ 1315 h 1523"/>
                <a:gd name="T14" fmla="*/ 509 w 3888"/>
                <a:gd name="T15" fmla="*/ 1227 h 1523"/>
                <a:gd name="T16" fmla="*/ 574 w 3888"/>
                <a:gd name="T17" fmla="*/ 1145 h 1523"/>
                <a:gd name="T18" fmla="*/ 640 w 3888"/>
                <a:gd name="T19" fmla="*/ 1075 h 1523"/>
                <a:gd name="T20" fmla="*/ 703 w 3888"/>
                <a:gd name="T21" fmla="*/ 1006 h 1523"/>
                <a:gd name="T22" fmla="*/ 768 w 3888"/>
                <a:gd name="T23" fmla="*/ 946 h 1523"/>
                <a:gd name="T24" fmla="*/ 834 w 3888"/>
                <a:gd name="T25" fmla="*/ 888 h 1523"/>
                <a:gd name="T26" fmla="*/ 899 w 3888"/>
                <a:gd name="T27" fmla="*/ 830 h 1523"/>
                <a:gd name="T28" fmla="*/ 964 w 3888"/>
                <a:gd name="T29" fmla="*/ 777 h 1523"/>
                <a:gd name="T30" fmla="*/ 1030 w 3888"/>
                <a:gd name="T31" fmla="*/ 740 h 1523"/>
                <a:gd name="T32" fmla="*/ 1093 w 3888"/>
                <a:gd name="T33" fmla="*/ 700 h 1523"/>
                <a:gd name="T34" fmla="*/ 1158 w 3888"/>
                <a:gd name="T35" fmla="*/ 650 h 1523"/>
                <a:gd name="T36" fmla="*/ 1224 w 3888"/>
                <a:gd name="T37" fmla="*/ 609 h 1523"/>
                <a:gd name="T38" fmla="*/ 1289 w 3888"/>
                <a:gd name="T39" fmla="*/ 567 h 1523"/>
                <a:gd name="T40" fmla="*/ 1354 w 3888"/>
                <a:gd name="T41" fmla="*/ 529 h 1523"/>
                <a:gd name="T42" fmla="*/ 1418 w 3888"/>
                <a:gd name="T43" fmla="*/ 486 h 1523"/>
                <a:gd name="T44" fmla="*/ 1483 w 3888"/>
                <a:gd name="T45" fmla="*/ 449 h 1523"/>
                <a:gd name="T46" fmla="*/ 1548 w 3888"/>
                <a:gd name="T47" fmla="*/ 409 h 1523"/>
                <a:gd name="T48" fmla="*/ 1614 w 3888"/>
                <a:gd name="T49" fmla="*/ 372 h 1523"/>
                <a:gd name="T50" fmla="*/ 1679 w 3888"/>
                <a:gd name="T51" fmla="*/ 334 h 1523"/>
                <a:gd name="T52" fmla="*/ 1744 w 3888"/>
                <a:gd name="T53" fmla="*/ 292 h 1523"/>
                <a:gd name="T54" fmla="*/ 1808 w 3888"/>
                <a:gd name="T55" fmla="*/ 260 h 1523"/>
                <a:gd name="T56" fmla="*/ 1873 w 3888"/>
                <a:gd name="T57" fmla="*/ 223 h 1523"/>
                <a:gd name="T58" fmla="*/ 1938 w 3888"/>
                <a:gd name="T59" fmla="*/ 195 h 1523"/>
                <a:gd name="T60" fmla="*/ 2004 w 3888"/>
                <a:gd name="T61" fmla="*/ 164 h 1523"/>
                <a:gd name="T62" fmla="*/ 2069 w 3888"/>
                <a:gd name="T63" fmla="*/ 135 h 1523"/>
                <a:gd name="T64" fmla="*/ 2134 w 3888"/>
                <a:gd name="T65" fmla="*/ 109 h 1523"/>
                <a:gd name="T66" fmla="*/ 2198 w 3888"/>
                <a:gd name="T67" fmla="*/ 75 h 1523"/>
                <a:gd name="T68" fmla="*/ 2263 w 3888"/>
                <a:gd name="T69" fmla="*/ 0 h 1523"/>
                <a:gd name="T70" fmla="*/ 2328 w 3888"/>
                <a:gd name="T71" fmla="*/ 224 h 1523"/>
                <a:gd name="T72" fmla="*/ 2394 w 3888"/>
                <a:gd name="T73" fmla="*/ 246 h 1523"/>
                <a:gd name="T74" fmla="*/ 2459 w 3888"/>
                <a:gd name="T75" fmla="*/ 273 h 1523"/>
                <a:gd name="T76" fmla="*/ 2524 w 3888"/>
                <a:gd name="T77" fmla="*/ 302 h 1523"/>
                <a:gd name="T78" fmla="*/ 2588 w 3888"/>
                <a:gd name="T79" fmla="*/ 325 h 1523"/>
                <a:gd name="T80" fmla="*/ 2653 w 3888"/>
                <a:gd name="T81" fmla="*/ 332 h 1523"/>
                <a:gd name="T82" fmla="*/ 2718 w 3888"/>
                <a:gd name="T83" fmla="*/ 350 h 1523"/>
                <a:gd name="T84" fmla="*/ 2784 w 3888"/>
                <a:gd name="T85" fmla="*/ 358 h 1523"/>
                <a:gd name="T86" fmla="*/ 2849 w 3888"/>
                <a:gd name="T87" fmla="*/ 366 h 1523"/>
                <a:gd name="T88" fmla="*/ 2913 w 3888"/>
                <a:gd name="T89" fmla="*/ 375 h 1523"/>
                <a:gd name="T90" fmla="*/ 2978 w 3888"/>
                <a:gd name="T91" fmla="*/ 376 h 1523"/>
                <a:gd name="T92" fmla="*/ 3043 w 3888"/>
                <a:gd name="T93" fmla="*/ 387 h 1523"/>
                <a:gd name="T94" fmla="*/ 3108 w 3888"/>
                <a:gd name="T95" fmla="*/ 392 h 1523"/>
                <a:gd name="T96" fmla="*/ 3174 w 3888"/>
                <a:gd name="T97" fmla="*/ 397 h 1523"/>
                <a:gd name="T98" fmla="*/ 3239 w 3888"/>
                <a:gd name="T99" fmla="*/ 403 h 1523"/>
                <a:gd name="T100" fmla="*/ 3303 w 3888"/>
                <a:gd name="T101" fmla="*/ 403 h 1523"/>
                <a:gd name="T102" fmla="*/ 3368 w 3888"/>
                <a:gd name="T103" fmla="*/ 411 h 1523"/>
                <a:gd name="T104" fmla="*/ 3433 w 3888"/>
                <a:gd name="T105" fmla="*/ 419 h 1523"/>
                <a:gd name="T106" fmla="*/ 3498 w 3888"/>
                <a:gd name="T107" fmla="*/ 424 h 1523"/>
                <a:gd name="T108" fmla="*/ 3564 w 3888"/>
                <a:gd name="T109" fmla="*/ 426 h 1523"/>
                <a:gd name="T110" fmla="*/ 3629 w 3888"/>
                <a:gd name="T111" fmla="*/ 436 h 1523"/>
                <a:gd name="T112" fmla="*/ 3693 w 3888"/>
                <a:gd name="T113" fmla="*/ 433 h 1523"/>
                <a:gd name="T114" fmla="*/ 3758 w 3888"/>
                <a:gd name="T115" fmla="*/ 428 h 1523"/>
                <a:gd name="T116" fmla="*/ 3823 w 3888"/>
                <a:gd name="T117" fmla="*/ 442 h 1523"/>
                <a:gd name="T118" fmla="*/ 3888 w 3888"/>
                <a:gd name="T119" fmla="*/ 444 h 15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3888" h="1523">
                  <a:moveTo>
                    <a:pt x="0" y="1523"/>
                  </a:moveTo>
                  <a:lnTo>
                    <a:pt x="11" y="1522"/>
                  </a:lnTo>
                  <a:lnTo>
                    <a:pt x="21" y="1519"/>
                  </a:lnTo>
                  <a:lnTo>
                    <a:pt x="33" y="1519"/>
                  </a:lnTo>
                  <a:lnTo>
                    <a:pt x="44" y="1519"/>
                  </a:lnTo>
                  <a:lnTo>
                    <a:pt x="54" y="1520"/>
                  </a:lnTo>
                  <a:lnTo>
                    <a:pt x="65" y="1518"/>
                  </a:lnTo>
                  <a:lnTo>
                    <a:pt x="75" y="1519"/>
                  </a:lnTo>
                  <a:lnTo>
                    <a:pt x="86" y="1516"/>
                  </a:lnTo>
                  <a:lnTo>
                    <a:pt x="98" y="1514"/>
                  </a:lnTo>
                  <a:lnTo>
                    <a:pt x="108" y="1517"/>
                  </a:lnTo>
                  <a:lnTo>
                    <a:pt x="119" y="1518"/>
                  </a:lnTo>
                  <a:lnTo>
                    <a:pt x="130" y="1517"/>
                  </a:lnTo>
                  <a:lnTo>
                    <a:pt x="140" y="1516"/>
                  </a:lnTo>
                  <a:lnTo>
                    <a:pt x="152" y="1520"/>
                  </a:lnTo>
                  <a:lnTo>
                    <a:pt x="163" y="1517"/>
                  </a:lnTo>
                  <a:lnTo>
                    <a:pt x="173" y="1519"/>
                  </a:lnTo>
                  <a:lnTo>
                    <a:pt x="184" y="1515"/>
                  </a:lnTo>
                  <a:lnTo>
                    <a:pt x="194" y="1515"/>
                  </a:lnTo>
                  <a:lnTo>
                    <a:pt x="206" y="1517"/>
                  </a:lnTo>
                  <a:lnTo>
                    <a:pt x="217" y="1516"/>
                  </a:lnTo>
                  <a:lnTo>
                    <a:pt x="227" y="1516"/>
                  </a:lnTo>
                  <a:lnTo>
                    <a:pt x="238" y="1516"/>
                  </a:lnTo>
                  <a:lnTo>
                    <a:pt x="250" y="1515"/>
                  </a:lnTo>
                  <a:lnTo>
                    <a:pt x="259" y="1512"/>
                  </a:lnTo>
                  <a:lnTo>
                    <a:pt x="271" y="1517"/>
                  </a:lnTo>
                  <a:lnTo>
                    <a:pt x="282" y="1507"/>
                  </a:lnTo>
                  <a:lnTo>
                    <a:pt x="292" y="1493"/>
                  </a:lnTo>
                  <a:lnTo>
                    <a:pt x="303" y="1501"/>
                  </a:lnTo>
                  <a:lnTo>
                    <a:pt x="313" y="1522"/>
                  </a:lnTo>
                  <a:lnTo>
                    <a:pt x="325" y="1492"/>
                  </a:lnTo>
                  <a:lnTo>
                    <a:pt x="336" y="1127"/>
                  </a:lnTo>
                  <a:lnTo>
                    <a:pt x="346" y="519"/>
                  </a:lnTo>
                  <a:lnTo>
                    <a:pt x="357" y="645"/>
                  </a:lnTo>
                  <a:lnTo>
                    <a:pt x="369" y="982"/>
                  </a:lnTo>
                  <a:lnTo>
                    <a:pt x="378" y="1186"/>
                  </a:lnTo>
                  <a:lnTo>
                    <a:pt x="390" y="1282"/>
                  </a:lnTo>
                  <a:lnTo>
                    <a:pt x="401" y="1322"/>
                  </a:lnTo>
                  <a:lnTo>
                    <a:pt x="411" y="1335"/>
                  </a:lnTo>
                  <a:lnTo>
                    <a:pt x="423" y="1332"/>
                  </a:lnTo>
                  <a:lnTo>
                    <a:pt x="432" y="1328"/>
                  </a:lnTo>
                  <a:lnTo>
                    <a:pt x="444" y="1315"/>
                  </a:lnTo>
                  <a:lnTo>
                    <a:pt x="455" y="1297"/>
                  </a:lnTo>
                  <a:lnTo>
                    <a:pt x="465" y="1283"/>
                  </a:lnTo>
                  <a:lnTo>
                    <a:pt x="476" y="1265"/>
                  </a:lnTo>
                  <a:lnTo>
                    <a:pt x="488" y="1255"/>
                  </a:lnTo>
                  <a:lnTo>
                    <a:pt x="498" y="1243"/>
                  </a:lnTo>
                  <a:lnTo>
                    <a:pt x="509" y="1227"/>
                  </a:lnTo>
                  <a:lnTo>
                    <a:pt x="520" y="1215"/>
                  </a:lnTo>
                  <a:lnTo>
                    <a:pt x="530" y="1200"/>
                  </a:lnTo>
                  <a:lnTo>
                    <a:pt x="542" y="1187"/>
                  </a:lnTo>
                  <a:lnTo>
                    <a:pt x="551" y="1172"/>
                  </a:lnTo>
                  <a:lnTo>
                    <a:pt x="563" y="1158"/>
                  </a:lnTo>
                  <a:lnTo>
                    <a:pt x="574" y="1145"/>
                  </a:lnTo>
                  <a:lnTo>
                    <a:pt x="584" y="1135"/>
                  </a:lnTo>
                  <a:lnTo>
                    <a:pt x="596" y="1119"/>
                  </a:lnTo>
                  <a:lnTo>
                    <a:pt x="607" y="1110"/>
                  </a:lnTo>
                  <a:lnTo>
                    <a:pt x="617" y="1099"/>
                  </a:lnTo>
                  <a:lnTo>
                    <a:pt x="628" y="1085"/>
                  </a:lnTo>
                  <a:lnTo>
                    <a:pt x="640" y="1075"/>
                  </a:lnTo>
                  <a:lnTo>
                    <a:pt x="649" y="1061"/>
                  </a:lnTo>
                  <a:lnTo>
                    <a:pt x="661" y="1053"/>
                  </a:lnTo>
                  <a:lnTo>
                    <a:pt x="672" y="1040"/>
                  </a:lnTo>
                  <a:lnTo>
                    <a:pt x="682" y="1029"/>
                  </a:lnTo>
                  <a:lnTo>
                    <a:pt x="693" y="1015"/>
                  </a:lnTo>
                  <a:lnTo>
                    <a:pt x="703" y="1006"/>
                  </a:lnTo>
                  <a:lnTo>
                    <a:pt x="715" y="995"/>
                  </a:lnTo>
                  <a:lnTo>
                    <a:pt x="726" y="982"/>
                  </a:lnTo>
                  <a:lnTo>
                    <a:pt x="736" y="973"/>
                  </a:lnTo>
                  <a:lnTo>
                    <a:pt x="747" y="963"/>
                  </a:lnTo>
                  <a:lnTo>
                    <a:pt x="759" y="953"/>
                  </a:lnTo>
                  <a:lnTo>
                    <a:pt x="768" y="946"/>
                  </a:lnTo>
                  <a:lnTo>
                    <a:pt x="780" y="936"/>
                  </a:lnTo>
                  <a:lnTo>
                    <a:pt x="791" y="924"/>
                  </a:lnTo>
                  <a:lnTo>
                    <a:pt x="801" y="921"/>
                  </a:lnTo>
                  <a:lnTo>
                    <a:pt x="813" y="908"/>
                  </a:lnTo>
                  <a:lnTo>
                    <a:pt x="822" y="901"/>
                  </a:lnTo>
                  <a:lnTo>
                    <a:pt x="834" y="888"/>
                  </a:lnTo>
                  <a:lnTo>
                    <a:pt x="845" y="879"/>
                  </a:lnTo>
                  <a:lnTo>
                    <a:pt x="855" y="870"/>
                  </a:lnTo>
                  <a:lnTo>
                    <a:pt x="866" y="863"/>
                  </a:lnTo>
                  <a:lnTo>
                    <a:pt x="878" y="851"/>
                  </a:lnTo>
                  <a:lnTo>
                    <a:pt x="888" y="841"/>
                  </a:lnTo>
                  <a:lnTo>
                    <a:pt x="899" y="830"/>
                  </a:lnTo>
                  <a:lnTo>
                    <a:pt x="910" y="828"/>
                  </a:lnTo>
                  <a:lnTo>
                    <a:pt x="920" y="817"/>
                  </a:lnTo>
                  <a:lnTo>
                    <a:pt x="932" y="805"/>
                  </a:lnTo>
                  <a:lnTo>
                    <a:pt x="941" y="797"/>
                  </a:lnTo>
                  <a:lnTo>
                    <a:pt x="953" y="791"/>
                  </a:lnTo>
                  <a:lnTo>
                    <a:pt x="964" y="777"/>
                  </a:lnTo>
                  <a:lnTo>
                    <a:pt x="974" y="756"/>
                  </a:lnTo>
                  <a:lnTo>
                    <a:pt x="985" y="770"/>
                  </a:lnTo>
                  <a:lnTo>
                    <a:pt x="997" y="762"/>
                  </a:lnTo>
                  <a:lnTo>
                    <a:pt x="1007" y="755"/>
                  </a:lnTo>
                  <a:lnTo>
                    <a:pt x="1018" y="749"/>
                  </a:lnTo>
                  <a:lnTo>
                    <a:pt x="1030" y="740"/>
                  </a:lnTo>
                  <a:lnTo>
                    <a:pt x="1039" y="734"/>
                  </a:lnTo>
                  <a:lnTo>
                    <a:pt x="1051" y="729"/>
                  </a:lnTo>
                  <a:lnTo>
                    <a:pt x="1061" y="721"/>
                  </a:lnTo>
                  <a:lnTo>
                    <a:pt x="1072" y="713"/>
                  </a:lnTo>
                  <a:lnTo>
                    <a:pt x="1083" y="707"/>
                  </a:lnTo>
                  <a:lnTo>
                    <a:pt x="1093" y="700"/>
                  </a:lnTo>
                  <a:lnTo>
                    <a:pt x="1105" y="694"/>
                  </a:lnTo>
                  <a:lnTo>
                    <a:pt x="1116" y="689"/>
                  </a:lnTo>
                  <a:lnTo>
                    <a:pt x="1126" y="677"/>
                  </a:lnTo>
                  <a:lnTo>
                    <a:pt x="1137" y="668"/>
                  </a:lnTo>
                  <a:lnTo>
                    <a:pt x="1149" y="660"/>
                  </a:lnTo>
                  <a:lnTo>
                    <a:pt x="1158" y="650"/>
                  </a:lnTo>
                  <a:lnTo>
                    <a:pt x="1170" y="640"/>
                  </a:lnTo>
                  <a:lnTo>
                    <a:pt x="1180" y="638"/>
                  </a:lnTo>
                  <a:lnTo>
                    <a:pt x="1191" y="631"/>
                  </a:lnTo>
                  <a:lnTo>
                    <a:pt x="1203" y="625"/>
                  </a:lnTo>
                  <a:lnTo>
                    <a:pt x="1212" y="617"/>
                  </a:lnTo>
                  <a:lnTo>
                    <a:pt x="1224" y="609"/>
                  </a:lnTo>
                  <a:lnTo>
                    <a:pt x="1235" y="600"/>
                  </a:lnTo>
                  <a:lnTo>
                    <a:pt x="1245" y="593"/>
                  </a:lnTo>
                  <a:lnTo>
                    <a:pt x="1256" y="590"/>
                  </a:lnTo>
                  <a:lnTo>
                    <a:pt x="1268" y="583"/>
                  </a:lnTo>
                  <a:lnTo>
                    <a:pt x="1278" y="575"/>
                  </a:lnTo>
                  <a:lnTo>
                    <a:pt x="1289" y="567"/>
                  </a:lnTo>
                  <a:lnTo>
                    <a:pt x="1299" y="560"/>
                  </a:lnTo>
                  <a:lnTo>
                    <a:pt x="1310" y="555"/>
                  </a:lnTo>
                  <a:lnTo>
                    <a:pt x="1322" y="546"/>
                  </a:lnTo>
                  <a:lnTo>
                    <a:pt x="1331" y="539"/>
                  </a:lnTo>
                  <a:lnTo>
                    <a:pt x="1343" y="535"/>
                  </a:lnTo>
                  <a:lnTo>
                    <a:pt x="1354" y="529"/>
                  </a:lnTo>
                  <a:lnTo>
                    <a:pt x="1364" y="517"/>
                  </a:lnTo>
                  <a:lnTo>
                    <a:pt x="1375" y="513"/>
                  </a:lnTo>
                  <a:lnTo>
                    <a:pt x="1387" y="506"/>
                  </a:lnTo>
                  <a:lnTo>
                    <a:pt x="1397" y="500"/>
                  </a:lnTo>
                  <a:lnTo>
                    <a:pt x="1408" y="497"/>
                  </a:lnTo>
                  <a:lnTo>
                    <a:pt x="1418" y="486"/>
                  </a:lnTo>
                  <a:lnTo>
                    <a:pt x="1429" y="484"/>
                  </a:lnTo>
                  <a:lnTo>
                    <a:pt x="1441" y="478"/>
                  </a:lnTo>
                  <a:lnTo>
                    <a:pt x="1451" y="471"/>
                  </a:lnTo>
                  <a:lnTo>
                    <a:pt x="1462" y="464"/>
                  </a:lnTo>
                  <a:lnTo>
                    <a:pt x="1473" y="457"/>
                  </a:lnTo>
                  <a:lnTo>
                    <a:pt x="1483" y="449"/>
                  </a:lnTo>
                  <a:lnTo>
                    <a:pt x="1495" y="440"/>
                  </a:lnTo>
                  <a:lnTo>
                    <a:pt x="1506" y="433"/>
                  </a:lnTo>
                  <a:lnTo>
                    <a:pt x="1516" y="429"/>
                  </a:lnTo>
                  <a:lnTo>
                    <a:pt x="1527" y="424"/>
                  </a:lnTo>
                  <a:lnTo>
                    <a:pt x="1539" y="418"/>
                  </a:lnTo>
                  <a:lnTo>
                    <a:pt x="1548" y="409"/>
                  </a:lnTo>
                  <a:lnTo>
                    <a:pt x="1560" y="404"/>
                  </a:lnTo>
                  <a:lnTo>
                    <a:pt x="1570" y="397"/>
                  </a:lnTo>
                  <a:lnTo>
                    <a:pt x="1581" y="388"/>
                  </a:lnTo>
                  <a:lnTo>
                    <a:pt x="1592" y="382"/>
                  </a:lnTo>
                  <a:lnTo>
                    <a:pt x="1602" y="381"/>
                  </a:lnTo>
                  <a:lnTo>
                    <a:pt x="1614" y="372"/>
                  </a:lnTo>
                  <a:lnTo>
                    <a:pt x="1625" y="367"/>
                  </a:lnTo>
                  <a:lnTo>
                    <a:pt x="1635" y="356"/>
                  </a:lnTo>
                  <a:lnTo>
                    <a:pt x="1646" y="352"/>
                  </a:lnTo>
                  <a:lnTo>
                    <a:pt x="1658" y="345"/>
                  </a:lnTo>
                  <a:lnTo>
                    <a:pt x="1668" y="339"/>
                  </a:lnTo>
                  <a:lnTo>
                    <a:pt x="1679" y="334"/>
                  </a:lnTo>
                  <a:lnTo>
                    <a:pt x="1689" y="328"/>
                  </a:lnTo>
                  <a:lnTo>
                    <a:pt x="1700" y="319"/>
                  </a:lnTo>
                  <a:lnTo>
                    <a:pt x="1712" y="314"/>
                  </a:lnTo>
                  <a:lnTo>
                    <a:pt x="1721" y="306"/>
                  </a:lnTo>
                  <a:lnTo>
                    <a:pt x="1733" y="297"/>
                  </a:lnTo>
                  <a:lnTo>
                    <a:pt x="1744" y="292"/>
                  </a:lnTo>
                  <a:lnTo>
                    <a:pt x="1754" y="287"/>
                  </a:lnTo>
                  <a:lnTo>
                    <a:pt x="1765" y="285"/>
                  </a:lnTo>
                  <a:lnTo>
                    <a:pt x="1777" y="280"/>
                  </a:lnTo>
                  <a:lnTo>
                    <a:pt x="1787" y="273"/>
                  </a:lnTo>
                  <a:lnTo>
                    <a:pt x="1798" y="266"/>
                  </a:lnTo>
                  <a:lnTo>
                    <a:pt x="1808" y="260"/>
                  </a:lnTo>
                  <a:lnTo>
                    <a:pt x="1819" y="255"/>
                  </a:lnTo>
                  <a:lnTo>
                    <a:pt x="1831" y="248"/>
                  </a:lnTo>
                  <a:lnTo>
                    <a:pt x="1841" y="239"/>
                  </a:lnTo>
                  <a:lnTo>
                    <a:pt x="1852" y="237"/>
                  </a:lnTo>
                  <a:lnTo>
                    <a:pt x="1863" y="228"/>
                  </a:lnTo>
                  <a:lnTo>
                    <a:pt x="1873" y="223"/>
                  </a:lnTo>
                  <a:lnTo>
                    <a:pt x="1885" y="222"/>
                  </a:lnTo>
                  <a:lnTo>
                    <a:pt x="1896" y="216"/>
                  </a:lnTo>
                  <a:lnTo>
                    <a:pt x="1906" y="211"/>
                  </a:lnTo>
                  <a:lnTo>
                    <a:pt x="1917" y="205"/>
                  </a:lnTo>
                  <a:lnTo>
                    <a:pt x="1927" y="198"/>
                  </a:lnTo>
                  <a:lnTo>
                    <a:pt x="1938" y="195"/>
                  </a:lnTo>
                  <a:lnTo>
                    <a:pt x="1950" y="187"/>
                  </a:lnTo>
                  <a:lnTo>
                    <a:pt x="1960" y="182"/>
                  </a:lnTo>
                  <a:lnTo>
                    <a:pt x="1971" y="177"/>
                  </a:lnTo>
                  <a:lnTo>
                    <a:pt x="1982" y="171"/>
                  </a:lnTo>
                  <a:lnTo>
                    <a:pt x="1992" y="169"/>
                  </a:lnTo>
                  <a:lnTo>
                    <a:pt x="2004" y="164"/>
                  </a:lnTo>
                  <a:lnTo>
                    <a:pt x="2015" y="155"/>
                  </a:lnTo>
                  <a:lnTo>
                    <a:pt x="2025" y="150"/>
                  </a:lnTo>
                  <a:lnTo>
                    <a:pt x="2036" y="151"/>
                  </a:lnTo>
                  <a:lnTo>
                    <a:pt x="2046" y="145"/>
                  </a:lnTo>
                  <a:lnTo>
                    <a:pt x="2058" y="141"/>
                  </a:lnTo>
                  <a:lnTo>
                    <a:pt x="2069" y="135"/>
                  </a:lnTo>
                  <a:lnTo>
                    <a:pt x="2079" y="131"/>
                  </a:lnTo>
                  <a:lnTo>
                    <a:pt x="2090" y="124"/>
                  </a:lnTo>
                  <a:lnTo>
                    <a:pt x="2102" y="118"/>
                  </a:lnTo>
                  <a:lnTo>
                    <a:pt x="2111" y="120"/>
                  </a:lnTo>
                  <a:lnTo>
                    <a:pt x="2123" y="116"/>
                  </a:lnTo>
                  <a:lnTo>
                    <a:pt x="2134" y="109"/>
                  </a:lnTo>
                  <a:lnTo>
                    <a:pt x="2144" y="102"/>
                  </a:lnTo>
                  <a:lnTo>
                    <a:pt x="2155" y="90"/>
                  </a:lnTo>
                  <a:lnTo>
                    <a:pt x="2165" y="88"/>
                  </a:lnTo>
                  <a:lnTo>
                    <a:pt x="2177" y="83"/>
                  </a:lnTo>
                  <a:lnTo>
                    <a:pt x="2188" y="79"/>
                  </a:lnTo>
                  <a:lnTo>
                    <a:pt x="2198" y="75"/>
                  </a:lnTo>
                  <a:lnTo>
                    <a:pt x="2209" y="74"/>
                  </a:lnTo>
                  <a:lnTo>
                    <a:pt x="2221" y="70"/>
                  </a:lnTo>
                  <a:lnTo>
                    <a:pt x="2231" y="68"/>
                  </a:lnTo>
                  <a:lnTo>
                    <a:pt x="2242" y="92"/>
                  </a:lnTo>
                  <a:lnTo>
                    <a:pt x="2253" y="89"/>
                  </a:lnTo>
                  <a:lnTo>
                    <a:pt x="2263" y="0"/>
                  </a:lnTo>
                  <a:lnTo>
                    <a:pt x="2275" y="355"/>
                  </a:lnTo>
                  <a:lnTo>
                    <a:pt x="2284" y="484"/>
                  </a:lnTo>
                  <a:lnTo>
                    <a:pt x="2296" y="351"/>
                  </a:lnTo>
                  <a:lnTo>
                    <a:pt x="2307" y="275"/>
                  </a:lnTo>
                  <a:lnTo>
                    <a:pt x="2317" y="241"/>
                  </a:lnTo>
                  <a:lnTo>
                    <a:pt x="2328" y="224"/>
                  </a:lnTo>
                  <a:lnTo>
                    <a:pt x="2340" y="220"/>
                  </a:lnTo>
                  <a:lnTo>
                    <a:pt x="2350" y="222"/>
                  </a:lnTo>
                  <a:lnTo>
                    <a:pt x="2361" y="229"/>
                  </a:lnTo>
                  <a:lnTo>
                    <a:pt x="2372" y="236"/>
                  </a:lnTo>
                  <a:lnTo>
                    <a:pt x="2382" y="237"/>
                  </a:lnTo>
                  <a:lnTo>
                    <a:pt x="2394" y="246"/>
                  </a:lnTo>
                  <a:lnTo>
                    <a:pt x="2405" y="252"/>
                  </a:lnTo>
                  <a:lnTo>
                    <a:pt x="2415" y="257"/>
                  </a:lnTo>
                  <a:lnTo>
                    <a:pt x="2426" y="264"/>
                  </a:lnTo>
                  <a:lnTo>
                    <a:pt x="2436" y="270"/>
                  </a:lnTo>
                  <a:lnTo>
                    <a:pt x="2448" y="271"/>
                  </a:lnTo>
                  <a:lnTo>
                    <a:pt x="2459" y="273"/>
                  </a:lnTo>
                  <a:lnTo>
                    <a:pt x="2469" y="280"/>
                  </a:lnTo>
                  <a:lnTo>
                    <a:pt x="2480" y="288"/>
                  </a:lnTo>
                  <a:lnTo>
                    <a:pt x="2492" y="293"/>
                  </a:lnTo>
                  <a:lnTo>
                    <a:pt x="2501" y="295"/>
                  </a:lnTo>
                  <a:lnTo>
                    <a:pt x="2513" y="297"/>
                  </a:lnTo>
                  <a:lnTo>
                    <a:pt x="2524" y="302"/>
                  </a:lnTo>
                  <a:lnTo>
                    <a:pt x="2534" y="302"/>
                  </a:lnTo>
                  <a:lnTo>
                    <a:pt x="2545" y="306"/>
                  </a:lnTo>
                  <a:lnTo>
                    <a:pt x="2555" y="310"/>
                  </a:lnTo>
                  <a:lnTo>
                    <a:pt x="2567" y="315"/>
                  </a:lnTo>
                  <a:lnTo>
                    <a:pt x="2578" y="321"/>
                  </a:lnTo>
                  <a:lnTo>
                    <a:pt x="2588" y="325"/>
                  </a:lnTo>
                  <a:lnTo>
                    <a:pt x="2599" y="324"/>
                  </a:lnTo>
                  <a:lnTo>
                    <a:pt x="2611" y="328"/>
                  </a:lnTo>
                  <a:lnTo>
                    <a:pt x="2620" y="332"/>
                  </a:lnTo>
                  <a:lnTo>
                    <a:pt x="2632" y="330"/>
                  </a:lnTo>
                  <a:lnTo>
                    <a:pt x="2643" y="329"/>
                  </a:lnTo>
                  <a:lnTo>
                    <a:pt x="2653" y="332"/>
                  </a:lnTo>
                  <a:lnTo>
                    <a:pt x="2665" y="336"/>
                  </a:lnTo>
                  <a:lnTo>
                    <a:pt x="2674" y="343"/>
                  </a:lnTo>
                  <a:lnTo>
                    <a:pt x="2686" y="343"/>
                  </a:lnTo>
                  <a:lnTo>
                    <a:pt x="2697" y="340"/>
                  </a:lnTo>
                  <a:lnTo>
                    <a:pt x="2707" y="345"/>
                  </a:lnTo>
                  <a:lnTo>
                    <a:pt x="2718" y="350"/>
                  </a:lnTo>
                  <a:lnTo>
                    <a:pt x="2730" y="346"/>
                  </a:lnTo>
                  <a:lnTo>
                    <a:pt x="2740" y="347"/>
                  </a:lnTo>
                  <a:lnTo>
                    <a:pt x="2751" y="351"/>
                  </a:lnTo>
                  <a:lnTo>
                    <a:pt x="2762" y="354"/>
                  </a:lnTo>
                  <a:lnTo>
                    <a:pt x="2772" y="354"/>
                  </a:lnTo>
                  <a:lnTo>
                    <a:pt x="2784" y="358"/>
                  </a:lnTo>
                  <a:lnTo>
                    <a:pt x="2793" y="356"/>
                  </a:lnTo>
                  <a:lnTo>
                    <a:pt x="2805" y="356"/>
                  </a:lnTo>
                  <a:lnTo>
                    <a:pt x="2816" y="356"/>
                  </a:lnTo>
                  <a:lnTo>
                    <a:pt x="2826" y="361"/>
                  </a:lnTo>
                  <a:lnTo>
                    <a:pt x="2838" y="365"/>
                  </a:lnTo>
                  <a:lnTo>
                    <a:pt x="2849" y="366"/>
                  </a:lnTo>
                  <a:lnTo>
                    <a:pt x="2859" y="368"/>
                  </a:lnTo>
                  <a:lnTo>
                    <a:pt x="2870" y="370"/>
                  </a:lnTo>
                  <a:lnTo>
                    <a:pt x="2882" y="373"/>
                  </a:lnTo>
                  <a:lnTo>
                    <a:pt x="2891" y="373"/>
                  </a:lnTo>
                  <a:lnTo>
                    <a:pt x="2903" y="372"/>
                  </a:lnTo>
                  <a:lnTo>
                    <a:pt x="2913" y="375"/>
                  </a:lnTo>
                  <a:lnTo>
                    <a:pt x="2924" y="372"/>
                  </a:lnTo>
                  <a:lnTo>
                    <a:pt x="2935" y="374"/>
                  </a:lnTo>
                  <a:lnTo>
                    <a:pt x="2945" y="376"/>
                  </a:lnTo>
                  <a:lnTo>
                    <a:pt x="2957" y="375"/>
                  </a:lnTo>
                  <a:lnTo>
                    <a:pt x="2968" y="376"/>
                  </a:lnTo>
                  <a:lnTo>
                    <a:pt x="2978" y="376"/>
                  </a:lnTo>
                  <a:lnTo>
                    <a:pt x="2989" y="378"/>
                  </a:lnTo>
                  <a:lnTo>
                    <a:pt x="3001" y="382"/>
                  </a:lnTo>
                  <a:lnTo>
                    <a:pt x="3010" y="384"/>
                  </a:lnTo>
                  <a:lnTo>
                    <a:pt x="3022" y="383"/>
                  </a:lnTo>
                  <a:lnTo>
                    <a:pt x="3032" y="385"/>
                  </a:lnTo>
                  <a:lnTo>
                    <a:pt x="3043" y="387"/>
                  </a:lnTo>
                  <a:lnTo>
                    <a:pt x="3055" y="387"/>
                  </a:lnTo>
                  <a:lnTo>
                    <a:pt x="3064" y="384"/>
                  </a:lnTo>
                  <a:lnTo>
                    <a:pt x="3076" y="388"/>
                  </a:lnTo>
                  <a:lnTo>
                    <a:pt x="3087" y="390"/>
                  </a:lnTo>
                  <a:lnTo>
                    <a:pt x="3097" y="388"/>
                  </a:lnTo>
                  <a:lnTo>
                    <a:pt x="3108" y="392"/>
                  </a:lnTo>
                  <a:lnTo>
                    <a:pt x="3120" y="390"/>
                  </a:lnTo>
                  <a:lnTo>
                    <a:pt x="3130" y="391"/>
                  </a:lnTo>
                  <a:lnTo>
                    <a:pt x="3141" y="397"/>
                  </a:lnTo>
                  <a:lnTo>
                    <a:pt x="3151" y="396"/>
                  </a:lnTo>
                  <a:lnTo>
                    <a:pt x="3162" y="394"/>
                  </a:lnTo>
                  <a:lnTo>
                    <a:pt x="3174" y="397"/>
                  </a:lnTo>
                  <a:lnTo>
                    <a:pt x="3183" y="400"/>
                  </a:lnTo>
                  <a:lnTo>
                    <a:pt x="3195" y="402"/>
                  </a:lnTo>
                  <a:lnTo>
                    <a:pt x="3206" y="403"/>
                  </a:lnTo>
                  <a:lnTo>
                    <a:pt x="3216" y="399"/>
                  </a:lnTo>
                  <a:lnTo>
                    <a:pt x="3227" y="404"/>
                  </a:lnTo>
                  <a:lnTo>
                    <a:pt x="3239" y="403"/>
                  </a:lnTo>
                  <a:lnTo>
                    <a:pt x="3249" y="404"/>
                  </a:lnTo>
                  <a:lnTo>
                    <a:pt x="3260" y="406"/>
                  </a:lnTo>
                  <a:lnTo>
                    <a:pt x="3272" y="406"/>
                  </a:lnTo>
                  <a:lnTo>
                    <a:pt x="3281" y="405"/>
                  </a:lnTo>
                  <a:lnTo>
                    <a:pt x="3293" y="403"/>
                  </a:lnTo>
                  <a:lnTo>
                    <a:pt x="3303" y="403"/>
                  </a:lnTo>
                  <a:lnTo>
                    <a:pt x="3314" y="405"/>
                  </a:lnTo>
                  <a:lnTo>
                    <a:pt x="3325" y="413"/>
                  </a:lnTo>
                  <a:lnTo>
                    <a:pt x="3335" y="414"/>
                  </a:lnTo>
                  <a:lnTo>
                    <a:pt x="3347" y="412"/>
                  </a:lnTo>
                  <a:lnTo>
                    <a:pt x="3358" y="410"/>
                  </a:lnTo>
                  <a:lnTo>
                    <a:pt x="3368" y="411"/>
                  </a:lnTo>
                  <a:lnTo>
                    <a:pt x="3379" y="413"/>
                  </a:lnTo>
                  <a:lnTo>
                    <a:pt x="3391" y="417"/>
                  </a:lnTo>
                  <a:lnTo>
                    <a:pt x="3400" y="412"/>
                  </a:lnTo>
                  <a:lnTo>
                    <a:pt x="3412" y="411"/>
                  </a:lnTo>
                  <a:lnTo>
                    <a:pt x="3422" y="418"/>
                  </a:lnTo>
                  <a:lnTo>
                    <a:pt x="3433" y="419"/>
                  </a:lnTo>
                  <a:lnTo>
                    <a:pt x="3445" y="420"/>
                  </a:lnTo>
                  <a:lnTo>
                    <a:pt x="3454" y="420"/>
                  </a:lnTo>
                  <a:lnTo>
                    <a:pt x="3466" y="416"/>
                  </a:lnTo>
                  <a:lnTo>
                    <a:pt x="3477" y="420"/>
                  </a:lnTo>
                  <a:lnTo>
                    <a:pt x="3487" y="420"/>
                  </a:lnTo>
                  <a:lnTo>
                    <a:pt x="3498" y="424"/>
                  </a:lnTo>
                  <a:lnTo>
                    <a:pt x="3510" y="428"/>
                  </a:lnTo>
                  <a:lnTo>
                    <a:pt x="3520" y="425"/>
                  </a:lnTo>
                  <a:lnTo>
                    <a:pt x="3531" y="425"/>
                  </a:lnTo>
                  <a:lnTo>
                    <a:pt x="3541" y="425"/>
                  </a:lnTo>
                  <a:lnTo>
                    <a:pt x="3552" y="425"/>
                  </a:lnTo>
                  <a:lnTo>
                    <a:pt x="3564" y="426"/>
                  </a:lnTo>
                  <a:lnTo>
                    <a:pt x="3573" y="427"/>
                  </a:lnTo>
                  <a:lnTo>
                    <a:pt x="3585" y="427"/>
                  </a:lnTo>
                  <a:lnTo>
                    <a:pt x="3596" y="432"/>
                  </a:lnTo>
                  <a:lnTo>
                    <a:pt x="3606" y="429"/>
                  </a:lnTo>
                  <a:lnTo>
                    <a:pt x="3617" y="431"/>
                  </a:lnTo>
                  <a:lnTo>
                    <a:pt x="3629" y="436"/>
                  </a:lnTo>
                  <a:lnTo>
                    <a:pt x="3639" y="434"/>
                  </a:lnTo>
                  <a:lnTo>
                    <a:pt x="3650" y="433"/>
                  </a:lnTo>
                  <a:lnTo>
                    <a:pt x="3660" y="434"/>
                  </a:lnTo>
                  <a:lnTo>
                    <a:pt x="3671" y="436"/>
                  </a:lnTo>
                  <a:lnTo>
                    <a:pt x="3683" y="433"/>
                  </a:lnTo>
                  <a:lnTo>
                    <a:pt x="3693" y="433"/>
                  </a:lnTo>
                  <a:lnTo>
                    <a:pt x="3704" y="431"/>
                  </a:lnTo>
                  <a:lnTo>
                    <a:pt x="3715" y="436"/>
                  </a:lnTo>
                  <a:lnTo>
                    <a:pt x="3725" y="440"/>
                  </a:lnTo>
                  <a:lnTo>
                    <a:pt x="3737" y="431"/>
                  </a:lnTo>
                  <a:lnTo>
                    <a:pt x="3748" y="426"/>
                  </a:lnTo>
                  <a:lnTo>
                    <a:pt x="3758" y="428"/>
                  </a:lnTo>
                  <a:lnTo>
                    <a:pt x="3769" y="435"/>
                  </a:lnTo>
                  <a:lnTo>
                    <a:pt x="3779" y="432"/>
                  </a:lnTo>
                  <a:lnTo>
                    <a:pt x="3790" y="434"/>
                  </a:lnTo>
                  <a:lnTo>
                    <a:pt x="3802" y="439"/>
                  </a:lnTo>
                  <a:lnTo>
                    <a:pt x="3812" y="443"/>
                  </a:lnTo>
                  <a:lnTo>
                    <a:pt x="3823" y="442"/>
                  </a:lnTo>
                  <a:lnTo>
                    <a:pt x="3834" y="441"/>
                  </a:lnTo>
                  <a:lnTo>
                    <a:pt x="3844" y="443"/>
                  </a:lnTo>
                  <a:lnTo>
                    <a:pt x="3856" y="443"/>
                  </a:lnTo>
                  <a:lnTo>
                    <a:pt x="3867" y="442"/>
                  </a:lnTo>
                  <a:lnTo>
                    <a:pt x="3877" y="442"/>
                  </a:lnTo>
                  <a:lnTo>
                    <a:pt x="3888" y="444"/>
                  </a:lnTo>
                </a:path>
              </a:pathLst>
            </a:custGeom>
            <a:noFill/>
            <a:ln w="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" name="Freeform 103"/>
            <p:cNvSpPr>
              <a:spLocks/>
            </p:cNvSpPr>
            <p:nvPr/>
          </p:nvSpPr>
          <p:spPr bwMode="auto">
            <a:xfrm>
              <a:off x="665" y="613"/>
              <a:ext cx="3888" cy="1706"/>
            </a:xfrm>
            <a:custGeom>
              <a:avLst/>
              <a:gdLst>
                <a:gd name="T0" fmla="*/ 54 w 3888"/>
                <a:gd name="T1" fmla="*/ 1702 h 1706"/>
                <a:gd name="T2" fmla="*/ 119 w 3888"/>
                <a:gd name="T3" fmla="*/ 1701 h 1706"/>
                <a:gd name="T4" fmla="*/ 184 w 3888"/>
                <a:gd name="T5" fmla="*/ 1705 h 1706"/>
                <a:gd name="T6" fmla="*/ 250 w 3888"/>
                <a:gd name="T7" fmla="*/ 1696 h 1706"/>
                <a:gd name="T8" fmla="*/ 313 w 3888"/>
                <a:gd name="T9" fmla="*/ 1706 h 1706"/>
                <a:gd name="T10" fmla="*/ 378 w 3888"/>
                <a:gd name="T11" fmla="*/ 1405 h 1706"/>
                <a:gd name="T12" fmla="*/ 444 w 3888"/>
                <a:gd name="T13" fmla="*/ 1505 h 1706"/>
                <a:gd name="T14" fmla="*/ 509 w 3888"/>
                <a:gd name="T15" fmla="*/ 1434 h 1706"/>
                <a:gd name="T16" fmla="*/ 574 w 3888"/>
                <a:gd name="T17" fmla="*/ 1364 h 1706"/>
                <a:gd name="T18" fmla="*/ 640 w 3888"/>
                <a:gd name="T19" fmla="*/ 1294 h 1706"/>
                <a:gd name="T20" fmla="*/ 703 w 3888"/>
                <a:gd name="T21" fmla="*/ 1233 h 1706"/>
                <a:gd name="T22" fmla="*/ 768 w 3888"/>
                <a:gd name="T23" fmla="*/ 1182 h 1706"/>
                <a:gd name="T24" fmla="*/ 834 w 3888"/>
                <a:gd name="T25" fmla="*/ 1138 h 1706"/>
                <a:gd name="T26" fmla="*/ 899 w 3888"/>
                <a:gd name="T27" fmla="*/ 1093 h 1706"/>
                <a:gd name="T28" fmla="*/ 964 w 3888"/>
                <a:gd name="T29" fmla="*/ 1050 h 1706"/>
                <a:gd name="T30" fmla="*/ 1030 w 3888"/>
                <a:gd name="T31" fmla="*/ 1003 h 1706"/>
                <a:gd name="T32" fmla="*/ 1093 w 3888"/>
                <a:gd name="T33" fmla="*/ 962 h 1706"/>
                <a:gd name="T34" fmla="*/ 1158 w 3888"/>
                <a:gd name="T35" fmla="*/ 926 h 1706"/>
                <a:gd name="T36" fmla="*/ 1224 w 3888"/>
                <a:gd name="T37" fmla="*/ 895 h 1706"/>
                <a:gd name="T38" fmla="*/ 1289 w 3888"/>
                <a:gd name="T39" fmla="*/ 851 h 1706"/>
                <a:gd name="T40" fmla="*/ 1354 w 3888"/>
                <a:gd name="T41" fmla="*/ 818 h 1706"/>
                <a:gd name="T42" fmla="*/ 1418 w 3888"/>
                <a:gd name="T43" fmla="*/ 782 h 1706"/>
                <a:gd name="T44" fmla="*/ 1483 w 3888"/>
                <a:gd name="T45" fmla="*/ 751 h 1706"/>
                <a:gd name="T46" fmla="*/ 1548 w 3888"/>
                <a:gd name="T47" fmla="*/ 714 h 1706"/>
                <a:gd name="T48" fmla="*/ 1614 w 3888"/>
                <a:gd name="T49" fmla="*/ 679 h 1706"/>
                <a:gd name="T50" fmla="*/ 1679 w 3888"/>
                <a:gd name="T51" fmla="*/ 644 h 1706"/>
                <a:gd name="T52" fmla="*/ 1744 w 3888"/>
                <a:gd name="T53" fmla="*/ 617 h 1706"/>
                <a:gd name="T54" fmla="*/ 1808 w 3888"/>
                <a:gd name="T55" fmla="*/ 585 h 1706"/>
                <a:gd name="T56" fmla="*/ 1873 w 3888"/>
                <a:gd name="T57" fmla="*/ 555 h 1706"/>
                <a:gd name="T58" fmla="*/ 1938 w 3888"/>
                <a:gd name="T59" fmla="*/ 520 h 1706"/>
                <a:gd name="T60" fmla="*/ 2004 w 3888"/>
                <a:gd name="T61" fmla="*/ 497 h 1706"/>
                <a:gd name="T62" fmla="*/ 2069 w 3888"/>
                <a:gd name="T63" fmla="*/ 467 h 1706"/>
                <a:gd name="T64" fmla="*/ 2134 w 3888"/>
                <a:gd name="T65" fmla="*/ 439 h 1706"/>
                <a:gd name="T66" fmla="*/ 2198 w 3888"/>
                <a:gd name="T67" fmla="*/ 414 h 1706"/>
                <a:gd name="T68" fmla="*/ 2263 w 3888"/>
                <a:gd name="T69" fmla="*/ 0 h 1706"/>
                <a:gd name="T70" fmla="*/ 2328 w 3888"/>
                <a:gd name="T71" fmla="*/ 568 h 1706"/>
                <a:gd name="T72" fmla="*/ 2394 w 3888"/>
                <a:gd name="T73" fmla="*/ 595 h 1706"/>
                <a:gd name="T74" fmla="*/ 2459 w 3888"/>
                <a:gd name="T75" fmla="*/ 626 h 1706"/>
                <a:gd name="T76" fmla="*/ 2524 w 3888"/>
                <a:gd name="T77" fmla="*/ 641 h 1706"/>
                <a:gd name="T78" fmla="*/ 2588 w 3888"/>
                <a:gd name="T79" fmla="*/ 662 h 1706"/>
                <a:gd name="T80" fmla="*/ 2653 w 3888"/>
                <a:gd name="T81" fmla="*/ 678 h 1706"/>
                <a:gd name="T82" fmla="*/ 2718 w 3888"/>
                <a:gd name="T83" fmla="*/ 687 h 1706"/>
                <a:gd name="T84" fmla="*/ 2784 w 3888"/>
                <a:gd name="T85" fmla="*/ 699 h 1706"/>
                <a:gd name="T86" fmla="*/ 2849 w 3888"/>
                <a:gd name="T87" fmla="*/ 708 h 1706"/>
                <a:gd name="T88" fmla="*/ 2913 w 3888"/>
                <a:gd name="T89" fmla="*/ 714 h 1706"/>
                <a:gd name="T90" fmla="*/ 2978 w 3888"/>
                <a:gd name="T91" fmla="*/ 721 h 1706"/>
                <a:gd name="T92" fmla="*/ 3043 w 3888"/>
                <a:gd name="T93" fmla="*/ 731 h 1706"/>
                <a:gd name="T94" fmla="*/ 3108 w 3888"/>
                <a:gd name="T95" fmla="*/ 737 h 1706"/>
                <a:gd name="T96" fmla="*/ 3174 w 3888"/>
                <a:gd name="T97" fmla="*/ 742 h 1706"/>
                <a:gd name="T98" fmla="*/ 3239 w 3888"/>
                <a:gd name="T99" fmla="*/ 746 h 1706"/>
                <a:gd name="T100" fmla="*/ 3303 w 3888"/>
                <a:gd name="T101" fmla="*/ 756 h 1706"/>
                <a:gd name="T102" fmla="*/ 3368 w 3888"/>
                <a:gd name="T103" fmla="*/ 764 h 1706"/>
                <a:gd name="T104" fmla="*/ 3433 w 3888"/>
                <a:gd name="T105" fmla="*/ 765 h 1706"/>
                <a:gd name="T106" fmla="*/ 3498 w 3888"/>
                <a:gd name="T107" fmla="*/ 771 h 1706"/>
                <a:gd name="T108" fmla="*/ 3564 w 3888"/>
                <a:gd name="T109" fmla="*/ 775 h 1706"/>
                <a:gd name="T110" fmla="*/ 3629 w 3888"/>
                <a:gd name="T111" fmla="*/ 779 h 1706"/>
                <a:gd name="T112" fmla="*/ 3693 w 3888"/>
                <a:gd name="T113" fmla="*/ 785 h 1706"/>
                <a:gd name="T114" fmla="*/ 3758 w 3888"/>
                <a:gd name="T115" fmla="*/ 776 h 1706"/>
                <a:gd name="T116" fmla="*/ 3823 w 3888"/>
                <a:gd name="T117" fmla="*/ 787 h 1706"/>
                <a:gd name="T118" fmla="*/ 3888 w 3888"/>
                <a:gd name="T119" fmla="*/ 791 h 17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3888" h="1706">
                  <a:moveTo>
                    <a:pt x="0" y="1698"/>
                  </a:moveTo>
                  <a:lnTo>
                    <a:pt x="11" y="1701"/>
                  </a:lnTo>
                  <a:lnTo>
                    <a:pt x="21" y="1698"/>
                  </a:lnTo>
                  <a:lnTo>
                    <a:pt x="33" y="1698"/>
                  </a:lnTo>
                  <a:lnTo>
                    <a:pt x="44" y="1701"/>
                  </a:lnTo>
                  <a:lnTo>
                    <a:pt x="54" y="1702"/>
                  </a:lnTo>
                  <a:lnTo>
                    <a:pt x="65" y="1703"/>
                  </a:lnTo>
                  <a:lnTo>
                    <a:pt x="75" y="1701"/>
                  </a:lnTo>
                  <a:lnTo>
                    <a:pt x="86" y="1700"/>
                  </a:lnTo>
                  <a:lnTo>
                    <a:pt x="98" y="1703"/>
                  </a:lnTo>
                  <a:lnTo>
                    <a:pt x="108" y="1700"/>
                  </a:lnTo>
                  <a:lnTo>
                    <a:pt x="119" y="1701"/>
                  </a:lnTo>
                  <a:lnTo>
                    <a:pt x="130" y="1701"/>
                  </a:lnTo>
                  <a:lnTo>
                    <a:pt x="140" y="1700"/>
                  </a:lnTo>
                  <a:lnTo>
                    <a:pt x="152" y="1700"/>
                  </a:lnTo>
                  <a:lnTo>
                    <a:pt x="163" y="1703"/>
                  </a:lnTo>
                  <a:lnTo>
                    <a:pt x="173" y="1703"/>
                  </a:lnTo>
                  <a:lnTo>
                    <a:pt x="184" y="1705"/>
                  </a:lnTo>
                  <a:lnTo>
                    <a:pt x="194" y="1702"/>
                  </a:lnTo>
                  <a:lnTo>
                    <a:pt x="206" y="1701"/>
                  </a:lnTo>
                  <a:lnTo>
                    <a:pt x="217" y="1702"/>
                  </a:lnTo>
                  <a:lnTo>
                    <a:pt x="227" y="1701"/>
                  </a:lnTo>
                  <a:lnTo>
                    <a:pt x="238" y="1696"/>
                  </a:lnTo>
                  <a:lnTo>
                    <a:pt x="250" y="1696"/>
                  </a:lnTo>
                  <a:lnTo>
                    <a:pt x="259" y="1700"/>
                  </a:lnTo>
                  <a:lnTo>
                    <a:pt x="271" y="1697"/>
                  </a:lnTo>
                  <a:lnTo>
                    <a:pt x="282" y="1688"/>
                  </a:lnTo>
                  <a:lnTo>
                    <a:pt x="292" y="1675"/>
                  </a:lnTo>
                  <a:lnTo>
                    <a:pt x="303" y="1691"/>
                  </a:lnTo>
                  <a:lnTo>
                    <a:pt x="313" y="1706"/>
                  </a:lnTo>
                  <a:lnTo>
                    <a:pt x="325" y="1654"/>
                  </a:lnTo>
                  <a:lnTo>
                    <a:pt x="336" y="1241"/>
                  </a:lnTo>
                  <a:lnTo>
                    <a:pt x="346" y="702"/>
                  </a:lnTo>
                  <a:lnTo>
                    <a:pt x="357" y="911"/>
                  </a:lnTo>
                  <a:lnTo>
                    <a:pt x="369" y="1232"/>
                  </a:lnTo>
                  <a:lnTo>
                    <a:pt x="378" y="1405"/>
                  </a:lnTo>
                  <a:lnTo>
                    <a:pt x="390" y="1484"/>
                  </a:lnTo>
                  <a:lnTo>
                    <a:pt x="401" y="1515"/>
                  </a:lnTo>
                  <a:lnTo>
                    <a:pt x="411" y="1529"/>
                  </a:lnTo>
                  <a:lnTo>
                    <a:pt x="423" y="1526"/>
                  </a:lnTo>
                  <a:lnTo>
                    <a:pt x="432" y="1522"/>
                  </a:lnTo>
                  <a:lnTo>
                    <a:pt x="444" y="1505"/>
                  </a:lnTo>
                  <a:lnTo>
                    <a:pt x="455" y="1491"/>
                  </a:lnTo>
                  <a:lnTo>
                    <a:pt x="465" y="1479"/>
                  </a:lnTo>
                  <a:lnTo>
                    <a:pt x="476" y="1468"/>
                  </a:lnTo>
                  <a:lnTo>
                    <a:pt x="488" y="1456"/>
                  </a:lnTo>
                  <a:lnTo>
                    <a:pt x="498" y="1444"/>
                  </a:lnTo>
                  <a:lnTo>
                    <a:pt x="509" y="1434"/>
                  </a:lnTo>
                  <a:lnTo>
                    <a:pt x="520" y="1425"/>
                  </a:lnTo>
                  <a:lnTo>
                    <a:pt x="530" y="1413"/>
                  </a:lnTo>
                  <a:lnTo>
                    <a:pt x="542" y="1400"/>
                  </a:lnTo>
                  <a:lnTo>
                    <a:pt x="551" y="1388"/>
                  </a:lnTo>
                  <a:lnTo>
                    <a:pt x="563" y="1378"/>
                  </a:lnTo>
                  <a:lnTo>
                    <a:pt x="574" y="1364"/>
                  </a:lnTo>
                  <a:lnTo>
                    <a:pt x="584" y="1351"/>
                  </a:lnTo>
                  <a:lnTo>
                    <a:pt x="596" y="1339"/>
                  </a:lnTo>
                  <a:lnTo>
                    <a:pt x="607" y="1327"/>
                  </a:lnTo>
                  <a:lnTo>
                    <a:pt x="617" y="1312"/>
                  </a:lnTo>
                  <a:lnTo>
                    <a:pt x="628" y="1306"/>
                  </a:lnTo>
                  <a:lnTo>
                    <a:pt x="640" y="1294"/>
                  </a:lnTo>
                  <a:lnTo>
                    <a:pt x="649" y="1287"/>
                  </a:lnTo>
                  <a:lnTo>
                    <a:pt x="661" y="1278"/>
                  </a:lnTo>
                  <a:lnTo>
                    <a:pt x="672" y="1263"/>
                  </a:lnTo>
                  <a:lnTo>
                    <a:pt x="682" y="1256"/>
                  </a:lnTo>
                  <a:lnTo>
                    <a:pt x="693" y="1246"/>
                  </a:lnTo>
                  <a:lnTo>
                    <a:pt x="703" y="1233"/>
                  </a:lnTo>
                  <a:lnTo>
                    <a:pt x="715" y="1222"/>
                  </a:lnTo>
                  <a:lnTo>
                    <a:pt x="726" y="1215"/>
                  </a:lnTo>
                  <a:lnTo>
                    <a:pt x="736" y="1205"/>
                  </a:lnTo>
                  <a:lnTo>
                    <a:pt x="747" y="1197"/>
                  </a:lnTo>
                  <a:lnTo>
                    <a:pt x="759" y="1189"/>
                  </a:lnTo>
                  <a:lnTo>
                    <a:pt x="768" y="1182"/>
                  </a:lnTo>
                  <a:lnTo>
                    <a:pt x="780" y="1176"/>
                  </a:lnTo>
                  <a:lnTo>
                    <a:pt x="791" y="1168"/>
                  </a:lnTo>
                  <a:lnTo>
                    <a:pt x="801" y="1157"/>
                  </a:lnTo>
                  <a:lnTo>
                    <a:pt x="813" y="1149"/>
                  </a:lnTo>
                  <a:lnTo>
                    <a:pt x="822" y="1142"/>
                  </a:lnTo>
                  <a:lnTo>
                    <a:pt x="834" y="1138"/>
                  </a:lnTo>
                  <a:lnTo>
                    <a:pt x="845" y="1130"/>
                  </a:lnTo>
                  <a:lnTo>
                    <a:pt x="855" y="1124"/>
                  </a:lnTo>
                  <a:lnTo>
                    <a:pt x="866" y="1112"/>
                  </a:lnTo>
                  <a:lnTo>
                    <a:pt x="878" y="1105"/>
                  </a:lnTo>
                  <a:lnTo>
                    <a:pt x="888" y="1098"/>
                  </a:lnTo>
                  <a:lnTo>
                    <a:pt x="899" y="1093"/>
                  </a:lnTo>
                  <a:lnTo>
                    <a:pt x="910" y="1082"/>
                  </a:lnTo>
                  <a:lnTo>
                    <a:pt x="920" y="1078"/>
                  </a:lnTo>
                  <a:lnTo>
                    <a:pt x="932" y="1068"/>
                  </a:lnTo>
                  <a:lnTo>
                    <a:pt x="941" y="1063"/>
                  </a:lnTo>
                  <a:lnTo>
                    <a:pt x="953" y="1052"/>
                  </a:lnTo>
                  <a:lnTo>
                    <a:pt x="964" y="1050"/>
                  </a:lnTo>
                  <a:lnTo>
                    <a:pt x="974" y="1039"/>
                  </a:lnTo>
                  <a:lnTo>
                    <a:pt x="985" y="1032"/>
                  </a:lnTo>
                  <a:lnTo>
                    <a:pt x="997" y="1024"/>
                  </a:lnTo>
                  <a:lnTo>
                    <a:pt x="1007" y="1016"/>
                  </a:lnTo>
                  <a:lnTo>
                    <a:pt x="1018" y="1012"/>
                  </a:lnTo>
                  <a:lnTo>
                    <a:pt x="1030" y="1003"/>
                  </a:lnTo>
                  <a:lnTo>
                    <a:pt x="1039" y="999"/>
                  </a:lnTo>
                  <a:lnTo>
                    <a:pt x="1051" y="993"/>
                  </a:lnTo>
                  <a:lnTo>
                    <a:pt x="1061" y="985"/>
                  </a:lnTo>
                  <a:lnTo>
                    <a:pt x="1072" y="978"/>
                  </a:lnTo>
                  <a:lnTo>
                    <a:pt x="1083" y="971"/>
                  </a:lnTo>
                  <a:lnTo>
                    <a:pt x="1093" y="962"/>
                  </a:lnTo>
                  <a:lnTo>
                    <a:pt x="1105" y="963"/>
                  </a:lnTo>
                  <a:lnTo>
                    <a:pt x="1116" y="954"/>
                  </a:lnTo>
                  <a:lnTo>
                    <a:pt x="1126" y="949"/>
                  </a:lnTo>
                  <a:lnTo>
                    <a:pt x="1137" y="940"/>
                  </a:lnTo>
                  <a:lnTo>
                    <a:pt x="1149" y="933"/>
                  </a:lnTo>
                  <a:lnTo>
                    <a:pt x="1158" y="926"/>
                  </a:lnTo>
                  <a:lnTo>
                    <a:pt x="1170" y="915"/>
                  </a:lnTo>
                  <a:lnTo>
                    <a:pt x="1180" y="914"/>
                  </a:lnTo>
                  <a:lnTo>
                    <a:pt x="1191" y="910"/>
                  </a:lnTo>
                  <a:lnTo>
                    <a:pt x="1203" y="906"/>
                  </a:lnTo>
                  <a:lnTo>
                    <a:pt x="1212" y="897"/>
                  </a:lnTo>
                  <a:lnTo>
                    <a:pt x="1224" y="895"/>
                  </a:lnTo>
                  <a:lnTo>
                    <a:pt x="1235" y="885"/>
                  </a:lnTo>
                  <a:lnTo>
                    <a:pt x="1245" y="882"/>
                  </a:lnTo>
                  <a:lnTo>
                    <a:pt x="1256" y="873"/>
                  </a:lnTo>
                  <a:lnTo>
                    <a:pt x="1268" y="868"/>
                  </a:lnTo>
                  <a:lnTo>
                    <a:pt x="1278" y="861"/>
                  </a:lnTo>
                  <a:lnTo>
                    <a:pt x="1289" y="851"/>
                  </a:lnTo>
                  <a:lnTo>
                    <a:pt x="1299" y="848"/>
                  </a:lnTo>
                  <a:lnTo>
                    <a:pt x="1310" y="842"/>
                  </a:lnTo>
                  <a:lnTo>
                    <a:pt x="1322" y="834"/>
                  </a:lnTo>
                  <a:lnTo>
                    <a:pt x="1331" y="830"/>
                  </a:lnTo>
                  <a:lnTo>
                    <a:pt x="1343" y="823"/>
                  </a:lnTo>
                  <a:lnTo>
                    <a:pt x="1354" y="818"/>
                  </a:lnTo>
                  <a:lnTo>
                    <a:pt x="1364" y="810"/>
                  </a:lnTo>
                  <a:lnTo>
                    <a:pt x="1375" y="801"/>
                  </a:lnTo>
                  <a:lnTo>
                    <a:pt x="1387" y="795"/>
                  </a:lnTo>
                  <a:lnTo>
                    <a:pt x="1397" y="793"/>
                  </a:lnTo>
                  <a:lnTo>
                    <a:pt x="1408" y="789"/>
                  </a:lnTo>
                  <a:lnTo>
                    <a:pt x="1418" y="782"/>
                  </a:lnTo>
                  <a:lnTo>
                    <a:pt x="1429" y="776"/>
                  </a:lnTo>
                  <a:lnTo>
                    <a:pt x="1441" y="767"/>
                  </a:lnTo>
                  <a:lnTo>
                    <a:pt x="1451" y="761"/>
                  </a:lnTo>
                  <a:lnTo>
                    <a:pt x="1462" y="758"/>
                  </a:lnTo>
                  <a:lnTo>
                    <a:pt x="1473" y="752"/>
                  </a:lnTo>
                  <a:lnTo>
                    <a:pt x="1483" y="751"/>
                  </a:lnTo>
                  <a:lnTo>
                    <a:pt x="1495" y="741"/>
                  </a:lnTo>
                  <a:lnTo>
                    <a:pt x="1506" y="734"/>
                  </a:lnTo>
                  <a:lnTo>
                    <a:pt x="1516" y="730"/>
                  </a:lnTo>
                  <a:lnTo>
                    <a:pt x="1527" y="725"/>
                  </a:lnTo>
                  <a:lnTo>
                    <a:pt x="1539" y="719"/>
                  </a:lnTo>
                  <a:lnTo>
                    <a:pt x="1548" y="714"/>
                  </a:lnTo>
                  <a:lnTo>
                    <a:pt x="1560" y="710"/>
                  </a:lnTo>
                  <a:lnTo>
                    <a:pt x="1570" y="703"/>
                  </a:lnTo>
                  <a:lnTo>
                    <a:pt x="1581" y="698"/>
                  </a:lnTo>
                  <a:lnTo>
                    <a:pt x="1592" y="692"/>
                  </a:lnTo>
                  <a:lnTo>
                    <a:pt x="1602" y="686"/>
                  </a:lnTo>
                  <a:lnTo>
                    <a:pt x="1614" y="679"/>
                  </a:lnTo>
                  <a:lnTo>
                    <a:pt x="1625" y="672"/>
                  </a:lnTo>
                  <a:lnTo>
                    <a:pt x="1635" y="669"/>
                  </a:lnTo>
                  <a:lnTo>
                    <a:pt x="1646" y="665"/>
                  </a:lnTo>
                  <a:lnTo>
                    <a:pt x="1658" y="661"/>
                  </a:lnTo>
                  <a:lnTo>
                    <a:pt x="1668" y="653"/>
                  </a:lnTo>
                  <a:lnTo>
                    <a:pt x="1679" y="644"/>
                  </a:lnTo>
                  <a:lnTo>
                    <a:pt x="1689" y="639"/>
                  </a:lnTo>
                  <a:lnTo>
                    <a:pt x="1700" y="630"/>
                  </a:lnTo>
                  <a:lnTo>
                    <a:pt x="1712" y="630"/>
                  </a:lnTo>
                  <a:lnTo>
                    <a:pt x="1721" y="624"/>
                  </a:lnTo>
                  <a:lnTo>
                    <a:pt x="1733" y="622"/>
                  </a:lnTo>
                  <a:lnTo>
                    <a:pt x="1744" y="617"/>
                  </a:lnTo>
                  <a:lnTo>
                    <a:pt x="1754" y="611"/>
                  </a:lnTo>
                  <a:lnTo>
                    <a:pt x="1765" y="607"/>
                  </a:lnTo>
                  <a:lnTo>
                    <a:pt x="1777" y="602"/>
                  </a:lnTo>
                  <a:lnTo>
                    <a:pt x="1787" y="593"/>
                  </a:lnTo>
                  <a:lnTo>
                    <a:pt x="1798" y="590"/>
                  </a:lnTo>
                  <a:lnTo>
                    <a:pt x="1808" y="585"/>
                  </a:lnTo>
                  <a:lnTo>
                    <a:pt x="1819" y="578"/>
                  </a:lnTo>
                  <a:lnTo>
                    <a:pt x="1831" y="577"/>
                  </a:lnTo>
                  <a:lnTo>
                    <a:pt x="1841" y="569"/>
                  </a:lnTo>
                  <a:lnTo>
                    <a:pt x="1852" y="562"/>
                  </a:lnTo>
                  <a:lnTo>
                    <a:pt x="1863" y="560"/>
                  </a:lnTo>
                  <a:lnTo>
                    <a:pt x="1873" y="555"/>
                  </a:lnTo>
                  <a:lnTo>
                    <a:pt x="1885" y="552"/>
                  </a:lnTo>
                  <a:lnTo>
                    <a:pt x="1896" y="545"/>
                  </a:lnTo>
                  <a:lnTo>
                    <a:pt x="1906" y="539"/>
                  </a:lnTo>
                  <a:lnTo>
                    <a:pt x="1917" y="534"/>
                  </a:lnTo>
                  <a:lnTo>
                    <a:pt x="1927" y="526"/>
                  </a:lnTo>
                  <a:lnTo>
                    <a:pt x="1938" y="520"/>
                  </a:lnTo>
                  <a:lnTo>
                    <a:pt x="1950" y="519"/>
                  </a:lnTo>
                  <a:lnTo>
                    <a:pt x="1960" y="517"/>
                  </a:lnTo>
                  <a:lnTo>
                    <a:pt x="1971" y="514"/>
                  </a:lnTo>
                  <a:lnTo>
                    <a:pt x="1982" y="510"/>
                  </a:lnTo>
                  <a:lnTo>
                    <a:pt x="1992" y="504"/>
                  </a:lnTo>
                  <a:lnTo>
                    <a:pt x="2004" y="497"/>
                  </a:lnTo>
                  <a:lnTo>
                    <a:pt x="2015" y="489"/>
                  </a:lnTo>
                  <a:lnTo>
                    <a:pt x="2025" y="485"/>
                  </a:lnTo>
                  <a:lnTo>
                    <a:pt x="2036" y="480"/>
                  </a:lnTo>
                  <a:lnTo>
                    <a:pt x="2046" y="476"/>
                  </a:lnTo>
                  <a:lnTo>
                    <a:pt x="2058" y="471"/>
                  </a:lnTo>
                  <a:lnTo>
                    <a:pt x="2069" y="467"/>
                  </a:lnTo>
                  <a:lnTo>
                    <a:pt x="2079" y="464"/>
                  </a:lnTo>
                  <a:lnTo>
                    <a:pt x="2090" y="458"/>
                  </a:lnTo>
                  <a:lnTo>
                    <a:pt x="2102" y="451"/>
                  </a:lnTo>
                  <a:lnTo>
                    <a:pt x="2111" y="450"/>
                  </a:lnTo>
                  <a:lnTo>
                    <a:pt x="2123" y="449"/>
                  </a:lnTo>
                  <a:lnTo>
                    <a:pt x="2134" y="439"/>
                  </a:lnTo>
                  <a:lnTo>
                    <a:pt x="2144" y="435"/>
                  </a:lnTo>
                  <a:lnTo>
                    <a:pt x="2155" y="432"/>
                  </a:lnTo>
                  <a:lnTo>
                    <a:pt x="2165" y="424"/>
                  </a:lnTo>
                  <a:lnTo>
                    <a:pt x="2177" y="422"/>
                  </a:lnTo>
                  <a:lnTo>
                    <a:pt x="2188" y="420"/>
                  </a:lnTo>
                  <a:lnTo>
                    <a:pt x="2198" y="414"/>
                  </a:lnTo>
                  <a:lnTo>
                    <a:pt x="2209" y="408"/>
                  </a:lnTo>
                  <a:lnTo>
                    <a:pt x="2221" y="405"/>
                  </a:lnTo>
                  <a:lnTo>
                    <a:pt x="2231" y="405"/>
                  </a:lnTo>
                  <a:lnTo>
                    <a:pt x="2242" y="431"/>
                  </a:lnTo>
                  <a:lnTo>
                    <a:pt x="2253" y="430"/>
                  </a:lnTo>
                  <a:lnTo>
                    <a:pt x="2263" y="0"/>
                  </a:lnTo>
                  <a:lnTo>
                    <a:pt x="2275" y="693"/>
                  </a:lnTo>
                  <a:lnTo>
                    <a:pt x="2284" y="772"/>
                  </a:lnTo>
                  <a:lnTo>
                    <a:pt x="2296" y="666"/>
                  </a:lnTo>
                  <a:lnTo>
                    <a:pt x="2307" y="608"/>
                  </a:lnTo>
                  <a:lnTo>
                    <a:pt x="2317" y="582"/>
                  </a:lnTo>
                  <a:lnTo>
                    <a:pt x="2328" y="568"/>
                  </a:lnTo>
                  <a:lnTo>
                    <a:pt x="2340" y="568"/>
                  </a:lnTo>
                  <a:lnTo>
                    <a:pt x="2350" y="573"/>
                  </a:lnTo>
                  <a:lnTo>
                    <a:pt x="2361" y="576"/>
                  </a:lnTo>
                  <a:lnTo>
                    <a:pt x="2372" y="584"/>
                  </a:lnTo>
                  <a:lnTo>
                    <a:pt x="2382" y="590"/>
                  </a:lnTo>
                  <a:lnTo>
                    <a:pt x="2394" y="595"/>
                  </a:lnTo>
                  <a:lnTo>
                    <a:pt x="2405" y="596"/>
                  </a:lnTo>
                  <a:lnTo>
                    <a:pt x="2415" y="599"/>
                  </a:lnTo>
                  <a:lnTo>
                    <a:pt x="2426" y="605"/>
                  </a:lnTo>
                  <a:lnTo>
                    <a:pt x="2436" y="611"/>
                  </a:lnTo>
                  <a:lnTo>
                    <a:pt x="2448" y="619"/>
                  </a:lnTo>
                  <a:lnTo>
                    <a:pt x="2459" y="626"/>
                  </a:lnTo>
                  <a:lnTo>
                    <a:pt x="2469" y="626"/>
                  </a:lnTo>
                  <a:lnTo>
                    <a:pt x="2480" y="627"/>
                  </a:lnTo>
                  <a:lnTo>
                    <a:pt x="2492" y="626"/>
                  </a:lnTo>
                  <a:lnTo>
                    <a:pt x="2501" y="632"/>
                  </a:lnTo>
                  <a:lnTo>
                    <a:pt x="2513" y="636"/>
                  </a:lnTo>
                  <a:lnTo>
                    <a:pt x="2524" y="641"/>
                  </a:lnTo>
                  <a:lnTo>
                    <a:pt x="2534" y="644"/>
                  </a:lnTo>
                  <a:lnTo>
                    <a:pt x="2545" y="650"/>
                  </a:lnTo>
                  <a:lnTo>
                    <a:pt x="2555" y="654"/>
                  </a:lnTo>
                  <a:lnTo>
                    <a:pt x="2567" y="655"/>
                  </a:lnTo>
                  <a:lnTo>
                    <a:pt x="2578" y="661"/>
                  </a:lnTo>
                  <a:lnTo>
                    <a:pt x="2588" y="662"/>
                  </a:lnTo>
                  <a:lnTo>
                    <a:pt x="2599" y="663"/>
                  </a:lnTo>
                  <a:lnTo>
                    <a:pt x="2611" y="668"/>
                  </a:lnTo>
                  <a:lnTo>
                    <a:pt x="2620" y="671"/>
                  </a:lnTo>
                  <a:lnTo>
                    <a:pt x="2632" y="675"/>
                  </a:lnTo>
                  <a:lnTo>
                    <a:pt x="2643" y="676"/>
                  </a:lnTo>
                  <a:lnTo>
                    <a:pt x="2653" y="678"/>
                  </a:lnTo>
                  <a:lnTo>
                    <a:pt x="2665" y="679"/>
                  </a:lnTo>
                  <a:lnTo>
                    <a:pt x="2674" y="679"/>
                  </a:lnTo>
                  <a:lnTo>
                    <a:pt x="2686" y="677"/>
                  </a:lnTo>
                  <a:lnTo>
                    <a:pt x="2697" y="681"/>
                  </a:lnTo>
                  <a:lnTo>
                    <a:pt x="2707" y="683"/>
                  </a:lnTo>
                  <a:lnTo>
                    <a:pt x="2718" y="687"/>
                  </a:lnTo>
                  <a:lnTo>
                    <a:pt x="2730" y="690"/>
                  </a:lnTo>
                  <a:lnTo>
                    <a:pt x="2740" y="693"/>
                  </a:lnTo>
                  <a:lnTo>
                    <a:pt x="2751" y="694"/>
                  </a:lnTo>
                  <a:lnTo>
                    <a:pt x="2762" y="695"/>
                  </a:lnTo>
                  <a:lnTo>
                    <a:pt x="2772" y="697"/>
                  </a:lnTo>
                  <a:lnTo>
                    <a:pt x="2784" y="699"/>
                  </a:lnTo>
                  <a:lnTo>
                    <a:pt x="2793" y="698"/>
                  </a:lnTo>
                  <a:lnTo>
                    <a:pt x="2805" y="702"/>
                  </a:lnTo>
                  <a:lnTo>
                    <a:pt x="2816" y="702"/>
                  </a:lnTo>
                  <a:lnTo>
                    <a:pt x="2826" y="700"/>
                  </a:lnTo>
                  <a:lnTo>
                    <a:pt x="2838" y="708"/>
                  </a:lnTo>
                  <a:lnTo>
                    <a:pt x="2849" y="708"/>
                  </a:lnTo>
                  <a:lnTo>
                    <a:pt x="2859" y="706"/>
                  </a:lnTo>
                  <a:lnTo>
                    <a:pt x="2870" y="713"/>
                  </a:lnTo>
                  <a:lnTo>
                    <a:pt x="2882" y="715"/>
                  </a:lnTo>
                  <a:lnTo>
                    <a:pt x="2891" y="714"/>
                  </a:lnTo>
                  <a:lnTo>
                    <a:pt x="2903" y="714"/>
                  </a:lnTo>
                  <a:lnTo>
                    <a:pt x="2913" y="714"/>
                  </a:lnTo>
                  <a:lnTo>
                    <a:pt x="2924" y="714"/>
                  </a:lnTo>
                  <a:lnTo>
                    <a:pt x="2935" y="717"/>
                  </a:lnTo>
                  <a:lnTo>
                    <a:pt x="2945" y="717"/>
                  </a:lnTo>
                  <a:lnTo>
                    <a:pt x="2957" y="721"/>
                  </a:lnTo>
                  <a:lnTo>
                    <a:pt x="2968" y="722"/>
                  </a:lnTo>
                  <a:lnTo>
                    <a:pt x="2978" y="721"/>
                  </a:lnTo>
                  <a:lnTo>
                    <a:pt x="2989" y="724"/>
                  </a:lnTo>
                  <a:lnTo>
                    <a:pt x="3001" y="728"/>
                  </a:lnTo>
                  <a:lnTo>
                    <a:pt x="3010" y="731"/>
                  </a:lnTo>
                  <a:lnTo>
                    <a:pt x="3022" y="734"/>
                  </a:lnTo>
                  <a:lnTo>
                    <a:pt x="3032" y="731"/>
                  </a:lnTo>
                  <a:lnTo>
                    <a:pt x="3043" y="731"/>
                  </a:lnTo>
                  <a:lnTo>
                    <a:pt x="3055" y="734"/>
                  </a:lnTo>
                  <a:lnTo>
                    <a:pt x="3064" y="734"/>
                  </a:lnTo>
                  <a:lnTo>
                    <a:pt x="3076" y="734"/>
                  </a:lnTo>
                  <a:lnTo>
                    <a:pt x="3087" y="735"/>
                  </a:lnTo>
                  <a:lnTo>
                    <a:pt x="3097" y="738"/>
                  </a:lnTo>
                  <a:lnTo>
                    <a:pt x="3108" y="737"/>
                  </a:lnTo>
                  <a:lnTo>
                    <a:pt x="3120" y="741"/>
                  </a:lnTo>
                  <a:lnTo>
                    <a:pt x="3130" y="743"/>
                  </a:lnTo>
                  <a:lnTo>
                    <a:pt x="3141" y="739"/>
                  </a:lnTo>
                  <a:lnTo>
                    <a:pt x="3151" y="739"/>
                  </a:lnTo>
                  <a:lnTo>
                    <a:pt x="3162" y="738"/>
                  </a:lnTo>
                  <a:lnTo>
                    <a:pt x="3174" y="742"/>
                  </a:lnTo>
                  <a:lnTo>
                    <a:pt x="3183" y="746"/>
                  </a:lnTo>
                  <a:lnTo>
                    <a:pt x="3195" y="749"/>
                  </a:lnTo>
                  <a:lnTo>
                    <a:pt x="3206" y="745"/>
                  </a:lnTo>
                  <a:lnTo>
                    <a:pt x="3216" y="747"/>
                  </a:lnTo>
                  <a:lnTo>
                    <a:pt x="3227" y="747"/>
                  </a:lnTo>
                  <a:lnTo>
                    <a:pt x="3239" y="746"/>
                  </a:lnTo>
                  <a:lnTo>
                    <a:pt x="3249" y="750"/>
                  </a:lnTo>
                  <a:lnTo>
                    <a:pt x="3260" y="753"/>
                  </a:lnTo>
                  <a:lnTo>
                    <a:pt x="3272" y="747"/>
                  </a:lnTo>
                  <a:lnTo>
                    <a:pt x="3281" y="749"/>
                  </a:lnTo>
                  <a:lnTo>
                    <a:pt x="3293" y="754"/>
                  </a:lnTo>
                  <a:lnTo>
                    <a:pt x="3303" y="756"/>
                  </a:lnTo>
                  <a:lnTo>
                    <a:pt x="3314" y="753"/>
                  </a:lnTo>
                  <a:lnTo>
                    <a:pt x="3325" y="756"/>
                  </a:lnTo>
                  <a:lnTo>
                    <a:pt x="3335" y="758"/>
                  </a:lnTo>
                  <a:lnTo>
                    <a:pt x="3347" y="760"/>
                  </a:lnTo>
                  <a:lnTo>
                    <a:pt x="3358" y="758"/>
                  </a:lnTo>
                  <a:lnTo>
                    <a:pt x="3368" y="764"/>
                  </a:lnTo>
                  <a:lnTo>
                    <a:pt x="3379" y="765"/>
                  </a:lnTo>
                  <a:lnTo>
                    <a:pt x="3391" y="763"/>
                  </a:lnTo>
                  <a:lnTo>
                    <a:pt x="3400" y="765"/>
                  </a:lnTo>
                  <a:lnTo>
                    <a:pt x="3412" y="763"/>
                  </a:lnTo>
                  <a:lnTo>
                    <a:pt x="3422" y="767"/>
                  </a:lnTo>
                  <a:lnTo>
                    <a:pt x="3433" y="765"/>
                  </a:lnTo>
                  <a:lnTo>
                    <a:pt x="3445" y="764"/>
                  </a:lnTo>
                  <a:lnTo>
                    <a:pt x="3454" y="765"/>
                  </a:lnTo>
                  <a:lnTo>
                    <a:pt x="3466" y="767"/>
                  </a:lnTo>
                  <a:lnTo>
                    <a:pt x="3477" y="766"/>
                  </a:lnTo>
                  <a:lnTo>
                    <a:pt x="3487" y="768"/>
                  </a:lnTo>
                  <a:lnTo>
                    <a:pt x="3498" y="771"/>
                  </a:lnTo>
                  <a:lnTo>
                    <a:pt x="3510" y="771"/>
                  </a:lnTo>
                  <a:lnTo>
                    <a:pt x="3520" y="769"/>
                  </a:lnTo>
                  <a:lnTo>
                    <a:pt x="3531" y="775"/>
                  </a:lnTo>
                  <a:lnTo>
                    <a:pt x="3541" y="773"/>
                  </a:lnTo>
                  <a:lnTo>
                    <a:pt x="3552" y="775"/>
                  </a:lnTo>
                  <a:lnTo>
                    <a:pt x="3564" y="775"/>
                  </a:lnTo>
                  <a:lnTo>
                    <a:pt x="3573" y="775"/>
                  </a:lnTo>
                  <a:lnTo>
                    <a:pt x="3585" y="773"/>
                  </a:lnTo>
                  <a:lnTo>
                    <a:pt x="3596" y="774"/>
                  </a:lnTo>
                  <a:lnTo>
                    <a:pt x="3606" y="779"/>
                  </a:lnTo>
                  <a:lnTo>
                    <a:pt x="3617" y="778"/>
                  </a:lnTo>
                  <a:lnTo>
                    <a:pt x="3629" y="779"/>
                  </a:lnTo>
                  <a:lnTo>
                    <a:pt x="3639" y="780"/>
                  </a:lnTo>
                  <a:lnTo>
                    <a:pt x="3650" y="781"/>
                  </a:lnTo>
                  <a:lnTo>
                    <a:pt x="3660" y="781"/>
                  </a:lnTo>
                  <a:lnTo>
                    <a:pt x="3671" y="782"/>
                  </a:lnTo>
                  <a:lnTo>
                    <a:pt x="3683" y="783"/>
                  </a:lnTo>
                  <a:lnTo>
                    <a:pt x="3693" y="785"/>
                  </a:lnTo>
                  <a:lnTo>
                    <a:pt x="3704" y="780"/>
                  </a:lnTo>
                  <a:lnTo>
                    <a:pt x="3715" y="779"/>
                  </a:lnTo>
                  <a:lnTo>
                    <a:pt x="3725" y="787"/>
                  </a:lnTo>
                  <a:lnTo>
                    <a:pt x="3737" y="781"/>
                  </a:lnTo>
                  <a:lnTo>
                    <a:pt x="3748" y="764"/>
                  </a:lnTo>
                  <a:lnTo>
                    <a:pt x="3758" y="776"/>
                  </a:lnTo>
                  <a:lnTo>
                    <a:pt x="3769" y="788"/>
                  </a:lnTo>
                  <a:lnTo>
                    <a:pt x="3779" y="781"/>
                  </a:lnTo>
                  <a:lnTo>
                    <a:pt x="3790" y="781"/>
                  </a:lnTo>
                  <a:lnTo>
                    <a:pt x="3802" y="783"/>
                  </a:lnTo>
                  <a:lnTo>
                    <a:pt x="3812" y="787"/>
                  </a:lnTo>
                  <a:lnTo>
                    <a:pt x="3823" y="787"/>
                  </a:lnTo>
                  <a:lnTo>
                    <a:pt x="3834" y="786"/>
                  </a:lnTo>
                  <a:lnTo>
                    <a:pt x="3844" y="785"/>
                  </a:lnTo>
                  <a:lnTo>
                    <a:pt x="3856" y="786"/>
                  </a:lnTo>
                  <a:lnTo>
                    <a:pt x="3867" y="781"/>
                  </a:lnTo>
                  <a:lnTo>
                    <a:pt x="3877" y="783"/>
                  </a:lnTo>
                  <a:lnTo>
                    <a:pt x="3888" y="791"/>
                  </a:lnTo>
                </a:path>
              </a:pathLst>
            </a:custGeom>
            <a:noFill/>
            <a:ln w="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1096253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dirty="0" smtClean="0"/>
              <a:t>Figure2C</a:t>
            </a:r>
            <a:endParaRPr lang="en-US" dirty="0"/>
          </a:p>
        </p:txBody>
      </p:sp>
      <p:grpSp>
        <p:nvGrpSpPr>
          <p:cNvPr id="90" name="Group 89"/>
          <p:cNvGrpSpPr/>
          <p:nvPr/>
        </p:nvGrpSpPr>
        <p:grpSpPr>
          <a:xfrm>
            <a:off x="599838" y="2116138"/>
            <a:ext cx="7526260" cy="3449637"/>
            <a:chOff x="599838" y="2116138"/>
            <a:chExt cx="7526260" cy="3449637"/>
          </a:xfrm>
        </p:grpSpPr>
        <p:sp>
          <p:nvSpPr>
            <p:cNvPr id="91" name="Line 9"/>
            <p:cNvSpPr>
              <a:spLocks noChangeShapeType="1"/>
            </p:cNvSpPr>
            <p:nvPr/>
          </p:nvSpPr>
          <p:spPr bwMode="auto">
            <a:xfrm flipV="1">
              <a:off x="1294310" y="2208212"/>
              <a:ext cx="4761" cy="185356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2" name="Line 19"/>
            <p:cNvSpPr>
              <a:spLocks noChangeShapeType="1"/>
            </p:cNvSpPr>
            <p:nvPr/>
          </p:nvSpPr>
          <p:spPr bwMode="auto">
            <a:xfrm flipH="1">
              <a:off x="1289050" y="3816350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3" name="Line 20"/>
            <p:cNvSpPr>
              <a:spLocks noChangeShapeType="1"/>
            </p:cNvSpPr>
            <p:nvPr/>
          </p:nvSpPr>
          <p:spPr bwMode="auto">
            <a:xfrm flipH="1">
              <a:off x="1289050" y="3586163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4" name="Line 21"/>
            <p:cNvSpPr>
              <a:spLocks noChangeShapeType="1"/>
            </p:cNvSpPr>
            <p:nvPr/>
          </p:nvSpPr>
          <p:spPr bwMode="auto">
            <a:xfrm flipH="1">
              <a:off x="1289050" y="3355975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5" name="Line 22"/>
            <p:cNvSpPr>
              <a:spLocks noChangeShapeType="1"/>
            </p:cNvSpPr>
            <p:nvPr/>
          </p:nvSpPr>
          <p:spPr bwMode="auto">
            <a:xfrm flipH="1">
              <a:off x="1289050" y="3127375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6" name="Line 23"/>
            <p:cNvSpPr>
              <a:spLocks noChangeShapeType="1"/>
            </p:cNvSpPr>
            <p:nvPr/>
          </p:nvSpPr>
          <p:spPr bwMode="auto">
            <a:xfrm flipH="1">
              <a:off x="1289050" y="2897188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7" name="Line 24"/>
            <p:cNvSpPr>
              <a:spLocks noChangeShapeType="1"/>
            </p:cNvSpPr>
            <p:nvPr/>
          </p:nvSpPr>
          <p:spPr bwMode="auto">
            <a:xfrm flipH="1">
              <a:off x="1289050" y="2667000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8" name="Line 25"/>
            <p:cNvSpPr>
              <a:spLocks noChangeShapeType="1"/>
            </p:cNvSpPr>
            <p:nvPr/>
          </p:nvSpPr>
          <p:spPr bwMode="auto">
            <a:xfrm flipH="1">
              <a:off x="1289050" y="2438400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99" name="Line 26"/>
            <p:cNvSpPr>
              <a:spLocks noChangeShapeType="1"/>
            </p:cNvSpPr>
            <p:nvPr/>
          </p:nvSpPr>
          <p:spPr bwMode="auto">
            <a:xfrm flipH="1">
              <a:off x="1289050" y="2208213"/>
              <a:ext cx="17463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00" name="Line 34"/>
            <p:cNvSpPr>
              <a:spLocks noChangeShapeType="1"/>
            </p:cNvSpPr>
            <p:nvPr/>
          </p:nvSpPr>
          <p:spPr bwMode="auto">
            <a:xfrm flipH="1">
              <a:off x="1270000" y="3586163"/>
              <a:ext cx="460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01" name="Line 35"/>
            <p:cNvSpPr>
              <a:spLocks noChangeShapeType="1"/>
            </p:cNvSpPr>
            <p:nvPr/>
          </p:nvSpPr>
          <p:spPr bwMode="auto">
            <a:xfrm flipH="1">
              <a:off x="1270000" y="3127375"/>
              <a:ext cx="460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02" name="Line 36"/>
            <p:cNvSpPr>
              <a:spLocks noChangeShapeType="1"/>
            </p:cNvSpPr>
            <p:nvPr/>
          </p:nvSpPr>
          <p:spPr bwMode="auto">
            <a:xfrm flipH="1">
              <a:off x="1270000" y="2667000"/>
              <a:ext cx="460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03" name="Line 37"/>
            <p:cNvSpPr>
              <a:spLocks noChangeShapeType="1"/>
            </p:cNvSpPr>
            <p:nvPr/>
          </p:nvSpPr>
          <p:spPr bwMode="auto">
            <a:xfrm flipH="1">
              <a:off x="1270000" y="2208213"/>
              <a:ext cx="460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04" name="Rectangle 44"/>
            <p:cNvSpPr>
              <a:spLocks noChangeArrowheads="1"/>
            </p:cNvSpPr>
            <p:nvPr/>
          </p:nvSpPr>
          <p:spPr bwMode="auto">
            <a:xfrm>
              <a:off x="1128713" y="3495675"/>
              <a:ext cx="1026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05" name="Rectangle 45"/>
            <p:cNvSpPr>
              <a:spLocks noChangeArrowheads="1"/>
            </p:cNvSpPr>
            <p:nvPr/>
          </p:nvSpPr>
          <p:spPr bwMode="auto">
            <a:xfrm>
              <a:off x="1020763" y="3048000"/>
              <a:ext cx="20528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5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06" name="Rectangle 46"/>
            <p:cNvSpPr>
              <a:spLocks noChangeArrowheads="1"/>
            </p:cNvSpPr>
            <p:nvPr/>
          </p:nvSpPr>
          <p:spPr bwMode="auto">
            <a:xfrm>
              <a:off x="938213" y="2576513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10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07" name="Rectangle 47"/>
            <p:cNvSpPr>
              <a:spLocks noChangeArrowheads="1"/>
            </p:cNvSpPr>
            <p:nvPr/>
          </p:nvSpPr>
          <p:spPr bwMode="auto">
            <a:xfrm>
              <a:off x="938213" y="2116138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15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08" name="Rectangle 87"/>
            <p:cNvSpPr>
              <a:spLocks noChangeArrowheads="1"/>
            </p:cNvSpPr>
            <p:nvPr/>
          </p:nvSpPr>
          <p:spPr bwMode="auto">
            <a:xfrm rot="16200000">
              <a:off x="-99342" y="2997880"/>
              <a:ext cx="164458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600" b="1" dirty="0" smtClean="0">
                  <a:solidFill>
                    <a:srgbClr val="000000"/>
                  </a:solidFill>
                  <a:latin typeface="Arial Black"/>
                  <a:cs typeface="Arial Black"/>
                </a:rPr>
                <a:t>Response (RU)</a:t>
              </a:r>
              <a:endParaRPr lang="es-ES" sz="1600" dirty="0">
                <a:latin typeface="Arial Black"/>
                <a:cs typeface="Arial Black"/>
              </a:endParaRPr>
            </a:p>
          </p:txBody>
        </p:sp>
        <p:sp>
          <p:nvSpPr>
            <p:cNvPr id="109" name="Rectangle 90"/>
            <p:cNvSpPr>
              <a:spLocks noChangeArrowheads="1"/>
            </p:cNvSpPr>
            <p:nvPr/>
          </p:nvSpPr>
          <p:spPr bwMode="auto">
            <a:xfrm>
              <a:off x="7052460" y="2563555"/>
              <a:ext cx="7096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 smtClean="0">
                  <a:solidFill>
                    <a:srgbClr val="000000"/>
                  </a:solidFill>
                  <a:latin typeface="Arial Black"/>
                  <a:cs typeface="Arial Black"/>
                </a:rPr>
                <a:t>PSG9-Fc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10" name="Rectangle 92"/>
            <p:cNvSpPr>
              <a:spLocks noChangeArrowheads="1"/>
            </p:cNvSpPr>
            <p:nvPr/>
          </p:nvSpPr>
          <p:spPr bwMode="auto">
            <a:xfrm>
              <a:off x="7034528" y="3454142"/>
              <a:ext cx="109157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CEACAM9-Fc 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11" name="Freeform 94"/>
            <p:cNvSpPr>
              <a:spLocks/>
            </p:cNvSpPr>
            <p:nvPr/>
          </p:nvSpPr>
          <p:spPr bwMode="auto">
            <a:xfrm>
              <a:off x="1671638" y="2305050"/>
              <a:ext cx="5275263" cy="3260725"/>
            </a:xfrm>
            <a:custGeom>
              <a:avLst/>
              <a:gdLst>
                <a:gd name="T0" fmla="*/ 47 w 3323"/>
                <a:gd name="T1" fmla="*/ 807 h 2054"/>
                <a:gd name="T2" fmla="*/ 102 w 3323"/>
                <a:gd name="T3" fmla="*/ 807 h 2054"/>
                <a:gd name="T4" fmla="*/ 157 w 3323"/>
                <a:gd name="T5" fmla="*/ 808 h 2054"/>
                <a:gd name="T6" fmla="*/ 214 w 3323"/>
                <a:gd name="T7" fmla="*/ 808 h 2054"/>
                <a:gd name="T8" fmla="*/ 269 w 3323"/>
                <a:gd name="T9" fmla="*/ 1091 h 2054"/>
                <a:gd name="T10" fmla="*/ 325 w 3323"/>
                <a:gd name="T11" fmla="*/ 862 h 2054"/>
                <a:gd name="T12" fmla="*/ 380 w 3323"/>
                <a:gd name="T13" fmla="*/ 725 h 2054"/>
                <a:gd name="T14" fmla="*/ 437 w 3323"/>
                <a:gd name="T15" fmla="*/ 644 h 2054"/>
                <a:gd name="T16" fmla="*/ 492 w 3323"/>
                <a:gd name="T17" fmla="*/ 582 h 2054"/>
                <a:gd name="T18" fmla="*/ 547 w 3323"/>
                <a:gd name="T19" fmla="*/ 530 h 2054"/>
                <a:gd name="T20" fmla="*/ 603 w 3323"/>
                <a:gd name="T21" fmla="*/ 489 h 2054"/>
                <a:gd name="T22" fmla="*/ 660 w 3323"/>
                <a:gd name="T23" fmla="*/ 454 h 2054"/>
                <a:gd name="T24" fmla="*/ 715 w 3323"/>
                <a:gd name="T25" fmla="*/ 424 h 2054"/>
                <a:gd name="T26" fmla="*/ 770 w 3323"/>
                <a:gd name="T27" fmla="*/ 396 h 2054"/>
                <a:gd name="T28" fmla="*/ 826 w 3323"/>
                <a:gd name="T29" fmla="*/ 370 h 2054"/>
                <a:gd name="T30" fmla="*/ 882 w 3323"/>
                <a:gd name="T31" fmla="*/ 349 h 2054"/>
                <a:gd name="T32" fmla="*/ 938 w 3323"/>
                <a:gd name="T33" fmla="*/ 326 h 2054"/>
                <a:gd name="T34" fmla="*/ 993 w 3323"/>
                <a:gd name="T35" fmla="*/ 304 h 2054"/>
                <a:gd name="T36" fmla="*/ 1048 w 3323"/>
                <a:gd name="T37" fmla="*/ 285 h 2054"/>
                <a:gd name="T38" fmla="*/ 1105 w 3323"/>
                <a:gd name="T39" fmla="*/ 262 h 2054"/>
                <a:gd name="T40" fmla="*/ 1160 w 3323"/>
                <a:gd name="T41" fmla="*/ 247 h 2054"/>
                <a:gd name="T42" fmla="*/ 1216 w 3323"/>
                <a:gd name="T43" fmla="*/ 227 h 2054"/>
                <a:gd name="T44" fmla="*/ 1271 w 3323"/>
                <a:gd name="T45" fmla="*/ 207 h 2054"/>
                <a:gd name="T46" fmla="*/ 1328 w 3323"/>
                <a:gd name="T47" fmla="*/ 190 h 2054"/>
                <a:gd name="T48" fmla="*/ 1383 w 3323"/>
                <a:gd name="T49" fmla="*/ 174 h 2054"/>
                <a:gd name="T50" fmla="*/ 1439 w 3323"/>
                <a:gd name="T51" fmla="*/ 159 h 2054"/>
                <a:gd name="T52" fmla="*/ 1494 w 3323"/>
                <a:gd name="T53" fmla="*/ 145 h 2054"/>
                <a:gd name="T54" fmla="*/ 1549 w 3323"/>
                <a:gd name="T55" fmla="*/ 128 h 2054"/>
                <a:gd name="T56" fmla="*/ 1606 w 3323"/>
                <a:gd name="T57" fmla="*/ 112 h 2054"/>
                <a:gd name="T58" fmla="*/ 1661 w 3323"/>
                <a:gd name="T59" fmla="*/ 99 h 2054"/>
                <a:gd name="T60" fmla="*/ 1717 w 3323"/>
                <a:gd name="T61" fmla="*/ 84 h 2054"/>
                <a:gd name="T62" fmla="*/ 1772 w 3323"/>
                <a:gd name="T63" fmla="*/ 69 h 2054"/>
                <a:gd name="T64" fmla="*/ 1829 w 3323"/>
                <a:gd name="T65" fmla="*/ 57 h 2054"/>
                <a:gd name="T66" fmla="*/ 1884 w 3323"/>
                <a:gd name="T67" fmla="*/ 43 h 2054"/>
                <a:gd name="T68" fmla="*/ 1939 w 3323"/>
                <a:gd name="T69" fmla="*/ 25 h 2054"/>
                <a:gd name="T70" fmla="*/ 1995 w 3323"/>
                <a:gd name="T71" fmla="*/ 62 h 2054"/>
                <a:gd name="T72" fmla="*/ 2052 w 3323"/>
                <a:gd name="T73" fmla="*/ 81 h 2054"/>
                <a:gd name="T74" fmla="*/ 2107 w 3323"/>
                <a:gd name="T75" fmla="*/ 95 h 2054"/>
                <a:gd name="T76" fmla="*/ 2162 w 3323"/>
                <a:gd name="T77" fmla="*/ 106 h 2054"/>
                <a:gd name="T78" fmla="*/ 2218 w 3323"/>
                <a:gd name="T79" fmla="*/ 116 h 2054"/>
                <a:gd name="T80" fmla="*/ 2274 w 3323"/>
                <a:gd name="T81" fmla="*/ 125 h 2054"/>
                <a:gd name="T82" fmla="*/ 2330 w 3323"/>
                <a:gd name="T83" fmla="*/ 132 h 2054"/>
                <a:gd name="T84" fmla="*/ 2385 w 3323"/>
                <a:gd name="T85" fmla="*/ 139 h 2054"/>
                <a:gd name="T86" fmla="*/ 2440 w 3323"/>
                <a:gd name="T87" fmla="*/ 146 h 2054"/>
                <a:gd name="T88" fmla="*/ 2497 w 3323"/>
                <a:gd name="T89" fmla="*/ 153 h 2054"/>
                <a:gd name="T90" fmla="*/ 2552 w 3323"/>
                <a:gd name="T91" fmla="*/ 159 h 2054"/>
                <a:gd name="T92" fmla="*/ 2608 w 3323"/>
                <a:gd name="T93" fmla="*/ 163 h 2054"/>
                <a:gd name="T94" fmla="*/ 2663 w 3323"/>
                <a:gd name="T95" fmla="*/ 169 h 2054"/>
                <a:gd name="T96" fmla="*/ 2720 w 3323"/>
                <a:gd name="T97" fmla="*/ 173 h 2054"/>
                <a:gd name="T98" fmla="*/ 2775 w 3323"/>
                <a:gd name="T99" fmla="*/ 177 h 2054"/>
                <a:gd name="T100" fmla="*/ 2831 w 3323"/>
                <a:gd name="T101" fmla="*/ 182 h 2054"/>
                <a:gd name="T102" fmla="*/ 2886 w 3323"/>
                <a:gd name="T103" fmla="*/ 184 h 2054"/>
                <a:gd name="T104" fmla="*/ 2941 w 3323"/>
                <a:gd name="T105" fmla="*/ 189 h 2054"/>
                <a:gd name="T106" fmla="*/ 2998 w 3323"/>
                <a:gd name="T107" fmla="*/ 191 h 2054"/>
                <a:gd name="T108" fmla="*/ 3053 w 3323"/>
                <a:gd name="T109" fmla="*/ 196 h 2054"/>
                <a:gd name="T110" fmla="*/ 3109 w 3323"/>
                <a:gd name="T111" fmla="*/ 201 h 2054"/>
                <a:gd name="T112" fmla="*/ 3164 w 3323"/>
                <a:gd name="T113" fmla="*/ 201 h 2054"/>
                <a:gd name="T114" fmla="*/ 3221 w 3323"/>
                <a:gd name="T115" fmla="*/ 208 h 2054"/>
                <a:gd name="T116" fmla="*/ 3276 w 3323"/>
                <a:gd name="T117" fmla="*/ 210 h 20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3323" h="2054">
                  <a:moveTo>
                    <a:pt x="0" y="807"/>
                  </a:moveTo>
                  <a:lnTo>
                    <a:pt x="10" y="807"/>
                  </a:lnTo>
                  <a:lnTo>
                    <a:pt x="18" y="807"/>
                  </a:lnTo>
                  <a:lnTo>
                    <a:pt x="28" y="808"/>
                  </a:lnTo>
                  <a:lnTo>
                    <a:pt x="37" y="807"/>
                  </a:lnTo>
                  <a:lnTo>
                    <a:pt x="47" y="807"/>
                  </a:lnTo>
                  <a:lnTo>
                    <a:pt x="56" y="806"/>
                  </a:lnTo>
                  <a:lnTo>
                    <a:pt x="65" y="806"/>
                  </a:lnTo>
                  <a:lnTo>
                    <a:pt x="75" y="806"/>
                  </a:lnTo>
                  <a:lnTo>
                    <a:pt x="83" y="808"/>
                  </a:lnTo>
                  <a:lnTo>
                    <a:pt x="93" y="807"/>
                  </a:lnTo>
                  <a:lnTo>
                    <a:pt x="102" y="807"/>
                  </a:lnTo>
                  <a:lnTo>
                    <a:pt x="112" y="807"/>
                  </a:lnTo>
                  <a:lnTo>
                    <a:pt x="120" y="808"/>
                  </a:lnTo>
                  <a:lnTo>
                    <a:pt x="130" y="807"/>
                  </a:lnTo>
                  <a:lnTo>
                    <a:pt x="139" y="807"/>
                  </a:lnTo>
                  <a:lnTo>
                    <a:pt x="149" y="807"/>
                  </a:lnTo>
                  <a:lnTo>
                    <a:pt x="157" y="808"/>
                  </a:lnTo>
                  <a:lnTo>
                    <a:pt x="167" y="807"/>
                  </a:lnTo>
                  <a:lnTo>
                    <a:pt x="177" y="810"/>
                  </a:lnTo>
                  <a:lnTo>
                    <a:pt x="186" y="808"/>
                  </a:lnTo>
                  <a:lnTo>
                    <a:pt x="196" y="807"/>
                  </a:lnTo>
                  <a:lnTo>
                    <a:pt x="204" y="808"/>
                  </a:lnTo>
                  <a:lnTo>
                    <a:pt x="214" y="808"/>
                  </a:lnTo>
                  <a:lnTo>
                    <a:pt x="223" y="810"/>
                  </a:lnTo>
                  <a:lnTo>
                    <a:pt x="232" y="803"/>
                  </a:lnTo>
                  <a:lnTo>
                    <a:pt x="241" y="796"/>
                  </a:lnTo>
                  <a:lnTo>
                    <a:pt x="251" y="801"/>
                  </a:lnTo>
                  <a:lnTo>
                    <a:pt x="259" y="685"/>
                  </a:lnTo>
                  <a:lnTo>
                    <a:pt x="269" y="1091"/>
                  </a:lnTo>
                  <a:lnTo>
                    <a:pt x="279" y="2054"/>
                  </a:lnTo>
                  <a:lnTo>
                    <a:pt x="288" y="1299"/>
                  </a:lnTo>
                  <a:lnTo>
                    <a:pt x="298" y="1159"/>
                  </a:lnTo>
                  <a:lnTo>
                    <a:pt x="306" y="1013"/>
                  </a:lnTo>
                  <a:lnTo>
                    <a:pt x="316" y="915"/>
                  </a:lnTo>
                  <a:lnTo>
                    <a:pt x="325" y="862"/>
                  </a:lnTo>
                  <a:lnTo>
                    <a:pt x="335" y="830"/>
                  </a:lnTo>
                  <a:lnTo>
                    <a:pt x="343" y="801"/>
                  </a:lnTo>
                  <a:lnTo>
                    <a:pt x="353" y="779"/>
                  </a:lnTo>
                  <a:lnTo>
                    <a:pt x="362" y="760"/>
                  </a:lnTo>
                  <a:lnTo>
                    <a:pt x="372" y="742"/>
                  </a:lnTo>
                  <a:lnTo>
                    <a:pt x="380" y="725"/>
                  </a:lnTo>
                  <a:lnTo>
                    <a:pt x="390" y="709"/>
                  </a:lnTo>
                  <a:lnTo>
                    <a:pt x="400" y="694"/>
                  </a:lnTo>
                  <a:lnTo>
                    <a:pt x="408" y="679"/>
                  </a:lnTo>
                  <a:lnTo>
                    <a:pt x="418" y="668"/>
                  </a:lnTo>
                  <a:lnTo>
                    <a:pt x="427" y="655"/>
                  </a:lnTo>
                  <a:lnTo>
                    <a:pt x="437" y="644"/>
                  </a:lnTo>
                  <a:lnTo>
                    <a:pt x="445" y="634"/>
                  </a:lnTo>
                  <a:lnTo>
                    <a:pt x="455" y="621"/>
                  </a:lnTo>
                  <a:lnTo>
                    <a:pt x="464" y="611"/>
                  </a:lnTo>
                  <a:lnTo>
                    <a:pt x="474" y="601"/>
                  </a:lnTo>
                  <a:lnTo>
                    <a:pt x="482" y="591"/>
                  </a:lnTo>
                  <a:lnTo>
                    <a:pt x="492" y="582"/>
                  </a:lnTo>
                  <a:lnTo>
                    <a:pt x="501" y="574"/>
                  </a:lnTo>
                  <a:lnTo>
                    <a:pt x="511" y="564"/>
                  </a:lnTo>
                  <a:lnTo>
                    <a:pt x="520" y="556"/>
                  </a:lnTo>
                  <a:lnTo>
                    <a:pt x="529" y="546"/>
                  </a:lnTo>
                  <a:lnTo>
                    <a:pt x="539" y="538"/>
                  </a:lnTo>
                  <a:lnTo>
                    <a:pt x="547" y="530"/>
                  </a:lnTo>
                  <a:lnTo>
                    <a:pt x="557" y="523"/>
                  </a:lnTo>
                  <a:lnTo>
                    <a:pt x="566" y="516"/>
                  </a:lnTo>
                  <a:lnTo>
                    <a:pt x="576" y="506"/>
                  </a:lnTo>
                  <a:lnTo>
                    <a:pt x="584" y="501"/>
                  </a:lnTo>
                  <a:lnTo>
                    <a:pt x="594" y="495"/>
                  </a:lnTo>
                  <a:lnTo>
                    <a:pt x="603" y="489"/>
                  </a:lnTo>
                  <a:lnTo>
                    <a:pt x="613" y="482"/>
                  </a:lnTo>
                  <a:lnTo>
                    <a:pt x="621" y="475"/>
                  </a:lnTo>
                  <a:lnTo>
                    <a:pt x="631" y="469"/>
                  </a:lnTo>
                  <a:lnTo>
                    <a:pt x="641" y="464"/>
                  </a:lnTo>
                  <a:lnTo>
                    <a:pt x="650" y="460"/>
                  </a:lnTo>
                  <a:lnTo>
                    <a:pt x="660" y="454"/>
                  </a:lnTo>
                  <a:lnTo>
                    <a:pt x="668" y="447"/>
                  </a:lnTo>
                  <a:lnTo>
                    <a:pt x="678" y="441"/>
                  </a:lnTo>
                  <a:lnTo>
                    <a:pt x="687" y="435"/>
                  </a:lnTo>
                  <a:lnTo>
                    <a:pt x="696" y="431"/>
                  </a:lnTo>
                  <a:lnTo>
                    <a:pt x="705" y="427"/>
                  </a:lnTo>
                  <a:lnTo>
                    <a:pt x="715" y="424"/>
                  </a:lnTo>
                  <a:lnTo>
                    <a:pt x="723" y="417"/>
                  </a:lnTo>
                  <a:lnTo>
                    <a:pt x="733" y="411"/>
                  </a:lnTo>
                  <a:lnTo>
                    <a:pt x="743" y="407"/>
                  </a:lnTo>
                  <a:lnTo>
                    <a:pt x="752" y="404"/>
                  </a:lnTo>
                  <a:lnTo>
                    <a:pt x="762" y="400"/>
                  </a:lnTo>
                  <a:lnTo>
                    <a:pt x="770" y="396"/>
                  </a:lnTo>
                  <a:lnTo>
                    <a:pt x="780" y="390"/>
                  </a:lnTo>
                  <a:lnTo>
                    <a:pt x="789" y="386"/>
                  </a:lnTo>
                  <a:lnTo>
                    <a:pt x="799" y="382"/>
                  </a:lnTo>
                  <a:lnTo>
                    <a:pt x="807" y="377"/>
                  </a:lnTo>
                  <a:lnTo>
                    <a:pt x="817" y="376"/>
                  </a:lnTo>
                  <a:lnTo>
                    <a:pt x="826" y="370"/>
                  </a:lnTo>
                  <a:lnTo>
                    <a:pt x="835" y="366"/>
                  </a:lnTo>
                  <a:lnTo>
                    <a:pt x="844" y="363"/>
                  </a:lnTo>
                  <a:lnTo>
                    <a:pt x="854" y="360"/>
                  </a:lnTo>
                  <a:lnTo>
                    <a:pt x="864" y="355"/>
                  </a:lnTo>
                  <a:lnTo>
                    <a:pt x="872" y="353"/>
                  </a:lnTo>
                  <a:lnTo>
                    <a:pt x="882" y="349"/>
                  </a:lnTo>
                  <a:lnTo>
                    <a:pt x="891" y="345"/>
                  </a:lnTo>
                  <a:lnTo>
                    <a:pt x="901" y="339"/>
                  </a:lnTo>
                  <a:lnTo>
                    <a:pt x="909" y="336"/>
                  </a:lnTo>
                  <a:lnTo>
                    <a:pt x="919" y="333"/>
                  </a:lnTo>
                  <a:lnTo>
                    <a:pt x="928" y="328"/>
                  </a:lnTo>
                  <a:lnTo>
                    <a:pt x="938" y="326"/>
                  </a:lnTo>
                  <a:lnTo>
                    <a:pt x="946" y="322"/>
                  </a:lnTo>
                  <a:lnTo>
                    <a:pt x="956" y="318"/>
                  </a:lnTo>
                  <a:lnTo>
                    <a:pt x="965" y="315"/>
                  </a:lnTo>
                  <a:lnTo>
                    <a:pt x="975" y="311"/>
                  </a:lnTo>
                  <a:lnTo>
                    <a:pt x="984" y="306"/>
                  </a:lnTo>
                  <a:lnTo>
                    <a:pt x="993" y="304"/>
                  </a:lnTo>
                  <a:lnTo>
                    <a:pt x="1003" y="301"/>
                  </a:lnTo>
                  <a:lnTo>
                    <a:pt x="1011" y="298"/>
                  </a:lnTo>
                  <a:lnTo>
                    <a:pt x="1021" y="294"/>
                  </a:lnTo>
                  <a:lnTo>
                    <a:pt x="1030" y="291"/>
                  </a:lnTo>
                  <a:lnTo>
                    <a:pt x="1040" y="288"/>
                  </a:lnTo>
                  <a:lnTo>
                    <a:pt x="1048" y="285"/>
                  </a:lnTo>
                  <a:lnTo>
                    <a:pt x="1058" y="279"/>
                  </a:lnTo>
                  <a:lnTo>
                    <a:pt x="1067" y="277"/>
                  </a:lnTo>
                  <a:lnTo>
                    <a:pt x="1077" y="274"/>
                  </a:lnTo>
                  <a:lnTo>
                    <a:pt x="1085" y="271"/>
                  </a:lnTo>
                  <a:lnTo>
                    <a:pt x="1095" y="267"/>
                  </a:lnTo>
                  <a:lnTo>
                    <a:pt x="1105" y="262"/>
                  </a:lnTo>
                  <a:lnTo>
                    <a:pt x="1114" y="261"/>
                  </a:lnTo>
                  <a:lnTo>
                    <a:pt x="1124" y="258"/>
                  </a:lnTo>
                  <a:lnTo>
                    <a:pt x="1132" y="255"/>
                  </a:lnTo>
                  <a:lnTo>
                    <a:pt x="1142" y="251"/>
                  </a:lnTo>
                  <a:lnTo>
                    <a:pt x="1151" y="247"/>
                  </a:lnTo>
                  <a:lnTo>
                    <a:pt x="1160" y="247"/>
                  </a:lnTo>
                  <a:lnTo>
                    <a:pt x="1169" y="243"/>
                  </a:lnTo>
                  <a:lnTo>
                    <a:pt x="1179" y="240"/>
                  </a:lnTo>
                  <a:lnTo>
                    <a:pt x="1187" y="235"/>
                  </a:lnTo>
                  <a:lnTo>
                    <a:pt x="1197" y="231"/>
                  </a:lnTo>
                  <a:lnTo>
                    <a:pt x="1207" y="228"/>
                  </a:lnTo>
                  <a:lnTo>
                    <a:pt x="1216" y="227"/>
                  </a:lnTo>
                  <a:lnTo>
                    <a:pt x="1226" y="223"/>
                  </a:lnTo>
                  <a:lnTo>
                    <a:pt x="1234" y="221"/>
                  </a:lnTo>
                  <a:lnTo>
                    <a:pt x="1244" y="217"/>
                  </a:lnTo>
                  <a:lnTo>
                    <a:pt x="1253" y="216"/>
                  </a:lnTo>
                  <a:lnTo>
                    <a:pt x="1263" y="211"/>
                  </a:lnTo>
                  <a:lnTo>
                    <a:pt x="1271" y="207"/>
                  </a:lnTo>
                  <a:lnTo>
                    <a:pt x="1281" y="206"/>
                  </a:lnTo>
                  <a:lnTo>
                    <a:pt x="1290" y="204"/>
                  </a:lnTo>
                  <a:lnTo>
                    <a:pt x="1299" y="200"/>
                  </a:lnTo>
                  <a:lnTo>
                    <a:pt x="1308" y="197"/>
                  </a:lnTo>
                  <a:lnTo>
                    <a:pt x="1318" y="194"/>
                  </a:lnTo>
                  <a:lnTo>
                    <a:pt x="1328" y="190"/>
                  </a:lnTo>
                  <a:lnTo>
                    <a:pt x="1336" y="190"/>
                  </a:lnTo>
                  <a:lnTo>
                    <a:pt x="1346" y="186"/>
                  </a:lnTo>
                  <a:lnTo>
                    <a:pt x="1355" y="183"/>
                  </a:lnTo>
                  <a:lnTo>
                    <a:pt x="1365" y="179"/>
                  </a:lnTo>
                  <a:lnTo>
                    <a:pt x="1373" y="176"/>
                  </a:lnTo>
                  <a:lnTo>
                    <a:pt x="1383" y="174"/>
                  </a:lnTo>
                  <a:lnTo>
                    <a:pt x="1392" y="173"/>
                  </a:lnTo>
                  <a:lnTo>
                    <a:pt x="1402" y="172"/>
                  </a:lnTo>
                  <a:lnTo>
                    <a:pt x="1410" y="169"/>
                  </a:lnTo>
                  <a:lnTo>
                    <a:pt x="1420" y="164"/>
                  </a:lnTo>
                  <a:lnTo>
                    <a:pt x="1429" y="160"/>
                  </a:lnTo>
                  <a:lnTo>
                    <a:pt x="1439" y="159"/>
                  </a:lnTo>
                  <a:lnTo>
                    <a:pt x="1448" y="156"/>
                  </a:lnTo>
                  <a:lnTo>
                    <a:pt x="1457" y="155"/>
                  </a:lnTo>
                  <a:lnTo>
                    <a:pt x="1467" y="152"/>
                  </a:lnTo>
                  <a:lnTo>
                    <a:pt x="1475" y="147"/>
                  </a:lnTo>
                  <a:lnTo>
                    <a:pt x="1485" y="145"/>
                  </a:lnTo>
                  <a:lnTo>
                    <a:pt x="1494" y="145"/>
                  </a:lnTo>
                  <a:lnTo>
                    <a:pt x="1504" y="140"/>
                  </a:lnTo>
                  <a:lnTo>
                    <a:pt x="1512" y="139"/>
                  </a:lnTo>
                  <a:lnTo>
                    <a:pt x="1522" y="136"/>
                  </a:lnTo>
                  <a:lnTo>
                    <a:pt x="1531" y="133"/>
                  </a:lnTo>
                  <a:lnTo>
                    <a:pt x="1541" y="130"/>
                  </a:lnTo>
                  <a:lnTo>
                    <a:pt x="1549" y="128"/>
                  </a:lnTo>
                  <a:lnTo>
                    <a:pt x="1559" y="126"/>
                  </a:lnTo>
                  <a:lnTo>
                    <a:pt x="1569" y="123"/>
                  </a:lnTo>
                  <a:lnTo>
                    <a:pt x="1578" y="122"/>
                  </a:lnTo>
                  <a:lnTo>
                    <a:pt x="1588" y="119"/>
                  </a:lnTo>
                  <a:lnTo>
                    <a:pt x="1596" y="116"/>
                  </a:lnTo>
                  <a:lnTo>
                    <a:pt x="1606" y="112"/>
                  </a:lnTo>
                  <a:lnTo>
                    <a:pt x="1615" y="111"/>
                  </a:lnTo>
                  <a:lnTo>
                    <a:pt x="1624" y="109"/>
                  </a:lnTo>
                  <a:lnTo>
                    <a:pt x="1633" y="106"/>
                  </a:lnTo>
                  <a:lnTo>
                    <a:pt x="1643" y="104"/>
                  </a:lnTo>
                  <a:lnTo>
                    <a:pt x="1651" y="101"/>
                  </a:lnTo>
                  <a:lnTo>
                    <a:pt x="1661" y="99"/>
                  </a:lnTo>
                  <a:lnTo>
                    <a:pt x="1671" y="95"/>
                  </a:lnTo>
                  <a:lnTo>
                    <a:pt x="1680" y="94"/>
                  </a:lnTo>
                  <a:lnTo>
                    <a:pt x="1690" y="91"/>
                  </a:lnTo>
                  <a:lnTo>
                    <a:pt x="1698" y="91"/>
                  </a:lnTo>
                  <a:lnTo>
                    <a:pt x="1708" y="86"/>
                  </a:lnTo>
                  <a:lnTo>
                    <a:pt x="1717" y="84"/>
                  </a:lnTo>
                  <a:lnTo>
                    <a:pt x="1727" y="81"/>
                  </a:lnTo>
                  <a:lnTo>
                    <a:pt x="1735" y="78"/>
                  </a:lnTo>
                  <a:lnTo>
                    <a:pt x="1745" y="77"/>
                  </a:lnTo>
                  <a:lnTo>
                    <a:pt x="1754" y="74"/>
                  </a:lnTo>
                  <a:lnTo>
                    <a:pt x="1763" y="72"/>
                  </a:lnTo>
                  <a:lnTo>
                    <a:pt x="1772" y="69"/>
                  </a:lnTo>
                  <a:lnTo>
                    <a:pt x="1782" y="65"/>
                  </a:lnTo>
                  <a:lnTo>
                    <a:pt x="1792" y="62"/>
                  </a:lnTo>
                  <a:lnTo>
                    <a:pt x="1800" y="61"/>
                  </a:lnTo>
                  <a:lnTo>
                    <a:pt x="1810" y="60"/>
                  </a:lnTo>
                  <a:lnTo>
                    <a:pt x="1819" y="58"/>
                  </a:lnTo>
                  <a:lnTo>
                    <a:pt x="1829" y="57"/>
                  </a:lnTo>
                  <a:lnTo>
                    <a:pt x="1837" y="54"/>
                  </a:lnTo>
                  <a:lnTo>
                    <a:pt x="1847" y="51"/>
                  </a:lnTo>
                  <a:lnTo>
                    <a:pt x="1856" y="50"/>
                  </a:lnTo>
                  <a:lnTo>
                    <a:pt x="1866" y="47"/>
                  </a:lnTo>
                  <a:lnTo>
                    <a:pt x="1874" y="45"/>
                  </a:lnTo>
                  <a:lnTo>
                    <a:pt x="1884" y="43"/>
                  </a:lnTo>
                  <a:lnTo>
                    <a:pt x="1893" y="38"/>
                  </a:lnTo>
                  <a:lnTo>
                    <a:pt x="1903" y="38"/>
                  </a:lnTo>
                  <a:lnTo>
                    <a:pt x="1912" y="55"/>
                  </a:lnTo>
                  <a:lnTo>
                    <a:pt x="1921" y="45"/>
                  </a:lnTo>
                  <a:lnTo>
                    <a:pt x="1931" y="166"/>
                  </a:lnTo>
                  <a:lnTo>
                    <a:pt x="1939" y="25"/>
                  </a:lnTo>
                  <a:lnTo>
                    <a:pt x="1949" y="0"/>
                  </a:lnTo>
                  <a:lnTo>
                    <a:pt x="1958" y="27"/>
                  </a:lnTo>
                  <a:lnTo>
                    <a:pt x="1968" y="45"/>
                  </a:lnTo>
                  <a:lnTo>
                    <a:pt x="1976" y="54"/>
                  </a:lnTo>
                  <a:lnTo>
                    <a:pt x="1986" y="60"/>
                  </a:lnTo>
                  <a:lnTo>
                    <a:pt x="1995" y="62"/>
                  </a:lnTo>
                  <a:lnTo>
                    <a:pt x="2005" y="67"/>
                  </a:lnTo>
                  <a:lnTo>
                    <a:pt x="2013" y="69"/>
                  </a:lnTo>
                  <a:lnTo>
                    <a:pt x="2023" y="74"/>
                  </a:lnTo>
                  <a:lnTo>
                    <a:pt x="2033" y="77"/>
                  </a:lnTo>
                  <a:lnTo>
                    <a:pt x="2042" y="78"/>
                  </a:lnTo>
                  <a:lnTo>
                    <a:pt x="2052" y="81"/>
                  </a:lnTo>
                  <a:lnTo>
                    <a:pt x="2060" y="82"/>
                  </a:lnTo>
                  <a:lnTo>
                    <a:pt x="2070" y="84"/>
                  </a:lnTo>
                  <a:lnTo>
                    <a:pt x="2078" y="86"/>
                  </a:lnTo>
                  <a:lnTo>
                    <a:pt x="2088" y="91"/>
                  </a:lnTo>
                  <a:lnTo>
                    <a:pt x="2097" y="92"/>
                  </a:lnTo>
                  <a:lnTo>
                    <a:pt x="2107" y="95"/>
                  </a:lnTo>
                  <a:lnTo>
                    <a:pt x="2115" y="98"/>
                  </a:lnTo>
                  <a:lnTo>
                    <a:pt x="2125" y="99"/>
                  </a:lnTo>
                  <a:lnTo>
                    <a:pt x="2135" y="99"/>
                  </a:lnTo>
                  <a:lnTo>
                    <a:pt x="2144" y="102"/>
                  </a:lnTo>
                  <a:lnTo>
                    <a:pt x="2154" y="104"/>
                  </a:lnTo>
                  <a:lnTo>
                    <a:pt x="2162" y="106"/>
                  </a:lnTo>
                  <a:lnTo>
                    <a:pt x="2172" y="108"/>
                  </a:lnTo>
                  <a:lnTo>
                    <a:pt x="2181" y="111"/>
                  </a:lnTo>
                  <a:lnTo>
                    <a:pt x="2191" y="112"/>
                  </a:lnTo>
                  <a:lnTo>
                    <a:pt x="2199" y="115"/>
                  </a:lnTo>
                  <a:lnTo>
                    <a:pt x="2209" y="116"/>
                  </a:lnTo>
                  <a:lnTo>
                    <a:pt x="2218" y="116"/>
                  </a:lnTo>
                  <a:lnTo>
                    <a:pt x="2227" y="119"/>
                  </a:lnTo>
                  <a:lnTo>
                    <a:pt x="2236" y="119"/>
                  </a:lnTo>
                  <a:lnTo>
                    <a:pt x="2246" y="121"/>
                  </a:lnTo>
                  <a:lnTo>
                    <a:pt x="2256" y="122"/>
                  </a:lnTo>
                  <a:lnTo>
                    <a:pt x="2264" y="123"/>
                  </a:lnTo>
                  <a:lnTo>
                    <a:pt x="2274" y="125"/>
                  </a:lnTo>
                  <a:lnTo>
                    <a:pt x="2283" y="126"/>
                  </a:lnTo>
                  <a:lnTo>
                    <a:pt x="2293" y="128"/>
                  </a:lnTo>
                  <a:lnTo>
                    <a:pt x="2301" y="128"/>
                  </a:lnTo>
                  <a:lnTo>
                    <a:pt x="2311" y="129"/>
                  </a:lnTo>
                  <a:lnTo>
                    <a:pt x="2320" y="130"/>
                  </a:lnTo>
                  <a:lnTo>
                    <a:pt x="2330" y="132"/>
                  </a:lnTo>
                  <a:lnTo>
                    <a:pt x="2338" y="133"/>
                  </a:lnTo>
                  <a:lnTo>
                    <a:pt x="2348" y="135"/>
                  </a:lnTo>
                  <a:lnTo>
                    <a:pt x="2357" y="136"/>
                  </a:lnTo>
                  <a:lnTo>
                    <a:pt x="2367" y="136"/>
                  </a:lnTo>
                  <a:lnTo>
                    <a:pt x="2376" y="138"/>
                  </a:lnTo>
                  <a:lnTo>
                    <a:pt x="2385" y="139"/>
                  </a:lnTo>
                  <a:lnTo>
                    <a:pt x="2395" y="140"/>
                  </a:lnTo>
                  <a:lnTo>
                    <a:pt x="2403" y="140"/>
                  </a:lnTo>
                  <a:lnTo>
                    <a:pt x="2413" y="142"/>
                  </a:lnTo>
                  <a:lnTo>
                    <a:pt x="2422" y="145"/>
                  </a:lnTo>
                  <a:lnTo>
                    <a:pt x="2432" y="143"/>
                  </a:lnTo>
                  <a:lnTo>
                    <a:pt x="2440" y="146"/>
                  </a:lnTo>
                  <a:lnTo>
                    <a:pt x="2450" y="147"/>
                  </a:lnTo>
                  <a:lnTo>
                    <a:pt x="2459" y="150"/>
                  </a:lnTo>
                  <a:lnTo>
                    <a:pt x="2469" y="150"/>
                  </a:lnTo>
                  <a:lnTo>
                    <a:pt x="2477" y="152"/>
                  </a:lnTo>
                  <a:lnTo>
                    <a:pt x="2487" y="150"/>
                  </a:lnTo>
                  <a:lnTo>
                    <a:pt x="2497" y="153"/>
                  </a:lnTo>
                  <a:lnTo>
                    <a:pt x="2506" y="153"/>
                  </a:lnTo>
                  <a:lnTo>
                    <a:pt x="2516" y="155"/>
                  </a:lnTo>
                  <a:lnTo>
                    <a:pt x="2524" y="155"/>
                  </a:lnTo>
                  <a:lnTo>
                    <a:pt x="2534" y="157"/>
                  </a:lnTo>
                  <a:lnTo>
                    <a:pt x="2542" y="157"/>
                  </a:lnTo>
                  <a:lnTo>
                    <a:pt x="2552" y="159"/>
                  </a:lnTo>
                  <a:lnTo>
                    <a:pt x="2561" y="159"/>
                  </a:lnTo>
                  <a:lnTo>
                    <a:pt x="2571" y="159"/>
                  </a:lnTo>
                  <a:lnTo>
                    <a:pt x="2579" y="162"/>
                  </a:lnTo>
                  <a:lnTo>
                    <a:pt x="2589" y="162"/>
                  </a:lnTo>
                  <a:lnTo>
                    <a:pt x="2599" y="162"/>
                  </a:lnTo>
                  <a:lnTo>
                    <a:pt x="2608" y="163"/>
                  </a:lnTo>
                  <a:lnTo>
                    <a:pt x="2618" y="163"/>
                  </a:lnTo>
                  <a:lnTo>
                    <a:pt x="2626" y="164"/>
                  </a:lnTo>
                  <a:lnTo>
                    <a:pt x="2636" y="164"/>
                  </a:lnTo>
                  <a:lnTo>
                    <a:pt x="2645" y="166"/>
                  </a:lnTo>
                  <a:lnTo>
                    <a:pt x="2655" y="169"/>
                  </a:lnTo>
                  <a:lnTo>
                    <a:pt x="2663" y="169"/>
                  </a:lnTo>
                  <a:lnTo>
                    <a:pt x="2673" y="170"/>
                  </a:lnTo>
                  <a:lnTo>
                    <a:pt x="2682" y="170"/>
                  </a:lnTo>
                  <a:lnTo>
                    <a:pt x="2691" y="170"/>
                  </a:lnTo>
                  <a:lnTo>
                    <a:pt x="2700" y="170"/>
                  </a:lnTo>
                  <a:lnTo>
                    <a:pt x="2710" y="172"/>
                  </a:lnTo>
                  <a:lnTo>
                    <a:pt x="2720" y="173"/>
                  </a:lnTo>
                  <a:lnTo>
                    <a:pt x="2728" y="173"/>
                  </a:lnTo>
                  <a:lnTo>
                    <a:pt x="2738" y="173"/>
                  </a:lnTo>
                  <a:lnTo>
                    <a:pt x="2747" y="174"/>
                  </a:lnTo>
                  <a:lnTo>
                    <a:pt x="2757" y="174"/>
                  </a:lnTo>
                  <a:lnTo>
                    <a:pt x="2765" y="176"/>
                  </a:lnTo>
                  <a:lnTo>
                    <a:pt x="2775" y="177"/>
                  </a:lnTo>
                  <a:lnTo>
                    <a:pt x="2784" y="177"/>
                  </a:lnTo>
                  <a:lnTo>
                    <a:pt x="2794" y="180"/>
                  </a:lnTo>
                  <a:lnTo>
                    <a:pt x="2802" y="180"/>
                  </a:lnTo>
                  <a:lnTo>
                    <a:pt x="2812" y="182"/>
                  </a:lnTo>
                  <a:lnTo>
                    <a:pt x="2821" y="180"/>
                  </a:lnTo>
                  <a:lnTo>
                    <a:pt x="2831" y="182"/>
                  </a:lnTo>
                  <a:lnTo>
                    <a:pt x="2840" y="184"/>
                  </a:lnTo>
                  <a:lnTo>
                    <a:pt x="2849" y="183"/>
                  </a:lnTo>
                  <a:lnTo>
                    <a:pt x="2859" y="184"/>
                  </a:lnTo>
                  <a:lnTo>
                    <a:pt x="2867" y="184"/>
                  </a:lnTo>
                  <a:lnTo>
                    <a:pt x="2877" y="184"/>
                  </a:lnTo>
                  <a:lnTo>
                    <a:pt x="2886" y="184"/>
                  </a:lnTo>
                  <a:lnTo>
                    <a:pt x="2896" y="187"/>
                  </a:lnTo>
                  <a:lnTo>
                    <a:pt x="2904" y="187"/>
                  </a:lnTo>
                  <a:lnTo>
                    <a:pt x="2914" y="187"/>
                  </a:lnTo>
                  <a:lnTo>
                    <a:pt x="2923" y="187"/>
                  </a:lnTo>
                  <a:lnTo>
                    <a:pt x="2933" y="189"/>
                  </a:lnTo>
                  <a:lnTo>
                    <a:pt x="2941" y="189"/>
                  </a:lnTo>
                  <a:lnTo>
                    <a:pt x="2951" y="190"/>
                  </a:lnTo>
                  <a:lnTo>
                    <a:pt x="2961" y="190"/>
                  </a:lnTo>
                  <a:lnTo>
                    <a:pt x="2970" y="191"/>
                  </a:lnTo>
                  <a:lnTo>
                    <a:pt x="2980" y="191"/>
                  </a:lnTo>
                  <a:lnTo>
                    <a:pt x="2988" y="190"/>
                  </a:lnTo>
                  <a:lnTo>
                    <a:pt x="2998" y="191"/>
                  </a:lnTo>
                  <a:lnTo>
                    <a:pt x="3006" y="193"/>
                  </a:lnTo>
                  <a:lnTo>
                    <a:pt x="3016" y="193"/>
                  </a:lnTo>
                  <a:lnTo>
                    <a:pt x="3025" y="194"/>
                  </a:lnTo>
                  <a:lnTo>
                    <a:pt x="3035" y="196"/>
                  </a:lnTo>
                  <a:lnTo>
                    <a:pt x="3043" y="194"/>
                  </a:lnTo>
                  <a:lnTo>
                    <a:pt x="3053" y="196"/>
                  </a:lnTo>
                  <a:lnTo>
                    <a:pt x="3063" y="197"/>
                  </a:lnTo>
                  <a:lnTo>
                    <a:pt x="3072" y="199"/>
                  </a:lnTo>
                  <a:lnTo>
                    <a:pt x="3082" y="199"/>
                  </a:lnTo>
                  <a:lnTo>
                    <a:pt x="3090" y="199"/>
                  </a:lnTo>
                  <a:lnTo>
                    <a:pt x="3100" y="200"/>
                  </a:lnTo>
                  <a:lnTo>
                    <a:pt x="3109" y="201"/>
                  </a:lnTo>
                  <a:lnTo>
                    <a:pt x="3119" y="201"/>
                  </a:lnTo>
                  <a:lnTo>
                    <a:pt x="3127" y="201"/>
                  </a:lnTo>
                  <a:lnTo>
                    <a:pt x="3137" y="201"/>
                  </a:lnTo>
                  <a:lnTo>
                    <a:pt x="3146" y="203"/>
                  </a:lnTo>
                  <a:lnTo>
                    <a:pt x="3155" y="203"/>
                  </a:lnTo>
                  <a:lnTo>
                    <a:pt x="3164" y="201"/>
                  </a:lnTo>
                  <a:lnTo>
                    <a:pt x="3174" y="204"/>
                  </a:lnTo>
                  <a:lnTo>
                    <a:pt x="3184" y="204"/>
                  </a:lnTo>
                  <a:lnTo>
                    <a:pt x="3192" y="203"/>
                  </a:lnTo>
                  <a:lnTo>
                    <a:pt x="3202" y="204"/>
                  </a:lnTo>
                  <a:lnTo>
                    <a:pt x="3211" y="204"/>
                  </a:lnTo>
                  <a:lnTo>
                    <a:pt x="3221" y="208"/>
                  </a:lnTo>
                  <a:lnTo>
                    <a:pt x="3229" y="208"/>
                  </a:lnTo>
                  <a:lnTo>
                    <a:pt x="3239" y="208"/>
                  </a:lnTo>
                  <a:lnTo>
                    <a:pt x="3248" y="210"/>
                  </a:lnTo>
                  <a:lnTo>
                    <a:pt x="3258" y="210"/>
                  </a:lnTo>
                  <a:lnTo>
                    <a:pt x="3266" y="208"/>
                  </a:lnTo>
                  <a:lnTo>
                    <a:pt x="3276" y="210"/>
                  </a:lnTo>
                  <a:lnTo>
                    <a:pt x="3285" y="211"/>
                  </a:lnTo>
                  <a:lnTo>
                    <a:pt x="3295" y="211"/>
                  </a:lnTo>
                  <a:lnTo>
                    <a:pt x="3304" y="213"/>
                  </a:lnTo>
                  <a:lnTo>
                    <a:pt x="3313" y="213"/>
                  </a:lnTo>
                  <a:lnTo>
                    <a:pt x="3323" y="216"/>
                  </a:lnTo>
                </a:path>
              </a:pathLst>
            </a:custGeom>
            <a:noFill/>
            <a:ln w="19050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12" name="Freeform 95"/>
            <p:cNvSpPr>
              <a:spLocks/>
            </p:cNvSpPr>
            <p:nvPr/>
          </p:nvSpPr>
          <p:spPr bwMode="auto">
            <a:xfrm>
              <a:off x="1833563" y="3536950"/>
              <a:ext cx="5113338" cy="74613"/>
            </a:xfrm>
            <a:custGeom>
              <a:avLst/>
              <a:gdLst>
                <a:gd name="T0" fmla="*/ 47 w 3221"/>
                <a:gd name="T1" fmla="*/ 31 h 47"/>
                <a:gd name="T2" fmla="*/ 102 w 3221"/>
                <a:gd name="T3" fmla="*/ 30 h 47"/>
                <a:gd name="T4" fmla="*/ 157 w 3221"/>
                <a:gd name="T5" fmla="*/ 38 h 47"/>
                <a:gd name="T6" fmla="*/ 214 w 3221"/>
                <a:gd name="T7" fmla="*/ 28 h 47"/>
                <a:gd name="T8" fmla="*/ 270 w 3221"/>
                <a:gd name="T9" fmla="*/ 25 h 47"/>
                <a:gd name="T10" fmla="*/ 325 w 3221"/>
                <a:gd name="T11" fmla="*/ 24 h 47"/>
                <a:gd name="T12" fmla="*/ 380 w 3221"/>
                <a:gd name="T13" fmla="*/ 24 h 47"/>
                <a:gd name="T14" fmla="*/ 437 w 3221"/>
                <a:gd name="T15" fmla="*/ 23 h 47"/>
                <a:gd name="T16" fmla="*/ 492 w 3221"/>
                <a:gd name="T17" fmla="*/ 21 h 47"/>
                <a:gd name="T18" fmla="*/ 548 w 3221"/>
                <a:gd name="T19" fmla="*/ 20 h 47"/>
                <a:gd name="T20" fmla="*/ 603 w 3221"/>
                <a:gd name="T21" fmla="*/ 21 h 47"/>
                <a:gd name="T22" fmla="*/ 660 w 3221"/>
                <a:gd name="T23" fmla="*/ 21 h 47"/>
                <a:gd name="T24" fmla="*/ 715 w 3221"/>
                <a:gd name="T25" fmla="*/ 23 h 47"/>
                <a:gd name="T26" fmla="*/ 770 w 3221"/>
                <a:gd name="T27" fmla="*/ 21 h 47"/>
                <a:gd name="T28" fmla="*/ 826 w 3221"/>
                <a:gd name="T29" fmla="*/ 23 h 47"/>
                <a:gd name="T30" fmla="*/ 882 w 3221"/>
                <a:gd name="T31" fmla="*/ 21 h 47"/>
                <a:gd name="T32" fmla="*/ 938 w 3221"/>
                <a:gd name="T33" fmla="*/ 21 h 47"/>
                <a:gd name="T34" fmla="*/ 993 w 3221"/>
                <a:gd name="T35" fmla="*/ 21 h 47"/>
                <a:gd name="T36" fmla="*/ 1049 w 3221"/>
                <a:gd name="T37" fmla="*/ 18 h 47"/>
                <a:gd name="T38" fmla="*/ 1105 w 3221"/>
                <a:gd name="T39" fmla="*/ 18 h 47"/>
                <a:gd name="T40" fmla="*/ 1161 w 3221"/>
                <a:gd name="T41" fmla="*/ 21 h 47"/>
                <a:gd name="T42" fmla="*/ 1216 w 3221"/>
                <a:gd name="T43" fmla="*/ 20 h 47"/>
                <a:gd name="T44" fmla="*/ 1271 w 3221"/>
                <a:gd name="T45" fmla="*/ 20 h 47"/>
                <a:gd name="T46" fmla="*/ 1327 w 3221"/>
                <a:gd name="T47" fmla="*/ 18 h 47"/>
                <a:gd name="T48" fmla="*/ 1383 w 3221"/>
                <a:gd name="T49" fmla="*/ 20 h 47"/>
                <a:gd name="T50" fmla="*/ 1439 w 3221"/>
                <a:gd name="T51" fmla="*/ 18 h 47"/>
                <a:gd name="T52" fmla="*/ 1494 w 3221"/>
                <a:gd name="T53" fmla="*/ 17 h 47"/>
                <a:gd name="T54" fmla="*/ 1549 w 3221"/>
                <a:gd name="T55" fmla="*/ 20 h 47"/>
                <a:gd name="T56" fmla="*/ 1606 w 3221"/>
                <a:gd name="T57" fmla="*/ 20 h 47"/>
                <a:gd name="T58" fmla="*/ 1661 w 3221"/>
                <a:gd name="T59" fmla="*/ 18 h 47"/>
                <a:gd name="T60" fmla="*/ 1717 w 3221"/>
                <a:gd name="T61" fmla="*/ 21 h 47"/>
                <a:gd name="T62" fmla="*/ 1772 w 3221"/>
                <a:gd name="T63" fmla="*/ 20 h 47"/>
                <a:gd name="T64" fmla="*/ 1829 w 3221"/>
                <a:gd name="T65" fmla="*/ 34 h 47"/>
                <a:gd name="T66" fmla="*/ 1884 w 3221"/>
                <a:gd name="T67" fmla="*/ 17 h 47"/>
                <a:gd name="T68" fmla="*/ 1940 w 3221"/>
                <a:gd name="T69" fmla="*/ 21 h 47"/>
                <a:gd name="T70" fmla="*/ 1995 w 3221"/>
                <a:gd name="T71" fmla="*/ 18 h 47"/>
                <a:gd name="T72" fmla="*/ 2052 w 3221"/>
                <a:gd name="T73" fmla="*/ 24 h 47"/>
                <a:gd name="T74" fmla="*/ 2107 w 3221"/>
                <a:gd name="T75" fmla="*/ 21 h 47"/>
                <a:gd name="T76" fmla="*/ 2162 w 3221"/>
                <a:gd name="T77" fmla="*/ 27 h 47"/>
                <a:gd name="T78" fmla="*/ 2218 w 3221"/>
                <a:gd name="T79" fmla="*/ 10 h 47"/>
                <a:gd name="T80" fmla="*/ 2274 w 3221"/>
                <a:gd name="T81" fmla="*/ 21 h 47"/>
                <a:gd name="T82" fmla="*/ 2330 w 3221"/>
                <a:gd name="T83" fmla="*/ 23 h 47"/>
                <a:gd name="T84" fmla="*/ 2385 w 3221"/>
                <a:gd name="T85" fmla="*/ 24 h 47"/>
                <a:gd name="T86" fmla="*/ 2440 w 3221"/>
                <a:gd name="T87" fmla="*/ 24 h 47"/>
                <a:gd name="T88" fmla="*/ 2497 w 3221"/>
                <a:gd name="T89" fmla="*/ 25 h 47"/>
                <a:gd name="T90" fmla="*/ 2553 w 3221"/>
                <a:gd name="T91" fmla="*/ 25 h 47"/>
                <a:gd name="T92" fmla="*/ 2608 w 3221"/>
                <a:gd name="T93" fmla="*/ 27 h 47"/>
                <a:gd name="T94" fmla="*/ 2663 w 3221"/>
                <a:gd name="T95" fmla="*/ 25 h 47"/>
                <a:gd name="T96" fmla="*/ 2719 w 3221"/>
                <a:gd name="T97" fmla="*/ 25 h 47"/>
                <a:gd name="T98" fmla="*/ 2775 w 3221"/>
                <a:gd name="T99" fmla="*/ 24 h 47"/>
                <a:gd name="T100" fmla="*/ 2831 w 3221"/>
                <a:gd name="T101" fmla="*/ 25 h 47"/>
                <a:gd name="T102" fmla="*/ 2886 w 3221"/>
                <a:gd name="T103" fmla="*/ 25 h 47"/>
                <a:gd name="T104" fmla="*/ 2941 w 3221"/>
                <a:gd name="T105" fmla="*/ 24 h 47"/>
                <a:gd name="T106" fmla="*/ 2998 w 3221"/>
                <a:gd name="T107" fmla="*/ 25 h 47"/>
                <a:gd name="T108" fmla="*/ 3053 w 3221"/>
                <a:gd name="T109" fmla="*/ 25 h 47"/>
                <a:gd name="T110" fmla="*/ 3109 w 3221"/>
                <a:gd name="T111" fmla="*/ 25 h 47"/>
                <a:gd name="T112" fmla="*/ 3164 w 3221"/>
                <a:gd name="T113" fmla="*/ 27 h 47"/>
                <a:gd name="T114" fmla="*/ 3221 w 3221"/>
                <a:gd name="T115" fmla="*/ 25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3221" h="47">
                  <a:moveTo>
                    <a:pt x="0" y="30"/>
                  </a:moveTo>
                  <a:lnTo>
                    <a:pt x="10" y="31"/>
                  </a:lnTo>
                  <a:lnTo>
                    <a:pt x="18" y="30"/>
                  </a:lnTo>
                  <a:lnTo>
                    <a:pt x="28" y="30"/>
                  </a:lnTo>
                  <a:lnTo>
                    <a:pt x="37" y="31"/>
                  </a:lnTo>
                  <a:lnTo>
                    <a:pt x="47" y="31"/>
                  </a:lnTo>
                  <a:lnTo>
                    <a:pt x="55" y="31"/>
                  </a:lnTo>
                  <a:lnTo>
                    <a:pt x="65" y="31"/>
                  </a:lnTo>
                  <a:lnTo>
                    <a:pt x="75" y="31"/>
                  </a:lnTo>
                  <a:lnTo>
                    <a:pt x="84" y="31"/>
                  </a:lnTo>
                  <a:lnTo>
                    <a:pt x="94" y="30"/>
                  </a:lnTo>
                  <a:lnTo>
                    <a:pt x="102" y="30"/>
                  </a:lnTo>
                  <a:lnTo>
                    <a:pt x="112" y="31"/>
                  </a:lnTo>
                  <a:lnTo>
                    <a:pt x="121" y="28"/>
                  </a:lnTo>
                  <a:lnTo>
                    <a:pt x="130" y="25"/>
                  </a:lnTo>
                  <a:lnTo>
                    <a:pt x="139" y="21"/>
                  </a:lnTo>
                  <a:lnTo>
                    <a:pt x="149" y="27"/>
                  </a:lnTo>
                  <a:lnTo>
                    <a:pt x="157" y="38"/>
                  </a:lnTo>
                  <a:lnTo>
                    <a:pt x="167" y="20"/>
                  </a:lnTo>
                  <a:lnTo>
                    <a:pt x="177" y="47"/>
                  </a:lnTo>
                  <a:lnTo>
                    <a:pt x="186" y="42"/>
                  </a:lnTo>
                  <a:lnTo>
                    <a:pt x="196" y="34"/>
                  </a:lnTo>
                  <a:lnTo>
                    <a:pt x="204" y="31"/>
                  </a:lnTo>
                  <a:lnTo>
                    <a:pt x="214" y="28"/>
                  </a:lnTo>
                  <a:lnTo>
                    <a:pt x="223" y="28"/>
                  </a:lnTo>
                  <a:lnTo>
                    <a:pt x="233" y="27"/>
                  </a:lnTo>
                  <a:lnTo>
                    <a:pt x="241" y="27"/>
                  </a:lnTo>
                  <a:lnTo>
                    <a:pt x="251" y="27"/>
                  </a:lnTo>
                  <a:lnTo>
                    <a:pt x="260" y="25"/>
                  </a:lnTo>
                  <a:lnTo>
                    <a:pt x="270" y="25"/>
                  </a:lnTo>
                  <a:lnTo>
                    <a:pt x="278" y="25"/>
                  </a:lnTo>
                  <a:lnTo>
                    <a:pt x="288" y="25"/>
                  </a:lnTo>
                  <a:lnTo>
                    <a:pt x="298" y="27"/>
                  </a:lnTo>
                  <a:lnTo>
                    <a:pt x="306" y="25"/>
                  </a:lnTo>
                  <a:lnTo>
                    <a:pt x="316" y="25"/>
                  </a:lnTo>
                  <a:lnTo>
                    <a:pt x="325" y="24"/>
                  </a:lnTo>
                  <a:lnTo>
                    <a:pt x="335" y="24"/>
                  </a:lnTo>
                  <a:lnTo>
                    <a:pt x="343" y="25"/>
                  </a:lnTo>
                  <a:lnTo>
                    <a:pt x="353" y="25"/>
                  </a:lnTo>
                  <a:lnTo>
                    <a:pt x="362" y="24"/>
                  </a:lnTo>
                  <a:lnTo>
                    <a:pt x="372" y="24"/>
                  </a:lnTo>
                  <a:lnTo>
                    <a:pt x="380" y="24"/>
                  </a:lnTo>
                  <a:lnTo>
                    <a:pt x="390" y="24"/>
                  </a:lnTo>
                  <a:lnTo>
                    <a:pt x="399" y="24"/>
                  </a:lnTo>
                  <a:lnTo>
                    <a:pt x="409" y="24"/>
                  </a:lnTo>
                  <a:lnTo>
                    <a:pt x="418" y="23"/>
                  </a:lnTo>
                  <a:lnTo>
                    <a:pt x="427" y="23"/>
                  </a:lnTo>
                  <a:lnTo>
                    <a:pt x="437" y="23"/>
                  </a:lnTo>
                  <a:lnTo>
                    <a:pt x="445" y="23"/>
                  </a:lnTo>
                  <a:lnTo>
                    <a:pt x="455" y="21"/>
                  </a:lnTo>
                  <a:lnTo>
                    <a:pt x="464" y="23"/>
                  </a:lnTo>
                  <a:lnTo>
                    <a:pt x="474" y="23"/>
                  </a:lnTo>
                  <a:lnTo>
                    <a:pt x="482" y="21"/>
                  </a:lnTo>
                  <a:lnTo>
                    <a:pt x="492" y="21"/>
                  </a:lnTo>
                  <a:lnTo>
                    <a:pt x="501" y="20"/>
                  </a:lnTo>
                  <a:lnTo>
                    <a:pt x="511" y="21"/>
                  </a:lnTo>
                  <a:lnTo>
                    <a:pt x="519" y="21"/>
                  </a:lnTo>
                  <a:lnTo>
                    <a:pt x="529" y="21"/>
                  </a:lnTo>
                  <a:lnTo>
                    <a:pt x="539" y="18"/>
                  </a:lnTo>
                  <a:lnTo>
                    <a:pt x="548" y="20"/>
                  </a:lnTo>
                  <a:lnTo>
                    <a:pt x="558" y="23"/>
                  </a:lnTo>
                  <a:lnTo>
                    <a:pt x="566" y="21"/>
                  </a:lnTo>
                  <a:lnTo>
                    <a:pt x="576" y="21"/>
                  </a:lnTo>
                  <a:lnTo>
                    <a:pt x="585" y="21"/>
                  </a:lnTo>
                  <a:lnTo>
                    <a:pt x="594" y="21"/>
                  </a:lnTo>
                  <a:lnTo>
                    <a:pt x="603" y="21"/>
                  </a:lnTo>
                  <a:lnTo>
                    <a:pt x="613" y="23"/>
                  </a:lnTo>
                  <a:lnTo>
                    <a:pt x="621" y="23"/>
                  </a:lnTo>
                  <a:lnTo>
                    <a:pt x="631" y="24"/>
                  </a:lnTo>
                  <a:lnTo>
                    <a:pt x="641" y="23"/>
                  </a:lnTo>
                  <a:lnTo>
                    <a:pt x="650" y="23"/>
                  </a:lnTo>
                  <a:lnTo>
                    <a:pt x="660" y="21"/>
                  </a:lnTo>
                  <a:lnTo>
                    <a:pt x="668" y="24"/>
                  </a:lnTo>
                  <a:lnTo>
                    <a:pt x="678" y="24"/>
                  </a:lnTo>
                  <a:lnTo>
                    <a:pt x="687" y="23"/>
                  </a:lnTo>
                  <a:lnTo>
                    <a:pt x="697" y="23"/>
                  </a:lnTo>
                  <a:lnTo>
                    <a:pt x="705" y="23"/>
                  </a:lnTo>
                  <a:lnTo>
                    <a:pt x="715" y="23"/>
                  </a:lnTo>
                  <a:lnTo>
                    <a:pt x="724" y="23"/>
                  </a:lnTo>
                  <a:lnTo>
                    <a:pt x="733" y="24"/>
                  </a:lnTo>
                  <a:lnTo>
                    <a:pt x="742" y="24"/>
                  </a:lnTo>
                  <a:lnTo>
                    <a:pt x="752" y="23"/>
                  </a:lnTo>
                  <a:lnTo>
                    <a:pt x="762" y="23"/>
                  </a:lnTo>
                  <a:lnTo>
                    <a:pt x="770" y="21"/>
                  </a:lnTo>
                  <a:lnTo>
                    <a:pt x="780" y="23"/>
                  </a:lnTo>
                  <a:lnTo>
                    <a:pt x="789" y="23"/>
                  </a:lnTo>
                  <a:lnTo>
                    <a:pt x="799" y="23"/>
                  </a:lnTo>
                  <a:lnTo>
                    <a:pt x="807" y="21"/>
                  </a:lnTo>
                  <a:lnTo>
                    <a:pt x="817" y="23"/>
                  </a:lnTo>
                  <a:lnTo>
                    <a:pt x="826" y="23"/>
                  </a:lnTo>
                  <a:lnTo>
                    <a:pt x="836" y="21"/>
                  </a:lnTo>
                  <a:lnTo>
                    <a:pt x="844" y="21"/>
                  </a:lnTo>
                  <a:lnTo>
                    <a:pt x="854" y="23"/>
                  </a:lnTo>
                  <a:lnTo>
                    <a:pt x="863" y="21"/>
                  </a:lnTo>
                  <a:lnTo>
                    <a:pt x="873" y="21"/>
                  </a:lnTo>
                  <a:lnTo>
                    <a:pt x="882" y="21"/>
                  </a:lnTo>
                  <a:lnTo>
                    <a:pt x="891" y="21"/>
                  </a:lnTo>
                  <a:lnTo>
                    <a:pt x="901" y="20"/>
                  </a:lnTo>
                  <a:lnTo>
                    <a:pt x="909" y="21"/>
                  </a:lnTo>
                  <a:lnTo>
                    <a:pt x="919" y="23"/>
                  </a:lnTo>
                  <a:lnTo>
                    <a:pt x="928" y="21"/>
                  </a:lnTo>
                  <a:lnTo>
                    <a:pt x="938" y="21"/>
                  </a:lnTo>
                  <a:lnTo>
                    <a:pt x="946" y="21"/>
                  </a:lnTo>
                  <a:lnTo>
                    <a:pt x="956" y="20"/>
                  </a:lnTo>
                  <a:lnTo>
                    <a:pt x="965" y="21"/>
                  </a:lnTo>
                  <a:lnTo>
                    <a:pt x="975" y="24"/>
                  </a:lnTo>
                  <a:lnTo>
                    <a:pt x="983" y="20"/>
                  </a:lnTo>
                  <a:lnTo>
                    <a:pt x="993" y="21"/>
                  </a:lnTo>
                  <a:lnTo>
                    <a:pt x="1003" y="20"/>
                  </a:lnTo>
                  <a:lnTo>
                    <a:pt x="1012" y="18"/>
                  </a:lnTo>
                  <a:lnTo>
                    <a:pt x="1022" y="20"/>
                  </a:lnTo>
                  <a:lnTo>
                    <a:pt x="1030" y="20"/>
                  </a:lnTo>
                  <a:lnTo>
                    <a:pt x="1040" y="21"/>
                  </a:lnTo>
                  <a:lnTo>
                    <a:pt x="1049" y="18"/>
                  </a:lnTo>
                  <a:lnTo>
                    <a:pt x="1058" y="20"/>
                  </a:lnTo>
                  <a:lnTo>
                    <a:pt x="1067" y="21"/>
                  </a:lnTo>
                  <a:lnTo>
                    <a:pt x="1077" y="20"/>
                  </a:lnTo>
                  <a:lnTo>
                    <a:pt x="1085" y="20"/>
                  </a:lnTo>
                  <a:lnTo>
                    <a:pt x="1095" y="20"/>
                  </a:lnTo>
                  <a:lnTo>
                    <a:pt x="1105" y="18"/>
                  </a:lnTo>
                  <a:lnTo>
                    <a:pt x="1114" y="20"/>
                  </a:lnTo>
                  <a:lnTo>
                    <a:pt x="1124" y="21"/>
                  </a:lnTo>
                  <a:lnTo>
                    <a:pt x="1132" y="23"/>
                  </a:lnTo>
                  <a:lnTo>
                    <a:pt x="1142" y="20"/>
                  </a:lnTo>
                  <a:lnTo>
                    <a:pt x="1151" y="21"/>
                  </a:lnTo>
                  <a:lnTo>
                    <a:pt x="1161" y="21"/>
                  </a:lnTo>
                  <a:lnTo>
                    <a:pt x="1169" y="18"/>
                  </a:lnTo>
                  <a:lnTo>
                    <a:pt x="1179" y="20"/>
                  </a:lnTo>
                  <a:lnTo>
                    <a:pt x="1188" y="20"/>
                  </a:lnTo>
                  <a:lnTo>
                    <a:pt x="1197" y="18"/>
                  </a:lnTo>
                  <a:lnTo>
                    <a:pt x="1206" y="18"/>
                  </a:lnTo>
                  <a:lnTo>
                    <a:pt x="1216" y="20"/>
                  </a:lnTo>
                  <a:lnTo>
                    <a:pt x="1226" y="18"/>
                  </a:lnTo>
                  <a:lnTo>
                    <a:pt x="1234" y="20"/>
                  </a:lnTo>
                  <a:lnTo>
                    <a:pt x="1244" y="21"/>
                  </a:lnTo>
                  <a:lnTo>
                    <a:pt x="1253" y="20"/>
                  </a:lnTo>
                  <a:lnTo>
                    <a:pt x="1263" y="21"/>
                  </a:lnTo>
                  <a:lnTo>
                    <a:pt x="1271" y="20"/>
                  </a:lnTo>
                  <a:lnTo>
                    <a:pt x="1281" y="18"/>
                  </a:lnTo>
                  <a:lnTo>
                    <a:pt x="1290" y="18"/>
                  </a:lnTo>
                  <a:lnTo>
                    <a:pt x="1300" y="21"/>
                  </a:lnTo>
                  <a:lnTo>
                    <a:pt x="1308" y="20"/>
                  </a:lnTo>
                  <a:lnTo>
                    <a:pt x="1318" y="17"/>
                  </a:lnTo>
                  <a:lnTo>
                    <a:pt x="1327" y="18"/>
                  </a:lnTo>
                  <a:lnTo>
                    <a:pt x="1337" y="18"/>
                  </a:lnTo>
                  <a:lnTo>
                    <a:pt x="1346" y="20"/>
                  </a:lnTo>
                  <a:lnTo>
                    <a:pt x="1355" y="18"/>
                  </a:lnTo>
                  <a:lnTo>
                    <a:pt x="1365" y="20"/>
                  </a:lnTo>
                  <a:lnTo>
                    <a:pt x="1373" y="18"/>
                  </a:lnTo>
                  <a:lnTo>
                    <a:pt x="1383" y="20"/>
                  </a:lnTo>
                  <a:lnTo>
                    <a:pt x="1392" y="20"/>
                  </a:lnTo>
                  <a:lnTo>
                    <a:pt x="1402" y="20"/>
                  </a:lnTo>
                  <a:lnTo>
                    <a:pt x="1410" y="18"/>
                  </a:lnTo>
                  <a:lnTo>
                    <a:pt x="1420" y="21"/>
                  </a:lnTo>
                  <a:lnTo>
                    <a:pt x="1429" y="20"/>
                  </a:lnTo>
                  <a:lnTo>
                    <a:pt x="1439" y="18"/>
                  </a:lnTo>
                  <a:lnTo>
                    <a:pt x="1447" y="20"/>
                  </a:lnTo>
                  <a:lnTo>
                    <a:pt x="1457" y="17"/>
                  </a:lnTo>
                  <a:lnTo>
                    <a:pt x="1467" y="18"/>
                  </a:lnTo>
                  <a:lnTo>
                    <a:pt x="1476" y="18"/>
                  </a:lnTo>
                  <a:lnTo>
                    <a:pt x="1486" y="18"/>
                  </a:lnTo>
                  <a:lnTo>
                    <a:pt x="1494" y="17"/>
                  </a:lnTo>
                  <a:lnTo>
                    <a:pt x="1504" y="18"/>
                  </a:lnTo>
                  <a:lnTo>
                    <a:pt x="1513" y="18"/>
                  </a:lnTo>
                  <a:lnTo>
                    <a:pt x="1522" y="20"/>
                  </a:lnTo>
                  <a:lnTo>
                    <a:pt x="1531" y="20"/>
                  </a:lnTo>
                  <a:lnTo>
                    <a:pt x="1541" y="18"/>
                  </a:lnTo>
                  <a:lnTo>
                    <a:pt x="1549" y="20"/>
                  </a:lnTo>
                  <a:lnTo>
                    <a:pt x="1559" y="20"/>
                  </a:lnTo>
                  <a:lnTo>
                    <a:pt x="1569" y="20"/>
                  </a:lnTo>
                  <a:lnTo>
                    <a:pt x="1578" y="20"/>
                  </a:lnTo>
                  <a:lnTo>
                    <a:pt x="1588" y="20"/>
                  </a:lnTo>
                  <a:lnTo>
                    <a:pt x="1596" y="20"/>
                  </a:lnTo>
                  <a:lnTo>
                    <a:pt x="1606" y="20"/>
                  </a:lnTo>
                  <a:lnTo>
                    <a:pt x="1615" y="21"/>
                  </a:lnTo>
                  <a:lnTo>
                    <a:pt x="1625" y="18"/>
                  </a:lnTo>
                  <a:lnTo>
                    <a:pt x="1633" y="21"/>
                  </a:lnTo>
                  <a:lnTo>
                    <a:pt x="1643" y="21"/>
                  </a:lnTo>
                  <a:lnTo>
                    <a:pt x="1652" y="20"/>
                  </a:lnTo>
                  <a:lnTo>
                    <a:pt x="1661" y="18"/>
                  </a:lnTo>
                  <a:lnTo>
                    <a:pt x="1670" y="21"/>
                  </a:lnTo>
                  <a:lnTo>
                    <a:pt x="1680" y="21"/>
                  </a:lnTo>
                  <a:lnTo>
                    <a:pt x="1690" y="20"/>
                  </a:lnTo>
                  <a:lnTo>
                    <a:pt x="1698" y="21"/>
                  </a:lnTo>
                  <a:lnTo>
                    <a:pt x="1708" y="21"/>
                  </a:lnTo>
                  <a:lnTo>
                    <a:pt x="1717" y="21"/>
                  </a:lnTo>
                  <a:lnTo>
                    <a:pt x="1727" y="23"/>
                  </a:lnTo>
                  <a:lnTo>
                    <a:pt x="1735" y="21"/>
                  </a:lnTo>
                  <a:lnTo>
                    <a:pt x="1745" y="21"/>
                  </a:lnTo>
                  <a:lnTo>
                    <a:pt x="1754" y="21"/>
                  </a:lnTo>
                  <a:lnTo>
                    <a:pt x="1764" y="20"/>
                  </a:lnTo>
                  <a:lnTo>
                    <a:pt x="1772" y="20"/>
                  </a:lnTo>
                  <a:lnTo>
                    <a:pt x="1782" y="20"/>
                  </a:lnTo>
                  <a:lnTo>
                    <a:pt x="1791" y="18"/>
                  </a:lnTo>
                  <a:lnTo>
                    <a:pt x="1801" y="30"/>
                  </a:lnTo>
                  <a:lnTo>
                    <a:pt x="1810" y="34"/>
                  </a:lnTo>
                  <a:lnTo>
                    <a:pt x="1819" y="27"/>
                  </a:lnTo>
                  <a:lnTo>
                    <a:pt x="1829" y="34"/>
                  </a:lnTo>
                  <a:lnTo>
                    <a:pt x="1837" y="0"/>
                  </a:lnTo>
                  <a:lnTo>
                    <a:pt x="1847" y="4"/>
                  </a:lnTo>
                  <a:lnTo>
                    <a:pt x="1856" y="11"/>
                  </a:lnTo>
                  <a:lnTo>
                    <a:pt x="1866" y="14"/>
                  </a:lnTo>
                  <a:lnTo>
                    <a:pt x="1874" y="15"/>
                  </a:lnTo>
                  <a:lnTo>
                    <a:pt x="1884" y="17"/>
                  </a:lnTo>
                  <a:lnTo>
                    <a:pt x="1893" y="18"/>
                  </a:lnTo>
                  <a:lnTo>
                    <a:pt x="1903" y="20"/>
                  </a:lnTo>
                  <a:lnTo>
                    <a:pt x="1911" y="20"/>
                  </a:lnTo>
                  <a:lnTo>
                    <a:pt x="1921" y="21"/>
                  </a:lnTo>
                  <a:lnTo>
                    <a:pt x="1931" y="23"/>
                  </a:lnTo>
                  <a:lnTo>
                    <a:pt x="1940" y="21"/>
                  </a:lnTo>
                  <a:lnTo>
                    <a:pt x="1950" y="21"/>
                  </a:lnTo>
                  <a:lnTo>
                    <a:pt x="1958" y="20"/>
                  </a:lnTo>
                  <a:lnTo>
                    <a:pt x="1968" y="21"/>
                  </a:lnTo>
                  <a:lnTo>
                    <a:pt x="1976" y="23"/>
                  </a:lnTo>
                  <a:lnTo>
                    <a:pt x="1986" y="18"/>
                  </a:lnTo>
                  <a:lnTo>
                    <a:pt x="1995" y="18"/>
                  </a:lnTo>
                  <a:lnTo>
                    <a:pt x="2005" y="23"/>
                  </a:lnTo>
                  <a:lnTo>
                    <a:pt x="2013" y="23"/>
                  </a:lnTo>
                  <a:lnTo>
                    <a:pt x="2023" y="23"/>
                  </a:lnTo>
                  <a:lnTo>
                    <a:pt x="2033" y="23"/>
                  </a:lnTo>
                  <a:lnTo>
                    <a:pt x="2042" y="24"/>
                  </a:lnTo>
                  <a:lnTo>
                    <a:pt x="2052" y="24"/>
                  </a:lnTo>
                  <a:lnTo>
                    <a:pt x="2060" y="24"/>
                  </a:lnTo>
                  <a:lnTo>
                    <a:pt x="2070" y="23"/>
                  </a:lnTo>
                  <a:lnTo>
                    <a:pt x="2079" y="23"/>
                  </a:lnTo>
                  <a:lnTo>
                    <a:pt x="2089" y="21"/>
                  </a:lnTo>
                  <a:lnTo>
                    <a:pt x="2097" y="21"/>
                  </a:lnTo>
                  <a:lnTo>
                    <a:pt x="2107" y="21"/>
                  </a:lnTo>
                  <a:lnTo>
                    <a:pt x="2116" y="24"/>
                  </a:lnTo>
                  <a:lnTo>
                    <a:pt x="2125" y="24"/>
                  </a:lnTo>
                  <a:lnTo>
                    <a:pt x="2134" y="21"/>
                  </a:lnTo>
                  <a:lnTo>
                    <a:pt x="2144" y="30"/>
                  </a:lnTo>
                  <a:lnTo>
                    <a:pt x="2154" y="34"/>
                  </a:lnTo>
                  <a:lnTo>
                    <a:pt x="2162" y="27"/>
                  </a:lnTo>
                  <a:lnTo>
                    <a:pt x="2172" y="20"/>
                  </a:lnTo>
                  <a:lnTo>
                    <a:pt x="2181" y="21"/>
                  </a:lnTo>
                  <a:lnTo>
                    <a:pt x="2191" y="25"/>
                  </a:lnTo>
                  <a:lnTo>
                    <a:pt x="2199" y="34"/>
                  </a:lnTo>
                  <a:lnTo>
                    <a:pt x="2209" y="21"/>
                  </a:lnTo>
                  <a:lnTo>
                    <a:pt x="2218" y="10"/>
                  </a:lnTo>
                  <a:lnTo>
                    <a:pt x="2228" y="17"/>
                  </a:lnTo>
                  <a:lnTo>
                    <a:pt x="2236" y="18"/>
                  </a:lnTo>
                  <a:lnTo>
                    <a:pt x="2246" y="18"/>
                  </a:lnTo>
                  <a:lnTo>
                    <a:pt x="2255" y="20"/>
                  </a:lnTo>
                  <a:lnTo>
                    <a:pt x="2265" y="21"/>
                  </a:lnTo>
                  <a:lnTo>
                    <a:pt x="2274" y="21"/>
                  </a:lnTo>
                  <a:lnTo>
                    <a:pt x="2283" y="8"/>
                  </a:lnTo>
                  <a:lnTo>
                    <a:pt x="2293" y="10"/>
                  </a:lnTo>
                  <a:lnTo>
                    <a:pt x="2301" y="23"/>
                  </a:lnTo>
                  <a:lnTo>
                    <a:pt x="2311" y="23"/>
                  </a:lnTo>
                  <a:lnTo>
                    <a:pt x="2320" y="24"/>
                  </a:lnTo>
                  <a:lnTo>
                    <a:pt x="2330" y="23"/>
                  </a:lnTo>
                  <a:lnTo>
                    <a:pt x="2338" y="24"/>
                  </a:lnTo>
                  <a:lnTo>
                    <a:pt x="2348" y="24"/>
                  </a:lnTo>
                  <a:lnTo>
                    <a:pt x="2357" y="24"/>
                  </a:lnTo>
                  <a:lnTo>
                    <a:pt x="2367" y="24"/>
                  </a:lnTo>
                  <a:lnTo>
                    <a:pt x="2375" y="23"/>
                  </a:lnTo>
                  <a:lnTo>
                    <a:pt x="2385" y="24"/>
                  </a:lnTo>
                  <a:lnTo>
                    <a:pt x="2395" y="24"/>
                  </a:lnTo>
                  <a:lnTo>
                    <a:pt x="2404" y="24"/>
                  </a:lnTo>
                  <a:lnTo>
                    <a:pt x="2414" y="23"/>
                  </a:lnTo>
                  <a:lnTo>
                    <a:pt x="2422" y="24"/>
                  </a:lnTo>
                  <a:lnTo>
                    <a:pt x="2432" y="24"/>
                  </a:lnTo>
                  <a:lnTo>
                    <a:pt x="2440" y="24"/>
                  </a:lnTo>
                  <a:lnTo>
                    <a:pt x="2450" y="24"/>
                  </a:lnTo>
                  <a:lnTo>
                    <a:pt x="2459" y="23"/>
                  </a:lnTo>
                  <a:lnTo>
                    <a:pt x="2469" y="24"/>
                  </a:lnTo>
                  <a:lnTo>
                    <a:pt x="2477" y="25"/>
                  </a:lnTo>
                  <a:lnTo>
                    <a:pt x="2487" y="24"/>
                  </a:lnTo>
                  <a:lnTo>
                    <a:pt x="2497" y="25"/>
                  </a:lnTo>
                  <a:lnTo>
                    <a:pt x="2506" y="27"/>
                  </a:lnTo>
                  <a:lnTo>
                    <a:pt x="2516" y="27"/>
                  </a:lnTo>
                  <a:lnTo>
                    <a:pt x="2524" y="27"/>
                  </a:lnTo>
                  <a:lnTo>
                    <a:pt x="2534" y="25"/>
                  </a:lnTo>
                  <a:lnTo>
                    <a:pt x="2543" y="25"/>
                  </a:lnTo>
                  <a:lnTo>
                    <a:pt x="2553" y="25"/>
                  </a:lnTo>
                  <a:lnTo>
                    <a:pt x="2561" y="25"/>
                  </a:lnTo>
                  <a:lnTo>
                    <a:pt x="2571" y="25"/>
                  </a:lnTo>
                  <a:lnTo>
                    <a:pt x="2580" y="25"/>
                  </a:lnTo>
                  <a:lnTo>
                    <a:pt x="2589" y="25"/>
                  </a:lnTo>
                  <a:lnTo>
                    <a:pt x="2598" y="27"/>
                  </a:lnTo>
                  <a:lnTo>
                    <a:pt x="2608" y="27"/>
                  </a:lnTo>
                  <a:lnTo>
                    <a:pt x="2618" y="27"/>
                  </a:lnTo>
                  <a:lnTo>
                    <a:pt x="2626" y="27"/>
                  </a:lnTo>
                  <a:lnTo>
                    <a:pt x="2636" y="27"/>
                  </a:lnTo>
                  <a:lnTo>
                    <a:pt x="2645" y="27"/>
                  </a:lnTo>
                  <a:lnTo>
                    <a:pt x="2655" y="25"/>
                  </a:lnTo>
                  <a:lnTo>
                    <a:pt x="2663" y="25"/>
                  </a:lnTo>
                  <a:lnTo>
                    <a:pt x="2673" y="25"/>
                  </a:lnTo>
                  <a:lnTo>
                    <a:pt x="2682" y="25"/>
                  </a:lnTo>
                  <a:lnTo>
                    <a:pt x="2692" y="25"/>
                  </a:lnTo>
                  <a:lnTo>
                    <a:pt x="2700" y="25"/>
                  </a:lnTo>
                  <a:lnTo>
                    <a:pt x="2710" y="25"/>
                  </a:lnTo>
                  <a:lnTo>
                    <a:pt x="2719" y="25"/>
                  </a:lnTo>
                  <a:lnTo>
                    <a:pt x="2729" y="27"/>
                  </a:lnTo>
                  <a:lnTo>
                    <a:pt x="2738" y="24"/>
                  </a:lnTo>
                  <a:lnTo>
                    <a:pt x="2747" y="24"/>
                  </a:lnTo>
                  <a:lnTo>
                    <a:pt x="2757" y="25"/>
                  </a:lnTo>
                  <a:lnTo>
                    <a:pt x="2765" y="24"/>
                  </a:lnTo>
                  <a:lnTo>
                    <a:pt x="2775" y="24"/>
                  </a:lnTo>
                  <a:lnTo>
                    <a:pt x="2784" y="25"/>
                  </a:lnTo>
                  <a:lnTo>
                    <a:pt x="2794" y="27"/>
                  </a:lnTo>
                  <a:lnTo>
                    <a:pt x="2802" y="25"/>
                  </a:lnTo>
                  <a:lnTo>
                    <a:pt x="2812" y="24"/>
                  </a:lnTo>
                  <a:lnTo>
                    <a:pt x="2821" y="24"/>
                  </a:lnTo>
                  <a:lnTo>
                    <a:pt x="2831" y="25"/>
                  </a:lnTo>
                  <a:lnTo>
                    <a:pt x="2839" y="25"/>
                  </a:lnTo>
                  <a:lnTo>
                    <a:pt x="2849" y="25"/>
                  </a:lnTo>
                  <a:lnTo>
                    <a:pt x="2859" y="25"/>
                  </a:lnTo>
                  <a:lnTo>
                    <a:pt x="2868" y="25"/>
                  </a:lnTo>
                  <a:lnTo>
                    <a:pt x="2878" y="25"/>
                  </a:lnTo>
                  <a:lnTo>
                    <a:pt x="2886" y="25"/>
                  </a:lnTo>
                  <a:lnTo>
                    <a:pt x="2896" y="25"/>
                  </a:lnTo>
                  <a:lnTo>
                    <a:pt x="2904" y="24"/>
                  </a:lnTo>
                  <a:lnTo>
                    <a:pt x="2914" y="24"/>
                  </a:lnTo>
                  <a:lnTo>
                    <a:pt x="2923" y="24"/>
                  </a:lnTo>
                  <a:lnTo>
                    <a:pt x="2933" y="24"/>
                  </a:lnTo>
                  <a:lnTo>
                    <a:pt x="2941" y="24"/>
                  </a:lnTo>
                  <a:lnTo>
                    <a:pt x="2951" y="25"/>
                  </a:lnTo>
                  <a:lnTo>
                    <a:pt x="2961" y="24"/>
                  </a:lnTo>
                  <a:lnTo>
                    <a:pt x="2970" y="24"/>
                  </a:lnTo>
                  <a:lnTo>
                    <a:pt x="2980" y="23"/>
                  </a:lnTo>
                  <a:lnTo>
                    <a:pt x="2988" y="24"/>
                  </a:lnTo>
                  <a:lnTo>
                    <a:pt x="2998" y="25"/>
                  </a:lnTo>
                  <a:lnTo>
                    <a:pt x="3007" y="27"/>
                  </a:lnTo>
                  <a:lnTo>
                    <a:pt x="3017" y="27"/>
                  </a:lnTo>
                  <a:lnTo>
                    <a:pt x="3025" y="27"/>
                  </a:lnTo>
                  <a:lnTo>
                    <a:pt x="3035" y="24"/>
                  </a:lnTo>
                  <a:lnTo>
                    <a:pt x="3044" y="25"/>
                  </a:lnTo>
                  <a:lnTo>
                    <a:pt x="3053" y="25"/>
                  </a:lnTo>
                  <a:lnTo>
                    <a:pt x="3062" y="25"/>
                  </a:lnTo>
                  <a:lnTo>
                    <a:pt x="3072" y="25"/>
                  </a:lnTo>
                  <a:lnTo>
                    <a:pt x="3082" y="24"/>
                  </a:lnTo>
                  <a:lnTo>
                    <a:pt x="3090" y="24"/>
                  </a:lnTo>
                  <a:lnTo>
                    <a:pt x="3100" y="25"/>
                  </a:lnTo>
                  <a:lnTo>
                    <a:pt x="3109" y="25"/>
                  </a:lnTo>
                  <a:lnTo>
                    <a:pt x="3119" y="24"/>
                  </a:lnTo>
                  <a:lnTo>
                    <a:pt x="3127" y="25"/>
                  </a:lnTo>
                  <a:lnTo>
                    <a:pt x="3137" y="27"/>
                  </a:lnTo>
                  <a:lnTo>
                    <a:pt x="3146" y="25"/>
                  </a:lnTo>
                  <a:lnTo>
                    <a:pt x="3156" y="25"/>
                  </a:lnTo>
                  <a:lnTo>
                    <a:pt x="3164" y="27"/>
                  </a:lnTo>
                  <a:lnTo>
                    <a:pt x="3174" y="27"/>
                  </a:lnTo>
                  <a:lnTo>
                    <a:pt x="3183" y="25"/>
                  </a:lnTo>
                  <a:lnTo>
                    <a:pt x="3193" y="25"/>
                  </a:lnTo>
                  <a:lnTo>
                    <a:pt x="3202" y="25"/>
                  </a:lnTo>
                  <a:lnTo>
                    <a:pt x="3211" y="25"/>
                  </a:lnTo>
                  <a:lnTo>
                    <a:pt x="3221" y="25"/>
                  </a:lnTo>
                </a:path>
              </a:pathLst>
            </a:custGeom>
            <a:noFill/>
            <a:ln w="19050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13" name="Line 13"/>
            <p:cNvSpPr>
              <a:spLocks noChangeShapeType="1"/>
            </p:cNvSpPr>
            <p:nvPr/>
          </p:nvSpPr>
          <p:spPr bwMode="auto">
            <a:xfrm flipH="1">
              <a:off x="1273673" y="4077647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14" name="Line 17"/>
            <p:cNvSpPr>
              <a:spLocks noChangeShapeType="1"/>
            </p:cNvSpPr>
            <p:nvPr/>
          </p:nvSpPr>
          <p:spPr bwMode="auto">
            <a:xfrm flipH="1">
              <a:off x="1273673" y="4087172"/>
              <a:ext cx="206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15" name="Line 32"/>
            <p:cNvSpPr>
              <a:spLocks noChangeShapeType="1"/>
            </p:cNvSpPr>
            <p:nvPr/>
          </p:nvSpPr>
          <p:spPr bwMode="auto">
            <a:xfrm flipH="1">
              <a:off x="1253036" y="4077647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16" name="Line 34"/>
            <p:cNvSpPr>
              <a:spLocks noChangeShapeType="1"/>
            </p:cNvSpPr>
            <p:nvPr/>
          </p:nvSpPr>
          <p:spPr bwMode="auto">
            <a:xfrm flipH="1">
              <a:off x="1253036" y="4087172"/>
              <a:ext cx="523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17" name="Rectangle 44"/>
            <p:cNvSpPr>
              <a:spLocks noChangeArrowheads="1"/>
            </p:cNvSpPr>
            <p:nvPr/>
          </p:nvSpPr>
          <p:spPr bwMode="auto">
            <a:xfrm>
              <a:off x="1067298" y="4090347"/>
              <a:ext cx="25653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 dirty="0">
                  <a:solidFill>
                    <a:srgbClr val="000000"/>
                  </a:solidFill>
                  <a:latin typeface="Arial Black"/>
                  <a:cs typeface="Arial Black"/>
                </a:rPr>
                <a:t>-50</a:t>
              </a:r>
              <a:endParaRPr lang="es-ES" sz="1200" dirty="0">
                <a:latin typeface="Arial Black"/>
                <a:cs typeface="Arial Black"/>
              </a:endParaRPr>
            </a:p>
          </p:txBody>
        </p:sp>
        <p:sp>
          <p:nvSpPr>
            <p:cNvPr id="118" name="Line 52"/>
            <p:cNvSpPr>
              <a:spLocks noChangeShapeType="1"/>
            </p:cNvSpPr>
            <p:nvPr/>
          </p:nvSpPr>
          <p:spPr bwMode="auto">
            <a:xfrm>
              <a:off x="1285729" y="4061772"/>
              <a:ext cx="606807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19" name="Line 53"/>
            <p:cNvSpPr>
              <a:spLocks noChangeShapeType="1"/>
            </p:cNvSpPr>
            <p:nvPr/>
          </p:nvSpPr>
          <p:spPr bwMode="auto">
            <a:xfrm>
              <a:off x="128954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0" name="Line 54"/>
            <p:cNvSpPr>
              <a:spLocks noChangeShapeType="1"/>
            </p:cNvSpPr>
            <p:nvPr/>
          </p:nvSpPr>
          <p:spPr bwMode="auto">
            <a:xfrm>
              <a:off x="1686423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1" name="Line 55"/>
            <p:cNvSpPr>
              <a:spLocks noChangeShapeType="1"/>
            </p:cNvSpPr>
            <p:nvPr/>
          </p:nvSpPr>
          <p:spPr bwMode="auto">
            <a:xfrm>
              <a:off x="212139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2" name="Line 56"/>
            <p:cNvSpPr>
              <a:spLocks noChangeShapeType="1"/>
            </p:cNvSpPr>
            <p:nvPr/>
          </p:nvSpPr>
          <p:spPr bwMode="auto">
            <a:xfrm>
              <a:off x="2556373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3" name="Line 57"/>
            <p:cNvSpPr>
              <a:spLocks noChangeShapeType="1"/>
            </p:cNvSpPr>
            <p:nvPr/>
          </p:nvSpPr>
          <p:spPr bwMode="auto">
            <a:xfrm>
              <a:off x="2994523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4" name="Line 58"/>
            <p:cNvSpPr>
              <a:spLocks noChangeShapeType="1"/>
            </p:cNvSpPr>
            <p:nvPr/>
          </p:nvSpPr>
          <p:spPr bwMode="auto">
            <a:xfrm>
              <a:off x="342949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5" name="Line 59"/>
            <p:cNvSpPr>
              <a:spLocks noChangeShapeType="1"/>
            </p:cNvSpPr>
            <p:nvPr/>
          </p:nvSpPr>
          <p:spPr bwMode="auto">
            <a:xfrm>
              <a:off x="3864473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6" name="Line 60"/>
            <p:cNvSpPr>
              <a:spLocks noChangeShapeType="1"/>
            </p:cNvSpPr>
            <p:nvPr/>
          </p:nvSpPr>
          <p:spPr bwMode="auto">
            <a:xfrm>
              <a:off x="429944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7" name="Line 61"/>
            <p:cNvSpPr>
              <a:spLocks noChangeShapeType="1"/>
            </p:cNvSpPr>
            <p:nvPr/>
          </p:nvSpPr>
          <p:spPr bwMode="auto">
            <a:xfrm>
              <a:off x="473759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8" name="Line 62"/>
            <p:cNvSpPr>
              <a:spLocks noChangeShapeType="1"/>
            </p:cNvSpPr>
            <p:nvPr/>
          </p:nvSpPr>
          <p:spPr bwMode="auto">
            <a:xfrm>
              <a:off x="5172573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29" name="Line 63"/>
            <p:cNvSpPr>
              <a:spLocks noChangeShapeType="1"/>
            </p:cNvSpPr>
            <p:nvPr/>
          </p:nvSpPr>
          <p:spPr bwMode="auto">
            <a:xfrm>
              <a:off x="560754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0" name="Line 64"/>
            <p:cNvSpPr>
              <a:spLocks noChangeShapeType="1"/>
            </p:cNvSpPr>
            <p:nvPr/>
          </p:nvSpPr>
          <p:spPr bwMode="auto">
            <a:xfrm>
              <a:off x="604569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1" name="Line 65"/>
            <p:cNvSpPr>
              <a:spLocks noChangeShapeType="1"/>
            </p:cNvSpPr>
            <p:nvPr/>
          </p:nvSpPr>
          <p:spPr bwMode="auto">
            <a:xfrm>
              <a:off x="6480673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2" name="Line 66"/>
            <p:cNvSpPr>
              <a:spLocks noChangeShapeType="1"/>
            </p:cNvSpPr>
            <p:nvPr/>
          </p:nvSpPr>
          <p:spPr bwMode="auto">
            <a:xfrm>
              <a:off x="6915648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3" name="Line 67"/>
            <p:cNvSpPr>
              <a:spLocks noChangeShapeType="1"/>
            </p:cNvSpPr>
            <p:nvPr/>
          </p:nvSpPr>
          <p:spPr bwMode="auto">
            <a:xfrm>
              <a:off x="7352211" y="4072884"/>
              <a:ext cx="1588" cy="206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4" name="Line 72"/>
            <p:cNvSpPr>
              <a:spLocks noChangeShapeType="1"/>
            </p:cNvSpPr>
            <p:nvPr/>
          </p:nvSpPr>
          <p:spPr bwMode="auto">
            <a:xfrm>
              <a:off x="1289548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5" name="Line 73"/>
            <p:cNvSpPr>
              <a:spLocks noChangeShapeType="1"/>
            </p:cNvSpPr>
            <p:nvPr/>
          </p:nvSpPr>
          <p:spPr bwMode="auto">
            <a:xfrm>
              <a:off x="2121398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6" name="Line 74"/>
            <p:cNvSpPr>
              <a:spLocks noChangeShapeType="1"/>
            </p:cNvSpPr>
            <p:nvPr/>
          </p:nvSpPr>
          <p:spPr bwMode="auto">
            <a:xfrm>
              <a:off x="2994523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7" name="Line 75"/>
            <p:cNvSpPr>
              <a:spLocks noChangeShapeType="1"/>
            </p:cNvSpPr>
            <p:nvPr/>
          </p:nvSpPr>
          <p:spPr bwMode="auto">
            <a:xfrm>
              <a:off x="3864473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8" name="Line 76"/>
            <p:cNvSpPr>
              <a:spLocks noChangeShapeType="1"/>
            </p:cNvSpPr>
            <p:nvPr/>
          </p:nvSpPr>
          <p:spPr bwMode="auto">
            <a:xfrm>
              <a:off x="4737598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39" name="Line 77"/>
            <p:cNvSpPr>
              <a:spLocks noChangeShapeType="1"/>
            </p:cNvSpPr>
            <p:nvPr/>
          </p:nvSpPr>
          <p:spPr bwMode="auto">
            <a:xfrm>
              <a:off x="5607548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40" name="Line 78"/>
            <p:cNvSpPr>
              <a:spLocks noChangeShapeType="1"/>
            </p:cNvSpPr>
            <p:nvPr/>
          </p:nvSpPr>
          <p:spPr bwMode="auto">
            <a:xfrm>
              <a:off x="6480673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41" name="Line 79"/>
            <p:cNvSpPr>
              <a:spLocks noChangeShapeType="1"/>
            </p:cNvSpPr>
            <p:nvPr/>
          </p:nvSpPr>
          <p:spPr bwMode="auto">
            <a:xfrm>
              <a:off x="7352211" y="4061772"/>
              <a:ext cx="1588" cy="523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200">
                <a:latin typeface="Arial Black"/>
                <a:cs typeface="Arial Black"/>
              </a:endParaRPr>
            </a:p>
          </p:txBody>
        </p:sp>
        <p:sp>
          <p:nvSpPr>
            <p:cNvPr id="142" name="Rectangle 83"/>
            <p:cNvSpPr>
              <a:spLocks noChangeArrowheads="1"/>
            </p:cNvSpPr>
            <p:nvPr/>
          </p:nvSpPr>
          <p:spPr bwMode="auto">
            <a:xfrm>
              <a:off x="2108698" y="4139559"/>
              <a:ext cx="1026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143" name="Rectangle 84"/>
            <p:cNvSpPr>
              <a:spLocks noChangeArrowheads="1"/>
            </p:cNvSpPr>
            <p:nvPr/>
          </p:nvSpPr>
          <p:spPr bwMode="auto">
            <a:xfrm>
              <a:off x="2965948" y="4139559"/>
              <a:ext cx="20528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5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144" name="Rectangle 85"/>
            <p:cNvSpPr>
              <a:spLocks noChangeArrowheads="1"/>
            </p:cNvSpPr>
            <p:nvPr/>
          </p:nvSpPr>
          <p:spPr bwMode="auto">
            <a:xfrm>
              <a:off x="3820023" y="4139559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10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145" name="Rectangle 86"/>
            <p:cNvSpPr>
              <a:spLocks noChangeArrowheads="1"/>
            </p:cNvSpPr>
            <p:nvPr/>
          </p:nvSpPr>
          <p:spPr bwMode="auto">
            <a:xfrm>
              <a:off x="4693148" y="4139559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15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146" name="Rectangle 87"/>
            <p:cNvSpPr>
              <a:spLocks noChangeArrowheads="1"/>
            </p:cNvSpPr>
            <p:nvPr/>
          </p:nvSpPr>
          <p:spPr bwMode="auto">
            <a:xfrm>
              <a:off x="5564686" y="4139559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20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147" name="Rectangle 88"/>
            <p:cNvSpPr>
              <a:spLocks noChangeArrowheads="1"/>
            </p:cNvSpPr>
            <p:nvPr/>
          </p:nvSpPr>
          <p:spPr bwMode="auto">
            <a:xfrm>
              <a:off x="6437811" y="4139559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25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148" name="Rectangle 89"/>
            <p:cNvSpPr>
              <a:spLocks noChangeArrowheads="1"/>
            </p:cNvSpPr>
            <p:nvPr/>
          </p:nvSpPr>
          <p:spPr bwMode="auto">
            <a:xfrm>
              <a:off x="7307761" y="4139559"/>
              <a:ext cx="3079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200">
                  <a:solidFill>
                    <a:srgbClr val="000000"/>
                  </a:solidFill>
                  <a:latin typeface="Arial Black"/>
                  <a:cs typeface="Arial Black"/>
                </a:rPr>
                <a:t>300</a:t>
              </a:r>
              <a:endParaRPr lang="es-ES" sz="1200">
                <a:latin typeface="Arial Black"/>
                <a:cs typeface="Arial Black"/>
              </a:endParaRPr>
            </a:p>
          </p:txBody>
        </p:sp>
        <p:sp>
          <p:nvSpPr>
            <p:cNvPr id="149" name="Rectangle 96"/>
            <p:cNvSpPr>
              <a:spLocks noChangeArrowheads="1"/>
            </p:cNvSpPr>
            <p:nvPr/>
          </p:nvSpPr>
          <p:spPr bwMode="auto">
            <a:xfrm>
              <a:off x="4472486" y="4396735"/>
              <a:ext cx="118572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s-ES" sz="1600" b="1" dirty="0" smtClean="0">
                  <a:solidFill>
                    <a:srgbClr val="000000"/>
                  </a:solidFill>
                  <a:latin typeface="Arial Black"/>
                  <a:cs typeface="Arial Black"/>
                </a:rPr>
                <a:t>Time (</a:t>
              </a:r>
              <a:r>
                <a:rPr lang="es-ES" sz="1600" b="1" dirty="0" err="1" smtClean="0">
                  <a:solidFill>
                    <a:srgbClr val="000000"/>
                  </a:solidFill>
                  <a:latin typeface="Arial Black"/>
                  <a:cs typeface="Arial Black"/>
                </a:rPr>
                <a:t>sec</a:t>
              </a:r>
              <a:r>
                <a:rPr lang="es-ES" sz="1600" b="1" dirty="0" smtClean="0">
                  <a:solidFill>
                    <a:srgbClr val="000000"/>
                  </a:solidFill>
                  <a:latin typeface="Arial Black"/>
                  <a:cs typeface="Arial Black"/>
                </a:rPr>
                <a:t>)</a:t>
              </a:r>
              <a:endParaRPr lang="es-ES" sz="1600" dirty="0">
                <a:latin typeface="Arial Black"/>
                <a:cs typeface="Arial Black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85387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05</Words>
  <Application>Microsoft Macintosh PowerPoint</Application>
  <PresentationFormat>On-screen Show (4:3)</PresentationFormat>
  <Paragraphs>129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Figure 2A</vt:lpstr>
      <vt:lpstr>Figure2A</vt:lpstr>
      <vt:lpstr>Figure2B</vt:lpstr>
      <vt:lpstr>Figure2B</vt:lpstr>
      <vt:lpstr>Figure2C</vt:lpstr>
      <vt:lpstr>Figure2C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gela Ballesteros Morcillo</dc:creator>
  <cp:lastModifiedBy>Angela Ballesteros Morcillo</cp:lastModifiedBy>
  <cp:revision>5</cp:revision>
  <dcterms:created xsi:type="dcterms:W3CDTF">2016-05-10T02:12:12Z</dcterms:created>
  <dcterms:modified xsi:type="dcterms:W3CDTF">2016-05-10T02:28:27Z</dcterms:modified>
</cp:coreProperties>
</file>